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</p:sldIdLst>
  <p:sldSz cx="6858000" cy="9144000" type="screen4x3"/>
  <p:notesSz cx="6669088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3199" autoAdjust="0"/>
  </p:normalViewPr>
  <p:slideViewPr>
    <p:cSldViewPr>
      <p:cViewPr varScale="1">
        <p:scale>
          <a:sx n="81" d="100"/>
          <a:sy n="81" d="100"/>
        </p:scale>
        <p:origin x="3060" y="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localhost\Volumes\Stock\qPCR_Platte\qPCRAuswertung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7028253968254001"/>
          <c:y val="0.211666666666667"/>
          <c:w val="0.66420158730158696"/>
          <c:h val="0.615213333333332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spp!$I$43</c:f>
              <c:strCache>
                <c:ptCount val="1"/>
                <c:pt idx="0">
                  <c:v>Average</c:v>
                </c:pt>
              </c:strCache>
            </c:strRef>
          </c:tx>
          <c:spPr>
            <a:solidFill>
              <a:srgbClr val="404040"/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ysClr val="windowText" lastClr="000000">
                  <a:lumMod val="65000"/>
                  <a:lumOff val="35000"/>
                </a:sysClr>
              </a:solidFill>
            </c:spPr>
            <c:extLst>
              <c:ext xmlns:c16="http://schemas.microsoft.com/office/drawing/2014/chart" uri="{C3380CC4-5D6E-409C-BE32-E72D297353CC}">
                <c16:uniqueId val="{00000001-56EC-45F0-91B3-289DAFECC23B}"/>
              </c:ext>
            </c:extLst>
          </c:dPt>
          <c:dPt>
            <c:idx val="1"/>
            <c:invertIfNegative val="0"/>
            <c:bubble3D val="0"/>
            <c:spPr>
              <a:solidFill>
                <a:srgbClr val="D9D9D9"/>
              </a:solidFill>
            </c:spPr>
            <c:extLst>
              <c:ext xmlns:c16="http://schemas.microsoft.com/office/drawing/2014/chart" uri="{C3380CC4-5D6E-409C-BE32-E72D297353CC}">
                <c16:uniqueId val="{00000001-B2A0-4F9F-87F2-EB3AC29A1F89}"/>
              </c:ext>
            </c:extLst>
          </c:dPt>
          <c:errBars>
            <c:errBarType val="both"/>
            <c:errValType val="cust"/>
            <c:noEndCap val="0"/>
            <c:plus>
              <c:numRef>
                <c:f>Pspp!$J$44:$K$44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120.314553026713</c:v>
                  </c:pt>
                </c:numCache>
              </c:numRef>
            </c:plus>
            <c:minus>
              <c:numRef>
                <c:f>Pspp!$J$44:$K$44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120.314553026713</c:v>
                  </c:pt>
                </c:numCache>
              </c:numRef>
            </c:minus>
          </c:errBars>
          <c:cat>
            <c:strRef>
              <c:f>Pspp!$J$42:$K$42</c:f>
              <c:strCache>
                <c:ptCount val="2"/>
                <c:pt idx="0">
                  <c:v>Kontrolle</c:v>
                </c:pt>
                <c:pt idx="1">
                  <c:v>Infektion</c:v>
                </c:pt>
              </c:strCache>
            </c:strRef>
          </c:cat>
          <c:val>
            <c:numRef>
              <c:f>Pspp!$J$43:$K$43</c:f>
              <c:numCache>
                <c:formatCode>General</c:formatCode>
                <c:ptCount val="2"/>
                <c:pt idx="0">
                  <c:v>0</c:v>
                </c:pt>
                <c:pt idx="1">
                  <c:v>322.73274792341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2A0-4F9F-87F2-EB3AC29A1F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62"/>
        <c:overlap val="-2"/>
        <c:axId val="115484544"/>
        <c:axId val="115486080"/>
      </c:barChart>
      <c:catAx>
        <c:axId val="1154845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9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15486080"/>
        <c:crosses val="autoZero"/>
        <c:auto val="1"/>
        <c:lblAlgn val="ctr"/>
        <c:lblOffset val="100"/>
        <c:noMultiLvlLbl val="0"/>
      </c:catAx>
      <c:valAx>
        <c:axId val="115486080"/>
        <c:scaling>
          <c:orientation val="minMax"/>
          <c:max val="600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15484544"/>
        <c:crosses val="autoZero"/>
        <c:crossBetween val="between"/>
        <c:majorUnit val="300"/>
      </c:valAx>
    </c:plotArea>
    <c:plotVisOnly val="1"/>
    <c:dispBlanksAs val="gap"/>
    <c:showDLblsOverMax val="0"/>
  </c:chart>
  <c:spPr>
    <a:ln w="12700"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26925-E3AC-4EF6-9FBF-BD8718DC4389}" type="datetimeFigureOut">
              <a:rPr lang="en-US" smtClean="0"/>
              <a:t>1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9F40B-B70A-4A41-8C17-6343C64EF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3953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26925-E3AC-4EF6-9FBF-BD8718DC4389}" type="datetimeFigureOut">
              <a:rPr lang="en-US" smtClean="0"/>
              <a:t>1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9F40B-B70A-4A41-8C17-6343C64EF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9889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26925-E3AC-4EF6-9FBF-BD8718DC4389}" type="datetimeFigureOut">
              <a:rPr lang="en-US" smtClean="0"/>
              <a:t>1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9F40B-B70A-4A41-8C17-6343C64EF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75281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26925-E3AC-4EF6-9FBF-BD8718DC4389}" type="datetimeFigureOut">
              <a:rPr lang="en-US" smtClean="0"/>
              <a:t>1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9F40B-B70A-4A41-8C17-6343C64EF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00669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26925-E3AC-4EF6-9FBF-BD8718DC4389}" type="datetimeFigureOut">
              <a:rPr lang="en-US" smtClean="0"/>
              <a:t>1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9F40B-B70A-4A41-8C17-6343C64EF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1073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26925-E3AC-4EF6-9FBF-BD8718DC4389}" type="datetimeFigureOut">
              <a:rPr lang="en-US" smtClean="0"/>
              <a:t>1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9F40B-B70A-4A41-8C17-6343C64EF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3636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26925-E3AC-4EF6-9FBF-BD8718DC4389}" type="datetimeFigureOut">
              <a:rPr lang="en-US" smtClean="0"/>
              <a:t>1/1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9F40B-B70A-4A41-8C17-6343C64EF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0601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26925-E3AC-4EF6-9FBF-BD8718DC4389}" type="datetimeFigureOut">
              <a:rPr lang="en-US" smtClean="0"/>
              <a:t>1/1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9F40B-B70A-4A41-8C17-6343C64EF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7145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26925-E3AC-4EF6-9FBF-BD8718DC4389}" type="datetimeFigureOut">
              <a:rPr lang="en-US" smtClean="0"/>
              <a:t>1/1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9F40B-B70A-4A41-8C17-6343C64EF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28713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26925-E3AC-4EF6-9FBF-BD8718DC4389}" type="datetimeFigureOut">
              <a:rPr lang="en-US" smtClean="0"/>
              <a:t>1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9F40B-B70A-4A41-8C17-6343C64EF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99657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26925-E3AC-4EF6-9FBF-BD8718DC4389}" type="datetimeFigureOut">
              <a:rPr lang="en-US" smtClean="0"/>
              <a:t>1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9F40B-B70A-4A41-8C17-6343C64EF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10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626925-E3AC-4EF6-9FBF-BD8718DC4389}" type="datetimeFigureOut">
              <a:rPr lang="en-US" smtClean="0"/>
              <a:t>1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19F40B-B70A-4A41-8C17-6343C64EF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7481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762000" y="5486400"/>
            <a:ext cx="52578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S1. </a:t>
            </a:r>
            <a:r>
              <a:rPr lang="en-US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Phytophthora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cactorum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fection induces the accumulation of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esquiterpene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n-US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Populus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trichocarpa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roots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A)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ulverized root material was extracted with hexane and the extracts were analyzed using GC-MS. 1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lemo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; 2, unidentifie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esquiterpen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lcohol 1; 3, unidentifie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esquiterpen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lcohol 2; 4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yristaldehyd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(B)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cactorum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fection was verified by RT-qPCR analysis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Ypt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hytophthor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specific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a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related protein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chen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t al., 2008) gene expression. Means and SE are shown (n = 7 - 8). Asterisks indicate statistical significance as assed by Wilcoxon rank sum test (***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&lt; 0.001) (t =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6,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&lt; 0.001)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838201" y="2521199"/>
            <a:ext cx="4900458" cy="2210304"/>
            <a:chOff x="838201" y="2521199"/>
            <a:chExt cx="4900458" cy="2210304"/>
          </a:xfrm>
        </p:grpSpPr>
        <p:grpSp>
          <p:nvGrpSpPr>
            <p:cNvPr id="6" name="Group 8"/>
            <p:cNvGrpSpPr>
              <a:grpSpLocks noChangeAspect="1"/>
            </p:cNvGrpSpPr>
            <p:nvPr/>
          </p:nvGrpSpPr>
          <p:grpSpPr bwMode="auto">
            <a:xfrm>
              <a:off x="1015994" y="2521199"/>
              <a:ext cx="2284265" cy="1914526"/>
              <a:chOff x="269" y="1567"/>
              <a:chExt cx="3619" cy="1206"/>
            </a:xfrm>
          </p:grpSpPr>
          <p:sp>
            <p:nvSpPr>
              <p:cNvPr id="24" name="AutoShape 7"/>
              <p:cNvSpPr>
                <a:spLocks noChangeAspect="1" noChangeArrowheads="1" noTextEdit="1"/>
              </p:cNvSpPr>
              <p:nvPr/>
            </p:nvSpPr>
            <p:spPr bwMode="auto">
              <a:xfrm>
                <a:off x="269" y="1567"/>
                <a:ext cx="3619" cy="11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Line 9"/>
              <p:cNvSpPr>
                <a:spLocks noChangeShapeType="1"/>
              </p:cNvSpPr>
              <p:nvPr/>
            </p:nvSpPr>
            <p:spPr bwMode="auto">
              <a:xfrm>
                <a:off x="791" y="2652"/>
                <a:ext cx="301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Line 10"/>
              <p:cNvSpPr>
                <a:spLocks noChangeShapeType="1"/>
              </p:cNvSpPr>
              <p:nvPr/>
            </p:nvSpPr>
            <p:spPr bwMode="auto">
              <a:xfrm flipV="1">
                <a:off x="803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Line 11"/>
              <p:cNvSpPr>
                <a:spLocks noChangeShapeType="1"/>
              </p:cNvSpPr>
              <p:nvPr/>
            </p:nvSpPr>
            <p:spPr bwMode="auto">
              <a:xfrm flipV="1">
                <a:off x="888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Line 12"/>
              <p:cNvSpPr>
                <a:spLocks noChangeShapeType="1"/>
              </p:cNvSpPr>
              <p:nvPr/>
            </p:nvSpPr>
            <p:spPr bwMode="auto">
              <a:xfrm flipV="1">
                <a:off x="973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Line 13"/>
              <p:cNvSpPr>
                <a:spLocks noChangeShapeType="1"/>
              </p:cNvSpPr>
              <p:nvPr/>
            </p:nvSpPr>
            <p:spPr bwMode="auto">
              <a:xfrm flipV="1">
                <a:off x="1058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Line 14"/>
              <p:cNvSpPr>
                <a:spLocks noChangeShapeType="1"/>
              </p:cNvSpPr>
              <p:nvPr/>
            </p:nvSpPr>
            <p:spPr bwMode="auto">
              <a:xfrm flipV="1">
                <a:off x="1143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Line 15"/>
              <p:cNvSpPr>
                <a:spLocks noChangeShapeType="1"/>
              </p:cNvSpPr>
              <p:nvPr/>
            </p:nvSpPr>
            <p:spPr bwMode="auto">
              <a:xfrm flipV="1">
                <a:off x="1228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Line 16"/>
              <p:cNvSpPr>
                <a:spLocks noChangeShapeType="1"/>
              </p:cNvSpPr>
              <p:nvPr/>
            </p:nvSpPr>
            <p:spPr bwMode="auto">
              <a:xfrm flipV="1">
                <a:off x="1313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Line 17"/>
              <p:cNvSpPr>
                <a:spLocks noChangeShapeType="1"/>
              </p:cNvSpPr>
              <p:nvPr/>
            </p:nvSpPr>
            <p:spPr bwMode="auto">
              <a:xfrm flipV="1">
                <a:off x="1398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Line 18"/>
              <p:cNvSpPr>
                <a:spLocks noChangeShapeType="1"/>
              </p:cNvSpPr>
              <p:nvPr/>
            </p:nvSpPr>
            <p:spPr bwMode="auto">
              <a:xfrm flipV="1">
                <a:off x="1484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Line 19"/>
              <p:cNvSpPr>
                <a:spLocks noChangeShapeType="1"/>
              </p:cNvSpPr>
              <p:nvPr/>
            </p:nvSpPr>
            <p:spPr bwMode="auto">
              <a:xfrm flipV="1">
                <a:off x="1569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Line 20"/>
              <p:cNvSpPr>
                <a:spLocks noChangeShapeType="1"/>
              </p:cNvSpPr>
              <p:nvPr/>
            </p:nvSpPr>
            <p:spPr bwMode="auto">
              <a:xfrm flipV="1">
                <a:off x="1654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Line 21"/>
              <p:cNvSpPr>
                <a:spLocks noChangeShapeType="1"/>
              </p:cNvSpPr>
              <p:nvPr/>
            </p:nvSpPr>
            <p:spPr bwMode="auto">
              <a:xfrm flipV="1">
                <a:off x="1739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Line 22"/>
              <p:cNvSpPr>
                <a:spLocks noChangeShapeType="1"/>
              </p:cNvSpPr>
              <p:nvPr/>
            </p:nvSpPr>
            <p:spPr bwMode="auto">
              <a:xfrm flipV="1">
                <a:off x="1824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Line 23"/>
              <p:cNvSpPr>
                <a:spLocks noChangeShapeType="1"/>
              </p:cNvSpPr>
              <p:nvPr/>
            </p:nvSpPr>
            <p:spPr bwMode="auto">
              <a:xfrm flipV="1">
                <a:off x="1909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Line 24"/>
              <p:cNvSpPr>
                <a:spLocks noChangeShapeType="1"/>
              </p:cNvSpPr>
              <p:nvPr/>
            </p:nvSpPr>
            <p:spPr bwMode="auto">
              <a:xfrm flipV="1">
                <a:off x="1994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Line 25"/>
              <p:cNvSpPr>
                <a:spLocks noChangeShapeType="1"/>
              </p:cNvSpPr>
              <p:nvPr/>
            </p:nvSpPr>
            <p:spPr bwMode="auto">
              <a:xfrm flipV="1">
                <a:off x="2079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Line 26"/>
              <p:cNvSpPr>
                <a:spLocks noChangeShapeType="1"/>
              </p:cNvSpPr>
              <p:nvPr/>
            </p:nvSpPr>
            <p:spPr bwMode="auto">
              <a:xfrm flipV="1">
                <a:off x="2164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Line 27"/>
              <p:cNvSpPr>
                <a:spLocks noChangeShapeType="1"/>
              </p:cNvSpPr>
              <p:nvPr/>
            </p:nvSpPr>
            <p:spPr bwMode="auto">
              <a:xfrm flipV="1">
                <a:off x="2249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Line 28"/>
              <p:cNvSpPr>
                <a:spLocks noChangeShapeType="1"/>
              </p:cNvSpPr>
              <p:nvPr/>
            </p:nvSpPr>
            <p:spPr bwMode="auto">
              <a:xfrm flipV="1">
                <a:off x="2334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Line 29"/>
              <p:cNvSpPr>
                <a:spLocks noChangeShapeType="1"/>
              </p:cNvSpPr>
              <p:nvPr/>
            </p:nvSpPr>
            <p:spPr bwMode="auto">
              <a:xfrm flipV="1">
                <a:off x="2419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Line 30"/>
              <p:cNvSpPr>
                <a:spLocks noChangeShapeType="1"/>
              </p:cNvSpPr>
              <p:nvPr/>
            </p:nvSpPr>
            <p:spPr bwMode="auto">
              <a:xfrm flipV="1">
                <a:off x="2504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Line 31"/>
              <p:cNvSpPr>
                <a:spLocks noChangeShapeType="1"/>
              </p:cNvSpPr>
              <p:nvPr/>
            </p:nvSpPr>
            <p:spPr bwMode="auto">
              <a:xfrm flipV="1">
                <a:off x="2589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Line 32"/>
              <p:cNvSpPr>
                <a:spLocks noChangeShapeType="1"/>
              </p:cNvSpPr>
              <p:nvPr/>
            </p:nvSpPr>
            <p:spPr bwMode="auto">
              <a:xfrm flipV="1">
                <a:off x="2674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Line 33"/>
              <p:cNvSpPr>
                <a:spLocks noChangeShapeType="1"/>
              </p:cNvSpPr>
              <p:nvPr/>
            </p:nvSpPr>
            <p:spPr bwMode="auto">
              <a:xfrm flipV="1">
                <a:off x="2760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Line 34"/>
              <p:cNvSpPr>
                <a:spLocks noChangeShapeType="1"/>
              </p:cNvSpPr>
              <p:nvPr/>
            </p:nvSpPr>
            <p:spPr bwMode="auto">
              <a:xfrm flipV="1">
                <a:off x="2845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Line 35"/>
              <p:cNvSpPr>
                <a:spLocks noChangeShapeType="1"/>
              </p:cNvSpPr>
              <p:nvPr/>
            </p:nvSpPr>
            <p:spPr bwMode="auto">
              <a:xfrm flipV="1">
                <a:off x="2930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Line 36"/>
              <p:cNvSpPr>
                <a:spLocks noChangeShapeType="1"/>
              </p:cNvSpPr>
              <p:nvPr/>
            </p:nvSpPr>
            <p:spPr bwMode="auto">
              <a:xfrm flipV="1">
                <a:off x="3015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Line 37"/>
              <p:cNvSpPr>
                <a:spLocks noChangeShapeType="1"/>
              </p:cNvSpPr>
              <p:nvPr/>
            </p:nvSpPr>
            <p:spPr bwMode="auto">
              <a:xfrm flipV="1">
                <a:off x="3100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Line 38"/>
              <p:cNvSpPr>
                <a:spLocks noChangeShapeType="1"/>
              </p:cNvSpPr>
              <p:nvPr/>
            </p:nvSpPr>
            <p:spPr bwMode="auto">
              <a:xfrm flipV="1">
                <a:off x="3185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Line 39"/>
              <p:cNvSpPr>
                <a:spLocks noChangeShapeType="1"/>
              </p:cNvSpPr>
              <p:nvPr/>
            </p:nvSpPr>
            <p:spPr bwMode="auto">
              <a:xfrm flipV="1">
                <a:off x="3270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Line 40"/>
              <p:cNvSpPr>
                <a:spLocks noChangeShapeType="1"/>
              </p:cNvSpPr>
              <p:nvPr/>
            </p:nvSpPr>
            <p:spPr bwMode="auto">
              <a:xfrm flipV="1">
                <a:off x="3355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Line 41"/>
              <p:cNvSpPr>
                <a:spLocks noChangeShapeType="1"/>
              </p:cNvSpPr>
              <p:nvPr/>
            </p:nvSpPr>
            <p:spPr bwMode="auto">
              <a:xfrm flipV="1">
                <a:off x="3440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Line 42"/>
              <p:cNvSpPr>
                <a:spLocks noChangeShapeType="1"/>
              </p:cNvSpPr>
              <p:nvPr/>
            </p:nvSpPr>
            <p:spPr bwMode="auto">
              <a:xfrm flipV="1">
                <a:off x="3525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Line 43"/>
              <p:cNvSpPr>
                <a:spLocks noChangeShapeType="1"/>
              </p:cNvSpPr>
              <p:nvPr/>
            </p:nvSpPr>
            <p:spPr bwMode="auto">
              <a:xfrm flipV="1">
                <a:off x="3610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Line 44"/>
              <p:cNvSpPr>
                <a:spLocks noChangeShapeType="1"/>
              </p:cNvSpPr>
              <p:nvPr/>
            </p:nvSpPr>
            <p:spPr bwMode="auto">
              <a:xfrm flipV="1">
                <a:off x="3695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Line 45"/>
              <p:cNvSpPr>
                <a:spLocks noChangeShapeType="1"/>
              </p:cNvSpPr>
              <p:nvPr/>
            </p:nvSpPr>
            <p:spPr bwMode="auto">
              <a:xfrm flipV="1">
                <a:off x="3780" y="2652"/>
                <a:ext cx="0" cy="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Rectangle 47"/>
              <p:cNvSpPr>
                <a:spLocks noChangeArrowheads="1"/>
              </p:cNvSpPr>
              <p:nvPr/>
            </p:nvSpPr>
            <p:spPr bwMode="auto">
              <a:xfrm>
                <a:off x="1169" y="2695"/>
                <a:ext cx="12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21.0</a:t>
                </a:r>
                <a:endParaRPr kumimoji="0" lang="en-US" altLang="en-US" sz="3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3" name="Rectangle 48"/>
              <p:cNvSpPr>
                <a:spLocks noChangeArrowheads="1"/>
              </p:cNvSpPr>
              <p:nvPr/>
            </p:nvSpPr>
            <p:spPr bwMode="auto">
              <a:xfrm>
                <a:off x="1595" y="2695"/>
                <a:ext cx="12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21.5</a:t>
                </a:r>
                <a:endParaRPr kumimoji="0" lang="en-US" altLang="en-US" sz="3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4" name="Rectangle 49"/>
              <p:cNvSpPr>
                <a:spLocks noChangeArrowheads="1"/>
              </p:cNvSpPr>
              <p:nvPr/>
            </p:nvSpPr>
            <p:spPr bwMode="auto">
              <a:xfrm>
                <a:off x="2020" y="2695"/>
                <a:ext cx="12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22.0</a:t>
                </a:r>
                <a:endParaRPr kumimoji="0" lang="en-US" altLang="en-US" sz="3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5" name="Rectangle 50"/>
              <p:cNvSpPr>
                <a:spLocks noChangeArrowheads="1"/>
              </p:cNvSpPr>
              <p:nvPr/>
            </p:nvSpPr>
            <p:spPr bwMode="auto">
              <a:xfrm>
                <a:off x="2445" y="2695"/>
                <a:ext cx="12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22.5</a:t>
                </a:r>
                <a:endParaRPr kumimoji="0" lang="en-US" altLang="en-US" sz="3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6" name="Rectangle 51"/>
              <p:cNvSpPr>
                <a:spLocks noChangeArrowheads="1"/>
              </p:cNvSpPr>
              <p:nvPr/>
            </p:nvSpPr>
            <p:spPr bwMode="auto">
              <a:xfrm>
                <a:off x="2871" y="2695"/>
                <a:ext cx="12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23.0</a:t>
                </a:r>
                <a:endParaRPr kumimoji="0" lang="en-US" altLang="en-US" sz="3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7" name="Rectangle 52"/>
              <p:cNvSpPr>
                <a:spLocks noChangeArrowheads="1"/>
              </p:cNvSpPr>
              <p:nvPr/>
            </p:nvSpPr>
            <p:spPr bwMode="auto">
              <a:xfrm>
                <a:off x="3296" y="2695"/>
                <a:ext cx="127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23.5</a:t>
                </a:r>
                <a:endParaRPr kumimoji="0" lang="en-US" altLang="en-US" sz="3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8" name="Line 53"/>
              <p:cNvSpPr>
                <a:spLocks noChangeShapeType="1"/>
              </p:cNvSpPr>
              <p:nvPr/>
            </p:nvSpPr>
            <p:spPr bwMode="auto">
              <a:xfrm flipV="1">
                <a:off x="803" y="2652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Line 54"/>
              <p:cNvSpPr>
                <a:spLocks noChangeShapeType="1"/>
              </p:cNvSpPr>
              <p:nvPr/>
            </p:nvSpPr>
            <p:spPr bwMode="auto">
              <a:xfrm flipV="1">
                <a:off x="1228" y="2652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Line 55"/>
              <p:cNvSpPr>
                <a:spLocks noChangeShapeType="1"/>
              </p:cNvSpPr>
              <p:nvPr/>
            </p:nvSpPr>
            <p:spPr bwMode="auto">
              <a:xfrm flipV="1">
                <a:off x="1654" y="2652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Line 56"/>
              <p:cNvSpPr>
                <a:spLocks noChangeShapeType="1"/>
              </p:cNvSpPr>
              <p:nvPr/>
            </p:nvSpPr>
            <p:spPr bwMode="auto">
              <a:xfrm flipV="1">
                <a:off x="2079" y="2652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Line 57"/>
              <p:cNvSpPr>
                <a:spLocks noChangeShapeType="1"/>
              </p:cNvSpPr>
              <p:nvPr/>
            </p:nvSpPr>
            <p:spPr bwMode="auto">
              <a:xfrm flipV="1">
                <a:off x="2504" y="2652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Line 58"/>
              <p:cNvSpPr>
                <a:spLocks noChangeShapeType="1"/>
              </p:cNvSpPr>
              <p:nvPr/>
            </p:nvSpPr>
            <p:spPr bwMode="auto">
              <a:xfrm flipV="1">
                <a:off x="2930" y="2652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Line 59"/>
              <p:cNvSpPr>
                <a:spLocks noChangeShapeType="1"/>
              </p:cNvSpPr>
              <p:nvPr/>
            </p:nvSpPr>
            <p:spPr bwMode="auto">
              <a:xfrm flipV="1">
                <a:off x="3355" y="2652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Line 60"/>
              <p:cNvSpPr>
                <a:spLocks noChangeShapeType="1"/>
              </p:cNvSpPr>
              <p:nvPr/>
            </p:nvSpPr>
            <p:spPr bwMode="auto">
              <a:xfrm flipV="1">
                <a:off x="3780" y="2652"/>
                <a:ext cx="0" cy="1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Line 61"/>
              <p:cNvSpPr>
                <a:spLocks noChangeShapeType="1"/>
              </p:cNvSpPr>
              <p:nvPr/>
            </p:nvSpPr>
            <p:spPr bwMode="auto">
              <a:xfrm flipV="1">
                <a:off x="791" y="1712"/>
                <a:ext cx="0" cy="94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Line 62"/>
              <p:cNvSpPr>
                <a:spLocks noChangeShapeType="1"/>
              </p:cNvSpPr>
              <p:nvPr/>
            </p:nvSpPr>
            <p:spPr bwMode="auto">
              <a:xfrm>
                <a:off x="786" y="2652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Line 63"/>
              <p:cNvSpPr>
                <a:spLocks noChangeShapeType="1"/>
              </p:cNvSpPr>
              <p:nvPr/>
            </p:nvSpPr>
            <p:spPr bwMode="auto">
              <a:xfrm>
                <a:off x="786" y="2638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Line 64"/>
              <p:cNvSpPr>
                <a:spLocks noChangeShapeType="1"/>
              </p:cNvSpPr>
              <p:nvPr/>
            </p:nvSpPr>
            <p:spPr bwMode="auto">
              <a:xfrm>
                <a:off x="786" y="2624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Line 65"/>
              <p:cNvSpPr>
                <a:spLocks noChangeShapeType="1"/>
              </p:cNvSpPr>
              <p:nvPr/>
            </p:nvSpPr>
            <p:spPr bwMode="auto">
              <a:xfrm>
                <a:off x="786" y="2609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Line 66"/>
              <p:cNvSpPr>
                <a:spLocks noChangeShapeType="1"/>
              </p:cNvSpPr>
              <p:nvPr/>
            </p:nvSpPr>
            <p:spPr bwMode="auto">
              <a:xfrm>
                <a:off x="786" y="2595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Line 67"/>
              <p:cNvSpPr>
                <a:spLocks noChangeShapeType="1"/>
              </p:cNvSpPr>
              <p:nvPr/>
            </p:nvSpPr>
            <p:spPr bwMode="auto">
              <a:xfrm>
                <a:off x="786" y="2580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Line 68"/>
              <p:cNvSpPr>
                <a:spLocks noChangeShapeType="1"/>
              </p:cNvSpPr>
              <p:nvPr/>
            </p:nvSpPr>
            <p:spPr bwMode="auto">
              <a:xfrm>
                <a:off x="786" y="2566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Line 69"/>
              <p:cNvSpPr>
                <a:spLocks noChangeShapeType="1"/>
              </p:cNvSpPr>
              <p:nvPr/>
            </p:nvSpPr>
            <p:spPr bwMode="auto">
              <a:xfrm>
                <a:off x="786" y="2552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Line 70"/>
              <p:cNvSpPr>
                <a:spLocks noChangeShapeType="1"/>
              </p:cNvSpPr>
              <p:nvPr/>
            </p:nvSpPr>
            <p:spPr bwMode="auto">
              <a:xfrm>
                <a:off x="786" y="2537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Line 71"/>
              <p:cNvSpPr>
                <a:spLocks noChangeShapeType="1"/>
              </p:cNvSpPr>
              <p:nvPr/>
            </p:nvSpPr>
            <p:spPr bwMode="auto">
              <a:xfrm>
                <a:off x="786" y="2523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Line 72"/>
              <p:cNvSpPr>
                <a:spLocks noChangeShapeType="1"/>
              </p:cNvSpPr>
              <p:nvPr/>
            </p:nvSpPr>
            <p:spPr bwMode="auto">
              <a:xfrm>
                <a:off x="786" y="2508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Line 73"/>
              <p:cNvSpPr>
                <a:spLocks noChangeShapeType="1"/>
              </p:cNvSpPr>
              <p:nvPr/>
            </p:nvSpPr>
            <p:spPr bwMode="auto">
              <a:xfrm>
                <a:off x="786" y="2494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Line 74"/>
              <p:cNvSpPr>
                <a:spLocks noChangeShapeType="1"/>
              </p:cNvSpPr>
              <p:nvPr/>
            </p:nvSpPr>
            <p:spPr bwMode="auto">
              <a:xfrm>
                <a:off x="786" y="2479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Line 75"/>
              <p:cNvSpPr>
                <a:spLocks noChangeShapeType="1"/>
              </p:cNvSpPr>
              <p:nvPr/>
            </p:nvSpPr>
            <p:spPr bwMode="auto">
              <a:xfrm>
                <a:off x="786" y="2465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Line 76"/>
              <p:cNvSpPr>
                <a:spLocks noChangeShapeType="1"/>
              </p:cNvSpPr>
              <p:nvPr/>
            </p:nvSpPr>
            <p:spPr bwMode="auto">
              <a:xfrm>
                <a:off x="786" y="2451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Line 77"/>
              <p:cNvSpPr>
                <a:spLocks noChangeShapeType="1"/>
              </p:cNvSpPr>
              <p:nvPr/>
            </p:nvSpPr>
            <p:spPr bwMode="auto">
              <a:xfrm>
                <a:off x="786" y="2436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Line 78"/>
              <p:cNvSpPr>
                <a:spLocks noChangeShapeType="1"/>
              </p:cNvSpPr>
              <p:nvPr/>
            </p:nvSpPr>
            <p:spPr bwMode="auto">
              <a:xfrm>
                <a:off x="786" y="2422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Line 79"/>
              <p:cNvSpPr>
                <a:spLocks noChangeShapeType="1"/>
              </p:cNvSpPr>
              <p:nvPr/>
            </p:nvSpPr>
            <p:spPr bwMode="auto">
              <a:xfrm>
                <a:off x="786" y="2407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Line 80"/>
              <p:cNvSpPr>
                <a:spLocks noChangeShapeType="1"/>
              </p:cNvSpPr>
              <p:nvPr/>
            </p:nvSpPr>
            <p:spPr bwMode="auto">
              <a:xfrm>
                <a:off x="786" y="2393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Line 81"/>
              <p:cNvSpPr>
                <a:spLocks noChangeShapeType="1"/>
              </p:cNvSpPr>
              <p:nvPr/>
            </p:nvSpPr>
            <p:spPr bwMode="auto">
              <a:xfrm>
                <a:off x="786" y="2378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Line 82"/>
              <p:cNvSpPr>
                <a:spLocks noChangeShapeType="1"/>
              </p:cNvSpPr>
              <p:nvPr/>
            </p:nvSpPr>
            <p:spPr bwMode="auto">
              <a:xfrm>
                <a:off x="786" y="2364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Line 83"/>
              <p:cNvSpPr>
                <a:spLocks noChangeShapeType="1"/>
              </p:cNvSpPr>
              <p:nvPr/>
            </p:nvSpPr>
            <p:spPr bwMode="auto">
              <a:xfrm>
                <a:off x="786" y="2350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Line 84"/>
              <p:cNvSpPr>
                <a:spLocks noChangeShapeType="1"/>
              </p:cNvSpPr>
              <p:nvPr/>
            </p:nvSpPr>
            <p:spPr bwMode="auto">
              <a:xfrm>
                <a:off x="786" y="2335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Line 85"/>
              <p:cNvSpPr>
                <a:spLocks noChangeShapeType="1"/>
              </p:cNvSpPr>
              <p:nvPr/>
            </p:nvSpPr>
            <p:spPr bwMode="auto">
              <a:xfrm>
                <a:off x="786" y="2321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Line 86"/>
              <p:cNvSpPr>
                <a:spLocks noChangeShapeType="1"/>
              </p:cNvSpPr>
              <p:nvPr/>
            </p:nvSpPr>
            <p:spPr bwMode="auto">
              <a:xfrm>
                <a:off x="786" y="2306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Line 87"/>
              <p:cNvSpPr>
                <a:spLocks noChangeShapeType="1"/>
              </p:cNvSpPr>
              <p:nvPr/>
            </p:nvSpPr>
            <p:spPr bwMode="auto">
              <a:xfrm>
                <a:off x="786" y="2292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Line 88"/>
              <p:cNvSpPr>
                <a:spLocks noChangeShapeType="1"/>
              </p:cNvSpPr>
              <p:nvPr/>
            </p:nvSpPr>
            <p:spPr bwMode="auto">
              <a:xfrm>
                <a:off x="786" y="2278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Line 89"/>
              <p:cNvSpPr>
                <a:spLocks noChangeShapeType="1"/>
              </p:cNvSpPr>
              <p:nvPr/>
            </p:nvSpPr>
            <p:spPr bwMode="auto">
              <a:xfrm>
                <a:off x="786" y="2263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Line 90"/>
              <p:cNvSpPr>
                <a:spLocks noChangeShapeType="1"/>
              </p:cNvSpPr>
              <p:nvPr/>
            </p:nvSpPr>
            <p:spPr bwMode="auto">
              <a:xfrm>
                <a:off x="786" y="2249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Line 91"/>
              <p:cNvSpPr>
                <a:spLocks noChangeShapeType="1"/>
              </p:cNvSpPr>
              <p:nvPr/>
            </p:nvSpPr>
            <p:spPr bwMode="auto">
              <a:xfrm>
                <a:off x="786" y="2234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Line 92"/>
              <p:cNvSpPr>
                <a:spLocks noChangeShapeType="1"/>
              </p:cNvSpPr>
              <p:nvPr/>
            </p:nvSpPr>
            <p:spPr bwMode="auto">
              <a:xfrm>
                <a:off x="786" y="2220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Line 93"/>
              <p:cNvSpPr>
                <a:spLocks noChangeShapeType="1"/>
              </p:cNvSpPr>
              <p:nvPr/>
            </p:nvSpPr>
            <p:spPr bwMode="auto">
              <a:xfrm>
                <a:off x="786" y="2205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9" name="Line 94"/>
              <p:cNvSpPr>
                <a:spLocks noChangeShapeType="1"/>
              </p:cNvSpPr>
              <p:nvPr/>
            </p:nvSpPr>
            <p:spPr bwMode="auto">
              <a:xfrm>
                <a:off x="786" y="2191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" name="Line 95"/>
              <p:cNvSpPr>
                <a:spLocks noChangeShapeType="1"/>
              </p:cNvSpPr>
              <p:nvPr/>
            </p:nvSpPr>
            <p:spPr bwMode="auto">
              <a:xfrm>
                <a:off x="786" y="2177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Line 96"/>
              <p:cNvSpPr>
                <a:spLocks noChangeShapeType="1"/>
              </p:cNvSpPr>
              <p:nvPr/>
            </p:nvSpPr>
            <p:spPr bwMode="auto">
              <a:xfrm>
                <a:off x="786" y="2162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Line 97"/>
              <p:cNvSpPr>
                <a:spLocks noChangeShapeType="1"/>
              </p:cNvSpPr>
              <p:nvPr/>
            </p:nvSpPr>
            <p:spPr bwMode="auto">
              <a:xfrm>
                <a:off x="786" y="2148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Line 98"/>
              <p:cNvSpPr>
                <a:spLocks noChangeShapeType="1"/>
              </p:cNvSpPr>
              <p:nvPr/>
            </p:nvSpPr>
            <p:spPr bwMode="auto">
              <a:xfrm>
                <a:off x="786" y="2133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4" name="Line 99"/>
              <p:cNvSpPr>
                <a:spLocks noChangeShapeType="1"/>
              </p:cNvSpPr>
              <p:nvPr/>
            </p:nvSpPr>
            <p:spPr bwMode="auto">
              <a:xfrm>
                <a:off x="786" y="2119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Line 100"/>
              <p:cNvSpPr>
                <a:spLocks noChangeShapeType="1"/>
              </p:cNvSpPr>
              <p:nvPr/>
            </p:nvSpPr>
            <p:spPr bwMode="auto">
              <a:xfrm>
                <a:off x="786" y="2104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Line 101"/>
              <p:cNvSpPr>
                <a:spLocks noChangeShapeType="1"/>
              </p:cNvSpPr>
              <p:nvPr/>
            </p:nvSpPr>
            <p:spPr bwMode="auto">
              <a:xfrm>
                <a:off x="786" y="2090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Line 102"/>
              <p:cNvSpPr>
                <a:spLocks noChangeShapeType="1"/>
              </p:cNvSpPr>
              <p:nvPr/>
            </p:nvSpPr>
            <p:spPr bwMode="auto">
              <a:xfrm>
                <a:off x="786" y="2076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Line 103"/>
              <p:cNvSpPr>
                <a:spLocks noChangeShapeType="1"/>
              </p:cNvSpPr>
              <p:nvPr/>
            </p:nvSpPr>
            <p:spPr bwMode="auto">
              <a:xfrm>
                <a:off x="786" y="2061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Line 104"/>
              <p:cNvSpPr>
                <a:spLocks noChangeShapeType="1"/>
              </p:cNvSpPr>
              <p:nvPr/>
            </p:nvSpPr>
            <p:spPr bwMode="auto">
              <a:xfrm>
                <a:off x="786" y="2047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Line 105"/>
              <p:cNvSpPr>
                <a:spLocks noChangeShapeType="1"/>
              </p:cNvSpPr>
              <p:nvPr/>
            </p:nvSpPr>
            <p:spPr bwMode="auto">
              <a:xfrm>
                <a:off x="786" y="2032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Line 106"/>
              <p:cNvSpPr>
                <a:spLocks noChangeShapeType="1"/>
              </p:cNvSpPr>
              <p:nvPr/>
            </p:nvSpPr>
            <p:spPr bwMode="auto">
              <a:xfrm>
                <a:off x="786" y="2018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Line 107"/>
              <p:cNvSpPr>
                <a:spLocks noChangeShapeType="1"/>
              </p:cNvSpPr>
              <p:nvPr/>
            </p:nvSpPr>
            <p:spPr bwMode="auto">
              <a:xfrm>
                <a:off x="786" y="2004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Line 108"/>
              <p:cNvSpPr>
                <a:spLocks noChangeShapeType="1"/>
              </p:cNvSpPr>
              <p:nvPr/>
            </p:nvSpPr>
            <p:spPr bwMode="auto">
              <a:xfrm>
                <a:off x="786" y="1989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Line 109"/>
              <p:cNvSpPr>
                <a:spLocks noChangeShapeType="1"/>
              </p:cNvSpPr>
              <p:nvPr/>
            </p:nvSpPr>
            <p:spPr bwMode="auto">
              <a:xfrm>
                <a:off x="786" y="1975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Line 110"/>
              <p:cNvSpPr>
                <a:spLocks noChangeShapeType="1"/>
              </p:cNvSpPr>
              <p:nvPr/>
            </p:nvSpPr>
            <p:spPr bwMode="auto">
              <a:xfrm>
                <a:off x="786" y="1960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Line 111"/>
              <p:cNvSpPr>
                <a:spLocks noChangeShapeType="1"/>
              </p:cNvSpPr>
              <p:nvPr/>
            </p:nvSpPr>
            <p:spPr bwMode="auto">
              <a:xfrm>
                <a:off x="786" y="1946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Line 112"/>
              <p:cNvSpPr>
                <a:spLocks noChangeShapeType="1"/>
              </p:cNvSpPr>
              <p:nvPr/>
            </p:nvSpPr>
            <p:spPr bwMode="auto">
              <a:xfrm>
                <a:off x="786" y="1931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Line 113"/>
              <p:cNvSpPr>
                <a:spLocks noChangeShapeType="1"/>
              </p:cNvSpPr>
              <p:nvPr/>
            </p:nvSpPr>
            <p:spPr bwMode="auto">
              <a:xfrm>
                <a:off x="786" y="1917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Line 114"/>
              <p:cNvSpPr>
                <a:spLocks noChangeShapeType="1"/>
              </p:cNvSpPr>
              <p:nvPr/>
            </p:nvSpPr>
            <p:spPr bwMode="auto">
              <a:xfrm>
                <a:off x="786" y="1903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Line 115"/>
              <p:cNvSpPr>
                <a:spLocks noChangeShapeType="1"/>
              </p:cNvSpPr>
              <p:nvPr/>
            </p:nvSpPr>
            <p:spPr bwMode="auto">
              <a:xfrm>
                <a:off x="786" y="1888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" name="Line 116"/>
              <p:cNvSpPr>
                <a:spLocks noChangeShapeType="1"/>
              </p:cNvSpPr>
              <p:nvPr/>
            </p:nvSpPr>
            <p:spPr bwMode="auto">
              <a:xfrm>
                <a:off x="786" y="1874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Line 117"/>
              <p:cNvSpPr>
                <a:spLocks noChangeShapeType="1"/>
              </p:cNvSpPr>
              <p:nvPr/>
            </p:nvSpPr>
            <p:spPr bwMode="auto">
              <a:xfrm>
                <a:off x="786" y="1859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" name="Line 118"/>
              <p:cNvSpPr>
                <a:spLocks noChangeShapeType="1"/>
              </p:cNvSpPr>
              <p:nvPr/>
            </p:nvSpPr>
            <p:spPr bwMode="auto">
              <a:xfrm>
                <a:off x="786" y="1845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Line 119"/>
              <p:cNvSpPr>
                <a:spLocks noChangeShapeType="1"/>
              </p:cNvSpPr>
              <p:nvPr/>
            </p:nvSpPr>
            <p:spPr bwMode="auto">
              <a:xfrm>
                <a:off x="786" y="1830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" name="Line 120"/>
              <p:cNvSpPr>
                <a:spLocks noChangeShapeType="1"/>
              </p:cNvSpPr>
              <p:nvPr/>
            </p:nvSpPr>
            <p:spPr bwMode="auto">
              <a:xfrm>
                <a:off x="786" y="1816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" name="Line 121"/>
              <p:cNvSpPr>
                <a:spLocks noChangeShapeType="1"/>
              </p:cNvSpPr>
              <p:nvPr/>
            </p:nvSpPr>
            <p:spPr bwMode="auto">
              <a:xfrm>
                <a:off x="786" y="1802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7" name="Line 122"/>
              <p:cNvSpPr>
                <a:spLocks noChangeShapeType="1"/>
              </p:cNvSpPr>
              <p:nvPr/>
            </p:nvSpPr>
            <p:spPr bwMode="auto">
              <a:xfrm>
                <a:off x="786" y="1787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" name="Line 123"/>
              <p:cNvSpPr>
                <a:spLocks noChangeShapeType="1"/>
              </p:cNvSpPr>
              <p:nvPr/>
            </p:nvSpPr>
            <p:spPr bwMode="auto">
              <a:xfrm>
                <a:off x="786" y="1773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" name="Line 124"/>
              <p:cNvSpPr>
                <a:spLocks noChangeShapeType="1"/>
              </p:cNvSpPr>
              <p:nvPr/>
            </p:nvSpPr>
            <p:spPr bwMode="auto">
              <a:xfrm>
                <a:off x="786" y="1758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" name="Line 125"/>
              <p:cNvSpPr>
                <a:spLocks noChangeShapeType="1"/>
              </p:cNvSpPr>
              <p:nvPr/>
            </p:nvSpPr>
            <p:spPr bwMode="auto">
              <a:xfrm>
                <a:off x="786" y="1744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" name="Line 126"/>
              <p:cNvSpPr>
                <a:spLocks noChangeShapeType="1"/>
              </p:cNvSpPr>
              <p:nvPr/>
            </p:nvSpPr>
            <p:spPr bwMode="auto">
              <a:xfrm>
                <a:off x="786" y="1730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Line 127"/>
              <p:cNvSpPr>
                <a:spLocks noChangeShapeType="1"/>
              </p:cNvSpPr>
              <p:nvPr/>
            </p:nvSpPr>
            <p:spPr bwMode="auto">
              <a:xfrm>
                <a:off x="786" y="1715"/>
                <a:ext cx="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" name="Line 128"/>
              <p:cNvSpPr>
                <a:spLocks noChangeShapeType="1"/>
              </p:cNvSpPr>
              <p:nvPr/>
            </p:nvSpPr>
            <p:spPr bwMode="auto">
              <a:xfrm>
                <a:off x="781" y="2652"/>
                <a:ext cx="1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" name="Rectangle 129"/>
              <p:cNvSpPr>
                <a:spLocks noChangeArrowheads="1"/>
              </p:cNvSpPr>
              <p:nvPr/>
            </p:nvSpPr>
            <p:spPr bwMode="auto">
              <a:xfrm>
                <a:off x="669" y="2623"/>
                <a:ext cx="3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0</a:t>
                </a:r>
                <a:endParaRPr kumimoji="0" lang="en-US" altLang="en-US" sz="3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45" name="Line 130"/>
              <p:cNvSpPr>
                <a:spLocks noChangeShapeType="1"/>
              </p:cNvSpPr>
              <p:nvPr/>
            </p:nvSpPr>
            <p:spPr bwMode="auto">
              <a:xfrm>
                <a:off x="781" y="2580"/>
                <a:ext cx="1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6" name="Line 132"/>
              <p:cNvSpPr>
                <a:spLocks noChangeShapeType="1"/>
              </p:cNvSpPr>
              <p:nvPr/>
            </p:nvSpPr>
            <p:spPr bwMode="auto">
              <a:xfrm>
                <a:off x="781" y="2508"/>
                <a:ext cx="1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7" name="Line 134"/>
              <p:cNvSpPr>
                <a:spLocks noChangeShapeType="1"/>
              </p:cNvSpPr>
              <p:nvPr/>
            </p:nvSpPr>
            <p:spPr bwMode="auto">
              <a:xfrm>
                <a:off x="781" y="2436"/>
                <a:ext cx="1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8" name="Line 136"/>
              <p:cNvSpPr>
                <a:spLocks noChangeShapeType="1"/>
              </p:cNvSpPr>
              <p:nvPr/>
            </p:nvSpPr>
            <p:spPr bwMode="auto">
              <a:xfrm>
                <a:off x="781" y="2364"/>
                <a:ext cx="1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9" name="Rectangle 137"/>
              <p:cNvSpPr>
                <a:spLocks noChangeArrowheads="1"/>
              </p:cNvSpPr>
              <p:nvPr/>
            </p:nvSpPr>
            <p:spPr bwMode="auto">
              <a:xfrm>
                <a:off x="640" y="2324"/>
                <a:ext cx="91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2</a:t>
                </a:r>
                <a:endParaRPr kumimoji="0" lang="en-US" altLang="en-US" sz="3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50" name="Line 138"/>
              <p:cNvSpPr>
                <a:spLocks noChangeShapeType="1"/>
              </p:cNvSpPr>
              <p:nvPr/>
            </p:nvSpPr>
            <p:spPr bwMode="auto">
              <a:xfrm>
                <a:off x="781" y="2292"/>
                <a:ext cx="1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1" name="Line 140"/>
              <p:cNvSpPr>
                <a:spLocks noChangeShapeType="1"/>
              </p:cNvSpPr>
              <p:nvPr/>
            </p:nvSpPr>
            <p:spPr bwMode="auto">
              <a:xfrm>
                <a:off x="781" y="2220"/>
                <a:ext cx="1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2" name="Line 142"/>
              <p:cNvSpPr>
                <a:spLocks noChangeShapeType="1"/>
              </p:cNvSpPr>
              <p:nvPr/>
            </p:nvSpPr>
            <p:spPr bwMode="auto">
              <a:xfrm>
                <a:off x="781" y="2148"/>
                <a:ext cx="1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3" name="Line 144"/>
              <p:cNvSpPr>
                <a:spLocks noChangeShapeType="1"/>
              </p:cNvSpPr>
              <p:nvPr/>
            </p:nvSpPr>
            <p:spPr bwMode="auto">
              <a:xfrm>
                <a:off x="781" y="2076"/>
                <a:ext cx="1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4" name="Rectangle 145"/>
              <p:cNvSpPr>
                <a:spLocks noChangeArrowheads="1"/>
              </p:cNvSpPr>
              <p:nvPr/>
            </p:nvSpPr>
            <p:spPr bwMode="auto">
              <a:xfrm>
                <a:off x="640" y="2035"/>
                <a:ext cx="91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4</a:t>
                </a:r>
                <a:endParaRPr kumimoji="0" lang="en-US" altLang="en-US" sz="3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55" name="Line 146"/>
              <p:cNvSpPr>
                <a:spLocks noChangeShapeType="1"/>
              </p:cNvSpPr>
              <p:nvPr/>
            </p:nvSpPr>
            <p:spPr bwMode="auto">
              <a:xfrm>
                <a:off x="781" y="2004"/>
                <a:ext cx="1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6" name="Line 148"/>
              <p:cNvSpPr>
                <a:spLocks noChangeShapeType="1"/>
              </p:cNvSpPr>
              <p:nvPr/>
            </p:nvSpPr>
            <p:spPr bwMode="auto">
              <a:xfrm>
                <a:off x="781" y="1931"/>
                <a:ext cx="1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7" name="Line 150"/>
              <p:cNvSpPr>
                <a:spLocks noChangeShapeType="1"/>
              </p:cNvSpPr>
              <p:nvPr/>
            </p:nvSpPr>
            <p:spPr bwMode="auto">
              <a:xfrm>
                <a:off x="781" y="1859"/>
                <a:ext cx="1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8" name="Line 152"/>
              <p:cNvSpPr>
                <a:spLocks noChangeShapeType="1"/>
              </p:cNvSpPr>
              <p:nvPr/>
            </p:nvSpPr>
            <p:spPr bwMode="auto">
              <a:xfrm>
                <a:off x="781" y="1787"/>
                <a:ext cx="1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9" name="Rectangle 153"/>
              <p:cNvSpPr>
                <a:spLocks noChangeArrowheads="1"/>
              </p:cNvSpPr>
              <p:nvPr/>
            </p:nvSpPr>
            <p:spPr bwMode="auto">
              <a:xfrm>
                <a:off x="640" y="1747"/>
                <a:ext cx="91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6</a:t>
                </a:r>
                <a:endParaRPr kumimoji="0" lang="en-US" altLang="en-US" sz="3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60" name="Line 154"/>
              <p:cNvSpPr>
                <a:spLocks noChangeShapeType="1"/>
              </p:cNvSpPr>
              <p:nvPr/>
            </p:nvSpPr>
            <p:spPr bwMode="auto">
              <a:xfrm>
                <a:off x="781" y="1715"/>
                <a:ext cx="10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1" name="Freeform 159"/>
              <p:cNvSpPr>
                <a:spLocks/>
              </p:cNvSpPr>
              <p:nvPr/>
            </p:nvSpPr>
            <p:spPr bwMode="auto">
              <a:xfrm flipV="1">
                <a:off x="791" y="2139"/>
                <a:ext cx="3017" cy="511"/>
              </a:xfrm>
              <a:custGeom>
                <a:avLst/>
                <a:gdLst>
                  <a:gd name="T0" fmla="*/ 188 w 13301"/>
                  <a:gd name="T1" fmla="*/ 115 h 5535"/>
                  <a:gd name="T2" fmla="*/ 400 w 13301"/>
                  <a:gd name="T3" fmla="*/ 57 h 5535"/>
                  <a:gd name="T4" fmla="*/ 611 w 13301"/>
                  <a:gd name="T5" fmla="*/ 28 h 5535"/>
                  <a:gd name="T6" fmla="*/ 823 w 13301"/>
                  <a:gd name="T7" fmla="*/ 96 h 5535"/>
                  <a:gd name="T8" fmla="*/ 1035 w 13301"/>
                  <a:gd name="T9" fmla="*/ 351 h 5535"/>
                  <a:gd name="T10" fmla="*/ 1246 w 13301"/>
                  <a:gd name="T11" fmla="*/ 85 h 5535"/>
                  <a:gd name="T12" fmla="*/ 1458 w 13301"/>
                  <a:gd name="T13" fmla="*/ 82 h 5535"/>
                  <a:gd name="T14" fmla="*/ 1670 w 13301"/>
                  <a:gd name="T15" fmla="*/ 168 h 5535"/>
                  <a:gd name="T16" fmla="*/ 1881 w 13301"/>
                  <a:gd name="T17" fmla="*/ 65 h 5535"/>
                  <a:gd name="T18" fmla="*/ 2093 w 13301"/>
                  <a:gd name="T19" fmla="*/ 45 h 5535"/>
                  <a:gd name="T20" fmla="*/ 2305 w 13301"/>
                  <a:gd name="T21" fmla="*/ 57 h 5535"/>
                  <a:gd name="T22" fmla="*/ 2517 w 13301"/>
                  <a:gd name="T23" fmla="*/ 74 h 5535"/>
                  <a:gd name="T24" fmla="*/ 2728 w 13301"/>
                  <a:gd name="T25" fmla="*/ 258 h 5535"/>
                  <a:gd name="T26" fmla="*/ 2940 w 13301"/>
                  <a:gd name="T27" fmla="*/ 153 h 5535"/>
                  <a:gd name="T28" fmla="*/ 3152 w 13301"/>
                  <a:gd name="T29" fmla="*/ 618 h 5535"/>
                  <a:gd name="T30" fmla="*/ 3363 w 13301"/>
                  <a:gd name="T31" fmla="*/ 231 h 5535"/>
                  <a:gd name="T32" fmla="*/ 3575 w 13301"/>
                  <a:gd name="T33" fmla="*/ 142 h 5535"/>
                  <a:gd name="T34" fmla="*/ 3787 w 13301"/>
                  <a:gd name="T35" fmla="*/ 112 h 5535"/>
                  <a:gd name="T36" fmla="*/ 3998 w 13301"/>
                  <a:gd name="T37" fmla="*/ 56 h 5535"/>
                  <a:gd name="T38" fmla="*/ 4210 w 13301"/>
                  <a:gd name="T39" fmla="*/ 89 h 5535"/>
                  <a:gd name="T40" fmla="*/ 4422 w 13301"/>
                  <a:gd name="T41" fmla="*/ 114 h 5535"/>
                  <a:gd name="T42" fmla="*/ 4634 w 13301"/>
                  <a:gd name="T43" fmla="*/ 55 h 5535"/>
                  <a:gd name="T44" fmla="*/ 4845 w 13301"/>
                  <a:gd name="T45" fmla="*/ 214 h 5535"/>
                  <a:gd name="T46" fmla="*/ 5057 w 13301"/>
                  <a:gd name="T47" fmla="*/ 66 h 5535"/>
                  <a:gd name="T48" fmla="*/ 5269 w 13301"/>
                  <a:gd name="T49" fmla="*/ 225 h 5535"/>
                  <a:gd name="T50" fmla="*/ 5480 w 13301"/>
                  <a:gd name="T51" fmla="*/ 160 h 5535"/>
                  <a:gd name="T52" fmla="*/ 5692 w 13301"/>
                  <a:gd name="T53" fmla="*/ 81 h 5535"/>
                  <a:gd name="T54" fmla="*/ 5904 w 13301"/>
                  <a:gd name="T55" fmla="*/ 54 h 5535"/>
                  <a:gd name="T56" fmla="*/ 6115 w 13301"/>
                  <a:gd name="T57" fmla="*/ 67 h 5535"/>
                  <a:gd name="T58" fmla="*/ 6327 w 13301"/>
                  <a:gd name="T59" fmla="*/ 54 h 5535"/>
                  <a:gd name="T60" fmla="*/ 6539 w 13301"/>
                  <a:gd name="T61" fmla="*/ 30 h 5535"/>
                  <a:gd name="T62" fmla="*/ 6751 w 13301"/>
                  <a:gd name="T63" fmla="*/ 46 h 5535"/>
                  <a:gd name="T64" fmla="*/ 6962 w 13301"/>
                  <a:gd name="T65" fmla="*/ 47 h 5535"/>
                  <a:gd name="T66" fmla="*/ 7174 w 13301"/>
                  <a:gd name="T67" fmla="*/ 11 h 5535"/>
                  <a:gd name="T68" fmla="*/ 7386 w 13301"/>
                  <a:gd name="T69" fmla="*/ 27 h 5535"/>
                  <a:gd name="T70" fmla="*/ 7597 w 13301"/>
                  <a:gd name="T71" fmla="*/ 43 h 5535"/>
                  <a:gd name="T72" fmla="*/ 7809 w 13301"/>
                  <a:gd name="T73" fmla="*/ 34 h 5535"/>
                  <a:gd name="T74" fmla="*/ 8021 w 13301"/>
                  <a:gd name="T75" fmla="*/ 2437 h 5535"/>
                  <a:gd name="T76" fmla="*/ 8232 w 13301"/>
                  <a:gd name="T77" fmla="*/ 1500 h 5535"/>
                  <a:gd name="T78" fmla="*/ 8444 w 13301"/>
                  <a:gd name="T79" fmla="*/ 521 h 5535"/>
                  <a:gd name="T80" fmla="*/ 8656 w 13301"/>
                  <a:gd name="T81" fmla="*/ 428 h 5535"/>
                  <a:gd name="T82" fmla="*/ 8868 w 13301"/>
                  <a:gd name="T83" fmla="*/ 248 h 5535"/>
                  <a:gd name="T84" fmla="*/ 9079 w 13301"/>
                  <a:gd name="T85" fmla="*/ 103 h 5535"/>
                  <a:gd name="T86" fmla="*/ 9291 w 13301"/>
                  <a:gd name="T87" fmla="*/ 66 h 5535"/>
                  <a:gd name="T88" fmla="*/ 9503 w 13301"/>
                  <a:gd name="T89" fmla="*/ 368 h 5535"/>
                  <a:gd name="T90" fmla="*/ 9714 w 13301"/>
                  <a:gd name="T91" fmla="*/ 188 h 5535"/>
                  <a:gd name="T92" fmla="*/ 9926 w 13301"/>
                  <a:gd name="T93" fmla="*/ 170 h 5535"/>
                  <a:gd name="T94" fmla="*/ 10138 w 13301"/>
                  <a:gd name="T95" fmla="*/ 82 h 5535"/>
                  <a:gd name="T96" fmla="*/ 10349 w 13301"/>
                  <a:gd name="T97" fmla="*/ 96 h 5535"/>
                  <a:gd name="T98" fmla="*/ 10561 w 13301"/>
                  <a:gd name="T99" fmla="*/ 63 h 5535"/>
                  <a:gd name="T100" fmla="*/ 10773 w 13301"/>
                  <a:gd name="T101" fmla="*/ 94 h 5535"/>
                  <a:gd name="T102" fmla="*/ 10985 w 13301"/>
                  <a:gd name="T103" fmla="*/ 238 h 5535"/>
                  <a:gd name="T104" fmla="*/ 11196 w 13301"/>
                  <a:gd name="T105" fmla="*/ 76 h 5535"/>
                  <a:gd name="T106" fmla="*/ 11408 w 13301"/>
                  <a:gd name="T107" fmla="*/ 54 h 5535"/>
                  <a:gd name="T108" fmla="*/ 11620 w 13301"/>
                  <a:gd name="T109" fmla="*/ 57 h 5535"/>
                  <a:gd name="T110" fmla="*/ 11831 w 13301"/>
                  <a:gd name="T111" fmla="*/ 47 h 5535"/>
                  <a:gd name="T112" fmla="*/ 12043 w 13301"/>
                  <a:gd name="T113" fmla="*/ 54 h 5535"/>
                  <a:gd name="T114" fmla="*/ 12255 w 13301"/>
                  <a:gd name="T115" fmla="*/ 319 h 5535"/>
                  <a:gd name="T116" fmla="*/ 12466 w 13301"/>
                  <a:gd name="T117" fmla="*/ 4139 h 5535"/>
                  <a:gd name="T118" fmla="*/ 12678 w 13301"/>
                  <a:gd name="T119" fmla="*/ 515 h 5535"/>
                  <a:gd name="T120" fmla="*/ 12890 w 13301"/>
                  <a:gd name="T121" fmla="*/ 262 h 5535"/>
                  <a:gd name="T122" fmla="*/ 13102 w 13301"/>
                  <a:gd name="T123" fmla="*/ 481 h 5535"/>
                  <a:gd name="T124" fmla="*/ 13301 w 13301"/>
                  <a:gd name="T125" fmla="*/ 213 h 55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  <a:cxn ang="0">
                    <a:pos x="T122" y="T123"/>
                  </a:cxn>
                  <a:cxn ang="0">
                    <a:pos x="T124" y="T125"/>
                  </a:cxn>
                </a:cxnLst>
                <a:rect l="0" t="0" r="r" b="b"/>
                <a:pathLst>
                  <a:path w="13301" h="5535">
                    <a:moveTo>
                      <a:pt x="0" y="48"/>
                    </a:moveTo>
                    <a:lnTo>
                      <a:pt x="4" y="54"/>
                    </a:lnTo>
                    <a:lnTo>
                      <a:pt x="18" y="57"/>
                    </a:lnTo>
                    <a:lnTo>
                      <a:pt x="33" y="27"/>
                    </a:lnTo>
                    <a:lnTo>
                      <a:pt x="47" y="41"/>
                    </a:lnTo>
                    <a:lnTo>
                      <a:pt x="61" y="53"/>
                    </a:lnTo>
                    <a:lnTo>
                      <a:pt x="75" y="61"/>
                    </a:lnTo>
                    <a:lnTo>
                      <a:pt x="89" y="63"/>
                    </a:lnTo>
                    <a:lnTo>
                      <a:pt x="103" y="58"/>
                    </a:lnTo>
                    <a:lnTo>
                      <a:pt x="117" y="89"/>
                    </a:lnTo>
                    <a:lnTo>
                      <a:pt x="131" y="72"/>
                    </a:lnTo>
                    <a:lnTo>
                      <a:pt x="145" y="97"/>
                    </a:lnTo>
                    <a:lnTo>
                      <a:pt x="160" y="95"/>
                    </a:lnTo>
                    <a:lnTo>
                      <a:pt x="174" y="145"/>
                    </a:lnTo>
                    <a:lnTo>
                      <a:pt x="188" y="115"/>
                    </a:lnTo>
                    <a:lnTo>
                      <a:pt x="202" y="164"/>
                    </a:lnTo>
                    <a:lnTo>
                      <a:pt x="216" y="116"/>
                    </a:lnTo>
                    <a:lnTo>
                      <a:pt x="230" y="124"/>
                    </a:lnTo>
                    <a:lnTo>
                      <a:pt x="244" y="125"/>
                    </a:lnTo>
                    <a:lnTo>
                      <a:pt x="258" y="98"/>
                    </a:lnTo>
                    <a:lnTo>
                      <a:pt x="272" y="90"/>
                    </a:lnTo>
                    <a:lnTo>
                      <a:pt x="287" y="83"/>
                    </a:lnTo>
                    <a:lnTo>
                      <a:pt x="301" y="82"/>
                    </a:lnTo>
                    <a:lnTo>
                      <a:pt x="315" y="57"/>
                    </a:lnTo>
                    <a:lnTo>
                      <a:pt x="329" y="70"/>
                    </a:lnTo>
                    <a:lnTo>
                      <a:pt x="343" y="59"/>
                    </a:lnTo>
                    <a:lnTo>
                      <a:pt x="357" y="57"/>
                    </a:lnTo>
                    <a:lnTo>
                      <a:pt x="371" y="42"/>
                    </a:lnTo>
                    <a:lnTo>
                      <a:pt x="385" y="45"/>
                    </a:lnTo>
                    <a:lnTo>
                      <a:pt x="400" y="57"/>
                    </a:lnTo>
                    <a:lnTo>
                      <a:pt x="414" y="25"/>
                    </a:lnTo>
                    <a:lnTo>
                      <a:pt x="428" y="51"/>
                    </a:lnTo>
                    <a:lnTo>
                      <a:pt x="442" y="40"/>
                    </a:lnTo>
                    <a:lnTo>
                      <a:pt x="456" y="32"/>
                    </a:lnTo>
                    <a:lnTo>
                      <a:pt x="470" y="37"/>
                    </a:lnTo>
                    <a:lnTo>
                      <a:pt x="484" y="24"/>
                    </a:lnTo>
                    <a:lnTo>
                      <a:pt x="498" y="18"/>
                    </a:lnTo>
                    <a:lnTo>
                      <a:pt x="512" y="22"/>
                    </a:lnTo>
                    <a:lnTo>
                      <a:pt x="527" y="17"/>
                    </a:lnTo>
                    <a:lnTo>
                      <a:pt x="541" y="37"/>
                    </a:lnTo>
                    <a:lnTo>
                      <a:pt x="555" y="38"/>
                    </a:lnTo>
                    <a:lnTo>
                      <a:pt x="569" y="43"/>
                    </a:lnTo>
                    <a:lnTo>
                      <a:pt x="583" y="28"/>
                    </a:lnTo>
                    <a:lnTo>
                      <a:pt x="597" y="17"/>
                    </a:lnTo>
                    <a:lnTo>
                      <a:pt x="611" y="28"/>
                    </a:lnTo>
                    <a:lnTo>
                      <a:pt x="625" y="38"/>
                    </a:lnTo>
                    <a:lnTo>
                      <a:pt x="639" y="15"/>
                    </a:lnTo>
                    <a:lnTo>
                      <a:pt x="654" y="10"/>
                    </a:lnTo>
                    <a:lnTo>
                      <a:pt x="668" y="44"/>
                    </a:lnTo>
                    <a:lnTo>
                      <a:pt x="682" y="15"/>
                    </a:lnTo>
                    <a:lnTo>
                      <a:pt x="696" y="26"/>
                    </a:lnTo>
                    <a:lnTo>
                      <a:pt x="710" y="21"/>
                    </a:lnTo>
                    <a:lnTo>
                      <a:pt x="724" y="26"/>
                    </a:lnTo>
                    <a:lnTo>
                      <a:pt x="738" y="29"/>
                    </a:lnTo>
                    <a:lnTo>
                      <a:pt x="752" y="41"/>
                    </a:lnTo>
                    <a:lnTo>
                      <a:pt x="766" y="35"/>
                    </a:lnTo>
                    <a:lnTo>
                      <a:pt x="781" y="22"/>
                    </a:lnTo>
                    <a:lnTo>
                      <a:pt x="795" y="44"/>
                    </a:lnTo>
                    <a:lnTo>
                      <a:pt x="809" y="45"/>
                    </a:lnTo>
                    <a:lnTo>
                      <a:pt x="823" y="96"/>
                    </a:lnTo>
                    <a:lnTo>
                      <a:pt x="837" y="116"/>
                    </a:lnTo>
                    <a:lnTo>
                      <a:pt x="851" y="179"/>
                    </a:lnTo>
                    <a:lnTo>
                      <a:pt x="865" y="202"/>
                    </a:lnTo>
                    <a:lnTo>
                      <a:pt x="879" y="301"/>
                    </a:lnTo>
                    <a:lnTo>
                      <a:pt x="893" y="321"/>
                    </a:lnTo>
                    <a:lnTo>
                      <a:pt x="908" y="422"/>
                    </a:lnTo>
                    <a:lnTo>
                      <a:pt x="922" y="497"/>
                    </a:lnTo>
                    <a:lnTo>
                      <a:pt x="936" y="586"/>
                    </a:lnTo>
                    <a:lnTo>
                      <a:pt x="950" y="603"/>
                    </a:lnTo>
                    <a:lnTo>
                      <a:pt x="964" y="587"/>
                    </a:lnTo>
                    <a:lnTo>
                      <a:pt x="978" y="591"/>
                    </a:lnTo>
                    <a:lnTo>
                      <a:pt x="992" y="515"/>
                    </a:lnTo>
                    <a:lnTo>
                      <a:pt x="1006" y="507"/>
                    </a:lnTo>
                    <a:lnTo>
                      <a:pt x="1020" y="397"/>
                    </a:lnTo>
                    <a:lnTo>
                      <a:pt x="1035" y="351"/>
                    </a:lnTo>
                    <a:lnTo>
                      <a:pt x="1049" y="362"/>
                    </a:lnTo>
                    <a:lnTo>
                      <a:pt x="1063" y="306"/>
                    </a:lnTo>
                    <a:lnTo>
                      <a:pt x="1077" y="261"/>
                    </a:lnTo>
                    <a:lnTo>
                      <a:pt x="1091" y="236"/>
                    </a:lnTo>
                    <a:lnTo>
                      <a:pt x="1105" y="204"/>
                    </a:lnTo>
                    <a:lnTo>
                      <a:pt x="1119" y="227"/>
                    </a:lnTo>
                    <a:lnTo>
                      <a:pt x="1133" y="182"/>
                    </a:lnTo>
                    <a:lnTo>
                      <a:pt x="1148" y="151"/>
                    </a:lnTo>
                    <a:lnTo>
                      <a:pt x="1162" y="148"/>
                    </a:lnTo>
                    <a:lnTo>
                      <a:pt x="1176" y="136"/>
                    </a:lnTo>
                    <a:lnTo>
                      <a:pt x="1190" y="131"/>
                    </a:lnTo>
                    <a:lnTo>
                      <a:pt x="1204" y="97"/>
                    </a:lnTo>
                    <a:lnTo>
                      <a:pt x="1218" y="111"/>
                    </a:lnTo>
                    <a:lnTo>
                      <a:pt x="1232" y="90"/>
                    </a:lnTo>
                    <a:lnTo>
                      <a:pt x="1246" y="85"/>
                    </a:lnTo>
                    <a:lnTo>
                      <a:pt x="1260" y="51"/>
                    </a:lnTo>
                    <a:lnTo>
                      <a:pt x="1275" y="104"/>
                    </a:lnTo>
                    <a:lnTo>
                      <a:pt x="1289" y="74"/>
                    </a:lnTo>
                    <a:lnTo>
                      <a:pt x="1303" y="83"/>
                    </a:lnTo>
                    <a:lnTo>
                      <a:pt x="1317" y="57"/>
                    </a:lnTo>
                    <a:lnTo>
                      <a:pt x="1331" y="78"/>
                    </a:lnTo>
                    <a:lnTo>
                      <a:pt x="1345" y="87"/>
                    </a:lnTo>
                    <a:lnTo>
                      <a:pt x="1359" y="74"/>
                    </a:lnTo>
                    <a:lnTo>
                      <a:pt x="1373" y="63"/>
                    </a:lnTo>
                    <a:lnTo>
                      <a:pt x="1387" y="77"/>
                    </a:lnTo>
                    <a:lnTo>
                      <a:pt x="1402" y="75"/>
                    </a:lnTo>
                    <a:lnTo>
                      <a:pt x="1416" y="87"/>
                    </a:lnTo>
                    <a:lnTo>
                      <a:pt x="1430" y="69"/>
                    </a:lnTo>
                    <a:lnTo>
                      <a:pt x="1444" y="98"/>
                    </a:lnTo>
                    <a:lnTo>
                      <a:pt x="1458" y="82"/>
                    </a:lnTo>
                    <a:lnTo>
                      <a:pt x="1472" y="86"/>
                    </a:lnTo>
                    <a:lnTo>
                      <a:pt x="1486" y="143"/>
                    </a:lnTo>
                    <a:lnTo>
                      <a:pt x="1500" y="112"/>
                    </a:lnTo>
                    <a:lnTo>
                      <a:pt x="1514" y="139"/>
                    </a:lnTo>
                    <a:lnTo>
                      <a:pt x="1529" y="171"/>
                    </a:lnTo>
                    <a:lnTo>
                      <a:pt x="1543" y="172"/>
                    </a:lnTo>
                    <a:lnTo>
                      <a:pt x="1557" y="191"/>
                    </a:lnTo>
                    <a:lnTo>
                      <a:pt x="1571" y="220"/>
                    </a:lnTo>
                    <a:lnTo>
                      <a:pt x="1585" y="209"/>
                    </a:lnTo>
                    <a:lnTo>
                      <a:pt x="1599" y="204"/>
                    </a:lnTo>
                    <a:lnTo>
                      <a:pt x="1613" y="188"/>
                    </a:lnTo>
                    <a:lnTo>
                      <a:pt x="1627" y="177"/>
                    </a:lnTo>
                    <a:lnTo>
                      <a:pt x="1641" y="134"/>
                    </a:lnTo>
                    <a:lnTo>
                      <a:pt x="1656" y="165"/>
                    </a:lnTo>
                    <a:lnTo>
                      <a:pt x="1670" y="168"/>
                    </a:lnTo>
                    <a:lnTo>
                      <a:pt x="1684" y="152"/>
                    </a:lnTo>
                    <a:lnTo>
                      <a:pt x="1698" y="167"/>
                    </a:lnTo>
                    <a:lnTo>
                      <a:pt x="1712" y="137"/>
                    </a:lnTo>
                    <a:lnTo>
                      <a:pt x="1726" y="127"/>
                    </a:lnTo>
                    <a:lnTo>
                      <a:pt x="1740" y="98"/>
                    </a:lnTo>
                    <a:lnTo>
                      <a:pt x="1754" y="105"/>
                    </a:lnTo>
                    <a:lnTo>
                      <a:pt x="1769" y="108"/>
                    </a:lnTo>
                    <a:lnTo>
                      <a:pt x="1783" y="93"/>
                    </a:lnTo>
                    <a:lnTo>
                      <a:pt x="1797" y="104"/>
                    </a:lnTo>
                    <a:lnTo>
                      <a:pt x="1811" y="112"/>
                    </a:lnTo>
                    <a:lnTo>
                      <a:pt x="1825" y="91"/>
                    </a:lnTo>
                    <a:lnTo>
                      <a:pt x="1839" y="84"/>
                    </a:lnTo>
                    <a:lnTo>
                      <a:pt x="1853" y="85"/>
                    </a:lnTo>
                    <a:lnTo>
                      <a:pt x="1867" y="83"/>
                    </a:lnTo>
                    <a:lnTo>
                      <a:pt x="1881" y="65"/>
                    </a:lnTo>
                    <a:lnTo>
                      <a:pt x="1896" y="87"/>
                    </a:lnTo>
                    <a:lnTo>
                      <a:pt x="1910" y="78"/>
                    </a:lnTo>
                    <a:lnTo>
                      <a:pt x="1924" y="74"/>
                    </a:lnTo>
                    <a:lnTo>
                      <a:pt x="1938" y="81"/>
                    </a:lnTo>
                    <a:lnTo>
                      <a:pt x="1952" y="82"/>
                    </a:lnTo>
                    <a:lnTo>
                      <a:pt x="1966" y="93"/>
                    </a:lnTo>
                    <a:lnTo>
                      <a:pt x="1980" y="82"/>
                    </a:lnTo>
                    <a:lnTo>
                      <a:pt x="1994" y="80"/>
                    </a:lnTo>
                    <a:lnTo>
                      <a:pt x="2008" y="75"/>
                    </a:lnTo>
                    <a:lnTo>
                      <a:pt x="2023" y="57"/>
                    </a:lnTo>
                    <a:lnTo>
                      <a:pt x="2037" y="58"/>
                    </a:lnTo>
                    <a:lnTo>
                      <a:pt x="2051" y="65"/>
                    </a:lnTo>
                    <a:lnTo>
                      <a:pt x="2065" y="66"/>
                    </a:lnTo>
                    <a:lnTo>
                      <a:pt x="2079" y="73"/>
                    </a:lnTo>
                    <a:lnTo>
                      <a:pt x="2093" y="45"/>
                    </a:lnTo>
                    <a:lnTo>
                      <a:pt x="2107" y="79"/>
                    </a:lnTo>
                    <a:lnTo>
                      <a:pt x="2121" y="53"/>
                    </a:lnTo>
                    <a:lnTo>
                      <a:pt x="2135" y="57"/>
                    </a:lnTo>
                    <a:lnTo>
                      <a:pt x="2150" y="48"/>
                    </a:lnTo>
                    <a:lnTo>
                      <a:pt x="2164" y="68"/>
                    </a:lnTo>
                    <a:lnTo>
                      <a:pt x="2178" y="54"/>
                    </a:lnTo>
                    <a:lnTo>
                      <a:pt x="2192" y="56"/>
                    </a:lnTo>
                    <a:lnTo>
                      <a:pt x="2206" y="55"/>
                    </a:lnTo>
                    <a:lnTo>
                      <a:pt x="2220" y="69"/>
                    </a:lnTo>
                    <a:lnTo>
                      <a:pt x="2234" y="46"/>
                    </a:lnTo>
                    <a:lnTo>
                      <a:pt x="2248" y="44"/>
                    </a:lnTo>
                    <a:lnTo>
                      <a:pt x="2262" y="50"/>
                    </a:lnTo>
                    <a:lnTo>
                      <a:pt x="2277" y="76"/>
                    </a:lnTo>
                    <a:lnTo>
                      <a:pt x="2291" y="49"/>
                    </a:lnTo>
                    <a:lnTo>
                      <a:pt x="2305" y="57"/>
                    </a:lnTo>
                    <a:lnTo>
                      <a:pt x="2319" y="72"/>
                    </a:lnTo>
                    <a:lnTo>
                      <a:pt x="2333" y="78"/>
                    </a:lnTo>
                    <a:lnTo>
                      <a:pt x="2347" y="59"/>
                    </a:lnTo>
                    <a:lnTo>
                      <a:pt x="2361" y="77"/>
                    </a:lnTo>
                    <a:lnTo>
                      <a:pt x="2375" y="109"/>
                    </a:lnTo>
                    <a:lnTo>
                      <a:pt x="2389" y="67"/>
                    </a:lnTo>
                    <a:lnTo>
                      <a:pt x="2404" y="65"/>
                    </a:lnTo>
                    <a:lnTo>
                      <a:pt x="2418" y="73"/>
                    </a:lnTo>
                    <a:lnTo>
                      <a:pt x="2432" y="76"/>
                    </a:lnTo>
                    <a:lnTo>
                      <a:pt x="2446" y="71"/>
                    </a:lnTo>
                    <a:lnTo>
                      <a:pt x="2460" y="54"/>
                    </a:lnTo>
                    <a:lnTo>
                      <a:pt x="2474" y="68"/>
                    </a:lnTo>
                    <a:lnTo>
                      <a:pt x="2488" y="82"/>
                    </a:lnTo>
                    <a:lnTo>
                      <a:pt x="2502" y="99"/>
                    </a:lnTo>
                    <a:lnTo>
                      <a:pt x="2517" y="74"/>
                    </a:lnTo>
                    <a:lnTo>
                      <a:pt x="2531" y="70"/>
                    </a:lnTo>
                    <a:lnTo>
                      <a:pt x="2545" y="126"/>
                    </a:lnTo>
                    <a:lnTo>
                      <a:pt x="2559" y="101"/>
                    </a:lnTo>
                    <a:lnTo>
                      <a:pt x="2573" y="134"/>
                    </a:lnTo>
                    <a:lnTo>
                      <a:pt x="2587" y="155"/>
                    </a:lnTo>
                    <a:lnTo>
                      <a:pt x="2601" y="201"/>
                    </a:lnTo>
                    <a:lnTo>
                      <a:pt x="2615" y="223"/>
                    </a:lnTo>
                    <a:lnTo>
                      <a:pt x="2629" y="227"/>
                    </a:lnTo>
                    <a:lnTo>
                      <a:pt x="2644" y="240"/>
                    </a:lnTo>
                    <a:lnTo>
                      <a:pt x="2658" y="255"/>
                    </a:lnTo>
                    <a:lnTo>
                      <a:pt x="2672" y="240"/>
                    </a:lnTo>
                    <a:lnTo>
                      <a:pt x="2686" y="284"/>
                    </a:lnTo>
                    <a:lnTo>
                      <a:pt x="2700" y="243"/>
                    </a:lnTo>
                    <a:lnTo>
                      <a:pt x="2714" y="229"/>
                    </a:lnTo>
                    <a:lnTo>
                      <a:pt x="2728" y="258"/>
                    </a:lnTo>
                    <a:lnTo>
                      <a:pt x="2742" y="210"/>
                    </a:lnTo>
                    <a:lnTo>
                      <a:pt x="2756" y="222"/>
                    </a:lnTo>
                    <a:lnTo>
                      <a:pt x="2771" y="179"/>
                    </a:lnTo>
                    <a:lnTo>
                      <a:pt x="2785" y="224"/>
                    </a:lnTo>
                    <a:lnTo>
                      <a:pt x="2799" y="191"/>
                    </a:lnTo>
                    <a:lnTo>
                      <a:pt x="2813" y="204"/>
                    </a:lnTo>
                    <a:lnTo>
                      <a:pt x="2827" y="201"/>
                    </a:lnTo>
                    <a:lnTo>
                      <a:pt x="2841" y="213"/>
                    </a:lnTo>
                    <a:lnTo>
                      <a:pt x="2855" y="168"/>
                    </a:lnTo>
                    <a:lnTo>
                      <a:pt x="2869" y="154"/>
                    </a:lnTo>
                    <a:lnTo>
                      <a:pt x="2883" y="148"/>
                    </a:lnTo>
                    <a:lnTo>
                      <a:pt x="2898" y="161"/>
                    </a:lnTo>
                    <a:lnTo>
                      <a:pt x="2912" y="180"/>
                    </a:lnTo>
                    <a:lnTo>
                      <a:pt x="2926" y="139"/>
                    </a:lnTo>
                    <a:lnTo>
                      <a:pt x="2940" y="153"/>
                    </a:lnTo>
                    <a:lnTo>
                      <a:pt x="2954" y="144"/>
                    </a:lnTo>
                    <a:lnTo>
                      <a:pt x="2968" y="151"/>
                    </a:lnTo>
                    <a:lnTo>
                      <a:pt x="2982" y="155"/>
                    </a:lnTo>
                    <a:lnTo>
                      <a:pt x="2996" y="154"/>
                    </a:lnTo>
                    <a:lnTo>
                      <a:pt x="3010" y="167"/>
                    </a:lnTo>
                    <a:lnTo>
                      <a:pt x="3025" y="160"/>
                    </a:lnTo>
                    <a:lnTo>
                      <a:pt x="3039" y="166"/>
                    </a:lnTo>
                    <a:lnTo>
                      <a:pt x="3053" y="169"/>
                    </a:lnTo>
                    <a:lnTo>
                      <a:pt x="3067" y="180"/>
                    </a:lnTo>
                    <a:lnTo>
                      <a:pt x="3081" y="211"/>
                    </a:lnTo>
                    <a:lnTo>
                      <a:pt x="3095" y="278"/>
                    </a:lnTo>
                    <a:lnTo>
                      <a:pt x="3109" y="351"/>
                    </a:lnTo>
                    <a:lnTo>
                      <a:pt x="3123" y="465"/>
                    </a:lnTo>
                    <a:lnTo>
                      <a:pt x="3138" y="516"/>
                    </a:lnTo>
                    <a:lnTo>
                      <a:pt x="3152" y="618"/>
                    </a:lnTo>
                    <a:lnTo>
                      <a:pt x="3166" y="659"/>
                    </a:lnTo>
                    <a:lnTo>
                      <a:pt x="3180" y="709"/>
                    </a:lnTo>
                    <a:lnTo>
                      <a:pt x="3194" y="793"/>
                    </a:lnTo>
                    <a:lnTo>
                      <a:pt x="3208" y="783"/>
                    </a:lnTo>
                    <a:lnTo>
                      <a:pt x="3222" y="741"/>
                    </a:lnTo>
                    <a:lnTo>
                      <a:pt x="3236" y="705"/>
                    </a:lnTo>
                    <a:lnTo>
                      <a:pt x="3250" y="636"/>
                    </a:lnTo>
                    <a:lnTo>
                      <a:pt x="3265" y="571"/>
                    </a:lnTo>
                    <a:lnTo>
                      <a:pt x="3279" y="529"/>
                    </a:lnTo>
                    <a:lnTo>
                      <a:pt x="3293" y="437"/>
                    </a:lnTo>
                    <a:lnTo>
                      <a:pt x="3307" y="341"/>
                    </a:lnTo>
                    <a:lnTo>
                      <a:pt x="3321" y="350"/>
                    </a:lnTo>
                    <a:lnTo>
                      <a:pt x="3335" y="305"/>
                    </a:lnTo>
                    <a:lnTo>
                      <a:pt x="3349" y="293"/>
                    </a:lnTo>
                    <a:lnTo>
                      <a:pt x="3363" y="231"/>
                    </a:lnTo>
                    <a:lnTo>
                      <a:pt x="3377" y="241"/>
                    </a:lnTo>
                    <a:lnTo>
                      <a:pt x="3392" y="214"/>
                    </a:lnTo>
                    <a:lnTo>
                      <a:pt x="3406" y="199"/>
                    </a:lnTo>
                    <a:lnTo>
                      <a:pt x="3420" y="165"/>
                    </a:lnTo>
                    <a:lnTo>
                      <a:pt x="3434" y="156"/>
                    </a:lnTo>
                    <a:lnTo>
                      <a:pt x="3448" y="177"/>
                    </a:lnTo>
                    <a:lnTo>
                      <a:pt x="3462" y="147"/>
                    </a:lnTo>
                    <a:lnTo>
                      <a:pt x="3476" y="157"/>
                    </a:lnTo>
                    <a:lnTo>
                      <a:pt x="3490" y="171"/>
                    </a:lnTo>
                    <a:lnTo>
                      <a:pt x="3504" y="150"/>
                    </a:lnTo>
                    <a:lnTo>
                      <a:pt x="3519" y="134"/>
                    </a:lnTo>
                    <a:lnTo>
                      <a:pt x="3533" y="171"/>
                    </a:lnTo>
                    <a:lnTo>
                      <a:pt x="3547" y="134"/>
                    </a:lnTo>
                    <a:lnTo>
                      <a:pt x="3561" y="132"/>
                    </a:lnTo>
                    <a:lnTo>
                      <a:pt x="3575" y="142"/>
                    </a:lnTo>
                    <a:lnTo>
                      <a:pt x="3589" y="129"/>
                    </a:lnTo>
                    <a:lnTo>
                      <a:pt x="3603" y="110"/>
                    </a:lnTo>
                    <a:lnTo>
                      <a:pt x="3617" y="136"/>
                    </a:lnTo>
                    <a:lnTo>
                      <a:pt x="3631" y="100"/>
                    </a:lnTo>
                    <a:lnTo>
                      <a:pt x="3646" y="98"/>
                    </a:lnTo>
                    <a:lnTo>
                      <a:pt x="3660" y="100"/>
                    </a:lnTo>
                    <a:lnTo>
                      <a:pt x="3674" y="93"/>
                    </a:lnTo>
                    <a:lnTo>
                      <a:pt x="3688" y="105"/>
                    </a:lnTo>
                    <a:lnTo>
                      <a:pt x="3702" y="113"/>
                    </a:lnTo>
                    <a:lnTo>
                      <a:pt x="3716" y="82"/>
                    </a:lnTo>
                    <a:lnTo>
                      <a:pt x="3730" y="110"/>
                    </a:lnTo>
                    <a:lnTo>
                      <a:pt x="3744" y="84"/>
                    </a:lnTo>
                    <a:lnTo>
                      <a:pt x="3758" y="91"/>
                    </a:lnTo>
                    <a:lnTo>
                      <a:pt x="3773" y="70"/>
                    </a:lnTo>
                    <a:lnTo>
                      <a:pt x="3787" y="112"/>
                    </a:lnTo>
                    <a:lnTo>
                      <a:pt x="3801" y="124"/>
                    </a:lnTo>
                    <a:lnTo>
                      <a:pt x="3815" y="71"/>
                    </a:lnTo>
                    <a:lnTo>
                      <a:pt x="3829" y="86"/>
                    </a:lnTo>
                    <a:lnTo>
                      <a:pt x="3843" y="78"/>
                    </a:lnTo>
                    <a:lnTo>
                      <a:pt x="3857" y="73"/>
                    </a:lnTo>
                    <a:lnTo>
                      <a:pt x="3871" y="72"/>
                    </a:lnTo>
                    <a:lnTo>
                      <a:pt x="3886" y="82"/>
                    </a:lnTo>
                    <a:lnTo>
                      <a:pt x="3900" y="51"/>
                    </a:lnTo>
                    <a:lnTo>
                      <a:pt x="3914" y="95"/>
                    </a:lnTo>
                    <a:lnTo>
                      <a:pt x="3928" y="69"/>
                    </a:lnTo>
                    <a:lnTo>
                      <a:pt x="3942" y="88"/>
                    </a:lnTo>
                    <a:lnTo>
                      <a:pt x="3956" y="56"/>
                    </a:lnTo>
                    <a:lnTo>
                      <a:pt x="3970" y="55"/>
                    </a:lnTo>
                    <a:lnTo>
                      <a:pt x="3984" y="52"/>
                    </a:lnTo>
                    <a:lnTo>
                      <a:pt x="3998" y="56"/>
                    </a:lnTo>
                    <a:lnTo>
                      <a:pt x="4013" y="55"/>
                    </a:lnTo>
                    <a:lnTo>
                      <a:pt x="4027" y="66"/>
                    </a:lnTo>
                    <a:lnTo>
                      <a:pt x="4041" y="86"/>
                    </a:lnTo>
                    <a:lnTo>
                      <a:pt x="4055" y="55"/>
                    </a:lnTo>
                    <a:lnTo>
                      <a:pt x="4069" y="84"/>
                    </a:lnTo>
                    <a:lnTo>
                      <a:pt x="4083" y="108"/>
                    </a:lnTo>
                    <a:lnTo>
                      <a:pt x="4097" y="93"/>
                    </a:lnTo>
                    <a:lnTo>
                      <a:pt x="4111" y="104"/>
                    </a:lnTo>
                    <a:lnTo>
                      <a:pt x="4125" y="93"/>
                    </a:lnTo>
                    <a:lnTo>
                      <a:pt x="4140" y="72"/>
                    </a:lnTo>
                    <a:lnTo>
                      <a:pt x="4154" y="85"/>
                    </a:lnTo>
                    <a:lnTo>
                      <a:pt x="4168" y="87"/>
                    </a:lnTo>
                    <a:lnTo>
                      <a:pt x="4182" y="116"/>
                    </a:lnTo>
                    <a:lnTo>
                      <a:pt x="4196" y="82"/>
                    </a:lnTo>
                    <a:lnTo>
                      <a:pt x="4210" y="89"/>
                    </a:lnTo>
                    <a:lnTo>
                      <a:pt x="4224" y="66"/>
                    </a:lnTo>
                    <a:lnTo>
                      <a:pt x="4238" y="83"/>
                    </a:lnTo>
                    <a:lnTo>
                      <a:pt x="4252" y="41"/>
                    </a:lnTo>
                    <a:lnTo>
                      <a:pt x="4267" y="58"/>
                    </a:lnTo>
                    <a:lnTo>
                      <a:pt x="4281" y="84"/>
                    </a:lnTo>
                    <a:lnTo>
                      <a:pt x="4295" y="77"/>
                    </a:lnTo>
                    <a:lnTo>
                      <a:pt x="4309" y="78"/>
                    </a:lnTo>
                    <a:lnTo>
                      <a:pt x="4323" y="74"/>
                    </a:lnTo>
                    <a:lnTo>
                      <a:pt x="4337" y="106"/>
                    </a:lnTo>
                    <a:lnTo>
                      <a:pt x="4351" y="64"/>
                    </a:lnTo>
                    <a:lnTo>
                      <a:pt x="4365" y="89"/>
                    </a:lnTo>
                    <a:lnTo>
                      <a:pt x="4379" y="92"/>
                    </a:lnTo>
                    <a:lnTo>
                      <a:pt x="4394" y="58"/>
                    </a:lnTo>
                    <a:lnTo>
                      <a:pt x="4408" y="77"/>
                    </a:lnTo>
                    <a:lnTo>
                      <a:pt x="4422" y="114"/>
                    </a:lnTo>
                    <a:lnTo>
                      <a:pt x="4436" y="97"/>
                    </a:lnTo>
                    <a:lnTo>
                      <a:pt x="4450" y="76"/>
                    </a:lnTo>
                    <a:lnTo>
                      <a:pt x="4464" y="69"/>
                    </a:lnTo>
                    <a:lnTo>
                      <a:pt x="4478" y="69"/>
                    </a:lnTo>
                    <a:lnTo>
                      <a:pt x="4492" y="89"/>
                    </a:lnTo>
                    <a:lnTo>
                      <a:pt x="4507" y="55"/>
                    </a:lnTo>
                    <a:lnTo>
                      <a:pt x="4521" y="65"/>
                    </a:lnTo>
                    <a:lnTo>
                      <a:pt x="4535" y="72"/>
                    </a:lnTo>
                    <a:lnTo>
                      <a:pt x="4549" y="62"/>
                    </a:lnTo>
                    <a:lnTo>
                      <a:pt x="4563" y="47"/>
                    </a:lnTo>
                    <a:lnTo>
                      <a:pt x="4577" y="48"/>
                    </a:lnTo>
                    <a:lnTo>
                      <a:pt x="4591" y="51"/>
                    </a:lnTo>
                    <a:lnTo>
                      <a:pt x="4605" y="51"/>
                    </a:lnTo>
                    <a:lnTo>
                      <a:pt x="4619" y="28"/>
                    </a:lnTo>
                    <a:lnTo>
                      <a:pt x="4634" y="55"/>
                    </a:lnTo>
                    <a:lnTo>
                      <a:pt x="4648" y="28"/>
                    </a:lnTo>
                    <a:lnTo>
                      <a:pt x="4662" y="32"/>
                    </a:lnTo>
                    <a:lnTo>
                      <a:pt x="4676" y="61"/>
                    </a:lnTo>
                    <a:lnTo>
                      <a:pt x="4690" y="48"/>
                    </a:lnTo>
                    <a:lnTo>
                      <a:pt x="4704" y="79"/>
                    </a:lnTo>
                    <a:lnTo>
                      <a:pt x="4718" y="62"/>
                    </a:lnTo>
                    <a:lnTo>
                      <a:pt x="4732" y="75"/>
                    </a:lnTo>
                    <a:lnTo>
                      <a:pt x="4746" y="114"/>
                    </a:lnTo>
                    <a:lnTo>
                      <a:pt x="4761" y="121"/>
                    </a:lnTo>
                    <a:lnTo>
                      <a:pt x="4775" y="148"/>
                    </a:lnTo>
                    <a:lnTo>
                      <a:pt x="4789" y="142"/>
                    </a:lnTo>
                    <a:lnTo>
                      <a:pt x="4803" y="189"/>
                    </a:lnTo>
                    <a:lnTo>
                      <a:pt x="4817" y="210"/>
                    </a:lnTo>
                    <a:lnTo>
                      <a:pt x="4831" y="201"/>
                    </a:lnTo>
                    <a:lnTo>
                      <a:pt x="4845" y="214"/>
                    </a:lnTo>
                    <a:lnTo>
                      <a:pt x="4859" y="205"/>
                    </a:lnTo>
                    <a:lnTo>
                      <a:pt x="4873" y="208"/>
                    </a:lnTo>
                    <a:lnTo>
                      <a:pt x="4888" y="203"/>
                    </a:lnTo>
                    <a:lnTo>
                      <a:pt x="4902" y="177"/>
                    </a:lnTo>
                    <a:lnTo>
                      <a:pt x="4916" y="187"/>
                    </a:lnTo>
                    <a:lnTo>
                      <a:pt x="4930" y="128"/>
                    </a:lnTo>
                    <a:lnTo>
                      <a:pt x="4944" y="112"/>
                    </a:lnTo>
                    <a:lnTo>
                      <a:pt x="4958" y="111"/>
                    </a:lnTo>
                    <a:lnTo>
                      <a:pt x="4972" y="93"/>
                    </a:lnTo>
                    <a:lnTo>
                      <a:pt x="4986" y="108"/>
                    </a:lnTo>
                    <a:lnTo>
                      <a:pt x="5000" y="83"/>
                    </a:lnTo>
                    <a:lnTo>
                      <a:pt x="5015" y="90"/>
                    </a:lnTo>
                    <a:lnTo>
                      <a:pt x="5029" y="63"/>
                    </a:lnTo>
                    <a:lnTo>
                      <a:pt x="5043" y="65"/>
                    </a:lnTo>
                    <a:lnTo>
                      <a:pt x="5057" y="66"/>
                    </a:lnTo>
                    <a:lnTo>
                      <a:pt x="5071" y="58"/>
                    </a:lnTo>
                    <a:lnTo>
                      <a:pt x="5085" y="67"/>
                    </a:lnTo>
                    <a:lnTo>
                      <a:pt x="5099" y="70"/>
                    </a:lnTo>
                    <a:lnTo>
                      <a:pt x="5113" y="63"/>
                    </a:lnTo>
                    <a:lnTo>
                      <a:pt x="5127" y="69"/>
                    </a:lnTo>
                    <a:lnTo>
                      <a:pt x="5142" y="75"/>
                    </a:lnTo>
                    <a:lnTo>
                      <a:pt x="5156" y="64"/>
                    </a:lnTo>
                    <a:lnTo>
                      <a:pt x="5170" y="39"/>
                    </a:lnTo>
                    <a:lnTo>
                      <a:pt x="5184" y="77"/>
                    </a:lnTo>
                    <a:lnTo>
                      <a:pt x="5198" y="82"/>
                    </a:lnTo>
                    <a:lnTo>
                      <a:pt x="5212" y="104"/>
                    </a:lnTo>
                    <a:lnTo>
                      <a:pt x="5226" y="143"/>
                    </a:lnTo>
                    <a:lnTo>
                      <a:pt x="5240" y="177"/>
                    </a:lnTo>
                    <a:lnTo>
                      <a:pt x="5255" y="215"/>
                    </a:lnTo>
                    <a:lnTo>
                      <a:pt x="5269" y="225"/>
                    </a:lnTo>
                    <a:lnTo>
                      <a:pt x="5283" y="294"/>
                    </a:lnTo>
                    <a:lnTo>
                      <a:pt x="5297" y="352"/>
                    </a:lnTo>
                    <a:lnTo>
                      <a:pt x="5311" y="378"/>
                    </a:lnTo>
                    <a:lnTo>
                      <a:pt x="5325" y="404"/>
                    </a:lnTo>
                    <a:lnTo>
                      <a:pt x="5339" y="350"/>
                    </a:lnTo>
                    <a:lnTo>
                      <a:pt x="5353" y="397"/>
                    </a:lnTo>
                    <a:lnTo>
                      <a:pt x="5367" y="340"/>
                    </a:lnTo>
                    <a:lnTo>
                      <a:pt x="5382" y="328"/>
                    </a:lnTo>
                    <a:lnTo>
                      <a:pt x="5396" y="282"/>
                    </a:lnTo>
                    <a:lnTo>
                      <a:pt x="5410" y="287"/>
                    </a:lnTo>
                    <a:lnTo>
                      <a:pt x="5424" y="205"/>
                    </a:lnTo>
                    <a:lnTo>
                      <a:pt x="5438" y="197"/>
                    </a:lnTo>
                    <a:lnTo>
                      <a:pt x="5452" y="160"/>
                    </a:lnTo>
                    <a:lnTo>
                      <a:pt x="5466" y="161"/>
                    </a:lnTo>
                    <a:lnTo>
                      <a:pt x="5480" y="160"/>
                    </a:lnTo>
                    <a:lnTo>
                      <a:pt x="5494" y="123"/>
                    </a:lnTo>
                    <a:lnTo>
                      <a:pt x="5509" y="168"/>
                    </a:lnTo>
                    <a:lnTo>
                      <a:pt x="5523" y="150"/>
                    </a:lnTo>
                    <a:lnTo>
                      <a:pt x="5537" y="133"/>
                    </a:lnTo>
                    <a:lnTo>
                      <a:pt x="5551" y="125"/>
                    </a:lnTo>
                    <a:lnTo>
                      <a:pt x="5565" y="134"/>
                    </a:lnTo>
                    <a:lnTo>
                      <a:pt x="5579" y="149"/>
                    </a:lnTo>
                    <a:lnTo>
                      <a:pt x="5593" y="147"/>
                    </a:lnTo>
                    <a:lnTo>
                      <a:pt x="5607" y="110"/>
                    </a:lnTo>
                    <a:lnTo>
                      <a:pt x="5621" y="91"/>
                    </a:lnTo>
                    <a:lnTo>
                      <a:pt x="5636" y="138"/>
                    </a:lnTo>
                    <a:lnTo>
                      <a:pt x="5650" y="116"/>
                    </a:lnTo>
                    <a:lnTo>
                      <a:pt x="5664" y="69"/>
                    </a:lnTo>
                    <a:lnTo>
                      <a:pt x="5678" y="98"/>
                    </a:lnTo>
                    <a:lnTo>
                      <a:pt x="5692" y="81"/>
                    </a:lnTo>
                    <a:lnTo>
                      <a:pt x="5706" y="70"/>
                    </a:lnTo>
                    <a:lnTo>
                      <a:pt x="5720" y="78"/>
                    </a:lnTo>
                    <a:lnTo>
                      <a:pt x="5734" y="70"/>
                    </a:lnTo>
                    <a:lnTo>
                      <a:pt x="5748" y="53"/>
                    </a:lnTo>
                    <a:lnTo>
                      <a:pt x="5763" y="77"/>
                    </a:lnTo>
                    <a:lnTo>
                      <a:pt x="5777" y="66"/>
                    </a:lnTo>
                    <a:lnTo>
                      <a:pt x="5791" y="70"/>
                    </a:lnTo>
                    <a:lnTo>
                      <a:pt x="5805" y="82"/>
                    </a:lnTo>
                    <a:lnTo>
                      <a:pt x="5819" y="53"/>
                    </a:lnTo>
                    <a:lnTo>
                      <a:pt x="5833" y="59"/>
                    </a:lnTo>
                    <a:lnTo>
                      <a:pt x="5847" y="56"/>
                    </a:lnTo>
                    <a:lnTo>
                      <a:pt x="5861" y="80"/>
                    </a:lnTo>
                    <a:lnTo>
                      <a:pt x="5876" y="38"/>
                    </a:lnTo>
                    <a:lnTo>
                      <a:pt x="5890" y="55"/>
                    </a:lnTo>
                    <a:lnTo>
                      <a:pt x="5904" y="54"/>
                    </a:lnTo>
                    <a:lnTo>
                      <a:pt x="5918" y="32"/>
                    </a:lnTo>
                    <a:lnTo>
                      <a:pt x="5932" y="38"/>
                    </a:lnTo>
                    <a:lnTo>
                      <a:pt x="5946" y="44"/>
                    </a:lnTo>
                    <a:lnTo>
                      <a:pt x="5960" y="50"/>
                    </a:lnTo>
                    <a:lnTo>
                      <a:pt x="5974" y="39"/>
                    </a:lnTo>
                    <a:lnTo>
                      <a:pt x="5988" y="63"/>
                    </a:lnTo>
                    <a:lnTo>
                      <a:pt x="6003" y="40"/>
                    </a:lnTo>
                    <a:lnTo>
                      <a:pt x="6017" y="50"/>
                    </a:lnTo>
                    <a:lnTo>
                      <a:pt x="6031" y="40"/>
                    </a:lnTo>
                    <a:lnTo>
                      <a:pt x="6045" y="61"/>
                    </a:lnTo>
                    <a:lnTo>
                      <a:pt x="6059" y="28"/>
                    </a:lnTo>
                    <a:lnTo>
                      <a:pt x="6073" y="45"/>
                    </a:lnTo>
                    <a:lnTo>
                      <a:pt x="6087" y="57"/>
                    </a:lnTo>
                    <a:lnTo>
                      <a:pt x="6101" y="41"/>
                    </a:lnTo>
                    <a:lnTo>
                      <a:pt x="6115" y="67"/>
                    </a:lnTo>
                    <a:lnTo>
                      <a:pt x="6130" y="48"/>
                    </a:lnTo>
                    <a:lnTo>
                      <a:pt x="6144" y="68"/>
                    </a:lnTo>
                    <a:lnTo>
                      <a:pt x="6158" y="38"/>
                    </a:lnTo>
                    <a:lnTo>
                      <a:pt x="6172" y="45"/>
                    </a:lnTo>
                    <a:lnTo>
                      <a:pt x="6186" y="74"/>
                    </a:lnTo>
                    <a:lnTo>
                      <a:pt x="6200" y="43"/>
                    </a:lnTo>
                    <a:lnTo>
                      <a:pt x="6214" y="52"/>
                    </a:lnTo>
                    <a:lnTo>
                      <a:pt x="6228" y="45"/>
                    </a:lnTo>
                    <a:lnTo>
                      <a:pt x="6242" y="36"/>
                    </a:lnTo>
                    <a:lnTo>
                      <a:pt x="6257" y="36"/>
                    </a:lnTo>
                    <a:lnTo>
                      <a:pt x="6271" y="45"/>
                    </a:lnTo>
                    <a:lnTo>
                      <a:pt x="6285" y="37"/>
                    </a:lnTo>
                    <a:lnTo>
                      <a:pt x="6299" y="45"/>
                    </a:lnTo>
                    <a:lnTo>
                      <a:pt x="6313" y="50"/>
                    </a:lnTo>
                    <a:lnTo>
                      <a:pt x="6327" y="54"/>
                    </a:lnTo>
                    <a:lnTo>
                      <a:pt x="6341" y="30"/>
                    </a:lnTo>
                    <a:lnTo>
                      <a:pt x="6355" y="28"/>
                    </a:lnTo>
                    <a:lnTo>
                      <a:pt x="6369" y="29"/>
                    </a:lnTo>
                    <a:lnTo>
                      <a:pt x="6384" y="39"/>
                    </a:lnTo>
                    <a:lnTo>
                      <a:pt x="6398" y="48"/>
                    </a:lnTo>
                    <a:lnTo>
                      <a:pt x="6412" y="17"/>
                    </a:lnTo>
                    <a:lnTo>
                      <a:pt x="6426" y="23"/>
                    </a:lnTo>
                    <a:lnTo>
                      <a:pt x="6440" y="21"/>
                    </a:lnTo>
                    <a:lnTo>
                      <a:pt x="6454" y="31"/>
                    </a:lnTo>
                    <a:lnTo>
                      <a:pt x="6468" y="33"/>
                    </a:lnTo>
                    <a:lnTo>
                      <a:pt x="6482" y="43"/>
                    </a:lnTo>
                    <a:lnTo>
                      <a:pt x="6496" y="21"/>
                    </a:lnTo>
                    <a:lnTo>
                      <a:pt x="6511" y="37"/>
                    </a:lnTo>
                    <a:lnTo>
                      <a:pt x="6525" y="31"/>
                    </a:lnTo>
                    <a:lnTo>
                      <a:pt x="6539" y="30"/>
                    </a:lnTo>
                    <a:lnTo>
                      <a:pt x="6553" y="35"/>
                    </a:lnTo>
                    <a:lnTo>
                      <a:pt x="6567" y="27"/>
                    </a:lnTo>
                    <a:lnTo>
                      <a:pt x="6581" y="44"/>
                    </a:lnTo>
                    <a:lnTo>
                      <a:pt x="6595" y="38"/>
                    </a:lnTo>
                    <a:lnTo>
                      <a:pt x="6609" y="42"/>
                    </a:lnTo>
                    <a:lnTo>
                      <a:pt x="6624" y="65"/>
                    </a:lnTo>
                    <a:lnTo>
                      <a:pt x="6638" y="34"/>
                    </a:lnTo>
                    <a:lnTo>
                      <a:pt x="6652" y="57"/>
                    </a:lnTo>
                    <a:lnTo>
                      <a:pt x="6666" y="78"/>
                    </a:lnTo>
                    <a:lnTo>
                      <a:pt x="6680" y="34"/>
                    </a:lnTo>
                    <a:lnTo>
                      <a:pt x="6694" y="50"/>
                    </a:lnTo>
                    <a:lnTo>
                      <a:pt x="6708" y="49"/>
                    </a:lnTo>
                    <a:lnTo>
                      <a:pt x="6722" y="47"/>
                    </a:lnTo>
                    <a:lnTo>
                      <a:pt x="6736" y="49"/>
                    </a:lnTo>
                    <a:lnTo>
                      <a:pt x="6751" y="46"/>
                    </a:lnTo>
                    <a:lnTo>
                      <a:pt x="6765" y="44"/>
                    </a:lnTo>
                    <a:lnTo>
                      <a:pt x="6779" y="30"/>
                    </a:lnTo>
                    <a:lnTo>
                      <a:pt x="6793" y="26"/>
                    </a:lnTo>
                    <a:lnTo>
                      <a:pt x="6807" y="49"/>
                    </a:lnTo>
                    <a:lnTo>
                      <a:pt x="6821" y="43"/>
                    </a:lnTo>
                    <a:lnTo>
                      <a:pt x="6835" y="50"/>
                    </a:lnTo>
                    <a:lnTo>
                      <a:pt x="6849" y="55"/>
                    </a:lnTo>
                    <a:lnTo>
                      <a:pt x="6863" y="62"/>
                    </a:lnTo>
                    <a:lnTo>
                      <a:pt x="6878" y="44"/>
                    </a:lnTo>
                    <a:lnTo>
                      <a:pt x="6892" y="37"/>
                    </a:lnTo>
                    <a:lnTo>
                      <a:pt x="6906" y="70"/>
                    </a:lnTo>
                    <a:lnTo>
                      <a:pt x="6920" y="82"/>
                    </a:lnTo>
                    <a:lnTo>
                      <a:pt x="6934" y="70"/>
                    </a:lnTo>
                    <a:lnTo>
                      <a:pt x="6948" y="66"/>
                    </a:lnTo>
                    <a:lnTo>
                      <a:pt x="6962" y="47"/>
                    </a:lnTo>
                    <a:lnTo>
                      <a:pt x="6976" y="73"/>
                    </a:lnTo>
                    <a:lnTo>
                      <a:pt x="6990" y="54"/>
                    </a:lnTo>
                    <a:lnTo>
                      <a:pt x="7005" y="52"/>
                    </a:lnTo>
                    <a:lnTo>
                      <a:pt x="7019" y="40"/>
                    </a:lnTo>
                    <a:lnTo>
                      <a:pt x="7033" y="41"/>
                    </a:lnTo>
                    <a:lnTo>
                      <a:pt x="7047" y="43"/>
                    </a:lnTo>
                    <a:lnTo>
                      <a:pt x="7061" y="55"/>
                    </a:lnTo>
                    <a:lnTo>
                      <a:pt x="7075" y="48"/>
                    </a:lnTo>
                    <a:lnTo>
                      <a:pt x="7089" y="62"/>
                    </a:lnTo>
                    <a:lnTo>
                      <a:pt x="7103" y="52"/>
                    </a:lnTo>
                    <a:lnTo>
                      <a:pt x="7117" y="41"/>
                    </a:lnTo>
                    <a:lnTo>
                      <a:pt x="7132" y="27"/>
                    </a:lnTo>
                    <a:lnTo>
                      <a:pt x="7146" y="41"/>
                    </a:lnTo>
                    <a:lnTo>
                      <a:pt x="7160" y="21"/>
                    </a:lnTo>
                    <a:lnTo>
                      <a:pt x="7174" y="11"/>
                    </a:lnTo>
                    <a:lnTo>
                      <a:pt x="7188" y="35"/>
                    </a:lnTo>
                    <a:lnTo>
                      <a:pt x="7202" y="26"/>
                    </a:lnTo>
                    <a:lnTo>
                      <a:pt x="7216" y="25"/>
                    </a:lnTo>
                    <a:lnTo>
                      <a:pt x="7230" y="23"/>
                    </a:lnTo>
                    <a:lnTo>
                      <a:pt x="7245" y="23"/>
                    </a:lnTo>
                    <a:lnTo>
                      <a:pt x="7259" y="42"/>
                    </a:lnTo>
                    <a:lnTo>
                      <a:pt x="7273" y="33"/>
                    </a:lnTo>
                    <a:lnTo>
                      <a:pt x="7287" y="54"/>
                    </a:lnTo>
                    <a:lnTo>
                      <a:pt x="7301" y="25"/>
                    </a:lnTo>
                    <a:lnTo>
                      <a:pt x="7315" y="23"/>
                    </a:lnTo>
                    <a:lnTo>
                      <a:pt x="7329" y="17"/>
                    </a:lnTo>
                    <a:lnTo>
                      <a:pt x="7343" y="24"/>
                    </a:lnTo>
                    <a:lnTo>
                      <a:pt x="7357" y="30"/>
                    </a:lnTo>
                    <a:lnTo>
                      <a:pt x="7372" y="49"/>
                    </a:lnTo>
                    <a:lnTo>
                      <a:pt x="7386" y="27"/>
                    </a:lnTo>
                    <a:lnTo>
                      <a:pt x="7400" y="0"/>
                    </a:lnTo>
                    <a:lnTo>
                      <a:pt x="7414" y="31"/>
                    </a:lnTo>
                    <a:lnTo>
                      <a:pt x="7428" y="20"/>
                    </a:lnTo>
                    <a:lnTo>
                      <a:pt x="7442" y="40"/>
                    </a:lnTo>
                    <a:lnTo>
                      <a:pt x="7456" y="13"/>
                    </a:lnTo>
                    <a:lnTo>
                      <a:pt x="7470" y="30"/>
                    </a:lnTo>
                    <a:lnTo>
                      <a:pt x="7484" y="30"/>
                    </a:lnTo>
                    <a:lnTo>
                      <a:pt x="7499" y="16"/>
                    </a:lnTo>
                    <a:lnTo>
                      <a:pt x="7513" y="20"/>
                    </a:lnTo>
                    <a:lnTo>
                      <a:pt x="7527" y="37"/>
                    </a:lnTo>
                    <a:lnTo>
                      <a:pt x="7541" y="43"/>
                    </a:lnTo>
                    <a:lnTo>
                      <a:pt x="7555" y="59"/>
                    </a:lnTo>
                    <a:lnTo>
                      <a:pt x="7569" y="43"/>
                    </a:lnTo>
                    <a:lnTo>
                      <a:pt x="7583" y="58"/>
                    </a:lnTo>
                    <a:lnTo>
                      <a:pt x="7597" y="43"/>
                    </a:lnTo>
                    <a:lnTo>
                      <a:pt x="7611" y="54"/>
                    </a:lnTo>
                    <a:lnTo>
                      <a:pt x="7626" y="42"/>
                    </a:lnTo>
                    <a:lnTo>
                      <a:pt x="7640" y="47"/>
                    </a:lnTo>
                    <a:lnTo>
                      <a:pt x="7654" y="50"/>
                    </a:lnTo>
                    <a:lnTo>
                      <a:pt x="7668" y="32"/>
                    </a:lnTo>
                    <a:lnTo>
                      <a:pt x="7682" y="51"/>
                    </a:lnTo>
                    <a:lnTo>
                      <a:pt x="7696" y="48"/>
                    </a:lnTo>
                    <a:lnTo>
                      <a:pt x="7710" y="40"/>
                    </a:lnTo>
                    <a:lnTo>
                      <a:pt x="7724" y="44"/>
                    </a:lnTo>
                    <a:lnTo>
                      <a:pt x="7738" y="47"/>
                    </a:lnTo>
                    <a:lnTo>
                      <a:pt x="7753" y="49"/>
                    </a:lnTo>
                    <a:lnTo>
                      <a:pt x="7767" y="32"/>
                    </a:lnTo>
                    <a:lnTo>
                      <a:pt x="7781" y="53"/>
                    </a:lnTo>
                    <a:lnTo>
                      <a:pt x="7795" y="56"/>
                    </a:lnTo>
                    <a:lnTo>
                      <a:pt x="7809" y="34"/>
                    </a:lnTo>
                    <a:lnTo>
                      <a:pt x="7823" y="40"/>
                    </a:lnTo>
                    <a:lnTo>
                      <a:pt x="7837" y="31"/>
                    </a:lnTo>
                    <a:lnTo>
                      <a:pt x="7851" y="49"/>
                    </a:lnTo>
                    <a:lnTo>
                      <a:pt x="7865" y="68"/>
                    </a:lnTo>
                    <a:lnTo>
                      <a:pt x="7880" y="114"/>
                    </a:lnTo>
                    <a:lnTo>
                      <a:pt x="7894" y="190"/>
                    </a:lnTo>
                    <a:lnTo>
                      <a:pt x="7908" y="277"/>
                    </a:lnTo>
                    <a:lnTo>
                      <a:pt x="7922" y="466"/>
                    </a:lnTo>
                    <a:lnTo>
                      <a:pt x="7936" y="599"/>
                    </a:lnTo>
                    <a:lnTo>
                      <a:pt x="7950" y="815"/>
                    </a:lnTo>
                    <a:lnTo>
                      <a:pt x="7964" y="1166"/>
                    </a:lnTo>
                    <a:lnTo>
                      <a:pt x="7978" y="1481"/>
                    </a:lnTo>
                    <a:lnTo>
                      <a:pt x="7993" y="1860"/>
                    </a:lnTo>
                    <a:lnTo>
                      <a:pt x="8007" y="2151"/>
                    </a:lnTo>
                    <a:lnTo>
                      <a:pt x="8021" y="2437"/>
                    </a:lnTo>
                    <a:lnTo>
                      <a:pt x="8035" y="2532"/>
                    </a:lnTo>
                    <a:lnTo>
                      <a:pt x="8049" y="2682"/>
                    </a:lnTo>
                    <a:lnTo>
                      <a:pt x="8063" y="2562"/>
                    </a:lnTo>
                    <a:lnTo>
                      <a:pt x="8077" y="2357"/>
                    </a:lnTo>
                    <a:lnTo>
                      <a:pt x="8091" y="2233"/>
                    </a:lnTo>
                    <a:lnTo>
                      <a:pt x="8105" y="1988"/>
                    </a:lnTo>
                    <a:lnTo>
                      <a:pt x="8120" y="1838"/>
                    </a:lnTo>
                    <a:lnTo>
                      <a:pt x="8134" y="1800"/>
                    </a:lnTo>
                    <a:lnTo>
                      <a:pt x="8148" y="1782"/>
                    </a:lnTo>
                    <a:lnTo>
                      <a:pt x="8162" y="1772"/>
                    </a:lnTo>
                    <a:lnTo>
                      <a:pt x="8176" y="1693"/>
                    </a:lnTo>
                    <a:lnTo>
                      <a:pt x="8190" y="1682"/>
                    </a:lnTo>
                    <a:lnTo>
                      <a:pt x="8204" y="1632"/>
                    </a:lnTo>
                    <a:lnTo>
                      <a:pt x="8218" y="1545"/>
                    </a:lnTo>
                    <a:lnTo>
                      <a:pt x="8232" y="1500"/>
                    </a:lnTo>
                    <a:lnTo>
                      <a:pt x="8247" y="1367"/>
                    </a:lnTo>
                    <a:lnTo>
                      <a:pt x="8261" y="1169"/>
                    </a:lnTo>
                    <a:lnTo>
                      <a:pt x="8275" y="1047"/>
                    </a:lnTo>
                    <a:lnTo>
                      <a:pt x="8289" y="1004"/>
                    </a:lnTo>
                    <a:lnTo>
                      <a:pt x="8303" y="922"/>
                    </a:lnTo>
                    <a:lnTo>
                      <a:pt x="8317" y="843"/>
                    </a:lnTo>
                    <a:lnTo>
                      <a:pt x="8331" y="803"/>
                    </a:lnTo>
                    <a:lnTo>
                      <a:pt x="8345" y="713"/>
                    </a:lnTo>
                    <a:lnTo>
                      <a:pt x="8359" y="705"/>
                    </a:lnTo>
                    <a:lnTo>
                      <a:pt x="8374" y="605"/>
                    </a:lnTo>
                    <a:lnTo>
                      <a:pt x="8388" y="617"/>
                    </a:lnTo>
                    <a:lnTo>
                      <a:pt x="8402" y="579"/>
                    </a:lnTo>
                    <a:lnTo>
                      <a:pt x="8416" y="534"/>
                    </a:lnTo>
                    <a:lnTo>
                      <a:pt x="8430" y="552"/>
                    </a:lnTo>
                    <a:lnTo>
                      <a:pt x="8444" y="521"/>
                    </a:lnTo>
                    <a:lnTo>
                      <a:pt x="8458" y="513"/>
                    </a:lnTo>
                    <a:lnTo>
                      <a:pt x="8472" y="523"/>
                    </a:lnTo>
                    <a:lnTo>
                      <a:pt x="8486" y="504"/>
                    </a:lnTo>
                    <a:lnTo>
                      <a:pt x="8501" y="519"/>
                    </a:lnTo>
                    <a:lnTo>
                      <a:pt x="8515" y="506"/>
                    </a:lnTo>
                    <a:lnTo>
                      <a:pt x="8529" y="446"/>
                    </a:lnTo>
                    <a:lnTo>
                      <a:pt x="8543" y="443"/>
                    </a:lnTo>
                    <a:lnTo>
                      <a:pt x="8557" y="415"/>
                    </a:lnTo>
                    <a:lnTo>
                      <a:pt x="8571" y="417"/>
                    </a:lnTo>
                    <a:lnTo>
                      <a:pt x="8585" y="442"/>
                    </a:lnTo>
                    <a:lnTo>
                      <a:pt x="8599" y="450"/>
                    </a:lnTo>
                    <a:lnTo>
                      <a:pt x="8614" y="510"/>
                    </a:lnTo>
                    <a:lnTo>
                      <a:pt x="8628" y="445"/>
                    </a:lnTo>
                    <a:lnTo>
                      <a:pt x="8642" y="433"/>
                    </a:lnTo>
                    <a:lnTo>
                      <a:pt x="8656" y="428"/>
                    </a:lnTo>
                    <a:lnTo>
                      <a:pt x="8670" y="468"/>
                    </a:lnTo>
                    <a:lnTo>
                      <a:pt x="8684" y="420"/>
                    </a:lnTo>
                    <a:lnTo>
                      <a:pt x="8698" y="426"/>
                    </a:lnTo>
                    <a:lnTo>
                      <a:pt x="8712" y="408"/>
                    </a:lnTo>
                    <a:lnTo>
                      <a:pt x="8726" y="375"/>
                    </a:lnTo>
                    <a:lnTo>
                      <a:pt x="8741" y="367"/>
                    </a:lnTo>
                    <a:lnTo>
                      <a:pt x="8755" y="334"/>
                    </a:lnTo>
                    <a:lnTo>
                      <a:pt x="8769" y="331"/>
                    </a:lnTo>
                    <a:lnTo>
                      <a:pt x="8783" y="312"/>
                    </a:lnTo>
                    <a:lnTo>
                      <a:pt x="8797" y="269"/>
                    </a:lnTo>
                    <a:lnTo>
                      <a:pt x="8811" y="298"/>
                    </a:lnTo>
                    <a:lnTo>
                      <a:pt x="8825" y="266"/>
                    </a:lnTo>
                    <a:lnTo>
                      <a:pt x="8839" y="255"/>
                    </a:lnTo>
                    <a:lnTo>
                      <a:pt x="8853" y="237"/>
                    </a:lnTo>
                    <a:lnTo>
                      <a:pt x="8868" y="248"/>
                    </a:lnTo>
                    <a:lnTo>
                      <a:pt x="8882" y="244"/>
                    </a:lnTo>
                    <a:lnTo>
                      <a:pt x="8896" y="203"/>
                    </a:lnTo>
                    <a:lnTo>
                      <a:pt x="8910" y="219"/>
                    </a:lnTo>
                    <a:lnTo>
                      <a:pt x="8924" y="156"/>
                    </a:lnTo>
                    <a:lnTo>
                      <a:pt x="8938" y="161"/>
                    </a:lnTo>
                    <a:lnTo>
                      <a:pt x="8952" y="193"/>
                    </a:lnTo>
                    <a:lnTo>
                      <a:pt x="8966" y="166"/>
                    </a:lnTo>
                    <a:lnTo>
                      <a:pt x="8980" y="167"/>
                    </a:lnTo>
                    <a:lnTo>
                      <a:pt x="8995" y="170"/>
                    </a:lnTo>
                    <a:lnTo>
                      <a:pt x="9009" y="161"/>
                    </a:lnTo>
                    <a:lnTo>
                      <a:pt x="9023" y="137"/>
                    </a:lnTo>
                    <a:lnTo>
                      <a:pt x="9037" y="127"/>
                    </a:lnTo>
                    <a:lnTo>
                      <a:pt x="9051" y="148"/>
                    </a:lnTo>
                    <a:lnTo>
                      <a:pt x="9065" y="141"/>
                    </a:lnTo>
                    <a:lnTo>
                      <a:pt x="9079" y="103"/>
                    </a:lnTo>
                    <a:lnTo>
                      <a:pt x="9093" y="98"/>
                    </a:lnTo>
                    <a:lnTo>
                      <a:pt x="9107" y="112"/>
                    </a:lnTo>
                    <a:lnTo>
                      <a:pt x="9122" y="114"/>
                    </a:lnTo>
                    <a:lnTo>
                      <a:pt x="9136" y="98"/>
                    </a:lnTo>
                    <a:lnTo>
                      <a:pt x="9150" y="88"/>
                    </a:lnTo>
                    <a:lnTo>
                      <a:pt x="9164" y="101"/>
                    </a:lnTo>
                    <a:lnTo>
                      <a:pt x="9178" y="75"/>
                    </a:lnTo>
                    <a:lnTo>
                      <a:pt x="9192" y="61"/>
                    </a:lnTo>
                    <a:lnTo>
                      <a:pt x="9206" y="74"/>
                    </a:lnTo>
                    <a:lnTo>
                      <a:pt x="9220" y="108"/>
                    </a:lnTo>
                    <a:lnTo>
                      <a:pt x="9234" y="66"/>
                    </a:lnTo>
                    <a:lnTo>
                      <a:pt x="9249" y="107"/>
                    </a:lnTo>
                    <a:lnTo>
                      <a:pt x="9263" y="84"/>
                    </a:lnTo>
                    <a:lnTo>
                      <a:pt x="9277" y="65"/>
                    </a:lnTo>
                    <a:lnTo>
                      <a:pt x="9291" y="66"/>
                    </a:lnTo>
                    <a:lnTo>
                      <a:pt x="9305" y="91"/>
                    </a:lnTo>
                    <a:lnTo>
                      <a:pt x="9319" y="104"/>
                    </a:lnTo>
                    <a:lnTo>
                      <a:pt x="9333" y="104"/>
                    </a:lnTo>
                    <a:lnTo>
                      <a:pt x="9347" y="122"/>
                    </a:lnTo>
                    <a:lnTo>
                      <a:pt x="9362" y="126"/>
                    </a:lnTo>
                    <a:lnTo>
                      <a:pt x="9376" y="150"/>
                    </a:lnTo>
                    <a:lnTo>
                      <a:pt x="9390" y="165"/>
                    </a:lnTo>
                    <a:lnTo>
                      <a:pt x="9404" y="207"/>
                    </a:lnTo>
                    <a:lnTo>
                      <a:pt x="9418" y="227"/>
                    </a:lnTo>
                    <a:lnTo>
                      <a:pt x="9432" y="264"/>
                    </a:lnTo>
                    <a:lnTo>
                      <a:pt x="9446" y="267"/>
                    </a:lnTo>
                    <a:lnTo>
                      <a:pt x="9460" y="288"/>
                    </a:lnTo>
                    <a:lnTo>
                      <a:pt x="9474" y="282"/>
                    </a:lnTo>
                    <a:lnTo>
                      <a:pt x="9489" y="288"/>
                    </a:lnTo>
                    <a:lnTo>
                      <a:pt x="9503" y="368"/>
                    </a:lnTo>
                    <a:lnTo>
                      <a:pt x="9517" y="310"/>
                    </a:lnTo>
                    <a:lnTo>
                      <a:pt x="9531" y="341"/>
                    </a:lnTo>
                    <a:lnTo>
                      <a:pt x="9545" y="292"/>
                    </a:lnTo>
                    <a:lnTo>
                      <a:pt x="9559" y="313"/>
                    </a:lnTo>
                    <a:lnTo>
                      <a:pt x="9573" y="270"/>
                    </a:lnTo>
                    <a:lnTo>
                      <a:pt x="9587" y="239"/>
                    </a:lnTo>
                    <a:lnTo>
                      <a:pt x="9601" y="229"/>
                    </a:lnTo>
                    <a:lnTo>
                      <a:pt x="9616" y="241"/>
                    </a:lnTo>
                    <a:lnTo>
                      <a:pt x="9630" y="220"/>
                    </a:lnTo>
                    <a:lnTo>
                      <a:pt x="9644" y="204"/>
                    </a:lnTo>
                    <a:lnTo>
                      <a:pt x="9658" y="243"/>
                    </a:lnTo>
                    <a:lnTo>
                      <a:pt x="9672" y="211"/>
                    </a:lnTo>
                    <a:lnTo>
                      <a:pt x="9686" y="217"/>
                    </a:lnTo>
                    <a:lnTo>
                      <a:pt x="9700" y="213"/>
                    </a:lnTo>
                    <a:lnTo>
                      <a:pt x="9714" y="188"/>
                    </a:lnTo>
                    <a:lnTo>
                      <a:pt x="9728" y="199"/>
                    </a:lnTo>
                    <a:lnTo>
                      <a:pt x="9743" y="191"/>
                    </a:lnTo>
                    <a:lnTo>
                      <a:pt x="9757" y="174"/>
                    </a:lnTo>
                    <a:lnTo>
                      <a:pt x="9771" y="201"/>
                    </a:lnTo>
                    <a:lnTo>
                      <a:pt x="9785" y="132"/>
                    </a:lnTo>
                    <a:lnTo>
                      <a:pt x="9799" y="142"/>
                    </a:lnTo>
                    <a:lnTo>
                      <a:pt x="9813" y="127"/>
                    </a:lnTo>
                    <a:lnTo>
                      <a:pt x="9827" y="138"/>
                    </a:lnTo>
                    <a:lnTo>
                      <a:pt x="9841" y="143"/>
                    </a:lnTo>
                    <a:lnTo>
                      <a:pt x="9855" y="193"/>
                    </a:lnTo>
                    <a:lnTo>
                      <a:pt x="9870" y="162"/>
                    </a:lnTo>
                    <a:lnTo>
                      <a:pt x="9884" y="165"/>
                    </a:lnTo>
                    <a:lnTo>
                      <a:pt x="9898" y="148"/>
                    </a:lnTo>
                    <a:lnTo>
                      <a:pt x="9912" y="177"/>
                    </a:lnTo>
                    <a:lnTo>
                      <a:pt x="9926" y="170"/>
                    </a:lnTo>
                    <a:lnTo>
                      <a:pt x="9940" y="177"/>
                    </a:lnTo>
                    <a:lnTo>
                      <a:pt x="9954" y="192"/>
                    </a:lnTo>
                    <a:lnTo>
                      <a:pt x="9968" y="198"/>
                    </a:lnTo>
                    <a:lnTo>
                      <a:pt x="9983" y="193"/>
                    </a:lnTo>
                    <a:lnTo>
                      <a:pt x="9997" y="173"/>
                    </a:lnTo>
                    <a:lnTo>
                      <a:pt x="10011" y="189"/>
                    </a:lnTo>
                    <a:lnTo>
                      <a:pt x="10025" y="212"/>
                    </a:lnTo>
                    <a:lnTo>
                      <a:pt x="10039" y="198"/>
                    </a:lnTo>
                    <a:lnTo>
                      <a:pt x="10053" y="195"/>
                    </a:lnTo>
                    <a:lnTo>
                      <a:pt x="10067" y="169"/>
                    </a:lnTo>
                    <a:lnTo>
                      <a:pt x="10081" y="188"/>
                    </a:lnTo>
                    <a:lnTo>
                      <a:pt x="10095" y="184"/>
                    </a:lnTo>
                    <a:lnTo>
                      <a:pt x="10110" y="151"/>
                    </a:lnTo>
                    <a:lnTo>
                      <a:pt x="10124" y="124"/>
                    </a:lnTo>
                    <a:lnTo>
                      <a:pt x="10138" y="82"/>
                    </a:lnTo>
                    <a:lnTo>
                      <a:pt x="10152" y="113"/>
                    </a:lnTo>
                    <a:lnTo>
                      <a:pt x="10166" y="68"/>
                    </a:lnTo>
                    <a:lnTo>
                      <a:pt x="10180" y="96"/>
                    </a:lnTo>
                    <a:lnTo>
                      <a:pt x="10194" y="87"/>
                    </a:lnTo>
                    <a:lnTo>
                      <a:pt x="10208" y="115"/>
                    </a:lnTo>
                    <a:lnTo>
                      <a:pt x="10222" y="76"/>
                    </a:lnTo>
                    <a:lnTo>
                      <a:pt x="10237" y="99"/>
                    </a:lnTo>
                    <a:lnTo>
                      <a:pt x="10251" y="130"/>
                    </a:lnTo>
                    <a:lnTo>
                      <a:pt x="10265" y="104"/>
                    </a:lnTo>
                    <a:lnTo>
                      <a:pt x="10279" y="92"/>
                    </a:lnTo>
                    <a:lnTo>
                      <a:pt x="10293" y="87"/>
                    </a:lnTo>
                    <a:lnTo>
                      <a:pt x="10307" y="93"/>
                    </a:lnTo>
                    <a:lnTo>
                      <a:pt x="10321" y="102"/>
                    </a:lnTo>
                    <a:lnTo>
                      <a:pt x="10335" y="81"/>
                    </a:lnTo>
                    <a:lnTo>
                      <a:pt x="10349" y="96"/>
                    </a:lnTo>
                    <a:lnTo>
                      <a:pt x="10364" y="60"/>
                    </a:lnTo>
                    <a:lnTo>
                      <a:pt x="10378" y="59"/>
                    </a:lnTo>
                    <a:lnTo>
                      <a:pt x="10392" y="73"/>
                    </a:lnTo>
                    <a:lnTo>
                      <a:pt x="10406" y="50"/>
                    </a:lnTo>
                    <a:lnTo>
                      <a:pt x="10420" y="54"/>
                    </a:lnTo>
                    <a:lnTo>
                      <a:pt x="10434" y="59"/>
                    </a:lnTo>
                    <a:lnTo>
                      <a:pt x="10448" y="45"/>
                    </a:lnTo>
                    <a:lnTo>
                      <a:pt x="10462" y="68"/>
                    </a:lnTo>
                    <a:lnTo>
                      <a:pt x="10476" y="53"/>
                    </a:lnTo>
                    <a:lnTo>
                      <a:pt x="10491" y="50"/>
                    </a:lnTo>
                    <a:lnTo>
                      <a:pt x="10505" y="40"/>
                    </a:lnTo>
                    <a:lnTo>
                      <a:pt x="10519" y="56"/>
                    </a:lnTo>
                    <a:lnTo>
                      <a:pt x="10533" y="62"/>
                    </a:lnTo>
                    <a:lnTo>
                      <a:pt x="10547" y="52"/>
                    </a:lnTo>
                    <a:lnTo>
                      <a:pt x="10561" y="63"/>
                    </a:lnTo>
                    <a:lnTo>
                      <a:pt x="10575" y="70"/>
                    </a:lnTo>
                    <a:lnTo>
                      <a:pt x="10589" y="45"/>
                    </a:lnTo>
                    <a:lnTo>
                      <a:pt x="10604" y="74"/>
                    </a:lnTo>
                    <a:lnTo>
                      <a:pt x="10618" y="51"/>
                    </a:lnTo>
                    <a:lnTo>
                      <a:pt x="10632" y="31"/>
                    </a:lnTo>
                    <a:lnTo>
                      <a:pt x="10646" y="60"/>
                    </a:lnTo>
                    <a:lnTo>
                      <a:pt x="10660" y="49"/>
                    </a:lnTo>
                    <a:lnTo>
                      <a:pt x="10674" y="34"/>
                    </a:lnTo>
                    <a:lnTo>
                      <a:pt x="10688" y="69"/>
                    </a:lnTo>
                    <a:lnTo>
                      <a:pt x="10702" y="58"/>
                    </a:lnTo>
                    <a:lnTo>
                      <a:pt x="10716" y="49"/>
                    </a:lnTo>
                    <a:lnTo>
                      <a:pt x="10731" y="74"/>
                    </a:lnTo>
                    <a:lnTo>
                      <a:pt x="10745" y="43"/>
                    </a:lnTo>
                    <a:lnTo>
                      <a:pt x="10759" y="52"/>
                    </a:lnTo>
                    <a:lnTo>
                      <a:pt x="10773" y="94"/>
                    </a:lnTo>
                    <a:lnTo>
                      <a:pt x="10787" y="102"/>
                    </a:lnTo>
                    <a:lnTo>
                      <a:pt x="10801" y="129"/>
                    </a:lnTo>
                    <a:lnTo>
                      <a:pt x="10815" y="142"/>
                    </a:lnTo>
                    <a:lnTo>
                      <a:pt x="10829" y="125"/>
                    </a:lnTo>
                    <a:lnTo>
                      <a:pt x="10843" y="117"/>
                    </a:lnTo>
                    <a:lnTo>
                      <a:pt x="10858" y="148"/>
                    </a:lnTo>
                    <a:lnTo>
                      <a:pt x="10872" y="128"/>
                    </a:lnTo>
                    <a:lnTo>
                      <a:pt x="10886" y="165"/>
                    </a:lnTo>
                    <a:lnTo>
                      <a:pt x="10900" y="152"/>
                    </a:lnTo>
                    <a:lnTo>
                      <a:pt x="10914" y="157"/>
                    </a:lnTo>
                    <a:lnTo>
                      <a:pt x="10928" y="177"/>
                    </a:lnTo>
                    <a:lnTo>
                      <a:pt x="10942" y="197"/>
                    </a:lnTo>
                    <a:lnTo>
                      <a:pt x="10956" y="197"/>
                    </a:lnTo>
                    <a:lnTo>
                      <a:pt x="10970" y="216"/>
                    </a:lnTo>
                    <a:lnTo>
                      <a:pt x="10985" y="238"/>
                    </a:lnTo>
                    <a:lnTo>
                      <a:pt x="10999" y="237"/>
                    </a:lnTo>
                    <a:lnTo>
                      <a:pt x="11013" y="241"/>
                    </a:lnTo>
                    <a:lnTo>
                      <a:pt x="11027" y="253"/>
                    </a:lnTo>
                    <a:lnTo>
                      <a:pt x="11041" y="250"/>
                    </a:lnTo>
                    <a:lnTo>
                      <a:pt x="11055" y="225"/>
                    </a:lnTo>
                    <a:lnTo>
                      <a:pt x="11069" y="228"/>
                    </a:lnTo>
                    <a:lnTo>
                      <a:pt x="11083" y="191"/>
                    </a:lnTo>
                    <a:lnTo>
                      <a:pt x="11097" y="153"/>
                    </a:lnTo>
                    <a:lnTo>
                      <a:pt x="11112" y="185"/>
                    </a:lnTo>
                    <a:lnTo>
                      <a:pt x="11126" y="122"/>
                    </a:lnTo>
                    <a:lnTo>
                      <a:pt x="11140" y="121"/>
                    </a:lnTo>
                    <a:lnTo>
                      <a:pt x="11154" y="102"/>
                    </a:lnTo>
                    <a:lnTo>
                      <a:pt x="11168" y="88"/>
                    </a:lnTo>
                    <a:lnTo>
                      <a:pt x="11182" y="84"/>
                    </a:lnTo>
                    <a:lnTo>
                      <a:pt x="11196" y="76"/>
                    </a:lnTo>
                    <a:lnTo>
                      <a:pt x="11210" y="95"/>
                    </a:lnTo>
                    <a:lnTo>
                      <a:pt x="11224" y="83"/>
                    </a:lnTo>
                    <a:lnTo>
                      <a:pt x="11239" y="57"/>
                    </a:lnTo>
                    <a:lnTo>
                      <a:pt x="11253" y="62"/>
                    </a:lnTo>
                    <a:lnTo>
                      <a:pt x="11267" y="78"/>
                    </a:lnTo>
                    <a:lnTo>
                      <a:pt x="11281" y="77"/>
                    </a:lnTo>
                    <a:lnTo>
                      <a:pt x="11295" y="65"/>
                    </a:lnTo>
                    <a:lnTo>
                      <a:pt x="11309" y="80"/>
                    </a:lnTo>
                    <a:lnTo>
                      <a:pt x="11323" y="69"/>
                    </a:lnTo>
                    <a:lnTo>
                      <a:pt x="11337" y="61"/>
                    </a:lnTo>
                    <a:lnTo>
                      <a:pt x="11352" y="62"/>
                    </a:lnTo>
                    <a:lnTo>
                      <a:pt x="11366" y="89"/>
                    </a:lnTo>
                    <a:lnTo>
                      <a:pt x="11380" y="73"/>
                    </a:lnTo>
                    <a:lnTo>
                      <a:pt x="11394" y="54"/>
                    </a:lnTo>
                    <a:lnTo>
                      <a:pt x="11408" y="54"/>
                    </a:lnTo>
                    <a:lnTo>
                      <a:pt x="11422" y="80"/>
                    </a:lnTo>
                    <a:lnTo>
                      <a:pt x="11436" y="69"/>
                    </a:lnTo>
                    <a:lnTo>
                      <a:pt x="11450" y="82"/>
                    </a:lnTo>
                    <a:lnTo>
                      <a:pt x="11464" y="60"/>
                    </a:lnTo>
                    <a:lnTo>
                      <a:pt x="11479" y="43"/>
                    </a:lnTo>
                    <a:lnTo>
                      <a:pt x="11493" y="60"/>
                    </a:lnTo>
                    <a:lnTo>
                      <a:pt x="11507" y="62"/>
                    </a:lnTo>
                    <a:lnTo>
                      <a:pt x="11521" y="46"/>
                    </a:lnTo>
                    <a:lnTo>
                      <a:pt x="11535" y="58"/>
                    </a:lnTo>
                    <a:lnTo>
                      <a:pt x="11549" y="52"/>
                    </a:lnTo>
                    <a:lnTo>
                      <a:pt x="11563" y="49"/>
                    </a:lnTo>
                    <a:lnTo>
                      <a:pt x="11577" y="65"/>
                    </a:lnTo>
                    <a:lnTo>
                      <a:pt x="11591" y="52"/>
                    </a:lnTo>
                    <a:lnTo>
                      <a:pt x="11606" y="57"/>
                    </a:lnTo>
                    <a:lnTo>
                      <a:pt x="11620" y="57"/>
                    </a:lnTo>
                    <a:lnTo>
                      <a:pt x="11634" y="68"/>
                    </a:lnTo>
                    <a:lnTo>
                      <a:pt x="11648" y="53"/>
                    </a:lnTo>
                    <a:lnTo>
                      <a:pt x="11662" y="70"/>
                    </a:lnTo>
                    <a:lnTo>
                      <a:pt x="11676" y="65"/>
                    </a:lnTo>
                    <a:lnTo>
                      <a:pt x="11690" y="54"/>
                    </a:lnTo>
                    <a:lnTo>
                      <a:pt x="11704" y="43"/>
                    </a:lnTo>
                    <a:lnTo>
                      <a:pt x="11718" y="58"/>
                    </a:lnTo>
                    <a:lnTo>
                      <a:pt x="11733" y="38"/>
                    </a:lnTo>
                    <a:lnTo>
                      <a:pt x="11747" y="34"/>
                    </a:lnTo>
                    <a:lnTo>
                      <a:pt x="11761" y="47"/>
                    </a:lnTo>
                    <a:lnTo>
                      <a:pt x="11775" y="37"/>
                    </a:lnTo>
                    <a:lnTo>
                      <a:pt x="11789" y="52"/>
                    </a:lnTo>
                    <a:lnTo>
                      <a:pt x="11803" y="37"/>
                    </a:lnTo>
                    <a:lnTo>
                      <a:pt x="11817" y="39"/>
                    </a:lnTo>
                    <a:lnTo>
                      <a:pt x="11831" y="47"/>
                    </a:lnTo>
                    <a:lnTo>
                      <a:pt x="11845" y="44"/>
                    </a:lnTo>
                    <a:lnTo>
                      <a:pt x="11860" y="30"/>
                    </a:lnTo>
                    <a:lnTo>
                      <a:pt x="11874" y="43"/>
                    </a:lnTo>
                    <a:lnTo>
                      <a:pt x="11888" y="45"/>
                    </a:lnTo>
                    <a:lnTo>
                      <a:pt x="11902" y="45"/>
                    </a:lnTo>
                    <a:lnTo>
                      <a:pt x="11916" y="46"/>
                    </a:lnTo>
                    <a:lnTo>
                      <a:pt x="11930" y="41"/>
                    </a:lnTo>
                    <a:lnTo>
                      <a:pt x="11944" y="38"/>
                    </a:lnTo>
                    <a:lnTo>
                      <a:pt x="11958" y="38"/>
                    </a:lnTo>
                    <a:lnTo>
                      <a:pt x="11973" y="42"/>
                    </a:lnTo>
                    <a:lnTo>
                      <a:pt x="11987" y="62"/>
                    </a:lnTo>
                    <a:lnTo>
                      <a:pt x="12001" y="34"/>
                    </a:lnTo>
                    <a:lnTo>
                      <a:pt x="12015" y="51"/>
                    </a:lnTo>
                    <a:lnTo>
                      <a:pt x="12029" y="50"/>
                    </a:lnTo>
                    <a:lnTo>
                      <a:pt x="12043" y="54"/>
                    </a:lnTo>
                    <a:lnTo>
                      <a:pt x="12057" y="59"/>
                    </a:lnTo>
                    <a:lnTo>
                      <a:pt x="12071" y="47"/>
                    </a:lnTo>
                    <a:lnTo>
                      <a:pt x="12085" y="63"/>
                    </a:lnTo>
                    <a:lnTo>
                      <a:pt x="12100" y="38"/>
                    </a:lnTo>
                    <a:lnTo>
                      <a:pt x="12114" y="65"/>
                    </a:lnTo>
                    <a:lnTo>
                      <a:pt x="12128" y="59"/>
                    </a:lnTo>
                    <a:lnTo>
                      <a:pt x="12142" y="58"/>
                    </a:lnTo>
                    <a:lnTo>
                      <a:pt x="12156" y="95"/>
                    </a:lnTo>
                    <a:lnTo>
                      <a:pt x="12170" y="129"/>
                    </a:lnTo>
                    <a:lnTo>
                      <a:pt x="12184" y="103"/>
                    </a:lnTo>
                    <a:lnTo>
                      <a:pt x="12198" y="119"/>
                    </a:lnTo>
                    <a:lnTo>
                      <a:pt x="12212" y="156"/>
                    </a:lnTo>
                    <a:lnTo>
                      <a:pt x="12227" y="130"/>
                    </a:lnTo>
                    <a:lnTo>
                      <a:pt x="12241" y="183"/>
                    </a:lnTo>
                    <a:lnTo>
                      <a:pt x="12255" y="319"/>
                    </a:lnTo>
                    <a:lnTo>
                      <a:pt x="12269" y="426"/>
                    </a:lnTo>
                    <a:lnTo>
                      <a:pt x="12283" y="681"/>
                    </a:lnTo>
                    <a:lnTo>
                      <a:pt x="12297" y="985"/>
                    </a:lnTo>
                    <a:lnTo>
                      <a:pt x="12311" y="1446"/>
                    </a:lnTo>
                    <a:lnTo>
                      <a:pt x="12325" y="2129"/>
                    </a:lnTo>
                    <a:lnTo>
                      <a:pt x="12339" y="2723"/>
                    </a:lnTo>
                    <a:lnTo>
                      <a:pt x="12354" y="3381"/>
                    </a:lnTo>
                    <a:lnTo>
                      <a:pt x="12368" y="4091"/>
                    </a:lnTo>
                    <a:lnTo>
                      <a:pt x="12382" y="4574"/>
                    </a:lnTo>
                    <a:lnTo>
                      <a:pt x="12396" y="5078"/>
                    </a:lnTo>
                    <a:lnTo>
                      <a:pt x="12410" y="5535"/>
                    </a:lnTo>
                    <a:lnTo>
                      <a:pt x="12424" y="5502"/>
                    </a:lnTo>
                    <a:lnTo>
                      <a:pt x="12438" y="5203"/>
                    </a:lnTo>
                    <a:lnTo>
                      <a:pt x="12452" y="4563"/>
                    </a:lnTo>
                    <a:lnTo>
                      <a:pt x="12466" y="4139"/>
                    </a:lnTo>
                    <a:lnTo>
                      <a:pt x="12481" y="3561"/>
                    </a:lnTo>
                    <a:lnTo>
                      <a:pt x="12495" y="2946"/>
                    </a:lnTo>
                    <a:lnTo>
                      <a:pt x="12509" y="2311"/>
                    </a:lnTo>
                    <a:lnTo>
                      <a:pt x="12523" y="1999"/>
                    </a:lnTo>
                    <a:lnTo>
                      <a:pt x="12537" y="1682"/>
                    </a:lnTo>
                    <a:lnTo>
                      <a:pt x="12551" y="1431"/>
                    </a:lnTo>
                    <a:lnTo>
                      <a:pt x="12565" y="1212"/>
                    </a:lnTo>
                    <a:lnTo>
                      <a:pt x="12579" y="1109"/>
                    </a:lnTo>
                    <a:lnTo>
                      <a:pt x="12593" y="967"/>
                    </a:lnTo>
                    <a:lnTo>
                      <a:pt x="12608" y="899"/>
                    </a:lnTo>
                    <a:lnTo>
                      <a:pt x="12622" y="799"/>
                    </a:lnTo>
                    <a:lnTo>
                      <a:pt x="12636" y="691"/>
                    </a:lnTo>
                    <a:lnTo>
                      <a:pt x="12650" y="630"/>
                    </a:lnTo>
                    <a:lnTo>
                      <a:pt x="12664" y="605"/>
                    </a:lnTo>
                    <a:lnTo>
                      <a:pt x="12678" y="515"/>
                    </a:lnTo>
                    <a:lnTo>
                      <a:pt x="12692" y="487"/>
                    </a:lnTo>
                    <a:lnTo>
                      <a:pt x="12706" y="383"/>
                    </a:lnTo>
                    <a:lnTo>
                      <a:pt x="12721" y="378"/>
                    </a:lnTo>
                    <a:lnTo>
                      <a:pt x="12735" y="324"/>
                    </a:lnTo>
                    <a:lnTo>
                      <a:pt x="12749" y="299"/>
                    </a:lnTo>
                    <a:lnTo>
                      <a:pt x="12763" y="290"/>
                    </a:lnTo>
                    <a:lnTo>
                      <a:pt x="12777" y="288"/>
                    </a:lnTo>
                    <a:lnTo>
                      <a:pt x="12791" y="248"/>
                    </a:lnTo>
                    <a:lnTo>
                      <a:pt x="12805" y="217"/>
                    </a:lnTo>
                    <a:lnTo>
                      <a:pt x="12819" y="230"/>
                    </a:lnTo>
                    <a:lnTo>
                      <a:pt x="12833" y="243"/>
                    </a:lnTo>
                    <a:lnTo>
                      <a:pt x="12848" y="200"/>
                    </a:lnTo>
                    <a:lnTo>
                      <a:pt x="12862" y="221"/>
                    </a:lnTo>
                    <a:lnTo>
                      <a:pt x="12876" y="242"/>
                    </a:lnTo>
                    <a:lnTo>
                      <a:pt x="12890" y="262"/>
                    </a:lnTo>
                    <a:lnTo>
                      <a:pt x="12904" y="283"/>
                    </a:lnTo>
                    <a:lnTo>
                      <a:pt x="12918" y="328"/>
                    </a:lnTo>
                    <a:lnTo>
                      <a:pt x="12932" y="388"/>
                    </a:lnTo>
                    <a:lnTo>
                      <a:pt x="12946" y="406"/>
                    </a:lnTo>
                    <a:lnTo>
                      <a:pt x="12960" y="435"/>
                    </a:lnTo>
                    <a:lnTo>
                      <a:pt x="12975" y="525"/>
                    </a:lnTo>
                    <a:lnTo>
                      <a:pt x="12989" y="522"/>
                    </a:lnTo>
                    <a:lnTo>
                      <a:pt x="13003" y="563"/>
                    </a:lnTo>
                    <a:lnTo>
                      <a:pt x="13017" y="536"/>
                    </a:lnTo>
                    <a:lnTo>
                      <a:pt x="13031" y="572"/>
                    </a:lnTo>
                    <a:lnTo>
                      <a:pt x="13045" y="526"/>
                    </a:lnTo>
                    <a:lnTo>
                      <a:pt x="13059" y="556"/>
                    </a:lnTo>
                    <a:lnTo>
                      <a:pt x="13073" y="520"/>
                    </a:lnTo>
                    <a:lnTo>
                      <a:pt x="13087" y="599"/>
                    </a:lnTo>
                    <a:lnTo>
                      <a:pt x="13102" y="481"/>
                    </a:lnTo>
                    <a:lnTo>
                      <a:pt x="13116" y="484"/>
                    </a:lnTo>
                    <a:lnTo>
                      <a:pt x="13130" y="478"/>
                    </a:lnTo>
                    <a:lnTo>
                      <a:pt x="13144" y="457"/>
                    </a:lnTo>
                    <a:lnTo>
                      <a:pt x="13158" y="432"/>
                    </a:lnTo>
                    <a:lnTo>
                      <a:pt x="13172" y="365"/>
                    </a:lnTo>
                    <a:lnTo>
                      <a:pt x="13186" y="355"/>
                    </a:lnTo>
                    <a:lnTo>
                      <a:pt x="13200" y="316"/>
                    </a:lnTo>
                    <a:lnTo>
                      <a:pt x="13214" y="290"/>
                    </a:lnTo>
                    <a:lnTo>
                      <a:pt x="13229" y="307"/>
                    </a:lnTo>
                    <a:lnTo>
                      <a:pt x="13243" y="263"/>
                    </a:lnTo>
                    <a:lnTo>
                      <a:pt x="13257" y="271"/>
                    </a:lnTo>
                    <a:lnTo>
                      <a:pt x="13271" y="237"/>
                    </a:lnTo>
                    <a:lnTo>
                      <a:pt x="13285" y="276"/>
                    </a:lnTo>
                    <a:lnTo>
                      <a:pt x="13299" y="214"/>
                    </a:lnTo>
                    <a:lnTo>
                      <a:pt x="13301" y="213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2" name="Freeform 161"/>
              <p:cNvSpPr>
                <a:spLocks/>
              </p:cNvSpPr>
              <p:nvPr/>
            </p:nvSpPr>
            <p:spPr bwMode="auto">
              <a:xfrm flipV="1">
                <a:off x="791" y="1742"/>
                <a:ext cx="3017" cy="316"/>
              </a:xfrm>
              <a:custGeom>
                <a:avLst/>
                <a:gdLst>
                  <a:gd name="T0" fmla="*/ 188 w 13301"/>
                  <a:gd name="T1" fmla="*/ 127 h 3425"/>
                  <a:gd name="T2" fmla="*/ 399 w 13301"/>
                  <a:gd name="T3" fmla="*/ 37 h 3425"/>
                  <a:gd name="T4" fmla="*/ 611 w 13301"/>
                  <a:gd name="T5" fmla="*/ 33 h 3425"/>
                  <a:gd name="T6" fmla="*/ 823 w 13301"/>
                  <a:gd name="T7" fmla="*/ 28 h 3425"/>
                  <a:gd name="T8" fmla="*/ 1035 w 13301"/>
                  <a:gd name="T9" fmla="*/ 58 h 3425"/>
                  <a:gd name="T10" fmla="*/ 1246 w 13301"/>
                  <a:gd name="T11" fmla="*/ 45 h 3425"/>
                  <a:gd name="T12" fmla="*/ 1458 w 13301"/>
                  <a:gd name="T13" fmla="*/ 50 h 3425"/>
                  <a:gd name="T14" fmla="*/ 1670 w 13301"/>
                  <a:gd name="T15" fmla="*/ 76 h 3425"/>
                  <a:gd name="T16" fmla="*/ 1881 w 13301"/>
                  <a:gd name="T17" fmla="*/ 44 h 3425"/>
                  <a:gd name="T18" fmla="*/ 2093 w 13301"/>
                  <a:gd name="T19" fmla="*/ 23 h 3425"/>
                  <a:gd name="T20" fmla="*/ 2305 w 13301"/>
                  <a:gd name="T21" fmla="*/ 66 h 3425"/>
                  <a:gd name="T22" fmla="*/ 2516 w 13301"/>
                  <a:gd name="T23" fmla="*/ 62 h 3425"/>
                  <a:gd name="T24" fmla="*/ 2728 w 13301"/>
                  <a:gd name="T25" fmla="*/ 327 h 3425"/>
                  <a:gd name="T26" fmla="*/ 2940 w 13301"/>
                  <a:gd name="T27" fmla="*/ 216 h 3425"/>
                  <a:gd name="T28" fmla="*/ 3152 w 13301"/>
                  <a:gd name="T29" fmla="*/ 170 h 3425"/>
                  <a:gd name="T30" fmla="*/ 3363 w 13301"/>
                  <a:gd name="T31" fmla="*/ 150 h 3425"/>
                  <a:gd name="T32" fmla="*/ 3575 w 13301"/>
                  <a:gd name="T33" fmla="*/ 90 h 3425"/>
                  <a:gd name="T34" fmla="*/ 3787 w 13301"/>
                  <a:gd name="T35" fmla="*/ 79 h 3425"/>
                  <a:gd name="T36" fmla="*/ 3998 w 13301"/>
                  <a:gd name="T37" fmla="*/ 58 h 3425"/>
                  <a:gd name="T38" fmla="*/ 4210 w 13301"/>
                  <a:gd name="T39" fmla="*/ 72 h 3425"/>
                  <a:gd name="T40" fmla="*/ 4422 w 13301"/>
                  <a:gd name="T41" fmla="*/ 115 h 3425"/>
                  <a:gd name="T42" fmla="*/ 4633 w 13301"/>
                  <a:gd name="T43" fmla="*/ 57 h 3425"/>
                  <a:gd name="T44" fmla="*/ 4845 w 13301"/>
                  <a:gd name="T45" fmla="*/ 33 h 3425"/>
                  <a:gd name="T46" fmla="*/ 5057 w 13301"/>
                  <a:gd name="T47" fmla="*/ 31 h 3425"/>
                  <a:gd name="T48" fmla="*/ 5269 w 13301"/>
                  <a:gd name="T49" fmla="*/ 164 h 3425"/>
                  <a:gd name="T50" fmla="*/ 5480 w 13301"/>
                  <a:gd name="T51" fmla="*/ 77 h 3425"/>
                  <a:gd name="T52" fmla="*/ 5692 w 13301"/>
                  <a:gd name="T53" fmla="*/ 39 h 3425"/>
                  <a:gd name="T54" fmla="*/ 5904 w 13301"/>
                  <a:gd name="T55" fmla="*/ 9 h 3425"/>
                  <a:gd name="T56" fmla="*/ 6115 w 13301"/>
                  <a:gd name="T57" fmla="*/ 59 h 3425"/>
                  <a:gd name="T58" fmla="*/ 6327 w 13301"/>
                  <a:gd name="T59" fmla="*/ 34 h 3425"/>
                  <a:gd name="T60" fmla="*/ 6539 w 13301"/>
                  <a:gd name="T61" fmla="*/ 25 h 3425"/>
                  <a:gd name="T62" fmla="*/ 6750 w 13301"/>
                  <a:gd name="T63" fmla="*/ 27 h 3425"/>
                  <a:gd name="T64" fmla="*/ 6962 w 13301"/>
                  <a:gd name="T65" fmla="*/ 27 h 3425"/>
                  <a:gd name="T66" fmla="*/ 7174 w 13301"/>
                  <a:gd name="T67" fmla="*/ 23 h 3425"/>
                  <a:gd name="T68" fmla="*/ 7386 w 13301"/>
                  <a:gd name="T69" fmla="*/ 23 h 3425"/>
                  <a:gd name="T70" fmla="*/ 7597 w 13301"/>
                  <a:gd name="T71" fmla="*/ 17 h 3425"/>
                  <a:gd name="T72" fmla="*/ 7809 w 13301"/>
                  <a:gd name="T73" fmla="*/ 44 h 3425"/>
                  <a:gd name="T74" fmla="*/ 8021 w 13301"/>
                  <a:gd name="T75" fmla="*/ 19 h 3425"/>
                  <a:gd name="T76" fmla="*/ 8232 w 13301"/>
                  <a:gd name="T77" fmla="*/ 12 h 3425"/>
                  <a:gd name="T78" fmla="*/ 8444 w 13301"/>
                  <a:gd name="T79" fmla="*/ 33 h 3425"/>
                  <a:gd name="T80" fmla="*/ 8656 w 13301"/>
                  <a:gd name="T81" fmla="*/ 90 h 3425"/>
                  <a:gd name="T82" fmla="*/ 8868 w 13301"/>
                  <a:gd name="T83" fmla="*/ 249 h 3425"/>
                  <a:gd name="T84" fmla="*/ 9079 w 13301"/>
                  <a:gd name="T85" fmla="*/ 108 h 3425"/>
                  <a:gd name="T86" fmla="*/ 9291 w 13301"/>
                  <a:gd name="T87" fmla="*/ 87 h 3425"/>
                  <a:gd name="T88" fmla="*/ 9503 w 13301"/>
                  <a:gd name="T89" fmla="*/ 83 h 3425"/>
                  <a:gd name="T90" fmla="*/ 9714 w 13301"/>
                  <a:gd name="T91" fmla="*/ 99 h 3425"/>
                  <a:gd name="T92" fmla="*/ 9926 w 13301"/>
                  <a:gd name="T93" fmla="*/ 70 h 3425"/>
                  <a:gd name="T94" fmla="*/ 10138 w 13301"/>
                  <a:gd name="T95" fmla="*/ 53 h 3425"/>
                  <a:gd name="T96" fmla="*/ 10349 w 13301"/>
                  <a:gd name="T97" fmla="*/ 61 h 3425"/>
                  <a:gd name="T98" fmla="*/ 10561 w 13301"/>
                  <a:gd name="T99" fmla="*/ 35 h 3425"/>
                  <a:gd name="T100" fmla="*/ 10773 w 13301"/>
                  <a:gd name="T101" fmla="*/ 40 h 3425"/>
                  <a:gd name="T102" fmla="*/ 10985 w 13301"/>
                  <a:gd name="T103" fmla="*/ 95 h 3425"/>
                  <a:gd name="T104" fmla="*/ 11196 w 13301"/>
                  <a:gd name="T105" fmla="*/ 38 h 3425"/>
                  <a:gd name="T106" fmla="*/ 11408 w 13301"/>
                  <a:gd name="T107" fmla="*/ 62 h 3425"/>
                  <a:gd name="T108" fmla="*/ 11620 w 13301"/>
                  <a:gd name="T109" fmla="*/ 39 h 3425"/>
                  <a:gd name="T110" fmla="*/ 11831 w 13301"/>
                  <a:gd name="T111" fmla="*/ 38 h 3425"/>
                  <a:gd name="T112" fmla="*/ 12043 w 13301"/>
                  <a:gd name="T113" fmla="*/ 41 h 3425"/>
                  <a:gd name="T114" fmla="*/ 12255 w 13301"/>
                  <a:gd name="T115" fmla="*/ 193 h 3425"/>
                  <a:gd name="T116" fmla="*/ 12466 w 13301"/>
                  <a:gd name="T117" fmla="*/ 2741 h 3425"/>
                  <a:gd name="T118" fmla="*/ 12678 w 13301"/>
                  <a:gd name="T119" fmla="*/ 360 h 3425"/>
                  <a:gd name="T120" fmla="*/ 12890 w 13301"/>
                  <a:gd name="T121" fmla="*/ 195 h 3425"/>
                  <a:gd name="T122" fmla="*/ 13102 w 13301"/>
                  <a:gd name="T123" fmla="*/ 117 h 3425"/>
                  <a:gd name="T124" fmla="*/ 13301 w 13301"/>
                  <a:gd name="T125" fmla="*/ 72 h 34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  <a:cxn ang="0">
                    <a:pos x="T122" y="T123"/>
                  </a:cxn>
                  <a:cxn ang="0">
                    <a:pos x="T124" y="T125"/>
                  </a:cxn>
                </a:cxnLst>
                <a:rect l="0" t="0" r="r" b="b"/>
                <a:pathLst>
                  <a:path w="13301" h="3425">
                    <a:moveTo>
                      <a:pt x="0" y="40"/>
                    </a:moveTo>
                    <a:lnTo>
                      <a:pt x="4" y="33"/>
                    </a:lnTo>
                    <a:lnTo>
                      <a:pt x="18" y="54"/>
                    </a:lnTo>
                    <a:lnTo>
                      <a:pt x="33" y="30"/>
                    </a:lnTo>
                    <a:lnTo>
                      <a:pt x="47" y="57"/>
                    </a:lnTo>
                    <a:lnTo>
                      <a:pt x="61" y="37"/>
                    </a:lnTo>
                    <a:lnTo>
                      <a:pt x="75" y="74"/>
                    </a:lnTo>
                    <a:lnTo>
                      <a:pt x="89" y="65"/>
                    </a:lnTo>
                    <a:lnTo>
                      <a:pt x="103" y="65"/>
                    </a:lnTo>
                    <a:lnTo>
                      <a:pt x="117" y="64"/>
                    </a:lnTo>
                    <a:lnTo>
                      <a:pt x="131" y="81"/>
                    </a:lnTo>
                    <a:lnTo>
                      <a:pt x="145" y="94"/>
                    </a:lnTo>
                    <a:lnTo>
                      <a:pt x="160" y="125"/>
                    </a:lnTo>
                    <a:lnTo>
                      <a:pt x="174" y="131"/>
                    </a:lnTo>
                    <a:lnTo>
                      <a:pt x="188" y="127"/>
                    </a:lnTo>
                    <a:lnTo>
                      <a:pt x="202" y="122"/>
                    </a:lnTo>
                    <a:lnTo>
                      <a:pt x="216" y="96"/>
                    </a:lnTo>
                    <a:lnTo>
                      <a:pt x="230" y="103"/>
                    </a:lnTo>
                    <a:lnTo>
                      <a:pt x="244" y="115"/>
                    </a:lnTo>
                    <a:lnTo>
                      <a:pt x="258" y="109"/>
                    </a:lnTo>
                    <a:lnTo>
                      <a:pt x="272" y="89"/>
                    </a:lnTo>
                    <a:lnTo>
                      <a:pt x="287" y="81"/>
                    </a:lnTo>
                    <a:lnTo>
                      <a:pt x="301" y="70"/>
                    </a:lnTo>
                    <a:lnTo>
                      <a:pt x="315" y="76"/>
                    </a:lnTo>
                    <a:lnTo>
                      <a:pt x="329" y="61"/>
                    </a:lnTo>
                    <a:lnTo>
                      <a:pt x="343" y="64"/>
                    </a:lnTo>
                    <a:lnTo>
                      <a:pt x="357" y="66"/>
                    </a:lnTo>
                    <a:lnTo>
                      <a:pt x="371" y="53"/>
                    </a:lnTo>
                    <a:lnTo>
                      <a:pt x="385" y="37"/>
                    </a:lnTo>
                    <a:lnTo>
                      <a:pt x="399" y="37"/>
                    </a:lnTo>
                    <a:lnTo>
                      <a:pt x="414" y="46"/>
                    </a:lnTo>
                    <a:lnTo>
                      <a:pt x="428" y="49"/>
                    </a:lnTo>
                    <a:lnTo>
                      <a:pt x="442" y="45"/>
                    </a:lnTo>
                    <a:lnTo>
                      <a:pt x="456" y="31"/>
                    </a:lnTo>
                    <a:lnTo>
                      <a:pt x="470" y="20"/>
                    </a:lnTo>
                    <a:lnTo>
                      <a:pt x="484" y="38"/>
                    </a:lnTo>
                    <a:lnTo>
                      <a:pt x="498" y="46"/>
                    </a:lnTo>
                    <a:lnTo>
                      <a:pt x="512" y="39"/>
                    </a:lnTo>
                    <a:lnTo>
                      <a:pt x="526" y="37"/>
                    </a:lnTo>
                    <a:lnTo>
                      <a:pt x="541" y="38"/>
                    </a:lnTo>
                    <a:lnTo>
                      <a:pt x="555" y="39"/>
                    </a:lnTo>
                    <a:lnTo>
                      <a:pt x="569" y="43"/>
                    </a:lnTo>
                    <a:lnTo>
                      <a:pt x="583" y="37"/>
                    </a:lnTo>
                    <a:lnTo>
                      <a:pt x="597" y="19"/>
                    </a:lnTo>
                    <a:lnTo>
                      <a:pt x="611" y="33"/>
                    </a:lnTo>
                    <a:lnTo>
                      <a:pt x="625" y="24"/>
                    </a:lnTo>
                    <a:lnTo>
                      <a:pt x="639" y="50"/>
                    </a:lnTo>
                    <a:lnTo>
                      <a:pt x="653" y="35"/>
                    </a:lnTo>
                    <a:lnTo>
                      <a:pt x="668" y="20"/>
                    </a:lnTo>
                    <a:lnTo>
                      <a:pt x="682" y="17"/>
                    </a:lnTo>
                    <a:lnTo>
                      <a:pt x="696" y="32"/>
                    </a:lnTo>
                    <a:lnTo>
                      <a:pt x="710" y="37"/>
                    </a:lnTo>
                    <a:lnTo>
                      <a:pt x="724" y="36"/>
                    </a:lnTo>
                    <a:lnTo>
                      <a:pt x="738" y="25"/>
                    </a:lnTo>
                    <a:lnTo>
                      <a:pt x="752" y="17"/>
                    </a:lnTo>
                    <a:lnTo>
                      <a:pt x="766" y="47"/>
                    </a:lnTo>
                    <a:lnTo>
                      <a:pt x="781" y="27"/>
                    </a:lnTo>
                    <a:lnTo>
                      <a:pt x="795" y="34"/>
                    </a:lnTo>
                    <a:lnTo>
                      <a:pt x="809" y="32"/>
                    </a:lnTo>
                    <a:lnTo>
                      <a:pt x="823" y="28"/>
                    </a:lnTo>
                    <a:lnTo>
                      <a:pt x="837" y="53"/>
                    </a:lnTo>
                    <a:lnTo>
                      <a:pt x="851" y="48"/>
                    </a:lnTo>
                    <a:lnTo>
                      <a:pt x="865" y="60"/>
                    </a:lnTo>
                    <a:lnTo>
                      <a:pt x="879" y="59"/>
                    </a:lnTo>
                    <a:lnTo>
                      <a:pt x="893" y="63"/>
                    </a:lnTo>
                    <a:lnTo>
                      <a:pt x="908" y="77"/>
                    </a:lnTo>
                    <a:lnTo>
                      <a:pt x="922" y="50"/>
                    </a:lnTo>
                    <a:lnTo>
                      <a:pt x="936" y="61"/>
                    </a:lnTo>
                    <a:lnTo>
                      <a:pt x="950" y="66"/>
                    </a:lnTo>
                    <a:lnTo>
                      <a:pt x="964" y="52"/>
                    </a:lnTo>
                    <a:lnTo>
                      <a:pt x="978" y="43"/>
                    </a:lnTo>
                    <a:lnTo>
                      <a:pt x="992" y="61"/>
                    </a:lnTo>
                    <a:lnTo>
                      <a:pt x="1006" y="44"/>
                    </a:lnTo>
                    <a:lnTo>
                      <a:pt x="1020" y="44"/>
                    </a:lnTo>
                    <a:lnTo>
                      <a:pt x="1035" y="58"/>
                    </a:lnTo>
                    <a:lnTo>
                      <a:pt x="1049" y="46"/>
                    </a:lnTo>
                    <a:lnTo>
                      <a:pt x="1063" y="50"/>
                    </a:lnTo>
                    <a:lnTo>
                      <a:pt x="1077" y="29"/>
                    </a:lnTo>
                    <a:lnTo>
                      <a:pt x="1091" y="29"/>
                    </a:lnTo>
                    <a:lnTo>
                      <a:pt x="1105" y="30"/>
                    </a:lnTo>
                    <a:lnTo>
                      <a:pt x="1119" y="35"/>
                    </a:lnTo>
                    <a:lnTo>
                      <a:pt x="1133" y="34"/>
                    </a:lnTo>
                    <a:lnTo>
                      <a:pt x="1147" y="34"/>
                    </a:lnTo>
                    <a:lnTo>
                      <a:pt x="1162" y="48"/>
                    </a:lnTo>
                    <a:lnTo>
                      <a:pt x="1176" y="43"/>
                    </a:lnTo>
                    <a:lnTo>
                      <a:pt x="1190" y="20"/>
                    </a:lnTo>
                    <a:lnTo>
                      <a:pt x="1204" y="19"/>
                    </a:lnTo>
                    <a:lnTo>
                      <a:pt x="1218" y="31"/>
                    </a:lnTo>
                    <a:lnTo>
                      <a:pt x="1232" y="39"/>
                    </a:lnTo>
                    <a:lnTo>
                      <a:pt x="1246" y="45"/>
                    </a:lnTo>
                    <a:lnTo>
                      <a:pt x="1260" y="43"/>
                    </a:lnTo>
                    <a:lnTo>
                      <a:pt x="1274" y="38"/>
                    </a:lnTo>
                    <a:lnTo>
                      <a:pt x="1289" y="31"/>
                    </a:lnTo>
                    <a:lnTo>
                      <a:pt x="1303" y="60"/>
                    </a:lnTo>
                    <a:lnTo>
                      <a:pt x="1317" y="20"/>
                    </a:lnTo>
                    <a:lnTo>
                      <a:pt x="1331" y="29"/>
                    </a:lnTo>
                    <a:lnTo>
                      <a:pt x="1345" y="31"/>
                    </a:lnTo>
                    <a:lnTo>
                      <a:pt x="1359" y="29"/>
                    </a:lnTo>
                    <a:lnTo>
                      <a:pt x="1373" y="30"/>
                    </a:lnTo>
                    <a:lnTo>
                      <a:pt x="1387" y="34"/>
                    </a:lnTo>
                    <a:lnTo>
                      <a:pt x="1402" y="42"/>
                    </a:lnTo>
                    <a:lnTo>
                      <a:pt x="1416" y="40"/>
                    </a:lnTo>
                    <a:lnTo>
                      <a:pt x="1430" y="40"/>
                    </a:lnTo>
                    <a:lnTo>
                      <a:pt x="1444" y="57"/>
                    </a:lnTo>
                    <a:lnTo>
                      <a:pt x="1458" y="50"/>
                    </a:lnTo>
                    <a:lnTo>
                      <a:pt x="1472" y="43"/>
                    </a:lnTo>
                    <a:lnTo>
                      <a:pt x="1486" y="41"/>
                    </a:lnTo>
                    <a:lnTo>
                      <a:pt x="1500" y="35"/>
                    </a:lnTo>
                    <a:lnTo>
                      <a:pt x="1514" y="69"/>
                    </a:lnTo>
                    <a:lnTo>
                      <a:pt x="1529" y="84"/>
                    </a:lnTo>
                    <a:lnTo>
                      <a:pt x="1543" y="78"/>
                    </a:lnTo>
                    <a:lnTo>
                      <a:pt x="1557" y="99"/>
                    </a:lnTo>
                    <a:lnTo>
                      <a:pt x="1571" y="82"/>
                    </a:lnTo>
                    <a:lnTo>
                      <a:pt x="1585" y="102"/>
                    </a:lnTo>
                    <a:lnTo>
                      <a:pt x="1599" y="93"/>
                    </a:lnTo>
                    <a:lnTo>
                      <a:pt x="1613" y="95"/>
                    </a:lnTo>
                    <a:lnTo>
                      <a:pt x="1627" y="91"/>
                    </a:lnTo>
                    <a:lnTo>
                      <a:pt x="1641" y="89"/>
                    </a:lnTo>
                    <a:lnTo>
                      <a:pt x="1656" y="73"/>
                    </a:lnTo>
                    <a:lnTo>
                      <a:pt x="1670" y="76"/>
                    </a:lnTo>
                    <a:lnTo>
                      <a:pt x="1684" y="77"/>
                    </a:lnTo>
                    <a:lnTo>
                      <a:pt x="1698" y="68"/>
                    </a:lnTo>
                    <a:lnTo>
                      <a:pt x="1712" y="64"/>
                    </a:lnTo>
                    <a:lnTo>
                      <a:pt x="1726" y="72"/>
                    </a:lnTo>
                    <a:lnTo>
                      <a:pt x="1740" y="52"/>
                    </a:lnTo>
                    <a:lnTo>
                      <a:pt x="1754" y="52"/>
                    </a:lnTo>
                    <a:lnTo>
                      <a:pt x="1768" y="56"/>
                    </a:lnTo>
                    <a:lnTo>
                      <a:pt x="1783" y="58"/>
                    </a:lnTo>
                    <a:lnTo>
                      <a:pt x="1797" y="46"/>
                    </a:lnTo>
                    <a:lnTo>
                      <a:pt x="1811" y="55"/>
                    </a:lnTo>
                    <a:lnTo>
                      <a:pt x="1825" y="75"/>
                    </a:lnTo>
                    <a:lnTo>
                      <a:pt x="1839" y="40"/>
                    </a:lnTo>
                    <a:lnTo>
                      <a:pt x="1853" y="43"/>
                    </a:lnTo>
                    <a:lnTo>
                      <a:pt x="1867" y="55"/>
                    </a:lnTo>
                    <a:lnTo>
                      <a:pt x="1881" y="44"/>
                    </a:lnTo>
                    <a:lnTo>
                      <a:pt x="1895" y="47"/>
                    </a:lnTo>
                    <a:lnTo>
                      <a:pt x="1910" y="40"/>
                    </a:lnTo>
                    <a:lnTo>
                      <a:pt x="1924" y="59"/>
                    </a:lnTo>
                    <a:lnTo>
                      <a:pt x="1938" y="33"/>
                    </a:lnTo>
                    <a:lnTo>
                      <a:pt x="1952" y="26"/>
                    </a:lnTo>
                    <a:lnTo>
                      <a:pt x="1966" y="48"/>
                    </a:lnTo>
                    <a:lnTo>
                      <a:pt x="1980" y="70"/>
                    </a:lnTo>
                    <a:lnTo>
                      <a:pt x="1994" y="42"/>
                    </a:lnTo>
                    <a:lnTo>
                      <a:pt x="2008" y="20"/>
                    </a:lnTo>
                    <a:lnTo>
                      <a:pt x="2022" y="41"/>
                    </a:lnTo>
                    <a:lnTo>
                      <a:pt x="2037" y="30"/>
                    </a:lnTo>
                    <a:lnTo>
                      <a:pt x="2051" y="26"/>
                    </a:lnTo>
                    <a:lnTo>
                      <a:pt x="2065" y="45"/>
                    </a:lnTo>
                    <a:lnTo>
                      <a:pt x="2079" y="57"/>
                    </a:lnTo>
                    <a:lnTo>
                      <a:pt x="2093" y="23"/>
                    </a:lnTo>
                    <a:lnTo>
                      <a:pt x="2107" y="47"/>
                    </a:lnTo>
                    <a:lnTo>
                      <a:pt x="2121" y="43"/>
                    </a:lnTo>
                    <a:lnTo>
                      <a:pt x="2135" y="27"/>
                    </a:lnTo>
                    <a:lnTo>
                      <a:pt x="2150" y="35"/>
                    </a:lnTo>
                    <a:lnTo>
                      <a:pt x="2164" y="52"/>
                    </a:lnTo>
                    <a:lnTo>
                      <a:pt x="2178" y="34"/>
                    </a:lnTo>
                    <a:lnTo>
                      <a:pt x="2192" y="17"/>
                    </a:lnTo>
                    <a:lnTo>
                      <a:pt x="2206" y="37"/>
                    </a:lnTo>
                    <a:lnTo>
                      <a:pt x="2220" y="35"/>
                    </a:lnTo>
                    <a:lnTo>
                      <a:pt x="2234" y="42"/>
                    </a:lnTo>
                    <a:lnTo>
                      <a:pt x="2248" y="43"/>
                    </a:lnTo>
                    <a:lnTo>
                      <a:pt x="2262" y="35"/>
                    </a:lnTo>
                    <a:lnTo>
                      <a:pt x="2277" y="62"/>
                    </a:lnTo>
                    <a:lnTo>
                      <a:pt x="2291" y="54"/>
                    </a:lnTo>
                    <a:lnTo>
                      <a:pt x="2305" y="66"/>
                    </a:lnTo>
                    <a:lnTo>
                      <a:pt x="2319" y="47"/>
                    </a:lnTo>
                    <a:lnTo>
                      <a:pt x="2333" y="51"/>
                    </a:lnTo>
                    <a:lnTo>
                      <a:pt x="2347" y="83"/>
                    </a:lnTo>
                    <a:lnTo>
                      <a:pt x="2361" y="90"/>
                    </a:lnTo>
                    <a:lnTo>
                      <a:pt x="2375" y="68"/>
                    </a:lnTo>
                    <a:lnTo>
                      <a:pt x="2389" y="80"/>
                    </a:lnTo>
                    <a:lnTo>
                      <a:pt x="2404" y="61"/>
                    </a:lnTo>
                    <a:lnTo>
                      <a:pt x="2418" y="73"/>
                    </a:lnTo>
                    <a:lnTo>
                      <a:pt x="2432" y="56"/>
                    </a:lnTo>
                    <a:lnTo>
                      <a:pt x="2446" y="51"/>
                    </a:lnTo>
                    <a:lnTo>
                      <a:pt x="2460" y="34"/>
                    </a:lnTo>
                    <a:lnTo>
                      <a:pt x="2474" y="68"/>
                    </a:lnTo>
                    <a:lnTo>
                      <a:pt x="2488" y="67"/>
                    </a:lnTo>
                    <a:lnTo>
                      <a:pt x="2502" y="69"/>
                    </a:lnTo>
                    <a:lnTo>
                      <a:pt x="2516" y="62"/>
                    </a:lnTo>
                    <a:lnTo>
                      <a:pt x="2531" y="92"/>
                    </a:lnTo>
                    <a:lnTo>
                      <a:pt x="2545" y="114"/>
                    </a:lnTo>
                    <a:lnTo>
                      <a:pt x="2559" y="150"/>
                    </a:lnTo>
                    <a:lnTo>
                      <a:pt x="2573" y="166"/>
                    </a:lnTo>
                    <a:lnTo>
                      <a:pt x="2587" y="187"/>
                    </a:lnTo>
                    <a:lnTo>
                      <a:pt x="2601" y="240"/>
                    </a:lnTo>
                    <a:lnTo>
                      <a:pt x="2615" y="249"/>
                    </a:lnTo>
                    <a:lnTo>
                      <a:pt x="2629" y="277"/>
                    </a:lnTo>
                    <a:lnTo>
                      <a:pt x="2643" y="279"/>
                    </a:lnTo>
                    <a:lnTo>
                      <a:pt x="2658" y="286"/>
                    </a:lnTo>
                    <a:lnTo>
                      <a:pt x="2672" y="364"/>
                    </a:lnTo>
                    <a:lnTo>
                      <a:pt x="2686" y="335"/>
                    </a:lnTo>
                    <a:lnTo>
                      <a:pt x="2700" y="350"/>
                    </a:lnTo>
                    <a:lnTo>
                      <a:pt x="2714" y="351"/>
                    </a:lnTo>
                    <a:lnTo>
                      <a:pt x="2728" y="327"/>
                    </a:lnTo>
                    <a:lnTo>
                      <a:pt x="2742" y="318"/>
                    </a:lnTo>
                    <a:lnTo>
                      <a:pt x="2756" y="293"/>
                    </a:lnTo>
                    <a:lnTo>
                      <a:pt x="2771" y="291"/>
                    </a:lnTo>
                    <a:lnTo>
                      <a:pt x="2785" y="277"/>
                    </a:lnTo>
                    <a:lnTo>
                      <a:pt x="2799" y="278"/>
                    </a:lnTo>
                    <a:lnTo>
                      <a:pt x="2813" y="299"/>
                    </a:lnTo>
                    <a:lnTo>
                      <a:pt x="2827" y="274"/>
                    </a:lnTo>
                    <a:lnTo>
                      <a:pt x="2841" y="243"/>
                    </a:lnTo>
                    <a:lnTo>
                      <a:pt x="2855" y="268"/>
                    </a:lnTo>
                    <a:lnTo>
                      <a:pt x="2869" y="231"/>
                    </a:lnTo>
                    <a:lnTo>
                      <a:pt x="2883" y="238"/>
                    </a:lnTo>
                    <a:lnTo>
                      <a:pt x="2898" y="229"/>
                    </a:lnTo>
                    <a:lnTo>
                      <a:pt x="2912" y="249"/>
                    </a:lnTo>
                    <a:lnTo>
                      <a:pt x="2926" y="208"/>
                    </a:lnTo>
                    <a:lnTo>
                      <a:pt x="2940" y="216"/>
                    </a:lnTo>
                    <a:lnTo>
                      <a:pt x="2954" y="204"/>
                    </a:lnTo>
                    <a:lnTo>
                      <a:pt x="2968" y="195"/>
                    </a:lnTo>
                    <a:lnTo>
                      <a:pt x="2982" y="172"/>
                    </a:lnTo>
                    <a:lnTo>
                      <a:pt x="2996" y="206"/>
                    </a:lnTo>
                    <a:lnTo>
                      <a:pt x="3010" y="202"/>
                    </a:lnTo>
                    <a:lnTo>
                      <a:pt x="3025" y="155"/>
                    </a:lnTo>
                    <a:lnTo>
                      <a:pt x="3039" y="187"/>
                    </a:lnTo>
                    <a:lnTo>
                      <a:pt x="3053" y="172"/>
                    </a:lnTo>
                    <a:lnTo>
                      <a:pt x="3067" y="171"/>
                    </a:lnTo>
                    <a:lnTo>
                      <a:pt x="3081" y="148"/>
                    </a:lnTo>
                    <a:lnTo>
                      <a:pt x="3095" y="204"/>
                    </a:lnTo>
                    <a:lnTo>
                      <a:pt x="3109" y="152"/>
                    </a:lnTo>
                    <a:lnTo>
                      <a:pt x="3123" y="147"/>
                    </a:lnTo>
                    <a:lnTo>
                      <a:pt x="3137" y="182"/>
                    </a:lnTo>
                    <a:lnTo>
                      <a:pt x="3152" y="170"/>
                    </a:lnTo>
                    <a:lnTo>
                      <a:pt x="3166" y="150"/>
                    </a:lnTo>
                    <a:lnTo>
                      <a:pt x="3180" y="171"/>
                    </a:lnTo>
                    <a:lnTo>
                      <a:pt x="3194" y="171"/>
                    </a:lnTo>
                    <a:lnTo>
                      <a:pt x="3208" y="169"/>
                    </a:lnTo>
                    <a:lnTo>
                      <a:pt x="3222" y="201"/>
                    </a:lnTo>
                    <a:lnTo>
                      <a:pt x="3236" y="166"/>
                    </a:lnTo>
                    <a:lnTo>
                      <a:pt x="3250" y="164"/>
                    </a:lnTo>
                    <a:lnTo>
                      <a:pt x="3264" y="147"/>
                    </a:lnTo>
                    <a:lnTo>
                      <a:pt x="3279" y="148"/>
                    </a:lnTo>
                    <a:lnTo>
                      <a:pt x="3293" y="123"/>
                    </a:lnTo>
                    <a:lnTo>
                      <a:pt x="3307" y="144"/>
                    </a:lnTo>
                    <a:lnTo>
                      <a:pt x="3321" y="113"/>
                    </a:lnTo>
                    <a:lnTo>
                      <a:pt x="3335" y="122"/>
                    </a:lnTo>
                    <a:lnTo>
                      <a:pt x="3349" y="150"/>
                    </a:lnTo>
                    <a:lnTo>
                      <a:pt x="3363" y="150"/>
                    </a:lnTo>
                    <a:lnTo>
                      <a:pt x="3377" y="136"/>
                    </a:lnTo>
                    <a:lnTo>
                      <a:pt x="3391" y="115"/>
                    </a:lnTo>
                    <a:lnTo>
                      <a:pt x="3406" y="115"/>
                    </a:lnTo>
                    <a:lnTo>
                      <a:pt x="3420" y="97"/>
                    </a:lnTo>
                    <a:lnTo>
                      <a:pt x="3434" y="88"/>
                    </a:lnTo>
                    <a:lnTo>
                      <a:pt x="3448" y="133"/>
                    </a:lnTo>
                    <a:lnTo>
                      <a:pt x="3462" y="101"/>
                    </a:lnTo>
                    <a:lnTo>
                      <a:pt x="3476" y="101"/>
                    </a:lnTo>
                    <a:lnTo>
                      <a:pt x="3490" y="81"/>
                    </a:lnTo>
                    <a:lnTo>
                      <a:pt x="3504" y="103"/>
                    </a:lnTo>
                    <a:lnTo>
                      <a:pt x="3519" y="103"/>
                    </a:lnTo>
                    <a:lnTo>
                      <a:pt x="3533" y="90"/>
                    </a:lnTo>
                    <a:lnTo>
                      <a:pt x="3547" y="78"/>
                    </a:lnTo>
                    <a:lnTo>
                      <a:pt x="3561" y="129"/>
                    </a:lnTo>
                    <a:lnTo>
                      <a:pt x="3575" y="90"/>
                    </a:lnTo>
                    <a:lnTo>
                      <a:pt x="3589" y="126"/>
                    </a:lnTo>
                    <a:lnTo>
                      <a:pt x="3603" y="104"/>
                    </a:lnTo>
                    <a:lnTo>
                      <a:pt x="3617" y="81"/>
                    </a:lnTo>
                    <a:lnTo>
                      <a:pt x="3631" y="78"/>
                    </a:lnTo>
                    <a:lnTo>
                      <a:pt x="3646" y="75"/>
                    </a:lnTo>
                    <a:lnTo>
                      <a:pt x="3660" y="90"/>
                    </a:lnTo>
                    <a:lnTo>
                      <a:pt x="3674" y="78"/>
                    </a:lnTo>
                    <a:lnTo>
                      <a:pt x="3688" y="92"/>
                    </a:lnTo>
                    <a:lnTo>
                      <a:pt x="3702" y="108"/>
                    </a:lnTo>
                    <a:lnTo>
                      <a:pt x="3716" y="63"/>
                    </a:lnTo>
                    <a:lnTo>
                      <a:pt x="3730" y="67"/>
                    </a:lnTo>
                    <a:lnTo>
                      <a:pt x="3744" y="74"/>
                    </a:lnTo>
                    <a:lnTo>
                      <a:pt x="3758" y="57"/>
                    </a:lnTo>
                    <a:lnTo>
                      <a:pt x="3773" y="76"/>
                    </a:lnTo>
                    <a:lnTo>
                      <a:pt x="3787" y="79"/>
                    </a:lnTo>
                    <a:lnTo>
                      <a:pt x="3801" y="82"/>
                    </a:lnTo>
                    <a:lnTo>
                      <a:pt x="3815" y="73"/>
                    </a:lnTo>
                    <a:lnTo>
                      <a:pt x="3829" y="105"/>
                    </a:lnTo>
                    <a:lnTo>
                      <a:pt x="3843" y="62"/>
                    </a:lnTo>
                    <a:lnTo>
                      <a:pt x="3857" y="81"/>
                    </a:lnTo>
                    <a:lnTo>
                      <a:pt x="3871" y="77"/>
                    </a:lnTo>
                    <a:lnTo>
                      <a:pt x="3885" y="82"/>
                    </a:lnTo>
                    <a:lnTo>
                      <a:pt x="3900" y="64"/>
                    </a:lnTo>
                    <a:lnTo>
                      <a:pt x="3914" y="64"/>
                    </a:lnTo>
                    <a:lnTo>
                      <a:pt x="3928" y="102"/>
                    </a:lnTo>
                    <a:lnTo>
                      <a:pt x="3942" y="86"/>
                    </a:lnTo>
                    <a:lnTo>
                      <a:pt x="3956" y="96"/>
                    </a:lnTo>
                    <a:lnTo>
                      <a:pt x="3970" y="78"/>
                    </a:lnTo>
                    <a:lnTo>
                      <a:pt x="3984" y="74"/>
                    </a:lnTo>
                    <a:lnTo>
                      <a:pt x="3998" y="58"/>
                    </a:lnTo>
                    <a:lnTo>
                      <a:pt x="4012" y="80"/>
                    </a:lnTo>
                    <a:lnTo>
                      <a:pt x="4027" y="75"/>
                    </a:lnTo>
                    <a:lnTo>
                      <a:pt x="4041" y="86"/>
                    </a:lnTo>
                    <a:lnTo>
                      <a:pt x="4055" y="51"/>
                    </a:lnTo>
                    <a:lnTo>
                      <a:pt x="4069" y="64"/>
                    </a:lnTo>
                    <a:lnTo>
                      <a:pt x="4083" y="82"/>
                    </a:lnTo>
                    <a:lnTo>
                      <a:pt x="4097" y="103"/>
                    </a:lnTo>
                    <a:lnTo>
                      <a:pt x="4111" y="80"/>
                    </a:lnTo>
                    <a:lnTo>
                      <a:pt x="4125" y="67"/>
                    </a:lnTo>
                    <a:lnTo>
                      <a:pt x="4140" y="50"/>
                    </a:lnTo>
                    <a:lnTo>
                      <a:pt x="4154" y="90"/>
                    </a:lnTo>
                    <a:lnTo>
                      <a:pt x="4168" y="51"/>
                    </a:lnTo>
                    <a:lnTo>
                      <a:pt x="4182" y="69"/>
                    </a:lnTo>
                    <a:lnTo>
                      <a:pt x="4196" y="72"/>
                    </a:lnTo>
                    <a:lnTo>
                      <a:pt x="4210" y="72"/>
                    </a:lnTo>
                    <a:lnTo>
                      <a:pt x="4224" y="71"/>
                    </a:lnTo>
                    <a:lnTo>
                      <a:pt x="4238" y="97"/>
                    </a:lnTo>
                    <a:lnTo>
                      <a:pt x="4252" y="74"/>
                    </a:lnTo>
                    <a:lnTo>
                      <a:pt x="4267" y="63"/>
                    </a:lnTo>
                    <a:lnTo>
                      <a:pt x="4281" y="76"/>
                    </a:lnTo>
                    <a:lnTo>
                      <a:pt x="4295" y="75"/>
                    </a:lnTo>
                    <a:lnTo>
                      <a:pt x="4309" y="72"/>
                    </a:lnTo>
                    <a:lnTo>
                      <a:pt x="4323" y="81"/>
                    </a:lnTo>
                    <a:lnTo>
                      <a:pt x="4337" y="107"/>
                    </a:lnTo>
                    <a:lnTo>
                      <a:pt x="4351" y="71"/>
                    </a:lnTo>
                    <a:lnTo>
                      <a:pt x="4365" y="104"/>
                    </a:lnTo>
                    <a:lnTo>
                      <a:pt x="4379" y="94"/>
                    </a:lnTo>
                    <a:lnTo>
                      <a:pt x="4394" y="81"/>
                    </a:lnTo>
                    <a:lnTo>
                      <a:pt x="4408" y="116"/>
                    </a:lnTo>
                    <a:lnTo>
                      <a:pt x="4422" y="115"/>
                    </a:lnTo>
                    <a:lnTo>
                      <a:pt x="4436" y="101"/>
                    </a:lnTo>
                    <a:lnTo>
                      <a:pt x="4450" y="123"/>
                    </a:lnTo>
                    <a:lnTo>
                      <a:pt x="4464" y="117"/>
                    </a:lnTo>
                    <a:lnTo>
                      <a:pt x="4478" y="119"/>
                    </a:lnTo>
                    <a:lnTo>
                      <a:pt x="4492" y="73"/>
                    </a:lnTo>
                    <a:lnTo>
                      <a:pt x="4506" y="84"/>
                    </a:lnTo>
                    <a:lnTo>
                      <a:pt x="4521" y="92"/>
                    </a:lnTo>
                    <a:lnTo>
                      <a:pt x="4535" y="81"/>
                    </a:lnTo>
                    <a:lnTo>
                      <a:pt x="4549" y="66"/>
                    </a:lnTo>
                    <a:lnTo>
                      <a:pt x="4563" y="61"/>
                    </a:lnTo>
                    <a:lnTo>
                      <a:pt x="4577" y="55"/>
                    </a:lnTo>
                    <a:lnTo>
                      <a:pt x="4591" y="80"/>
                    </a:lnTo>
                    <a:lnTo>
                      <a:pt x="4605" y="54"/>
                    </a:lnTo>
                    <a:lnTo>
                      <a:pt x="4619" y="57"/>
                    </a:lnTo>
                    <a:lnTo>
                      <a:pt x="4633" y="57"/>
                    </a:lnTo>
                    <a:lnTo>
                      <a:pt x="4648" y="36"/>
                    </a:lnTo>
                    <a:lnTo>
                      <a:pt x="4662" y="46"/>
                    </a:lnTo>
                    <a:lnTo>
                      <a:pt x="4676" y="49"/>
                    </a:lnTo>
                    <a:lnTo>
                      <a:pt x="4690" y="61"/>
                    </a:lnTo>
                    <a:lnTo>
                      <a:pt x="4704" y="38"/>
                    </a:lnTo>
                    <a:lnTo>
                      <a:pt x="4718" y="40"/>
                    </a:lnTo>
                    <a:lnTo>
                      <a:pt x="4732" y="60"/>
                    </a:lnTo>
                    <a:lnTo>
                      <a:pt x="4746" y="33"/>
                    </a:lnTo>
                    <a:lnTo>
                      <a:pt x="4760" y="46"/>
                    </a:lnTo>
                    <a:lnTo>
                      <a:pt x="4775" y="44"/>
                    </a:lnTo>
                    <a:lnTo>
                      <a:pt x="4789" y="66"/>
                    </a:lnTo>
                    <a:lnTo>
                      <a:pt x="4803" y="52"/>
                    </a:lnTo>
                    <a:lnTo>
                      <a:pt x="4817" y="49"/>
                    </a:lnTo>
                    <a:lnTo>
                      <a:pt x="4831" y="49"/>
                    </a:lnTo>
                    <a:lnTo>
                      <a:pt x="4845" y="33"/>
                    </a:lnTo>
                    <a:lnTo>
                      <a:pt x="4859" y="44"/>
                    </a:lnTo>
                    <a:lnTo>
                      <a:pt x="4873" y="40"/>
                    </a:lnTo>
                    <a:lnTo>
                      <a:pt x="4888" y="38"/>
                    </a:lnTo>
                    <a:lnTo>
                      <a:pt x="4902" y="50"/>
                    </a:lnTo>
                    <a:lnTo>
                      <a:pt x="4916" y="41"/>
                    </a:lnTo>
                    <a:lnTo>
                      <a:pt x="4930" y="56"/>
                    </a:lnTo>
                    <a:lnTo>
                      <a:pt x="4944" y="39"/>
                    </a:lnTo>
                    <a:lnTo>
                      <a:pt x="4958" y="27"/>
                    </a:lnTo>
                    <a:lnTo>
                      <a:pt x="4972" y="36"/>
                    </a:lnTo>
                    <a:lnTo>
                      <a:pt x="4986" y="32"/>
                    </a:lnTo>
                    <a:lnTo>
                      <a:pt x="5000" y="33"/>
                    </a:lnTo>
                    <a:lnTo>
                      <a:pt x="5015" y="55"/>
                    </a:lnTo>
                    <a:lnTo>
                      <a:pt x="5029" y="46"/>
                    </a:lnTo>
                    <a:lnTo>
                      <a:pt x="5043" y="38"/>
                    </a:lnTo>
                    <a:lnTo>
                      <a:pt x="5057" y="31"/>
                    </a:lnTo>
                    <a:lnTo>
                      <a:pt x="5071" y="36"/>
                    </a:lnTo>
                    <a:lnTo>
                      <a:pt x="5085" y="34"/>
                    </a:lnTo>
                    <a:lnTo>
                      <a:pt x="5099" y="41"/>
                    </a:lnTo>
                    <a:lnTo>
                      <a:pt x="5113" y="56"/>
                    </a:lnTo>
                    <a:lnTo>
                      <a:pt x="5127" y="64"/>
                    </a:lnTo>
                    <a:lnTo>
                      <a:pt x="5142" y="29"/>
                    </a:lnTo>
                    <a:lnTo>
                      <a:pt x="5156" y="37"/>
                    </a:lnTo>
                    <a:lnTo>
                      <a:pt x="5170" y="54"/>
                    </a:lnTo>
                    <a:lnTo>
                      <a:pt x="5184" y="51"/>
                    </a:lnTo>
                    <a:lnTo>
                      <a:pt x="5198" y="53"/>
                    </a:lnTo>
                    <a:lnTo>
                      <a:pt x="5212" y="63"/>
                    </a:lnTo>
                    <a:lnTo>
                      <a:pt x="5226" y="79"/>
                    </a:lnTo>
                    <a:lnTo>
                      <a:pt x="5240" y="119"/>
                    </a:lnTo>
                    <a:lnTo>
                      <a:pt x="5254" y="142"/>
                    </a:lnTo>
                    <a:lnTo>
                      <a:pt x="5269" y="164"/>
                    </a:lnTo>
                    <a:lnTo>
                      <a:pt x="5283" y="199"/>
                    </a:lnTo>
                    <a:lnTo>
                      <a:pt x="5297" y="222"/>
                    </a:lnTo>
                    <a:lnTo>
                      <a:pt x="5311" y="261"/>
                    </a:lnTo>
                    <a:lnTo>
                      <a:pt x="5325" y="268"/>
                    </a:lnTo>
                    <a:lnTo>
                      <a:pt x="5339" y="225"/>
                    </a:lnTo>
                    <a:lnTo>
                      <a:pt x="5353" y="229"/>
                    </a:lnTo>
                    <a:lnTo>
                      <a:pt x="5367" y="242"/>
                    </a:lnTo>
                    <a:lnTo>
                      <a:pt x="5381" y="225"/>
                    </a:lnTo>
                    <a:lnTo>
                      <a:pt x="5396" y="186"/>
                    </a:lnTo>
                    <a:lnTo>
                      <a:pt x="5410" y="189"/>
                    </a:lnTo>
                    <a:lnTo>
                      <a:pt x="5424" y="149"/>
                    </a:lnTo>
                    <a:lnTo>
                      <a:pt x="5438" y="123"/>
                    </a:lnTo>
                    <a:lnTo>
                      <a:pt x="5452" y="103"/>
                    </a:lnTo>
                    <a:lnTo>
                      <a:pt x="5466" y="94"/>
                    </a:lnTo>
                    <a:lnTo>
                      <a:pt x="5480" y="77"/>
                    </a:lnTo>
                    <a:lnTo>
                      <a:pt x="5494" y="69"/>
                    </a:lnTo>
                    <a:lnTo>
                      <a:pt x="5509" y="79"/>
                    </a:lnTo>
                    <a:lnTo>
                      <a:pt x="5523" y="58"/>
                    </a:lnTo>
                    <a:lnTo>
                      <a:pt x="5537" y="66"/>
                    </a:lnTo>
                    <a:lnTo>
                      <a:pt x="5551" y="54"/>
                    </a:lnTo>
                    <a:lnTo>
                      <a:pt x="5565" y="58"/>
                    </a:lnTo>
                    <a:lnTo>
                      <a:pt x="5579" y="45"/>
                    </a:lnTo>
                    <a:lnTo>
                      <a:pt x="5593" y="58"/>
                    </a:lnTo>
                    <a:lnTo>
                      <a:pt x="5607" y="48"/>
                    </a:lnTo>
                    <a:lnTo>
                      <a:pt x="5621" y="48"/>
                    </a:lnTo>
                    <a:lnTo>
                      <a:pt x="5636" y="35"/>
                    </a:lnTo>
                    <a:lnTo>
                      <a:pt x="5650" y="56"/>
                    </a:lnTo>
                    <a:lnTo>
                      <a:pt x="5664" y="37"/>
                    </a:lnTo>
                    <a:lnTo>
                      <a:pt x="5678" y="37"/>
                    </a:lnTo>
                    <a:lnTo>
                      <a:pt x="5692" y="39"/>
                    </a:lnTo>
                    <a:lnTo>
                      <a:pt x="5706" y="42"/>
                    </a:lnTo>
                    <a:lnTo>
                      <a:pt x="5720" y="48"/>
                    </a:lnTo>
                    <a:lnTo>
                      <a:pt x="5734" y="36"/>
                    </a:lnTo>
                    <a:lnTo>
                      <a:pt x="5748" y="42"/>
                    </a:lnTo>
                    <a:lnTo>
                      <a:pt x="5763" y="51"/>
                    </a:lnTo>
                    <a:lnTo>
                      <a:pt x="5777" y="27"/>
                    </a:lnTo>
                    <a:lnTo>
                      <a:pt x="5791" y="47"/>
                    </a:lnTo>
                    <a:lnTo>
                      <a:pt x="5805" y="26"/>
                    </a:lnTo>
                    <a:lnTo>
                      <a:pt x="5819" y="40"/>
                    </a:lnTo>
                    <a:lnTo>
                      <a:pt x="5833" y="33"/>
                    </a:lnTo>
                    <a:lnTo>
                      <a:pt x="5847" y="36"/>
                    </a:lnTo>
                    <a:lnTo>
                      <a:pt x="5861" y="27"/>
                    </a:lnTo>
                    <a:lnTo>
                      <a:pt x="5875" y="24"/>
                    </a:lnTo>
                    <a:lnTo>
                      <a:pt x="5890" y="26"/>
                    </a:lnTo>
                    <a:lnTo>
                      <a:pt x="5904" y="9"/>
                    </a:lnTo>
                    <a:lnTo>
                      <a:pt x="5918" y="34"/>
                    </a:lnTo>
                    <a:lnTo>
                      <a:pt x="5932" y="36"/>
                    </a:lnTo>
                    <a:lnTo>
                      <a:pt x="5946" y="23"/>
                    </a:lnTo>
                    <a:lnTo>
                      <a:pt x="5960" y="21"/>
                    </a:lnTo>
                    <a:lnTo>
                      <a:pt x="5974" y="26"/>
                    </a:lnTo>
                    <a:lnTo>
                      <a:pt x="5988" y="28"/>
                    </a:lnTo>
                    <a:lnTo>
                      <a:pt x="6002" y="10"/>
                    </a:lnTo>
                    <a:lnTo>
                      <a:pt x="6017" y="21"/>
                    </a:lnTo>
                    <a:lnTo>
                      <a:pt x="6031" y="25"/>
                    </a:lnTo>
                    <a:lnTo>
                      <a:pt x="6045" y="19"/>
                    </a:lnTo>
                    <a:lnTo>
                      <a:pt x="6059" y="28"/>
                    </a:lnTo>
                    <a:lnTo>
                      <a:pt x="6073" y="24"/>
                    </a:lnTo>
                    <a:lnTo>
                      <a:pt x="6087" y="41"/>
                    </a:lnTo>
                    <a:lnTo>
                      <a:pt x="6101" y="48"/>
                    </a:lnTo>
                    <a:lnTo>
                      <a:pt x="6115" y="59"/>
                    </a:lnTo>
                    <a:lnTo>
                      <a:pt x="6129" y="65"/>
                    </a:lnTo>
                    <a:lnTo>
                      <a:pt x="6144" y="71"/>
                    </a:lnTo>
                    <a:lnTo>
                      <a:pt x="6158" y="67"/>
                    </a:lnTo>
                    <a:lnTo>
                      <a:pt x="6172" y="72"/>
                    </a:lnTo>
                    <a:lnTo>
                      <a:pt x="6186" y="64"/>
                    </a:lnTo>
                    <a:lnTo>
                      <a:pt x="6200" y="90"/>
                    </a:lnTo>
                    <a:lnTo>
                      <a:pt x="6214" y="65"/>
                    </a:lnTo>
                    <a:lnTo>
                      <a:pt x="6228" y="49"/>
                    </a:lnTo>
                    <a:lnTo>
                      <a:pt x="6242" y="48"/>
                    </a:lnTo>
                    <a:lnTo>
                      <a:pt x="6257" y="35"/>
                    </a:lnTo>
                    <a:lnTo>
                      <a:pt x="6271" y="42"/>
                    </a:lnTo>
                    <a:lnTo>
                      <a:pt x="6285" y="51"/>
                    </a:lnTo>
                    <a:lnTo>
                      <a:pt x="6299" y="38"/>
                    </a:lnTo>
                    <a:lnTo>
                      <a:pt x="6313" y="55"/>
                    </a:lnTo>
                    <a:lnTo>
                      <a:pt x="6327" y="34"/>
                    </a:lnTo>
                    <a:lnTo>
                      <a:pt x="6341" y="41"/>
                    </a:lnTo>
                    <a:lnTo>
                      <a:pt x="6355" y="28"/>
                    </a:lnTo>
                    <a:lnTo>
                      <a:pt x="6369" y="35"/>
                    </a:lnTo>
                    <a:lnTo>
                      <a:pt x="6384" y="36"/>
                    </a:lnTo>
                    <a:lnTo>
                      <a:pt x="6398" y="33"/>
                    </a:lnTo>
                    <a:lnTo>
                      <a:pt x="6412" y="34"/>
                    </a:lnTo>
                    <a:lnTo>
                      <a:pt x="6426" y="47"/>
                    </a:lnTo>
                    <a:lnTo>
                      <a:pt x="6440" y="28"/>
                    </a:lnTo>
                    <a:lnTo>
                      <a:pt x="6454" y="32"/>
                    </a:lnTo>
                    <a:lnTo>
                      <a:pt x="6468" y="34"/>
                    </a:lnTo>
                    <a:lnTo>
                      <a:pt x="6482" y="37"/>
                    </a:lnTo>
                    <a:lnTo>
                      <a:pt x="6496" y="17"/>
                    </a:lnTo>
                    <a:lnTo>
                      <a:pt x="6511" y="28"/>
                    </a:lnTo>
                    <a:lnTo>
                      <a:pt x="6525" y="3"/>
                    </a:lnTo>
                    <a:lnTo>
                      <a:pt x="6539" y="25"/>
                    </a:lnTo>
                    <a:lnTo>
                      <a:pt x="6553" y="37"/>
                    </a:lnTo>
                    <a:lnTo>
                      <a:pt x="6567" y="11"/>
                    </a:lnTo>
                    <a:lnTo>
                      <a:pt x="6581" y="28"/>
                    </a:lnTo>
                    <a:lnTo>
                      <a:pt x="6595" y="30"/>
                    </a:lnTo>
                    <a:lnTo>
                      <a:pt x="6609" y="30"/>
                    </a:lnTo>
                    <a:lnTo>
                      <a:pt x="6623" y="24"/>
                    </a:lnTo>
                    <a:lnTo>
                      <a:pt x="6638" y="22"/>
                    </a:lnTo>
                    <a:lnTo>
                      <a:pt x="6652" y="27"/>
                    </a:lnTo>
                    <a:lnTo>
                      <a:pt x="6666" y="29"/>
                    </a:lnTo>
                    <a:lnTo>
                      <a:pt x="6680" y="26"/>
                    </a:lnTo>
                    <a:lnTo>
                      <a:pt x="6694" y="29"/>
                    </a:lnTo>
                    <a:lnTo>
                      <a:pt x="6708" y="22"/>
                    </a:lnTo>
                    <a:lnTo>
                      <a:pt x="6722" y="24"/>
                    </a:lnTo>
                    <a:lnTo>
                      <a:pt x="6736" y="16"/>
                    </a:lnTo>
                    <a:lnTo>
                      <a:pt x="6750" y="27"/>
                    </a:lnTo>
                    <a:lnTo>
                      <a:pt x="6765" y="23"/>
                    </a:lnTo>
                    <a:lnTo>
                      <a:pt x="6779" y="14"/>
                    </a:lnTo>
                    <a:lnTo>
                      <a:pt x="6793" y="22"/>
                    </a:lnTo>
                    <a:lnTo>
                      <a:pt x="6807" y="34"/>
                    </a:lnTo>
                    <a:lnTo>
                      <a:pt x="6821" y="12"/>
                    </a:lnTo>
                    <a:lnTo>
                      <a:pt x="6835" y="11"/>
                    </a:lnTo>
                    <a:lnTo>
                      <a:pt x="6849" y="27"/>
                    </a:lnTo>
                    <a:lnTo>
                      <a:pt x="6863" y="39"/>
                    </a:lnTo>
                    <a:lnTo>
                      <a:pt x="6878" y="19"/>
                    </a:lnTo>
                    <a:lnTo>
                      <a:pt x="6892" y="31"/>
                    </a:lnTo>
                    <a:lnTo>
                      <a:pt x="6906" y="16"/>
                    </a:lnTo>
                    <a:lnTo>
                      <a:pt x="6920" y="23"/>
                    </a:lnTo>
                    <a:lnTo>
                      <a:pt x="6934" y="24"/>
                    </a:lnTo>
                    <a:lnTo>
                      <a:pt x="6948" y="19"/>
                    </a:lnTo>
                    <a:lnTo>
                      <a:pt x="6962" y="27"/>
                    </a:lnTo>
                    <a:lnTo>
                      <a:pt x="6976" y="32"/>
                    </a:lnTo>
                    <a:lnTo>
                      <a:pt x="6990" y="18"/>
                    </a:lnTo>
                    <a:lnTo>
                      <a:pt x="7005" y="35"/>
                    </a:lnTo>
                    <a:lnTo>
                      <a:pt x="7019" y="37"/>
                    </a:lnTo>
                    <a:lnTo>
                      <a:pt x="7033" y="14"/>
                    </a:lnTo>
                    <a:lnTo>
                      <a:pt x="7047" y="35"/>
                    </a:lnTo>
                    <a:lnTo>
                      <a:pt x="7061" y="16"/>
                    </a:lnTo>
                    <a:lnTo>
                      <a:pt x="7075" y="29"/>
                    </a:lnTo>
                    <a:lnTo>
                      <a:pt x="7089" y="15"/>
                    </a:lnTo>
                    <a:lnTo>
                      <a:pt x="7103" y="26"/>
                    </a:lnTo>
                    <a:lnTo>
                      <a:pt x="7117" y="26"/>
                    </a:lnTo>
                    <a:lnTo>
                      <a:pt x="7132" y="13"/>
                    </a:lnTo>
                    <a:lnTo>
                      <a:pt x="7146" y="14"/>
                    </a:lnTo>
                    <a:lnTo>
                      <a:pt x="7160" y="13"/>
                    </a:lnTo>
                    <a:lnTo>
                      <a:pt x="7174" y="23"/>
                    </a:lnTo>
                    <a:lnTo>
                      <a:pt x="7188" y="13"/>
                    </a:lnTo>
                    <a:lnTo>
                      <a:pt x="7202" y="19"/>
                    </a:lnTo>
                    <a:lnTo>
                      <a:pt x="7216" y="20"/>
                    </a:lnTo>
                    <a:lnTo>
                      <a:pt x="7230" y="9"/>
                    </a:lnTo>
                    <a:lnTo>
                      <a:pt x="7244" y="12"/>
                    </a:lnTo>
                    <a:lnTo>
                      <a:pt x="7259" y="13"/>
                    </a:lnTo>
                    <a:lnTo>
                      <a:pt x="7273" y="26"/>
                    </a:lnTo>
                    <a:lnTo>
                      <a:pt x="7287" y="16"/>
                    </a:lnTo>
                    <a:lnTo>
                      <a:pt x="7301" y="22"/>
                    </a:lnTo>
                    <a:lnTo>
                      <a:pt x="7315" y="14"/>
                    </a:lnTo>
                    <a:lnTo>
                      <a:pt x="7329" y="16"/>
                    </a:lnTo>
                    <a:lnTo>
                      <a:pt x="7343" y="26"/>
                    </a:lnTo>
                    <a:lnTo>
                      <a:pt x="7357" y="24"/>
                    </a:lnTo>
                    <a:lnTo>
                      <a:pt x="7371" y="33"/>
                    </a:lnTo>
                    <a:lnTo>
                      <a:pt x="7386" y="23"/>
                    </a:lnTo>
                    <a:lnTo>
                      <a:pt x="7400" y="4"/>
                    </a:lnTo>
                    <a:lnTo>
                      <a:pt x="7414" y="19"/>
                    </a:lnTo>
                    <a:lnTo>
                      <a:pt x="7428" y="8"/>
                    </a:lnTo>
                    <a:lnTo>
                      <a:pt x="7442" y="15"/>
                    </a:lnTo>
                    <a:lnTo>
                      <a:pt x="7456" y="14"/>
                    </a:lnTo>
                    <a:lnTo>
                      <a:pt x="7470" y="21"/>
                    </a:lnTo>
                    <a:lnTo>
                      <a:pt x="7484" y="21"/>
                    </a:lnTo>
                    <a:lnTo>
                      <a:pt x="7498" y="12"/>
                    </a:lnTo>
                    <a:lnTo>
                      <a:pt x="7513" y="19"/>
                    </a:lnTo>
                    <a:lnTo>
                      <a:pt x="7527" y="19"/>
                    </a:lnTo>
                    <a:lnTo>
                      <a:pt x="7541" y="18"/>
                    </a:lnTo>
                    <a:lnTo>
                      <a:pt x="7555" y="31"/>
                    </a:lnTo>
                    <a:lnTo>
                      <a:pt x="7569" y="35"/>
                    </a:lnTo>
                    <a:lnTo>
                      <a:pt x="7583" y="15"/>
                    </a:lnTo>
                    <a:lnTo>
                      <a:pt x="7597" y="17"/>
                    </a:lnTo>
                    <a:lnTo>
                      <a:pt x="7611" y="32"/>
                    </a:lnTo>
                    <a:lnTo>
                      <a:pt x="7626" y="17"/>
                    </a:lnTo>
                    <a:lnTo>
                      <a:pt x="7640" y="12"/>
                    </a:lnTo>
                    <a:lnTo>
                      <a:pt x="7654" y="9"/>
                    </a:lnTo>
                    <a:lnTo>
                      <a:pt x="7668" y="12"/>
                    </a:lnTo>
                    <a:lnTo>
                      <a:pt x="7682" y="11"/>
                    </a:lnTo>
                    <a:lnTo>
                      <a:pt x="7696" y="11"/>
                    </a:lnTo>
                    <a:lnTo>
                      <a:pt x="7710" y="25"/>
                    </a:lnTo>
                    <a:lnTo>
                      <a:pt x="7724" y="36"/>
                    </a:lnTo>
                    <a:lnTo>
                      <a:pt x="7738" y="26"/>
                    </a:lnTo>
                    <a:lnTo>
                      <a:pt x="7753" y="22"/>
                    </a:lnTo>
                    <a:lnTo>
                      <a:pt x="7767" y="21"/>
                    </a:lnTo>
                    <a:lnTo>
                      <a:pt x="7781" y="28"/>
                    </a:lnTo>
                    <a:lnTo>
                      <a:pt x="7795" y="16"/>
                    </a:lnTo>
                    <a:lnTo>
                      <a:pt x="7809" y="44"/>
                    </a:lnTo>
                    <a:lnTo>
                      <a:pt x="7823" y="17"/>
                    </a:lnTo>
                    <a:lnTo>
                      <a:pt x="7837" y="17"/>
                    </a:lnTo>
                    <a:lnTo>
                      <a:pt x="7851" y="29"/>
                    </a:lnTo>
                    <a:lnTo>
                      <a:pt x="7865" y="25"/>
                    </a:lnTo>
                    <a:lnTo>
                      <a:pt x="7880" y="31"/>
                    </a:lnTo>
                    <a:lnTo>
                      <a:pt x="7894" y="15"/>
                    </a:lnTo>
                    <a:lnTo>
                      <a:pt x="7908" y="11"/>
                    </a:lnTo>
                    <a:lnTo>
                      <a:pt x="7922" y="21"/>
                    </a:lnTo>
                    <a:lnTo>
                      <a:pt x="7936" y="37"/>
                    </a:lnTo>
                    <a:lnTo>
                      <a:pt x="7950" y="17"/>
                    </a:lnTo>
                    <a:lnTo>
                      <a:pt x="7964" y="18"/>
                    </a:lnTo>
                    <a:lnTo>
                      <a:pt x="7978" y="12"/>
                    </a:lnTo>
                    <a:lnTo>
                      <a:pt x="7992" y="23"/>
                    </a:lnTo>
                    <a:lnTo>
                      <a:pt x="8007" y="23"/>
                    </a:lnTo>
                    <a:lnTo>
                      <a:pt x="8021" y="19"/>
                    </a:lnTo>
                    <a:lnTo>
                      <a:pt x="8035" y="25"/>
                    </a:lnTo>
                    <a:lnTo>
                      <a:pt x="8049" y="19"/>
                    </a:lnTo>
                    <a:lnTo>
                      <a:pt x="8063" y="9"/>
                    </a:lnTo>
                    <a:lnTo>
                      <a:pt x="8077" y="0"/>
                    </a:lnTo>
                    <a:lnTo>
                      <a:pt x="8091" y="30"/>
                    </a:lnTo>
                    <a:lnTo>
                      <a:pt x="8105" y="11"/>
                    </a:lnTo>
                    <a:lnTo>
                      <a:pt x="8119" y="34"/>
                    </a:lnTo>
                    <a:lnTo>
                      <a:pt x="8134" y="6"/>
                    </a:lnTo>
                    <a:lnTo>
                      <a:pt x="8148" y="21"/>
                    </a:lnTo>
                    <a:lnTo>
                      <a:pt x="8162" y="17"/>
                    </a:lnTo>
                    <a:lnTo>
                      <a:pt x="8176" y="25"/>
                    </a:lnTo>
                    <a:lnTo>
                      <a:pt x="8190" y="11"/>
                    </a:lnTo>
                    <a:lnTo>
                      <a:pt x="8204" y="12"/>
                    </a:lnTo>
                    <a:lnTo>
                      <a:pt x="8218" y="4"/>
                    </a:lnTo>
                    <a:lnTo>
                      <a:pt x="8232" y="12"/>
                    </a:lnTo>
                    <a:lnTo>
                      <a:pt x="8247" y="16"/>
                    </a:lnTo>
                    <a:lnTo>
                      <a:pt x="8261" y="38"/>
                    </a:lnTo>
                    <a:lnTo>
                      <a:pt x="8275" y="44"/>
                    </a:lnTo>
                    <a:lnTo>
                      <a:pt x="8289" y="26"/>
                    </a:lnTo>
                    <a:lnTo>
                      <a:pt x="8303" y="41"/>
                    </a:lnTo>
                    <a:lnTo>
                      <a:pt x="8317" y="38"/>
                    </a:lnTo>
                    <a:lnTo>
                      <a:pt x="8331" y="45"/>
                    </a:lnTo>
                    <a:lnTo>
                      <a:pt x="8345" y="28"/>
                    </a:lnTo>
                    <a:lnTo>
                      <a:pt x="8359" y="40"/>
                    </a:lnTo>
                    <a:lnTo>
                      <a:pt x="8374" y="20"/>
                    </a:lnTo>
                    <a:lnTo>
                      <a:pt x="8388" y="37"/>
                    </a:lnTo>
                    <a:lnTo>
                      <a:pt x="8402" y="28"/>
                    </a:lnTo>
                    <a:lnTo>
                      <a:pt x="8416" y="40"/>
                    </a:lnTo>
                    <a:lnTo>
                      <a:pt x="8430" y="40"/>
                    </a:lnTo>
                    <a:lnTo>
                      <a:pt x="8444" y="33"/>
                    </a:lnTo>
                    <a:lnTo>
                      <a:pt x="8458" y="31"/>
                    </a:lnTo>
                    <a:lnTo>
                      <a:pt x="8472" y="45"/>
                    </a:lnTo>
                    <a:lnTo>
                      <a:pt x="8486" y="35"/>
                    </a:lnTo>
                    <a:lnTo>
                      <a:pt x="8501" y="24"/>
                    </a:lnTo>
                    <a:lnTo>
                      <a:pt x="8515" y="41"/>
                    </a:lnTo>
                    <a:lnTo>
                      <a:pt x="8529" y="35"/>
                    </a:lnTo>
                    <a:lnTo>
                      <a:pt x="8543" y="27"/>
                    </a:lnTo>
                    <a:lnTo>
                      <a:pt x="8557" y="27"/>
                    </a:lnTo>
                    <a:lnTo>
                      <a:pt x="8571" y="42"/>
                    </a:lnTo>
                    <a:lnTo>
                      <a:pt x="8585" y="47"/>
                    </a:lnTo>
                    <a:lnTo>
                      <a:pt x="8599" y="60"/>
                    </a:lnTo>
                    <a:lnTo>
                      <a:pt x="8613" y="71"/>
                    </a:lnTo>
                    <a:lnTo>
                      <a:pt x="8628" y="73"/>
                    </a:lnTo>
                    <a:lnTo>
                      <a:pt x="8642" y="68"/>
                    </a:lnTo>
                    <a:lnTo>
                      <a:pt x="8656" y="90"/>
                    </a:lnTo>
                    <a:lnTo>
                      <a:pt x="8670" y="108"/>
                    </a:lnTo>
                    <a:lnTo>
                      <a:pt x="8684" y="127"/>
                    </a:lnTo>
                    <a:lnTo>
                      <a:pt x="8698" y="164"/>
                    </a:lnTo>
                    <a:lnTo>
                      <a:pt x="8712" y="180"/>
                    </a:lnTo>
                    <a:lnTo>
                      <a:pt x="8726" y="243"/>
                    </a:lnTo>
                    <a:lnTo>
                      <a:pt x="8740" y="229"/>
                    </a:lnTo>
                    <a:lnTo>
                      <a:pt x="8755" y="268"/>
                    </a:lnTo>
                    <a:lnTo>
                      <a:pt x="8769" y="252"/>
                    </a:lnTo>
                    <a:lnTo>
                      <a:pt x="8783" y="230"/>
                    </a:lnTo>
                    <a:lnTo>
                      <a:pt x="8797" y="211"/>
                    </a:lnTo>
                    <a:lnTo>
                      <a:pt x="8811" y="215"/>
                    </a:lnTo>
                    <a:lnTo>
                      <a:pt x="8825" y="224"/>
                    </a:lnTo>
                    <a:lnTo>
                      <a:pt x="8839" y="201"/>
                    </a:lnTo>
                    <a:lnTo>
                      <a:pt x="8853" y="207"/>
                    </a:lnTo>
                    <a:lnTo>
                      <a:pt x="8868" y="249"/>
                    </a:lnTo>
                    <a:lnTo>
                      <a:pt x="8882" y="175"/>
                    </a:lnTo>
                    <a:lnTo>
                      <a:pt x="8896" y="185"/>
                    </a:lnTo>
                    <a:lnTo>
                      <a:pt x="8910" y="179"/>
                    </a:lnTo>
                    <a:lnTo>
                      <a:pt x="8924" y="182"/>
                    </a:lnTo>
                    <a:lnTo>
                      <a:pt x="8938" y="189"/>
                    </a:lnTo>
                    <a:lnTo>
                      <a:pt x="8952" y="161"/>
                    </a:lnTo>
                    <a:lnTo>
                      <a:pt x="8966" y="160"/>
                    </a:lnTo>
                    <a:lnTo>
                      <a:pt x="8980" y="170"/>
                    </a:lnTo>
                    <a:lnTo>
                      <a:pt x="8995" y="161"/>
                    </a:lnTo>
                    <a:lnTo>
                      <a:pt x="9009" y="121"/>
                    </a:lnTo>
                    <a:lnTo>
                      <a:pt x="9023" y="154"/>
                    </a:lnTo>
                    <a:lnTo>
                      <a:pt x="9037" y="156"/>
                    </a:lnTo>
                    <a:lnTo>
                      <a:pt x="9051" y="146"/>
                    </a:lnTo>
                    <a:lnTo>
                      <a:pt x="9065" y="118"/>
                    </a:lnTo>
                    <a:lnTo>
                      <a:pt x="9079" y="108"/>
                    </a:lnTo>
                    <a:lnTo>
                      <a:pt x="9093" y="129"/>
                    </a:lnTo>
                    <a:lnTo>
                      <a:pt x="9107" y="109"/>
                    </a:lnTo>
                    <a:lnTo>
                      <a:pt x="9122" y="117"/>
                    </a:lnTo>
                    <a:lnTo>
                      <a:pt x="9136" y="90"/>
                    </a:lnTo>
                    <a:lnTo>
                      <a:pt x="9150" y="124"/>
                    </a:lnTo>
                    <a:lnTo>
                      <a:pt x="9164" y="113"/>
                    </a:lnTo>
                    <a:lnTo>
                      <a:pt x="9178" y="128"/>
                    </a:lnTo>
                    <a:lnTo>
                      <a:pt x="9192" y="89"/>
                    </a:lnTo>
                    <a:lnTo>
                      <a:pt x="9206" y="106"/>
                    </a:lnTo>
                    <a:lnTo>
                      <a:pt x="9220" y="96"/>
                    </a:lnTo>
                    <a:lnTo>
                      <a:pt x="9234" y="109"/>
                    </a:lnTo>
                    <a:lnTo>
                      <a:pt x="9249" y="85"/>
                    </a:lnTo>
                    <a:lnTo>
                      <a:pt x="9263" y="71"/>
                    </a:lnTo>
                    <a:lnTo>
                      <a:pt x="9277" y="93"/>
                    </a:lnTo>
                    <a:lnTo>
                      <a:pt x="9291" y="87"/>
                    </a:lnTo>
                    <a:lnTo>
                      <a:pt x="9305" y="60"/>
                    </a:lnTo>
                    <a:lnTo>
                      <a:pt x="9319" y="90"/>
                    </a:lnTo>
                    <a:lnTo>
                      <a:pt x="9333" y="81"/>
                    </a:lnTo>
                    <a:lnTo>
                      <a:pt x="9347" y="88"/>
                    </a:lnTo>
                    <a:lnTo>
                      <a:pt x="9361" y="90"/>
                    </a:lnTo>
                    <a:lnTo>
                      <a:pt x="9376" y="78"/>
                    </a:lnTo>
                    <a:lnTo>
                      <a:pt x="9390" y="80"/>
                    </a:lnTo>
                    <a:lnTo>
                      <a:pt x="9404" y="74"/>
                    </a:lnTo>
                    <a:lnTo>
                      <a:pt x="9418" y="80"/>
                    </a:lnTo>
                    <a:lnTo>
                      <a:pt x="9432" y="96"/>
                    </a:lnTo>
                    <a:lnTo>
                      <a:pt x="9446" y="96"/>
                    </a:lnTo>
                    <a:lnTo>
                      <a:pt x="9460" y="94"/>
                    </a:lnTo>
                    <a:lnTo>
                      <a:pt x="9474" y="90"/>
                    </a:lnTo>
                    <a:lnTo>
                      <a:pt x="9488" y="83"/>
                    </a:lnTo>
                    <a:lnTo>
                      <a:pt x="9503" y="83"/>
                    </a:lnTo>
                    <a:lnTo>
                      <a:pt x="9517" y="87"/>
                    </a:lnTo>
                    <a:lnTo>
                      <a:pt x="9531" y="87"/>
                    </a:lnTo>
                    <a:lnTo>
                      <a:pt x="9545" y="78"/>
                    </a:lnTo>
                    <a:lnTo>
                      <a:pt x="9559" y="82"/>
                    </a:lnTo>
                    <a:lnTo>
                      <a:pt x="9573" y="90"/>
                    </a:lnTo>
                    <a:lnTo>
                      <a:pt x="9587" y="95"/>
                    </a:lnTo>
                    <a:lnTo>
                      <a:pt x="9601" y="86"/>
                    </a:lnTo>
                    <a:lnTo>
                      <a:pt x="9616" y="88"/>
                    </a:lnTo>
                    <a:lnTo>
                      <a:pt x="9630" y="99"/>
                    </a:lnTo>
                    <a:lnTo>
                      <a:pt x="9644" y="85"/>
                    </a:lnTo>
                    <a:lnTo>
                      <a:pt x="9658" y="117"/>
                    </a:lnTo>
                    <a:lnTo>
                      <a:pt x="9672" y="69"/>
                    </a:lnTo>
                    <a:lnTo>
                      <a:pt x="9686" y="96"/>
                    </a:lnTo>
                    <a:lnTo>
                      <a:pt x="9700" y="65"/>
                    </a:lnTo>
                    <a:lnTo>
                      <a:pt x="9714" y="99"/>
                    </a:lnTo>
                    <a:lnTo>
                      <a:pt x="9728" y="77"/>
                    </a:lnTo>
                    <a:lnTo>
                      <a:pt x="9743" y="71"/>
                    </a:lnTo>
                    <a:lnTo>
                      <a:pt x="9757" y="90"/>
                    </a:lnTo>
                    <a:lnTo>
                      <a:pt x="9771" y="83"/>
                    </a:lnTo>
                    <a:lnTo>
                      <a:pt x="9785" y="95"/>
                    </a:lnTo>
                    <a:lnTo>
                      <a:pt x="9799" y="90"/>
                    </a:lnTo>
                    <a:lnTo>
                      <a:pt x="9813" y="75"/>
                    </a:lnTo>
                    <a:lnTo>
                      <a:pt x="9827" y="94"/>
                    </a:lnTo>
                    <a:lnTo>
                      <a:pt x="9841" y="78"/>
                    </a:lnTo>
                    <a:lnTo>
                      <a:pt x="9855" y="89"/>
                    </a:lnTo>
                    <a:lnTo>
                      <a:pt x="9870" y="94"/>
                    </a:lnTo>
                    <a:lnTo>
                      <a:pt x="9884" y="77"/>
                    </a:lnTo>
                    <a:lnTo>
                      <a:pt x="9898" y="82"/>
                    </a:lnTo>
                    <a:lnTo>
                      <a:pt x="9912" y="73"/>
                    </a:lnTo>
                    <a:lnTo>
                      <a:pt x="9926" y="70"/>
                    </a:lnTo>
                    <a:lnTo>
                      <a:pt x="9940" y="86"/>
                    </a:lnTo>
                    <a:lnTo>
                      <a:pt x="9954" y="79"/>
                    </a:lnTo>
                    <a:lnTo>
                      <a:pt x="9968" y="53"/>
                    </a:lnTo>
                    <a:lnTo>
                      <a:pt x="9982" y="81"/>
                    </a:lnTo>
                    <a:lnTo>
                      <a:pt x="9997" y="73"/>
                    </a:lnTo>
                    <a:lnTo>
                      <a:pt x="10011" y="87"/>
                    </a:lnTo>
                    <a:lnTo>
                      <a:pt x="10025" y="70"/>
                    </a:lnTo>
                    <a:lnTo>
                      <a:pt x="10039" y="58"/>
                    </a:lnTo>
                    <a:lnTo>
                      <a:pt x="10053" y="42"/>
                    </a:lnTo>
                    <a:lnTo>
                      <a:pt x="10067" y="39"/>
                    </a:lnTo>
                    <a:lnTo>
                      <a:pt x="10081" y="43"/>
                    </a:lnTo>
                    <a:lnTo>
                      <a:pt x="10095" y="82"/>
                    </a:lnTo>
                    <a:lnTo>
                      <a:pt x="10109" y="43"/>
                    </a:lnTo>
                    <a:lnTo>
                      <a:pt x="10124" y="35"/>
                    </a:lnTo>
                    <a:lnTo>
                      <a:pt x="10138" y="53"/>
                    </a:lnTo>
                    <a:lnTo>
                      <a:pt x="10152" y="51"/>
                    </a:lnTo>
                    <a:lnTo>
                      <a:pt x="10166" y="45"/>
                    </a:lnTo>
                    <a:lnTo>
                      <a:pt x="10180" y="58"/>
                    </a:lnTo>
                    <a:lnTo>
                      <a:pt x="10194" y="36"/>
                    </a:lnTo>
                    <a:lnTo>
                      <a:pt x="10208" y="56"/>
                    </a:lnTo>
                    <a:lnTo>
                      <a:pt x="10222" y="64"/>
                    </a:lnTo>
                    <a:lnTo>
                      <a:pt x="10237" y="55"/>
                    </a:lnTo>
                    <a:lnTo>
                      <a:pt x="10251" y="55"/>
                    </a:lnTo>
                    <a:lnTo>
                      <a:pt x="10265" y="54"/>
                    </a:lnTo>
                    <a:lnTo>
                      <a:pt x="10279" y="78"/>
                    </a:lnTo>
                    <a:lnTo>
                      <a:pt x="10293" y="64"/>
                    </a:lnTo>
                    <a:lnTo>
                      <a:pt x="10307" y="57"/>
                    </a:lnTo>
                    <a:lnTo>
                      <a:pt x="10321" y="50"/>
                    </a:lnTo>
                    <a:lnTo>
                      <a:pt x="10335" y="49"/>
                    </a:lnTo>
                    <a:lnTo>
                      <a:pt x="10349" y="61"/>
                    </a:lnTo>
                    <a:lnTo>
                      <a:pt x="10364" y="61"/>
                    </a:lnTo>
                    <a:lnTo>
                      <a:pt x="10378" y="73"/>
                    </a:lnTo>
                    <a:lnTo>
                      <a:pt x="10392" y="36"/>
                    </a:lnTo>
                    <a:lnTo>
                      <a:pt x="10406" y="46"/>
                    </a:lnTo>
                    <a:lnTo>
                      <a:pt x="10420" y="46"/>
                    </a:lnTo>
                    <a:lnTo>
                      <a:pt x="10434" y="71"/>
                    </a:lnTo>
                    <a:lnTo>
                      <a:pt x="10448" y="44"/>
                    </a:lnTo>
                    <a:lnTo>
                      <a:pt x="10462" y="52"/>
                    </a:lnTo>
                    <a:lnTo>
                      <a:pt x="10476" y="48"/>
                    </a:lnTo>
                    <a:lnTo>
                      <a:pt x="10491" y="43"/>
                    </a:lnTo>
                    <a:lnTo>
                      <a:pt x="10505" y="53"/>
                    </a:lnTo>
                    <a:lnTo>
                      <a:pt x="10519" y="47"/>
                    </a:lnTo>
                    <a:lnTo>
                      <a:pt x="10533" y="39"/>
                    </a:lnTo>
                    <a:lnTo>
                      <a:pt x="10547" y="51"/>
                    </a:lnTo>
                    <a:lnTo>
                      <a:pt x="10561" y="35"/>
                    </a:lnTo>
                    <a:lnTo>
                      <a:pt x="10575" y="58"/>
                    </a:lnTo>
                    <a:lnTo>
                      <a:pt x="10589" y="45"/>
                    </a:lnTo>
                    <a:lnTo>
                      <a:pt x="10603" y="34"/>
                    </a:lnTo>
                    <a:lnTo>
                      <a:pt x="10618" y="34"/>
                    </a:lnTo>
                    <a:lnTo>
                      <a:pt x="10632" y="45"/>
                    </a:lnTo>
                    <a:lnTo>
                      <a:pt x="10646" y="39"/>
                    </a:lnTo>
                    <a:lnTo>
                      <a:pt x="10660" y="56"/>
                    </a:lnTo>
                    <a:lnTo>
                      <a:pt x="10674" y="42"/>
                    </a:lnTo>
                    <a:lnTo>
                      <a:pt x="10688" y="49"/>
                    </a:lnTo>
                    <a:lnTo>
                      <a:pt x="10702" y="37"/>
                    </a:lnTo>
                    <a:lnTo>
                      <a:pt x="10716" y="42"/>
                    </a:lnTo>
                    <a:lnTo>
                      <a:pt x="10730" y="42"/>
                    </a:lnTo>
                    <a:lnTo>
                      <a:pt x="10745" y="34"/>
                    </a:lnTo>
                    <a:lnTo>
                      <a:pt x="10759" y="37"/>
                    </a:lnTo>
                    <a:lnTo>
                      <a:pt x="10773" y="40"/>
                    </a:lnTo>
                    <a:lnTo>
                      <a:pt x="10787" y="54"/>
                    </a:lnTo>
                    <a:lnTo>
                      <a:pt x="10801" y="36"/>
                    </a:lnTo>
                    <a:lnTo>
                      <a:pt x="10815" y="33"/>
                    </a:lnTo>
                    <a:lnTo>
                      <a:pt x="10829" y="51"/>
                    </a:lnTo>
                    <a:lnTo>
                      <a:pt x="10843" y="37"/>
                    </a:lnTo>
                    <a:lnTo>
                      <a:pt x="10857" y="35"/>
                    </a:lnTo>
                    <a:lnTo>
                      <a:pt x="10872" y="33"/>
                    </a:lnTo>
                    <a:lnTo>
                      <a:pt x="10886" y="75"/>
                    </a:lnTo>
                    <a:lnTo>
                      <a:pt x="10900" y="59"/>
                    </a:lnTo>
                    <a:lnTo>
                      <a:pt x="10914" y="84"/>
                    </a:lnTo>
                    <a:lnTo>
                      <a:pt x="10928" y="57"/>
                    </a:lnTo>
                    <a:lnTo>
                      <a:pt x="10942" y="69"/>
                    </a:lnTo>
                    <a:lnTo>
                      <a:pt x="10956" y="80"/>
                    </a:lnTo>
                    <a:lnTo>
                      <a:pt x="10970" y="117"/>
                    </a:lnTo>
                    <a:lnTo>
                      <a:pt x="10985" y="95"/>
                    </a:lnTo>
                    <a:lnTo>
                      <a:pt x="10999" y="72"/>
                    </a:lnTo>
                    <a:lnTo>
                      <a:pt x="11013" y="100"/>
                    </a:lnTo>
                    <a:lnTo>
                      <a:pt x="11027" y="91"/>
                    </a:lnTo>
                    <a:lnTo>
                      <a:pt x="11041" y="116"/>
                    </a:lnTo>
                    <a:lnTo>
                      <a:pt x="11055" y="98"/>
                    </a:lnTo>
                    <a:lnTo>
                      <a:pt x="11069" y="86"/>
                    </a:lnTo>
                    <a:lnTo>
                      <a:pt x="11083" y="113"/>
                    </a:lnTo>
                    <a:lnTo>
                      <a:pt x="11097" y="96"/>
                    </a:lnTo>
                    <a:lnTo>
                      <a:pt x="11112" y="82"/>
                    </a:lnTo>
                    <a:lnTo>
                      <a:pt x="11126" y="78"/>
                    </a:lnTo>
                    <a:lnTo>
                      <a:pt x="11140" y="65"/>
                    </a:lnTo>
                    <a:lnTo>
                      <a:pt x="11154" y="56"/>
                    </a:lnTo>
                    <a:lnTo>
                      <a:pt x="11168" y="62"/>
                    </a:lnTo>
                    <a:lnTo>
                      <a:pt x="11182" y="45"/>
                    </a:lnTo>
                    <a:lnTo>
                      <a:pt x="11196" y="38"/>
                    </a:lnTo>
                    <a:lnTo>
                      <a:pt x="11210" y="49"/>
                    </a:lnTo>
                    <a:lnTo>
                      <a:pt x="11224" y="54"/>
                    </a:lnTo>
                    <a:lnTo>
                      <a:pt x="11239" y="66"/>
                    </a:lnTo>
                    <a:lnTo>
                      <a:pt x="11253" y="54"/>
                    </a:lnTo>
                    <a:lnTo>
                      <a:pt x="11267" y="46"/>
                    </a:lnTo>
                    <a:lnTo>
                      <a:pt x="11281" y="42"/>
                    </a:lnTo>
                    <a:lnTo>
                      <a:pt x="11295" y="44"/>
                    </a:lnTo>
                    <a:lnTo>
                      <a:pt x="11309" y="44"/>
                    </a:lnTo>
                    <a:lnTo>
                      <a:pt x="11323" y="57"/>
                    </a:lnTo>
                    <a:lnTo>
                      <a:pt x="11337" y="62"/>
                    </a:lnTo>
                    <a:lnTo>
                      <a:pt x="11351" y="50"/>
                    </a:lnTo>
                    <a:lnTo>
                      <a:pt x="11366" y="53"/>
                    </a:lnTo>
                    <a:lnTo>
                      <a:pt x="11380" y="34"/>
                    </a:lnTo>
                    <a:lnTo>
                      <a:pt x="11394" y="67"/>
                    </a:lnTo>
                    <a:lnTo>
                      <a:pt x="11408" y="62"/>
                    </a:lnTo>
                    <a:lnTo>
                      <a:pt x="11422" y="72"/>
                    </a:lnTo>
                    <a:lnTo>
                      <a:pt x="11436" y="48"/>
                    </a:lnTo>
                    <a:lnTo>
                      <a:pt x="11450" y="47"/>
                    </a:lnTo>
                    <a:lnTo>
                      <a:pt x="11464" y="52"/>
                    </a:lnTo>
                    <a:lnTo>
                      <a:pt x="11478" y="52"/>
                    </a:lnTo>
                    <a:lnTo>
                      <a:pt x="11493" y="68"/>
                    </a:lnTo>
                    <a:lnTo>
                      <a:pt x="11507" y="41"/>
                    </a:lnTo>
                    <a:lnTo>
                      <a:pt x="11521" y="23"/>
                    </a:lnTo>
                    <a:lnTo>
                      <a:pt x="11535" y="50"/>
                    </a:lnTo>
                    <a:lnTo>
                      <a:pt x="11549" y="29"/>
                    </a:lnTo>
                    <a:lnTo>
                      <a:pt x="11563" y="39"/>
                    </a:lnTo>
                    <a:lnTo>
                      <a:pt x="11577" y="38"/>
                    </a:lnTo>
                    <a:lnTo>
                      <a:pt x="11591" y="47"/>
                    </a:lnTo>
                    <a:lnTo>
                      <a:pt x="11606" y="69"/>
                    </a:lnTo>
                    <a:lnTo>
                      <a:pt x="11620" y="39"/>
                    </a:lnTo>
                    <a:lnTo>
                      <a:pt x="11634" y="27"/>
                    </a:lnTo>
                    <a:lnTo>
                      <a:pt x="11648" y="41"/>
                    </a:lnTo>
                    <a:lnTo>
                      <a:pt x="11662" y="54"/>
                    </a:lnTo>
                    <a:lnTo>
                      <a:pt x="11676" y="54"/>
                    </a:lnTo>
                    <a:lnTo>
                      <a:pt x="11690" y="40"/>
                    </a:lnTo>
                    <a:lnTo>
                      <a:pt x="11704" y="19"/>
                    </a:lnTo>
                    <a:lnTo>
                      <a:pt x="11718" y="29"/>
                    </a:lnTo>
                    <a:lnTo>
                      <a:pt x="11733" y="48"/>
                    </a:lnTo>
                    <a:lnTo>
                      <a:pt x="11747" y="24"/>
                    </a:lnTo>
                    <a:lnTo>
                      <a:pt x="11761" y="27"/>
                    </a:lnTo>
                    <a:lnTo>
                      <a:pt x="11775" y="27"/>
                    </a:lnTo>
                    <a:lnTo>
                      <a:pt x="11789" y="41"/>
                    </a:lnTo>
                    <a:lnTo>
                      <a:pt x="11803" y="38"/>
                    </a:lnTo>
                    <a:lnTo>
                      <a:pt x="11817" y="41"/>
                    </a:lnTo>
                    <a:lnTo>
                      <a:pt x="11831" y="38"/>
                    </a:lnTo>
                    <a:lnTo>
                      <a:pt x="11845" y="31"/>
                    </a:lnTo>
                    <a:lnTo>
                      <a:pt x="11860" y="54"/>
                    </a:lnTo>
                    <a:lnTo>
                      <a:pt x="11874" y="21"/>
                    </a:lnTo>
                    <a:lnTo>
                      <a:pt x="11888" y="49"/>
                    </a:lnTo>
                    <a:lnTo>
                      <a:pt x="11902" y="37"/>
                    </a:lnTo>
                    <a:lnTo>
                      <a:pt x="11916" y="47"/>
                    </a:lnTo>
                    <a:lnTo>
                      <a:pt x="11930" y="36"/>
                    </a:lnTo>
                    <a:lnTo>
                      <a:pt x="11944" y="27"/>
                    </a:lnTo>
                    <a:lnTo>
                      <a:pt x="11958" y="51"/>
                    </a:lnTo>
                    <a:lnTo>
                      <a:pt x="11972" y="29"/>
                    </a:lnTo>
                    <a:lnTo>
                      <a:pt x="11987" y="24"/>
                    </a:lnTo>
                    <a:lnTo>
                      <a:pt x="12001" y="38"/>
                    </a:lnTo>
                    <a:lnTo>
                      <a:pt x="12015" y="34"/>
                    </a:lnTo>
                    <a:lnTo>
                      <a:pt x="12029" y="39"/>
                    </a:lnTo>
                    <a:lnTo>
                      <a:pt x="12043" y="41"/>
                    </a:lnTo>
                    <a:lnTo>
                      <a:pt x="12057" y="44"/>
                    </a:lnTo>
                    <a:lnTo>
                      <a:pt x="12071" y="47"/>
                    </a:lnTo>
                    <a:lnTo>
                      <a:pt x="12085" y="46"/>
                    </a:lnTo>
                    <a:lnTo>
                      <a:pt x="12099" y="56"/>
                    </a:lnTo>
                    <a:lnTo>
                      <a:pt x="12114" y="55"/>
                    </a:lnTo>
                    <a:lnTo>
                      <a:pt x="12128" y="83"/>
                    </a:lnTo>
                    <a:lnTo>
                      <a:pt x="12142" y="66"/>
                    </a:lnTo>
                    <a:lnTo>
                      <a:pt x="12156" y="93"/>
                    </a:lnTo>
                    <a:lnTo>
                      <a:pt x="12170" y="81"/>
                    </a:lnTo>
                    <a:lnTo>
                      <a:pt x="12184" y="87"/>
                    </a:lnTo>
                    <a:lnTo>
                      <a:pt x="12198" y="107"/>
                    </a:lnTo>
                    <a:lnTo>
                      <a:pt x="12212" y="92"/>
                    </a:lnTo>
                    <a:lnTo>
                      <a:pt x="12226" y="108"/>
                    </a:lnTo>
                    <a:lnTo>
                      <a:pt x="12241" y="131"/>
                    </a:lnTo>
                    <a:lnTo>
                      <a:pt x="12255" y="193"/>
                    </a:lnTo>
                    <a:lnTo>
                      <a:pt x="12269" y="243"/>
                    </a:lnTo>
                    <a:lnTo>
                      <a:pt x="12283" y="334"/>
                    </a:lnTo>
                    <a:lnTo>
                      <a:pt x="12297" y="547"/>
                    </a:lnTo>
                    <a:lnTo>
                      <a:pt x="12311" y="787"/>
                    </a:lnTo>
                    <a:lnTo>
                      <a:pt x="12325" y="1159"/>
                    </a:lnTo>
                    <a:lnTo>
                      <a:pt x="12339" y="1514"/>
                    </a:lnTo>
                    <a:lnTo>
                      <a:pt x="12354" y="2001"/>
                    </a:lnTo>
                    <a:lnTo>
                      <a:pt x="12368" y="2510"/>
                    </a:lnTo>
                    <a:lnTo>
                      <a:pt x="12382" y="2857"/>
                    </a:lnTo>
                    <a:lnTo>
                      <a:pt x="12396" y="3150"/>
                    </a:lnTo>
                    <a:lnTo>
                      <a:pt x="12410" y="3425"/>
                    </a:lnTo>
                    <a:lnTo>
                      <a:pt x="12424" y="3345"/>
                    </a:lnTo>
                    <a:lnTo>
                      <a:pt x="12438" y="3313"/>
                    </a:lnTo>
                    <a:lnTo>
                      <a:pt x="12452" y="3031"/>
                    </a:lnTo>
                    <a:lnTo>
                      <a:pt x="12466" y="2741"/>
                    </a:lnTo>
                    <a:lnTo>
                      <a:pt x="12481" y="2214"/>
                    </a:lnTo>
                    <a:lnTo>
                      <a:pt x="12495" y="1799"/>
                    </a:lnTo>
                    <a:lnTo>
                      <a:pt x="12509" y="1518"/>
                    </a:lnTo>
                    <a:lnTo>
                      <a:pt x="12523" y="1253"/>
                    </a:lnTo>
                    <a:lnTo>
                      <a:pt x="12537" y="1009"/>
                    </a:lnTo>
                    <a:lnTo>
                      <a:pt x="12551" y="885"/>
                    </a:lnTo>
                    <a:lnTo>
                      <a:pt x="12565" y="694"/>
                    </a:lnTo>
                    <a:lnTo>
                      <a:pt x="12579" y="653"/>
                    </a:lnTo>
                    <a:lnTo>
                      <a:pt x="12593" y="562"/>
                    </a:lnTo>
                    <a:lnTo>
                      <a:pt x="12608" y="509"/>
                    </a:lnTo>
                    <a:lnTo>
                      <a:pt x="12622" y="436"/>
                    </a:lnTo>
                    <a:lnTo>
                      <a:pt x="12636" y="418"/>
                    </a:lnTo>
                    <a:lnTo>
                      <a:pt x="12650" y="409"/>
                    </a:lnTo>
                    <a:lnTo>
                      <a:pt x="12664" y="383"/>
                    </a:lnTo>
                    <a:lnTo>
                      <a:pt x="12678" y="360"/>
                    </a:lnTo>
                    <a:lnTo>
                      <a:pt x="12692" y="348"/>
                    </a:lnTo>
                    <a:lnTo>
                      <a:pt x="12706" y="345"/>
                    </a:lnTo>
                    <a:lnTo>
                      <a:pt x="12720" y="297"/>
                    </a:lnTo>
                    <a:lnTo>
                      <a:pt x="12735" y="287"/>
                    </a:lnTo>
                    <a:lnTo>
                      <a:pt x="12749" y="273"/>
                    </a:lnTo>
                    <a:lnTo>
                      <a:pt x="12763" y="294"/>
                    </a:lnTo>
                    <a:lnTo>
                      <a:pt x="12777" y="251"/>
                    </a:lnTo>
                    <a:lnTo>
                      <a:pt x="12791" y="227"/>
                    </a:lnTo>
                    <a:lnTo>
                      <a:pt x="12805" y="266"/>
                    </a:lnTo>
                    <a:lnTo>
                      <a:pt x="12819" y="215"/>
                    </a:lnTo>
                    <a:lnTo>
                      <a:pt x="12833" y="200"/>
                    </a:lnTo>
                    <a:lnTo>
                      <a:pt x="12847" y="212"/>
                    </a:lnTo>
                    <a:lnTo>
                      <a:pt x="12862" y="207"/>
                    </a:lnTo>
                    <a:lnTo>
                      <a:pt x="12876" y="219"/>
                    </a:lnTo>
                    <a:lnTo>
                      <a:pt x="12890" y="195"/>
                    </a:lnTo>
                    <a:lnTo>
                      <a:pt x="12904" y="158"/>
                    </a:lnTo>
                    <a:lnTo>
                      <a:pt x="12918" y="213"/>
                    </a:lnTo>
                    <a:lnTo>
                      <a:pt x="12932" y="161"/>
                    </a:lnTo>
                    <a:lnTo>
                      <a:pt x="12946" y="143"/>
                    </a:lnTo>
                    <a:lnTo>
                      <a:pt x="12960" y="156"/>
                    </a:lnTo>
                    <a:lnTo>
                      <a:pt x="12975" y="139"/>
                    </a:lnTo>
                    <a:lnTo>
                      <a:pt x="12989" y="155"/>
                    </a:lnTo>
                    <a:lnTo>
                      <a:pt x="13003" y="143"/>
                    </a:lnTo>
                    <a:lnTo>
                      <a:pt x="13017" y="145"/>
                    </a:lnTo>
                    <a:lnTo>
                      <a:pt x="13031" y="131"/>
                    </a:lnTo>
                    <a:lnTo>
                      <a:pt x="13045" y="121"/>
                    </a:lnTo>
                    <a:lnTo>
                      <a:pt x="13059" y="116"/>
                    </a:lnTo>
                    <a:lnTo>
                      <a:pt x="13073" y="143"/>
                    </a:lnTo>
                    <a:lnTo>
                      <a:pt x="13087" y="111"/>
                    </a:lnTo>
                    <a:lnTo>
                      <a:pt x="13102" y="117"/>
                    </a:lnTo>
                    <a:lnTo>
                      <a:pt x="13116" y="104"/>
                    </a:lnTo>
                    <a:lnTo>
                      <a:pt x="13130" y="126"/>
                    </a:lnTo>
                    <a:lnTo>
                      <a:pt x="13144" y="70"/>
                    </a:lnTo>
                    <a:lnTo>
                      <a:pt x="13158" y="81"/>
                    </a:lnTo>
                    <a:lnTo>
                      <a:pt x="13172" y="76"/>
                    </a:lnTo>
                    <a:lnTo>
                      <a:pt x="13186" y="66"/>
                    </a:lnTo>
                    <a:lnTo>
                      <a:pt x="13200" y="60"/>
                    </a:lnTo>
                    <a:lnTo>
                      <a:pt x="13214" y="69"/>
                    </a:lnTo>
                    <a:lnTo>
                      <a:pt x="13229" y="88"/>
                    </a:lnTo>
                    <a:lnTo>
                      <a:pt x="13243" y="73"/>
                    </a:lnTo>
                    <a:lnTo>
                      <a:pt x="13257" y="56"/>
                    </a:lnTo>
                    <a:lnTo>
                      <a:pt x="13271" y="32"/>
                    </a:lnTo>
                    <a:lnTo>
                      <a:pt x="13285" y="55"/>
                    </a:lnTo>
                    <a:lnTo>
                      <a:pt x="13299" y="74"/>
                    </a:lnTo>
                    <a:lnTo>
                      <a:pt x="13301" y="72"/>
                    </a:lnTo>
                  </a:path>
                </a:pathLst>
              </a:custGeom>
              <a:noFill/>
              <a:ln w="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3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" name="TextBox 6"/>
            <p:cNvSpPr txBox="1"/>
            <p:nvPr/>
          </p:nvSpPr>
          <p:spPr>
            <a:xfrm>
              <a:off x="1655756" y="4401979"/>
              <a:ext cx="5578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tention time </a:t>
              </a:r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min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92105" y="3306979"/>
              <a:ext cx="189230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lative </a:t>
              </a:r>
              <a:r>
                <a:rPr lang="de-DE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bundance</a:t>
              </a:r>
              <a:r>
                <a:rPr lang="de-DE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TIC x 100,000 </a:t>
              </a:r>
              <a:r>
                <a:rPr lang="de-DE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ons</a:t>
              </a:r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Rectangle 470"/>
            <p:cNvSpPr>
              <a:spLocks noChangeArrowheads="1"/>
            </p:cNvSpPr>
            <p:nvPr/>
          </p:nvSpPr>
          <p:spPr bwMode="auto">
            <a:xfrm>
              <a:off x="1461556" y="4011886"/>
              <a:ext cx="2294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</a:t>
              </a:r>
              <a:endParaRPr kumimoji="0" lang="en-US" altLang="en-US" sz="4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" name="Rectangle 470"/>
            <p:cNvSpPr>
              <a:spLocks noChangeArrowheads="1"/>
            </p:cNvSpPr>
            <p:nvPr/>
          </p:nvSpPr>
          <p:spPr bwMode="auto">
            <a:xfrm>
              <a:off x="2413724" y="3909448"/>
              <a:ext cx="2294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</a:t>
              </a:r>
              <a:endParaRPr kumimoji="0" lang="en-US" altLang="en-US" sz="4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1" name="Rectangle 470"/>
            <p:cNvSpPr>
              <a:spLocks noChangeArrowheads="1"/>
            </p:cNvSpPr>
            <p:nvPr/>
          </p:nvSpPr>
          <p:spPr bwMode="auto">
            <a:xfrm>
              <a:off x="2546830" y="3908156"/>
              <a:ext cx="2294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3</a:t>
              </a:r>
              <a:endParaRPr kumimoji="0" lang="en-US" altLang="en-US" sz="4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2" name="Rectangle 470"/>
            <p:cNvSpPr>
              <a:spLocks noChangeArrowheads="1"/>
            </p:cNvSpPr>
            <p:nvPr/>
          </p:nvSpPr>
          <p:spPr bwMode="auto">
            <a:xfrm>
              <a:off x="3022191" y="3427185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4</a:t>
              </a:r>
              <a:endParaRPr kumimoji="0" lang="en-US" altLang="en-US" sz="4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3" name="Rectangle 470"/>
            <p:cNvSpPr>
              <a:spLocks noChangeArrowheads="1"/>
            </p:cNvSpPr>
            <p:nvPr/>
          </p:nvSpPr>
          <p:spPr bwMode="auto">
            <a:xfrm>
              <a:off x="3020532" y="2780921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4</a:t>
              </a:r>
              <a:endParaRPr kumimoji="0" lang="en-US" altLang="en-US" sz="4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334647" y="2665648"/>
              <a:ext cx="95813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uninfected</a:t>
              </a:r>
              <a:r>
                <a:rPr lang="de-DE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oots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214458" y="3345098"/>
              <a:ext cx="119851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. </a:t>
              </a:r>
              <a:r>
                <a:rPr lang="de-DE" sz="10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actorum</a:t>
              </a:r>
              <a:r>
                <a:rPr lang="de-DE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-infected</a:t>
              </a:r>
              <a:r>
                <a:rPr lang="de-DE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oots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857311" y="2527313"/>
              <a:ext cx="12504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7" name="Chart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25298843"/>
                </p:ext>
              </p:extLst>
            </p:nvPr>
          </p:nvGraphicFramePr>
          <p:xfrm>
            <a:off x="3636533" y="2572062"/>
            <a:ext cx="2102126" cy="201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8" name="Textfeld 15"/>
            <p:cNvSpPr txBox="1"/>
            <p:nvPr/>
          </p:nvSpPr>
          <p:spPr>
            <a:xfrm>
              <a:off x="3575023" y="2527313"/>
              <a:ext cx="48875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b="1" dirty="0" smtClean="0">
                  <a:latin typeface="Arial" charset="0"/>
                  <a:ea typeface="Arial" charset="0"/>
                  <a:cs typeface="Arial" charset="0"/>
                </a:rPr>
                <a:t>B</a:t>
              </a:r>
              <a:endParaRPr lang="de-DE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9" name="Textfeld 28"/>
            <p:cNvSpPr txBox="1"/>
            <p:nvPr/>
          </p:nvSpPr>
          <p:spPr>
            <a:xfrm>
              <a:off x="4644686" y="3075801"/>
              <a:ext cx="377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charset="0"/>
                  <a:ea typeface="Arial" charset="0"/>
                  <a:cs typeface="Arial" charset="0"/>
                </a:rPr>
                <a:t>***</a:t>
              </a:r>
              <a:endParaRPr lang="de-DE" sz="12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0" name="Rectangle 19"/>
            <p:cNvSpPr/>
            <p:nvPr/>
          </p:nvSpPr>
          <p:spPr>
            <a:xfrm>
              <a:off x="4116817" y="2571690"/>
              <a:ext cx="1469442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de-DE" sz="10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. </a:t>
              </a:r>
              <a:r>
                <a:rPr lang="de-DE" sz="10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actorum</a:t>
              </a:r>
              <a:r>
                <a:rPr lang="de-DE" sz="10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Ypt1 </a:t>
              </a:r>
              <a:r>
                <a:rPr lang="de-DE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xpression</a:t>
              </a:r>
              <a:endParaRPr lang="en-US" sz="1000" b="1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197586" y="4269838"/>
              <a:ext cx="70287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uninfected</a:t>
              </a:r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oots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847996" y="4269838"/>
              <a:ext cx="81446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. </a:t>
              </a:r>
              <a:r>
                <a:rPr lang="de-DE" sz="8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actorum</a:t>
              </a:r>
              <a:r>
                <a:rPr lang="de-D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-infected</a:t>
              </a:r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oots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 rot="16200000">
              <a:off x="2973121" y="3519348"/>
              <a:ext cx="1489272" cy="1909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lative </a:t>
              </a:r>
              <a:r>
                <a:rPr lang="de-DE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xpressio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380099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Line 5"/>
          <p:cNvSpPr>
            <a:spLocks noChangeShapeType="1"/>
          </p:cNvSpPr>
          <p:nvPr/>
        </p:nvSpPr>
        <p:spPr bwMode="auto">
          <a:xfrm>
            <a:off x="1392239" y="6640513"/>
            <a:ext cx="49958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Line 6"/>
          <p:cNvSpPr>
            <a:spLocks noChangeShapeType="1"/>
          </p:cNvSpPr>
          <p:nvPr/>
        </p:nvSpPr>
        <p:spPr bwMode="auto">
          <a:xfrm flipV="1">
            <a:off x="1408114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Line 7"/>
          <p:cNvSpPr>
            <a:spLocks noChangeShapeType="1"/>
          </p:cNvSpPr>
          <p:nvPr/>
        </p:nvSpPr>
        <p:spPr bwMode="auto">
          <a:xfrm flipV="1">
            <a:off x="1563689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Line 8"/>
          <p:cNvSpPr>
            <a:spLocks noChangeShapeType="1"/>
          </p:cNvSpPr>
          <p:nvPr/>
        </p:nvSpPr>
        <p:spPr bwMode="auto">
          <a:xfrm flipV="1">
            <a:off x="1717677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Line 9"/>
          <p:cNvSpPr>
            <a:spLocks noChangeShapeType="1"/>
          </p:cNvSpPr>
          <p:nvPr/>
        </p:nvSpPr>
        <p:spPr bwMode="auto">
          <a:xfrm flipV="1">
            <a:off x="1873252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Line 10"/>
          <p:cNvSpPr>
            <a:spLocks noChangeShapeType="1"/>
          </p:cNvSpPr>
          <p:nvPr/>
        </p:nvSpPr>
        <p:spPr bwMode="auto">
          <a:xfrm flipV="1">
            <a:off x="2027239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Line 11"/>
          <p:cNvSpPr>
            <a:spLocks noChangeShapeType="1"/>
          </p:cNvSpPr>
          <p:nvPr/>
        </p:nvSpPr>
        <p:spPr bwMode="auto">
          <a:xfrm flipV="1">
            <a:off x="2182814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Line 12"/>
          <p:cNvSpPr>
            <a:spLocks noChangeShapeType="1"/>
          </p:cNvSpPr>
          <p:nvPr/>
        </p:nvSpPr>
        <p:spPr bwMode="auto">
          <a:xfrm flipV="1">
            <a:off x="2338389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Line 13"/>
          <p:cNvSpPr>
            <a:spLocks noChangeShapeType="1"/>
          </p:cNvSpPr>
          <p:nvPr/>
        </p:nvSpPr>
        <p:spPr bwMode="auto">
          <a:xfrm flipV="1">
            <a:off x="2492377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Line 14"/>
          <p:cNvSpPr>
            <a:spLocks noChangeShapeType="1"/>
          </p:cNvSpPr>
          <p:nvPr/>
        </p:nvSpPr>
        <p:spPr bwMode="auto">
          <a:xfrm flipV="1">
            <a:off x="2646364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Line 15"/>
          <p:cNvSpPr>
            <a:spLocks noChangeShapeType="1"/>
          </p:cNvSpPr>
          <p:nvPr/>
        </p:nvSpPr>
        <p:spPr bwMode="auto">
          <a:xfrm flipV="1">
            <a:off x="2801939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Line 16"/>
          <p:cNvSpPr>
            <a:spLocks noChangeShapeType="1"/>
          </p:cNvSpPr>
          <p:nvPr/>
        </p:nvSpPr>
        <p:spPr bwMode="auto">
          <a:xfrm flipV="1">
            <a:off x="2957514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Line 17"/>
          <p:cNvSpPr>
            <a:spLocks noChangeShapeType="1"/>
          </p:cNvSpPr>
          <p:nvPr/>
        </p:nvSpPr>
        <p:spPr bwMode="auto">
          <a:xfrm flipV="1">
            <a:off x="3111502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Line 18"/>
          <p:cNvSpPr>
            <a:spLocks noChangeShapeType="1"/>
          </p:cNvSpPr>
          <p:nvPr/>
        </p:nvSpPr>
        <p:spPr bwMode="auto">
          <a:xfrm flipV="1">
            <a:off x="3267077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Line 19"/>
          <p:cNvSpPr>
            <a:spLocks noChangeShapeType="1"/>
          </p:cNvSpPr>
          <p:nvPr/>
        </p:nvSpPr>
        <p:spPr bwMode="auto">
          <a:xfrm flipV="1">
            <a:off x="3421064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Line 20"/>
          <p:cNvSpPr>
            <a:spLocks noChangeShapeType="1"/>
          </p:cNvSpPr>
          <p:nvPr/>
        </p:nvSpPr>
        <p:spPr bwMode="auto">
          <a:xfrm flipV="1">
            <a:off x="3576639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Line 21"/>
          <p:cNvSpPr>
            <a:spLocks noChangeShapeType="1"/>
          </p:cNvSpPr>
          <p:nvPr/>
        </p:nvSpPr>
        <p:spPr bwMode="auto">
          <a:xfrm flipV="1">
            <a:off x="3732214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Line 22"/>
          <p:cNvSpPr>
            <a:spLocks noChangeShapeType="1"/>
          </p:cNvSpPr>
          <p:nvPr/>
        </p:nvSpPr>
        <p:spPr bwMode="auto">
          <a:xfrm flipV="1">
            <a:off x="3886202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Line 23"/>
          <p:cNvSpPr>
            <a:spLocks noChangeShapeType="1"/>
          </p:cNvSpPr>
          <p:nvPr/>
        </p:nvSpPr>
        <p:spPr bwMode="auto">
          <a:xfrm flipV="1">
            <a:off x="4041777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Line 24"/>
          <p:cNvSpPr>
            <a:spLocks noChangeShapeType="1"/>
          </p:cNvSpPr>
          <p:nvPr/>
        </p:nvSpPr>
        <p:spPr bwMode="auto">
          <a:xfrm flipV="1">
            <a:off x="4195764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Line 25"/>
          <p:cNvSpPr>
            <a:spLocks noChangeShapeType="1"/>
          </p:cNvSpPr>
          <p:nvPr/>
        </p:nvSpPr>
        <p:spPr bwMode="auto">
          <a:xfrm flipV="1">
            <a:off x="4351339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Line 26"/>
          <p:cNvSpPr>
            <a:spLocks noChangeShapeType="1"/>
          </p:cNvSpPr>
          <p:nvPr/>
        </p:nvSpPr>
        <p:spPr bwMode="auto">
          <a:xfrm flipV="1">
            <a:off x="4505327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Line 27"/>
          <p:cNvSpPr>
            <a:spLocks noChangeShapeType="1"/>
          </p:cNvSpPr>
          <p:nvPr/>
        </p:nvSpPr>
        <p:spPr bwMode="auto">
          <a:xfrm flipV="1">
            <a:off x="4660902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Line 28"/>
          <p:cNvSpPr>
            <a:spLocks noChangeShapeType="1"/>
          </p:cNvSpPr>
          <p:nvPr/>
        </p:nvSpPr>
        <p:spPr bwMode="auto">
          <a:xfrm flipV="1">
            <a:off x="4816477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Line 29"/>
          <p:cNvSpPr>
            <a:spLocks noChangeShapeType="1"/>
          </p:cNvSpPr>
          <p:nvPr/>
        </p:nvSpPr>
        <p:spPr bwMode="auto">
          <a:xfrm flipV="1">
            <a:off x="4970464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Line 30"/>
          <p:cNvSpPr>
            <a:spLocks noChangeShapeType="1"/>
          </p:cNvSpPr>
          <p:nvPr/>
        </p:nvSpPr>
        <p:spPr bwMode="auto">
          <a:xfrm flipV="1">
            <a:off x="5124452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Line 31"/>
          <p:cNvSpPr>
            <a:spLocks noChangeShapeType="1"/>
          </p:cNvSpPr>
          <p:nvPr/>
        </p:nvSpPr>
        <p:spPr bwMode="auto">
          <a:xfrm flipV="1">
            <a:off x="5280027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Line 32"/>
          <p:cNvSpPr>
            <a:spLocks noChangeShapeType="1"/>
          </p:cNvSpPr>
          <p:nvPr/>
        </p:nvSpPr>
        <p:spPr bwMode="auto">
          <a:xfrm flipV="1">
            <a:off x="5435602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Line 33"/>
          <p:cNvSpPr>
            <a:spLocks noChangeShapeType="1"/>
          </p:cNvSpPr>
          <p:nvPr/>
        </p:nvSpPr>
        <p:spPr bwMode="auto">
          <a:xfrm flipV="1">
            <a:off x="5589589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Line 34"/>
          <p:cNvSpPr>
            <a:spLocks noChangeShapeType="1"/>
          </p:cNvSpPr>
          <p:nvPr/>
        </p:nvSpPr>
        <p:spPr bwMode="auto">
          <a:xfrm flipV="1">
            <a:off x="5745164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Line 35"/>
          <p:cNvSpPr>
            <a:spLocks noChangeShapeType="1"/>
          </p:cNvSpPr>
          <p:nvPr/>
        </p:nvSpPr>
        <p:spPr bwMode="auto">
          <a:xfrm flipV="1">
            <a:off x="5899152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Line 36"/>
          <p:cNvSpPr>
            <a:spLocks noChangeShapeType="1"/>
          </p:cNvSpPr>
          <p:nvPr/>
        </p:nvSpPr>
        <p:spPr bwMode="auto">
          <a:xfrm flipV="1">
            <a:off x="6054727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Line 37"/>
          <p:cNvSpPr>
            <a:spLocks noChangeShapeType="1"/>
          </p:cNvSpPr>
          <p:nvPr/>
        </p:nvSpPr>
        <p:spPr bwMode="auto">
          <a:xfrm flipV="1">
            <a:off x="6208714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Line 38"/>
          <p:cNvSpPr>
            <a:spLocks noChangeShapeType="1"/>
          </p:cNvSpPr>
          <p:nvPr/>
        </p:nvSpPr>
        <p:spPr bwMode="auto">
          <a:xfrm flipV="1">
            <a:off x="6364289" y="6640513"/>
            <a:ext cx="0" cy="428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tangle 39"/>
          <p:cNvSpPr>
            <a:spLocks noChangeArrowheads="1"/>
          </p:cNvSpPr>
          <p:nvPr/>
        </p:nvSpPr>
        <p:spPr bwMode="auto">
          <a:xfrm>
            <a:off x="1858964" y="6753225"/>
            <a:ext cx="3524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0.00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2" name="Rectangle 40"/>
          <p:cNvSpPr>
            <a:spLocks noChangeArrowheads="1"/>
          </p:cNvSpPr>
          <p:nvPr/>
        </p:nvSpPr>
        <p:spPr bwMode="auto">
          <a:xfrm>
            <a:off x="2633664" y="6753225"/>
            <a:ext cx="3524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15.00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3" name="Rectangle 41"/>
          <p:cNvSpPr>
            <a:spLocks noChangeArrowheads="1"/>
          </p:cNvSpPr>
          <p:nvPr/>
        </p:nvSpPr>
        <p:spPr bwMode="auto">
          <a:xfrm>
            <a:off x="3408364" y="6753225"/>
            <a:ext cx="3524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20.00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4" name="Rectangle 42"/>
          <p:cNvSpPr>
            <a:spLocks noChangeArrowheads="1"/>
          </p:cNvSpPr>
          <p:nvPr/>
        </p:nvSpPr>
        <p:spPr bwMode="auto">
          <a:xfrm>
            <a:off x="4183064" y="6753225"/>
            <a:ext cx="3524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25.00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5" name="Rectangle 43"/>
          <p:cNvSpPr>
            <a:spLocks noChangeArrowheads="1"/>
          </p:cNvSpPr>
          <p:nvPr/>
        </p:nvSpPr>
        <p:spPr bwMode="auto">
          <a:xfrm>
            <a:off x="4956177" y="6753225"/>
            <a:ext cx="3524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30.00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6" name="Rectangle 44"/>
          <p:cNvSpPr>
            <a:spLocks noChangeArrowheads="1"/>
          </p:cNvSpPr>
          <p:nvPr/>
        </p:nvSpPr>
        <p:spPr bwMode="auto">
          <a:xfrm>
            <a:off x="5730877" y="6753225"/>
            <a:ext cx="35242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35.00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7" name="Line 45"/>
          <p:cNvSpPr>
            <a:spLocks noChangeShapeType="1"/>
          </p:cNvSpPr>
          <p:nvPr/>
        </p:nvSpPr>
        <p:spPr bwMode="auto">
          <a:xfrm flipV="1">
            <a:off x="2027239" y="6640513"/>
            <a:ext cx="0" cy="873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Line 46"/>
          <p:cNvSpPr>
            <a:spLocks noChangeShapeType="1"/>
          </p:cNvSpPr>
          <p:nvPr/>
        </p:nvSpPr>
        <p:spPr bwMode="auto">
          <a:xfrm flipV="1">
            <a:off x="2801939" y="6640513"/>
            <a:ext cx="0" cy="873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Line 47"/>
          <p:cNvSpPr>
            <a:spLocks noChangeShapeType="1"/>
          </p:cNvSpPr>
          <p:nvPr/>
        </p:nvSpPr>
        <p:spPr bwMode="auto">
          <a:xfrm flipV="1">
            <a:off x="3576639" y="6640513"/>
            <a:ext cx="0" cy="873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Line 48"/>
          <p:cNvSpPr>
            <a:spLocks noChangeShapeType="1"/>
          </p:cNvSpPr>
          <p:nvPr/>
        </p:nvSpPr>
        <p:spPr bwMode="auto">
          <a:xfrm flipV="1">
            <a:off x="4351339" y="6640513"/>
            <a:ext cx="0" cy="873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Line 49"/>
          <p:cNvSpPr>
            <a:spLocks noChangeShapeType="1"/>
          </p:cNvSpPr>
          <p:nvPr/>
        </p:nvSpPr>
        <p:spPr bwMode="auto">
          <a:xfrm flipV="1">
            <a:off x="5124452" y="6640513"/>
            <a:ext cx="0" cy="873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Line 50"/>
          <p:cNvSpPr>
            <a:spLocks noChangeShapeType="1"/>
          </p:cNvSpPr>
          <p:nvPr/>
        </p:nvSpPr>
        <p:spPr bwMode="auto">
          <a:xfrm flipV="1">
            <a:off x="5899152" y="6640513"/>
            <a:ext cx="0" cy="873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Line 51"/>
          <p:cNvSpPr>
            <a:spLocks noChangeShapeType="1"/>
          </p:cNvSpPr>
          <p:nvPr/>
        </p:nvSpPr>
        <p:spPr bwMode="auto">
          <a:xfrm flipV="1">
            <a:off x="1392239" y="381000"/>
            <a:ext cx="0" cy="62595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Line 52"/>
          <p:cNvSpPr>
            <a:spLocks noChangeShapeType="1"/>
          </p:cNvSpPr>
          <p:nvPr/>
        </p:nvSpPr>
        <p:spPr bwMode="auto">
          <a:xfrm>
            <a:off x="1384302" y="6640513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Line 53"/>
          <p:cNvSpPr>
            <a:spLocks noChangeShapeType="1"/>
          </p:cNvSpPr>
          <p:nvPr/>
        </p:nvSpPr>
        <p:spPr bwMode="auto">
          <a:xfrm>
            <a:off x="1384302" y="6564313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Line 54"/>
          <p:cNvSpPr>
            <a:spLocks noChangeShapeType="1"/>
          </p:cNvSpPr>
          <p:nvPr/>
        </p:nvSpPr>
        <p:spPr bwMode="auto">
          <a:xfrm>
            <a:off x="1384302" y="6486525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Line 55"/>
          <p:cNvSpPr>
            <a:spLocks noChangeShapeType="1"/>
          </p:cNvSpPr>
          <p:nvPr/>
        </p:nvSpPr>
        <p:spPr bwMode="auto">
          <a:xfrm>
            <a:off x="1384302" y="6410325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Line 56"/>
          <p:cNvSpPr>
            <a:spLocks noChangeShapeType="1"/>
          </p:cNvSpPr>
          <p:nvPr/>
        </p:nvSpPr>
        <p:spPr bwMode="auto">
          <a:xfrm>
            <a:off x="1384302" y="6334125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Line 57"/>
          <p:cNvSpPr>
            <a:spLocks noChangeShapeType="1"/>
          </p:cNvSpPr>
          <p:nvPr/>
        </p:nvSpPr>
        <p:spPr bwMode="auto">
          <a:xfrm>
            <a:off x="1384302" y="6256338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Line 58"/>
          <p:cNvSpPr>
            <a:spLocks noChangeShapeType="1"/>
          </p:cNvSpPr>
          <p:nvPr/>
        </p:nvSpPr>
        <p:spPr bwMode="auto">
          <a:xfrm>
            <a:off x="1384302" y="6180138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Line 59"/>
          <p:cNvSpPr>
            <a:spLocks noChangeShapeType="1"/>
          </p:cNvSpPr>
          <p:nvPr/>
        </p:nvSpPr>
        <p:spPr bwMode="auto">
          <a:xfrm>
            <a:off x="1384302" y="6102350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Line 60"/>
          <p:cNvSpPr>
            <a:spLocks noChangeShapeType="1"/>
          </p:cNvSpPr>
          <p:nvPr/>
        </p:nvSpPr>
        <p:spPr bwMode="auto">
          <a:xfrm>
            <a:off x="1384302" y="6026150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Line 61"/>
          <p:cNvSpPr>
            <a:spLocks noChangeShapeType="1"/>
          </p:cNvSpPr>
          <p:nvPr/>
        </p:nvSpPr>
        <p:spPr bwMode="auto">
          <a:xfrm>
            <a:off x="1384302" y="5949950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Line 62"/>
          <p:cNvSpPr>
            <a:spLocks noChangeShapeType="1"/>
          </p:cNvSpPr>
          <p:nvPr/>
        </p:nvSpPr>
        <p:spPr bwMode="auto">
          <a:xfrm>
            <a:off x="1384302" y="5872163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Line 63"/>
          <p:cNvSpPr>
            <a:spLocks noChangeShapeType="1"/>
          </p:cNvSpPr>
          <p:nvPr/>
        </p:nvSpPr>
        <p:spPr bwMode="auto">
          <a:xfrm>
            <a:off x="1384302" y="5795963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Line 64"/>
          <p:cNvSpPr>
            <a:spLocks noChangeShapeType="1"/>
          </p:cNvSpPr>
          <p:nvPr/>
        </p:nvSpPr>
        <p:spPr bwMode="auto">
          <a:xfrm>
            <a:off x="1384302" y="5719763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Line 65"/>
          <p:cNvSpPr>
            <a:spLocks noChangeShapeType="1"/>
          </p:cNvSpPr>
          <p:nvPr/>
        </p:nvSpPr>
        <p:spPr bwMode="auto">
          <a:xfrm>
            <a:off x="1384302" y="5641975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Line 66"/>
          <p:cNvSpPr>
            <a:spLocks noChangeShapeType="1"/>
          </p:cNvSpPr>
          <p:nvPr/>
        </p:nvSpPr>
        <p:spPr bwMode="auto">
          <a:xfrm>
            <a:off x="1384302" y="5565775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Line 67"/>
          <p:cNvSpPr>
            <a:spLocks noChangeShapeType="1"/>
          </p:cNvSpPr>
          <p:nvPr/>
        </p:nvSpPr>
        <p:spPr bwMode="auto">
          <a:xfrm>
            <a:off x="1384302" y="5489575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Line 68"/>
          <p:cNvSpPr>
            <a:spLocks noChangeShapeType="1"/>
          </p:cNvSpPr>
          <p:nvPr/>
        </p:nvSpPr>
        <p:spPr bwMode="auto">
          <a:xfrm>
            <a:off x="1384302" y="5411788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Line 69"/>
          <p:cNvSpPr>
            <a:spLocks noChangeShapeType="1"/>
          </p:cNvSpPr>
          <p:nvPr/>
        </p:nvSpPr>
        <p:spPr bwMode="auto">
          <a:xfrm>
            <a:off x="1384302" y="5335588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Line 70"/>
          <p:cNvSpPr>
            <a:spLocks noChangeShapeType="1"/>
          </p:cNvSpPr>
          <p:nvPr/>
        </p:nvSpPr>
        <p:spPr bwMode="auto">
          <a:xfrm>
            <a:off x="1384302" y="5259388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Line 71"/>
          <p:cNvSpPr>
            <a:spLocks noChangeShapeType="1"/>
          </p:cNvSpPr>
          <p:nvPr/>
        </p:nvSpPr>
        <p:spPr bwMode="auto">
          <a:xfrm>
            <a:off x="1384302" y="5181600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Line 72"/>
          <p:cNvSpPr>
            <a:spLocks noChangeShapeType="1"/>
          </p:cNvSpPr>
          <p:nvPr/>
        </p:nvSpPr>
        <p:spPr bwMode="auto">
          <a:xfrm>
            <a:off x="1384302" y="5105400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Line 73"/>
          <p:cNvSpPr>
            <a:spLocks noChangeShapeType="1"/>
          </p:cNvSpPr>
          <p:nvPr/>
        </p:nvSpPr>
        <p:spPr bwMode="auto">
          <a:xfrm>
            <a:off x="1384302" y="5029200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Line 74"/>
          <p:cNvSpPr>
            <a:spLocks noChangeShapeType="1"/>
          </p:cNvSpPr>
          <p:nvPr/>
        </p:nvSpPr>
        <p:spPr bwMode="auto">
          <a:xfrm>
            <a:off x="1384302" y="4951413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Line 75"/>
          <p:cNvSpPr>
            <a:spLocks noChangeShapeType="1"/>
          </p:cNvSpPr>
          <p:nvPr/>
        </p:nvSpPr>
        <p:spPr bwMode="auto">
          <a:xfrm>
            <a:off x="1384302" y="4875213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Line 76"/>
          <p:cNvSpPr>
            <a:spLocks noChangeShapeType="1"/>
          </p:cNvSpPr>
          <p:nvPr/>
        </p:nvSpPr>
        <p:spPr bwMode="auto">
          <a:xfrm>
            <a:off x="1384302" y="4799013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Line 77"/>
          <p:cNvSpPr>
            <a:spLocks noChangeShapeType="1"/>
          </p:cNvSpPr>
          <p:nvPr/>
        </p:nvSpPr>
        <p:spPr bwMode="auto">
          <a:xfrm>
            <a:off x="1384302" y="4721225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Line 78"/>
          <p:cNvSpPr>
            <a:spLocks noChangeShapeType="1"/>
          </p:cNvSpPr>
          <p:nvPr/>
        </p:nvSpPr>
        <p:spPr bwMode="auto">
          <a:xfrm>
            <a:off x="1384302" y="4645025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Line 79"/>
          <p:cNvSpPr>
            <a:spLocks noChangeShapeType="1"/>
          </p:cNvSpPr>
          <p:nvPr/>
        </p:nvSpPr>
        <p:spPr bwMode="auto">
          <a:xfrm>
            <a:off x="1384302" y="4568825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Line 80"/>
          <p:cNvSpPr>
            <a:spLocks noChangeShapeType="1"/>
          </p:cNvSpPr>
          <p:nvPr/>
        </p:nvSpPr>
        <p:spPr bwMode="auto">
          <a:xfrm>
            <a:off x="1384302" y="4491038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Line 81"/>
          <p:cNvSpPr>
            <a:spLocks noChangeShapeType="1"/>
          </p:cNvSpPr>
          <p:nvPr/>
        </p:nvSpPr>
        <p:spPr bwMode="auto">
          <a:xfrm>
            <a:off x="1384302" y="4414838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Line 82"/>
          <p:cNvSpPr>
            <a:spLocks noChangeShapeType="1"/>
          </p:cNvSpPr>
          <p:nvPr/>
        </p:nvSpPr>
        <p:spPr bwMode="auto">
          <a:xfrm>
            <a:off x="1384302" y="4338638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Line 83"/>
          <p:cNvSpPr>
            <a:spLocks noChangeShapeType="1"/>
          </p:cNvSpPr>
          <p:nvPr/>
        </p:nvSpPr>
        <p:spPr bwMode="auto">
          <a:xfrm>
            <a:off x="1384302" y="4260850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Line 84"/>
          <p:cNvSpPr>
            <a:spLocks noChangeShapeType="1"/>
          </p:cNvSpPr>
          <p:nvPr/>
        </p:nvSpPr>
        <p:spPr bwMode="auto">
          <a:xfrm>
            <a:off x="1384302" y="4183063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Line 85"/>
          <p:cNvSpPr>
            <a:spLocks noChangeShapeType="1"/>
          </p:cNvSpPr>
          <p:nvPr/>
        </p:nvSpPr>
        <p:spPr bwMode="auto">
          <a:xfrm>
            <a:off x="1384302" y="4106863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Line 86"/>
          <p:cNvSpPr>
            <a:spLocks noChangeShapeType="1"/>
          </p:cNvSpPr>
          <p:nvPr/>
        </p:nvSpPr>
        <p:spPr bwMode="auto">
          <a:xfrm>
            <a:off x="1384302" y="4030663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Line 87"/>
          <p:cNvSpPr>
            <a:spLocks noChangeShapeType="1"/>
          </p:cNvSpPr>
          <p:nvPr/>
        </p:nvSpPr>
        <p:spPr bwMode="auto">
          <a:xfrm>
            <a:off x="1384302" y="3954463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Line 88"/>
          <p:cNvSpPr>
            <a:spLocks noChangeShapeType="1"/>
          </p:cNvSpPr>
          <p:nvPr/>
        </p:nvSpPr>
        <p:spPr bwMode="auto">
          <a:xfrm>
            <a:off x="1384302" y="3876675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Line 89"/>
          <p:cNvSpPr>
            <a:spLocks noChangeShapeType="1"/>
          </p:cNvSpPr>
          <p:nvPr/>
        </p:nvSpPr>
        <p:spPr bwMode="auto">
          <a:xfrm>
            <a:off x="1384302" y="3800475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Line 90"/>
          <p:cNvSpPr>
            <a:spLocks noChangeShapeType="1"/>
          </p:cNvSpPr>
          <p:nvPr/>
        </p:nvSpPr>
        <p:spPr bwMode="auto">
          <a:xfrm>
            <a:off x="1384302" y="3724275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Line 91"/>
          <p:cNvSpPr>
            <a:spLocks noChangeShapeType="1"/>
          </p:cNvSpPr>
          <p:nvPr/>
        </p:nvSpPr>
        <p:spPr bwMode="auto">
          <a:xfrm>
            <a:off x="1384302" y="3646488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Line 92"/>
          <p:cNvSpPr>
            <a:spLocks noChangeShapeType="1"/>
          </p:cNvSpPr>
          <p:nvPr/>
        </p:nvSpPr>
        <p:spPr bwMode="auto">
          <a:xfrm>
            <a:off x="1384302" y="3570288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Line 93"/>
          <p:cNvSpPr>
            <a:spLocks noChangeShapeType="1"/>
          </p:cNvSpPr>
          <p:nvPr/>
        </p:nvSpPr>
        <p:spPr bwMode="auto">
          <a:xfrm>
            <a:off x="1384302" y="3494088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Line 94"/>
          <p:cNvSpPr>
            <a:spLocks noChangeShapeType="1"/>
          </p:cNvSpPr>
          <p:nvPr/>
        </p:nvSpPr>
        <p:spPr bwMode="auto">
          <a:xfrm>
            <a:off x="1384302" y="3416300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Line 95"/>
          <p:cNvSpPr>
            <a:spLocks noChangeShapeType="1"/>
          </p:cNvSpPr>
          <p:nvPr/>
        </p:nvSpPr>
        <p:spPr bwMode="auto">
          <a:xfrm>
            <a:off x="1384302" y="3340100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Line 96"/>
          <p:cNvSpPr>
            <a:spLocks noChangeShapeType="1"/>
          </p:cNvSpPr>
          <p:nvPr/>
        </p:nvSpPr>
        <p:spPr bwMode="auto">
          <a:xfrm>
            <a:off x="1384302" y="3263900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Line 97"/>
          <p:cNvSpPr>
            <a:spLocks noChangeShapeType="1"/>
          </p:cNvSpPr>
          <p:nvPr/>
        </p:nvSpPr>
        <p:spPr bwMode="auto">
          <a:xfrm>
            <a:off x="1384302" y="3186113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Line 98"/>
          <p:cNvSpPr>
            <a:spLocks noChangeShapeType="1"/>
          </p:cNvSpPr>
          <p:nvPr/>
        </p:nvSpPr>
        <p:spPr bwMode="auto">
          <a:xfrm>
            <a:off x="1384302" y="3109913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Line 99"/>
          <p:cNvSpPr>
            <a:spLocks noChangeShapeType="1"/>
          </p:cNvSpPr>
          <p:nvPr/>
        </p:nvSpPr>
        <p:spPr bwMode="auto">
          <a:xfrm>
            <a:off x="1384302" y="3033713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Line 100"/>
          <p:cNvSpPr>
            <a:spLocks noChangeShapeType="1"/>
          </p:cNvSpPr>
          <p:nvPr/>
        </p:nvSpPr>
        <p:spPr bwMode="auto">
          <a:xfrm>
            <a:off x="1384302" y="2955925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Line 101"/>
          <p:cNvSpPr>
            <a:spLocks noChangeShapeType="1"/>
          </p:cNvSpPr>
          <p:nvPr/>
        </p:nvSpPr>
        <p:spPr bwMode="auto">
          <a:xfrm>
            <a:off x="1384302" y="2879725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Line 102"/>
          <p:cNvSpPr>
            <a:spLocks noChangeShapeType="1"/>
          </p:cNvSpPr>
          <p:nvPr/>
        </p:nvSpPr>
        <p:spPr bwMode="auto">
          <a:xfrm>
            <a:off x="1384302" y="2803525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Line 103"/>
          <p:cNvSpPr>
            <a:spLocks noChangeShapeType="1"/>
          </p:cNvSpPr>
          <p:nvPr/>
        </p:nvSpPr>
        <p:spPr bwMode="auto">
          <a:xfrm>
            <a:off x="1384302" y="2725738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Line 104"/>
          <p:cNvSpPr>
            <a:spLocks noChangeShapeType="1"/>
          </p:cNvSpPr>
          <p:nvPr/>
        </p:nvSpPr>
        <p:spPr bwMode="auto">
          <a:xfrm>
            <a:off x="1384302" y="2649538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Line 105"/>
          <p:cNvSpPr>
            <a:spLocks noChangeShapeType="1"/>
          </p:cNvSpPr>
          <p:nvPr/>
        </p:nvSpPr>
        <p:spPr bwMode="auto">
          <a:xfrm>
            <a:off x="1384302" y="2573338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Line 106"/>
          <p:cNvSpPr>
            <a:spLocks noChangeShapeType="1"/>
          </p:cNvSpPr>
          <p:nvPr/>
        </p:nvSpPr>
        <p:spPr bwMode="auto">
          <a:xfrm>
            <a:off x="1384302" y="2495550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Line 107"/>
          <p:cNvSpPr>
            <a:spLocks noChangeShapeType="1"/>
          </p:cNvSpPr>
          <p:nvPr/>
        </p:nvSpPr>
        <p:spPr bwMode="auto">
          <a:xfrm>
            <a:off x="1384302" y="2417763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Line 108"/>
          <p:cNvSpPr>
            <a:spLocks noChangeShapeType="1"/>
          </p:cNvSpPr>
          <p:nvPr/>
        </p:nvSpPr>
        <p:spPr bwMode="auto">
          <a:xfrm>
            <a:off x="1384302" y="2341563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Line 109"/>
          <p:cNvSpPr>
            <a:spLocks noChangeShapeType="1"/>
          </p:cNvSpPr>
          <p:nvPr/>
        </p:nvSpPr>
        <p:spPr bwMode="auto">
          <a:xfrm>
            <a:off x="1384302" y="2265363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Line 110"/>
          <p:cNvSpPr>
            <a:spLocks noChangeShapeType="1"/>
          </p:cNvSpPr>
          <p:nvPr/>
        </p:nvSpPr>
        <p:spPr bwMode="auto">
          <a:xfrm>
            <a:off x="1384302" y="2187575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Line 111"/>
          <p:cNvSpPr>
            <a:spLocks noChangeShapeType="1"/>
          </p:cNvSpPr>
          <p:nvPr/>
        </p:nvSpPr>
        <p:spPr bwMode="auto">
          <a:xfrm>
            <a:off x="1384302" y="2111375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Line 112"/>
          <p:cNvSpPr>
            <a:spLocks noChangeShapeType="1"/>
          </p:cNvSpPr>
          <p:nvPr/>
        </p:nvSpPr>
        <p:spPr bwMode="auto">
          <a:xfrm>
            <a:off x="1384302" y="2035175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Line 113"/>
          <p:cNvSpPr>
            <a:spLocks noChangeShapeType="1"/>
          </p:cNvSpPr>
          <p:nvPr/>
        </p:nvSpPr>
        <p:spPr bwMode="auto">
          <a:xfrm>
            <a:off x="1384302" y="1957388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Line 114"/>
          <p:cNvSpPr>
            <a:spLocks noChangeShapeType="1"/>
          </p:cNvSpPr>
          <p:nvPr/>
        </p:nvSpPr>
        <p:spPr bwMode="auto">
          <a:xfrm>
            <a:off x="1384302" y="1881188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Line 115"/>
          <p:cNvSpPr>
            <a:spLocks noChangeShapeType="1"/>
          </p:cNvSpPr>
          <p:nvPr/>
        </p:nvSpPr>
        <p:spPr bwMode="auto">
          <a:xfrm>
            <a:off x="1384302" y="1804988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Line 116"/>
          <p:cNvSpPr>
            <a:spLocks noChangeShapeType="1"/>
          </p:cNvSpPr>
          <p:nvPr/>
        </p:nvSpPr>
        <p:spPr bwMode="auto">
          <a:xfrm>
            <a:off x="1384302" y="1727200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Line 117"/>
          <p:cNvSpPr>
            <a:spLocks noChangeShapeType="1"/>
          </p:cNvSpPr>
          <p:nvPr/>
        </p:nvSpPr>
        <p:spPr bwMode="auto">
          <a:xfrm>
            <a:off x="1384302" y="1651000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Line 118"/>
          <p:cNvSpPr>
            <a:spLocks noChangeShapeType="1"/>
          </p:cNvSpPr>
          <p:nvPr/>
        </p:nvSpPr>
        <p:spPr bwMode="auto">
          <a:xfrm>
            <a:off x="1384302" y="1574800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Line 119"/>
          <p:cNvSpPr>
            <a:spLocks noChangeShapeType="1"/>
          </p:cNvSpPr>
          <p:nvPr/>
        </p:nvSpPr>
        <p:spPr bwMode="auto">
          <a:xfrm>
            <a:off x="1384302" y="1498600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Line 120"/>
          <p:cNvSpPr>
            <a:spLocks noChangeShapeType="1"/>
          </p:cNvSpPr>
          <p:nvPr/>
        </p:nvSpPr>
        <p:spPr bwMode="auto">
          <a:xfrm>
            <a:off x="1384302" y="1420813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Line 121"/>
          <p:cNvSpPr>
            <a:spLocks noChangeShapeType="1"/>
          </p:cNvSpPr>
          <p:nvPr/>
        </p:nvSpPr>
        <p:spPr bwMode="auto">
          <a:xfrm>
            <a:off x="1384302" y="1344613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Line 122"/>
          <p:cNvSpPr>
            <a:spLocks noChangeShapeType="1"/>
          </p:cNvSpPr>
          <p:nvPr/>
        </p:nvSpPr>
        <p:spPr bwMode="auto">
          <a:xfrm>
            <a:off x="1384302" y="1268413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Line 123"/>
          <p:cNvSpPr>
            <a:spLocks noChangeShapeType="1"/>
          </p:cNvSpPr>
          <p:nvPr/>
        </p:nvSpPr>
        <p:spPr bwMode="auto">
          <a:xfrm>
            <a:off x="1384302" y="1190625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Line 124"/>
          <p:cNvSpPr>
            <a:spLocks noChangeShapeType="1"/>
          </p:cNvSpPr>
          <p:nvPr/>
        </p:nvSpPr>
        <p:spPr bwMode="auto">
          <a:xfrm>
            <a:off x="1384302" y="1114425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Line 125"/>
          <p:cNvSpPr>
            <a:spLocks noChangeShapeType="1"/>
          </p:cNvSpPr>
          <p:nvPr/>
        </p:nvSpPr>
        <p:spPr bwMode="auto">
          <a:xfrm>
            <a:off x="1384302" y="1038225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Line 126"/>
          <p:cNvSpPr>
            <a:spLocks noChangeShapeType="1"/>
          </p:cNvSpPr>
          <p:nvPr/>
        </p:nvSpPr>
        <p:spPr bwMode="auto">
          <a:xfrm>
            <a:off x="1384302" y="960438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Line 127"/>
          <p:cNvSpPr>
            <a:spLocks noChangeShapeType="1"/>
          </p:cNvSpPr>
          <p:nvPr/>
        </p:nvSpPr>
        <p:spPr bwMode="auto">
          <a:xfrm>
            <a:off x="1384302" y="884238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Line 128"/>
          <p:cNvSpPr>
            <a:spLocks noChangeShapeType="1"/>
          </p:cNvSpPr>
          <p:nvPr/>
        </p:nvSpPr>
        <p:spPr bwMode="auto">
          <a:xfrm>
            <a:off x="1384302" y="808038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Line 129"/>
          <p:cNvSpPr>
            <a:spLocks noChangeShapeType="1"/>
          </p:cNvSpPr>
          <p:nvPr/>
        </p:nvSpPr>
        <p:spPr bwMode="auto">
          <a:xfrm>
            <a:off x="1384302" y="730250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Line 130"/>
          <p:cNvSpPr>
            <a:spLocks noChangeShapeType="1"/>
          </p:cNvSpPr>
          <p:nvPr/>
        </p:nvSpPr>
        <p:spPr bwMode="auto">
          <a:xfrm>
            <a:off x="1384302" y="652463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Line 131"/>
          <p:cNvSpPr>
            <a:spLocks noChangeShapeType="1"/>
          </p:cNvSpPr>
          <p:nvPr/>
        </p:nvSpPr>
        <p:spPr bwMode="auto">
          <a:xfrm>
            <a:off x="1384302" y="576263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Line 132"/>
          <p:cNvSpPr>
            <a:spLocks noChangeShapeType="1"/>
          </p:cNvSpPr>
          <p:nvPr/>
        </p:nvSpPr>
        <p:spPr bwMode="auto">
          <a:xfrm>
            <a:off x="1384302" y="500063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Line 133"/>
          <p:cNvSpPr>
            <a:spLocks noChangeShapeType="1"/>
          </p:cNvSpPr>
          <p:nvPr/>
        </p:nvSpPr>
        <p:spPr bwMode="auto">
          <a:xfrm>
            <a:off x="1384302" y="422275"/>
            <a:ext cx="7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Line 134"/>
          <p:cNvSpPr>
            <a:spLocks noChangeShapeType="1"/>
          </p:cNvSpPr>
          <p:nvPr/>
        </p:nvSpPr>
        <p:spPr bwMode="auto">
          <a:xfrm>
            <a:off x="1376364" y="6640513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Rectangle 135"/>
          <p:cNvSpPr>
            <a:spLocks noChangeArrowheads="1"/>
          </p:cNvSpPr>
          <p:nvPr/>
        </p:nvSpPr>
        <p:spPr bwMode="auto">
          <a:xfrm>
            <a:off x="1260477" y="6553200"/>
            <a:ext cx="77788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0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8" name="Line 136"/>
          <p:cNvSpPr>
            <a:spLocks noChangeShapeType="1"/>
          </p:cNvSpPr>
          <p:nvPr/>
        </p:nvSpPr>
        <p:spPr bwMode="auto">
          <a:xfrm>
            <a:off x="1376364" y="6256338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Rectangle 137"/>
          <p:cNvSpPr>
            <a:spLocks noChangeArrowheads="1"/>
          </p:cNvSpPr>
          <p:nvPr/>
        </p:nvSpPr>
        <p:spPr bwMode="auto">
          <a:xfrm>
            <a:off x="765177" y="6169025"/>
            <a:ext cx="5492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1000000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0" name="Line 138"/>
          <p:cNvSpPr>
            <a:spLocks noChangeShapeType="1"/>
          </p:cNvSpPr>
          <p:nvPr/>
        </p:nvSpPr>
        <p:spPr bwMode="auto">
          <a:xfrm>
            <a:off x="1376364" y="5872163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Rectangle 139"/>
          <p:cNvSpPr>
            <a:spLocks noChangeArrowheads="1"/>
          </p:cNvSpPr>
          <p:nvPr/>
        </p:nvSpPr>
        <p:spPr bwMode="auto">
          <a:xfrm>
            <a:off x="765177" y="5784850"/>
            <a:ext cx="5492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2000000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2" name="Line 140"/>
          <p:cNvSpPr>
            <a:spLocks noChangeShapeType="1"/>
          </p:cNvSpPr>
          <p:nvPr/>
        </p:nvSpPr>
        <p:spPr bwMode="auto">
          <a:xfrm>
            <a:off x="1376364" y="5489575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Rectangle 141"/>
          <p:cNvSpPr>
            <a:spLocks noChangeArrowheads="1"/>
          </p:cNvSpPr>
          <p:nvPr/>
        </p:nvSpPr>
        <p:spPr bwMode="auto">
          <a:xfrm>
            <a:off x="765177" y="5402263"/>
            <a:ext cx="5492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3000000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4" name="Line 142"/>
          <p:cNvSpPr>
            <a:spLocks noChangeShapeType="1"/>
          </p:cNvSpPr>
          <p:nvPr/>
        </p:nvSpPr>
        <p:spPr bwMode="auto">
          <a:xfrm>
            <a:off x="1376364" y="5105400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Rectangle 143"/>
          <p:cNvSpPr>
            <a:spLocks noChangeArrowheads="1"/>
          </p:cNvSpPr>
          <p:nvPr/>
        </p:nvSpPr>
        <p:spPr bwMode="auto">
          <a:xfrm>
            <a:off x="765177" y="5018088"/>
            <a:ext cx="5492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4000000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6" name="Line 144"/>
          <p:cNvSpPr>
            <a:spLocks noChangeShapeType="1"/>
          </p:cNvSpPr>
          <p:nvPr/>
        </p:nvSpPr>
        <p:spPr bwMode="auto">
          <a:xfrm>
            <a:off x="1376364" y="4721225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Rectangle 145"/>
          <p:cNvSpPr>
            <a:spLocks noChangeArrowheads="1"/>
          </p:cNvSpPr>
          <p:nvPr/>
        </p:nvSpPr>
        <p:spPr bwMode="auto">
          <a:xfrm>
            <a:off x="765177" y="4633913"/>
            <a:ext cx="5492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5000000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8" name="Line 146"/>
          <p:cNvSpPr>
            <a:spLocks noChangeShapeType="1"/>
          </p:cNvSpPr>
          <p:nvPr/>
        </p:nvSpPr>
        <p:spPr bwMode="auto">
          <a:xfrm>
            <a:off x="1376364" y="4338638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Rectangle 147"/>
          <p:cNvSpPr>
            <a:spLocks noChangeArrowheads="1"/>
          </p:cNvSpPr>
          <p:nvPr/>
        </p:nvSpPr>
        <p:spPr bwMode="auto">
          <a:xfrm>
            <a:off x="765177" y="4251325"/>
            <a:ext cx="5492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6000000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50" name="Line 148"/>
          <p:cNvSpPr>
            <a:spLocks noChangeShapeType="1"/>
          </p:cNvSpPr>
          <p:nvPr/>
        </p:nvSpPr>
        <p:spPr bwMode="auto">
          <a:xfrm>
            <a:off x="1376364" y="3954463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Rectangle 149"/>
          <p:cNvSpPr>
            <a:spLocks noChangeArrowheads="1"/>
          </p:cNvSpPr>
          <p:nvPr/>
        </p:nvSpPr>
        <p:spPr bwMode="auto">
          <a:xfrm>
            <a:off x="765177" y="3867150"/>
            <a:ext cx="5492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7000000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52" name="Line 150"/>
          <p:cNvSpPr>
            <a:spLocks noChangeShapeType="1"/>
          </p:cNvSpPr>
          <p:nvPr/>
        </p:nvSpPr>
        <p:spPr bwMode="auto">
          <a:xfrm>
            <a:off x="1376364" y="3570288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Rectangle 151"/>
          <p:cNvSpPr>
            <a:spLocks noChangeArrowheads="1"/>
          </p:cNvSpPr>
          <p:nvPr/>
        </p:nvSpPr>
        <p:spPr bwMode="auto">
          <a:xfrm>
            <a:off x="765177" y="3482975"/>
            <a:ext cx="5492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8000000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54" name="Line 152"/>
          <p:cNvSpPr>
            <a:spLocks noChangeShapeType="1"/>
          </p:cNvSpPr>
          <p:nvPr/>
        </p:nvSpPr>
        <p:spPr bwMode="auto">
          <a:xfrm>
            <a:off x="1376364" y="3186113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Rectangle 153"/>
          <p:cNvSpPr>
            <a:spLocks noChangeArrowheads="1"/>
          </p:cNvSpPr>
          <p:nvPr/>
        </p:nvSpPr>
        <p:spPr bwMode="auto">
          <a:xfrm>
            <a:off x="765177" y="3098800"/>
            <a:ext cx="5492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9000000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56" name="Line 154"/>
          <p:cNvSpPr>
            <a:spLocks noChangeShapeType="1"/>
          </p:cNvSpPr>
          <p:nvPr/>
        </p:nvSpPr>
        <p:spPr bwMode="auto">
          <a:xfrm>
            <a:off x="1376364" y="2803525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Rectangle 155"/>
          <p:cNvSpPr>
            <a:spLocks noChangeArrowheads="1"/>
          </p:cNvSpPr>
          <p:nvPr/>
        </p:nvSpPr>
        <p:spPr bwMode="auto">
          <a:xfrm>
            <a:off x="801689" y="2716213"/>
            <a:ext cx="511175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   1e+07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58" name="Line 156"/>
          <p:cNvSpPr>
            <a:spLocks noChangeShapeType="1"/>
          </p:cNvSpPr>
          <p:nvPr/>
        </p:nvSpPr>
        <p:spPr bwMode="auto">
          <a:xfrm>
            <a:off x="1376364" y="2417763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Rectangle 157"/>
          <p:cNvSpPr>
            <a:spLocks noChangeArrowheads="1"/>
          </p:cNvSpPr>
          <p:nvPr/>
        </p:nvSpPr>
        <p:spPr bwMode="auto">
          <a:xfrm>
            <a:off x="760414" y="2332038"/>
            <a:ext cx="5508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 1.1e+07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60" name="Line 158"/>
          <p:cNvSpPr>
            <a:spLocks noChangeShapeType="1"/>
          </p:cNvSpPr>
          <p:nvPr/>
        </p:nvSpPr>
        <p:spPr bwMode="auto">
          <a:xfrm>
            <a:off x="1376364" y="2035175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Rectangle 159"/>
          <p:cNvSpPr>
            <a:spLocks noChangeArrowheads="1"/>
          </p:cNvSpPr>
          <p:nvPr/>
        </p:nvSpPr>
        <p:spPr bwMode="auto">
          <a:xfrm>
            <a:off x="760414" y="1947863"/>
            <a:ext cx="5508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 1.2e+07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62" name="Line 160"/>
          <p:cNvSpPr>
            <a:spLocks noChangeShapeType="1"/>
          </p:cNvSpPr>
          <p:nvPr/>
        </p:nvSpPr>
        <p:spPr bwMode="auto">
          <a:xfrm>
            <a:off x="1376364" y="1651000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Rectangle 161"/>
          <p:cNvSpPr>
            <a:spLocks noChangeArrowheads="1"/>
          </p:cNvSpPr>
          <p:nvPr/>
        </p:nvSpPr>
        <p:spPr bwMode="auto">
          <a:xfrm>
            <a:off x="760414" y="1563688"/>
            <a:ext cx="5508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 1.3e+07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64" name="Line 162"/>
          <p:cNvSpPr>
            <a:spLocks noChangeShapeType="1"/>
          </p:cNvSpPr>
          <p:nvPr/>
        </p:nvSpPr>
        <p:spPr bwMode="auto">
          <a:xfrm>
            <a:off x="1376364" y="1268413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Rectangle 163"/>
          <p:cNvSpPr>
            <a:spLocks noChangeArrowheads="1"/>
          </p:cNvSpPr>
          <p:nvPr/>
        </p:nvSpPr>
        <p:spPr bwMode="auto">
          <a:xfrm>
            <a:off x="760414" y="1181100"/>
            <a:ext cx="5508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 1.4e+07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66" name="Line 164"/>
          <p:cNvSpPr>
            <a:spLocks noChangeShapeType="1"/>
          </p:cNvSpPr>
          <p:nvPr/>
        </p:nvSpPr>
        <p:spPr bwMode="auto">
          <a:xfrm>
            <a:off x="1376364" y="884238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Rectangle 165"/>
          <p:cNvSpPr>
            <a:spLocks noChangeArrowheads="1"/>
          </p:cNvSpPr>
          <p:nvPr/>
        </p:nvSpPr>
        <p:spPr bwMode="auto">
          <a:xfrm>
            <a:off x="760414" y="796925"/>
            <a:ext cx="5508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 1.5e+07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68" name="Line 166"/>
          <p:cNvSpPr>
            <a:spLocks noChangeShapeType="1"/>
          </p:cNvSpPr>
          <p:nvPr/>
        </p:nvSpPr>
        <p:spPr bwMode="auto">
          <a:xfrm>
            <a:off x="1376364" y="500063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Rectangle 167"/>
          <p:cNvSpPr>
            <a:spLocks noChangeArrowheads="1"/>
          </p:cNvSpPr>
          <p:nvPr/>
        </p:nvSpPr>
        <p:spPr bwMode="auto">
          <a:xfrm>
            <a:off x="760414" y="412750"/>
            <a:ext cx="550863" cy="1698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</a:rPr>
              <a:t> 1.6e+07</a:t>
            </a:r>
            <a:endParaRPr kumimoji="0" lang="en-US" altLang="en-US" sz="14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77" name="Freeform 175"/>
          <p:cNvSpPr>
            <a:spLocks/>
          </p:cNvSpPr>
          <p:nvPr/>
        </p:nvSpPr>
        <p:spPr bwMode="auto">
          <a:xfrm flipV="1">
            <a:off x="1392239" y="4124325"/>
            <a:ext cx="2236788" cy="1073150"/>
          </a:xfrm>
          <a:custGeom>
            <a:avLst/>
            <a:gdLst>
              <a:gd name="T0" fmla="*/ 52 w 3385"/>
              <a:gd name="T1" fmla="*/ 0 h 1364"/>
              <a:gd name="T2" fmla="*/ 105 w 3385"/>
              <a:gd name="T3" fmla="*/ 1 h 1364"/>
              <a:gd name="T4" fmla="*/ 158 w 3385"/>
              <a:gd name="T5" fmla="*/ 1 h 1364"/>
              <a:gd name="T6" fmla="*/ 211 w 3385"/>
              <a:gd name="T7" fmla="*/ 1 h 1364"/>
              <a:gd name="T8" fmla="*/ 264 w 3385"/>
              <a:gd name="T9" fmla="*/ 5 h 1364"/>
              <a:gd name="T10" fmla="*/ 317 w 3385"/>
              <a:gd name="T11" fmla="*/ 2 h 1364"/>
              <a:gd name="T12" fmla="*/ 370 w 3385"/>
              <a:gd name="T13" fmla="*/ 3 h 1364"/>
              <a:gd name="T14" fmla="*/ 422 w 3385"/>
              <a:gd name="T15" fmla="*/ 2 h 1364"/>
              <a:gd name="T16" fmla="*/ 475 w 3385"/>
              <a:gd name="T17" fmla="*/ 15 h 1364"/>
              <a:gd name="T18" fmla="*/ 528 w 3385"/>
              <a:gd name="T19" fmla="*/ 6 h 1364"/>
              <a:gd name="T20" fmla="*/ 581 w 3385"/>
              <a:gd name="T21" fmla="*/ 2 h 1364"/>
              <a:gd name="T22" fmla="*/ 634 w 3385"/>
              <a:gd name="T23" fmla="*/ 2 h 1364"/>
              <a:gd name="T24" fmla="*/ 687 w 3385"/>
              <a:gd name="T25" fmla="*/ 1 h 1364"/>
              <a:gd name="T26" fmla="*/ 740 w 3385"/>
              <a:gd name="T27" fmla="*/ 9 h 1364"/>
              <a:gd name="T28" fmla="*/ 793 w 3385"/>
              <a:gd name="T29" fmla="*/ 15 h 1364"/>
              <a:gd name="T30" fmla="*/ 846 w 3385"/>
              <a:gd name="T31" fmla="*/ 9 h 1364"/>
              <a:gd name="T32" fmla="*/ 899 w 3385"/>
              <a:gd name="T33" fmla="*/ 4 h 1364"/>
              <a:gd name="T34" fmla="*/ 952 w 3385"/>
              <a:gd name="T35" fmla="*/ 5 h 1364"/>
              <a:gd name="T36" fmla="*/ 1005 w 3385"/>
              <a:gd name="T37" fmla="*/ 4 h 1364"/>
              <a:gd name="T38" fmla="*/ 1058 w 3385"/>
              <a:gd name="T39" fmla="*/ 1 h 1364"/>
              <a:gd name="T40" fmla="*/ 1110 w 3385"/>
              <a:gd name="T41" fmla="*/ 43 h 1364"/>
              <a:gd name="T42" fmla="*/ 1163 w 3385"/>
              <a:gd name="T43" fmla="*/ 6 h 1364"/>
              <a:gd name="T44" fmla="*/ 1216 w 3385"/>
              <a:gd name="T45" fmla="*/ 11 h 1364"/>
              <a:gd name="T46" fmla="*/ 1269 w 3385"/>
              <a:gd name="T47" fmla="*/ 2 h 1364"/>
              <a:gd name="T48" fmla="*/ 1322 w 3385"/>
              <a:gd name="T49" fmla="*/ 2 h 1364"/>
              <a:gd name="T50" fmla="*/ 1375 w 3385"/>
              <a:gd name="T51" fmla="*/ 3 h 1364"/>
              <a:gd name="T52" fmla="*/ 1428 w 3385"/>
              <a:gd name="T53" fmla="*/ 3 h 1364"/>
              <a:gd name="T54" fmla="*/ 1481 w 3385"/>
              <a:gd name="T55" fmla="*/ 4 h 1364"/>
              <a:gd name="T56" fmla="*/ 1534 w 3385"/>
              <a:gd name="T57" fmla="*/ 6 h 1364"/>
              <a:gd name="T58" fmla="*/ 1587 w 3385"/>
              <a:gd name="T59" fmla="*/ 3 h 1364"/>
              <a:gd name="T60" fmla="*/ 1640 w 3385"/>
              <a:gd name="T61" fmla="*/ 15 h 1364"/>
              <a:gd name="T62" fmla="*/ 1693 w 3385"/>
              <a:gd name="T63" fmla="*/ 9 h 1364"/>
              <a:gd name="T64" fmla="*/ 1746 w 3385"/>
              <a:gd name="T65" fmla="*/ 1 h 1364"/>
              <a:gd name="T66" fmla="*/ 1799 w 3385"/>
              <a:gd name="T67" fmla="*/ 2 h 1364"/>
              <a:gd name="T68" fmla="*/ 1851 w 3385"/>
              <a:gd name="T69" fmla="*/ 2 h 1364"/>
              <a:gd name="T70" fmla="*/ 1904 w 3385"/>
              <a:gd name="T71" fmla="*/ 1 h 1364"/>
              <a:gd name="T72" fmla="*/ 1957 w 3385"/>
              <a:gd name="T73" fmla="*/ 1 h 1364"/>
              <a:gd name="T74" fmla="*/ 2010 w 3385"/>
              <a:gd name="T75" fmla="*/ 2 h 1364"/>
              <a:gd name="T76" fmla="*/ 2063 w 3385"/>
              <a:gd name="T77" fmla="*/ 1 h 1364"/>
              <a:gd name="T78" fmla="*/ 2116 w 3385"/>
              <a:gd name="T79" fmla="*/ 1 h 1364"/>
              <a:gd name="T80" fmla="*/ 2169 w 3385"/>
              <a:gd name="T81" fmla="*/ 1 h 1364"/>
              <a:gd name="T82" fmla="*/ 2222 w 3385"/>
              <a:gd name="T83" fmla="*/ 1 h 1364"/>
              <a:gd name="T84" fmla="*/ 2275 w 3385"/>
              <a:gd name="T85" fmla="*/ 1 h 1364"/>
              <a:gd name="T86" fmla="*/ 2328 w 3385"/>
              <a:gd name="T87" fmla="*/ 32 h 1364"/>
              <a:gd name="T88" fmla="*/ 2381 w 3385"/>
              <a:gd name="T89" fmla="*/ 9 h 1364"/>
              <a:gd name="T90" fmla="*/ 2434 w 3385"/>
              <a:gd name="T91" fmla="*/ 3 h 1364"/>
              <a:gd name="T92" fmla="*/ 2487 w 3385"/>
              <a:gd name="T93" fmla="*/ 1 h 1364"/>
              <a:gd name="T94" fmla="*/ 2539 w 3385"/>
              <a:gd name="T95" fmla="*/ 4 h 1364"/>
              <a:gd name="T96" fmla="*/ 2592 w 3385"/>
              <a:gd name="T97" fmla="*/ 2 h 1364"/>
              <a:gd name="T98" fmla="*/ 2645 w 3385"/>
              <a:gd name="T99" fmla="*/ 2 h 1364"/>
              <a:gd name="T100" fmla="*/ 2698 w 3385"/>
              <a:gd name="T101" fmla="*/ 1 h 1364"/>
              <a:gd name="T102" fmla="*/ 2751 w 3385"/>
              <a:gd name="T103" fmla="*/ 3 h 1364"/>
              <a:gd name="T104" fmla="*/ 2804 w 3385"/>
              <a:gd name="T105" fmla="*/ 1 h 1364"/>
              <a:gd name="T106" fmla="*/ 2857 w 3385"/>
              <a:gd name="T107" fmla="*/ 1 h 1364"/>
              <a:gd name="T108" fmla="*/ 2910 w 3385"/>
              <a:gd name="T109" fmla="*/ 1 h 1364"/>
              <a:gd name="T110" fmla="*/ 2963 w 3385"/>
              <a:gd name="T111" fmla="*/ 0 h 1364"/>
              <a:gd name="T112" fmla="*/ 3016 w 3385"/>
              <a:gd name="T113" fmla="*/ 1 h 1364"/>
              <a:gd name="T114" fmla="*/ 3069 w 3385"/>
              <a:gd name="T115" fmla="*/ 0 h 1364"/>
              <a:gd name="T116" fmla="*/ 3122 w 3385"/>
              <a:gd name="T117" fmla="*/ 3 h 1364"/>
              <a:gd name="T118" fmla="*/ 3175 w 3385"/>
              <a:gd name="T119" fmla="*/ 7 h 1364"/>
              <a:gd name="T120" fmla="*/ 3227 w 3385"/>
              <a:gd name="T121" fmla="*/ 4 h 1364"/>
              <a:gd name="T122" fmla="*/ 3280 w 3385"/>
              <a:gd name="T123" fmla="*/ 7 h 1364"/>
              <a:gd name="T124" fmla="*/ 3333 w 3385"/>
              <a:gd name="T125" fmla="*/ 4 h 13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  <a:cxn ang="0">
                <a:pos x="T124" y="T125"/>
              </a:cxn>
            </a:cxnLst>
            <a:rect l="0" t="0" r="r" b="b"/>
            <a:pathLst>
              <a:path w="3385" h="1364">
                <a:moveTo>
                  <a:pt x="0" y="0"/>
                </a:moveTo>
                <a:lnTo>
                  <a:pt x="1" y="0"/>
                </a:lnTo>
                <a:lnTo>
                  <a:pt x="2" y="0"/>
                </a:lnTo>
                <a:lnTo>
                  <a:pt x="3" y="1"/>
                </a:lnTo>
                <a:lnTo>
                  <a:pt x="3" y="0"/>
                </a:lnTo>
                <a:lnTo>
                  <a:pt x="4" y="0"/>
                </a:lnTo>
                <a:lnTo>
                  <a:pt x="5" y="1"/>
                </a:lnTo>
                <a:lnTo>
                  <a:pt x="6" y="0"/>
                </a:lnTo>
                <a:lnTo>
                  <a:pt x="7" y="1"/>
                </a:lnTo>
                <a:lnTo>
                  <a:pt x="8" y="0"/>
                </a:lnTo>
                <a:lnTo>
                  <a:pt x="9" y="0"/>
                </a:lnTo>
                <a:lnTo>
                  <a:pt x="10" y="0"/>
                </a:lnTo>
                <a:lnTo>
                  <a:pt x="11" y="0"/>
                </a:lnTo>
                <a:lnTo>
                  <a:pt x="11" y="0"/>
                </a:lnTo>
                <a:lnTo>
                  <a:pt x="12" y="1"/>
                </a:lnTo>
                <a:lnTo>
                  <a:pt x="13" y="0"/>
                </a:lnTo>
                <a:lnTo>
                  <a:pt x="14" y="0"/>
                </a:lnTo>
                <a:lnTo>
                  <a:pt x="15" y="1"/>
                </a:lnTo>
                <a:lnTo>
                  <a:pt x="16" y="0"/>
                </a:lnTo>
                <a:lnTo>
                  <a:pt x="17" y="1"/>
                </a:lnTo>
                <a:lnTo>
                  <a:pt x="18" y="0"/>
                </a:lnTo>
                <a:lnTo>
                  <a:pt x="18" y="1"/>
                </a:lnTo>
                <a:lnTo>
                  <a:pt x="19" y="0"/>
                </a:lnTo>
                <a:lnTo>
                  <a:pt x="20" y="1"/>
                </a:lnTo>
                <a:lnTo>
                  <a:pt x="21" y="1"/>
                </a:lnTo>
                <a:lnTo>
                  <a:pt x="22" y="0"/>
                </a:lnTo>
                <a:lnTo>
                  <a:pt x="23" y="0"/>
                </a:lnTo>
                <a:lnTo>
                  <a:pt x="24" y="0"/>
                </a:lnTo>
                <a:lnTo>
                  <a:pt x="25" y="1"/>
                </a:lnTo>
                <a:lnTo>
                  <a:pt x="26" y="0"/>
                </a:lnTo>
                <a:lnTo>
                  <a:pt x="26" y="0"/>
                </a:lnTo>
                <a:lnTo>
                  <a:pt x="27" y="1"/>
                </a:lnTo>
                <a:lnTo>
                  <a:pt x="28" y="0"/>
                </a:lnTo>
                <a:lnTo>
                  <a:pt x="29" y="1"/>
                </a:lnTo>
                <a:lnTo>
                  <a:pt x="30" y="0"/>
                </a:lnTo>
                <a:lnTo>
                  <a:pt x="31" y="1"/>
                </a:lnTo>
                <a:lnTo>
                  <a:pt x="32" y="0"/>
                </a:lnTo>
                <a:lnTo>
                  <a:pt x="33" y="0"/>
                </a:lnTo>
                <a:lnTo>
                  <a:pt x="33" y="0"/>
                </a:lnTo>
                <a:lnTo>
                  <a:pt x="34" y="0"/>
                </a:lnTo>
                <a:lnTo>
                  <a:pt x="35" y="1"/>
                </a:lnTo>
                <a:lnTo>
                  <a:pt x="36" y="0"/>
                </a:lnTo>
                <a:lnTo>
                  <a:pt x="37" y="0"/>
                </a:lnTo>
                <a:lnTo>
                  <a:pt x="38" y="0"/>
                </a:lnTo>
                <a:lnTo>
                  <a:pt x="39" y="1"/>
                </a:lnTo>
                <a:lnTo>
                  <a:pt x="40" y="0"/>
                </a:lnTo>
                <a:lnTo>
                  <a:pt x="41" y="1"/>
                </a:lnTo>
                <a:lnTo>
                  <a:pt x="41" y="1"/>
                </a:lnTo>
                <a:lnTo>
                  <a:pt x="42" y="1"/>
                </a:lnTo>
                <a:lnTo>
                  <a:pt x="43" y="0"/>
                </a:lnTo>
                <a:lnTo>
                  <a:pt x="44" y="1"/>
                </a:lnTo>
                <a:lnTo>
                  <a:pt x="45" y="1"/>
                </a:lnTo>
                <a:lnTo>
                  <a:pt x="46" y="0"/>
                </a:lnTo>
                <a:lnTo>
                  <a:pt x="47" y="1"/>
                </a:lnTo>
                <a:lnTo>
                  <a:pt x="48" y="0"/>
                </a:lnTo>
                <a:lnTo>
                  <a:pt x="48" y="1"/>
                </a:lnTo>
                <a:lnTo>
                  <a:pt x="49" y="0"/>
                </a:lnTo>
                <a:lnTo>
                  <a:pt x="50" y="1"/>
                </a:lnTo>
                <a:lnTo>
                  <a:pt x="51" y="1"/>
                </a:lnTo>
                <a:lnTo>
                  <a:pt x="52" y="0"/>
                </a:lnTo>
                <a:lnTo>
                  <a:pt x="53" y="1"/>
                </a:lnTo>
                <a:lnTo>
                  <a:pt x="54" y="1"/>
                </a:lnTo>
                <a:lnTo>
                  <a:pt x="55" y="1"/>
                </a:lnTo>
                <a:lnTo>
                  <a:pt x="56" y="1"/>
                </a:lnTo>
                <a:lnTo>
                  <a:pt x="56" y="1"/>
                </a:lnTo>
                <a:lnTo>
                  <a:pt x="57" y="1"/>
                </a:lnTo>
                <a:lnTo>
                  <a:pt x="58" y="2"/>
                </a:lnTo>
                <a:lnTo>
                  <a:pt x="59" y="1"/>
                </a:lnTo>
                <a:lnTo>
                  <a:pt x="60" y="1"/>
                </a:lnTo>
                <a:lnTo>
                  <a:pt x="61" y="1"/>
                </a:lnTo>
                <a:lnTo>
                  <a:pt x="62" y="2"/>
                </a:lnTo>
                <a:lnTo>
                  <a:pt x="63" y="1"/>
                </a:lnTo>
                <a:lnTo>
                  <a:pt x="63" y="1"/>
                </a:lnTo>
                <a:lnTo>
                  <a:pt x="64" y="0"/>
                </a:lnTo>
                <a:lnTo>
                  <a:pt x="65" y="1"/>
                </a:lnTo>
                <a:lnTo>
                  <a:pt x="66" y="1"/>
                </a:lnTo>
                <a:lnTo>
                  <a:pt x="67" y="1"/>
                </a:lnTo>
                <a:lnTo>
                  <a:pt x="68" y="1"/>
                </a:lnTo>
                <a:lnTo>
                  <a:pt x="69" y="1"/>
                </a:lnTo>
                <a:lnTo>
                  <a:pt x="70" y="1"/>
                </a:lnTo>
                <a:lnTo>
                  <a:pt x="70" y="1"/>
                </a:lnTo>
                <a:lnTo>
                  <a:pt x="71" y="1"/>
                </a:lnTo>
                <a:lnTo>
                  <a:pt x="72" y="0"/>
                </a:lnTo>
                <a:lnTo>
                  <a:pt x="73" y="0"/>
                </a:lnTo>
                <a:lnTo>
                  <a:pt x="74" y="1"/>
                </a:lnTo>
                <a:lnTo>
                  <a:pt x="75" y="0"/>
                </a:lnTo>
                <a:lnTo>
                  <a:pt x="76" y="0"/>
                </a:lnTo>
                <a:lnTo>
                  <a:pt x="77" y="0"/>
                </a:lnTo>
                <a:lnTo>
                  <a:pt x="78" y="0"/>
                </a:lnTo>
                <a:lnTo>
                  <a:pt x="78" y="1"/>
                </a:lnTo>
                <a:lnTo>
                  <a:pt x="79" y="1"/>
                </a:lnTo>
                <a:lnTo>
                  <a:pt x="80" y="1"/>
                </a:lnTo>
                <a:lnTo>
                  <a:pt x="81" y="0"/>
                </a:lnTo>
                <a:lnTo>
                  <a:pt x="82" y="0"/>
                </a:lnTo>
                <a:lnTo>
                  <a:pt x="83" y="1"/>
                </a:lnTo>
                <a:lnTo>
                  <a:pt x="84" y="0"/>
                </a:lnTo>
                <a:lnTo>
                  <a:pt x="85" y="0"/>
                </a:lnTo>
                <a:lnTo>
                  <a:pt x="85" y="0"/>
                </a:lnTo>
                <a:lnTo>
                  <a:pt x="86" y="0"/>
                </a:lnTo>
                <a:lnTo>
                  <a:pt x="87" y="0"/>
                </a:lnTo>
                <a:lnTo>
                  <a:pt x="88" y="1"/>
                </a:lnTo>
                <a:lnTo>
                  <a:pt x="89" y="0"/>
                </a:lnTo>
                <a:lnTo>
                  <a:pt x="90" y="0"/>
                </a:lnTo>
                <a:lnTo>
                  <a:pt x="91" y="0"/>
                </a:lnTo>
                <a:lnTo>
                  <a:pt x="92" y="1"/>
                </a:lnTo>
                <a:lnTo>
                  <a:pt x="93" y="0"/>
                </a:lnTo>
                <a:lnTo>
                  <a:pt x="93" y="0"/>
                </a:lnTo>
                <a:lnTo>
                  <a:pt x="94" y="1"/>
                </a:lnTo>
                <a:lnTo>
                  <a:pt x="95" y="1"/>
                </a:lnTo>
                <a:lnTo>
                  <a:pt x="96" y="1"/>
                </a:lnTo>
                <a:lnTo>
                  <a:pt x="97" y="1"/>
                </a:lnTo>
                <a:lnTo>
                  <a:pt x="98" y="2"/>
                </a:lnTo>
                <a:lnTo>
                  <a:pt x="99" y="2"/>
                </a:lnTo>
                <a:lnTo>
                  <a:pt x="100" y="2"/>
                </a:lnTo>
                <a:lnTo>
                  <a:pt x="100" y="1"/>
                </a:lnTo>
                <a:lnTo>
                  <a:pt x="101" y="2"/>
                </a:lnTo>
                <a:lnTo>
                  <a:pt x="102" y="1"/>
                </a:lnTo>
                <a:lnTo>
                  <a:pt x="103" y="1"/>
                </a:lnTo>
                <a:lnTo>
                  <a:pt x="104" y="1"/>
                </a:lnTo>
                <a:lnTo>
                  <a:pt x="105" y="1"/>
                </a:lnTo>
                <a:lnTo>
                  <a:pt x="106" y="1"/>
                </a:lnTo>
                <a:lnTo>
                  <a:pt x="107" y="0"/>
                </a:lnTo>
                <a:lnTo>
                  <a:pt x="108" y="1"/>
                </a:lnTo>
                <a:lnTo>
                  <a:pt x="108" y="0"/>
                </a:lnTo>
                <a:lnTo>
                  <a:pt x="109" y="0"/>
                </a:lnTo>
                <a:lnTo>
                  <a:pt x="110" y="1"/>
                </a:lnTo>
                <a:lnTo>
                  <a:pt x="111" y="1"/>
                </a:lnTo>
                <a:lnTo>
                  <a:pt x="112" y="1"/>
                </a:lnTo>
                <a:lnTo>
                  <a:pt x="113" y="1"/>
                </a:lnTo>
                <a:lnTo>
                  <a:pt x="114" y="1"/>
                </a:lnTo>
                <a:lnTo>
                  <a:pt x="115" y="1"/>
                </a:lnTo>
                <a:lnTo>
                  <a:pt x="115" y="2"/>
                </a:lnTo>
                <a:lnTo>
                  <a:pt x="116" y="1"/>
                </a:lnTo>
                <a:lnTo>
                  <a:pt x="117" y="1"/>
                </a:lnTo>
                <a:lnTo>
                  <a:pt x="118" y="1"/>
                </a:lnTo>
                <a:lnTo>
                  <a:pt x="119" y="1"/>
                </a:lnTo>
                <a:lnTo>
                  <a:pt x="120" y="2"/>
                </a:lnTo>
                <a:lnTo>
                  <a:pt x="121" y="2"/>
                </a:lnTo>
                <a:lnTo>
                  <a:pt x="122" y="2"/>
                </a:lnTo>
                <a:lnTo>
                  <a:pt x="123" y="1"/>
                </a:lnTo>
                <a:lnTo>
                  <a:pt x="123" y="1"/>
                </a:lnTo>
                <a:lnTo>
                  <a:pt x="124" y="1"/>
                </a:lnTo>
                <a:lnTo>
                  <a:pt x="125" y="1"/>
                </a:lnTo>
                <a:lnTo>
                  <a:pt x="126" y="1"/>
                </a:lnTo>
                <a:lnTo>
                  <a:pt x="127" y="1"/>
                </a:lnTo>
                <a:lnTo>
                  <a:pt x="128" y="0"/>
                </a:lnTo>
                <a:lnTo>
                  <a:pt x="129" y="1"/>
                </a:lnTo>
                <a:lnTo>
                  <a:pt x="130" y="0"/>
                </a:lnTo>
                <a:lnTo>
                  <a:pt x="130" y="0"/>
                </a:lnTo>
                <a:lnTo>
                  <a:pt x="131" y="1"/>
                </a:lnTo>
                <a:lnTo>
                  <a:pt x="132" y="1"/>
                </a:lnTo>
                <a:lnTo>
                  <a:pt x="133" y="0"/>
                </a:lnTo>
                <a:lnTo>
                  <a:pt x="134" y="0"/>
                </a:lnTo>
                <a:lnTo>
                  <a:pt x="135" y="1"/>
                </a:lnTo>
                <a:lnTo>
                  <a:pt x="136" y="0"/>
                </a:lnTo>
                <a:lnTo>
                  <a:pt x="137" y="1"/>
                </a:lnTo>
                <a:lnTo>
                  <a:pt x="138" y="1"/>
                </a:lnTo>
                <a:lnTo>
                  <a:pt x="138" y="1"/>
                </a:lnTo>
                <a:lnTo>
                  <a:pt x="139" y="1"/>
                </a:lnTo>
                <a:lnTo>
                  <a:pt x="140" y="1"/>
                </a:lnTo>
                <a:lnTo>
                  <a:pt x="141" y="2"/>
                </a:lnTo>
                <a:lnTo>
                  <a:pt x="142" y="2"/>
                </a:lnTo>
                <a:lnTo>
                  <a:pt x="143" y="3"/>
                </a:lnTo>
                <a:lnTo>
                  <a:pt x="144" y="4"/>
                </a:lnTo>
                <a:lnTo>
                  <a:pt x="145" y="5"/>
                </a:lnTo>
                <a:lnTo>
                  <a:pt x="145" y="5"/>
                </a:lnTo>
                <a:lnTo>
                  <a:pt x="146" y="4"/>
                </a:lnTo>
                <a:lnTo>
                  <a:pt x="147" y="5"/>
                </a:lnTo>
                <a:lnTo>
                  <a:pt x="148" y="4"/>
                </a:lnTo>
                <a:lnTo>
                  <a:pt x="149" y="3"/>
                </a:lnTo>
                <a:lnTo>
                  <a:pt x="150" y="2"/>
                </a:lnTo>
                <a:lnTo>
                  <a:pt x="151" y="2"/>
                </a:lnTo>
                <a:lnTo>
                  <a:pt x="152" y="1"/>
                </a:lnTo>
                <a:lnTo>
                  <a:pt x="153" y="1"/>
                </a:lnTo>
                <a:lnTo>
                  <a:pt x="153" y="1"/>
                </a:lnTo>
                <a:lnTo>
                  <a:pt x="154" y="1"/>
                </a:lnTo>
                <a:lnTo>
                  <a:pt x="155" y="1"/>
                </a:lnTo>
                <a:lnTo>
                  <a:pt x="156" y="1"/>
                </a:lnTo>
                <a:lnTo>
                  <a:pt x="157" y="0"/>
                </a:lnTo>
                <a:lnTo>
                  <a:pt x="158" y="1"/>
                </a:lnTo>
                <a:lnTo>
                  <a:pt x="159" y="0"/>
                </a:lnTo>
                <a:lnTo>
                  <a:pt x="160" y="1"/>
                </a:lnTo>
                <a:lnTo>
                  <a:pt x="160" y="1"/>
                </a:lnTo>
                <a:lnTo>
                  <a:pt x="161" y="1"/>
                </a:lnTo>
                <a:lnTo>
                  <a:pt x="162" y="1"/>
                </a:lnTo>
                <a:lnTo>
                  <a:pt x="163" y="0"/>
                </a:lnTo>
                <a:lnTo>
                  <a:pt x="164" y="0"/>
                </a:lnTo>
                <a:lnTo>
                  <a:pt x="165" y="1"/>
                </a:lnTo>
                <a:lnTo>
                  <a:pt x="166" y="0"/>
                </a:lnTo>
                <a:lnTo>
                  <a:pt x="167" y="1"/>
                </a:lnTo>
                <a:lnTo>
                  <a:pt x="168" y="0"/>
                </a:lnTo>
                <a:lnTo>
                  <a:pt x="168" y="1"/>
                </a:lnTo>
                <a:lnTo>
                  <a:pt x="169" y="1"/>
                </a:lnTo>
                <a:lnTo>
                  <a:pt x="170" y="1"/>
                </a:lnTo>
                <a:lnTo>
                  <a:pt x="171" y="0"/>
                </a:lnTo>
                <a:lnTo>
                  <a:pt x="172" y="1"/>
                </a:lnTo>
                <a:lnTo>
                  <a:pt x="173" y="1"/>
                </a:lnTo>
                <a:lnTo>
                  <a:pt x="174" y="2"/>
                </a:lnTo>
                <a:lnTo>
                  <a:pt x="175" y="1"/>
                </a:lnTo>
                <a:lnTo>
                  <a:pt x="175" y="1"/>
                </a:lnTo>
                <a:lnTo>
                  <a:pt x="176" y="2"/>
                </a:lnTo>
                <a:lnTo>
                  <a:pt x="177" y="1"/>
                </a:lnTo>
                <a:lnTo>
                  <a:pt x="178" y="1"/>
                </a:lnTo>
                <a:lnTo>
                  <a:pt x="179" y="2"/>
                </a:lnTo>
                <a:lnTo>
                  <a:pt x="180" y="1"/>
                </a:lnTo>
                <a:lnTo>
                  <a:pt x="181" y="0"/>
                </a:lnTo>
                <a:lnTo>
                  <a:pt x="182" y="1"/>
                </a:lnTo>
                <a:lnTo>
                  <a:pt x="183" y="0"/>
                </a:lnTo>
                <a:lnTo>
                  <a:pt x="183" y="0"/>
                </a:lnTo>
                <a:lnTo>
                  <a:pt x="184" y="1"/>
                </a:lnTo>
                <a:lnTo>
                  <a:pt x="185" y="0"/>
                </a:lnTo>
                <a:lnTo>
                  <a:pt x="186" y="1"/>
                </a:lnTo>
                <a:lnTo>
                  <a:pt x="187" y="2"/>
                </a:lnTo>
                <a:lnTo>
                  <a:pt x="188" y="2"/>
                </a:lnTo>
                <a:lnTo>
                  <a:pt x="189" y="2"/>
                </a:lnTo>
                <a:lnTo>
                  <a:pt x="190" y="1"/>
                </a:lnTo>
                <a:lnTo>
                  <a:pt x="190" y="2"/>
                </a:lnTo>
                <a:lnTo>
                  <a:pt x="191" y="2"/>
                </a:lnTo>
                <a:lnTo>
                  <a:pt x="192" y="2"/>
                </a:lnTo>
                <a:lnTo>
                  <a:pt x="193" y="2"/>
                </a:lnTo>
                <a:lnTo>
                  <a:pt x="194" y="2"/>
                </a:lnTo>
                <a:lnTo>
                  <a:pt x="195" y="2"/>
                </a:lnTo>
                <a:lnTo>
                  <a:pt x="196" y="1"/>
                </a:lnTo>
                <a:lnTo>
                  <a:pt x="197" y="1"/>
                </a:lnTo>
                <a:lnTo>
                  <a:pt x="198" y="1"/>
                </a:lnTo>
                <a:lnTo>
                  <a:pt x="198" y="1"/>
                </a:lnTo>
                <a:lnTo>
                  <a:pt x="199" y="1"/>
                </a:lnTo>
                <a:lnTo>
                  <a:pt x="200" y="1"/>
                </a:lnTo>
                <a:lnTo>
                  <a:pt x="201" y="1"/>
                </a:lnTo>
                <a:lnTo>
                  <a:pt x="202" y="1"/>
                </a:lnTo>
                <a:lnTo>
                  <a:pt x="203" y="1"/>
                </a:lnTo>
                <a:lnTo>
                  <a:pt x="204" y="1"/>
                </a:lnTo>
                <a:lnTo>
                  <a:pt x="205" y="1"/>
                </a:lnTo>
                <a:lnTo>
                  <a:pt x="205" y="1"/>
                </a:lnTo>
                <a:lnTo>
                  <a:pt x="206" y="1"/>
                </a:lnTo>
                <a:lnTo>
                  <a:pt x="207" y="0"/>
                </a:lnTo>
                <a:lnTo>
                  <a:pt x="208" y="1"/>
                </a:lnTo>
                <a:lnTo>
                  <a:pt x="209" y="1"/>
                </a:lnTo>
                <a:lnTo>
                  <a:pt x="210" y="0"/>
                </a:lnTo>
                <a:lnTo>
                  <a:pt x="211" y="1"/>
                </a:lnTo>
                <a:lnTo>
                  <a:pt x="212" y="1"/>
                </a:lnTo>
                <a:lnTo>
                  <a:pt x="213" y="1"/>
                </a:lnTo>
                <a:lnTo>
                  <a:pt x="213" y="1"/>
                </a:lnTo>
                <a:lnTo>
                  <a:pt x="214" y="1"/>
                </a:lnTo>
                <a:lnTo>
                  <a:pt x="215" y="1"/>
                </a:lnTo>
                <a:lnTo>
                  <a:pt x="216" y="1"/>
                </a:lnTo>
                <a:lnTo>
                  <a:pt x="217" y="1"/>
                </a:lnTo>
                <a:lnTo>
                  <a:pt x="218" y="1"/>
                </a:lnTo>
                <a:lnTo>
                  <a:pt x="219" y="1"/>
                </a:lnTo>
                <a:lnTo>
                  <a:pt x="220" y="1"/>
                </a:lnTo>
                <a:lnTo>
                  <a:pt x="220" y="2"/>
                </a:lnTo>
                <a:lnTo>
                  <a:pt x="221" y="2"/>
                </a:lnTo>
                <a:lnTo>
                  <a:pt x="222" y="2"/>
                </a:lnTo>
                <a:lnTo>
                  <a:pt x="223" y="1"/>
                </a:lnTo>
                <a:lnTo>
                  <a:pt x="224" y="1"/>
                </a:lnTo>
                <a:lnTo>
                  <a:pt x="225" y="1"/>
                </a:lnTo>
                <a:lnTo>
                  <a:pt x="226" y="2"/>
                </a:lnTo>
                <a:lnTo>
                  <a:pt x="227" y="1"/>
                </a:lnTo>
                <a:lnTo>
                  <a:pt x="228" y="1"/>
                </a:lnTo>
                <a:lnTo>
                  <a:pt x="228" y="1"/>
                </a:lnTo>
                <a:lnTo>
                  <a:pt x="229" y="1"/>
                </a:lnTo>
                <a:lnTo>
                  <a:pt x="230" y="1"/>
                </a:lnTo>
                <a:lnTo>
                  <a:pt x="231" y="1"/>
                </a:lnTo>
                <a:lnTo>
                  <a:pt x="232" y="0"/>
                </a:lnTo>
                <a:lnTo>
                  <a:pt x="233" y="1"/>
                </a:lnTo>
                <a:lnTo>
                  <a:pt x="234" y="1"/>
                </a:lnTo>
                <a:lnTo>
                  <a:pt x="235" y="1"/>
                </a:lnTo>
                <a:lnTo>
                  <a:pt x="235" y="1"/>
                </a:lnTo>
                <a:lnTo>
                  <a:pt x="236" y="1"/>
                </a:lnTo>
                <a:lnTo>
                  <a:pt x="237" y="1"/>
                </a:lnTo>
                <a:lnTo>
                  <a:pt x="238" y="1"/>
                </a:lnTo>
                <a:lnTo>
                  <a:pt x="239" y="1"/>
                </a:lnTo>
                <a:lnTo>
                  <a:pt x="240" y="1"/>
                </a:lnTo>
                <a:lnTo>
                  <a:pt x="241" y="1"/>
                </a:lnTo>
                <a:lnTo>
                  <a:pt x="242" y="1"/>
                </a:lnTo>
                <a:lnTo>
                  <a:pt x="243" y="1"/>
                </a:lnTo>
                <a:lnTo>
                  <a:pt x="243" y="1"/>
                </a:lnTo>
                <a:lnTo>
                  <a:pt x="244" y="2"/>
                </a:lnTo>
                <a:lnTo>
                  <a:pt x="245" y="1"/>
                </a:lnTo>
                <a:lnTo>
                  <a:pt x="246" y="1"/>
                </a:lnTo>
                <a:lnTo>
                  <a:pt x="247" y="1"/>
                </a:lnTo>
                <a:lnTo>
                  <a:pt x="248" y="2"/>
                </a:lnTo>
                <a:lnTo>
                  <a:pt x="249" y="1"/>
                </a:lnTo>
                <a:lnTo>
                  <a:pt x="250" y="1"/>
                </a:lnTo>
                <a:lnTo>
                  <a:pt x="250" y="1"/>
                </a:lnTo>
                <a:lnTo>
                  <a:pt x="251" y="1"/>
                </a:lnTo>
                <a:lnTo>
                  <a:pt x="252" y="1"/>
                </a:lnTo>
                <a:lnTo>
                  <a:pt x="253" y="0"/>
                </a:lnTo>
                <a:lnTo>
                  <a:pt x="254" y="1"/>
                </a:lnTo>
                <a:lnTo>
                  <a:pt x="255" y="1"/>
                </a:lnTo>
                <a:lnTo>
                  <a:pt x="256" y="1"/>
                </a:lnTo>
                <a:lnTo>
                  <a:pt x="257" y="1"/>
                </a:lnTo>
                <a:lnTo>
                  <a:pt x="257" y="1"/>
                </a:lnTo>
                <a:lnTo>
                  <a:pt x="258" y="1"/>
                </a:lnTo>
                <a:lnTo>
                  <a:pt x="259" y="2"/>
                </a:lnTo>
                <a:lnTo>
                  <a:pt x="260" y="3"/>
                </a:lnTo>
                <a:lnTo>
                  <a:pt x="261" y="3"/>
                </a:lnTo>
                <a:lnTo>
                  <a:pt x="262" y="4"/>
                </a:lnTo>
                <a:lnTo>
                  <a:pt x="263" y="4"/>
                </a:lnTo>
                <a:lnTo>
                  <a:pt x="264" y="5"/>
                </a:lnTo>
                <a:lnTo>
                  <a:pt x="265" y="4"/>
                </a:lnTo>
                <a:lnTo>
                  <a:pt x="265" y="4"/>
                </a:lnTo>
                <a:lnTo>
                  <a:pt x="266" y="4"/>
                </a:lnTo>
                <a:lnTo>
                  <a:pt x="267" y="2"/>
                </a:lnTo>
                <a:lnTo>
                  <a:pt x="268" y="3"/>
                </a:lnTo>
                <a:lnTo>
                  <a:pt x="269" y="2"/>
                </a:lnTo>
                <a:lnTo>
                  <a:pt x="270" y="2"/>
                </a:lnTo>
                <a:lnTo>
                  <a:pt x="271" y="1"/>
                </a:lnTo>
                <a:lnTo>
                  <a:pt x="272" y="1"/>
                </a:lnTo>
                <a:lnTo>
                  <a:pt x="272" y="2"/>
                </a:lnTo>
                <a:lnTo>
                  <a:pt x="273" y="2"/>
                </a:lnTo>
                <a:lnTo>
                  <a:pt x="274" y="3"/>
                </a:lnTo>
                <a:lnTo>
                  <a:pt x="275" y="2"/>
                </a:lnTo>
                <a:lnTo>
                  <a:pt x="276" y="2"/>
                </a:lnTo>
                <a:lnTo>
                  <a:pt x="277" y="2"/>
                </a:lnTo>
                <a:lnTo>
                  <a:pt x="278" y="1"/>
                </a:lnTo>
                <a:lnTo>
                  <a:pt x="279" y="2"/>
                </a:lnTo>
                <a:lnTo>
                  <a:pt x="280" y="1"/>
                </a:lnTo>
                <a:lnTo>
                  <a:pt x="280" y="2"/>
                </a:lnTo>
                <a:lnTo>
                  <a:pt x="281" y="2"/>
                </a:lnTo>
                <a:lnTo>
                  <a:pt x="282" y="3"/>
                </a:lnTo>
                <a:lnTo>
                  <a:pt x="283" y="5"/>
                </a:lnTo>
                <a:lnTo>
                  <a:pt x="284" y="8"/>
                </a:lnTo>
                <a:lnTo>
                  <a:pt x="285" y="13"/>
                </a:lnTo>
                <a:lnTo>
                  <a:pt x="286" y="21"/>
                </a:lnTo>
                <a:lnTo>
                  <a:pt x="287" y="29"/>
                </a:lnTo>
                <a:lnTo>
                  <a:pt x="287" y="37"/>
                </a:lnTo>
                <a:lnTo>
                  <a:pt x="288" y="42"/>
                </a:lnTo>
                <a:lnTo>
                  <a:pt x="289" y="43"/>
                </a:lnTo>
                <a:lnTo>
                  <a:pt x="290" y="38"/>
                </a:lnTo>
                <a:lnTo>
                  <a:pt x="291" y="36"/>
                </a:lnTo>
                <a:lnTo>
                  <a:pt x="292" y="29"/>
                </a:lnTo>
                <a:lnTo>
                  <a:pt x="293" y="23"/>
                </a:lnTo>
                <a:lnTo>
                  <a:pt x="294" y="18"/>
                </a:lnTo>
                <a:lnTo>
                  <a:pt x="295" y="15"/>
                </a:lnTo>
                <a:lnTo>
                  <a:pt x="295" y="12"/>
                </a:lnTo>
                <a:lnTo>
                  <a:pt x="296" y="9"/>
                </a:lnTo>
                <a:lnTo>
                  <a:pt x="297" y="9"/>
                </a:lnTo>
                <a:lnTo>
                  <a:pt x="298" y="8"/>
                </a:lnTo>
                <a:lnTo>
                  <a:pt x="299" y="8"/>
                </a:lnTo>
                <a:lnTo>
                  <a:pt x="300" y="7"/>
                </a:lnTo>
                <a:lnTo>
                  <a:pt x="301" y="6"/>
                </a:lnTo>
                <a:lnTo>
                  <a:pt x="302" y="6"/>
                </a:lnTo>
                <a:lnTo>
                  <a:pt x="302" y="5"/>
                </a:lnTo>
                <a:lnTo>
                  <a:pt x="303" y="6"/>
                </a:lnTo>
                <a:lnTo>
                  <a:pt x="304" y="5"/>
                </a:lnTo>
                <a:lnTo>
                  <a:pt x="305" y="5"/>
                </a:lnTo>
                <a:lnTo>
                  <a:pt x="306" y="4"/>
                </a:lnTo>
                <a:lnTo>
                  <a:pt x="307" y="6"/>
                </a:lnTo>
                <a:lnTo>
                  <a:pt x="308" y="5"/>
                </a:lnTo>
                <a:lnTo>
                  <a:pt x="309" y="5"/>
                </a:lnTo>
                <a:lnTo>
                  <a:pt x="310" y="4"/>
                </a:lnTo>
                <a:lnTo>
                  <a:pt x="310" y="5"/>
                </a:lnTo>
                <a:lnTo>
                  <a:pt x="311" y="4"/>
                </a:lnTo>
                <a:lnTo>
                  <a:pt x="312" y="4"/>
                </a:lnTo>
                <a:lnTo>
                  <a:pt x="313" y="4"/>
                </a:lnTo>
                <a:lnTo>
                  <a:pt x="314" y="3"/>
                </a:lnTo>
                <a:lnTo>
                  <a:pt x="315" y="2"/>
                </a:lnTo>
                <a:lnTo>
                  <a:pt x="316" y="2"/>
                </a:lnTo>
                <a:lnTo>
                  <a:pt x="317" y="2"/>
                </a:lnTo>
                <a:lnTo>
                  <a:pt x="317" y="3"/>
                </a:lnTo>
                <a:lnTo>
                  <a:pt x="318" y="2"/>
                </a:lnTo>
                <a:lnTo>
                  <a:pt x="319" y="2"/>
                </a:lnTo>
                <a:lnTo>
                  <a:pt x="320" y="2"/>
                </a:lnTo>
                <a:lnTo>
                  <a:pt x="321" y="3"/>
                </a:lnTo>
                <a:lnTo>
                  <a:pt x="322" y="3"/>
                </a:lnTo>
                <a:lnTo>
                  <a:pt x="323" y="3"/>
                </a:lnTo>
                <a:lnTo>
                  <a:pt x="324" y="4"/>
                </a:lnTo>
                <a:lnTo>
                  <a:pt x="325" y="3"/>
                </a:lnTo>
                <a:lnTo>
                  <a:pt x="325" y="4"/>
                </a:lnTo>
                <a:lnTo>
                  <a:pt x="326" y="4"/>
                </a:lnTo>
                <a:lnTo>
                  <a:pt x="327" y="4"/>
                </a:lnTo>
                <a:lnTo>
                  <a:pt x="328" y="3"/>
                </a:lnTo>
                <a:lnTo>
                  <a:pt x="329" y="4"/>
                </a:lnTo>
                <a:lnTo>
                  <a:pt x="330" y="2"/>
                </a:lnTo>
                <a:lnTo>
                  <a:pt x="331" y="2"/>
                </a:lnTo>
                <a:lnTo>
                  <a:pt x="332" y="3"/>
                </a:lnTo>
                <a:lnTo>
                  <a:pt x="332" y="2"/>
                </a:lnTo>
                <a:lnTo>
                  <a:pt x="333" y="2"/>
                </a:lnTo>
                <a:lnTo>
                  <a:pt x="334" y="2"/>
                </a:lnTo>
                <a:lnTo>
                  <a:pt x="335" y="2"/>
                </a:lnTo>
                <a:lnTo>
                  <a:pt x="336" y="2"/>
                </a:lnTo>
                <a:lnTo>
                  <a:pt x="337" y="1"/>
                </a:lnTo>
                <a:lnTo>
                  <a:pt x="338" y="2"/>
                </a:lnTo>
                <a:lnTo>
                  <a:pt x="339" y="2"/>
                </a:lnTo>
                <a:lnTo>
                  <a:pt x="340" y="2"/>
                </a:lnTo>
                <a:lnTo>
                  <a:pt x="340" y="1"/>
                </a:lnTo>
                <a:lnTo>
                  <a:pt x="341" y="2"/>
                </a:lnTo>
                <a:lnTo>
                  <a:pt x="342" y="2"/>
                </a:lnTo>
                <a:lnTo>
                  <a:pt x="343" y="2"/>
                </a:lnTo>
                <a:lnTo>
                  <a:pt x="344" y="2"/>
                </a:lnTo>
                <a:lnTo>
                  <a:pt x="345" y="2"/>
                </a:lnTo>
                <a:lnTo>
                  <a:pt x="346" y="3"/>
                </a:lnTo>
                <a:lnTo>
                  <a:pt x="347" y="2"/>
                </a:lnTo>
                <a:lnTo>
                  <a:pt x="347" y="4"/>
                </a:lnTo>
                <a:lnTo>
                  <a:pt x="348" y="3"/>
                </a:lnTo>
                <a:lnTo>
                  <a:pt x="349" y="4"/>
                </a:lnTo>
                <a:lnTo>
                  <a:pt x="350" y="4"/>
                </a:lnTo>
                <a:lnTo>
                  <a:pt x="351" y="3"/>
                </a:lnTo>
                <a:lnTo>
                  <a:pt x="352" y="2"/>
                </a:lnTo>
                <a:lnTo>
                  <a:pt x="353" y="2"/>
                </a:lnTo>
                <a:lnTo>
                  <a:pt x="354" y="3"/>
                </a:lnTo>
                <a:lnTo>
                  <a:pt x="355" y="3"/>
                </a:lnTo>
                <a:lnTo>
                  <a:pt x="355" y="3"/>
                </a:lnTo>
                <a:lnTo>
                  <a:pt x="356" y="3"/>
                </a:lnTo>
                <a:lnTo>
                  <a:pt x="357" y="4"/>
                </a:lnTo>
                <a:lnTo>
                  <a:pt x="358" y="4"/>
                </a:lnTo>
                <a:lnTo>
                  <a:pt x="359" y="5"/>
                </a:lnTo>
                <a:lnTo>
                  <a:pt x="360" y="4"/>
                </a:lnTo>
                <a:lnTo>
                  <a:pt x="361" y="5"/>
                </a:lnTo>
                <a:lnTo>
                  <a:pt x="362" y="5"/>
                </a:lnTo>
                <a:lnTo>
                  <a:pt x="362" y="5"/>
                </a:lnTo>
                <a:lnTo>
                  <a:pt x="363" y="4"/>
                </a:lnTo>
                <a:lnTo>
                  <a:pt x="364" y="5"/>
                </a:lnTo>
                <a:lnTo>
                  <a:pt x="365" y="4"/>
                </a:lnTo>
                <a:lnTo>
                  <a:pt x="366" y="4"/>
                </a:lnTo>
                <a:lnTo>
                  <a:pt x="367" y="3"/>
                </a:lnTo>
                <a:lnTo>
                  <a:pt x="368" y="3"/>
                </a:lnTo>
                <a:lnTo>
                  <a:pt x="369" y="2"/>
                </a:lnTo>
                <a:lnTo>
                  <a:pt x="370" y="3"/>
                </a:lnTo>
                <a:lnTo>
                  <a:pt x="370" y="3"/>
                </a:lnTo>
                <a:lnTo>
                  <a:pt x="371" y="2"/>
                </a:lnTo>
                <a:lnTo>
                  <a:pt x="372" y="3"/>
                </a:lnTo>
                <a:lnTo>
                  <a:pt x="373" y="3"/>
                </a:lnTo>
                <a:lnTo>
                  <a:pt x="374" y="4"/>
                </a:lnTo>
                <a:lnTo>
                  <a:pt x="375" y="2"/>
                </a:lnTo>
                <a:lnTo>
                  <a:pt x="376" y="3"/>
                </a:lnTo>
                <a:lnTo>
                  <a:pt x="377" y="4"/>
                </a:lnTo>
                <a:lnTo>
                  <a:pt x="377" y="3"/>
                </a:lnTo>
                <a:lnTo>
                  <a:pt x="378" y="3"/>
                </a:lnTo>
                <a:lnTo>
                  <a:pt x="379" y="4"/>
                </a:lnTo>
                <a:lnTo>
                  <a:pt x="380" y="3"/>
                </a:lnTo>
                <a:lnTo>
                  <a:pt x="381" y="3"/>
                </a:lnTo>
                <a:lnTo>
                  <a:pt x="382" y="3"/>
                </a:lnTo>
                <a:lnTo>
                  <a:pt x="383" y="3"/>
                </a:lnTo>
                <a:lnTo>
                  <a:pt x="384" y="3"/>
                </a:lnTo>
                <a:lnTo>
                  <a:pt x="385" y="2"/>
                </a:lnTo>
                <a:lnTo>
                  <a:pt x="385" y="3"/>
                </a:lnTo>
                <a:lnTo>
                  <a:pt x="386" y="3"/>
                </a:lnTo>
                <a:lnTo>
                  <a:pt x="387" y="4"/>
                </a:lnTo>
                <a:lnTo>
                  <a:pt x="388" y="4"/>
                </a:lnTo>
                <a:lnTo>
                  <a:pt x="389" y="4"/>
                </a:lnTo>
                <a:lnTo>
                  <a:pt x="390" y="4"/>
                </a:lnTo>
                <a:lnTo>
                  <a:pt x="391" y="5"/>
                </a:lnTo>
                <a:lnTo>
                  <a:pt x="392" y="4"/>
                </a:lnTo>
                <a:lnTo>
                  <a:pt x="392" y="4"/>
                </a:lnTo>
                <a:lnTo>
                  <a:pt x="393" y="2"/>
                </a:lnTo>
                <a:lnTo>
                  <a:pt x="394" y="3"/>
                </a:lnTo>
                <a:lnTo>
                  <a:pt x="395" y="2"/>
                </a:lnTo>
                <a:lnTo>
                  <a:pt x="396" y="3"/>
                </a:lnTo>
                <a:lnTo>
                  <a:pt x="397" y="2"/>
                </a:lnTo>
                <a:lnTo>
                  <a:pt x="398" y="2"/>
                </a:lnTo>
                <a:lnTo>
                  <a:pt x="399" y="1"/>
                </a:lnTo>
                <a:lnTo>
                  <a:pt x="400" y="3"/>
                </a:lnTo>
                <a:lnTo>
                  <a:pt x="400" y="2"/>
                </a:lnTo>
                <a:lnTo>
                  <a:pt x="401" y="2"/>
                </a:lnTo>
                <a:lnTo>
                  <a:pt x="402" y="3"/>
                </a:lnTo>
                <a:lnTo>
                  <a:pt x="403" y="2"/>
                </a:lnTo>
                <a:lnTo>
                  <a:pt x="404" y="2"/>
                </a:lnTo>
                <a:lnTo>
                  <a:pt x="405" y="3"/>
                </a:lnTo>
                <a:lnTo>
                  <a:pt x="406" y="3"/>
                </a:lnTo>
                <a:lnTo>
                  <a:pt x="407" y="3"/>
                </a:lnTo>
                <a:lnTo>
                  <a:pt x="407" y="3"/>
                </a:lnTo>
                <a:lnTo>
                  <a:pt x="408" y="3"/>
                </a:lnTo>
                <a:lnTo>
                  <a:pt x="409" y="2"/>
                </a:lnTo>
                <a:lnTo>
                  <a:pt x="410" y="2"/>
                </a:lnTo>
                <a:lnTo>
                  <a:pt x="411" y="3"/>
                </a:lnTo>
                <a:lnTo>
                  <a:pt x="412" y="2"/>
                </a:lnTo>
                <a:lnTo>
                  <a:pt x="413" y="2"/>
                </a:lnTo>
                <a:lnTo>
                  <a:pt x="414" y="2"/>
                </a:lnTo>
                <a:lnTo>
                  <a:pt x="415" y="2"/>
                </a:lnTo>
                <a:lnTo>
                  <a:pt x="415" y="1"/>
                </a:lnTo>
                <a:lnTo>
                  <a:pt x="416" y="1"/>
                </a:lnTo>
                <a:lnTo>
                  <a:pt x="417" y="1"/>
                </a:lnTo>
                <a:lnTo>
                  <a:pt x="418" y="2"/>
                </a:lnTo>
                <a:lnTo>
                  <a:pt x="419" y="1"/>
                </a:lnTo>
                <a:lnTo>
                  <a:pt x="420" y="1"/>
                </a:lnTo>
                <a:lnTo>
                  <a:pt x="421" y="2"/>
                </a:lnTo>
                <a:lnTo>
                  <a:pt x="422" y="2"/>
                </a:lnTo>
                <a:lnTo>
                  <a:pt x="422" y="2"/>
                </a:lnTo>
                <a:lnTo>
                  <a:pt x="423" y="2"/>
                </a:lnTo>
                <a:lnTo>
                  <a:pt x="424" y="3"/>
                </a:lnTo>
                <a:lnTo>
                  <a:pt x="425" y="3"/>
                </a:lnTo>
                <a:lnTo>
                  <a:pt x="426" y="3"/>
                </a:lnTo>
                <a:lnTo>
                  <a:pt x="427" y="3"/>
                </a:lnTo>
                <a:lnTo>
                  <a:pt x="428" y="3"/>
                </a:lnTo>
                <a:lnTo>
                  <a:pt x="429" y="3"/>
                </a:lnTo>
                <a:lnTo>
                  <a:pt x="430" y="3"/>
                </a:lnTo>
                <a:lnTo>
                  <a:pt x="430" y="3"/>
                </a:lnTo>
                <a:lnTo>
                  <a:pt x="431" y="3"/>
                </a:lnTo>
                <a:lnTo>
                  <a:pt x="432" y="3"/>
                </a:lnTo>
                <a:lnTo>
                  <a:pt x="433" y="3"/>
                </a:lnTo>
                <a:lnTo>
                  <a:pt x="434" y="3"/>
                </a:lnTo>
                <a:lnTo>
                  <a:pt x="435" y="4"/>
                </a:lnTo>
                <a:lnTo>
                  <a:pt x="436" y="4"/>
                </a:lnTo>
                <a:lnTo>
                  <a:pt x="437" y="3"/>
                </a:lnTo>
                <a:lnTo>
                  <a:pt x="437" y="4"/>
                </a:lnTo>
                <a:lnTo>
                  <a:pt x="438" y="3"/>
                </a:lnTo>
                <a:lnTo>
                  <a:pt x="439" y="3"/>
                </a:lnTo>
                <a:lnTo>
                  <a:pt x="440" y="5"/>
                </a:lnTo>
                <a:lnTo>
                  <a:pt x="441" y="4"/>
                </a:lnTo>
                <a:lnTo>
                  <a:pt x="442" y="4"/>
                </a:lnTo>
                <a:lnTo>
                  <a:pt x="443" y="3"/>
                </a:lnTo>
                <a:lnTo>
                  <a:pt x="444" y="3"/>
                </a:lnTo>
                <a:lnTo>
                  <a:pt x="445" y="3"/>
                </a:lnTo>
                <a:lnTo>
                  <a:pt x="445" y="3"/>
                </a:lnTo>
                <a:lnTo>
                  <a:pt x="446" y="3"/>
                </a:lnTo>
                <a:lnTo>
                  <a:pt x="447" y="3"/>
                </a:lnTo>
                <a:lnTo>
                  <a:pt x="448" y="2"/>
                </a:lnTo>
                <a:lnTo>
                  <a:pt x="449" y="3"/>
                </a:lnTo>
                <a:lnTo>
                  <a:pt x="450" y="3"/>
                </a:lnTo>
                <a:lnTo>
                  <a:pt x="451" y="3"/>
                </a:lnTo>
                <a:lnTo>
                  <a:pt x="452" y="5"/>
                </a:lnTo>
                <a:lnTo>
                  <a:pt x="452" y="6"/>
                </a:lnTo>
                <a:lnTo>
                  <a:pt x="453" y="5"/>
                </a:lnTo>
                <a:lnTo>
                  <a:pt x="454" y="5"/>
                </a:lnTo>
                <a:lnTo>
                  <a:pt x="455" y="4"/>
                </a:lnTo>
                <a:lnTo>
                  <a:pt x="456" y="4"/>
                </a:lnTo>
                <a:lnTo>
                  <a:pt x="457" y="3"/>
                </a:lnTo>
                <a:lnTo>
                  <a:pt x="458" y="3"/>
                </a:lnTo>
                <a:lnTo>
                  <a:pt x="459" y="2"/>
                </a:lnTo>
                <a:lnTo>
                  <a:pt x="459" y="2"/>
                </a:lnTo>
                <a:lnTo>
                  <a:pt x="460" y="2"/>
                </a:lnTo>
                <a:lnTo>
                  <a:pt x="461" y="2"/>
                </a:lnTo>
                <a:lnTo>
                  <a:pt x="462" y="1"/>
                </a:lnTo>
                <a:lnTo>
                  <a:pt x="463" y="1"/>
                </a:lnTo>
                <a:lnTo>
                  <a:pt x="464" y="1"/>
                </a:lnTo>
                <a:lnTo>
                  <a:pt x="465" y="2"/>
                </a:lnTo>
                <a:lnTo>
                  <a:pt x="466" y="3"/>
                </a:lnTo>
                <a:lnTo>
                  <a:pt x="467" y="4"/>
                </a:lnTo>
                <a:lnTo>
                  <a:pt x="467" y="5"/>
                </a:lnTo>
                <a:lnTo>
                  <a:pt x="468" y="8"/>
                </a:lnTo>
                <a:lnTo>
                  <a:pt x="469" y="11"/>
                </a:lnTo>
                <a:lnTo>
                  <a:pt x="470" y="14"/>
                </a:lnTo>
                <a:lnTo>
                  <a:pt x="471" y="15"/>
                </a:lnTo>
                <a:lnTo>
                  <a:pt x="472" y="18"/>
                </a:lnTo>
                <a:lnTo>
                  <a:pt x="473" y="18"/>
                </a:lnTo>
                <a:lnTo>
                  <a:pt x="474" y="19"/>
                </a:lnTo>
                <a:lnTo>
                  <a:pt x="474" y="16"/>
                </a:lnTo>
                <a:lnTo>
                  <a:pt x="475" y="15"/>
                </a:lnTo>
                <a:lnTo>
                  <a:pt x="476" y="12"/>
                </a:lnTo>
                <a:lnTo>
                  <a:pt x="477" y="11"/>
                </a:lnTo>
                <a:lnTo>
                  <a:pt x="478" y="10"/>
                </a:lnTo>
                <a:lnTo>
                  <a:pt x="479" y="10"/>
                </a:lnTo>
                <a:lnTo>
                  <a:pt x="480" y="10"/>
                </a:lnTo>
                <a:lnTo>
                  <a:pt x="481" y="9"/>
                </a:lnTo>
                <a:lnTo>
                  <a:pt x="482" y="9"/>
                </a:lnTo>
                <a:lnTo>
                  <a:pt x="482" y="9"/>
                </a:lnTo>
                <a:lnTo>
                  <a:pt x="483" y="9"/>
                </a:lnTo>
                <a:lnTo>
                  <a:pt x="484" y="8"/>
                </a:lnTo>
                <a:lnTo>
                  <a:pt x="485" y="7"/>
                </a:lnTo>
                <a:lnTo>
                  <a:pt x="486" y="6"/>
                </a:lnTo>
                <a:lnTo>
                  <a:pt x="487" y="6"/>
                </a:lnTo>
                <a:lnTo>
                  <a:pt x="488" y="5"/>
                </a:lnTo>
                <a:lnTo>
                  <a:pt x="489" y="5"/>
                </a:lnTo>
                <a:lnTo>
                  <a:pt x="489" y="4"/>
                </a:lnTo>
                <a:lnTo>
                  <a:pt x="490" y="5"/>
                </a:lnTo>
                <a:lnTo>
                  <a:pt x="491" y="4"/>
                </a:lnTo>
                <a:lnTo>
                  <a:pt x="492" y="3"/>
                </a:lnTo>
                <a:lnTo>
                  <a:pt x="493" y="4"/>
                </a:lnTo>
                <a:lnTo>
                  <a:pt x="494" y="4"/>
                </a:lnTo>
                <a:lnTo>
                  <a:pt x="495" y="3"/>
                </a:lnTo>
                <a:lnTo>
                  <a:pt x="496" y="3"/>
                </a:lnTo>
                <a:lnTo>
                  <a:pt x="497" y="3"/>
                </a:lnTo>
                <a:lnTo>
                  <a:pt x="497" y="4"/>
                </a:lnTo>
                <a:lnTo>
                  <a:pt x="498" y="4"/>
                </a:lnTo>
                <a:lnTo>
                  <a:pt x="499" y="4"/>
                </a:lnTo>
                <a:lnTo>
                  <a:pt x="500" y="3"/>
                </a:lnTo>
                <a:lnTo>
                  <a:pt x="501" y="4"/>
                </a:lnTo>
                <a:lnTo>
                  <a:pt x="502" y="5"/>
                </a:lnTo>
                <a:lnTo>
                  <a:pt x="503" y="4"/>
                </a:lnTo>
                <a:lnTo>
                  <a:pt x="504" y="5"/>
                </a:lnTo>
                <a:lnTo>
                  <a:pt x="504" y="4"/>
                </a:lnTo>
                <a:lnTo>
                  <a:pt x="505" y="3"/>
                </a:lnTo>
                <a:lnTo>
                  <a:pt x="506" y="4"/>
                </a:lnTo>
                <a:lnTo>
                  <a:pt x="507" y="4"/>
                </a:lnTo>
                <a:lnTo>
                  <a:pt x="508" y="4"/>
                </a:lnTo>
                <a:lnTo>
                  <a:pt x="509" y="3"/>
                </a:lnTo>
                <a:lnTo>
                  <a:pt x="510" y="3"/>
                </a:lnTo>
                <a:lnTo>
                  <a:pt x="511" y="2"/>
                </a:lnTo>
                <a:lnTo>
                  <a:pt x="512" y="3"/>
                </a:lnTo>
                <a:lnTo>
                  <a:pt x="512" y="4"/>
                </a:lnTo>
                <a:lnTo>
                  <a:pt x="513" y="3"/>
                </a:lnTo>
                <a:lnTo>
                  <a:pt x="514" y="3"/>
                </a:lnTo>
                <a:lnTo>
                  <a:pt x="515" y="3"/>
                </a:lnTo>
                <a:lnTo>
                  <a:pt x="516" y="3"/>
                </a:lnTo>
                <a:lnTo>
                  <a:pt x="517" y="4"/>
                </a:lnTo>
                <a:lnTo>
                  <a:pt x="518" y="3"/>
                </a:lnTo>
                <a:lnTo>
                  <a:pt x="519" y="3"/>
                </a:lnTo>
                <a:lnTo>
                  <a:pt x="519" y="3"/>
                </a:lnTo>
                <a:lnTo>
                  <a:pt x="520" y="3"/>
                </a:lnTo>
                <a:lnTo>
                  <a:pt x="521" y="2"/>
                </a:lnTo>
                <a:lnTo>
                  <a:pt x="522" y="3"/>
                </a:lnTo>
                <a:lnTo>
                  <a:pt x="523" y="2"/>
                </a:lnTo>
                <a:lnTo>
                  <a:pt x="524" y="3"/>
                </a:lnTo>
                <a:lnTo>
                  <a:pt x="525" y="3"/>
                </a:lnTo>
                <a:lnTo>
                  <a:pt x="526" y="3"/>
                </a:lnTo>
                <a:lnTo>
                  <a:pt x="527" y="5"/>
                </a:lnTo>
                <a:lnTo>
                  <a:pt x="527" y="5"/>
                </a:lnTo>
                <a:lnTo>
                  <a:pt x="528" y="6"/>
                </a:lnTo>
                <a:lnTo>
                  <a:pt x="529" y="8"/>
                </a:lnTo>
                <a:lnTo>
                  <a:pt x="530" y="8"/>
                </a:lnTo>
                <a:lnTo>
                  <a:pt x="531" y="10"/>
                </a:lnTo>
                <a:lnTo>
                  <a:pt x="532" y="11"/>
                </a:lnTo>
                <a:lnTo>
                  <a:pt x="533" y="12"/>
                </a:lnTo>
                <a:lnTo>
                  <a:pt x="534" y="11"/>
                </a:lnTo>
                <a:lnTo>
                  <a:pt x="534" y="10"/>
                </a:lnTo>
                <a:lnTo>
                  <a:pt x="535" y="9"/>
                </a:lnTo>
                <a:lnTo>
                  <a:pt x="536" y="8"/>
                </a:lnTo>
                <a:lnTo>
                  <a:pt x="537" y="8"/>
                </a:lnTo>
                <a:lnTo>
                  <a:pt x="538" y="7"/>
                </a:lnTo>
                <a:lnTo>
                  <a:pt x="539" y="8"/>
                </a:lnTo>
                <a:lnTo>
                  <a:pt x="540" y="9"/>
                </a:lnTo>
                <a:lnTo>
                  <a:pt x="541" y="11"/>
                </a:lnTo>
                <a:lnTo>
                  <a:pt x="542" y="14"/>
                </a:lnTo>
                <a:lnTo>
                  <a:pt x="542" y="16"/>
                </a:lnTo>
                <a:lnTo>
                  <a:pt x="543" y="18"/>
                </a:lnTo>
                <a:lnTo>
                  <a:pt x="544" y="19"/>
                </a:lnTo>
                <a:lnTo>
                  <a:pt x="545" y="22"/>
                </a:lnTo>
                <a:lnTo>
                  <a:pt x="546" y="20"/>
                </a:lnTo>
                <a:lnTo>
                  <a:pt x="547" y="19"/>
                </a:lnTo>
                <a:lnTo>
                  <a:pt x="548" y="17"/>
                </a:lnTo>
                <a:lnTo>
                  <a:pt x="549" y="14"/>
                </a:lnTo>
                <a:lnTo>
                  <a:pt x="549" y="10"/>
                </a:lnTo>
                <a:lnTo>
                  <a:pt x="550" y="9"/>
                </a:lnTo>
                <a:lnTo>
                  <a:pt x="551" y="7"/>
                </a:lnTo>
                <a:lnTo>
                  <a:pt x="552" y="5"/>
                </a:lnTo>
                <a:lnTo>
                  <a:pt x="553" y="4"/>
                </a:lnTo>
                <a:lnTo>
                  <a:pt x="554" y="4"/>
                </a:lnTo>
                <a:lnTo>
                  <a:pt x="555" y="4"/>
                </a:lnTo>
                <a:lnTo>
                  <a:pt x="556" y="4"/>
                </a:lnTo>
                <a:lnTo>
                  <a:pt x="557" y="3"/>
                </a:lnTo>
                <a:lnTo>
                  <a:pt x="557" y="4"/>
                </a:lnTo>
                <a:lnTo>
                  <a:pt x="558" y="4"/>
                </a:lnTo>
                <a:lnTo>
                  <a:pt x="559" y="5"/>
                </a:lnTo>
                <a:lnTo>
                  <a:pt x="560" y="4"/>
                </a:lnTo>
                <a:lnTo>
                  <a:pt x="561" y="4"/>
                </a:lnTo>
                <a:lnTo>
                  <a:pt x="562" y="4"/>
                </a:lnTo>
                <a:lnTo>
                  <a:pt x="563" y="5"/>
                </a:lnTo>
                <a:lnTo>
                  <a:pt x="564" y="6"/>
                </a:lnTo>
                <a:lnTo>
                  <a:pt x="564" y="4"/>
                </a:lnTo>
                <a:lnTo>
                  <a:pt x="565" y="7"/>
                </a:lnTo>
                <a:lnTo>
                  <a:pt x="566" y="7"/>
                </a:lnTo>
                <a:lnTo>
                  <a:pt x="567" y="6"/>
                </a:lnTo>
                <a:lnTo>
                  <a:pt x="568" y="7"/>
                </a:lnTo>
                <a:lnTo>
                  <a:pt x="569" y="6"/>
                </a:lnTo>
                <a:lnTo>
                  <a:pt x="570" y="6"/>
                </a:lnTo>
                <a:lnTo>
                  <a:pt x="571" y="5"/>
                </a:lnTo>
                <a:lnTo>
                  <a:pt x="572" y="6"/>
                </a:lnTo>
                <a:lnTo>
                  <a:pt x="572" y="5"/>
                </a:lnTo>
                <a:lnTo>
                  <a:pt x="573" y="4"/>
                </a:lnTo>
                <a:lnTo>
                  <a:pt x="574" y="4"/>
                </a:lnTo>
                <a:lnTo>
                  <a:pt x="575" y="4"/>
                </a:lnTo>
                <a:lnTo>
                  <a:pt x="576" y="3"/>
                </a:lnTo>
                <a:lnTo>
                  <a:pt x="577" y="3"/>
                </a:lnTo>
                <a:lnTo>
                  <a:pt x="578" y="3"/>
                </a:lnTo>
                <a:lnTo>
                  <a:pt x="579" y="2"/>
                </a:lnTo>
                <a:lnTo>
                  <a:pt x="579" y="2"/>
                </a:lnTo>
                <a:lnTo>
                  <a:pt x="580" y="2"/>
                </a:lnTo>
                <a:lnTo>
                  <a:pt x="581" y="2"/>
                </a:lnTo>
                <a:lnTo>
                  <a:pt x="582" y="2"/>
                </a:lnTo>
                <a:lnTo>
                  <a:pt x="583" y="2"/>
                </a:lnTo>
                <a:lnTo>
                  <a:pt x="584" y="2"/>
                </a:lnTo>
                <a:lnTo>
                  <a:pt x="585" y="3"/>
                </a:lnTo>
                <a:lnTo>
                  <a:pt x="586" y="3"/>
                </a:lnTo>
                <a:lnTo>
                  <a:pt x="587" y="3"/>
                </a:lnTo>
                <a:lnTo>
                  <a:pt x="587" y="3"/>
                </a:lnTo>
                <a:lnTo>
                  <a:pt x="588" y="3"/>
                </a:lnTo>
                <a:lnTo>
                  <a:pt x="589" y="3"/>
                </a:lnTo>
                <a:lnTo>
                  <a:pt x="590" y="4"/>
                </a:lnTo>
                <a:lnTo>
                  <a:pt x="591" y="3"/>
                </a:lnTo>
                <a:lnTo>
                  <a:pt x="592" y="2"/>
                </a:lnTo>
                <a:lnTo>
                  <a:pt x="593" y="2"/>
                </a:lnTo>
                <a:lnTo>
                  <a:pt x="594" y="2"/>
                </a:lnTo>
                <a:lnTo>
                  <a:pt x="594" y="2"/>
                </a:lnTo>
                <a:lnTo>
                  <a:pt x="595" y="3"/>
                </a:lnTo>
                <a:lnTo>
                  <a:pt x="596" y="1"/>
                </a:lnTo>
                <a:lnTo>
                  <a:pt x="597" y="2"/>
                </a:lnTo>
                <a:lnTo>
                  <a:pt x="598" y="2"/>
                </a:lnTo>
                <a:lnTo>
                  <a:pt x="599" y="1"/>
                </a:lnTo>
                <a:lnTo>
                  <a:pt x="600" y="1"/>
                </a:lnTo>
                <a:lnTo>
                  <a:pt x="601" y="2"/>
                </a:lnTo>
                <a:lnTo>
                  <a:pt x="602" y="2"/>
                </a:lnTo>
                <a:lnTo>
                  <a:pt x="602" y="1"/>
                </a:lnTo>
                <a:lnTo>
                  <a:pt x="603" y="2"/>
                </a:lnTo>
                <a:lnTo>
                  <a:pt x="604" y="2"/>
                </a:lnTo>
                <a:lnTo>
                  <a:pt x="605" y="1"/>
                </a:lnTo>
                <a:lnTo>
                  <a:pt x="606" y="2"/>
                </a:lnTo>
                <a:lnTo>
                  <a:pt x="607" y="1"/>
                </a:lnTo>
                <a:lnTo>
                  <a:pt x="608" y="2"/>
                </a:lnTo>
                <a:lnTo>
                  <a:pt x="609" y="3"/>
                </a:lnTo>
                <a:lnTo>
                  <a:pt x="609" y="3"/>
                </a:lnTo>
                <a:lnTo>
                  <a:pt x="610" y="3"/>
                </a:lnTo>
                <a:lnTo>
                  <a:pt x="611" y="3"/>
                </a:lnTo>
                <a:lnTo>
                  <a:pt x="612" y="3"/>
                </a:lnTo>
                <a:lnTo>
                  <a:pt x="613" y="3"/>
                </a:lnTo>
                <a:lnTo>
                  <a:pt x="614" y="3"/>
                </a:lnTo>
                <a:lnTo>
                  <a:pt x="615" y="3"/>
                </a:lnTo>
                <a:lnTo>
                  <a:pt x="616" y="3"/>
                </a:lnTo>
                <a:lnTo>
                  <a:pt x="617" y="3"/>
                </a:lnTo>
                <a:lnTo>
                  <a:pt x="617" y="3"/>
                </a:lnTo>
                <a:lnTo>
                  <a:pt x="618" y="2"/>
                </a:lnTo>
                <a:lnTo>
                  <a:pt x="619" y="1"/>
                </a:lnTo>
                <a:lnTo>
                  <a:pt x="620" y="1"/>
                </a:lnTo>
                <a:lnTo>
                  <a:pt x="621" y="1"/>
                </a:lnTo>
                <a:lnTo>
                  <a:pt x="622" y="1"/>
                </a:lnTo>
                <a:lnTo>
                  <a:pt x="623" y="1"/>
                </a:lnTo>
                <a:lnTo>
                  <a:pt x="624" y="1"/>
                </a:lnTo>
                <a:lnTo>
                  <a:pt x="624" y="1"/>
                </a:lnTo>
                <a:lnTo>
                  <a:pt x="625" y="1"/>
                </a:lnTo>
                <a:lnTo>
                  <a:pt x="626" y="2"/>
                </a:lnTo>
                <a:lnTo>
                  <a:pt x="627" y="1"/>
                </a:lnTo>
                <a:lnTo>
                  <a:pt x="628" y="2"/>
                </a:lnTo>
                <a:lnTo>
                  <a:pt x="629" y="2"/>
                </a:lnTo>
                <a:lnTo>
                  <a:pt x="630" y="1"/>
                </a:lnTo>
                <a:lnTo>
                  <a:pt x="631" y="1"/>
                </a:lnTo>
                <a:lnTo>
                  <a:pt x="632" y="1"/>
                </a:lnTo>
                <a:lnTo>
                  <a:pt x="632" y="1"/>
                </a:lnTo>
                <a:lnTo>
                  <a:pt x="633" y="2"/>
                </a:lnTo>
                <a:lnTo>
                  <a:pt x="634" y="2"/>
                </a:lnTo>
                <a:lnTo>
                  <a:pt x="635" y="1"/>
                </a:lnTo>
                <a:lnTo>
                  <a:pt x="636" y="1"/>
                </a:lnTo>
                <a:lnTo>
                  <a:pt x="637" y="1"/>
                </a:lnTo>
                <a:lnTo>
                  <a:pt x="638" y="1"/>
                </a:lnTo>
                <a:lnTo>
                  <a:pt x="639" y="1"/>
                </a:lnTo>
                <a:lnTo>
                  <a:pt x="639" y="1"/>
                </a:lnTo>
                <a:lnTo>
                  <a:pt x="640" y="1"/>
                </a:lnTo>
                <a:lnTo>
                  <a:pt x="641" y="1"/>
                </a:lnTo>
                <a:lnTo>
                  <a:pt x="642" y="1"/>
                </a:lnTo>
                <a:lnTo>
                  <a:pt x="643" y="1"/>
                </a:lnTo>
                <a:lnTo>
                  <a:pt x="644" y="1"/>
                </a:lnTo>
                <a:lnTo>
                  <a:pt x="645" y="2"/>
                </a:lnTo>
                <a:lnTo>
                  <a:pt x="646" y="1"/>
                </a:lnTo>
                <a:lnTo>
                  <a:pt x="647" y="2"/>
                </a:lnTo>
                <a:lnTo>
                  <a:pt x="647" y="2"/>
                </a:lnTo>
                <a:lnTo>
                  <a:pt x="648" y="2"/>
                </a:lnTo>
                <a:lnTo>
                  <a:pt x="649" y="2"/>
                </a:lnTo>
                <a:lnTo>
                  <a:pt x="650" y="2"/>
                </a:lnTo>
                <a:lnTo>
                  <a:pt x="651" y="2"/>
                </a:lnTo>
                <a:lnTo>
                  <a:pt x="652" y="2"/>
                </a:lnTo>
                <a:lnTo>
                  <a:pt x="653" y="2"/>
                </a:lnTo>
                <a:lnTo>
                  <a:pt x="654" y="1"/>
                </a:lnTo>
                <a:lnTo>
                  <a:pt x="654" y="2"/>
                </a:lnTo>
                <a:lnTo>
                  <a:pt x="655" y="2"/>
                </a:lnTo>
                <a:lnTo>
                  <a:pt x="656" y="2"/>
                </a:lnTo>
                <a:lnTo>
                  <a:pt x="657" y="2"/>
                </a:lnTo>
                <a:lnTo>
                  <a:pt x="658" y="1"/>
                </a:lnTo>
                <a:lnTo>
                  <a:pt x="659" y="1"/>
                </a:lnTo>
                <a:lnTo>
                  <a:pt x="660" y="2"/>
                </a:lnTo>
                <a:lnTo>
                  <a:pt x="661" y="2"/>
                </a:lnTo>
                <a:lnTo>
                  <a:pt x="661" y="2"/>
                </a:lnTo>
                <a:lnTo>
                  <a:pt x="662" y="3"/>
                </a:lnTo>
                <a:lnTo>
                  <a:pt x="663" y="3"/>
                </a:lnTo>
                <a:lnTo>
                  <a:pt x="664" y="2"/>
                </a:lnTo>
                <a:lnTo>
                  <a:pt x="665" y="3"/>
                </a:lnTo>
                <a:lnTo>
                  <a:pt x="666" y="3"/>
                </a:lnTo>
                <a:lnTo>
                  <a:pt x="667" y="3"/>
                </a:lnTo>
                <a:lnTo>
                  <a:pt x="668" y="3"/>
                </a:lnTo>
                <a:lnTo>
                  <a:pt x="669" y="2"/>
                </a:lnTo>
                <a:lnTo>
                  <a:pt x="669" y="3"/>
                </a:lnTo>
                <a:lnTo>
                  <a:pt x="670" y="2"/>
                </a:lnTo>
                <a:lnTo>
                  <a:pt x="671" y="2"/>
                </a:lnTo>
                <a:lnTo>
                  <a:pt x="672" y="3"/>
                </a:lnTo>
                <a:lnTo>
                  <a:pt x="673" y="2"/>
                </a:lnTo>
                <a:lnTo>
                  <a:pt x="674" y="2"/>
                </a:lnTo>
                <a:lnTo>
                  <a:pt x="675" y="1"/>
                </a:lnTo>
                <a:lnTo>
                  <a:pt x="676" y="1"/>
                </a:lnTo>
                <a:lnTo>
                  <a:pt x="676" y="1"/>
                </a:lnTo>
                <a:lnTo>
                  <a:pt x="677" y="2"/>
                </a:lnTo>
                <a:lnTo>
                  <a:pt x="678" y="1"/>
                </a:lnTo>
                <a:lnTo>
                  <a:pt x="679" y="1"/>
                </a:lnTo>
                <a:lnTo>
                  <a:pt x="680" y="0"/>
                </a:lnTo>
                <a:lnTo>
                  <a:pt x="681" y="1"/>
                </a:lnTo>
                <a:lnTo>
                  <a:pt x="682" y="1"/>
                </a:lnTo>
                <a:lnTo>
                  <a:pt x="683" y="1"/>
                </a:lnTo>
                <a:lnTo>
                  <a:pt x="684" y="1"/>
                </a:lnTo>
                <a:lnTo>
                  <a:pt x="684" y="0"/>
                </a:lnTo>
                <a:lnTo>
                  <a:pt x="685" y="1"/>
                </a:lnTo>
                <a:lnTo>
                  <a:pt x="686" y="1"/>
                </a:lnTo>
                <a:lnTo>
                  <a:pt x="687" y="1"/>
                </a:lnTo>
                <a:lnTo>
                  <a:pt x="688" y="2"/>
                </a:lnTo>
                <a:lnTo>
                  <a:pt x="689" y="1"/>
                </a:lnTo>
                <a:lnTo>
                  <a:pt x="690" y="2"/>
                </a:lnTo>
                <a:lnTo>
                  <a:pt x="691" y="2"/>
                </a:lnTo>
                <a:lnTo>
                  <a:pt x="691" y="4"/>
                </a:lnTo>
                <a:lnTo>
                  <a:pt x="692" y="3"/>
                </a:lnTo>
                <a:lnTo>
                  <a:pt x="693" y="4"/>
                </a:lnTo>
                <a:lnTo>
                  <a:pt x="694" y="7"/>
                </a:lnTo>
                <a:lnTo>
                  <a:pt x="695" y="7"/>
                </a:lnTo>
                <a:lnTo>
                  <a:pt x="696" y="9"/>
                </a:lnTo>
                <a:lnTo>
                  <a:pt x="697" y="13"/>
                </a:lnTo>
                <a:lnTo>
                  <a:pt x="698" y="15"/>
                </a:lnTo>
                <a:lnTo>
                  <a:pt x="699" y="17"/>
                </a:lnTo>
                <a:lnTo>
                  <a:pt x="699" y="21"/>
                </a:lnTo>
                <a:lnTo>
                  <a:pt x="700" y="22"/>
                </a:lnTo>
                <a:lnTo>
                  <a:pt x="701" y="24"/>
                </a:lnTo>
                <a:lnTo>
                  <a:pt x="702" y="26"/>
                </a:lnTo>
                <a:lnTo>
                  <a:pt x="703" y="22"/>
                </a:lnTo>
                <a:lnTo>
                  <a:pt x="704" y="21"/>
                </a:lnTo>
                <a:lnTo>
                  <a:pt x="705" y="22"/>
                </a:lnTo>
                <a:lnTo>
                  <a:pt x="706" y="22"/>
                </a:lnTo>
                <a:lnTo>
                  <a:pt x="706" y="23"/>
                </a:lnTo>
                <a:lnTo>
                  <a:pt x="707" y="26"/>
                </a:lnTo>
                <a:lnTo>
                  <a:pt x="708" y="28"/>
                </a:lnTo>
                <a:lnTo>
                  <a:pt x="709" y="29"/>
                </a:lnTo>
                <a:lnTo>
                  <a:pt x="710" y="30"/>
                </a:lnTo>
                <a:lnTo>
                  <a:pt x="711" y="28"/>
                </a:lnTo>
                <a:lnTo>
                  <a:pt x="712" y="26"/>
                </a:lnTo>
                <a:lnTo>
                  <a:pt x="713" y="22"/>
                </a:lnTo>
                <a:lnTo>
                  <a:pt x="714" y="19"/>
                </a:lnTo>
                <a:lnTo>
                  <a:pt x="714" y="16"/>
                </a:lnTo>
                <a:lnTo>
                  <a:pt x="715" y="15"/>
                </a:lnTo>
                <a:lnTo>
                  <a:pt x="716" y="13"/>
                </a:lnTo>
                <a:lnTo>
                  <a:pt x="717" y="14"/>
                </a:lnTo>
                <a:lnTo>
                  <a:pt x="718" y="17"/>
                </a:lnTo>
                <a:lnTo>
                  <a:pt x="719" y="21"/>
                </a:lnTo>
                <a:lnTo>
                  <a:pt x="720" y="27"/>
                </a:lnTo>
                <a:lnTo>
                  <a:pt x="721" y="33"/>
                </a:lnTo>
                <a:lnTo>
                  <a:pt x="721" y="35"/>
                </a:lnTo>
                <a:lnTo>
                  <a:pt x="722" y="36"/>
                </a:lnTo>
                <a:lnTo>
                  <a:pt x="723" y="35"/>
                </a:lnTo>
                <a:lnTo>
                  <a:pt x="724" y="32"/>
                </a:lnTo>
                <a:lnTo>
                  <a:pt x="725" y="30"/>
                </a:lnTo>
                <a:lnTo>
                  <a:pt x="726" y="27"/>
                </a:lnTo>
                <a:lnTo>
                  <a:pt x="727" y="24"/>
                </a:lnTo>
                <a:lnTo>
                  <a:pt x="728" y="22"/>
                </a:lnTo>
                <a:lnTo>
                  <a:pt x="729" y="18"/>
                </a:lnTo>
                <a:lnTo>
                  <a:pt x="729" y="17"/>
                </a:lnTo>
                <a:lnTo>
                  <a:pt x="730" y="16"/>
                </a:lnTo>
                <a:lnTo>
                  <a:pt x="731" y="15"/>
                </a:lnTo>
                <a:lnTo>
                  <a:pt x="732" y="14"/>
                </a:lnTo>
                <a:lnTo>
                  <a:pt x="733" y="12"/>
                </a:lnTo>
                <a:lnTo>
                  <a:pt x="734" y="12"/>
                </a:lnTo>
                <a:lnTo>
                  <a:pt x="735" y="11"/>
                </a:lnTo>
                <a:lnTo>
                  <a:pt x="736" y="11"/>
                </a:lnTo>
                <a:lnTo>
                  <a:pt x="736" y="12"/>
                </a:lnTo>
                <a:lnTo>
                  <a:pt x="737" y="10"/>
                </a:lnTo>
                <a:lnTo>
                  <a:pt x="738" y="11"/>
                </a:lnTo>
                <a:lnTo>
                  <a:pt x="739" y="10"/>
                </a:lnTo>
                <a:lnTo>
                  <a:pt x="740" y="9"/>
                </a:lnTo>
                <a:lnTo>
                  <a:pt x="741" y="9"/>
                </a:lnTo>
                <a:lnTo>
                  <a:pt x="742" y="8"/>
                </a:lnTo>
                <a:lnTo>
                  <a:pt x="743" y="9"/>
                </a:lnTo>
                <a:lnTo>
                  <a:pt x="744" y="8"/>
                </a:lnTo>
                <a:lnTo>
                  <a:pt x="744" y="8"/>
                </a:lnTo>
                <a:lnTo>
                  <a:pt x="745" y="7"/>
                </a:lnTo>
                <a:lnTo>
                  <a:pt x="746" y="8"/>
                </a:lnTo>
                <a:lnTo>
                  <a:pt x="747" y="6"/>
                </a:lnTo>
                <a:lnTo>
                  <a:pt x="748" y="7"/>
                </a:lnTo>
                <a:lnTo>
                  <a:pt x="749" y="7"/>
                </a:lnTo>
                <a:lnTo>
                  <a:pt x="750" y="7"/>
                </a:lnTo>
                <a:lnTo>
                  <a:pt x="751" y="6"/>
                </a:lnTo>
                <a:lnTo>
                  <a:pt x="751" y="6"/>
                </a:lnTo>
                <a:lnTo>
                  <a:pt x="752" y="6"/>
                </a:lnTo>
                <a:lnTo>
                  <a:pt x="753" y="6"/>
                </a:lnTo>
                <a:lnTo>
                  <a:pt x="754" y="5"/>
                </a:lnTo>
                <a:lnTo>
                  <a:pt x="755" y="5"/>
                </a:lnTo>
                <a:lnTo>
                  <a:pt x="756" y="5"/>
                </a:lnTo>
                <a:lnTo>
                  <a:pt x="757" y="5"/>
                </a:lnTo>
                <a:lnTo>
                  <a:pt x="758" y="5"/>
                </a:lnTo>
                <a:lnTo>
                  <a:pt x="759" y="6"/>
                </a:lnTo>
                <a:lnTo>
                  <a:pt x="759" y="5"/>
                </a:lnTo>
                <a:lnTo>
                  <a:pt x="760" y="5"/>
                </a:lnTo>
                <a:lnTo>
                  <a:pt x="761" y="5"/>
                </a:lnTo>
                <a:lnTo>
                  <a:pt x="762" y="5"/>
                </a:lnTo>
                <a:lnTo>
                  <a:pt x="763" y="5"/>
                </a:lnTo>
                <a:lnTo>
                  <a:pt x="764" y="6"/>
                </a:lnTo>
                <a:lnTo>
                  <a:pt x="765" y="8"/>
                </a:lnTo>
                <a:lnTo>
                  <a:pt x="766" y="13"/>
                </a:lnTo>
                <a:lnTo>
                  <a:pt x="766" y="21"/>
                </a:lnTo>
                <a:lnTo>
                  <a:pt x="767" y="34"/>
                </a:lnTo>
                <a:lnTo>
                  <a:pt x="768" y="54"/>
                </a:lnTo>
                <a:lnTo>
                  <a:pt x="769" y="83"/>
                </a:lnTo>
                <a:lnTo>
                  <a:pt x="770" y="116"/>
                </a:lnTo>
                <a:lnTo>
                  <a:pt x="771" y="145"/>
                </a:lnTo>
                <a:lnTo>
                  <a:pt x="772" y="166"/>
                </a:lnTo>
                <a:lnTo>
                  <a:pt x="773" y="171"/>
                </a:lnTo>
                <a:lnTo>
                  <a:pt x="774" y="170"/>
                </a:lnTo>
                <a:lnTo>
                  <a:pt x="774" y="152"/>
                </a:lnTo>
                <a:lnTo>
                  <a:pt x="775" y="133"/>
                </a:lnTo>
                <a:lnTo>
                  <a:pt x="776" y="110"/>
                </a:lnTo>
                <a:lnTo>
                  <a:pt x="777" y="92"/>
                </a:lnTo>
                <a:lnTo>
                  <a:pt x="778" y="78"/>
                </a:lnTo>
                <a:lnTo>
                  <a:pt x="779" y="65"/>
                </a:lnTo>
                <a:lnTo>
                  <a:pt x="780" y="56"/>
                </a:lnTo>
                <a:lnTo>
                  <a:pt x="781" y="48"/>
                </a:lnTo>
                <a:lnTo>
                  <a:pt x="781" y="43"/>
                </a:lnTo>
                <a:lnTo>
                  <a:pt x="782" y="36"/>
                </a:lnTo>
                <a:lnTo>
                  <a:pt x="783" y="33"/>
                </a:lnTo>
                <a:lnTo>
                  <a:pt x="784" y="31"/>
                </a:lnTo>
                <a:lnTo>
                  <a:pt x="785" y="26"/>
                </a:lnTo>
                <a:lnTo>
                  <a:pt x="786" y="25"/>
                </a:lnTo>
                <a:lnTo>
                  <a:pt x="787" y="23"/>
                </a:lnTo>
                <a:lnTo>
                  <a:pt x="788" y="22"/>
                </a:lnTo>
                <a:lnTo>
                  <a:pt x="789" y="19"/>
                </a:lnTo>
                <a:lnTo>
                  <a:pt x="789" y="20"/>
                </a:lnTo>
                <a:lnTo>
                  <a:pt x="790" y="18"/>
                </a:lnTo>
                <a:lnTo>
                  <a:pt x="791" y="17"/>
                </a:lnTo>
                <a:lnTo>
                  <a:pt x="792" y="16"/>
                </a:lnTo>
                <a:lnTo>
                  <a:pt x="793" y="15"/>
                </a:lnTo>
                <a:lnTo>
                  <a:pt x="794" y="14"/>
                </a:lnTo>
                <a:lnTo>
                  <a:pt x="795" y="13"/>
                </a:lnTo>
                <a:lnTo>
                  <a:pt x="796" y="15"/>
                </a:lnTo>
                <a:lnTo>
                  <a:pt x="796" y="14"/>
                </a:lnTo>
                <a:lnTo>
                  <a:pt x="797" y="13"/>
                </a:lnTo>
                <a:lnTo>
                  <a:pt x="798" y="13"/>
                </a:lnTo>
                <a:lnTo>
                  <a:pt x="799" y="13"/>
                </a:lnTo>
                <a:lnTo>
                  <a:pt x="800" y="15"/>
                </a:lnTo>
                <a:lnTo>
                  <a:pt x="801" y="18"/>
                </a:lnTo>
                <a:lnTo>
                  <a:pt x="802" y="19"/>
                </a:lnTo>
                <a:lnTo>
                  <a:pt x="803" y="22"/>
                </a:lnTo>
                <a:lnTo>
                  <a:pt x="804" y="23"/>
                </a:lnTo>
                <a:lnTo>
                  <a:pt x="804" y="24"/>
                </a:lnTo>
                <a:lnTo>
                  <a:pt x="805" y="24"/>
                </a:lnTo>
                <a:lnTo>
                  <a:pt x="806" y="24"/>
                </a:lnTo>
                <a:lnTo>
                  <a:pt x="807" y="22"/>
                </a:lnTo>
                <a:lnTo>
                  <a:pt x="808" y="23"/>
                </a:lnTo>
                <a:lnTo>
                  <a:pt x="809" y="21"/>
                </a:lnTo>
                <a:lnTo>
                  <a:pt x="810" y="21"/>
                </a:lnTo>
                <a:lnTo>
                  <a:pt x="811" y="20"/>
                </a:lnTo>
                <a:lnTo>
                  <a:pt x="811" y="21"/>
                </a:lnTo>
                <a:lnTo>
                  <a:pt x="812" y="21"/>
                </a:lnTo>
                <a:lnTo>
                  <a:pt x="813" y="20"/>
                </a:lnTo>
                <a:lnTo>
                  <a:pt x="814" y="20"/>
                </a:lnTo>
                <a:lnTo>
                  <a:pt x="815" y="20"/>
                </a:lnTo>
                <a:lnTo>
                  <a:pt x="816" y="19"/>
                </a:lnTo>
                <a:lnTo>
                  <a:pt x="817" y="18"/>
                </a:lnTo>
                <a:lnTo>
                  <a:pt x="818" y="17"/>
                </a:lnTo>
                <a:lnTo>
                  <a:pt x="819" y="17"/>
                </a:lnTo>
                <a:lnTo>
                  <a:pt x="819" y="15"/>
                </a:lnTo>
                <a:lnTo>
                  <a:pt x="820" y="16"/>
                </a:lnTo>
                <a:lnTo>
                  <a:pt x="821" y="16"/>
                </a:lnTo>
                <a:lnTo>
                  <a:pt x="822" y="16"/>
                </a:lnTo>
                <a:lnTo>
                  <a:pt x="823" y="14"/>
                </a:lnTo>
                <a:lnTo>
                  <a:pt x="824" y="14"/>
                </a:lnTo>
                <a:lnTo>
                  <a:pt x="825" y="13"/>
                </a:lnTo>
                <a:lnTo>
                  <a:pt x="826" y="13"/>
                </a:lnTo>
                <a:lnTo>
                  <a:pt x="826" y="13"/>
                </a:lnTo>
                <a:lnTo>
                  <a:pt x="827" y="14"/>
                </a:lnTo>
                <a:lnTo>
                  <a:pt x="828" y="13"/>
                </a:lnTo>
                <a:lnTo>
                  <a:pt x="829" y="14"/>
                </a:lnTo>
                <a:lnTo>
                  <a:pt x="830" y="12"/>
                </a:lnTo>
                <a:lnTo>
                  <a:pt x="831" y="12"/>
                </a:lnTo>
                <a:lnTo>
                  <a:pt x="832" y="12"/>
                </a:lnTo>
                <a:lnTo>
                  <a:pt x="833" y="12"/>
                </a:lnTo>
                <a:lnTo>
                  <a:pt x="834" y="12"/>
                </a:lnTo>
                <a:lnTo>
                  <a:pt x="834" y="10"/>
                </a:lnTo>
                <a:lnTo>
                  <a:pt x="835" y="9"/>
                </a:lnTo>
                <a:lnTo>
                  <a:pt x="836" y="11"/>
                </a:lnTo>
                <a:lnTo>
                  <a:pt x="837" y="11"/>
                </a:lnTo>
                <a:lnTo>
                  <a:pt x="838" y="11"/>
                </a:lnTo>
                <a:lnTo>
                  <a:pt x="839" y="10"/>
                </a:lnTo>
                <a:lnTo>
                  <a:pt x="840" y="11"/>
                </a:lnTo>
                <a:lnTo>
                  <a:pt x="841" y="10"/>
                </a:lnTo>
                <a:lnTo>
                  <a:pt x="841" y="11"/>
                </a:lnTo>
                <a:lnTo>
                  <a:pt x="842" y="10"/>
                </a:lnTo>
                <a:lnTo>
                  <a:pt x="843" y="11"/>
                </a:lnTo>
                <a:lnTo>
                  <a:pt x="844" y="9"/>
                </a:lnTo>
                <a:lnTo>
                  <a:pt x="845" y="9"/>
                </a:lnTo>
                <a:lnTo>
                  <a:pt x="846" y="9"/>
                </a:lnTo>
                <a:lnTo>
                  <a:pt x="847" y="8"/>
                </a:lnTo>
                <a:lnTo>
                  <a:pt x="848" y="7"/>
                </a:lnTo>
                <a:lnTo>
                  <a:pt x="848" y="8"/>
                </a:lnTo>
                <a:lnTo>
                  <a:pt x="849" y="8"/>
                </a:lnTo>
                <a:lnTo>
                  <a:pt x="850" y="7"/>
                </a:lnTo>
                <a:lnTo>
                  <a:pt x="851" y="7"/>
                </a:lnTo>
                <a:lnTo>
                  <a:pt x="852" y="6"/>
                </a:lnTo>
                <a:lnTo>
                  <a:pt x="853" y="6"/>
                </a:lnTo>
                <a:lnTo>
                  <a:pt x="854" y="6"/>
                </a:lnTo>
                <a:lnTo>
                  <a:pt x="855" y="6"/>
                </a:lnTo>
                <a:lnTo>
                  <a:pt x="856" y="5"/>
                </a:lnTo>
                <a:lnTo>
                  <a:pt x="856" y="5"/>
                </a:lnTo>
                <a:lnTo>
                  <a:pt x="857" y="5"/>
                </a:lnTo>
                <a:lnTo>
                  <a:pt x="858" y="4"/>
                </a:lnTo>
                <a:lnTo>
                  <a:pt x="859" y="4"/>
                </a:lnTo>
                <a:lnTo>
                  <a:pt x="860" y="4"/>
                </a:lnTo>
                <a:lnTo>
                  <a:pt x="861" y="4"/>
                </a:lnTo>
                <a:lnTo>
                  <a:pt x="862" y="4"/>
                </a:lnTo>
                <a:lnTo>
                  <a:pt x="863" y="4"/>
                </a:lnTo>
                <a:lnTo>
                  <a:pt x="863" y="5"/>
                </a:lnTo>
                <a:lnTo>
                  <a:pt x="864" y="5"/>
                </a:lnTo>
                <a:lnTo>
                  <a:pt x="865" y="4"/>
                </a:lnTo>
                <a:lnTo>
                  <a:pt x="866" y="5"/>
                </a:lnTo>
                <a:lnTo>
                  <a:pt x="867" y="6"/>
                </a:lnTo>
                <a:lnTo>
                  <a:pt x="868" y="7"/>
                </a:lnTo>
                <a:lnTo>
                  <a:pt x="869" y="8"/>
                </a:lnTo>
                <a:lnTo>
                  <a:pt x="870" y="11"/>
                </a:lnTo>
                <a:lnTo>
                  <a:pt x="871" y="11"/>
                </a:lnTo>
                <a:lnTo>
                  <a:pt x="871" y="13"/>
                </a:lnTo>
                <a:lnTo>
                  <a:pt x="872" y="14"/>
                </a:lnTo>
                <a:lnTo>
                  <a:pt x="873" y="15"/>
                </a:lnTo>
                <a:lnTo>
                  <a:pt x="874" y="16"/>
                </a:lnTo>
                <a:lnTo>
                  <a:pt x="875" y="17"/>
                </a:lnTo>
                <a:lnTo>
                  <a:pt x="876" y="15"/>
                </a:lnTo>
                <a:lnTo>
                  <a:pt x="877" y="13"/>
                </a:lnTo>
                <a:lnTo>
                  <a:pt x="878" y="12"/>
                </a:lnTo>
                <a:lnTo>
                  <a:pt x="878" y="10"/>
                </a:lnTo>
                <a:lnTo>
                  <a:pt x="879" y="10"/>
                </a:lnTo>
                <a:lnTo>
                  <a:pt x="880" y="8"/>
                </a:lnTo>
                <a:lnTo>
                  <a:pt x="881" y="7"/>
                </a:lnTo>
                <a:lnTo>
                  <a:pt x="882" y="6"/>
                </a:lnTo>
                <a:lnTo>
                  <a:pt x="883" y="6"/>
                </a:lnTo>
                <a:lnTo>
                  <a:pt x="884" y="6"/>
                </a:lnTo>
                <a:lnTo>
                  <a:pt x="885" y="5"/>
                </a:lnTo>
                <a:lnTo>
                  <a:pt x="886" y="6"/>
                </a:lnTo>
                <a:lnTo>
                  <a:pt x="886" y="5"/>
                </a:lnTo>
                <a:lnTo>
                  <a:pt x="887" y="5"/>
                </a:lnTo>
                <a:lnTo>
                  <a:pt x="888" y="5"/>
                </a:lnTo>
                <a:lnTo>
                  <a:pt x="889" y="5"/>
                </a:lnTo>
                <a:lnTo>
                  <a:pt x="890" y="5"/>
                </a:lnTo>
                <a:lnTo>
                  <a:pt x="891" y="4"/>
                </a:lnTo>
                <a:lnTo>
                  <a:pt x="892" y="6"/>
                </a:lnTo>
                <a:lnTo>
                  <a:pt x="893" y="4"/>
                </a:lnTo>
                <a:lnTo>
                  <a:pt x="893" y="5"/>
                </a:lnTo>
                <a:lnTo>
                  <a:pt x="894" y="4"/>
                </a:lnTo>
                <a:lnTo>
                  <a:pt x="895" y="5"/>
                </a:lnTo>
                <a:lnTo>
                  <a:pt x="896" y="4"/>
                </a:lnTo>
                <a:lnTo>
                  <a:pt x="897" y="4"/>
                </a:lnTo>
                <a:lnTo>
                  <a:pt x="898" y="3"/>
                </a:lnTo>
                <a:lnTo>
                  <a:pt x="899" y="4"/>
                </a:lnTo>
                <a:lnTo>
                  <a:pt x="900" y="4"/>
                </a:lnTo>
                <a:lnTo>
                  <a:pt x="901" y="5"/>
                </a:lnTo>
                <a:lnTo>
                  <a:pt x="901" y="4"/>
                </a:lnTo>
                <a:lnTo>
                  <a:pt x="902" y="5"/>
                </a:lnTo>
                <a:lnTo>
                  <a:pt x="903" y="5"/>
                </a:lnTo>
                <a:lnTo>
                  <a:pt x="904" y="6"/>
                </a:lnTo>
                <a:lnTo>
                  <a:pt x="905" y="6"/>
                </a:lnTo>
                <a:lnTo>
                  <a:pt x="906" y="7"/>
                </a:lnTo>
                <a:lnTo>
                  <a:pt x="907" y="7"/>
                </a:lnTo>
                <a:lnTo>
                  <a:pt x="908" y="7"/>
                </a:lnTo>
                <a:lnTo>
                  <a:pt x="908" y="7"/>
                </a:lnTo>
                <a:lnTo>
                  <a:pt x="909" y="6"/>
                </a:lnTo>
                <a:lnTo>
                  <a:pt x="910" y="6"/>
                </a:lnTo>
                <a:lnTo>
                  <a:pt x="911" y="7"/>
                </a:lnTo>
                <a:lnTo>
                  <a:pt x="912" y="5"/>
                </a:lnTo>
                <a:lnTo>
                  <a:pt x="913" y="5"/>
                </a:lnTo>
                <a:lnTo>
                  <a:pt x="914" y="4"/>
                </a:lnTo>
                <a:lnTo>
                  <a:pt x="915" y="3"/>
                </a:lnTo>
                <a:lnTo>
                  <a:pt x="916" y="4"/>
                </a:lnTo>
                <a:lnTo>
                  <a:pt x="916" y="3"/>
                </a:lnTo>
                <a:lnTo>
                  <a:pt x="917" y="3"/>
                </a:lnTo>
                <a:lnTo>
                  <a:pt x="918" y="3"/>
                </a:lnTo>
                <a:lnTo>
                  <a:pt x="919" y="2"/>
                </a:lnTo>
                <a:lnTo>
                  <a:pt x="920" y="3"/>
                </a:lnTo>
                <a:lnTo>
                  <a:pt x="921" y="2"/>
                </a:lnTo>
                <a:lnTo>
                  <a:pt x="922" y="2"/>
                </a:lnTo>
                <a:lnTo>
                  <a:pt x="923" y="3"/>
                </a:lnTo>
                <a:lnTo>
                  <a:pt x="923" y="2"/>
                </a:lnTo>
                <a:lnTo>
                  <a:pt x="924" y="2"/>
                </a:lnTo>
                <a:lnTo>
                  <a:pt x="925" y="1"/>
                </a:lnTo>
                <a:lnTo>
                  <a:pt x="926" y="2"/>
                </a:lnTo>
                <a:lnTo>
                  <a:pt x="927" y="2"/>
                </a:lnTo>
                <a:lnTo>
                  <a:pt x="928" y="3"/>
                </a:lnTo>
                <a:lnTo>
                  <a:pt x="929" y="3"/>
                </a:lnTo>
                <a:lnTo>
                  <a:pt x="930" y="3"/>
                </a:lnTo>
                <a:lnTo>
                  <a:pt x="931" y="2"/>
                </a:lnTo>
                <a:lnTo>
                  <a:pt x="931" y="2"/>
                </a:lnTo>
                <a:lnTo>
                  <a:pt x="932" y="3"/>
                </a:lnTo>
                <a:lnTo>
                  <a:pt x="933" y="2"/>
                </a:lnTo>
                <a:lnTo>
                  <a:pt x="934" y="2"/>
                </a:lnTo>
                <a:lnTo>
                  <a:pt x="935" y="3"/>
                </a:lnTo>
                <a:lnTo>
                  <a:pt x="936" y="3"/>
                </a:lnTo>
                <a:lnTo>
                  <a:pt x="937" y="3"/>
                </a:lnTo>
                <a:lnTo>
                  <a:pt x="938" y="3"/>
                </a:lnTo>
                <a:lnTo>
                  <a:pt x="938" y="3"/>
                </a:lnTo>
                <a:lnTo>
                  <a:pt x="939" y="3"/>
                </a:lnTo>
                <a:lnTo>
                  <a:pt x="940" y="3"/>
                </a:lnTo>
                <a:lnTo>
                  <a:pt x="941" y="3"/>
                </a:lnTo>
                <a:lnTo>
                  <a:pt x="942" y="3"/>
                </a:lnTo>
                <a:lnTo>
                  <a:pt x="943" y="3"/>
                </a:lnTo>
                <a:lnTo>
                  <a:pt x="944" y="3"/>
                </a:lnTo>
                <a:lnTo>
                  <a:pt x="945" y="4"/>
                </a:lnTo>
                <a:lnTo>
                  <a:pt x="946" y="4"/>
                </a:lnTo>
                <a:lnTo>
                  <a:pt x="946" y="5"/>
                </a:lnTo>
                <a:lnTo>
                  <a:pt x="947" y="5"/>
                </a:lnTo>
                <a:lnTo>
                  <a:pt x="948" y="5"/>
                </a:lnTo>
                <a:lnTo>
                  <a:pt x="949" y="5"/>
                </a:lnTo>
                <a:lnTo>
                  <a:pt x="950" y="5"/>
                </a:lnTo>
                <a:lnTo>
                  <a:pt x="951" y="6"/>
                </a:lnTo>
                <a:lnTo>
                  <a:pt x="952" y="5"/>
                </a:lnTo>
                <a:lnTo>
                  <a:pt x="953" y="5"/>
                </a:lnTo>
                <a:lnTo>
                  <a:pt x="953" y="5"/>
                </a:lnTo>
                <a:lnTo>
                  <a:pt x="954" y="5"/>
                </a:lnTo>
                <a:lnTo>
                  <a:pt x="955" y="4"/>
                </a:lnTo>
                <a:lnTo>
                  <a:pt x="956" y="4"/>
                </a:lnTo>
                <a:lnTo>
                  <a:pt x="957" y="3"/>
                </a:lnTo>
                <a:lnTo>
                  <a:pt x="958" y="5"/>
                </a:lnTo>
                <a:lnTo>
                  <a:pt x="959" y="4"/>
                </a:lnTo>
                <a:lnTo>
                  <a:pt x="960" y="4"/>
                </a:lnTo>
                <a:lnTo>
                  <a:pt x="961" y="4"/>
                </a:lnTo>
                <a:lnTo>
                  <a:pt x="961" y="4"/>
                </a:lnTo>
                <a:lnTo>
                  <a:pt x="962" y="3"/>
                </a:lnTo>
                <a:lnTo>
                  <a:pt x="963" y="3"/>
                </a:lnTo>
                <a:lnTo>
                  <a:pt x="964" y="4"/>
                </a:lnTo>
                <a:lnTo>
                  <a:pt x="965" y="3"/>
                </a:lnTo>
                <a:lnTo>
                  <a:pt x="966" y="2"/>
                </a:lnTo>
                <a:lnTo>
                  <a:pt x="967" y="3"/>
                </a:lnTo>
                <a:lnTo>
                  <a:pt x="968" y="3"/>
                </a:lnTo>
                <a:lnTo>
                  <a:pt x="968" y="4"/>
                </a:lnTo>
                <a:lnTo>
                  <a:pt x="969" y="2"/>
                </a:lnTo>
                <a:lnTo>
                  <a:pt x="970" y="3"/>
                </a:lnTo>
                <a:lnTo>
                  <a:pt x="971" y="3"/>
                </a:lnTo>
                <a:lnTo>
                  <a:pt x="972" y="3"/>
                </a:lnTo>
                <a:lnTo>
                  <a:pt x="973" y="2"/>
                </a:lnTo>
                <a:lnTo>
                  <a:pt x="974" y="2"/>
                </a:lnTo>
                <a:lnTo>
                  <a:pt x="975" y="2"/>
                </a:lnTo>
                <a:lnTo>
                  <a:pt x="976" y="2"/>
                </a:lnTo>
                <a:lnTo>
                  <a:pt x="976" y="3"/>
                </a:lnTo>
                <a:lnTo>
                  <a:pt x="977" y="2"/>
                </a:lnTo>
                <a:lnTo>
                  <a:pt x="978" y="2"/>
                </a:lnTo>
                <a:lnTo>
                  <a:pt x="979" y="2"/>
                </a:lnTo>
                <a:lnTo>
                  <a:pt x="980" y="2"/>
                </a:lnTo>
                <a:lnTo>
                  <a:pt x="981" y="2"/>
                </a:lnTo>
                <a:lnTo>
                  <a:pt x="982" y="1"/>
                </a:lnTo>
                <a:lnTo>
                  <a:pt x="983" y="2"/>
                </a:lnTo>
                <a:lnTo>
                  <a:pt x="983" y="1"/>
                </a:lnTo>
                <a:lnTo>
                  <a:pt x="984" y="1"/>
                </a:lnTo>
                <a:lnTo>
                  <a:pt x="985" y="1"/>
                </a:lnTo>
                <a:lnTo>
                  <a:pt x="986" y="1"/>
                </a:lnTo>
                <a:lnTo>
                  <a:pt x="987" y="2"/>
                </a:lnTo>
                <a:lnTo>
                  <a:pt x="988" y="2"/>
                </a:lnTo>
                <a:lnTo>
                  <a:pt x="989" y="2"/>
                </a:lnTo>
                <a:lnTo>
                  <a:pt x="990" y="1"/>
                </a:lnTo>
                <a:lnTo>
                  <a:pt x="991" y="1"/>
                </a:lnTo>
                <a:lnTo>
                  <a:pt x="991" y="2"/>
                </a:lnTo>
                <a:lnTo>
                  <a:pt x="992" y="2"/>
                </a:lnTo>
                <a:lnTo>
                  <a:pt x="993" y="1"/>
                </a:lnTo>
                <a:lnTo>
                  <a:pt x="994" y="1"/>
                </a:lnTo>
                <a:lnTo>
                  <a:pt x="995" y="2"/>
                </a:lnTo>
                <a:lnTo>
                  <a:pt x="996" y="2"/>
                </a:lnTo>
                <a:lnTo>
                  <a:pt x="997" y="2"/>
                </a:lnTo>
                <a:lnTo>
                  <a:pt x="998" y="2"/>
                </a:lnTo>
                <a:lnTo>
                  <a:pt x="998" y="2"/>
                </a:lnTo>
                <a:lnTo>
                  <a:pt x="999" y="2"/>
                </a:lnTo>
                <a:lnTo>
                  <a:pt x="1000" y="3"/>
                </a:lnTo>
                <a:lnTo>
                  <a:pt x="1001" y="3"/>
                </a:lnTo>
                <a:lnTo>
                  <a:pt x="1002" y="4"/>
                </a:lnTo>
                <a:lnTo>
                  <a:pt x="1003" y="5"/>
                </a:lnTo>
                <a:lnTo>
                  <a:pt x="1004" y="4"/>
                </a:lnTo>
                <a:lnTo>
                  <a:pt x="1005" y="4"/>
                </a:lnTo>
                <a:lnTo>
                  <a:pt x="1006" y="6"/>
                </a:lnTo>
                <a:lnTo>
                  <a:pt x="1006" y="5"/>
                </a:lnTo>
                <a:lnTo>
                  <a:pt x="1007" y="4"/>
                </a:lnTo>
                <a:lnTo>
                  <a:pt x="1008" y="4"/>
                </a:lnTo>
                <a:lnTo>
                  <a:pt x="1009" y="3"/>
                </a:lnTo>
                <a:lnTo>
                  <a:pt x="1010" y="3"/>
                </a:lnTo>
                <a:lnTo>
                  <a:pt x="1011" y="3"/>
                </a:lnTo>
                <a:lnTo>
                  <a:pt x="1012" y="2"/>
                </a:lnTo>
                <a:lnTo>
                  <a:pt x="1013" y="2"/>
                </a:lnTo>
                <a:lnTo>
                  <a:pt x="1013" y="1"/>
                </a:lnTo>
                <a:lnTo>
                  <a:pt x="1014" y="1"/>
                </a:lnTo>
                <a:lnTo>
                  <a:pt x="1015" y="2"/>
                </a:lnTo>
                <a:lnTo>
                  <a:pt x="1016" y="1"/>
                </a:lnTo>
                <a:lnTo>
                  <a:pt x="1017" y="1"/>
                </a:lnTo>
                <a:lnTo>
                  <a:pt x="1018" y="1"/>
                </a:lnTo>
                <a:lnTo>
                  <a:pt x="1019" y="2"/>
                </a:lnTo>
                <a:lnTo>
                  <a:pt x="1020" y="1"/>
                </a:lnTo>
                <a:lnTo>
                  <a:pt x="1021" y="2"/>
                </a:lnTo>
                <a:lnTo>
                  <a:pt x="1021" y="2"/>
                </a:lnTo>
                <a:lnTo>
                  <a:pt x="1022" y="2"/>
                </a:lnTo>
                <a:lnTo>
                  <a:pt x="1023" y="3"/>
                </a:lnTo>
                <a:lnTo>
                  <a:pt x="1024" y="2"/>
                </a:lnTo>
                <a:lnTo>
                  <a:pt x="1025" y="2"/>
                </a:lnTo>
                <a:lnTo>
                  <a:pt x="1026" y="3"/>
                </a:lnTo>
                <a:lnTo>
                  <a:pt x="1027" y="2"/>
                </a:lnTo>
                <a:lnTo>
                  <a:pt x="1028" y="2"/>
                </a:lnTo>
                <a:lnTo>
                  <a:pt x="1028" y="3"/>
                </a:lnTo>
                <a:lnTo>
                  <a:pt x="1029" y="2"/>
                </a:lnTo>
                <a:lnTo>
                  <a:pt x="1030" y="2"/>
                </a:lnTo>
                <a:lnTo>
                  <a:pt x="1031" y="3"/>
                </a:lnTo>
                <a:lnTo>
                  <a:pt x="1032" y="4"/>
                </a:lnTo>
                <a:lnTo>
                  <a:pt x="1033" y="3"/>
                </a:lnTo>
                <a:lnTo>
                  <a:pt x="1034" y="4"/>
                </a:lnTo>
                <a:lnTo>
                  <a:pt x="1035" y="5"/>
                </a:lnTo>
                <a:lnTo>
                  <a:pt x="1036" y="5"/>
                </a:lnTo>
                <a:lnTo>
                  <a:pt x="1036" y="5"/>
                </a:lnTo>
                <a:lnTo>
                  <a:pt x="1037" y="5"/>
                </a:lnTo>
                <a:lnTo>
                  <a:pt x="1038" y="5"/>
                </a:lnTo>
                <a:lnTo>
                  <a:pt x="1039" y="4"/>
                </a:lnTo>
                <a:lnTo>
                  <a:pt x="1040" y="3"/>
                </a:lnTo>
                <a:lnTo>
                  <a:pt x="1041" y="3"/>
                </a:lnTo>
                <a:lnTo>
                  <a:pt x="1042" y="3"/>
                </a:lnTo>
                <a:lnTo>
                  <a:pt x="1043" y="2"/>
                </a:lnTo>
                <a:lnTo>
                  <a:pt x="1043" y="2"/>
                </a:lnTo>
                <a:lnTo>
                  <a:pt x="1044" y="2"/>
                </a:lnTo>
                <a:lnTo>
                  <a:pt x="1045" y="1"/>
                </a:lnTo>
                <a:lnTo>
                  <a:pt x="1046" y="2"/>
                </a:lnTo>
                <a:lnTo>
                  <a:pt x="1047" y="3"/>
                </a:lnTo>
                <a:lnTo>
                  <a:pt x="1048" y="2"/>
                </a:lnTo>
                <a:lnTo>
                  <a:pt x="1049" y="2"/>
                </a:lnTo>
                <a:lnTo>
                  <a:pt x="1050" y="2"/>
                </a:lnTo>
                <a:lnTo>
                  <a:pt x="1050" y="2"/>
                </a:lnTo>
                <a:lnTo>
                  <a:pt x="1051" y="2"/>
                </a:lnTo>
                <a:lnTo>
                  <a:pt x="1052" y="2"/>
                </a:lnTo>
                <a:lnTo>
                  <a:pt x="1053" y="3"/>
                </a:lnTo>
                <a:lnTo>
                  <a:pt x="1054" y="2"/>
                </a:lnTo>
                <a:lnTo>
                  <a:pt x="1055" y="2"/>
                </a:lnTo>
                <a:lnTo>
                  <a:pt x="1056" y="1"/>
                </a:lnTo>
                <a:lnTo>
                  <a:pt x="1057" y="2"/>
                </a:lnTo>
                <a:lnTo>
                  <a:pt x="1058" y="1"/>
                </a:lnTo>
                <a:lnTo>
                  <a:pt x="1058" y="2"/>
                </a:lnTo>
                <a:lnTo>
                  <a:pt x="1059" y="1"/>
                </a:lnTo>
                <a:lnTo>
                  <a:pt x="1060" y="1"/>
                </a:lnTo>
                <a:lnTo>
                  <a:pt x="1061" y="1"/>
                </a:lnTo>
                <a:lnTo>
                  <a:pt x="1062" y="1"/>
                </a:lnTo>
                <a:lnTo>
                  <a:pt x="1063" y="1"/>
                </a:lnTo>
                <a:lnTo>
                  <a:pt x="1064" y="1"/>
                </a:lnTo>
                <a:lnTo>
                  <a:pt x="1065" y="1"/>
                </a:lnTo>
                <a:lnTo>
                  <a:pt x="1065" y="2"/>
                </a:lnTo>
                <a:lnTo>
                  <a:pt x="1066" y="1"/>
                </a:lnTo>
                <a:lnTo>
                  <a:pt x="1067" y="1"/>
                </a:lnTo>
                <a:lnTo>
                  <a:pt x="1068" y="2"/>
                </a:lnTo>
                <a:lnTo>
                  <a:pt x="1069" y="2"/>
                </a:lnTo>
                <a:lnTo>
                  <a:pt x="1070" y="3"/>
                </a:lnTo>
                <a:lnTo>
                  <a:pt x="1071" y="2"/>
                </a:lnTo>
                <a:lnTo>
                  <a:pt x="1072" y="2"/>
                </a:lnTo>
                <a:lnTo>
                  <a:pt x="1073" y="3"/>
                </a:lnTo>
                <a:lnTo>
                  <a:pt x="1073" y="2"/>
                </a:lnTo>
                <a:lnTo>
                  <a:pt x="1074" y="2"/>
                </a:lnTo>
                <a:lnTo>
                  <a:pt x="1075" y="3"/>
                </a:lnTo>
                <a:lnTo>
                  <a:pt x="1076" y="3"/>
                </a:lnTo>
                <a:lnTo>
                  <a:pt x="1077" y="4"/>
                </a:lnTo>
                <a:lnTo>
                  <a:pt x="1078" y="5"/>
                </a:lnTo>
                <a:lnTo>
                  <a:pt x="1079" y="6"/>
                </a:lnTo>
                <a:lnTo>
                  <a:pt x="1080" y="10"/>
                </a:lnTo>
                <a:lnTo>
                  <a:pt x="1080" y="15"/>
                </a:lnTo>
                <a:lnTo>
                  <a:pt x="1081" y="21"/>
                </a:lnTo>
                <a:lnTo>
                  <a:pt x="1082" y="28"/>
                </a:lnTo>
                <a:lnTo>
                  <a:pt x="1083" y="33"/>
                </a:lnTo>
                <a:lnTo>
                  <a:pt x="1084" y="41"/>
                </a:lnTo>
                <a:lnTo>
                  <a:pt x="1085" y="45"/>
                </a:lnTo>
                <a:lnTo>
                  <a:pt x="1086" y="50"/>
                </a:lnTo>
                <a:lnTo>
                  <a:pt x="1087" y="51"/>
                </a:lnTo>
                <a:lnTo>
                  <a:pt x="1088" y="53"/>
                </a:lnTo>
                <a:lnTo>
                  <a:pt x="1088" y="52"/>
                </a:lnTo>
                <a:lnTo>
                  <a:pt x="1089" y="52"/>
                </a:lnTo>
                <a:lnTo>
                  <a:pt x="1090" y="50"/>
                </a:lnTo>
                <a:lnTo>
                  <a:pt x="1091" y="47"/>
                </a:lnTo>
                <a:lnTo>
                  <a:pt x="1092" y="50"/>
                </a:lnTo>
                <a:lnTo>
                  <a:pt x="1093" y="48"/>
                </a:lnTo>
                <a:lnTo>
                  <a:pt x="1094" y="48"/>
                </a:lnTo>
                <a:lnTo>
                  <a:pt x="1095" y="46"/>
                </a:lnTo>
                <a:lnTo>
                  <a:pt x="1095" y="48"/>
                </a:lnTo>
                <a:lnTo>
                  <a:pt x="1096" y="47"/>
                </a:lnTo>
                <a:lnTo>
                  <a:pt x="1097" y="47"/>
                </a:lnTo>
                <a:lnTo>
                  <a:pt x="1098" y="49"/>
                </a:lnTo>
                <a:lnTo>
                  <a:pt x="1099" y="51"/>
                </a:lnTo>
                <a:lnTo>
                  <a:pt x="1100" y="54"/>
                </a:lnTo>
                <a:lnTo>
                  <a:pt x="1101" y="54"/>
                </a:lnTo>
                <a:lnTo>
                  <a:pt x="1102" y="55"/>
                </a:lnTo>
                <a:lnTo>
                  <a:pt x="1103" y="56"/>
                </a:lnTo>
                <a:lnTo>
                  <a:pt x="1103" y="55"/>
                </a:lnTo>
                <a:lnTo>
                  <a:pt x="1104" y="56"/>
                </a:lnTo>
                <a:lnTo>
                  <a:pt x="1105" y="53"/>
                </a:lnTo>
                <a:lnTo>
                  <a:pt x="1106" y="51"/>
                </a:lnTo>
                <a:lnTo>
                  <a:pt x="1107" y="49"/>
                </a:lnTo>
                <a:lnTo>
                  <a:pt x="1108" y="48"/>
                </a:lnTo>
                <a:lnTo>
                  <a:pt x="1109" y="46"/>
                </a:lnTo>
                <a:lnTo>
                  <a:pt x="1110" y="44"/>
                </a:lnTo>
                <a:lnTo>
                  <a:pt x="1110" y="43"/>
                </a:lnTo>
                <a:lnTo>
                  <a:pt x="1111" y="39"/>
                </a:lnTo>
                <a:lnTo>
                  <a:pt x="1112" y="37"/>
                </a:lnTo>
                <a:lnTo>
                  <a:pt x="1113" y="36"/>
                </a:lnTo>
                <a:lnTo>
                  <a:pt x="1114" y="34"/>
                </a:lnTo>
                <a:lnTo>
                  <a:pt x="1115" y="32"/>
                </a:lnTo>
                <a:lnTo>
                  <a:pt x="1116" y="30"/>
                </a:lnTo>
                <a:lnTo>
                  <a:pt x="1117" y="29"/>
                </a:lnTo>
                <a:lnTo>
                  <a:pt x="1118" y="28"/>
                </a:lnTo>
                <a:lnTo>
                  <a:pt x="1118" y="27"/>
                </a:lnTo>
                <a:lnTo>
                  <a:pt x="1119" y="25"/>
                </a:lnTo>
                <a:lnTo>
                  <a:pt x="1120" y="24"/>
                </a:lnTo>
                <a:lnTo>
                  <a:pt x="1121" y="23"/>
                </a:lnTo>
                <a:lnTo>
                  <a:pt x="1122" y="23"/>
                </a:lnTo>
                <a:lnTo>
                  <a:pt x="1123" y="21"/>
                </a:lnTo>
                <a:lnTo>
                  <a:pt x="1124" y="21"/>
                </a:lnTo>
                <a:lnTo>
                  <a:pt x="1125" y="20"/>
                </a:lnTo>
                <a:lnTo>
                  <a:pt x="1125" y="18"/>
                </a:lnTo>
                <a:lnTo>
                  <a:pt x="1126" y="18"/>
                </a:lnTo>
                <a:lnTo>
                  <a:pt x="1127" y="17"/>
                </a:lnTo>
                <a:lnTo>
                  <a:pt x="1128" y="15"/>
                </a:lnTo>
                <a:lnTo>
                  <a:pt x="1129" y="15"/>
                </a:lnTo>
                <a:lnTo>
                  <a:pt x="1130" y="14"/>
                </a:lnTo>
                <a:lnTo>
                  <a:pt x="1131" y="13"/>
                </a:lnTo>
                <a:lnTo>
                  <a:pt x="1132" y="14"/>
                </a:lnTo>
                <a:lnTo>
                  <a:pt x="1133" y="14"/>
                </a:lnTo>
                <a:lnTo>
                  <a:pt x="1133" y="15"/>
                </a:lnTo>
                <a:lnTo>
                  <a:pt x="1134" y="17"/>
                </a:lnTo>
                <a:lnTo>
                  <a:pt x="1135" y="17"/>
                </a:lnTo>
                <a:lnTo>
                  <a:pt x="1136" y="19"/>
                </a:lnTo>
                <a:lnTo>
                  <a:pt x="1137" y="20"/>
                </a:lnTo>
                <a:lnTo>
                  <a:pt x="1138" y="20"/>
                </a:lnTo>
                <a:lnTo>
                  <a:pt x="1139" y="20"/>
                </a:lnTo>
                <a:lnTo>
                  <a:pt x="1140" y="22"/>
                </a:lnTo>
                <a:lnTo>
                  <a:pt x="1140" y="23"/>
                </a:lnTo>
                <a:lnTo>
                  <a:pt x="1141" y="22"/>
                </a:lnTo>
                <a:lnTo>
                  <a:pt x="1142" y="22"/>
                </a:lnTo>
                <a:lnTo>
                  <a:pt x="1143" y="21"/>
                </a:lnTo>
                <a:lnTo>
                  <a:pt x="1144" y="20"/>
                </a:lnTo>
                <a:lnTo>
                  <a:pt x="1145" y="19"/>
                </a:lnTo>
                <a:lnTo>
                  <a:pt x="1146" y="17"/>
                </a:lnTo>
                <a:lnTo>
                  <a:pt x="1147" y="16"/>
                </a:lnTo>
                <a:lnTo>
                  <a:pt x="1148" y="14"/>
                </a:lnTo>
                <a:lnTo>
                  <a:pt x="1148" y="12"/>
                </a:lnTo>
                <a:lnTo>
                  <a:pt x="1149" y="12"/>
                </a:lnTo>
                <a:lnTo>
                  <a:pt x="1150" y="11"/>
                </a:lnTo>
                <a:lnTo>
                  <a:pt x="1151" y="9"/>
                </a:lnTo>
                <a:lnTo>
                  <a:pt x="1152" y="8"/>
                </a:lnTo>
                <a:lnTo>
                  <a:pt x="1153" y="8"/>
                </a:lnTo>
                <a:lnTo>
                  <a:pt x="1154" y="7"/>
                </a:lnTo>
                <a:lnTo>
                  <a:pt x="1155" y="7"/>
                </a:lnTo>
                <a:lnTo>
                  <a:pt x="1155" y="6"/>
                </a:lnTo>
                <a:lnTo>
                  <a:pt x="1156" y="5"/>
                </a:lnTo>
                <a:lnTo>
                  <a:pt x="1157" y="5"/>
                </a:lnTo>
                <a:lnTo>
                  <a:pt x="1158" y="5"/>
                </a:lnTo>
                <a:lnTo>
                  <a:pt x="1159" y="6"/>
                </a:lnTo>
                <a:lnTo>
                  <a:pt x="1160" y="6"/>
                </a:lnTo>
                <a:lnTo>
                  <a:pt x="1161" y="6"/>
                </a:lnTo>
                <a:lnTo>
                  <a:pt x="1162" y="5"/>
                </a:lnTo>
                <a:lnTo>
                  <a:pt x="1163" y="5"/>
                </a:lnTo>
                <a:lnTo>
                  <a:pt x="1163" y="6"/>
                </a:lnTo>
                <a:lnTo>
                  <a:pt x="1164" y="6"/>
                </a:lnTo>
                <a:lnTo>
                  <a:pt x="1165" y="6"/>
                </a:lnTo>
                <a:lnTo>
                  <a:pt x="1166" y="7"/>
                </a:lnTo>
                <a:lnTo>
                  <a:pt x="1167" y="7"/>
                </a:lnTo>
                <a:lnTo>
                  <a:pt x="1168" y="7"/>
                </a:lnTo>
                <a:lnTo>
                  <a:pt x="1169" y="8"/>
                </a:lnTo>
                <a:lnTo>
                  <a:pt x="1170" y="7"/>
                </a:lnTo>
                <a:lnTo>
                  <a:pt x="1170" y="7"/>
                </a:lnTo>
                <a:lnTo>
                  <a:pt x="1171" y="6"/>
                </a:lnTo>
                <a:lnTo>
                  <a:pt x="1172" y="5"/>
                </a:lnTo>
                <a:lnTo>
                  <a:pt x="1173" y="5"/>
                </a:lnTo>
                <a:lnTo>
                  <a:pt x="1174" y="5"/>
                </a:lnTo>
                <a:lnTo>
                  <a:pt x="1175" y="4"/>
                </a:lnTo>
                <a:lnTo>
                  <a:pt x="1176" y="4"/>
                </a:lnTo>
                <a:lnTo>
                  <a:pt x="1177" y="3"/>
                </a:lnTo>
                <a:lnTo>
                  <a:pt x="1178" y="3"/>
                </a:lnTo>
                <a:lnTo>
                  <a:pt x="1178" y="3"/>
                </a:lnTo>
                <a:lnTo>
                  <a:pt x="1179" y="3"/>
                </a:lnTo>
                <a:lnTo>
                  <a:pt x="1180" y="2"/>
                </a:lnTo>
                <a:lnTo>
                  <a:pt x="1181" y="4"/>
                </a:lnTo>
                <a:lnTo>
                  <a:pt x="1182" y="6"/>
                </a:lnTo>
                <a:lnTo>
                  <a:pt x="1183" y="9"/>
                </a:lnTo>
                <a:lnTo>
                  <a:pt x="1184" y="15"/>
                </a:lnTo>
                <a:lnTo>
                  <a:pt x="1185" y="22"/>
                </a:lnTo>
                <a:lnTo>
                  <a:pt x="1185" y="30"/>
                </a:lnTo>
                <a:lnTo>
                  <a:pt x="1186" y="38"/>
                </a:lnTo>
                <a:lnTo>
                  <a:pt x="1187" y="44"/>
                </a:lnTo>
                <a:lnTo>
                  <a:pt x="1188" y="49"/>
                </a:lnTo>
                <a:lnTo>
                  <a:pt x="1189" y="52"/>
                </a:lnTo>
                <a:lnTo>
                  <a:pt x="1190" y="52"/>
                </a:lnTo>
                <a:lnTo>
                  <a:pt x="1191" y="48"/>
                </a:lnTo>
                <a:lnTo>
                  <a:pt x="1192" y="46"/>
                </a:lnTo>
                <a:lnTo>
                  <a:pt x="1193" y="42"/>
                </a:lnTo>
                <a:lnTo>
                  <a:pt x="1193" y="39"/>
                </a:lnTo>
                <a:lnTo>
                  <a:pt x="1194" y="35"/>
                </a:lnTo>
                <a:lnTo>
                  <a:pt x="1195" y="31"/>
                </a:lnTo>
                <a:lnTo>
                  <a:pt x="1196" y="28"/>
                </a:lnTo>
                <a:lnTo>
                  <a:pt x="1197" y="26"/>
                </a:lnTo>
                <a:lnTo>
                  <a:pt x="1198" y="25"/>
                </a:lnTo>
                <a:lnTo>
                  <a:pt x="1199" y="22"/>
                </a:lnTo>
                <a:lnTo>
                  <a:pt x="1200" y="22"/>
                </a:lnTo>
                <a:lnTo>
                  <a:pt x="1200" y="18"/>
                </a:lnTo>
                <a:lnTo>
                  <a:pt x="1201" y="17"/>
                </a:lnTo>
                <a:lnTo>
                  <a:pt x="1202" y="17"/>
                </a:lnTo>
                <a:lnTo>
                  <a:pt x="1203" y="16"/>
                </a:lnTo>
                <a:lnTo>
                  <a:pt x="1204" y="16"/>
                </a:lnTo>
                <a:lnTo>
                  <a:pt x="1205" y="16"/>
                </a:lnTo>
                <a:lnTo>
                  <a:pt x="1206" y="17"/>
                </a:lnTo>
                <a:lnTo>
                  <a:pt x="1207" y="14"/>
                </a:lnTo>
                <a:lnTo>
                  <a:pt x="1208" y="14"/>
                </a:lnTo>
                <a:lnTo>
                  <a:pt x="1208" y="14"/>
                </a:lnTo>
                <a:lnTo>
                  <a:pt x="1209" y="14"/>
                </a:lnTo>
                <a:lnTo>
                  <a:pt x="1210" y="13"/>
                </a:lnTo>
                <a:lnTo>
                  <a:pt x="1211" y="13"/>
                </a:lnTo>
                <a:lnTo>
                  <a:pt x="1212" y="11"/>
                </a:lnTo>
                <a:lnTo>
                  <a:pt x="1213" y="11"/>
                </a:lnTo>
                <a:lnTo>
                  <a:pt x="1214" y="11"/>
                </a:lnTo>
                <a:lnTo>
                  <a:pt x="1215" y="11"/>
                </a:lnTo>
                <a:lnTo>
                  <a:pt x="1215" y="10"/>
                </a:lnTo>
                <a:lnTo>
                  <a:pt x="1216" y="11"/>
                </a:lnTo>
                <a:lnTo>
                  <a:pt x="1217" y="10"/>
                </a:lnTo>
                <a:lnTo>
                  <a:pt x="1218" y="10"/>
                </a:lnTo>
                <a:lnTo>
                  <a:pt x="1219" y="10"/>
                </a:lnTo>
                <a:lnTo>
                  <a:pt x="1220" y="10"/>
                </a:lnTo>
                <a:lnTo>
                  <a:pt x="1221" y="9"/>
                </a:lnTo>
                <a:lnTo>
                  <a:pt x="1222" y="8"/>
                </a:lnTo>
                <a:lnTo>
                  <a:pt x="1223" y="8"/>
                </a:lnTo>
                <a:lnTo>
                  <a:pt x="1223" y="8"/>
                </a:lnTo>
                <a:lnTo>
                  <a:pt x="1224" y="8"/>
                </a:lnTo>
                <a:lnTo>
                  <a:pt x="1225" y="8"/>
                </a:lnTo>
                <a:lnTo>
                  <a:pt x="1226" y="8"/>
                </a:lnTo>
                <a:lnTo>
                  <a:pt x="1227" y="7"/>
                </a:lnTo>
                <a:lnTo>
                  <a:pt x="1228" y="7"/>
                </a:lnTo>
                <a:lnTo>
                  <a:pt x="1229" y="6"/>
                </a:lnTo>
                <a:lnTo>
                  <a:pt x="1230" y="7"/>
                </a:lnTo>
                <a:lnTo>
                  <a:pt x="1230" y="6"/>
                </a:lnTo>
                <a:lnTo>
                  <a:pt x="1231" y="7"/>
                </a:lnTo>
                <a:lnTo>
                  <a:pt x="1232" y="6"/>
                </a:lnTo>
                <a:lnTo>
                  <a:pt x="1233" y="7"/>
                </a:lnTo>
                <a:lnTo>
                  <a:pt x="1234" y="6"/>
                </a:lnTo>
                <a:lnTo>
                  <a:pt x="1235" y="6"/>
                </a:lnTo>
                <a:lnTo>
                  <a:pt x="1236" y="6"/>
                </a:lnTo>
                <a:lnTo>
                  <a:pt x="1237" y="6"/>
                </a:lnTo>
                <a:lnTo>
                  <a:pt x="1237" y="6"/>
                </a:lnTo>
                <a:lnTo>
                  <a:pt x="1238" y="6"/>
                </a:lnTo>
                <a:lnTo>
                  <a:pt x="1239" y="5"/>
                </a:lnTo>
                <a:lnTo>
                  <a:pt x="1240" y="5"/>
                </a:lnTo>
                <a:lnTo>
                  <a:pt x="1241" y="6"/>
                </a:lnTo>
                <a:lnTo>
                  <a:pt x="1242" y="5"/>
                </a:lnTo>
                <a:lnTo>
                  <a:pt x="1243" y="5"/>
                </a:lnTo>
                <a:lnTo>
                  <a:pt x="1244" y="5"/>
                </a:lnTo>
                <a:lnTo>
                  <a:pt x="1245" y="5"/>
                </a:lnTo>
                <a:lnTo>
                  <a:pt x="1245" y="5"/>
                </a:lnTo>
                <a:lnTo>
                  <a:pt x="1246" y="4"/>
                </a:lnTo>
                <a:lnTo>
                  <a:pt x="1247" y="4"/>
                </a:lnTo>
                <a:lnTo>
                  <a:pt x="1248" y="4"/>
                </a:lnTo>
                <a:lnTo>
                  <a:pt x="1249" y="4"/>
                </a:lnTo>
                <a:lnTo>
                  <a:pt x="1250" y="4"/>
                </a:lnTo>
                <a:lnTo>
                  <a:pt x="1251" y="4"/>
                </a:lnTo>
                <a:lnTo>
                  <a:pt x="1252" y="4"/>
                </a:lnTo>
                <a:lnTo>
                  <a:pt x="1252" y="4"/>
                </a:lnTo>
                <a:lnTo>
                  <a:pt x="1253" y="3"/>
                </a:lnTo>
                <a:lnTo>
                  <a:pt x="1254" y="4"/>
                </a:lnTo>
                <a:lnTo>
                  <a:pt x="1255" y="4"/>
                </a:lnTo>
                <a:lnTo>
                  <a:pt x="1256" y="4"/>
                </a:lnTo>
                <a:lnTo>
                  <a:pt x="1257" y="3"/>
                </a:lnTo>
                <a:lnTo>
                  <a:pt x="1258" y="4"/>
                </a:lnTo>
                <a:lnTo>
                  <a:pt x="1259" y="3"/>
                </a:lnTo>
                <a:lnTo>
                  <a:pt x="1260" y="4"/>
                </a:lnTo>
                <a:lnTo>
                  <a:pt x="1260" y="3"/>
                </a:lnTo>
                <a:lnTo>
                  <a:pt x="1261" y="4"/>
                </a:lnTo>
                <a:lnTo>
                  <a:pt x="1262" y="4"/>
                </a:lnTo>
                <a:lnTo>
                  <a:pt x="1263" y="4"/>
                </a:lnTo>
                <a:lnTo>
                  <a:pt x="1264" y="4"/>
                </a:lnTo>
                <a:lnTo>
                  <a:pt x="1265" y="3"/>
                </a:lnTo>
                <a:lnTo>
                  <a:pt x="1266" y="3"/>
                </a:lnTo>
                <a:lnTo>
                  <a:pt x="1267" y="3"/>
                </a:lnTo>
                <a:lnTo>
                  <a:pt x="1267" y="3"/>
                </a:lnTo>
                <a:lnTo>
                  <a:pt x="1268" y="3"/>
                </a:lnTo>
                <a:lnTo>
                  <a:pt x="1269" y="2"/>
                </a:lnTo>
                <a:lnTo>
                  <a:pt x="1270" y="2"/>
                </a:lnTo>
                <a:lnTo>
                  <a:pt x="1271" y="3"/>
                </a:lnTo>
                <a:lnTo>
                  <a:pt x="1272" y="3"/>
                </a:lnTo>
                <a:lnTo>
                  <a:pt x="1273" y="3"/>
                </a:lnTo>
                <a:lnTo>
                  <a:pt x="1274" y="3"/>
                </a:lnTo>
                <a:lnTo>
                  <a:pt x="1275" y="3"/>
                </a:lnTo>
                <a:lnTo>
                  <a:pt x="1275" y="2"/>
                </a:lnTo>
                <a:lnTo>
                  <a:pt x="1276" y="3"/>
                </a:lnTo>
                <a:lnTo>
                  <a:pt x="1277" y="3"/>
                </a:lnTo>
                <a:lnTo>
                  <a:pt x="1278" y="2"/>
                </a:lnTo>
                <a:lnTo>
                  <a:pt x="1279" y="3"/>
                </a:lnTo>
                <a:lnTo>
                  <a:pt x="1280" y="3"/>
                </a:lnTo>
                <a:lnTo>
                  <a:pt x="1281" y="2"/>
                </a:lnTo>
                <a:lnTo>
                  <a:pt x="1282" y="3"/>
                </a:lnTo>
                <a:lnTo>
                  <a:pt x="1282" y="2"/>
                </a:lnTo>
                <a:lnTo>
                  <a:pt x="1283" y="2"/>
                </a:lnTo>
                <a:lnTo>
                  <a:pt x="1284" y="3"/>
                </a:lnTo>
                <a:lnTo>
                  <a:pt x="1285" y="3"/>
                </a:lnTo>
                <a:lnTo>
                  <a:pt x="1286" y="2"/>
                </a:lnTo>
                <a:lnTo>
                  <a:pt x="1287" y="3"/>
                </a:lnTo>
                <a:lnTo>
                  <a:pt x="1288" y="2"/>
                </a:lnTo>
                <a:lnTo>
                  <a:pt x="1289" y="2"/>
                </a:lnTo>
                <a:lnTo>
                  <a:pt x="1290" y="3"/>
                </a:lnTo>
                <a:lnTo>
                  <a:pt x="1290" y="2"/>
                </a:lnTo>
                <a:lnTo>
                  <a:pt x="1291" y="2"/>
                </a:lnTo>
                <a:lnTo>
                  <a:pt x="1292" y="2"/>
                </a:lnTo>
                <a:lnTo>
                  <a:pt x="1293" y="3"/>
                </a:lnTo>
                <a:lnTo>
                  <a:pt x="1294" y="3"/>
                </a:lnTo>
                <a:lnTo>
                  <a:pt x="1295" y="2"/>
                </a:lnTo>
                <a:lnTo>
                  <a:pt x="1296" y="2"/>
                </a:lnTo>
                <a:lnTo>
                  <a:pt x="1297" y="2"/>
                </a:lnTo>
                <a:lnTo>
                  <a:pt x="1297" y="3"/>
                </a:lnTo>
                <a:lnTo>
                  <a:pt x="1298" y="3"/>
                </a:lnTo>
                <a:lnTo>
                  <a:pt x="1299" y="2"/>
                </a:lnTo>
                <a:lnTo>
                  <a:pt x="1300" y="3"/>
                </a:lnTo>
                <a:lnTo>
                  <a:pt x="1301" y="2"/>
                </a:lnTo>
                <a:lnTo>
                  <a:pt x="1302" y="2"/>
                </a:lnTo>
                <a:lnTo>
                  <a:pt x="1303" y="2"/>
                </a:lnTo>
                <a:lnTo>
                  <a:pt x="1304" y="2"/>
                </a:lnTo>
                <a:lnTo>
                  <a:pt x="1305" y="2"/>
                </a:lnTo>
                <a:lnTo>
                  <a:pt x="1305" y="2"/>
                </a:lnTo>
                <a:lnTo>
                  <a:pt x="1306" y="3"/>
                </a:lnTo>
                <a:lnTo>
                  <a:pt x="1307" y="2"/>
                </a:lnTo>
                <a:lnTo>
                  <a:pt x="1308" y="2"/>
                </a:lnTo>
                <a:lnTo>
                  <a:pt x="1309" y="2"/>
                </a:lnTo>
                <a:lnTo>
                  <a:pt x="1310" y="3"/>
                </a:lnTo>
                <a:lnTo>
                  <a:pt x="1311" y="2"/>
                </a:lnTo>
                <a:lnTo>
                  <a:pt x="1312" y="2"/>
                </a:lnTo>
                <a:lnTo>
                  <a:pt x="1312" y="2"/>
                </a:lnTo>
                <a:lnTo>
                  <a:pt x="1313" y="2"/>
                </a:lnTo>
                <a:lnTo>
                  <a:pt x="1314" y="2"/>
                </a:lnTo>
                <a:lnTo>
                  <a:pt x="1315" y="2"/>
                </a:lnTo>
                <a:lnTo>
                  <a:pt x="1316" y="3"/>
                </a:lnTo>
                <a:lnTo>
                  <a:pt x="1317" y="3"/>
                </a:lnTo>
                <a:lnTo>
                  <a:pt x="1318" y="2"/>
                </a:lnTo>
                <a:lnTo>
                  <a:pt x="1319" y="3"/>
                </a:lnTo>
                <a:lnTo>
                  <a:pt x="1320" y="2"/>
                </a:lnTo>
                <a:lnTo>
                  <a:pt x="1320" y="3"/>
                </a:lnTo>
                <a:lnTo>
                  <a:pt x="1321" y="2"/>
                </a:lnTo>
                <a:lnTo>
                  <a:pt x="1322" y="2"/>
                </a:lnTo>
                <a:lnTo>
                  <a:pt x="1323" y="2"/>
                </a:lnTo>
                <a:lnTo>
                  <a:pt x="1324" y="2"/>
                </a:lnTo>
                <a:lnTo>
                  <a:pt x="1325" y="2"/>
                </a:lnTo>
                <a:lnTo>
                  <a:pt x="1326" y="2"/>
                </a:lnTo>
                <a:lnTo>
                  <a:pt x="1327" y="3"/>
                </a:lnTo>
                <a:lnTo>
                  <a:pt x="1327" y="2"/>
                </a:lnTo>
                <a:lnTo>
                  <a:pt x="1328" y="3"/>
                </a:lnTo>
                <a:lnTo>
                  <a:pt x="1329" y="2"/>
                </a:lnTo>
                <a:lnTo>
                  <a:pt x="1330" y="1"/>
                </a:lnTo>
                <a:lnTo>
                  <a:pt x="1331" y="3"/>
                </a:lnTo>
                <a:lnTo>
                  <a:pt x="1332" y="1"/>
                </a:lnTo>
                <a:lnTo>
                  <a:pt x="1333" y="2"/>
                </a:lnTo>
                <a:lnTo>
                  <a:pt x="1334" y="3"/>
                </a:lnTo>
                <a:lnTo>
                  <a:pt x="1335" y="2"/>
                </a:lnTo>
                <a:lnTo>
                  <a:pt x="1335" y="2"/>
                </a:lnTo>
                <a:lnTo>
                  <a:pt x="1336" y="2"/>
                </a:lnTo>
                <a:lnTo>
                  <a:pt x="1337" y="2"/>
                </a:lnTo>
                <a:lnTo>
                  <a:pt x="1338" y="2"/>
                </a:lnTo>
                <a:lnTo>
                  <a:pt x="1339" y="2"/>
                </a:lnTo>
                <a:lnTo>
                  <a:pt x="1340" y="2"/>
                </a:lnTo>
                <a:lnTo>
                  <a:pt x="1341" y="2"/>
                </a:lnTo>
                <a:lnTo>
                  <a:pt x="1342" y="2"/>
                </a:lnTo>
                <a:lnTo>
                  <a:pt x="1342" y="2"/>
                </a:lnTo>
                <a:lnTo>
                  <a:pt x="1343" y="2"/>
                </a:lnTo>
                <a:lnTo>
                  <a:pt x="1344" y="1"/>
                </a:lnTo>
                <a:lnTo>
                  <a:pt x="1345" y="2"/>
                </a:lnTo>
                <a:lnTo>
                  <a:pt x="1346" y="1"/>
                </a:lnTo>
                <a:lnTo>
                  <a:pt x="1347" y="2"/>
                </a:lnTo>
                <a:lnTo>
                  <a:pt x="1348" y="2"/>
                </a:lnTo>
                <a:lnTo>
                  <a:pt x="1349" y="2"/>
                </a:lnTo>
                <a:lnTo>
                  <a:pt x="1350" y="2"/>
                </a:lnTo>
                <a:lnTo>
                  <a:pt x="1350" y="2"/>
                </a:lnTo>
                <a:lnTo>
                  <a:pt x="1351" y="1"/>
                </a:lnTo>
                <a:lnTo>
                  <a:pt x="1352" y="2"/>
                </a:lnTo>
                <a:lnTo>
                  <a:pt x="1353" y="2"/>
                </a:lnTo>
                <a:lnTo>
                  <a:pt x="1354" y="2"/>
                </a:lnTo>
                <a:lnTo>
                  <a:pt x="1355" y="2"/>
                </a:lnTo>
                <a:lnTo>
                  <a:pt x="1356" y="1"/>
                </a:lnTo>
                <a:lnTo>
                  <a:pt x="1357" y="1"/>
                </a:lnTo>
                <a:lnTo>
                  <a:pt x="1357" y="2"/>
                </a:lnTo>
                <a:lnTo>
                  <a:pt x="1358" y="2"/>
                </a:lnTo>
                <a:lnTo>
                  <a:pt x="1359" y="2"/>
                </a:lnTo>
                <a:lnTo>
                  <a:pt x="1360" y="2"/>
                </a:lnTo>
                <a:lnTo>
                  <a:pt x="1361" y="1"/>
                </a:lnTo>
                <a:lnTo>
                  <a:pt x="1362" y="1"/>
                </a:lnTo>
                <a:lnTo>
                  <a:pt x="1363" y="1"/>
                </a:lnTo>
                <a:lnTo>
                  <a:pt x="1364" y="3"/>
                </a:lnTo>
                <a:lnTo>
                  <a:pt x="1365" y="2"/>
                </a:lnTo>
                <a:lnTo>
                  <a:pt x="1365" y="2"/>
                </a:lnTo>
                <a:lnTo>
                  <a:pt x="1366" y="2"/>
                </a:lnTo>
                <a:lnTo>
                  <a:pt x="1367" y="3"/>
                </a:lnTo>
                <a:lnTo>
                  <a:pt x="1368" y="2"/>
                </a:lnTo>
                <a:lnTo>
                  <a:pt x="1369" y="2"/>
                </a:lnTo>
                <a:lnTo>
                  <a:pt x="1370" y="3"/>
                </a:lnTo>
                <a:lnTo>
                  <a:pt x="1371" y="2"/>
                </a:lnTo>
                <a:lnTo>
                  <a:pt x="1372" y="3"/>
                </a:lnTo>
                <a:lnTo>
                  <a:pt x="1372" y="4"/>
                </a:lnTo>
                <a:lnTo>
                  <a:pt x="1373" y="3"/>
                </a:lnTo>
                <a:lnTo>
                  <a:pt x="1374" y="3"/>
                </a:lnTo>
                <a:lnTo>
                  <a:pt x="1375" y="3"/>
                </a:lnTo>
                <a:lnTo>
                  <a:pt x="1376" y="2"/>
                </a:lnTo>
                <a:lnTo>
                  <a:pt x="1377" y="3"/>
                </a:lnTo>
                <a:lnTo>
                  <a:pt x="1378" y="3"/>
                </a:lnTo>
                <a:lnTo>
                  <a:pt x="1379" y="3"/>
                </a:lnTo>
                <a:lnTo>
                  <a:pt x="1380" y="1"/>
                </a:lnTo>
                <a:lnTo>
                  <a:pt x="1380" y="2"/>
                </a:lnTo>
                <a:lnTo>
                  <a:pt x="1381" y="2"/>
                </a:lnTo>
                <a:lnTo>
                  <a:pt x="1382" y="2"/>
                </a:lnTo>
                <a:lnTo>
                  <a:pt x="1383" y="2"/>
                </a:lnTo>
                <a:lnTo>
                  <a:pt x="1384" y="2"/>
                </a:lnTo>
                <a:lnTo>
                  <a:pt x="1385" y="3"/>
                </a:lnTo>
                <a:lnTo>
                  <a:pt x="1386" y="3"/>
                </a:lnTo>
                <a:lnTo>
                  <a:pt x="1387" y="4"/>
                </a:lnTo>
                <a:lnTo>
                  <a:pt x="1387" y="6"/>
                </a:lnTo>
                <a:lnTo>
                  <a:pt x="1388" y="6"/>
                </a:lnTo>
                <a:lnTo>
                  <a:pt x="1389" y="8"/>
                </a:lnTo>
                <a:lnTo>
                  <a:pt x="1390" y="9"/>
                </a:lnTo>
                <a:lnTo>
                  <a:pt x="1391" y="9"/>
                </a:lnTo>
                <a:lnTo>
                  <a:pt x="1392" y="9"/>
                </a:lnTo>
                <a:lnTo>
                  <a:pt x="1393" y="9"/>
                </a:lnTo>
                <a:lnTo>
                  <a:pt x="1394" y="10"/>
                </a:lnTo>
                <a:lnTo>
                  <a:pt x="1395" y="11"/>
                </a:lnTo>
                <a:lnTo>
                  <a:pt x="1395" y="9"/>
                </a:lnTo>
                <a:lnTo>
                  <a:pt x="1396" y="9"/>
                </a:lnTo>
                <a:lnTo>
                  <a:pt x="1397" y="7"/>
                </a:lnTo>
                <a:lnTo>
                  <a:pt x="1398" y="8"/>
                </a:lnTo>
                <a:lnTo>
                  <a:pt x="1399" y="7"/>
                </a:lnTo>
                <a:lnTo>
                  <a:pt x="1400" y="7"/>
                </a:lnTo>
                <a:lnTo>
                  <a:pt x="1401" y="7"/>
                </a:lnTo>
                <a:lnTo>
                  <a:pt x="1402" y="6"/>
                </a:lnTo>
                <a:lnTo>
                  <a:pt x="1402" y="7"/>
                </a:lnTo>
                <a:lnTo>
                  <a:pt x="1403" y="7"/>
                </a:lnTo>
                <a:lnTo>
                  <a:pt x="1404" y="5"/>
                </a:lnTo>
                <a:lnTo>
                  <a:pt x="1405" y="6"/>
                </a:lnTo>
                <a:lnTo>
                  <a:pt x="1406" y="5"/>
                </a:lnTo>
                <a:lnTo>
                  <a:pt x="1407" y="5"/>
                </a:lnTo>
                <a:lnTo>
                  <a:pt x="1408" y="5"/>
                </a:lnTo>
                <a:lnTo>
                  <a:pt x="1409" y="4"/>
                </a:lnTo>
                <a:lnTo>
                  <a:pt x="1410" y="5"/>
                </a:lnTo>
                <a:lnTo>
                  <a:pt x="1410" y="4"/>
                </a:lnTo>
                <a:lnTo>
                  <a:pt x="1411" y="5"/>
                </a:lnTo>
                <a:lnTo>
                  <a:pt x="1412" y="4"/>
                </a:lnTo>
                <a:lnTo>
                  <a:pt x="1413" y="4"/>
                </a:lnTo>
                <a:lnTo>
                  <a:pt x="1414" y="3"/>
                </a:lnTo>
                <a:lnTo>
                  <a:pt x="1415" y="3"/>
                </a:lnTo>
                <a:lnTo>
                  <a:pt x="1416" y="3"/>
                </a:lnTo>
                <a:lnTo>
                  <a:pt x="1417" y="3"/>
                </a:lnTo>
                <a:lnTo>
                  <a:pt x="1417" y="2"/>
                </a:lnTo>
                <a:lnTo>
                  <a:pt x="1418" y="2"/>
                </a:lnTo>
                <a:lnTo>
                  <a:pt x="1419" y="2"/>
                </a:lnTo>
                <a:lnTo>
                  <a:pt x="1420" y="3"/>
                </a:lnTo>
                <a:lnTo>
                  <a:pt x="1421" y="3"/>
                </a:lnTo>
                <a:lnTo>
                  <a:pt x="1422" y="4"/>
                </a:lnTo>
                <a:lnTo>
                  <a:pt x="1423" y="3"/>
                </a:lnTo>
                <a:lnTo>
                  <a:pt x="1424" y="3"/>
                </a:lnTo>
                <a:lnTo>
                  <a:pt x="1425" y="3"/>
                </a:lnTo>
                <a:lnTo>
                  <a:pt x="1425" y="3"/>
                </a:lnTo>
                <a:lnTo>
                  <a:pt x="1426" y="3"/>
                </a:lnTo>
                <a:lnTo>
                  <a:pt x="1427" y="3"/>
                </a:lnTo>
                <a:lnTo>
                  <a:pt x="1428" y="3"/>
                </a:lnTo>
                <a:lnTo>
                  <a:pt x="1429" y="2"/>
                </a:lnTo>
                <a:lnTo>
                  <a:pt x="1430" y="3"/>
                </a:lnTo>
                <a:lnTo>
                  <a:pt x="1431" y="2"/>
                </a:lnTo>
                <a:lnTo>
                  <a:pt x="1432" y="4"/>
                </a:lnTo>
                <a:lnTo>
                  <a:pt x="1432" y="2"/>
                </a:lnTo>
                <a:lnTo>
                  <a:pt x="1433" y="2"/>
                </a:lnTo>
                <a:lnTo>
                  <a:pt x="1434" y="3"/>
                </a:lnTo>
                <a:lnTo>
                  <a:pt x="1435" y="3"/>
                </a:lnTo>
                <a:lnTo>
                  <a:pt x="1436" y="3"/>
                </a:lnTo>
                <a:lnTo>
                  <a:pt x="1437" y="3"/>
                </a:lnTo>
                <a:lnTo>
                  <a:pt x="1438" y="2"/>
                </a:lnTo>
                <a:lnTo>
                  <a:pt x="1439" y="2"/>
                </a:lnTo>
                <a:lnTo>
                  <a:pt x="1439" y="2"/>
                </a:lnTo>
                <a:lnTo>
                  <a:pt x="1440" y="2"/>
                </a:lnTo>
                <a:lnTo>
                  <a:pt x="1441" y="3"/>
                </a:lnTo>
                <a:lnTo>
                  <a:pt x="1442" y="3"/>
                </a:lnTo>
                <a:lnTo>
                  <a:pt x="1443" y="2"/>
                </a:lnTo>
                <a:lnTo>
                  <a:pt x="1444" y="2"/>
                </a:lnTo>
                <a:lnTo>
                  <a:pt x="1445" y="1"/>
                </a:lnTo>
                <a:lnTo>
                  <a:pt x="1446" y="2"/>
                </a:lnTo>
                <a:lnTo>
                  <a:pt x="1447" y="2"/>
                </a:lnTo>
                <a:lnTo>
                  <a:pt x="1447" y="2"/>
                </a:lnTo>
                <a:lnTo>
                  <a:pt x="1448" y="2"/>
                </a:lnTo>
                <a:lnTo>
                  <a:pt x="1449" y="2"/>
                </a:lnTo>
                <a:lnTo>
                  <a:pt x="1450" y="2"/>
                </a:lnTo>
                <a:lnTo>
                  <a:pt x="1451" y="2"/>
                </a:lnTo>
                <a:lnTo>
                  <a:pt x="1452" y="2"/>
                </a:lnTo>
                <a:lnTo>
                  <a:pt x="1453" y="2"/>
                </a:lnTo>
                <a:lnTo>
                  <a:pt x="1454" y="3"/>
                </a:lnTo>
                <a:lnTo>
                  <a:pt x="1454" y="3"/>
                </a:lnTo>
                <a:lnTo>
                  <a:pt x="1455" y="3"/>
                </a:lnTo>
                <a:lnTo>
                  <a:pt x="1456" y="5"/>
                </a:lnTo>
                <a:lnTo>
                  <a:pt x="1457" y="4"/>
                </a:lnTo>
                <a:lnTo>
                  <a:pt x="1458" y="5"/>
                </a:lnTo>
                <a:lnTo>
                  <a:pt x="1459" y="6"/>
                </a:lnTo>
                <a:lnTo>
                  <a:pt x="1460" y="9"/>
                </a:lnTo>
                <a:lnTo>
                  <a:pt x="1461" y="10"/>
                </a:lnTo>
                <a:lnTo>
                  <a:pt x="1462" y="11"/>
                </a:lnTo>
                <a:lnTo>
                  <a:pt x="1462" y="11"/>
                </a:lnTo>
                <a:lnTo>
                  <a:pt x="1463" y="12"/>
                </a:lnTo>
                <a:lnTo>
                  <a:pt x="1464" y="11"/>
                </a:lnTo>
                <a:lnTo>
                  <a:pt x="1465" y="11"/>
                </a:lnTo>
                <a:lnTo>
                  <a:pt x="1466" y="10"/>
                </a:lnTo>
                <a:lnTo>
                  <a:pt x="1467" y="9"/>
                </a:lnTo>
                <a:lnTo>
                  <a:pt x="1468" y="9"/>
                </a:lnTo>
                <a:lnTo>
                  <a:pt x="1469" y="8"/>
                </a:lnTo>
                <a:lnTo>
                  <a:pt x="1469" y="7"/>
                </a:lnTo>
                <a:lnTo>
                  <a:pt x="1470" y="7"/>
                </a:lnTo>
                <a:lnTo>
                  <a:pt x="1471" y="6"/>
                </a:lnTo>
                <a:lnTo>
                  <a:pt x="1472" y="7"/>
                </a:lnTo>
                <a:lnTo>
                  <a:pt x="1473" y="6"/>
                </a:lnTo>
                <a:lnTo>
                  <a:pt x="1474" y="5"/>
                </a:lnTo>
                <a:lnTo>
                  <a:pt x="1475" y="5"/>
                </a:lnTo>
                <a:lnTo>
                  <a:pt x="1476" y="4"/>
                </a:lnTo>
                <a:lnTo>
                  <a:pt x="1477" y="5"/>
                </a:lnTo>
                <a:lnTo>
                  <a:pt x="1477" y="5"/>
                </a:lnTo>
                <a:lnTo>
                  <a:pt x="1478" y="5"/>
                </a:lnTo>
                <a:lnTo>
                  <a:pt x="1479" y="4"/>
                </a:lnTo>
                <a:lnTo>
                  <a:pt x="1480" y="5"/>
                </a:lnTo>
                <a:lnTo>
                  <a:pt x="1481" y="4"/>
                </a:lnTo>
                <a:lnTo>
                  <a:pt x="1482" y="4"/>
                </a:lnTo>
                <a:lnTo>
                  <a:pt x="1483" y="4"/>
                </a:lnTo>
                <a:lnTo>
                  <a:pt x="1484" y="5"/>
                </a:lnTo>
                <a:lnTo>
                  <a:pt x="1484" y="4"/>
                </a:lnTo>
                <a:lnTo>
                  <a:pt x="1485" y="3"/>
                </a:lnTo>
                <a:lnTo>
                  <a:pt x="1486" y="3"/>
                </a:lnTo>
                <a:lnTo>
                  <a:pt x="1487" y="3"/>
                </a:lnTo>
                <a:lnTo>
                  <a:pt x="1488" y="3"/>
                </a:lnTo>
                <a:lnTo>
                  <a:pt x="1489" y="3"/>
                </a:lnTo>
                <a:lnTo>
                  <a:pt x="1490" y="3"/>
                </a:lnTo>
                <a:lnTo>
                  <a:pt x="1491" y="3"/>
                </a:lnTo>
                <a:lnTo>
                  <a:pt x="1492" y="3"/>
                </a:lnTo>
                <a:lnTo>
                  <a:pt x="1492" y="3"/>
                </a:lnTo>
                <a:lnTo>
                  <a:pt x="1493" y="2"/>
                </a:lnTo>
                <a:lnTo>
                  <a:pt x="1494" y="2"/>
                </a:lnTo>
                <a:lnTo>
                  <a:pt x="1495" y="2"/>
                </a:lnTo>
                <a:lnTo>
                  <a:pt x="1496" y="2"/>
                </a:lnTo>
                <a:lnTo>
                  <a:pt x="1497" y="2"/>
                </a:lnTo>
                <a:lnTo>
                  <a:pt x="1498" y="2"/>
                </a:lnTo>
                <a:lnTo>
                  <a:pt x="1499" y="2"/>
                </a:lnTo>
                <a:lnTo>
                  <a:pt x="1499" y="2"/>
                </a:lnTo>
                <a:lnTo>
                  <a:pt x="1500" y="3"/>
                </a:lnTo>
                <a:lnTo>
                  <a:pt x="1501" y="3"/>
                </a:lnTo>
                <a:lnTo>
                  <a:pt x="1502" y="3"/>
                </a:lnTo>
                <a:lnTo>
                  <a:pt x="1503" y="2"/>
                </a:lnTo>
                <a:lnTo>
                  <a:pt x="1504" y="2"/>
                </a:lnTo>
                <a:lnTo>
                  <a:pt x="1505" y="2"/>
                </a:lnTo>
                <a:lnTo>
                  <a:pt x="1506" y="2"/>
                </a:lnTo>
                <a:lnTo>
                  <a:pt x="1507" y="2"/>
                </a:lnTo>
                <a:lnTo>
                  <a:pt x="1507" y="3"/>
                </a:lnTo>
                <a:lnTo>
                  <a:pt x="1508" y="2"/>
                </a:lnTo>
                <a:lnTo>
                  <a:pt x="1509" y="3"/>
                </a:lnTo>
                <a:lnTo>
                  <a:pt x="1510" y="2"/>
                </a:lnTo>
                <a:lnTo>
                  <a:pt x="1511" y="2"/>
                </a:lnTo>
                <a:lnTo>
                  <a:pt x="1512" y="2"/>
                </a:lnTo>
                <a:lnTo>
                  <a:pt x="1513" y="1"/>
                </a:lnTo>
                <a:lnTo>
                  <a:pt x="1514" y="2"/>
                </a:lnTo>
                <a:lnTo>
                  <a:pt x="1514" y="1"/>
                </a:lnTo>
                <a:lnTo>
                  <a:pt x="1515" y="2"/>
                </a:lnTo>
                <a:lnTo>
                  <a:pt x="1516" y="2"/>
                </a:lnTo>
                <a:lnTo>
                  <a:pt x="1517" y="1"/>
                </a:lnTo>
                <a:lnTo>
                  <a:pt x="1518" y="1"/>
                </a:lnTo>
                <a:lnTo>
                  <a:pt x="1519" y="1"/>
                </a:lnTo>
                <a:lnTo>
                  <a:pt x="1520" y="2"/>
                </a:lnTo>
                <a:lnTo>
                  <a:pt x="1521" y="2"/>
                </a:lnTo>
                <a:lnTo>
                  <a:pt x="1522" y="2"/>
                </a:lnTo>
                <a:lnTo>
                  <a:pt x="1522" y="2"/>
                </a:lnTo>
                <a:lnTo>
                  <a:pt x="1523" y="2"/>
                </a:lnTo>
                <a:lnTo>
                  <a:pt x="1524" y="2"/>
                </a:lnTo>
                <a:lnTo>
                  <a:pt x="1525" y="2"/>
                </a:lnTo>
                <a:lnTo>
                  <a:pt x="1526" y="3"/>
                </a:lnTo>
                <a:lnTo>
                  <a:pt x="1527" y="3"/>
                </a:lnTo>
                <a:lnTo>
                  <a:pt x="1528" y="3"/>
                </a:lnTo>
                <a:lnTo>
                  <a:pt x="1529" y="4"/>
                </a:lnTo>
                <a:lnTo>
                  <a:pt x="1529" y="5"/>
                </a:lnTo>
                <a:lnTo>
                  <a:pt x="1530" y="5"/>
                </a:lnTo>
                <a:lnTo>
                  <a:pt x="1531" y="6"/>
                </a:lnTo>
                <a:lnTo>
                  <a:pt x="1532" y="5"/>
                </a:lnTo>
                <a:lnTo>
                  <a:pt x="1533" y="6"/>
                </a:lnTo>
                <a:lnTo>
                  <a:pt x="1534" y="6"/>
                </a:lnTo>
                <a:lnTo>
                  <a:pt x="1535" y="6"/>
                </a:lnTo>
                <a:lnTo>
                  <a:pt x="1536" y="7"/>
                </a:lnTo>
                <a:lnTo>
                  <a:pt x="1537" y="6"/>
                </a:lnTo>
                <a:lnTo>
                  <a:pt x="1537" y="6"/>
                </a:lnTo>
                <a:lnTo>
                  <a:pt x="1538" y="5"/>
                </a:lnTo>
                <a:lnTo>
                  <a:pt x="1539" y="5"/>
                </a:lnTo>
                <a:lnTo>
                  <a:pt x="1540" y="5"/>
                </a:lnTo>
                <a:lnTo>
                  <a:pt x="1541" y="4"/>
                </a:lnTo>
                <a:lnTo>
                  <a:pt x="1542" y="6"/>
                </a:lnTo>
                <a:lnTo>
                  <a:pt x="1543" y="4"/>
                </a:lnTo>
                <a:lnTo>
                  <a:pt x="1544" y="5"/>
                </a:lnTo>
                <a:lnTo>
                  <a:pt x="1544" y="4"/>
                </a:lnTo>
                <a:lnTo>
                  <a:pt x="1545" y="5"/>
                </a:lnTo>
                <a:lnTo>
                  <a:pt x="1546" y="4"/>
                </a:lnTo>
                <a:lnTo>
                  <a:pt x="1547" y="5"/>
                </a:lnTo>
                <a:lnTo>
                  <a:pt x="1548" y="5"/>
                </a:lnTo>
                <a:lnTo>
                  <a:pt x="1549" y="5"/>
                </a:lnTo>
                <a:lnTo>
                  <a:pt x="1550" y="5"/>
                </a:lnTo>
                <a:lnTo>
                  <a:pt x="1551" y="5"/>
                </a:lnTo>
                <a:lnTo>
                  <a:pt x="1552" y="5"/>
                </a:lnTo>
                <a:lnTo>
                  <a:pt x="1552" y="5"/>
                </a:lnTo>
                <a:lnTo>
                  <a:pt x="1553" y="4"/>
                </a:lnTo>
                <a:lnTo>
                  <a:pt x="1554" y="5"/>
                </a:lnTo>
                <a:lnTo>
                  <a:pt x="1555" y="5"/>
                </a:lnTo>
                <a:lnTo>
                  <a:pt x="1556" y="5"/>
                </a:lnTo>
                <a:lnTo>
                  <a:pt x="1557" y="4"/>
                </a:lnTo>
                <a:lnTo>
                  <a:pt x="1558" y="4"/>
                </a:lnTo>
                <a:lnTo>
                  <a:pt x="1559" y="4"/>
                </a:lnTo>
                <a:lnTo>
                  <a:pt x="1559" y="5"/>
                </a:lnTo>
                <a:lnTo>
                  <a:pt x="1560" y="4"/>
                </a:lnTo>
                <a:lnTo>
                  <a:pt x="1561" y="6"/>
                </a:lnTo>
                <a:lnTo>
                  <a:pt x="1562" y="5"/>
                </a:lnTo>
                <a:lnTo>
                  <a:pt x="1563" y="5"/>
                </a:lnTo>
                <a:lnTo>
                  <a:pt x="1564" y="5"/>
                </a:lnTo>
                <a:lnTo>
                  <a:pt x="1565" y="5"/>
                </a:lnTo>
                <a:lnTo>
                  <a:pt x="1566" y="5"/>
                </a:lnTo>
                <a:lnTo>
                  <a:pt x="1567" y="4"/>
                </a:lnTo>
                <a:lnTo>
                  <a:pt x="1567" y="4"/>
                </a:lnTo>
                <a:lnTo>
                  <a:pt x="1568" y="5"/>
                </a:lnTo>
                <a:lnTo>
                  <a:pt x="1569" y="4"/>
                </a:lnTo>
                <a:lnTo>
                  <a:pt x="1570" y="4"/>
                </a:lnTo>
                <a:lnTo>
                  <a:pt x="1571" y="4"/>
                </a:lnTo>
                <a:lnTo>
                  <a:pt x="1572" y="4"/>
                </a:lnTo>
                <a:lnTo>
                  <a:pt x="1573" y="4"/>
                </a:lnTo>
                <a:lnTo>
                  <a:pt x="1574" y="3"/>
                </a:lnTo>
                <a:lnTo>
                  <a:pt x="1574" y="3"/>
                </a:lnTo>
                <a:lnTo>
                  <a:pt x="1575" y="3"/>
                </a:lnTo>
                <a:lnTo>
                  <a:pt x="1576" y="3"/>
                </a:lnTo>
                <a:lnTo>
                  <a:pt x="1577" y="3"/>
                </a:lnTo>
                <a:lnTo>
                  <a:pt x="1578" y="3"/>
                </a:lnTo>
                <a:lnTo>
                  <a:pt x="1579" y="3"/>
                </a:lnTo>
                <a:lnTo>
                  <a:pt x="1580" y="3"/>
                </a:lnTo>
                <a:lnTo>
                  <a:pt x="1581" y="2"/>
                </a:lnTo>
                <a:lnTo>
                  <a:pt x="1582" y="3"/>
                </a:lnTo>
                <a:lnTo>
                  <a:pt x="1582" y="2"/>
                </a:lnTo>
                <a:lnTo>
                  <a:pt x="1583" y="3"/>
                </a:lnTo>
                <a:lnTo>
                  <a:pt x="1584" y="2"/>
                </a:lnTo>
                <a:lnTo>
                  <a:pt x="1585" y="3"/>
                </a:lnTo>
                <a:lnTo>
                  <a:pt x="1586" y="2"/>
                </a:lnTo>
                <a:lnTo>
                  <a:pt x="1587" y="3"/>
                </a:lnTo>
                <a:lnTo>
                  <a:pt x="1588" y="3"/>
                </a:lnTo>
                <a:lnTo>
                  <a:pt x="1589" y="3"/>
                </a:lnTo>
                <a:lnTo>
                  <a:pt x="1589" y="3"/>
                </a:lnTo>
                <a:lnTo>
                  <a:pt x="1590" y="3"/>
                </a:lnTo>
                <a:lnTo>
                  <a:pt x="1591" y="3"/>
                </a:lnTo>
                <a:lnTo>
                  <a:pt x="1592" y="3"/>
                </a:lnTo>
                <a:lnTo>
                  <a:pt x="1593" y="3"/>
                </a:lnTo>
                <a:lnTo>
                  <a:pt x="1594" y="2"/>
                </a:lnTo>
                <a:lnTo>
                  <a:pt x="1595" y="3"/>
                </a:lnTo>
                <a:lnTo>
                  <a:pt x="1596" y="3"/>
                </a:lnTo>
                <a:lnTo>
                  <a:pt x="1597" y="3"/>
                </a:lnTo>
                <a:lnTo>
                  <a:pt x="1597" y="2"/>
                </a:lnTo>
                <a:lnTo>
                  <a:pt x="1598" y="3"/>
                </a:lnTo>
                <a:lnTo>
                  <a:pt x="1599" y="2"/>
                </a:lnTo>
                <a:lnTo>
                  <a:pt x="1600" y="2"/>
                </a:lnTo>
                <a:lnTo>
                  <a:pt x="1601" y="2"/>
                </a:lnTo>
                <a:lnTo>
                  <a:pt x="1602" y="2"/>
                </a:lnTo>
                <a:lnTo>
                  <a:pt x="1603" y="3"/>
                </a:lnTo>
                <a:lnTo>
                  <a:pt x="1604" y="1"/>
                </a:lnTo>
                <a:lnTo>
                  <a:pt x="1604" y="2"/>
                </a:lnTo>
                <a:lnTo>
                  <a:pt x="1605" y="2"/>
                </a:lnTo>
                <a:lnTo>
                  <a:pt x="1606" y="2"/>
                </a:lnTo>
                <a:lnTo>
                  <a:pt x="1607" y="2"/>
                </a:lnTo>
                <a:lnTo>
                  <a:pt x="1608" y="2"/>
                </a:lnTo>
                <a:lnTo>
                  <a:pt x="1609" y="2"/>
                </a:lnTo>
                <a:lnTo>
                  <a:pt x="1610" y="3"/>
                </a:lnTo>
                <a:lnTo>
                  <a:pt x="1611" y="2"/>
                </a:lnTo>
                <a:lnTo>
                  <a:pt x="1612" y="2"/>
                </a:lnTo>
                <a:lnTo>
                  <a:pt x="1612" y="2"/>
                </a:lnTo>
                <a:lnTo>
                  <a:pt x="1613" y="3"/>
                </a:lnTo>
                <a:lnTo>
                  <a:pt x="1614" y="2"/>
                </a:lnTo>
                <a:lnTo>
                  <a:pt x="1615" y="3"/>
                </a:lnTo>
                <a:lnTo>
                  <a:pt x="1616" y="3"/>
                </a:lnTo>
                <a:lnTo>
                  <a:pt x="1617" y="2"/>
                </a:lnTo>
                <a:lnTo>
                  <a:pt x="1618" y="1"/>
                </a:lnTo>
                <a:lnTo>
                  <a:pt x="1619" y="2"/>
                </a:lnTo>
                <a:lnTo>
                  <a:pt x="1619" y="1"/>
                </a:lnTo>
                <a:lnTo>
                  <a:pt x="1620" y="2"/>
                </a:lnTo>
                <a:lnTo>
                  <a:pt x="1621" y="2"/>
                </a:lnTo>
                <a:lnTo>
                  <a:pt x="1622" y="2"/>
                </a:lnTo>
                <a:lnTo>
                  <a:pt x="1623" y="2"/>
                </a:lnTo>
                <a:lnTo>
                  <a:pt x="1624" y="1"/>
                </a:lnTo>
                <a:lnTo>
                  <a:pt x="1625" y="2"/>
                </a:lnTo>
                <a:lnTo>
                  <a:pt x="1626" y="2"/>
                </a:lnTo>
                <a:lnTo>
                  <a:pt x="1627" y="2"/>
                </a:lnTo>
                <a:lnTo>
                  <a:pt x="1627" y="1"/>
                </a:lnTo>
                <a:lnTo>
                  <a:pt x="1628" y="2"/>
                </a:lnTo>
                <a:lnTo>
                  <a:pt x="1629" y="1"/>
                </a:lnTo>
                <a:lnTo>
                  <a:pt x="1630" y="2"/>
                </a:lnTo>
                <a:lnTo>
                  <a:pt x="1631" y="2"/>
                </a:lnTo>
                <a:lnTo>
                  <a:pt x="1632" y="2"/>
                </a:lnTo>
                <a:lnTo>
                  <a:pt x="1633" y="4"/>
                </a:lnTo>
                <a:lnTo>
                  <a:pt x="1634" y="3"/>
                </a:lnTo>
                <a:lnTo>
                  <a:pt x="1634" y="5"/>
                </a:lnTo>
                <a:lnTo>
                  <a:pt x="1635" y="6"/>
                </a:lnTo>
                <a:lnTo>
                  <a:pt x="1636" y="8"/>
                </a:lnTo>
                <a:lnTo>
                  <a:pt x="1637" y="10"/>
                </a:lnTo>
                <a:lnTo>
                  <a:pt x="1638" y="11"/>
                </a:lnTo>
                <a:lnTo>
                  <a:pt x="1639" y="14"/>
                </a:lnTo>
                <a:lnTo>
                  <a:pt x="1640" y="15"/>
                </a:lnTo>
                <a:lnTo>
                  <a:pt x="1641" y="16"/>
                </a:lnTo>
                <a:lnTo>
                  <a:pt x="1641" y="15"/>
                </a:lnTo>
                <a:lnTo>
                  <a:pt x="1642" y="13"/>
                </a:lnTo>
                <a:lnTo>
                  <a:pt x="1643" y="12"/>
                </a:lnTo>
                <a:lnTo>
                  <a:pt x="1644" y="12"/>
                </a:lnTo>
                <a:lnTo>
                  <a:pt x="1645" y="11"/>
                </a:lnTo>
                <a:lnTo>
                  <a:pt x="1646" y="9"/>
                </a:lnTo>
                <a:lnTo>
                  <a:pt x="1647" y="8"/>
                </a:lnTo>
                <a:lnTo>
                  <a:pt x="1648" y="7"/>
                </a:lnTo>
                <a:lnTo>
                  <a:pt x="1649" y="7"/>
                </a:lnTo>
                <a:lnTo>
                  <a:pt x="1649" y="7"/>
                </a:lnTo>
                <a:lnTo>
                  <a:pt x="1650" y="5"/>
                </a:lnTo>
                <a:lnTo>
                  <a:pt x="1651" y="4"/>
                </a:lnTo>
                <a:lnTo>
                  <a:pt x="1652" y="5"/>
                </a:lnTo>
                <a:lnTo>
                  <a:pt x="1653" y="4"/>
                </a:lnTo>
                <a:lnTo>
                  <a:pt x="1654" y="4"/>
                </a:lnTo>
                <a:lnTo>
                  <a:pt x="1655" y="4"/>
                </a:lnTo>
                <a:lnTo>
                  <a:pt x="1656" y="4"/>
                </a:lnTo>
                <a:lnTo>
                  <a:pt x="1656" y="4"/>
                </a:lnTo>
                <a:lnTo>
                  <a:pt x="1657" y="5"/>
                </a:lnTo>
                <a:lnTo>
                  <a:pt x="1658" y="3"/>
                </a:lnTo>
                <a:lnTo>
                  <a:pt x="1659" y="3"/>
                </a:lnTo>
                <a:lnTo>
                  <a:pt x="1660" y="2"/>
                </a:lnTo>
                <a:lnTo>
                  <a:pt x="1661" y="3"/>
                </a:lnTo>
                <a:lnTo>
                  <a:pt x="1662" y="3"/>
                </a:lnTo>
                <a:lnTo>
                  <a:pt x="1663" y="3"/>
                </a:lnTo>
                <a:lnTo>
                  <a:pt x="1664" y="3"/>
                </a:lnTo>
                <a:lnTo>
                  <a:pt x="1664" y="2"/>
                </a:lnTo>
                <a:lnTo>
                  <a:pt x="1665" y="2"/>
                </a:lnTo>
                <a:lnTo>
                  <a:pt x="1666" y="2"/>
                </a:lnTo>
                <a:lnTo>
                  <a:pt x="1667" y="2"/>
                </a:lnTo>
                <a:lnTo>
                  <a:pt x="1668" y="2"/>
                </a:lnTo>
                <a:lnTo>
                  <a:pt x="1669" y="2"/>
                </a:lnTo>
                <a:lnTo>
                  <a:pt x="1670" y="2"/>
                </a:lnTo>
                <a:lnTo>
                  <a:pt x="1671" y="2"/>
                </a:lnTo>
                <a:lnTo>
                  <a:pt x="1671" y="2"/>
                </a:lnTo>
                <a:lnTo>
                  <a:pt x="1672" y="2"/>
                </a:lnTo>
                <a:lnTo>
                  <a:pt x="1673" y="1"/>
                </a:lnTo>
                <a:lnTo>
                  <a:pt x="1674" y="2"/>
                </a:lnTo>
                <a:lnTo>
                  <a:pt x="1675" y="2"/>
                </a:lnTo>
                <a:lnTo>
                  <a:pt x="1676" y="1"/>
                </a:lnTo>
                <a:lnTo>
                  <a:pt x="1677" y="1"/>
                </a:lnTo>
                <a:lnTo>
                  <a:pt x="1678" y="2"/>
                </a:lnTo>
                <a:lnTo>
                  <a:pt x="1679" y="1"/>
                </a:lnTo>
                <a:lnTo>
                  <a:pt x="1679" y="2"/>
                </a:lnTo>
                <a:lnTo>
                  <a:pt x="1680" y="1"/>
                </a:lnTo>
                <a:lnTo>
                  <a:pt x="1681" y="1"/>
                </a:lnTo>
                <a:lnTo>
                  <a:pt x="1682" y="2"/>
                </a:lnTo>
                <a:lnTo>
                  <a:pt x="1683" y="2"/>
                </a:lnTo>
                <a:lnTo>
                  <a:pt x="1684" y="2"/>
                </a:lnTo>
                <a:lnTo>
                  <a:pt x="1685" y="1"/>
                </a:lnTo>
                <a:lnTo>
                  <a:pt x="1686" y="1"/>
                </a:lnTo>
                <a:lnTo>
                  <a:pt x="1686" y="2"/>
                </a:lnTo>
                <a:lnTo>
                  <a:pt x="1687" y="2"/>
                </a:lnTo>
                <a:lnTo>
                  <a:pt x="1688" y="3"/>
                </a:lnTo>
                <a:lnTo>
                  <a:pt x="1689" y="4"/>
                </a:lnTo>
                <a:lnTo>
                  <a:pt x="1690" y="5"/>
                </a:lnTo>
                <a:lnTo>
                  <a:pt x="1691" y="7"/>
                </a:lnTo>
                <a:lnTo>
                  <a:pt x="1692" y="8"/>
                </a:lnTo>
                <a:lnTo>
                  <a:pt x="1693" y="9"/>
                </a:lnTo>
                <a:lnTo>
                  <a:pt x="1694" y="8"/>
                </a:lnTo>
                <a:lnTo>
                  <a:pt x="1694" y="9"/>
                </a:lnTo>
                <a:lnTo>
                  <a:pt x="1695" y="9"/>
                </a:lnTo>
                <a:lnTo>
                  <a:pt x="1696" y="10"/>
                </a:lnTo>
                <a:lnTo>
                  <a:pt x="1697" y="8"/>
                </a:lnTo>
                <a:lnTo>
                  <a:pt x="1698" y="7"/>
                </a:lnTo>
                <a:lnTo>
                  <a:pt x="1699" y="5"/>
                </a:lnTo>
                <a:lnTo>
                  <a:pt x="1700" y="5"/>
                </a:lnTo>
                <a:lnTo>
                  <a:pt x="1701" y="4"/>
                </a:lnTo>
                <a:lnTo>
                  <a:pt x="1701" y="4"/>
                </a:lnTo>
                <a:lnTo>
                  <a:pt x="1702" y="3"/>
                </a:lnTo>
                <a:lnTo>
                  <a:pt x="1703" y="3"/>
                </a:lnTo>
                <a:lnTo>
                  <a:pt x="1704" y="2"/>
                </a:lnTo>
                <a:lnTo>
                  <a:pt x="1705" y="2"/>
                </a:lnTo>
                <a:lnTo>
                  <a:pt x="1706" y="3"/>
                </a:lnTo>
                <a:lnTo>
                  <a:pt x="1707" y="2"/>
                </a:lnTo>
                <a:lnTo>
                  <a:pt x="1708" y="2"/>
                </a:lnTo>
                <a:lnTo>
                  <a:pt x="1709" y="2"/>
                </a:lnTo>
                <a:lnTo>
                  <a:pt x="1709" y="2"/>
                </a:lnTo>
                <a:lnTo>
                  <a:pt x="1710" y="1"/>
                </a:lnTo>
                <a:lnTo>
                  <a:pt x="1711" y="1"/>
                </a:lnTo>
                <a:lnTo>
                  <a:pt x="1712" y="2"/>
                </a:lnTo>
                <a:lnTo>
                  <a:pt x="1713" y="1"/>
                </a:lnTo>
                <a:lnTo>
                  <a:pt x="1714" y="1"/>
                </a:lnTo>
                <a:lnTo>
                  <a:pt x="1715" y="2"/>
                </a:lnTo>
                <a:lnTo>
                  <a:pt x="1716" y="2"/>
                </a:lnTo>
                <a:lnTo>
                  <a:pt x="1716" y="2"/>
                </a:lnTo>
                <a:lnTo>
                  <a:pt x="1717" y="2"/>
                </a:lnTo>
                <a:lnTo>
                  <a:pt x="1718" y="3"/>
                </a:lnTo>
                <a:lnTo>
                  <a:pt x="1719" y="3"/>
                </a:lnTo>
                <a:lnTo>
                  <a:pt x="1720" y="4"/>
                </a:lnTo>
                <a:lnTo>
                  <a:pt x="1721" y="5"/>
                </a:lnTo>
                <a:lnTo>
                  <a:pt x="1722" y="4"/>
                </a:lnTo>
                <a:lnTo>
                  <a:pt x="1723" y="5"/>
                </a:lnTo>
                <a:lnTo>
                  <a:pt x="1724" y="5"/>
                </a:lnTo>
                <a:lnTo>
                  <a:pt x="1724" y="4"/>
                </a:lnTo>
                <a:lnTo>
                  <a:pt x="1725" y="5"/>
                </a:lnTo>
                <a:lnTo>
                  <a:pt x="1726" y="4"/>
                </a:lnTo>
                <a:lnTo>
                  <a:pt x="1727" y="4"/>
                </a:lnTo>
                <a:lnTo>
                  <a:pt x="1728" y="2"/>
                </a:lnTo>
                <a:lnTo>
                  <a:pt x="1729" y="2"/>
                </a:lnTo>
                <a:lnTo>
                  <a:pt x="1730" y="3"/>
                </a:lnTo>
                <a:lnTo>
                  <a:pt x="1731" y="2"/>
                </a:lnTo>
                <a:lnTo>
                  <a:pt x="1731" y="2"/>
                </a:lnTo>
                <a:lnTo>
                  <a:pt x="1732" y="2"/>
                </a:lnTo>
                <a:lnTo>
                  <a:pt x="1733" y="2"/>
                </a:lnTo>
                <a:lnTo>
                  <a:pt x="1734" y="2"/>
                </a:lnTo>
                <a:lnTo>
                  <a:pt x="1735" y="2"/>
                </a:lnTo>
                <a:lnTo>
                  <a:pt x="1736" y="2"/>
                </a:lnTo>
                <a:lnTo>
                  <a:pt x="1737" y="1"/>
                </a:lnTo>
                <a:lnTo>
                  <a:pt x="1738" y="2"/>
                </a:lnTo>
                <a:lnTo>
                  <a:pt x="1739" y="2"/>
                </a:lnTo>
                <a:lnTo>
                  <a:pt x="1739" y="1"/>
                </a:lnTo>
                <a:lnTo>
                  <a:pt x="1740" y="1"/>
                </a:lnTo>
                <a:lnTo>
                  <a:pt x="1741" y="1"/>
                </a:lnTo>
                <a:lnTo>
                  <a:pt x="1742" y="1"/>
                </a:lnTo>
                <a:lnTo>
                  <a:pt x="1743" y="1"/>
                </a:lnTo>
                <a:lnTo>
                  <a:pt x="1744" y="1"/>
                </a:lnTo>
                <a:lnTo>
                  <a:pt x="1745" y="0"/>
                </a:lnTo>
                <a:lnTo>
                  <a:pt x="1746" y="1"/>
                </a:lnTo>
                <a:lnTo>
                  <a:pt x="1746" y="1"/>
                </a:lnTo>
                <a:lnTo>
                  <a:pt x="1747" y="1"/>
                </a:lnTo>
                <a:lnTo>
                  <a:pt x="1748" y="1"/>
                </a:lnTo>
                <a:lnTo>
                  <a:pt x="1749" y="0"/>
                </a:lnTo>
                <a:lnTo>
                  <a:pt x="1750" y="1"/>
                </a:lnTo>
                <a:lnTo>
                  <a:pt x="1751" y="1"/>
                </a:lnTo>
                <a:lnTo>
                  <a:pt x="1752" y="1"/>
                </a:lnTo>
                <a:lnTo>
                  <a:pt x="1753" y="1"/>
                </a:lnTo>
                <a:lnTo>
                  <a:pt x="1754" y="1"/>
                </a:lnTo>
                <a:lnTo>
                  <a:pt x="1754" y="1"/>
                </a:lnTo>
                <a:lnTo>
                  <a:pt x="1755" y="1"/>
                </a:lnTo>
                <a:lnTo>
                  <a:pt x="1756" y="1"/>
                </a:lnTo>
                <a:lnTo>
                  <a:pt x="1757" y="1"/>
                </a:lnTo>
                <a:lnTo>
                  <a:pt x="1758" y="0"/>
                </a:lnTo>
                <a:lnTo>
                  <a:pt x="1759" y="1"/>
                </a:lnTo>
                <a:lnTo>
                  <a:pt x="1760" y="1"/>
                </a:lnTo>
                <a:lnTo>
                  <a:pt x="1761" y="1"/>
                </a:lnTo>
                <a:lnTo>
                  <a:pt x="1761" y="1"/>
                </a:lnTo>
                <a:lnTo>
                  <a:pt x="1762" y="1"/>
                </a:lnTo>
                <a:lnTo>
                  <a:pt x="1763" y="1"/>
                </a:lnTo>
                <a:lnTo>
                  <a:pt x="1764" y="1"/>
                </a:lnTo>
                <a:lnTo>
                  <a:pt x="1765" y="2"/>
                </a:lnTo>
                <a:lnTo>
                  <a:pt x="1766" y="2"/>
                </a:lnTo>
                <a:lnTo>
                  <a:pt x="1767" y="3"/>
                </a:lnTo>
                <a:lnTo>
                  <a:pt x="1768" y="3"/>
                </a:lnTo>
                <a:lnTo>
                  <a:pt x="1769" y="4"/>
                </a:lnTo>
                <a:lnTo>
                  <a:pt x="1769" y="4"/>
                </a:lnTo>
                <a:lnTo>
                  <a:pt x="1770" y="4"/>
                </a:lnTo>
                <a:lnTo>
                  <a:pt x="1771" y="4"/>
                </a:lnTo>
                <a:lnTo>
                  <a:pt x="1772" y="5"/>
                </a:lnTo>
                <a:lnTo>
                  <a:pt x="1773" y="4"/>
                </a:lnTo>
                <a:lnTo>
                  <a:pt x="1774" y="5"/>
                </a:lnTo>
                <a:lnTo>
                  <a:pt x="1775" y="4"/>
                </a:lnTo>
                <a:lnTo>
                  <a:pt x="1776" y="4"/>
                </a:lnTo>
                <a:lnTo>
                  <a:pt x="1776" y="3"/>
                </a:lnTo>
                <a:lnTo>
                  <a:pt x="1777" y="3"/>
                </a:lnTo>
                <a:lnTo>
                  <a:pt x="1778" y="3"/>
                </a:lnTo>
                <a:lnTo>
                  <a:pt x="1779" y="3"/>
                </a:lnTo>
                <a:lnTo>
                  <a:pt x="1780" y="2"/>
                </a:lnTo>
                <a:lnTo>
                  <a:pt x="1781" y="2"/>
                </a:lnTo>
                <a:lnTo>
                  <a:pt x="1782" y="2"/>
                </a:lnTo>
                <a:lnTo>
                  <a:pt x="1783" y="2"/>
                </a:lnTo>
                <a:lnTo>
                  <a:pt x="1784" y="2"/>
                </a:lnTo>
                <a:lnTo>
                  <a:pt x="1784" y="2"/>
                </a:lnTo>
                <a:lnTo>
                  <a:pt x="1785" y="2"/>
                </a:lnTo>
                <a:lnTo>
                  <a:pt x="1786" y="2"/>
                </a:lnTo>
                <a:lnTo>
                  <a:pt x="1787" y="2"/>
                </a:lnTo>
                <a:lnTo>
                  <a:pt x="1788" y="2"/>
                </a:lnTo>
                <a:lnTo>
                  <a:pt x="1789" y="2"/>
                </a:lnTo>
                <a:lnTo>
                  <a:pt x="1790" y="1"/>
                </a:lnTo>
                <a:lnTo>
                  <a:pt x="1791" y="2"/>
                </a:lnTo>
                <a:lnTo>
                  <a:pt x="1791" y="1"/>
                </a:lnTo>
                <a:lnTo>
                  <a:pt x="1792" y="2"/>
                </a:lnTo>
                <a:lnTo>
                  <a:pt x="1793" y="1"/>
                </a:lnTo>
                <a:lnTo>
                  <a:pt x="1794" y="3"/>
                </a:lnTo>
                <a:lnTo>
                  <a:pt x="1795" y="2"/>
                </a:lnTo>
                <a:lnTo>
                  <a:pt x="1796" y="1"/>
                </a:lnTo>
                <a:lnTo>
                  <a:pt x="1797" y="1"/>
                </a:lnTo>
                <a:lnTo>
                  <a:pt x="1798" y="1"/>
                </a:lnTo>
                <a:lnTo>
                  <a:pt x="1799" y="2"/>
                </a:lnTo>
                <a:lnTo>
                  <a:pt x="1799" y="2"/>
                </a:lnTo>
                <a:lnTo>
                  <a:pt x="1800" y="2"/>
                </a:lnTo>
                <a:lnTo>
                  <a:pt x="1801" y="1"/>
                </a:lnTo>
                <a:lnTo>
                  <a:pt x="1802" y="1"/>
                </a:lnTo>
                <a:lnTo>
                  <a:pt x="1803" y="1"/>
                </a:lnTo>
                <a:lnTo>
                  <a:pt x="1804" y="1"/>
                </a:lnTo>
                <a:lnTo>
                  <a:pt x="1805" y="1"/>
                </a:lnTo>
                <a:lnTo>
                  <a:pt x="1806" y="2"/>
                </a:lnTo>
                <a:lnTo>
                  <a:pt x="1806" y="1"/>
                </a:lnTo>
                <a:lnTo>
                  <a:pt x="1807" y="2"/>
                </a:lnTo>
                <a:lnTo>
                  <a:pt x="1808" y="1"/>
                </a:lnTo>
                <a:lnTo>
                  <a:pt x="1809" y="2"/>
                </a:lnTo>
                <a:lnTo>
                  <a:pt x="1810" y="2"/>
                </a:lnTo>
                <a:lnTo>
                  <a:pt x="1811" y="2"/>
                </a:lnTo>
                <a:lnTo>
                  <a:pt x="1812" y="2"/>
                </a:lnTo>
                <a:lnTo>
                  <a:pt x="1813" y="2"/>
                </a:lnTo>
                <a:lnTo>
                  <a:pt x="1814" y="2"/>
                </a:lnTo>
                <a:lnTo>
                  <a:pt x="1814" y="2"/>
                </a:lnTo>
                <a:lnTo>
                  <a:pt x="1815" y="1"/>
                </a:lnTo>
                <a:lnTo>
                  <a:pt x="1816" y="2"/>
                </a:lnTo>
                <a:lnTo>
                  <a:pt x="1817" y="2"/>
                </a:lnTo>
                <a:lnTo>
                  <a:pt x="1818" y="2"/>
                </a:lnTo>
                <a:lnTo>
                  <a:pt x="1819" y="2"/>
                </a:lnTo>
                <a:lnTo>
                  <a:pt x="1820" y="3"/>
                </a:lnTo>
                <a:lnTo>
                  <a:pt x="1821" y="1"/>
                </a:lnTo>
                <a:lnTo>
                  <a:pt x="1821" y="3"/>
                </a:lnTo>
                <a:lnTo>
                  <a:pt x="1822" y="2"/>
                </a:lnTo>
                <a:lnTo>
                  <a:pt x="1823" y="2"/>
                </a:lnTo>
                <a:lnTo>
                  <a:pt x="1824" y="2"/>
                </a:lnTo>
                <a:lnTo>
                  <a:pt x="1825" y="2"/>
                </a:lnTo>
                <a:lnTo>
                  <a:pt x="1826" y="2"/>
                </a:lnTo>
                <a:lnTo>
                  <a:pt x="1827" y="2"/>
                </a:lnTo>
                <a:lnTo>
                  <a:pt x="1828" y="2"/>
                </a:lnTo>
                <a:lnTo>
                  <a:pt x="1828" y="2"/>
                </a:lnTo>
                <a:lnTo>
                  <a:pt x="1829" y="2"/>
                </a:lnTo>
                <a:lnTo>
                  <a:pt x="1830" y="2"/>
                </a:lnTo>
                <a:lnTo>
                  <a:pt x="1831" y="2"/>
                </a:lnTo>
                <a:lnTo>
                  <a:pt x="1832" y="2"/>
                </a:lnTo>
                <a:lnTo>
                  <a:pt x="1833" y="2"/>
                </a:lnTo>
                <a:lnTo>
                  <a:pt x="1834" y="2"/>
                </a:lnTo>
                <a:lnTo>
                  <a:pt x="1835" y="2"/>
                </a:lnTo>
                <a:lnTo>
                  <a:pt x="1836" y="2"/>
                </a:lnTo>
                <a:lnTo>
                  <a:pt x="1836" y="1"/>
                </a:lnTo>
                <a:lnTo>
                  <a:pt x="1837" y="2"/>
                </a:lnTo>
                <a:lnTo>
                  <a:pt x="1838" y="2"/>
                </a:lnTo>
                <a:lnTo>
                  <a:pt x="1839" y="2"/>
                </a:lnTo>
                <a:lnTo>
                  <a:pt x="1840" y="2"/>
                </a:lnTo>
                <a:lnTo>
                  <a:pt x="1841" y="2"/>
                </a:lnTo>
                <a:lnTo>
                  <a:pt x="1842" y="2"/>
                </a:lnTo>
                <a:lnTo>
                  <a:pt x="1843" y="2"/>
                </a:lnTo>
                <a:lnTo>
                  <a:pt x="1843" y="3"/>
                </a:lnTo>
                <a:lnTo>
                  <a:pt x="1844" y="2"/>
                </a:lnTo>
                <a:lnTo>
                  <a:pt x="1845" y="2"/>
                </a:lnTo>
                <a:lnTo>
                  <a:pt x="1846" y="2"/>
                </a:lnTo>
                <a:lnTo>
                  <a:pt x="1847" y="2"/>
                </a:lnTo>
                <a:lnTo>
                  <a:pt x="1848" y="3"/>
                </a:lnTo>
                <a:lnTo>
                  <a:pt x="1849" y="2"/>
                </a:lnTo>
                <a:lnTo>
                  <a:pt x="1850" y="2"/>
                </a:lnTo>
                <a:lnTo>
                  <a:pt x="1851" y="2"/>
                </a:lnTo>
                <a:lnTo>
                  <a:pt x="1851" y="2"/>
                </a:lnTo>
                <a:lnTo>
                  <a:pt x="1852" y="2"/>
                </a:lnTo>
                <a:lnTo>
                  <a:pt x="1853" y="1"/>
                </a:lnTo>
                <a:lnTo>
                  <a:pt x="1854" y="2"/>
                </a:lnTo>
                <a:lnTo>
                  <a:pt x="1855" y="2"/>
                </a:lnTo>
                <a:lnTo>
                  <a:pt x="1856" y="2"/>
                </a:lnTo>
                <a:lnTo>
                  <a:pt x="1857" y="2"/>
                </a:lnTo>
                <a:lnTo>
                  <a:pt x="1858" y="3"/>
                </a:lnTo>
                <a:lnTo>
                  <a:pt x="1858" y="2"/>
                </a:lnTo>
                <a:lnTo>
                  <a:pt x="1859" y="2"/>
                </a:lnTo>
                <a:lnTo>
                  <a:pt x="1860" y="2"/>
                </a:lnTo>
                <a:lnTo>
                  <a:pt x="1861" y="3"/>
                </a:lnTo>
                <a:lnTo>
                  <a:pt x="1862" y="2"/>
                </a:lnTo>
                <a:lnTo>
                  <a:pt x="1863" y="2"/>
                </a:lnTo>
                <a:lnTo>
                  <a:pt x="1864" y="2"/>
                </a:lnTo>
                <a:lnTo>
                  <a:pt x="1865" y="2"/>
                </a:lnTo>
                <a:lnTo>
                  <a:pt x="1866" y="0"/>
                </a:lnTo>
                <a:lnTo>
                  <a:pt x="1866" y="2"/>
                </a:lnTo>
                <a:lnTo>
                  <a:pt x="1867" y="2"/>
                </a:lnTo>
                <a:lnTo>
                  <a:pt x="1868" y="1"/>
                </a:lnTo>
                <a:lnTo>
                  <a:pt x="1869" y="1"/>
                </a:lnTo>
                <a:lnTo>
                  <a:pt x="1870" y="2"/>
                </a:lnTo>
                <a:lnTo>
                  <a:pt x="1871" y="1"/>
                </a:lnTo>
                <a:lnTo>
                  <a:pt x="1872" y="2"/>
                </a:lnTo>
                <a:lnTo>
                  <a:pt x="1873" y="1"/>
                </a:lnTo>
                <a:lnTo>
                  <a:pt x="1873" y="1"/>
                </a:lnTo>
                <a:lnTo>
                  <a:pt x="1874" y="2"/>
                </a:lnTo>
                <a:lnTo>
                  <a:pt x="1875" y="1"/>
                </a:lnTo>
                <a:lnTo>
                  <a:pt x="1876" y="2"/>
                </a:lnTo>
                <a:lnTo>
                  <a:pt x="1877" y="1"/>
                </a:lnTo>
                <a:lnTo>
                  <a:pt x="1878" y="1"/>
                </a:lnTo>
                <a:lnTo>
                  <a:pt x="1879" y="1"/>
                </a:lnTo>
                <a:lnTo>
                  <a:pt x="1880" y="1"/>
                </a:lnTo>
                <a:lnTo>
                  <a:pt x="1881" y="1"/>
                </a:lnTo>
                <a:lnTo>
                  <a:pt x="1881" y="1"/>
                </a:lnTo>
                <a:lnTo>
                  <a:pt x="1882" y="1"/>
                </a:lnTo>
                <a:lnTo>
                  <a:pt x="1883" y="1"/>
                </a:lnTo>
                <a:lnTo>
                  <a:pt x="1884" y="1"/>
                </a:lnTo>
                <a:lnTo>
                  <a:pt x="1885" y="1"/>
                </a:lnTo>
                <a:lnTo>
                  <a:pt x="1886" y="1"/>
                </a:lnTo>
                <a:lnTo>
                  <a:pt x="1887" y="1"/>
                </a:lnTo>
                <a:lnTo>
                  <a:pt x="1888" y="1"/>
                </a:lnTo>
                <a:lnTo>
                  <a:pt x="1888" y="1"/>
                </a:lnTo>
                <a:lnTo>
                  <a:pt x="1889" y="1"/>
                </a:lnTo>
                <a:lnTo>
                  <a:pt x="1890" y="1"/>
                </a:lnTo>
                <a:lnTo>
                  <a:pt x="1891" y="0"/>
                </a:lnTo>
                <a:lnTo>
                  <a:pt x="1892" y="0"/>
                </a:lnTo>
                <a:lnTo>
                  <a:pt x="1893" y="1"/>
                </a:lnTo>
                <a:lnTo>
                  <a:pt x="1894" y="1"/>
                </a:lnTo>
                <a:lnTo>
                  <a:pt x="1895" y="1"/>
                </a:lnTo>
                <a:lnTo>
                  <a:pt x="1896" y="0"/>
                </a:lnTo>
                <a:lnTo>
                  <a:pt x="1896" y="0"/>
                </a:lnTo>
                <a:lnTo>
                  <a:pt x="1897" y="1"/>
                </a:lnTo>
                <a:lnTo>
                  <a:pt x="1898" y="1"/>
                </a:lnTo>
                <a:lnTo>
                  <a:pt x="1899" y="1"/>
                </a:lnTo>
                <a:lnTo>
                  <a:pt x="1900" y="0"/>
                </a:lnTo>
                <a:lnTo>
                  <a:pt x="1901" y="1"/>
                </a:lnTo>
                <a:lnTo>
                  <a:pt x="1902" y="1"/>
                </a:lnTo>
                <a:lnTo>
                  <a:pt x="1903" y="1"/>
                </a:lnTo>
                <a:lnTo>
                  <a:pt x="1903" y="1"/>
                </a:lnTo>
                <a:lnTo>
                  <a:pt x="1904" y="1"/>
                </a:lnTo>
                <a:lnTo>
                  <a:pt x="1905" y="0"/>
                </a:lnTo>
                <a:lnTo>
                  <a:pt x="1906" y="1"/>
                </a:lnTo>
                <a:lnTo>
                  <a:pt x="1907" y="1"/>
                </a:lnTo>
                <a:lnTo>
                  <a:pt x="1908" y="1"/>
                </a:lnTo>
                <a:lnTo>
                  <a:pt x="1909" y="1"/>
                </a:lnTo>
                <a:lnTo>
                  <a:pt x="1910" y="1"/>
                </a:lnTo>
                <a:lnTo>
                  <a:pt x="1911" y="0"/>
                </a:lnTo>
                <a:lnTo>
                  <a:pt x="1911" y="1"/>
                </a:lnTo>
                <a:lnTo>
                  <a:pt x="1912" y="1"/>
                </a:lnTo>
                <a:lnTo>
                  <a:pt x="1913" y="1"/>
                </a:lnTo>
                <a:lnTo>
                  <a:pt x="1914" y="0"/>
                </a:lnTo>
                <a:lnTo>
                  <a:pt x="1915" y="0"/>
                </a:lnTo>
                <a:lnTo>
                  <a:pt x="1916" y="1"/>
                </a:lnTo>
                <a:lnTo>
                  <a:pt x="1917" y="1"/>
                </a:lnTo>
                <a:lnTo>
                  <a:pt x="1918" y="0"/>
                </a:lnTo>
                <a:lnTo>
                  <a:pt x="1918" y="1"/>
                </a:lnTo>
                <a:lnTo>
                  <a:pt x="1919" y="1"/>
                </a:lnTo>
                <a:lnTo>
                  <a:pt x="1920" y="1"/>
                </a:lnTo>
                <a:lnTo>
                  <a:pt x="1921" y="1"/>
                </a:lnTo>
                <a:lnTo>
                  <a:pt x="1922" y="1"/>
                </a:lnTo>
                <a:lnTo>
                  <a:pt x="1923" y="1"/>
                </a:lnTo>
                <a:lnTo>
                  <a:pt x="1924" y="1"/>
                </a:lnTo>
                <a:lnTo>
                  <a:pt x="1925" y="1"/>
                </a:lnTo>
                <a:lnTo>
                  <a:pt x="1926" y="0"/>
                </a:lnTo>
                <a:lnTo>
                  <a:pt x="1926" y="1"/>
                </a:lnTo>
                <a:lnTo>
                  <a:pt x="1927" y="1"/>
                </a:lnTo>
                <a:lnTo>
                  <a:pt x="1928" y="1"/>
                </a:lnTo>
                <a:lnTo>
                  <a:pt x="1929" y="0"/>
                </a:lnTo>
                <a:lnTo>
                  <a:pt x="1930" y="1"/>
                </a:lnTo>
                <a:lnTo>
                  <a:pt x="1931" y="1"/>
                </a:lnTo>
                <a:lnTo>
                  <a:pt x="1932" y="0"/>
                </a:lnTo>
                <a:lnTo>
                  <a:pt x="1933" y="1"/>
                </a:lnTo>
                <a:lnTo>
                  <a:pt x="1933" y="1"/>
                </a:lnTo>
                <a:lnTo>
                  <a:pt x="1934" y="1"/>
                </a:lnTo>
                <a:lnTo>
                  <a:pt x="1935" y="0"/>
                </a:lnTo>
                <a:lnTo>
                  <a:pt x="1936" y="2"/>
                </a:lnTo>
                <a:lnTo>
                  <a:pt x="1937" y="2"/>
                </a:lnTo>
                <a:lnTo>
                  <a:pt x="1938" y="2"/>
                </a:lnTo>
                <a:lnTo>
                  <a:pt x="1939" y="3"/>
                </a:lnTo>
                <a:lnTo>
                  <a:pt x="1940" y="2"/>
                </a:lnTo>
                <a:lnTo>
                  <a:pt x="1941" y="2"/>
                </a:lnTo>
                <a:lnTo>
                  <a:pt x="1941" y="2"/>
                </a:lnTo>
                <a:lnTo>
                  <a:pt x="1942" y="3"/>
                </a:lnTo>
                <a:lnTo>
                  <a:pt x="1943" y="2"/>
                </a:lnTo>
                <a:lnTo>
                  <a:pt x="1944" y="2"/>
                </a:lnTo>
                <a:lnTo>
                  <a:pt x="1945" y="2"/>
                </a:lnTo>
                <a:lnTo>
                  <a:pt x="1946" y="2"/>
                </a:lnTo>
                <a:lnTo>
                  <a:pt x="1947" y="2"/>
                </a:lnTo>
                <a:lnTo>
                  <a:pt x="1948" y="2"/>
                </a:lnTo>
                <a:lnTo>
                  <a:pt x="1948" y="2"/>
                </a:lnTo>
                <a:lnTo>
                  <a:pt x="1949" y="2"/>
                </a:lnTo>
                <a:lnTo>
                  <a:pt x="1950" y="1"/>
                </a:lnTo>
                <a:lnTo>
                  <a:pt x="1951" y="2"/>
                </a:lnTo>
                <a:lnTo>
                  <a:pt x="1952" y="1"/>
                </a:lnTo>
                <a:lnTo>
                  <a:pt x="1953" y="2"/>
                </a:lnTo>
                <a:lnTo>
                  <a:pt x="1954" y="1"/>
                </a:lnTo>
                <a:lnTo>
                  <a:pt x="1955" y="1"/>
                </a:lnTo>
                <a:lnTo>
                  <a:pt x="1956" y="1"/>
                </a:lnTo>
                <a:lnTo>
                  <a:pt x="1956" y="1"/>
                </a:lnTo>
                <a:lnTo>
                  <a:pt x="1957" y="1"/>
                </a:lnTo>
                <a:lnTo>
                  <a:pt x="1958" y="1"/>
                </a:lnTo>
                <a:lnTo>
                  <a:pt x="1959" y="1"/>
                </a:lnTo>
                <a:lnTo>
                  <a:pt x="1960" y="1"/>
                </a:lnTo>
                <a:lnTo>
                  <a:pt x="1961" y="0"/>
                </a:lnTo>
                <a:lnTo>
                  <a:pt x="1962" y="1"/>
                </a:lnTo>
                <a:lnTo>
                  <a:pt x="1963" y="1"/>
                </a:lnTo>
                <a:lnTo>
                  <a:pt x="1963" y="1"/>
                </a:lnTo>
                <a:lnTo>
                  <a:pt x="1964" y="1"/>
                </a:lnTo>
                <a:lnTo>
                  <a:pt x="1965" y="1"/>
                </a:lnTo>
                <a:lnTo>
                  <a:pt x="1966" y="1"/>
                </a:lnTo>
                <a:lnTo>
                  <a:pt x="1967" y="1"/>
                </a:lnTo>
                <a:lnTo>
                  <a:pt x="1968" y="1"/>
                </a:lnTo>
                <a:lnTo>
                  <a:pt x="1969" y="1"/>
                </a:lnTo>
                <a:lnTo>
                  <a:pt x="1970" y="0"/>
                </a:lnTo>
                <a:lnTo>
                  <a:pt x="1971" y="1"/>
                </a:lnTo>
                <a:lnTo>
                  <a:pt x="1971" y="1"/>
                </a:lnTo>
                <a:lnTo>
                  <a:pt x="1972" y="1"/>
                </a:lnTo>
                <a:lnTo>
                  <a:pt x="1973" y="1"/>
                </a:lnTo>
                <a:lnTo>
                  <a:pt x="1974" y="1"/>
                </a:lnTo>
                <a:lnTo>
                  <a:pt x="1975" y="1"/>
                </a:lnTo>
                <a:lnTo>
                  <a:pt x="1976" y="1"/>
                </a:lnTo>
                <a:lnTo>
                  <a:pt x="1977" y="1"/>
                </a:lnTo>
                <a:lnTo>
                  <a:pt x="1978" y="1"/>
                </a:lnTo>
                <a:lnTo>
                  <a:pt x="1978" y="0"/>
                </a:lnTo>
                <a:lnTo>
                  <a:pt x="1979" y="1"/>
                </a:lnTo>
                <a:lnTo>
                  <a:pt x="1980" y="1"/>
                </a:lnTo>
                <a:lnTo>
                  <a:pt x="1981" y="1"/>
                </a:lnTo>
                <a:lnTo>
                  <a:pt x="1982" y="0"/>
                </a:lnTo>
                <a:lnTo>
                  <a:pt x="1983" y="1"/>
                </a:lnTo>
                <a:lnTo>
                  <a:pt x="1984" y="1"/>
                </a:lnTo>
                <a:lnTo>
                  <a:pt x="1985" y="1"/>
                </a:lnTo>
                <a:lnTo>
                  <a:pt x="1986" y="2"/>
                </a:lnTo>
                <a:lnTo>
                  <a:pt x="1986" y="2"/>
                </a:lnTo>
                <a:lnTo>
                  <a:pt x="1987" y="3"/>
                </a:lnTo>
                <a:lnTo>
                  <a:pt x="1988" y="6"/>
                </a:lnTo>
                <a:lnTo>
                  <a:pt x="1989" y="6"/>
                </a:lnTo>
                <a:lnTo>
                  <a:pt x="1990" y="7"/>
                </a:lnTo>
                <a:lnTo>
                  <a:pt x="1991" y="9"/>
                </a:lnTo>
                <a:lnTo>
                  <a:pt x="1992" y="10"/>
                </a:lnTo>
                <a:lnTo>
                  <a:pt x="1993" y="13"/>
                </a:lnTo>
                <a:lnTo>
                  <a:pt x="1993" y="12"/>
                </a:lnTo>
                <a:lnTo>
                  <a:pt x="1994" y="10"/>
                </a:lnTo>
                <a:lnTo>
                  <a:pt x="1995" y="11"/>
                </a:lnTo>
                <a:lnTo>
                  <a:pt x="1996" y="10"/>
                </a:lnTo>
                <a:lnTo>
                  <a:pt x="1997" y="8"/>
                </a:lnTo>
                <a:lnTo>
                  <a:pt x="1998" y="7"/>
                </a:lnTo>
                <a:lnTo>
                  <a:pt x="1999" y="6"/>
                </a:lnTo>
                <a:lnTo>
                  <a:pt x="2000" y="4"/>
                </a:lnTo>
                <a:lnTo>
                  <a:pt x="2001" y="4"/>
                </a:lnTo>
                <a:lnTo>
                  <a:pt x="2001" y="4"/>
                </a:lnTo>
                <a:lnTo>
                  <a:pt x="2002" y="3"/>
                </a:lnTo>
                <a:lnTo>
                  <a:pt x="2003" y="2"/>
                </a:lnTo>
                <a:lnTo>
                  <a:pt x="2004" y="2"/>
                </a:lnTo>
                <a:lnTo>
                  <a:pt x="2005" y="2"/>
                </a:lnTo>
                <a:lnTo>
                  <a:pt x="2006" y="2"/>
                </a:lnTo>
                <a:lnTo>
                  <a:pt x="2007" y="2"/>
                </a:lnTo>
                <a:lnTo>
                  <a:pt x="2008" y="2"/>
                </a:lnTo>
                <a:lnTo>
                  <a:pt x="2008" y="1"/>
                </a:lnTo>
                <a:lnTo>
                  <a:pt x="2009" y="2"/>
                </a:lnTo>
                <a:lnTo>
                  <a:pt x="2010" y="2"/>
                </a:lnTo>
                <a:lnTo>
                  <a:pt x="2011" y="2"/>
                </a:lnTo>
                <a:lnTo>
                  <a:pt x="2012" y="4"/>
                </a:lnTo>
                <a:lnTo>
                  <a:pt x="2013" y="3"/>
                </a:lnTo>
                <a:lnTo>
                  <a:pt x="2014" y="4"/>
                </a:lnTo>
                <a:lnTo>
                  <a:pt x="2015" y="5"/>
                </a:lnTo>
                <a:lnTo>
                  <a:pt x="2016" y="5"/>
                </a:lnTo>
                <a:lnTo>
                  <a:pt x="2016" y="6"/>
                </a:lnTo>
                <a:lnTo>
                  <a:pt x="2017" y="5"/>
                </a:lnTo>
                <a:lnTo>
                  <a:pt x="2018" y="5"/>
                </a:lnTo>
                <a:lnTo>
                  <a:pt x="2019" y="5"/>
                </a:lnTo>
                <a:lnTo>
                  <a:pt x="2020" y="4"/>
                </a:lnTo>
                <a:lnTo>
                  <a:pt x="2021" y="4"/>
                </a:lnTo>
                <a:lnTo>
                  <a:pt x="2022" y="3"/>
                </a:lnTo>
                <a:lnTo>
                  <a:pt x="2023" y="4"/>
                </a:lnTo>
                <a:lnTo>
                  <a:pt x="2023" y="3"/>
                </a:lnTo>
                <a:lnTo>
                  <a:pt x="2024" y="3"/>
                </a:lnTo>
                <a:lnTo>
                  <a:pt x="2025" y="2"/>
                </a:lnTo>
                <a:lnTo>
                  <a:pt x="2026" y="3"/>
                </a:lnTo>
                <a:lnTo>
                  <a:pt x="2027" y="2"/>
                </a:lnTo>
                <a:lnTo>
                  <a:pt x="2028" y="2"/>
                </a:lnTo>
                <a:lnTo>
                  <a:pt x="2029" y="2"/>
                </a:lnTo>
                <a:lnTo>
                  <a:pt x="2030" y="2"/>
                </a:lnTo>
                <a:lnTo>
                  <a:pt x="2030" y="2"/>
                </a:lnTo>
                <a:lnTo>
                  <a:pt x="2031" y="1"/>
                </a:lnTo>
                <a:lnTo>
                  <a:pt x="2032" y="2"/>
                </a:lnTo>
                <a:lnTo>
                  <a:pt x="2033" y="2"/>
                </a:lnTo>
                <a:lnTo>
                  <a:pt x="2034" y="1"/>
                </a:lnTo>
                <a:lnTo>
                  <a:pt x="2035" y="1"/>
                </a:lnTo>
                <a:lnTo>
                  <a:pt x="2036" y="2"/>
                </a:lnTo>
                <a:lnTo>
                  <a:pt x="2037" y="2"/>
                </a:lnTo>
                <a:lnTo>
                  <a:pt x="2038" y="1"/>
                </a:lnTo>
                <a:lnTo>
                  <a:pt x="2038" y="1"/>
                </a:lnTo>
                <a:lnTo>
                  <a:pt x="2039" y="2"/>
                </a:lnTo>
                <a:lnTo>
                  <a:pt x="2040" y="2"/>
                </a:lnTo>
                <a:lnTo>
                  <a:pt x="2041" y="1"/>
                </a:lnTo>
                <a:lnTo>
                  <a:pt x="2042" y="1"/>
                </a:lnTo>
                <a:lnTo>
                  <a:pt x="2043" y="1"/>
                </a:lnTo>
                <a:lnTo>
                  <a:pt x="2044" y="1"/>
                </a:lnTo>
                <a:lnTo>
                  <a:pt x="2045" y="1"/>
                </a:lnTo>
                <a:lnTo>
                  <a:pt x="2045" y="2"/>
                </a:lnTo>
                <a:lnTo>
                  <a:pt x="2046" y="1"/>
                </a:lnTo>
                <a:lnTo>
                  <a:pt x="2047" y="2"/>
                </a:lnTo>
                <a:lnTo>
                  <a:pt x="2048" y="1"/>
                </a:lnTo>
                <a:lnTo>
                  <a:pt x="2049" y="1"/>
                </a:lnTo>
                <a:lnTo>
                  <a:pt x="2050" y="1"/>
                </a:lnTo>
                <a:lnTo>
                  <a:pt x="2051" y="2"/>
                </a:lnTo>
                <a:lnTo>
                  <a:pt x="2052" y="1"/>
                </a:lnTo>
                <a:lnTo>
                  <a:pt x="2053" y="2"/>
                </a:lnTo>
                <a:lnTo>
                  <a:pt x="2053" y="1"/>
                </a:lnTo>
                <a:lnTo>
                  <a:pt x="2054" y="2"/>
                </a:lnTo>
                <a:lnTo>
                  <a:pt x="2055" y="2"/>
                </a:lnTo>
                <a:lnTo>
                  <a:pt x="2056" y="1"/>
                </a:lnTo>
                <a:lnTo>
                  <a:pt x="2057" y="2"/>
                </a:lnTo>
                <a:lnTo>
                  <a:pt x="2058" y="2"/>
                </a:lnTo>
                <a:lnTo>
                  <a:pt x="2059" y="2"/>
                </a:lnTo>
                <a:lnTo>
                  <a:pt x="2060" y="2"/>
                </a:lnTo>
                <a:lnTo>
                  <a:pt x="2060" y="2"/>
                </a:lnTo>
                <a:lnTo>
                  <a:pt x="2061" y="3"/>
                </a:lnTo>
                <a:lnTo>
                  <a:pt x="2062" y="2"/>
                </a:lnTo>
                <a:lnTo>
                  <a:pt x="2063" y="1"/>
                </a:lnTo>
                <a:lnTo>
                  <a:pt x="2064" y="2"/>
                </a:lnTo>
                <a:lnTo>
                  <a:pt x="2065" y="2"/>
                </a:lnTo>
                <a:lnTo>
                  <a:pt x="2066" y="1"/>
                </a:lnTo>
                <a:lnTo>
                  <a:pt x="2067" y="2"/>
                </a:lnTo>
                <a:lnTo>
                  <a:pt x="2068" y="1"/>
                </a:lnTo>
                <a:lnTo>
                  <a:pt x="2068" y="2"/>
                </a:lnTo>
                <a:lnTo>
                  <a:pt x="2069" y="1"/>
                </a:lnTo>
                <a:lnTo>
                  <a:pt x="2070" y="2"/>
                </a:lnTo>
                <a:lnTo>
                  <a:pt x="2071" y="1"/>
                </a:lnTo>
                <a:lnTo>
                  <a:pt x="2072" y="2"/>
                </a:lnTo>
                <a:lnTo>
                  <a:pt x="2073" y="1"/>
                </a:lnTo>
                <a:lnTo>
                  <a:pt x="2074" y="1"/>
                </a:lnTo>
                <a:lnTo>
                  <a:pt x="2075" y="2"/>
                </a:lnTo>
                <a:lnTo>
                  <a:pt x="2075" y="2"/>
                </a:lnTo>
                <a:lnTo>
                  <a:pt x="2076" y="2"/>
                </a:lnTo>
                <a:lnTo>
                  <a:pt x="2077" y="2"/>
                </a:lnTo>
                <a:lnTo>
                  <a:pt x="2078" y="2"/>
                </a:lnTo>
                <a:lnTo>
                  <a:pt x="2079" y="1"/>
                </a:lnTo>
                <a:lnTo>
                  <a:pt x="2080" y="2"/>
                </a:lnTo>
                <a:lnTo>
                  <a:pt x="2081" y="1"/>
                </a:lnTo>
                <a:lnTo>
                  <a:pt x="2082" y="2"/>
                </a:lnTo>
                <a:lnTo>
                  <a:pt x="2083" y="1"/>
                </a:lnTo>
                <a:lnTo>
                  <a:pt x="2083" y="2"/>
                </a:lnTo>
                <a:lnTo>
                  <a:pt x="2084" y="1"/>
                </a:lnTo>
                <a:lnTo>
                  <a:pt x="2085" y="1"/>
                </a:lnTo>
                <a:lnTo>
                  <a:pt x="2086" y="1"/>
                </a:lnTo>
                <a:lnTo>
                  <a:pt x="2087" y="1"/>
                </a:lnTo>
                <a:lnTo>
                  <a:pt x="2088" y="2"/>
                </a:lnTo>
                <a:lnTo>
                  <a:pt x="2089" y="1"/>
                </a:lnTo>
                <a:lnTo>
                  <a:pt x="2090" y="1"/>
                </a:lnTo>
                <a:lnTo>
                  <a:pt x="2090" y="1"/>
                </a:lnTo>
                <a:lnTo>
                  <a:pt x="2091" y="1"/>
                </a:lnTo>
                <a:lnTo>
                  <a:pt x="2092" y="1"/>
                </a:lnTo>
                <a:lnTo>
                  <a:pt x="2093" y="2"/>
                </a:lnTo>
                <a:lnTo>
                  <a:pt x="2094" y="1"/>
                </a:lnTo>
                <a:lnTo>
                  <a:pt x="2095" y="1"/>
                </a:lnTo>
                <a:lnTo>
                  <a:pt x="2096" y="1"/>
                </a:lnTo>
                <a:lnTo>
                  <a:pt x="2097" y="1"/>
                </a:lnTo>
                <a:lnTo>
                  <a:pt x="2098" y="2"/>
                </a:lnTo>
                <a:lnTo>
                  <a:pt x="2098" y="1"/>
                </a:lnTo>
                <a:lnTo>
                  <a:pt x="2099" y="1"/>
                </a:lnTo>
                <a:lnTo>
                  <a:pt x="2100" y="1"/>
                </a:lnTo>
                <a:lnTo>
                  <a:pt x="2101" y="2"/>
                </a:lnTo>
                <a:lnTo>
                  <a:pt x="2102" y="1"/>
                </a:lnTo>
                <a:lnTo>
                  <a:pt x="2103" y="2"/>
                </a:lnTo>
                <a:lnTo>
                  <a:pt x="2104" y="2"/>
                </a:lnTo>
                <a:lnTo>
                  <a:pt x="2105" y="1"/>
                </a:lnTo>
                <a:lnTo>
                  <a:pt x="2105" y="1"/>
                </a:lnTo>
                <a:lnTo>
                  <a:pt x="2106" y="1"/>
                </a:lnTo>
                <a:lnTo>
                  <a:pt x="2107" y="2"/>
                </a:lnTo>
                <a:lnTo>
                  <a:pt x="2108" y="1"/>
                </a:lnTo>
                <a:lnTo>
                  <a:pt x="2109" y="1"/>
                </a:lnTo>
                <a:lnTo>
                  <a:pt x="2110" y="1"/>
                </a:lnTo>
                <a:lnTo>
                  <a:pt x="2111" y="1"/>
                </a:lnTo>
                <a:lnTo>
                  <a:pt x="2112" y="1"/>
                </a:lnTo>
                <a:lnTo>
                  <a:pt x="2113" y="0"/>
                </a:lnTo>
                <a:lnTo>
                  <a:pt x="2113" y="0"/>
                </a:lnTo>
                <a:lnTo>
                  <a:pt x="2114" y="1"/>
                </a:lnTo>
                <a:lnTo>
                  <a:pt x="2115" y="1"/>
                </a:lnTo>
                <a:lnTo>
                  <a:pt x="2116" y="1"/>
                </a:lnTo>
                <a:lnTo>
                  <a:pt x="2117" y="1"/>
                </a:lnTo>
                <a:lnTo>
                  <a:pt x="2118" y="1"/>
                </a:lnTo>
                <a:lnTo>
                  <a:pt x="2119" y="1"/>
                </a:lnTo>
                <a:lnTo>
                  <a:pt x="2120" y="1"/>
                </a:lnTo>
                <a:lnTo>
                  <a:pt x="2120" y="1"/>
                </a:lnTo>
                <a:lnTo>
                  <a:pt x="2121" y="1"/>
                </a:lnTo>
                <a:lnTo>
                  <a:pt x="2122" y="1"/>
                </a:lnTo>
                <a:lnTo>
                  <a:pt x="2123" y="2"/>
                </a:lnTo>
                <a:lnTo>
                  <a:pt x="2124" y="1"/>
                </a:lnTo>
                <a:lnTo>
                  <a:pt x="2125" y="1"/>
                </a:lnTo>
                <a:lnTo>
                  <a:pt x="2126" y="2"/>
                </a:lnTo>
                <a:lnTo>
                  <a:pt x="2127" y="2"/>
                </a:lnTo>
                <a:lnTo>
                  <a:pt x="2128" y="2"/>
                </a:lnTo>
                <a:lnTo>
                  <a:pt x="2128" y="2"/>
                </a:lnTo>
                <a:lnTo>
                  <a:pt x="2129" y="3"/>
                </a:lnTo>
                <a:lnTo>
                  <a:pt x="2130" y="3"/>
                </a:lnTo>
                <a:lnTo>
                  <a:pt x="2131" y="4"/>
                </a:lnTo>
                <a:lnTo>
                  <a:pt x="2132" y="4"/>
                </a:lnTo>
                <a:lnTo>
                  <a:pt x="2133" y="4"/>
                </a:lnTo>
                <a:lnTo>
                  <a:pt x="2134" y="5"/>
                </a:lnTo>
                <a:lnTo>
                  <a:pt x="2135" y="5"/>
                </a:lnTo>
                <a:lnTo>
                  <a:pt x="2135" y="5"/>
                </a:lnTo>
                <a:lnTo>
                  <a:pt x="2136" y="5"/>
                </a:lnTo>
                <a:lnTo>
                  <a:pt x="2137" y="5"/>
                </a:lnTo>
                <a:lnTo>
                  <a:pt x="2138" y="4"/>
                </a:lnTo>
                <a:lnTo>
                  <a:pt x="2139" y="3"/>
                </a:lnTo>
                <a:lnTo>
                  <a:pt x="2140" y="4"/>
                </a:lnTo>
                <a:lnTo>
                  <a:pt x="2141" y="3"/>
                </a:lnTo>
                <a:lnTo>
                  <a:pt x="2142" y="3"/>
                </a:lnTo>
                <a:lnTo>
                  <a:pt x="2143" y="2"/>
                </a:lnTo>
                <a:lnTo>
                  <a:pt x="2143" y="2"/>
                </a:lnTo>
                <a:lnTo>
                  <a:pt x="2144" y="1"/>
                </a:lnTo>
                <a:lnTo>
                  <a:pt x="2145" y="2"/>
                </a:lnTo>
                <a:lnTo>
                  <a:pt x="2146" y="0"/>
                </a:lnTo>
                <a:lnTo>
                  <a:pt x="2147" y="1"/>
                </a:lnTo>
                <a:lnTo>
                  <a:pt x="2148" y="1"/>
                </a:lnTo>
                <a:lnTo>
                  <a:pt x="2149" y="1"/>
                </a:lnTo>
                <a:lnTo>
                  <a:pt x="2150" y="1"/>
                </a:lnTo>
                <a:lnTo>
                  <a:pt x="2150" y="0"/>
                </a:lnTo>
                <a:lnTo>
                  <a:pt x="2151" y="0"/>
                </a:lnTo>
                <a:lnTo>
                  <a:pt x="2152" y="0"/>
                </a:lnTo>
                <a:lnTo>
                  <a:pt x="2153" y="1"/>
                </a:lnTo>
                <a:lnTo>
                  <a:pt x="2154" y="0"/>
                </a:lnTo>
                <a:lnTo>
                  <a:pt x="2155" y="1"/>
                </a:lnTo>
                <a:lnTo>
                  <a:pt x="2156" y="1"/>
                </a:lnTo>
                <a:lnTo>
                  <a:pt x="2157" y="1"/>
                </a:lnTo>
                <a:lnTo>
                  <a:pt x="2158" y="0"/>
                </a:lnTo>
                <a:lnTo>
                  <a:pt x="2158" y="1"/>
                </a:lnTo>
                <a:lnTo>
                  <a:pt x="2159" y="1"/>
                </a:lnTo>
                <a:lnTo>
                  <a:pt x="2160" y="1"/>
                </a:lnTo>
                <a:lnTo>
                  <a:pt x="2161" y="1"/>
                </a:lnTo>
                <a:lnTo>
                  <a:pt x="2162" y="1"/>
                </a:lnTo>
                <a:lnTo>
                  <a:pt x="2163" y="1"/>
                </a:lnTo>
                <a:lnTo>
                  <a:pt x="2164" y="1"/>
                </a:lnTo>
                <a:lnTo>
                  <a:pt x="2165" y="1"/>
                </a:lnTo>
                <a:lnTo>
                  <a:pt x="2165" y="1"/>
                </a:lnTo>
                <a:lnTo>
                  <a:pt x="2166" y="1"/>
                </a:lnTo>
                <a:lnTo>
                  <a:pt x="2167" y="1"/>
                </a:lnTo>
                <a:lnTo>
                  <a:pt x="2168" y="1"/>
                </a:lnTo>
                <a:lnTo>
                  <a:pt x="2169" y="1"/>
                </a:lnTo>
                <a:lnTo>
                  <a:pt x="2170" y="1"/>
                </a:lnTo>
                <a:lnTo>
                  <a:pt x="2171" y="1"/>
                </a:lnTo>
                <a:lnTo>
                  <a:pt x="2172" y="1"/>
                </a:lnTo>
                <a:lnTo>
                  <a:pt x="2173" y="1"/>
                </a:lnTo>
                <a:lnTo>
                  <a:pt x="2173" y="1"/>
                </a:lnTo>
                <a:lnTo>
                  <a:pt x="2174" y="1"/>
                </a:lnTo>
                <a:lnTo>
                  <a:pt x="2175" y="1"/>
                </a:lnTo>
                <a:lnTo>
                  <a:pt x="2176" y="1"/>
                </a:lnTo>
                <a:lnTo>
                  <a:pt x="2177" y="1"/>
                </a:lnTo>
                <a:lnTo>
                  <a:pt x="2178" y="2"/>
                </a:lnTo>
                <a:lnTo>
                  <a:pt x="2179" y="2"/>
                </a:lnTo>
                <a:lnTo>
                  <a:pt x="2180" y="1"/>
                </a:lnTo>
                <a:lnTo>
                  <a:pt x="2180" y="2"/>
                </a:lnTo>
                <a:lnTo>
                  <a:pt x="2181" y="1"/>
                </a:lnTo>
                <a:lnTo>
                  <a:pt x="2182" y="2"/>
                </a:lnTo>
                <a:lnTo>
                  <a:pt x="2183" y="2"/>
                </a:lnTo>
                <a:lnTo>
                  <a:pt x="2184" y="2"/>
                </a:lnTo>
                <a:lnTo>
                  <a:pt x="2185" y="2"/>
                </a:lnTo>
                <a:lnTo>
                  <a:pt x="2186" y="2"/>
                </a:lnTo>
                <a:lnTo>
                  <a:pt x="2187" y="2"/>
                </a:lnTo>
                <a:lnTo>
                  <a:pt x="2188" y="2"/>
                </a:lnTo>
                <a:lnTo>
                  <a:pt x="2188" y="2"/>
                </a:lnTo>
                <a:lnTo>
                  <a:pt x="2189" y="2"/>
                </a:lnTo>
                <a:lnTo>
                  <a:pt x="2190" y="2"/>
                </a:lnTo>
                <a:lnTo>
                  <a:pt x="2191" y="3"/>
                </a:lnTo>
                <a:lnTo>
                  <a:pt x="2192" y="3"/>
                </a:lnTo>
                <a:lnTo>
                  <a:pt x="2193" y="4"/>
                </a:lnTo>
                <a:lnTo>
                  <a:pt x="2194" y="4"/>
                </a:lnTo>
                <a:lnTo>
                  <a:pt x="2195" y="4"/>
                </a:lnTo>
                <a:lnTo>
                  <a:pt x="2195" y="4"/>
                </a:lnTo>
                <a:lnTo>
                  <a:pt x="2196" y="3"/>
                </a:lnTo>
                <a:lnTo>
                  <a:pt x="2197" y="3"/>
                </a:lnTo>
                <a:lnTo>
                  <a:pt x="2198" y="4"/>
                </a:lnTo>
                <a:lnTo>
                  <a:pt x="2199" y="3"/>
                </a:lnTo>
                <a:lnTo>
                  <a:pt x="2200" y="3"/>
                </a:lnTo>
                <a:lnTo>
                  <a:pt x="2201" y="3"/>
                </a:lnTo>
                <a:lnTo>
                  <a:pt x="2202" y="3"/>
                </a:lnTo>
                <a:lnTo>
                  <a:pt x="2203" y="3"/>
                </a:lnTo>
                <a:lnTo>
                  <a:pt x="2203" y="3"/>
                </a:lnTo>
                <a:lnTo>
                  <a:pt x="2204" y="3"/>
                </a:lnTo>
                <a:lnTo>
                  <a:pt x="2205" y="3"/>
                </a:lnTo>
                <a:lnTo>
                  <a:pt x="2206" y="3"/>
                </a:lnTo>
                <a:lnTo>
                  <a:pt x="2207" y="2"/>
                </a:lnTo>
                <a:lnTo>
                  <a:pt x="2208" y="3"/>
                </a:lnTo>
                <a:lnTo>
                  <a:pt x="2209" y="2"/>
                </a:lnTo>
                <a:lnTo>
                  <a:pt x="2210" y="3"/>
                </a:lnTo>
                <a:lnTo>
                  <a:pt x="2210" y="2"/>
                </a:lnTo>
                <a:lnTo>
                  <a:pt x="2211" y="2"/>
                </a:lnTo>
                <a:lnTo>
                  <a:pt x="2212" y="1"/>
                </a:lnTo>
                <a:lnTo>
                  <a:pt x="2213" y="2"/>
                </a:lnTo>
                <a:lnTo>
                  <a:pt x="2214" y="2"/>
                </a:lnTo>
                <a:lnTo>
                  <a:pt x="2215" y="1"/>
                </a:lnTo>
                <a:lnTo>
                  <a:pt x="2216" y="1"/>
                </a:lnTo>
                <a:lnTo>
                  <a:pt x="2217" y="1"/>
                </a:lnTo>
                <a:lnTo>
                  <a:pt x="2217" y="1"/>
                </a:lnTo>
                <a:lnTo>
                  <a:pt x="2218" y="1"/>
                </a:lnTo>
                <a:lnTo>
                  <a:pt x="2219" y="1"/>
                </a:lnTo>
                <a:lnTo>
                  <a:pt x="2220" y="1"/>
                </a:lnTo>
                <a:lnTo>
                  <a:pt x="2221" y="1"/>
                </a:lnTo>
                <a:lnTo>
                  <a:pt x="2222" y="1"/>
                </a:lnTo>
                <a:lnTo>
                  <a:pt x="2223" y="0"/>
                </a:lnTo>
                <a:lnTo>
                  <a:pt x="2224" y="1"/>
                </a:lnTo>
                <a:lnTo>
                  <a:pt x="2225" y="1"/>
                </a:lnTo>
                <a:lnTo>
                  <a:pt x="2225" y="0"/>
                </a:lnTo>
                <a:lnTo>
                  <a:pt x="2226" y="0"/>
                </a:lnTo>
                <a:lnTo>
                  <a:pt x="2227" y="1"/>
                </a:lnTo>
                <a:lnTo>
                  <a:pt x="2228" y="1"/>
                </a:lnTo>
                <a:lnTo>
                  <a:pt x="2229" y="1"/>
                </a:lnTo>
                <a:lnTo>
                  <a:pt x="2230" y="1"/>
                </a:lnTo>
                <a:lnTo>
                  <a:pt x="2231" y="1"/>
                </a:lnTo>
                <a:lnTo>
                  <a:pt x="2232" y="1"/>
                </a:lnTo>
                <a:lnTo>
                  <a:pt x="2232" y="1"/>
                </a:lnTo>
                <a:lnTo>
                  <a:pt x="2233" y="1"/>
                </a:lnTo>
                <a:lnTo>
                  <a:pt x="2234" y="2"/>
                </a:lnTo>
                <a:lnTo>
                  <a:pt x="2235" y="2"/>
                </a:lnTo>
                <a:lnTo>
                  <a:pt x="2236" y="3"/>
                </a:lnTo>
                <a:lnTo>
                  <a:pt x="2237" y="2"/>
                </a:lnTo>
                <a:lnTo>
                  <a:pt x="2238" y="2"/>
                </a:lnTo>
                <a:lnTo>
                  <a:pt x="2239" y="2"/>
                </a:lnTo>
                <a:lnTo>
                  <a:pt x="2240" y="2"/>
                </a:lnTo>
                <a:lnTo>
                  <a:pt x="2240" y="2"/>
                </a:lnTo>
                <a:lnTo>
                  <a:pt x="2241" y="3"/>
                </a:lnTo>
                <a:lnTo>
                  <a:pt x="2242" y="2"/>
                </a:lnTo>
                <a:lnTo>
                  <a:pt x="2243" y="2"/>
                </a:lnTo>
                <a:lnTo>
                  <a:pt x="2244" y="1"/>
                </a:lnTo>
                <a:lnTo>
                  <a:pt x="2245" y="2"/>
                </a:lnTo>
                <a:lnTo>
                  <a:pt x="2246" y="2"/>
                </a:lnTo>
                <a:lnTo>
                  <a:pt x="2247" y="2"/>
                </a:lnTo>
                <a:lnTo>
                  <a:pt x="2247" y="2"/>
                </a:lnTo>
                <a:lnTo>
                  <a:pt x="2248" y="2"/>
                </a:lnTo>
                <a:lnTo>
                  <a:pt x="2249" y="2"/>
                </a:lnTo>
                <a:lnTo>
                  <a:pt x="2250" y="1"/>
                </a:lnTo>
                <a:lnTo>
                  <a:pt x="2251" y="2"/>
                </a:lnTo>
                <a:lnTo>
                  <a:pt x="2252" y="1"/>
                </a:lnTo>
                <a:lnTo>
                  <a:pt x="2253" y="2"/>
                </a:lnTo>
                <a:lnTo>
                  <a:pt x="2254" y="1"/>
                </a:lnTo>
                <a:lnTo>
                  <a:pt x="2255" y="1"/>
                </a:lnTo>
                <a:lnTo>
                  <a:pt x="2255" y="1"/>
                </a:lnTo>
                <a:lnTo>
                  <a:pt x="2256" y="1"/>
                </a:lnTo>
                <a:lnTo>
                  <a:pt x="2257" y="1"/>
                </a:lnTo>
                <a:lnTo>
                  <a:pt x="2258" y="1"/>
                </a:lnTo>
                <a:lnTo>
                  <a:pt x="2259" y="1"/>
                </a:lnTo>
                <a:lnTo>
                  <a:pt x="2260" y="1"/>
                </a:lnTo>
                <a:lnTo>
                  <a:pt x="2261" y="1"/>
                </a:lnTo>
                <a:lnTo>
                  <a:pt x="2262" y="1"/>
                </a:lnTo>
                <a:lnTo>
                  <a:pt x="2262" y="0"/>
                </a:lnTo>
                <a:lnTo>
                  <a:pt x="2263" y="0"/>
                </a:lnTo>
                <a:lnTo>
                  <a:pt x="2264" y="1"/>
                </a:lnTo>
                <a:lnTo>
                  <a:pt x="2265" y="0"/>
                </a:lnTo>
                <a:lnTo>
                  <a:pt x="2266" y="1"/>
                </a:lnTo>
                <a:lnTo>
                  <a:pt x="2267" y="0"/>
                </a:lnTo>
                <a:lnTo>
                  <a:pt x="2268" y="1"/>
                </a:lnTo>
                <a:lnTo>
                  <a:pt x="2269" y="1"/>
                </a:lnTo>
                <a:lnTo>
                  <a:pt x="2270" y="1"/>
                </a:lnTo>
                <a:lnTo>
                  <a:pt x="2270" y="2"/>
                </a:lnTo>
                <a:lnTo>
                  <a:pt x="2271" y="2"/>
                </a:lnTo>
                <a:lnTo>
                  <a:pt x="2272" y="2"/>
                </a:lnTo>
                <a:lnTo>
                  <a:pt x="2273" y="2"/>
                </a:lnTo>
                <a:lnTo>
                  <a:pt x="2274" y="1"/>
                </a:lnTo>
                <a:lnTo>
                  <a:pt x="2275" y="1"/>
                </a:lnTo>
                <a:lnTo>
                  <a:pt x="2276" y="2"/>
                </a:lnTo>
                <a:lnTo>
                  <a:pt x="2277" y="1"/>
                </a:lnTo>
                <a:lnTo>
                  <a:pt x="2277" y="1"/>
                </a:lnTo>
                <a:lnTo>
                  <a:pt x="2278" y="1"/>
                </a:lnTo>
                <a:lnTo>
                  <a:pt x="2279" y="1"/>
                </a:lnTo>
                <a:lnTo>
                  <a:pt x="2280" y="2"/>
                </a:lnTo>
                <a:lnTo>
                  <a:pt x="2281" y="2"/>
                </a:lnTo>
                <a:lnTo>
                  <a:pt x="2282" y="5"/>
                </a:lnTo>
                <a:lnTo>
                  <a:pt x="2283" y="7"/>
                </a:lnTo>
                <a:lnTo>
                  <a:pt x="2284" y="15"/>
                </a:lnTo>
                <a:lnTo>
                  <a:pt x="2285" y="27"/>
                </a:lnTo>
                <a:lnTo>
                  <a:pt x="2285" y="53"/>
                </a:lnTo>
                <a:lnTo>
                  <a:pt x="2286" y="91"/>
                </a:lnTo>
                <a:lnTo>
                  <a:pt x="2287" y="151"/>
                </a:lnTo>
                <a:lnTo>
                  <a:pt x="2288" y="241"/>
                </a:lnTo>
                <a:lnTo>
                  <a:pt x="2289" y="358"/>
                </a:lnTo>
                <a:lnTo>
                  <a:pt x="2290" y="499"/>
                </a:lnTo>
                <a:lnTo>
                  <a:pt x="2291" y="662"/>
                </a:lnTo>
                <a:lnTo>
                  <a:pt x="2292" y="843"/>
                </a:lnTo>
                <a:lnTo>
                  <a:pt x="2292" y="1017"/>
                </a:lnTo>
                <a:lnTo>
                  <a:pt x="2293" y="1177"/>
                </a:lnTo>
                <a:lnTo>
                  <a:pt x="2294" y="1311"/>
                </a:lnTo>
                <a:lnTo>
                  <a:pt x="2295" y="1342"/>
                </a:lnTo>
                <a:lnTo>
                  <a:pt x="2296" y="1364"/>
                </a:lnTo>
                <a:lnTo>
                  <a:pt x="2297" y="1330"/>
                </a:lnTo>
                <a:lnTo>
                  <a:pt x="2298" y="1217"/>
                </a:lnTo>
                <a:lnTo>
                  <a:pt x="2299" y="1012"/>
                </a:lnTo>
                <a:lnTo>
                  <a:pt x="2300" y="805"/>
                </a:lnTo>
                <a:lnTo>
                  <a:pt x="2300" y="623"/>
                </a:lnTo>
                <a:lnTo>
                  <a:pt x="2301" y="474"/>
                </a:lnTo>
                <a:lnTo>
                  <a:pt x="2302" y="341"/>
                </a:lnTo>
                <a:lnTo>
                  <a:pt x="2303" y="271"/>
                </a:lnTo>
                <a:lnTo>
                  <a:pt x="2304" y="207"/>
                </a:lnTo>
                <a:lnTo>
                  <a:pt x="2305" y="170"/>
                </a:lnTo>
                <a:lnTo>
                  <a:pt x="2306" y="147"/>
                </a:lnTo>
                <a:lnTo>
                  <a:pt x="2307" y="128"/>
                </a:lnTo>
                <a:lnTo>
                  <a:pt x="2307" y="114"/>
                </a:lnTo>
                <a:lnTo>
                  <a:pt x="2308" y="101"/>
                </a:lnTo>
                <a:lnTo>
                  <a:pt x="2309" y="89"/>
                </a:lnTo>
                <a:lnTo>
                  <a:pt x="2310" y="78"/>
                </a:lnTo>
                <a:lnTo>
                  <a:pt x="2311" y="73"/>
                </a:lnTo>
                <a:lnTo>
                  <a:pt x="2312" y="67"/>
                </a:lnTo>
                <a:lnTo>
                  <a:pt x="2313" y="64"/>
                </a:lnTo>
                <a:lnTo>
                  <a:pt x="2314" y="60"/>
                </a:lnTo>
                <a:lnTo>
                  <a:pt x="2315" y="54"/>
                </a:lnTo>
                <a:lnTo>
                  <a:pt x="2315" y="50"/>
                </a:lnTo>
                <a:lnTo>
                  <a:pt x="2316" y="50"/>
                </a:lnTo>
                <a:lnTo>
                  <a:pt x="2317" y="47"/>
                </a:lnTo>
                <a:lnTo>
                  <a:pt x="2318" y="47"/>
                </a:lnTo>
                <a:lnTo>
                  <a:pt x="2319" y="44"/>
                </a:lnTo>
                <a:lnTo>
                  <a:pt x="2320" y="42"/>
                </a:lnTo>
                <a:lnTo>
                  <a:pt x="2321" y="41"/>
                </a:lnTo>
                <a:lnTo>
                  <a:pt x="2322" y="39"/>
                </a:lnTo>
                <a:lnTo>
                  <a:pt x="2322" y="40"/>
                </a:lnTo>
                <a:lnTo>
                  <a:pt x="2323" y="36"/>
                </a:lnTo>
                <a:lnTo>
                  <a:pt x="2324" y="33"/>
                </a:lnTo>
                <a:lnTo>
                  <a:pt x="2325" y="36"/>
                </a:lnTo>
                <a:lnTo>
                  <a:pt x="2326" y="33"/>
                </a:lnTo>
                <a:lnTo>
                  <a:pt x="2327" y="33"/>
                </a:lnTo>
                <a:lnTo>
                  <a:pt x="2328" y="32"/>
                </a:lnTo>
                <a:lnTo>
                  <a:pt x="2329" y="30"/>
                </a:lnTo>
                <a:lnTo>
                  <a:pt x="2330" y="28"/>
                </a:lnTo>
                <a:lnTo>
                  <a:pt x="2330" y="28"/>
                </a:lnTo>
                <a:lnTo>
                  <a:pt x="2331" y="25"/>
                </a:lnTo>
                <a:lnTo>
                  <a:pt x="2332" y="24"/>
                </a:lnTo>
                <a:lnTo>
                  <a:pt x="2333" y="25"/>
                </a:lnTo>
                <a:lnTo>
                  <a:pt x="2334" y="23"/>
                </a:lnTo>
                <a:lnTo>
                  <a:pt x="2335" y="22"/>
                </a:lnTo>
                <a:lnTo>
                  <a:pt x="2336" y="22"/>
                </a:lnTo>
                <a:lnTo>
                  <a:pt x="2337" y="21"/>
                </a:lnTo>
                <a:lnTo>
                  <a:pt x="2337" y="19"/>
                </a:lnTo>
                <a:lnTo>
                  <a:pt x="2338" y="21"/>
                </a:lnTo>
                <a:lnTo>
                  <a:pt x="2339" y="20"/>
                </a:lnTo>
                <a:lnTo>
                  <a:pt x="2340" y="19"/>
                </a:lnTo>
                <a:lnTo>
                  <a:pt x="2341" y="19"/>
                </a:lnTo>
                <a:lnTo>
                  <a:pt x="2342" y="20"/>
                </a:lnTo>
                <a:lnTo>
                  <a:pt x="2343" y="18"/>
                </a:lnTo>
                <a:lnTo>
                  <a:pt x="2344" y="18"/>
                </a:lnTo>
                <a:lnTo>
                  <a:pt x="2345" y="17"/>
                </a:lnTo>
                <a:lnTo>
                  <a:pt x="2345" y="17"/>
                </a:lnTo>
                <a:lnTo>
                  <a:pt x="2346" y="17"/>
                </a:lnTo>
                <a:lnTo>
                  <a:pt x="2347" y="15"/>
                </a:lnTo>
                <a:lnTo>
                  <a:pt x="2348" y="16"/>
                </a:lnTo>
                <a:lnTo>
                  <a:pt x="2349" y="16"/>
                </a:lnTo>
                <a:lnTo>
                  <a:pt x="2350" y="16"/>
                </a:lnTo>
                <a:lnTo>
                  <a:pt x="2351" y="14"/>
                </a:lnTo>
                <a:lnTo>
                  <a:pt x="2352" y="13"/>
                </a:lnTo>
                <a:lnTo>
                  <a:pt x="2352" y="12"/>
                </a:lnTo>
                <a:lnTo>
                  <a:pt x="2353" y="13"/>
                </a:lnTo>
                <a:lnTo>
                  <a:pt x="2354" y="12"/>
                </a:lnTo>
                <a:lnTo>
                  <a:pt x="2355" y="12"/>
                </a:lnTo>
                <a:lnTo>
                  <a:pt x="2356" y="12"/>
                </a:lnTo>
                <a:lnTo>
                  <a:pt x="2357" y="12"/>
                </a:lnTo>
                <a:lnTo>
                  <a:pt x="2358" y="11"/>
                </a:lnTo>
                <a:lnTo>
                  <a:pt x="2359" y="10"/>
                </a:lnTo>
                <a:lnTo>
                  <a:pt x="2360" y="10"/>
                </a:lnTo>
                <a:lnTo>
                  <a:pt x="2360" y="10"/>
                </a:lnTo>
                <a:lnTo>
                  <a:pt x="2361" y="10"/>
                </a:lnTo>
                <a:lnTo>
                  <a:pt x="2362" y="10"/>
                </a:lnTo>
                <a:lnTo>
                  <a:pt x="2363" y="10"/>
                </a:lnTo>
                <a:lnTo>
                  <a:pt x="2364" y="10"/>
                </a:lnTo>
                <a:lnTo>
                  <a:pt x="2365" y="9"/>
                </a:lnTo>
                <a:lnTo>
                  <a:pt x="2366" y="8"/>
                </a:lnTo>
                <a:lnTo>
                  <a:pt x="2367" y="8"/>
                </a:lnTo>
                <a:lnTo>
                  <a:pt x="2367" y="8"/>
                </a:lnTo>
                <a:lnTo>
                  <a:pt x="2368" y="8"/>
                </a:lnTo>
                <a:lnTo>
                  <a:pt x="2369" y="8"/>
                </a:lnTo>
                <a:lnTo>
                  <a:pt x="2370" y="8"/>
                </a:lnTo>
                <a:lnTo>
                  <a:pt x="2371" y="7"/>
                </a:lnTo>
                <a:lnTo>
                  <a:pt x="2372" y="9"/>
                </a:lnTo>
                <a:lnTo>
                  <a:pt x="2373" y="10"/>
                </a:lnTo>
                <a:lnTo>
                  <a:pt x="2374" y="9"/>
                </a:lnTo>
                <a:lnTo>
                  <a:pt x="2375" y="11"/>
                </a:lnTo>
                <a:lnTo>
                  <a:pt x="2375" y="10"/>
                </a:lnTo>
                <a:lnTo>
                  <a:pt x="2376" y="10"/>
                </a:lnTo>
                <a:lnTo>
                  <a:pt x="2377" y="11"/>
                </a:lnTo>
                <a:lnTo>
                  <a:pt x="2378" y="11"/>
                </a:lnTo>
                <a:lnTo>
                  <a:pt x="2379" y="10"/>
                </a:lnTo>
                <a:lnTo>
                  <a:pt x="2380" y="10"/>
                </a:lnTo>
                <a:lnTo>
                  <a:pt x="2381" y="9"/>
                </a:lnTo>
                <a:lnTo>
                  <a:pt x="2382" y="8"/>
                </a:lnTo>
                <a:lnTo>
                  <a:pt x="2382" y="8"/>
                </a:lnTo>
                <a:lnTo>
                  <a:pt x="2383" y="8"/>
                </a:lnTo>
                <a:lnTo>
                  <a:pt x="2384" y="7"/>
                </a:lnTo>
                <a:lnTo>
                  <a:pt x="2385" y="6"/>
                </a:lnTo>
                <a:lnTo>
                  <a:pt x="2386" y="6"/>
                </a:lnTo>
                <a:lnTo>
                  <a:pt x="2387" y="5"/>
                </a:lnTo>
                <a:lnTo>
                  <a:pt x="2388" y="5"/>
                </a:lnTo>
                <a:lnTo>
                  <a:pt x="2389" y="5"/>
                </a:lnTo>
                <a:lnTo>
                  <a:pt x="2390" y="6"/>
                </a:lnTo>
                <a:lnTo>
                  <a:pt x="2390" y="4"/>
                </a:lnTo>
                <a:lnTo>
                  <a:pt x="2391" y="5"/>
                </a:lnTo>
                <a:lnTo>
                  <a:pt x="2392" y="5"/>
                </a:lnTo>
                <a:lnTo>
                  <a:pt x="2393" y="4"/>
                </a:lnTo>
                <a:lnTo>
                  <a:pt x="2394" y="5"/>
                </a:lnTo>
                <a:lnTo>
                  <a:pt x="2395" y="5"/>
                </a:lnTo>
                <a:lnTo>
                  <a:pt x="2396" y="5"/>
                </a:lnTo>
                <a:lnTo>
                  <a:pt x="2397" y="5"/>
                </a:lnTo>
                <a:lnTo>
                  <a:pt x="2397" y="5"/>
                </a:lnTo>
                <a:lnTo>
                  <a:pt x="2398" y="6"/>
                </a:lnTo>
                <a:lnTo>
                  <a:pt x="2399" y="6"/>
                </a:lnTo>
                <a:lnTo>
                  <a:pt x="2400" y="7"/>
                </a:lnTo>
                <a:lnTo>
                  <a:pt x="2401" y="7"/>
                </a:lnTo>
                <a:lnTo>
                  <a:pt x="2402" y="8"/>
                </a:lnTo>
                <a:lnTo>
                  <a:pt x="2403" y="7"/>
                </a:lnTo>
                <a:lnTo>
                  <a:pt x="2404" y="7"/>
                </a:lnTo>
                <a:lnTo>
                  <a:pt x="2405" y="6"/>
                </a:lnTo>
                <a:lnTo>
                  <a:pt x="2405" y="7"/>
                </a:lnTo>
                <a:lnTo>
                  <a:pt x="2406" y="6"/>
                </a:lnTo>
                <a:lnTo>
                  <a:pt x="2407" y="6"/>
                </a:lnTo>
                <a:lnTo>
                  <a:pt x="2408" y="5"/>
                </a:lnTo>
                <a:lnTo>
                  <a:pt x="2409" y="5"/>
                </a:lnTo>
                <a:lnTo>
                  <a:pt x="2410" y="4"/>
                </a:lnTo>
                <a:lnTo>
                  <a:pt x="2411" y="4"/>
                </a:lnTo>
                <a:lnTo>
                  <a:pt x="2412" y="3"/>
                </a:lnTo>
                <a:lnTo>
                  <a:pt x="2412" y="4"/>
                </a:lnTo>
                <a:lnTo>
                  <a:pt x="2413" y="4"/>
                </a:lnTo>
                <a:lnTo>
                  <a:pt x="2414" y="4"/>
                </a:lnTo>
                <a:lnTo>
                  <a:pt x="2415" y="3"/>
                </a:lnTo>
                <a:lnTo>
                  <a:pt x="2416" y="4"/>
                </a:lnTo>
                <a:lnTo>
                  <a:pt x="2417" y="2"/>
                </a:lnTo>
                <a:lnTo>
                  <a:pt x="2418" y="2"/>
                </a:lnTo>
                <a:lnTo>
                  <a:pt x="2419" y="3"/>
                </a:lnTo>
                <a:lnTo>
                  <a:pt x="2419" y="3"/>
                </a:lnTo>
                <a:lnTo>
                  <a:pt x="2420" y="2"/>
                </a:lnTo>
                <a:lnTo>
                  <a:pt x="2421" y="4"/>
                </a:lnTo>
                <a:lnTo>
                  <a:pt x="2422" y="4"/>
                </a:lnTo>
                <a:lnTo>
                  <a:pt x="2423" y="4"/>
                </a:lnTo>
                <a:lnTo>
                  <a:pt x="2424" y="4"/>
                </a:lnTo>
                <a:lnTo>
                  <a:pt x="2425" y="3"/>
                </a:lnTo>
                <a:lnTo>
                  <a:pt x="2426" y="5"/>
                </a:lnTo>
                <a:lnTo>
                  <a:pt x="2427" y="4"/>
                </a:lnTo>
                <a:lnTo>
                  <a:pt x="2427" y="5"/>
                </a:lnTo>
                <a:lnTo>
                  <a:pt x="2428" y="4"/>
                </a:lnTo>
                <a:lnTo>
                  <a:pt x="2429" y="4"/>
                </a:lnTo>
                <a:lnTo>
                  <a:pt x="2430" y="3"/>
                </a:lnTo>
                <a:lnTo>
                  <a:pt x="2431" y="3"/>
                </a:lnTo>
                <a:lnTo>
                  <a:pt x="2432" y="4"/>
                </a:lnTo>
                <a:lnTo>
                  <a:pt x="2433" y="2"/>
                </a:lnTo>
                <a:lnTo>
                  <a:pt x="2434" y="3"/>
                </a:lnTo>
                <a:lnTo>
                  <a:pt x="2434" y="3"/>
                </a:lnTo>
                <a:lnTo>
                  <a:pt x="2435" y="3"/>
                </a:lnTo>
                <a:lnTo>
                  <a:pt x="2436" y="3"/>
                </a:lnTo>
                <a:lnTo>
                  <a:pt x="2437" y="2"/>
                </a:lnTo>
                <a:lnTo>
                  <a:pt x="2438" y="2"/>
                </a:lnTo>
                <a:lnTo>
                  <a:pt x="2439" y="2"/>
                </a:lnTo>
                <a:lnTo>
                  <a:pt x="2440" y="2"/>
                </a:lnTo>
                <a:lnTo>
                  <a:pt x="2441" y="2"/>
                </a:lnTo>
                <a:lnTo>
                  <a:pt x="2442" y="2"/>
                </a:lnTo>
                <a:lnTo>
                  <a:pt x="2442" y="2"/>
                </a:lnTo>
                <a:lnTo>
                  <a:pt x="2443" y="1"/>
                </a:lnTo>
                <a:lnTo>
                  <a:pt x="2444" y="2"/>
                </a:lnTo>
                <a:lnTo>
                  <a:pt x="2445" y="2"/>
                </a:lnTo>
                <a:lnTo>
                  <a:pt x="2446" y="2"/>
                </a:lnTo>
                <a:lnTo>
                  <a:pt x="2447" y="1"/>
                </a:lnTo>
                <a:lnTo>
                  <a:pt x="2448" y="1"/>
                </a:lnTo>
                <a:lnTo>
                  <a:pt x="2449" y="2"/>
                </a:lnTo>
                <a:lnTo>
                  <a:pt x="2449" y="3"/>
                </a:lnTo>
                <a:lnTo>
                  <a:pt x="2450" y="2"/>
                </a:lnTo>
                <a:lnTo>
                  <a:pt x="2451" y="2"/>
                </a:lnTo>
                <a:lnTo>
                  <a:pt x="2452" y="2"/>
                </a:lnTo>
                <a:lnTo>
                  <a:pt x="2453" y="3"/>
                </a:lnTo>
                <a:lnTo>
                  <a:pt x="2454" y="2"/>
                </a:lnTo>
                <a:lnTo>
                  <a:pt x="2455" y="3"/>
                </a:lnTo>
                <a:lnTo>
                  <a:pt x="2456" y="3"/>
                </a:lnTo>
                <a:lnTo>
                  <a:pt x="2457" y="3"/>
                </a:lnTo>
                <a:lnTo>
                  <a:pt x="2457" y="5"/>
                </a:lnTo>
                <a:lnTo>
                  <a:pt x="2458" y="4"/>
                </a:lnTo>
                <a:lnTo>
                  <a:pt x="2459" y="4"/>
                </a:lnTo>
                <a:lnTo>
                  <a:pt x="2460" y="6"/>
                </a:lnTo>
                <a:lnTo>
                  <a:pt x="2461" y="6"/>
                </a:lnTo>
                <a:lnTo>
                  <a:pt x="2462" y="6"/>
                </a:lnTo>
                <a:lnTo>
                  <a:pt x="2463" y="7"/>
                </a:lnTo>
                <a:lnTo>
                  <a:pt x="2464" y="7"/>
                </a:lnTo>
                <a:lnTo>
                  <a:pt x="2464" y="5"/>
                </a:lnTo>
                <a:lnTo>
                  <a:pt x="2465" y="4"/>
                </a:lnTo>
                <a:lnTo>
                  <a:pt x="2466" y="5"/>
                </a:lnTo>
                <a:lnTo>
                  <a:pt x="2467" y="4"/>
                </a:lnTo>
                <a:lnTo>
                  <a:pt x="2468" y="4"/>
                </a:lnTo>
                <a:lnTo>
                  <a:pt x="2469" y="4"/>
                </a:lnTo>
                <a:lnTo>
                  <a:pt x="2470" y="3"/>
                </a:lnTo>
                <a:lnTo>
                  <a:pt x="2471" y="3"/>
                </a:lnTo>
                <a:lnTo>
                  <a:pt x="2472" y="3"/>
                </a:lnTo>
                <a:lnTo>
                  <a:pt x="2472" y="3"/>
                </a:lnTo>
                <a:lnTo>
                  <a:pt x="2473" y="4"/>
                </a:lnTo>
                <a:lnTo>
                  <a:pt x="2474" y="3"/>
                </a:lnTo>
                <a:lnTo>
                  <a:pt x="2475" y="3"/>
                </a:lnTo>
                <a:lnTo>
                  <a:pt x="2476" y="2"/>
                </a:lnTo>
                <a:lnTo>
                  <a:pt x="2477" y="2"/>
                </a:lnTo>
                <a:lnTo>
                  <a:pt x="2478" y="3"/>
                </a:lnTo>
                <a:lnTo>
                  <a:pt x="2479" y="3"/>
                </a:lnTo>
                <a:lnTo>
                  <a:pt x="2479" y="3"/>
                </a:lnTo>
                <a:lnTo>
                  <a:pt x="2480" y="2"/>
                </a:lnTo>
                <a:lnTo>
                  <a:pt x="2481" y="2"/>
                </a:lnTo>
                <a:lnTo>
                  <a:pt x="2482" y="2"/>
                </a:lnTo>
                <a:lnTo>
                  <a:pt x="2483" y="2"/>
                </a:lnTo>
                <a:lnTo>
                  <a:pt x="2484" y="2"/>
                </a:lnTo>
                <a:lnTo>
                  <a:pt x="2485" y="2"/>
                </a:lnTo>
                <a:lnTo>
                  <a:pt x="2486" y="1"/>
                </a:lnTo>
                <a:lnTo>
                  <a:pt x="2487" y="1"/>
                </a:lnTo>
                <a:lnTo>
                  <a:pt x="2487" y="2"/>
                </a:lnTo>
                <a:lnTo>
                  <a:pt x="2488" y="1"/>
                </a:lnTo>
                <a:lnTo>
                  <a:pt x="2489" y="1"/>
                </a:lnTo>
                <a:lnTo>
                  <a:pt x="2490" y="1"/>
                </a:lnTo>
                <a:lnTo>
                  <a:pt x="2491" y="1"/>
                </a:lnTo>
                <a:lnTo>
                  <a:pt x="2492" y="1"/>
                </a:lnTo>
                <a:lnTo>
                  <a:pt x="2493" y="2"/>
                </a:lnTo>
                <a:lnTo>
                  <a:pt x="2494" y="2"/>
                </a:lnTo>
                <a:lnTo>
                  <a:pt x="2494" y="3"/>
                </a:lnTo>
                <a:lnTo>
                  <a:pt x="2495" y="4"/>
                </a:lnTo>
                <a:lnTo>
                  <a:pt x="2496" y="7"/>
                </a:lnTo>
                <a:lnTo>
                  <a:pt x="2497" y="10"/>
                </a:lnTo>
                <a:lnTo>
                  <a:pt x="2498" y="12"/>
                </a:lnTo>
                <a:lnTo>
                  <a:pt x="2499" y="15"/>
                </a:lnTo>
                <a:lnTo>
                  <a:pt x="2500" y="19"/>
                </a:lnTo>
                <a:lnTo>
                  <a:pt x="2501" y="20"/>
                </a:lnTo>
                <a:lnTo>
                  <a:pt x="2502" y="22"/>
                </a:lnTo>
                <a:lnTo>
                  <a:pt x="2502" y="23"/>
                </a:lnTo>
                <a:lnTo>
                  <a:pt x="2503" y="23"/>
                </a:lnTo>
                <a:lnTo>
                  <a:pt x="2504" y="22"/>
                </a:lnTo>
                <a:lnTo>
                  <a:pt x="2505" y="19"/>
                </a:lnTo>
                <a:lnTo>
                  <a:pt x="2506" y="18"/>
                </a:lnTo>
                <a:lnTo>
                  <a:pt x="2507" y="15"/>
                </a:lnTo>
                <a:lnTo>
                  <a:pt x="2508" y="14"/>
                </a:lnTo>
                <a:lnTo>
                  <a:pt x="2509" y="11"/>
                </a:lnTo>
                <a:lnTo>
                  <a:pt x="2509" y="11"/>
                </a:lnTo>
                <a:lnTo>
                  <a:pt x="2510" y="9"/>
                </a:lnTo>
                <a:lnTo>
                  <a:pt x="2511" y="9"/>
                </a:lnTo>
                <a:lnTo>
                  <a:pt x="2512" y="9"/>
                </a:lnTo>
                <a:lnTo>
                  <a:pt x="2513" y="7"/>
                </a:lnTo>
                <a:lnTo>
                  <a:pt x="2514" y="6"/>
                </a:lnTo>
                <a:lnTo>
                  <a:pt x="2515" y="8"/>
                </a:lnTo>
                <a:lnTo>
                  <a:pt x="2516" y="8"/>
                </a:lnTo>
                <a:lnTo>
                  <a:pt x="2517" y="8"/>
                </a:lnTo>
                <a:lnTo>
                  <a:pt x="2517" y="7"/>
                </a:lnTo>
                <a:lnTo>
                  <a:pt x="2518" y="7"/>
                </a:lnTo>
                <a:lnTo>
                  <a:pt x="2519" y="7"/>
                </a:lnTo>
                <a:lnTo>
                  <a:pt x="2520" y="7"/>
                </a:lnTo>
                <a:lnTo>
                  <a:pt x="2521" y="6"/>
                </a:lnTo>
                <a:lnTo>
                  <a:pt x="2522" y="6"/>
                </a:lnTo>
                <a:lnTo>
                  <a:pt x="2523" y="6"/>
                </a:lnTo>
                <a:lnTo>
                  <a:pt x="2524" y="5"/>
                </a:lnTo>
                <a:lnTo>
                  <a:pt x="2524" y="5"/>
                </a:lnTo>
                <a:lnTo>
                  <a:pt x="2525" y="5"/>
                </a:lnTo>
                <a:lnTo>
                  <a:pt x="2526" y="5"/>
                </a:lnTo>
                <a:lnTo>
                  <a:pt x="2527" y="5"/>
                </a:lnTo>
                <a:lnTo>
                  <a:pt x="2528" y="5"/>
                </a:lnTo>
                <a:lnTo>
                  <a:pt x="2529" y="5"/>
                </a:lnTo>
                <a:lnTo>
                  <a:pt x="2530" y="4"/>
                </a:lnTo>
                <a:lnTo>
                  <a:pt x="2531" y="5"/>
                </a:lnTo>
                <a:lnTo>
                  <a:pt x="2532" y="4"/>
                </a:lnTo>
                <a:lnTo>
                  <a:pt x="2532" y="5"/>
                </a:lnTo>
                <a:lnTo>
                  <a:pt x="2533" y="4"/>
                </a:lnTo>
                <a:lnTo>
                  <a:pt x="2534" y="4"/>
                </a:lnTo>
                <a:lnTo>
                  <a:pt x="2535" y="4"/>
                </a:lnTo>
                <a:lnTo>
                  <a:pt x="2536" y="3"/>
                </a:lnTo>
                <a:lnTo>
                  <a:pt x="2537" y="4"/>
                </a:lnTo>
                <a:lnTo>
                  <a:pt x="2538" y="4"/>
                </a:lnTo>
                <a:lnTo>
                  <a:pt x="2539" y="4"/>
                </a:lnTo>
                <a:lnTo>
                  <a:pt x="2539" y="4"/>
                </a:lnTo>
                <a:lnTo>
                  <a:pt x="2540" y="3"/>
                </a:lnTo>
                <a:lnTo>
                  <a:pt x="2541" y="4"/>
                </a:lnTo>
                <a:lnTo>
                  <a:pt x="2542" y="3"/>
                </a:lnTo>
                <a:lnTo>
                  <a:pt x="2543" y="3"/>
                </a:lnTo>
                <a:lnTo>
                  <a:pt x="2544" y="3"/>
                </a:lnTo>
                <a:lnTo>
                  <a:pt x="2545" y="3"/>
                </a:lnTo>
                <a:lnTo>
                  <a:pt x="2546" y="2"/>
                </a:lnTo>
                <a:lnTo>
                  <a:pt x="2547" y="3"/>
                </a:lnTo>
                <a:lnTo>
                  <a:pt x="2547" y="2"/>
                </a:lnTo>
                <a:lnTo>
                  <a:pt x="2548" y="2"/>
                </a:lnTo>
                <a:lnTo>
                  <a:pt x="2549" y="3"/>
                </a:lnTo>
                <a:lnTo>
                  <a:pt x="2550" y="3"/>
                </a:lnTo>
                <a:lnTo>
                  <a:pt x="2551" y="3"/>
                </a:lnTo>
                <a:lnTo>
                  <a:pt x="2552" y="3"/>
                </a:lnTo>
                <a:lnTo>
                  <a:pt x="2553" y="3"/>
                </a:lnTo>
                <a:lnTo>
                  <a:pt x="2554" y="4"/>
                </a:lnTo>
                <a:lnTo>
                  <a:pt x="2554" y="4"/>
                </a:lnTo>
                <a:lnTo>
                  <a:pt x="2555" y="4"/>
                </a:lnTo>
                <a:lnTo>
                  <a:pt x="2556" y="6"/>
                </a:lnTo>
                <a:lnTo>
                  <a:pt x="2557" y="6"/>
                </a:lnTo>
                <a:lnTo>
                  <a:pt x="2558" y="6"/>
                </a:lnTo>
                <a:lnTo>
                  <a:pt x="2559" y="7"/>
                </a:lnTo>
                <a:lnTo>
                  <a:pt x="2560" y="7"/>
                </a:lnTo>
                <a:lnTo>
                  <a:pt x="2561" y="7"/>
                </a:lnTo>
                <a:lnTo>
                  <a:pt x="2562" y="6"/>
                </a:lnTo>
                <a:lnTo>
                  <a:pt x="2562" y="5"/>
                </a:lnTo>
                <a:lnTo>
                  <a:pt x="2563" y="6"/>
                </a:lnTo>
                <a:lnTo>
                  <a:pt x="2564" y="5"/>
                </a:lnTo>
                <a:lnTo>
                  <a:pt x="2565" y="4"/>
                </a:lnTo>
                <a:lnTo>
                  <a:pt x="2566" y="4"/>
                </a:lnTo>
                <a:lnTo>
                  <a:pt x="2567" y="5"/>
                </a:lnTo>
                <a:lnTo>
                  <a:pt x="2568" y="4"/>
                </a:lnTo>
                <a:lnTo>
                  <a:pt x="2569" y="4"/>
                </a:lnTo>
                <a:lnTo>
                  <a:pt x="2569" y="4"/>
                </a:lnTo>
                <a:lnTo>
                  <a:pt x="2570" y="4"/>
                </a:lnTo>
                <a:lnTo>
                  <a:pt x="2571" y="3"/>
                </a:lnTo>
                <a:lnTo>
                  <a:pt x="2572" y="4"/>
                </a:lnTo>
                <a:lnTo>
                  <a:pt x="2573" y="3"/>
                </a:lnTo>
                <a:lnTo>
                  <a:pt x="2574" y="3"/>
                </a:lnTo>
                <a:lnTo>
                  <a:pt x="2575" y="3"/>
                </a:lnTo>
                <a:lnTo>
                  <a:pt x="2576" y="3"/>
                </a:lnTo>
                <a:lnTo>
                  <a:pt x="2577" y="4"/>
                </a:lnTo>
                <a:lnTo>
                  <a:pt x="2577" y="3"/>
                </a:lnTo>
                <a:lnTo>
                  <a:pt x="2578" y="4"/>
                </a:lnTo>
                <a:lnTo>
                  <a:pt x="2579" y="3"/>
                </a:lnTo>
                <a:lnTo>
                  <a:pt x="2580" y="3"/>
                </a:lnTo>
                <a:lnTo>
                  <a:pt x="2581" y="3"/>
                </a:lnTo>
                <a:lnTo>
                  <a:pt x="2582" y="3"/>
                </a:lnTo>
                <a:lnTo>
                  <a:pt x="2583" y="3"/>
                </a:lnTo>
                <a:lnTo>
                  <a:pt x="2584" y="3"/>
                </a:lnTo>
                <a:lnTo>
                  <a:pt x="2584" y="3"/>
                </a:lnTo>
                <a:lnTo>
                  <a:pt x="2585" y="3"/>
                </a:lnTo>
                <a:lnTo>
                  <a:pt x="2586" y="3"/>
                </a:lnTo>
                <a:lnTo>
                  <a:pt x="2587" y="3"/>
                </a:lnTo>
                <a:lnTo>
                  <a:pt x="2588" y="3"/>
                </a:lnTo>
                <a:lnTo>
                  <a:pt x="2589" y="3"/>
                </a:lnTo>
                <a:lnTo>
                  <a:pt x="2590" y="3"/>
                </a:lnTo>
                <a:lnTo>
                  <a:pt x="2591" y="3"/>
                </a:lnTo>
                <a:lnTo>
                  <a:pt x="2592" y="2"/>
                </a:lnTo>
                <a:lnTo>
                  <a:pt x="2592" y="2"/>
                </a:lnTo>
                <a:lnTo>
                  <a:pt x="2593" y="2"/>
                </a:lnTo>
                <a:lnTo>
                  <a:pt x="2594" y="2"/>
                </a:lnTo>
                <a:lnTo>
                  <a:pt x="2595" y="2"/>
                </a:lnTo>
                <a:lnTo>
                  <a:pt x="2596" y="2"/>
                </a:lnTo>
                <a:lnTo>
                  <a:pt x="2597" y="2"/>
                </a:lnTo>
                <a:lnTo>
                  <a:pt x="2598" y="2"/>
                </a:lnTo>
                <a:lnTo>
                  <a:pt x="2599" y="2"/>
                </a:lnTo>
                <a:lnTo>
                  <a:pt x="2599" y="3"/>
                </a:lnTo>
                <a:lnTo>
                  <a:pt x="2600" y="2"/>
                </a:lnTo>
                <a:lnTo>
                  <a:pt x="2601" y="2"/>
                </a:lnTo>
                <a:lnTo>
                  <a:pt x="2602" y="2"/>
                </a:lnTo>
                <a:lnTo>
                  <a:pt x="2603" y="2"/>
                </a:lnTo>
                <a:lnTo>
                  <a:pt x="2604" y="2"/>
                </a:lnTo>
                <a:lnTo>
                  <a:pt x="2605" y="2"/>
                </a:lnTo>
                <a:lnTo>
                  <a:pt x="2606" y="2"/>
                </a:lnTo>
                <a:lnTo>
                  <a:pt x="2607" y="2"/>
                </a:lnTo>
                <a:lnTo>
                  <a:pt x="2607" y="2"/>
                </a:lnTo>
                <a:lnTo>
                  <a:pt x="2608" y="2"/>
                </a:lnTo>
                <a:lnTo>
                  <a:pt x="2609" y="2"/>
                </a:lnTo>
                <a:lnTo>
                  <a:pt x="2610" y="2"/>
                </a:lnTo>
                <a:lnTo>
                  <a:pt x="2611" y="2"/>
                </a:lnTo>
                <a:lnTo>
                  <a:pt x="2612" y="2"/>
                </a:lnTo>
                <a:lnTo>
                  <a:pt x="2613" y="1"/>
                </a:lnTo>
                <a:lnTo>
                  <a:pt x="2614" y="2"/>
                </a:lnTo>
                <a:lnTo>
                  <a:pt x="2614" y="2"/>
                </a:lnTo>
                <a:lnTo>
                  <a:pt x="2615" y="2"/>
                </a:lnTo>
                <a:lnTo>
                  <a:pt x="2616" y="2"/>
                </a:lnTo>
                <a:lnTo>
                  <a:pt x="2617" y="1"/>
                </a:lnTo>
                <a:lnTo>
                  <a:pt x="2618" y="2"/>
                </a:lnTo>
                <a:lnTo>
                  <a:pt x="2619" y="2"/>
                </a:lnTo>
                <a:lnTo>
                  <a:pt x="2620" y="1"/>
                </a:lnTo>
                <a:lnTo>
                  <a:pt x="2621" y="2"/>
                </a:lnTo>
                <a:lnTo>
                  <a:pt x="2621" y="2"/>
                </a:lnTo>
                <a:lnTo>
                  <a:pt x="2622" y="2"/>
                </a:lnTo>
                <a:lnTo>
                  <a:pt x="2623" y="2"/>
                </a:lnTo>
                <a:lnTo>
                  <a:pt x="2624" y="1"/>
                </a:lnTo>
                <a:lnTo>
                  <a:pt x="2625" y="1"/>
                </a:lnTo>
                <a:lnTo>
                  <a:pt x="2626" y="2"/>
                </a:lnTo>
                <a:lnTo>
                  <a:pt x="2627" y="2"/>
                </a:lnTo>
                <a:lnTo>
                  <a:pt x="2628" y="1"/>
                </a:lnTo>
                <a:lnTo>
                  <a:pt x="2629" y="2"/>
                </a:lnTo>
                <a:lnTo>
                  <a:pt x="2629" y="1"/>
                </a:lnTo>
                <a:lnTo>
                  <a:pt x="2630" y="1"/>
                </a:lnTo>
                <a:lnTo>
                  <a:pt x="2631" y="1"/>
                </a:lnTo>
                <a:lnTo>
                  <a:pt x="2632" y="1"/>
                </a:lnTo>
                <a:lnTo>
                  <a:pt x="2633" y="1"/>
                </a:lnTo>
                <a:lnTo>
                  <a:pt x="2634" y="1"/>
                </a:lnTo>
                <a:lnTo>
                  <a:pt x="2635" y="1"/>
                </a:lnTo>
                <a:lnTo>
                  <a:pt x="2636" y="1"/>
                </a:lnTo>
                <a:lnTo>
                  <a:pt x="2636" y="1"/>
                </a:lnTo>
                <a:lnTo>
                  <a:pt x="2637" y="1"/>
                </a:lnTo>
                <a:lnTo>
                  <a:pt x="2638" y="2"/>
                </a:lnTo>
                <a:lnTo>
                  <a:pt x="2639" y="2"/>
                </a:lnTo>
                <a:lnTo>
                  <a:pt x="2640" y="3"/>
                </a:lnTo>
                <a:lnTo>
                  <a:pt x="2641" y="2"/>
                </a:lnTo>
                <a:lnTo>
                  <a:pt x="2642" y="2"/>
                </a:lnTo>
                <a:lnTo>
                  <a:pt x="2643" y="2"/>
                </a:lnTo>
                <a:lnTo>
                  <a:pt x="2644" y="2"/>
                </a:lnTo>
                <a:lnTo>
                  <a:pt x="2644" y="1"/>
                </a:lnTo>
                <a:lnTo>
                  <a:pt x="2645" y="2"/>
                </a:lnTo>
                <a:lnTo>
                  <a:pt x="2646" y="2"/>
                </a:lnTo>
                <a:lnTo>
                  <a:pt x="2647" y="2"/>
                </a:lnTo>
                <a:lnTo>
                  <a:pt x="2648" y="2"/>
                </a:lnTo>
                <a:lnTo>
                  <a:pt x="2649" y="2"/>
                </a:lnTo>
                <a:lnTo>
                  <a:pt x="2650" y="1"/>
                </a:lnTo>
                <a:lnTo>
                  <a:pt x="2651" y="1"/>
                </a:lnTo>
                <a:lnTo>
                  <a:pt x="2651" y="1"/>
                </a:lnTo>
                <a:lnTo>
                  <a:pt x="2652" y="1"/>
                </a:lnTo>
                <a:lnTo>
                  <a:pt x="2653" y="1"/>
                </a:lnTo>
                <a:lnTo>
                  <a:pt x="2654" y="1"/>
                </a:lnTo>
                <a:lnTo>
                  <a:pt x="2655" y="1"/>
                </a:lnTo>
                <a:lnTo>
                  <a:pt x="2656" y="1"/>
                </a:lnTo>
                <a:lnTo>
                  <a:pt x="2657" y="1"/>
                </a:lnTo>
                <a:lnTo>
                  <a:pt x="2658" y="1"/>
                </a:lnTo>
                <a:lnTo>
                  <a:pt x="2659" y="2"/>
                </a:lnTo>
                <a:lnTo>
                  <a:pt x="2659" y="2"/>
                </a:lnTo>
                <a:lnTo>
                  <a:pt x="2660" y="1"/>
                </a:lnTo>
                <a:lnTo>
                  <a:pt x="2661" y="1"/>
                </a:lnTo>
                <a:lnTo>
                  <a:pt x="2662" y="2"/>
                </a:lnTo>
                <a:lnTo>
                  <a:pt x="2663" y="1"/>
                </a:lnTo>
                <a:lnTo>
                  <a:pt x="2664" y="1"/>
                </a:lnTo>
                <a:lnTo>
                  <a:pt x="2665" y="1"/>
                </a:lnTo>
                <a:lnTo>
                  <a:pt x="2666" y="1"/>
                </a:lnTo>
                <a:lnTo>
                  <a:pt x="2666" y="1"/>
                </a:lnTo>
                <a:lnTo>
                  <a:pt x="2667" y="1"/>
                </a:lnTo>
                <a:lnTo>
                  <a:pt x="2668" y="1"/>
                </a:lnTo>
                <a:lnTo>
                  <a:pt x="2669" y="1"/>
                </a:lnTo>
                <a:lnTo>
                  <a:pt x="2670" y="1"/>
                </a:lnTo>
                <a:lnTo>
                  <a:pt x="2671" y="1"/>
                </a:lnTo>
                <a:lnTo>
                  <a:pt x="2672" y="1"/>
                </a:lnTo>
                <a:lnTo>
                  <a:pt x="2673" y="1"/>
                </a:lnTo>
                <a:lnTo>
                  <a:pt x="2674" y="1"/>
                </a:lnTo>
                <a:lnTo>
                  <a:pt x="2674" y="1"/>
                </a:lnTo>
                <a:lnTo>
                  <a:pt x="2675" y="1"/>
                </a:lnTo>
                <a:lnTo>
                  <a:pt x="2676" y="1"/>
                </a:lnTo>
                <a:lnTo>
                  <a:pt x="2677" y="1"/>
                </a:lnTo>
                <a:lnTo>
                  <a:pt x="2678" y="1"/>
                </a:lnTo>
                <a:lnTo>
                  <a:pt x="2679" y="1"/>
                </a:lnTo>
                <a:lnTo>
                  <a:pt x="2680" y="0"/>
                </a:lnTo>
                <a:lnTo>
                  <a:pt x="2681" y="1"/>
                </a:lnTo>
                <a:lnTo>
                  <a:pt x="2681" y="1"/>
                </a:lnTo>
                <a:lnTo>
                  <a:pt x="2682" y="1"/>
                </a:lnTo>
                <a:lnTo>
                  <a:pt x="2683" y="1"/>
                </a:lnTo>
                <a:lnTo>
                  <a:pt x="2684" y="1"/>
                </a:lnTo>
                <a:lnTo>
                  <a:pt x="2685" y="1"/>
                </a:lnTo>
                <a:lnTo>
                  <a:pt x="2686" y="1"/>
                </a:lnTo>
                <a:lnTo>
                  <a:pt x="2687" y="1"/>
                </a:lnTo>
                <a:lnTo>
                  <a:pt x="2688" y="1"/>
                </a:lnTo>
                <a:lnTo>
                  <a:pt x="2689" y="1"/>
                </a:lnTo>
                <a:lnTo>
                  <a:pt x="2689" y="1"/>
                </a:lnTo>
                <a:lnTo>
                  <a:pt x="2690" y="1"/>
                </a:lnTo>
                <a:lnTo>
                  <a:pt x="2691" y="1"/>
                </a:lnTo>
                <a:lnTo>
                  <a:pt x="2692" y="0"/>
                </a:lnTo>
                <a:lnTo>
                  <a:pt x="2693" y="0"/>
                </a:lnTo>
                <a:lnTo>
                  <a:pt x="2694" y="1"/>
                </a:lnTo>
                <a:lnTo>
                  <a:pt x="2695" y="1"/>
                </a:lnTo>
                <a:lnTo>
                  <a:pt x="2696" y="0"/>
                </a:lnTo>
                <a:lnTo>
                  <a:pt x="2696" y="1"/>
                </a:lnTo>
                <a:lnTo>
                  <a:pt x="2697" y="1"/>
                </a:lnTo>
                <a:lnTo>
                  <a:pt x="2698" y="1"/>
                </a:lnTo>
                <a:lnTo>
                  <a:pt x="2699" y="0"/>
                </a:lnTo>
                <a:lnTo>
                  <a:pt x="2700" y="1"/>
                </a:lnTo>
                <a:lnTo>
                  <a:pt x="2701" y="1"/>
                </a:lnTo>
                <a:lnTo>
                  <a:pt x="2702" y="1"/>
                </a:lnTo>
                <a:lnTo>
                  <a:pt x="2703" y="1"/>
                </a:lnTo>
                <a:lnTo>
                  <a:pt x="2704" y="1"/>
                </a:lnTo>
                <a:lnTo>
                  <a:pt x="2704" y="1"/>
                </a:lnTo>
                <a:lnTo>
                  <a:pt x="2705" y="1"/>
                </a:lnTo>
                <a:lnTo>
                  <a:pt x="2706" y="1"/>
                </a:lnTo>
                <a:lnTo>
                  <a:pt x="2707" y="1"/>
                </a:lnTo>
                <a:lnTo>
                  <a:pt x="2708" y="2"/>
                </a:lnTo>
                <a:lnTo>
                  <a:pt x="2709" y="1"/>
                </a:lnTo>
                <a:lnTo>
                  <a:pt x="2710" y="2"/>
                </a:lnTo>
                <a:lnTo>
                  <a:pt x="2711" y="1"/>
                </a:lnTo>
                <a:lnTo>
                  <a:pt x="2711" y="1"/>
                </a:lnTo>
                <a:lnTo>
                  <a:pt x="2712" y="1"/>
                </a:lnTo>
                <a:lnTo>
                  <a:pt x="2713" y="2"/>
                </a:lnTo>
                <a:lnTo>
                  <a:pt x="2714" y="2"/>
                </a:lnTo>
                <a:lnTo>
                  <a:pt x="2715" y="1"/>
                </a:lnTo>
                <a:lnTo>
                  <a:pt x="2716" y="1"/>
                </a:lnTo>
                <a:lnTo>
                  <a:pt x="2717" y="1"/>
                </a:lnTo>
                <a:lnTo>
                  <a:pt x="2718" y="1"/>
                </a:lnTo>
                <a:lnTo>
                  <a:pt x="2719" y="1"/>
                </a:lnTo>
                <a:lnTo>
                  <a:pt x="2719" y="1"/>
                </a:lnTo>
                <a:lnTo>
                  <a:pt x="2720" y="1"/>
                </a:lnTo>
                <a:lnTo>
                  <a:pt x="2721" y="1"/>
                </a:lnTo>
                <a:lnTo>
                  <a:pt x="2722" y="1"/>
                </a:lnTo>
                <a:lnTo>
                  <a:pt x="2723" y="1"/>
                </a:lnTo>
                <a:lnTo>
                  <a:pt x="2724" y="1"/>
                </a:lnTo>
                <a:lnTo>
                  <a:pt x="2725" y="1"/>
                </a:lnTo>
                <a:lnTo>
                  <a:pt x="2726" y="0"/>
                </a:lnTo>
                <a:lnTo>
                  <a:pt x="2726" y="1"/>
                </a:lnTo>
                <a:lnTo>
                  <a:pt x="2727" y="1"/>
                </a:lnTo>
                <a:lnTo>
                  <a:pt x="2728" y="1"/>
                </a:lnTo>
                <a:lnTo>
                  <a:pt x="2729" y="0"/>
                </a:lnTo>
                <a:lnTo>
                  <a:pt x="2730" y="1"/>
                </a:lnTo>
                <a:lnTo>
                  <a:pt x="2731" y="1"/>
                </a:lnTo>
                <a:lnTo>
                  <a:pt x="2732" y="1"/>
                </a:lnTo>
                <a:lnTo>
                  <a:pt x="2733" y="1"/>
                </a:lnTo>
                <a:lnTo>
                  <a:pt x="2734" y="1"/>
                </a:lnTo>
                <a:lnTo>
                  <a:pt x="2734" y="1"/>
                </a:lnTo>
                <a:lnTo>
                  <a:pt x="2735" y="1"/>
                </a:lnTo>
                <a:lnTo>
                  <a:pt x="2736" y="1"/>
                </a:lnTo>
                <a:lnTo>
                  <a:pt x="2737" y="1"/>
                </a:lnTo>
                <a:lnTo>
                  <a:pt x="2738" y="1"/>
                </a:lnTo>
                <a:lnTo>
                  <a:pt x="2739" y="1"/>
                </a:lnTo>
                <a:lnTo>
                  <a:pt x="2740" y="1"/>
                </a:lnTo>
                <a:lnTo>
                  <a:pt x="2741" y="0"/>
                </a:lnTo>
                <a:lnTo>
                  <a:pt x="2741" y="1"/>
                </a:lnTo>
                <a:lnTo>
                  <a:pt x="2742" y="1"/>
                </a:lnTo>
                <a:lnTo>
                  <a:pt x="2743" y="1"/>
                </a:lnTo>
                <a:lnTo>
                  <a:pt x="2744" y="0"/>
                </a:lnTo>
                <a:lnTo>
                  <a:pt x="2745" y="1"/>
                </a:lnTo>
                <a:lnTo>
                  <a:pt x="2746" y="1"/>
                </a:lnTo>
                <a:lnTo>
                  <a:pt x="2747" y="2"/>
                </a:lnTo>
                <a:lnTo>
                  <a:pt x="2748" y="1"/>
                </a:lnTo>
                <a:lnTo>
                  <a:pt x="2749" y="2"/>
                </a:lnTo>
                <a:lnTo>
                  <a:pt x="2749" y="2"/>
                </a:lnTo>
                <a:lnTo>
                  <a:pt x="2750" y="2"/>
                </a:lnTo>
                <a:lnTo>
                  <a:pt x="2751" y="3"/>
                </a:lnTo>
                <a:lnTo>
                  <a:pt x="2752" y="2"/>
                </a:lnTo>
                <a:lnTo>
                  <a:pt x="2753" y="2"/>
                </a:lnTo>
                <a:lnTo>
                  <a:pt x="2754" y="2"/>
                </a:lnTo>
                <a:lnTo>
                  <a:pt x="2755" y="2"/>
                </a:lnTo>
                <a:lnTo>
                  <a:pt x="2756" y="2"/>
                </a:lnTo>
                <a:lnTo>
                  <a:pt x="2756" y="2"/>
                </a:lnTo>
                <a:lnTo>
                  <a:pt x="2757" y="2"/>
                </a:lnTo>
                <a:lnTo>
                  <a:pt x="2758" y="2"/>
                </a:lnTo>
                <a:lnTo>
                  <a:pt x="2759" y="1"/>
                </a:lnTo>
                <a:lnTo>
                  <a:pt x="2760" y="1"/>
                </a:lnTo>
                <a:lnTo>
                  <a:pt x="2761" y="1"/>
                </a:lnTo>
                <a:lnTo>
                  <a:pt x="2762" y="1"/>
                </a:lnTo>
                <a:lnTo>
                  <a:pt x="2763" y="1"/>
                </a:lnTo>
                <a:lnTo>
                  <a:pt x="2764" y="1"/>
                </a:lnTo>
                <a:lnTo>
                  <a:pt x="2764" y="1"/>
                </a:lnTo>
                <a:lnTo>
                  <a:pt x="2765" y="0"/>
                </a:lnTo>
                <a:lnTo>
                  <a:pt x="2766" y="1"/>
                </a:lnTo>
                <a:lnTo>
                  <a:pt x="2767" y="1"/>
                </a:lnTo>
                <a:lnTo>
                  <a:pt x="2768" y="1"/>
                </a:lnTo>
                <a:lnTo>
                  <a:pt x="2769" y="1"/>
                </a:lnTo>
                <a:lnTo>
                  <a:pt x="2770" y="1"/>
                </a:lnTo>
                <a:lnTo>
                  <a:pt x="2771" y="1"/>
                </a:lnTo>
                <a:lnTo>
                  <a:pt x="2771" y="2"/>
                </a:lnTo>
                <a:lnTo>
                  <a:pt x="2772" y="1"/>
                </a:lnTo>
                <a:lnTo>
                  <a:pt x="2773" y="1"/>
                </a:lnTo>
                <a:lnTo>
                  <a:pt x="2774" y="1"/>
                </a:lnTo>
                <a:lnTo>
                  <a:pt x="2775" y="1"/>
                </a:lnTo>
                <a:lnTo>
                  <a:pt x="2776" y="1"/>
                </a:lnTo>
                <a:lnTo>
                  <a:pt x="2777" y="0"/>
                </a:lnTo>
                <a:lnTo>
                  <a:pt x="2778" y="1"/>
                </a:lnTo>
                <a:lnTo>
                  <a:pt x="2779" y="1"/>
                </a:lnTo>
                <a:lnTo>
                  <a:pt x="2779" y="0"/>
                </a:lnTo>
                <a:lnTo>
                  <a:pt x="2780" y="1"/>
                </a:lnTo>
                <a:lnTo>
                  <a:pt x="2781" y="1"/>
                </a:lnTo>
                <a:lnTo>
                  <a:pt x="2782" y="1"/>
                </a:lnTo>
                <a:lnTo>
                  <a:pt x="2783" y="1"/>
                </a:lnTo>
                <a:lnTo>
                  <a:pt x="2784" y="1"/>
                </a:lnTo>
                <a:lnTo>
                  <a:pt x="2785" y="0"/>
                </a:lnTo>
                <a:lnTo>
                  <a:pt x="2786" y="0"/>
                </a:lnTo>
                <a:lnTo>
                  <a:pt x="2786" y="0"/>
                </a:lnTo>
                <a:lnTo>
                  <a:pt x="2787" y="1"/>
                </a:lnTo>
                <a:lnTo>
                  <a:pt x="2788" y="1"/>
                </a:lnTo>
                <a:lnTo>
                  <a:pt x="2789" y="1"/>
                </a:lnTo>
                <a:lnTo>
                  <a:pt x="2790" y="1"/>
                </a:lnTo>
                <a:lnTo>
                  <a:pt x="2791" y="1"/>
                </a:lnTo>
                <a:lnTo>
                  <a:pt x="2792" y="1"/>
                </a:lnTo>
                <a:lnTo>
                  <a:pt x="2793" y="1"/>
                </a:lnTo>
                <a:lnTo>
                  <a:pt x="2794" y="1"/>
                </a:lnTo>
                <a:lnTo>
                  <a:pt x="2794" y="1"/>
                </a:lnTo>
                <a:lnTo>
                  <a:pt x="2795" y="1"/>
                </a:lnTo>
                <a:lnTo>
                  <a:pt x="2796" y="1"/>
                </a:lnTo>
                <a:lnTo>
                  <a:pt x="2797" y="2"/>
                </a:lnTo>
                <a:lnTo>
                  <a:pt x="2798" y="1"/>
                </a:lnTo>
                <a:lnTo>
                  <a:pt x="2799" y="1"/>
                </a:lnTo>
                <a:lnTo>
                  <a:pt x="2800" y="2"/>
                </a:lnTo>
                <a:lnTo>
                  <a:pt x="2801" y="1"/>
                </a:lnTo>
                <a:lnTo>
                  <a:pt x="2801" y="1"/>
                </a:lnTo>
                <a:lnTo>
                  <a:pt x="2802" y="1"/>
                </a:lnTo>
                <a:lnTo>
                  <a:pt x="2803" y="1"/>
                </a:lnTo>
                <a:lnTo>
                  <a:pt x="2804" y="1"/>
                </a:lnTo>
                <a:lnTo>
                  <a:pt x="2805" y="0"/>
                </a:lnTo>
                <a:lnTo>
                  <a:pt x="2806" y="1"/>
                </a:lnTo>
                <a:lnTo>
                  <a:pt x="2807" y="1"/>
                </a:lnTo>
                <a:lnTo>
                  <a:pt x="2808" y="1"/>
                </a:lnTo>
                <a:lnTo>
                  <a:pt x="2808" y="1"/>
                </a:lnTo>
                <a:lnTo>
                  <a:pt x="2809" y="0"/>
                </a:lnTo>
                <a:lnTo>
                  <a:pt x="2810" y="1"/>
                </a:lnTo>
                <a:lnTo>
                  <a:pt x="2811" y="0"/>
                </a:lnTo>
                <a:lnTo>
                  <a:pt x="2812" y="1"/>
                </a:lnTo>
                <a:lnTo>
                  <a:pt x="2813" y="0"/>
                </a:lnTo>
                <a:lnTo>
                  <a:pt x="2814" y="0"/>
                </a:lnTo>
                <a:lnTo>
                  <a:pt x="2815" y="0"/>
                </a:lnTo>
                <a:lnTo>
                  <a:pt x="2816" y="0"/>
                </a:lnTo>
                <a:lnTo>
                  <a:pt x="2816" y="1"/>
                </a:lnTo>
                <a:lnTo>
                  <a:pt x="2817" y="0"/>
                </a:lnTo>
                <a:lnTo>
                  <a:pt x="2818" y="0"/>
                </a:lnTo>
                <a:lnTo>
                  <a:pt x="2819" y="1"/>
                </a:lnTo>
                <a:lnTo>
                  <a:pt x="2820" y="1"/>
                </a:lnTo>
                <a:lnTo>
                  <a:pt x="2821" y="1"/>
                </a:lnTo>
                <a:lnTo>
                  <a:pt x="2822" y="0"/>
                </a:lnTo>
                <a:lnTo>
                  <a:pt x="2823" y="0"/>
                </a:lnTo>
                <a:lnTo>
                  <a:pt x="2823" y="1"/>
                </a:lnTo>
                <a:lnTo>
                  <a:pt x="2824" y="1"/>
                </a:lnTo>
                <a:lnTo>
                  <a:pt x="2825" y="1"/>
                </a:lnTo>
                <a:lnTo>
                  <a:pt x="2826" y="0"/>
                </a:lnTo>
                <a:lnTo>
                  <a:pt x="2827" y="0"/>
                </a:lnTo>
                <a:lnTo>
                  <a:pt x="2828" y="0"/>
                </a:lnTo>
                <a:lnTo>
                  <a:pt x="2829" y="1"/>
                </a:lnTo>
                <a:lnTo>
                  <a:pt x="2830" y="1"/>
                </a:lnTo>
                <a:lnTo>
                  <a:pt x="2831" y="0"/>
                </a:lnTo>
                <a:lnTo>
                  <a:pt x="2831" y="1"/>
                </a:lnTo>
                <a:lnTo>
                  <a:pt x="2832" y="1"/>
                </a:lnTo>
                <a:lnTo>
                  <a:pt x="2833" y="1"/>
                </a:lnTo>
                <a:lnTo>
                  <a:pt x="2834" y="1"/>
                </a:lnTo>
                <a:lnTo>
                  <a:pt x="2835" y="1"/>
                </a:lnTo>
                <a:lnTo>
                  <a:pt x="2836" y="1"/>
                </a:lnTo>
                <a:lnTo>
                  <a:pt x="2837" y="1"/>
                </a:lnTo>
                <a:lnTo>
                  <a:pt x="2838" y="1"/>
                </a:lnTo>
                <a:lnTo>
                  <a:pt x="2838" y="1"/>
                </a:lnTo>
                <a:lnTo>
                  <a:pt x="2839" y="0"/>
                </a:lnTo>
                <a:lnTo>
                  <a:pt x="2840" y="1"/>
                </a:lnTo>
                <a:lnTo>
                  <a:pt x="2841" y="0"/>
                </a:lnTo>
                <a:lnTo>
                  <a:pt x="2842" y="1"/>
                </a:lnTo>
                <a:lnTo>
                  <a:pt x="2843" y="0"/>
                </a:lnTo>
                <a:lnTo>
                  <a:pt x="2844" y="1"/>
                </a:lnTo>
                <a:lnTo>
                  <a:pt x="2845" y="0"/>
                </a:lnTo>
                <a:lnTo>
                  <a:pt x="2846" y="0"/>
                </a:lnTo>
                <a:lnTo>
                  <a:pt x="2846" y="0"/>
                </a:lnTo>
                <a:lnTo>
                  <a:pt x="2847" y="0"/>
                </a:lnTo>
                <a:lnTo>
                  <a:pt x="2848" y="1"/>
                </a:lnTo>
                <a:lnTo>
                  <a:pt x="2849" y="0"/>
                </a:lnTo>
                <a:lnTo>
                  <a:pt x="2850" y="0"/>
                </a:lnTo>
                <a:lnTo>
                  <a:pt x="2851" y="0"/>
                </a:lnTo>
                <a:lnTo>
                  <a:pt x="2852" y="0"/>
                </a:lnTo>
                <a:lnTo>
                  <a:pt x="2853" y="1"/>
                </a:lnTo>
                <a:lnTo>
                  <a:pt x="2853" y="0"/>
                </a:lnTo>
                <a:lnTo>
                  <a:pt x="2854" y="1"/>
                </a:lnTo>
                <a:lnTo>
                  <a:pt x="2855" y="1"/>
                </a:lnTo>
                <a:lnTo>
                  <a:pt x="2856" y="0"/>
                </a:lnTo>
                <a:lnTo>
                  <a:pt x="2857" y="1"/>
                </a:lnTo>
                <a:lnTo>
                  <a:pt x="2858" y="1"/>
                </a:lnTo>
                <a:lnTo>
                  <a:pt x="2859" y="0"/>
                </a:lnTo>
                <a:lnTo>
                  <a:pt x="2860" y="0"/>
                </a:lnTo>
                <a:lnTo>
                  <a:pt x="2861" y="0"/>
                </a:lnTo>
                <a:lnTo>
                  <a:pt x="2861" y="1"/>
                </a:lnTo>
                <a:lnTo>
                  <a:pt x="2862" y="1"/>
                </a:lnTo>
                <a:lnTo>
                  <a:pt x="2863" y="1"/>
                </a:lnTo>
                <a:lnTo>
                  <a:pt x="2864" y="1"/>
                </a:lnTo>
                <a:lnTo>
                  <a:pt x="2865" y="1"/>
                </a:lnTo>
                <a:lnTo>
                  <a:pt x="2866" y="1"/>
                </a:lnTo>
                <a:lnTo>
                  <a:pt x="2867" y="1"/>
                </a:lnTo>
                <a:lnTo>
                  <a:pt x="2868" y="1"/>
                </a:lnTo>
                <a:lnTo>
                  <a:pt x="2868" y="1"/>
                </a:lnTo>
                <a:lnTo>
                  <a:pt x="2869" y="1"/>
                </a:lnTo>
                <a:lnTo>
                  <a:pt x="2870" y="0"/>
                </a:lnTo>
                <a:lnTo>
                  <a:pt x="2871" y="0"/>
                </a:lnTo>
                <a:lnTo>
                  <a:pt x="2872" y="1"/>
                </a:lnTo>
                <a:lnTo>
                  <a:pt x="2873" y="0"/>
                </a:lnTo>
                <a:lnTo>
                  <a:pt x="2874" y="0"/>
                </a:lnTo>
                <a:lnTo>
                  <a:pt x="2875" y="0"/>
                </a:lnTo>
                <a:lnTo>
                  <a:pt x="2876" y="0"/>
                </a:lnTo>
                <a:lnTo>
                  <a:pt x="2876" y="0"/>
                </a:lnTo>
                <a:lnTo>
                  <a:pt x="2877" y="0"/>
                </a:lnTo>
                <a:lnTo>
                  <a:pt x="2878" y="0"/>
                </a:lnTo>
                <a:lnTo>
                  <a:pt x="2879" y="1"/>
                </a:lnTo>
                <a:lnTo>
                  <a:pt x="2880" y="0"/>
                </a:lnTo>
                <a:lnTo>
                  <a:pt x="2881" y="0"/>
                </a:lnTo>
                <a:lnTo>
                  <a:pt x="2882" y="1"/>
                </a:lnTo>
                <a:lnTo>
                  <a:pt x="2883" y="0"/>
                </a:lnTo>
                <a:lnTo>
                  <a:pt x="2883" y="0"/>
                </a:lnTo>
                <a:lnTo>
                  <a:pt x="2884" y="0"/>
                </a:lnTo>
                <a:lnTo>
                  <a:pt x="2885" y="0"/>
                </a:lnTo>
                <a:lnTo>
                  <a:pt x="2886" y="0"/>
                </a:lnTo>
                <a:lnTo>
                  <a:pt x="2887" y="0"/>
                </a:lnTo>
                <a:lnTo>
                  <a:pt x="2888" y="0"/>
                </a:lnTo>
                <a:lnTo>
                  <a:pt x="2889" y="0"/>
                </a:lnTo>
                <a:lnTo>
                  <a:pt x="2890" y="0"/>
                </a:lnTo>
                <a:lnTo>
                  <a:pt x="2891" y="0"/>
                </a:lnTo>
                <a:lnTo>
                  <a:pt x="2891" y="0"/>
                </a:lnTo>
                <a:lnTo>
                  <a:pt x="2892" y="0"/>
                </a:lnTo>
                <a:lnTo>
                  <a:pt x="2893" y="0"/>
                </a:lnTo>
                <a:lnTo>
                  <a:pt x="2894" y="1"/>
                </a:lnTo>
                <a:lnTo>
                  <a:pt x="2895" y="0"/>
                </a:lnTo>
                <a:lnTo>
                  <a:pt x="2896" y="1"/>
                </a:lnTo>
                <a:lnTo>
                  <a:pt x="2897" y="0"/>
                </a:lnTo>
                <a:lnTo>
                  <a:pt x="2898" y="0"/>
                </a:lnTo>
                <a:lnTo>
                  <a:pt x="2898" y="0"/>
                </a:lnTo>
                <a:lnTo>
                  <a:pt x="2899" y="0"/>
                </a:lnTo>
                <a:lnTo>
                  <a:pt x="2900" y="1"/>
                </a:lnTo>
                <a:lnTo>
                  <a:pt x="2901" y="0"/>
                </a:lnTo>
                <a:lnTo>
                  <a:pt x="2902" y="0"/>
                </a:lnTo>
                <a:lnTo>
                  <a:pt x="2903" y="1"/>
                </a:lnTo>
                <a:lnTo>
                  <a:pt x="2904" y="0"/>
                </a:lnTo>
                <a:lnTo>
                  <a:pt x="2905" y="0"/>
                </a:lnTo>
                <a:lnTo>
                  <a:pt x="2906" y="0"/>
                </a:lnTo>
                <a:lnTo>
                  <a:pt x="2906" y="1"/>
                </a:lnTo>
                <a:lnTo>
                  <a:pt x="2907" y="1"/>
                </a:lnTo>
                <a:lnTo>
                  <a:pt x="2908" y="1"/>
                </a:lnTo>
                <a:lnTo>
                  <a:pt x="2909" y="0"/>
                </a:lnTo>
                <a:lnTo>
                  <a:pt x="2910" y="1"/>
                </a:lnTo>
                <a:lnTo>
                  <a:pt x="2911" y="1"/>
                </a:lnTo>
                <a:lnTo>
                  <a:pt x="2912" y="1"/>
                </a:lnTo>
                <a:lnTo>
                  <a:pt x="2913" y="1"/>
                </a:lnTo>
                <a:lnTo>
                  <a:pt x="2913" y="1"/>
                </a:lnTo>
                <a:lnTo>
                  <a:pt x="2914" y="1"/>
                </a:lnTo>
                <a:lnTo>
                  <a:pt x="2915" y="2"/>
                </a:lnTo>
                <a:lnTo>
                  <a:pt x="2916" y="2"/>
                </a:lnTo>
                <a:lnTo>
                  <a:pt x="2917" y="3"/>
                </a:lnTo>
                <a:lnTo>
                  <a:pt x="2918" y="2"/>
                </a:lnTo>
                <a:lnTo>
                  <a:pt x="2919" y="4"/>
                </a:lnTo>
                <a:lnTo>
                  <a:pt x="2920" y="3"/>
                </a:lnTo>
                <a:lnTo>
                  <a:pt x="2921" y="4"/>
                </a:lnTo>
                <a:lnTo>
                  <a:pt x="2921" y="4"/>
                </a:lnTo>
                <a:lnTo>
                  <a:pt x="2922" y="4"/>
                </a:lnTo>
                <a:lnTo>
                  <a:pt x="2923" y="3"/>
                </a:lnTo>
                <a:lnTo>
                  <a:pt x="2924" y="3"/>
                </a:lnTo>
                <a:lnTo>
                  <a:pt x="2925" y="3"/>
                </a:lnTo>
                <a:lnTo>
                  <a:pt x="2926" y="3"/>
                </a:lnTo>
                <a:lnTo>
                  <a:pt x="2927" y="3"/>
                </a:lnTo>
                <a:lnTo>
                  <a:pt x="2928" y="2"/>
                </a:lnTo>
                <a:lnTo>
                  <a:pt x="2928" y="3"/>
                </a:lnTo>
                <a:lnTo>
                  <a:pt x="2929" y="3"/>
                </a:lnTo>
                <a:lnTo>
                  <a:pt x="2930" y="2"/>
                </a:lnTo>
                <a:lnTo>
                  <a:pt x="2931" y="2"/>
                </a:lnTo>
                <a:lnTo>
                  <a:pt x="2932" y="3"/>
                </a:lnTo>
                <a:lnTo>
                  <a:pt x="2933" y="2"/>
                </a:lnTo>
                <a:lnTo>
                  <a:pt x="2934" y="2"/>
                </a:lnTo>
                <a:lnTo>
                  <a:pt x="2935" y="2"/>
                </a:lnTo>
                <a:lnTo>
                  <a:pt x="2936" y="2"/>
                </a:lnTo>
                <a:lnTo>
                  <a:pt x="2936" y="1"/>
                </a:lnTo>
                <a:lnTo>
                  <a:pt x="2937" y="1"/>
                </a:lnTo>
                <a:lnTo>
                  <a:pt x="2938" y="1"/>
                </a:lnTo>
                <a:lnTo>
                  <a:pt x="2939" y="2"/>
                </a:lnTo>
                <a:lnTo>
                  <a:pt x="2940" y="1"/>
                </a:lnTo>
                <a:lnTo>
                  <a:pt x="2941" y="1"/>
                </a:lnTo>
                <a:lnTo>
                  <a:pt x="2942" y="1"/>
                </a:lnTo>
                <a:lnTo>
                  <a:pt x="2943" y="1"/>
                </a:lnTo>
                <a:lnTo>
                  <a:pt x="2943" y="1"/>
                </a:lnTo>
                <a:lnTo>
                  <a:pt x="2944" y="1"/>
                </a:lnTo>
                <a:lnTo>
                  <a:pt x="2945" y="1"/>
                </a:lnTo>
                <a:lnTo>
                  <a:pt x="2946" y="1"/>
                </a:lnTo>
                <a:lnTo>
                  <a:pt x="2947" y="1"/>
                </a:lnTo>
                <a:lnTo>
                  <a:pt x="2948" y="1"/>
                </a:lnTo>
                <a:lnTo>
                  <a:pt x="2949" y="1"/>
                </a:lnTo>
                <a:lnTo>
                  <a:pt x="2950" y="1"/>
                </a:lnTo>
                <a:lnTo>
                  <a:pt x="2951" y="1"/>
                </a:lnTo>
                <a:lnTo>
                  <a:pt x="2951" y="1"/>
                </a:lnTo>
                <a:lnTo>
                  <a:pt x="2952" y="1"/>
                </a:lnTo>
                <a:lnTo>
                  <a:pt x="2953" y="1"/>
                </a:lnTo>
                <a:lnTo>
                  <a:pt x="2954" y="1"/>
                </a:lnTo>
                <a:lnTo>
                  <a:pt x="2955" y="1"/>
                </a:lnTo>
                <a:lnTo>
                  <a:pt x="2956" y="1"/>
                </a:lnTo>
                <a:lnTo>
                  <a:pt x="2957" y="1"/>
                </a:lnTo>
                <a:lnTo>
                  <a:pt x="2958" y="1"/>
                </a:lnTo>
                <a:lnTo>
                  <a:pt x="2958" y="1"/>
                </a:lnTo>
                <a:lnTo>
                  <a:pt x="2959" y="1"/>
                </a:lnTo>
                <a:lnTo>
                  <a:pt x="2960" y="1"/>
                </a:lnTo>
                <a:lnTo>
                  <a:pt x="2961" y="1"/>
                </a:lnTo>
                <a:lnTo>
                  <a:pt x="2962" y="1"/>
                </a:lnTo>
                <a:lnTo>
                  <a:pt x="2963" y="0"/>
                </a:lnTo>
                <a:lnTo>
                  <a:pt x="2964" y="0"/>
                </a:lnTo>
                <a:lnTo>
                  <a:pt x="2965" y="0"/>
                </a:lnTo>
                <a:lnTo>
                  <a:pt x="2966" y="1"/>
                </a:lnTo>
                <a:lnTo>
                  <a:pt x="2966" y="0"/>
                </a:lnTo>
                <a:lnTo>
                  <a:pt x="2967" y="0"/>
                </a:lnTo>
                <a:lnTo>
                  <a:pt x="2968" y="0"/>
                </a:lnTo>
                <a:lnTo>
                  <a:pt x="2969" y="1"/>
                </a:lnTo>
                <a:lnTo>
                  <a:pt x="2970" y="0"/>
                </a:lnTo>
                <a:lnTo>
                  <a:pt x="2971" y="0"/>
                </a:lnTo>
                <a:lnTo>
                  <a:pt x="2972" y="1"/>
                </a:lnTo>
                <a:lnTo>
                  <a:pt x="2973" y="1"/>
                </a:lnTo>
                <a:lnTo>
                  <a:pt x="2973" y="1"/>
                </a:lnTo>
                <a:lnTo>
                  <a:pt x="2974" y="1"/>
                </a:lnTo>
                <a:lnTo>
                  <a:pt x="2975" y="0"/>
                </a:lnTo>
                <a:lnTo>
                  <a:pt x="2976" y="1"/>
                </a:lnTo>
                <a:lnTo>
                  <a:pt x="2977" y="0"/>
                </a:lnTo>
                <a:lnTo>
                  <a:pt x="2978" y="0"/>
                </a:lnTo>
                <a:lnTo>
                  <a:pt x="2979" y="0"/>
                </a:lnTo>
                <a:lnTo>
                  <a:pt x="2980" y="0"/>
                </a:lnTo>
                <a:lnTo>
                  <a:pt x="2981" y="1"/>
                </a:lnTo>
                <a:lnTo>
                  <a:pt x="2981" y="0"/>
                </a:lnTo>
                <a:lnTo>
                  <a:pt x="2982" y="1"/>
                </a:lnTo>
                <a:lnTo>
                  <a:pt x="2983" y="1"/>
                </a:lnTo>
                <a:lnTo>
                  <a:pt x="2984" y="0"/>
                </a:lnTo>
                <a:lnTo>
                  <a:pt x="2985" y="0"/>
                </a:lnTo>
                <a:lnTo>
                  <a:pt x="2986" y="0"/>
                </a:lnTo>
                <a:lnTo>
                  <a:pt x="2987" y="1"/>
                </a:lnTo>
                <a:lnTo>
                  <a:pt x="2988" y="0"/>
                </a:lnTo>
                <a:lnTo>
                  <a:pt x="2988" y="1"/>
                </a:lnTo>
                <a:lnTo>
                  <a:pt x="2989" y="1"/>
                </a:lnTo>
                <a:lnTo>
                  <a:pt x="2990" y="1"/>
                </a:lnTo>
                <a:lnTo>
                  <a:pt x="2991" y="1"/>
                </a:lnTo>
                <a:lnTo>
                  <a:pt x="2992" y="1"/>
                </a:lnTo>
                <a:lnTo>
                  <a:pt x="2993" y="0"/>
                </a:lnTo>
                <a:lnTo>
                  <a:pt x="2994" y="1"/>
                </a:lnTo>
                <a:lnTo>
                  <a:pt x="2995" y="0"/>
                </a:lnTo>
                <a:lnTo>
                  <a:pt x="2996" y="1"/>
                </a:lnTo>
                <a:lnTo>
                  <a:pt x="2996" y="1"/>
                </a:lnTo>
                <a:lnTo>
                  <a:pt x="2997" y="0"/>
                </a:lnTo>
                <a:lnTo>
                  <a:pt x="2998" y="1"/>
                </a:lnTo>
                <a:lnTo>
                  <a:pt x="2999" y="1"/>
                </a:lnTo>
                <a:lnTo>
                  <a:pt x="3000" y="1"/>
                </a:lnTo>
                <a:lnTo>
                  <a:pt x="3001" y="1"/>
                </a:lnTo>
                <a:lnTo>
                  <a:pt x="3002" y="1"/>
                </a:lnTo>
                <a:lnTo>
                  <a:pt x="3003" y="1"/>
                </a:lnTo>
                <a:lnTo>
                  <a:pt x="3003" y="1"/>
                </a:lnTo>
                <a:lnTo>
                  <a:pt x="3004" y="0"/>
                </a:lnTo>
                <a:lnTo>
                  <a:pt x="3005" y="1"/>
                </a:lnTo>
                <a:lnTo>
                  <a:pt x="3006" y="1"/>
                </a:lnTo>
                <a:lnTo>
                  <a:pt x="3007" y="1"/>
                </a:lnTo>
                <a:lnTo>
                  <a:pt x="3008" y="1"/>
                </a:lnTo>
                <a:lnTo>
                  <a:pt x="3009" y="1"/>
                </a:lnTo>
                <a:lnTo>
                  <a:pt x="3010" y="0"/>
                </a:lnTo>
                <a:lnTo>
                  <a:pt x="3010" y="1"/>
                </a:lnTo>
                <a:lnTo>
                  <a:pt x="3011" y="1"/>
                </a:lnTo>
                <a:lnTo>
                  <a:pt x="3012" y="1"/>
                </a:lnTo>
                <a:lnTo>
                  <a:pt x="3013" y="1"/>
                </a:lnTo>
                <a:lnTo>
                  <a:pt x="3014" y="0"/>
                </a:lnTo>
                <a:lnTo>
                  <a:pt x="3015" y="0"/>
                </a:lnTo>
                <a:lnTo>
                  <a:pt x="3016" y="1"/>
                </a:lnTo>
                <a:lnTo>
                  <a:pt x="3017" y="1"/>
                </a:lnTo>
                <a:lnTo>
                  <a:pt x="3018" y="0"/>
                </a:lnTo>
                <a:lnTo>
                  <a:pt x="3018" y="0"/>
                </a:lnTo>
                <a:lnTo>
                  <a:pt x="3019" y="0"/>
                </a:lnTo>
                <a:lnTo>
                  <a:pt x="3020" y="1"/>
                </a:lnTo>
                <a:lnTo>
                  <a:pt x="3021" y="1"/>
                </a:lnTo>
                <a:lnTo>
                  <a:pt x="3022" y="1"/>
                </a:lnTo>
                <a:lnTo>
                  <a:pt x="3023" y="0"/>
                </a:lnTo>
                <a:lnTo>
                  <a:pt x="3024" y="1"/>
                </a:lnTo>
                <a:lnTo>
                  <a:pt x="3025" y="1"/>
                </a:lnTo>
                <a:lnTo>
                  <a:pt x="3025" y="0"/>
                </a:lnTo>
                <a:lnTo>
                  <a:pt x="3026" y="0"/>
                </a:lnTo>
                <a:lnTo>
                  <a:pt x="3027" y="1"/>
                </a:lnTo>
                <a:lnTo>
                  <a:pt x="3028" y="1"/>
                </a:lnTo>
                <a:lnTo>
                  <a:pt x="3029" y="0"/>
                </a:lnTo>
                <a:lnTo>
                  <a:pt x="3030" y="0"/>
                </a:lnTo>
                <a:lnTo>
                  <a:pt x="3031" y="0"/>
                </a:lnTo>
                <a:lnTo>
                  <a:pt x="3032" y="0"/>
                </a:lnTo>
                <a:lnTo>
                  <a:pt x="3033" y="0"/>
                </a:lnTo>
                <a:lnTo>
                  <a:pt x="3033" y="0"/>
                </a:lnTo>
                <a:lnTo>
                  <a:pt x="3034" y="1"/>
                </a:lnTo>
                <a:lnTo>
                  <a:pt x="3035" y="0"/>
                </a:lnTo>
                <a:lnTo>
                  <a:pt x="3036" y="0"/>
                </a:lnTo>
                <a:lnTo>
                  <a:pt x="3037" y="1"/>
                </a:lnTo>
                <a:lnTo>
                  <a:pt x="3038" y="1"/>
                </a:lnTo>
                <a:lnTo>
                  <a:pt x="3039" y="0"/>
                </a:lnTo>
                <a:lnTo>
                  <a:pt x="3040" y="1"/>
                </a:lnTo>
                <a:lnTo>
                  <a:pt x="3040" y="1"/>
                </a:lnTo>
                <a:lnTo>
                  <a:pt x="3041" y="1"/>
                </a:lnTo>
                <a:lnTo>
                  <a:pt x="3042" y="0"/>
                </a:lnTo>
                <a:lnTo>
                  <a:pt x="3043" y="1"/>
                </a:lnTo>
                <a:lnTo>
                  <a:pt x="3044" y="1"/>
                </a:lnTo>
                <a:lnTo>
                  <a:pt x="3045" y="1"/>
                </a:lnTo>
                <a:lnTo>
                  <a:pt x="3046" y="1"/>
                </a:lnTo>
                <a:lnTo>
                  <a:pt x="3047" y="0"/>
                </a:lnTo>
                <a:lnTo>
                  <a:pt x="3048" y="0"/>
                </a:lnTo>
                <a:lnTo>
                  <a:pt x="3048" y="1"/>
                </a:lnTo>
                <a:lnTo>
                  <a:pt x="3049" y="0"/>
                </a:lnTo>
                <a:lnTo>
                  <a:pt x="3050" y="1"/>
                </a:lnTo>
                <a:lnTo>
                  <a:pt x="3051" y="1"/>
                </a:lnTo>
                <a:lnTo>
                  <a:pt x="3052" y="1"/>
                </a:lnTo>
                <a:lnTo>
                  <a:pt x="3053" y="1"/>
                </a:lnTo>
                <a:lnTo>
                  <a:pt x="3054" y="1"/>
                </a:lnTo>
                <a:lnTo>
                  <a:pt x="3055" y="0"/>
                </a:lnTo>
                <a:lnTo>
                  <a:pt x="3055" y="1"/>
                </a:lnTo>
                <a:lnTo>
                  <a:pt x="3056" y="0"/>
                </a:lnTo>
                <a:lnTo>
                  <a:pt x="3057" y="1"/>
                </a:lnTo>
                <a:lnTo>
                  <a:pt x="3058" y="1"/>
                </a:lnTo>
                <a:lnTo>
                  <a:pt x="3059" y="0"/>
                </a:lnTo>
                <a:lnTo>
                  <a:pt x="3060" y="1"/>
                </a:lnTo>
                <a:lnTo>
                  <a:pt x="3061" y="1"/>
                </a:lnTo>
                <a:lnTo>
                  <a:pt x="3062" y="1"/>
                </a:lnTo>
                <a:lnTo>
                  <a:pt x="3063" y="0"/>
                </a:lnTo>
                <a:lnTo>
                  <a:pt x="3063" y="1"/>
                </a:lnTo>
                <a:lnTo>
                  <a:pt x="3064" y="1"/>
                </a:lnTo>
                <a:lnTo>
                  <a:pt x="3065" y="0"/>
                </a:lnTo>
                <a:lnTo>
                  <a:pt x="3066" y="0"/>
                </a:lnTo>
                <a:lnTo>
                  <a:pt x="3067" y="0"/>
                </a:lnTo>
                <a:lnTo>
                  <a:pt x="3068" y="1"/>
                </a:lnTo>
                <a:lnTo>
                  <a:pt x="3069" y="0"/>
                </a:lnTo>
                <a:lnTo>
                  <a:pt x="3070" y="1"/>
                </a:lnTo>
                <a:lnTo>
                  <a:pt x="3070" y="0"/>
                </a:lnTo>
                <a:lnTo>
                  <a:pt x="3071" y="0"/>
                </a:lnTo>
                <a:lnTo>
                  <a:pt x="3072" y="0"/>
                </a:lnTo>
                <a:lnTo>
                  <a:pt x="3073" y="1"/>
                </a:lnTo>
                <a:lnTo>
                  <a:pt x="3074" y="0"/>
                </a:lnTo>
                <a:lnTo>
                  <a:pt x="3075" y="0"/>
                </a:lnTo>
                <a:lnTo>
                  <a:pt x="3076" y="0"/>
                </a:lnTo>
                <a:lnTo>
                  <a:pt x="3077" y="0"/>
                </a:lnTo>
                <a:lnTo>
                  <a:pt x="3078" y="1"/>
                </a:lnTo>
                <a:lnTo>
                  <a:pt x="3078" y="1"/>
                </a:lnTo>
                <a:lnTo>
                  <a:pt x="3079" y="0"/>
                </a:lnTo>
                <a:lnTo>
                  <a:pt x="3080" y="1"/>
                </a:lnTo>
                <a:lnTo>
                  <a:pt x="3081" y="1"/>
                </a:lnTo>
                <a:lnTo>
                  <a:pt x="3082" y="1"/>
                </a:lnTo>
                <a:lnTo>
                  <a:pt x="3083" y="2"/>
                </a:lnTo>
                <a:lnTo>
                  <a:pt x="3084" y="1"/>
                </a:lnTo>
                <a:lnTo>
                  <a:pt x="3085" y="1"/>
                </a:lnTo>
                <a:lnTo>
                  <a:pt x="3085" y="1"/>
                </a:lnTo>
                <a:lnTo>
                  <a:pt x="3086" y="1"/>
                </a:lnTo>
                <a:lnTo>
                  <a:pt x="3087" y="2"/>
                </a:lnTo>
                <a:lnTo>
                  <a:pt x="3088" y="1"/>
                </a:lnTo>
                <a:lnTo>
                  <a:pt x="3089" y="1"/>
                </a:lnTo>
                <a:lnTo>
                  <a:pt x="3090" y="1"/>
                </a:lnTo>
                <a:lnTo>
                  <a:pt x="3091" y="1"/>
                </a:lnTo>
                <a:lnTo>
                  <a:pt x="3092" y="1"/>
                </a:lnTo>
                <a:lnTo>
                  <a:pt x="3093" y="1"/>
                </a:lnTo>
                <a:lnTo>
                  <a:pt x="3093" y="1"/>
                </a:lnTo>
                <a:lnTo>
                  <a:pt x="3094" y="1"/>
                </a:lnTo>
                <a:lnTo>
                  <a:pt x="3095" y="1"/>
                </a:lnTo>
                <a:lnTo>
                  <a:pt x="3096" y="1"/>
                </a:lnTo>
                <a:lnTo>
                  <a:pt x="3097" y="1"/>
                </a:lnTo>
                <a:lnTo>
                  <a:pt x="3098" y="1"/>
                </a:lnTo>
                <a:lnTo>
                  <a:pt x="3099" y="1"/>
                </a:lnTo>
                <a:lnTo>
                  <a:pt x="3100" y="1"/>
                </a:lnTo>
                <a:lnTo>
                  <a:pt x="3100" y="0"/>
                </a:lnTo>
                <a:lnTo>
                  <a:pt x="3101" y="0"/>
                </a:lnTo>
                <a:lnTo>
                  <a:pt x="3102" y="1"/>
                </a:lnTo>
                <a:lnTo>
                  <a:pt x="3103" y="0"/>
                </a:lnTo>
                <a:lnTo>
                  <a:pt x="3104" y="1"/>
                </a:lnTo>
                <a:lnTo>
                  <a:pt x="3105" y="1"/>
                </a:lnTo>
                <a:lnTo>
                  <a:pt x="3106" y="1"/>
                </a:lnTo>
                <a:lnTo>
                  <a:pt x="3107" y="1"/>
                </a:lnTo>
                <a:lnTo>
                  <a:pt x="3108" y="1"/>
                </a:lnTo>
                <a:lnTo>
                  <a:pt x="3108" y="1"/>
                </a:lnTo>
                <a:lnTo>
                  <a:pt x="3109" y="2"/>
                </a:lnTo>
                <a:lnTo>
                  <a:pt x="3110" y="1"/>
                </a:lnTo>
                <a:lnTo>
                  <a:pt x="3111" y="2"/>
                </a:lnTo>
                <a:lnTo>
                  <a:pt x="3112" y="2"/>
                </a:lnTo>
                <a:lnTo>
                  <a:pt x="3113" y="2"/>
                </a:lnTo>
                <a:lnTo>
                  <a:pt x="3114" y="1"/>
                </a:lnTo>
                <a:lnTo>
                  <a:pt x="3115" y="2"/>
                </a:lnTo>
                <a:lnTo>
                  <a:pt x="3115" y="2"/>
                </a:lnTo>
                <a:lnTo>
                  <a:pt x="3116" y="2"/>
                </a:lnTo>
                <a:lnTo>
                  <a:pt x="3117" y="2"/>
                </a:lnTo>
                <a:lnTo>
                  <a:pt x="3118" y="2"/>
                </a:lnTo>
                <a:lnTo>
                  <a:pt x="3119" y="2"/>
                </a:lnTo>
                <a:lnTo>
                  <a:pt x="3120" y="2"/>
                </a:lnTo>
                <a:lnTo>
                  <a:pt x="3121" y="2"/>
                </a:lnTo>
                <a:lnTo>
                  <a:pt x="3122" y="3"/>
                </a:lnTo>
                <a:lnTo>
                  <a:pt x="3123" y="4"/>
                </a:lnTo>
                <a:lnTo>
                  <a:pt x="3123" y="5"/>
                </a:lnTo>
                <a:lnTo>
                  <a:pt x="3124" y="7"/>
                </a:lnTo>
                <a:lnTo>
                  <a:pt x="3125" y="7"/>
                </a:lnTo>
                <a:lnTo>
                  <a:pt x="3126" y="8"/>
                </a:lnTo>
                <a:lnTo>
                  <a:pt x="3127" y="11"/>
                </a:lnTo>
                <a:lnTo>
                  <a:pt x="3128" y="11"/>
                </a:lnTo>
                <a:lnTo>
                  <a:pt x="3129" y="13"/>
                </a:lnTo>
                <a:lnTo>
                  <a:pt x="3130" y="14"/>
                </a:lnTo>
                <a:lnTo>
                  <a:pt x="3130" y="13"/>
                </a:lnTo>
                <a:lnTo>
                  <a:pt x="3131" y="16"/>
                </a:lnTo>
                <a:lnTo>
                  <a:pt x="3132" y="17"/>
                </a:lnTo>
                <a:lnTo>
                  <a:pt x="3133" y="15"/>
                </a:lnTo>
                <a:lnTo>
                  <a:pt x="3134" y="16"/>
                </a:lnTo>
                <a:lnTo>
                  <a:pt x="3135" y="16"/>
                </a:lnTo>
                <a:lnTo>
                  <a:pt x="3136" y="16"/>
                </a:lnTo>
                <a:lnTo>
                  <a:pt x="3137" y="16"/>
                </a:lnTo>
                <a:lnTo>
                  <a:pt x="3138" y="16"/>
                </a:lnTo>
                <a:lnTo>
                  <a:pt x="3138" y="16"/>
                </a:lnTo>
                <a:lnTo>
                  <a:pt x="3139" y="16"/>
                </a:lnTo>
                <a:lnTo>
                  <a:pt x="3140" y="15"/>
                </a:lnTo>
                <a:lnTo>
                  <a:pt x="3141" y="15"/>
                </a:lnTo>
                <a:lnTo>
                  <a:pt x="3142" y="13"/>
                </a:lnTo>
                <a:lnTo>
                  <a:pt x="3143" y="13"/>
                </a:lnTo>
                <a:lnTo>
                  <a:pt x="3144" y="13"/>
                </a:lnTo>
                <a:lnTo>
                  <a:pt x="3145" y="14"/>
                </a:lnTo>
                <a:lnTo>
                  <a:pt x="3145" y="12"/>
                </a:lnTo>
                <a:lnTo>
                  <a:pt x="3146" y="12"/>
                </a:lnTo>
                <a:lnTo>
                  <a:pt x="3147" y="12"/>
                </a:lnTo>
                <a:lnTo>
                  <a:pt x="3148" y="13"/>
                </a:lnTo>
                <a:lnTo>
                  <a:pt x="3149" y="11"/>
                </a:lnTo>
                <a:lnTo>
                  <a:pt x="3150" y="12"/>
                </a:lnTo>
                <a:lnTo>
                  <a:pt x="3151" y="11"/>
                </a:lnTo>
                <a:lnTo>
                  <a:pt x="3152" y="10"/>
                </a:lnTo>
                <a:lnTo>
                  <a:pt x="3153" y="11"/>
                </a:lnTo>
                <a:lnTo>
                  <a:pt x="3153" y="10"/>
                </a:lnTo>
                <a:lnTo>
                  <a:pt x="3154" y="10"/>
                </a:lnTo>
                <a:lnTo>
                  <a:pt x="3155" y="8"/>
                </a:lnTo>
                <a:lnTo>
                  <a:pt x="3156" y="9"/>
                </a:lnTo>
                <a:lnTo>
                  <a:pt x="3157" y="9"/>
                </a:lnTo>
                <a:lnTo>
                  <a:pt x="3158" y="9"/>
                </a:lnTo>
                <a:lnTo>
                  <a:pt x="3159" y="9"/>
                </a:lnTo>
                <a:lnTo>
                  <a:pt x="3160" y="8"/>
                </a:lnTo>
                <a:lnTo>
                  <a:pt x="3160" y="8"/>
                </a:lnTo>
                <a:lnTo>
                  <a:pt x="3161" y="7"/>
                </a:lnTo>
                <a:lnTo>
                  <a:pt x="3162" y="8"/>
                </a:lnTo>
                <a:lnTo>
                  <a:pt x="3163" y="8"/>
                </a:lnTo>
                <a:lnTo>
                  <a:pt x="3164" y="8"/>
                </a:lnTo>
                <a:lnTo>
                  <a:pt x="3165" y="7"/>
                </a:lnTo>
                <a:lnTo>
                  <a:pt x="3166" y="7"/>
                </a:lnTo>
                <a:lnTo>
                  <a:pt x="3167" y="7"/>
                </a:lnTo>
                <a:lnTo>
                  <a:pt x="3168" y="7"/>
                </a:lnTo>
                <a:lnTo>
                  <a:pt x="3168" y="6"/>
                </a:lnTo>
                <a:lnTo>
                  <a:pt x="3169" y="7"/>
                </a:lnTo>
                <a:lnTo>
                  <a:pt x="3170" y="7"/>
                </a:lnTo>
                <a:lnTo>
                  <a:pt x="3171" y="7"/>
                </a:lnTo>
                <a:lnTo>
                  <a:pt x="3172" y="7"/>
                </a:lnTo>
                <a:lnTo>
                  <a:pt x="3173" y="7"/>
                </a:lnTo>
                <a:lnTo>
                  <a:pt x="3174" y="6"/>
                </a:lnTo>
                <a:lnTo>
                  <a:pt x="3175" y="7"/>
                </a:lnTo>
                <a:lnTo>
                  <a:pt x="3175" y="7"/>
                </a:lnTo>
                <a:lnTo>
                  <a:pt x="3176" y="7"/>
                </a:lnTo>
                <a:lnTo>
                  <a:pt x="3177" y="6"/>
                </a:lnTo>
                <a:lnTo>
                  <a:pt x="3178" y="7"/>
                </a:lnTo>
                <a:lnTo>
                  <a:pt x="3179" y="7"/>
                </a:lnTo>
                <a:lnTo>
                  <a:pt x="3180" y="6"/>
                </a:lnTo>
                <a:lnTo>
                  <a:pt x="3181" y="6"/>
                </a:lnTo>
                <a:lnTo>
                  <a:pt x="3182" y="6"/>
                </a:lnTo>
                <a:lnTo>
                  <a:pt x="3183" y="6"/>
                </a:lnTo>
                <a:lnTo>
                  <a:pt x="3183" y="6"/>
                </a:lnTo>
                <a:lnTo>
                  <a:pt x="3184" y="5"/>
                </a:lnTo>
                <a:lnTo>
                  <a:pt x="3185" y="6"/>
                </a:lnTo>
                <a:lnTo>
                  <a:pt x="3186" y="7"/>
                </a:lnTo>
                <a:lnTo>
                  <a:pt x="3187" y="6"/>
                </a:lnTo>
                <a:lnTo>
                  <a:pt x="3188" y="6"/>
                </a:lnTo>
                <a:lnTo>
                  <a:pt x="3189" y="5"/>
                </a:lnTo>
                <a:lnTo>
                  <a:pt x="3190" y="6"/>
                </a:lnTo>
                <a:lnTo>
                  <a:pt x="3190" y="5"/>
                </a:lnTo>
                <a:lnTo>
                  <a:pt x="3191" y="5"/>
                </a:lnTo>
                <a:lnTo>
                  <a:pt x="3192" y="6"/>
                </a:lnTo>
                <a:lnTo>
                  <a:pt x="3193" y="6"/>
                </a:lnTo>
                <a:lnTo>
                  <a:pt x="3194" y="5"/>
                </a:lnTo>
                <a:lnTo>
                  <a:pt x="3195" y="7"/>
                </a:lnTo>
                <a:lnTo>
                  <a:pt x="3196" y="6"/>
                </a:lnTo>
                <a:lnTo>
                  <a:pt x="3197" y="7"/>
                </a:lnTo>
                <a:lnTo>
                  <a:pt x="3198" y="7"/>
                </a:lnTo>
                <a:lnTo>
                  <a:pt x="3198" y="7"/>
                </a:lnTo>
                <a:lnTo>
                  <a:pt x="3199" y="6"/>
                </a:lnTo>
                <a:lnTo>
                  <a:pt x="3200" y="8"/>
                </a:lnTo>
                <a:lnTo>
                  <a:pt x="3201" y="7"/>
                </a:lnTo>
                <a:lnTo>
                  <a:pt x="3202" y="7"/>
                </a:lnTo>
                <a:lnTo>
                  <a:pt x="3203" y="7"/>
                </a:lnTo>
                <a:lnTo>
                  <a:pt x="3204" y="6"/>
                </a:lnTo>
                <a:lnTo>
                  <a:pt x="3205" y="5"/>
                </a:lnTo>
                <a:lnTo>
                  <a:pt x="3205" y="6"/>
                </a:lnTo>
                <a:lnTo>
                  <a:pt x="3206" y="5"/>
                </a:lnTo>
                <a:lnTo>
                  <a:pt x="3207" y="4"/>
                </a:lnTo>
                <a:lnTo>
                  <a:pt x="3208" y="5"/>
                </a:lnTo>
                <a:lnTo>
                  <a:pt x="3209" y="5"/>
                </a:lnTo>
                <a:lnTo>
                  <a:pt x="3210" y="4"/>
                </a:lnTo>
                <a:lnTo>
                  <a:pt x="3211" y="4"/>
                </a:lnTo>
                <a:lnTo>
                  <a:pt x="3212" y="4"/>
                </a:lnTo>
                <a:lnTo>
                  <a:pt x="3212" y="4"/>
                </a:lnTo>
                <a:lnTo>
                  <a:pt x="3213" y="4"/>
                </a:lnTo>
                <a:lnTo>
                  <a:pt x="3214" y="4"/>
                </a:lnTo>
                <a:lnTo>
                  <a:pt x="3215" y="5"/>
                </a:lnTo>
                <a:lnTo>
                  <a:pt x="3216" y="5"/>
                </a:lnTo>
                <a:lnTo>
                  <a:pt x="3217" y="5"/>
                </a:lnTo>
                <a:lnTo>
                  <a:pt x="3218" y="5"/>
                </a:lnTo>
                <a:lnTo>
                  <a:pt x="3219" y="5"/>
                </a:lnTo>
                <a:lnTo>
                  <a:pt x="3220" y="6"/>
                </a:lnTo>
                <a:lnTo>
                  <a:pt x="3220" y="5"/>
                </a:lnTo>
                <a:lnTo>
                  <a:pt x="3221" y="6"/>
                </a:lnTo>
                <a:lnTo>
                  <a:pt x="3222" y="6"/>
                </a:lnTo>
                <a:lnTo>
                  <a:pt x="3223" y="5"/>
                </a:lnTo>
                <a:lnTo>
                  <a:pt x="3224" y="5"/>
                </a:lnTo>
                <a:lnTo>
                  <a:pt x="3225" y="6"/>
                </a:lnTo>
                <a:lnTo>
                  <a:pt x="3226" y="5"/>
                </a:lnTo>
                <a:lnTo>
                  <a:pt x="3227" y="5"/>
                </a:lnTo>
                <a:lnTo>
                  <a:pt x="3227" y="4"/>
                </a:lnTo>
                <a:lnTo>
                  <a:pt x="3228" y="5"/>
                </a:lnTo>
                <a:lnTo>
                  <a:pt x="3229" y="4"/>
                </a:lnTo>
                <a:lnTo>
                  <a:pt x="3230" y="4"/>
                </a:lnTo>
                <a:lnTo>
                  <a:pt x="3231" y="4"/>
                </a:lnTo>
                <a:lnTo>
                  <a:pt x="3232" y="3"/>
                </a:lnTo>
                <a:lnTo>
                  <a:pt x="3233" y="4"/>
                </a:lnTo>
                <a:lnTo>
                  <a:pt x="3234" y="4"/>
                </a:lnTo>
                <a:lnTo>
                  <a:pt x="3235" y="4"/>
                </a:lnTo>
                <a:lnTo>
                  <a:pt x="3235" y="4"/>
                </a:lnTo>
                <a:lnTo>
                  <a:pt x="3236" y="4"/>
                </a:lnTo>
                <a:lnTo>
                  <a:pt x="3237" y="3"/>
                </a:lnTo>
                <a:lnTo>
                  <a:pt x="3238" y="4"/>
                </a:lnTo>
                <a:lnTo>
                  <a:pt x="3239" y="3"/>
                </a:lnTo>
                <a:lnTo>
                  <a:pt x="3240" y="3"/>
                </a:lnTo>
                <a:lnTo>
                  <a:pt x="3241" y="3"/>
                </a:lnTo>
                <a:lnTo>
                  <a:pt x="3242" y="4"/>
                </a:lnTo>
                <a:lnTo>
                  <a:pt x="3242" y="3"/>
                </a:lnTo>
                <a:lnTo>
                  <a:pt x="3243" y="3"/>
                </a:lnTo>
                <a:lnTo>
                  <a:pt x="3244" y="2"/>
                </a:lnTo>
                <a:lnTo>
                  <a:pt x="3245" y="3"/>
                </a:lnTo>
                <a:lnTo>
                  <a:pt x="3246" y="3"/>
                </a:lnTo>
                <a:lnTo>
                  <a:pt x="3247" y="3"/>
                </a:lnTo>
                <a:lnTo>
                  <a:pt x="3248" y="4"/>
                </a:lnTo>
                <a:lnTo>
                  <a:pt x="3249" y="3"/>
                </a:lnTo>
                <a:lnTo>
                  <a:pt x="3250" y="3"/>
                </a:lnTo>
                <a:lnTo>
                  <a:pt x="3250" y="4"/>
                </a:lnTo>
                <a:lnTo>
                  <a:pt x="3251" y="5"/>
                </a:lnTo>
                <a:lnTo>
                  <a:pt x="3252" y="4"/>
                </a:lnTo>
                <a:lnTo>
                  <a:pt x="3253" y="5"/>
                </a:lnTo>
                <a:lnTo>
                  <a:pt x="3254" y="4"/>
                </a:lnTo>
                <a:lnTo>
                  <a:pt x="3255" y="5"/>
                </a:lnTo>
                <a:lnTo>
                  <a:pt x="3256" y="5"/>
                </a:lnTo>
                <a:lnTo>
                  <a:pt x="3257" y="5"/>
                </a:lnTo>
                <a:lnTo>
                  <a:pt x="3257" y="5"/>
                </a:lnTo>
                <a:lnTo>
                  <a:pt x="3258" y="7"/>
                </a:lnTo>
                <a:lnTo>
                  <a:pt x="3259" y="6"/>
                </a:lnTo>
                <a:lnTo>
                  <a:pt x="3260" y="7"/>
                </a:lnTo>
                <a:lnTo>
                  <a:pt x="3261" y="7"/>
                </a:lnTo>
                <a:lnTo>
                  <a:pt x="3262" y="8"/>
                </a:lnTo>
                <a:lnTo>
                  <a:pt x="3263" y="7"/>
                </a:lnTo>
                <a:lnTo>
                  <a:pt x="3264" y="7"/>
                </a:lnTo>
                <a:lnTo>
                  <a:pt x="3265" y="6"/>
                </a:lnTo>
                <a:lnTo>
                  <a:pt x="3265" y="5"/>
                </a:lnTo>
                <a:lnTo>
                  <a:pt x="3266" y="5"/>
                </a:lnTo>
                <a:lnTo>
                  <a:pt x="3267" y="5"/>
                </a:lnTo>
                <a:lnTo>
                  <a:pt x="3268" y="5"/>
                </a:lnTo>
                <a:lnTo>
                  <a:pt x="3269" y="5"/>
                </a:lnTo>
                <a:lnTo>
                  <a:pt x="3270" y="4"/>
                </a:lnTo>
                <a:lnTo>
                  <a:pt x="3271" y="4"/>
                </a:lnTo>
                <a:lnTo>
                  <a:pt x="3272" y="3"/>
                </a:lnTo>
                <a:lnTo>
                  <a:pt x="3272" y="4"/>
                </a:lnTo>
                <a:lnTo>
                  <a:pt x="3273" y="3"/>
                </a:lnTo>
                <a:lnTo>
                  <a:pt x="3274" y="4"/>
                </a:lnTo>
                <a:lnTo>
                  <a:pt x="3275" y="3"/>
                </a:lnTo>
                <a:lnTo>
                  <a:pt x="3276" y="3"/>
                </a:lnTo>
                <a:lnTo>
                  <a:pt x="3277" y="4"/>
                </a:lnTo>
                <a:lnTo>
                  <a:pt x="3278" y="4"/>
                </a:lnTo>
                <a:lnTo>
                  <a:pt x="3279" y="5"/>
                </a:lnTo>
                <a:lnTo>
                  <a:pt x="3280" y="5"/>
                </a:lnTo>
                <a:lnTo>
                  <a:pt x="3280" y="7"/>
                </a:lnTo>
                <a:lnTo>
                  <a:pt x="3281" y="9"/>
                </a:lnTo>
                <a:lnTo>
                  <a:pt x="3282" y="10"/>
                </a:lnTo>
                <a:lnTo>
                  <a:pt x="3283" y="14"/>
                </a:lnTo>
                <a:lnTo>
                  <a:pt x="3284" y="17"/>
                </a:lnTo>
                <a:lnTo>
                  <a:pt x="3285" y="19"/>
                </a:lnTo>
                <a:lnTo>
                  <a:pt x="3286" y="22"/>
                </a:lnTo>
                <a:lnTo>
                  <a:pt x="3287" y="24"/>
                </a:lnTo>
                <a:lnTo>
                  <a:pt x="3287" y="25"/>
                </a:lnTo>
                <a:lnTo>
                  <a:pt x="3288" y="25"/>
                </a:lnTo>
                <a:lnTo>
                  <a:pt x="3289" y="26"/>
                </a:lnTo>
                <a:lnTo>
                  <a:pt x="3290" y="26"/>
                </a:lnTo>
                <a:lnTo>
                  <a:pt x="3291" y="29"/>
                </a:lnTo>
                <a:lnTo>
                  <a:pt x="3292" y="33"/>
                </a:lnTo>
                <a:lnTo>
                  <a:pt x="3293" y="37"/>
                </a:lnTo>
                <a:lnTo>
                  <a:pt x="3294" y="42"/>
                </a:lnTo>
                <a:lnTo>
                  <a:pt x="3295" y="46"/>
                </a:lnTo>
                <a:lnTo>
                  <a:pt x="3295" y="47"/>
                </a:lnTo>
                <a:lnTo>
                  <a:pt x="3296" y="49"/>
                </a:lnTo>
                <a:lnTo>
                  <a:pt x="3297" y="48"/>
                </a:lnTo>
                <a:lnTo>
                  <a:pt x="3298" y="46"/>
                </a:lnTo>
                <a:lnTo>
                  <a:pt x="3299" y="40"/>
                </a:lnTo>
                <a:lnTo>
                  <a:pt x="3300" y="36"/>
                </a:lnTo>
                <a:lnTo>
                  <a:pt x="3301" y="35"/>
                </a:lnTo>
                <a:lnTo>
                  <a:pt x="3302" y="30"/>
                </a:lnTo>
                <a:lnTo>
                  <a:pt x="3302" y="25"/>
                </a:lnTo>
                <a:lnTo>
                  <a:pt x="3303" y="23"/>
                </a:lnTo>
                <a:lnTo>
                  <a:pt x="3304" y="19"/>
                </a:lnTo>
                <a:lnTo>
                  <a:pt x="3305" y="17"/>
                </a:lnTo>
                <a:lnTo>
                  <a:pt x="3306" y="15"/>
                </a:lnTo>
                <a:lnTo>
                  <a:pt x="3307" y="14"/>
                </a:lnTo>
                <a:lnTo>
                  <a:pt x="3308" y="13"/>
                </a:lnTo>
                <a:lnTo>
                  <a:pt x="3309" y="12"/>
                </a:lnTo>
                <a:lnTo>
                  <a:pt x="3310" y="10"/>
                </a:lnTo>
                <a:lnTo>
                  <a:pt x="3310" y="10"/>
                </a:lnTo>
                <a:lnTo>
                  <a:pt x="3311" y="9"/>
                </a:lnTo>
                <a:lnTo>
                  <a:pt x="3312" y="8"/>
                </a:lnTo>
                <a:lnTo>
                  <a:pt x="3313" y="8"/>
                </a:lnTo>
                <a:lnTo>
                  <a:pt x="3314" y="9"/>
                </a:lnTo>
                <a:lnTo>
                  <a:pt x="3315" y="8"/>
                </a:lnTo>
                <a:lnTo>
                  <a:pt x="3316" y="7"/>
                </a:lnTo>
                <a:lnTo>
                  <a:pt x="3317" y="7"/>
                </a:lnTo>
                <a:lnTo>
                  <a:pt x="3317" y="6"/>
                </a:lnTo>
                <a:lnTo>
                  <a:pt x="3318" y="6"/>
                </a:lnTo>
                <a:lnTo>
                  <a:pt x="3319" y="6"/>
                </a:lnTo>
                <a:lnTo>
                  <a:pt x="3320" y="6"/>
                </a:lnTo>
                <a:lnTo>
                  <a:pt x="3321" y="6"/>
                </a:lnTo>
                <a:lnTo>
                  <a:pt x="3322" y="5"/>
                </a:lnTo>
                <a:lnTo>
                  <a:pt x="3323" y="5"/>
                </a:lnTo>
                <a:lnTo>
                  <a:pt x="3324" y="6"/>
                </a:lnTo>
                <a:lnTo>
                  <a:pt x="3325" y="5"/>
                </a:lnTo>
                <a:lnTo>
                  <a:pt x="3325" y="4"/>
                </a:lnTo>
                <a:lnTo>
                  <a:pt x="3326" y="5"/>
                </a:lnTo>
                <a:lnTo>
                  <a:pt x="3327" y="6"/>
                </a:lnTo>
                <a:lnTo>
                  <a:pt x="3328" y="4"/>
                </a:lnTo>
                <a:lnTo>
                  <a:pt x="3329" y="4"/>
                </a:lnTo>
                <a:lnTo>
                  <a:pt x="3330" y="3"/>
                </a:lnTo>
                <a:lnTo>
                  <a:pt x="3331" y="4"/>
                </a:lnTo>
                <a:lnTo>
                  <a:pt x="3332" y="3"/>
                </a:lnTo>
                <a:lnTo>
                  <a:pt x="3332" y="3"/>
                </a:lnTo>
                <a:lnTo>
                  <a:pt x="3333" y="4"/>
                </a:lnTo>
                <a:lnTo>
                  <a:pt x="3334" y="3"/>
                </a:lnTo>
                <a:lnTo>
                  <a:pt x="3335" y="3"/>
                </a:lnTo>
                <a:lnTo>
                  <a:pt x="3336" y="3"/>
                </a:lnTo>
                <a:lnTo>
                  <a:pt x="3337" y="3"/>
                </a:lnTo>
                <a:lnTo>
                  <a:pt x="3338" y="3"/>
                </a:lnTo>
                <a:lnTo>
                  <a:pt x="3339" y="3"/>
                </a:lnTo>
                <a:lnTo>
                  <a:pt x="3340" y="3"/>
                </a:lnTo>
                <a:lnTo>
                  <a:pt x="3340" y="2"/>
                </a:lnTo>
                <a:lnTo>
                  <a:pt x="3341" y="3"/>
                </a:lnTo>
                <a:lnTo>
                  <a:pt x="3342" y="2"/>
                </a:lnTo>
                <a:lnTo>
                  <a:pt x="3343" y="3"/>
                </a:lnTo>
                <a:lnTo>
                  <a:pt x="3344" y="2"/>
                </a:lnTo>
                <a:lnTo>
                  <a:pt x="3345" y="2"/>
                </a:lnTo>
                <a:lnTo>
                  <a:pt x="3346" y="2"/>
                </a:lnTo>
                <a:lnTo>
                  <a:pt x="3347" y="2"/>
                </a:lnTo>
                <a:lnTo>
                  <a:pt x="3347" y="2"/>
                </a:lnTo>
                <a:lnTo>
                  <a:pt x="3348" y="3"/>
                </a:lnTo>
                <a:lnTo>
                  <a:pt x="3349" y="3"/>
                </a:lnTo>
                <a:lnTo>
                  <a:pt x="3350" y="3"/>
                </a:lnTo>
                <a:lnTo>
                  <a:pt x="3351" y="3"/>
                </a:lnTo>
                <a:lnTo>
                  <a:pt x="3352" y="2"/>
                </a:lnTo>
                <a:lnTo>
                  <a:pt x="3353" y="3"/>
                </a:lnTo>
                <a:lnTo>
                  <a:pt x="3354" y="3"/>
                </a:lnTo>
                <a:lnTo>
                  <a:pt x="3355" y="3"/>
                </a:lnTo>
                <a:lnTo>
                  <a:pt x="3355" y="4"/>
                </a:lnTo>
                <a:lnTo>
                  <a:pt x="3356" y="2"/>
                </a:lnTo>
                <a:lnTo>
                  <a:pt x="3357" y="2"/>
                </a:lnTo>
                <a:lnTo>
                  <a:pt x="3358" y="2"/>
                </a:lnTo>
                <a:lnTo>
                  <a:pt x="3359" y="3"/>
                </a:lnTo>
                <a:lnTo>
                  <a:pt x="3360" y="3"/>
                </a:lnTo>
                <a:lnTo>
                  <a:pt x="3361" y="2"/>
                </a:lnTo>
                <a:lnTo>
                  <a:pt x="3362" y="2"/>
                </a:lnTo>
                <a:lnTo>
                  <a:pt x="3362" y="2"/>
                </a:lnTo>
                <a:lnTo>
                  <a:pt x="3363" y="3"/>
                </a:lnTo>
                <a:lnTo>
                  <a:pt x="3364" y="3"/>
                </a:lnTo>
                <a:lnTo>
                  <a:pt x="3365" y="2"/>
                </a:lnTo>
                <a:lnTo>
                  <a:pt x="3366" y="1"/>
                </a:lnTo>
                <a:lnTo>
                  <a:pt x="3367" y="2"/>
                </a:lnTo>
                <a:lnTo>
                  <a:pt x="3368" y="2"/>
                </a:lnTo>
                <a:lnTo>
                  <a:pt x="3369" y="1"/>
                </a:lnTo>
                <a:lnTo>
                  <a:pt x="3370" y="2"/>
                </a:lnTo>
                <a:lnTo>
                  <a:pt x="3370" y="1"/>
                </a:lnTo>
                <a:lnTo>
                  <a:pt x="3371" y="1"/>
                </a:lnTo>
                <a:lnTo>
                  <a:pt x="3372" y="1"/>
                </a:lnTo>
                <a:lnTo>
                  <a:pt x="3373" y="1"/>
                </a:lnTo>
                <a:lnTo>
                  <a:pt x="3374" y="1"/>
                </a:lnTo>
                <a:lnTo>
                  <a:pt x="3375" y="1"/>
                </a:lnTo>
                <a:lnTo>
                  <a:pt x="3376" y="1"/>
                </a:lnTo>
                <a:lnTo>
                  <a:pt x="3377" y="1"/>
                </a:lnTo>
                <a:lnTo>
                  <a:pt x="3377" y="1"/>
                </a:lnTo>
                <a:lnTo>
                  <a:pt x="3378" y="2"/>
                </a:lnTo>
                <a:lnTo>
                  <a:pt x="3379" y="2"/>
                </a:lnTo>
                <a:lnTo>
                  <a:pt x="3380" y="1"/>
                </a:lnTo>
                <a:lnTo>
                  <a:pt x="3381" y="2"/>
                </a:lnTo>
                <a:lnTo>
                  <a:pt x="3382" y="2"/>
                </a:lnTo>
                <a:lnTo>
                  <a:pt x="3383" y="1"/>
                </a:lnTo>
                <a:lnTo>
                  <a:pt x="3384" y="2"/>
                </a:lnTo>
                <a:lnTo>
                  <a:pt x="3385" y="3"/>
                </a:lnTo>
                <a:lnTo>
                  <a:pt x="3385" y="2"/>
                </a:lnTo>
              </a:path>
            </a:pathLst>
          </a:custGeom>
          <a:noFill/>
          <a:ln w="0">
            <a:solidFill>
              <a:srgbClr val="00007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Freeform 176"/>
          <p:cNvSpPr>
            <a:spLocks/>
          </p:cNvSpPr>
          <p:nvPr/>
        </p:nvSpPr>
        <p:spPr bwMode="auto">
          <a:xfrm flipV="1">
            <a:off x="3629027" y="3622675"/>
            <a:ext cx="2236788" cy="1574800"/>
          </a:xfrm>
          <a:custGeom>
            <a:avLst/>
            <a:gdLst>
              <a:gd name="T0" fmla="*/ 52 w 3386"/>
              <a:gd name="T1" fmla="*/ 3 h 2004"/>
              <a:gd name="T2" fmla="*/ 105 w 3386"/>
              <a:gd name="T3" fmla="*/ 7 h 2004"/>
              <a:gd name="T4" fmla="*/ 158 w 3386"/>
              <a:gd name="T5" fmla="*/ 3 h 2004"/>
              <a:gd name="T6" fmla="*/ 211 w 3386"/>
              <a:gd name="T7" fmla="*/ 7 h 2004"/>
              <a:gd name="T8" fmla="*/ 264 w 3386"/>
              <a:gd name="T9" fmla="*/ 3 h 2004"/>
              <a:gd name="T10" fmla="*/ 317 w 3386"/>
              <a:gd name="T11" fmla="*/ 2 h 2004"/>
              <a:gd name="T12" fmla="*/ 370 w 3386"/>
              <a:gd name="T13" fmla="*/ 13 h 2004"/>
              <a:gd name="T14" fmla="*/ 423 w 3386"/>
              <a:gd name="T15" fmla="*/ 1 h 2004"/>
              <a:gd name="T16" fmla="*/ 476 w 3386"/>
              <a:gd name="T17" fmla="*/ 1 h 2004"/>
              <a:gd name="T18" fmla="*/ 529 w 3386"/>
              <a:gd name="T19" fmla="*/ 6 h 2004"/>
              <a:gd name="T20" fmla="*/ 582 w 3386"/>
              <a:gd name="T21" fmla="*/ 12 h 2004"/>
              <a:gd name="T22" fmla="*/ 635 w 3386"/>
              <a:gd name="T23" fmla="*/ 8 h 2004"/>
              <a:gd name="T24" fmla="*/ 688 w 3386"/>
              <a:gd name="T25" fmla="*/ 2 h 2004"/>
              <a:gd name="T26" fmla="*/ 740 w 3386"/>
              <a:gd name="T27" fmla="*/ 3 h 2004"/>
              <a:gd name="T28" fmla="*/ 793 w 3386"/>
              <a:gd name="T29" fmla="*/ 2 h 2004"/>
              <a:gd name="T30" fmla="*/ 846 w 3386"/>
              <a:gd name="T31" fmla="*/ 17 h 2004"/>
              <a:gd name="T32" fmla="*/ 899 w 3386"/>
              <a:gd name="T33" fmla="*/ 5 h 2004"/>
              <a:gd name="T34" fmla="*/ 952 w 3386"/>
              <a:gd name="T35" fmla="*/ 4 h 2004"/>
              <a:gd name="T36" fmla="*/ 1005 w 3386"/>
              <a:gd name="T37" fmla="*/ 284 h 2004"/>
              <a:gd name="T38" fmla="*/ 1058 w 3386"/>
              <a:gd name="T39" fmla="*/ 12 h 2004"/>
              <a:gd name="T40" fmla="*/ 1111 w 3386"/>
              <a:gd name="T41" fmla="*/ 7 h 2004"/>
              <a:gd name="T42" fmla="*/ 1164 w 3386"/>
              <a:gd name="T43" fmla="*/ 6 h 2004"/>
              <a:gd name="T44" fmla="*/ 1217 w 3386"/>
              <a:gd name="T45" fmla="*/ 5 h 2004"/>
              <a:gd name="T46" fmla="*/ 1270 w 3386"/>
              <a:gd name="T47" fmla="*/ 16 h 2004"/>
              <a:gd name="T48" fmla="*/ 1323 w 3386"/>
              <a:gd name="T49" fmla="*/ 33 h 2004"/>
              <a:gd name="T50" fmla="*/ 1376 w 3386"/>
              <a:gd name="T51" fmla="*/ 15 h 2004"/>
              <a:gd name="T52" fmla="*/ 1428 w 3386"/>
              <a:gd name="T53" fmla="*/ 20 h 2004"/>
              <a:gd name="T54" fmla="*/ 1481 w 3386"/>
              <a:gd name="T55" fmla="*/ 9 h 2004"/>
              <a:gd name="T56" fmla="*/ 1534 w 3386"/>
              <a:gd name="T57" fmla="*/ 35 h 2004"/>
              <a:gd name="T58" fmla="*/ 1587 w 3386"/>
              <a:gd name="T59" fmla="*/ 5 h 2004"/>
              <a:gd name="T60" fmla="*/ 1640 w 3386"/>
              <a:gd name="T61" fmla="*/ 14 h 2004"/>
              <a:gd name="T62" fmla="*/ 1693 w 3386"/>
              <a:gd name="T63" fmla="*/ 6 h 2004"/>
              <a:gd name="T64" fmla="*/ 1746 w 3386"/>
              <a:gd name="T65" fmla="*/ 22 h 2004"/>
              <a:gd name="T66" fmla="*/ 1799 w 3386"/>
              <a:gd name="T67" fmla="*/ 724 h 2004"/>
              <a:gd name="T68" fmla="*/ 1852 w 3386"/>
              <a:gd name="T69" fmla="*/ 52 h 2004"/>
              <a:gd name="T70" fmla="*/ 1905 w 3386"/>
              <a:gd name="T71" fmla="*/ 27 h 2004"/>
              <a:gd name="T72" fmla="*/ 1958 w 3386"/>
              <a:gd name="T73" fmla="*/ 26 h 2004"/>
              <a:gd name="T74" fmla="*/ 2011 w 3386"/>
              <a:gd name="T75" fmla="*/ 14 h 2004"/>
              <a:gd name="T76" fmla="*/ 2064 w 3386"/>
              <a:gd name="T77" fmla="*/ 22 h 2004"/>
              <a:gd name="T78" fmla="*/ 2117 w 3386"/>
              <a:gd name="T79" fmla="*/ 42 h 2004"/>
              <a:gd name="T80" fmla="*/ 2169 w 3386"/>
              <a:gd name="T81" fmla="*/ 23 h 2004"/>
              <a:gd name="T82" fmla="*/ 2222 w 3386"/>
              <a:gd name="T83" fmla="*/ 16 h 2004"/>
              <a:gd name="T84" fmla="*/ 2275 w 3386"/>
              <a:gd name="T85" fmla="*/ 10 h 2004"/>
              <a:gd name="T86" fmla="*/ 2328 w 3386"/>
              <a:gd name="T87" fmla="*/ 12 h 2004"/>
              <a:gd name="T88" fmla="*/ 2381 w 3386"/>
              <a:gd name="T89" fmla="*/ 11 h 2004"/>
              <a:gd name="T90" fmla="*/ 2434 w 3386"/>
              <a:gd name="T91" fmla="*/ 331 h 2004"/>
              <a:gd name="T92" fmla="*/ 2487 w 3386"/>
              <a:gd name="T93" fmla="*/ 48 h 2004"/>
              <a:gd name="T94" fmla="*/ 2540 w 3386"/>
              <a:gd name="T95" fmla="*/ 75 h 2004"/>
              <a:gd name="T96" fmla="*/ 2593 w 3386"/>
              <a:gd name="T97" fmla="*/ 32 h 2004"/>
              <a:gd name="T98" fmla="*/ 2646 w 3386"/>
              <a:gd name="T99" fmla="*/ 28 h 2004"/>
              <a:gd name="T100" fmla="*/ 2699 w 3386"/>
              <a:gd name="T101" fmla="*/ 17 h 2004"/>
              <a:gd name="T102" fmla="*/ 2752 w 3386"/>
              <a:gd name="T103" fmla="*/ 17 h 2004"/>
              <a:gd name="T104" fmla="*/ 2805 w 3386"/>
              <a:gd name="T105" fmla="*/ 17 h 2004"/>
              <a:gd name="T106" fmla="*/ 2857 w 3386"/>
              <a:gd name="T107" fmla="*/ 16 h 2004"/>
              <a:gd name="T108" fmla="*/ 2910 w 3386"/>
              <a:gd name="T109" fmla="*/ 14 h 2004"/>
              <a:gd name="T110" fmla="*/ 2963 w 3386"/>
              <a:gd name="T111" fmla="*/ 17 h 2004"/>
              <a:gd name="T112" fmla="*/ 3016 w 3386"/>
              <a:gd name="T113" fmla="*/ 16 h 2004"/>
              <a:gd name="T114" fmla="*/ 3069 w 3386"/>
              <a:gd name="T115" fmla="*/ 15 h 2004"/>
              <a:gd name="T116" fmla="*/ 3122 w 3386"/>
              <a:gd name="T117" fmla="*/ 19 h 2004"/>
              <a:gd name="T118" fmla="*/ 3175 w 3386"/>
              <a:gd name="T119" fmla="*/ 129 h 2004"/>
              <a:gd name="T120" fmla="*/ 3228 w 3386"/>
              <a:gd name="T121" fmla="*/ 40 h 2004"/>
              <a:gd name="T122" fmla="*/ 3281 w 3386"/>
              <a:gd name="T123" fmla="*/ 25 h 2004"/>
              <a:gd name="T124" fmla="*/ 3334 w 3386"/>
              <a:gd name="T125" fmla="*/ 15 h 20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  <a:cxn ang="0">
                <a:pos x="T120" y="T121"/>
              </a:cxn>
              <a:cxn ang="0">
                <a:pos x="T122" y="T123"/>
              </a:cxn>
              <a:cxn ang="0">
                <a:pos x="T124" y="T125"/>
              </a:cxn>
            </a:cxnLst>
            <a:rect l="0" t="0" r="r" b="b"/>
            <a:pathLst>
              <a:path w="3386" h="2004">
                <a:moveTo>
                  <a:pt x="0" y="2"/>
                </a:moveTo>
                <a:lnTo>
                  <a:pt x="1" y="2"/>
                </a:lnTo>
                <a:lnTo>
                  <a:pt x="2" y="2"/>
                </a:lnTo>
                <a:lnTo>
                  <a:pt x="3" y="2"/>
                </a:lnTo>
                <a:lnTo>
                  <a:pt x="4" y="1"/>
                </a:lnTo>
                <a:lnTo>
                  <a:pt x="5" y="1"/>
                </a:lnTo>
                <a:lnTo>
                  <a:pt x="6" y="1"/>
                </a:lnTo>
                <a:lnTo>
                  <a:pt x="7" y="2"/>
                </a:lnTo>
                <a:lnTo>
                  <a:pt x="7" y="1"/>
                </a:lnTo>
                <a:lnTo>
                  <a:pt x="8" y="1"/>
                </a:lnTo>
                <a:lnTo>
                  <a:pt x="9" y="1"/>
                </a:lnTo>
                <a:lnTo>
                  <a:pt x="10" y="1"/>
                </a:lnTo>
                <a:lnTo>
                  <a:pt x="11" y="1"/>
                </a:lnTo>
                <a:lnTo>
                  <a:pt x="12" y="1"/>
                </a:lnTo>
                <a:lnTo>
                  <a:pt x="13" y="1"/>
                </a:lnTo>
                <a:lnTo>
                  <a:pt x="14" y="1"/>
                </a:lnTo>
                <a:lnTo>
                  <a:pt x="14" y="2"/>
                </a:lnTo>
                <a:lnTo>
                  <a:pt x="15" y="2"/>
                </a:lnTo>
                <a:lnTo>
                  <a:pt x="16" y="2"/>
                </a:lnTo>
                <a:lnTo>
                  <a:pt x="17" y="2"/>
                </a:lnTo>
                <a:lnTo>
                  <a:pt x="18" y="2"/>
                </a:lnTo>
                <a:lnTo>
                  <a:pt x="19" y="3"/>
                </a:lnTo>
                <a:lnTo>
                  <a:pt x="20" y="1"/>
                </a:lnTo>
                <a:lnTo>
                  <a:pt x="21" y="2"/>
                </a:lnTo>
                <a:lnTo>
                  <a:pt x="22" y="2"/>
                </a:lnTo>
                <a:lnTo>
                  <a:pt x="22" y="1"/>
                </a:lnTo>
                <a:lnTo>
                  <a:pt x="23" y="2"/>
                </a:lnTo>
                <a:lnTo>
                  <a:pt x="24" y="2"/>
                </a:lnTo>
                <a:lnTo>
                  <a:pt x="25" y="2"/>
                </a:lnTo>
                <a:lnTo>
                  <a:pt x="26" y="3"/>
                </a:lnTo>
                <a:lnTo>
                  <a:pt x="27" y="2"/>
                </a:lnTo>
                <a:lnTo>
                  <a:pt x="28" y="2"/>
                </a:lnTo>
                <a:lnTo>
                  <a:pt x="29" y="2"/>
                </a:lnTo>
                <a:lnTo>
                  <a:pt x="29" y="2"/>
                </a:lnTo>
                <a:lnTo>
                  <a:pt x="30" y="2"/>
                </a:lnTo>
                <a:lnTo>
                  <a:pt x="31" y="2"/>
                </a:lnTo>
                <a:lnTo>
                  <a:pt x="32" y="1"/>
                </a:lnTo>
                <a:lnTo>
                  <a:pt x="33" y="2"/>
                </a:lnTo>
                <a:lnTo>
                  <a:pt x="34" y="1"/>
                </a:lnTo>
                <a:lnTo>
                  <a:pt x="35" y="1"/>
                </a:lnTo>
                <a:lnTo>
                  <a:pt x="36" y="2"/>
                </a:lnTo>
                <a:lnTo>
                  <a:pt x="37" y="2"/>
                </a:lnTo>
                <a:lnTo>
                  <a:pt x="37" y="1"/>
                </a:lnTo>
                <a:lnTo>
                  <a:pt x="38" y="1"/>
                </a:lnTo>
                <a:lnTo>
                  <a:pt x="39" y="2"/>
                </a:lnTo>
                <a:lnTo>
                  <a:pt x="40" y="2"/>
                </a:lnTo>
                <a:lnTo>
                  <a:pt x="41" y="2"/>
                </a:lnTo>
                <a:lnTo>
                  <a:pt x="42" y="2"/>
                </a:lnTo>
                <a:lnTo>
                  <a:pt x="43" y="3"/>
                </a:lnTo>
                <a:lnTo>
                  <a:pt x="44" y="2"/>
                </a:lnTo>
                <a:lnTo>
                  <a:pt x="44" y="3"/>
                </a:lnTo>
                <a:lnTo>
                  <a:pt x="45" y="3"/>
                </a:lnTo>
                <a:lnTo>
                  <a:pt x="46" y="5"/>
                </a:lnTo>
                <a:lnTo>
                  <a:pt x="47" y="4"/>
                </a:lnTo>
                <a:lnTo>
                  <a:pt x="48" y="5"/>
                </a:lnTo>
                <a:lnTo>
                  <a:pt x="49" y="4"/>
                </a:lnTo>
                <a:lnTo>
                  <a:pt x="50" y="4"/>
                </a:lnTo>
                <a:lnTo>
                  <a:pt x="51" y="4"/>
                </a:lnTo>
                <a:lnTo>
                  <a:pt x="52" y="3"/>
                </a:lnTo>
                <a:lnTo>
                  <a:pt x="52" y="3"/>
                </a:lnTo>
                <a:lnTo>
                  <a:pt x="53" y="3"/>
                </a:lnTo>
                <a:lnTo>
                  <a:pt x="54" y="3"/>
                </a:lnTo>
                <a:lnTo>
                  <a:pt x="55" y="2"/>
                </a:lnTo>
                <a:lnTo>
                  <a:pt x="56" y="2"/>
                </a:lnTo>
                <a:lnTo>
                  <a:pt x="57" y="2"/>
                </a:lnTo>
                <a:lnTo>
                  <a:pt x="58" y="2"/>
                </a:lnTo>
                <a:lnTo>
                  <a:pt x="59" y="1"/>
                </a:lnTo>
                <a:lnTo>
                  <a:pt x="59" y="2"/>
                </a:lnTo>
                <a:lnTo>
                  <a:pt x="60" y="2"/>
                </a:lnTo>
                <a:lnTo>
                  <a:pt x="61" y="1"/>
                </a:lnTo>
                <a:lnTo>
                  <a:pt x="62" y="2"/>
                </a:lnTo>
                <a:lnTo>
                  <a:pt x="63" y="1"/>
                </a:lnTo>
                <a:lnTo>
                  <a:pt x="64" y="1"/>
                </a:lnTo>
                <a:lnTo>
                  <a:pt x="65" y="1"/>
                </a:lnTo>
                <a:lnTo>
                  <a:pt x="66" y="1"/>
                </a:lnTo>
                <a:lnTo>
                  <a:pt x="67" y="1"/>
                </a:lnTo>
                <a:lnTo>
                  <a:pt x="67" y="1"/>
                </a:lnTo>
                <a:lnTo>
                  <a:pt x="68" y="1"/>
                </a:lnTo>
                <a:lnTo>
                  <a:pt x="69" y="1"/>
                </a:lnTo>
                <a:lnTo>
                  <a:pt x="70" y="1"/>
                </a:lnTo>
                <a:lnTo>
                  <a:pt x="71" y="1"/>
                </a:lnTo>
                <a:lnTo>
                  <a:pt x="72" y="1"/>
                </a:lnTo>
                <a:lnTo>
                  <a:pt x="73" y="1"/>
                </a:lnTo>
                <a:lnTo>
                  <a:pt x="74" y="1"/>
                </a:lnTo>
                <a:lnTo>
                  <a:pt x="74" y="1"/>
                </a:lnTo>
                <a:lnTo>
                  <a:pt x="75" y="1"/>
                </a:lnTo>
                <a:lnTo>
                  <a:pt x="76" y="0"/>
                </a:lnTo>
                <a:lnTo>
                  <a:pt x="77" y="2"/>
                </a:lnTo>
                <a:lnTo>
                  <a:pt x="78" y="1"/>
                </a:lnTo>
                <a:lnTo>
                  <a:pt x="79" y="1"/>
                </a:lnTo>
                <a:lnTo>
                  <a:pt x="80" y="1"/>
                </a:lnTo>
                <a:lnTo>
                  <a:pt x="81" y="1"/>
                </a:lnTo>
                <a:lnTo>
                  <a:pt x="82" y="1"/>
                </a:lnTo>
                <a:lnTo>
                  <a:pt x="82" y="1"/>
                </a:lnTo>
                <a:lnTo>
                  <a:pt x="83" y="1"/>
                </a:lnTo>
                <a:lnTo>
                  <a:pt x="84" y="1"/>
                </a:lnTo>
                <a:lnTo>
                  <a:pt x="85" y="1"/>
                </a:lnTo>
                <a:lnTo>
                  <a:pt x="86" y="2"/>
                </a:lnTo>
                <a:lnTo>
                  <a:pt x="87" y="3"/>
                </a:lnTo>
                <a:lnTo>
                  <a:pt x="88" y="4"/>
                </a:lnTo>
                <a:lnTo>
                  <a:pt x="89" y="6"/>
                </a:lnTo>
                <a:lnTo>
                  <a:pt x="89" y="6"/>
                </a:lnTo>
                <a:lnTo>
                  <a:pt x="90" y="10"/>
                </a:lnTo>
                <a:lnTo>
                  <a:pt x="91" y="10"/>
                </a:lnTo>
                <a:lnTo>
                  <a:pt x="92" y="13"/>
                </a:lnTo>
                <a:lnTo>
                  <a:pt x="93" y="16"/>
                </a:lnTo>
                <a:lnTo>
                  <a:pt x="94" y="18"/>
                </a:lnTo>
                <a:lnTo>
                  <a:pt x="95" y="19"/>
                </a:lnTo>
                <a:lnTo>
                  <a:pt x="96" y="18"/>
                </a:lnTo>
                <a:lnTo>
                  <a:pt x="97" y="19"/>
                </a:lnTo>
                <a:lnTo>
                  <a:pt x="97" y="16"/>
                </a:lnTo>
                <a:lnTo>
                  <a:pt x="98" y="16"/>
                </a:lnTo>
                <a:lnTo>
                  <a:pt x="99" y="13"/>
                </a:lnTo>
                <a:lnTo>
                  <a:pt x="100" y="11"/>
                </a:lnTo>
                <a:lnTo>
                  <a:pt x="101" y="11"/>
                </a:lnTo>
                <a:lnTo>
                  <a:pt x="102" y="10"/>
                </a:lnTo>
                <a:lnTo>
                  <a:pt x="103" y="8"/>
                </a:lnTo>
                <a:lnTo>
                  <a:pt x="104" y="7"/>
                </a:lnTo>
                <a:lnTo>
                  <a:pt x="104" y="7"/>
                </a:lnTo>
                <a:lnTo>
                  <a:pt x="105" y="7"/>
                </a:lnTo>
                <a:lnTo>
                  <a:pt x="106" y="6"/>
                </a:lnTo>
                <a:lnTo>
                  <a:pt x="107" y="5"/>
                </a:lnTo>
                <a:lnTo>
                  <a:pt x="108" y="5"/>
                </a:lnTo>
                <a:lnTo>
                  <a:pt x="109" y="4"/>
                </a:lnTo>
                <a:lnTo>
                  <a:pt x="110" y="4"/>
                </a:lnTo>
                <a:lnTo>
                  <a:pt x="111" y="3"/>
                </a:lnTo>
                <a:lnTo>
                  <a:pt x="112" y="4"/>
                </a:lnTo>
                <a:lnTo>
                  <a:pt x="112" y="3"/>
                </a:lnTo>
                <a:lnTo>
                  <a:pt x="113" y="3"/>
                </a:lnTo>
                <a:lnTo>
                  <a:pt x="114" y="2"/>
                </a:lnTo>
                <a:lnTo>
                  <a:pt x="115" y="3"/>
                </a:lnTo>
                <a:lnTo>
                  <a:pt x="116" y="2"/>
                </a:lnTo>
                <a:lnTo>
                  <a:pt x="117" y="3"/>
                </a:lnTo>
                <a:lnTo>
                  <a:pt x="118" y="2"/>
                </a:lnTo>
                <a:lnTo>
                  <a:pt x="119" y="3"/>
                </a:lnTo>
                <a:lnTo>
                  <a:pt x="119" y="3"/>
                </a:lnTo>
                <a:lnTo>
                  <a:pt x="120" y="2"/>
                </a:lnTo>
                <a:lnTo>
                  <a:pt x="121" y="2"/>
                </a:lnTo>
                <a:lnTo>
                  <a:pt x="122" y="3"/>
                </a:lnTo>
                <a:lnTo>
                  <a:pt x="123" y="2"/>
                </a:lnTo>
                <a:lnTo>
                  <a:pt x="124" y="3"/>
                </a:lnTo>
                <a:lnTo>
                  <a:pt x="125" y="2"/>
                </a:lnTo>
                <a:lnTo>
                  <a:pt x="126" y="3"/>
                </a:lnTo>
                <a:lnTo>
                  <a:pt x="127" y="3"/>
                </a:lnTo>
                <a:lnTo>
                  <a:pt x="127" y="3"/>
                </a:lnTo>
                <a:lnTo>
                  <a:pt x="128" y="5"/>
                </a:lnTo>
                <a:lnTo>
                  <a:pt x="129" y="4"/>
                </a:lnTo>
                <a:lnTo>
                  <a:pt x="130" y="4"/>
                </a:lnTo>
                <a:lnTo>
                  <a:pt x="131" y="5"/>
                </a:lnTo>
                <a:lnTo>
                  <a:pt x="132" y="6"/>
                </a:lnTo>
                <a:lnTo>
                  <a:pt x="133" y="6"/>
                </a:lnTo>
                <a:lnTo>
                  <a:pt x="134" y="7"/>
                </a:lnTo>
                <a:lnTo>
                  <a:pt x="134" y="7"/>
                </a:lnTo>
                <a:lnTo>
                  <a:pt x="135" y="6"/>
                </a:lnTo>
                <a:lnTo>
                  <a:pt x="136" y="6"/>
                </a:lnTo>
                <a:lnTo>
                  <a:pt x="137" y="6"/>
                </a:lnTo>
                <a:lnTo>
                  <a:pt x="138" y="4"/>
                </a:lnTo>
                <a:lnTo>
                  <a:pt x="139" y="5"/>
                </a:lnTo>
                <a:lnTo>
                  <a:pt x="140" y="5"/>
                </a:lnTo>
                <a:lnTo>
                  <a:pt x="141" y="5"/>
                </a:lnTo>
                <a:lnTo>
                  <a:pt x="142" y="5"/>
                </a:lnTo>
                <a:lnTo>
                  <a:pt x="142" y="4"/>
                </a:lnTo>
                <a:lnTo>
                  <a:pt x="143" y="4"/>
                </a:lnTo>
                <a:lnTo>
                  <a:pt x="144" y="3"/>
                </a:lnTo>
                <a:lnTo>
                  <a:pt x="145" y="3"/>
                </a:lnTo>
                <a:lnTo>
                  <a:pt x="146" y="4"/>
                </a:lnTo>
                <a:lnTo>
                  <a:pt x="147" y="3"/>
                </a:lnTo>
                <a:lnTo>
                  <a:pt x="148" y="3"/>
                </a:lnTo>
                <a:lnTo>
                  <a:pt x="149" y="4"/>
                </a:lnTo>
                <a:lnTo>
                  <a:pt x="149" y="3"/>
                </a:lnTo>
                <a:lnTo>
                  <a:pt x="150" y="3"/>
                </a:lnTo>
                <a:lnTo>
                  <a:pt x="151" y="3"/>
                </a:lnTo>
                <a:lnTo>
                  <a:pt x="152" y="3"/>
                </a:lnTo>
                <a:lnTo>
                  <a:pt x="153" y="2"/>
                </a:lnTo>
                <a:lnTo>
                  <a:pt x="154" y="3"/>
                </a:lnTo>
                <a:lnTo>
                  <a:pt x="155" y="3"/>
                </a:lnTo>
                <a:lnTo>
                  <a:pt x="156" y="2"/>
                </a:lnTo>
                <a:lnTo>
                  <a:pt x="157" y="3"/>
                </a:lnTo>
                <a:lnTo>
                  <a:pt x="157" y="3"/>
                </a:lnTo>
                <a:lnTo>
                  <a:pt x="158" y="3"/>
                </a:lnTo>
                <a:lnTo>
                  <a:pt x="159" y="3"/>
                </a:lnTo>
                <a:lnTo>
                  <a:pt x="160" y="3"/>
                </a:lnTo>
                <a:lnTo>
                  <a:pt x="161" y="2"/>
                </a:lnTo>
                <a:lnTo>
                  <a:pt x="162" y="2"/>
                </a:lnTo>
                <a:lnTo>
                  <a:pt x="163" y="2"/>
                </a:lnTo>
                <a:lnTo>
                  <a:pt x="164" y="2"/>
                </a:lnTo>
                <a:lnTo>
                  <a:pt x="164" y="2"/>
                </a:lnTo>
                <a:lnTo>
                  <a:pt x="165" y="2"/>
                </a:lnTo>
                <a:lnTo>
                  <a:pt x="166" y="2"/>
                </a:lnTo>
                <a:lnTo>
                  <a:pt x="167" y="3"/>
                </a:lnTo>
                <a:lnTo>
                  <a:pt x="168" y="2"/>
                </a:lnTo>
                <a:lnTo>
                  <a:pt x="169" y="2"/>
                </a:lnTo>
                <a:lnTo>
                  <a:pt x="170" y="2"/>
                </a:lnTo>
                <a:lnTo>
                  <a:pt x="171" y="2"/>
                </a:lnTo>
                <a:lnTo>
                  <a:pt x="172" y="2"/>
                </a:lnTo>
                <a:lnTo>
                  <a:pt x="172" y="2"/>
                </a:lnTo>
                <a:lnTo>
                  <a:pt x="173" y="2"/>
                </a:lnTo>
                <a:lnTo>
                  <a:pt x="174" y="2"/>
                </a:lnTo>
                <a:lnTo>
                  <a:pt x="175" y="2"/>
                </a:lnTo>
                <a:lnTo>
                  <a:pt x="176" y="1"/>
                </a:lnTo>
                <a:lnTo>
                  <a:pt x="177" y="2"/>
                </a:lnTo>
                <a:lnTo>
                  <a:pt x="178" y="2"/>
                </a:lnTo>
                <a:lnTo>
                  <a:pt x="179" y="2"/>
                </a:lnTo>
                <a:lnTo>
                  <a:pt x="179" y="2"/>
                </a:lnTo>
                <a:lnTo>
                  <a:pt x="180" y="2"/>
                </a:lnTo>
                <a:lnTo>
                  <a:pt x="181" y="3"/>
                </a:lnTo>
                <a:lnTo>
                  <a:pt x="182" y="2"/>
                </a:lnTo>
                <a:lnTo>
                  <a:pt x="183" y="3"/>
                </a:lnTo>
                <a:lnTo>
                  <a:pt x="184" y="4"/>
                </a:lnTo>
                <a:lnTo>
                  <a:pt x="185" y="2"/>
                </a:lnTo>
                <a:lnTo>
                  <a:pt x="186" y="2"/>
                </a:lnTo>
                <a:lnTo>
                  <a:pt x="187" y="2"/>
                </a:lnTo>
                <a:lnTo>
                  <a:pt x="187" y="3"/>
                </a:lnTo>
                <a:lnTo>
                  <a:pt x="188" y="2"/>
                </a:lnTo>
                <a:lnTo>
                  <a:pt x="189" y="2"/>
                </a:lnTo>
                <a:lnTo>
                  <a:pt x="190" y="2"/>
                </a:lnTo>
                <a:lnTo>
                  <a:pt x="191" y="3"/>
                </a:lnTo>
                <a:lnTo>
                  <a:pt x="192" y="3"/>
                </a:lnTo>
                <a:lnTo>
                  <a:pt x="193" y="2"/>
                </a:lnTo>
                <a:lnTo>
                  <a:pt x="194" y="2"/>
                </a:lnTo>
                <a:lnTo>
                  <a:pt x="194" y="4"/>
                </a:lnTo>
                <a:lnTo>
                  <a:pt x="195" y="3"/>
                </a:lnTo>
                <a:lnTo>
                  <a:pt x="196" y="4"/>
                </a:lnTo>
                <a:lnTo>
                  <a:pt x="197" y="5"/>
                </a:lnTo>
                <a:lnTo>
                  <a:pt x="198" y="6"/>
                </a:lnTo>
                <a:lnTo>
                  <a:pt x="199" y="7"/>
                </a:lnTo>
                <a:lnTo>
                  <a:pt x="200" y="7"/>
                </a:lnTo>
                <a:lnTo>
                  <a:pt x="201" y="8"/>
                </a:lnTo>
                <a:lnTo>
                  <a:pt x="202" y="8"/>
                </a:lnTo>
                <a:lnTo>
                  <a:pt x="202" y="8"/>
                </a:lnTo>
                <a:lnTo>
                  <a:pt x="203" y="9"/>
                </a:lnTo>
                <a:lnTo>
                  <a:pt x="204" y="8"/>
                </a:lnTo>
                <a:lnTo>
                  <a:pt x="205" y="7"/>
                </a:lnTo>
                <a:lnTo>
                  <a:pt x="206" y="8"/>
                </a:lnTo>
                <a:lnTo>
                  <a:pt x="207" y="7"/>
                </a:lnTo>
                <a:lnTo>
                  <a:pt x="208" y="7"/>
                </a:lnTo>
                <a:lnTo>
                  <a:pt x="209" y="6"/>
                </a:lnTo>
                <a:lnTo>
                  <a:pt x="209" y="7"/>
                </a:lnTo>
                <a:lnTo>
                  <a:pt x="210" y="6"/>
                </a:lnTo>
                <a:lnTo>
                  <a:pt x="211" y="7"/>
                </a:lnTo>
                <a:lnTo>
                  <a:pt x="212" y="6"/>
                </a:lnTo>
                <a:lnTo>
                  <a:pt x="213" y="7"/>
                </a:lnTo>
                <a:lnTo>
                  <a:pt x="214" y="5"/>
                </a:lnTo>
                <a:lnTo>
                  <a:pt x="215" y="5"/>
                </a:lnTo>
                <a:lnTo>
                  <a:pt x="216" y="5"/>
                </a:lnTo>
                <a:lnTo>
                  <a:pt x="216" y="5"/>
                </a:lnTo>
                <a:lnTo>
                  <a:pt x="217" y="6"/>
                </a:lnTo>
                <a:lnTo>
                  <a:pt x="218" y="4"/>
                </a:lnTo>
                <a:lnTo>
                  <a:pt x="219" y="5"/>
                </a:lnTo>
                <a:lnTo>
                  <a:pt x="220" y="5"/>
                </a:lnTo>
                <a:lnTo>
                  <a:pt x="221" y="5"/>
                </a:lnTo>
                <a:lnTo>
                  <a:pt x="222" y="5"/>
                </a:lnTo>
                <a:lnTo>
                  <a:pt x="223" y="5"/>
                </a:lnTo>
                <a:lnTo>
                  <a:pt x="224" y="5"/>
                </a:lnTo>
                <a:lnTo>
                  <a:pt x="224" y="5"/>
                </a:lnTo>
                <a:lnTo>
                  <a:pt x="225" y="5"/>
                </a:lnTo>
                <a:lnTo>
                  <a:pt x="226" y="5"/>
                </a:lnTo>
                <a:lnTo>
                  <a:pt x="227" y="6"/>
                </a:lnTo>
                <a:lnTo>
                  <a:pt x="228" y="7"/>
                </a:lnTo>
                <a:lnTo>
                  <a:pt x="229" y="9"/>
                </a:lnTo>
                <a:lnTo>
                  <a:pt x="230" y="11"/>
                </a:lnTo>
                <a:lnTo>
                  <a:pt x="231" y="15"/>
                </a:lnTo>
                <a:lnTo>
                  <a:pt x="231" y="16"/>
                </a:lnTo>
                <a:lnTo>
                  <a:pt x="232" y="19"/>
                </a:lnTo>
                <a:lnTo>
                  <a:pt x="233" y="21"/>
                </a:lnTo>
                <a:lnTo>
                  <a:pt x="234" y="22"/>
                </a:lnTo>
                <a:lnTo>
                  <a:pt x="235" y="25"/>
                </a:lnTo>
                <a:lnTo>
                  <a:pt x="236" y="25"/>
                </a:lnTo>
                <a:lnTo>
                  <a:pt x="237" y="23"/>
                </a:lnTo>
                <a:lnTo>
                  <a:pt x="238" y="22"/>
                </a:lnTo>
                <a:lnTo>
                  <a:pt x="239" y="20"/>
                </a:lnTo>
                <a:lnTo>
                  <a:pt x="239" y="18"/>
                </a:lnTo>
                <a:lnTo>
                  <a:pt x="240" y="17"/>
                </a:lnTo>
                <a:lnTo>
                  <a:pt x="241" y="14"/>
                </a:lnTo>
                <a:lnTo>
                  <a:pt x="242" y="11"/>
                </a:lnTo>
                <a:lnTo>
                  <a:pt x="243" y="11"/>
                </a:lnTo>
                <a:lnTo>
                  <a:pt x="244" y="10"/>
                </a:lnTo>
                <a:lnTo>
                  <a:pt x="245" y="9"/>
                </a:lnTo>
                <a:lnTo>
                  <a:pt x="246" y="7"/>
                </a:lnTo>
                <a:lnTo>
                  <a:pt x="246" y="8"/>
                </a:lnTo>
                <a:lnTo>
                  <a:pt x="247" y="7"/>
                </a:lnTo>
                <a:lnTo>
                  <a:pt x="248" y="6"/>
                </a:lnTo>
                <a:lnTo>
                  <a:pt x="249" y="5"/>
                </a:lnTo>
                <a:lnTo>
                  <a:pt x="250" y="5"/>
                </a:lnTo>
                <a:lnTo>
                  <a:pt x="251" y="6"/>
                </a:lnTo>
                <a:lnTo>
                  <a:pt x="252" y="5"/>
                </a:lnTo>
                <a:lnTo>
                  <a:pt x="253" y="5"/>
                </a:lnTo>
                <a:lnTo>
                  <a:pt x="254" y="5"/>
                </a:lnTo>
                <a:lnTo>
                  <a:pt x="254" y="5"/>
                </a:lnTo>
                <a:lnTo>
                  <a:pt x="255" y="4"/>
                </a:lnTo>
                <a:lnTo>
                  <a:pt x="256" y="5"/>
                </a:lnTo>
                <a:lnTo>
                  <a:pt x="257" y="4"/>
                </a:lnTo>
                <a:lnTo>
                  <a:pt x="258" y="4"/>
                </a:lnTo>
                <a:lnTo>
                  <a:pt x="259" y="5"/>
                </a:lnTo>
                <a:lnTo>
                  <a:pt x="260" y="4"/>
                </a:lnTo>
                <a:lnTo>
                  <a:pt x="261" y="4"/>
                </a:lnTo>
                <a:lnTo>
                  <a:pt x="261" y="4"/>
                </a:lnTo>
                <a:lnTo>
                  <a:pt x="262" y="3"/>
                </a:lnTo>
                <a:lnTo>
                  <a:pt x="263" y="3"/>
                </a:lnTo>
                <a:lnTo>
                  <a:pt x="264" y="3"/>
                </a:lnTo>
                <a:lnTo>
                  <a:pt x="265" y="3"/>
                </a:lnTo>
                <a:lnTo>
                  <a:pt x="266" y="3"/>
                </a:lnTo>
                <a:lnTo>
                  <a:pt x="267" y="4"/>
                </a:lnTo>
                <a:lnTo>
                  <a:pt x="268" y="3"/>
                </a:lnTo>
                <a:lnTo>
                  <a:pt x="269" y="4"/>
                </a:lnTo>
                <a:lnTo>
                  <a:pt x="269" y="3"/>
                </a:lnTo>
                <a:lnTo>
                  <a:pt x="270" y="3"/>
                </a:lnTo>
                <a:lnTo>
                  <a:pt x="271" y="2"/>
                </a:lnTo>
                <a:lnTo>
                  <a:pt x="272" y="4"/>
                </a:lnTo>
                <a:lnTo>
                  <a:pt x="273" y="4"/>
                </a:lnTo>
                <a:lnTo>
                  <a:pt x="274" y="2"/>
                </a:lnTo>
                <a:lnTo>
                  <a:pt x="275" y="3"/>
                </a:lnTo>
                <a:lnTo>
                  <a:pt x="276" y="3"/>
                </a:lnTo>
                <a:lnTo>
                  <a:pt x="276" y="2"/>
                </a:lnTo>
                <a:lnTo>
                  <a:pt x="277" y="2"/>
                </a:lnTo>
                <a:lnTo>
                  <a:pt x="278" y="3"/>
                </a:lnTo>
                <a:lnTo>
                  <a:pt x="279" y="2"/>
                </a:lnTo>
                <a:lnTo>
                  <a:pt x="280" y="3"/>
                </a:lnTo>
                <a:lnTo>
                  <a:pt x="281" y="2"/>
                </a:lnTo>
                <a:lnTo>
                  <a:pt x="282" y="3"/>
                </a:lnTo>
                <a:lnTo>
                  <a:pt x="283" y="2"/>
                </a:lnTo>
                <a:lnTo>
                  <a:pt x="284" y="2"/>
                </a:lnTo>
                <a:lnTo>
                  <a:pt x="284" y="2"/>
                </a:lnTo>
                <a:lnTo>
                  <a:pt x="285" y="2"/>
                </a:lnTo>
                <a:lnTo>
                  <a:pt x="286" y="2"/>
                </a:lnTo>
                <a:lnTo>
                  <a:pt x="287" y="2"/>
                </a:lnTo>
                <a:lnTo>
                  <a:pt x="288" y="3"/>
                </a:lnTo>
                <a:lnTo>
                  <a:pt x="289" y="2"/>
                </a:lnTo>
                <a:lnTo>
                  <a:pt x="290" y="3"/>
                </a:lnTo>
                <a:lnTo>
                  <a:pt x="291" y="4"/>
                </a:lnTo>
                <a:lnTo>
                  <a:pt x="291" y="3"/>
                </a:lnTo>
                <a:lnTo>
                  <a:pt x="292" y="3"/>
                </a:lnTo>
                <a:lnTo>
                  <a:pt x="293" y="3"/>
                </a:lnTo>
                <a:lnTo>
                  <a:pt x="294" y="2"/>
                </a:lnTo>
                <a:lnTo>
                  <a:pt x="295" y="3"/>
                </a:lnTo>
                <a:lnTo>
                  <a:pt x="296" y="3"/>
                </a:lnTo>
                <a:lnTo>
                  <a:pt x="297" y="4"/>
                </a:lnTo>
                <a:lnTo>
                  <a:pt x="298" y="3"/>
                </a:lnTo>
                <a:lnTo>
                  <a:pt x="299" y="3"/>
                </a:lnTo>
                <a:lnTo>
                  <a:pt x="299" y="2"/>
                </a:lnTo>
                <a:lnTo>
                  <a:pt x="300" y="3"/>
                </a:lnTo>
                <a:lnTo>
                  <a:pt x="301" y="1"/>
                </a:lnTo>
                <a:lnTo>
                  <a:pt x="302" y="2"/>
                </a:lnTo>
                <a:lnTo>
                  <a:pt x="303" y="3"/>
                </a:lnTo>
                <a:lnTo>
                  <a:pt x="304" y="3"/>
                </a:lnTo>
                <a:lnTo>
                  <a:pt x="305" y="3"/>
                </a:lnTo>
                <a:lnTo>
                  <a:pt x="306" y="2"/>
                </a:lnTo>
                <a:lnTo>
                  <a:pt x="306" y="3"/>
                </a:lnTo>
                <a:lnTo>
                  <a:pt x="307" y="2"/>
                </a:lnTo>
                <a:lnTo>
                  <a:pt x="308" y="3"/>
                </a:lnTo>
                <a:lnTo>
                  <a:pt x="309" y="3"/>
                </a:lnTo>
                <a:lnTo>
                  <a:pt x="310" y="2"/>
                </a:lnTo>
                <a:lnTo>
                  <a:pt x="311" y="3"/>
                </a:lnTo>
                <a:lnTo>
                  <a:pt x="312" y="4"/>
                </a:lnTo>
                <a:lnTo>
                  <a:pt x="313" y="3"/>
                </a:lnTo>
                <a:lnTo>
                  <a:pt x="314" y="3"/>
                </a:lnTo>
                <a:lnTo>
                  <a:pt x="314" y="2"/>
                </a:lnTo>
                <a:lnTo>
                  <a:pt x="315" y="2"/>
                </a:lnTo>
                <a:lnTo>
                  <a:pt x="316" y="3"/>
                </a:lnTo>
                <a:lnTo>
                  <a:pt x="317" y="2"/>
                </a:lnTo>
                <a:lnTo>
                  <a:pt x="318" y="2"/>
                </a:lnTo>
                <a:lnTo>
                  <a:pt x="319" y="2"/>
                </a:lnTo>
                <a:lnTo>
                  <a:pt x="320" y="2"/>
                </a:lnTo>
                <a:lnTo>
                  <a:pt x="321" y="2"/>
                </a:lnTo>
                <a:lnTo>
                  <a:pt x="321" y="2"/>
                </a:lnTo>
                <a:lnTo>
                  <a:pt x="322" y="2"/>
                </a:lnTo>
                <a:lnTo>
                  <a:pt x="323" y="2"/>
                </a:lnTo>
                <a:lnTo>
                  <a:pt x="324" y="1"/>
                </a:lnTo>
                <a:lnTo>
                  <a:pt x="325" y="2"/>
                </a:lnTo>
                <a:lnTo>
                  <a:pt x="326" y="1"/>
                </a:lnTo>
                <a:lnTo>
                  <a:pt x="327" y="1"/>
                </a:lnTo>
                <a:lnTo>
                  <a:pt x="328" y="2"/>
                </a:lnTo>
                <a:lnTo>
                  <a:pt x="329" y="2"/>
                </a:lnTo>
                <a:lnTo>
                  <a:pt x="329" y="3"/>
                </a:lnTo>
                <a:lnTo>
                  <a:pt x="330" y="2"/>
                </a:lnTo>
                <a:lnTo>
                  <a:pt x="331" y="2"/>
                </a:lnTo>
                <a:lnTo>
                  <a:pt x="332" y="4"/>
                </a:lnTo>
                <a:lnTo>
                  <a:pt x="333" y="4"/>
                </a:lnTo>
                <a:lnTo>
                  <a:pt x="334" y="5"/>
                </a:lnTo>
                <a:lnTo>
                  <a:pt x="335" y="5"/>
                </a:lnTo>
                <a:lnTo>
                  <a:pt x="336" y="6"/>
                </a:lnTo>
                <a:lnTo>
                  <a:pt x="336" y="7"/>
                </a:lnTo>
                <a:lnTo>
                  <a:pt x="337" y="6"/>
                </a:lnTo>
                <a:lnTo>
                  <a:pt x="338" y="7"/>
                </a:lnTo>
                <a:lnTo>
                  <a:pt x="339" y="7"/>
                </a:lnTo>
                <a:lnTo>
                  <a:pt x="340" y="7"/>
                </a:lnTo>
                <a:lnTo>
                  <a:pt x="341" y="6"/>
                </a:lnTo>
                <a:lnTo>
                  <a:pt x="342" y="6"/>
                </a:lnTo>
                <a:lnTo>
                  <a:pt x="343" y="6"/>
                </a:lnTo>
                <a:lnTo>
                  <a:pt x="344" y="4"/>
                </a:lnTo>
                <a:lnTo>
                  <a:pt x="344" y="4"/>
                </a:lnTo>
                <a:lnTo>
                  <a:pt x="345" y="4"/>
                </a:lnTo>
                <a:lnTo>
                  <a:pt x="346" y="3"/>
                </a:lnTo>
                <a:lnTo>
                  <a:pt x="347" y="3"/>
                </a:lnTo>
                <a:lnTo>
                  <a:pt x="348" y="3"/>
                </a:lnTo>
                <a:lnTo>
                  <a:pt x="349" y="3"/>
                </a:lnTo>
                <a:lnTo>
                  <a:pt x="350" y="2"/>
                </a:lnTo>
                <a:lnTo>
                  <a:pt x="351" y="2"/>
                </a:lnTo>
                <a:lnTo>
                  <a:pt x="351" y="2"/>
                </a:lnTo>
                <a:lnTo>
                  <a:pt x="352" y="2"/>
                </a:lnTo>
                <a:lnTo>
                  <a:pt x="353" y="2"/>
                </a:lnTo>
                <a:lnTo>
                  <a:pt x="354" y="2"/>
                </a:lnTo>
                <a:lnTo>
                  <a:pt x="355" y="2"/>
                </a:lnTo>
                <a:lnTo>
                  <a:pt x="356" y="2"/>
                </a:lnTo>
                <a:lnTo>
                  <a:pt x="357" y="2"/>
                </a:lnTo>
                <a:lnTo>
                  <a:pt x="358" y="2"/>
                </a:lnTo>
                <a:lnTo>
                  <a:pt x="359" y="1"/>
                </a:lnTo>
                <a:lnTo>
                  <a:pt x="359" y="3"/>
                </a:lnTo>
                <a:lnTo>
                  <a:pt x="360" y="3"/>
                </a:lnTo>
                <a:lnTo>
                  <a:pt x="361" y="3"/>
                </a:lnTo>
                <a:lnTo>
                  <a:pt x="362" y="5"/>
                </a:lnTo>
                <a:lnTo>
                  <a:pt x="363" y="6"/>
                </a:lnTo>
                <a:lnTo>
                  <a:pt x="364" y="7"/>
                </a:lnTo>
                <a:lnTo>
                  <a:pt x="365" y="7"/>
                </a:lnTo>
                <a:lnTo>
                  <a:pt x="366" y="9"/>
                </a:lnTo>
                <a:lnTo>
                  <a:pt x="366" y="11"/>
                </a:lnTo>
                <a:lnTo>
                  <a:pt x="367" y="12"/>
                </a:lnTo>
                <a:lnTo>
                  <a:pt x="368" y="13"/>
                </a:lnTo>
                <a:lnTo>
                  <a:pt x="369" y="11"/>
                </a:lnTo>
                <a:lnTo>
                  <a:pt x="370" y="13"/>
                </a:lnTo>
                <a:lnTo>
                  <a:pt x="371" y="11"/>
                </a:lnTo>
                <a:lnTo>
                  <a:pt x="372" y="10"/>
                </a:lnTo>
                <a:lnTo>
                  <a:pt x="373" y="9"/>
                </a:lnTo>
                <a:lnTo>
                  <a:pt x="374" y="9"/>
                </a:lnTo>
                <a:lnTo>
                  <a:pt x="374" y="7"/>
                </a:lnTo>
                <a:lnTo>
                  <a:pt x="375" y="6"/>
                </a:lnTo>
                <a:lnTo>
                  <a:pt x="376" y="5"/>
                </a:lnTo>
                <a:lnTo>
                  <a:pt x="377" y="5"/>
                </a:lnTo>
                <a:lnTo>
                  <a:pt x="378" y="5"/>
                </a:lnTo>
                <a:lnTo>
                  <a:pt x="379" y="4"/>
                </a:lnTo>
                <a:lnTo>
                  <a:pt x="380" y="5"/>
                </a:lnTo>
                <a:lnTo>
                  <a:pt x="381" y="5"/>
                </a:lnTo>
                <a:lnTo>
                  <a:pt x="381" y="4"/>
                </a:lnTo>
                <a:lnTo>
                  <a:pt x="382" y="4"/>
                </a:lnTo>
                <a:lnTo>
                  <a:pt x="383" y="4"/>
                </a:lnTo>
                <a:lnTo>
                  <a:pt x="384" y="5"/>
                </a:lnTo>
                <a:lnTo>
                  <a:pt x="385" y="5"/>
                </a:lnTo>
                <a:lnTo>
                  <a:pt x="386" y="4"/>
                </a:lnTo>
                <a:lnTo>
                  <a:pt x="387" y="3"/>
                </a:lnTo>
                <a:lnTo>
                  <a:pt x="388" y="4"/>
                </a:lnTo>
                <a:lnTo>
                  <a:pt x="389" y="4"/>
                </a:lnTo>
                <a:lnTo>
                  <a:pt x="389" y="2"/>
                </a:lnTo>
                <a:lnTo>
                  <a:pt x="390" y="3"/>
                </a:lnTo>
                <a:lnTo>
                  <a:pt x="391" y="3"/>
                </a:lnTo>
                <a:lnTo>
                  <a:pt x="392" y="2"/>
                </a:lnTo>
                <a:lnTo>
                  <a:pt x="393" y="3"/>
                </a:lnTo>
                <a:lnTo>
                  <a:pt x="394" y="2"/>
                </a:lnTo>
                <a:lnTo>
                  <a:pt x="395" y="2"/>
                </a:lnTo>
                <a:lnTo>
                  <a:pt x="396" y="3"/>
                </a:lnTo>
                <a:lnTo>
                  <a:pt x="396" y="2"/>
                </a:lnTo>
                <a:lnTo>
                  <a:pt x="397" y="2"/>
                </a:lnTo>
                <a:lnTo>
                  <a:pt x="398" y="3"/>
                </a:lnTo>
                <a:lnTo>
                  <a:pt x="399" y="2"/>
                </a:lnTo>
                <a:lnTo>
                  <a:pt x="400" y="2"/>
                </a:lnTo>
                <a:lnTo>
                  <a:pt x="401" y="2"/>
                </a:lnTo>
                <a:lnTo>
                  <a:pt x="402" y="3"/>
                </a:lnTo>
                <a:lnTo>
                  <a:pt x="403" y="1"/>
                </a:lnTo>
                <a:lnTo>
                  <a:pt x="403" y="2"/>
                </a:lnTo>
                <a:lnTo>
                  <a:pt x="404" y="2"/>
                </a:lnTo>
                <a:lnTo>
                  <a:pt x="405" y="1"/>
                </a:lnTo>
                <a:lnTo>
                  <a:pt x="406" y="1"/>
                </a:lnTo>
                <a:lnTo>
                  <a:pt x="407" y="2"/>
                </a:lnTo>
                <a:lnTo>
                  <a:pt x="408" y="2"/>
                </a:lnTo>
                <a:lnTo>
                  <a:pt x="409" y="1"/>
                </a:lnTo>
                <a:lnTo>
                  <a:pt x="410" y="2"/>
                </a:lnTo>
                <a:lnTo>
                  <a:pt x="411" y="1"/>
                </a:lnTo>
                <a:lnTo>
                  <a:pt x="411" y="2"/>
                </a:lnTo>
                <a:lnTo>
                  <a:pt x="412" y="1"/>
                </a:lnTo>
                <a:lnTo>
                  <a:pt x="413" y="2"/>
                </a:lnTo>
                <a:lnTo>
                  <a:pt x="414" y="1"/>
                </a:lnTo>
                <a:lnTo>
                  <a:pt x="415" y="2"/>
                </a:lnTo>
                <a:lnTo>
                  <a:pt x="416" y="2"/>
                </a:lnTo>
                <a:lnTo>
                  <a:pt x="417" y="1"/>
                </a:lnTo>
                <a:lnTo>
                  <a:pt x="418" y="2"/>
                </a:lnTo>
                <a:lnTo>
                  <a:pt x="418" y="2"/>
                </a:lnTo>
                <a:lnTo>
                  <a:pt x="419" y="2"/>
                </a:lnTo>
                <a:lnTo>
                  <a:pt x="420" y="1"/>
                </a:lnTo>
                <a:lnTo>
                  <a:pt x="421" y="2"/>
                </a:lnTo>
                <a:lnTo>
                  <a:pt x="422" y="2"/>
                </a:lnTo>
                <a:lnTo>
                  <a:pt x="423" y="1"/>
                </a:lnTo>
                <a:lnTo>
                  <a:pt x="424" y="2"/>
                </a:lnTo>
                <a:lnTo>
                  <a:pt x="425" y="2"/>
                </a:lnTo>
                <a:lnTo>
                  <a:pt x="426" y="1"/>
                </a:lnTo>
                <a:lnTo>
                  <a:pt x="426" y="1"/>
                </a:lnTo>
                <a:lnTo>
                  <a:pt x="427" y="2"/>
                </a:lnTo>
                <a:lnTo>
                  <a:pt x="428" y="1"/>
                </a:lnTo>
                <a:lnTo>
                  <a:pt x="429" y="2"/>
                </a:lnTo>
                <a:lnTo>
                  <a:pt x="430" y="2"/>
                </a:lnTo>
                <a:lnTo>
                  <a:pt x="431" y="2"/>
                </a:lnTo>
                <a:lnTo>
                  <a:pt x="432" y="1"/>
                </a:lnTo>
                <a:lnTo>
                  <a:pt x="433" y="1"/>
                </a:lnTo>
                <a:lnTo>
                  <a:pt x="433" y="1"/>
                </a:lnTo>
                <a:lnTo>
                  <a:pt x="434" y="1"/>
                </a:lnTo>
                <a:lnTo>
                  <a:pt x="435" y="2"/>
                </a:lnTo>
                <a:lnTo>
                  <a:pt x="436" y="1"/>
                </a:lnTo>
                <a:lnTo>
                  <a:pt x="437" y="1"/>
                </a:lnTo>
                <a:lnTo>
                  <a:pt x="438" y="1"/>
                </a:lnTo>
                <a:lnTo>
                  <a:pt x="439" y="1"/>
                </a:lnTo>
                <a:lnTo>
                  <a:pt x="440" y="1"/>
                </a:lnTo>
                <a:lnTo>
                  <a:pt x="441" y="1"/>
                </a:lnTo>
                <a:lnTo>
                  <a:pt x="441" y="1"/>
                </a:lnTo>
                <a:lnTo>
                  <a:pt x="442" y="1"/>
                </a:lnTo>
                <a:lnTo>
                  <a:pt x="443" y="1"/>
                </a:lnTo>
                <a:lnTo>
                  <a:pt x="444" y="1"/>
                </a:lnTo>
                <a:lnTo>
                  <a:pt x="445" y="1"/>
                </a:lnTo>
                <a:lnTo>
                  <a:pt x="446" y="1"/>
                </a:lnTo>
                <a:lnTo>
                  <a:pt x="447" y="2"/>
                </a:lnTo>
                <a:lnTo>
                  <a:pt x="448" y="1"/>
                </a:lnTo>
                <a:lnTo>
                  <a:pt x="448" y="1"/>
                </a:lnTo>
                <a:lnTo>
                  <a:pt x="449" y="2"/>
                </a:lnTo>
                <a:lnTo>
                  <a:pt x="450" y="1"/>
                </a:lnTo>
                <a:lnTo>
                  <a:pt x="451" y="2"/>
                </a:lnTo>
                <a:lnTo>
                  <a:pt x="452" y="3"/>
                </a:lnTo>
                <a:lnTo>
                  <a:pt x="453" y="1"/>
                </a:lnTo>
                <a:lnTo>
                  <a:pt x="454" y="2"/>
                </a:lnTo>
                <a:lnTo>
                  <a:pt x="455" y="2"/>
                </a:lnTo>
                <a:lnTo>
                  <a:pt x="456" y="2"/>
                </a:lnTo>
                <a:lnTo>
                  <a:pt x="456" y="2"/>
                </a:lnTo>
                <a:lnTo>
                  <a:pt x="457" y="2"/>
                </a:lnTo>
                <a:lnTo>
                  <a:pt x="458" y="1"/>
                </a:lnTo>
                <a:lnTo>
                  <a:pt x="459" y="1"/>
                </a:lnTo>
                <a:lnTo>
                  <a:pt x="460" y="1"/>
                </a:lnTo>
                <a:lnTo>
                  <a:pt x="461" y="2"/>
                </a:lnTo>
                <a:lnTo>
                  <a:pt x="462" y="1"/>
                </a:lnTo>
                <a:lnTo>
                  <a:pt x="463" y="2"/>
                </a:lnTo>
                <a:lnTo>
                  <a:pt x="463" y="2"/>
                </a:lnTo>
                <a:lnTo>
                  <a:pt x="464" y="2"/>
                </a:lnTo>
                <a:lnTo>
                  <a:pt x="465" y="1"/>
                </a:lnTo>
                <a:lnTo>
                  <a:pt x="466" y="1"/>
                </a:lnTo>
                <a:lnTo>
                  <a:pt x="467" y="2"/>
                </a:lnTo>
                <a:lnTo>
                  <a:pt x="468" y="3"/>
                </a:lnTo>
                <a:lnTo>
                  <a:pt x="469" y="2"/>
                </a:lnTo>
                <a:lnTo>
                  <a:pt x="470" y="2"/>
                </a:lnTo>
                <a:lnTo>
                  <a:pt x="471" y="2"/>
                </a:lnTo>
                <a:lnTo>
                  <a:pt x="471" y="2"/>
                </a:lnTo>
                <a:lnTo>
                  <a:pt x="472" y="2"/>
                </a:lnTo>
                <a:lnTo>
                  <a:pt x="473" y="2"/>
                </a:lnTo>
                <a:lnTo>
                  <a:pt x="474" y="1"/>
                </a:lnTo>
                <a:lnTo>
                  <a:pt x="475" y="1"/>
                </a:lnTo>
                <a:lnTo>
                  <a:pt x="476" y="1"/>
                </a:lnTo>
                <a:lnTo>
                  <a:pt x="477" y="2"/>
                </a:lnTo>
                <a:lnTo>
                  <a:pt x="478" y="2"/>
                </a:lnTo>
                <a:lnTo>
                  <a:pt x="478" y="2"/>
                </a:lnTo>
                <a:lnTo>
                  <a:pt x="479" y="2"/>
                </a:lnTo>
                <a:lnTo>
                  <a:pt x="480" y="1"/>
                </a:lnTo>
                <a:lnTo>
                  <a:pt x="481" y="1"/>
                </a:lnTo>
                <a:lnTo>
                  <a:pt x="482" y="1"/>
                </a:lnTo>
                <a:lnTo>
                  <a:pt x="483" y="1"/>
                </a:lnTo>
                <a:lnTo>
                  <a:pt x="484" y="0"/>
                </a:lnTo>
                <a:lnTo>
                  <a:pt x="485" y="1"/>
                </a:lnTo>
                <a:lnTo>
                  <a:pt x="486" y="1"/>
                </a:lnTo>
                <a:lnTo>
                  <a:pt x="486" y="1"/>
                </a:lnTo>
                <a:lnTo>
                  <a:pt x="487" y="1"/>
                </a:lnTo>
                <a:lnTo>
                  <a:pt x="488" y="1"/>
                </a:lnTo>
                <a:lnTo>
                  <a:pt x="489" y="1"/>
                </a:lnTo>
                <a:lnTo>
                  <a:pt x="490" y="1"/>
                </a:lnTo>
                <a:lnTo>
                  <a:pt x="491" y="2"/>
                </a:lnTo>
                <a:lnTo>
                  <a:pt x="492" y="1"/>
                </a:lnTo>
                <a:lnTo>
                  <a:pt x="493" y="1"/>
                </a:lnTo>
                <a:lnTo>
                  <a:pt x="493" y="1"/>
                </a:lnTo>
                <a:lnTo>
                  <a:pt x="494" y="1"/>
                </a:lnTo>
                <a:lnTo>
                  <a:pt x="495" y="1"/>
                </a:lnTo>
                <a:lnTo>
                  <a:pt x="496" y="2"/>
                </a:lnTo>
                <a:lnTo>
                  <a:pt x="497" y="1"/>
                </a:lnTo>
                <a:lnTo>
                  <a:pt x="498" y="0"/>
                </a:lnTo>
                <a:lnTo>
                  <a:pt x="499" y="1"/>
                </a:lnTo>
                <a:lnTo>
                  <a:pt x="500" y="1"/>
                </a:lnTo>
                <a:lnTo>
                  <a:pt x="501" y="1"/>
                </a:lnTo>
                <a:lnTo>
                  <a:pt x="501" y="1"/>
                </a:lnTo>
                <a:lnTo>
                  <a:pt x="502" y="1"/>
                </a:lnTo>
                <a:lnTo>
                  <a:pt x="503" y="1"/>
                </a:lnTo>
                <a:lnTo>
                  <a:pt x="504" y="1"/>
                </a:lnTo>
                <a:lnTo>
                  <a:pt x="505" y="1"/>
                </a:lnTo>
                <a:lnTo>
                  <a:pt x="506" y="1"/>
                </a:lnTo>
                <a:lnTo>
                  <a:pt x="507" y="1"/>
                </a:lnTo>
                <a:lnTo>
                  <a:pt x="508" y="2"/>
                </a:lnTo>
                <a:lnTo>
                  <a:pt x="508" y="1"/>
                </a:lnTo>
                <a:lnTo>
                  <a:pt x="509" y="2"/>
                </a:lnTo>
                <a:lnTo>
                  <a:pt x="510" y="1"/>
                </a:lnTo>
                <a:lnTo>
                  <a:pt x="511" y="2"/>
                </a:lnTo>
                <a:lnTo>
                  <a:pt x="512" y="1"/>
                </a:lnTo>
                <a:lnTo>
                  <a:pt x="513" y="2"/>
                </a:lnTo>
                <a:lnTo>
                  <a:pt x="514" y="2"/>
                </a:lnTo>
                <a:lnTo>
                  <a:pt x="515" y="1"/>
                </a:lnTo>
                <a:lnTo>
                  <a:pt x="516" y="2"/>
                </a:lnTo>
                <a:lnTo>
                  <a:pt x="516" y="2"/>
                </a:lnTo>
                <a:lnTo>
                  <a:pt x="517" y="1"/>
                </a:lnTo>
                <a:lnTo>
                  <a:pt x="518" y="1"/>
                </a:lnTo>
                <a:lnTo>
                  <a:pt x="519" y="2"/>
                </a:lnTo>
                <a:lnTo>
                  <a:pt x="520" y="2"/>
                </a:lnTo>
                <a:lnTo>
                  <a:pt x="521" y="1"/>
                </a:lnTo>
                <a:lnTo>
                  <a:pt x="522" y="2"/>
                </a:lnTo>
                <a:lnTo>
                  <a:pt x="523" y="2"/>
                </a:lnTo>
                <a:lnTo>
                  <a:pt x="523" y="1"/>
                </a:lnTo>
                <a:lnTo>
                  <a:pt x="524" y="1"/>
                </a:lnTo>
                <a:lnTo>
                  <a:pt x="525" y="1"/>
                </a:lnTo>
                <a:lnTo>
                  <a:pt x="526" y="2"/>
                </a:lnTo>
                <a:lnTo>
                  <a:pt x="527" y="2"/>
                </a:lnTo>
                <a:lnTo>
                  <a:pt x="528" y="4"/>
                </a:lnTo>
                <a:lnTo>
                  <a:pt x="529" y="6"/>
                </a:lnTo>
                <a:lnTo>
                  <a:pt x="530" y="9"/>
                </a:lnTo>
                <a:lnTo>
                  <a:pt x="531" y="15"/>
                </a:lnTo>
                <a:lnTo>
                  <a:pt x="531" y="19"/>
                </a:lnTo>
                <a:lnTo>
                  <a:pt x="532" y="26"/>
                </a:lnTo>
                <a:lnTo>
                  <a:pt x="533" y="37"/>
                </a:lnTo>
                <a:lnTo>
                  <a:pt x="534" y="46"/>
                </a:lnTo>
                <a:lnTo>
                  <a:pt x="535" y="58"/>
                </a:lnTo>
                <a:lnTo>
                  <a:pt x="536" y="67"/>
                </a:lnTo>
                <a:lnTo>
                  <a:pt x="537" y="76"/>
                </a:lnTo>
                <a:lnTo>
                  <a:pt x="538" y="79"/>
                </a:lnTo>
                <a:lnTo>
                  <a:pt x="538" y="84"/>
                </a:lnTo>
                <a:lnTo>
                  <a:pt x="539" y="80"/>
                </a:lnTo>
                <a:lnTo>
                  <a:pt x="540" y="74"/>
                </a:lnTo>
                <a:lnTo>
                  <a:pt x="541" y="70"/>
                </a:lnTo>
                <a:lnTo>
                  <a:pt x="542" y="62"/>
                </a:lnTo>
                <a:lnTo>
                  <a:pt x="543" y="58"/>
                </a:lnTo>
                <a:lnTo>
                  <a:pt x="544" y="56"/>
                </a:lnTo>
                <a:lnTo>
                  <a:pt x="545" y="56"/>
                </a:lnTo>
                <a:lnTo>
                  <a:pt x="546" y="56"/>
                </a:lnTo>
                <a:lnTo>
                  <a:pt x="546" y="53"/>
                </a:lnTo>
                <a:lnTo>
                  <a:pt x="547" y="53"/>
                </a:lnTo>
                <a:lnTo>
                  <a:pt x="548" y="51"/>
                </a:lnTo>
                <a:lnTo>
                  <a:pt x="549" y="48"/>
                </a:lnTo>
                <a:lnTo>
                  <a:pt x="550" y="47"/>
                </a:lnTo>
                <a:lnTo>
                  <a:pt x="551" y="43"/>
                </a:lnTo>
                <a:lnTo>
                  <a:pt x="552" y="37"/>
                </a:lnTo>
                <a:lnTo>
                  <a:pt x="553" y="33"/>
                </a:lnTo>
                <a:lnTo>
                  <a:pt x="553" y="32"/>
                </a:lnTo>
                <a:lnTo>
                  <a:pt x="554" y="29"/>
                </a:lnTo>
                <a:lnTo>
                  <a:pt x="555" y="26"/>
                </a:lnTo>
                <a:lnTo>
                  <a:pt x="556" y="25"/>
                </a:lnTo>
                <a:lnTo>
                  <a:pt x="557" y="22"/>
                </a:lnTo>
                <a:lnTo>
                  <a:pt x="558" y="22"/>
                </a:lnTo>
                <a:lnTo>
                  <a:pt x="559" y="19"/>
                </a:lnTo>
                <a:lnTo>
                  <a:pt x="560" y="19"/>
                </a:lnTo>
                <a:lnTo>
                  <a:pt x="561" y="18"/>
                </a:lnTo>
                <a:lnTo>
                  <a:pt x="561" y="17"/>
                </a:lnTo>
                <a:lnTo>
                  <a:pt x="562" y="17"/>
                </a:lnTo>
                <a:lnTo>
                  <a:pt x="563" y="16"/>
                </a:lnTo>
                <a:lnTo>
                  <a:pt x="564" y="16"/>
                </a:lnTo>
                <a:lnTo>
                  <a:pt x="565" y="16"/>
                </a:lnTo>
                <a:lnTo>
                  <a:pt x="566" y="16"/>
                </a:lnTo>
                <a:lnTo>
                  <a:pt x="567" y="16"/>
                </a:lnTo>
                <a:lnTo>
                  <a:pt x="568" y="16"/>
                </a:lnTo>
                <a:lnTo>
                  <a:pt x="568" y="14"/>
                </a:lnTo>
                <a:lnTo>
                  <a:pt x="569" y="14"/>
                </a:lnTo>
                <a:lnTo>
                  <a:pt x="570" y="13"/>
                </a:lnTo>
                <a:lnTo>
                  <a:pt x="571" y="13"/>
                </a:lnTo>
                <a:lnTo>
                  <a:pt x="572" y="14"/>
                </a:lnTo>
                <a:lnTo>
                  <a:pt x="573" y="14"/>
                </a:lnTo>
                <a:lnTo>
                  <a:pt x="574" y="16"/>
                </a:lnTo>
                <a:lnTo>
                  <a:pt x="575" y="14"/>
                </a:lnTo>
                <a:lnTo>
                  <a:pt x="576" y="14"/>
                </a:lnTo>
                <a:lnTo>
                  <a:pt x="576" y="14"/>
                </a:lnTo>
                <a:lnTo>
                  <a:pt x="577" y="15"/>
                </a:lnTo>
                <a:lnTo>
                  <a:pt x="578" y="13"/>
                </a:lnTo>
                <a:lnTo>
                  <a:pt x="579" y="13"/>
                </a:lnTo>
                <a:lnTo>
                  <a:pt x="580" y="13"/>
                </a:lnTo>
                <a:lnTo>
                  <a:pt x="581" y="12"/>
                </a:lnTo>
                <a:lnTo>
                  <a:pt x="582" y="12"/>
                </a:lnTo>
                <a:lnTo>
                  <a:pt x="583" y="11"/>
                </a:lnTo>
                <a:lnTo>
                  <a:pt x="583" y="10"/>
                </a:lnTo>
                <a:lnTo>
                  <a:pt x="584" y="10"/>
                </a:lnTo>
                <a:lnTo>
                  <a:pt x="585" y="9"/>
                </a:lnTo>
                <a:lnTo>
                  <a:pt x="586" y="9"/>
                </a:lnTo>
                <a:lnTo>
                  <a:pt x="587" y="8"/>
                </a:lnTo>
                <a:lnTo>
                  <a:pt x="588" y="8"/>
                </a:lnTo>
                <a:lnTo>
                  <a:pt x="589" y="8"/>
                </a:lnTo>
                <a:lnTo>
                  <a:pt x="590" y="8"/>
                </a:lnTo>
                <a:lnTo>
                  <a:pt x="591" y="8"/>
                </a:lnTo>
                <a:lnTo>
                  <a:pt x="591" y="6"/>
                </a:lnTo>
                <a:lnTo>
                  <a:pt x="592" y="7"/>
                </a:lnTo>
                <a:lnTo>
                  <a:pt x="593" y="5"/>
                </a:lnTo>
                <a:lnTo>
                  <a:pt x="594" y="5"/>
                </a:lnTo>
                <a:lnTo>
                  <a:pt x="595" y="6"/>
                </a:lnTo>
                <a:lnTo>
                  <a:pt x="596" y="5"/>
                </a:lnTo>
                <a:lnTo>
                  <a:pt x="597" y="5"/>
                </a:lnTo>
                <a:lnTo>
                  <a:pt x="598" y="5"/>
                </a:lnTo>
                <a:lnTo>
                  <a:pt x="598" y="5"/>
                </a:lnTo>
                <a:lnTo>
                  <a:pt x="599" y="4"/>
                </a:lnTo>
                <a:lnTo>
                  <a:pt x="600" y="4"/>
                </a:lnTo>
                <a:lnTo>
                  <a:pt x="601" y="5"/>
                </a:lnTo>
                <a:lnTo>
                  <a:pt x="602" y="5"/>
                </a:lnTo>
                <a:lnTo>
                  <a:pt x="603" y="3"/>
                </a:lnTo>
                <a:lnTo>
                  <a:pt x="604" y="3"/>
                </a:lnTo>
                <a:lnTo>
                  <a:pt x="605" y="4"/>
                </a:lnTo>
                <a:lnTo>
                  <a:pt x="605" y="4"/>
                </a:lnTo>
                <a:lnTo>
                  <a:pt x="606" y="3"/>
                </a:lnTo>
                <a:lnTo>
                  <a:pt x="607" y="3"/>
                </a:lnTo>
                <a:lnTo>
                  <a:pt x="608" y="3"/>
                </a:lnTo>
                <a:lnTo>
                  <a:pt x="609" y="2"/>
                </a:lnTo>
                <a:lnTo>
                  <a:pt x="610" y="2"/>
                </a:lnTo>
                <a:lnTo>
                  <a:pt x="611" y="2"/>
                </a:lnTo>
                <a:lnTo>
                  <a:pt x="612" y="3"/>
                </a:lnTo>
                <a:lnTo>
                  <a:pt x="613" y="2"/>
                </a:lnTo>
                <a:lnTo>
                  <a:pt x="613" y="3"/>
                </a:lnTo>
                <a:lnTo>
                  <a:pt x="614" y="3"/>
                </a:lnTo>
                <a:lnTo>
                  <a:pt x="615" y="2"/>
                </a:lnTo>
                <a:lnTo>
                  <a:pt x="616" y="2"/>
                </a:lnTo>
                <a:lnTo>
                  <a:pt x="617" y="3"/>
                </a:lnTo>
                <a:lnTo>
                  <a:pt x="618" y="3"/>
                </a:lnTo>
                <a:lnTo>
                  <a:pt x="619" y="3"/>
                </a:lnTo>
                <a:lnTo>
                  <a:pt x="620" y="4"/>
                </a:lnTo>
                <a:lnTo>
                  <a:pt x="620" y="4"/>
                </a:lnTo>
                <a:lnTo>
                  <a:pt x="621" y="5"/>
                </a:lnTo>
                <a:lnTo>
                  <a:pt x="622" y="5"/>
                </a:lnTo>
                <a:lnTo>
                  <a:pt x="623" y="7"/>
                </a:lnTo>
                <a:lnTo>
                  <a:pt x="624" y="7"/>
                </a:lnTo>
                <a:lnTo>
                  <a:pt x="625" y="8"/>
                </a:lnTo>
                <a:lnTo>
                  <a:pt x="626" y="8"/>
                </a:lnTo>
                <a:lnTo>
                  <a:pt x="627" y="9"/>
                </a:lnTo>
                <a:lnTo>
                  <a:pt x="628" y="9"/>
                </a:lnTo>
                <a:lnTo>
                  <a:pt x="628" y="9"/>
                </a:lnTo>
                <a:lnTo>
                  <a:pt x="629" y="12"/>
                </a:lnTo>
                <a:lnTo>
                  <a:pt x="630" y="10"/>
                </a:lnTo>
                <a:lnTo>
                  <a:pt x="631" y="11"/>
                </a:lnTo>
                <a:lnTo>
                  <a:pt x="632" y="9"/>
                </a:lnTo>
                <a:lnTo>
                  <a:pt x="633" y="10"/>
                </a:lnTo>
                <a:lnTo>
                  <a:pt x="634" y="9"/>
                </a:lnTo>
                <a:lnTo>
                  <a:pt x="635" y="8"/>
                </a:lnTo>
                <a:lnTo>
                  <a:pt x="635" y="7"/>
                </a:lnTo>
                <a:lnTo>
                  <a:pt x="636" y="8"/>
                </a:lnTo>
                <a:lnTo>
                  <a:pt x="637" y="7"/>
                </a:lnTo>
                <a:lnTo>
                  <a:pt x="638" y="7"/>
                </a:lnTo>
                <a:lnTo>
                  <a:pt x="639" y="8"/>
                </a:lnTo>
                <a:lnTo>
                  <a:pt x="640" y="7"/>
                </a:lnTo>
                <a:lnTo>
                  <a:pt x="641" y="7"/>
                </a:lnTo>
                <a:lnTo>
                  <a:pt x="642" y="7"/>
                </a:lnTo>
                <a:lnTo>
                  <a:pt x="643" y="6"/>
                </a:lnTo>
                <a:lnTo>
                  <a:pt x="643" y="6"/>
                </a:lnTo>
                <a:lnTo>
                  <a:pt x="644" y="6"/>
                </a:lnTo>
                <a:lnTo>
                  <a:pt x="645" y="6"/>
                </a:lnTo>
                <a:lnTo>
                  <a:pt x="646" y="6"/>
                </a:lnTo>
                <a:lnTo>
                  <a:pt x="647" y="4"/>
                </a:lnTo>
                <a:lnTo>
                  <a:pt x="648" y="5"/>
                </a:lnTo>
                <a:lnTo>
                  <a:pt x="649" y="4"/>
                </a:lnTo>
                <a:lnTo>
                  <a:pt x="650" y="4"/>
                </a:lnTo>
                <a:lnTo>
                  <a:pt x="650" y="5"/>
                </a:lnTo>
                <a:lnTo>
                  <a:pt x="651" y="6"/>
                </a:lnTo>
                <a:lnTo>
                  <a:pt x="652" y="5"/>
                </a:lnTo>
                <a:lnTo>
                  <a:pt x="653" y="5"/>
                </a:lnTo>
                <a:lnTo>
                  <a:pt x="654" y="5"/>
                </a:lnTo>
                <a:lnTo>
                  <a:pt x="655" y="6"/>
                </a:lnTo>
                <a:lnTo>
                  <a:pt x="656" y="5"/>
                </a:lnTo>
                <a:lnTo>
                  <a:pt x="657" y="6"/>
                </a:lnTo>
                <a:lnTo>
                  <a:pt x="658" y="6"/>
                </a:lnTo>
                <a:lnTo>
                  <a:pt x="658" y="6"/>
                </a:lnTo>
                <a:lnTo>
                  <a:pt x="659" y="6"/>
                </a:lnTo>
                <a:lnTo>
                  <a:pt x="660" y="6"/>
                </a:lnTo>
                <a:lnTo>
                  <a:pt x="661" y="6"/>
                </a:lnTo>
                <a:lnTo>
                  <a:pt x="662" y="7"/>
                </a:lnTo>
                <a:lnTo>
                  <a:pt x="663" y="6"/>
                </a:lnTo>
                <a:lnTo>
                  <a:pt x="664" y="6"/>
                </a:lnTo>
                <a:lnTo>
                  <a:pt x="665" y="5"/>
                </a:lnTo>
                <a:lnTo>
                  <a:pt x="665" y="6"/>
                </a:lnTo>
                <a:lnTo>
                  <a:pt x="666" y="6"/>
                </a:lnTo>
                <a:lnTo>
                  <a:pt x="667" y="5"/>
                </a:lnTo>
                <a:lnTo>
                  <a:pt x="668" y="4"/>
                </a:lnTo>
                <a:lnTo>
                  <a:pt x="669" y="3"/>
                </a:lnTo>
                <a:lnTo>
                  <a:pt x="670" y="4"/>
                </a:lnTo>
                <a:lnTo>
                  <a:pt x="671" y="2"/>
                </a:lnTo>
                <a:lnTo>
                  <a:pt x="672" y="3"/>
                </a:lnTo>
                <a:lnTo>
                  <a:pt x="673" y="3"/>
                </a:lnTo>
                <a:lnTo>
                  <a:pt x="673" y="4"/>
                </a:lnTo>
                <a:lnTo>
                  <a:pt x="674" y="3"/>
                </a:lnTo>
                <a:lnTo>
                  <a:pt x="675" y="3"/>
                </a:lnTo>
                <a:lnTo>
                  <a:pt x="676" y="4"/>
                </a:lnTo>
                <a:lnTo>
                  <a:pt x="677" y="3"/>
                </a:lnTo>
                <a:lnTo>
                  <a:pt x="678" y="3"/>
                </a:lnTo>
                <a:lnTo>
                  <a:pt x="679" y="3"/>
                </a:lnTo>
                <a:lnTo>
                  <a:pt x="680" y="3"/>
                </a:lnTo>
                <a:lnTo>
                  <a:pt x="680" y="3"/>
                </a:lnTo>
                <a:lnTo>
                  <a:pt x="681" y="3"/>
                </a:lnTo>
                <a:lnTo>
                  <a:pt x="682" y="3"/>
                </a:lnTo>
                <a:lnTo>
                  <a:pt x="683" y="2"/>
                </a:lnTo>
                <a:lnTo>
                  <a:pt x="684" y="2"/>
                </a:lnTo>
                <a:lnTo>
                  <a:pt x="685" y="2"/>
                </a:lnTo>
                <a:lnTo>
                  <a:pt x="686" y="2"/>
                </a:lnTo>
                <a:lnTo>
                  <a:pt x="687" y="2"/>
                </a:lnTo>
                <a:lnTo>
                  <a:pt x="688" y="2"/>
                </a:lnTo>
                <a:lnTo>
                  <a:pt x="688" y="2"/>
                </a:lnTo>
                <a:lnTo>
                  <a:pt x="689" y="2"/>
                </a:lnTo>
                <a:lnTo>
                  <a:pt x="690" y="2"/>
                </a:lnTo>
                <a:lnTo>
                  <a:pt x="691" y="2"/>
                </a:lnTo>
                <a:lnTo>
                  <a:pt x="692" y="1"/>
                </a:lnTo>
                <a:lnTo>
                  <a:pt x="693" y="2"/>
                </a:lnTo>
                <a:lnTo>
                  <a:pt x="694" y="2"/>
                </a:lnTo>
                <a:lnTo>
                  <a:pt x="695" y="2"/>
                </a:lnTo>
                <a:lnTo>
                  <a:pt x="695" y="2"/>
                </a:lnTo>
                <a:lnTo>
                  <a:pt x="696" y="2"/>
                </a:lnTo>
                <a:lnTo>
                  <a:pt x="697" y="2"/>
                </a:lnTo>
                <a:lnTo>
                  <a:pt x="698" y="2"/>
                </a:lnTo>
                <a:lnTo>
                  <a:pt x="699" y="2"/>
                </a:lnTo>
                <a:lnTo>
                  <a:pt x="700" y="1"/>
                </a:lnTo>
                <a:lnTo>
                  <a:pt x="701" y="2"/>
                </a:lnTo>
                <a:lnTo>
                  <a:pt x="702" y="2"/>
                </a:lnTo>
                <a:lnTo>
                  <a:pt x="703" y="1"/>
                </a:lnTo>
                <a:lnTo>
                  <a:pt x="703" y="2"/>
                </a:lnTo>
                <a:lnTo>
                  <a:pt x="704" y="2"/>
                </a:lnTo>
                <a:lnTo>
                  <a:pt x="705" y="2"/>
                </a:lnTo>
                <a:lnTo>
                  <a:pt x="706" y="2"/>
                </a:lnTo>
                <a:lnTo>
                  <a:pt x="707" y="1"/>
                </a:lnTo>
                <a:lnTo>
                  <a:pt x="708" y="2"/>
                </a:lnTo>
                <a:lnTo>
                  <a:pt x="709" y="3"/>
                </a:lnTo>
                <a:lnTo>
                  <a:pt x="710" y="3"/>
                </a:lnTo>
                <a:lnTo>
                  <a:pt x="710" y="4"/>
                </a:lnTo>
                <a:lnTo>
                  <a:pt x="711" y="5"/>
                </a:lnTo>
                <a:lnTo>
                  <a:pt x="712" y="4"/>
                </a:lnTo>
                <a:lnTo>
                  <a:pt x="713" y="4"/>
                </a:lnTo>
                <a:lnTo>
                  <a:pt x="714" y="5"/>
                </a:lnTo>
                <a:lnTo>
                  <a:pt x="715" y="4"/>
                </a:lnTo>
                <a:lnTo>
                  <a:pt x="716" y="5"/>
                </a:lnTo>
                <a:lnTo>
                  <a:pt x="717" y="5"/>
                </a:lnTo>
                <a:lnTo>
                  <a:pt x="718" y="5"/>
                </a:lnTo>
                <a:lnTo>
                  <a:pt x="718" y="6"/>
                </a:lnTo>
                <a:lnTo>
                  <a:pt x="719" y="6"/>
                </a:lnTo>
                <a:lnTo>
                  <a:pt x="720" y="6"/>
                </a:lnTo>
                <a:lnTo>
                  <a:pt x="721" y="7"/>
                </a:lnTo>
                <a:lnTo>
                  <a:pt x="722" y="8"/>
                </a:lnTo>
                <a:lnTo>
                  <a:pt x="723" y="8"/>
                </a:lnTo>
                <a:lnTo>
                  <a:pt x="724" y="8"/>
                </a:lnTo>
                <a:lnTo>
                  <a:pt x="725" y="8"/>
                </a:lnTo>
                <a:lnTo>
                  <a:pt x="725" y="8"/>
                </a:lnTo>
                <a:lnTo>
                  <a:pt x="726" y="7"/>
                </a:lnTo>
                <a:lnTo>
                  <a:pt x="727" y="7"/>
                </a:lnTo>
                <a:lnTo>
                  <a:pt x="728" y="6"/>
                </a:lnTo>
                <a:lnTo>
                  <a:pt x="729" y="5"/>
                </a:lnTo>
                <a:lnTo>
                  <a:pt x="730" y="6"/>
                </a:lnTo>
                <a:lnTo>
                  <a:pt x="731" y="4"/>
                </a:lnTo>
                <a:lnTo>
                  <a:pt x="732" y="4"/>
                </a:lnTo>
                <a:lnTo>
                  <a:pt x="733" y="3"/>
                </a:lnTo>
                <a:lnTo>
                  <a:pt x="733" y="3"/>
                </a:lnTo>
                <a:lnTo>
                  <a:pt x="734" y="3"/>
                </a:lnTo>
                <a:lnTo>
                  <a:pt x="735" y="3"/>
                </a:lnTo>
                <a:lnTo>
                  <a:pt x="736" y="3"/>
                </a:lnTo>
                <a:lnTo>
                  <a:pt x="737" y="3"/>
                </a:lnTo>
                <a:lnTo>
                  <a:pt x="738" y="2"/>
                </a:lnTo>
                <a:lnTo>
                  <a:pt x="739" y="2"/>
                </a:lnTo>
                <a:lnTo>
                  <a:pt x="740" y="3"/>
                </a:lnTo>
                <a:lnTo>
                  <a:pt x="740" y="3"/>
                </a:lnTo>
                <a:lnTo>
                  <a:pt x="741" y="2"/>
                </a:lnTo>
                <a:lnTo>
                  <a:pt x="742" y="3"/>
                </a:lnTo>
                <a:lnTo>
                  <a:pt x="743" y="2"/>
                </a:lnTo>
                <a:lnTo>
                  <a:pt x="744" y="2"/>
                </a:lnTo>
                <a:lnTo>
                  <a:pt x="745" y="2"/>
                </a:lnTo>
                <a:lnTo>
                  <a:pt x="746" y="3"/>
                </a:lnTo>
                <a:lnTo>
                  <a:pt x="747" y="2"/>
                </a:lnTo>
                <a:lnTo>
                  <a:pt x="748" y="2"/>
                </a:lnTo>
                <a:lnTo>
                  <a:pt x="748" y="2"/>
                </a:lnTo>
                <a:lnTo>
                  <a:pt x="749" y="3"/>
                </a:lnTo>
                <a:lnTo>
                  <a:pt x="750" y="2"/>
                </a:lnTo>
                <a:lnTo>
                  <a:pt x="751" y="3"/>
                </a:lnTo>
                <a:lnTo>
                  <a:pt x="752" y="2"/>
                </a:lnTo>
                <a:lnTo>
                  <a:pt x="753" y="1"/>
                </a:lnTo>
                <a:lnTo>
                  <a:pt x="754" y="2"/>
                </a:lnTo>
                <a:lnTo>
                  <a:pt x="755" y="2"/>
                </a:lnTo>
                <a:lnTo>
                  <a:pt x="755" y="2"/>
                </a:lnTo>
                <a:lnTo>
                  <a:pt x="756" y="2"/>
                </a:lnTo>
                <a:lnTo>
                  <a:pt x="757" y="2"/>
                </a:lnTo>
                <a:lnTo>
                  <a:pt x="758" y="2"/>
                </a:lnTo>
                <a:lnTo>
                  <a:pt x="759" y="2"/>
                </a:lnTo>
                <a:lnTo>
                  <a:pt x="760" y="2"/>
                </a:lnTo>
                <a:lnTo>
                  <a:pt x="761" y="2"/>
                </a:lnTo>
                <a:lnTo>
                  <a:pt x="762" y="2"/>
                </a:lnTo>
                <a:lnTo>
                  <a:pt x="763" y="2"/>
                </a:lnTo>
                <a:lnTo>
                  <a:pt x="763" y="2"/>
                </a:lnTo>
                <a:lnTo>
                  <a:pt x="764" y="2"/>
                </a:lnTo>
                <a:lnTo>
                  <a:pt x="765" y="2"/>
                </a:lnTo>
                <a:lnTo>
                  <a:pt x="766" y="2"/>
                </a:lnTo>
                <a:lnTo>
                  <a:pt x="767" y="1"/>
                </a:lnTo>
                <a:lnTo>
                  <a:pt x="768" y="2"/>
                </a:lnTo>
                <a:lnTo>
                  <a:pt x="769" y="1"/>
                </a:lnTo>
                <a:lnTo>
                  <a:pt x="770" y="1"/>
                </a:lnTo>
                <a:lnTo>
                  <a:pt x="770" y="2"/>
                </a:lnTo>
                <a:lnTo>
                  <a:pt x="771" y="1"/>
                </a:lnTo>
                <a:lnTo>
                  <a:pt x="772" y="2"/>
                </a:lnTo>
                <a:lnTo>
                  <a:pt x="773" y="1"/>
                </a:lnTo>
                <a:lnTo>
                  <a:pt x="774" y="1"/>
                </a:lnTo>
                <a:lnTo>
                  <a:pt x="775" y="2"/>
                </a:lnTo>
                <a:lnTo>
                  <a:pt x="776" y="2"/>
                </a:lnTo>
                <a:lnTo>
                  <a:pt x="777" y="1"/>
                </a:lnTo>
                <a:lnTo>
                  <a:pt x="778" y="1"/>
                </a:lnTo>
                <a:lnTo>
                  <a:pt x="778" y="2"/>
                </a:lnTo>
                <a:lnTo>
                  <a:pt x="779" y="2"/>
                </a:lnTo>
                <a:lnTo>
                  <a:pt x="780" y="2"/>
                </a:lnTo>
                <a:lnTo>
                  <a:pt x="781" y="1"/>
                </a:lnTo>
                <a:lnTo>
                  <a:pt x="782" y="1"/>
                </a:lnTo>
                <a:lnTo>
                  <a:pt x="783" y="1"/>
                </a:lnTo>
                <a:lnTo>
                  <a:pt x="784" y="1"/>
                </a:lnTo>
                <a:lnTo>
                  <a:pt x="785" y="2"/>
                </a:lnTo>
                <a:lnTo>
                  <a:pt x="785" y="1"/>
                </a:lnTo>
                <a:lnTo>
                  <a:pt x="786" y="2"/>
                </a:lnTo>
                <a:lnTo>
                  <a:pt x="787" y="2"/>
                </a:lnTo>
                <a:lnTo>
                  <a:pt x="788" y="2"/>
                </a:lnTo>
                <a:lnTo>
                  <a:pt x="789" y="2"/>
                </a:lnTo>
                <a:lnTo>
                  <a:pt x="790" y="2"/>
                </a:lnTo>
                <a:lnTo>
                  <a:pt x="791" y="2"/>
                </a:lnTo>
                <a:lnTo>
                  <a:pt x="792" y="1"/>
                </a:lnTo>
                <a:lnTo>
                  <a:pt x="793" y="2"/>
                </a:lnTo>
                <a:lnTo>
                  <a:pt x="793" y="2"/>
                </a:lnTo>
                <a:lnTo>
                  <a:pt x="794" y="2"/>
                </a:lnTo>
                <a:lnTo>
                  <a:pt x="795" y="3"/>
                </a:lnTo>
                <a:lnTo>
                  <a:pt x="796" y="4"/>
                </a:lnTo>
                <a:lnTo>
                  <a:pt x="797" y="3"/>
                </a:lnTo>
                <a:lnTo>
                  <a:pt x="798" y="4"/>
                </a:lnTo>
                <a:lnTo>
                  <a:pt x="799" y="5"/>
                </a:lnTo>
                <a:lnTo>
                  <a:pt x="800" y="4"/>
                </a:lnTo>
                <a:lnTo>
                  <a:pt x="800" y="6"/>
                </a:lnTo>
                <a:lnTo>
                  <a:pt x="801" y="10"/>
                </a:lnTo>
                <a:lnTo>
                  <a:pt x="802" y="13"/>
                </a:lnTo>
                <a:lnTo>
                  <a:pt x="803" y="21"/>
                </a:lnTo>
                <a:lnTo>
                  <a:pt x="804" y="31"/>
                </a:lnTo>
                <a:lnTo>
                  <a:pt x="805" y="45"/>
                </a:lnTo>
                <a:lnTo>
                  <a:pt x="806" y="67"/>
                </a:lnTo>
                <a:lnTo>
                  <a:pt x="807" y="85"/>
                </a:lnTo>
                <a:lnTo>
                  <a:pt x="807" y="106"/>
                </a:lnTo>
                <a:lnTo>
                  <a:pt x="808" y="128"/>
                </a:lnTo>
                <a:lnTo>
                  <a:pt x="809" y="143"/>
                </a:lnTo>
                <a:lnTo>
                  <a:pt x="810" y="159"/>
                </a:lnTo>
                <a:lnTo>
                  <a:pt x="811" y="173"/>
                </a:lnTo>
                <a:lnTo>
                  <a:pt x="812" y="172"/>
                </a:lnTo>
                <a:lnTo>
                  <a:pt x="813" y="163"/>
                </a:lnTo>
                <a:lnTo>
                  <a:pt x="814" y="143"/>
                </a:lnTo>
                <a:lnTo>
                  <a:pt x="815" y="129"/>
                </a:lnTo>
                <a:lnTo>
                  <a:pt x="815" y="111"/>
                </a:lnTo>
                <a:lnTo>
                  <a:pt x="816" y="92"/>
                </a:lnTo>
                <a:lnTo>
                  <a:pt x="817" y="72"/>
                </a:lnTo>
                <a:lnTo>
                  <a:pt x="818" y="63"/>
                </a:lnTo>
                <a:lnTo>
                  <a:pt x="819" y="53"/>
                </a:lnTo>
                <a:lnTo>
                  <a:pt x="820" y="45"/>
                </a:lnTo>
                <a:lnTo>
                  <a:pt x="821" y="38"/>
                </a:lnTo>
                <a:lnTo>
                  <a:pt x="822" y="35"/>
                </a:lnTo>
                <a:lnTo>
                  <a:pt x="822" y="30"/>
                </a:lnTo>
                <a:lnTo>
                  <a:pt x="823" y="28"/>
                </a:lnTo>
                <a:lnTo>
                  <a:pt x="824" y="25"/>
                </a:lnTo>
                <a:lnTo>
                  <a:pt x="825" y="22"/>
                </a:lnTo>
                <a:lnTo>
                  <a:pt x="826" y="20"/>
                </a:lnTo>
                <a:lnTo>
                  <a:pt x="827" y="19"/>
                </a:lnTo>
                <a:lnTo>
                  <a:pt x="828" y="16"/>
                </a:lnTo>
                <a:lnTo>
                  <a:pt x="829" y="15"/>
                </a:lnTo>
                <a:lnTo>
                  <a:pt x="830" y="12"/>
                </a:lnTo>
                <a:lnTo>
                  <a:pt x="830" y="12"/>
                </a:lnTo>
                <a:lnTo>
                  <a:pt x="831" y="10"/>
                </a:lnTo>
                <a:lnTo>
                  <a:pt x="832" y="9"/>
                </a:lnTo>
                <a:lnTo>
                  <a:pt x="833" y="9"/>
                </a:lnTo>
                <a:lnTo>
                  <a:pt x="834" y="9"/>
                </a:lnTo>
                <a:lnTo>
                  <a:pt x="835" y="8"/>
                </a:lnTo>
                <a:lnTo>
                  <a:pt x="836" y="7"/>
                </a:lnTo>
                <a:lnTo>
                  <a:pt x="837" y="7"/>
                </a:lnTo>
                <a:lnTo>
                  <a:pt x="837" y="8"/>
                </a:lnTo>
                <a:lnTo>
                  <a:pt x="838" y="6"/>
                </a:lnTo>
                <a:lnTo>
                  <a:pt x="839" y="7"/>
                </a:lnTo>
                <a:lnTo>
                  <a:pt x="840" y="8"/>
                </a:lnTo>
                <a:lnTo>
                  <a:pt x="841" y="8"/>
                </a:lnTo>
                <a:lnTo>
                  <a:pt x="842" y="9"/>
                </a:lnTo>
                <a:lnTo>
                  <a:pt x="843" y="10"/>
                </a:lnTo>
                <a:lnTo>
                  <a:pt x="844" y="12"/>
                </a:lnTo>
                <a:lnTo>
                  <a:pt x="845" y="13"/>
                </a:lnTo>
                <a:lnTo>
                  <a:pt x="845" y="14"/>
                </a:lnTo>
                <a:lnTo>
                  <a:pt x="846" y="17"/>
                </a:lnTo>
                <a:lnTo>
                  <a:pt x="847" y="16"/>
                </a:lnTo>
                <a:lnTo>
                  <a:pt x="848" y="18"/>
                </a:lnTo>
                <a:lnTo>
                  <a:pt x="849" y="17"/>
                </a:lnTo>
                <a:lnTo>
                  <a:pt x="850" y="18"/>
                </a:lnTo>
                <a:lnTo>
                  <a:pt x="851" y="17"/>
                </a:lnTo>
                <a:lnTo>
                  <a:pt x="852" y="17"/>
                </a:lnTo>
                <a:lnTo>
                  <a:pt x="852" y="16"/>
                </a:lnTo>
                <a:lnTo>
                  <a:pt x="853" y="19"/>
                </a:lnTo>
                <a:lnTo>
                  <a:pt x="854" y="15"/>
                </a:lnTo>
                <a:lnTo>
                  <a:pt x="855" y="15"/>
                </a:lnTo>
                <a:lnTo>
                  <a:pt x="856" y="15"/>
                </a:lnTo>
                <a:lnTo>
                  <a:pt x="857" y="14"/>
                </a:lnTo>
                <a:lnTo>
                  <a:pt x="858" y="14"/>
                </a:lnTo>
                <a:lnTo>
                  <a:pt x="859" y="12"/>
                </a:lnTo>
                <a:lnTo>
                  <a:pt x="860" y="11"/>
                </a:lnTo>
                <a:lnTo>
                  <a:pt x="860" y="10"/>
                </a:lnTo>
                <a:lnTo>
                  <a:pt x="861" y="9"/>
                </a:lnTo>
                <a:lnTo>
                  <a:pt x="862" y="10"/>
                </a:lnTo>
                <a:lnTo>
                  <a:pt x="863" y="8"/>
                </a:lnTo>
                <a:lnTo>
                  <a:pt x="864" y="9"/>
                </a:lnTo>
                <a:lnTo>
                  <a:pt x="865" y="8"/>
                </a:lnTo>
                <a:lnTo>
                  <a:pt x="866" y="9"/>
                </a:lnTo>
                <a:lnTo>
                  <a:pt x="867" y="7"/>
                </a:lnTo>
                <a:lnTo>
                  <a:pt x="867" y="7"/>
                </a:lnTo>
                <a:lnTo>
                  <a:pt x="868" y="7"/>
                </a:lnTo>
                <a:lnTo>
                  <a:pt x="869" y="7"/>
                </a:lnTo>
                <a:lnTo>
                  <a:pt x="870" y="7"/>
                </a:lnTo>
                <a:lnTo>
                  <a:pt x="871" y="6"/>
                </a:lnTo>
                <a:lnTo>
                  <a:pt x="872" y="7"/>
                </a:lnTo>
                <a:lnTo>
                  <a:pt x="873" y="8"/>
                </a:lnTo>
                <a:lnTo>
                  <a:pt x="874" y="7"/>
                </a:lnTo>
                <a:lnTo>
                  <a:pt x="875" y="9"/>
                </a:lnTo>
                <a:lnTo>
                  <a:pt x="875" y="9"/>
                </a:lnTo>
                <a:lnTo>
                  <a:pt x="876" y="10"/>
                </a:lnTo>
                <a:lnTo>
                  <a:pt x="877" y="9"/>
                </a:lnTo>
                <a:lnTo>
                  <a:pt x="878" y="11"/>
                </a:lnTo>
                <a:lnTo>
                  <a:pt x="879" y="11"/>
                </a:lnTo>
                <a:lnTo>
                  <a:pt x="880" y="12"/>
                </a:lnTo>
                <a:lnTo>
                  <a:pt x="881" y="12"/>
                </a:lnTo>
                <a:lnTo>
                  <a:pt x="882" y="12"/>
                </a:lnTo>
                <a:lnTo>
                  <a:pt x="882" y="11"/>
                </a:lnTo>
                <a:lnTo>
                  <a:pt x="883" y="11"/>
                </a:lnTo>
                <a:lnTo>
                  <a:pt x="884" y="12"/>
                </a:lnTo>
                <a:lnTo>
                  <a:pt x="885" y="10"/>
                </a:lnTo>
                <a:lnTo>
                  <a:pt x="886" y="10"/>
                </a:lnTo>
                <a:lnTo>
                  <a:pt x="887" y="11"/>
                </a:lnTo>
                <a:lnTo>
                  <a:pt x="888" y="9"/>
                </a:lnTo>
                <a:lnTo>
                  <a:pt x="889" y="9"/>
                </a:lnTo>
                <a:lnTo>
                  <a:pt x="890" y="9"/>
                </a:lnTo>
                <a:lnTo>
                  <a:pt x="890" y="8"/>
                </a:lnTo>
                <a:lnTo>
                  <a:pt x="891" y="7"/>
                </a:lnTo>
                <a:lnTo>
                  <a:pt x="892" y="8"/>
                </a:lnTo>
                <a:lnTo>
                  <a:pt x="893" y="7"/>
                </a:lnTo>
                <a:lnTo>
                  <a:pt x="894" y="7"/>
                </a:lnTo>
                <a:lnTo>
                  <a:pt x="895" y="5"/>
                </a:lnTo>
                <a:lnTo>
                  <a:pt x="896" y="6"/>
                </a:lnTo>
                <a:lnTo>
                  <a:pt x="897" y="5"/>
                </a:lnTo>
                <a:lnTo>
                  <a:pt x="897" y="5"/>
                </a:lnTo>
                <a:lnTo>
                  <a:pt x="898" y="5"/>
                </a:lnTo>
                <a:lnTo>
                  <a:pt x="899" y="5"/>
                </a:lnTo>
                <a:lnTo>
                  <a:pt x="900" y="4"/>
                </a:lnTo>
                <a:lnTo>
                  <a:pt x="901" y="4"/>
                </a:lnTo>
                <a:lnTo>
                  <a:pt x="902" y="4"/>
                </a:lnTo>
                <a:lnTo>
                  <a:pt x="903" y="4"/>
                </a:lnTo>
                <a:lnTo>
                  <a:pt x="904" y="4"/>
                </a:lnTo>
                <a:lnTo>
                  <a:pt x="905" y="4"/>
                </a:lnTo>
                <a:lnTo>
                  <a:pt x="905" y="4"/>
                </a:lnTo>
                <a:lnTo>
                  <a:pt x="906" y="4"/>
                </a:lnTo>
                <a:lnTo>
                  <a:pt x="907" y="4"/>
                </a:lnTo>
                <a:lnTo>
                  <a:pt x="908" y="4"/>
                </a:lnTo>
                <a:lnTo>
                  <a:pt x="909" y="5"/>
                </a:lnTo>
                <a:lnTo>
                  <a:pt x="910" y="4"/>
                </a:lnTo>
                <a:lnTo>
                  <a:pt x="911" y="4"/>
                </a:lnTo>
                <a:lnTo>
                  <a:pt x="912" y="5"/>
                </a:lnTo>
                <a:lnTo>
                  <a:pt x="912" y="4"/>
                </a:lnTo>
                <a:lnTo>
                  <a:pt x="913" y="5"/>
                </a:lnTo>
                <a:lnTo>
                  <a:pt x="914" y="4"/>
                </a:lnTo>
                <a:lnTo>
                  <a:pt x="915" y="4"/>
                </a:lnTo>
                <a:lnTo>
                  <a:pt x="916" y="5"/>
                </a:lnTo>
                <a:lnTo>
                  <a:pt x="917" y="6"/>
                </a:lnTo>
                <a:lnTo>
                  <a:pt x="918" y="5"/>
                </a:lnTo>
                <a:lnTo>
                  <a:pt x="919" y="6"/>
                </a:lnTo>
                <a:lnTo>
                  <a:pt x="920" y="5"/>
                </a:lnTo>
                <a:lnTo>
                  <a:pt x="920" y="5"/>
                </a:lnTo>
                <a:lnTo>
                  <a:pt x="921" y="7"/>
                </a:lnTo>
                <a:lnTo>
                  <a:pt x="922" y="5"/>
                </a:lnTo>
                <a:lnTo>
                  <a:pt x="923" y="5"/>
                </a:lnTo>
                <a:lnTo>
                  <a:pt x="924" y="5"/>
                </a:lnTo>
                <a:lnTo>
                  <a:pt x="925" y="6"/>
                </a:lnTo>
                <a:lnTo>
                  <a:pt x="926" y="6"/>
                </a:lnTo>
                <a:lnTo>
                  <a:pt x="927" y="5"/>
                </a:lnTo>
                <a:lnTo>
                  <a:pt x="927" y="6"/>
                </a:lnTo>
                <a:lnTo>
                  <a:pt x="928" y="5"/>
                </a:lnTo>
                <a:lnTo>
                  <a:pt x="929" y="5"/>
                </a:lnTo>
                <a:lnTo>
                  <a:pt x="930" y="5"/>
                </a:lnTo>
                <a:lnTo>
                  <a:pt x="931" y="5"/>
                </a:lnTo>
                <a:lnTo>
                  <a:pt x="932" y="4"/>
                </a:lnTo>
                <a:lnTo>
                  <a:pt x="933" y="5"/>
                </a:lnTo>
                <a:lnTo>
                  <a:pt x="934" y="5"/>
                </a:lnTo>
                <a:lnTo>
                  <a:pt x="935" y="5"/>
                </a:lnTo>
                <a:lnTo>
                  <a:pt x="935" y="4"/>
                </a:lnTo>
                <a:lnTo>
                  <a:pt x="936" y="4"/>
                </a:lnTo>
                <a:lnTo>
                  <a:pt x="937" y="4"/>
                </a:lnTo>
                <a:lnTo>
                  <a:pt x="938" y="4"/>
                </a:lnTo>
                <a:lnTo>
                  <a:pt x="939" y="5"/>
                </a:lnTo>
                <a:lnTo>
                  <a:pt x="940" y="4"/>
                </a:lnTo>
                <a:lnTo>
                  <a:pt x="941" y="4"/>
                </a:lnTo>
                <a:lnTo>
                  <a:pt x="942" y="4"/>
                </a:lnTo>
                <a:lnTo>
                  <a:pt x="942" y="3"/>
                </a:lnTo>
                <a:lnTo>
                  <a:pt x="943" y="3"/>
                </a:lnTo>
                <a:lnTo>
                  <a:pt x="944" y="4"/>
                </a:lnTo>
                <a:lnTo>
                  <a:pt x="945" y="4"/>
                </a:lnTo>
                <a:lnTo>
                  <a:pt x="946" y="3"/>
                </a:lnTo>
                <a:lnTo>
                  <a:pt x="947" y="3"/>
                </a:lnTo>
                <a:lnTo>
                  <a:pt x="948" y="4"/>
                </a:lnTo>
                <a:lnTo>
                  <a:pt x="949" y="5"/>
                </a:lnTo>
                <a:lnTo>
                  <a:pt x="950" y="4"/>
                </a:lnTo>
                <a:lnTo>
                  <a:pt x="950" y="4"/>
                </a:lnTo>
                <a:lnTo>
                  <a:pt x="951" y="3"/>
                </a:lnTo>
                <a:lnTo>
                  <a:pt x="952" y="4"/>
                </a:lnTo>
                <a:lnTo>
                  <a:pt x="953" y="3"/>
                </a:lnTo>
                <a:lnTo>
                  <a:pt x="954" y="4"/>
                </a:lnTo>
                <a:lnTo>
                  <a:pt x="955" y="4"/>
                </a:lnTo>
                <a:lnTo>
                  <a:pt x="956" y="3"/>
                </a:lnTo>
                <a:lnTo>
                  <a:pt x="957" y="3"/>
                </a:lnTo>
                <a:lnTo>
                  <a:pt x="957" y="4"/>
                </a:lnTo>
                <a:lnTo>
                  <a:pt x="958" y="4"/>
                </a:lnTo>
                <a:lnTo>
                  <a:pt x="959" y="3"/>
                </a:lnTo>
                <a:lnTo>
                  <a:pt x="960" y="3"/>
                </a:lnTo>
                <a:lnTo>
                  <a:pt x="961" y="4"/>
                </a:lnTo>
                <a:lnTo>
                  <a:pt x="962" y="3"/>
                </a:lnTo>
                <a:lnTo>
                  <a:pt x="963" y="4"/>
                </a:lnTo>
                <a:lnTo>
                  <a:pt x="964" y="4"/>
                </a:lnTo>
                <a:lnTo>
                  <a:pt x="965" y="3"/>
                </a:lnTo>
                <a:lnTo>
                  <a:pt x="965" y="5"/>
                </a:lnTo>
                <a:lnTo>
                  <a:pt x="966" y="4"/>
                </a:lnTo>
                <a:lnTo>
                  <a:pt x="967" y="3"/>
                </a:lnTo>
                <a:lnTo>
                  <a:pt x="968" y="4"/>
                </a:lnTo>
                <a:lnTo>
                  <a:pt x="969" y="4"/>
                </a:lnTo>
                <a:lnTo>
                  <a:pt x="970" y="5"/>
                </a:lnTo>
                <a:lnTo>
                  <a:pt x="971" y="5"/>
                </a:lnTo>
                <a:lnTo>
                  <a:pt x="972" y="5"/>
                </a:lnTo>
                <a:lnTo>
                  <a:pt x="972" y="5"/>
                </a:lnTo>
                <a:lnTo>
                  <a:pt x="973" y="5"/>
                </a:lnTo>
                <a:lnTo>
                  <a:pt x="974" y="6"/>
                </a:lnTo>
                <a:lnTo>
                  <a:pt x="975" y="7"/>
                </a:lnTo>
                <a:lnTo>
                  <a:pt x="976" y="7"/>
                </a:lnTo>
                <a:lnTo>
                  <a:pt x="977" y="7"/>
                </a:lnTo>
                <a:lnTo>
                  <a:pt x="978" y="8"/>
                </a:lnTo>
                <a:lnTo>
                  <a:pt x="979" y="9"/>
                </a:lnTo>
                <a:lnTo>
                  <a:pt x="980" y="9"/>
                </a:lnTo>
                <a:lnTo>
                  <a:pt x="980" y="8"/>
                </a:lnTo>
                <a:lnTo>
                  <a:pt x="981" y="10"/>
                </a:lnTo>
                <a:lnTo>
                  <a:pt x="982" y="9"/>
                </a:lnTo>
                <a:lnTo>
                  <a:pt x="983" y="7"/>
                </a:lnTo>
                <a:lnTo>
                  <a:pt x="984" y="7"/>
                </a:lnTo>
                <a:lnTo>
                  <a:pt x="985" y="8"/>
                </a:lnTo>
                <a:lnTo>
                  <a:pt x="986" y="5"/>
                </a:lnTo>
                <a:lnTo>
                  <a:pt x="987" y="6"/>
                </a:lnTo>
                <a:lnTo>
                  <a:pt x="987" y="6"/>
                </a:lnTo>
                <a:lnTo>
                  <a:pt x="988" y="7"/>
                </a:lnTo>
                <a:lnTo>
                  <a:pt x="989" y="9"/>
                </a:lnTo>
                <a:lnTo>
                  <a:pt x="990" y="9"/>
                </a:lnTo>
                <a:lnTo>
                  <a:pt x="991" y="13"/>
                </a:lnTo>
                <a:lnTo>
                  <a:pt x="992" y="16"/>
                </a:lnTo>
                <a:lnTo>
                  <a:pt x="993" y="19"/>
                </a:lnTo>
                <a:lnTo>
                  <a:pt x="994" y="26"/>
                </a:lnTo>
                <a:lnTo>
                  <a:pt x="994" y="36"/>
                </a:lnTo>
                <a:lnTo>
                  <a:pt x="995" y="46"/>
                </a:lnTo>
                <a:lnTo>
                  <a:pt x="996" y="57"/>
                </a:lnTo>
                <a:lnTo>
                  <a:pt x="997" y="70"/>
                </a:lnTo>
                <a:lnTo>
                  <a:pt x="998" y="87"/>
                </a:lnTo>
                <a:lnTo>
                  <a:pt x="999" y="107"/>
                </a:lnTo>
                <a:lnTo>
                  <a:pt x="1000" y="129"/>
                </a:lnTo>
                <a:lnTo>
                  <a:pt x="1001" y="153"/>
                </a:lnTo>
                <a:lnTo>
                  <a:pt x="1002" y="178"/>
                </a:lnTo>
                <a:lnTo>
                  <a:pt x="1002" y="202"/>
                </a:lnTo>
                <a:lnTo>
                  <a:pt x="1003" y="235"/>
                </a:lnTo>
                <a:lnTo>
                  <a:pt x="1004" y="261"/>
                </a:lnTo>
                <a:lnTo>
                  <a:pt x="1005" y="284"/>
                </a:lnTo>
                <a:lnTo>
                  <a:pt x="1006" y="306"/>
                </a:lnTo>
                <a:lnTo>
                  <a:pt x="1007" y="336"/>
                </a:lnTo>
                <a:lnTo>
                  <a:pt x="1008" y="372"/>
                </a:lnTo>
                <a:lnTo>
                  <a:pt x="1009" y="406"/>
                </a:lnTo>
                <a:lnTo>
                  <a:pt x="1009" y="434"/>
                </a:lnTo>
                <a:lnTo>
                  <a:pt x="1010" y="471"/>
                </a:lnTo>
                <a:lnTo>
                  <a:pt x="1011" y="471"/>
                </a:lnTo>
                <a:lnTo>
                  <a:pt x="1012" y="474"/>
                </a:lnTo>
                <a:lnTo>
                  <a:pt x="1013" y="462"/>
                </a:lnTo>
                <a:lnTo>
                  <a:pt x="1014" y="411"/>
                </a:lnTo>
                <a:lnTo>
                  <a:pt x="1015" y="328"/>
                </a:lnTo>
                <a:lnTo>
                  <a:pt x="1016" y="253"/>
                </a:lnTo>
                <a:lnTo>
                  <a:pt x="1017" y="188"/>
                </a:lnTo>
                <a:lnTo>
                  <a:pt x="1017" y="143"/>
                </a:lnTo>
                <a:lnTo>
                  <a:pt x="1018" y="121"/>
                </a:lnTo>
                <a:lnTo>
                  <a:pt x="1019" y="100"/>
                </a:lnTo>
                <a:lnTo>
                  <a:pt x="1020" y="87"/>
                </a:lnTo>
                <a:lnTo>
                  <a:pt x="1021" y="82"/>
                </a:lnTo>
                <a:lnTo>
                  <a:pt x="1022" y="75"/>
                </a:lnTo>
                <a:lnTo>
                  <a:pt x="1023" y="74"/>
                </a:lnTo>
                <a:lnTo>
                  <a:pt x="1024" y="71"/>
                </a:lnTo>
                <a:lnTo>
                  <a:pt x="1024" y="65"/>
                </a:lnTo>
                <a:lnTo>
                  <a:pt x="1025" y="62"/>
                </a:lnTo>
                <a:lnTo>
                  <a:pt x="1026" y="64"/>
                </a:lnTo>
                <a:lnTo>
                  <a:pt x="1027" y="58"/>
                </a:lnTo>
                <a:lnTo>
                  <a:pt x="1028" y="61"/>
                </a:lnTo>
                <a:lnTo>
                  <a:pt x="1029" y="58"/>
                </a:lnTo>
                <a:lnTo>
                  <a:pt x="1030" y="54"/>
                </a:lnTo>
                <a:lnTo>
                  <a:pt x="1031" y="53"/>
                </a:lnTo>
                <a:lnTo>
                  <a:pt x="1032" y="47"/>
                </a:lnTo>
                <a:lnTo>
                  <a:pt x="1032" y="44"/>
                </a:lnTo>
                <a:lnTo>
                  <a:pt x="1033" y="46"/>
                </a:lnTo>
                <a:lnTo>
                  <a:pt x="1034" y="40"/>
                </a:lnTo>
                <a:lnTo>
                  <a:pt x="1035" y="38"/>
                </a:lnTo>
                <a:lnTo>
                  <a:pt x="1036" y="38"/>
                </a:lnTo>
                <a:lnTo>
                  <a:pt x="1037" y="35"/>
                </a:lnTo>
                <a:lnTo>
                  <a:pt x="1038" y="32"/>
                </a:lnTo>
                <a:lnTo>
                  <a:pt x="1039" y="33"/>
                </a:lnTo>
                <a:lnTo>
                  <a:pt x="1039" y="30"/>
                </a:lnTo>
                <a:lnTo>
                  <a:pt x="1040" y="27"/>
                </a:lnTo>
                <a:lnTo>
                  <a:pt x="1041" y="26"/>
                </a:lnTo>
                <a:lnTo>
                  <a:pt x="1042" y="25"/>
                </a:lnTo>
                <a:lnTo>
                  <a:pt x="1043" y="24"/>
                </a:lnTo>
                <a:lnTo>
                  <a:pt x="1044" y="22"/>
                </a:lnTo>
                <a:lnTo>
                  <a:pt x="1045" y="22"/>
                </a:lnTo>
                <a:lnTo>
                  <a:pt x="1046" y="21"/>
                </a:lnTo>
                <a:lnTo>
                  <a:pt x="1047" y="21"/>
                </a:lnTo>
                <a:lnTo>
                  <a:pt x="1047" y="20"/>
                </a:lnTo>
                <a:lnTo>
                  <a:pt x="1048" y="18"/>
                </a:lnTo>
                <a:lnTo>
                  <a:pt x="1049" y="17"/>
                </a:lnTo>
                <a:lnTo>
                  <a:pt x="1050" y="18"/>
                </a:lnTo>
                <a:lnTo>
                  <a:pt x="1051" y="20"/>
                </a:lnTo>
                <a:lnTo>
                  <a:pt x="1052" y="17"/>
                </a:lnTo>
                <a:lnTo>
                  <a:pt x="1053" y="17"/>
                </a:lnTo>
                <a:lnTo>
                  <a:pt x="1054" y="16"/>
                </a:lnTo>
                <a:lnTo>
                  <a:pt x="1054" y="16"/>
                </a:lnTo>
                <a:lnTo>
                  <a:pt x="1055" y="15"/>
                </a:lnTo>
                <a:lnTo>
                  <a:pt x="1056" y="14"/>
                </a:lnTo>
                <a:lnTo>
                  <a:pt x="1057" y="15"/>
                </a:lnTo>
                <a:lnTo>
                  <a:pt x="1058" y="12"/>
                </a:lnTo>
                <a:lnTo>
                  <a:pt x="1059" y="14"/>
                </a:lnTo>
                <a:lnTo>
                  <a:pt x="1060" y="13"/>
                </a:lnTo>
                <a:lnTo>
                  <a:pt x="1061" y="13"/>
                </a:lnTo>
                <a:lnTo>
                  <a:pt x="1062" y="13"/>
                </a:lnTo>
                <a:lnTo>
                  <a:pt x="1062" y="14"/>
                </a:lnTo>
                <a:lnTo>
                  <a:pt x="1063" y="12"/>
                </a:lnTo>
                <a:lnTo>
                  <a:pt x="1064" y="11"/>
                </a:lnTo>
                <a:lnTo>
                  <a:pt x="1065" y="12"/>
                </a:lnTo>
                <a:lnTo>
                  <a:pt x="1066" y="12"/>
                </a:lnTo>
                <a:lnTo>
                  <a:pt x="1067" y="12"/>
                </a:lnTo>
                <a:lnTo>
                  <a:pt x="1068" y="12"/>
                </a:lnTo>
                <a:lnTo>
                  <a:pt x="1069" y="11"/>
                </a:lnTo>
                <a:lnTo>
                  <a:pt x="1069" y="12"/>
                </a:lnTo>
                <a:lnTo>
                  <a:pt x="1070" y="13"/>
                </a:lnTo>
                <a:lnTo>
                  <a:pt x="1071" y="12"/>
                </a:lnTo>
                <a:lnTo>
                  <a:pt x="1072" y="14"/>
                </a:lnTo>
                <a:lnTo>
                  <a:pt x="1073" y="12"/>
                </a:lnTo>
                <a:lnTo>
                  <a:pt x="1074" y="12"/>
                </a:lnTo>
                <a:lnTo>
                  <a:pt x="1075" y="13"/>
                </a:lnTo>
                <a:lnTo>
                  <a:pt x="1076" y="12"/>
                </a:lnTo>
                <a:lnTo>
                  <a:pt x="1077" y="12"/>
                </a:lnTo>
                <a:lnTo>
                  <a:pt x="1077" y="12"/>
                </a:lnTo>
                <a:lnTo>
                  <a:pt x="1078" y="11"/>
                </a:lnTo>
                <a:lnTo>
                  <a:pt x="1079" y="10"/>
                </a:lnTo>
                <a:lnTo>
                  <a:pt x="1080" y="10"/>
                </a:lnTo>
                <a:lnTo>
                  <a:pt x="1081" y="11"/>
                </a:lnTo>
                <a:lnTo>
                  <a:pt x="1082" y="10"/>
                </a:lnTo>
                <a:lnTo>
                  <a:pt x="1083" y="10"/>
                </a:lnTo>
                <a:lnTo>
                  <a:pt x="1084" y="9"/>
                </a:lnTo>
                <a:lnTo>
                  <a:pt x="1084" y="9"/>
                </a:lnTo>
                <a:lnTo>
                  <a:pt x="1085" y="8"/>
                </a:lnTo>
                <a:lnTo>
                  <a:pt x="1086" y="9"/>
                </a:lnTo>
                <a:lnTo>
                  <a:pt x="1087" y="9"/>
                </a:lnTo>
                <a:lnTo>
                  <a:pt x="1088" y="8"/>
                </a:lnTo>
                <a:lnTo>
                  <a:pt x="1089" y="8"/>
                </a:lnTo>
                <a:lnTo>
                  <a:pt x="1090" y="8"/>
                </a:lnTo>
                <a:lnTo>
                  <a:pt x="1091" y="8"/>
                </a:lnTo>
                <a:lnTo>
                  <a:pt x="1092" y="8"/>
                </a:lnTo>
                <a:lnTo>
                  <a:pt x="1092" y="8"/>
                </a:lnTo>
                <a:lnTo>
                  <a:pt x="1093" y="8"/>
                </a:lnTo>
                <a:lnTo>
                  <a:pt x="1094" y="8"/>
                </a:lnTo>
                <a:lnTo>
                  <a:pt x="1095" y="7"/>
                </a:lnTo>
                <a:lnTo>
                  <a:pt x="1096" y="7"/>
                </a:lnTo>
                <a:lnTo>
                  <a:pt x="1097" y="7"/>
                </a:lnTo>
                <a:lnTo>
                  <a:pt x="1098" y="7"/>
                </a:lnTo>
                <a:lnTo>
                  <a:pt x="1099" y="7"/>
                </a:lnTo>
                <a:lnTo>
                  <a:pt x="1099" y="8"/>
                </a:lnTo>
                <a:lnTo>
                  <a:pt x="1100" y="7"/>
                </a:lnTo>
                <a:lnTo>
                  <a:pt x="1101" y="7"/>
                </a:lnTo>
                <a:lnTo>
                  <a:pt x="1102" y="8"/>
                </a:lnTo>
                <a:lnTo>
                  <a:pt x="1103" y="7"/>
                </a:lnTo>
                <a:lnTo>
                  <a:pt x="1104" y="7"/>
                </a:lnTo>
                <a:lnTo>
                  <a:pt x="1105" y="7"/>
                </a:lnTo>
                <a:lnTo>
                  <a:pt x="1106" y="8"/>
                </a:lnTo>
                <a:lnTo>
                  <a:pt x="1107" y="7"/>
                </a:lnTo>
                <a:lnTo>
                  <a:pt x="1107" y="7"/>
                </a:lnTo>
                <a:lnTo>
                  <a:pt x="1108" y="7"/>
                </a:lnTo>
                <a:lnTo>
                  <a:pt x="1109" y="6"/>
                </a:lnTo>
                <a:lnTo>
                  <a:pt x="1110" y="6"/>
                </a:lnTo>
                <a:lnTo>
                  <a:pt x="1111" y="7"/>
                </a:lnTo>
                <a:lnTo>
                  <a:pt x="1112" y="7"/>
                </a:lnTo>
                <a:lnTo>
                  <a:pt x="1113" y="7"/>
                </a:lnTo>
                <a:lnTo>
                  <a:pt x="1114" y="6"/>
                </a:lnTo>
                <a:lnTo>
                  <a:pt x="1114" y="7"/>
                </a:lnTo>
                <a:lnTo>
                  <a:pt x="1115" y="6"/>
                </a:lnTo>
                <a:lnTo>
                  <a:pt x="1116" y="7"/>
                </a:lnTo>
                <a:lnTo>
                  <a:pt x="1117" y="7"/>
                </a:lnTo>
                <a:lnTo>
                  <a:pt x="1118" y="7"/>
                </a:lnTo>
                <a:lnTo>
                  <a:pt x="1119" y="7"/>
                </a:lnTo>
                <a:lnTo>
                  <a:pt x="1120" y="6"/>
                </a:lnTo>
                <a:lnTo>
                  <a:pt x="1121" y="6"/>
                </a:lnTo>
                <a:lnTo>
                  <a:pt x="1122" y="5"/>
                </a:lnTo>
                <a:lnTo>
                  <a:pt x="1122" y="6"/>
                </a:lnTo>
                <a:lnTo>
                  <a:pt x="1123" y="6"/>
                </a:lnTo>
                <a:lnTo>
                  <a:pt x="1124" y="6"/>
                </a:lnTo>
                <a:lnTo>
                  <a:pt x="1125" y="6"/>
                </a:lnTo>
                <a:lnTo>
                  <a:pt x="1126" y="7"/>
                </a:lnTo>
                <a:lnTo>
                  <a:pt x="1127" y="6"/>
                </a:lnTo>
                <a:lnTo>
                  <a:pt x="1128" y="6"/>
                </a:lnTo>
                <a:lnTo>
                  <a:pt x="1129" y="4"/>
                </a:lnTo>
                <a:lnTo>
                  <a:pt x="1129" y="5"/>
                </a:lnTo>
                <a:lnTo>
                  <a:pt x="1130" y="5"/>
                </a:lnTo>
                <a:lnTo>
                  <a:pt x="1131" y="5"/>
                </a:lnTo>
                <a:lnTo>
                  <a:pt x="1132" y="6"/>
                </a:lnTo>
                <a:lnTo>
                  <a:pt x="1133" y="5"/>
                </a:lnTo>
                <a:lnTo>
                  <a:pt x="1134" y="6"/>
                </a:lnTo>
                <a:lnTo>
                  <a:pt x="1135" y="5"/>
                </a:lnTo>
                <a:lnTo>
                  <a:pt x="1136" y="7"/>
                </a:lnTo>
                <a:lnTo>
                  <a:pt x="1137" y="7"/>
                </a:lnTo>
                <a:lnTo>
                  <a:pt x="1137" y="6"/>
                </a:lnTo>
                <a:lnTo>
                  <a:pt x="1138" y="7"/>
                </a:lnTo>
                <a:lnTo>
                  <a:pt x="1139" y="8"/>
                </a:lnTo>
                <a:lnTo>
                  <a:pt x="1140" y="8"/>
                </a:lnTo>
                <a:lnTo>
                  <a:pt x="1141" y="9"/>
                </a:lnTo>
                <a:lnTo>
                  <a:pt x="1142" y="9"/>
                </a:lnTo>
                <a:lnTo>
                  <a:pt x="1143" y="9"/>
                </a:lnTo>
                <a:lnTo>
                  <a:pt x="1144" y="9"/>
                </a:lnTo>
                <a:lnTo>
                  <a:pt x="1144" y="9"/>
                </a:lnTo>
                <a:lnTo>
                  <a:pt x="1145" y="8"/>
                </a:lnTo>
                <a:lnTo>
                  <a:pt x="1146" y="9"/>
                </a:lnTo>
                <a:lnTo>
                  <a:pt x="1147" y="8"/>
                </a:lnTo>
                <a:lnTo>
                  <a:pt x="1148" y="8"/>
                </a:lnTo>
                <a:lnTo>
                  <a:pt x="1149" y="8"/>
                </a:lnTo>
                <a:lnTo>
                  <a:pt x="1150" y="7"/>
                </a:lnTo>
                <a:lnTo>
                  <a:pt x="1151" y="7"/>
                </a:lnTo>
                <a:lnTo>
                  <a:pt x="1152" y="7"/>
                </a:lnTo>
                <a:lnTo>
                  <a:pt x="1152" y="7"/>
                </a:lnTo>
                <a:lnTo>
                  <a:pt x="1153" y="7"/>
                </a:lnTo>
                <a:lnTo>
                  <a:pt x="1154" y="6"/>
                </a:lnTo>
                <a:lnTo>
                  <a:pt x="1155" y="5"/>
                </a:lnTo>
                <a:lnTo>
                  <a:pt x="1156" y="6"/>
                </a:lnTo>
                <a:lnTo>
                  <a:pt x="1157" y="6"/>
                </a:lnTo>
                <a:lnTo>
                  <a:pt x="1158" y="5"/>
                </a:lnTo>
                <a:lnTo>
                  <a:pt x="1159" y="5"/>
                </a:lnTo>
                <a:lnTo>
                  <a:pt x="1159" y="6"/>
                </a:lnTo>
                <a:lnTo>
                  <a:pt x="1160" y="6"/>
                </a:lnTo>
                <a:lnTo>
                  <a:pt x="1161" y="6"/>
                </a:lnTo>
                <a:lnTo>
                  <a:pt x="1162" y="6"/>
                </a:lnTo>
                <a:lnTo>
                  <a:pt x="1163" y="6"/>
                </a:lnTo>
                <a:lnTo>
                  <a:pt x="1164" y="6"/>
                </a:lnTo>
                <a:lnTo>
                  <a:pt x="1165" y="7"/>
                </a:lnTo>
                <a:lnTo>
                  <a:pt x="1166" y="6"/>
                </a:lnTo>
                <a:lnTo>
                  <a:pt x="1167" y="7"/>
                </a:lnTo>
                <a:lnTo>
                  <a:pt x="1167" y="7"/>
                </a:lnTo>
                <a:lnTo>
                  <a:pt x="1168" y="7"/>
                </a:lnTo>
                <a:lnTo>
                  <a:pt x="1169" y="7"/>
                </a:lnTo>
                <a:lnTo>
                  <a:pt x="1170" y="7"/>
                </a:lnTo>
                <a:lnTo>
                  <a:pt x="1171" y="7"/>
                </a:lnTo>
                <a:lnTo>
                  <a:pt x="1172" y="7"/>
                </a:lnTo>
                <a:lnTo>
                  <a:pt x="1173" y="7"/>
                </a:lnTo>
                <a:lnTo>
                  <a:pt x="1174" y="6"/>
                </a:lnTo>
                <a:lnTo>
                  <a:pt x="1174" y="7"/>
                </a:lnTo>
                <a:lnTo>
                  <a:pt x="1175" y="5"/>
                </a:lnTo>
                <a:lnTo>
                  <a:pt x="1176" y="7"/>
                </a:lnTo>
                <a:lnTo>
                  <a:pt x="1177" y="5"/>
                </a:lnTo>
                <a:lnTo>
                  <a:pt x="1178" y="6"/>
                </a:lnTo>
                <a:lnTo>
                  <a:pt x="1179" y="6"/>
                </a:lnTo>
                <a:lnTo>
                  <a:pt x="1180" y="5"/>
                </a:lnTo>
                <a:lnTo>
                  <a:pt x="1181" y="6"/>
                </a:lnTo>
                <a:lnTo>
                  <a:pt x="1182" y="5"/>
                </a:lnTo>
                <a:lnTo>
                  <a:pt x="1182" y="6"/>
                </a:lnTo>
                <a:lnTo>
                  <a:pt x="1183" y="5"/>
                </a:lnTo>
                <a:lnTo>
                  <a:pt x="1184" y="5"/>
                </a:lnTo>
                <a:lnTo>
                  <a:pt x="1185" y="4"/>
                </a:lnTo>
                <a:lnTo>
                  <a:pt x="1186" y="5"/>
                </a:lnTo>
                <a:lnTo>
                  <a:pt x="1187" y="5"/>
                </a:lnTo>
                <a:lnTo>
                  <a:pt x="1188" y="5"/>
                </a:lnTo>
                <a:lnTo>
                  <a:pt x="1189" y="4"/>
                </a:lnTo>
                <a:lnTo>
                  <a:pt x="1189" y="4"/>
                </a:lnTo>
                <a:lnTo>
                  <a:pt x="1190" y="6"/>
                </a:lnTo>
                <a:lnTo>
                  <a:pt x="1191" y="5"/>
                </a:lnTo>
                <a:lnTo>
                  <a:pt x="1192" y="4"/>
                </a:lnTo>
                <a:lnTo>
                  <a:pt x="1193" y="5"/>
                </a:lnTo>
                <a:lnTo>
                  <a:pt x="1194" y="5"/>
                </a:lnTo>
                <a:lnTo>
                  <a:pt x="1195" y="4"/>
                </a:lnTo>
                <a:lnTo>
                  <a:pt x="1196" y="4"/>
                </a:lnTo>
                <a:lnTo>
                  <a:pt x="1196" y="6"/>
                </a:lnTo>
                <a:lnTo>
                  <a:pt x="1197" y="5"/>
                </a:lnTo>
                <a:lnTo>
                  <a:pt x="1198" y="5"/>
                </a:lnTo>
                <a:lnTo>
                  <a:pt x="1199" y="4"/>
                </a:lnTo>
                <a:lnTo>
                  <a:pt x="1200" y="5"/>
                </a:lnTo>
                <a:lnTo>
                  <a:pt x="1201" y="4"/>
                </a:lnTo>
                <a:lnTo>
                  <a:pt x="1202" y="4"/>
                </a:lnTo>
                <a:lnTo>
                  <a:pt x="1203" y="4"/>
                </a:lnTo>
                <a:lnTo>
                  <a:pt x="1204" y="5"/>
                </a:lnTo>
                <a:lnTo>
                  <a:pt x="1204" y="4"/>
                </a:lnTo>
                <a:lnTo>
                  <a:pt x="1205" y="5"/>
                </a:lnTo>
                <a:lnTo>
                  <a:pt x="1206" y="4"/>
                </a:lnTo>
                <a:lnTo>
                  <a:pt x="1207" y="3"/>
                </a:lnTo>
                <a:lnTo>
                  <a:pt x="1208" y="5"/>
                </a:lnTo>
                <a:lnTo>
                  <a:pt x="1209" y="5"/>
                </a:lnTo>
                <a:lnTo>
                  <a:pt x="1210" y="5"/>
                </a:lnTo>
                <a:lnTo>
                  <a:pt x="1211" y="5"/>
                </a:lnTo>
                <a:lnTo>
                  <a:pt x="1211" y="5"/>
                </a:lnTo>
                <a:lnTo>
                  <a:pt x="1212" y="5"/>
                </a:lnTo>
                <a:lnTo>
                  <a:pt x="1213" y="6"/>
                </a:lnTo>
                <a:lnTo>
                  <a:pt x="1214" y="6"/>
                </a:lnTo>
                <a:lnTo>
                  <a:pt x="1215" y="5"/>
                </a:lnTo>
                <a:lnTo>
                  <a:pt x="1216" y="4"/>
                </a:lnTo>
                <a:lnTo>
                  <a:pt x="1217" y="5"/>
                </a:lnTo>
                <a:lnTo>
                  <a:pt x="1218" y="5"/>
                </a:lnTo>
                <a:lnTo>
                  <a:pt x="1219" y="5"/>
                </a:lnTo>
                <a:lnTo>
                  <a:pt x="1219" y="4"/>
                </a:lnTo>
                <a:lnTo>
                  <a:pt x="1220" y="5"/>
                </a:lnTo>
                <a:lnTo>
                  <a:pt x="1221" y="4"/>
                </a:lnTo>
                <a:lnTo>
                  <a:pt x="1222" y="4"/>
                </a:lnTo>
                <a:lnTo>
                  <a:pt x="1223" y="4"/>
                </a:lnTo>
                <a:lnTo>
                  <a:pt x="1224" y="4"/>
                </a:lnTo>
                <a:lnTo>
                  <a:pt x="1225" y="4"/>
                </a:lnTo>
                <a:lnTo>
                  <a:pt x="1226" y="5"/>
                </a:lnTo>
                <a:lnTo>
                  <a:pt x="1226" y="6"/>
                </a:lnTo>
                <a:lnTo>
                  <a:pt x="1227" y="5"/>
                </a:lnTo>
                <a:lnTo>
                  <a:pt x="1228" y="6"/>
                </a:lnTo>
                <a:lnTo>
                  <a:pt x="1229" y="7"/>
                </a:lnTo>
                <a:lnTo>
                  <a:pt x="1230" y="7"/>
                </a:lnTo>
                <a:lnTo>
                  <a:pt x="1231" y="8"/>
                </a:lnTo>
                <a:lnTo>
                  <a:pt x="1232" y="8"/>
                </a:lnTo>
                <a:lnTo>
                  <a:pt x="1233" y="8"/>
                </a:lnTo>
                <a:lnTo>
                  <a:pt x="1234" y="10"/>
                </a:lnTo>
                <a:lnTo>
                  <a:pt x="1234" y="9"/>
                </a:lnTo>
                <a:lnTo>
                  <a:pt x="1235" y="9"/>
                </a:lnTo>
                <a:lnTo>
                  <a:pt x="1236" y="9"/>
                </a:lnTo>
                <a:lnTo>
                  <a:pt x="1237" y="7"/>
                </a:lnTo>
                <a:lnTo>
                  <a:pt x="1238" y="9"/>
                </a:lnTo>
                <a:lnTo>
                  <a:pt x="1239" y="8"/>
                </a:lnTo>
                <a:lnTo>
                  <a:pt x="1240" y="7"/>
                </a:lnTo>
                <a:lnTo>
                  <a:pt x="1241" y="7"/>
                </a:lnTo>
                <a:lnTo>
                  <a:pt x="1241" y="5"/>
                </a:lnTo>
                <a:lnTo>
                  <a:pt x="1242" y="6"/>
                </a:lnTo>
                <a:lnTo>
                  <a:pt x="1243" y="5"/>
                </a:lnTo>
                <a:lnTo>
                  <a:pt x="1244" y="6"/>
                </a:lnTo>
                <a:lnTo>
                  <a:pt x="1245" y="6"/>
                </a:lnTo>
                <a:lnTo>
                  <a:pt x="1246" y="5"/>
                </a:lnTo>
                <a:lnTo>
                  <a:pt x="1247" y="4"/>
                </a:lnTo>
                <a:lnTo>
                  <a:pt x="1248" y="5"/>
                </a:lnTo>
                <a:lnTo>
                  <a:pt x="1249" y="5"/>
                </a:lnTo>
                <a:lnTo>
                  <a:pt x="1249" y="6"/>
                </a:lnTo>
                <a:lnTo>
                  <a:pt x="1250" y="7"/>
                </a:lnTo>
                <a:lnTo>
                  <a:pt x="1251" y="9"/>
                </a:lnTo>
                <a:lnTo>
                  <a:pt x="1252" y="9"/>
                </a:lnTo>
                <a:lnTo>
                  <a:pt x="1253" y="11"/>
                </a:lnTo>
                <a:lnTo>
                  <a:pt x="1254" y="11"/>
                </a:lnTo>
                <a:lnTo>
                  <a:pt x="1255" y="14"/>
                </a:lnTo>
                <a:lnTo>
                  <a:pt x="1256" y="17"/>
                </a:lnTo>
                <a:lnTo>
                  <a:pt x="1256" y="18"/>
                </a:lnTo>
                <a:lnTo>
                  <a:pt x="1257" y="21"/>
                </a:lnTo>
                <a:lnTo>
                  <a:pt x="1258" y="23"/>
                </a:lnTo>
                <a:lnTo>
                  <a:pt x="1259" y="23"/>
                </a:lnTo>
                <a:lnTo>
                  <a:pt x="1260" y="24"/>
                </a:lnTo>
                <a:lnTo>
                  <a:pt x="1261" y="25"/>
                </a:lnTo>
                <a:lnTo>
                  <a:pt x="1262" y="24"/>
                </a:lnTo>
                <a:lnTo>
                  <a:pt x="1263" y="23"/>
                </a:lnTo>
                <a:lnTo>
                  <a:pt x="1264" y="21"/>
                </a:lnTo>
                <a:lnTo>
                  <a:pt x="1264" y="21"/>
                </a:lnTo>
                <a:lnTo>
                  <a:pt x="1265" y="19"/>
                </a:lnTo>
                <a:lnTo>
                  <a:pt x="1266" y="19"/>
                </a:lnTo>
                <a:lnTo>
                  <a:pt x="1267" y="18"/>
                </a:lnTo>
                <a:lnTo>
                  <a:pt x="1268" y="17"/>
                </a:lnTo>
                <a:lnTo>
                  <a:pt x="1269" y="16"/>
                </a:lnTo>
                <a:lnTo>
                  <a:pt x="1270" y="16"/>
                </a:lnTo>
                <a:lnTo>
                  <a:pt x="1271" y="15"/>
                </a:lnTo>
                <a:lnTo>
                  <a:pt x="1271" y="15"/>
                </a:lnTo>
                <a:lnTo>
                  <a:pt x="1272" y="13"/>
                </a:lnTo>
                <a:lnTo>
                  <a:pt x="1273" y="12"/>
                </a:lnTo>
                <a:lnTo>
                  <a:pt x="1274" y="13"/>
                </a:lnTo>
                <a:lnTo>
                  <a:pt x="1275" y="13"/>
                </a:lnTo>
                <a:lnTo>
                  <a:pt x="1276" y="13"/>
                </a:lnTo>
                <a:lnTo>
                  <a:pt x="1277" y="13"/>
                </a:lnTo>
                <a:lnTo>
                  <a:pt x="1278" y="11"/>
                </a:lnTo>
                <a:lnTo>
                  <a:pt x="1279" y="11"/>
                </a:lnTo>
                <a:lnTo>
                  <a:pt x="1279" y="12"/>
                </a:lnTo>
                <a:lnTo>
                  <a:pt x="1280" y="14"/>
                </a:lnTo>
                <a:lnTo>
                  <a:pt x="1281" y="16"/>
                </a:lnTo>
                <a:lnTo>
                  <a:pt x="1282" y="19"/>
                </a:lnTo>
                <a:lnTo>
                  <a:pt x="1283" y="24"/>
                </a:lnTo>
                <a:lnTo>
                  <a:pt x="1284" y="29"/>
                </a:lnTo>
                <a:lnTo>
                  <a:pt x="1285" y="38"/>
                </a:lnTo>
                <a:lnTo>
                  <a:pt x="1286" y="48"/>
                </a:lnTo>
                <a:lnTo>
                  <a:pt x="1286" y="60"/>
                </a:lnTo>
                <a:lnTo>
                  <a:pt x="1287" y="78"/>
                </a:lnTo>
                <a:lnTo>
                  <a:pt x="1288" y="95"/>
                </a:lnTo>
                <a:lnTo>
                  <a:pt x="1289" y="120"/>
                </a:lnTo>
                <a:lnTo>
                  <a:pt x="1290" y="144"/>
                </a:lnTo>
                <a:lnTo>
                  <a:pt x="1291" y="173"/>
                </a:lnTo>
                <a:lnTo>
                  <a:pt x="1292" y="196"/>
                </a:lnTo>
                <a:lnTo>
                  <a:pt x="1293" y="214"/>
                </a:lnTo>
                <a:lnTo>
                  <a:pt x="1294" y="237"/>
                </a:lnTo>
                <a:lnTo>
                  <a:pt x="1294" y="253"/>
                </a:lnTo>
                <a:lnTo>
                  <a:pt x="1295" y="272"/>
                </a:lnTo>
                <a:lnTo>
                  <a:pt x="1296" y="267"/>
                </a:lnTo>
                <a:lnTo>
                  <a:pt x="1297" y="248"/>
                </a:lnTo>
                <a:lnTo>
                  <a:pt x="1298" y="225"/>
                </a:lnTo>
                <a:lnTo>
                  <a:pt x="1299" y="204"/>
                </a:lnTo>
                <a:lnTo>
                  <a:pt x="1300" y="172"/>
                </a:lnTo>
                <a:lnTo>
                  <a:pt x="1301" y="147"/>
                </a:lnTo>
                <a:lnTo>
                  <a:pt x="1301" y="121"/>
                </a:lnTo>
                <a:lnTo>
                  <a:pt x="1302" y="105"/>
                </a:lnTo>
                <a:lnTo>
                  <a:pt x="1303" y="91"/>
                </a:lnTo>
                <a:lnTo>
                  <a:pt x="1304" y="80"/>
                </a:lnTo>
                <a:lnTo>
                  <a:pt x="1305" y="72"/>
                </a:lnTo>
                <a:lnTo>
                  <a:pt x="1306" y="63"/>
                </a:lnTo>
                <a:lnTo>
                  <a:pt x="1307" y="59"/>
                </a:lnTo>
                <a:lnTo>
                  <a:pt x="1308" y="57"/>
                </a:lnTo>
                <a:lnTo>
                  <a:pt x="1309" y="52"/>
                </a:lnTo>
                <a:lnTo>
                  <a:pt x="1309" y="48"/>
                </a:lnTo>
                <a:lnTo>
                  <a:pt x="1310" y="44"/>
                </a:lnTo>
                <a:lnTo>
                  <a:pt x="1311" y="42"/>
                </a:lnTo>
                <a:lnTo>
                  <a:pt x="1312" y="39"/>
                </a:lnTo>
                <a:lnTo>
                  <a:pt x="1313" y="36"/>
                </a:lnTo>
                <a:lnTo>
                  <a:pt x="1314" y="37"/>
                </a:lnTo>
                <a:lnTo>
                  <a:pt x="1315" y="35"/>
                </a:lnTo>
                <a:lnTo>
                  <a:pt x="1316" y="35"/>
                </a:lnTo>
                <a:lnTo>
                  <a:pt x="1316" y="35"/>
                </a:lnTo>
                <a:lnTo>
                  <a:pt x="1317" y="35"/>
                </a:lnTo>
                <a:lnTo>
                  <a:pt x="1318" y="36"/>
                </a:lnTo>
                <a:lnTo>
                  <a:pt x="1319" y="38"/>
                </a:lnTo>
                <a:lnTo>
                  <a:pt x="1320" y="35"/>
                </a:lnTo>
                <a:lnTo>
                  <a:pt x="1321" y="35"/>
                </a:lnTo>
                <a:lnTo>
                  <a:pt x="1322" y="35"/>
                </a:lnTo>
                <a:lnTo>
                  <a:pt x="1323" y="33"/>
                </a:lnTo>
                <a:lnTo>
                  <a:pt x="1324" y="33"/>
                </a:lnTo>
                <a:lnTo>
                  <a:pt x="1324" y="31"/>
                </a:lnTo>
                <a:lnTo>
                  <a:pt x="1325" y="32"/>
                </a:lnTo>
                <a:lnTo>
                  <a:pt x="1326" y="31"/>
                </a:lnTo>
                <a:lnTo>
                  <a:pt x="1327" y="29"/>
                </a:lnTo>
                <a:lnTo>
                  <a:pt x="1328" y="27"/>
                </a:lnTo>
                <a:lnTo>
                  <a:pt x="1329" y="26"/>
                </a:lnTo>
                <a:lnTo>
                  <a:pt x="1330" y="25"/>
                </a:lnTo>
                <a:lnTo>
                  <a:pt x="1331" y="25"/>
                </a:lnTo>
                <a:lnTo>
                  <a:pt x="1331" y="24"/>
                </a:lnTo>
                <a:lnTo>
                  <a:pt x="1332" y="22"/>
                </a:lnTo>
                <a:lnTo>
                  <a:pt x="1333" y="22"/>
                </a:lnTo>
                <a:lnTo>
                  <a:pt x="1334" y="21"/>
                </a:lnTo>
                <a:lnTo>
                  <a:pt x="1335" y="24"/>
                </a:lnTo>
                <a:lnTo>
                  <a:pt x="1336" y="24"/>
                </a:lnTo>
                <a:lnTo>
                  <a:pt x="1337" y="27"/>
                </a:lnTo>
                <a:lnTo>
                  <a:pt x="1338" y="27"/>
                </a:lnTo>
                <a:lnTo>
                  <a:pt x="1339" y="28"/>
                </a:lnTo>
                <a:lnTo>
                  <a:pt x="1339" y="30"/>
                </a:lnTo>
                <a:lnTo>
                  <a:pt x="1340" y="30"/>
                </a:lnTo>
                <a:lnTo>
                  <a:pt x="1341" y="31"/>
                </a:lnTo>
                <a:lnTo>
                  <a:pt x="1342" y="30"/>
                </a:lnTo>
                <a:lnTo>
                  <a:pt x="1343" y="28"/>
                </a:lnTo>
                <a:lnTo>
                  <a:pt x="1344" y="28"/>
                </a:lnTo>
                <a:lnTo>
                  <a:pt x="1345" y="27"/>
                </a:lnTo>
                <a:lnTo>
                  <a:pt x="1346" y="25"/>
                </a:lnTo>
                <a:lnTo>
                  <a:pt x="1346" y="26"/>
                </a:lnTo>
                <a:lnTo>
                  <a:pt x="1347" y="24"/>
                </a:lnTo>
                <a:lnTo>
                  <a:pt x="1348" y="24"/>
                </a:lnTo>
                <a:lnTo>
                  <a:pt x="1349" y="22"/>
                </a:lnTo>
                <a:lnTo>
                  <a:pt x="1350" y="21"/>
                </a:lnTo>
                <a:lnTo>
                  <a:pt x="1351" y="20"/>
                </a:lnTo>
                <a:lnTo>
                  <a:pt x="1352" y="18"/>
                </a:lnTo>
                <a:lnTo>
                  <a:pt x="1353" y="18"/>
                </a:lnTo>
                <a:lnTo>
                  <a:pt x="1354" y="15"/>
                </a:lnTo>
                <a:lnTo>
                  <a:pt x="1354" y="16"/>
                </a:lnTo>
                <a:lnTo>
                  <a:pt x="1355" y="16"/>
                </a:lnTo>
                <a:lnTo>
                  <a:pt x="1356" y="14"/>
                </a:lnTo>
                <a:lnTo>
                  <a:pt x="1357" y="13"/>
                </a:lnTo>
                <a:lnTo>
                  <a:pt x="1358" y="13"/>
                </a:lnTo>
                <a:lnTo>
                  <a:pt x="1359" y="13"/>
                </a:lnTo>
                <a:lnTo>
                  <a:pt x="1360" y="12"/>
                </a:lnTo>
                <a:lnTo>
                  <a:pt x="1361" y="12"/>
                </a:lnTo>
                <a:lnTo>
                  <a:pt x="1361" y="14"/>
                </a:lnTo>
                <a:lnTo>
                  <a:pt x="1362" y="11"/>
                </a:lnTo>
                <a:lnTo>
                  <a:pt x="1363" y="12"/>
                </a:lnTo>
                <a:lnTo>
                  <a:pt x="1364" y="13"/>
                </a:lnTo>
                <a:lnTo>
                  <a:pt x="1365" y="11"/>
                </a:lnTo>
                <a:lnTo>
                  <a:pt x="1366" y="11"/>
                </a:lnTo>
                <a:lnTo>
                  <a:pt x="1367" y="13"/>
                </a:lnTo>
                <a:lnTo>
                  <a:pt x="1368" y="13"/>
                </a:lnTo>
                <a:lnTo>
                  <a:pt x="1369" y="13"/>
                </a:lnTo>
                <a:lnTo>
                  <a:pt x="1369" y="15"/>
                </a:lnTo>
                <a:lnTo>
                  <a:pt x="1370" y="16"/>
                </a:lnTo>
                <a:lnTo>
                  <a:pt x="1371" y="16"/>
                </a:lnTo>
                <a:lnTo>
                  <a:pt x="1372" y="17"/>
                </a:lnTo>
                <a:lnTo>
                  <a:pt x="1373" y="16"/>
                </a:lnTo>
                <a:lnTo>
                  <a:pt x="1374" y="16"/>
                </a:lnTo>
                <a:lnTo>
                  <a:pt x="1375" y="16"/>
                </a:lnTo>
                <a:lnTo>
                  <a:pt x="1376" y="15"/>
                </a:lnTo>
                <a:lnTo>
                  <a:pt x="1376" y="17"/>
                </a:lnTo>
                <a:lnTo>
                  <a:pt x="1377" y="17"/>
                </a:lnTo>
                <a:lnTo>
                  <a:pt x="1378" y="15"/>
                </a:lnTo>
                <a:lnTo>
                  <a:pt x="1379" y="15"/>
                </a:lnTo>
                <a:lnTo>
                  <a:pt x="1380" y="15"/>
                </a:lnTo>
                <a:lnTo>
                  <a:pt x="1381" y="15"/>
                </a:lnTo>
                <a:lnTo>
                  <a:pt x="1382" y="13"/>
                </a:lnTo>
                <a:lnTo>
                  <a:pt x="1383" y="13"/>
                </a:lnTo>
                <a:lnTo>
                  <a:pt x="1384" y="12"/>
                </a:lnTo>
                <a:lnTo>
                  <a:pt x="1384" y="11"/>
                </a:lnTo>
                <a:lnTo>
                  <a:pt x="1385" y="12"/>
                </a:lnTo>
                <a:lnTo>
                  <a:pt x="1386" y="10"/>
                </a:lnTo>
                <a:lnTo>
                  <a:pt x="1387" y="10"/>
                </a:lnTo>
                <a:lnTo>
                  <a:pt x="1388" y="10"/>
                </a:lnTo>
                <a:lnTo>
                  <a:pt x="1389" y="9"/>
                </a:lnTo>
                <a:lnTo>
                  <a:pt x="1390" y="9"/>
                </a:lnTo>
                <a:lnTo>
                  <a:pt x="1391" y="9"/>
                </a:lnTo>
                <a:lnTo>
                  <a:pt x="1391" y="9"/>
                </a:lnTo>
                <a:lnTo>
                  <a:pt x="1392" y="8"/>
                </a:lnTo>
                <a:lnTo>
                  <a:pt x="1393" y="9"/>
                </a:lnTo>
                <a:lnTo>
                  <a:pt x="1394" y="12"/>
                </a:lnTo>
                <a:lnTo>
                  <a:pt x="1395" y="13"/>
                </a:lnTo>
                <a:lnTo>
                  <a:pt x="1396" y="18"/>
                </a:lnTo>
                <a:lnTo>
                  <a:pt x="1397" y="21"/>
                </a:lnTo>
                <a:lnTo>
                  <a:pt x="1398" y="27"/>
                </a:lnTo>
                <a:lnTo>
                  <a:pt x="1398" y="33"/>
                </a:lnTo>
                <a:lnTo>
                  <a:pt x="1399" y="47"/>
                </a:lnTo>
                <a:lnTo>
                  <a:pt x="1400" y="58"/>
                </a:lnTo>
                <a:lnTo>
                  <a:pt x="1401" y="72"/>
                </a:lnTo>
                <a:lnTo>
                  <a:pt x="1402" y="96"/>
                </a:lnTo>
                <a:lnTo>
                  <a:pt x="1403" y="111"/>
                </a:lnTo>
                <a:lnTo>
                  <a:pt x="1404" y="131"/>
                </a:lnTo>
                <a:lnTo>
                  <a:pt x="1405" y="151"/>
                </a:lnTo>
                <a:lnTo>
                  <a:pt x="1406" y="164"/>
                </a:lnTo>
                <a:lnTo>
                  <a:pt x="1406" y="171"/>
                </a:lnTo>
                <a:lnTo>
                  <a:pt x="1407" y="169"/>
                </a:lnTo>
                <a:lnTo>
                  <a:pt x="1408" y="155"/>
                </a:lnTo>
                <a:lnTo>
                  <a:pt x="1409" y="146"/>
                </a:lnTo>
                <a:lnTo>
                  <a:pt x="1410" y="127"/>
                </a:lnTo>
                <a:lnTo>
                  <a:pt x="1411" y="114"/>
                </a:lnTo>
                <a:lnTo>
                  <a:pt x="1412" y="95"/>
                </a:lnTo>
                <a:lnTo>
                  <a:pt x="1413" y="83"/>
                </a:lnTo>
                <a:lnTo>
                  <a:pt x="1413" y="74"/>
                </a:lnTo>
                <a:lnTo>
                  <a:pt x="1414" y="63"/>
                </a:lnTo>
                <a:lnTo>
                  <a:pt x="1415" y="59"/>
                </a:lnTo>
                <a:lnTo>
                  <a:pt x="1416" y="52"/>
                </a:lnTo>
                <a:lnTo>
                  <a:pt x="1417" y="50"/>
                </a:lnTo>
                <a:lnTo>
                  <a:pt x="1418" y="47"/>
                </a:lnTo>
                <a:lnTo>
                  <a:pt x="1419" y="40"/>
                </a:lnTo>
                <a:lnTo>
                  <a:pt x="1420" y="40"/>
                </a:lnTo>
                <a:lnTo>
                  <a:pt x="1421" y="36"/>
                </a:lnTo>
                <a:lnTo>
                  <a:pt x="1421" y="34"/>
                </a:lnTo>
                <a:lnTo>
                  <a:pt x="1422" y="31"/>
                </a:lnTo>
                <a:lnTo>
                  <a:pt x="1423" y="31"/>
                </a:lnTo>
                <a:lnTo>
                  <a:pt x="1424" y="27"/>
                </a:lnTo>
                <a:lnTo>
                  <a:pt x="1425" y="26"/>
                </a:lnTo>
                <a:lnTo>
                  <a:pt x="1426" y="25"/>
                </a:lnTo>
                <a:lnTo>
                  <a:pt x="1427" y="25"/>
                </a:lnTo>
                <a:lnTo>
                  <a:pt x="1428" y="24"/>
                </a:lnTo>
                <a:lnTo>
                  <a:pt x="1428" y="20"/>
                </a:lnTo>
                <a:lnTo>
                  <a:pt x="1429" y="22"/>
                </a:lnTo>
                <a:lnTo>
                  <a:pt x="1430" y="20"/>
                </a:lnTo>
                <a:lnTo>
                  <a:pt x="1431" y="20"/>
                </a:lnTo>
                <a:lnTo>
                  <a:pt x="1432" y="18"/>
                </a:lnTo>
                <a:lnTo>
                  <a:pt x="1433" y="18"/>
                </a:lnTo>
                <a:lnTo>
                  <a:pt x="1434" y="17"/>
                </a:lnTo>
                <a:lnTo>
                  <a:pt x="1435" y="17"/>
                </a:lnTo>
                <a:lnTo>
                  <a:pt x="1436" y="17"/>
                </a:lnTo>
                <a:lnTo>
                  <a:pt x="1436" y="17"/>
                </a:lnTo>
                <a:lnTo>
                  <a:pt x="1437" y="17"/>
                </a:lnTo>
                <a:lnTo>
                  <a:pt x="1438" y="16"/>
                </a:lnTo>
                <a:lnTo>
                  <a:pt x="1439" y="16"/>
                </a:lnTo>
                <a:lnTo>
                  <a:pt x="1440" y="18"/>
                </a:lnTo>
                <a:lnTo>
                  <a:pt x="1441" y="16"/>
                </a:lnTo>
                <a:lnTo>
                  <a:pt x="1442" y="17"/>
                </a:lnTo>
                <a:lnTo>
                  <a:pt x="1443" y="18"/>
                </a:lnTo>
                <a:lnTo>
                  <a:pt x="1443" y="21"/>
                </a:lnTo>
                <a:lnTo>
                  <a:pt x="1444" y="25"/>
                </a:lnTo>
                <a:lnTo>
                  <a:pt x="1445" y="29"/>
                </a:lnTo>
                <a:lnTo>
                  <a:pt x="1446" y="31"/>
                </a:lnTo>
                <a:lnTo>
                  <a:pt x="1447" y="36"/>
                </a:lnTo>
                <a:lnTo>
                  <a:pt x="1448" y="41"/>
                </a:lnTo>
                <a:lnTo>
                  <a:pt x="1449" y="40"/>
                </a:lnTo>
                <a:lnTo>
                  <a:pt x="1450" y="43"/>
                </a:lnTo>
                <a:lnTo>
                  <a:pt x="1451" y="41"/>
                </a:lnTo>
                <a:lnTo>
                  <a:pt x="1451" y="42"/>
                </a:lnTo>
                <a:lnTo>
                  <a:pt x="1452" y="38"/>
                </a:lnTo>
                <a:lnTo>
                  <a:pt x="1453" y="34"/>
                </a:lnTo>
                <a:lnTo>
                  <a:pt x="1454" y="34"/>
                </a:lnTo>
                <a:lnTo>
                  <a:pt x="1455" y="31"/>
                </a:lnTo>
                <a:lnTo>
                  <a:pt x="1456" y="27"/>
                </a:lnTo>
                <a:lnTo>
                  <a:pt x="1457" y="24"/>
                </a:lnTo>
                <a:lnTo>
                  <a:pt x="1458" y="22"/>
                </a:lnTo>
                <a:lnTo>
                  <a:pt x="1458" y="20"/>
                </a:lnTo>
                <a:lnTo>
                  <a:pt x="1459" y="19"/>
                </a:lnTo>
                <a:lnTo>
                  <a:pt x="1460" y="18"/>
                </a:lnTo>
                <a:lnTo>
                  <a:pt x="1461" y="16"/>
                </a:lnTo>
                <a:lnTo>
                  <a:pt x="1462" y="14"/>
                </a:lnTo>
                <a:lnTo>
                  <a:pt x="1463" y="15"/>
                </a:lnTo>
                <a:lnTo>
                  <a:pt x="1464" y="15"/>
                </a:lnTo>
                <a:lnTo>
                  <a:pt x="1465" y="14"/>
                </a:lnTo>
                <a:lnTo>
                  <a:pt x="1466" y="14"/>
                </a:lnTo>
                <a:lnTo>
                  <a:pt x="1466" y="14"/>
                </a:lnTo>
                <a:lnTo>
                  <a:pt x="1467" y="14"/>
                </a:lnTo>
                <a:lnTo>
                  <a:pt x="1468" y="14"/>
                </a:lnTo>
                <a:lnTo>
                  <a:pt x="1469" y="15"/>
                </a:lnTo>
                <a:lnTo>
                  <a:pt x="1470" y="14"/>
                </a:lnTo>
                <a:lnTo>
                  <a:pt x="1471" y="12"/>
                </a:lnTo>
                <a:lnTo>
                  <a:pt x="1472" y="12"/>
                </a:lnTo>
                <a:lnTo>
                  <a:pt x="1473" y="12"/>
                </a:lnTo>
                <a:lnTo>
                  <a:pt x="1473" y="12"/>
                </a:lnTo>
                <a:lnTo>
                  <a:pt x="1474" y="11"/>
                </a:lnTo>
                <a:lnTo>
                  <a:pt x="1475" y="10"/>
                </a:lnTo>
                <a:lnTo>
                  <a:pt x="1476" y="11"/>
                </a:lnTo>
                <a:lnTo>
                  <a:pt x="1477" y="11"/>
                </a:lnTo>
                <a:lnTo>
                  <a:pt x="1478" y="9"/>
                </a:lnTo>
                <a:lnTo>
                  <a:pt x="1479" y="10"/>
                </a:lnTo>
                <a:lnTo>
                  <a:pt x="1480" y="9"/>
                </a:lnTo>
                <a:lnTo>
                  <a:pt x="1481" y="9"/>
                </a:lnTo>
                <a:lnTo>
                  <a:pt x="1481" y="9"/>
                </a:lnTo>
                <a:lnTo>
                  <a:pt x="1482" y="9"/>
                </a:lnTo>
                <a:lnTo>
                  <a:pt x="1483" y="10"/>
                </a:lnTo>
                <a:lnTo>
                  <a:pt x="1484" y="9"/>
                </a:lnTo>
                <a:lnTo>
                  <a:pt x="1485" y="10"/>
                </a:lnTo>
                <a:lnTo>
                  <a:pt x="1486" y="9"/>
                </a:lnTo>
                <a:lnTo>
                  <a:pt x="1487" y="9"/>
                </a:lnTo>
                <a:lnTo>
                  <a:pt x="1488" y="9"/>
                </a:lnTo>
                <a:lnTo>
                  <a:pt x="1488" y="7"/>
                </a:lnTo>
                <a:lnTo>
                  <a:pt x="1489" y="8"/>
                </a:lnTo>
                <a:lnTo>
                  <a:pt x="1490" y="9"/>
                </a:lnTo>
                <a:lnTo>
                  <a:pt x="1491" y="8"/>
                </a:lnTo>
                <a:lnTo>
                  <a:pt x="1492" y="9"/>
                </a:lnTo>
                <a:lnTo>
                  <a:pt x="1493" y="7"/>
                </a:lnTo>
                <a:lnTo>
                  <a:pt x="1494" y="7"/>
                </a:lnTo>
                <a:lnTo>
                  <a:pt x="1495" y="8"/>
                </a:lnTo>
                <a:lnTo>
                  <a:pt x="1496" y="7"/>
                </a:lnTo>
                <a:lnTo>
                  <a:pt x="1496" y="7"/>
                </a:lnTo>
                <a:lnTo>
                  <a:pt x="1497" y="8"/>
                </a:lnTo>
                <a:lnTo>
                  <a:pt x="1498" y="7"/>
                </a:lnTo>
                <a:lnTo>
                  <a:pt x="1499" y="7"/>
                </a:lnTo>
                <a:lnTo>
                  <a:pt x="1500" y="6"/>
                </a:lnTo>
                <a:lnTo>
                  <a:pt x="1501" y="7"/>
                </a:lnTo>
                <a:lnTo>
                  <a:pt x="1502" y="6"/>
                </a:lnTo>
                <a:lnTo>
                  <a:pt x="1503" y="6"/>
                </a:lnTo>
                <a:lnTo>
                  <a:pt x="1503" y="6"/>
                </a:lnTo>
                <a:lnTo>
                  <a:pt x="1504" y="7"/>
                </a:lnTo>
                <a:lnTo>
                  <a:pt x="1505" y="8"/>
                </a:lnTo>
                <a:lnTo>
                  <a:pt x="1506" y="10"/>
                </a:lnTo>
                <a:lnTo>
                  <a:pt x="1507" y="10"/>
                </a:lnTo>
                <a:lnTo>
                  <a:pt x="1508" y="13"/>
                </a:lnTo>
                <a:lnTo>
                  <a:pt x="1509" y="16"/>
                </a:lnTo>
                <a:lnTo>
                  <a:pt x="1510" y="17"/>
                </a:lnTo>
                <a:lnTo>
                  <a:pt x="1511" y="21"/>
                </a:lnTo>
                <a:lnTo>
                  <a:pt x="1511" y="25"/>
                </a:lnTo>
                <a:lnTo>
                  <a:pt x="1512" y="28"/>
                </a:lnTo>
                <a:lnTo>
                  <a:pt x="1513" y="30"/>
                </a:lnTo>
                <a:lnTo>
                  <a:pt x="1514" y="32"/>
                </a:lnTo>
                <a:lnTo>
                  <a:pt x="1515" y="31"/>
                </a:lnTo>
                <a:lnTo>
                  <a:pt x="1516" y="30"/>
                </a:lnTo>
                <a:lnTo>
                  <a:pt x="1517" y="29"/>
                </a:lnTo>
                <a:lnTo>
                  <a:pt x="1518" y="25"/>
                </a:lnTo>
                <a:lnTo>
                  <a:pt x="1518" y="23"/>
                </a:lnTo>
                <a:lnTo>
                  <a:pt x="1519" y="21"/>
                </a:lnTo>
                <a:lnTo>
                  <a:pt x="1520" y="18"/>
                </a:lnTo>
                <a:lnTo>
                  <a:pt x="1521" y="14"/>
                </a:lnTo>
                <a:lnTo>
                  <a:pt x="1522" y="12"/>
                </a:lnTo>
                <a:lnTo>
                  <a:pt x="1523" y="11"/>
                </a:lnTo>
                <a:lnTo>
                  <a:pt x="1524" y="10"/>
                </a:lnTo>
                <a:lnTo>
                  <a:pt x="1525" y="10"/>
                </a:lnTo>
                <a:lnTo>
                  <a:pt x="1526" y="8"/>
                </a:lnTo>
                <a:lnTo>
                  <a:pt x="1526" y="8"/>
                </a:lnTo>
                <a:lnTo>
                  <a:pt x="1527" y="10"/>
                </a:lnTo>
                <a:lnTo>
                  <a:pt x="1528" y="9"/>
                </a:lnTo>
                <a:lnTo>
                  <a:pt x="1529" y="10"/>
                </a:lnTo>
                <a:lnTo>
                  <a:pt x="1530" y="12"/>
                </a:lnTo>
                <a:lnTo>
                  <a:pt x="1531" y="15"/>
                </a:lnTo>
                <a:lnTo>
                  <a:pt x="1532" y="16"/>
                </a:lnTo>
                <a:lnTo>
                  <a:pt x="1533" y="24"/>
                </a:lnTo>
                <a:lnTo>
                  <a:pt x="1533" y="28"/>
                </a:lnTo>
                <a:lnTo>
                  <a:pt x="1534" y="35"/>
                </a:lnTo>
                <a:lnTo>
                  <a:pt x="1535" y="42"/>
                </a:lnTo>
                <a:lnTo>
                  <a:pt x="1536" y="53"/>
                </a:lnTo>
                <a:lnTo>
                  <a:pt x="1537" y="60"/>
                </a:lnTo>
                <a:lnTo>
                  <a:pt x="1538" y="65"/>
                </a:lnTo>
                <a:lnTo>
                  <a:pt x="1539" y="65"/>
                </a:lnTo>
                <a:lnTo>
                  <a:pt x="1540" y="68"/>
                </a:lnTo>
                <a:lnTo>
                  <a:pt x="1541" y="64"/>
                </a:lnTo>
                <a:lnTo>
                  <a:pt x="1541" y="62"/>
                </a:lnTo>
                <a:lnTo>
                  <a:pt x="1542" y="58"/>
                </a:lnTo>
                <a:lnTo>
                  <a:pt x="1543" y="48"/>
                </a:lnTo>
                <a:lnTo>
                  <a:pt x="1544" y="41"/>
                </a:lnTo>
                <a:lnTo>
                  <a:pt x="1545" y="35"/>
                </a:lnTo>
                <a:lnTo>
                  <a:pt x="1546" y="32"/>
                </a:lnTo>
                <a:lnTo>
                  <a:pt x="1547" y="26"/>
                </a:lnTo>
                <a:lnTo>
                  <a:pt x="1548" y="22"/>
                </a:lnTo>
                <a:lnTo>
                  <a:pt x="1548" y="20"/>
                </a:lnTo>
                <a:lnTo>
                  <a:pt x="1549" y="17"/>
                </a:lnTo>
                <a:lnTo>
                  <a:pt x="1550" y="17"/>
                </a:lnTo>
                <a:lnTo>
                  <a:pt x="1551" y="16"/>
                </a:lnTo>
                <a:lnTo>
                  <a:pt x="1552" y="15"/>
                </a:lnTo>
                <a:lnTo>
                  <a:pt x="1553" y="14"/>
                </a:lnTo>
                <a:lnTo>
                  <a:pt x="1554" y="14"/>
                </a:lnTo>
                <a:lnTo>
                  <a:pt x="1555" y="12"/>
                </a:lnTo>
                <a:lnTo>
                  <a:pt x="1556" y="11"/>
                </a:lnTo>
                <a:lnTo>
                  <a:pt x="1556" y="11"/>
                </a:lnTo>
                <a:lnTo>
                  <a:pt x="1557" y="11"/>
                </a:lnTo>
                <a:lnTo>
                  <a:pt x="1558" y="10"/>
                </a:lnTo>
                <a:lnTo>
                  <a:pt x="1559" y="9"/>
                </a:lnTo>
                <a:lnTo>
                  <a:pt x="1560" y="9"/>
                </a:lnTo>
                <a:lnTo>
                  <a:pt x="1561" y="10"/>
                </a:lnTo>
                <a:lnTo>
                  <a:pt x="1562" y="9"/>
                </a:lnTo>
                <a:lnTo>
                  <a:pt x="1563" y="9"/>
                </a:lnTo>
                <a:lnTo>
                  <a:pt x="1563" y="9"/>
                </a:lnTo>
                <a:lnTo>
                  <a:pt x="1564" y="8"/>
                </a:lnTo>
                <a:lnTo>
                  <a:pt x="1565" y="8"/>
                </a:lnTo>
                <a:lnTo>
                  <a:pt x="1566" y="7"/>
                </a:lnTo>
                <a:lnTo>
                  <a:pt x="1567" y="7"/>
                </a:lnTo>
                <a:lnTo>
                  <a:pt x="1568" y="6"/>
                </a:lnTo>
                <a:lnTo>
                  <a:pt x="1569" y="6"/>
                </a:lnTo>
                <a:lnTo>
                  <a:pt x="1570" y="6"/>
                </a:lnTo>
                <a:lnTo>
                  <a:pt x="1571" y="7"/>
                </a:lnTo>
                <a:lnTo>
                  <a:pt x="1571" y="7"/>
                </a:lnTo>
                <a:lnTo>
                  <a:pt x="1572" y="6"/>
                </a:lnTo>
                <a:lnTo>
                  <a:pt x="1573" y="6"/>
                </a:lnTo>
                <a:lnTo>
                  <a:pt x="1574" y="6"/>
                </a:lnTo>
                <a:lnTo>
                  <a:pt x="1575" y="5"/>
                </a:lnTo>
                <a:lnTo>
                  <a:pt x="1576" y="6"/>
                </a:lnTo>
                <a:lnTo>
                  <a:pt x="1577" y="6"/>
                </a:lnTo>
                <a:lnTo>
                  <a:pt x="1578" y="7"/>
                </a:lnTo>
                <a:lnTo>
                  <a:pt x="1578" y="6"/>
                </a:lnTo>
                <a:lnTo>
                  <a:pt x="1579" y="5"/>
                </a:lnTo>
                <a:lnTo>
                  <a:pt x="1580" y="6"/>
                </a:lnTo>
                <a:lnTo>
                  <a:pt x="1581" y="5"/>
                </a:lnTo>
                <a:lnTo>
                  <a:pt x="1582" y="5"/>
                </a:lnTo>
                <a:lnTo>
                  <a:pt x="1583" y="6"/>
                </a:lnTo>
                <a:lnTo>
                  <a:pt x="1584" y="6"/>
                </a:lnTo>
                <a:lnTo>
                  <a:pt x="1585" y="6"/>
                </a:lnTo>
                <a:lnTo>
                  <a:pt x="1585" y="6"/>
                </a:lnTo>
                <a:lnTo>
                  <a:pt x="1586" y="5"/>
                </a:lnTo>
                <a:lnTo>
                  <a:pt x="1587" y="5"/>
                </a:lnTo>
                <a:lnTo>
                  <a:pt x="1588" y="5"/>
                </a:lnTo>
                <a:lnTo>
                  <a:pt x="1589" y="6"/>
                </a:lnTo>
                <a:lnTo>
                  <a:pt x="1590" y="6"/>
                </a:lnTo>
                <a:lnTo>
                  <a:pt x="1591" y="6"/>
                </a:lnTo>
                <a:lnTo>
                  <a:pt x="1592" y="6"/>
                </a:lnTo>
                <a:lnTo>
                  <a:pt x="1593" y="5"/>
                </a:lnTo>
                <a:lnTo>
                  <a:pt x="1593" y="6"/>
                </a:lnTo>
                <a:lnTo>
                  <a:pt x="1594" y="5"/>
                </a:lnTo>
                <a:lnTo>
                  <a:pt x="1595" y="4"/>
                </a:lnTo>
                <a:lnTo>
                  <a:pt x="1596" y="6"/>
                </a:lnTo>
                <a:lnTo>
                  <a:pt x="1597" y="4"/>
                </a:lnTo>
                <a:lnTo>
                  <a:pt x="1598" y="4"/>
                </a:lnTo>
                <a:lnTo>
                  <a:pt x="1599" y="5"/>
                </a:lnTo>
                <a:lnTo>
                  <a:pt x="1600" y="5"/>
                </a:lnTo>
                <a:lnTo>
                  <a:pt x="1600" y="5"/>
                </a:lnTo>
                <a:lnTo>
                  <a:pt x="1601" y="5"/>
                </a:lnTo>
                <a:lnTo>
                  <a:pt x="1602" y="5"/>
                </a:lnTo>
                <a:lnTo>
                  <a:pt x="1603" y="5"/>
                </a:lnTo>
                <a:lnTo>
                  <a:pt x="1604" y="5"/>
                </a:lnTo>
                <a:lnTo>
                  <a:pt x="1605" y="5"/>
                </a:lnTo>
                <a:lnTo>
                  <a:pt x="1606" y="4"/>
                </a:lnTo>
                <a:lnTo>
                  <a:pt x="1607" y="4"/>
                </a:lnTo>
                <a:lnTo>
                  <a:pt x="1608" y="5"/>
                </a:lnTo>
                <a:lnTo>
                  <a:pt x="1608" y="4"/>
                </a:lnTo>
                <a:lnTo>
                  <a:pt x="1609" y="5"/>
                </a:lnTo>
                <a:lnTo>
                  <a:pt x="1610" y="4"/>
                </a:lnTo>
                <a:lnTo>
                  <a:pt x="1611" y="5"/>
                </a:lnTo>
                <a:lnTo>
                  <a:pt x="1612" y="3"/>
                </a:lnTo>
                <a:lnTo>
                  <a:pt x="1613" y="4"/>
                </a:lnTo>
                <a:lnTo>
                  <a:pt x="1614" y="5"/>
                </a:lnTo>
                <a:lnTo>
                  <a:pt x="1615" y="5"/>
                </a:lnTo>
                <a:lnTo>
                  <a:pt x="1615" y="4"/>
                </a:lnTo>
                <a:lnTo>
                  <a:pt x="1616" y="4"/>
                </a:lnTo>
                <a:lnTo>
                  <a:pt x="1617" y="4"/>
                </a:lnTo>
                <a:lnTo>
                  <a:pt x="1618" y="5"/>
                </a:lnTo>
                <a:lnTo>
                  <a:pt x="1619" y="4"/>
                </a:lnTo>
                <a:lnTo>
                  <a:pt x="1620" y="4"/>
                </a:lnTo>
                <a:lnTo>
                  <a:pt x="1621" y="4"/>
                </a:lnTo>
                <a:lnTo>
                  <a:pt x="1622" y="4"/>
                </a:lnTo>
                <a:lnTo>
                  <a:pt x="1623" y="4"/>
                </a:lnTo>
                <a:lnTo>
                  <a:pt x="1623" y="5"/>
                </a:lnTo>
                <a:lnTo>
                  <a:pt x="1624" y="4"/>
                </a:lnTo>
                <a:lnTo>
                  <a:pt x="1625" y="5"/>
                </a:lnTo>
                <a:lnTo>
                  <a:pt x="1626" y="6"/>
                </a:lnTo>
                <a:lnTo>
                  <a:pt x="1627" y="7"/>
                </a:lnTo>
                <a:lnTo>
                  <a:pt x="1628" y="7"/>
                </a:lnTo>
                <a:lnTo>
                  <a:pt x="1629" y="8"/>
                </a:lnTo>
                <a:lnTo>
                  <a:pt x="1630" y="8"/>
                </a:lnTo>
                <a:lnTo>
                  <a:pt x="1630" y="9"/>
                </a:lnTo>
                <a:lnTo>
                  <a:pt x="1631" y="11"/>
                </a:lnTo>
                <a:lnTo>
                  <a:pt x="1632" y="11"/>
                </a:lnTo>
                <a:lnTo>
                  <a:pt x="1633" y="11"/>
                </a:lnTo>
                <a:lnTo>
                  <a:pt x="1634" y="12"/>
                </a:lnTo>
                <a:lnTo>
                  <a:pt x="1635" y="11"/>
                </a:lnTo>
                <a:lnTo>
                  <a:pt x="1636" y="12"/>
                </a:lnTo>
                <a:lnTo>
                  <a:pt x="1637" y="14"/>
                </a:lnTo>
                <a:lnTo>
                  <a:pt x="1638" y="12"/>
                </a:lnTo>
                <a:lnTo>
                  <a:pt x="1638" y="13"/>
                </a:lnTo>
                <a:lnTo>
                  <a:pt x="1639" y="14"/>
                </a:lnTo>
                <a:lnTo>
                  <a:pt x="1640" y="14"/>
                </a:lnTo>
                <a:lnTo>
                  <a:pt x="1641" y="14"/>
                </a:lnTo>
                <a:lnTo>
                  <a:pt x="1642" y="13"/>
                </a:lnTo>
                <a:lnTo>
                  <a:pt x="1643" y="13"/>
                </a:lnTo>
                <a:lnTo>
                  <a:pt x="1644" y="14"/>
                </a:lnTo>
                <a:lnTo>
                  <a:pt x="1645" y="12"/>
                </a:lnTo>
                <a:lnTo>
                  <a:pt x="1645" y="12"/>
                </a:lnTo>
                <a:lnTo>
                  <a:pt x="1646" y="12"/>
                </a:lnTo>
                <a:lnTo>
                  <a:pt x="1647" y="13"/>
                </a:lnTo>
                <a:lnTo>
                  <a:pt x="1648" y="14"/>
                </a:lnTo>
                <a:lnTo>
                  <a:pt x="1649" y="14"/>
                </a:lnTo>
                <a:lnTo>
                  <a:pt x="1650" y="14"/>
                </a:lnTo>
                <a:lnTo>
                  <a:pt x="1651" y="15"/>
                </a:lnTo>
                <a:lnTo>
                  <a:pt x="1652" y="15"/>
                </a:lnTo>
                <a:lnTo>
                  <a:pt x="1653" y="18"/>
                </a:lnTo>
                <a:lnTo>
                  <a:pt x="1653" y="19"/>
                </a:lnTo>
                <a:lnTo>
                  <a:pt x="1654" y="21"/>
                </a:lnTo>
                <a:lnTo>
                  <a:pt x="1655" y="23"/>
                </a:lnTo>
                <a:lnTo>
                  <a:pt x="1656" y="26"/>
                </a:lnTo>
                <a:lnTo>
                  <a:pt x="1657" y="28"/>
                </a:lnTo>
                <a:lnTo>
                  <a:pt x="1658" y="31"/>
                </a:lnTo>
                <a:lnTo>
                  <a:pt x="1659" y="34"/>
                </a:lnTo>
                <a:lnTo>
                  <a:pt x="1660" y="37"/>
                </a:lnTo>
                <a:lnTo>
                  <a:pt x="1660" y="38"/>
                </a:lnTo>
                <a:lnTo>
                  <a:pt x="1661" y="39"/>
                </a:lnTo>
                <a:lnTo>
                  <a:pt x="1662" y="39"/>
                </a:lnTo>
                <a:lnTo>
                  <a:pt x="1663" y="37"/>
                </a:lnTo>
                <a:lnTo>
                  <a:pt x="1664" y="36"/>
                </a:lnTo>
                <a:lnTo>
                  <a:pt x="1665" y="32"/>
                </a:lnTo>
                <a:lnTo>
                  <a:pt x="1666" y="27"/>
                </a:lnTo>
                <a:lnTo>
                  <a:pt x="1667" y="26"/>
                </a:lnTo>
                <a:lnTo>
                  <a:pt x="1668" y="22"/>
                </a:lnTo>
                <a:lnTo>
                  <a:pt x="1668" y="19"/>
                </a:lnTo>
                <a:lnTo>
                  <a:pt x="1669" y="15"/>
                </a:lnTo>
                <a:lnTo>
                  <a:pt x="1670" y="14"/>
                </a:lnTo>
                <a:lnTo>
                  <a:pt x="1671" y="11"/>
                </a:lnTo>
                <a:lnTo>
                  <a:pt x="1672" y="10"/>
                </a:lnTo>
                <a:lnTo>
                  <a:pt x="1673" y="11"/>
                </a:lnTo>
                <a:lnTo>
                  <a:pt x="1674" y="10"/>
                </a:lnTo>
                <a:lnTo>
                  <a:pt x="1675" y="9"/>
                </a:lnTo>
                <a:lnTo>
                  <a:pt x="1675" y="9"/>
                </a:lnTo>
                <a:lnTo>
                  <a:pt x="1676" y="9"/>
                </a:lnTo>
                <a:lnTo>
                  <a:pt x="1677" y="7"/>
                </a:lnTo>
                <a:lnTo>
                  <a:pt x="1678" y="8"/>
                </a:lnTo>
                <a:lnTo>
                  <a:pt x="1679" y="9"/>
                </a:lnTo>
                <a:lnTo>
                  <a:pt x="1680" y="8"/>
                </a:lnTo>
                <a:lnTo>
                  <a:pt x="1681" y="7"/>
                </a:lnTo>
                <a:lnTo>
                  <a:pt x="1682" y="8"/>
                </a:lnTo>
                <a:lnTo>
                  <a:pt x="1683" y="7"/>
                </a:lnTo>
                <a:lnTo>
                  <a:pt x="1683" y="8"/>
                </a:lnTo>
                <a:lnTo>
                  <a:pt x="1684" y="7"/>
                </a:lnTo>
                <a:lnTo>
                  <a:pt x="1685" y="7"/>
                </a:lnTo>
                <a:lnTo>
                  <a:pt x="1686" y="8"/>
                </a:lnTo>
                <a:lnTo>
                  <a:pt x="1687" y="7"/>
                </a:lnTo>
                <a:lnTo>
                  <a:pt x="1688" y="8"/>
                </a:lnTo>
                <a:lnTo>
                  <a:pt x="1689" y="8"/>
                </a:lnTo>
                <a:lnTo>
                  <a:pt x="1690" y="7"/>
                </a:lnTo>
                <a:lnTo>
                  <a:pt x="1690" y="7"/>
                </a:lnTo>
                <a:lnTo>
                  <a:pt x="1691" y="8"/>
                </a:lnTo>
                <a:lnTo>
                  <a:pt x="1692" y="6"/>
                </a:lnTo>
                <a:lnTo>
                  <a:pt x="1693" y="6"/>
                </a:lnTo>
                <a:lnTo>
                  <a:pt x="1694" y="7"/>
                </a:lnTo>
                <a:lnTo>
                  <a:pt x="1695" y="6"/>
                </a:lnTo>
                <a:lnTo>
                  <a:pt x="1696" y="6"/>
                </a:lnTo>
                <a:lnTo>
                  <a:pt x="1697" y="6"/>
                </a:lnTo>
                <a:lnTo>
                  <a:pt x="1698" y="6"/>
                </a:lnTo>
                <a:lnTo>
                  <a:pt x="1698" y="7"/>
                </a:lnTo>
                <a:lnTo>
                  <a:pt x="1699" y="7"/>
                </a:lnTo>
                <a:lnTo>
                  <a:pt x="1700" y="8"/>
                </a:lnTo>
                <a:lnTo>
                  <a:pt x="1701" y="9"/>
                </a:lnTo>
                <a:lnTo>
                  <a:pt x="1702" y="10"/>
                </a:lnTo>
                <a:lnTo>
                  <a:pt x="1703" y="11"/>
                </a:lnTo>
                <a:lnTo>
                  <a:pt x="1704" y="12"/>
                </a:lnTo>
                <a:lnTo>
                  <a:pt x="1705" y="13"/>
                </a:lnTo>
                <a:lnTo>
                  <a:pt x="1705" y="15"/>
                </a:lnTo>
                <a:lnTo>
                  <a:pt x="1706" y="17"/>
                </a:lnTo>
                <a:lnTo>
                  <a:pt x="1707" y="19"/>
                </a:lnTo>
                <a:lnTo>
                  <a:pt x="1708" y="22"/>
                </a:lnTo>
                <a:lnTo>
                  <a:pt x="1709" y="24"/>
                </a:lnTo>
                <a:lnTo>
                  <a:pt x="1710" y="28"/>
                </a:lnTo>
                <a:lnTo>
                  <a:pt x="1711" y="34"/>
                </a:lnTo>
                <a:lnTo>
                  <a:pt x="1712" y="37"/>
                </a:lnTo>
                <a:lnTo>
                  <a:pt x="1713" y="42"/>
                </a:lnTo>
                <a:lnTo>
                  <a:pt x="1713" y="48"/>
                </a:lnTo>
                <a:lnTo>
                  <a:pt x="1714" y="56"/>
                </a:lnTo>
                <a:lnTo>
                  <a:pt x="1715" y="64"/>
                </a:lnTo>
                <a:lnTo>
                  <a:pt x="1716" y="71"/>
                </a:lnTo>
                <a:lnTo>
                  <a:pt x="1717" y="74"/>
                </a:lnTo>
                <a:lnTo>
                  <a:pt x="1718" y="78"/>
                </a:lnTo>
                <a:lnTo>
                  <a:pt x="1719" y="82"/>
                </a:lnTo>
                <a:lnTo>
                  <a:pt x="1720" y="86"/>
                </a:lnTo>
                <a:lnTo>
                  <a:pt x="1720" y="83"/>
                </a:lnTo>
                <a:lnTo>
                  <a:pt x="1721" y="82"/>
                </a:lnTo>
                <a:lnTo>
                  <a:pt x="1722" y="81"/>
                </a:lnTo>
                <a:lnTo>
                  <a:pt x="1723" y="80"/>
                </a:lnTo>
                <a:lnTo>
                  <a:pt x="1724" y="75"/>
                </a:lnTo>
                <a:lnTo>
                  <a:pt x="1725" y="74"/>
                </a:lnTo>
                <a:lnTo>
                  <a:pt x="1726" y="71"/>
                </a:lnTo>
                <a:lnTo>
                  <a:pt x="1727" y="66"/>
                </a:lnTo>
                <a:lnTo>
                  <a:pt x="1728" y="64"/>
                </a:lnTo>
                <a:lnTo>
                  <a:pt x="1728" y="59"/>
                </a:lnTo>
                <a:lnTo>
                  <a:pt x="1729" y="58"/>
                </a:lnTo>
                <a:lnTo>
                  <a:pt x="1730" y="54"/>
                </a:lnTo>
                <a:lnTo>
                  <a:pt x="1731" y="50"/>
                </a:lnTo>
                <a:lnTo>
                  <a:pt x="1732" y="47"/>
                </a:lnTo>
                <a:lnTo>
                  <a:pt x="1733" y="44"/>
                </a:lnTo>
                <a:lnTo>
                  <a:pt x="1734" y="41"/>
                </a:lnTo>
                <a:lnTo>
                  <a:pt x="1735" y="39"/>
                </a:lnTo>
                <a:lnTo>
                  <a:pt x="1735" y="36"/>
                </a:lnTo>
                <a:lnTo>
                  <a:pt x="1736" y="35"/>
                </a:lnTo>
                <a:lnTo>
                  <a:pt x="1737" y="33"/>
                </a:lnTo>
                <a:lnTo>
                  <a:pt x="1738" y="32"/>
                </a:lnTo>
                <a:lnTo>
                  <a:pt x="1739" y="29"/>
                </a:lnTo>
                <a:lnTo>
                  <a:pt x="1740" y="27"/>
                </a:lnTo>
                <a:lnTo>
                  <a:pt x="1741" y="28"/>
                </a:lnTo>
                <a:lnTo>
                  <a:pt x="1742" y="25"/>
                </a:lnTo>
                <a:lnTo>
                  <a:pt x="1743" y="25"/>
                </a:lnTo>
                <a:lnTo>
                  <a:pt x="1743" y="25"/>
                </a:lnTo>
                <a:lnTo>
                  <a:pt x="1744" y="22"/>
                </a:lnTo>
                <a:lnTo>
                  <a:pt x="1745" y="24"/>
                </a:lnTo>
                <a:lnTo>
                  <a:pt x="1746" y="22"/>
                </a:lnTo>
                <a:lnTo>
                  <a:pt x="1747" y="21"/>
                </a:lnTo>
                <a:lnTo>
                  <a:pt x="1748" y="21"/>
                </a:lnTo>
                <a:lnTo>
                  <a:pt x="1749" y="19"/>
                </a:lnTo>
                <a:lnTo>
                  <a:pt x="1750" y="20"/>
                </a:lnTo>
                <a:lnTo>
                  <a:pt x="1750" y="18"/>
                </a:lnTo>
                <a:lnTo>
                  <a:pt x="1751" y="19"/>
                </a:lnTo>
                <a:lnTo>
                  <a:pt x="1752" y="18"/>
                </a:lnTo>
                <a:lnTo>
                  <a:pt x="1753" y="18"/>
                </a:lnTo>
                <a:lnTo>
                  <a:pt x="1754" y="17"/>
                </a:lnTo>
                <a:lnTo>
                  <a:pt x="1755" y="18"/>
                </a:lnTo>
                <a:lnTo>
                  <a:pt x="1756" y="17"/>
                </a:lnTo>
                <a:lnTo>
                  <a:pt x="1757" y="16"/>
                </a:lnTo>
                <a:lnTo>
                  <a:pt x="1758" y="16"/>
                </a:lnTo>
                <a:lnTo>
                  <a:pt x="1758" y="15"/>
                </a:lnTo>
                <a:lnTo>
                  <a:pt x="1759" y="14"/>
                </a:lnTo>
                <a:lnTo>
                  <a:pt x="1760" y="14"/>
                </a:lnTo>
                <a:lnTo>
                  <a:pt x="1761" y="15"/>
                </a:lnTo>
                <a:lnTo>
                  <a:pt x="1762" y="14"/>
                </a:lnTo>
                <a:lnTo>
                  <a:pt x="1763" y="15"/>
                </a:lnTo>
                <a:lnTo>
                  <a:pt x="1764" y="14"/>
                </a:lnTo>
                <a:lnTo>
                  <a:pt x="1765" y="13"/>
                </a:lnTo>
                <a:lnTo>
                  <a:pt x="1765" y="14"/>
                </a:lnTo>
                <a:lnTo>
                  <a:pt x="1766" y="14"/>
                </a:lnTo>
                <a:lnTo>
                  <a:pt x="1767" y="13"/>
                </a:lnTo>
                <a:lnTo>
                  <a:pt x="1768" y="12"/>
                </a:lnTo>
                <a:lnTo>
                  <a:pt x="1769" y="14"/>
                </a:lnTo>
                <a:lnTo>
                  <a:pt x="1770" y="14"/>
                </a:lnTo>
                <a:lnTo>
                  <a:pt x="1771" y="13"/>
                </a:lnTo>
                <a:lnTo>
                  <a:pt x="1772" y="13"/>
                </a:lnTo>
                <a:lnTo>
                  <a:pt x="1773" y="13"/>
                </a:lnTo>
                <a:lnTo>
                  <a:pt x="1773" y="12"/>
                </a:lnTo>
                <a:lnTo>
                  <a:pt x="1774" y="13"/>
                </a:lnTo>
                <a:lnTo>
                  <a:pt x="1775" y="13"/>
                </a:lnTo>
                <a:lnTo>
                  <a:pt x="1776" y="14"/>
                </a:lnTo>
                <a:lnTo>
                  <a:pt x="1777" y="13"/>
                </a:lnTo>
                <a:lnTo>
                  <a:pt x="1778" y="15"/>
                </a:lnTo>
                <a:lnTo>
                  <a:pt x="1779" y="15"/>
                </a:lnTo>
                <a:lnTo>
                  <a:pt x="1780" y="18"/>
                </a:lnTo>
                <a:lnTo>
                  <a:pt x="1780" y="20"/>
                </a:lnTo>
                <a:lnTo>
                  <a:pt x="1781" y="24"/>
                </a:lnTo>
                <a:lnTo>
                  <a:pt x="1782" y="30"/>
                </a:lnTo>
                <a:lnTo>
                  <a:pt x="1783" y="37"/>
                </a:lnTo>
                <a:lnTo>
                  <a:pt x="1784" y="52"/>
                </a:lnTo>
                <a:lnTo>
                  <a:pt x="1785" y="67"/>
                </a:lnTo>
                <a:lnTo>
                  <a:pt x="1786" y="86"/>
                </a:lnTo>
                <a:lnTo>
                  <a:pt x="1787" y="109"/>
                </a:lnTo>
                <a:lnTo>
                  <a:pt x="1787" y="135"/>
                </a:lnTo>
                <a:lnTo>
                  <a:pt x="1788" y="174"/>
                </a:lnTo>
                <a:lnTo>
                  <a:pt x="1789" y="212"/>
                </a:lnTo>
                <a:lnTo>
                  <a:pt x="1790" y="253"/>
                </a:lnTo>
                <a:lnTo>
                  <a:pt x="1791" y="284"/>
                </a:lnTo>
                <a:lnTo>
                  <a:pt x="1792" y="327"/>
                </a:lnTo>
                <a:lnTo>
                  <a:pt x="1793" y="365"/>
                </a:lnTo>
                <a:lnTo>
                  <a:pt x="1794" y="408"/>
                </a:lnTo>
                <a:lnTo>
                  <a:pt x="1795" y="448"/>
                </a:lnTo>
                <a:lnTo>
                  <a:pt x="1795" y="506"/>
                </a:lnTo>
                <a:lnTo>
                  <a:pt x="1796" y="555"/>
                </a:lnTo>
                <a:lnTo>
                  <a:pt x="1797" y="616"/>
                </a:lnTo>
                <a:lnTo>
                  <a:pt x="1798" y="675"/>
                </a:lnTo>
                <a:lnTo>
                  <a:pt x="1799" y="724"/>
                </a:lnTo>
                <a:lnTo>
                  <a:pt x="1800" y="761"/>
                </a:lnTo>
                <a:lnTo>
                  <a:pt x="1801" y="807"/>
                </a:lnTo>
                <a:lnTo>
                  <a:pt x="1802" y="863"/>
                </a:lnTo>
                <a:lnTo>
                  <a:pt x="1802" y="920"/>
                </a:lnTo>
                <a:lnTo>
                  <a:pt x="1803" y="975"/>
                </a:lnTo>
                <a:lnTo>
                  <a:pt x="1804" y="1022"/>
                </a:lnTo>
                <a:lnTo>
                  <a:pt x="1805" y="1079"/>
                </a:lnTo>
                <a:lnTo>
                  <a:pt x="1806" y="1166"/>
                </a:lnTo>
                <a:lnTo>
                  <a:pt x="1807" y="1259"/>
                </a:lnTo>
                <a:lnTo>
                  <a:pt x="1808" y="1298"/>
                </a:lnTo>
                <a:lnTo>
                  <a:pt x="1809" y="1361"/>
                </a:lnTo>
                <a:lnTo>
                  <a:pt x="1810" y="1424"/>
                </a:lnTo>
                <a:lnTo>
                  <a:pt x="1810" y="1505"/>
                </a:lnTo>
                <a:lnTo>
                  <a:pt x="1811" y="1600"/>
                </a:lnTo>
                <a:lnTo>
                  <a:pt x="1812" y="1651"/>
                </a:lnTo>
                <a:lnTo>
                  <a:pt x="1813" y="1701"/>
                </a:lnTo>
                <a:lnTo>
                  <a:pt x="1814" y="1756"/>
                </a:lnTo>
                <a:lnTo>
                  <a:pt x="1815" y="1843"/>
                </a:lnTo>
                <a:lnTo>
                  <a:pt x="1816" y="1929"/>
                </a:lnTo>
                <a:lnTo>
                  <a:pt x="1817" y="1980"/>
                </a:lnTo>
                <a:lnTo>
                  <a:pt x="1817" y="2004"/>
                </a:lnTo>
                <a:lnTo>
                  <a:pt x="1818" y="1984"/>
                </a:lnTo>
                <a:lnTo>
                  <a:pt x="1819" y="1748"/>
                </a:lnTo>
                <a:lnTo>
                  <a:pt x="1820" y="1298"/>
                </a:lnTo>
                <a:lnTo>
                  <a:pt x="1821" y="819"/>
                </a:lnTo>
                <a:lnTo>
                  <a:pt x="1822" y="521"/>
                </a:lnTo>
                <a:lnTo>
                  <a:pt x="1823" y="359"/>
                </a:lnTo>
                <a:lnTo>
                  <a:pt x="1824" y="278"/>
                </a:lnTo>
                <a:lnTo>
                  <a:pt x="1825" y="224"/>
                </a:lnTo>
                <a:lnTo>
                  <a:pt x="1825" y="192"/>
                </a:lnTo>
                <a:lnTo>
                  <a:pt x="1826" y="172"/>
                </a:lnTo>
                <a:lnTo>
                  <a:pt x="1827" y="154"/>
                </a:lnTo>
                <a:lnTo>
                  <a:pt x="1828" y="142"/>
                </a:lnTo>
                <a:lnTo>
                  <a:pt x="1829" y="134"/>
                </a:lnTo>
                <a:lnTo>
                  <a:pt x="1830" y="125"/>
                </a:lnTo>
                <a:lnTo>
                  <a:pt x="1831" y="119"/>
                </a:lnTo>
                <a:lnTo>
                  <a:pt x="1832" y="111"/>
                </a:lnTo>
                <a:lnTo>
                  <a:pt x="1832" y="104"/>
                </a:lnTo>
                <a:lnTo>
                  <a:pt x="1833" y="100"/>
                </a:lnTo>
                <a:lnTo>
                  <a:pt x="1834" y="96"/>
                </a:lnTo>
                <a:lnTo>
                  <a:pt x="1835" y="92"/>
                </a:lnTo>
                <a:lnTo>
                  <a:pt x="1836" y="86"/>
                </a:lnTo>
                <a:lnTo>
                  <a:pt x="1837" y="85"/>
                </a:lnTo>
                <a:lnTo>
                  <a:pt x="1838" y="80"/>
                </a:lnTo>
                <a:lnTo>
                  <a:pt x="1839" y="79"/>
                </a:lnTo>
                <a:lnTo>
                  <a:pt x="1840" y="75"/>
                </a:lnTo>
                <a:lnTo>
                  <a:pt x="1840" y="74"/>
                </a:lnTo>
                <a:lnTo>
                  <a:pt x="1841" y="71"/>
                </a:lnTo>
                <a:lnTo>
                  <a:pt x="1842" y="69"/>
                </a:lnTo>
                <a:lnTo>
                  <a:pt x="1843" y="70"/>
                </a:lnTo>
                <a:lnTo>
                  <a:pt x="1844" y="67"/>
                </a:lnTo>
                <a:lnTo>
                  <a:pt x="1845" y="61"/>
                </a:lnTo>
                <a:lnTo>
                  <a:pt x="1846" y="62"/>
                </a:lnTo>
                <a:lnTo>
                  <a:pt x="1847" y="62"/>
                </a:lnTo>
                <a:lnTo>
                  <a:pt x="1847" y="61"/>
                </a:lnTo>
                <a:lnTo>
                  <a:pt x="1848" y="59"/>
                </a:lnTo>
                <a:lnTo>
                  <a:pt x="1849" y="58"/>
                </a:lnTo>
                <a:lnTo>
                  <a:pt x="1850" y="55"/>
                </a:lnTo>
                <a:lnTo>
                  <a:pt x="1851" y="55"/>
                </a:lnTo>
                <a:lnTo>
                  <a:pt x="1852" y="52"/>
                </a:lnTo>
                <a:lnTo>
                  <a:pt x="1853" y="53"/>
                </a:lnTo>
                <a:lnTo>
                  <a:pt x="1854" y="50"/>
                </a:lnTo>
                <a:lnTo>
                  <a:pt x="1855" y="48"/>
                </a:lnTo>
                <a:lnTo>
                  <a:pt x="1855" y="49"/>
                </a:lnTo>
                <a:lnTo>
                  <a:pt x="1856" y="48"/>
                </a:lnTo>
                <a:lnTo>
                  <a:pt x="1857" y="46"/>
                </a:lnTo>
                <a:lnTo>
                  <a:pt x="1858" y="47"/>
                </a:lnTo>
                <a:lnTo>
                  <a:pt x="1859" y="47"/>
                </a:lnTo>
                <a:lnTo>
                  <a:pt x="1860" y="45"/>
                </a:lnTo>
                <a:lnTo>
                  <a:pt x="1861" y="43"/>
                </a:lnTo>
                <a:lnTo>
                  <a:pt x="1862" y="44"/>
                </a:lnTo>
                <a:lnTo>
                  <a:pt x="1862" y="44"/>
                </a:lnTo>
                <a:lnTo>
                  <a:pt x="1863" y="43"/>
                </a:lnTo>
                <a:lnTo>
                  <a:pt x="1864" y="43"/>
                </a:lnTo>
                <a:lnTo>
                  <a:pt x="1865" y="41"/>
                </a:lnTo>
                <a:lnTo>
                  <a:pt x="1866" y="42"/>
                </a:lnTo>
                <a:lnTo>
                  <a:pt x="1867" y="38"/>
                </a:lnTo>
                <a:lnTo>
                  <a:pt x="1868" y="40"/>
                </a:lnTo>
                <a:lnTo>
                  <a:pt x="1869" y="41"/>
                </a:lnTo>
                <a:lnTo>
                  <a:pt x="1870" y="38"/>
                </a:lnTo>
                <a:lnTo>
                  <a:pt x="1870" y="39"/>
                </a:lnTo>
                <a:lnTo>
                  <a:pt x="1871" y="38"/>
                </a:lnTo>
                <a:lnTo>
                  <a:pt x="1872" y="39"/>
                </a:lnTo>
                <a:lnTo>
                  <a:pt x="1873" y="39"/>
                </a:lnTo>
                <a:lnTo>
                  <a:pt x="1874" y="37"/>
                </a:lnTo>
                <a:lnTo>
                  <a:pt x="1875" y="38"/>
                </a:lnTo>
                <a:lnTo>
                  <a:pt x="1876" y="37"/>
                </a:lnTo>
                <a:lnTo>
                  <a:pt x="1877" y="36"/>
                </a:lnTo>
                <a:lnTo>
                  <a:pt x="1877" y="36"/>
                </a:lnTo>
                <a:lnTo>
                  <a:pt x="1878" y="36"/>
                </a:lnTo>
                <a:lnTo>
                  <a:pt x="1879" y="34"/>
                </a:lnTo>
                <a:lnTo>
                  <a:pt x="1880" y="34"/>
                </a:lnTo>
                <a:lnTo>
                  <a:pt x="1881" y="33"/>
                </a:lnTo>
                <a:lnTo>
                  <a:pt x="1882" y="35"/>
                </a:lnTo>
                <a:lnTo>
                  <a:pt x="1883" y="34"/>
                </a:lnTo>
                <a:lnTo>
                  <a:pt x="1884" y="33"/>
                </a:lnTo>
                <a:lnTo>
                  <a:pt x="1885" y="34"/>
                </a:lnTo>
                <a:lnTo>
                  <a:pt x="1885" y="33"/>
                </a:lnTo>
                <a:lnTo>
                  <a:pt x="1886" y="30"/>
                </a:lnTo>
                <a:lnTo>
                  <a:pt x="1887" y="32"/>
                </a:lnTo>
                <a:lnTo>
                  <a:pt x="1888" y="30"/>
                </a:lnTo>
                <a:lnTo>
                  <a:pt x="1889" y="31"/>
                </a:lnTo>
                <a:lnTo>
                  <a:pt x="1890" y="30"/>
                </a:lnTo>
                <a:lnTo>
                  <a:pt x="1891" y="30"/>
                </a:lnTo>
                <a:lnTo>
                  <a:pt x="1892" y="29"/>
                </a:lnTo>
                <a:lnTo>
                  <a:pt x="1892" y="28"/>
                </a:lnTo>
                <a:lnTo>
                  <a:pt x="1893" y="29"/>
                </a:lnTo>
                <a:lnTo>
                  <a:pt x="1894" y="28"/>
                </a:lnTo>
                <a:lnTo>
                  <a:pt x="1895" y="28"/>
                </a:lnTo>
                <a:lnTo>
                  <a:pt x="1896" y="28"/>
                </a:lnTo>
                <a:lnTo>
                  <a:pt x="1897" y="27"/>
                </a:lnTo>
                <a:lnTo>
                  <a:pt x="1898" y="28"/>
                </a:lnTo>
                <a:lnTo>
                  <a:pt x="1899" y="26"/>
                </a:lnTo>
                <a:lnTo>
                  <a:pt x="1900" y="27"/>
                </a:lnTo>
                <a:lnTo>
                  <a:pt x="1900" y="26"/>
                </a:lnTo>
                <a:lnTo>
                  <a:pt x="1901" y="26"/>
                </a:lnTo>
                <a:lnTo>
                  <a:pt x="1902" y="28"/>
                </a:lnTo>
                <a:lnTo>
                  <a:pt x="1903" y="25"/>
                </a:lnTo>
                <a:lnTo>
                  <a:pt x="1904" y="26"/>
                </a:lnTo>
                <a:lnTo>
                  <a:pt x="1905" y="27"/>
                </a:lnTo>
                <a:lnTo>
                  <a:pt x="1906" y="25"/>
                </a:lnTo>
                <a:lnTo>
                  <a:pt x="1907" y="27"/>
                </a:lnTo>
                <a:lnTo>
                  <a:pt x="1907" y="26"/>
                </a:lnTo>
                <a:lnTo>
                  <a:pt x="1908" y="26"/>
                </a:lnTo>
                <a:lnTo>
                  <a:pt x="1909" y="24"/>
                </a:lnTo>
                <a:lnTo>
                  <a:pt x="1910" y="26"/>
                </a:lnTo>
                <a:lnTo>
                  <a:pt x="1911" y="28"/>
                </a:lnTo>
                <a:lnTo>
                  <a:pt x="1912" y="28"/>
                </a:lnTo>
                <a:lnTo>
                  <a:pt x="1913" y="31"/>
                </a:lnTo>
                <a:lnTo>
                  <a:pt x="1914" y="35"/>
                </a:lnTo>
                <a:lnTo>
                  <a:pt x="1915" y="34"/>
                </a:lnTo>
                <a:lnTo>
                  <a:pt x="1915" y="39"/>
                </a:lnTo>
                <a:lnTo>
                  <a:pt x="1916" y="45"/>
                </a:lnTo>
                <a:lnTo>
                  <a:pt x="1917" y="46"/>
                </a:lnTo>
                <a:lnTo>
                  <a:pt x="1918" y="50"/>
                </a:lnTo>
                <a:lnTo>
                  <a:pt x="1919" y="53"/>
                </a:lnTo>
                <a:lnTo>
                  <a:pt x="1920" y="55"/>
                </a:lnTo>
                <a:lnTo>
                  <a:pt x="1921" y="55"/>
                </a:lnTo>
                <a:lnTo>
                  <a:pt x="1922" y="58"/>
                </a:lnTo>
                <a:lnTo>
                  <a:pt x="1922" y="54"/>
                </a:lnTo>
                <a:lnTo>
                  <a:pt x="1923" y="49"/>
                </a:lnTo>
                <a:lnTo>
                  <a:pt x="1924" y="45"/>
                </a:lnTo>
                <a:lnTo>
                  <a:pt x="1925" y="43"/>
                </a:lnTo>
                <a:lnTo>
                  <a:pt x="1926" y="38"/>
                </a:lnTo>
                <a:lnTo>
                  <a:pt x="1927" y="34"/>
                </a:lnTo>
                <a:lnTo>
                  <a:pt x="1928" y="31"/>
                </a:lnTo>
                <a:lnTo>
                  <a:pt x="1929" y="30"/>
                </a:lnTo>
                <a:lnTo>
                  <a:pt x="1930" y="27"/>
                </a:lnTo>
                <a:lnTo>
                  <a:pt x="1930" y="26"/>
                </a:lnTo>
                <a:lnTo>
                  <a:pt x="1931" y="26"/>
                </a:lnTo>
                <a:lnTo>
                  <a:pt x="1932" y="25"/>
                </a:lnTo>
                <a:lnTo>
                  <a:pt x="1933" y="24"/>
                </a:lnTo>
                <a:lnTo>
                  <a:pt x="1934" y="23"/>
                </a:lnTo>
                <a:lnTo>
                  <a:pt x="1935" y="25"/>
                </a:lnTo>
                <a:lnTo>
                  <a:pt x="1936" y="26"/>
                </a:lnTo>
                <a:lnTo>
                  <a:pt x="1937" y="25"/>
                </a:lnTo>
                <a:lnTo>
                  <a:pt x="1937" y="25"/>
                </a:lnTo>
                <a:lnTo>
                  <a:pt x="1938" y="28"/>
                </a:lnTo>
                <a:lnTo>
                  <a:pt x="1939" y="27"/>
                </a:lnTo>
                <a:lnTo>
                  <a:pt x="1940" y="28"/>
                </a:lnTo>
                <a:lnTo>
                  <a:pt x="1941" y="29"/>
                </a:lnTo>
                <a:lnTo>
                  <a:pt x="1942" y="31"/>
                </a:lnTo>
                <a:lnTo>
                  <a:pt x="1943" y="32"/>
                </a:lnTo>
                <a:lnTo>
                  <a:pt x="1944" y="33"/>
                </a:lnTo>
                <a:lnTo>
                  <a:pt x="1945" y="34"/>
                </a:lnTo>
                <a:lnTo>
                  <a:pt x="1945" y="32"/>
                </a:lnTo>
                <a:lnTo>
                  <a:pt x="1946" y="35"/>
                </a:lnTo>
                <a:lnTo>
                  <a:pt x="1947" y="34"/>
                </a:lnTo>
                <a:lnTo>
                  <a:pt x="1948" y="33"/>
                </a:lnTo>
                <a:lnTo>
                  <a:pt x="1949" y="33"/>
                </a:lnTo>
                <a:lnTo>
                  <a:pt x="1950" y="31"/>
                </a:lnTo>
                <a:lnTo>
                  <a:pt x="1951" y="30"/>
                </a:lnTo>
                <a:lnTo>
                  <a:pt x="1952" y="27"/>
                </a:lnTo>
                <a:lnTo>
                  <a:pt x="1952" y="26"/>
                </a:lnTo>
                <a:lnTo>
                  <a:pt x="1953" y="25"/>
                </a:lnTo>
                <a:lnTo>
                  <a:pt x="1954" y="25"/>
                </a:lnTo>
                <a:lnTo>
                  <a:pt x="1955" y="26"/>
                </a:lnTo>
                <a:lnTo>
                  <a:pt x="1956" y="25"/>
                </a:lnTo>
                <a:lnTo>
                  <a:pt x="1957" y="24"/>
                </a:lnTo>
                <a:lnTo>
                  <a:pt x="1958" y="26"/>
                </a:lnTo>
                <a:lnTo>
                  <a:pt x="1959" y="26"/>
                </a:lnTo>
                <a:lnTo>
                  <a:pt x="1960" y="24"/>
                </a:lnTo>
                <a:lnTo>
                  <a:pt x="1960" y="25"/>
                </a:lnTo>
                <a:lnTo>
                  <a:pt x="1961" y="24"/>
                </a:lnTo>
                <a:lnTo>
                  <a:pt x="1962" y="24"/>
                </a:lnTo>
                <a:lnTo>
                  <a:pt x="1963" y="22"/>
                </a:lnTo>
                <a:lnTo>
                  <a:pt x="1964" y="23"/>
                </a:lnTo>
                <a:lnTo>
                  <a:pt x="1965" y="21"/>
                </a:lnTo>
                <a:lnTo>
                  <a:pt x="1966" y="23"/>
                </a:lnTo>
                <a:lnTo>
                  <a:pt x="1967" y="22"/>
                </a:lnTo>
                <a:lnTo>
                  <a:pt x="1967" y="22"/>
                </a:lnTo>
                <a:lnTo>
                  <a:pt x="1968" y="20"/>
                </a:lnTo>
                <a:lnTo>
                  <a:pt x="1969" y="21"/>
                </a:lnTo>
                <a:lnTo>
                  <a:pt x="1970" y="19"/>
                </a:lnTo>
                <a:lnTo>
                  <a:pt x="1971" y="19"/>
                </a:lnTo>
                <a:lnTo>
                  <a:pt x="1972" y="19"/>
                </a:lnTo>
                <a:lnTo>
                  <a:pt x="1973" y="19"/>
                </a:lnTo>
                <a:lnTo>
                  <a:pt x="1974" y="19"/>
                </a:lnTo>
                <a:lnTo>
                  <a:pt x="1974" y="20"/>
                </a:lnTo>
                <a:lnTo>
                  <a:pt x="1975" y="18"/>
                </a:lnTo>
                <a:lnTo>
                  <a:pt x="1976" y="18"/>
                </a:lnTo>
                <a:lnTo>
                  <a:pt x="1977" y="18"/>
                </a:lnTo>
                <a:lnTo>
                  <a:pt x="1978" y="17"/>
                </a:lnTo>
                <a:lnTo>
                  <a:pt x="1979" y="18"/>
                </a:lnTo>
                <a:lnTo>
                  <a:pt x="1980" y="19"/>
                </a:lnTo>
                <a:lnTo>
                  <a:pt x="1981" y="18"/>
                </a:lnTo>
                <a:lnTo>
                  <a:pt x="1982" y="19"/>
                </a:lnTo>
                <a:lnTo>
                  <a:pt x="1982" y="18"/>
                </a:lnTo>
                <a:lnTo>
                  <a:pt x="1983" y="19"/>
                </a:lnTo>
                <a:lnTo>
                  <a:pt x="1984" y="17"/>
                </a:lnTo>
                <a:lnTo>
                  <a:pt x="1985" y="18"/>
                </a:lnTo>
                <a:lnTo>
                  <a:pt x="1986" y="18"/>
                </a:lnTo>
                <a:lnTo>
                  <a:pt x="1987" y="18"/>
                </a:lnTo>
                <a:lnTo>
                  <a:pt x="1988" y="18"/>
                </a:lnTo>
                <a:lnTo>
                  <a:pt x="1989" y="18"/>
                </a:lnTo>
                <a:lnTo>
                  <a:pt x="1989" y="19"/>
                </a:lnTo>
                <a:lnTo>
                  <a:pt x="1990" y="18"/>
                </a:lnTo>
                <a:lnTo>
                  <a:pt x="1991" y="19"/>
                </a:lnTo>
                <a:lnTo>
                  <a:pt x="1992" y="18"/>
                </a:lnTo>
                <a:lnTo>
                  <a:pt x="1993" y="19"/>
                </a:lnTo>
                <a:lnTo>
                  <a:pt x="1994" y="19"/>
                </a:lnTo>
                <a:lnTo>
                  <a:pt x="1995" y="20"/>
                </a:lnTo>
                <a:lnTo>
                  <a:pt x="1996" y="18"/>
                </a:lnTo>
                <a:lnTo>
                  <a:pt x="1997" y="17"/>
                </a:lnTo>
                <a:lnTo>
                  <a:pt x="1997" y="18"/>
                </a:lnTo>
                <a:lnTo>
                  <a:pt x="1998" y="17"/>
                </a:lnTo>
                <a:lnTo>
                  <a:pt x="1999" y="17"/>
                </a:lnTo>
                <a:lnTo>
                  <a:pt x="2000" y="17"/>
                </a:lnTo>
                <a:lnTo>
                  <a:pt x="2001" y="18"/>
                </a:lnTo>
                <a:lnTo>
                  <a:pt x="2002" y="17"/>
                </a:lnTo>
                <a:lnTo>
                  <a:pt x="2003" y="17"/>
                </a:lnTo>
                <a:lnTo>
                  <a:pt x="2004" y="17"/>
                </a:lnTo>
                <a:lnTo>
                  <a:pt x="2004" y="18"/>
                </a:lnTo>
                <a:lnTo>
                  <a:pt x="2005" y="17"/>
                </a:lnTo>
                <a:lnTo>
                  <a:pt x="2006" y="16"/>
                </a:lnTo>
                <a:lnTo>
                  <a:pt x="2007" y="16"/>
                </a:lnTo>
                <a:lnTo>
                  <a:pt x="2008" y="16"/>
                </a:lnTo>
                <a:lnTo>
                  <a:pt x="2009" y="15"/>
                </a:lnTo>
                <a:lnTo>
                  <a:pt x="2010" y="16"/>
                </a:lnTo>
                <a:lnTo>
                  <a:pt x="2011" y="14"/>
                </a:lnTo>
                <a:lnTo>
                  <a:pt x="2012" y="14"/>
                </a:lnTo>
                <a:lnTo>
                  <a:pt x="2012" y="14"/>
                </a:lnTo>
                <a:lnTo>
                  <a:pt x="2013" y="14"/>
                </a:lnTo>
                <a:lnTo>
                  <a:pt x="2014" y="15"/>
                </a:lnTo>
                <a:lnTo>
                  <a:pt x="2015" y="14"/>
                </a:lnTo>
                <a:lnTo>
                  <a:pt x="2016" y="16"/>
                </a:lnTo>
                <a:lnTo>
                  <a:pt x="2017" y="15"/>
                </a:lnTo>
                <a:lnTo>
                  <a:pt x="2018" y="15"/>
                </a:lnTo>
                <a:lnTo>
                  <a:pt x="2019" y="17"/>
                </a:lnTo>
                <a:lnTo>
                  <a:pt x="2019" y="16"/>
                </a:lnTo>
                <a:lnTo>
                  <a:pt x="2020" y="17"/>
                </a:lnTo>
                <a:lnTo>
                  <a:pt x="2021" y="18"/>
                </a:lnTo>
                <a:lnTo>
                  <a:pt x="2022" y="17"/>
                </a:lnTo>
                <a:lnTo>
                  <a:pt x="2023" y="18"/>
                </a:lnTo>
                <a:lnTo>
                  <a:pt x="2024" y="18"/>
                </a:lnTo>
                <a:lnTo>
                  <a:pt x="2025" y="20"/>
                </a:lnTo>
                <a:lnTo>
                  <a:pt x="2026" y="18"/>
                </a:lnTo>
                <a:lnTo>
                  <a:pt x="2027" y="17"/>
                </a:lnTo>
                <a:lnTo>
                  <a:pt x="2027" y="19"/>
                </a:lnTo>
                <a:lnTo>
                  <a:pt x="2028" y="20"/>
                </a:lnTo>
                <a:lnTo>
                  <a:pt x="2029" y="20"/>
                </a:lnTo>
                <a:lnTo>
                  <a:pt x="2030" y="19"/>
                </a:lnTo>
                <a:lnTo>
                  <a:pt x="2031" y="19"/>
                </a:lnTo>
                <a:lnTo>
                  <a:pt x="2032" y="19"/>
                </a:lnTo>
                <a:lnTo>
                  <a:pt x="2033" y="19"/>
                </a:lnTo>
                <a:lnTo>
                  <a:pt x="2034" y="18"/>
                </a:lnTo>
                <a:lnTo>
                  <a:pt x="2034" y="19"/>
                </a:lnTo>
                <a:lnTo>
                  <a:pt x="2035" y="20"/>
                </a:lnTo>
                <a:lnTo>
                  <a:pt x="2036" y="18"/>
                </a:lnTo>
                <a:lnTo>
                  <a:pt x="2037" y="18"/>
                </a:lnTo>
                <a:lnTo>
                  <a:pt x="2038" y="18"/>
                </a:lnTo>
                <a:lnTo>
                  <a:pt x="2039" y="18"/>
                </a:lnTo>
                <a:lnTo>
                  <a:pt x="2040" y="18"/>
                </a:lnTo>
                <a:lnTo>
                  <a:pt x="2041" y="18"/>
                </a:lnTo>
                <a:lnTo>
                  <a:pt x="2042" y="17"/>
                </a:lnTo>
                <a:lnTo>
                  <a:pt x="2042" y="18"/>
                </a:lnTo>
                <a:lnTo>
                  <a:pt x="2043" y="18"/>
                </a:lnTo>
                <a:lnTo>
                  <a:pt x="2044" y="19"/>
                </a:lnTo>
                <a:lnTo>
                  <a:pt x="2045" y="18"/>
                </a:lnTo>
                <a:lnTo>
                  <a:pt x="2046" y="17"/>
                </a:lnTo>
                <a:lnTo>
                  <a:pt x="2047" y="18"/>
                </a:lnTo>
                <a:lnTo>
                  <a:pt x="2048" y="19"/>
                </a:lnTo>
                <a:lnTo>
                  <a:pt x="2049" y="18"/>
                </a:lnTo>
                <a:lnTo>
                  <a:pt x="2049" y="20"/>
                </a:lnTo>
                <a:lnTo>
                  <a:pt x="2050" y="19"/>
                </a:lnTo>
                <a:lnTo>
                  <a:pt x="2051" y="21"/>
                </a:lnTo>
                <a:lnTo>
                  <a:pt x="2052" y="21"/>
                </a:lnTo>
                <a:lnTo>
                  <a:pt x="2053" y="22"/>
                </a:lnTo>
                <a:lnTo>
                  <a:pt x="2054" y="23"/>
                </a:lnTo>
                <a:lnTo>
                  <a:pt x="2055" y="24"/>
                </a:lnTo>
                <a:lnTo>
                  <a:pt x="2056" y="25"/>
                </a:lnTo>
                <a:lnTo>
                  <a:pt x="2057" y="24"/>
                </a:lnTo>
                <a:lnTo>
                  <a:pt x="2057" y="23"/>
                </a:lnTo>
                <a:lnTo>
                  <a:pt x="2058" y="24"/>
                </a:lnTo>
                <a:lnTo>
                  <a:pt x="2059" y="25"/>
                </a:lnTo>
                <a:lnTo>
                  <a:pt x="2060" y="23"/>
                </a:lnTo>
                <a:lnTo>
                  <a:pt x="2061" y="22"/>
                </a:lnTo>
                <a:lnTo>
                  <a:pt x="2062" y="22"/>
                </a:lnTo>
                <a:lnTo>
                  <a:pt x="2063" y="21"/>
                </a:lnTo>
                <a:lnTo>
                  <a:pt x="2064" y="22"/>
                </a:lnTo>
                <a:lnTo>
                  <a:pt x="2064" y="20"/>
                </a:lnTo>
                <a:lnTo>
                  <a:pt x="2065" y="22"/>
                </a:lnTo>
                <a:lnTo>
                  <a:pt x="2066" y="21"/>
                </a:lnTo>
                <a:lnTo>
                  <a:pt x="2067" y="19"/>
                </a:lnTo>
                <a:lnTo>
                  <a:pt x="2068" y="20"/>
                </a:lnTo>
                <a:lnTo>
                  <a:pt x="2069" y="21"/>
                </a:lnTo>
                <a:lnTo>
                  <a:pt x="2070" y="22"/>
                </a:lnTo>
                <a:lnTo>
                  <a:pt x="2071" y="23"/>
                </a:lnTo>
                <a:lnTo>
                  <a:pt x="2072" y="24"/>
                </a:lnTo>
                <a:lnTo>
                  <a:pt x="2072" y="26"/>
                </a:lnTo>
                <a:lnTo>
                  <a:pt x="2073" y="27"/>
                </a:lnTo>
                <a:lnTo>
                  <a:pt x="2074" y="28"/>
                </a:lnTo>
                <a:lnTo>
                  <a:pt x="2075" y="30"/>
                </a:lnTo>
                <a:lnTo>
                  <a:pt x="2076" y="30"/>
                </a:lnTo>
                <a:lnTo>
                  <a:pt x="2077" y="31"/>
                </a:lnTo>
                <a:lnTo>
                  <a:pt x="2078" y="28"/>
                </a:lnTo>
                <a:lnTo>
                  <a:pt x="2079" y="30"/>
                </a:lnTo>
                <a:lnTo>
                  <a:pt x="2079" y="28"/>
                </a:lnTo>
                <a:lnTo>
                  <a:pt x="2080" y="27"/>
                </a:lnTo>
                <a:lnTo>
                  <a:pt x="2081" y="28"/>
                </a:lnTo>
                <a:lnTo>
                  <a:pt x="2082" y="27"/>
                </a:lnTo>
                <a:lnTo>
                  <a:pt x="2083" y="25"/>
                </a:lnTo>
                <a:lnTo>
                  <a:pt x="2084" y="25"/>
                </a:lnTo>
                <a:lnTo>
                  <a:pt x="2085" y="24"/>
                </a:lnTo>
                <a:lnTo>
                  <a:pt x="2086" y="24"/>
                </a:lnTo>
                <a:lnTo>
                  <a:pt x="2087" y="25"/>
                </a:lnTo>
                <a:lnTo>
                  <a:pt x="2087" y="23"/>
                </a:lnTo>
                <a:lnTo>
                  <a:pt x="2088" y="22"/>
                </a:lnTo>
                <a:lnTo>
                  <a:pt x="2089" y="23"/>
                </a:lnTo>
                <a:lnTo>
                  <a:pt x="2090" y="24"/>
                </a:lnTo>
                <a:lnTo>
                  <a:pt x="2091" y="23"/>
                </a:lnTo>
                <a:lnTo>
                  <a:pt x="2092" y="24"/>
                </a:lnTo>
                <a:lnTo>
                  <a:pt x="2093" y="27"/>
                </a:lnTo>
                <a:lnTo>
                  <a:pt x="2094" y="29"/>
                </a:lnTo>
                <a:lnTo>
                  <a:pt x="2094" y="30"/>
                </a:lnTo>
                <a:lnTo>
                  <a:pt x="2095" y="38"/>
                </a:lnTo>
                <a:lnTo>
                  <a:pt x="2096" y="43"/>
                </a:lnTo>
                <a:lnTo>
                  <a:pt x="2097" y="47"/>
                </a:lnTo>
                <a:lnTo>
                  <a:pt x="2098" y="55"/>
                </a:lnTo>
                <a:lnTo>
                  <a:pt x="2099" y="59"/>
                </a:lnTo>
                <a:lnTo>
                  <a:pt x="2100" y="66"/>
                </a:lnTo>
                <a:lnTo>
                  <a:pt x="2101" y="70"/>
                </a:lnTo>
                <a:lnTo>
                  <a:pt x="2102" y="76"/>
                </a:lnTo>
                <a:lnTo>
                  <a:pt x="2102" y="78"/>
                </a:lnTo>
                <a:lnTo>
                  <a:pt x="2103" y="80"/>
                </a:lnTo>
                <a:lnTo>
                  <a:pt x="2104" y="78"/>
                </a:lnTo>
                <a:lnTo>
                  <a:pt x="2105" y="76"/>
                </a:lnTo>
                <a:lnTo>
                  <a:pt x="2106" y="72"/>
                </a:lnTo>
                <a:lnTo>
                  <a:pt x="2107" y="69"/>
                </a:lnTo>
                <a:lnTo>
                  <a:pt x="2108" y="68"/>
                </a:lnTo>
                <a:lnTo>
                  <a:pt x="2109" y="65"/>
                </a:lnTo>
                <a:lnTo>
                  <a:pt x="2109" y="62"/>
                </a:lnTo>
                <a:lnTo>
                  <a:pt x="2110" y="60"/>
                </a:lnTo>
                <a:lnTo>
                  <a:pt x="2111" y="58"/>
                </a:lnTo>
                <a:lnTo>
                  <a:pt x="2112" y="56"/>
                </a:lnTo>
                <a:lnTo>
                  <a:pt x="2113" y="56"/>
                </a:lnTo>
                <a:lnTo>
                  <a:pt x="2114" y="50"/>
                </a:lnTo>
                <a:lnTo>
                  <a:pt x="2115" y="48"/>
                </a:lnTo>
                <a:lnTo>
                  <a:pt x="2116" y="47"/>
                </a:lnTo>
                <a:lnTo>
                  <a:pt x="2117" y="42"/>
                </a:lnTo>
                <a:lnTo>
                  <a:pt x="2117" y="41"/>
                </a:lnTo>
                <a:lnTo>
                  <a:pt x="2118" y="37"/>
                </a:lnTo>
                <a:lnTo>
                  <a:pt x="2119" y="37"/>
                </a:lnTo>
                <a:lnTo>
                  <a:pt x="2120" y="33"/>
                </a:lnTo>
                <a:lnTo>
                  <a:pt x="2121" y="32"/>
                </a:lnTo>
                <a:lnTo>
                  <a:pt x="2122" y="32"/>
                </a:lnTo>
                <a:lnTo>
                  <a:pt x="2123" y="28"/>
                </a:lnTo>
                <a:lnTo>
                  <a:pt x="2124" y="27"/>
                </a:lnTo>
                <a:lnTo>
                  <a:pt x="2124" y="26"/>
                </a:lnTo>
                <a:lnTo>
                  <a:pt x="2125" y="24"/>
                </a:lnTo>
                <a:lnTo>
                  <a:pt x="2126" y="23"/>
                </a:lnTo>
                <a:lnTo>
                  <a:pt x="2127" y="22"/>
                </a:lnTo>
                <a:lnTo>
                  <a:pt x="2128" y="22"/>
                </a:lnTo>
                <a:lnTo>
                  <a:pt x="2129" y="20"/>
                </a:lnTo>
                <a:lnTo>
                  <a:pt x="2130" y="22"/>
                </a:lnTo>
                <a:lnTo>
                  <a:pt x="2131" y="21"/>
                </a:lnTo>
                <a:lnTo>
                  <a:pt x="2132" y="19"/>
                </a:lnTo>
                <a:lnTo>
                  <a:pt x="2132" y="20"/>
                </a:lnTo>
                <a:lnTo>
                  <a:pt x="2133" y="19"/>
                </a:lnTo>
                <a:lnTo>
                  <a:pt x="2134" y="20"/>
                </a:lnTo>
                <a:lnTo>
                  <a:pt x="2135" y="18"/>
                </a:lnTo>
                <a:lnTo>
                  <a:pt x="2136" y="17"/>
                </a:lnTo>
                <a:lnTo>
                  <a:pt x="2137" y="19"/>
                </a:lnTo>
                <a:lnTo>
                  <a:pt x="2138" y="17"/>
                </a:lnTo>
                <a:lnTo>
                  <a:pt x="2139" y="18"/>
                </a:lnTo>
                <a:lnTo>
                  <a:pt x="2139" y="17"/>
                </a:lnTo>
                <a:lnTo>
                  <a:pt x="2140" y="15"/>
                </a:lnTo>
                <a:lnTo>
                  <a:pt x="2141" y="16"/>
                </a:lnTo>
                <a:lnTo>
                  <a:pt x="2142" y="16"/>
                </a:lnTo>
                <a:lnTo>
                  <a:pt x="2143" y="17"/>
                </a:lnTo>
                <a:lnTo>
                  <a:pt x="2144" y="16"/>
                </a:lnTo>
                <a:lnTo>
                  <a:pt x="2145" y="16"/>
                </a:lnTo>
                <a:lnTo>
                  <a:pt x="2146" y="16"/>
                </a:lnTo>
                <a:lnTo>
                  <a:pt x="2147" y="16"/>
                </a:lnTo>
                <a:lnTo>
                  <a:pt x="2147" y="16"/>
                </a:lnTo>
                <a:lnTo>
                  <a:pt x="2148" y="16"/>
                </a:lnTo>
                <a:lnTo>
                  <a:pt x="2149" y="17"/>
                </a:lnTo>
                <a:lnTo>
                  <a:pt x="2150" y="17"/>
                </a:lnTo>
                <a:lnTo>
                  <a:pt x="2151" y="18"/>
                </a:lnTo>
                <a:lnTo>
                  <a:pt x="2152" y="19"/>
                </a:lnTo>
                <a:lnTo>
                  <a:pt x="2153" y="18"/>
                </a:lnTo>
                <a:lnTo>
                  <a:pt x="2154" y="21"/>
                </a:lnTo>
                <a:lnTo>
                  <a:pt x="2154" y="23"/>
                </a:lnTo>
                <a:lnTo>
                  <a:pt x="2155" y="26"/>
                </a:lnTo>
                <a:lnTo>
                  <a:pt x="2156" y="28"/>
                </a:lnTo>
                <a:lnTo>
                  <a:pt x="2157" y="30"/>
                </a:lnTo>
                <a:lnTo>
                  <a:pt x="2158" y="32"/>
                </a:lnTo>
                <a:lnTo>
                  <a:pt x="2159" y="34"/>
                </a:lnTo>
                <a:lnTo>
                  <a:pt x="2160" y="37"/>
                </a:lnTo>
                <a:lnTo>
                  <a:pt x="2161" y="37"/>
                </a:lnTo>
                <a:lnTo>
                  <a:pt x="2162" y="36"/>
                </a:lnTo>
                <a:lnTo>
                  <a:pt x="2162" y="35"/>
                </a:lnTo>
                <a:lnTo>
                  <a:pt x="2163" y="34"/>
                </a:lnTo>
                <a:lnTo>
                  <a:pt x="2164" y="30"/>
                </a:lnTo>
                <a:lnTo>
                  <a:pt x="2165" y="30"/>
                </a:lnTo>
                <a:lnTo>
                  <a:pt x="2166" y="29"/>
                </a:lnTo>
                <a:lnTo>
                  <a:pt x="2167" y="28"/>
                </a:lnTo>
                <a:lnTo>
                  <a:pt x="2168" y="26"/>
                </a:lnTo>
                <a:lnTo>
                  <a:pt x="2169" y="25"/>
                </a:lnTo>
                <a:lnTo>
                  <a:pt x="2169" y="23"/>
                </a:lnTo>
                <a:lnTo>
                  <a:pt x="2170" y="22"/>
                </a:lnTo>
                <a:lnTo>
                  <a:pt x="2171" y="23"/>
                </a:lnTo>
                <a:lnTo>
                  <a:pt x="2172" y="21"/>
                </a:lnTo>
                <a:lnTo>
                  <a:pt x="2173" y="22"/>
                </a:lnTo>
                <a:lnTo>
                  <a:pt x="2174" y="19"/>
                </a:lnTo>
                <a:lnTo>
                  <a:pt x="2175" y="20"/>
                </a:lnTo>
                <a:lnTo>
                  <a:pt x="2176" y="20"/>
                </a:lnTo>
                <a:lnTo>
                  <a:pt x="2176" y="18"/>
                </a:lnTo>
                <a:lnTo>
                  <a:pt x="2177" y="18"/>
                </a:lnTo>
                <a:lnTo>
                  <a:pt x="2178" y="18"/>
                </a:lnTo>
                <a:lnTo>
                  <a:pt x="2179" y="20"/>
                </a:lnTo>
                <a:lnTo>
                  <a:pt x="2180" y="18"/>
                </a:lnTo>
                <a:lnTo>
                  <a:pt x="2181" y="17"/>
                </a:lnTo>
                <a:lnTo>
                  <a:pt x="2182" y="19"/>
                </a:lnTo>
                <a:lnTo>
                  <a:pt x="2183" y="18"/>
                </a:lnTo>
                <a:lnTo>
                  <a:pt x="2184" y="17"/>
                </a:lnTo>
                <a:lnTo>
                  <a:pt x="2184" y="16"/>
                </a:lnTo>
                <a:lnTo>
                  <a:pt x="2185" y="18"/>
                </a:lnTo>
                <a:lnTo>
                  <a:pt x="2186" y="18"/>
                </a:lnTo>
                <a:lnTo>
                  <a:pt x="2187" y="17"/>
                </a:lnTo>
                <a:lnTo>
                  <a:pt x="2188" y="16"/>
                </a:lnTo>
                <a:lnTo>
                  <a:pt x="2189" y="17"/>
                </a:lnTo>
                <a:lnTo>
                  <a:pt x="2190" y="16"/>
                </a:lnTo>
                <a:lnTo>
                  <a:pt x="2191" y="17"/>
                </a:lnTo>
                <a:lnTo>
                  <a:pt x="2191" y="16"/>
                </a:lnTo>
                <a:lnTo>
                  <a:pt x="2192" y="16"/>
                </a:lnTo>
                <a:lnTo>
                  <a:pt x="2193" y="16"/>
                </a:lnTo>
                <a:lnTo>
                  <a:pt x="2194" y="15"/>
                </a:lnTo>
                <a:lnTo>
                  <a:pt x="2195" y="16"/>
                </a:lnTo>
                <a:lnTo>
                  <a:pt x="2196" y="15"/>
                </a:lnTo>
                <a:lnTo>
                  <a:pt x="2197" y="15"/>
                </a:lnTo>
                <a:lnTo>
                  <a:pt x="2198" y="15"/>
                </a:lnTo>
                <a:lnTo>
                  <a:pt x="2199" y="14"/>
                </a:lnTo>
                <a:lnTo>
                  <a:pt x="2199" y="14"/>
                </a:lnTo>
                <a:lnTo>
                  <a:pt x="2200" y="14"/>
                </a:lnTo>
                <a:lnTo>
                  <a:pt x="2201" y="15"/>
                </a:lnTo>
                <a:lnTo>
                  <a:pt x="2202" y="15"/>
                </a:lnTo>
                <a:lnTo>
                  <a:pt x="2203" y="16"/>
                </a:lnTo>
                <a:lnTo>
                  <a:pt x="2204" y="16"/>
                </a:lnTo>
                <a:lnTo>
                  <a:pt x="2205" y="14"/>
                </a:lnTo>
                <a:lnTo>
                  <a:pt x="2206" y="13"/>
                </a:lnTo>
                <a:lnTo>
                  <a:pt x="2206" y="15"/>
                </a:lnTo>
                <a:lnTo>
                  <a:pt x="2207" y="14"/>
                </a:lnTo>
                <a:lnTo>
                  <a:pt x="2208" y="15"/>
                </a:lnTo>
                <a:lnTo>
                  <a:pt x="2209" y="14"/>
                </a:lnTo>
                <a:lnTo>
                  <a:pt x="2210" y="13"/>
                </a:lnTo>
                <a:lnTo>
                  <a:pt x="2211" y="15"/>
                </a:lnTo>
                <a:lnTo>
                  <a:pt x="2212" y="17"/>
                </a:lnTo>
                <a:lnTo>
                  <a:pt x="2213" y="15"/>
                </a:lnTo>
                <a:lnTo>
                  <a:pt x="2214" y="14"/>
                </a:lnTo>
                <a:lnTo>
                  <a:pt x="2214" y="16"/>
                </a:lnTo>
                <a:lnTo>
                  <a:pt x="2215" y="15"/>
                </a:lnTo>
                <a:lnTo>
                  <a:pt x="2216" y="17"/>
                </a:lnTo>
                <a:lnTo>
                  <a:pt x="2217" y="15"/>
                </a:lnTo>
                <a:lnTo>
                  <a:pt x="2218" y="16"/>
                </a:lnTo>
                <a:lnTo>
                  <a:pt x="2219" y="17"/>
                </a:lnTo>
                <a:lnTo>
                  <a:pt x="2220" y="17"/>
                </a:lnTo>
                <a:lnTo>
                  <a:pt x="2221" y="16"/>
                </a:lnTo>
                <a:lnTo>
                  <a:pt x="2221" y="15"/>
                </a:lnTo>
                <a:lnTo>
                  <a:pt x="2222" y="16"/>
                </a:lnTo>
                <a:lnTo>
                  <a:pt x="2223" y="14"/>
                </a:lnTo>
                <a:lnTo>
                  <a:pt x="2224" y="15"/>
                </a:lnTo>
                <a:lnTo>
                  <a:pt x="2225" y="16"/>
                </a:lnTo>
                <a:lnTo>
                  <a:pt x="2226" y="14"/>
                </a:lnTo>
                <a:lnTo>
                  <a:pt x="2227" y="14"/>
                </a:lnTo>
                <a:lnTo>
                  <a:pt x="2228" y="14"/>
                </a:lnTo>
                <a:lnTo>
                  <a:pt x="2229" y="14"/>
                </a:lnTo>
                <a:lnTo>
                  <a:pt x="2229" y="15"/>
                </a:lnTo>
                <a:lnTo>
                  <a:pt x="2230" y="13"/>
                </a:lnTo>
                <a:lnTo>
                  <a:pt x="2231" y="14"/>
                </a:lnTo>
                <a:lnTo>
                  <a:pt x="2232" y="14"/>
                </a:lnTo>
                <a:lnTo>
                  <a:pt x="2233" y="13"/>
                </a:lnTo>
                <a:lnTo>
                  <a:pt x="2234" y="13"/>
                </a:lnTo>
                <a:lnTo>
                  <a:pt x="2235" y="12"/>
                </a:lnTo>
                <a:lnTo>
                  <a:pt x="2236" y="13"/>
                </a:lnTo>
                <a:lnTo>
                  <a:pt x="2236" y="13"/>
                </a:lnTo>
                <a:lnTo>
                  <a:pt x="2237" y="12"/>
                </a:lnTo>
                <a:lnTo>
                  <a:pt x="2238" y="11"/>
                </a:lnTo>
                <a:lnTo>
                  <a:pt x="2239" y="12"/>
                </a:lnTo>
                <a:lnTo>
                  <a:pt x="2240" y="11"/>
                </a:lnTo>
                <a:lnTo>
                  <a:pt x="2241" y="11"/>
                </a:lnTo>
                <a:lnTo>
                  <a:pt x="2242" y="12"/>
                </a:lnTo>
                <a:lnTo>
                  <a:pt x="2243" y="11"/>
                </a:lnTo>
                <a:lnTo>
                  <a:pt x="2244" y="11"/>
                </a:lnTo>
                <a:lnTo>
                  <a:pt x="2244" y="11"/>
                </a:lnTo>
                <a:lnTo>
                  <a:pt x="2245" y="10"/>
                </a:lnTo>
                <a:lnTo>
                  <a:pt x="2246" y="9"/>
                </a:lnTo>
                <a:lnTo>
                  <a:pt x="2247" y="11"/>
                </a:lnTo>
                <a:lnTo>
                  <a:pt x="2248" y="10"/>
                </a:lnTo>
                <a:lnTo>
                  <a:pt x="2249" y="11"/>
                </a:lnTo>
                <a:lnTo>
                  <a:pt x="2250" y="12"/>
                </a:lnTo>
                <a:lnTo>
                  <a:pt x="2251" y="11"/>
                </a:lnTo>
                <a:lnTo>
                  <a:pt x="2251" y="10"/>
                </a:lnTo>
                <a:lnTo>
                  <a:pt x="2252" y="11"/>
                </a:lnTo>
                <a:lnTo>
                  <a:pt x="2253" y="11"/>
                </a:lnTo>
                <a:lnTo>
                  <a:pt x="2254" y="11"/>
                </a:lnTo>
                <a:lnTo>
                  <a:pt x="2255" y="11"/>
                </a:lnTo>
                <a:lnTo>
                  <a:pt x="2256" y="10"/>
                </a:lnTo>
                <a:lnTo>
                  <a:pt x="2257" y="9"/>
                </a:lnTo>
                <a:lnTo>
                  <a:pt x="2258" y="10"/>
                </a:lnTo>
                <a:lnTo>
                  <a:pt x="2259" y="10"/>
                </a:lnTo>
                <a:lnTo>
                  <a:pt x="2259" y="10"/>
                </a:lnTo>
                <a:lnTo>
                  <a:pt x="2260" y="10"/>
                </a:lnTo>
                <a:lnTo>
                  <a:pt x="2261" y="11"/>
                </a:lnTo>
                <a:lnTo>
                  <a:pt x="2262" y="10"/>
                </a:lnTo>
                <a:lnTo>
                  <a:pt x="2263" y="9"/>
                </a:lnTo>
                <a:lnTo>
                  <a:pt x="2264" y="10"/>
                </a:lnTo>
                <a:lnTo>
                  <a:pt x="2265" y="9"/>
                </a:lnTo>
                <a:lnTo>
                  <a:pt x="2266" y="10"/>
                </a:lnTo>
                <a:lnTo>
                  <a:pt x="2266" y="11"/>
                </a:lnTo>
                <a:lnTo>
                  <a:pt x="2267" y="12"/>
                </a:lnTo>
                <a:lnTo>
                  <a:pt x="2268" y="10"/>
                </a:lnTo>
                <a:lnTo>
                  <a:pt x="2269" y="10"/>
                </a:lnTo>
                <a:lnTo>
                  <a:pt x="2270" y="10"/>
                </a:lnTo>
                <a:lnTo>
                  <a:pt x="2271" y="10"/>
                </a:lnTo>
                <a:lnTo>
                  <a:pt x="2272" y="11"/>
                </a:lnTo>
                <a:lnTo>
                  <a:pt x="2273" y="12"/>
                </a:lnTo>
                <a:lnTo>
                  <a:pt x="2274" y="11"/>
                </a:lnTo>
                <a:lnTo>
                  <a:pt x="2274" y="10"/>
                </a:lnTo>
                <a:lnTo>
                  <a:pt x="2275" y="10"/>
                </a:lnTo>
                <a:lnTo>
                  <a:pt x="2276" y="11"/>
                </a:lnTo>
                <a:lnTo>
                  <a:pt x="2277" y="13"/>
                </a:lnTo>
                <a:lnTo>
                  <a:pt x="2278" y="14"/>
                </a:lnTo>
                <a:lnTo>
                  <a:pt x="2279" y="16"/>
                </a:lnTo>
                <a:lnTo>
                  <a:pt x="2280" y="18"/>
                </a:lnTo>
                <a:lnTo>
                  <a:pt x="2281" y="19"/>
                </a:lnTo>
                <a:lnTo>
                  <a:pt x="2281" y="24"/>
                </a:lnTo>
                <a:lnTo>
                  <a:pt x="2282" y="27"/>
                </a:lnTo>
                <a:lnTo>
                  <a:pt x="2283" y="32"/>
                </a:lnTo>
                <a:lnTo>
                  <a:pt x="2284" y="32"/>
                </a:lnTo>
                <a:lnTo>
                  <a:pt x="2285" y="37"/>
                </a:lnTo>
                <a:lnTo>
                  <a:pt x="2286" y="37"/>
                </a:lnTo>
                <a:lnTo>
                  <a:pt x="2287" y="37"/>
                </a:lnTo>
                <a:lnTo>
                  <a:pt x="2288" y="36"/>
                </a:lnTo>
                <a:lnTo>
                  <a:pt x="2289" y="34"/>
                </a:lnTo>
                <a:lnTo>
                  <a:pt x="2289" y="30"/>
                </a:lnTo>
                <a:lnTo>
                  <a:pt x="2290" y="30"/>
                </a:lnTo>
                <a:lnTo>
                  <a:pt x="2291" y="25"/>
                </a:lnTo>
                <a:lnTo>
                  <a:pt x="2292" y="24"/>
                </a:lnTo>
                <a:lnTo>
                  <a:pt x="2293" y="19"/>
                </a:lnTo>
                <a:lnTo>
                  <a:pt x="2294" y="18"/>
                </a:lnTo>
                <a:lnTo>
                  <a:pt x="2295" y="16"/>
                </a:lnTo>
                <a:lnTo>
                  <a:pt x="2296" y="18"/>
                </a:lnTo>
                <a:lnTo>
                  <a:pt x="2296" y="17"/>
                </a:lnTo>
                <a:lnTo>
                  <a:pt x="2297" y="17"/>
                </a:lnTo>
                <a:lnTo>
                  <a:pt x="2298" y="16"/>
                </a:lnTo>
                <a:lnTo>
                  <a:pt x="2299" y="17"/>
                </a:lnTo>
                <a:lnTo>
                  <a:pt x="2300" y="20"/>
                </a:lnTo>
                <a:lnTo>
                  <a:pt x="2301" y="18"/>
                </a:lnTo>
                <a:lnTo>
                  <a:pt x="2302" y="20"/>
                </a:lnTo>
                <a:lnTo>
                  <a:pt x="2303" y="20"/>
                </a:lnTo>
                <a:lnTo>
                  <a:pt x="2304" y="21"/>
                </a:lnTo>
                <a:lnTo>
                  <a:pt x="2304" y="19"/>
                </a:lnTo>
                <a:lnTo>
                  <a:pt x="2305" y="19"/>
                </a:lnTo>
                <a:lnTo>
                  <a:pt x="2306" y="19"/>
                </a:lnTo>
                <a:lnTo>
                  <a:pt x="2307" y="18"/>
                </a:lnTo>
                <a:lnTo>
                  <a:pt x="2308" y="17"/>
                </a:lnTo>
                <a:lnTo>
                  <a:pt x="2309" y="17"/>
                </a:lnTo>
                <a:lnTo>
                  <a:pt x="2310" y="16"/>
                </a:lnTo>
                <a:lnTo>
                  <a:pt x="2311" y="13"/>
                </a:lnTo>
                <a:lnTo>
                  <a:pt x="2311" y="15"/>
                </a:lnTo>
                <a:lnTo>
                  <a:pt x="2312" y="14"/>
                </a:lnTo>
                <a:lnTo>
                  <a:pt x="2313" y="13"/>
                </a:lnTo>
                <a:lnTo>
                  <a:pt x="2314" y="13"/>
                </a:lnTo>
                <a:lnTo>
                  <a:pt x="2315" y="11"/>
                </a:lnTo>
                <a:lnTo>
                  <a:pt x="2316" y="13"/>
                </a:lnTo>
                <a:lnTo>
                  <a:pt x="2317" y="12"/>
                </a:lnTo>
                <a:lnTo>
                  <a:pt x="2318" y="12"/>
                </a:lnTo>
                <a:lnTo>
                  <a:pt x="2319" y="12"/>
                </a:lnTo>
                <a:lnTo>
                  <a:pt x="2319" y="12"/>
                </a:lnTo>
                <a:lnTo>
                  <a:pt x="2320" y="12"/>
                </a:lnTo>
                <a:lnTo>
                  <a:pt x="2321" y="12"/>
                </a:lnTo>
                <a:lnTo>
                  <a:pt x="2322" y="10"/>
                </a:lnTo>
                <a:lnTo>
                  <a:pt x="2323" y="13"/>
                </a:lnTo>
                <a:lnTo>
                  <a:pt x="2324" y="12"/>
                </a:lnTo>
                <a:lnTo>
                  <a:pt x="2325" y="13"/>
                </a:lnTo>
                <a:lnTo>
                  <a:pt x="2326" y="13"/>
                </a:lnTo>
                <a:lnTo>
                  <a:pt x="2326" y="13"/>
                </a:lnTo>
                <a:lnTo>
                  <a:pt x="2327" y="13"/>
                </a:lnTo>
                <a:lnTo>
                  <a:pt x="2328" y="12"/>
                </a:lnTo>
                <a:lnTo>
                  <a:pt x="2329" y="13"/>
                </a:lnTo>
                <a:lnTo>
                  <a:pt x="2330" y="12"/>
                </a:lnTo>
                <a:lnTo>
                  <a:pt x="2331" y="12"/>
                </a:lnTo>
                <a:lnTo>
                  <a:pt x="2332" y="12"/>
                </a:lnTo>
                <a:lnTo>
                  <a:pt x="2333" y="12"/>
                </a:lnTo>
                <a:lnTo>
                  <a:pt x="2334" y="14"/>
                </a:lnTo>
                <a:lnTo>
                  <a:pt x="2334" y="12"/>
                </a:lnTo>
                <a:lnTo>
                  <a:pt x="2335" y="14"/>
                </a:lnTo>
                <a:lnTo>
                  <a:pt x="2336" y="11"/>
                </a:lnTo>
                <a:lnTo>
                  <a:pt x="2337" y="11"/>
                </a:lnTo>
                <a:lnTo>
                  <a:pt x="2338" y="11"/>
                </a:lnTo>
                <a:lnTo>
                  <a:pt x="2339" y="10"/>
                </a:lnTo>
                <a:lnTo>
                  <a:pt x="2340" y="11"/>
                </a:lnTo>
                <a:lnTo>
                  <a:pt x="2341" y="11"/>
                </a:lnTo>
                <a:lnTo>
                  <a:pt x="2341" y="11"/>
                </a:lnTo>
                <a:lnTo>
                  <a:pt x="2342" y="9"/>
                </a:lnTo>
                <a:lnTo>
                  <a:pt x="2343" y="10"/>
                </a:lnTo>
                <a:lnTo>
                  <a:pt x="2344" y="10"/>
                </a:lnTo>
                <a:lnTo>
                  <a:pt x="2345" y="10"/>
                </a:lnTo>
                <a:lnTo>
                  <a:pt x="2346" y="11"/>
                </a:lnTo>
                <a:lnTo>
                  <a:pt x="2347" y="11"/>
                </a:lnTo>
                <a:lnTo>
                  <a:pt x="2348" y="9"/>
                </a:lnTo>
                <a:lnTo>
                  <a:pt x="2349" y="11"/>
                </a:lnTo>
                <a:lnTo>
                  <a:pt x="2349" y="11"/>
                </a:lnTo>
                <a:lnTo>
                  <a:pt x="2350" y="11"/>
                </a:lnTo>
                <a:lnTo>
                  <a:pt x="2351" y="11"/>
                </a:lnTo>
                <a:lnTo>
                  <a:pt x="2352" y="10"/>
                </a:lnTo>
                <a:lnTo>
                  <a:pt x="2353" y="10"/>
                </a:lnTo>
                <a:lnTo>
                  <a:pt x="2354" y="11"/>
                </a:lnTo>
                <a:lnTo>
                  <a:pt x="2355" y="9"/>
                </a:lnTo>
                <a:lnTo>
                  <a:pt x="2356" y="10"/>
                </a:lnTo>
                <a:lnTo>
                  <a:pt x="2356" y="11"/>
                </a:lnTo>
                <a:lnTo>
                  <a:pt x="2357" y="10"/>
                </a:lnTo>
                <a:lnTo>
                  <a:pt x="2358" y="9"/>
                </a:lnTo>
                <a:lnTo>
                  <a:pt x="2359" y="11"/>
                </a:lnTo>
                <a:lnTo>
                  <a:pt x="2360" y="10"/>
                </a:lnTo>
                <a:lnTo>
                  <a:pt x="2361" y="10"/>
                </a:lnTo>
                <a:lnTo>
                  <a:pt x="2362" y="10"/>
                </a:lnTo>
                <a:lnTo>
                  <a:pt x="2363" y="11"/>
                </a:lnTo>
                <a:lnTo>
                  <a:pt x="2364" y="11"/>
                </a:lnTo>
                <a:lnTo>
                  <a:pt x="2364" y="11"/>
                </a:lnTo>
                <a:lnTo>
                  <a:pt x="2365" y="11"/>
                </a:lnTo>
                <a:lnTo>
                  <a:pt x="2366" y="11"/>
                </a:lnTo>
                <a:lnTo>
                  <a:pt x="2367" y="12"/>
                </a:lnTo>
                <a:lnTo>
                  <a:pt x="2368" y="11"/>
                </a:lnTo>
                <a:lnTo>
                  <a:pt x="2369" y="12"/>
                </a:lnTo>
                <a:lnTo>
                  <a:pt x="2370" y="12"/>
                </a:lnTo>
                <a:lnTo>
                  <a:pt x="2371" y="12"/>
                </a:lnTo>
                <a:lnTo>
                  <a:pt x="2371" y="12"/>
                </a:lnTo>
                <a:lnTo>
                  <a:pt x="2372" y="13"/>
                </a:lnTo>
                <a:lnTo>
                  <a:pt x="2373" y="12"/>
                </a:lnTo>
                <a:lnTo>
                  <a:pt x="2374" y="13"/>
                </a:lnTo>
                <a:lnTo>
                  <a:pt x="2375" y="11"/>
                </a:lnTo>
                <a:lnTo>
                  <a:pt x="2376" y="11"/>
                </a:lnTo>
                <a:lnTo>
                  <a:pt x="2377" y="11"/>
                </a:lnTo>
                <a:lnTo>
                  <a:pt x="2378" y="12"/>
                </a:lnTo>
                <a:lnTo>
                  <a:pt x="2378" y="11"/>
                </a:lnTo>
                <a:lnTo>
                  <a:pt x="2379" y="12"/>
                </a:lnTo>
                <a:lnTo>
                  <a:pt x="2380" y="11"/>
                </a:lnTo>
                <a:lnTo>
                  <a:pt x="2381" y="11"/>
                </a:lnTo>
                <a:lnTo>
                  <a:pt x="2382" y="13"/>
                </a:lnTo>
                <a:lnTo>
                  <a:pt x="2383" y="11"/>
                </a:lnTo>
                <a:lnTo>
                  <a:pt x="2384" y="12"/>
                </a:lnTo>
                <a:lnTo>
                  <a:pt x="2385" y="12"/>
                </a:lnTo>
                <a:lnTo>
                  <a:pt x="2386" y="12"/>
                </a:lnTo>
                <a:lnTo>
                  <a:pt x="2386" y="12"/>
                </a:lnTo>
                <a:lnTo>
                  <a:pt x="2387" y="11"/>
                </a:lnTo>
                <a:lnTo>
                  <a:pt x="2388" y="12"/>
                </a:lnTo>
                <a:lnTo>
                  <a:pt x="2389" y="12"/>
                </a:lnTo>
                <a:lnTo>
                  <a:pt x="2390" y="13"/>
                </a:lnTo>
                <a:lnTo>
                  <a:pt x="2391" y="13"/>
                </a:lnTo>
                <a:lnTo>
                  <a:pt x="2392" y="12"/>
                </a:lnTo>
                <a:lnTo>
                  <a:pt x="2393" y="13"/>
                </a:lnTo>
                <a:lnTo>
                  <a:pt x="2393" y="13"/>
                </a:lnTo>
                <a:lnTo>
                  <a:pt x="2394" y="14"/>
                </a:lnTo>
                <a:lnTo>
                  <a:pt x="2395" y="14"/>
                </a:lnTo>
                <a:lnTo>
                  <a:pt x="2396" y="14"/>
                </a:lnTo>
                <a:lnTo>
                  <a:pt x="2397" y="14"/>
                </a:lnTo>
                <a:lnTo>
                  <a:pt x="2398" y="13"/>
                </a:lnTo>
                <a:lnTo>
                  <a:pt x="2399" y="14"/>
                </a:lnTo>
                <a:lnTo>
                  <a:pt x="2400" y="15"/>
                </a:lnTo>
                <a:lnTo>
                  <a:pt x="2401" y="14"/>
                </a:lnTo>
                <a:lnTo>
                  <a:pt x="2401" y="15"/>
                </a:lnTo>
                <a:lnTo>
                  <a:pt x="2402" y="16"/>
                </a:lnTo>
                <a:lnTo>
                  <a:pt x="2403" y="16"/>
                </a:lnTo>
                <a:lnTo>
                  <a:pt x="2404" y="16"/>
                </a:lnTo>
                <a:lnTo>
                  <a:pt x="2405" y="17"/>
                </a:lnTo>
                <a:lnTo>
                  <a:pt x="2406" y="20"/>
                </a:lnTo>
                <a:lnTo>
                  <a:pt x="2407" y="24"/>
                </a:lnTo>
                <a:lnTo>
                  <a:pt x="2408" y="28"/>
                </a:lnTo>
                <a:lnTo>
                  <a:pt x="2408" y="32"/>
                </a:lnTo>
                <a:lnTo>
                  <a:pt x="2409" y="39"/>
                </a:lnTo>
                <a:lnTo>
                  <a:pt x="2410" y="43"/>
                </a:lnTo>
                <a:lnTo>
                  <a:pt x="2411" y="45"/>
                </a:lnTo>
                <a:lnTo>
                  <a:pt x="2412" y="53"/>
                </a:lnTo>
                <a:lnTo>
                  <a:pt x="2413" y="57"/>
                </a:lnTo>
                <a:lnTo>
                  <a:pt x="2414" y="63"/>
                </a:lnTo>
                <a:lnTo>
                  <a:pt x="2415" y="72"/>
                </a:lnTo>
                <a:lnTo>
                  <a:pt x="2416" y="74"/>
                </a:lnTo>
                <a:lnTo>
                  <a:pt x="2416" y="74"/>
                </a:lnTo>
                <a:lnTo>
                  <a:pt x="2417" y="74"/>
                </a:lnTo>
                <a:lnTo>
                  <a:pt x="2418" y="75"/>
                </a:lnTo>
                <a:lnTo>
                  <a:pt x="2419" y="73"/>
                </a:lnTo>
                <a:lnTo>
                  <a:pt x="2420" y="72"/>
                </a:lnTo>
                <a:lnTo>
                  <a:pt x="2421" y="71"/>
                </a:lnTo>
                <a:lnTo>
                  <a:pt x="2422" y="70"/>
                </a:lnTo>
                <a:lnTo>
                  <a:pt x="2423" y="66"/>
                </a:lnTo>
                <a:lnTo>
                  <a:pt x="2423" y="68"/>
                </a:lnTo>
                <a:lnTo>
                  <a:pt x="2424" y="72"/>
                </a:lnTo>
                <a:lnTo>
                  <a:pt x="2425" y="77"/>
                </a:lnTo>
                <a:lnTo>
                  <a:pt x="2426" y="81"/>
                </a:lnTo>
                <a:lnTo>
                  <a:pt x="2427" y="96"/>
                </a:lnTo>
                <a:lnTo>
                  <a:pt x="2428" y="109"/>
                </a:lnTo>
                <a:lnTo>
                  <a:pt x="2429" y="130"/>
                </a:lnTo>
                <a:lnTo>
                  <a:pt x="2430" y="153"/>
                </a:lnTo>
                <a:lnTo>
                  <a:pt x="2431" y="182"/>
                </a:lnTo>
                <a:lnTo>
                  <a:pt x="2431" y="210"/>
                </a:lnTo>
                <a:lnTo>
                  <a:pt x="2432" y="243"/>
                </a:lnTo>
                <a:lnTo>
                  <a:pt x="2433" y="288"/>
                </a:lnTo>
                <a:lnTo>
                  <a:pt x="2434" y="331"/>
                </a:lnTo>
                <a:lnTo>
                  <a:pt x="2435" y="385"/>
                </a:lnTo>
                <a:lnTo>
                  <a:pt x="2436" y="437"/>
                </a:lnTo>
                <a:lnTo>
                  <a:pt x="2437" y="495"/>
                </a:lnTo>
                <a:lnTo>
                  <a:pt x="2438" y="532"/>
                </a:lnTo>
                <a:lnTo>
                  <a:pt x="2438" y="562"/>
                </a:lnTo>
                <a:lnTo>
                  <a:pt x="2439" y="600"/>
                </a:lnTo>
                <a:lnTo>
                  <a:pt x="2440" y="619"/>
                </a:lnTo>
                <a:lnTo>
                  <a:pt x="2441" y="617"/>
                </a:lnTo>
                <a:lnTo>
                  <a:pt x="2442" y="591"/>
                </a:lnTo>
                <a:lnTo>
                  <a:pt x="2443" y="563"/>
                </a:lnTo>
                <a:lnTo>
                  <a:pt x="2444" y="526"/>
                </a:lnTo>
                <a:lnTo>
                  <a:pt x="2445" y="452"/>
                </a:lnTo>
                <a:lnTo>
                  <a:pt x="2446" y="390"/>
                </a:lnTo>
                <a:lnTo>
                  <a:pt x="2446" y="344"/>
                </a:lnTo>
                <a:lnTo>
                  <a:pt x="2447" y="305"/>
                </a:lnTo>
                <a:lnTo>
                  <a:pt x="2448" y="288"/>
                </a:lnTo>
                <a:lnTo>
                  <a:pt x="2449" y="279"/>
                </a:lnTo>
                <a:lnTo>
                  <a:pt x="2450" y="278"/>
                </a:lnTo>
                <a:lnTo>
                  <a:pt x="2451" y="279"/>
                </a:lnTo>
                <a:lnTo>
                  <a:pt x="2452" y="283"/>
                </a:lnTo>
                <a:lnTo>
                  <a:pt x="2453" y="296"/>
                </a:lnTo>
                <a:lnTo>
                  <a:pt x="2453" y="303"/>
                </a:lnTo>
                <a:lnTo>
                  <a:pt x="2454" y="308"/>
                </a:lnTo>
                <a:lnTo>
                  <a:pt x="2455" y="289"/>
                </a:lnTo>
                <a:lnTo>
                  <a:pt x="2456" y="261"/>
                </a:lnTo>
                <a:lnTo>
                  <a:pt x="2457" y="230"/>
                </a:lnTo>
                <a:lnTo>
                  <a:pt x="2458" y="205"/>
                </a:lnTo>
                <a:lnTo>
                  <a:pt x="2459" y="185"/>
                </a:lnTo>
                <a:lnTo>
                  <a:pt x="2460" y="164"/>
                </a:lnTo>
                <a:lnTo>
                  <a:pt x="2461" y="147"/>
                </a:lnTo>
                <a:lnTo>
                  <a:pt x="2461" y="134"/>
                </a:lnTo>
                <a:lnTo>
                  <a:pt x="2462" y="120"/>
                </a:lnTo>
                <a:lnTo>
                  <a:pt x="2463" y="112"/>
                </a:lnTo>
                <a:lnTo>
                  <a:pt x="2464" y="104"/>
                </a:lnTo>
                <a:lnTo>
                  <a:pt x="2465" y="99"/>
                </a:lnTo>
                <a:lnTo>
                  <a:pt x="2466" y="92"/>
                </a:lnTo>
                <a:lnTo>
                  <a:pt x="2467" y="92"/>
                </a:lnTo>
                <a:lnTo>
                  <a:pt x="2468" y="87"/>
                </a:lnTo>
                <a:lnTo>
                  <a:pt x="2468" y="82"/>
                </a:lnTo>
                <a:lnTo>
                  <a:pt x="2469" y="78"/>
                </a:lnTo>
                <a:lnTo>
                  <a:pt x="2470" y="77"/>
                </a:lnTo>
                <a:lnTo>
                  <a:pt x="2471" y="74"/>
                </a:lnTo>
                <a:lnTo>
                  <a:pt x="2472" y="70"/>
                </a:lnTo>
                <a:lnTo>
                  <a:pt x="2473" y="68"/>
                </a:lnTo>
                <a:lnTo>
                  <a:pt x="2474" y="68"/>
                </a:lnTo>
                <a:lnTo>
                  <a:pt x="2475" y="67"/>
                </a:lnTo>
                <a:lnTo>
                  <a:pt x="2476" y="64"/>
                </a:lnTo>
                <a:lnTo>
                  <a:pt x="2476" y="63"/>
                </a:lnTo>
                <a:lnTo>
                  <a:pt x="2477" y="61"/>
                </a:lnTo>
                <a:lnTo>
                  <a:pt x="2478" y="60"/>
                </a:lnTo>
                <a:lnTo>
                  <a:pt x="2479" y="59"/>
                </a:lnTo>
                <a:lnTo>
                  <a:pt x="2480" y="57"/>
                </a:lnTo>
                <a:lnTo>
                  <a:pt x="2481" y="58"/>
                </a:lnTo>
                <a:lnTo>
                  <a:pt x="2482" y="55"/>
                </a:lnTo>
                <a:lnTo>
                  <a:pt x="2483" y="53"/>
                </a:lnTo>
                <a:lnTo>
                  <a:pt x="2483" y="52"/>
                </a:lnTo>
                <a:lnTo>
                  <a:pt x="2484" y="51"/>
                </a:lnTo>
                <a:lnTo>
                  <a:pt x="2485" y="51"/>
                </a:lnTo>
                <a:lnTo>
                  <a:pt x="2486" y="49"/>
                </a:lnTo>
                <a:lnTo>
                  <a:pt x="2487" y="48"/>
                </a:lnTo>
                <a:lnTo>
                  <a:pt x="2488" y="49"/>
                </a:lnTo>
                <a:lnTo>
                  <a:pt x="2489" y="45"/>
                </a:lnTo>
                <a:lnTo>
                  <a:pt x="2490" y="47"/>
                </a:lnTo>
                <a:lnTo>
                  <a:pt x="2491" y="44"/>
                </a:lnTo>
                <a:lnTo>
                  <a:pt x="2491" y="44"/>
                </a:lnTo>
                <a:lnTo>
                  <a:pt x="2492" y="45"/>
                </a:lnTo>
                <a:lnTo>
                  <a:pt x="2493" y="44"/>
                </a:lnTo>
                <a:lnTo>
                  <a:pt x="2494" y="41"/>
                </a:lnTo>
                <a:lnTo>
                  <a:pt x="2495" y="41"/>
                </a:lnTo>
                <a:lnTo>
                  <a:pt x="2496" y="41"/>
                </a:lnTo>
                <a:lnTo>
                  <a:pt x="2497" y="39"/>
                </a:lnTo>
                <a:lnTo>
                  <a:pt x="2498" y="38"/>
                </a:lnTo>
                <a:lnTo>
                  <a:pt x="2498" y="38"/>
                </a:lnTo>
                <a:lnTo>
                  <a:pt x="2499" y="36"/>
                </a:lnTo>
                <a:lnTo>
                  <a:pt x="2500" y="37"/>
                </a:lnTo>
                <a:lnTo>
                  <a:pt x="2501" y="36"/>
                </a:lnTo>
                <a:lnTo>
                  <a:pt x="2502" y="37"/>
                </a:lnTo>
                <a:lnTo>
                  <a:pt x="2503" y="36"/>
                </a:lnTo>
                <a:lnTo>
                  <a:pt x="2504" y="38"/>
                </a:lnTo>
                <a:lnTo>
                  <a:pt x="2505" y="38"/>
                </a:lnTo>
                <a:lnTo>
                  <a:pt x="2506" y="40"/>
                </a:lnTo>
                <a:lnTo>
                  <a:pt x="2506" y="42"/>
                </a:lnTo>
                <a:lnTo>
                  <a:pt x="2507" y="44"/>
                </a:lnTo>
                <a:lnTo>
                  <a:pt x="2508" y="48"/>
                </a:lnTo>
                <a:lnTo>
                  <a:pt x="2509" y="56"/>
                </a:lnTo>
                <a:lnTo>
                  <a:pt x="2510" y="62"/>
                </a:lnTo>
                <a:lnTo>
                  <a:pt x="2511" y="74"/>
                </a:lnTo>
                <a:lnTo>
                  <a:pt x="2512" y="88"/>
                </a:lnTo>
                <a:lnTo>
                  <a:pt x="2513" y="106"/>
                </a:lnTo>
                <a:lnTo>
                  <a:pt x="2513" y="125"/>
                </a:lnTo>
                <a:lnTo>
                  <a:pt x="2514" y="149"/>
                </a:lnTo>
                <a:lnTo>
                  <a:pt x="2515" y="166"/>
                </a:lnTo>
                <a:lnTo>
                  <a:pt x="2516" y="188"/>
                </a:lnTo>
                <a:lnTo>
                  <a:pt x="2517" y="193"/>
                </a:lnTo>
                <a:lnTo>
                  <a:pt x="2518" y="201"/>
                </a:lnTo>
                <a:lnTo>
                  <a:pt x="2519" y="203"/>
                </a:lnTo>
                <a:lnTo>
                  <a:pt x="2520" y="196"/>
                </a:lnTo>
                <a:lnTo>
                  <a:pt x="2521" y="183"/>
                </a:lnTo>
                <a:lnTo>
                  <a:pt x="2521" y="166"/>
                </a:lnTo>
                <a:lnTo>
                  <a:pt x="2522" y="149"/>
                </a:lnTo>
                <a:lnTo>
                  <a:pt x="2523" y="133"/>
                </a:lnTo>
                <a:lnTo>
                  <a:pt x="2524" y="113"/>
                </a:lnTo>
                <a:lnTo>
                  <a:pt x="2525" y="105"/>
                </a:lnTo>
                <a:lnTo>
                  <a:pt x="2526" y="97"/>
                </a:lnTo>
                <a:lnTo>
                  <a:pt x="2527" y="89"/>
                </a:lnTo>
                <a:lnTo>
                  <a:pt x="2528" y="82"/>
                </a:lnTo>
                <a:lnTo>
                  <a:pt x="2528" y="75"/>
                </a:lnTo>
                <a:lnTo>
                  <a:pt x="2529" y="75"/>
                </a:lnTo>
                <a:lnTo>
                  <a:pt x="2530" y="68"/>
                </a:lnTo>
                <a:lnTo>
                  <a:pt x="2531" y="71"/>
                </a:lnTo>
                <a:lnTo>
                  <a:pt x="2532" y="68"/>
                </a:lnTo>
                <a:lnTo>
                  <a:pt x="2533" y="69"/>
                </a:lnTo>
                <a:lnTo>
                  <a:pt x="2534" y="68"/>
                </a:lnTo>
                <a:lnTo>
                  <a:pt x="2535" y="71"/>
                </a:lnTo>
                <a:lnTo>
                  <a:pt x="2536" y="75"/>
                </a:lnTo>
                <a:lnTo>
                  <a:pt x="2536" y="76"/>
                </a:lnTo>
                <a:lnTo>
                  <a:pt x="2537" y="75"/>
                </a:lnTo>
                <a:lnTo>
                  <a:pt x="2538" y="73"/>
                </a:lnTo>
                <a:lnTo>
                  <a:pt x="2539" y="75"/>
                </a:lnTo>
                <a:lnTo>
                  <a:pt x="2540" y="75"/>
                </a:lnTo>
                <a:lnTo>
                  <a:pt x="2541" y="72"/>
                </a:lnTo>
                <a:lnTo>
                  <a:pt x="2542" y="70"/>
                </a:lnTo>
                <a:lnTo>
                  <a:pt x="2543" y="68"/>
                </a:lnTo>
                <a:lnTo>
                  <a:pt x="2543" y="67"/>
                </a:lnTo>
                <a:lnTo>
                  <a:pt x="2544" y="63"/>
                </a:lnTo>
                <a:lnTo>
                  <a:pt x="2545" y="60"/>
                </a:lnTo>
                <a:lnTo>
                  <a:pt x="2546" y="57"/>
                </a:lnTo>
                <a:lnTo>
                  <a:pt x="2547" y="57"/>
                </a:lnTo>
                <a:lnTo>
                  <a:pt x="2548" y="55"/>
                </a:lnTo>
                <a:lnTo>
                  <a:pt x="2549" y="51"/>
                </a:lnTo>
                <a:lnTo>
                  <a:pt x="2550" y="50"/>
                </a:lnTo>
                <a:lnTo>
                  <a:pt x="2551" y="47"/>
                </a:lnTo>
                <a:lnTo>
                  <a:pt x="2551" y="45"/>
                </a:lnTo>
                <a:lnTo>
                  <a:pt x="2552" y="45"/>
                </a:lnTo>
                <a:lnTo>
                  <a:pt x="2553" y="44"/>
                </a:lnTo>
                <a:lnTo>
                  <a:pt x="2554" y="42"/>
                </a:lnTo>
                <a:lnTo>
                  <a:pt x="2555" y="42"/>
                </a:lnTo>
                <a:lnTo>
                  <a:pt x="2556" y="40"/>
                </a:lnTo>
                <a:lnTo>
                  <a:pt x="2557" y="39"/>
                </a:lnTo>
                <a:lnTo>
                  <a:pt x="2558" y="40"/>
                </a:lnTo>
                <a:lnTo>
                  <a:pt x="2558" y="38"/>
                </a:lnTo>
                <a:lnTo>
                  <a:pt x="2559" y="36"/>
                </a:lnTo>
                <a:lnTo>
                  <a:pt x="2560" y="36"/>
                </a:lnTo>
                <a:lnTo>
                  <a:pt x="2561" y="35"/>
                </a:lnTo>
                <a:lnTo>
                  <a:pt x="2562" y="34"/>
                </a:lnTo>
                <a:lnTo>
                  <a:pt x="2563" y="34"/>
                </a:lnTo>
                <a:lnTo>
                  <a:pt x="2564" y="34"/>
                </a:lnTo>
                <a:lnTo>
                  <a:pt x="2565" y="35"/>
                </a:lnTo>
                <a:lnTo>
                  <a:pt x="2565" y="35"/>
                </a:lnTo>
                <a:lnTo>
                  <a:pt x="2566" y="34"/>
                </a:lnTo>
                <a:lnTo>
                  <a:pt x="2567" y="34"/>
                </a:lnTo>
                <a:lnTo>
                  <a:pt x="2568" y="34"/>
                </a:lnTo>
                <a:lnTo>
                  <a:pt x="2569" y="34"/>
                </a:lnTo>
                <a:lnTo>
                  <a:pt x="2570" y="39"/>
                </a:lnTo>
                <a:lnTo>
                  <a:pt x="2571" y="39"/>
                </a:lnTo>
                <a:lnTo>
                  <a:pt x="2572" y="44"/>
                </a:lnTo>
                <a:lnTo>
                  <a:pt x="2573" y="45"/>
                </a:lnTo>
                <a:lnTo>
                  <a:pt x="2573" y="49"/>
                </a:lnTo>
                <a:lnTo>
                  <a:pt x="2574" y="52"/>
                </a:lnTo>
                <a:lnTo>
                  <a:pt x="2575" y="55"/>
                </a:lnTo>
                <a:lnTo>
                  <a:pt x="2576" y="54"/>
                </a:lnTo>
                <a:lnTo>
                  <a:pt x="2577" y="56"/>
                </a:lnTo>
                <a:lnTo>
                  <a:pt x="2578" y="56"/>
                </a:lnTo>
                <a:lnTo>
                  <a:pt x="2579" y="56"/>
                </a:lnTo>
                <a:lnTo>
                  <a:pt x="2580" y="55"/>
                </a:lnTo>
                <a:lnTo>
                  <a:pt x="2580" y="56"/>
                </a:lnTo>
                <a:lnTo>
                  <a:pt x="2581" y="52"/>
                </a:lnTo>
                <a:lnTo>
                  <a:pt x="2582" y="52"/>
                </a:lnTo>
                <a:lnTo>
                  <a:pt x="2583" y="52"/>
                </a:lnTo>
                <a:lnTo>
                  <a:pt x="2584" y="52"/>
                </a:lnTo>
                <a:lnTo>
                  <a:pt x="2585" y="50"/>
                </a:lnTo>
                <a:lnTo>
                  <a:pt x="2586" y="48"/>
                </a:lnTo>
                <a:lnTo>
                  <a:pt x="2587" y="45"/>
                </a:lnTo>
                <a:lnTo>
                  <a:pt x="2588" y="43"/>
                </a:lnTo>
                <a:lnTo>
                  <a:pt x="2588" y="41"/>
                </a:lnTo>
                <a:lnTo>
                  <a:pt x="2589" y="39"/>
                </a:lnTo>
                <a:lnTo>
                  <a:pt x="2590" y="38"/>
                </a:lnTo>
                <a:lnTo>
                  <a:pt x="2591" y="34"/>
                </a:lnTo>
                <a:lnTo>
                  <a:pt x="2592" y="36"/>
                </a:lnTo>
                <a:lnTo>
                  <a:pt x="2593" y="32"/>
                </a:lnTo>
                <a:lnTo>
                  <a:pt x="2594" y="32"/>
                </a:lnTo>
                <a:lnTo>
                  <a:pt x="2595" y="31"/>
                </a:lnTo>
                <a:lnTo>
                  <a:pt x="2595" y="31"/>
                </a:lnTo>
                <a:lnTo>
                  <a:pt x="2596" y="28"/>
                </a:lnTo>
                <a:lnTo>
                  <a:pt x="2597" y="29"/>
                </a:lnTo>
                <a:lnTo>
                  <a:pt x="2598" y="29"/>
                </a:lnTo>
                <a:lnTo>
                  <a:pt x="2599" y="28"/>
                </a:lnTo>
                <a:lnTo>
                  <a:pt x="2600" y="28"/>
                </a:lnTo>
                <a:lnTo>
                  <a:pt x="2601" y="29"/>
                </a:lnTo>
                <a:lnTo>
                  <a:pt x="2602" y="27"/>
                </a:lnTo>
                <a:lnTo>
                  <a:pt x="2603" y="27"/>
                </a:lnTo>
                <a:lnTo>
                  <a:pt x="2603" y="28"/>
                </a:lnTo>
                <a:lnTo>
                  <a:pt x="2604" y="28"/>
                </a:lnTo>
                <a:lnTo>
                  <a:pt x="2605" y="28"/>
                </a:lnTo>
                <a:lnTo>
                  <a:pt x="2606" y="28"/>
                </a:lnTo>
                <a:lnTo>
                  <a:pt x="2607" y="29"/>
                </a:lnTo>
                <a:lnTo>
                  <a:pt x="2608" y="28"/>
                </a:lnTo>
                <a:lnTo>
                  <a:pt x="2609" y="26"/>
                </a:lnTo>
                <a:lnTo>
                  <a:pt x="2610" y="26"/>
                </a:lnTo>
                <a:lnTo>
                  <a:pt x="2610" y="27"/>
                </a:lnTo>
                <a:lnTo>
                  <a:pt x="2611" y="26"/>
                </a:lnTo>
                <a:lnTo>
                  <a:pt x="2612" y="26"/>
                </a:lnTo>
                <a:lnTo>
                  <a:pt x="2613" y="25"/>
                </a:lnTo>
                <a:lnTo>
                  <a:pt x="2614" y="25"/>
                </a:lnTo>
                <a:lnTo>
                  <a:pt x="2615" y="25"/>
                </a:lnTo>
                <a:lnTo>
                  <a:pt x="2616" y="24"/>
                </a:lnTo>
                <a:lnTo>
                  <a:pt x="2617" y="23"/>
                </a:lnTo>
                <a:lnTo>
                  <a:pt x="2618" y="25"/>
                </a:lnTo>
                <a:lnTo>
                  <a:pt x="2618" y="23"/>
                </a:lnTo>
                <a:lnTo>
                  <a:pt x="2619" y="23"/>
                </a:lnTo>
                <a:lnTo>
                  <a:pt x="2620" y="22"/>
                </a:lnTo>
                <a:lnTo>
                  <a:pt x="2621" y="23"/>
                </a:lnTo>
                <a:lnTo>
                  <a:pt x="2622" y="23"/>
                </a:lnTo>
                <a:lnTo>
                  <a:pt x="2623" y="22"/>
                </a:lnTo>
                <a:lnTo>
                  <a:pt x="2624" y="22"/>
                </a:lnTo>
                <a:lnTo>
                  <a:pt x="2625" y="22"/>
                </a:lnTo>
                <a:lnTo>
                  <a:pt x="2625" y="22"/>
                </a:lnTo>
                <a:lnTo>
                  <a:pt x="2626" y="24"/>
                </a:lnTo>
                <a:lnTo>
                  <a:pt x="2627" y="24"/>
                </a:lnTo>
                <a:lnTo>
                  <a:pt x="2628" y="23"/>
                </a:lnTo>
                <a:lnTo>
                  <a:pt x="2629" y="26"/>
                </a:lnTo>
                <a:lnTo>
                  <a:pt x="2630" y="24"/>
                </a:lnTo>
                <a:lnTo>
                  <a:pt x="2631" y="26"/>
                </a:lnTo>
                <a:lnTo>
                  <a:pt x="2632" y="24"/>
                </a:lnTo>
                <a:lnTo>
                  <a:pt x="2633" y="25"/>
                </a:lnTo>
                <a:lnTo>
                  <a:pt x="2633" y="23"/>
                </a:lnTo>
                <a:lnTo>
                  <a:pt x="2634" y="25"/>
                </a:lnTo>
                <a:lnTo>
                  <a:pt x="2635" y="25"/>
                </a:lnTo>
                <a:lnTo>
                  <a:pt x="2636" y="24"/>
                </a:lnTo>
                <a:lnTo>
                  <a:pt x="2637" y="24"/>
                </a:lnTo>
                <a:lnTo>
                  <a:pt x="2638" y="22"/>
                </a:lnTo>
                <a:lnTo>
                  <a:pt x="2639" y="23"/>
                </a:lnTo>
                <a:lnTo>
                  <a:pt x="2640" y="24"/>
                </a:lnTo>
                <a:lnTo>
                  <a:pt x="2640" y="22"/>
                </a:lnTo>
                <a:lnTo>
                  <a:pt x="2641" y="23"/>
                </a:lnTo>
                <a:lnTo>
                  <a:pt x="2642" y="23"/>
                </a:lnTo>
                <a:lnTo>
                  <a:pt x="2643" y="27"/>
                </a:lnTo>
                <a:lnTo>
                  <a:pt x="2644" y="26"/>
                </a:lnTo>
                <a:lnTo>
                  <a:pt x="2645" y="26"/>
                </a:lnTo>
                <a:lnTo>
                  <a:pt x="2646" y="28"/>
                </a:lnTo>
                <a:lnTo>
                  <a:pt x="2647" y="30"/>
                </a:lnTo>
                <a:lnTo>
                  <a:pt x="2648" y="30"/>
                </a:lnTo>
                <a:lnTo>
                  <a:pt x="2648" y="32"/>
                </a:lnTo>
                <a:lnTo>
                  <a:pt x="2649" y="33"/>
                </a:lnTo>
                <a:lnTo>
                  <a:pt x="2650" y="33"/>
                </a:lnTo>
                <a:lnTo>
                  <a:pt x="2651" y="32"/>
                </a:lnTo>
                <a:lnTo>
                  <a:pt x="2652" y="30"/>
                </a:lnTo>
                <a:lnTo>
                  <a:pt x="2653" y="30"/>
                </a:lnTo>
                <a:lnTo>
                  <a:pt x="2654" y="29"/>
                </a:lnTo>
                <a:lnTo>
                  <a:pt x="2655" y="26"/>
                </a:lnTo>
                <a:lnTo>
                  <a:pt x="2655" y="26"/>
                </a:lnTo>
                <a:lnTo>
                  <a:pt x="2656" y="24"/>
                </a:lnTo>
                <a:lnTo>
                  <a:pt x="2657" y="22"/>
                </a:lnTo>
                <a:lnTo>
                  <a:pt x="2658" y="21"/>
                </a:lnTo>
                <a:lnTo>
                  <a:pt x="2659" y="21"/>
                </a:lnTo>
                <a:lnTo>
                  <a:pt x="2660" y="19"/>
                </a:lnTo>
                <a:lnTo>
                  <a:pt x="2661" y="20"/>
                </a:lnTo>
                <a:lnTo>
                  <a:pt x="2662" y="20"/>
                </a:lnTo>
                <a:lnTo>
                  <a:pt x="2663" y="20"/>
                </a:lnTo>
                <a:lnTo>
                  <a:pt x="2663" y="18"/>
                </a:lnTo>
                <a:lnTo>
                  <a:pt x="2664" y="19"/>
                </a:lnTo>
                <a:lnTo>
                  <a:pt x="2665" y="17"/>
                </a:lnTo>
                <a:lnTo>
                  <a:pt x="2666" y="19"/>
                </a:lnTo>
                <a:lnTo>
                  <a:pt x="2667" y="19"/>
                </a:lnTo>
                <a:lnTo>
                  <a:pt x="2668" y="18"/>
                </a:lnTo>
                <a:lnTo>
                  <a:pt x="2669" y="19"/>
                </a:lnTo>
                <a:lnTo>
                  <a:pt x="2670" y="17"/>
                </a:lnTo>
                <a:lnTo>
                  <a:pt x="2670" y="18"/>
                </a:lnTo>
                <a:lnTo>
                  <a:pt x="2671" y="18"/>
                </a:lnTo>
                <a:lnTo>
                  <a:pt x="2672" y="17"/>
                </a:lnTo>
                <a:lnTo>
                  <a:pt x="2673" y="17"/>
                </a:lnTo>
                <a:lnTo>
                  <a:pt x="2674" y="18"/>
                </a:lnTo>
                <a:lnTo>
                  <a:pt x="2675" y="17"/>
                </a:lnTo>
                <a:lnTo>
                  <a:pt x="2676" y="17"/>
                </a:lnTo>
                <a:lnTo>
                  <a:pt x="2677" y="16"/>
                </a:lnTo>
                <a:lnTo>
                  <a:pt x="2678" y="19"/>
                </a:lnTo>
                <a:lnTo>
                  <a:pt x="2678" y="17"/>
                </a:lnTo>
                <a:lnTo>
                  <a:pt x="2679" y="18"/>
                </a:lnTo>
                <a:lnTo>
                  <a:pt x="2680" y="19"/>
                </a:lnTo>
                <a:lnTo>
                  <a:pt x="2681" y="18"/>
                </a:lnTo>
                <a:lnTo>
                  <a:pt x="2682" y="21"/>
                </a:lnTo>
                <a:lnTo>
                  <a:pt x="2683" y="19"/>
                </a:lnTo>
                <a:lnTo>
                  <a:pt x="2684" y="20"/>
                </a:lnTo>
                <a:lnTo>
                  <a:pt x="2685" y="19"/>
                </a:lnTo>
                <a:lnTo>
                  <a:pt x="2685" y="20"/>
                </a:lnTo>
                <a:lnTo>
                  <a:pt x="2686" y="19"/>
                </a:lnTo>
                <a:lnTo>
                  <a:pt x="2687" y="19"/>
                </a:lnTo>
                <a:lnTo>
                  <a:pt x="2688" y="18"/>
                </a:lnTo>
                <a:lnTo>
                  <a:pt x="2689" y="18"/>
                </a:lnTo>
                <a:lnTo>
                  <a:pt x="2690" y="17"/>
                </a:lnTo>
                <a:lnTo>
                  <a:pt x="2691" y="19"/>
                </a:lnTo>
                <a:lnTo>
                  <a:pt x="2692" y="17"/>
                </a:lnTo>
                <a:lnTo>
                  <a:pt x="2693" y="17"/>
                </a:lnTo>
                <a:lnTo>
                  <a:pt x="2693" y="17"/>
                </a:lnTo>
                <a:lnTo>
                  <a:pt x="2694" y="17"/>
                </a:lnTo>
                <a:lnTo>
                  <a:pt x="2695" y="18"/>
                </a:lnTo>
                <a:lnTo>
                  <a:pt x="2696" y="18"/>
                </a:lnTo>
                <a:lnTo>
                  <a:pt x="2697" y="17"/>
                </a:lnTo>
                <a:lnTo>
                  <a:pt x="2698" y="18"/>
                </a:lnTo>
                <a:lnTo>
                  <a:pt x="2699" y="17"/>
                </a:lnTo>
                <a:lnTo>
                  <a:pt x="2700" y="18"/>
                </a:lnTo>
                <a:lnTo>
                  <a:pt x="2700" y="18"/>
                </a:lnTo>
                <a:lnTo>
                  <a:pt x="2701" y="18"/>
                </a:lnTo>
                <a:lnTo>
                  <a:pt x="2702" y="18"/>
                </a:lnTo>
                <a:lnTo>
                  <a:pt x="2703" y="19"/>
                </a:lnTo>
                <a:lnTo>
                  <a:pt x="2704" y="19"/>
                </a:lnTo>
                <a:lnTo>
                  <a:pt x="2705" y="18"/>
                </a:lnTo>
                <a:lnTo>
                  <a:pt x="2706" y="19"/>
                </a:lnTo>
                <a:lnTo>
                  <a:pt x="2707" y="20"/>
                </a:lnTo>
                <a:lnTo>
                  <a:pt x="2708" y="19"/>
                </a:lnTo>
                <a:lnTo>
                  <a:pt x="2708" y="19"/>
                </a:lnTo>
                <a:lnTo>
                  <a:pt x="2709" y="17"/>
                </a:lnTo>
                <a:lnTo>
                  <a:pt x="2710" y="20"/>
                </a:lnTo>
                <a:lnTo>
                  <a:pt x="2711" y="19"/>
                </a:lnTo>
                <a:lnTo>
                  <a:pt x="2712" y="17"/>
                </a:lnTo>
                <a:lnTo>
                  <a:pt x="2713" y="19"/>
                </a:lnTo>
                <a:lnTo>
                  <a:pt x="2714" y="19"/>
                </a:lnTo>
                <a:lnTo>
                  <a:pt x="2715" y="19"/>
                </a:lnTo>
                <a:lnTo>
                  <a:pt x="2715" y="18"/>
                </a:lnTo>
                <a:lnTo>
                  <a:pt x="2716" y="19"/>
                </a:lnTo>
                <a:lnTo>
                  <a:pt x="2717" y="20"/>
                </a:lnTo>
                <a:lnTo>
                  <a:pt x="2718" y="18"/>
                </a:lnTo>
                <a:lnTo>
                  <a:pt x="2719" y="20"/>
                </a:lnTo>
                <a:lnTo>
                  <a:pt x="2720" y="18"/>
                </a:lnTo>
                <a:lnTo>
                  <a:pt x="2721" y="18"/>
                </a:lnTo>
                <a:lnTo>
                  <a:pt x="2722" y="17"/>
                </a:lnTo>
                <a:lnTo>
                  <a:pt x="2723" y="18"/>
                </a:lnTo>
                <a:lnTo>
                  <a:pt x="2723" y="17"/>
                </a:lnTo>
                <a:lnTo>
                  <a:pt x="2724" y="19"/>
                </a:lnTo>
                <a:lnTo>
                  <a:pt x="2725" y="18"/>
                </a:lnTo>
                <a:lnTo>
                  <a:pt x="2726" y="18"/>
                </a:lnTo>
                <a:lnTo>
                  <a:pt x="2727" y="18"/>
                </a:lnTo>
                <a:lnTo>
                  <a:pt x="2728" y="18"/>
                </a:lnTo>
                <a:lnTo>
                  <a:pt x="2729" y="18"/>
                </a:lnTo>
                <a:lnTo>
                  <a:pt x="2730" y="17"/>
                </a:lnTo>
                <a:lnTo>
                  <a:pt x="2730" y="16"/>
                </a:lnTo>
                <a:lnTo>
                  <a:pt x="2731" y="17"/>
                </a:lnTo>
                <a:lnTo>
                  <a:pt x="2732" y="17"/>
                </a:lnTo>
                <a:lnTo>
                  <a:pt x="2733" y="17"/>
                </a:lnTo>
                <a:lnTo>
                  <a:pt x="2734" y="19"/>
                </a:lnTo>
                <a:lnTo>
                  <a:pt x="2735" y="17"/>
                </a:lnTo>
                <a:lnTo>
                  <a:pt x="2736" y="15"/>
                </a:lnTo>
                <a:lnTo>
                  <a:pt x="2737" y="18"/>
                </a:lnTo>
                <a:lnTo>
                  <a:pt x="2738" y="17"/>
                </a:lnTo>
                <a:lnTo>
                  <a:pt x="2738" y="16"/>
                </a:lnTo>
                <a:lnTo>
                  <a:pt x="2739" y="16"/>
                </a:lnTo>
                <a:lnTo>
                  <a:pt x="2740" y="17"/>
                </a:lnTo>
                <a:lnTo>
                  <a:pt x="2741" y="18"/>
                </a:lnTo>
                <a:lnTo>
                  <a:pt x="2742" y="18"/>
                </a:lnTo>
                <a:lnTo>
                  <a:pt x="2743" y="18"/>
                </a:lnTo>
                <a:lnTo>
                  <a:pt x="2744" y="17"/>
                </a:lnTo>
                <a:lnTo>
                  <a:pt x="2745" y="17"/>
                </a:lnTo>
                <a:lnTo>
                  <a:pt x="2745" y="18"/>
                </a:lnTo>
                <a:lnTo>
                  <a:pt x="2746" y="19"/>
                </a:lnTo>
                <a:lnTo>
                  <a:pt x="2747" y="18"/>
                </a:lnTo>
                <a:lnTo>
                  <a:pt x="2748" y="16"/>
                </a:lnTo>
                <a:lnTo>
                  <a:pt x="2749" y="17"/>
                </a:lnTo>
                <a:lnTo>
                  <a:pt x="2750" y="18"/>
                </a:lnTo>
                <a:lnTo>
                  <a:pt x="2751" y="17"/>
                </a:lnTo>
                <a:lnTo>
                  <a:pt x="2752" y="17"/>
                </a:lnTo>
                <a:lnTo>
                  <a:pt x="2753" y="15"/>
                </a:lnTo>
                <a:lnTo>
                  <a:pt x="2753" y="16"/>
                </a:lnTo>
                <a:lnTo>
                  <a:pt x="2754" y="16"/>
                </a:lnTo>
                <a:lnTo>
                  <a:pt x="2755" y="17"/>
                </a:lnTo>
                <a:lnTo>
                  <a:pt x="2756" y="17"/>
                </a:lnTo>
                <a:lnTo>
                  <a:pt x="2757" y="15"/>
                </a:lnTo>
                <a:lnTo>
                  <a:pt x="2758" y="15"/>
                </a:lnTo>
                <a:lnTo>
                  <a:pt x="2759" y="16"/>
                </a:lnTo>
                <a:lnTo>
                  <a:pt x="2760" y="16"/>
                </a:lnTo>
                <a:lnTo>
                  <a:pt x="2760" y="16"/>
                </a:lnTo>
                <a:lnTo>
                  <a:pt x="2761" y="15"/>
                </a:lnTo>
                <a:lnTo>
                  <a:pt x="2762" y="17"/>
                </a:lnTo>
                <a:lnTo>
                  <a:pt x="2763" y="16"/>
                </a:lnTo>
                <a:lnTo>
                  <a:pt x="2764" y="17"/>
                </a:lnTo>
                <a:lnTo>
                  <a:pt x="2765" y="15"/>
                </a:lnTo>
                <a:lnTo>
                  <a:pt x="2766" y="17"/>
                </a:lnTo>
                <a:lnTo>
                  <a:pt x="2767" y="17"/>
                </a:lnTo>
                <a:lnTo>
                  <a:pt x="2767" y="18"/>
                </a:lnTo>
                <a:lnTo>
                  <a:pt x="2768" y="15"/>
                </a:lnTo>
                <a:lnTo>
                  <a:pt x="2769" y="16"/>
                </a:lnTo>
                <a:lnTo>
                  <a:pt x="2770" y="15"/>
                </a:lnTo>
                <a:lnTo>
                  <a:pt x="2771" y="16"/>
                </a:lnTo>
                <a:lnTo>
                  <a:pt x="2772" y="16"/>
                </a:lnTo>
                <a:lnTo>
                  <a:pt x="2773" y="15"/>
                </a:lnTo>
                <a:lnTo>
                  <a:pt x="2774" y="17"/>
                </a:lnTo>
                <a:lnTo>
                  <a:pt x="2775" y="17"/>
                </a:lnTo>
                <a:lnTo>
                  <a:pt x="2775" y="15"/>
                </a:lnTo>
                <a:lnTo>
                  <a:pt x="2776" y="16"/>
                </a:lnTo>
                <a:lnTo>
                  <a:pt x="2777" y="16"/>
                </a:lnTo>
                <a:lnTo>
                  <a:pt x="2778" y="16"/>
                </a:lnTo>
                <a:lnTo>
                  <a:pt x="2779" y="15"/>
                </a:lnTo>
                <a:lnTo>
                  <a:pt x="2780" y="14"/>
                </a:lnTo>
                <a:lnTo>
                  <a:pt x="2781" y="14"/>
                </a:lnTo>
                <a:lnTo>
                  <a:pt x="2782" y="15"/>
                </a:lnTo>
                <a:lnTo>
                  <a:pt x="2782" y="15"/>
                </a:lnTo>
                <a:lnTo>
                  <a:pt x="2783" y="13"/>
                </a:lnTo>
                <a:lnTo>
                  <a:pt x="2784" y="14"/>
                </a:lnTo>
                <a:lnTo>
                  <a:pt x="2785" y="13"/>
                </a:lnTo>
                <a:lnTo>
                  <a:pt x="2786" y="14"/>
                </a:lnTo>
                <a:lnTo>
                  <a:pt x="2787" y="14"/>
                </a:lnTo>
                <a:lnTo>
                  <a:pt x="2788" y="15"/>
                </a:lnTo>
                <a:lnTo>
                  <a:pt x="2789" y="14"/>
                </a:lnTo>
                <a:lnTo>
                  <a:pt x="2790" y="14"/>
                </a:lnTo>
                <a:lnTo>
                  <a:pt x="2790" y="13"/>
                </a:lnTo>
                <a:lnTo>
                  <a:pt x="2791" y="15"/>
                </a:lnTo>
                <a:lnTo>
                  <a:pt x="2792" y="15"/>
                </a:lnTo>
                <a:lnTo>
                  <a:pt x="2793" y="14"/>
                </a:lnTo>
                <a:lnTo>
                  <a:pt x="2794" y="15"/>
                </a:lnTo>
                <a:lnTo>
                  <a:pt x="2795" y="16"/>
                </a:lnTo>
                <a:lnTo>
                  <a:pt x="2796" y="15"/>
                </a:lnTo>
                <a:lnTo>
                  <a:pt x="2797" y="15"/>
                </a:lnTo>
                <a:lnTo>
                  <a:pt x="2797" y="16"/>
                </a:lnTo>
                <a:lnTo>
                  <a:pt x="2798" y="15"/>
                </a:lnTo>
                <a:lnTo>
                  <a:pt x="2799" y="16"/>
                </a:lnTo>
                <a:lnTo>
                  <a:pt x="2800" y="17"/>
                </a:lnTo>
                <a:lnTo>
                  <a:pt x="2801" y="17"/>
                </a:lnTo>
                <a:lnTo>
                  <a:pt x="2802" y="17"/>
                </a:lnTo>
                <a:lnTo>
                  <a:pt x="2803" y="17"/>
                </a:lnTo>
                <a:lnTo>
                  <a:pt x="2804" y="18"/>
                </a:lnTo>
                <a:lnTo>
                  <a:pt x="2805" y="17"/>
                </a:lnTo>
                <a:lnTo>
                  <a:pt x="2805" y="18"/>
                </a:lnTo>
                <a:lnTo>
                  <a:pt x="2806" y="18"/>
                </a:lnTo>
                <a:lnTo>
                  <a:pt x="2807" y="18"/>
                </a:lnTo>
                <a:lnTo>
                  <a:pt x="2808" y="19"/>
                </a:lnTo>
                <a:lnTo>
                  <a:pt x="2809" y="19"/>
                </a:lnTo>
                <a:lnTo>
                  <a:pt x="2810" y="22"/>
                </a:lnTo>
                <a:lnTo>
                  <a:pt x="2811" y="21"/>
                </a:lnTo>
                <a:lnTo>
                  <a:pt x="2812" y="23"/>
                </a:lnTo>
                <a:lnTo>
                  <a:pt x="2812" y="24"/>
                </a:lnTo>
                <a:lnTo>
                  <a:pt x="2813" y="24"/>
                </a:lnTo>
                <a:lnTo>
                  <a:pt x="2814" y="23"/>
                </a:lnTo>
                <a:lnTo>
                  <a:pt x="2815" y="25"/>
                </a:lnTo>
                <a:lnTo>
                  <a:pt x="2816" y="25"/>
                </a:lnTo>
                <a:lnTo>
                  <a:pt x="2817" y="23"/>
                </a:lnTo>
                <a:lnTo>
                  <a:pt x="2818" y="22"/>
                </a:lnTo>
                <a:lnTo>
                  <a:pt x="2819" y="24"/>
                </a:lnTo>
                <a:lnTo>
                  <a:pt x="2820" y="22"/>
                </a:lnTo>
                <a:lnTo>
                  <a:pt x="2820" y="23"/>
                </a:lnTo>
                <a:lnTo>
                  <a:pt x="2821" y="21"/>
                </a:lnTo>
                <a:lnTo>
                  <a:pt x="2822" y="21"/>
                </a:lnTo>
                <a:lnTo>
                  <a:pt x="2823" y="21"/>
                </a:lnTo>
                <a:lnTo>
                  <a:pt x="2824" y="19"/>
                </a:lnTo>
                <a:lnTo>
                  <a:pt x="2825" y="21"/>
                </a:lnTo>
                <a:lnTo>
                  <a:pt x="2826" y="21"/>
                </a:lnTo>
                <a:lnTo>
                  <a:pt x="2827" y="18"/>
                </a:lnTo>
                <a:lnTo>
                  <a:pt x="2827" y="20"/>
                </a:lnTo>
                <a:lnTo>
                  <a:pt x="2828" y="19"/>
                </a:lnTo>
                <a:lnTo>
                  <a:pt x="2829" y="18"/>
                </a:lnTo>
                <a:lnTo>
                  <a:pt x="2830" y="20"/>
                </a:lnTo>
                <a:lnTo>
                  <a:pt x="2831" y="20"/>
                </a:lnTo>
                <a:lnTo>
                  <a:pt x="2832" y="19"/>
                </a:lnTo>
                <a:lnTo>
                  <a:pt x="2833" y="17"/>
                </a:lnTo>
                <a:lnTo>
                  <a:pt x="2834" y="17"/>
                </a:lnTo>
                <a:lnTo>
                  <a:pt x="2835" y="18"/>
                </a:lnTo>
                <a:lnTo>
                  <a:pt x="2835" y="18"/>
                </a:lnTo>
                <a:lnTo>
                  <a:pt x="2836" y="17"/>
                </a:lnTo>
                <a:lnTo>
                  <a:pt x="2837" y="17"/>
                </a:lnTo>
                <a:lnTo>
                  <a:pt x="2838" y="15"/>
                </a:lnTo>
                <a:lnTo>
                  <a:pt x="2839" y="16"/>
                </a:lnTo>
                <a:lnTo>
                  <a:pt x="2840" y="15"/>
                </a:lnTo>
                <a:lnTo>
                  <a:pt x="2841" y="18"/>
                </a:lnTo>
                <a:lnTo>
                  <a:pt x="2842" y="16"/>
                </a:lnTo>
                <a:lnTo>
                  <a:pt x="2842" y="15"/>
                </a:lnTo>
                <a:lnTo>
                  <a:pt x="2843" y="17"/>
                </a:lnTo>
                <a:lnTo>
                  <a:pt x="2844" y="15"/>
                </a:lnTo>
                <a:lnTo>
                  <a:pt x="2845" y="14"/>
                </a:lnTo>
                <a:lnTo>
                  <a:pt x="2846" y="16"/>
                </a:lnTo>
                <a:lnTo>
                  <a:pt x="2847" y="15"/>
                </a:lnTo>
                <a:lnTo>
                  <a:pt x="2848" y="15"/>
                </a:lnTo>
                <a:lnTo>
                  <a:pt x="2849" y="16"/>
                </a:lnTo>
                <a:lnTo>
                  <a:pt x="2850" y="15"/>
                </a:lnTo>
                <a:lnTo>
                  <a:pt x="2850" y="15"/>
                </a:lnTo>
                <a:lnTo>
                  <a:pt x="2851" y="14"/>
                </a:lnTo>
                <a:lnTo>
                  <a:pt x="2852" y="15"/>
                </a:lnTo>
                <a:lnTo>
                  <a:pt x="2853" y="14"/>
                </a:lnTo>
                <a:lnTo>
                  <a:pt x="2854" y="15"/>
                </a:lnTo>
                <a:lnTo>
                  <a:pt x="2855" y="14"/>
                </a:lnTo>
                <a:lnTo>
                  <a:pt x="2856" y="14"/>
                </a:lnTo>
                <a:lnTo>
                  <a:pt x="2857" y="13"/>
                </a:lnTo>
                <a:lnTo>
                  <a:pt x="2857" y="16"/>
                </a:lnTo>
                <a:lnTo>
                  <a:pt x="2858" y="15"/>
                </a:lnTo>
                <a:lnTo>
                  <a:pt x="2859" y="14"/>
                </a:lnTo>
                <a:lnTo>
                  <a:pt x="2860" y="15"/>
                </a:lnTo>
                <a:lnTo>
                  <a:pt x="2861" y="15"/>
                </a:lnTo>
                <a:lnTo>
                  <a:pt x="2862" y="14"/>
                </a:lnTo>
                <a:lnTo>
                  <a:pt x="2863" y="14"/>
                </a:lnTo>
                <a:lnTo>
                  <a:pt x="2864" y="15"/>
                </a:lnTo>
                <a:lnTo>
                  <a:pt x="2865" y="12"/>
                </a:lnTo>
                <a:lnTo>
                  <a:pt x="2865" y="15"/>
                </a:lnTo>
                <a:lnTo>
                  <a:pt x="2866" y="13"/>
                </a:lnTo>
                <a:lnTo>
                  <a:pt x="2867" y="13"/>
                </a:lnTo>
                <a:lnTo>
                  <a:pt x="2868" y="14"/>
                </a:lnTo>
                <a:lnTo>
                  <a:pt x="2869" y="14"/>
                </a:lnTo>
                <a:lnTo>
                  <a:pt x="2870" y="14"/>
                </a:lnTo>
                <a:lnTo>
                  <a:pt x="2871" y="15"/>
                </a:lnTo>
                <a:lnTo>
                  <a:pt x="2872" y="14"/>
                </a:lnTo>
                <a:lnTo>
                  <a:pt x="2872" y="14"/>
                </a:lnTo>
                <a:lnTo>
                  <a:pt x="2873" y="14"/>
                </a:lnTo>
                <a:lnTo>
                  <a:pt x="2874" y="14"/>
                </a:lnTo>
                <a:lnTo>
                  <a:pt x="2875" y="16"/>
                </a:lnTo>
                <a:lnTo>
                  <a:pt x="2876" y="15"/>
                </a:lnTo>
                <a:lnTo>
                  <a:pt x="2877" y="16"/>
                </a:lnTo>
                <a:lnTo>
                  <a:pt x="2878" y="16"/>
                </a:lnTo>
                <a:lnTo>
                  <a:pt x="2879" y="16"/>
                </a:lnTo>
                <a:lnTo>
                  <a:pt x="2880" y="15"/>
                </a:lnTo>
                <a:lnTo>
                  <a:pt x="2880" y="16"/>
                </a:lnTo>
                <a:lnTo>
                  <a:pt x="2881" y="16"/>
                </a:lnTo>
                <a:lnTo>
                  <a:pt x="2882" y="17"/>
                </a:lnTo>
                <a:lnTo>
                  <a:pt x="2883" y="16"/>
                </a:lnTo>
                <a:lnTo>
                  <a:pt x="2884" y="16"/>
                </a:lnTo>
                <a:lnTo>
                  <a:pt x="2885" y="16"/>
                </a:lnTo>
                <a:lnTo>
                  <a:pt x="2886" y="15"/>
                </a:lnTo>
                <a:lnTo>
                  <a:pt x="2887" y="14"/>
                </a:lnTo>
                <a:lnTo>
                  <a:pt x="2887" y="16"/>
                </a:lnTo>
                <a:lnTo>
                  <a:pt x="2888" y="15"/>
                </a:lnTo>
                <a:lnTo>
                  <a:pt x="2889" y="15"/>
                </a:lnTo>
                <a:lnTo>
                  <a:pt x="2890" y="15"/>
                </a:lnTo>
                <a:lnTo>
                  <a:pt x="2891" y="15"/>
                </a:lnTo>
                <a:lnTo>
                  <a:pt x="2892" y="16"/>
                </a:lnTo>
                <a:lnTo>
                  <a:pt x="2893" y="16"/>
                </a:lnTo>
                <a:lnTo>
                  <a:pt x="2894" y="15"/>
                </a:lnTo>
                <a:lnTo>
                  <a:pt x="2895" y="16"/>
                </a:lnTo>
                <a:lnTo>
                  <a:pt x="2895" y="15"/>
                </a:lnTo>
                <a:lnTo>
                  <a:pt x="2896" y="16"/>
                </a:lnTo>
                <a:lnTo>
                  <a:pt x="2897" y="16"/>
                </a:lnTo>
                <a:lnTo>
                  <a:pt x="2898" y="14"/>
                </a:lnTo>
                <a:lnTo>
                  <a:pt x="2899" y="15"/>
                </a:lnTo>
                <a:lnTo>
                  <a:pt x="2900" y="16"/>
                </a:lnTo>
                <a:lnTo>
                  <a:pt x="2901" y="15"/>
                </a:lnTo>
                <a:lnTo>
                  <a:pt x="2902" y="14"/>
                </a:lnTo>
                <a:lnTo>
                  <a:pt x="2902" y="13"/>
                </a:lnTo>
                <a:lnTo>
                  <a:pt x="2903" y="14"/>
                </a:lnTo>
                <a:lnTo>
                  <a:pt x="2904" y="13"/>
                </a:lnTo>
                <a:lnTo>
                  <a:pt x="2905" y="14"/>
                </a:lnTo>
                <a:lnTo>
                  <a:pt x="2906" y="13"/>
                </a:lnTo>
                <a:lnTo>
                  <a:pt x="2907" y="14"/>
                </a:lnTo>
                <a:lnTo>
                  <a:pt x="2908" y="14"/>
                </a:lnTo>
                <a:lnTo>
                  <a:pt x="2909" y="13"/>
                </a:lnTo>
                <a:lnTo>
                  <a:pt x="2910" y="14"/>
                </a:lnTo>
                <a:lnTo>
                  <a:pt x="2910" y="14"/>
                </a:lnTo>
                <a:lnTo>
                  <a:pt x="2911" y="13"/>
                </a:lnTo>
                <a:lnTo>
                  <a:pt x="2912" y="13"/>
                </a:lnTo>
                <a:lnTo>
                  <a:pt x="2913" y="13"/>
                </a:lnTo>
                <a:lnTo>
                  <a:pt x="2914" y="14"/>
                </a:lnTo>
                <a:lnTo>
                  <a:pt x="2915" y="13"/>
                </a:lnTo>
                <a:lnTo>
                  <a:pt x="2916" y="14"/>
                </a:lnTo>
                <a:lnTo>
                  <a:pt x="2917" y="14"/>
                </a:lnTo>
                <a:lnTo>
                  <a:pt x="2917" y="15"/>
                </a:lnTo>
                <a:lnTo>
                  <a:pt x="2918" y="14"/>
                </a:lnTo>
                <a:lnTo>
                  <a:pt x="2919" y="14"/>
                </a:lnTo>
                <a:lnTo>
                  <a:pt x="2920" y="14"/>
                </a:lnTo>
                <a:lnTo>
                  <a:pt x="2921" y="14"/>
                </a:lnTo>
                <a:lnTo>
                  <a:pt x="2922" y="13"/>
                </a:lnTo>
                <a:lnTo>
                  <a:pt x="2923" y="12"/>
                </a:lnTo>
                <a:lnTo>
                  <a:pt x="2924" y="13"/>
                </a:lnTo>
                <a:lnTo>
                  <a:pt x="2925" y="13"/>
                </a:lnTo>
                <a:lnTo>
                  <a:pt x="2925" y="13"/>
                </a:lnTo>
                <a:lnTo>
                  <a:pt x="2926" y="14"/>
                </a:lnTo>
                <a:lnTo>
                  <a:pt x="2927" y="14"/>
                </a:lnTo>
                <a:lnTo>
                  <a:pt x="2928" y="13"/>
                </a:lnTo>
                <a:lnTo>
                  <a:pt x="2929" y="13"/>
                </a:lnTo>
                <a:lnTo>
                  <a:pt x="2930" y="13"/>
                </a:lnTo>
                <a:lnTo>
                  <a:pt x="2931" y="14"/>
                </a:lnTo>
                <a:lnTo>
                  <a:pt x="2932" y="12"/>
                </a:lnTo>
                <a:lnTo>
                  <a:pt x="2932" y="12"/>
                </a:lnTo>
                <a:lnTo>
                  <a:pt x="2933" y="13"/>
                </a:lnTo>
                <a:lnTo>
                  <a:pt x="2934" y="14"/>
                </a:lnTo>
                <a:lnTo>
                  <a:pt x="2935" y="13"/>
                </a:lnTo>
                <a:lnTo>
                  <a:pt x="2936" y="12"/>
                </a:lnTo>
                <a:lnTo>
                  <a:pt x="2937" y="12"/>
                </a:lnTo>
                <a:lnTo>
                  <a:pt x="2938" y="12"/>
                </a:lnTo>
                <a:lnTo>
                  <a:pt x="2939" y="11"/>
                </a:lnTo>
                <a:lnTo>
                  <a:pt x="2940" y="12"/>
                </a:lnTo>
                <a:lnTo>
                  <a:pt x="2940" y="12"/>
                </a:lnTo>
                <a:lnTo>
                  <a:pt x="2941" y="12"/>
                </a:lnTo>
                <a:lnTo>
                  <a:pt x="2942" y="13"/>
                </a:lnTo>
                <a:lnTo>
                  <a:pt x="2943" y="11"/>
                </a:lnTo>
                <a:lnTo>
                  <a:pt x="2944" y="13"/>
                </a:lnTo>
                <a:lnTo>
                  <a:pt x="2945" y="12"/>
                </a:lnTo>
                <a:lnTo>
                  <a:pt x="2946" y="12"/>
                </a:lnTo>
                <a:lnTo>
                  <a:pt x="2947" y="13"/>
                </a:lnTo>
                <a:lnTo>
                  <a:pt x="2947" y="13"/>
                </a:lnTo>
                <a:lnTo>
                  <a:pt x="2948" y="12"/>
                </a:lnTo>
                <a:lnTo>
                  <a:pt x="2949" y="13"/>
                </a:lnTo>
                <a:lnTo>
                  <a:pt x="2950" y="14"/>
                </a:lnTo>
                <a:lnTo>
                  <a:pt x="2951" y="12"/>
                </a:lnTo>
                <a:lnTo>
                  <a:pt x="2952" y="13"/>
                </a:lnTo>
                <a:lnTo>
                  <a:pt x="2953" y="13"/>
                </a:lnTo>
                <a:lnTo>
                  <a:pt x="2954" y="12"/>
                </a:lnTo>
                <a:lnTo>
                  <a:pt x="2954" y="14"/>
                </a:lnTo>
                <a:lnTo>
                  <a:pt x="2955" y="13"/>
                </a:lnTo>
                <a:lnTo>
                  <a:pt x="2956" y="13"/>
                </a:lnTo>
                <a:lnTo>
                  <a:pt x="2957" y="11"/>
                </a:lnTo>
                <a:lnTo>
                  <a:pt x="2958" y="11"/>
                </a:lnTo>
                <a:lnTo>
                  <a:pt x="2959" y="14"/>
                </a:lnTo>
                <a:lnTo>
                  <a:pt x="2960" y="13"/>
                </a:lnTo>
                <a:lnTo>
                  <a:pt x="2961" y="12"/>
                </a:lnTo>
                <a:lnTo>
                  <a:pt x="2962" y="14"/>
                </a:lnTo>
                <a:lnTo>
                  <a:pt x="2962" y="15"/>
                </a:lnTo>
                <a:lnTo>
                  <a:pt x="2963" y="17"/>
                </a:lnTo>
                <a:lnTo>
                  <a:pt x="2964" y="19"/>
                </a:lnTo>
                <a:lnTo>
                  <a:pt x="2965" y="22"/>
                </a:lnTo>
                <a:lnTo>
                  <a:pt x="2966" y="29"/>
                </a:lnTo>
                <a:lnTo>
                  <a:pt x="2967" y="35"/>
                </a:lnTo>
                <a:lnTo>
                  <a:pt x="2968" y="42"/>
                </a:lnTo>
                <a:lnTo>
                  <a:pt x="2969" y="54"/>
                </a:lnTo>
                <a:lnTo>
                  <a:pt x="2969" y="63"/>
                </a:lnTo>
                <a:lnTo>
                  <a:pt x="2970" y="65"/>
                </a:lnTo>
                <a:lnTo>
                  <a:pt x="2971" y="66"/>
                </a:lnTo>
                <a:lnTo>
                  <a:pt x="2972" y="69"/>
                </a:lnTo>
                <a:lnTo>
                  <a:pt x="2973" y="73"/>
                </a:lnTo>
                <a:lnTo>
                  <a:pt x="2974" y="69"/>
                </a:lnTo>
                <a:lnTo>
                  <a:pt x="2975" y="62"/>
                </a:lnTo>
                <a:lnTo>
                  <a:pt x="2976" y="56"/>
                </a:lnTo>
                <a:lnTo>
                  <a:pt x="2977" y="53"/>
                </a:lnTo>
                <a:lnTo>
                  <a:pt x="2977" y="48"/>
                </a:lnTo>
                <a:lnTo>
                  <a:pt x="2978" y="43"/>
                </a:lnTo>
                <a:lnTo>
                  <a:pt x="2979" y="40"/>
                </a:lnTo>
                <a:lnTo>
                  <a:pt x="2980" y="38"/>
                </a:lnTo>
                <a:lnTo>
                  <a:pt x="2981" y="36"/>
                </a:lnTo>
                <a:lnTo>
                  <a:pt x="2982" y="35"/>
                </a:lnTo>
                <a:lnTo>
                  <a:pt x="2983" y="33"/>
                </a:lnTo>
                <a:lnTo>
                  <a:pt x="2984" y="32"/>
                </a:lnTo>
                <a:lnTo>
                  <a:pt x="2984" y="28"/>
                </a:lnTo>
                <a:lnTo>
                  <a:pt x="2985" y="25"/>
                </a:lnTo>
                <a:lnTo>
                  <a:pt x="2986" y="26"/>
                </a:lnTo>
                <a:lnTo>
                  <a:pt x="2987" y="25"/>
                </a:lnTo>
                <a:lnTo>
                  <a:pt x="2988" y="23"/>
                </a:lnTo>
                <a:lnTo>
                  <a:pt x="2989" y="18"/>
                </a:lnTo>
                <a:lnTo>
                  <a:pt x="2990" y="19"/>
                </a:lnTo>
                <a:lnTo>
                  <a:pt x="2991" y="20"/>
                </a:lnTo>
                <a:lnTo>
                  <a:pt x="2992" y="16"/>
                </a:lnTo>
                <a:lnTo>
                  <a:pt x="2992" y="14"/>
                </a:lnTo>
                <a:lnTo>
                  <a:pt x="2993" y="16"/>
                </a:lnTo>
                <a:lnTo>
                  <a:pt x="2994" y="15"/>
                </a:lnTo>
                <a:lnTo>
                  <a:pt x="2995" y="14"/>
                </a:lnTo>
                <a:lnTo>
                  <a:pt x="2996" y="14"/>
                </a:lnTo>
                <a:lnTo>
                  <a:pt x="2997" y="14"/>
                </a:lnTo>
                <a:lnTo>
                  <a:pt x="2998" y="16"/>
                </a:lnTo>
                <a:lnTo>
                  <a:pt x="2999" y="15"/>
                </a:lnTo>
                <a:lnTo>
                  <a:pt x="2999" y="16"/>
                </a:lnTo>
                <a:lnTo>
                  <a:pt x="3000" y="16"/>
                </a:lnTo>
                <a:lnTo>
                  <a:pt x="3001" y="17"/>
                </a:lnTo>
                <a:lnTo>
                  <a:pt x="3002" y="17"/>
                </a:lnTo>
                <a:lnTo>
                  <a:pt x="3003" y="19"/>
                </a:lnTo>
                <a:lnTo>
                  <a:pt x="3004" y="19"/>
                </a:lnTo>
                <a:lnTo>
                  <a:pt x="3005" y="18"/>
                </a:lnTo>
                <a:lnTo>
                  <a:pt x="3006" y="18"/>
                </a:lnTo>
                <a:lnTo>
                  <a:pt x="3007" y="17"/>
                </a:lnTo>
                <a:lnTo>
                  <a:pt x="3007" y="17"/>
                </a:lnTo>
                <a:lnTo>
                  <a:pt x="3008" y="17"/>
                </a:lnTo>
                <a:lnTo>
                  <a:pt x="3009" y="18"/>
                </a:lnTo>
                <a:lnTo>
                  <a:pt x="3010" y="18"/>
                </a:lnTo>
                <a:lnTo>
                  <a:pt x="3011" y="17"/>
                </a:lnTo>
                <a:lnTo>
                  <a:pt x="3012" y="15"/>
                </a:lnTo>
                <a:lnTo>
                  <a:pt x="3013" y="16"/>
                </a:lnTo>
                <a:lnTo>
                  <a:pt x="3014" y="15"/>
                </a:lnTo>
                <a:lnTo>
                  <a:pt x="3014" y="15"/>
                </a:lnTo>
                <a:lnTo>
                  <a:pt x="3015" y="14"/>
                </a:lnTo>
                <a:lnTo>
                  <a:pt x="3016" y="16"/>
                </a:lnTo>
                <a:lnTo>
                  <a:pt x="3017" y="15"/>
                </a:lnTo>
                <a:lnTo>
                  <a:pt x="3018" y="16"/>
                </a:lnTo>
                <a:lnTo>
                  <a:pt x="3019" y="16"/>
                </a:lnTo>
                <a:lnTo>
                  <a:pt x="3020" y="16"/>
                </a:lnTo>
                <a:lnTo>
                  <a:pt x="3021" y="14"/>
                </a:lnTo>
                <a:lnTo>
                  <a:pt x="3022" y="14"/>
                </a:lnTo>
                <a:lnTo>
                  <a:pt x="3022" y="16"/>
                </a:lnTo>
                <a:lnTo>
                  <a:pt x="3023" y="15"/>
                </a:lnTo>
                <a:lnTo>
                  <a:pt x="3024" y="15"/>
                </a:lnTo>
                <a:lnTo>
                  <a:pt x="3025" y="15"/>
                </a:lnTo>
                <a:lnTo>
                  <a:pt x="3026" y="16"/>
                </a:lnTo>
                <a:lnTo>
                  <a:pt x="3027" y="15"/>
                </a:lnTo>
                <a:lnTo>
                  <a:pt x="3028" y="17"/>
                </a:lnTo>
                <a:lnTo>
                  <a:pt x="3029" y="17"/>
                </a:lnTo>
                <a:lnTo>
                  <a:pt x="3029" y="16"/>
                </a:lnTo>
                <a:lnTo>
                  <a:pt x="3030" y="16"/>
                </a:lnTo>
                <a:lnTo>
                  <a:pt x="3031" y="18"/>
                </a:lnTo>
                <a:lnTo>
                  <a:pt x="3032" y="18"/>
                </a:lnTo>
                <a:lnTo>
                  <a:pt x="3033" y="17"/>
                </a:lnTo>
                <a:lnTo>
                  <a:pt x="3034" y="17"/>
                </a:lnTo>
                <a:lnTo>
                  <a:pt x="3035" y="16"/>
                </a:lnTo>
                <a:lnTo>
                  <a:pt x="3036" y="18"/>
                </a:lnTo>
                <a:lnTo>
                  <a:pt x="3037" y="17"/>
                </a:lnTo>
                <a:lnTo>
                  <a:pt x="3037" y="17"/>
                </a:lnTo>
                <a:lnTo>
                  <a:pt x="3038" y="18"/>
                </a:lnTo>
                <a:lnTo>
                  <a:pt x="3039" y="16"/>
                </a:lnTo>
                <a:lnTo>
                  <a:pt x="3040" y="17"/>
                </a:lnTo>
                <a:lnTo>
                  <a:pt x="3041" y="17"/>
                </a:lnTo>
                <a:lnTo>
                  <a:pt x="3042" y="16"/>
                </a:lnTo>
                <a:lnTo>
                  <a:pt x="3043" y="16"/>
                </a:lnTo>
                <a:lnTo>
                  <a:pt x="3044" y="16"/>
                </a:lnTo>
                <a:lnTo>
                  <a:pt x="3044" y="15"/>
                </a:lnTo>
                <a:lnTo>
                  <a:pt x="3045" y="15"/>
                </a:lnTo>
                <a:lnTo>
                  <a:pt x="3046" y="17"/>
                </a:lnTo>
                <a:lnTo>
                  <a:pt x="3047" y="16"/>
                </a:lnTo>
                <a:lnTo>
                  <a:pt x="3048" y="16"/>
                </a:lnTo>
                <a:lnTo>
                  <a:pt x="3049" y="17"/>
                </a:lnTo>
                <a:lnTo>
                  <a:pt x="3050" y="16"/>
                </a:lnTo>
                <a:lnTo>
                  <a:pt x="3051" y="15"/>
                </a:lnTo>
                <a:lnTo>
                  <a:pt x="3052" y="15"/>
                </a:lnTo>
                <a:lnTo>
                  <a:pt x="3052" y="16"/>
                </a:lnTo>
                <a:lnTo>
                  <a:pt x="3053" y="14"/>
                </a:lnTo>
                <a:lnTo>
                  <a:pt x="3054" y="15"/>
                </a:lnTo>
                <a:lnTo>
                  <a:pt x="3055" y="16"/>
                </a:lnTo>
                <a:lnTo>
                  <a:pt x="3056" y="14"/>
                </a:lnTo>
                <a:lnTo>
                  <a:pt x="3057" y="15"/>
                </a:lnTo>
                <a:lnTo>
                  <a:pt x="3058" y="15"/>
                </a:lnTo>
                <a:lnTo>
                  <a:pt x="3059" y="15"/>
                </a:lnTo>
                <a:lnTo>
                  <a:pt x="3059" y="14"/>
                </a:lnTo>
                <a:lnTo>
                  <a:pt x="3060" y="15"/>
                </a:lnTo>
                <a:lnTo>
                  <a:pt x="3061" y="16"/>
                </a:lnTo>
                <a:lnTo>
                  <a:pt x="3062" y="15"/>
                </a:lnTo>
                <a:lnTo>
                  <a:pt x="3063" y="14"/>
                </a:lnTo>
                <a:lnTo>
                  <a:pt x="3064" y="15"/>
                </a:lnTo>
                <a:lnTo>
                  <a:pt x="3065" y="14"/>
                </a:lnTo>
                <a:lnTo>
                  <a:pt x="3066" y="14"/>
                </a:lnTo>
                <a:lnTo>
                  <a:pt x="3067" y="15"/>
                </a:lnTo>
                <a:lnTo>
                  <a:pt x="3067" y="16"/>
                </a:lnTo>
                <a:lnTo>
                  <a:pt x="3068" y="15"/>
                </a:lnTo>
                <a:lnTo>
                  <a:pt x="3069" y="15"/>
                </a:lnTo>
                <a:lnTo>
                  <a:pt x="3070" y="13"/>
                </a:lnTo>
                <a:lnTo>
                  <a:pt x="3071" y="15"/>
                </a:lnTo>
                <a:lnTo>
                  <a:pt x="3072" y="14"/>
                </a:lnTo>
                <a:lnTo>
                  <a:pt x="3073" y="14"/>
                </a:lnTo>
                <a:lnTo>
                  <a:pt x="3074" y="15"/>
                </a:lnTo>
                <a:lnTo>
                  <a:pt x="3074" y="13"/>
                </a:lnTo>
                <a:lnTo>
                  <a:pt x="3075" y="15"/>
                </a:lnTo>
                <a:lnTo>
                  <a:pt x="3076" y="13"/>
                </a:lnTo>
                <a:lnTo>
                  <a:pt x="3077" y="14"/>
                </a:lnTo>
                <a:lnTo>
                  <a:pt x="3078" y="13"/>
                </a:lnTo>
                <a:lnTo>
                  <a:pt x="3079" y="13"/>
                </a:lnTo>
                <a:lnTo>
                  <a:pt x="3080" y="13"/>
                </a:lnTo>
                <a:lnTo>
                  <a:pt x="3081" y="14"/>
                </a:lnTo>
                <a:lnTo>
                  <a:pt x="3082" y="14"/>
                </a:lnTo>
                <a:lnTo>
                  <a:pt x="3082" y="13"/>
                </a:lnTo>
                <a:lnTo>
                  <a:pt x="3083" y="16"/>
                </a:lnTo>
                <a:lnTo>
                  <a:pt x="3084" y="13"/>
                </a:lnTo>
                <a:lnTo>
                  <a:pt x="3085" y="15"/>
                </a:lnTo>
                <a:lnTo>
                  <a:pt x="3086" y="16"/>
                </a:lnTo>
                <a:lnTo>
                  <a:pt x="3087" y="15"/>
                </a:lnTo>
                <a:lnTo>
                  <a:pt x="3088" y="16"/>
                </a:lnTo>
                <a:lnTo>
                  <a:pt x="3089" y="15"/>
                </a:lnTo>
                <a:lnTo>
                  <a:pt x="3089" y="15"/>
                </a:lnTo>
                <a:lnTo>
                  <a:pt x="3090" y="15"/>
                </a:lnTo>
                <a:lnTo>
                  <a:pt x="3091" y="16"/>
                </a:lnTo>
                <a:lnTo>
                  <a:pt x="3092" y="16"/>
                </a:lnTo>
                <a:lnTo>
                  <a:pt x="3093" y="16"/>
                </a:lnTo>
                <a:lnTo>
                  <a:pt x="3094" y="16"/>
                </a:lnTo>
                <a:lnTo>
                  <a:pt x="3095" y="16"/>
                </a:lnTo>
                <a:lnTo>
                  <a:pt x="3096" y="19"/>
                </a:lnTo>
                <a:lnTo>
                  <a:pt x="3097" y="18"/>
                </a:lnTo>
                <a:lnTo>
                  <a:pt x="3097" y="18"/>
                </a:lnTo>
                <a:lnTo>
                  <a:pt x="3098" y="22"/>
                </a:lnTo>
                <a:lnTo>
                  <a:pt x="3099" y="23"/>
                </a:lnTo>
                <a:lnTo>
                  <a:pt x="3100" y="25"/>
                </a:lnTo>
                <a:lnTo>
                  <a:pt x="3101" y="26"/>
                </a:lnTo>
                <a:lnTo>
                  <a:pt x="3102" y="27"/>
                </a:lnTo>
                <a:lnTo>
                  <a:pt x="3103" y="29"/>
                </a:lnTo>
                <a:lnTo>
                  <a:pt x="3104" y="29"/>
                </a:lnTo>
                <a:lnTo>
                  <a:pt x="3104" y="30"/>
                </a:lnTo>
                <a:lnTo>
                  <a:pt x="3105" y="29"/>
                </a:lnTo>
                <a:lnTo>
                  <a:pt x="3106" y="30"/>
                </a:lnTo>
                <a:lnTo>
                  <a:pt x="3107" y="30"/>
                </a:lnTo>
                <a:lnTo>
                  <a:pt x="3108" y="29"/>
                </a:lnTo>
                <a:lnTo>
                  <a:pt x="3109" y="30"/>
                </a:lnTo>
                <a:lnTo>
                  <a:pt x="3110" y="26"/>
                </a:lnTo>
                <a:lnTo>
                  <a:pt x="3111" y="25"/>
                </a:lnTo>
                <a:lnTo>
                  <a:pt x="3112" y="25"/>
                </a:lnTo>
                <a:lnTo>
                  <a:pt x="3112" y="23"/>
                </a:lnTo>
                <a:lnTo>
                  <a:pt x="3113" y="24"/>
                </a:lnTo>
                <a:lnTo>
                  <a:pt x="3114" y="23"/>
                </a:lnTo>
                <a:lnTo>
                  <a:pt x="3115" y="23"/>
                </a:lnTo>
                <a:lnTo>
                  <a:pt x="3116" y="23"/>
                </a:lnTo>
                <a:lnTo>
                  <a:pt x="3117" y="22"/>
                </a:lnTo>
                <a:lnTo>
                  <a:pt x="3118" y="20"/>
                </a:lnTo>
                <a:lnTo>
                  <a:pt x="3119" y="20"/>
                </a:lnTo>
                <a:lnTo>
                  <a:pt x="3119" y="22"/>
                </a:lnTo>
                <a:lnTo>
                  <a:pt x="3120" y="20"/>
                </a:lnTo>
                <a:lnTo>
                  <a:pt x="3121" y="21"/>
                </a:lnTo>
                <a:lnTo>
                  <a:pt x="3122" y="19"/>
                </a:lnTo>
                <a:lnTo>
                  <a:pt x="3123" y="19"/>
                </a:lnTo>
                <a:lnTo>
                  <a:pt x="3124" y="18"/>
                </a:lnTo>
                <a:lnTo>
                  <a:pt x="3125" y="18"/>
                </a:lnTo>
                <a:lnTo>
                  <a:pt x="3126" y="18"/>
                </a:lnTo>
                <a:lnTo>
                  <a:pt x="3127" y="17"/>
                </a:lnTo>
                <a:lnTo>
                  <a:pt x="3127" y="18"/>
                </a:lnTo>
                <a:lnTo>
                  <a:pt x="3128" y="18"/>
                </a:lnTo>
                <a:lnTo>
                  <a:pt x="3129" y="16"/>
                </a:lnTo>
                <a:lnTo>
                  <a:pt x="3130" y="16"/>
                </a:lnTo>
                <a:lnTo>
                  <a:pt x="3131" y="16"/>
                </a:lnTo>
                <a:lnTo>
                  <a:pt x="3132" y="18"/>
                </a:lnTo>
                <a:lnTo>
                  <a:pt x="3133" y="17"/>
                </a:lnTo>
                <a:lnTo>
                  <a:pt x="3134" y="16"/>
                </a:lnTo>
                <a:lnTo>
                  <a:pt x="3134" y="18"/>
                </a:lnTo>
                <a:lnTo>
                  <a:pt x="3135" y="15"/>
                </a:lnTo>
                <a:lnTo>
                  <a:pt x="3136" y="16"/>
                </a:lnTo>
                <a:lnTo>
                  <a:pt x="3137" y="14"/>
                </a:lnTo>
                <a:lnTo>
                  <a:pt x="3138" y="17"/>
                </a:lnTo>
                <a:lnTo>
                  <a:pt x="3139" y="15"/>
                </a:lnTo>
                <a:lnTo>
                  <a:pt x="3140" y="15"/>
                </a:lnTo>
                <a:lnTo>
                  <a:pt x="3141" y="16"/>
                </a:lnTo>
                <a:lnTo>
                  <a:pt x="3142" y="16"/>
                </a:lnTo>
                <a:lnTo>
                  <a:pt x="3142" y="15"/>
                </a:lnTo>
                <a:lnTo>
                  <a:pt x="3143" y="16"/>
                </a:lnTo>
                <a:lnTo>
                  <a:pt x="3144" y="14"/>
                </a:lnTo>
                <a:lnTo>
                  <a:pt x="3145" y="16"/>
                </a:lnTo>
                <a:lnTo>
                  <a:pt x="3146" y="16"/>
                </a:lnTo>
                <a:lnTo>
                  <a:pt x="3147" y="19"/>
                </a:lnTo>
                <a:lnTo>
                  <a:pt x="3148" y="17"/>
                </a:lnTo>
                <a:lnTo>
                  <a:pt x="3149" y="16"/>
                </a:lnTo>
                <a:lnTo>
                  <a:pt x="3149" y="17"/>
                </a:lnTo>
                <a:lnTo>
                  <a:pt x="3150" y="17"/>
                </a:lnTo>
                <a:lnTo>
                  <a:pt x="3151" y="17"/>
                </a:lnTo>
                <a:lnTo>
                  <a:pt x="3152" y="18"/>
                </a:lnTo>
                <a:lnTo>
                  <a:pt x="3153" y="20"/>
                </a:lnTo>
                <a:lnTo>
                  <a:pt x="3154" y="20"/>
                </a:lnTo>
                <a:lnTo>
                  <a:pt x="3155" y="19"/>
                </a:lnTo>
                <a:lnTo>
                  <a:pt x="3156" y="19"/>
                </a:lnTo>
                <a:lnTo>
                  <a:pt x="3156" y="18"/>
                </a:lnTo>
                <a:lnTo>
                  <a:pt x="3157" y="18"/>
                </a:lnTo>
                <a:lnTo>
                  <a:pt x="3158" y="18"/>
                </a:lnTo>
                <a:lnTo>
                  <a:pt x="3159" y="18"/>
                </a:lnTo>
                <a:lnTo>
                  <a:pt x="3160" y="18"/>
                </a:lnTo>
                <a:lnTo>
                  <a:pt x="3161" y="18"/>
                </a:lnTo>
                <a:lnTo>
                  <a:pt x="3162" y="19"/>
                </a:lnTo>
                <a:lnTo>
                  <a:pt x="3163" y="18"/>
                </a:lnTo>
                <a:lnTo>
                  <a:pt x="3164" y="20"/>
                </a:lnTo>
                <a:lnTo>
                  <a:pt x="3164" y="20"/>
                </a:lnTo>
                <a:lnTo>
                  <a:pt x="3165" y="24"/>
                </a:lnTo>
                <a:lnTo>
                  <a:pt x="3166" y="29"/>
                </a:lnTo>
                <a:lnTo>
                  <a:pt x="3167" y="33"/>
                </a:lnTo>
                <a:lnTo>
                  <a:pt x="3168" y="42"/>
                </a:lnTo>
                <a:lnTo>
                  <a:pt x="3169" y="50"/>
                </a:lnTo>
                <a:lnTo>
                  <a:pt x="3170" y="60"/>
                </a:lnTo>
                <a:lnTo>
                  <a:pt x="3171" y="74"/>
                </a:lnTo>
                <a:lnTo>
                  <a:pt x="3171" y="86"/>
                </a:lnTo>
                <a:lnTo>
                  <a:pt x="3172" y="102"/>
                </a:lnTo>
                <a:lnTo>
                  <a:pt x="3173" y="113"/>
                </a:lnTo>
                <a:lnTo>
                  <a:pt x="3174" y="125"/>
                </a:lnTo>
                <a:lnTo>
                  <a:pt x="3175" y="129"/>
                </a:lnTo>
                <a:lnTo>
                  <a:pt x="3176" y="134"/>
                </a:lnTo>
                <a:lnTo>
                  <a:pt x="3177" y="128"/>
                </a:lnTo>
                <a:lnTo>
                  <a:pt x="3178" y="128"/>
                </a:lnTo>
                <a:lnTo>
                  <a:pt x="3179" y="124"/>
                </a:lnTo>
                <a:lnTo>
                  <a:pt x="3179" y="116"/>
                </a:lnTo>
                <a:lnTo>
                  <a:pt x="3180" y="109"/>
                </a:lnTo>
                <a:lnTo>
                  <a:pt x="3181" y="105"/>
                </a:lnTo>
                <a:lnTo>
                  <a:pt x="3182" y="98"/>
                </a:lnTo>
                <a:lnTo>
                  <a:pt x="3183" y="89"/>
                </a:lnTo>
                <a:lnTo>
                  <a:pt x="3184" y="85"/>
                </a:lnTo>
                <a:lnTo>
                  <a:pt x="3185" y="81"/>
                </a:lnTo>
                <a:lnTo>
                  <a:pt x="3186" y="78"/>
                </a:lnTo>
                <a:lnTo>
                  <a:pt x="3186" y="77"/>
                </a:lnTo>
                <a:lnTo>
                  <a:pt x="3187" y="74"/>
                </a:lnTo>
                <a:lnTo>
                  <a:pt x="3188" y="73"/>
                </a:lnTo>
                <a:lnTo>
                  <a:pt x="3189" y="75"/>
                </a:lnTo>
                <a:lnTo>
                  <a:pt x="3190" y="74"/>
                </a:lnTo>
                <a:lnTo>
                  <a:pt x="3191" y="74"/>
                </a:lnTo>
                <a:lnTo>
                  <a:pt x="3192" y="76"/>
                </a:lnTo>
                <a:lnTo>
                  <a:pt x="3193" y="74"/>
                </a:lnTo>
                <a:lnTo>
                  <a:pt x="3194" y="75"/>
                </a:lnTo>
                <a:lnTo>
                  <a:pt x="3194" y="74"/>
                </a:lnTo>
                <a:lnTo>
                  <a:pt x="3195" y="74"/>
                </a:lnTo>
                <a:lnTo>
                  <a:pt x="3196" y="71"/>
                </a:lnTo>
                <a:lnTo>
                  <a:pt x="3197" y="74"/>
                </a:lnTo>
                <a:lnTo>
                  <a:pt x="3198" y="66"/>
                </a:lnTo>
                <a:lnTo>
                  <a:pt x="3199" y="69"/>
                </a:lnTo>
                <a:lnTo>
                  <a:pt x="3200" y="66"/>
                </a:lnTo>
                <a:lnTo>
                  <a:pt x="3201" y="65"/>
                </a:lnTo>
                <a:lnTo>
                  <a:pt x="3201" y="65"/>
                </a:lnTo>
                <a:lnTo>
                  <a:pt x="3202" y="64"/>
                </a:lnTo>
                <a:lnTo>
                  <a:pt x="3203" y="65"/>
                </a:lnTo>
                <a:lnTo>
                  <a:pt x="3204" y="66"/>
                </a:lnTo>
                <a:lnTo>
                  <a:pt x="3205" y="69"/>
                </a:lnTo>
                <a:lnTo>
                  <a:pt x="3206" y="69"/>
                </a:lnTo>
                <a:lnTo>
                  <a:pt x="3207" y="71"/>
                </a:lnTo>
                <a:lnTo>
                  <a:pt x="3208" y="72"/>
                </a:lnTo>
                <a:lnTo>
                  <a:pt x="3209" y="73"/>
                </a:lnTo>
                <a:lnTo>
                  <a:pt x="3209" y="73"/>
                </a:lnTo>
                <a:lnTo>
                  <a:pt x="3210" y="68"/>
                </a:lnTo>
                <a:lnTo>
                  <a:pt x="3211" y="69"/>
                </a:lnTo>
                <a:lnTo>
                  <a:pt x="3212" y="70"/>
                </a:lnTo>
                <a:lnTo>
                  <a:pt x="3213" y="66"/>
                </a:lnTo>
                <a:lnTo>
                  <a:pt x="3214" y="63"/>
                </a:lnTo>
                <a:lnTo>
                  <a:pt x="3215" y="63"/>
                </a:lnTo>
                <a:lnTo>
                  <a:pt x="3216" y="59"/>
                </a:lnTo>
                <a:lnTo>
                  <a:pt x="3216" y="60"/>
                </a:lnTo>
                <a:lnTo>
                  <a:pt x="3217" y="55"/>
                </a:lnTo>
                <a:lnTo>
                  <a:pt x="3218" y="52"/>
                </a:lnTo>
                <a:lnTo>
                  <a:pt x="3219" y="50"/>
                </a:lnTo>
                <a:lnTo>
                  <a:pt x="3220" y="48"/>
                </a:lnTo>
                <a:lnTo>
                  <a:pt x="3221" y="45"/>
                </a:lnTo>
                <a:lnTo>
                  <a:pt x="3222" y="45"/>
                </a:lnTo>
                <a:lnTo>
                  <a:pt x="3223" y="44"/>
                </a:lnTo>
                <a:lnTo>
                  <a:pt x="3224" y="44"/>
                </a:lnTo>
                <a:lnTo>
                  <a:pt x="3224" y="41"/>
                </a:lnTo>
                <a:lnTo>
                  <a:pt x="3225" y="42"/>
                </a:lnTo>
                <a:lnTo>
                  <a:pt x="3226" y="40"/>
                </a:lnTo>
                <a:lnTo>
                  <a:pt x="3227" y="41"/>
                </a:lnTo>
                <a:lnTo>
                  <a:pt x="3228" y="40"/>
                </a:lnTo>
                <a:lnTo>
                  <a:pt x="3229" y="37"/>
                </a:lnTo>
                <a:lnTo>
                  <a:pt x="3230" y="39"/>
                </a:lnTo>
                <a:lnTo>
                  <a:pt x="3231" y="37"/>
                </a:lnTo>
                <a:lnTo>
                  <a:pt x="3231" y="35"/>
                </a:lnTo>
                <a:lnTo>
                  <a:pt x="3232" y="37"/>
                </a:lnTo>
                <a:lnTo>
                  <a:pt x="3233" y="35"/>
                </a:lnTo>
                <a:lnTo>
                  <a:pt x="3234" y="33"/>
                </a:lnTo>
                <a:lnTo>
                  <a:pt x="3235" y="33"/>
                </a:lnTo>
                <a:lnTo>
                  <a:pt x="3236" y="32"/>
                </a:lnTo>
                <a:lnTo>
                  <a:pt x="3237" y="33"/>
                </a:lnTo>
                <a:lnTo>
                  <a:pt x="3238" y="31"/>
                </a:lnTo>
                <a:lnTo>
                  <a:pt x="3239" y="32"/>
                </a:lnTo>
                <a:lnTo>
                  <a:pt x="3239" y="31"/>
                </a:lnTo>
                <a:lnTo>
                  <a:pt x="3240" y="32"/>
                </a:lnTo>
                <a:lnTo>
                  <a:pt x="3241" y="31"/>
                </a:lnTo>
                <a:lnTo>
                  <a:pt x="3242" y="29"/>
                </a:lnTo>
                <a:lnTo>
                  <a:pt x="3243" y="29"/>
                </a:lnTo>
                <a:lnTo>
                  <a:pt x="3244" y="27"/>
                </a:lnTo>
                <a:lnTo>
                  <a:pt x="3245" y="29"/>
                </a:lnTo>
                <a:lnTo>
                  <a:pt x="3246" y="29"/>
                </a:lnTo>
                <a:lnTo>
                  <a:pt x="3246" y="26"/>
                </a:lnTo>
                <a:lnTo>
                  <a:pt x="3247" y="27"/>
                </a:lnTo>
                <a:lnTo>
                  <a:pt x="3248" y="28"/>
                </a:lnTo>
                <a:lnTo>
                  <a:pt x="3249" y="28"/>
                </a:lnTo>
                <a:lnTo>
                  <a:pt x="3250" y="27"/>
                </a:lnTo>
                <a:lnTo>
                  <a:pt x="3251" y="28"/>
                </a:lnTo>
                <a:lnTo>
                  <a:pt x="3252" y="31"/>
                </a:lnTo>
                <a:lnTo>
                  <a:pt x="3253" y="30"/>
                </a:lnTo>
                <a:lnTo>
                  <a:pt x="3254" y="30"/>
                </a:lnTo>
                <a:lnTo>
                  <a:pt x="3254" y="30"/>
                </a:lnTo>
                <a:lnTo>
                  <a:pt x="3255" y="30"/>
                </a:lnTo>
                <a:lnTo>
                  <a:pt x="3256" y="30"/>
                </a:lnTo>
                <a:lnTo>
                  <a:pt x="3257" y="30"/>
                </a:lnTo>
                <a:lnTo>
                  <a:pt x="3258" y="31"/>
                </a:lnTo>
                <a:lnTo>
                  <a:pt x="3259" y="30"/>
                </a:lnTo>
                <a:lnTo>
                  <a:pt x="3260" y="28"/>
                </a:lnTo>
                <a:lnTo>
                  <a:pt x="3261" y="30"/>
                </a:lnTo>
                <a:lnTo>
                  <a:pt x="3261" y="28"/>
                </a:lnTo>
                <a:lnTo>
                  <a:pt x="3262" y="28"/>
                </a:lnTo>
                <a:lnTo>
                  <a:pt x="3263" y="26"/>
                </a:lnTo>
                <a:lnTo>
                  <a:pt x="3264" y="25"/>
                </a:lnTo>
                <a:lnTo>
                  <a:pt x="3265" y="25"/>
                </a:lnTo>
                <a:lnTo>
                  <a:pt x="3266" y="27"/>
                </a:lnTo>
                <a:lnTo>
                  <a:pt x="3267" y="25"/>
                </a:lnTo>
                <a:lnTo>
                  <a:pt x="3268" y="25"/>
                </a:lnTo>
                <a:lnTo>
                  <a:pt x="3269" y="23"/>
                </a:lnTo>
                <a:lnTo>
                  <a:pt x="3269" y="23"/>
                </a:lnTo>
                <a:lnTo>
                  <a:pt x="3270" y="23"/>
                </a:lnTo>
                <a:lnTo>
                  <a:pt x="3271" y="20"/>
                </a:lnTo>
                <a:lnTo>
                  <a:pt x="3272" y="23"/>
                </a:lnTo>
                <a:lnTo>
                  <a:pt x="3273" y="23"/>
                </a:lnTo>
                <a:lnTo>
                  <a:pt x="3274" y="22"/>
                </a:lnTo>
                <a:lnTo>
                  <a:pt x="3275" y="22"/>
                </a:lnTo>
                <a:lnTo>
                  <a:pt x="3276" y="21"/>
                </a:lnTo>
                <a:lnTo>
                  <a:pt x="3276" y="24"/>
                </a:lnTo>
                <a:lnTo>
                  <a:pt x="3277" y="22"/>
                </a:lnTo>
                <a:lnTo>
                  <a:pt x="3278" y="22"/>
                </a:lnTo>
                <a:lnTo>
                  <a:pt x="3279" y="22"/>
                </a:lnTo>
                <a:lnTo>
                  <a:pt x="3280" y="24"/>
                </a:lnTo>
                <a:lnTo>
                  <a:pt x="3281" y="25"/>
                </a:lnTo>
                <a:lnTo>
                  <a:pt x="3282" y="26"/>
                </a:lnTo>
                <a:lnTo>
                  <a:pt x="3283" y="24"/>
                </a:lnTo>
                <a:lnTo>
                  <a:pt x="3284" y="27"/>
                </a:lnTo>
                <a:lnTo>
                  <a:pt x="3284" y="25"/>
                </a:lnTo>
                <a:lnTo>
                  <a:pt x="3285" y="25"/>
                </a:lnTo>
                <a:lnTo>
                  <a:pt x="3286" y="23"/>
                </a:lnTo>
                <a:lnTo>
                  <a:pt x="3287" y="23"/>
                </a:lnTo>
                <a:lnTo>
                  <a:pt x="3288" y="22"/>
                </a:lnTo>
                <a:lnTo>
                  <a:pt x="3289" y="22"/>
                </a:lnTo>
                <a:lnTo>
                  <a:pt x="3290" y="21"/>
                </a:lnTo>
                <a:lnTo>
                  <a:pt x="3291" y="21"/>
                </a:lnTo>
                <a:lnTo>
                  <a:pt x="3291" y="21"/>
                </a:lnTo>
                <a:lnTo>
                  <a:pt x="3292" y="19"/>
                </a:lnTo>
                <a:lnTo>
                  <a:pt x="3293" y="20"/>
                </a:lnTo>
                <a:lnTo>
                  <a:pt x="3294" y="21"/>
                </a:lnTo>
                <a:lnTo>
                  <a:pt x="3295" y="22"/>
                </a:lnTo>
                <a:lnTo>
                  <a:pt x="3296" y="21"/>
                </a:lnTo>
                <a:lnTo>
                  <a:pt x="3297" y="24"/>
                </a:lnTo>
                <a:lnTo>
                  <a:pt x="3298" y="24"/>
                </a:lnTo>
                <a:lnTo>
                  <a:pt x="3299" y="24"/>
                </a:lnTo>
                <a:lnTo>
                  <a:pt x="3299" y="25"/>
                </a:lnTo>
                <a:lnTo>
                  <a:pt x="3300" y="26"/>
                </a:lnTo>
                <a:lnTo>
                  <a:pt x="3301" y="28"/>
                </a:lnTo>
                <a:lnTo>
                  <a:pt x="3302" y="28"/>
                </a:lnTo>
                <a:lnTo>
                  <a:pt x="3303" y="31"/>
                </a:lnTo>
                <a:lnTo>
                  <a:pt x="3304" y="29"/>
                </a:lnTo>
                <a:lnTo>
                  <a:pt x="3305" y="30"/>
                </a:lnTo>
                <a:lnTo>
                  <a:pt x="3306" y="28"/>
                </a:lnTo>
                <a:lnTo>
                  <a:pt x="3306" y="26"/>
                </a:lnTo>
                <a:lnTo>
                  <a:pt x="3307" y="26"/>
                </a:lnTo>
                <a:lnTo>
                  <a:pt x="3308" y="22"/>
                </a:lnTo>
                <a:lnTo>
                  <a:pt x="3309" y="22"/>
                </a:lnTo>
                <a:lnTo>
                  <a:pt x="3310" y="21"/>
                </a:lnTo>
                <a:lnTo>
                  <a:pt x="3311" y="19"/>
                </a:lnTo>
                <a:lnTo>
                  <a:pt x="3312" y="18"/>
                </a:lnTo>
                <a:lnTo>
                  <a:pt x="3313" y="17"/>
                </a:lnTo>
                <a:lnTo>
                  <a:pt x="3314" y="19"/>
                </a:lnTo>
                <a:lnTo>
                  <a:pt x="3314" y="17"/>
                </a:lnTo>
                <a:lnTo>
                  <a:pt x="3315" y="16"/>
                </a:lnTo>
                <a:lnTo>
                  <a:pt x="3316" y="15"/>
                </a:lnTo>
                <a:lnTo>
                  <a:pt x="3317" y="15"/>
                </a:lnTo>
                <a:lnTo>
                  <a:pt x="3318" y="16"/>
                </a:lnTo>
                <a:lnTo>
                  <a:pt x="3319" y="15"/>
                </a:lnTo>
                <a:lnTo>
                  <a:pt x="3320" y="15"/>
                </a:lnTo>
                <a:lnTo>
                  <a:pt x="3321" y="16"/>
                </a:lnTo>
                <a:lnTo>
                  <a:pt x="3321" y="16"/>
                </a:lnTo>
                <a:lnTo>
                  <a:pt x="3322" y="15"/>
                </a:lnTo>
                <a:lnTo>
                  <a:pt x="3323" y="14"/>
                </a:lnTo>
                <a:lnTo>
                  <a:pt x="3324" y="15"/>
                </a:lnTo>
                <a:lnTo>
                  <a:pt x="3325" y="16"/>
                </a:lnTo>
                <a:lnTo>
                  <a:pt x="3326" y="15"/>
                </a:lnTo>
                <a:lnTo>
                  <a:pt x="3327" y="15"/>
                </a:lnTo>
                <a:lnTo>
                  <a:pt x="3328" y="16"/>
                </a:lnTo>
                <a:lnTo>
                  <a:pt x="3329" y="15"/>
                </a:lnTo>
                <a:lnTo>
                  <a:pt x="3329" y="15"/>
                </a:lnTo>
                <a:lnTo>
                  <a:pt x="3330" y="15"/>
                </a:lnTo>
                <a:lnTo>
                  <a:pt x="3331" y="16"/>
                </a:lnTo>
                <a:lnTo>
                  <a:pt x="3332" y="16"/>
                </a:lnTo>
                <a:lnTo>
                  <a:pt x="3333" y="14"/>
                </a:lnTo>
                <a:lnTo>
                  <a:pt x="3334" y="15"/>
                </a:lnTo>
                <a:lnTo>
                  <a:pt x="3335" y="15"/>
                </a:lnTo>
                <a:lnTo>
                  <a:pt x="3336" y="15"/>
                </a:lnTo>
                <a:lnTo>
                  <a:pt x="3336" y="15"/>
                </a:lnTo>
                <a:lnTo>
                  <a:pt x="3337" y="16"/>
                </a:lnTo>
                <a:lnTo>
                  <a:pt x="3338" y="17"/>
                </a:lnTo>
                <a:lnTo>
                  <a:pt x="3339" y="17"/>
                </a:lnTo>
                <a:lnTo>
                  <a:pt x="3340" y="17"/>
                </a:lnTo>
                <a:lnTo>
                  <a:pt x="3341" y="17"/>
                </a:lnTo>
                <a:lnTo>
                  <a:pt x="3342" y="19"/>
                </a:lnTo>
                <a:lnTo>
                  <a:pt x="3343" y="19"/>
                </a:lnTo>
                <a:lnTo>
                  <a:pt x="3344" y="19"/>
                </a:lnTo>
                <a:lnTo>
                  <a:pt x="3344" y="22"/>
                </a:lnTo>
                <a:lnTo>
                  <a:pt x="3345" y="22"/>
                </a:lnTo>
                <a:lnTo>
                  <a:pt x="3346" y="22"/>
                </a:lnTo>
                <a:lnTo>
                  <a:pt x="3347" y="23"/>
                </a:lnTo>
                <a:lnTo>
                  <a:pt x="3348" y="23"/>
                </a:lnTo>
                <a:lnTo>
                  <a:pt x="3349" y="24"/>
                </a:lnTo>
                <a:lnTo>
                  <a:pt x="3350" y="25"/>
                </a:lnTo>
                <a:lnTo>
                  <a:pt x="3351" y="25"/>
                </a:lnTo>
                <a:lnTo>
                  <a:pt x="3351" y="26"/>
                </a:lnTo>
                <a:lnTo>
                  <a:pt x="3352" y="26"/>
                </a:lnTo>
                <a:lnTo>
                  <a:pt x="3353" y="25"/>
                </a:lnTo>
                <a:lnTo>
                  <a:pt x="3354" y="26"/>
                </a:lnTo>
                <a:lnTo>
                  <a:pt x="3355" y="26"/>
                </a:lnTo>
                <a:lnTo>
                  <a:pt x="3356" y="25"/>
                </a:lnTo>
                <a:lnTo>
                  <a:pt x="3357" y="25"/>
                </a:lnTo>
                <a:lnTo>
                  <a:pt x="3358" y="26"/>
                </a:lnTo>
                <a:lnTo>
                  <a:pt x="3358" y="25"/>
                </a:lnTo>
                <a:lnTo>
                  <a:pt x="3359" y="25"/>
                </a:lnTo>
                <a:lnTo>
                  <a:pt x="3360" y="25"/>
                </a:lnTo>
                <a:lnTo>
                  <a:pt x="3361" y="22"/>
                </a:lnTo>
                <a:lnTo>
                  <a:pt x="3362" y="23"/>
                </a:lnTo>
                <a:lnTo>
                  <a:pt x="3363" y="21"/>
                </a:lnTo>
                <a:lnTo>
                  <a:pt x="3364" y="22"/>
                </a:lnTo>
                <a:lnTo>
                  <a:pt x="3365" y="20"/>
                </a:lnTo>
                <a:lnTo>
                  <a:pt x="3366" y="20"/>
                </a:lnTo>
                <a:lnTo>
                  <a:pt x="3366" y="22"/>
                </a:lnTo>
                <a:lnTo>
                  <a:pt x="3367" y="22"/>
                </a:lnTo>
                <a:lnTo>
                  <a:pt x="3368" y="21"/>
                </a:lnTo>
                <a:lnTo>
                  <a:pt x="3369" y="21"/>
                </a:lnTo>
                <a:lnTo>
                  <a:pt x="3370" y="21"/>
                </a:lnTo>
                <a:lnTo>
                  <a:pt x="3371" y="20"/>
                </a:lnTo>
                <a:lnTo>
                  <a:pt x="3372" y="21"/>
                </a:lnTo>
                <a:lnTo>
                  <a:pt x="3373" y="20"/>
                </a:lnTo>
                <a:lnTo>
                  <a:pt x="3373" y="18"/>
                </a:lnTo>
                <a:lnTo>
                  <a:pt x="3374" y="18"/>
                </a:lnTo>
                <a:lnTo>
                  <a:pt x="3375" y="18"/>
                </a:lnTo>
                <a:lnTo>
                  <a:pt x="3376" y="18"/>
                </a:lnTo>
                <a:lnTo>
                  <a:pt x="3377" y="18"/>
                </a:lnTo>
                <a:lnTo>
                  <a:pt x="3378" y="18"/>
                </a:lnTo>
                <a:lnTo>
                  <a:pt x="3379" y="18"/>
                </a:lnTo>
                <a:lnTo>
                  <a:pt x="3380" y="17"/>
                </a:lnTo>
                <a:lnTo>
                  <a:pt x="3381" y="17"/>
                </a:lnTo>
                <a:lnTo>
                  <a:pt x="3381" y="17"/>
                </a:lnTo>
                <a:lnTo>
                  <a:pt x="3382" y="17"/>
                </a:lnTo>
                <a:lnTo>
                  <a:pt x="3383" y="16"/>
                </a:lnTo>
                <a:lnTo>
                  <a:pt x="3384" y="14"/>
                </a:lnTo>
                <a:lnTo>
                  <a:pt x="3385" y="15"/>
                </a:lnTo>
                <a:lnTo>
                  <a:pt x="3386" y="16"/>
                </a:lnTo>
              </a:path>
            </a:pathLst>
          </a:custGeom>
          <a:noFill/>
          <a:ln w="0">
            <a:solidFill>
              <a:srgbClr val="00007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Freeform 177"/>
          <p:cNvSpPr>
            <a:spLocks/>
          </p:cNvSpPr>
          <p:nvPr/>
        </p:nvSpPr>
        <p:spPr bwMode="auto">
          <a:xfrm flipV="1">
            <a:off x="5865814" y="5183188"/>
            <a:ext cx="520700" cy="7938"/>
          </a:xfrm>
          <a:custGeom>
            <a:avLst/>
            <a:gdLst>
              <a:gd name="T0" fmla="*/ 12 w 789"/>
              <a:gd name="T1" fmla="*/ 7 h 10"/>
              <a:gd name="T2" fmla="*/ 25 w 789"/>
              <a:gd name="T3" fmla="*/ 6 h 10"/>
              <a:gd name="T4" fmla="*/ 39 w 789"/>
              <a:gd name="T5" fmla="*/ 6 h 10"/>
              <a:gd name="T6" fmla="*/ 52 w 789"/>
              <a:gd name="T7" fmla="*/ 4 h 10"/>
              <a:gd name="T8" fmla="*/ 65 w 789"/>
              <a:gd name="T9" fmla="*/ 5 h 10"/>
              <a:gd name="T10" fmla="*/ 78 w 789"/>
              <a:gd name="T11" fmla="*/ 4 h 10"/>
              <a:gd name="T12" fmla="*/ 92 w 789"/>
              <a:gd name="T13" fmla="*/ 4 h 10"/>
              <a:gd name="T14" fmla="*/ 105 w 789"/>
              <a:gd name="T15" fmla="*/ 4 h 10"/>
              <a:gd name="T16" fmla="*/ 118 w 789"/>
              <a:gd name="T17" fmla="*/ 2 h 10"/>
              <a:gd name="T18" fmla="*/ 131 w 789"/>
              <a:gd name="T19" fmla="*/ 3 h 10"/>
              <a:gd name="T20" fmla="*/ 145 w 789"/>
              <a:gd name="T21" fmla="*/ 2 h 10"/>
              <a:gd name="T22" fmla="*/ 158 w 789"/>
              <a:gd name="T23" fmla="*/ 4 h 10"/>
              <a:gd name="T24" fmla="*/ 171 w 789"/>
              <a:gd name="T25" fmla="*/ 8 h 10"/>
              <a:gd name="T26" fmla="*/ 184 w 789"/>
              <a:gd name="T27" fmla="*/ 6 h 10"/>
              <a:gd name="T28" fmla="*/ 197 w 789"/>
              <a:gd name="T29" fmla="*/ 4 h 10"/>
              <a:gd name="T30" fmla="*/ 211 w 789"/>
              <a:gd name="T31" fmla="*/ 3 h 10"/>
              <a:gd name="T32" fmla="*/ 224 w 789"/>
              <a:gd name="T33" fmla="*/ 9 h 10"/>
              <a:gd name="T34" fmla="*/ 237 w 789"/>
              <a:gd name="T35" fmla="*/ 3 h 10"/>
              <a:gd name="T36" fmla="*/ 250 w 789"/>
              <a:gd name="T37" fmla="*/ 2 h 10"/>
              <a:gd name="T38" fmla="*/ 264 w 789"/>
              <a:gd name="T39" fmla="*/ 1 h 10"/>
              <a:gd name="T40" fmla="*/ 277 w 789"/>
              <a:gd name="T41" fmla="*/ 2 h 10"/>
              <a:gd name="T42" fmla="*/ 290 w 789"/>
              <a:gd name="T43" fmla="*/ 1 h 10"/>
              <a:gd name="T44" fmla="*/ 303 w 789"/>
              <a:gd name="T45" fmla="*/ 2 h 10"/>
              <a:gd name="T46" fmla="*/ 317 w 789"/>
              <a:gd name="T47" fmla="*/ 3 h 10"/>
              <a:gd name="T48" fmla="*/ 330 w 789"/>
              <a:gd name="T49" fmla="*/ 4 h 10"/>
              <a:gd name="T50" fmla="*/ 343 w 789"/>
              <a:gd name="T51" fmla="*/ 7 h 10"/>
              <a:gd name="T52" fmla="*/ 356 w 789"/>
              <a:gd name="T53" fmla="*/ 6 h 10"/>
              <a:gd name="T54" fmla="*/ 369 w 789"/>
              <a:gd name="T55" fmla="*/ 7 h 10"/>
              <a:gd name="T56" fmla="*/ 383 w 789"/>
              <a:gd name="T57" fmla="*/ 7 h 10"/>
              <a:gd name="T58" fmla="*/ 396 w 789"/>
              <a:gd name="T59" fmla="*/ 5 h 10"/>
              <a:gd name="T60" fmla="*/ 409 w 789"/>
              <a:gd name="T61" fmla="*/ 5 h 10"/>
              <a:gd name="T62" fmla="*/ 422 w 789"/>
              <a:gd name="T63" fmla="*/ 5 h 10"/>
              <a:gd name="T64" fmla="*/ 436 w 789"/>
              <a:gd name="T65" fmla="*/ 6 h 10"/>
              <a:gd name="T66" fmla="*/ 449 w 789"/>
              <a:gd name="T67" fmla="*/ 7 h 10"/>
              <a:gd name="T68" fmla="*/ 462 w 789"/>
              <a:gd name="T69" fmla="*/ 5 h 10"/>
              <a:gd name="T70" fmla="*/ 475 w 789"/>
              <a:gd name="T71" fmla="*/ 3 h 10"/>
              <a:gd name="T72" fmla="*/ 489 w 789"/>
              <a:gd name="T73" fmla="*/ 5 h 10"/>
              <a:gd name="T74" fmla="*/ 502 w 789"/>
              <a:gd name="T75" fmla="*/ 3 h 10"/>
              <a:gd name="T76" fmla="*/ 515 w 789"/>
              <a:gd name="T77" fmla="*/ 4 h 10"/>
              <a:gd name="T78" fmla="*/ 528 w 789"/>
              <a:gd name="T79" fmla="*/ 4 h 10"/>
              <a:gd name="T80" fmla="*/ 541 w 789"/>
              <a:gd name="T81" fmla="*/ 4 h 10"/>
              <a:gd name="T82" fmla="*/ 555 w 789"/>
              <a:gd name="T83" fmla="*/ 4 h 10"/>
              <a:gd name="T84" fmla="*/ 568 w 789"/>
              <a:gd name="T85" fmla="*/ 3 h 10"/>
              <a:gd name="T86" fmla="*/ 581 w 789"/>
              <a:gd name="T87" fmla="*/ 4 h 10"/>
              <a:gd name="T88" fmla="*/ 594 w 789"/>
              <a:gd name="T89" fmla="*/ 3 h 10"/>
              <a:gd name="T90" fmla="*/ 608 w 789"/>
              <a:gd name="T91" fmla="*/ 2 h 10"/>
              <a:gd name="T92" fmla="*/ 621 w 789"/>
              <a:gd name="T93" fmla="*/ 3 h 10"/>
              <a:gd name="T94" fmla="*/ 634 w 789"/>
              <a:gd name="T95" fmla="*/ 2 h 10"/>
              <a:gd name="T96" fmla="*/ 647 w 789"/>
              <a:gd name="T97" fmla="*/ 3 h 10"/>
              <a:gd name="T98" fmla="*/ 661 w 789"/>
              <a:gd name="T99" fmla="*/ 2 h 10"/>
              <a:gd name="T100" fmla="*/ 674 w 789"/>
              <a:gd name="T101" fmla="*/ 3 h 10"/>
              <a:gd name="T102" fmla="*/ 687 w 789"/>
              <a:gd name="T103" fmla="*/ 3 h 10"/>
              <a:gd name="T104" fmla="*/ 700 w 789"/>
              <a:gd name="T105" fmla="*/ 3 h 10"/>
              <a:gd name="T106" fmla="*/ 713 w 789"/>
              <a:gd name="T107" fmla="*/ 1 h 10"/>
              <a:gd name="T108" fmla="*/ 727 w 789"/>
              <a:gd name="T109" fmla="*/ 4 h 10"/>
              <a:gd name="T110" fmla="*/ 740 w 789"/>
              <a:gd name="T111" fmla="*/ 2 h 10"/>
              <a:gd name="T112" fmla="*/ 753 w 789"/>
              <a:gd name="T113" fmla="*/ 3 h 10"/>
              <a:gd name="T114" fmla="*/ 766 w 789"/>
              <a:gd name="T115" fmla="*/ 1 h 10"/>
              <a:gd name="T116" fmla="*/ 780 w 789"/>
              <a:gd name="T117" fmla="*/ 1 h 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</a:cxnLst>
            <a:rect l="0" t="0" r="r" b="b"/>
            <a:pathLst>
              <a:path w="789" h="10">
                <a:moveTo>
                  <a:pt x="0" y="9"/>
                </a:moveTo>
                <a:lnTo>
                  <a:pt x="1" y="8"/>
                </a:lnTo>
                <a:lnTo>
                  <a:pt x="2" y="10"/>
                </a:lnTo>
                <a:lnTo>
                  <a:pt x="2" y="9"/>
                </a:lnTo>
                <a:lnTo>
                  <a:pt x="3" y="9"/>
                </a:lnTo>
                <a:lnTo>
                  <a:pt x="4" y="8"/>
                </a:lnTo>
                <a:lnTo>
                  <a:pt x="5" y="8"/>
                </a:lnTo>
                <a:lnTo>
                  <a:pt x="6" y="9"/>
                </a:lnTo>
                <a:lnTo>
                  <a:pt x="7" y="9"/>
                </a:lnTo>
                <a:lnTo>
                  <a:pt x="8" y="8"/>
                </a:lnTo>
                <a:lnTo>
                  <a:pt x="9" y="7"/>
                </a:lnTo>
                <a:lnTo>
                  <a:pt x="10" y="8"/>
                </a:lnTo>
                <a:lnTo>
                  <a:pt x="10" y="6"/>
                </a:lnTo>
                <a:lnTo>
                  <a:pt x="11" y="7"/>
                </a:lnTo>
                <a:lnTo>
                  <a:pt x="12" y="7"/>
                </a:lnTo>
                <a:lnTo>
                  <a:pt x="13" y="6"/>
                </a:lnTo>
                <a:lnTo>
                  <a:pt x="14" y="6"/>
                </a:lnTo>
                <a:lnTo>
                  <a:pt x="15" y="6"/>
                </a:lnTo>
                <a:lnTo>
                  <a:pt x="16" y="7"/>
                </a:lnTo>
                <a:lnTo>
                  <a:pt x="17" y="6"/>
                </a:lnTo>
                <a:lnTo>
                  <a:pt x="17" y="5"/>
                </a:lnTo>
                <a:lnTo>
                  <a:pt x="18" y="6"/>
                </a:lnTo>
                <a:lnTo>
                  <a:pt x="19" y="6"/>
                </a:lnTo>
                <a:lnTo>
                  <a:pt x="20" y="6"/>
                </a:lnTo>
                <a:lnTo>
                  <a:pt x="21" y="6"/>
                </a:lnTo>
                <a:lnTo>
                  <a:pt x="22" y="6"/>
                </a:lnTo>
                <a:lnTo>
                  <a:pt x="23" y="6"/>
                </a:lnTo>
                <a:lnTo>
                  <a:pt x="24" y="7"/>
                </a:lnTo>
                <a:lnTo>
                  <a:pt x="25" y="7"/>
                </a:lnTo>
                <a:lnTo>
                  <a:pt x="25" y="6"/>
                </a:lnTo>
                <a:lnTo>
                  <a:pt x="26" y="4"/>
                </a:lnTo>
                <a:lnTo>
                  <a:pt x="27" y="6"/>
                </a:lnTo>
                <a:lnTo>
                  <a:pt x="28" y="5"/>
                </a:lnTo>
                <a:lnTo>
                  <a:pt x="29" y="6"/>
                </a:lnTo>
                <a:lnTo>
                  <a:pt x="30" y="6"/>
                </a:lnTo>
                <a:lnTo>
                  <a:pt x="31" y="6"/>
                </a:lnTo>
                <a:lnTo>
                  <a:pt x="32" y="6"/>
                </a:lnTo>
                <a:lnTo>
                  <a:pt x="32" y="5"/>
                </a:lnTo>
                <a:lnTo>
                  <a:pt x="33" y="5"/>
                </a:lnTo>
                <a:lnTo>
                  <a:pt x="34" y="5"/>
                </a:lnTo>
                <a:lnTo>
                  <a:pt x="35" y="6"/>
                </a:lnTo>
                <a:lnTo>
                  <a:pt x="36" y="6"/>
                </a:lnTo>
                <a:lnTo>
                  <a:pt x="37" y="4"/>
                </a:lnTo>
                <a:lnTo>
                  <a:pt x="38" y="5"/>
                </a:lnTo>
                <a:lnTo>
                  <a:pt x="39" y="6"/>
                </a:lnTo>
                <a:lnTo>
                  <a:pt x="40" y="5"/>
                </a:lnTo>
                <a:lnTo>
                  <a:pt x="40" y="4"/>
                </a:lnTo>
                <a:lnTo>
                  <a:pt x="41" y="4"/>
                </a:lnTo>
                <a:lnTo>
                  <a:pt x="42" y="5"/>
                </a:lnTo>
                <a:lnTo>
                  <a:pt x="43" y="4"/>
                </a:lnTo>
                <a:lnTo>
                  <a:pt x="44" y="4"/>
                </a:lnTo>
                <a:lnTo>
                  <a:pt x="45" y="5"/>
                </a:lnTo>
                <a:lnTo>
                  <a:pt x="46" y="4"/>
                </a:lnTo>
                <a:lnTo>
                  <a:pt x="47" y="4"/>
                </a:lnTo>
                <a:lnTo>
                  <a:pt x="47" y="4"/>
                </a:lnTo>
                <a:lnTo>
                  <a:pt x="48" y="4"/>
                </a:lnTo>
                <a:lnTo>
                  <a:pt x="49" y="5"/>
                </a:lnTo>
                <a:lnTo>
                  <a:pt x="50" y="5"/>
                </a:lnTo>
                <a:lnTo>
                  <a:pt x="51" y="4"/>
                </a:lnTo>
                <a:lnTo>
                  <a:pt x="52" y="4"/>
                </a:lnTo>
                <a:lnTo>
                  <a:pt x="53" y="4"/>
                </a:lnTo>
                <a:lnTo>
                  <a:pt x="54" y="5"/>
                </a:lnTo>
                <a:lnTo>
                  <a:pt x="55" y="5"/>
                </a:lnTo>
                <a:lnTo>
                  <a:pt x="55" y="5"/>
                </a:lnTo>
                <a:lnTo>
                  <a:pt x="56" y="5"/>
                </a:lnTo>
                <a:lnTo>
                  <a:pt x="57" y="6"/>
                </a:lnTo>
                <a:lnTo>
                  <a:pt x="58" y="5"/>
                </a:lnTo>
                <a:lnTo>
                  <a:pt x="59" y="5"/>
                </a:lnTo>
                <a:lnTo>
                  <a:pt x="60" y="3"/>
                </a:lnTo>
                <a:lnTo>
                  <a:pt x="61" y="3"/>
                </a:lnTo>
                <a:lnTo>
                  <a:pt x="62" y="3"/>
                </a:lnTo>
                <a:lnTo>
                  <a:pt x="62" y="4"/>
                </a:lnTo>
                <a:lnTo>
                  <a:pt x="63" y="5"/>
                </a:lnTo>
                <a:lnTo>
                  <a:pt x="64" y="4"/>
                </a:lnTo>
                <a:lnTo>
                  <a:pt x="65" y="5"/>
                </a:lnTo>
                <a:lnTo>
                  <a:pt x="66" y="3"/>
                </a:lnTo>
                <a:lnTo>
                  <a:pt x="67" y="4"/>
                </a:lnTo>
                <a:lnTo>
                  <a:pt x="68" y="4"/>
                </a:lnTo>
                <a:lnTo>
                  <a:pt x="69" y="4"/>
                </a:lnTo>
                <a:lnTo>
                  <a:pt x="70" y="3"/>
                </a:lnTo>
                <a:lnTo>
                  <a:pt x="70" y="4"/>
                </a:lnTo>
                <a:lnTo>
                  <a:pt x="71" y="3"/>
                </a:lnTo>
                <a:lnTo>
                  <a:pt x="72" y="3"/>
                </a:lnTo>
                <a:lnTo>
                  <a:pt x="73" y="3"/>
                </a:lnTo>
                <a:lnTo>
                  <a:pt x="74" y="4"/>
                </a:lnTo>
                <a:lnTo>
                  <a:pt x="75" y="4"/>
                </a:lnTo>
                <a:lnTo>
                  <a:pt x="76" y="4"/>
                </a:lnTo>
                <a:lnTo>
                  <a:pt x="77" y="4"/>
                </a:lnTo>
                <a:lnTo>
                  <a:pt x="77" y="4"/>
                </a:lnTo>
                <a:lnTo>
                  <a:pt x="78" y="4"/>
                </a:lnTo>
                <a:lnTo>
                  <a:pt x="79" y="3"/>
                </a:lnTo>
                <a:lnTo>
                  <a:pt x="80" y="3"/>
                </a:lnTo>
                <a:lnTo>
                  <a:pt x="81" y="2"/>
                </a:lnTo>
                <a:lnTo>
                  <a:pt x="82" y="3"/>
                </a:lnTo>
                <a:lnTo>
                  <a:pt x="83" y="2"/>
                </a:lnTo>
                <a:lnTo>
                  <a:pt x="84" y="3"/>
                </a:lnTo>
                <a:lnTo>
                  <a:pt x="85" y="2"/>
                </a:lnTo>
                <a:lnTo>
                  <a:pt x="85" y="3"/>
                </a:lnTo>
                <a:lnTo>
                  <a:pt x="86" y="4"/>
                </a:lnTo>
                <a:lnTo>
                  <a:pt x="87" y="3"/>
                </a:lnTo>
                <a:lnTo>
                  <a:pt x="88" y="3"/>
                </a:lnTo>
                <a:lnTo>
                  <a:pt x="89" y="4"/>
                </a:lnTo>
                <a:lnTo>
                  <a:pt x="90" y="3"/>
                </a:lnTo>
                <a:lnTo>
                  <a:pt x="91" y="5"/>
                </a:lnTo>
                <a:lnTo>
                  <a:pt x="92" y="4"/>
                </a:lnTo>
                <a:lnTo>
                  <a:pt x="92" y="2"/>
                </a:lnTo>
                <a:lnTo>
                  <a:pt x="93" y="4"/>
                </a:lnTo>
                <a:lnTo>
                  <a:pt x="94" y="4"/>
                </a:lnTo>
                <a:lnTo>
                  <a:pt x="95" y="4"/>
                </a:lnTo>
                <a:lnTo>
                  <a:pt x="96" y="3"/>
                </a:lnTo>
                <a:lnTo>
                  <a:pt x="97" y="3"/>
                </a:lnTo>
                <a:lnTo>
                  <a:pt x="98" y="4"/>
                </a:lnTo>
                <a:lnTo>
                  <a:pt x="99" y="3"/>
                </a:lnTo>
                <a:lnTo>
                  <a:pt x="100" y="3"/>
                </a:lnTo>
                <a:lnTo>
                  <a:pt x="100" y="3"/>
                </a:lnTo>
                <a:lnTo>
                  <a:pt x="101" y="3"/>
                </a:lnTo>
                <a:lnTo>
                  <a:pt x="102" y="3"/>
                </a:lnTo>
                <a:lnTo>
                  <a:pt x="103" y="3"/>
                </a:lnTo>
                <a:lnTo>
                  <a:pt x="104" y="4"/>
                </a:lnTo>
                <a:lnTo>
                  <a:pt x="105" y="4"/>
                </a:lnTo>
                <a:lnTo>
                  <a:pt x="106" y="2"/>
                </a:lnTo>
                <a:lnTo>
                  <a:pt x="107" y="3"/>
                </a:lnTo>
                <a:lnTo>
                  <a:pt x="107" y="2"/>
                </a:lnTo>
                <a:lnTo>
                  <a:pt x="108" y="5"/>
                </a:lnTo>
                <a:lnTo>
                  <a:pt x="109" y="3"/>
                </a:lnTo>
                <a:lnTo>
                  <a:pt x="110" y="3"/>
                </a:lnTo>
                <a:lnTo>
                  <a:pt x="111" y="3"/>
                </a:lnTo>
                <a:lnTo>
                  <a:pt x="112" y="4"/>
                </a:lnTo>
                <a:lnTo>
                  <a:pt x="113" y="4"/>
                </a:lnTo>
                <a:lnTo>
                  <a:pt x="114" y="3"/>
                </a:lnTo>
                <a:lnTo>
                  <a:pt x="115" y="2"/>
                </a:lnTo>
                <a:lnTo>
                  <a:pt x="115" y="3"/>
                </a:lnTo>
                <a:lnTo>
                  <a:pt x="116" y="3"/>
                </a:lnTo>
                <a:lnTo>
                  <a:pt x="117" y="4"/>
                </a:lnTo>
                <a:lnTo>
                  <a:pt x="118" y="2"/>
                </a:lnTo>
                <a:lnTo>
                  <a:pt x="119" y="2"/>
                </a:lnTo>
                <a:lnTo>
                  <a:pt x="120" y="3"/>
                </a:lnTo>
                <a:lnTo>
                  <a:pt x="121" y="4"/>
                </a:lnTo>
                <a:lnTo>
                  <a:pt x="122" y="2"/>
                </a:lnTo>
                <a:lnTo>
                  <a:pt x="122" y="2"/>
                </a:lnTo>
                <a:lnTo>
                  <a:pt x="123" y="3"/>
                </a:lnTo>
                <a:lnTo>
                  <a:pt x="124" y="3"/>
                </a:lnTo>
                <a:lnTo>
                  <a:pt x="125" y="2"/>
                </a:lnTo>
                <a:lnTo>
                  <a:pt x="126" y="1"/>
                </a:lnTo>
                <a:lnTo>
                  <a:pt x="127" y="2"/>
                </a:lnTo>
                <a:lnTo>
                  <a:pt x="128" y="3"/>
                </a:lnTo>
                <a:lnTo>
                  <a:pt x="129" y="3"/>
                </a:lnTo>
                <a:lnTo>
                  <a:pt x="130" y="2"/>
                </a:lnTo>
                <a:lnTo>
                  <a:pt x="130" y="4"/>
                </a:lnTo>
                <a:lnTo>
                  <a:pt x="131" y="3"/>
                </a:lnTo>
                <a:lnTo>
                  <a:pt x="132" y="1"/>
                </a:lnTo>
                <a:lnTo>
                  <a:pt x="133" y="2"/>
                </a:lnTo>
                <a:lnTo>
                  <a:pt x="134" y="3"/>
                </a:lnTo>
                <a:lnTo>
                  <a:pt x="135" y="4"/>
                </a:lnTo>
                <a:lnTo>
                  <a:pt x="136" y="2"/>
                </a:lnTo>
                <a:lnTo>
                  <a:pt x="137" y="3"/>
                </a:lnTo>
                <a:lnTo>
                  <a:pt x="137" y="3"/>
                </a:lnTo>
                <a:lnTo>
                  <a:pt x="138" y="4"/>
                </a:lnTo>
                <a:lnTo>
                  <a:pt x="139" y="3"/>
                </a:lnTo>
                <a:lnTo>
                  <a:pt x="140" y="4"/>
                </a:lnTo>
                <a:lnTo>
                  <a:pt x="141" y="3"/>
                </a:lnTo>
                <a:lnTo>
                  <a:pt x="142" y="3"/>
                </a:lnTo>
                <a:lnTo>
                  <a:pt x="143" y="3"/>
                </a:lnTo>
                <a:lnTo>
                  <a:pt x="144" y="3"/>
                </a:lnTo>
                <a:lnTo>
                  <a:pt x="145" y="2"/>
                </a:lnTo>
                <a:lnTo>
                  <a:pt x="145" y="2"/>
                </a:lnTo>
                <a:lnTo>
                  <a:pt x="146" y="2"/>
                </a:lnTo>
                <a:lnTo>
                  <a:pt x="147" y="3"/>
                </a:lnTo>
                <a:lnTo>
                  <a:pt x="148" y="3"/>
                </a:lnTo>
                <a:lnTo>
                  <a:pt x="149" y="2"/>
                </a:lnTo>
                <a:lnTo>
                  <a:pt x="150" y="3"/>
                </a:lnTo>
                <a:lnTo>
                  <a:pt x="151" y="2"/>
                </a:lnTo>
                <a:lnTo>
                  <a:pt x="152" y="3"/>
                </a:lnTo>
                <a:lnTo>
                  <a:pt x="152" y="3"/>
                </a:lnTo>
                <a:lnTo>
                  <a:pt x="153" y="2"/>
                </a:lnTo>
                <a:lnTo>
                  <a:pt x="154" y="3"/>
                </a:lnTo>
                <a:lnTo>
                  <a:pt x="155" y="3"/>
                </a:lnTo>
                <a:lnTo>
                  <a:pt x="156" y="4"/>
                </a:lnTo>
                <a:lnTo>
                  <a:pt x="157" y="3"/>
                </a:lnTo>
                <a:lnTo>
                  <a:pt x="158" y="4"/>
                </a:lnTo>
                <a:lnTo>
                  <a:pt x="159" y="3"/>
                </a:lnTo>
                <a:lnTo>
                  <a:pt x="159" y="6"/>
                </a:lnTo>
                <a:lnTo>
                  <a:pt x="160" y="4"/>
                </a:lnTo>
                <a:lnTo>
                  <a:pt x="161" y="4"/>
                </a:lnTo>
                <a:lnTo>
                  <a:pt x="162" y="4"/>
                </a:lnTo>
                <a:lnTo>
                  <a:pt x="163" y="6"/>
                </a:lnTo>
                <a:lnTo>
                  <a:pt x="164" y="5"/>
                </a:lnTo>
                <a:lnTo>
                  <a:pt x="165" y="6"/>
                </a:lnTo>
                <a:lnTo>
                  <a:pt x="166" y="6"/>
                </a:lnTo>
                <a:lnTo>
                  <a:pt x="167" y="4"/>
                </a:lnTo>
                <a:lnTo>
                  <a:pt x="167" y="4"/>
                </a:lnTo>
                <a:lnTo>
                  <a:pt x="168" y="6"/>
                </a:lnTo>
                <a:lnTo>
                  <a:pt x="169" y="6"/>
                </a:lnTo>
                <a:lnTo>
                  <a:pt x="170" y="6"/>
                </a:lnTo>
                <a:lnTo>
                  <a:pt x="171" y="8"/>
                </a:lnTo>
                <a:lnTo>
                  <a:pt x="172" y="6"/>
                </a:lnTo>
                <a:lnTo>
                  <a:pt x="173" y="7"/>
                </a:lnTo>
                <a:lnTo>
                  <a:pt x="174" y="7"/>
                </a:lnTo>
                <a:lnTo>
                  <a:pt x="174" y="8"/>
                </a:lnTo>
                <a:lnTo>
                  <a:pt x="175" y="8"/>
                </a:lnTo>
                <a:lnTo>
                  <a:pt x="176" y="7"/>
                </a:lnTo>
                <a:lnTo>
                  <a:pt x="177" y="6"/>
                </a:lnTo>
                <a:lnTo>
                  <a:pt x="178" y="7"/>
                </a:lnTo>
                <a:lnTo>
                  <a:pt x="179" y="6"/>
                </a:lnTo>
                <a:lnTo>
                  <a:pt x="180" y="7"/>
                </a:lnTo>
                <a:lnTo>
                  <a:pt x="181" y="5"/>
                </a:lnTo>
                <a:lnTo>
                  <a:pt x="182" y="6"/>
                </a:lnTo>
                <a:lnTo>
                  <a:pt x="182" y="7"/>
                </a:lnTo>
                <a:lnTo>
                  <a:pt x="183" y="6"/>
                </a:lnTo>
                <a:lnTo>
                  <a:pt x="184" y="6"/>
                </a:lnTo>
                <a:lnTo>
                  <a:pt x="185" y="6"/>
                </a:lnTo>
                <a:lnTo>
                  <a:pt x="186" y="6"/>
                </a:lnTo>
                <a:lnTo>
                  <a:pt x="187" y="5"/>
                </a:lnTo>
                <a:lnTo>
                  <a:pt x="188" y="7"/>
                </a:lnTo>
                <a:lnTo>
                  <a:pt x="189" y="6"/>
                </a:lnTo>
                <a:lnTo>
                  <a:pt x="189" y="5"/>
                </a:lnTo>
                <a:lnTo>
                  <a:pt x="190" y="6"/>
                </a:lnTo>
                <a:lnTo>
                  <a:pt x="191" y="5"/>
                </a:lnTo>
                <a:lnTo>
                  <a:pt x="192" y="5"/>
                </a:lnTo>
                <a:lnTo>
                  <a:pt x="193" y="5"/>
                </a:lnTo>
                <a:lnTo>
                  <a:pt x="194" y="5"/>
                </a:lnTo>
                <a:lnTo>
                  <a:pt x="195" y="4"/>
                </a:lnTo>
                <a:lnTo>
                  <a:pt x="196" y="4"/>
                </a:lnTo>
                <a:lnTo>
                  <a:pt x="197" y="4"/>
                </a:lnTo>
                <a:lnTo>
                  <a:pt x="197" y="4"/>
                </a:lnTo>
                <a:lnTo>
                  <a:pt x="198" y="4"/>
                </a:lnTo>
                <a:lnTo>
                  <a:pt x="199" y="3"/>
                </a:lnTo>
                <a:lnTo>
                  <a:pt x="200" y="4"/>
                </a:lnTo>
                <a:lnTo>
                  <a:pt x="201" y="3"/>
                </a:lnTo>
                <a:lnTo>
                  <a:pt x="202" y="3"/>
                </a:lnTo>
                <a:lnTo>
                  <a:pt x="203" y="4"/>
                </a:lnTo>
                <a:lnTo>
                  <a:pt x="204" y="3"/>
                </a:lnTo>
                <a:lnTo>
                  <a:pt x="204" y="3"/>
                </a:lnTo>
                <a:lnTo>
                  <a:pt x="205" y="2"/>
                </a:lnTo>
                <a:lnTo>
                  <a:pt x="206" y="3"/>
                </a:lnTo>
                <a:lnTo>
                  <a:pt x="207" y="3"/>
                </a:lnTo>
                <a:lnTo>
                  <a:pt x="208" y="4"/>
                </a:lnTo>
                <a:lnTo>
                  <a:pt x="209" y="2"/>
                </a:lnTo>
                <a:lnTo>
                  <a:pt x="210" y="2"/>
                </a:lnTo>
                <a:lnTo>
                  <a:pt x="211" y="3"/>
                </a:lnTo>
                <a:lnTo>
                  <a:pt x="212" y="3"/>
                </a:lnTo>
                <a:lnTo>
                  <a:pt x="212" y="3"/>
                </a:lnTo>
                <a:lnTo>
                  <a:pt x="213" y="3"/>
                </a:lnTo>
                <a:lnTo>
                  <a:pt x="214" y="2"/>
                </a:lnTo>
                <a:lnTo>
                  <a:pt x="215" y="3"/>
                </a:lnTo>
                <a:lnTo>
                  <a:pt x="216" y="3"/>
                </a:lnTo>
                <a:lnTo>
                  <a:pt x="217" y="2"/>
                </a:lnTo>
                <a:lnTo>
                  <a:pt x="218" y="4"/>
                </a:lnTo>
                <a:lnTo>
                  <a:pt x="219" y="5"/>
                </a:lnTo>
                <a:lnTo>
                  <a:pt x="219" y="5"/>
                </a:lnTo>
                <a:lnTo>
                  <a:pt x="220" y="6"/>
                </a:lnTo>
                <a:lnTo>
                  <a:pt x="221" y="7"/>
                </a:lnTo>
                <a:lnTo>
                  <a:pt x="222" y="7"/>
                </a:lnTo>
                <a:lnTo>
                  <a:pt x="223" y="10"/>
                </a:lnTo>
                <a:lnTo>
                  <a:pt x="224" y="9"/>
                </a:lnTo>
                <a:lnTo>
                  <a:pt x="225" y="9"/>
                </a:lnTo>
                <a:lnTo>
                  <a:pt x="226" y="9"/>
                </a:lnTo>
                <a:lnTo>
                  <a:pt x="227" y="8"/>
                </a:lnTo>
                <a:lnTo>
                  <a:pt x="227" y="7"/>
                </a:lnTo>
                <a:lnTo>
                  <a:pt x="228" y="6"/>
                </a:lnTo>
                <a:lnTo>
                  <a:pt x="229" y="9"/>
                </a:lnTo>
                <a:lnTo>
                  <a:pt x="230" y="6"/>
                </a:lnTo>
                <a:lnTo>
                  <a:pt x="231" y="4"/>
                </a:lnTo>
                <a:lnTo>
                  <a:pt x="232" y="4"/>
                </a:lnTo>
                <a:lnTo>
                  <a:pt x="233" y="4"/>
                </a:lnTo>
                <a:lnTo>
                  <a:pt x="234" y="5"/>
                </a:lnTo>
                <a:lnTo>
                  <a:pt x="234" y="3"/>
                </a:lnTo>
                <a:lnTo>
                  <a:pt x="235" y="2"/>
                </a:lnTo>
                <a:lnTo>
                  <a:pt x="236" y="5"/>
                </a:lnTo>
                <a:lnTo>
                  <a:pt x="237" y="3"/>
                </a:lnTo>
                <a:lnTo>
                  <a:pt x="238" y="4"/>
                </a:lnTo>
                <a:lnTo>
                  <a:pt x="239" y="4"/>
                </a:lnTo>
                <a:lnTo>
                  <a:pt x="240" y="3"/>
                </a:lnTo>
                <a:lnTo>
                  <a:pt x="241" y="2"/>
                </a:lnTo>
                <a:lnTo>
                  <a:pt x="242" y="2"/>
                </a:lnTo>
                <a:lnTo>
                  <a:pt x="242" y="3"/>
                </a:lnTo>
                <a:lnTo>
                  <a:pt x="243" y="2"/>
                </a:lnTo>
                <a:lnTo>
                  <a:pt x="244" y="2"/>
                </a:lnTo>
                <a:lnTo>
                  <a:pt x="245" y="2"/>
                </a:lnTo>
                <a:lnTo>
                  <a:pt x="246" y="2"/>
                </a:lnTo>
                <a:lnTo>
                  <a:pt x="247" y="2"/>
                </a:lnTo>
                <a:lnTo>
                  <a:pt x="248" y="2"/>
                </a:lnTo>
                <a:lnTo>
                  <a:pt x="249" y="3"/>
                </a:lnTo>
                <a:lnTo>
                  <a:pt x="249" y="2"/>
                </a:lnTo>
                <a:lnTo>
                  <a:pt x="250" y="2"/>
                </a:lnTo>
                <a:lnTo>
                  <a:pt x="251" y="2"/>
                </a:lnTo>
                <a:lnTo>
                  <a:pt x="252" y="3"/>
                </a:lnTo>
                <a:lnTo>
                  <a:pt x="253" y="4"/>
                </a:lnTo>
                <a:lnTo>
                  <a:pt x="254" y="2"/>
                </a:lnTo>
                <a:lnTo>
                  <a:pt x="255" y="2"/>
                </a:lnTo>
                <a:lnTo>
                  <a:pt x="256" y="3"/>
                </a:lnTo>
                <a:lnTo>
                  <a:pt x="257" y="2"/>
                </a:lnTo>
                <a:lnTo>
                  <a:pt x="257" y="2"/>
                </a:lnTo>
                <a:lnTo>
                  <a:pt x="258" y="3"/>
                </a:lnTo>
                <a:lnTo>
                  <a:pt x="259" y="2"/>
                </a:lnTo>
                <a:lnTo>
                  <a:pt x="260" y="1"/>
                </a:lnTo>
                <a:lnTo>
                  <a:pt x="261" y="2"/>
                </a:lnTo>
                <a:lnTo>
                  <a:pt x="262" y="1"/>
                </a:lnTo>
                <a:lnTo>
                  <a:pt x="263" y="2"/>
                </a:lnTo>
                <a:lnTo>
                  <a:pt x="264" y="1"/>
                </a:lnTo>
                <a:lnTo>
                  <a:pt x="264" y="2"/>
                </a:lnTo>
                <a:lnTo>
                  <a:pt x="265" y="1"/>
                </a:lnTo>
                <a:lnTo>
                  <a:pt x="266" y="1"/>
                </a:lnTo>
                <a:lnTo>
                  <a:pt x="267" y="3"/>
                </a:lnTo>
                <a:lnTo>
                  <a:pt x="268" y="3"/>
                </a:lnTo>
                <a:lnTo>
                  <a:pt x="269" y="2"/>
                </a:lnTo>
                <a:lnTo>
                  <a:pt x="270" y="2"/>
                </a:lnTo>
                <a:lnTo>
                  <a:pt x="271" y="2"/>
                </a:lnTo>
                <a:lnTo>
                  <a:pt x="272" y="2"/>
                </a:lnTo>
                <a:lnTo>
                  <a:pt x="272" y="2"/>
                </a:lnTo>
                <a:lnTo>
                  <a:pt x="273" y="3"/>
                </a:lnTo>
                <a:lnTo>
                  <a:pt x="274" y="2"/>
                </a:lnTo>
                <a:lnTo>
                  <a:pt x="275" y="3"/>
                </a:lnTo>
                <a:lnTo>
                  <a:pt x="276" y="2"/>
                </a:lnTo>
                <a:lnTo>
                  <a:pt x="277" y="2"/>
                </a:lnTo>
                <a:lnTo>
                  <a:pt x="278" y="4"/>
                </a:lnTo>
                <a:lnTo>
                  <a:pt x="279" y="1"/>
                </a:lnTo>
                <a:lnTo>
                  <a:pt x="279" y="2"/>
                </a:lnTo>
                <a:lnTo>
                  <a:pt x="280" y="2"/>
                </a:lnTo>
                <a:lnTo>
                  <a:pt x="281" y="1"/>
                </a:lnTo>
                <a:lnTo>
                  <a:pt x="282" y="2"/>
                </a:lnTo>
                <a:lnTo>
                  <a:pt x="283" y="3"/>
                </a:lnTo>
                <a:lnTo>
                  <a:pt x="284" y="3"/>
                </a:lnTo>
                <a:lnTo>
                  <a:pt x="285" y="1"/>
                </a:lnTo>
                <a:lnTo>
                  <a:pt x="286" y="1"/>
                </a:lnTo>
                <a:lnTo>
                  <a:pt x="287" y="0"/>
                </a:lnTo>
                <a:lnTo>
                  <a:pt x="287" y="1"/>
                </a:lnTo>
                <a:lnTo>
                  <a:pt x="288" y="2"/>
                </a:lnTo>
                <a:lnTo>
                  <a:pt x="289" y="3"/>
                </a:lnTo>
                <a:lnTo>
                  <a:pt x="290" y="1"/>
                </a:lnTo>
                <a:lnTo>
                  <a:pt x="291" y="2"/>
                </a:lnTo>
                <a:lnTo>
                  <a:pt x="292" y="4"/>
                </a:lnTo>
                <a:lnTo>
                  <a:pt x="293" y="3"/>
                </a:lnTo>
                <a:lnTo>
                  <a:pt x="294" y="2"/>
                </a:lnTo>
                <a:lnTo>
                  <a:pt x="294" y="3"/>
                </a:lnTo>
                <a:lnTo>
                  <a:pt x="295" y="2"/>
                </a:lnTo>
                <a:lnTo>
                  <a:pt x="296" y="2"/>
                </a:lnTo>
                <a:lnTo>
                  <a:pt x="297" y="2"/>
                </a:lnTo>
                <a:lnTo>
                  <a:pt x="298" y="2"/>
                </a:lnTo>
                <a:lnTo>
                  <a:pt x="299" y="2"/>
                </a:lnTo>
                <a:lnTo>
                  <a:pt x="300" y="2"/>
                </a:lnTo>
                <a:lnTo>
                  <a:pt x="301" y="3"/>
                </a:lnTo>
                <a:lnTo>
                  <a:pt x="302" y="2"/>
                </a:lnTo>
                <a:lnTo>
                  <a:pt x="302" y="1"/>
                </a:lnTo>
                <a:lnTo>
                  <a:pt x="303" y="2"/>
                </a:lnTo>
                <a:lnTo>
                  <a:pt x="304" y="3"/>
                </a:lnTo>
                <a:lnTo>
                  <a:pt x="305" y="2"/>
                </a:lnTo>
                <a:lnTo>
                  <a:pt x="306" y="1"/>
                </a:lnTo>
                <a:lnTo>
                  <a:pt x="307" y="2"/>
                </a:lnTo>
                <a:lnTo>
                  <a:pt x="308" y="2"/>
                </a:lnTo>
                <a:lnTo>
                  <a:pt x="309" y="2"/>
                </a:lnTo>
                <a:lnTo>
                  <a:pt x="309" y="1"/>
                </a:lnTo>
                <a:lnTo>
                  <a:pt x="310" y="3"/>
                </a:lnTo>
                <a:lnTo>
                  <a:pt x="311" y="2"/>
                </a:lnTo>
                <a:lnTo>
                  <a:pt x="312" y="3"/>
                </a:lnTo>
                <a:lnTo>
                  <a:pt x="313" y="1"/>
                </a:lnTo>
                <a:lnTo>
                  <a:pt x="314" y="3"/>
                </a:lnTo>
                <a:lnTo>
                  <a:pt x="315" y="4"/>
                </a:lnTo>
                <a:lnTo>
                  <a:pt x="316" y="3"/>
                </a:lnTo>
                <a:lnTo>
                  <a:pt x="317" y="3"/>
                </a:lnTo>
                <a:lnTo>
                  <a:pt x="317" y="3"/>
                </a:lnTo>
                <a:lnTo>
                  <a:pt x="318" y="3"/>
                </a:lnTo>
                <a:lnTo>
                  <a:pt x="319" y="3"/>
                </a:lnTo>
                <a:lnTo>
                  <a:pt x="320" y="4"/>
                </a:lnTo>
                <a:lnTo>
                  <a:pt x="321" y="4"/>
                </a:lnTo>
                <a:lnTo>
                  <a:pt x="322" y="4"/>
                </a:lnTo>
                <a:lnTo>
                  <a:pt x="323" y="3"/>
                </a:lnTo>
                <a:lnTo>
                  <a:pt x="324" y="3"/>
                </a:lnTo>
                <a:lnTo>
                  <a:pt x="324" y="4"/>
                </a:lnTo>
                <a:lnTo>
                  <a:pt x="325" y="3"/>
                </a:lnTo>
                <a:lnTo>
                  <a:pt x="326" y="3"/>
                </a:lnTo>
                <a:lnTo>
                  <a:pt x="327" y="3"/>
                </a:lnTo>
                <a:lnTo>
                  <a:pt x="328" y="4"/>
                </a:lnTo>
                <a:lnTo>
                  <a:pt x="329" y="2"/>
                </a:lnTo>
                <a:lnTo>
                  <a:pt x="330" y="4"/>
                </a:lnTo>
                <a:lnTo>
                  <a:pt x="331" y="3"/>
                </a:lnTo>
                <a:lnTo>
                  <a:pt x="332" y="3"/>
                </a:lnTo>
                <a:lnTo>
                  <a:pt x="332" y="5"/>
                </a:lnTo>
                <a:lnTo>
                  <a:pt x="333" y="4"/>
                </a:lnTo>
                <a:lnTo>
                  <a:pt x="334" y="5"/>
                </a:lnTo>
                <a:lnTo>
                  <a:pt x="335" y="5"/>
                </a:lnTo>
                <a:lnTo>
                  <a:pt x="336" y="5"/>
                </a:lnTo>
                <a:lnTo>
                  <a:pt x="337" y="4"/>
                </a:lnTo>
                <a:lnTo>
                  <a:pt x="338" y="4"/>
                </a:lnTo>
                <a:lnTo>
                  <a:pt x="339" y="5"/>
                </a:lnTo>
                <a:lnTo>
                  <a:pt x="339" y="5"/>
                </a:lnTo>
                <a:lnTo>
                  <a:pt x="340" y="5"/>
                </a:lnTo>
                <a:lnTo>
                  <a:pt x="341" y="6"/>
                </a:lnTo>
                <a:lnTo>
                  <a:pt x="342" y="5"/>
                </a:lnTo>
                <a:lnTo>
                  <a:pt x="343" y="7"/>
                </a:lnTo>
                <a:lnTo>
                  <a:pt x="344" y="6"/>
                </a:lnTo>
                <a:lnTo>
                  <a:pt x="345" y="6"/>
                </a:lnTo>
                <a:lnTo>
                  <a:pt x="346" y="5"/>
                </a:lnTo>
                <a:lnTo>
                  <a:pt x="347" y="5"/>
                </a:lnTo>
                <a:lnTo>
                  <a:pt x="347" y="5"/>
                </a:lnTo>
                <a:lnTo>
                  <a:pt x="348" y="5"/>
                </a:lnTo>
                <a:lnTo>
                  <a:pt x="349" y="5"/>
                </a:lnTo>
                <a:lnTo>
                  <a:pt x="350" y="4"/>
                </a:lnTo>
                <a:lnTo>
                  <a:pt x="351" y="6"/>
                </a:lnTo>
                <a:lnTo>
                  <a:pt x="352" y="6"/>
                </a:lnTo>
                <a:lnTo>
                  <a:pt x="353" y="6"/>
                </a:lnTo>
                <a:lnTo>
                  <a:pt x="354" y="6"/>
                </a:lnTo>
                <a:lnTo>
                  <a:pt x="354" y="6"/>
                </a:lnTo>
                <a:lnTo>
                  <a:pt x="355" y="6"/>
                </a:lnTo>
                <a:lnTo>
                  <a:pt x="356" y="6"/>
                </a:lnTo>
                <a:lnTo>
                  <a:pt x="357" y="5"/>
                </a:lnTo>
                <a:lnTo>
                  <a:pt x="358" y="4"/>
                </a:lnTo>
                <a:lnTo>
                  <a:pt x="359" y="6"/>
                </a:lnTo>
                <a:lnTo>
                  <a:pt x="360" y="6"/>
                </a:lnTo>
                <a:lnTo>
                  <a:pt x="361" y="5"/>
                </a:lnTo>
                <a:lnTo>
                  <a:pt x="361" y="5"/>
                </a:lnTo>
                <a:lnTo>
                  <a:pt x="362" y="6"/>
                </a:lnTo>
                <a:lnTo>
                  <a:pt x="363" y="6"/>
                </a:lnTo>
                <a:lnTo>
                  <a:pt x="364" y="6"/>
                </a:lnTo>
                <a:lnTo>
                  <a:pt x="365" y="6"/>
                </a:lnTo>
                <a:lnTo>
                  <a:pt x="366" y="5"/>
                </a:lnTo>
                <a:lnTo>
                  <a:pt x="367" y="6"/>
                </a:lnTo>
                <a:lnTo>
                  <a:pt x="368" y="7"/>
                </a:lnTo>
                <a:lnTo>
                  <a:pt x="369" y="6"/>
                </a:lnTo>
                <a:lnTo>
                  <a:pt x="369" y="7"/>
                </a:lnTo>
                <a:lnTo>
                  <a:pt x="370" y="8"/>
                </a:lnTo>
                <a:lnTo>
                  <a:pt x="371" y="6"/>
                </a:lnTo>
                <a:lnTo>
                  <a:pt x="372" y="7"/>
                </a:lnTo>
                <a:lnTo>
                  <a:pt x="373" y="8"/>
                </a:lnTo>
                <a:lnTo>
                  <a:pt x="374" y="6"/>
                </a:lnTo>
                <a:lnTo>
                  <a:pt x="375" y="7"/>
                </a:lnTo>
                <a:lnTo>
                  <a:pt x="376" y="7"/>
                </a:lnTo>
                <a:lnTo>
                  <a:pt x="376" y="5"/>
                </a:lnTo>
                <a:lnTo>
                  <a:pt x="377" y="5"/>
                </a:lnTo>
                <a:lnTo>
                  <a:pt x="378" y="5"/>
                </a:lnTo>
                <a:lnTo>
                  <a:pt x="379" y="5"/>
                </a:lnTo>
                <a:lnTo>
                  <a:pt x="380" y="5"/>
                </a:lnTo>
                <a:lnTo>
                  <a:pt x="381" y="5"/>
                </a:lnTo>
                <a:lnTo>
                  <a:pt x="382" y="5"/>
                </a:lnTo>
                <a:lnTo>
                  <a:pt x="383" y="7"/>
                </a:lnTo>
                <a:lnTo>
                  <a:pt x="384" y="4"/>
                </a:lnTo>
                <a:lnTo>
                  <a:pt x="384" y="5"/>
                </a:lnTo>
                <a:lnTo>
                  <a:pt x="385" y="4"/>
                </a:lnTo>
                <a:lnTo>
                  <a:pt x="386" y="6"/>
                </a:lnTo>
                <a:lnTo>
                  <a:pt x="387" y="5"/>
                </a:lnTo>
                <a:lnTo>
                  <a:pt x="388" y="5"/>
                </a:lnTo>
                <a:lnTo>
                  <a:pt x="389" y="6"/>
                </a:lnTo>
                <a:lnTo>
                  <a:pt x="390" y="4"/>
                </a:lnTo>
                <a:lnTo>
                  <a:pt x="391" y="6"/>
                </a:lnTo>
                <a:lnTo>
                  <a:pt x="391" y="6"/>
                </a:lnTo>
                <a:lnTo>
                  <a:pt x="392" y="6"/>
                </a:lnTo>
                <a:lnTo>
                  <a:pt x="393" y="5"/>
                </a:lnTo>
                <a:lnTo>
                  <a:pt x="394" y="4"/>
                </a:lnTo>
                <a:lnTo>
                  <a:pt x="395" y="5"/>
                </a:lnTo>
                <a:lnTo>
                  <a:pt x="396" y="5"/>
                </a:lnTo>
                <a:lnTo>
                  <a:pt x="397" y="5"/>
                </a:lnTo>
                <a:lnTo>
                  <a:pt x="398" y="5"/>
                </a:lnTo>
                <a:lnTo>
                  <a:pt x="399" y="6"/>
                </a:lnTo>
                <a:lnTo>
                  <a:pt x="399" y="5"/>
                </a:lnTo>
                <a:lnTo>
                  <a:pt x="400" y="4"/>
                </a:lnTo>
                <a:lnTo>
                  <a:pt x="401" y="5"/>
                </a:lnTo>
                <a:lnTo>
                  <a:pt x="402" y="3"/>
                </a:lnTo>
                <a:lnTo>
                  <a:pt x="403" y="4"/>
                </a:lnTo>
                <a:lnTo>
                  <a:pt x="404" y="5"/>
                </a:lnTo>
                <a:lnTo>
                  <a:pt x="405" y="4"/>
                </a:lnTo>
                <a:lnTo>
                  <a:pt x="406" y="5"/>
                </a:lnTo>
                <a:lnTo>
                  <a:pt x="406" y="6"/>
                </a:lnTo>
                <a:lnTo>
                  <a:pt x="407" y="5"/>
                </a:lnTo>
                <a:lnTo>
                  <a:pt x="408" y="5"/>
                </a:lnTo>
                <a:lnTo>
                  <a:pt x="409" y="5"/>
                </a:lnTo>
                <a:lnTo>
                  <a:pt x="410" y="5"/>
                </a:lnTo>
                <a:lnTo>
                  <a:pt x="411" y="5"/>
                </a:lnTo>
                <a:lnTo>
                  <a:pt x="412" y="5"/>
                </a:lnTo>
                <a:lnTo>
                  <a:pt x="413" y="6"/>
                </a:lnTo>
                <a:lnTo>
                  <a:pt x="414" y="5"/>
                </a:lnTo>
                <a:lnTo>
                  <a:pt x="414" y="4"/>
                </a:lnTo>
                <a:lnTo>
                  <a:pt x="415" y="6"/>
                </a:lnTo>
                <a:lnTo>
                  <a:pt x="416" y="6"/>
                </a:lnTo>
                <a:lnTo>
                  <a:pt x="417" y="6"/>
                </a:lnTo>
                <a:lnTo>
                  <a:pt x="418" y="6"/>
                </a:lnTo>
                <a:lnTo>
                  <a:pt x="419" y="5"/>
                </a:lnTo>
                <a:lnTo>
                  <a:pt x="420" y="7"/>
                </a:lnTo>
                <a:lnTo>
                  <a:pt x="421" y="6"/>
                </a:lnTo>
                <a:lnTo>
                  <a:pt x="421" y="5"/>
                </a:lnTo>
                <a:lnTo>
                  <a:pt x="422" y="5"/>
                </a:lnTo>
                <a:lnTo>
                  <a:pt x="423" y="5"/>
                </a:lnTo>
                <a:lnTo>
                  <a:pt x="424" y="5"/>
                </a:lnTo>
                <a:lnTo>
                  <a:pt x="425" y="6"/>
                </a:lnTo>
                <a:lnTo>
                  <a:pt x="426" y="7"/>
                </a:lnTo>
                <a:lnTo>
                  <a:pt x="427" y="8"/>
                </a:lnTo>
                <a:lnTo>
                  <a:pt x="428" y="9"/>
                </a:lnTo>
                <a:lnTo>
                  <a:pt x="429" y="6"/>
                </a:lnTo>
                <a:lnTo>
                  <a:pt x="429" y="8"/>
                </a:lnTo>
                <a:lnTo>
                  <a:pt x="430" y="6"/>
                </a:lnTo>
                <a:lnTo>
                  <a:pt x="431" y="7"/>
                </a:lnTo>
                <a:lnTo>
                  <a:pt x="432" y="7"/>
                </a:lnTo>
                <a:lnTo>
                  <a:pt x="433" y="6"/>
                </a:lnTo>
                <a:lnTo>
                  <a:pt x="434" y="5"/>
                </a:lnTo>
                <a:lnTo>
                  <a:pt x="435" y="6"/>
                </a:lnTo>
                <a:lnTo>
                  <a:pt x="436" y="6"/>
                </a:lnTo>
                <a:lnTo>
                  <a:pt x="436" y="6"/>
                </a:lnTo>
                <a:lnTo>
                  <a:pt x="437" y="6"/>
                </a:lnTo>
                <a:lnTo>
                  <a:pt x="438" y="6"/>
                </a:lnTo>
                <a:lnTo>
                  <a:pt x="439" y="6"/>
                </a:lnTo>
                <a:lnTo>
                  <a:pt x="440" y="7"/>
                </a:lnTo>
                <a:lnTo>
                  <a:pt x="441" y="6"/>
                </a:lnTo>
                <a:lnTo>
                  <a:pt x="442" y="6"/>
                </a:lnTo>
                <a:lnTo>
                  <a:pt x="443" y="6"/>
                </a:lnTo>
                <a:lnTo>
                  <a:pt x="444" y="6"/>
                </a:lnTo>
                <a:lnTo>
                  <a:pt x="444" y="7"/>
                </a:lnTo>
                <a:lnTo>
                  <a:pt x="445" y="6"/>
                </a:lnTo>
                <a:lnTo>
                  <a:pt x="446" y="8"/>
                </a:lnTo>
                <a:lnTo>
                  <a:pt x="447" y="7"/>
                </a:lnTo>
                <a:lnTo>
                  <a:pt x="448" y="6"/>
                </a:lnTo>
                <a:lnTo>
                  <a:pt x="449" y="7"/>
                </a:lnTo>
                <a:lnTo>
                  <a:pt x="450" y="6"/>
                </a:lnTo>
                <a:lnTo>
                  <a:pt x="451" y="8"/>
                </a:lnTo>
                <a:lnTo>
                  <a:pt x="451" y="9"/>
                </a:lnTo>
                <a:lnTo>
                  <a:pt x="452" y="7"/>
                </a:lnTo>
                <a:lnTo>
                  <a:pt x="453" y="7"/>
                </a:lnTo>
                <a:lnTo>
                  <a:pt x="454" y="8"/>
                </a:lnTo>
                <a:lnTo>
                  <a:pt x="455" y="6"/>
                </a:lnTo>
                <a:lnTo>
                  <a:pt x="456" y="8"/>
                </a:lnTo>
                <a:lnTo>
                  <a:pt x="457" y="9"/>
                </a:lnTo>
                <a:lnTo>
                  <a:pt x="458" y="9"/>
                </a:lnTo>
                <a:lnTo>
                  <a:pt x="459" y="7"/>
                </a:lnTo>
                <a:lnTo>
                  <a:pt x="459" y="7"/>
                </a:lnTo>
                <a:lnTo>
                  <a:pt x="460" y="6"/>
                </a:lnTo>
                <a:lnTo>
                  <a:pt x="461" y="4"/>
                </a:lnTo>
                <a:lnTo>
                  <a:pt x="462" y="5"/>
                </a:lnTo>
                <a:lnTo>
                  <a:pt x="463" y="8"/>
                </a:lnTo>
                <a:lnTo>
                  <a:pt x="464" y="7"/>
                </a:lnTo>
                <a:lnTo>
                  <a:pt x="465" y="4"/>
                </a:lnTo>
                <a:lnTo>
                  <a:pt x="466" y="7"/>
                </a:lnTo>
                <a:lnTo>
                  <a:pt x="466" y="4"/>
                </a:lnTo>
                <a:lnTo>
                  <a:pt x="467" y="4"/>
                </a:lnTo>
                <a:lnTo>
                  <a:pt x="468" y="5"/>
                </a:lnTo>
                <a:lnTo>
                  <a:pt x="469" y="4"/>
                </a:lnTo>
                <a:lnTo>
                  <a:pt x="470" y="5"/>
                </a:lnTo>
                <a:lnTo>
                  <a:pt x="471" y="4"/>
                </a:lnTo>
                <a:lnTo>
                  <a:pt x="472" y="6"/>
                </a:lnTo>
                <a:lnTo>
                  <a:pt x="473" y="5"/>
                </a:lnTo>
                <a:lnTo>
                  <a:pt x="474" y="5"/>
                </a:lnTo>
                <a:lnTo>
                  <a:pt x="474" y="6"/>
                </a:lnTo>
                <a:lnTo>
                  <a:pt x="475" y="3"/>
                </a:lnTo>
                <a:lnTo>
                  <a:pt x="476" y="4"/>
                </a:lnTo>
                <a:lnTo>
                  <a:pt x="477" y="6"/>
                </a:lnTo>
                <a:lnTo>
                  <a:pt x="478" y="6"/>
                </a:lnTo>
                <a:lnTo>
                  <a:pt x="479" y="4"/>
                </a:lnTo>
                <a:lnTo>
                  <a:pt x="480" y="5"/>
                </a:lnTo>
                <a:lnTo>
                  <a:pt x="481" y="4"/>
                </a:lnTo>
                <a:lnTo>
                  <a:pt x="481" y="4"/>
                </a:lnTo>
                <a:lnTo>
                  <a:pt x="482" y="5"/>
                </a:lnTo>
                <a:lnTo>
                  <a:pt x="483" y="4"/>
                </a:lnTo>
                <a:lnTo>
                  <a:pt x="484" y="3"/>
                </a:lnTo>
                <a:lnTo>
                  <a:pt x="485" y="3"/>
                </a:lnTo>
                <a:lnTo>
                  <a:pt x="486" y="4"/>
                </a:lnTo>
                <a:lnTo>
                  <a:pt x="487" y="4"/>
                </a:lnTo>
                <a:lnTo>
                  <a:pt x="488" y="4"/>
                </a:lnTo>
                <a:lnTo>
                  <a:pt x="489" y="5"/>
                </a:lnTo>
                <a:lnTo>
                  <a:pt x="489" y="5"/>
                </a:lnTo>
                <a:lnTo>
                  <a:pt x="490" y="3"/>
                </a:lnTo>
                <a:lnTo>
                  <a:pt x="491" y="3"/>
                </a:lnTo>
                <a:lnTo>
                  <a:pt x="492" y="4"/>
                </a:lnTo>
                <a:lnTo>
                  <a:pt x="493" y="4"/>
                </a:lnTo>
                <a:lnTo>
                  <a:pt x="494" y="4"/>
                </a:lnTo>
                <a:lnTo>
                  <a:pt x="495" y="4"/>
                </a:lnTo>
                <a:lnTo>
                  <a:pt x="496" y="5"/>
                </a:lnTo>
                <a:lnTo>
                  <a:pt x="496" y="2"/>
                </a:lnTo>
                <a:lnTo>
                  <a:pt x="497" y="4"/>
                </a:lnTo>
                <a:lnTo>
                  <a:pt x="498" y="3"/>
                </a:lnTo>
                <a:lnTo>
                  <a:pt x="499" y="6"/>
                </a:lnTo>
                <a:lnTo>
                  <a:pt x="500" y="3"/>
                </a:lnTo>
                <a:lnTo>
                  <a:pt x="501" y="5"/>
                </a:lnTo>
                <a:lnTo>
                  <a:pt x="502" y="3"/>
                </a:lnTo>
                <a:lnTo>
                  <a:pt x="503" y="3"/>
                </a:lnTo>
                <a:lnTo>
                  <a:pt x="504" y="4"/>
                </a:lnTo>
                <a:lnTo>
                  <a:pt x="504" y="3"/>
                </a:lnTo>
                <a:lnTo>
                  <a:pt x="505" y="4"/>
                </a:lnTo>
                <a:lnTo>
                  <a:pt x="506" y="4"/>
                </a:lnTo>
                <a:lnTo>
                  <a:pt x="507" y="5"/>
                </a:lnTo>
                <a:lnTo>
                  <a:pt x="508" y="3"/>
                </a:lnTo>
                <a:lnTo>
                  <a:pt x="509" y="3"/>
                </a:lnTo>
                <a:lnTo>
                  <a:pt x="510" y="4"/>
                </a:lnTo>
                <a:lnTo>
                  <a:pt x="511" y="5"/>
                </a:lnTo>
                <a:lnTo>
                  <a:pt x="511" y="4"/>
                </a:lnTo>
                <a:lnTo>
                  <a:pt x="512" y="4"/>
                </a:lnTo>
                <a:lnTo>
                  <a:pt x="513" y="5"/>
                </a:lnTo>
                <a:lnTo>
                  <a:pt x="514" y="4"/>
                </a:lnTo>
                <a:lnTo>
                  <a:pt x="515" y="4"/>
                </a:lnTo>
                <a:lnTo>
                  <a:pt x="516" y="6"/>
                </a:lnTo>
                <a:lnTo>
                  <a:pt x="517" y="5"/>
                </a:lnTo>
                <a:lnTo>
                  <a:pt x="518" y="6"/>
                </a:lnTo>
                <a:lnTo>
                  <a:pt x="519" y="5"/>
                </a:lnTo>
                <a:lnTo>
                  <a:pt x="519" y="6"/>
                </a:lnTo>
                <a:lnTo>
                  <a:pt x="520" y="6"/>
                </a:lnTo>
                <a:lnTo>
                  <a:pt x="521" y="6"/>
                </a:lnTo>
                <a:lnTo>
                  <a:pt x="522" y="6"/>
                </a:lnTo>
                <a:lnTo>
                  <a:pt x="523" y="6"/>
                </a:lnTo>
                <a:lnTo>
                  <a:pt x="524" y="6"/>
                </a:lnTo>
                <a:lnTo>
                  <a:pt x="525" y="6"/>
                </a:lnTo>
                <a:lnTo>
                  <a:pt x="526" y="6"/>
                </a:lnTo>
                <a:lnTo>
                  <a:pt x="526" y="5"/>
                </a:lnTo>
                <a:lnTo>
                  <a:pt x="527" y="5"/>
                </a:lnTo>
                <a:lnTo>
                  <a:pt x="528" y="4"/>
                </a:lnTo>
                <a:lnTo>
                  <a:pt x="529" y="5"/>
                </a:lnTo>
                <a:lnTo>
                  <a:pt x="530" y="4"/>
                </a:lnTo>
                <a:lnTo>
                  <a:pt x="531" y="4"/>
                </a:lnTo>
                <a:lnTo>
                  <a:pt x="532" y="4"/>
                </a:lnTo>
                <a:lnTo>
                  <a:pt x="533" y="5"/>
                </a:lnTo>
                <a:lnTo>
                  <a:pt x="534" y="4"/>
                </a:lnTo>
                <a:lnTo>
                  <a:pt x="534" y="5"/>
                </a:lnTo>
                <a:lnTo>
                  <a:pt x="535" y="5"/>
                </a:lnTo>
                <a:lnTo>
                  <a:pt x="536" y="5"/>
                </a:lnTo>
                <a:lnTo>
                  <a:pt x="537" y="4"/>
                </a:lnTo>
                <a:lnTo>
                  <a:pt x="538" y="4"/>
                </a:lnTo>
                <a:lnTo>
                  <a:pt x="539" y="4"/>
                </a:lnTo>
                <a:lnTo>
                  <a:pt x="540" y="4"/>
                </a:lnTo>
                <a:lnTo>
                  <a:pt x="541" y="5"/>
                </a:lnTo>
                <a:lnTo>
                  <a:pt x="541" y="4"/>
                </a:lnTo>
                <a:lnTo>
                  <a:pt x="542" y="4"/>
                </a:lnTo>
                <a:lnTo>
                  <a:pt x="543" y="4"/>
                </a:lnTo>
                <a:lnTo>
                  <a:pt x="544" y="4"/>
                </a:lnTo>
                <a:lnTo>
                  <a:pt x="545" y="4"/>
                </a:lnTo>
                <a:lnTo>
                  <a:pt x="546" y="4"/>
                </a:lnTo>
                <a:lnTo>
                  <a:pt x="547" y="5"/>
                </a:lnTo>
                <a:lnTo>
                  <a:pt x="548" y="4"/>
                </a:lnTo>
                <a:lnTo>
                  <a:pt x="549" y="3"/>
                </a:lnTo>
                <a:lnTo>
                  <a:pt x="549" y="3"/>
                </a:lnTo>
                <a:lnTo>
                  <a:pt x="550" y="4"/>
                </a:lnTo>
                <a:lnTo>
                  <a:pt x="551" y="4"/>
                </a:lnTo>
                <a:lnTo>
                  <a:pt x="552" y="4"/>
                </a:lnTo>
                <a:lnTo>
                  <a:pt x="553" y="4"/>
                </a:lnTo>
                <a:lnTo>
                  <a:pt x="554" y="5"/>
                </a:lnTo>
                <a:lnTo>
                  <a:pt x="555" y="4"/>
                </a:lnTo>
                <a:lnTo>
                  <a:pt x="556" y="3"/>
                </a:lnTo>
                <a:lnTo>
                  <a:pt x="556" y="3"/>
                </a:lnTo>
                <a:lnTo>
                  <a:pt x="557" y="5"/>
                </a:lnTo>
                <a:lnTo>
                  <a:pt x="558" y="4"/>
                </a:lnTo>
                <a:lnTo>
                  <a:pt x="559" y="4"/>
                </a:lnTo>
                <a:lnTo>
                  <a:pt x="560" y="3"/>
                </a:lnTo>
                <a:lnTo>
                  <a:pt x="561" y="3"/>
                </a:lnTo>
                <a:lnTo>
                  <a:pt x="562" y="3"/>
                </a:lnTo>
                <a:lnTo>
                  <a:pt x="563" y="3"/>
                </a:lnTo>
                <a:lnTo>
                  <a:pt x="563" y="4"/>
                </a:lnTo>
                <a:lnTo>
                  <a:pt x="564" y="2"/>
                </a:lnTo>
                <a:lnTo>
                  <a:pt x="565" y="2"/>
                </a:lnTo>
                <a:lnTo>
                  <a:pt x="566" y="3"/>
                </a:lnTo>
                <a:lnTo>
                  <a:pt x="567" y="4"/>
                </a:lnTo>
                <a:lnTo>
                  <a:pt x="568" y="3"/>
                </a:lnTo>
                <a:lnTo>
                  <a:pt x="569" y="3"/>
                </a:lnTo>
                <a:lnTo>
                  <a:pt x="570" y="3"/>
                </a:lnTo>
                <a:lnTo>
                  <a:pt x="571" y="3"/>
                </a:lnTo>
                <a:lnTo>
                  <a:pt x="571" y="1"/>
                </a:lnTo>
                <a:lnTo>
                  <a:pt x="572" y="2"/>
                </a:lnTo>
                <a:lnTo>
                  <a:pt x="573" y="3"/>
                </a:lnTo>
                <a:lnTo>
                  <a:pt x="574" y="3"/>
                </a:lnTo>
                <a:lnTo>
                  <a:pt x="575" y="3"/>
                </a:lnTo>
                <a:lnTo>
                  <a:pt x="576" y="3"/>
                </a:lnTo>
                <a:lnTo>
                  <a:pt x="577" y="2"/>
                </a:lnTo>
                <a:lnTo>
                  <a:pt x="578" y="2"/>
                </a:lnTo>
                <a:lnTo>
                  <a:pt x="578" y="4"/>
                </a:lnTo>
                <a:lnTo>
                  <a:pt x="579" y="2"/>
                </a:lnTo>
                <a:lnTo>
                  <a:pt x="580" y="2"/>
                </a:lnTo>
                <a:lnTo>
                  <a:pt x="581" y="4"/>
                </a:lnTo>
                <a:lnTo>
                  <a:pt x="582" y="3"/>
                </a:lnTo>
                <a:lnTo>
                  <a:pt x="583" y="2"/>
                </a:lnTo>
                <a:lnTo>
                  <a:pt x="584" y="3"/>
                </a:lnTo>
                <a:lnTo>
                  <a:pt x="585" y="2"/>
                </a:lnTo>
                <a:lnTo>
                  <a:pt x="586" y="2"/>
                </a:lnTo>
                <a:lnTo>
                  <a:pt x="586" y="2"/>
                </a:lnTo>
                <a:lnTo>
                  <a:pt x="587" y="3"/>
                </a:lnTo>
                <a:lnTo>
                  <a:pt x="588" y="3"/>
                </a:lnTo>
                <a:lnTo>
                  <a:pt x="589" y="3"/>
                </a:lnTo>
                <a:lnTo>
                  <a:pt x="590" y="2"/>
                </a:lnTo>
                <a:lnTo>
                  <a:pt x="591" y="2"/>
                </a:lnTo>
                <a:lnTo>
                  <a:pt x="592" y="4"/>
                </a:lnTo>
                <a:lnTo>
                  <a:pt x="593" y="3"/>
                </a:lnTo>
                <a:lnTo>
                  <a:pt x="593" y="3"/>
                </a:lnTo>
                <a:lnTo>
                  <a:pt x="594" y="3"/>
                </a:lnTo>
                <a:lnTo>
                  <a:pt x="595" y="4"/>
                </a:lnTo>
                <a:lnTo>
                  <a:pt x="596" y="2"/>
                </a:lnTo>
                <a:lnTo>
                  <a:pt x="597" y="3"/>
                </a:lnTo>
                <a:lnTo>
                  <a:pt x="598" y="1"/>
                </a:lnTo>
                <a:lnTo>
                  <a:pt x="599" y="2"/>
                </a:lnTo>
                <a:lnTo>
                  <a:pt x="600" y="4"/>
                </a:lnTo>
                <a:lnTo>
                  <a:pt x="601" y="1"/>
                </a:lnTo>
                <a:lnTo>
                  <a:pt x="601" y="2"/>
                </a:lnTo>
                <a:lnTo>
                  <a:pt x="602" y="2"/>
                </a:lnTo>
                <a:lnTo>
                  <a:pt x="603" y="3"/>
                </a:lnTo>
                <a:lnTo>
                  <a:pt x="604" y="3"/>
                </a:lnTo>
                <a:lnTo>
                  <a:pt x="605" y="1"/>
                </a:lnTo>
                <a:lnTo>
                  <a:pt x="606" y="2"/>
                </a:lnTo>
                <a:lnTo>
                  <a:pt x="607" y="4"/>
                </a:lnTo>
                <a:lnTo>
                  <a:pt x="608" y="2"/>
                </a:lnTo>
                <a:lnTo>
                  <a:pt x="608" y="3"/>
                </a:lnTo>
                <a:lnTo>
                  <a:pt x="609" y="1"/>
                </a:lnTo>
                <a:lnTo>
                  <a:pt x="610" y="3"/>
                </a:lnTo>
                <a:lnTo>
                  <a:pt x="611" y="3"/>
                </a:lnTo>
                <a:lnTo>
                  <a:pt x="612" y="3"/>
                </a:lnTo>
                <a:lnTo>
                  <a:pt x="613" y="1"/>
                </a:lnTo>
                <a:lnTo>
                  <a:pt x="614" y="2"/>
                </a:lnTo>
                <a:lnTo>
                  <a:pt x="615" y="2"/>
                </a:lnTo>
                <a:lnTo>
                  <a:pt x="616" y="2"/>
                </a:lnTo>
                <a:lnTo>
                  <a:pt x="616" y="4"/>
                </a:lnTo>
                <a:lnTo>
                  <a:pt x="617" y="3"/>
                </a:lnTo>
                <a:lnTo>
                  <a:pt x="618" y="2"/>
                </a:lnTo>
                <a:lnTo>
                  <a:pt x="619" y="2"/>
                </a:lnTo>
                <a:lnTo>
                  <a:pt x="620" y="3"/>
                </a:lnTo>
                <a:lnTo>
                  <a:pt x="621" y="3"/>
                </a:lnTo>
                <a:lnTo>
                  <a:pt x="622" y="2"/>
                </a:lnTo>
                <a:lnTo>
                  <a:pt x="623" y="3"/>
                </a:lnTo>
                <a:lnTo>
                  <a:pt x="623" y="2"/>
                </a:lnTo>
                <a:lnTo>
                  <a:pt x="624" y="3"/>
                </a:lnTo>
                <a:lnTo>
                  <a:pt x="625" y="2"/>
                </a:lnTo>
                <a:lnTo>
                  <a:pt x="626" y="3"/>
                </a:lnTo>
                <a:lnTo>
                  <a:pt x="627" y="2"/>
                </a:lnTo>
                <a:lnTo>
                  <a:pt x="628" y="2"/>
                </a:lnTo>
                <a:lnTo>
                  <a:pt x="629" y="3"/>
                </a:lnTo>
                <a:lnTo>
                  <a:pt x="630" y="2"/>
                </a:lnTo>
                <a:lnTo>
                  <a:pt x="631" y="4"/>
                </a:lnTo>
                <a:lnTo>
                  <a:pt x="631" y="2"/>
                </a:lnTo>
                <a:lnTo>
                  <a:pt x="632" y="2"/>
                </a:lnTo>
                <a:lnTo>
                  <a:pt x="633" y="3"/>
                </a:lnTo>
                <a:lnTo>
                  <a:pt x="634" y="2"/>
                </a:lnTo>
                <a:lnTo>
                  <a:pt x="635" y="3"/>
                </a:lnTo>
                <a:lnTo>
                  <a:pt x="636" y="3"/>
                </a:lnTo>
                <a:lnTo>
                  <a:pt x="637" y="3"/>
                </a:lnTo>
                <a:lnTo>
                  <a:pt x="638" y="3"/>
                </a:lnTo>
                <a:lnTo>
                  <a:pt x="638" y="2"/>
                </a:lnTo>
                <a:lnTo>
                  <a:pt x="639" y="2"/>
                </a:lnTo>
                <a:lnTo>
                  <a:pt x="640" y="2"/>
                </a:lnTo>
                <a:lnTo>
                  <a:pt x="641" y="3"/>
                </a:lnTo>
                <a:lnTo>
                  <a:pt x="642" y="3"/>
                </a:lnTo>
                <a:lnTo>
                  <a:pt x="643" y="3"/>
                </a:lnTo>
                <a:lnTo>
                  <a:pt x="644" y="2"/>
                </a:lnTo>
                <a:lnTo>
                  <a:pt x="645" y="2"/>
                </a:lnTo>
                <a:lnTo>
                  <a:pt x="646" y="3"/>
                </a:lnTo>
                <a:lnTo>
                  <a:pt x="646" y="2"/>
                </a:lnTo>
                <a:lnTo>
                  <a:pt x="647" y="3"/>
                </a:lnTo>
                <a:lnTo>
                  <a:pt x="648" y="3"/>
                </a:lnTo>
                <a:lnTo>
                  <a:pt x="649" y="3"/>
                </a:lnTo>
                <a:lnTo>
                  <a:pt x="650" y="2"/>
                </a:lnTo>
                <a:lnTo>
                  <a:pt x="651" y="3"/>
                </a:lnTo>
                <a:lnTo>
                  <a:pt x="652" y="2"/>
                </a:lnTo>
                <a:lnTo>
                  <a:pt x="653" y="2"/>
                </a:lnTo>
                <a:lnTo>
                  <a:pt x="653" y="3"/>
                </a:lnTo>
                <a:lnTo>
                  <a:pt x="654" y="3"/>
                </a:lnTo>
                <a:lnTo>
                  <a:pt x="655" y="2"/>
                </a:lnTo>
                <a:lnTo>
                  <a:pt x="656" y="1"/>
                </a:lnTo>
                <a:lnTo>
                  <a:pt x="657" y="2"/>
                </a:lnTo>
                <a:lnTo>
                  <a:pt x="658" y="1"/>
                </a:lnTo>
                <a:lnTo>
                  <a:pt x="659" y="1"/>
                </a:lnTo>
                <a:lnTo>
                  <a:pt x="660" y="2"/>
                </a:lnTo>
                <a:lnTo>
                  <a:pt x="661" y="2"/>
                </a:lnTo>
                <a:lnTo>
                  <a:pt x="661" y="2"/>
                </a:lnTo>
                <a:lnTo>
                  <a:pt x="662" y="1"/>
                </a:lnTo>
                <a:lnTo>
                  <a:pt x="663" y="2"/>
                </a:lnTo>
                <a:lnTo>
                  <a:pt x="664" y="3"/>
                </a:lnTo>
                <a:lnTo>
                  <a:pt x="665" y="2"/>
                </a:lnTo>
                <a:lnTo>
                  <a:pt x="666" y="2"/>
                </a:lnTo>
                <a:lnTo>
                  <a:pt x="667" y="3"/>
                </a:lnTo>
                <a:lnTo>
                  <a:pt x="668" y="2"/>
                </a:lnTo>
                <a:lnTo>
                  <a:pt x="668" y="3"/>
                </a:lnTo>
                <a:lnTo>
                  <a:pt x="669" y="2"/>
                </a:lnTo>
                <a:lnTo>
                  <a:pt x="670" y="2"/>
                </a:lnTo>
                <a:lnTo>
                  <a:pt x="671" y="2"/>
                </a:lnTo>
                <a:lnTo>
                  <a:pt x="672" y="2"/>
                </a:lnTo>
                <a:lnTo>
                  <a:pt x="673" y="2"/>
                </a:lnTo>
                <a:lnTo>
                  <a:pt x="674" y="3"/>
                </a:lnTo>
                <a:lnTo>
                  <a:pt x="675" y="2"/>
                </a:lnTo>
                <a:lnTo>
                  <a:pt x="676" y="2"/>
                </a:lnTo>
                <a:lnTo>
                  <a:pt x="676" y="2"/>
                </a:lnTo>
                <a:lnTo>
                  <a:pt x="677" y="2"/>
                </a:lnTo>
                <a:lnTo>
                  <a:pt x="678" y="3"/>
                </a:lnTo>
                <a:lnTo>
                  <a:pt x="679" y="2"/>
                </a:lnTo>
                <a:lnTo>
                  <a:pt x="680" y="2"/>
                </a:lnTo>
                <a:lnTo>
                  <a:pt x="681" y="2"/>
                </a:lnTo>
                <a:lnTo>
                  <a:pt x="682" y="2"/>
                </a:lnTo>
                <a:lnTo>
                  <a:pt x="683" y="3"/>
                </a:lnTo>
                <a:lnTo>
                  <a:pt x="683" y="3"/>
                </a:lnTo>
                <a:lnTo>
                  <a:pt x="684" y="1"/>
                </a:lnTo>
                <a:lnTo>
                  <a:pt x="685" y="3"/>
                </a:lnTo>
                <a:lnTo>
                  <a:pt x="686" y="2"/>
                </a:lnTo>
                <a:lnTo>
                  <a:pt x="687" y="3"/>
                </a:lnTo>
                <a:lnTo>
                  <a:pt x="688" y="2"/>
                </a:lnTo>
                <a:lnTo>
                  <a:pt x="689" y="2"/>
                </a:lnTo>
                <a:lnTo>
                  <a:pt x="690" y="4"/>
                </a:lnTo>
                <a:lnTo>
                  <a:pt x="691" y="1"/>
                </a:lnTo>
                <a:lnTo>
                  <a:pt x="691" y="2"/>
                </a:lnTo>
                <a:lnTo>
                  <a:pt x="692" y="3"/>
                </a:lnTo>
                <a:lnTo>
                  <a:pt x="693" y="2"/>
                </a:lnTo>
                <a:lnTo>
                  <a:pt x="694" y="3"/>
                </a:lnTo>
                <a:lnTo>
                  <a:pt x="695" y="2"/>
                </a:lnTo>
                <a:lnTo>
                  <a:pt x="696" y="2"/>
                </a:lnTo>
                <a:lnTo>
                  <a:pt x="697" y="2"/>
                </a:lnTo>
                <a:lnTo>
                  <a:pt x="698" y="3"/>
                </a:lnTo>
                <a:lnTo>
                  <a:pt x="698" y="2"/>
                </a:lnTo>
                <a:lnTo>
                  <a:pt x="699" y="2"/>
                </a:lnTo>
                <a:lnTo>
                  <a:pt x="700" y="3"/>
                </a:lnTo>
                <a:lnTo>
                  <a:pt x="701" y="3"/>
                </a:lnTo>
                <a:lnTo>
                  <a:pt x="702" y="2"/>
                </a:lnTo>
                <a:lnTo>
                  <a:pt x="703" y="2"/>
                </a:lnTo>
                <a:lnTo>
                  <a:pt x="704" y="2"/>
                </a:lnTo>
                <a:lnTo>
                  <a:pt x="705" y="2"/>
                </a:lnTo>
                <a:lnTo>
                  <a:pt x="706" y="3"/>
                </a:lnTo>
                <a:lnTo>
                  <a:pt x="706" y="2"/>
                </a:lnTo>
                <a:lnTo>
                  <a:pt x="707" y="3"/>
                </a:lnTo>
                <a:lnTo>
                  <a:pt x="708" y="2"/>
                </a:lnTo>
                <a:lnTo>
                  <a:pt x="709" y="2"/>
                </a:lnTo>
                <a:lnTo>
                  <a:pt x="710" y="2"/>
                </a:lnTo>
                <a:lnTo>
                  <a:pt x="711" y="3"/>
                </a:lnTo>
                <a:lnTo>
                  <a:pt x="712" y="2"/>
                </a:lnTo>
                <a:lnTo>
                  <a:pt x="713" y="3"/>
                </a:lnTo>
                <a:lnTo>
                  <a:pt x="713" y="1"/>
                </a:lnTo>
                <a:lnTo>
                  <a:pt x="714" y="4"/>
                </a:lnTo>
                <a:lnTo>
                  <a:pt x="715" y="2"/>
                </a:lnTo>
                <a:lnTo>
                  <a:pt x="716" y="1"/>
                </a:lnTo>
                <a:lnTo>
                  <a:pt x="717" y="2"/>
                </a:lnTo>
                <a:lnTo>
                  <a:pt x="718" y="3"/>
                </a:lnTo>
                <a:lnTo>
                  <a:pt x="719" y="3"/>
                </a:lnTo>
                <a:lnTo>
                  <a:pt x="720" y="1"/>
                </a:lnTo>
                <a:lnTo>
                  <a:pt x="721" y="2"/>
                </a:lnTo>
                <a:lnTo>
                  <a:pt x="721" y="2"/>
                </a:lnTo>
                <a:lnTo>
                  <a:pt x="722" y="2"/>
                </a:lnTo>
                <a:lnTo>
                  <a:pt x="723" y="3"/>
                </a:lnTo>
                <a:lnTo>
                  <a:pt x="724" y="2"/>
                </a:lnTo>
                <a:lnTo>
                  <a:pt x="725" y="3"/>
                </a:lnTo>
                <a:lnTo>
                  <a:pt x="726" y="2"/>
                </a:lnTo>
                <a:lnTo>
                  <a:pt x="727" y="4"/>
                </a:lnTo>
                <a:lnTo>
                  <a:pt x="728" y="3"/>
                </a:lnTo>
                <a:lnTo>
                  <a:pt x="728" y="2"/>
                </a:lnTo>
                <a:lnTo>
                  <a:pt x="729" y="2"/>
                </a:lnTo>
                <a:lnTo>
                  <a:pt x="730" y="3"/>
                </a:lnTo>
                <a:lnTo>
                  <a:pt x="731" y="2"/>
                </a:lnTo>
                <a:lnTo>
                  <a:pt x="732" y="2"/>
                </a:lnTo>
                <a:lnTo>
                  <a:pt x="733" y="1"/>
                </a:lnTo>
                <a:lnTo>
                  <a:pt x="734" y="1"/>
                </a:lnTo>
                <a:lnTo>
                  <a:pt x="735" y="2"/>
                </a:lnTo>
                <a:lnTo>
                  <a:pt x="736" y="3"/>
                </a:lnTo>
                <a:lnTo>
                  <a:pt x="736" y="2"/>
                </a:lnTo>
                <a:lnTo>
                  <a:pt x="737" y="2"/>
                </a:lnTo>
                <a:lnTo>
                  <a:pt x="738" y="1"/>
                </a:lnTo>
                <a:lnTo>
                  <a:pt x="739" y="2"/>
                </a:lnTo>
                <a:lnTo>
                  <a:pt x="740" y="2"/>
                </a:lnTo>
                <a:lnTo>
                  <a:pt x="741" y="3"/>
                </a:lnTo>
                <a:lnTo>
                  <a:pt x="742" y="3"/>
                </a:lnTo>
                <a:lnTo>
                  <a:pt x="743" y="2"/>
                </a:lnTo>
                <a:lnTo>
                  <a:pt x="743" y="2"/>
                </a:lnTo>
                <a:lnTo>
                  <a:pt x="744" y="2"/>
                </a:lnTo>
                <a:lnTo>
                  <a:pt x="745" y="3"/>
                </a:lnTo>
                <a:lnTo>
                  <a:pt x="746" y="2"/>
                </a:lnTo>
                <a:lnTo>
                  <a:pt x="747" y="2"/>
                </a:lnTo>
                <a:lnTo>
                  <a:pt x="748" y="3"/>
                </a:lnTo>
                <a:lnTo>
                  <a:pt x="749" y="2"/>
                </a:lnTo>
                <a:lnTo>
                  <a:pt x="750" y="3"/>
                </a:lnTo>
                <a:lnTo>
                  <a:pt x="750" y="3"/>
                </a:lnTo>
                <a:lnTo>
                  <a:pt x="751" y="1"/>
                </a:lnTo>
                <a:lnTo>
                  <a:pt x="752" y="3"/>
                </a:lnTo>
                <a:lnTo>
                  <a:pt x="753" y="3"/>
                </a:lnTo>
                <a:lnTo>
                  <a:pt x="754" y="1"/>
                </a:lnTo>
                <a:lnTo>
                  <a:pt x="755" y="2"/>
                </a:lnTo>
                <a:lnTo>
                  <a:pt x="756" y="3"/>
                </a:lnTo>
                <a:lnTo>
                  <a:pt x="757" y="2"/>
                </a:lnTo>
                <a:lnTo>
                  <a:pt x="758" y="1"/>
                </a:lnTo>
                <a:lnTo>
                  <a:pt x="758" y="2"/>
                </a:lnTo>
                <a:lnTo>
                  <a:pt x="759" y="2"/>
                </a:lnTo>
                <a:lnTo>
                  <a:pt x="760" y="2"/>
                </a:lnTo>
                <a:lnTo>
                  <a:pt x="761" y="1"/>
                </a:lnTo>
                <a:lnTo>
                  <a:pt x="762" y="3"/>
                </a:lnTo>
                <a:lnTo>
                  <a:pt x="763" y="2"/>
                </a:lnTo>
                <a:lnTo>
                  <a:pt x="764" y="2"/>
                </a:lnTo>
                <a:lnTo>
                  <a:pt x="765" y="1"/>
                </a:lnTo>
                <a:lnTo>
                  <a:pt x="765" y="2"/>
                </a:lnTo>
                <a:lnTo>
                  <a:pt x="766" y="1"/>
                </a:lnTo>
                <a:lnTo>
                  <a:pt x="767" y="2"/>
                </a:lnTo>
                <a:lnTo>
                  <a:pt x="768" y="2"/>
                </a:lnTo>
                <a:lnTo>
                  <a:pt x="769" y="1"/>
                </a:lnTo>
                <a:lnTo>
                  <a:pt x="770" y="1"/>
                </a:lnTo>
                <a:lnTo>
                  <a:pt x="771" y="3"/>
                </a:lnTo>
                <a:lnTo>
                  <a:pt x="772" y="2"/>
                </a:lnTo>
                <a:lnTo>
                  <a:pt x="773" y="2"/>
                </a:lnTo>
                <a:lnTo>
                  <a:pt x="773" y="1"/>
                </a:lnTo>
                <a:lnTo>
                  <a:pt x="774" y="1"/>
                </a:lnTo>
                <a:lnTo>
                  <a:pt x="775" y="2"/>
                </a:lnTo>
                <a:lnTo>
                  <a:pt x="776" y="2"/>
                </a:lnTo>
                <a:lnTo>
                  <a:pt x="777" y="2"/>
                </a:lnTo>
                <a:lnTo>
                  <a:pt x="778" y="2"/>
                </a:lnTo>
                <a:lnTo>
                  <a:pt x="779" y="1"/>
                </a:lnTo>
                <a:lnTo>
                  <a:pt x="780" y="1"/>
                </a:lnTo>
                <a:lnTo>
                  <a:pt x="780" y="2"/>
                </a:lnTo>
                <a:lnTo>
                  <a:pt x="781" y="2"/>
                </a:lnTo>
                <a:lnTo>
                  <a:pt x="782" y="2"/>
                </a:lnTo>
                <a:lnTo>
                  <a:pt x="783" y="1"/>
                </a:lnTo>
                <a:lnTo>
                  <a:pt x="784" y="0"/>
                </a:lnTo>
                <a:lnTo>
                  <a:pt x="785" y="2"/>
                </a:lnTo>
                <a:lnTo>
                  <a:pt x="786" y="3"/>
                </a:lnTo>
                <a:lnTo>
                  <a:pt x="787" y="3"/>
                </a:lnTo>
                <a:lnTo>
                  <a:pt x="788" y="1"/>
                </a:lnTo>
                <a:lnTo>
                  <a:pt x="788" y="1"/>
                </a:lnTo>
                <a:lnTo>
                  <a:pt x="789" y="1"/>
                </a:lnTo>
                <a:lnTo>
                  <a:pt x="789" y="1"/>
                </a:lnTo>
              </a:path>
            </a:pathLst>
          </a:custGeom>
          <a:noFill/>
          <a:ln w="0">
            <a:solidFill>
              <a:srgbClr val="00007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39" name="Group 1538"/>
          <p:cNvGrpSpPr/>
          <p:nvPr/>
        </p:nvGrpSpPr>
        <p:grpSpPr>
          <a:xfrm>
            <a:off x="1392239" y="582612"/>
            <a:ext cx="4994275" cy="2968625"/>
            <a:chOff x="1392239" y="496888"/>
            <a:chExt cx="4994275" cy="3054350"/>
          </a:xfrm>
        </p:grpSpPr>
        <p:sp>
          <p:nvSpPr>
            <p:cNvPr id="181" name="Freeform 179"/>
            <p:cNvSpPr>
              <a:spLocks/>
            </p:cNvSpPr>
            <p:nvPr/>
          </p:nvSpPr>
          <p:spPr bwMode="auto">
            <a:xfrm flipV="1">
              <a:off x="1392239" y="2219325"/>
              <a:ext cx="2236788" cy="1331913"/>
            </a:xfrm>
            <a:custGeom>
              <a:avLst/>
              <a:gdLst>
                <a:gd name="T0" fmla="*/ 52 w 3385"/>
                <a:gd name="T1" fmla="*/ 1 h 1761"/>
                <a:gd name="T2" fmla="*/ 105 w 3385"/>
                <a:gd name="T3" fmla="*/ 2 h 1761"/>
                <a:gd name="T4" fmla="*/ 158 w 3385"/>
                <a:gd name="T5" fmla="*/ 1 h 1761"/>
                <a:gd name="T6" fmla="*/ 211 w 3385"/>
                <a:gd name="T7" fmla="*/ 2 h 1761"/>
                <a:gd name="T8" fmla="*/ 264 w 3385"/>
                <a:gd name="T9" fmla="*/ 4 h 1761"/>
                <a:gd name="T10" fmla="*/ 317 w 3385"/>
                <a:gd name="T11" fmla="*/ 2 h 1761"/>
                <a:gd name="T12" fmla="*/ 369 w 3385"/>
                <a:gd name="T13" fmla="*/ 3 h 1761"/>
                <a:gd name="T14" fmla="*/ 422 w 3385"/>
                <a:gd name="T15" fmla="*/ 3 h 1761"/>
                <a:gd name="T16" fmla="*/ 475 w 3385"/>
                <a:gd name="T17" fmla="*/ 11 h 1761"/>
                <a:gd name="T18" fmla="*/ 528 w 3385"/>
                <a:gd name="T19" fmla="*/ 8 h 1761"/>
                <a:gd name="T20" fmla="*/ 581 w 3385"/>
                <a:gd name="T21" fmla="*/ 3 h 1761"/>
                <a:gd name="T22" fmla="*/ 634 w 3385"/>
                <a:gd name="T23" fmla="*/ 2 h 1761"/>
                <a:gd name="T24" fmla="*/ 687 w 3385"/>
                <a:gd name="T25" fmla="*/ 2 h 1761"/>
                <a:gd name="T26" fmla="*/ 740 w 3385"/>
                <a:gd name="T27" fmla="*/ 3 h 1761"/>
                <a:gd name="T28" fmla="*/ 793 w 3385"/>
                <a:gd name="T29" fmla="*/ 3 h 1761"/>
                <a:gd name="T30" fmla="*/ 846 w 3385"/>
                <a:gd name="T31" fmla="*/ 3 h 1761"/>
                <a:gd name="T32" fmla="*/ 899 w 3385"/>
                <a:gd name="T33" fmla="*/ 3 h 1761"/>
                <a:gd name="T34" fmla="*/ 952 w 3385"/>
                <a:gd name="T35" fmla="*/ 3 h 1761"/>
                <a:gd name="T36" fmla="*/ 1005 w 3385"/>
                <a:gd name="T37" fmla="*/ 3 h 1761"/>
                <a:gd name="T38" fmla="*/ 1058 w 3385"/>
                <a:gd name="T39" fmla="*/ 2 h 1761"/>
                <a:gd name="T40" fmla="*/ 1110 w 3385"/>
                <a:gd name="T41" fmla="*/ 4 h 1761"/>
                <a:gd name="T42" fmla="*/ 1163 w 3385"/>
                <a:gd name="T43" fmla="*/ 5 h 1761"/>
                <a:gd name="T44" fmla="*/ 1216 w 3385"/>
                <a:gd name="T45" fmla="*/ 3 h 1761"/>
                <a:gd name="T46" fmla="*/ 1269 w 3385"/>
                <a:gd name="T47" fmla="*/ 1 h 1761"/>
                <a:gd name="T48" fmla="*/ 1322 w 3385"/>
                <a:gd name="T49" fmla="*/ 1 h 1761"/>
                <a:gd name="T50" fmla="*/ 1375 w 3385"/>
                <a:gd name="T51" fmla="*/ 1 h 1761"/>
                <a:gd name="T52" fmla="*/ 1428 w 3385"/>
                <a:gd name="T53" fmla="*/ 1 h 1761"/>
                <a:gd name="T54" fmla="*/ 1481 w 3385"/>
                <a:gd name="T55" fmla="*/ 2 h 1761"/>
                <a:gd name="T56" fmla="*/ 1534 w 3385"/>
                <a:gd name="T57" fmla="*/ 2 h 1761"/>
                <a:gd name="T58" fmla="*/ 1587 w 3385"/>
                <a:gd name="T59" fmla="*/ 2 h 1761"/>
                <a:gd name="T60" fmla="*/ 1640 w 3385"/>
                <a:gd name="T61" fmla="*/ 1 h 1761"/>
                <a:gd name="T62" fmla="*/ 1693 w 3385"/>
                <a:gd name="T63" fmla="*/ 13 h 1761"/>
                <a:gd name="T64" fmla="*/ 1746 w 3385"/>
                <a:gd name="T65" fmla="*/ 2 h 1761"/>
                <a:gd name="T66" fmla="*/ 1798 w 3385"/>
                <a:gd name="T67" fmla="*/ 1 h 1761"/>
                <a:gd name="T68" fmla="*/ 1851 w 3385"/>
                <a:gd name="T69" fmla="*/ 1 h 1761"/>
                <a:gd name="T70" fmla="*/ 1904 w 3385"/>
                <a:gd name="T71" fmla="*/ 1 h 1761"/>
                <a:gd name="T72" fmla="*/ 1957 w 3385"/>
                <a:gd name="T73" fmla="*/ 1 h 1761"/>
                <a:gd name="T74" fmla="*/ 2010 w 3385"/>
                <a:gd name="T75" fmla="*/ 4 h 1761"/>
                <a:gd name="T76" fmla="*/ 2063 w 3385"/>
                <a:gd name="T77" fmla="*/ 5 h 1761"/>
                <a:gd name="T78" fmla="*/ 2116 w 3385"/>
                <a:gd name="T79" fmla="*/ 3 h 1761"/>
                <a:gd name="T80" fmla="*/ 2169 w 3385"/>
                <a:gd name="T81" fmla="*/ 3 h 1761"/>
                <a:gd name="T82" fmla="*/ 2222 w 3385"/>
                <a:gd name="T83" fmla="*/ 2 h 1761"/>
                <a:gd name="T84" fmla="*/ 2275 w 3385"/>
                <a:gd name="T85" fmla="*/ 2 h 1761"/>
                <a:gd name="T86" fmla="*/ 2328 w 3385"/>
                <a:gd name="T87" fmla="*/ 36 h 1761"/>
                <a:gd name="T88" fmla="*/ 2381 w 3385"/>
                <a:gd name="T89" fmla="*/ 13 h 1761"/>
                <a:gd name="T90" fmla="*/ 2434 w 3385"/>
                <a:gd name="T91" fmla="*/ 5 h 1761"/>
                <a:gd name="T92" fmla="*/ 2487 w 3385"/>
                <a:gd name="T93" fmla="*/ 4 h 1761"/>
                <a:gd name="T94" fmla="*/ 2539 w 3385"/>
                <a:gd name="T95" fmla="*/ 4 h 1761"/>
                <a:gd name="T96" fmla="*/ 2592 w 3385"/>
                <a:gd name="T97" fmla="*/ 3 h 1761"/>
                <a:gd name="T98" fmla="*/ 2645 w 3385"/>
                <a:gd name="T99" fmla="*/ 3 h 1761"/>
                <a:gd name="T100" fmla="*/ 2698 w 3385"/>
                <a:gd name="T101" fmla="*/ 2 h 1761"/>
                <a:gd name="T102" fmla="*/ 2751 w 3385"/>
                <a:gd name="T103" fmla="*/ 4 h 1761"/>
                <a:gd name="T104" fmla="*/ 2804 w 3385"/>
                <a:gd name="T105" fmla="*/ 2 h 1761"/>
                <a:gd name="T106" fmla="*/ 2857 w 3385"/>
                <a:gd name="T107" fmla="*/ 1 h 1761"/>
                <a:gd name="T108" fmla="*/ 2910 w 3385"/>
                <a:gd name="T109" fmla="*/ 1 h 1761"/>
                <a:gd name="T110" fmla="*/ 2963 w 3385"/>
                <a:gd name="T111" fmla="*/ 1 h 1761"/>
                <a:gd name="T112" fmla="*/ 3016 w 3385"/>
                <a:gd name="T113" fmla="*/ 1 h 1761"/>
                <a:gd name="T114" fmla="*/ 3069 w 3385"/>
                <a:gd name="T115" fmla="*/ 1 h 1761"/>
                <a:gd name="T116" fmla="*/ 3122 w 3385"/>
                <a:gd name="T117" fmla="*/ 1 h 1761"/>
                <a:gd name="T118" fmla="*/ 3175 w 3385"/>
                <a:gd name="T119" fmla="*/ 2 h 1761"/>
                <a:gd name="T120" fmla="*/ 3227 w 3385"/>
                <a:gd name="T121" fmla="*/ 3 h 1761"/>
                <a:gd name="T122" fmla="*/ 3280 w 3385"/>
                <a:gd name="T123" fmla="*/ 1 h 1761"/>
                <a:gd name="T124" fmla="*/ 3333 w 3385"/>
                <a:gd name="T125" fmla="*/ 7 h 17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3385" h="1761">
                  <a:moveTo>
                    <a:pt x="0" y="1"/>
                  </a:moveTo>
                  <a:lnTo>
                    <a:pt x="1" y="1"/>
                  </a:lnTo>
                  <a:lnTo>
                    <a:pt x="2" y="1"/>
                  </a:lnTo>
                  <a:lnTo>
                    <a:pt x="3" y="1"/>
                  </a:lnTo>
                  <a:lnTo>
                    <a:pt x="3" y="1"/>
                  </a:lnTo>
                  <a:lnTo>
                    <a:pt x="4" y="1"/>
                  </a:lnTo>
                  <a:lnTo>
                    <a:pt x="5" y="1"/>
                  </a:lnTo>
                  <a:lnTo>
                    <a:pt x="6" y="2"/>
                  </a:lnTo>
                  <a:lnTo>
                    <a:pt x="7" y="1"/>
                  </a:lnTo>
                  <a:lnTo>
                    <a:pt x="8" y="2"/>
                  </a:lnTo>
                  <a:lnTo>
                    <a:pt x="9" y="2"/>
                  </a:lnTo>
                  <a:lnTo>
                    <a:pt x="10" y="2"/>
                  </a:lnTo>
                  <a:lnTo>
                    <a:pt x="10" y="2"/>
                  </a:lnTo>
                  <a:lnTo>
                    <a:pt x="11" y="2"/>
                  </a:lnTo>
                  <a:lnTo>
                    <a:pt x="12" y="2"/>
                  </a:lnTo>
                  <a:lnTo>
                    <a:pt x="13" y="2"/>
                  </a:lnTo>
                  <a:lnTo>
                    <a:pt x="14" y="2"/>
                  </a:lnTo>
                  <a:lnTo>
                    <a:pt x="15" y="1"/>
                  </a:lnTo>
                  <a:lnTo>
                    <a:pt x="16" y="2"/>
                  </a:lnTo>
                  <a:lnTo>
                    <a:pt x="17" y="1"/>
                  </a:lnTo>
                  <a:lnTo>
                    <a:pt x="18" y="1"/>
                  </a:lnTo>
                  <a:lnTo>
                    <a:pt x="18" y="1"/>
                  </a:lnTo>
                  <a:lnTo>
                    <a:pt x="19" y="2"/>
                  </a:lnTo>
                  <a:lnTo>
                    <a:pt x="20" y="2"/>
                  </a:lnTo>
                  <a:lnTo>
                    <a:pt x="21" y="2"/>
                  </a:lnTo>
                  <a:lnTo>
                    <a:pt x="22" y="2"/>
                  </a:lnTo>
                  <a:lnTo>
                    <a:pt x="23" y="1"/>
                  </a:lnTo>
                  <a:lnTo>
                    <a:pt x="24" y="2"/>
                  </a:lnTo>
                  <a:lnTo>
                    <a:pt x="25" y="2"/>
                  </a:lnTo>
                  <a:lnTo>
                    <a:pt x="25" y="1"/>
                  </a:lnTo>
                  <a:lnTo>
                    <a:pt x="26" y="1"/>
                  </a:lnTo>
                  <a:lnTo>
                    <a:pt x="27" y="1"/>
                  </a:lnTo>
                  <a:lnTo>
                    <a:pt x="28" y="2"/>
                  </a:lnTo>
                  <a:lnTo>
                    <a:pt x="29" y="1"/>
                  </a:lnTo>
                  <a:lnTo>
                    <a:pt x="30" y="1"/>
                  </a:lnTo>
                  <a:lnTo>
                    <a:pt x="31" y="1"/>
                  </a:lnTo>
                  <a:lnTo>
                    <a:pt x="32" y="1"/>
                  </a:lnTo>
                  <a:lnTo>
                    <a:pt x="33" y="1"/>
                  </a:lnTo>
                  <a:lnTo>
                    <a:pt x="33" y="1"/>
                  </a:lnTo>
                  <a:lnTo>
                    <a:pt x="34" y="1"/>
                  </a:lnTo>
                  <a:lnTo>
                    <a:pt x="35" y="1"/>
                  </a:lnTo>
                  <a:lnTo>
                    <a:pt x="36" y="1"/>
                  </a:lnTo>
                  <a:lnTo>
                    <a:pt x="37" y="2"/>
                  </a:lnTo>
                  <a:lnTo>
                    <a:pt x="38" y="1"/>
                  </a:lnTo>
                  <a:lnTo>
                    <a:pt x="39" y="1"/>
                  </a:lnTo>
                  <a:lnTo>
                    <a:pt x="40" y="1"/>
                  </a:lnTo>
                  <a:lnTo>
                    <a:pt x="40" y="2"/>
                  </a:lnTo>
                  <a:lnTo>
                    <a:pt x="41" y="1"/>
                  </a:lnTo>
                  <a:lnTo>
                    <a:pt x="42" y="2"/>
                  </a:lnTo>
                  <a:lnTo>
                    <a:pt x="43" y="2"/>
                  </a:lnTo>
                  <a:lnTo>
                    <a:pt x="44" y="2"/>
                  </a:lnTo>
                  <a:lnTo>
                    <a:pt x="45" y="2"/>
                  </a:lnTo>
                  <a:lnTo>
                    <a:pt x="46" y="2"/>
                  </a:lnTo>
                  <a:lnTo>
                    <a:pt x="47" y="2"/>
                  </a:lnTo>
                  <a:lnTo>
                    <a:pt x="48" y="2"/>
                  </a:lnTo>
                  <a:lnTo>
                    <a:pt x="48" y="2"/>
                  </a:lnTo>
                  <a:lnTo>
                    <a:pt x="49" y="1"/>
                  </a:lnTo>
                  <a:lnTo>
                    <a:pt x="50" y="2"/>
                  </a:lnTo>
                  <a:lnTo>
                    <a:pt x="51" y="1"/>
                  </a:lnTo>
                  <a:lnTo>
                    <a:pt x="52" y="1"/>
                  </a:lnTo>
                  <a:lnTo>
                    <a:pt x="53" y="1"/>
                  </a:lnTo>
                  <a:lnTo>
                    <a:pt x="54" y="1"/>
                  </a:lnTo>
                  <a:lnTo>
                    <a:pt x="55" y="2"/>
                  </a:lnTo>
                  <a:lnTo>
                    <a:pt x="55" y="2"/>
                  </a:lnTo>
                  <a:lnTo>
                    <a:pt x="56" y="2"/>
                  </a:lnTo>
                  <a:lnTo>
                    <a:pt x="57" y="3"/>
                  </a:lnTo>
                  <a:lnTo>
                    <a:pt x="58" y="3"/>
                  </a:lnTo>
                  <a:lnTo>
                    <a:pt x="59" y="3"/>
                  </a:lnTo>
                  <a:lnTo>
                    <a:pt x="60" y="2"/>
                  </a:lnTo>
                  <a:lnTo>
                    <a:pt x="61" y="2"/>
                  </a:lnTo>
                  <a:lnTo>
                    <a:pt x="62" y="2"/>
                  </a:lnTo>
                  <a:lnTo>
                    <a:pt x="63" y="2"/>
                  </a:lnTo>
                  <a:lnTo>
                    <a:pt x="63" y="2"/>
                  </a:lnTo>
                  <a:lnTo>
                    <a:pt x="64" y="2"/>
                  </a:lnTo>
                  <a:lnTo>
                    <a:pt x="65" y="2"/>
                  </a:lnTo>
                  <a:lnTo>
                    <a:pt x="66" y="2"/>
                  </a:lnTo>
                  <a:lnTo>
                    <a:pt x="67" y="2"/>
                  </a:lnTo>
                  <a:lnTo>
                    <a:pt x="68" y="2"/>
                  </a:lnTo>
                  <a:lnTo>
                    <a:pt x="69" y="2"/>
                  </a:lnTo>
                  <a:lnTo>
                    <a:pt x="70" y="2"/>
                  </a:lnTo>
                  <a:lnTo>
                    <a:pt x="70" y="1"/>
                  </a:lnTo>
                  <a:lnTo>
                    <a:pt x="71" y="2"/>
                  </a:lnTo>
                  <a:lnTo>
                    <a:pt x="72" y="2"/>
                  </a:lnTo>
                  <a:lnTo>
                    <a:pt x="73" y="2"/>
                  </a:lnTo>
                  <a:lnTo>
                    <a:pt x="74" y="2"/>
                  </a:lnTo>
                  <a:lnTo>
                    <a:pt x="75" y="1"/>
                  </a:lnTo>
                  <a:lnTo>
                    <a:pt x="76" y="2"/>
                  </a:lnTo>
                  <a:lnTo>
                    <a:pt x="77" y="2"/>
                  </a:lnTo>
                  <a:lnTo>
                    <a:pt x="78" y="1"/>
                  </a:lnTo>
                  <a:lnTo>
                    <a:pt x="78" y="2"/>
                  </a:lnTo>
                  <a:lnTo>
                    <a:pt x="79" y="1"/>
                  </a:lnTo>
                  <a:lnTo>
                    <a:pt x="80" y="1"/>
                  </a:lnTo>
                  <a:lnTo>
                    <a:pt x="81" y="2"/>
                  </a:lnTo>
                  <a:lnTo>
                    <a:pt x="82" y="2"/>
                  </a:lnTo>
                  <a:lnTo>
                    <a:pt x="83" y="1"/>
                  </a:lnTo>
                  <a:lnTo>
                    <a:pt x="84" y="2"/>
                  </a:lnTo>
                  <a:lnTo>
                    <a:pt x="85" y="1"/>
                  </a:lnTo>
                  <a:lnTo>
                    <a:pt x="85" y="1"/>
                  </a:lnTo>
                  <a:lnTo>
                    <a:pt x="86" y="1"/>
                  </a:lnTo>
                  <a:lnTo>
                    <a:pt x="87" y="2"/>
                  </a:lnTo>
                  <a:lnTo>
                    <a:pt x="88" y="1"/>
                  </a:lnTo>
                  <a:lnTo>
                    <a:pt x="89" y="2"/>
                  </a:lnTo>
                  <a:lnTo>
                    <a:pt x="90" y="2"/>
                  </a:lnTo>
                  <a:lnTo>
                    <a:pt x="91" y="1"/>
                  </a:lnTo>
                  <a:lnTo>
                    <a:pt x="92" y="1"/>
                  </a:lnTo>
                  <a:lnTo>
                    <a:pt x="93" y="2"/>
                  </a:lnTo>
                  <a:lnTo>
                    <a:pt x="93" y="2"/>
                  </a:lnTo>
                  <a:lnTo>
                    <a:pt x="94" y="2"/>
                  </a:lnTo>
                  <a:lnTo>
                    <a:pt x="95" y="2"/>
                  </a:lnTo>
                  <a:lnTo>
                    <a:pt x="96" y="2"/>
                  </a:lnTo>
                  <a:lnTo>
                    <a:pt x="97" y="2"/>
                  </a:lnTo>
                  <a:lnTo>
                    <a:pt x="98" y="2"/>
                  </a:lnTo>
                  <a:lnTo>
                    <a:pt x="99" y="3"/>
                  </a:lnTo>
                  <a:lnTo>
                    <a:pt x="100" y="3"/>
                  </a:lnTo>
                  <a:lnTo>
                    <a:pt x="100" y="2"/>
                  </a:lnTo>
                  <a:lnTo>
                    <a:pt x="101" y="2"/>
                  </a:lnTo>
                  <a:lnTo>
                    <a:pt x="102" y="2"/>
                  </a:lnTo>
                  <a:lnTo>
                    <a:pt x="103" y="2"/>
                  </a:lnTo>
                  <a:lnTo>
                    <a:pt x="104" y="1"/>
                  </a:lnTo>
                  <a:lnTo>
                    <a:pt x="105" y="2"/>
                  </a:lnTo>
                  <a:lnTo>
                    <a:pt x="106" y="2"/>
                  </a:lnTo>
                  <a:lnTo>
                    <a:pt x="107" y="1"/>
                  </a:lnTo>
                  <a:lnTo>
                    <a:pt x="108" y="1"/>
                  </a:lnTo>
                  <a:lnTo>
                    <a:pt x="108" y="1"/>
                  </a:lnTo>
                  <a:lnTo>
                    <a:pt x="109" y="2"/>
                  </a:lnTo>
                  <a:lnTo>
                    <a:pt x="110" y="2"/>
                  </a:lnTo>
                  <a:lnTo>
                    <a:pt x="111" y="1"/>
                  </a:lnTo>
                  <a:lnTo>
                    <a:pt x="112" y="2"/>
                  </a:lnTo>
                  <a:lnTo>
                    <a:pt x="113" y="2"/>
                  </a:lnTo>
                  <a:lnTo>
                    <a:pt x="114" y="2"/>
                  </a:lnTo>
                  <a:lnTo>
                    <a:pt x="115" y="2"/>
                  </a:lnTo>
                  <a:lnTo>
                    <a:pt x="115" y="2"/>
                  </a:lnTo>
                  <a:lnTo>
                    <a:pt x="116" y="2"/>
                  </a:lnTo>
                  <a:lnTo>
                    <a:pt x="117" y="2"/>
                  </a:lnTo>
                  <a:lnTo>
                    <a:pt x="118" y="3"/>
                  </a:lnTo>
                  <a:lnTo>
                    <a:pt x="119" y="2"/>
                  </a:lnTo>
                  <a:lnTo>
                    <a:pt x="120" y="2"/>
                  </a:lnTo>
                  <a:lnTo>
                    <a:pt x="121" y="2"/>
                  </a:lnTo>
                  <a:lnTo>
                    <a:pt x="122" y="3"/>
                  </a:lnTo>
                  <a:lnTo>
                    <a:pt x="123" y="3"/>
                  </a:lnTo>
                  <a:lnTo>
                    <a:pt x="123" y="3"/>
                  </a:lnTo>
                  <a:lnTo>
                    <a:pt x="124" y="2"/>
                  </a:lnTo>
                  <a:lnTo>
                    <a:pt x="125" y="2"/>
                  </a:lnTo>
                  <a:lnTo>
                    <a:pt x="126" y="2"/>
                  </a:lnTo>
                  <a:lnTo>
                    <a:pt x="127" y="1"/>
                  </a:lnTo>
                  <a:lnTo>
                    <a:pt x="128" y="1"/>
                  </a:lnTo>
                  <a:lnTo>
                    <a:pt x="129" y="1"/>
                  </a:lnTo>
                  <a:lnTo>
                    <a:pt x="130" y="2"/>
                  </a:lnTo>
                  <a:lnTo>
                    <a:pt x="130" y="1"/>
                  </a:lnTo>
                  <a:lnTo>
                    <a:pt x="131" y="1"/>
                  </a:lnTo>
                  <a:lnTo>
                    <a:pt x="132" y="1"/>
                  </a:lnTo>
                  <a:lnTo>
                    <a:pt x="133" y="1"/>
                  </a:lnTo>
                  <a:lnTo>
                    <a:pt x="134" y="1"/>
                  </a:lnTo>
                  <a:lnTo>
                    <a:pt x="135" y="1"/>
                  </a:lnTo>
                  <a:lnTo>
                    <a:pt x="136" y="1"/>
                  </a:lnTo>
                  <a:lnTo>
                    <a:pt x="137" y="2"/>
                  </a:lnTo>
                  <a:lnTo>
                    <a:pt x="138" y="1"/>
                  </a:lnTo>
                  <a:lnTo>
                    <a:pt x="138" y="1"/>
                  </a:lnTo>
                  <a:lnTo>
                    <a:pt x="139" y="2"/>
                  </a:lnTo>
                  <a:lnTo>
                    <a:pt x="140" y="2"/>
                  </a:lnTo>
                  <a:lnTo>
                    <a:pt x="141" y="2"/>
                  </a:lnTo>
                  <a:lnTo>
                    <a:pt x="142" y="2"/>
                  </a:lnTo>
                  <a:lnTo>
                    <a:pt x="143" y="2"/>
                  </a:lnTo>
                  <a:lnTo>
                    <a:pt x="144" y="2"/>
                  </a:lnTo>
                  <a:lnTo>
                    <a:pt x="145" y="3"/>
                  </a:lnTo>
                  <a:lnTo>
                    <a:pt x="145" y="4"/>
                  </a:lnTo>
                  <a:lnTo>
                    <a:pt x="146" y="2"/>
                  </a:lnTo>
                  <a:lnTo>
                    <a:pt x="147" y="2"/>
                  </a:lnTo>
                  <a:lnTo>
                    <a:pt x="148" y="3"/>
                  </a:lnTo>
                  <a:lnTo>
                    <a:pt x="149" y="3"/>
                  </a:lnTo>
                  <a:lnTo>
                    <a:pt x="150" y="3"/>
                  </a:lnTo>
                  <a:lnTo>
                    <a:pt x="151" y="2"/>
                  </a:lnTo>
                  <a:lnTo>
                    <a:pt x="152" y="3"/>
                  </a:lnTo>
                  <a:lnTo>
                    <a:pt x="153" y="2"/>
                  </a:lnTo>
                  <a:lnTo>
                    <a:pt x="153" y="2"/>
                  </a:lnTo>
                  <a:lnTo>
                    <a:pt x="154" y="2"/>
                  </a:lnTo>
                  <a:lnTo>
                    <a:pt x="155" y="2"/>
                  </a:lnTo>
                  <a:lnTo>
                    <a:pt x="156" y="1"/>
                  </a:lnTo>
                  <a:lnTo>
                    <a:pt x="157" y="1"/>
                  </a:lnTo>
                  <a:lnTo>
                    <a:pt x="158" y="1"/>
                  </a:lnTo>
                  <a:lnTo>
                    <a:pt x="159" y="1"/>
                  </a:lnTo>
                  <a:lnTo>
                    <a:pt x="160" y="2"/>
                  </a:lnTo>
                  <a:lnTo>
                    <a:pt x="160" y="1"/>
                  </a:lnTo>
                  <a:lnTo>
                    <a:pt x="161" y="2"/>
                  </a:lnTo>
                  <a:lnTo>
                    <a:pt x="162" y="1"/>
                  </a:lnTo>
                  <a:lnTo>
                    <a:pt x="163" y="1"/>
                  </a:lnTo>
                  <a:lnTo>
                    <a:pt x="164" y="1"/>
                  </a:lnTo>
                  <a:lnTo>
                    <a:pt x="165" y="1"/>
                  </a:lnTo>
                  <a:lnTo>
                    <a:pt x="166" y="2"/>
                  </a:lnTo>
                  <a:lnTo>
                    <a:pt x="167" y="1"/>
                  </a:lnTo>
                  <a:lnTo>
                    <a:pt x="168" y="1"/>
                  </a:lnTo>
                  <a:lnTo>
                    <a:pt x="168" y="2"/>
                  </a:lnTo>
                  <a:lnTo>
                    <a:pt x="169" y="1"/>
                  </a:lnTo>
                  <a:lnTo>
                    <a:pt x="170" y="2"/>
                  </a:lnTo>
                  <a:lnTo>
                    <a:pt x="171" y="2"/>
                  </a:lnTo>
                  <a:lnTo>
                    <a:pt x="172" y="1"/>
                  </a:lnTo>
                  <a:lnTo>
                    <a:pt x="173" y="2"/>
                  </a:lnTo>
                  <a:lnTo>
                    <a:pt x="174" y="2"/>
                  </a:lnTo>
                  <a:lnTo>
                    <a:pt x="175" y="3"/>
                  </a:lnTo>
                  <a:lnTo>
                    <a:pt x="175" y="3"/>
                  </a:lnTo>
                  <a:lnTo>
                    <a:pt x="176" y="3"/>
                  </a:lnTo>
                  <a:lnTo>
                    <a:pt x="177" y="3"/>
                  </a:lnTo>
                  <a:lnTo>
                    <a:pt x="178" y="2"/>
                  </a:lnTo>
                  <a:lnTo>
                    <a:pt x="179" y="2"/>
                  </a:lnTo>
                  <a:lnTo>
                    <a:pt x="180" y="2"/>
                  </a:lnTo>
                  <a:lnTo>
                    <a:pt x="181" y="2"/>
                  </a:lnTo>
                  <a:lnTo>
                    <a:pt x="182" y="2"/>
                  </a:lnTo>
                  <a:lnTo>
                    <a:pt x="182" y="1"/>
                  </a:lnTo>
                  <a:lnTo>
                    <a:pt x="183" y="2"/>
                  </a:lnTo>
                  <a:lnTo>
                    <a:pt x="184" y="1"/>
                  </a:lnTo>
                  <a:lnTo>
                    <a:pt x="185" y="2"/>
                  </a:lnTo>
                  <a:lnTo>
                    <a:pt x="186" y="2"/>
                  </a:lnTo>
                  <a:lnTo>
                    <a:pt x="187" y="2"/>
                  </a:lnTo>
                  <a:lnTo>
                    <a:pt x="188" y="2"/>
                  </a:lnTo>
                  <a:lnTo>
                    <a:pt x="189" y="2"/>
                  </a:lnTo>
                  <a:lnTo>
                    <a:pt x="190" y="2"/>
                  </a:lnTo>
                  <a:lnTo>
                    <a:pt x="190" y="3"/>
                  </a:lnTo>
                  <a:lnTo>
                    <a:pt x="191" y="3"/>
                  </a:lnTo>
                  <a:lnTo>
                    <a:pt x="192" y="2"/>
                  </a:lnTo>
                  <a:lnTo>
                    <a:pt x="193" y="2"/>
                  </a:lnTo>
                  <a:lnTo>
                    <a:pt x="194" y="2"/>
                  </a:lnTo>
                  <a:lnTo>
                    <a:pt x="195" y="2"/>
                  </a:lnTo>
                  <a:lnTo>
                    <a:pt x="196" y="2"/>
                  </a:lnTo>
                  <a:lnTo>
                    <a:pt x="197" y="2"/>
                  </a:lnTo>
                  <a:lnTo>
                    <a:pt x="197" y="2"/>
                  </a:lnTo>
                  <a:lnTo>
                    <a:pt x="198" y="2"/>
                  </a:lnTo>
                  <a:lnTo>
                    <a:pt x="199" y="1"/>
                  </a:lnTo>
                  <a:lnTo>
                    <a:pt x="200" y="1"/>
                  </a:lnTo>
                  <a:lnTo>
                    <a:pt x="201" y="1"/>
                  </a:lnTo>
                  <a:lnTo>
                    <a:pt x="202" y="1"/>
                  </a:lnTo>
                  <a:lnTo>
                    <a:pt x="203" y="2"/>
                  </a:lnTo>
                  <a:lnTo>
                    <a:pt x="204" y="1"/>
                  </a:lnTo>
                  <a:lnTo>
                    <a:pt x="205" y="1"/>
                  </a:lnTo>
                  <a:lnTo>
                    <a:pt x="205" y="1"/>
                  </a:lnTo>
                  <a:lnTo>
                    <a:pt x="206" y="1"/>
                  </a:lnTo>
                  <a:lnTo>
                    <a:pt x="207" y="2"/>
                  </a:lnTo>
                  <a:lnTo>
                    <a:pt x="208" y="1"/>
                  </a:lnTo>
                  <a:lnTo>
                    <a:pt x="209" y="2"/>
                  </a:lnTo>
                  <a:lnTo>
                    <a:pt x="210" y="1"/>
                  </a:lnTo>
                  <a:lnTo>
                    <a:pt x="211" y="2"/>
                  </a:lnTo>
                  <a:lnTo>
                    <a:pt x="212" y="2"/>
                  </a:lnTo>
                  <a:lnTo>
                    <a:pt x="212" y="2"/>
                  </a:lnTo>
                  <a:lnTo>
                    <a:pt x="213" y="2"/>
                  </a:lnTo>
                  <a:lnTo>
                    <a:pt x="214" y="2"/>
                  </a:lnTo>
                  <a:lnTo>
                    <a:pt x="215" y="2"/>
                  </a:lnTo>
                  <a:lnTo>
                    <a:pt x="216" y="2"/>
                  </a:lnTo>
                  <a:lnTo>
                    <a:pt x="217" y="2"/>
                  </a:lnTo>
                  <a:lnTo>
                    <a:pt x="218" y="2"/>
                  </a:lnTo>
                  <a:lnTo>
                    <a:pt x="219" y="2"/>
                  </a:lnTo>
                  <a:lnTo>
                    <a:pt x="220" y="2"/>
                  </a:lnTo>
                  <a:lnTo>
                    <a:pt x="220" y="1"/>
                  </a:lnTo>
                  <a:lnTo>
                    <a:pt x="221" y="2"/>
                  </a:lnTo>
                  <a:lnTo>
                    <a:pt x="222" y="2"/>
                  </a:lnTo>
                  <a:lnTo>
                    <a:pt x="223" y="2"/>
                  </a:lnTo>
                  <a:lnTo>
                    <a:pt x="224" y="2"/>
                  </a:lnTo>
                  <a:lnTo>
                    <a:pt x="225" y="2"/>
                  </a:lnTo>
                  <a:lnTo>
                    <a:pt x="226" y="2"/>
                  </a:lnTo>
                  <a:lnTo>
                    <a:pt x="227" y="2"/>
                  </a:lnTo>
                  <a:lnTo>
                    <a:pt x="227" y="2"/>
                  </a:lnTo>
                  <a:lnTo>
                    <a:pt x="228" y="2"/>
                  </a:lnTo>
                  <a:lnTo>
                    <a:pt x="229" y="2"/>
                  </a:lnTo>
                  <a:lnTo>
                    <a:pt x="230" y="1"/>
                  </a:lnTo>
                  <a:lnTo>
                    <a:pt x="231" y="2"/>
                  </a:lnTo>
                  <a:lnTo>
                    <a:pt x="232" y="2"/>
                  </a:lnTo>
                  <a:lnTo>
                    <a:pt x="233" y="2"/>
                  </a:lnTo>
                  <a:lnTo>
                    <a:pt x="234" y="2"/>
                  </a:lnTo>
                  <a:lnTo>
                    <a:pt x="235" y="2"/>
                  </a:lnTo>
                  <a:lnTo>
                    <a:pt x="235" y="2"/>
                  </a:lnTo>
                  <a:lnTo>
                    <a:pt x="236" y="2"/>
                  </a:lnTo>
                  <a:lnTo>
                    <a:pt x="237" y="2"/>
                  </a:lnTo>
                  <a:lnTo>
                    <a:pt x="238" y="2"/>
                  </a:lnTo>
                  <a:lnTo>
                    <a:pt x="239" y="2"/>
                  </a:lnTo>
                  <a:lnTo>
                    <a:pt x="240" y="2"/>
                  </a:lnTo>
                  <a:lnTo>
                    <a:pt x="241" y="2"/>
                  </a:lnTo>
                  <a:lnTo>
                    <a:pt x="242" y="2"/>
                  </a:lnTo>
                  <a:lnTo>
                    <a:pt x="242" y="2"/>
                  </a:lnTo>
                  <a:lnTo>
                    <a:pt x="243" y="2"/>
                  </a:lnTo>
                  <a:lnTo>
                    <a:pt x="244" y="2"/>
                  </a:lnTo>
                  <a:lnTo>
                    <a:pt x="245" y="2"/>
                  </a:lnTo>
                  <a:lnTo>
                    <a:pt x="246" y="3"/>
                  </a:lnTo>
                  <a:lnTo>
                    <a:pt x="247" y="2"/>
                  </a:lnTo>
                  <a:lnTo>
                    <a:pt x="248" y="2"/>
                  </a:lnTo>
                  <a:lnTo>
                    <a:pt x="249" y="2"/>
                  </a:lnTo>
                  <a:lnTo>
                    <a:pt x="250" y="2"/>
                  </a:lnTo>
                  <a:lnTo>
                    <a:pt x="250" y="2"/>
                  </a:lnTo>
                  <a:lnTo>
                    <a:pt x="251" y="2"/>
                  </a:lnTo>
                  <a:lnTo>
                    <a:pt x="252" y="1"/>
                  </a:lnTo>
                  <a:lnTo>
                    <a:pt x="253" y="2"/>
                  </a:lnTo>
                  <a:lnTo>
                    <a:pt x="254" y="2"/>
                  </a:lnTo>
                  <a:lnTo>
                    <a:pt x="255" y="1"/>
                  </a:lnTo>
                  <a:lnTo>
                    <a:pt x="256" y="1"/>
                  </a:lnTo>
                  <a:lnTo>
                    <a:pt x="257" y="2"/>
                  </a:lnTo>
                  <a:lnTo>
                    <a:pt x="257" y="2"/>
                  </a:lnTo>
                  <a:lnTo>
                    <a:pt x="258" y="2"/>
                  </a:lnTo>
                  <a:lnTo>
                    <a:pt x="259" y="2"/>
                  </a:lnTo>
                  <a:lnTo>
                    <a:pt x="260" y="3"/>
                  </a:lnTo>
                  <a:lnTo>
                    <a:pt x="261" y="2"/>
                  </a:lnTo>
                  <a:lnTo>
                    <a:pt x="262" y="3"/>
                  </a:lnTo>
                  <a:lnTo>
                    <a:pt x="263" y="4"/>
                  </a:lnTo>
                  <a:lnTo>
                    <a:pt x="264" y="4"/>
                  </a:lnTo>
                  <a:lnTo>
                    <a:pt x="265" y="4"/>
                  </a:lnTo>
                  <a:lnTo>
                    <a:pt x="265" y="3"/>
                  </a:lnTo>
                  <a:lnTo>
                    <a:pt x="266" y="3"/>
                  </a:lnTo>
                  <a:lnTo>
                    <a:pt x="267" y="2"/>
                  </a:lnTo>
                  <a:lnTo>
                    <a:pt x="268" y="3"/>
                  </a:lnTo>
                  <a:lnTo>
                    <a:pt x="269" y="2"/>
                  </a:lnTo>
                  <a:lnTo>
                    <a:pt x="270" y="2"/>
                  </a:lnTo>
                  <a:lnTo>
                    <a:pt x="271" y="2"/>
                  </a:lnTo>
                  <a:lnTo>
                    <a:pt x="272" y="2"/>
                  </a:lnTo>
                  <a:lnTo>
                    <a:pt x="272" y="2"/>
                  </a:lnTo>
                  <a:lnTo>
                    <a:pt x="273" y="2"/>
                  </a:lnTo>
                  <a:lnTo>
                    <a:pt x="274" y="2"/>
                  </a:lnTo>
                  <a:lnTo>
                    <a:pt x="275" y="2"/>
                  </a:lnTo>
                  <a:lnTo>
                    <a:pt x="276" y="2"/>
                  </a:lnTo>
                  <a:lnTo>
                    <a:pt x="277" y="2"/>
                  </a:lnTo>
                  <a:lnTo>
                    <a:pt x="278" y="2"/>
                  </a:lnTo>
                  <a:lnTo>
                    <a:pt x="279" y="1"/>
                  </a:lnTo>
                  <a:lnTo>
                    <a:pt x="280" y="2"/>
                  </a:lnTo>
                  <a:lnTo>
                    <a:pt x="280" y="2"/>
                  </a:lnTo>
                  <a:lnTo>
                    <a:pt x="281" y="2"/>
                  </a:lnTo>
                  <a:lnTo>
                    <a:pt x="282" y="2"/>
                  </a:lnTo>
                  <a:lnTo>
                    <a:pt x="283" y="2"/>
                  </a:lnTo>
                  <a:lnTo>
                    <a:pt x="284" y="3"/>
                  </a:lnTo>
                  <a:lnTo>
                    <a:pt x="285" y="4"/>
                  </a:lnTo>
                  <a:lnTo>
                    <a:pt x="286" y="4"/>
                  </a:lnTo>
                  <a:lnTo>
                    <a:pt x="287" y="5"/>
                  </a:lnTo>
                  <a:lnTo>
                    <a:pt x="287" y="7"/>
                  </a:lnTo>
                  <a:lnTo>
                    <a:pt x="288" y="8"/>
                  </a:lnTo>
                  <a:lnTo>
                    <a:pt x="289" y="9"/>
                  </a:lnTo>
                  <a:lnTo>
                    <a:pt x="290" y="8"/>
                  </a:lnTo>
                  <a:lnTo>
                    <a:pt x="291" y="8"/>
                  </a:lnTo>
                  <a:lnTo>
                    <a:pt x="292" y="8"/>
                  </a:lnTo>
                  <a:lnTo>
                    <a:pt x="293" y="7"/>
                  </a:lnTo>
                  <a:lnTo>
                    <a:pt x="294" y="6"/>
                  </a:lnTo>
                  <a:lnTo>
                    <a:pt x="295" y="5"/>
                  </a:lnTo>
                  <a:lnTo>
                    <a:pt x="295" y="5"/>
                  </a:lnTo>
                  <a:lnTo>
                    <a:pt x="296" y="4"/>
                  </a:lnTo>
                  <a:lnTo>
                    <a:pt x="297" y="4"/>
                  </a:lnTo>
                  <a:lnTo>
                    <a:pt x="298" y="4"/>
                  </a:lnTo>
                  <a:lnTo>
                    <a:pt x="299" y="4"/>
                  </a:lnTo>
                  <a:lnTo>
                    <a:pt x="300" y="4"/>
                  </a:lnTo>
                  <a:lnTo>
                    <a:pt x="301" y="4"/>
                  </a:lnTo>
                  <a:lnTo>
                    <a:pt x="302" y="3"/>
                  </a:lnTo>
                  <a:lnTo>
                    <a:pt x="302" y="3"/>
                  </a:lnTo>
                  <a:lnTo>
                    <a:pt x="303" y="3"/>
                  </a:lnTo>
                  <a:lnTo>
                    <a:pt x="304" y="3"/>
                  </a:lnTo>
                  <a:lnTo>
                    <a:pt x="305" y="3"/>
                  </a:lnTo>
                  <a:lnTo>
                    <a:pt x="306" y="3"/>
                  </a:lnTo>
                  <a:lnTo>
                    <a:pt x="307" y="2"/>
                  </a:lnTo>
                  <a:lnTo>
                    <a:pt x="308" y="3"/>
                  </a:lnTo>
                  <a:lnTo>
                    <a:pt x="309" y="4"/>
                  </a:lnTo>
                  <a:lnTo>
                    <a:pt x="310" y="3"/>
                  </a:lnTo>
                  <a:lnTo>
                    <a:pt x="310" y="4"/>
                  </a:lnTo>
                  <a:lnTo>
                    <a:pt x="311" y="3"/>
                  </a:lnTo>
                  <a:lnTo>
                    <a:pt x="312" y="3"/>
                  </a:lnTo>
                  <a:lnTo>
                    <a:pt x="313" y="3"/>
                  </a:lnTo>
                  <a:lnTo>
                    <a:pt x="314" y="2"/>
                  </a:lnTo>
                  <a:lnTo>
                    <a:pt x="315" y="2"/>
                  </a:lnTo>
                  <a:lnTo>
                    <a:pt x="316" y="2"/>
                  </a:lnTo>
                  <a:lnTo>
                    <a:pt x="317" y="2"/>
                  </a:lnTo>
                  <a:lnTo>
                    <a:pt x="317" y="2"/>
                  </a:lnTo>
                  <a:lnTo>
                    <a:pt x="318" y="2"/>
                  </a:lnTo>
                  <a:lnTo>
                    <a:pt x="319" y="3"/>
                  </a:lnTo>
                  <a:lnTo>
                    <a:pt x="320" y="3"/>
                  </a:lnTo>
                  <a:lnTo>
                    <a:pt x="321" y="3"/>
                  </a:lnTo>
                  <a:lnTo>
                    <a:pt x="322" y="3"/>
                  </a:lnTo>
                  <a:lnTo>
                    <a:pt x="323" y="4"/>
                  </a:lnTo>
                  <a:lnTo>
                    <a:pt x="324" y="5"/>
                  </a:lnTo>
                  <a:lnTo>
                    <a:pt x="325" y="4"/>
                  </a:lnTo>
                  <a:lnTo>
                    <a:pt x="325" y="4"/>
                  </a:lnTo>
                  <a:lnTo>
                    <a:pt x="326" y="3"/>
                  </a:lnTo>
                  <a:lnTo>
                    <a:pt x="327" y="4"/>
                  </a:lnTo>
                  <a:lnTo>
                    <a:pt x="328" y="3"/>
                  </a:lnTo>
                  <a:lnTo>
                    <a:pt x="329" y="3"/>
                  </a:lnTo>
                  <a:lnTo>
                    <a:pt x="330" y="3"/>
                  </a:lnTo>
                  <a:lnTo>
                    <a:pt x="331" y="2"/>
                  </a:lnTo>
                  <a:lnTo>
                    <a:pt x="332" y="1"/>
                  </a:lnTo>
                  <a:lnTo>
                    <a:pt x="332" y="1"/>
                  </a:lnTo>
                  <a:lnTo>
                    <a:pt x="333" y="2"/>
                  </a:lnTo>
                  <a:lnTo>
                    <a:pt x="334" y="2"/>
                  </a:lnTo>
                  <a:lnTo>
                    <a:pt x="335" y="2"/>
                  </a:lnTo>
                  <a:lnTo>
                    <a:pt x="336" y="2"/>
                  </a:lnTo>
                  <a:lnTo>
                    <a:pt x="337" y="2"/>
                  </a:lnTo>
                  <a:lnTo>
                    <a:pt x="338" y="1"/>
                  </a:lnTo>
                  <a:lnTo>
                    <a:pt x="339" y="2"/>
                  </a:lnTo>
                  <a:lnTo>
                    <a:pt x="340" y="2"/>
                  </a:lnTo>
                  <a:lnTo>
                    <a:pt x="340" y="2"/>
                  </a:lnTo>
                  <a:lnTo>
                    <a:pt x="341" y="2"/>
                  </a:lnTo>
                  <a:lnTo>
                    <a:pt x="342" y="2"/>
                  </a:lnTo>
                  <a:lnTo>
                    <a:pt x="343" y="2"/>
                  </a:lnTo>
                  <a:lnTo>
                    <a:pt x="344" y="3"/>
                  </a:lnTo>
                  <a:lnTo>
                    <a:pt x="345" y="2"/>
                  </a:lnTo>
                  <a:lnTo>
                    <a:pt x="346" y="2"/>
                  </a:lnTo>
                  <a:lnTo>
                    <a:pt x="347" y="2"/>
                  </a:lnTo>
                  <a:lnTo>
                    <a:pt x="347" y="3"/>
                  </a:lnTo>
                  <a:lnTo>
                    <a:pt x="348" y="3"/>
                  </a:lnTo>
                  <a:lnTo>
                    <a:pt x="349" y="2"/>
                  </a:lnTo>
                  <a:lnTo>
                    <a:pt x="350" y="2"/>
                  </a:lnTo>
                  <a:lnTo>
                    <a:pt x="351" y="3"/>
                  </a:lnTo>
                  <a:lnTo>
                    <a:pt x="352" y="3"/>
                  </a:lnTo>
                  <a:lnTo>
                    <a:pt x="353" y="3"/>
                  </a:lnTo>
                  <a:lnTo>
                    <a:pt x="354" y="3"/>
                  </a:lnTo>
                  <a:lnTo>
                    <a:pt x="355" y="3"/>
                  </a:lnTo>
                  <a:lnTo>
                    <a:pt x="355" y="3"/>
                  </a:lnTo>
                  <a:lnTo>
                    <a:pt x="356" y="3"/>
                  </a:lnTo>
                  <a:lnTo>
                    <a:pt x="357" y="3"/>
                  </a:lnTo>
                  <a:lnTo>
                    <a:pt x="358" y="2"/>
                  </a:lnTo>
                  <a:lnTo>
                    <a:pt x="359" y="3"/>
                  </a:lnTo>
                  <a:lnTo>
                    <a:pt x="360" y="4"/>
                  </a:lnTo>
                  <a:lnTo>
                    <a:pt x="361" y="4"/>
                  </a:lnTo>
                  <a:lnTo>
                    <a:pt x="362" y="4"/>
                  </a:lnTo>
                  <a:lnTo>
                    <a:pt x="362" y="4"/>
                  </a:lnTo>
                  <a:lnTo>
                    <a:pt x="363" y="4"/>
                  </a:lnTo>
                  <a:lnTo>
                    <a:pt x="364" y="4"/>
                  </a:lnTo>
                  <a:lnTo>
                    <a:pt x="365" y="4"/>
                  </a:lnTo>
                  <a:lnTo>
                    <a:pt x="366" y="4"/>
                  </a:lnTo>
                  <a:lnTo>
                    <a:pt x="367" y="4"/>
                  </a:lnTo>
                  <a:lnTo>
                    <a:pt x="368" y="3"/>
                  </a:lnTo>
                  <a:lnTo>
                    <a:pt x="369" y="3"/>
                  </a:lnTo>
                  <a:lnTo>
                    <a:pt x="369" y="3"/>
                  </a:lnTo>
                  <a:lnTo>
                    <a:pt x="370" y="3"/>
                  </a:lnTo>
                  <a:lnTo>
                    <a:pt x="371" y="4"/>
                  </a:lnTo>
                  <a:lnTo>
                    <a:pt x="372" y="3"/>
                  </a:lnTo>
                  <a:lnTo>
                    <a:pt x="373" y="4"/>
                  </a:lnTo>
                  <a:lnTo>
                    <a:pt x="374" y="4"/>
                  </a:lnTo>
                  <a:lnTo>
                    <a:pt x="375" y="4"/>
                  </a:lnTo>
                  <a:lnTo>
                    <a:pt x="376" y="4"/>
                  </a:lnTo>
                  <a:lnTo>
                    <a:pt x="377" y="4"/>
                  </a:lnTo>
                  <a:lnTo>
                    <a:pt x="377" y="3"/>
                  </a:lnTo>
                  <a:lnTo>
                    <a:pt x="378" y="3"/>
                  </a:lnTo>
                  <a:lnTo>
                    <a:pt x="379" y="3"/>
                  </a:lnTo>
                  <a:lnTo>
                    <a:pt x="380" y="3"/>
                  </a:lnTo>
                  <a:lnTo>
                    <a:pt x="381" y="3"/>
                  </a:lnTo>
                  <a:lnTo>
                    <a:pt x="382" y="3"/>
                  </a:lnTo>
                  <a:lnTo>
                    <a:pt x="383" y="3"/>
                  </a:lnTo>
                  <a:lnTo>
                    <a:pt x="384" y="3"/>
                  </a:lnTo>
                  <a:lnTo>
                    <a:pt x="384" y="3"/>
                  </a:lnTo>
                  <a:lnTo>
                    <a:pt x="385" y="4"/>
                  </a:lnTo>
                  <a:lnTo>
                    <a:pt x="386" y="4"/>
                  </a:lnTo>
                  <a:lnTo>
                    <a:pt x="387" y="3"/>
                  </a:lnTo>
                  <a:lnTo>
                    <a:pt x="388" y="4"/>
                  </a:lnTo>
                  <a:lnTo>
                    <a:pt x="389" y="4"/>
                  </a:lnTo>
                  <a:lnTo>
                    <a:pt x="390" y="5"/>
                  </a:lnTo>
                  <a:lnTo>
                    <a:pt x="391" y="5"/>
                  </a:lnTo>
                  <a:lnTo>
                    <a:pt x="392" y="4"/>
                  </a:lnTo>
                  <a:lnTo>
                    <a:pt x="392" y="4"/>
                  </a:lnTo>
                  <a:lnTo>
                    <a:pt x="393" y="4"/>
                  </a:lnTo>
                  <a:lnTo>
                    <a:pt x="394" y="5"/>
                  </a:lnTo>
                  <a:lnTo>
                    <a:pt x="395" y="4"/>
                  </a:lnTo>
                  <a:lnTo>
                    <a:pt x="396" y="4"/>
                  </a:lnTo>
                  <a:lnTo>
                    <a:pt x="397" y="4"/>
                  </a:lnTo>
                  <a:lnTo>
                    <a:pt x="398" y="4"/>
                  </a:lnTo>
                  <a:lnTo>
                    <a:pt x="399" y="4"/>
                  </a:lnTo>
                  <a:lnTo>
                    <a:pt x="399" y="4"/>
                  </a:lnTo>
                  <a:lnTo>
                    <a:pt x="400" y="3"/>
                  </a:lnTo>
                  <a:lnTo>
                    <a:pt x="401" y="4"/>
                  </a:lnTo>
                  <a:lnTo>
                    <a:pt x="402" y="3"/>
                  </a:lnTo>
                  <a:lnTo>
                    <a:pt x="403" y="3"/>
                  </a:lnTo>
                  <a:lnTo>
                    <a:pt x="404" y="3"/>
                  </a:lnTo>
                  <a:lnTo>
                    <a:pt x="405" y="3"/>
                  </a:lnTo>
                  <a:lnTo>
                    <a:pt x="406" y="3"/>
                  </a:lnTo>
                  <a:lnTo>
                    <a:pt x="407" y="2"/>
                  </a:lnTo>
                  <a:lnTo>
                    <a:pt x="407" y="2"/>
                  </a:lnTo>
                  <a:lnTo>
                    <a:pt x="408" y="2"/>
                  </a:lnTo>
                  <a:lnTo>
                    <a:pt x="409" y="3"/>
                  </a:lnTo>
                  <a:lnTo>
                    <a:pt x="410" y="2"/>
                  </a:lnTo>
                  <a:lnTo>
                    <a:pt x="411" y="2"/>
                  </a:lnTo>
                  <a:lnTo>
                    <a:pt x="412" y="2"/>
                  </a:lnTo>
                  <a:lnTo>
                    <a:pt x="413" y="3"/>
                  </a:lnTo>
                  <a:lnTo>
                    <a:pt x="414" y="2"/>
                  </a:lnTo>
                  <a:lnTo>
                    <a:pt x="414" y="2"/>
                  </a:lnTo>
                  <a:lnTo>
                    <a:pt x="415" y="3"/>
                  </a:lnTo>
                  <a:lnTo>
                    <a:pt x="416" y="2"/>
                  </a:lnTo>
                  <a:lnTo>
                    <a:pt x="417" y="3"/>
                  </a:lnTo>
                  <a:lnTo>
                    <a:pt x="418" y="2"/>
                  </a:lnTo>
                  <a:lnTo>
                    <a:pt x="419" y="3"/>
                  </a:lnTo>
                  <a:lnTo>
                    <a:pt x="420" y="3"/>
                  </a:lnTo>
                  <a:lnTo>
                    <a:pt x="421" y="2"/>
                  </a:lnTo>
                  <a:lnTo>
                    <a:pt x="422" y="2"/>
                  </a:lnTo>
                  <a:lnTo>
                    <a:pt x="422" y="3"/>
                  </a:lnTo>
                  <a:lnTo>
                    <a:pt x="423" y="3"/>
                  </a:lnTo>
                  <a:lnTo>
                    <a:pt x="424" y="4"/>
                  </a:lnTo>
                  <a:lnTo>
                    <a:pt x="425" y="5"/>
                  </a:lnTo>
                  <a:lnTo>
                    <a:pt x="426" y="5"/>
                  </a:lnTo>
                  <a:lnTo>
                    <a:pt x="427" y="5"/>
                  </a:lnTo>
                  <a:lnTo>
                    <a:pt x="428" y="4"/>
                  </a:lnTo>
                  <a:lnTo>
                    <a:pt x="429" y="5"/>
                  </a:lnTo>
                  <a:lnTo>
                    <a:pt x="429" y="3"/>
                  </a:lnTo>
                  <a:lnTo>
                    <a:pt x="430" y="3"/>
                  </a:lnTo>
                  <a:lnTo>
                    <a:pt x="431" y="4"/>
                  </a:lnTo>
                  <a:lnTo>
                    <a:pt x="432" y="5"/>
                  </a:lnTo>
                  <a:lnTo>
                    <a:pt x="433" y="4"/>
                  </a:lnTo>
                  <a:lnTo>
                    <a:pt x="434" y="4"/>
                  </a:lnTo>
                  <a:lnTo>
                    <a:pt x="435" y="4"/>
                  </a:lnTo>
                  <a:lnTo>
                    <a:pt x="436" y="5"/>
                  </a:lnTo>
                  <a:lnTo>
                    <a:pt x="437" y="6"/>
                  </a:lnTo>
                  <a:lnTo>
                    <a:pt x="437" y="5"/>
                  </a:lnTo>
                  <a:lnTo>
                    <a:pt x="438" y="5"/>
                  </a:lnTo>
                  <a:lnTo>
                    <a:pt x="439" y="5"/>
                  </a:lnTo>
                  <a:lnTo>
                    <a:pt x="440" y="5"/>
                  </a:lnTo>
                  <a:lnTo>
                    <a:pt x="441" y="6"/>
                  </a:lnTo>
                  <a:lnTo>
                    <a:pt x="442" y="5"/>
                  </a:lnTo>
                  <a:lnTo>
                    <a:pt x="443" y="5"/>
                  </a:lnTo>
                  <a:lnTo>
                    <a:pt x="444" y="4"/>
                  </a:lnTo>
                  <a:lnTo>
                    <a:pt x="444" y="5"/>
                  </a:lnTo>
                  <a:lnTo>
                    <a:pt x="445" y="4"/>
                  </a:lnTo>
                  <a:lnTo>
                    <a:pt x="446" y="3"/>
                  </a:lnTo>
                  <a:lnTo>
                    <a:pt x="447" y="3"/>
                  </a:lnTo>
                  <a:lnTo>
                    <a:pt x="448" y="4"/>
                  </a:lnTo>
                  <a:lnTo>
                    <a:pt x="449" y="3"/>
                  </a:lnTo>
                  <a:lnTo>
                    <a:pt x="450" y="3"/>
                  </a:lnTo>
                  <a:lnTo>
                    <a:pt x="451" y="4"/>
                  </a:lnTo>
                  <a:lnTo>
                    <a:pt x="452" y="4"/>
                  </a:lnTo>
                  <a:lnTo>
                    <a:pt x="452" y="5"/>
                  </a:lnTo>
                  <a:lnTo>
                    <a:pt x="453" y="4"/>
                  </a:lnTo>
                  <a:lnTo>
                    <a:pt x="454" y="5"/>
                  </a:lnTo>
                  <a:lnTo>
                    <a:pt x="455" y="5"/>
                  </a:lnTo>
                  <a:lnTo>
                    <a:pt x="456" y="4"/>
                  </a:lnTo>
                  <a:lnTo>
                    <a:pt x="457" y="4"/>
                  </a:lnTo>
                  <a:lnTo>
                    <a:pt x="458" y="3"/>
                  </a:lnTo>
                  <a:lnTo>
                    <a:pt x="459" y="3"/>
                  </a:lnTo>
                  <a:lnTo>
                    <a:pt x="459" y="2"/>
                  </a:lnTo>
                  <a:lnTo>
                    <a:pt x="460" y="2"/>
                  </a:lnTo>
                  <a:lnTo>
                    <a:pt x="461" y="2"/>
                  </a:lnTo>
                  <a:lnTo>
                    <a:pt x="462" y="2"/>
                  </a:lnTo>
                  <a:lnTo>
                    <a:pt x="463" y="2"/>
                  </a:lnTo>
                  <a:lnTo>
                    <a:pt x="464" y="3"/>
                  </a:lnTo>
                  <a:lnTo>
                    <a:pt x="465" y="3"/>
                  </a:lnTo>
                  <a:lnTo>
                    <a:pt x="466" y="3"/>
                  </a:lnTo>
                  <a:lnTo>
                    <a:pt x="467" y="4"/>
                  </a:lnTo>
                  <a:lnTo>
                    <a:pt x="467" y="6"/>
                  </a:lnTo>
                  <a:lnTo>
                    <a:pt x="468" y="8"/>
                  </a:lnTo>
                  <a:lnTo>
                    <a:pt x="469" y="10"/>
                  </a:lnTo>
                  <a:lnTo>
                    <a:pt x="470" y="11"/>
                  </a:lnTo>
                  <a:lnTo>
                    <a:pt x="471" y="14"/>
                  </a:lnTo>
                  <a:lnTo>
                    <a:pt x="472" y="13"/>
                  </a:lnTo>
                  <a:lnTo>
                    <a:pt x="473" y="13"/>
                  </a:lnTo>
                  <a:lnTo>
                    <a:pt x="474" y="13"/>
                  </a:lnTo>
                  <a:lnTo>
                    <a:pt x="474" y="11"/>
                  </a:lnTo>
                  <a:lnTo>
                    <a:pt x="475" y="11"/>
                  </a:lnTo>
                  <a:lnTo>
                    <a:pt x="476" y="10"/>
                  </a:lnTo>
                  <a:lnTo>
                    <a:pt x="477" y="10"/>
                  </a:lnTo>
                  <a:lnTo>
                    <a:pt x="478" y="9"/>
                  </a:lnTo>
                  <a:lnTo>
                    <a:pt x="479" y="8"/>
                  </a:lnTo>
                  <a:lnTo>
                    <a:pt x="480" y="9"/>
                  </a:lnTo>
                  <a:lnTo>
                    <a:pt x="481" y="10"/>
                  </a:lnTo>
                  <a:lnTo>
                    <a:pt x="482" y="8"/>
                  </a:lnTo>
                  <a:lnTo>
                    <a:pt x="482" y="9"/>
                  </a:lnTo>
                  <a:lnTo>
                    <a:pt x="483" y="8"/>
                  </a:lnTo>
                  <a:lnTo>
                    <a:pt x="484" y="7"/>
                  </a:lnTo>
                  <a:lnTo>
                    <a:pt x="485" y="7"/>
                  </a:lnTo>
                  <a:lnTo>
                    <a:pt x="486" y="6"/>
                  </a:lnTo>
                  <a:lnTo>
                    <a:pt x="487" y="5"/>
                  </a:lnTo>
                  <a:lnTo>
                    <a:pt x="488" y="5"/>
                  </a:lnTo>
                  <a:lnTo>
                    <a:pt x="489" y="4"/>
                  </a:lnTo>
                  <a:lnTo>
                    <a:pt x="489" y="4"/>
                  </a:lnTo>
                  <a:lnTo>
                    <a:pt x="490" y="4"/>
                  </a:lnTo>
                  <a:lnTo>
                    <a:pt x="491" y="4"/>
                  </a:lnTo>
                  <a:lnTo>
                    <a:pt x="492" y="3"/>
                  </a:lnTo>
                  <a:lnTo>
                    <a:pt x="493" y="4"/>
                  </a:lnTo>
                  <a:lnTo>
                    <a:pt x="494" y="3"/>
                  </a:lnTo>
                  <a:lnTo>
                    <a:pt x="495" y="4"/>
                  </a:lnTo>
                  <a:lnTo>
                    <a:pt x="496" y="3"/>
                  </a:lnTo>
                  <a:lnTo>
                    <a:pt x="497" y="4"/>
                  </a:lnTo>
                  <a:lnTo>
                    <a:pt x="497" y="4"/>
                  </a:lnTo>
                  <a:lnTo>
                    <a:pt x="498" y="3"/>
                  </a:lnTo>
                  <a:lnTo>
                    <a:pt x="499" y="4"/>
                  </a:lnTo>
                  <a:lnTo>
                    <a:pt x="500" y="4"/>
                  </a:lnTo>
                  <a:lnTo>
                    <a:pt x="501" y="3"/>
                  </a:lnTo>
                  <a:lnTo>
                    <a:pt x="502" y="4"/>
                  </a:lnTo>
                  <a:lnTo>
                    <a:pt x="503" y="4"/>
                  </a:lnTo>
                  <a:lnTo>
                    <a:pt x="504" y="4"/>
                  </a:lnTo>
                  <a:lnTo>
                    <a:pt x="504" y="4"/>
                  </a:lnTo>
                  <a:lnTo>
                    <a:pt x="505" y="3"/>
                  </a:lnTo>
                  <a:lnTo>
                    <a:pt x="506" y="3"/>
                  </a:lnTo>
                  <a:lnTo>
                    <a:pt x="507" y="3"/>
                  </a:lnTo>
                  <a:lnTo>
                    <a:pt x="508" y="3"/>
                  </a:lnTo>
                  <a:lnTo>
                    <a:pt x="509" y="3"/>
                  </a:lnTo>
                  <a:lnTo>
                    <a:pt x="510" y="2"/>
                  </a:lnTo>
                  <a:lnTo>
                    <a:pt x="511" y="3"/>
                  </a:lnTo>
                  <a:lnTo>
                    <a:pt x="512" y="2"/>
                  </a:lnTo>
                  <a:lnTo>
                    <a:pt x="512" y="3"/>
                  </a:lnTo>
                  <a:lnTo>
                    <a:pt x="513" y="2"/>
                  </a:lnTo>
                  <a:lnTo>
                    <a:pt x="514" y="3"/>
                  </a:lnTo>
                  <a:lnTo>
                    <a:pt x="515" y="2"/>
                  </a:lnTo>
                  <a:lnTo>
                    <a:pt x="516" y="3"/>
                  </a:lnTo>
                  <a:lnTo>
                    <a:pt x="517" y="2"/>
                  </a:lnTo>
                  <a:lnTo>
                    <a:pt x="518" y="2"/>
                  </a:lnTo>
                  <a:lnTo>
                    <a:pt x="519" y="3"/>
                  </a:lnTo>
                  <a:lnTo>
                    <a:pt x="519" y="2"/>
                  </a:lnTo>
                  <a:lnTo>
                    <a:pt x="520" y="3"/>
                  </a:lnTo>
                  <a:lnTo>
                    <a:pt x="521" y="3"/>
                  </a:lnTo>
                  <a:lnTo>
                    <a:pt x="522" y="3"/>
                  </a:lnTo>
                  <a:lnTo>
                    <a:pt x="523" y="2"/>
                  </a:lnTo>
                  <a:lnTo>
                    <a:pt x="524" y="3"/>
                  </a:lnTo>
                  <a:lnTo>
                    <a:pt x="525" y="4"/>
                  </a:lnTo>
                  <a:lnTo>
                    <a:pt x="526" y="4"/>
                  </a:lnTo>
                  <a:lnTo>
                    <a:pt x="527" y="6"/>
                  </a:lnTo>
                  <a:lnTo>
                    <a:pt x="527" y="7"/>
                  </a:lnTo>
                  <a:lnTo>
                    <a:pt x="528" y="8"/>
                  </a:lnTo>
                  <a:lnTo>
                    <a:pt x="529" y="10"/>
                  </a:lnTo>
                  <a:lnTo>
                    <a:pt x="530" y="13"/>
                  </a:lnTo>
                  <a:lnTo>
                    <a:pt x="531" y="14"/>
                  </a:lnTo>
                  <a:lnTo>
                    <a:pt x="532" y="15"/>
                  </a:lnTo>
                  <a:lnTo>
                    <a:pt x="533" y="15"/>
                  </a:lnTo>
                  <a:lnTo>
                    <a:pt x="534" y="14"/>
                  </a:lnTo>
                  <a:lnTo>
                    <a:pt x="534" y="12"/>
                  </a:lnTo>
                  <a:lnTo>
                    <a:pt x="535" y="10"/>
                  </a:lnTo>
                  <a:lnTo>
                    <a:pt x="536" y="9"/>
                  </a:lnTo>
                  <a:lnTo>
                    <a:pt x="537" y="10"/>
                  </a:lnTo>
                  <a:lnTo>
                    <a:pt x="538" y="9"/>
                  </a:lnTo>
                  <a:lnTo>
                    <a:pt x="539" y="12"/>
                  </a:lnTo>
                  <a:lnTo>
                    <a:pt x="540" y="15"/>
                  </a:lnTo>
                  <a:lnTo>
                    <a:pt x="541" y="21"/>
                  </a:lnTo>
                  <a:lnTo>
                    <a:pt x="542" y="25"/>
                  </a:lnTo>
                  <a:lnTo>
                    <a:pt x="542" y="29"/>
                  </a:lnTo>
                  <a:lnTo>
                    <a:pt x="543" y="33"/>
                  </a:lnTo>
                  <a:lnTo>
                    <a:pt x="544" y="35"/>
                  </a:lnTo>
                  <a:lnTo>
                    <a:pt x="545" y="33"/>
                  </a:lnTo>
                  <a:lnTo>
                    <a:pt x="546" y="29"/>
                  </a:lnTo>
                  <a:lnTo>
                    <a:pt x="547" y="28"/>
                  </a:lnTo>
                  <a:lnTo>
                    <a:pt x="548" y="21"/>
                  </a:lnTo>
                  <a:lnTo>
                    <a:pt x="549" y="18"/>
                  </a:lnTo>
                  <a:lnTo>
                    <a:pt x="549" y="14"/>
                  </a:lnTo>
                  <a:lnTo>
                    <a:pt x="550" y="13"/>
                  </a:lnTo>
                  <a:lnTo>
                    <a:pt x="551" y="10"/>
                  </a:lnTo>
                  <a:lnTo>
                    <a:pt x="552" y="8"/>
                  </a:lnTo>
                  <a:lnTo>
                    <a:pt x="553" y="7"/>
                  </a:lnTo>
                  <a:lnTo>
                    <a:pt x="554" y="6"/>
                  </a:lnTo>
                  <a:lnTo>
                    <a:pt x="555" y="6"/>
                  </a:lnTo>
                  <a:lnTo>
                    <a:pt x="556" y="7"/>
                  </a:lnTo>
                  <a:lnTo>
                    <a:pt x="557" y="6"/>
                  </a:lnTo>
                  <a:lnTo>
                    <a:pt x="557" y="5"/>
                  </a:lnTo>
                  <a:lnTo>
                    <a:pt x="558" y="5"/>
                  </a:lnTo>
                  <a:lnTo>
                    <a:pt x="559" y="6"/>
                  </a:lnTo>
                  <a:lnTo>
                    <a:pt x="560" y="6"/>
                  </a:lnTo>
                  <a:lnTo>
                    <a:pt x="561" y="6"/>
                  </a:lnTo>
                  <a:lnTo>
                    <a:pt x="562" y="6"/>
                  </a:lnTo>
                  <a:lnTo>
                    <a:pt x="563" y="8"/>
                  </a:lnTo>
                  <a:lnTo>
                    <a:pt x="564" y="9"/>
                  </a:lnTo>
                  <a:lnTo>
                    <a:pt x="564" y="7"/>
                  </a:lnTo>
                  <a:lnTo>
                    <a:pt x="565" y="9"/>
                  </a:lnTo>
                  <a:lnTo>
                    <a:pt x="566" y="9"/>
                  </a:lnTo>
                  <a:lnTo>
                    <a:pt x="567" y="8"/>
                  </a:lnTo>
                  <a:lnTo>
                    <a:pt x="568" y="9"/>
                  </a:lnTo>
                  <a:lnTo>
                    <a:pt x="569" y="8"/>
                  </a:lnTo>
                  <a:lnTo>
                    <a:pt x="570" y="7"/>
                  </a:lnTo>
                  <a:lnTo>
                    <a:pt x="571" y="7"/>
                  </a:lnTo>
                  <a:lnTo>
                    <a:pt x="571" y="7"/>
                  </a:lnTo>
                  <a:lnTo>
                    <a:pt x="572" y="6"/>
                  </a:lnTo>
                  <a:lnTo>
                    <a:pt x="573" y="6"/>
                  </a:lnTo>
                  <a:lnTo>
                    <a:pt x="574" y="5"/>
                  </a:lnTo>
                  <a:lnTo>
                    <a:pt x="575" y="4"/>
                  </a:lnTo>
                  <a:lnTo>
                    <a:pt x="576" y="4"/>
                  </a:lnTo>
                  <a:lnTo>
                    <a:pt x="577" y="4"/>
                  </a:lnTo>
                  <a:lnTo>
                    <a:pt x="578" y="4"/>
                  </a:lnTo>
                  <a:lnTo>
                    <a:pt x="579" y="3"/>
                  </a:lnTo>
                  <a:lnTo>
                    <a:pt x="579" y="3"/>
                  </a:lnTo>
                  <a:lnTo>
                    <a:pt x="580" y="3"/>
                  </a:lnTo>
                  <a:lnTo>
                    <a:pt x="581" y="3"/>
                  </a:lnTo>
                  <a:lnTo>
                    <a:pt x="582" y="4"/>
                  </a:lnTo>
                  <a:lnTo>
                    <a:pt x="583" y="3"/>
                  </a:lnTo>
                  <a:lnTo>
                    <a:pt x="584" y="3"/>
                  </a:lnTo>
                  <a:lnTo>
                    <a:pt x="585" y="3"/>
                  </a:lnTo>
                  <a:lnTo>
                    <a:pt x="586" y="5"/>
                  </a:lnTo>
                  <a:lnTo>
                    <a:pt x="586" y="4"/>
                  </a:lnTo>
                  <a:lnTo>
                    <a:pt x="587" y="4"/>
                  </a:lnTo>
                  <a:lnTo>
                    <a:pt x="588" y="5"/>
                  </a:lnTo>
                  <a:lnTo>
                    <a:pt x="589" y="4"/>
                  </a:lnTo>
                  <a:lnTo>
                    <a:pt x="590" y="6"/>
                  </a:lnTo>
                  <a:lnTo>
                    <a:pt x="591" y="4"/>
                  </a:lnTo>
                  <a:lnTo>
                    <a:pt x="592" y="4"/>
                  </a:lnTo>
                  <a:lnTo>
                    <a:pt x="593" y="3"/>
                  </a:lnTo>
                  <a:lnTo>
                    <a:pt x="594" y="4"/>
                  </a:lnTo>
                  <a:lnTo>
                    <a:pt x="594" y="3"/>
                  </a:lnTo>
                  <a:lnTo>
                    <a:pt x="595" y="3"/>
                  </a:lnTo>
                  <a:lnTo>
                    <a:pt x="596" y="3"/>
                  </a:lnTo>
                  <a:lnTo>
                    <a:pt x="597" y="3"/>
                  </a:lnTo>
                  <a:lnTo>
                    <a:pt x="598" y="2"/>
                  </a:lnTo>
                  <a:lnTo>
                    <a:pt x="599" y="3"/>
                  </a:lnTo>
                  <a:lnTo>
                    <a:pt x="600" y="2"/>
                  </a:lnTo>
                  <a:lnTo>
                    <a:pt x="601" y="2"/>
                  </a:lnTo>
                  <a:lnTo>
                    <a:pt x="601" y="2"/>
                  </a:lnTo>
                  <a:lnTo>
                    <a:pt x="602" y="2"/>
                  </a:lnTo>
                  <a:lnTo>
                    <a:pt x="603" y="2"/>
                  </a:lnTo>
                  <a:lnTo>
                    <a:pt x="604" y="2"/>
                  </a:lnTo>
                  <a:lnTo>
                    <a:pt x="605" y="3"/>
                  </a:lnTo>
                  <a:lnTo>
                    <a:pt x="606" y="3"/>
                  </a:lnTo>
                  <a:lnTo>
                    <a:pt x="607" y="2"/>
                  </a:lnTo>
                  <a:lnTo>
                    <a:pt x="608" y="3"/>
                  </a:lnTo>
                  <a:lnTo>
                    <a:pt x="609" y="4"/>
                  </a:lnTo>
                  <a:lnTo>
                    <a:pt x="609" y="4"/>
                  </a:lnTo>
                  <a:lnTo>
                    <a:pt x="610" y="4"/>
                  </a:lnTo>
                  <a:lnTo>
                    <a:pt x="611" y="4"/>
                  </a:lnTo>
                  <a:lnTo>
                    <a:pt x="612" y="4"/>
                  </a:lnTo>
                  <a:lnTo>
                    <a:pt x="613" y="3"/>
                  </a:lnTo>
                  <a:lnTo>
                    <a:pt x="614" y="4"/>
                  </a:lnTo>
                  <a:lnTo>
                    <a:pt x="615" y="4"/>
                  </a:lnTo>
                  <a:lnTo>
                    <a:pt x="616" y="4"/>
                  </a:lnTo>
                  <a:lnTo>
                    <a:pt x="616" y="4"/>
                  </a:lnTo>
                  <a:lnTo>
                    <a:pt x="617" y="3"/>
                  </a:lnTo>
                  <a:lnTo>
                    <a:pt x="618" y="3"/>
                  </a:lnTo>
                  <a:lnTo>
                    <a:pt x="619" y="3"/>
                  </a:lnTo>
                  <a:lnTo>
                    <a:pt x="620" y="3"/>
                  </a:lnTo>
                  <a:lnTo>
                    <a:pt x="621" y="3"/>
                  </a:lnTo>
                  <a:lnTo>
                    <a:pt x="622" y="2"/>
                  </a:lnTo>
                  <a:lnTo>
                    <a:pt x="623" y="2"/>
                  </a:lnTo>
                  <a:lnTo>
                    <a:pt x="624" y="2"/>
                  </a:lnTo>
                  <a:lnTo>
                    <a:pt x="624" y="2"/>
                  </a:lnTo>
                  <a:lnTo>
                    <a:pt x="625" y="2"/>
                  </a:lnTo>
                  <a:lnTo>
                    <a:pt x="626" y="2"/>
                  </a:lnTo>
                  <a:lnTo>
                    <a:pt x="627" y="2"/>
                  </a:lnTo>
                  <a:lnTo>
                    <a:pt x="628" y="2"/>
                  </a:lnTo>
                  <a:lnTo>
                    <a:pt x="629" y="3"/>
                  </a:lnTo>
                  <a:lnTo>
                    <a:pt x="630" y="2"/>
                  </a:lnTo>
                  <a:lnTo>
                    <a:pt x="631" y="1"/>
                  </a:lnTo>
                  <a:lnTo>
                    <a:pt x="631" y="2"/>
                  </a:lnTo>
                  <a:lnTo>
                    <a:pt x="632" y="2"/>
                  </a:lnTo>
                  <a:lnTo>
                    <a:pt x="633" y="1"/>
                  </a:lnTo>
                  <a:lnTo>
                    <a:pt x="634" y="2"/>
                  </a:lnTo>
                  <a:lnTo>
                    <a:pt x="635" y="2"/>
                  </a:lnTo>
                  <a:lnTo>
                    <a:pt x="636" y="2"/>
                  </a:lnTo>
                  <a:lnTo>
                    <a:pt x="637" y="2"/>
                  </a:lnTo>
                  <a:lnTo>
                    <a:pt x="638" y="2"/>
                  </a:lnTo>
                  <a:lnTo>
                    <a:pt x="639" y="2"/>
                  </a:lnTo>
                  <a:lnTo>
                    <a:pt x="639" y="2"/>
                  </a:lnTo>
                  <a:lnTo>
                    <a:pt x="640" y="2"/>
                  </a:lnTo>
                  <a:lnTo>
                    <a:pt x="641" y="2"/>
                  </a:lnTo>
                  <a:lnTo>
                    <a:pt x="642" y="1"/>
                  </a:lnTo>
                  <a:lnTo>
                    <a:pt x="643" y="2"/>
                  </a:lnTo>
                  <a:lnTo>
                    <a:pt x="644" y="2"/>
                  </a:lnTo>
                  <a:lnTo>
                    <a:pt x="645" y="2"/>
                  </a:lnTo>
                  <a:lnTo>
                    <a:pt x="646" y="2"/>
                  </a:lnTo>
                  <a:lnTo>
                    <a:pt x="646" y="3"/>
                  </a:lnTo>
                  <a:lnTo>
                    <a:pt x="647" y="3"/>
                  </a:lnTo>
                  <a:lnTo>
                    <a:pt x="648" y="2"/>
                  </a:lnTo>
                  <a:lnTo>
                    <a:pt x="649" y="3"/>
                  </a:lnTo>
                  <a:lnTo>
                    <a:pt x="650" y="3"/>
                  </a:lnTo>
                  <a:lnTo>
                    <a:pt x="651" y="3"/>
                  </a:lnTo>
                  <a:lnTo>
                    <a:pt x="652" y="3"/>
                  </a:lnTo>
                  <a:lnTo>
                    <a:pt x="653" y="3"/>
                  </a:lnTo>
                  <a:lnTo>
                    <a:pt x="654" y="2"/>
                  </a:lnTo>
                  <a:lnTo>
                    <a:pt x="654" y="3"/>
                  </a:lnTo>
                  <a:lnTo>
                    <a:pt x="655" y="3"/>
                  </a:lnTo>
                  <a:lnTo>
                    <a:pt x="656" y="3"/>
                  </a:lnTo>
                  <a:lnTo>
                    <a:pt x="657" y="2"/>
                  </a:lnTo>
                  <a:lnTo>
                    <a:pt x="658" y="2"/>
                  </a:lnTo>
                  <a:lnTo>
                    <a:pt x="659" y="2"/>
                  </a:lnTo>
                  <a:lnTo>
                    <a:pt x="660" y="2"/>
                  </a:lnTo>
                  <a:lnTo>
                    <a:pt x="661" y="2"/>
                  </a:lnTo>
                  <a:lnTo>
                    <a:pt x="661" y="3"/>
                  </a:lnTo>
                  <a:lnTo>
                    <a:pt x="662" y="3"/>
                  </a:lnTo>
                  <a:lnTo>
                    <a:pt x="663" y="5"/>
                  </a:lnTo>
                  <a:lnTo>
                    <a:pt x="664" y="5"/>
                  </a:lnTo>
                  <a:lnTo>
                    <a:pt x="665" y="5"/>
                  </a:lnTo>
                  <a:lnTo>
                    <a:pt x="666" y="6"/>
                  </a:lnTo>
                  <a:lnTo>
                    <a:pt x="667" y="6"/>
                  </a:lnTo>
                  <a:lnTo>
                    <a:pt x="668" y="5"/>
                  </a:lnTo>
                  <a:lnTo>
                    <a:pt x="669" y="5"/>
                  </a:lnTo>
                  <a:lnTo>
                    <a:pt x="669" y="5"/>
                  </a:lnTo>
                  <a:lnTo>
                    <a:pt x="670" y="4"/>
                  </a:lnTo>
                  <a:lnTo>
                    <a:pt x="671" y="3"/>
                  </a:lnTo>
                  <a:lnTo>
                    <a:pt x="672" y="3"/>
                  </a:lnTo>
                  <a:lnTo>
                    <a:pt x="673" y="3"/>
                  </a:lnTo>
                  <a:lnTo>
                    <a:pt x="674" y="3"/>
                  </a:lnTo>
                  <a:lnTo>
                    <a:pt x="675" y="2"/>
                  </a:lnTo>
                  <a:lnTo>
                    <a:pt x="676" y="2"/>
                  </a:lnTo>
                  <a:lnTo>
                    <a:pt x="676" y="2"/>
                  </a:lnTo>
                  <a:lnTo>
                    <a:pt x="677" y="2"/>
                  </a:lnTo>
                  <a:lnTo>
                    <a:pt x="678" y="1"/>
                  </a:lnTo>
                  <a:lnTo>
                    <a:pt x="679" y="2"/>
                  </a:lnTo>
                  <a:lnTo>
                    <a:pt x="680" y="2"/>
                  </a:lnTo>
                  <a:lnTo>
                    <a:pt x="681" y="2"/>
                  </a:lnTo>
                  <a:lnTo>
                    <a:pt x="682" y="2"/>
                  </a:lnTo>
                  <a:lnTo>
                    <a:pt x="683" y="2"/>
                  </a:lnTo>
                  <a:lnTo>
                    <a:pt x="684" y="1"/>
                  </a:lnTo>
                  <a:lnTo>
                    <a:pt x="684" y="1"/>
                  </a:lnTo>
                  <a:lnTo>
                    <a:pt x="685" y="2"/>
                  </a:lnTo>
                  <a:lnTo>
                    <a:pt x="686" y="2"/>
                  </a:lnTo>
                  <a:lnTo>
                    <a:pt x="687" y="2"/>
                  </a:lnTo>
                  <a:lnTo>
                    <a:pt x="688" y="2"/>
                  </a:lnTo>
                  <a:lnTo>
                    <a:pt x="689" y="3"/>
                  </a:lnTo>
                  <a:lnTo>
                    <a:pt x="690" y="3"/>
                  </a:lnTo>
                  <a:lnTo>
                    <a:pt x="691" y="3"/>
                  </a:lnTo>
                  <a:lnTo>
                    <a:pt x="691" y="4"/>
                  </a:lnTo>
                  <a:lnTo>
                    <a:pt x="692" y="5"/>
                  </a:lnTo>
                  <a:lnTo>
                    <a:pt x="693" y="6"/>
                  </a:lnTo>
                  <a:lnTo>
                    <a:pt x="694" y="6"/>
                  </a:lnTo>
                  <a:lnTo>
                    <a:pt x="695" y="6"/>
                  </a:lnTo>
                  <a:lnTo>
                    <a:pt x="696" y="7"/>
                  </a:lnTo>
                  <a:lnTo>
                    <a:pt x="697" y="7"/>
                  </a:lnTo>
                  <a:lnTo>
                    <a:pt x="698" y="7"/>
                  </a:lnTo>
                  <a:lnTo>
                    <a:pt x="699" y="6"/>
                  </a:lnTo>
                  <a:lnTo>
                    <a:pt x="699" y="6"/>
                  </a:lnTo>
                  <a:lnTo>
                    <a:pt x="700" y="5"/>
                  </a:lnTo>
                  <a:lnTo>
                    <a:pt x="701" y="5"/>
                  </a:lnTo>
                  <a:lnTo>
                    <a:pt x="702" y="5"/>
                  </a:lnTo>
                  <a:lnTo>
                    <a:pt x="703" y="5"/>
                  </a:lnTo>
                  <a:lnTo>
                    <a:pt x="704" y="3"/>
                  </a:lnTo>
                  <a:lnTo>
                    <a:pt x="705" y="3"/>
                  </a:lnTo>
                  <a:lnTo>
                    <a:pt x="706" y="3"/>
                  </a:lnTo>
                  <a:lnTo>
                    <a:pt x="706" y="3"/>
                  </a:lnTo>
                  <a:lnTo>
                    <a:pt x="707" y="4"/>
                  </a:lnTo>
                  <a:lnTo>
                    <a:pt x="708" y="3"/>
                  </a:lnTo>
                  <a:lnTo>
                    <a:pt x="709" y="3"/>
                  </a:lnTo>
                  <a:lnTo>
                    <a:pt x="710" y="4"/>
                  </a:lnTo>
                  <a:lnTo>
                    <a:pt x="711" y="4"/>
                  </a:lnTo>
                  <a:lnTo>
                    <a:pt x="712" y="4"/>
                  </a:lnTo>
                  <a:lnTo>
                    <a:pt x="713" y="4"/>
                  </a:lnTo>
                  <a:lnTo>
                    <a:pt x="714" y="5"/>
                  </a:lnTo>
                  <a:lnTo>
                    <a:pt x="714" y="3"/>
                  </a:lnTo>
                  <a:lnTo>
                    <a:pt x="715" y="3"/>
                  </a:lnTo>
                  <a:lnTo>
                    <a:pt x="716" y="3"/>
                  </a:lnTo>
                  <a:lnTo>
                    <a:pt x="717" y="2"/>
                  </a:lnTo>
                  <a:lnTo>
                    <a:pt x="718" y="3"/>
                  </a:lnTo>
                  <a:lnTo>
                    <a:pt x="719" y="2"/>
                  </a:lnTo>
                  <a:lnTo>
                    <a:pt x="720" y="2"/>
                  </a:lnTo>
                  <a:lnTo>
                    <a:pt x="721" y="3"/>
                  </a:lnTo>
                  <a:lnTo>
                    <a:pt x="721" y="3"/>
                  </a:lnTo>
                  <a:lnTo>
                    <a:pt x="722" y="3"/>
                  </a:lnTo>
                  <a:lnTo>
                    <a:pt x="723" y="4"/>
                  </a:lnTo>
                  <a:lnTo>
                    <a:pt x="724" y="3"/>
                  </a:lnTo>
                  <a:lnTo>
                    <a:pt x="725" y="5"/>
                  </a:lnTo>
                  <a:lnTo>
                    <a:pt x="726" y="4"/>
                  </a:lnTo>
                  <a:lnTo>
                    <a:pt x="727" y="4"/>
                  </a:lnTo>
                  <a:lnTo>
                    <a:pt x="728" y="4"/>
                  </a:lnTo>
                  <a:lnTo>
                    <a:pt x="729" y="4"/>
                  </a:lnTo>
                  <a:lnTo>
                    <a:pt x="729" y="3"/>
                  </a:lnTo>
                  <a:lnTo>
                    <a:pt x="730" y="3"/>
                  </a:lnTo>
                  <a:lnTo>
                    <a:pt x="731" y="3"/>
                  </a:lnTo>
                  <a:lnTo>
                    <a:pt x="732" y="3"/>
                  </a:lnTo>
                  <a:lnTo>
                    <a:pt x="733" y="3"/>
                  </a:lnTo>
                  <a:lnTo>
                    <a:pt x="734" y="3"/>
                  </a:lnTo>
                  <a:lnTo>
                    <a:pt x="735" y="3"/>
                  </a:lnTo>
                  <a:lnTo>
                    <a:pt x="736" y="3"/>
                  </a:lnTo>
                  <a:lnTo>
                    <a:pt x="736" y="3"/>
                  </a:lnTo>
                  <a:lnTo>
                    <a:pt x="737" y="3"/>
                  </a:lnTo>
                  <a:lnTo>
                    <a:pt x="738" y="3"/>
                  </a:lnTo>
                  <a:lnTo>
                    <a:pt x="739" y="3"/>
                  </a:lnTo>
                  <a:lnTo>
                    <a:pt x="740" y="3"/>
                  </a:lnTo>
                  <a:lnTo>
                    <a:pt x="741" y="3"/>
                  </a:lnTo>
                  <a:lnTo>
                    <a:pt x="742" y="3"/>
                  </a:lnTo>
                  <a:lnTo>
                    <a:pt x="743" y="3"/>
                  </a:lnTo>
                  <a:lnTo>
                    <a:pt x="744" y="3"/>
                  </a:lnTo>
                  <a:lnTo>
                    <a:pt x="744" y="2"/>
                  </a:lnTo>
                  <a:lnTo>
                    <a:pt x="745" y="3"/>
                  </a:lnTo>
                  <a:lnTo>
                    <a:pt x="746" y="2"/>
                  </a:lnTo>
                  <a:lnTo>
                    <a:pt x="747" y="3"/>
                  </a:lnTo>
                  <a:lnTo>
                    <a:pt x="748" y="3"/>
                  </a:lnTo>
                  <a:lnTo>
                    <a:pt x="749" y="2"/>
                  </a:lnTo>
                  <a:lnTo>
                    <a:pt x="750" y="2"/>
                  </a:lnTo>
                  <a:lnTo>
                    <a:pt x="751" y="2"/>
                  </a:lnTo>
                  <a:lnTo>
                    <a:pt x="751" y="2"/>
                  </a:lnTo>
                  <a:lnTo>
                    <a:pt x="752" y="2"/>
                  </a:lnTo>
                  <a:lnTo>
                    <a:pt x="753" y="2"/>
                  </a:lnTo>
                  <a:lnTo>
                    <a:pt x="754" y="2"/>
                  </a:lnTo>
                  <a:lnTo>
                    <a:pt x="755" y="3"/>
                  </a:lnTo>
                  <a:lnTo>
                    <a:pt x="756" y="3"/>
                  </a:lnTo>
                  <a:lnTo>
                    <a:pt x="757" y="3"/>
                  </a:lnTo>
                  <a:lnTo>
                    <a:pt x="758" y="2"/>
                  </a:lnTo>
                  <a:lnTo>
                    <a:pt x="759" y="3"/>
                  </a:lnTo>
                  <a:lnTo>
                    <a:pt x="759" y="3"/>
                  </a:lnTo>
                  <a:lnTo>
                    <a:pt x="760" y="3"/>
                  </a:lnTo>
                  <a:lnTo>
                    <a:pt x="761" y="3"/>
                  </a:lnTo>
                  <a:lnTo>
                    <a:pt x="762" y="3"/>
                  </a:lnTo>
                  <a:lnTo>
                    <a:pt x="763" y="3"/>
                  </a:lnTo>
                  <a:lnTo>
                    <a:pt x="764" y="3"/>
                  </a:lnTo>
                  <a:lnTo>
                    <a:pt x="765" y="2"/>
                  </a:lnTo>
                  <a:lnTo>
                    <a:pt x="766" y="3"/>
                  </a:lnTo>
                  <a:lnTo>
                    <a:pt x="766" y="3"/>
                  </a:lnTo>
                  <a:lnTo>
                    <a:pt x="767" y="2"/>
                  </a:lnTo>
                  <a:lnTo>
                    <a:pt x="768" y="3"/>
                  </a:lnTo>
                  <a:lnTo>
                    <a:pt x="769" y="3"/>
                  </a:lnTo>
                  <a:lnTo>
                    <a:pt x="770" y="3"/>
                  </a:lnTo>
                  <a:lnTo>
                    <a:pt x="771" y="4"/>
                  </a:lnTo>
                  <a:lnTo>
                    <a:pt x="772" y="3"/>
                  </a:lnTo>
                  <a:lnTo>
                    <a:pt x="773" y="4"/>
                  </a:lnTo>
                  <a:lnTo>
                    <a:pt x="773" y="3"/>
                  </a:lnTo>
                  <a:lnTo>
                    <a:pt x="774" y="3"/>
                  </a:lnTo>
                  <a:lnTo>
                    <a:pt x="775" y="4"/>
                  </a:lnTo>
                  <a:lnTo>
                    <a:pt x="776" y="2"/>
                  </a:lnTo>
                  <a:lnTo>
                    <a:pt x="777" y="3"/>
                  </a:lnTo>
                  <a:lnTo>
                    <a:pt x="778" y="3"/>
                  </a:lnTo>
                  <a:lnTo>
                    <a:pt x="779" y="3"/>
                  </a:lnTo>
                  <a:lnTo>
                    <a:pt x="780" y="3"/>
                  </a:lnTo>
                  <a:lnTo>
                    <a:pt x="781" y="3"/>
                  </a:lnTo>
                  <a:lnTo>
                    <a:pt x="781" y="2"/>
                  </a:lnTo>
                  <a:lnTo>
                    <a:pt x="782" y="2"/>
                  </a:lnTo>
                  <a:lnTo>
                    <a:pt x="783" y="3"/>
                  </a:lnTo>
                  <a:lnTo>
                    <a:pt x="784" y="3"/>
                  </a:lnTo>
                  <a:lnTo>
                    <a:pt x="785" y="3"/>
                  </a:lnTo>
                  <a:lnTo>
                    <a:pt x="786" y="3"/>
                  </a:lnTo>
                  <a:lnTo>
                    <a:pt x="787" y="4"/>
                  </a:lnTo>
                  <a:lnTo>
                    <a:pt x="788" y="4"/>
                  </a:lnTo>
                  <a:lnTo>
                    <a:pt x="788" y="3"/>
                  </a:lnTo>
                  <a:lnTo>
                    <a:pt x="789" y="4"/>
                  </a:lnTo>
                  <a:lnTo>
                    <a:pt x="790" y="4"/>
                  </a:lnTo>
                  <a:lnTo>
                    <a:pt x="791" y="4"/>
                  </a:lnTo>
                  <a:lnTo>
                    <a:pt x="792" y="3"/>
                  </a:lnTo>
                  <a:lnTo>
                    <a:pt x="793" y="3"/>
                  </a:lnTo>
                  <a:lnTo>
                    <a:pt x="794" y="3"/>
                  </a:lnTo>
                  <a:lnTo>
                    <a:pt x="795" y="3"/>
                  </a:lnTo>
                  <a:lnTo>
                    <a:pt x="796" y="2"/>
                  </a:lnTo>
                  <a:lnTo>
                    <a:pt x="796" y="2"/>
                  </a:lnTo>
                  <a:lnTo>
                    <a:pt x="797" y="2"/>
                  </a:lnTo>
                  <a:lnTo>
                    <a:pt x="798" y="3"/>
                  </a:lnTo>
                  <a:lnTo>
                    <a:pt x="799" y="3"/>
                  </a:lnTo>
                  <a:lnTo>
                    <a:pt x="800" y="2"/>
                  </a:lnTo>
                  <a:lnTo>
                    <a:pt x="801" y="2"/>
                  </a:lnTo>
                  <a:lnTo>
                    <a:pt x="802" y="2"/>
                  </a:lnTo>
                  <a:lnTo>
                    <a:pt x="803" y="2"/>
                  </a:lnTo>
                  <a:lnTo>
                    <a:pt x="803" y="2"/>
                  </a:lnTo>
                  <a:lnTo>
                    <a:pt x="804" y="2"/>
                  </a:lnTo>
                  <a:lnTo>
                    <a:pt x="805" y="2"/>
                  </a:lnTo>
                  <a:lnTo>
                    <a:pt x="806" y="2"/>
                  </a:lnTo>
                  <a:lnTo>
                    <a:pt x="807" y="2"/>
                  </a:lnTo>
                  <a:lnTo>
                    <a:pt x="808" y="2"/>
                  </a:lnTo>
                  <a:lnTo>
                    <a:pt x="809" y="2"/>
                  </a:lnTo>
                  <a:lnTo>
                    <a:pt x="810" y="2"/>
                  </a:lnTo>
                  <a:lnTo>
                    <a:pt x="811" y="2"/>
                  </a:lnTo>
                  <a:lnTo>
                    <a:pt x="811" y="2"/>
                  </a:lnTo>
                  <a:lnTo>
                    <a:pt x="812" y="2"/>
                  </a:lnTo>
                  <a:lnTo>
                    <a:pt x="813" y="2"/>
                  </a:lnTo>
                  <a:lnTo>
                    <a:pt x="814" y="3"/>
                  </a:lnTo>
                  <a:lnTo>
                    <a:pt x="815" y="2"/>
                  </a:lnTo>
                  <a:lnTo>
                    <a:pt x="816" y="2"/>
                  </a:lnTo>
                  <a:lnTo>
                    <a:pt x="817" y="2"/>
                  </a:lnTo>
                  <a:lnTo>
                    <a:pt x="818" y="2"/>
                  </a:lnTo>
                  <a:lnTo>
                    <a:pt x="818" y="2"/>
                  </a:lnTo>
                  <a:lnTo>
                    <a:pt x="819" y="2"/>
                  </a:lnTo>
                  <a:lnTo>
                    <a:pt x="820" y="3"/>
                  </a:lnTo>
                  <a:lnTo>
                    <a:pt x="821" y="2"/>
                  </a:lnTo>
                  <a:lnTo>
                    <a:pt x="822" y="2"/>
                  </a:lnTo>
                  <a:lnTo>
                    <a:pt x="823" y="2"/>
                  </a:lnTo>
                  <a:lnTo>
                    <a:pt x="824" y="2"/>
                  </a:lnTo>
                  <a:lnTo>
                    <a:pt x="825" y="2"/>
                  </a:lnTo>
                  <a:lnTo>
                    <a:pt x="826" y="2"/>
                  </a:lnTo>
                  <a:lnTo>
                    <a:pt x="826" y="2"/>
                  </a:lnTo>
                  <a:lnTo>
                    <a:pt x="827" y="3"/>
                  </a:lnTo>
                  <a:lnTo>
                    <a:pt x="828" y="3"/>
                  </a:lnTo>
                  <a:lnTo>
                    <a:pt x="829" y="3"/>
                  </a:lnTo>
                  <a:lnTo>
                    <a:pt x="830" y="3"/>
                  </a:lnTo>
                  <a:lnTo>
                    <a:pt x="831" y="3"/>
                  </a:lnTo>
                  <a:lnTo>
                    <a:pt x="832" y="3"/>
                  </a:lnTo>
                  <a:lnTo>
                    <a:pt x="833" y="3"/>
                  </a:lnTo>
                  <a:lnTo>
                    <a:pt x="833" y="3"/>
                  </a:lnTo>
                  <a:lnTo>
                    <a:pt x="834" y="3"/>
                  </a:lnTo>
                  <a:lnTo>
                    <a:pt x="835" y="3"/>
                  </a:lnTo>
                  <a:lnTo>
                    <a:pt x="836" y="3"/>
                  </a:lnTo>
                  <a:lnTo>
                    <a:pt x="837" y="4"/>
                  </a:lnTo>
                  <a:lnTo>
                    <a:pt x="838" y="4"/>
                  </a:lnTo>
                  <a:lnTo>
                    <a:pt x="839" y="4"/>
                  </a:lnTo>
                  <a:lnTo>
                    <a:pt x="840" y="4"/>
                  </a:lnTo>
                  <a:lnTo>
                    <a:pt x="841" y="5"/>
                  </a:lnTo>
                  <a:lnTo>
                    <a:pt x="841" y="4"/>
                  </a:lnTo>
                  <a:lnTo>
                    <a:pt x="842" y="5"/>
                  </a:lnTo>
                  <a:lnTo>
                    <a:pt x="843" y="5"/>
                  </a:lnTo>
                  <a:lnTo>
                    <a:pt x="844" y="4"/>
                  </a:lnTo>
                  <a:lnTo>
                    <a:pt x="845" y="3"/>
                  </a:lnTo>
                  <a:lnTo>
                    <a:pt x="846" y="3"/>
                  </a:lnTo>
                  <a:lnTo>
                    <a:pt x="847" y="4"/>
                  </a:lnTo>
                  <a:lnTo>
                    <a:pt x="848" y="3"/>
                  </a:lnTo>
                  <a:lnTo>
                    <a:pt x="848" y="3"/>
                  </a:lnTo>
                  <a:lnTo>
                    <a:pt x="849" y="4"/>
                  </a:lnTo>
                  <a:lnTo>
                    <a:pt x="850" y="3"/>
                  </a:lnTo>
                  <a:lnTo>
                    <a:pt x="851" y="3"/>
                  </a:lnTo>
                  <a:lnTo>
                    <a:pt x="852" y="3"/>
                  </a:lnTo>
                  <a:lnTo>
                    <a:pt x="853" y="3"/>
                  </a:lnTo>
                  <a:lnTo>
                    <a:pt x="854" y="3"/>
                  </a:lnTo>
                  <a:lnTo>
                    <a:pt x="855" y="3"/>
                  </a:lnTo>
                  <a:lnTo>
                    <a:pt x="856" y="3"/>
                  </a:lnTo>
                  <a:lnTo>
                    <a:pt x="856" y="3"/>
                  </a:lnTo>
                  <a:lnTo>
                    <a:pt x="857" y="3"/>
                  </a:lnTo>
                  <a:lnTo>
                    <a:pt x="858" y="3"/>
                  </a:lnTo>
                  <a:lnTo>
                    <a:pt x="859" y="3"/>
                  </a:lnTo>
                  <a:lnTo>
                    <a:pt x="860" y="3"/>
                  </a:lnTo>
                  <a:lnTo>
                    <a:pt x="861" y="3"/>
                  </a:lnTo>
                  <a:lnTo>
                    <a:pt x="862" y="2"/>
                  </a:lnTo>
                  <a:lnTo>
                    <a:pt x="863" y="2"/>
                  </a:lnTo>
                  <a:lnTo>
                    <a:pt x="863" y="3"/>
                  </a:lnTo>
                  <a:lnTo>
                    <a:pt x="864" y="3"/>
                  </a:lnTo>
                  <a:lnTo>
                    <a:pt x="865" y="3"/>
                  </a:lnTo>
                  <a:lnTo>
                    <a:pt x="866" y="5"/>
                  </a:lnTo>
                  <a:lnTo>
                    <a:pt x="867" y="6"/>
                  </a:lnTo>
                  <a:lnTo>
                    <a:pt x="868" y="7"/>
                  </a:lnTo>
                  <a:lnTo>
                    <a:pt x="869" y="12"/>
                  </a:lnTo>
                  <a:lnTo>
                    <a:pt x="870" y="13"/>
                  </a:lnTo>
                  <a:lnTo>
                    <a:pt x="871" y="15"/>
                  </a:lnTo>
                  <a:lnTo>
                    <a:pt x="871" y="17"/>
                  </a:lnTo>
                  <a:lnTo>
                    <a:pt x="872" y="20"/>
                  </a:lnTo>
                  <a:lnTo>
                    <a:pt x="873" y="20"/>
                  </a:lnTo>
                  <a:lnTo>
                    <a:pt x="874" y="21"/>
                  </a:lnTo>
                  <a:lnTo>
                    <a:pt x="875" y="20"/>
                  </a:lnTo>
                  <a:lnTo>
                    <a:pt x="876" y="19"/>
                  </a:lnTo>
                  <a:lnTo>
                    <a:pt x="877" y="17"/>
                  </a:lnTo>
                  <a:lnTo>
                    <a:pt x="878" y="14"/>
                  </a:lnTo>
                  <a:lnTo>
                    <a:pt x="878" y="11"/>
                  </a:lnTo>
                  <a:lnTo>
                    <a:pt x="879" y="10"/>
                  </a:lnTo>
                  <a:lnTo>
                    <a:pt x="880" y="8"/>
                  </a:lnTo>
                  <a:lnTo>
                    <a:pt x="881" y="7"/>
                  </a:lnTo>
                  <a:lnTo>
                    <a:pt x="882" y="7"/>
                  </a:lnTo>
                  <a:lnTo>
                    <a:pt x="883" y="5"/>
                  </a:lnTo>
                  <a:lnTo>
                    <a:pt x="884" y="5"/>
                  </a:lnTo>
                  <a:lnTo>
                    <a:pt x="885" y="5"/>
                  </a:lnTo>
                  <a:lnTo>
                    <a:pt x="886" y="5"/>
                  </a:lnTo>
                  <a:lnTo>
                    <a:pt x="886" y="4"/>
                  </a:lnTo>
                  <a:lnTo>
                    <a:pt x="887" y="4"/>
                  </a:lnTo>
                  <a:lnTo>
                    <a:pt x="888" y="4"/>
                  </a:lnTo>
                  <a:lnTo>
                    <a:pt x="889" y="4"/>
                  </a:lnTo>
                  <a:lnTo>
                    <a:pt x="890" y="5"/>
                  </a:lnTo>
                  <a:lnTo>
                    <a:pt x="891" y="5"/>
                  </a:lnTo>
                  <a:lnTo>
                    <a:pt x="892" y="4"/>
                  </a:lnTo>
                  <a:lnTo>
                    <a:pt x="893" y="4"/>
                  </a:lnTo>
                  <a:lnTo>
                    <a:pt x="893" y="4"/>
                  </a:lnTo>
                  <a:lnTo>
                    <a:pt x="894" y="4"/>
                  </a:lnTo>
                  <a:lnTo>
                    <a:pt x="895" y="4"/>
                  </a:lnTo>
                  <a:lnTo>
                    <a:pt x="896" y="3"/>
                  </a:lnTo>
                  <a:lnTo>
                    <a:pt x="897" y="3"/>
                  </a:lnTo>
                  <a:lnTo>
                    <a:pt x="898" y="4"/>
                  </a:lnTo>
                  <a:lnTo>
                    <a:pt x="899" y="3"/>
                  </a:lnTo>
                  <a:lnTo>
                    <a:pt x="900" y="3"/>
                  </a:lnTo>
                  <a:lnTo>
                    <a:pt x="901" y="3"/>
                  </a:lnTo>
                  <a:lnTo>
                    <a:pt x="901" y="5"/>
                  </a:lnTo>
                  <a:lnTo>
                    <a:pt x="902" y="5"/>
                  </a:lnTo>
                  <a:lnTo>
                    <a:pt x="903" y="7"/>
                  </a:lnTo>
                  <a:lnTo>
                    <a:pt x="904" y="7"/>
                  </a:lnTo>
                  <a:lnTo>
                    <a:pt x="905" y="8"/>
                  </a:lnTo>
                  <a:lnTo>
                    <a:pt x="906" y="9"/>
                  </a:lnTo>
                  <a:lnTo>
                    <a:pt x="907" y="8"/>
                  </a:lnTo>
                  <a:lnTo>
                    <a:pt x="908" y="8"/>
                  </a:lnTo>
                  <a:lnTo>
                    <a:pt x="908" y="8"/>
                  </a:lnTo>
                  <a:lnTo>
                    <a:pt x="909" y="7"/>
                  </a:lnTo>
                  <a:lnTo>
                    <a:pt x="910" y="6"/>
                  </a:lnTo>
                  <a:lnTo>
                    <a:pt x="911" y="6"/>
                  </a:lnTo>
                  <a:lnTo>
                    <a:pt x="912" y="5"/>
                  </a:lnTo>
                  <a:lnTo>
                    <a:pt x="913" y="4"/>
                  </a:lnTo>
                  <a:lnTo>
                    <a:pt x="914" y="4"/>
                  </a:lnTo>
                  <a:lnTo>
                    <a:pt x="915" y="4"/>
                  </a:lnTo>
                  <a:lnTo>
                    <a:pt x="916" y="3"/>
                  </a:lnTo>
                  <a:lnTo>
                    <a:pt x="916" y="3"/>
                  </a:lnTo>
                  <a:lnTo>
                    <a:pt x="917" y="3"/>
                  </a:lnTo>
                  <a:lnTo>
                    <a:pt x="918" y="3"/>
                  </a:lnTo>
                  <a:lnTo>
                    <a:pt x="919" y="2"/>
                  </a:lnTo>
                  <a:lnTo>
                    <a:pt x="920" y="2"/>
                  </a:lnTo>
                  <a:lnTo>
                    <a:pt x="921" y="2"/>
                  </a:lnTo>
                  <a:lnTo>
                    <a:pt x="922" y="2"/>
                  </a:lnTo>
                  <a:lnTo>
                    <a:pt x="923" y="2"/>
                  </a:lnTo>
                  <a:lnTo>
                    <a:pt x="923" y="2"/>
                  </a:lnTo>
                  <a:lnTo>
                    <a:pt x="924" y="2"/>
                  </a:lnTo>
                  <a:lnTo>
                    <a:pt x="925" y="2"/>
                  </a:lnTo>
                  <a:lnTo>
                    <a:pt x="926" y="2"/>
                  </a:lnTo>
                  <a:lnTo>
                    <a:pt x="927" y="1"/>
                  </a:lnTo>
                  <a:lnTo>
                    <a:pt x="928" y="2"/>
                  </a:lnTo>
                  <a:lnTo>
                    <a:pt x="929" y="2"/>
                  </a:lnTo>
                  <a:lnTo>
                    <a:pt x="930" y="2"/>
                  </a:lnTo>
                  <a:lnTo>
                    <a:pt x="931" y="2"/>
                  </a:lnTo>
                  <a:lnTo>
                    <a:pt x="931" y="1"/>
                  </a:lnTo>
                  <a:lnTo>
                    <a:pt x="932" y="2"/>
                  </a:lnTo>
                  <a:lnTo>
                    <a:pt x="933" y="2"/>
                  </a:lnTo>
                  <a:lnTo>
                    <a:pt x="934" y="2"/>
                  </a:lnTo>
                  <a:lnTo>
                    <a:pt x="935" y="2"/>
                  </a:lnTo>
                  <a:lnTo>
                    <a:pt x="936" y="2"/>
                  </a:lnTo>
                  <a:lnTo>
                    <a:pt x="937" y="2"/>
                  </a:lnTo>
                  <a:lnTo>
                    <a:pt x="938" y="2"/>
                  </a:lnTo>
                  <a:lnTo>
                    <a:pt x="938" y="2"/>
                  </a:lnTo>
                  <a:lnTo>
                    <a:pt x="939" y="2"/>
                  </a:lnTo>
                  <a:lnTo>
                    <a:pt x="940" y="2"/>
                  </a:lnTo>
                  <a:lnTo>
                    <a:pt x="941" y="2"/>
                  </a:lnTo>
                  <a:lnTo>
                    <a:pt x="942" y="2"/>
                  </a:lnTo>
                  <a:lnTo>
                    <a:pt x="943" y="2"/>
                  </a:lnTo>
                  <a:lnTo>
                    <a:pt x="944" y="3"/>
                  </a:lnTo>
                  <a:lnTo>
                    <a:pt x="945" y="3"/>
                  </a:lnTo>
                  <a:lnTo>
                    <a:pt x="946" y="3"/>
                  </a:lnTo>
                  <a:lnTo>
                    <a:pt x="946" y="3"/>
                  </a:lnTo>
                  <a:lnTo>
                    <a:pt x="947" y="3"/>
                  </a:lnTo>
                  <a:lnTo>
                    <a:pt x="948" y="3"/>
                  </a:lnTo>
                  <a:lnTo>
                    <a:pt x="949" y="3"/>
                  </a:lnTo>
                  <a:lnTo>
                    <a:pt x="950" y="4"/>
                  </a:lnTo>
                  <a:lnTo>
                    <a:pt x="951" y="3"/>
                  </a:lnTo>
                  <a:lnTo>
                    <a:pt x="952" y="3"/>
                  </a:lnTo>
                  <a:lnTo>
                    <a:pt x="953" y="3"/>
                  </a:lnTo>
                  <a:lnTo>
                    <a:pt x="953" y="3"/>
                  </a:lnTo>
                  <a:lnTo>
                    <a:pt x="954" y="3"/>
                  </a:lnTo>
                  <a:lnTo>
                    <a:pt x="955" y="3"/>
                  </a:lnTo>
                  <a:lnTo>
                    <a:pt x="956" y="3"/>
                  </a:lnTo>
                  <a:lnTo>
                    <a:pt x="957" y="2"/>
                  </a:lnTo>
                  <a:lnTo>
                    <a:pt x="958" y="3"/>
                  </a:lnTo>
                  <a:lnTo>
                    <a:pt x="959" y="3"/>
                  </a:lnTo>
                  <a:lnTo>
                    <a:pt x="960" y="2"/>
                  </a:lnTo>
                  <a:lnTo>
                    <a:pt x="960" y="2"/>
                  </a:lnTo>
                  <a:lnTo>
                    <a:pt x="961" y="2"/>
                  </a:lnTo>
                  <a:lnTo>
                    <a:pt x="962" y="2"/>
                  </a:lnTo>
                  <a:lnTo>
                    <a:pt x="963" y="3"/>
                  </a:lnTo>
                  <a:lnTo>
                    <a:pt x="964" y="2"/>
                  </a:lnTo>
                  <a:lnTo>
                    <a:pt x="965" y="2"/>
                  </a:lnTo>
                  <a:lnTo>
                    <a:pt x="966" y="3"/>
                  </a:lnTo>
                  <a:lnTo>
                    <a:pt x="967" y="2"/>
                  </a:lnTo>
                  <a:lnTo>
                    <a:pt x="968" y="2"/>
                  </a:lnTo>
                  <a:lnTo>
                    <a:pt x="968" y="2"/>
                  </a:lnTo>
                  <a:lnTo>
                    <a:pt x="969" y="2"/>
                  </a:lnTo>
                  <a:lnTo>
                    <a:pt x="970" y="2"/>
                  </a:lnTo>
                  <a:lnTo>
                    <a:pt x="971" y="3"/>
                  </a:lnTo>
                  <a:lnTo>
                    <a:pt x="972" y="2"/>
                  </a:lnTo>
                  <a:lnTo>
                    <a:pt x="973" y="2"/>
                  </a:lnTo>
                  <a:lnTo>
                    <a:pt x="974" y="2"/>
                  </a:lnTo>
                  <a:lnTo>
                    <a:pt x="975" y="2"/>
                  </a:lnTo>
                  <a:lnTo>
                    <a:pt x="975" y="2"/>
                  </a:lnTo>
                  <a:lnTo>
                    <a:pt x="976" y="2"/>
                  </a:lnTo>
                  <a:lnTo>
                    <a:pt x="977" y="1"/>
                  </a:lnTo>
                  <a:lnTo>
                    <a:pt x="978" y="1"/>
                  </a:lnTo>
                  <a:lnTo>
                    <a:pt x="979" y="2"/>
                  </a:lnTo>
                  <a:lnTo>
                    <a:pt x="980" y="2"/>
                  </a:lnTo>
                  <a:lnTo>
                    <a:pt x="981" y="2"/>
                  </a:lnTo>
                  <a:lnTo>
                    <a:pt x="982" y="2"/>
                  </a:lnTo>
                  <a:lnTo>
                    <a:pt x="983" y="2"/>
                  </a:lnTo>
                  <a:lnTo>
                    <a:pt x="983" y="2"/>
                  </a:lnTo>
                  <a:lnTo>
                    <a:pt x="984" y="1"/>
                  </a:lnTo>
                  <a:lnTo>
                    <a:pt x="985" y="2"/>
                  </a:lnTo>
                  <a:lnTo>
                    <a:pt x="986" y="2"/>
                  </a:lnTo>
                  <a:lnTo>
                    <a:pt x="987" y="2"/>
                  </a:lnTo>
                  <a:lnTo>
                    <a:pt x="988" y="2"/>
                  </a:lnTo>
                  <a:lnTo>
                    <a:pt x="989" y="1"/>
                  </a:lnTo>
                  <a:lnTo>
                    <a:pt x="990" y="2"/>
                  </a:lnTo>
                  <a:lnTo>
                    <a:pt x="990" y="2"/>
                  </a:lnTo>
                  <a:lnTo>
                    <a:pt x="991" y="2"/>
                  </a:lnTo>
                  <a:lnTo>
                    <a:pt x="992" y="2"/>
                  </a:lnTo>
                  <a:lnTo>
                    <a:pt x="993" y="1"/>
                  </a:lnTo>
                  <a:lnTo>
                    <a:pt x="994" y="3"/>
                  </a:lnTo>
                  <a:lnTo>
                    <a:pt x="995" y="3"/>
                  </a:lnTo>
                  <a:lnTo>
                    <a:pt x="996" y="2"/>
                  </a:lnTo>
                  <a:lnTo>
                    <a:pt x="997" y="2"/>
                  </a:lnTo>
                  <a:lnTo>
                    <a:pt x="998" y="3"/>
                  </a:lnTo>
                  <a:lnTo>
                    <a:pt x="998" y="3"/>
                  </a:lnTo>
                  <a:lnTo>
                    <a:pt x="999" y="3"/>
                  </a:lnTo>
                  <a:lnTo>
                    <a:pt x="1000" y="3"/>
                  </a:lnTo>
                  <a:lnTo>
                    <a:pt x="1001" y="4"/>
                  </a:lnTo>
                  <a:lnTo>
                    <a:pt x="1002" y="4"/>
                  </a:lnTo>
                  <a:lnTo>
                    <a:pt x="1003" y="3"/>
                  </a:lnTo>
                  <a:lnTo>
                    <a:pt x="1004" y="3"/>
                  </a:lnTo>
                  <a:lnTo>
                    <a:pt x="1005" y="3"/>
                  </a:lnTo>
                  <a:lnTo>
                    <a:pt x="1005" y="3"/>
                  </a:lnTo>
                  <a:lnTo>
                    <a:pt x="1006" y="2"/>
                  </a:lnTo>
                  <a:lnTo>
                    <a:pt x="1007" y="3"/>
                  </a:lnTo>
                  <a:lnTo>
                    <a:pt x="1008" y="2"/>
                  </a:lnTo>
                  <a:lnTo>
                    <a:pt x="1009" y="2"/>
                  </a:lnTo>
                  <a:lnTo>
                    <a:pt x="1010" y="2"/>
                  </a:lnTo>
                  <a:lnTo>
                    <a:pt x="1011" y="2"/>
                  </a:lnTo>
                  <a:lnTo>
                    <a:pt x="1012" y="2"/>
                  </a:lnTo>
                  <a:lnTo>
                    <a:pt x="1013" y="2"/>
                  </a:lnTo>
                  <a:lnTo>
                    <a:pt x="1013" y="2"/>
                  </a:lnTo>
                  <a:lnTo>
                    <a:pt x="1014" y="2"/>
                  </a:lnTo>
                  <a:lnTo>
                    <a:pt x="1015" y="2"/>
                  </a:lnTo>
                  <a:lnTo>
                    <a:pt x="1016" y="2"/>
                  </a:lnTo>
                  <a:lnTo>
                    <a:pt x="1017" y="2"/>
                  </a:lnTo>
                  <a:lnTo>
                    <a:pt x="1018" y="2"/>
                  </a:lnTo>
                  <a:lnTo>
                    <a:pt x="1019" y="2"/>
                  </a:lnTo>
                  <a:lnTo>
                    <a:pt x="1020" y="2"/>
                  </a:lnTo>
                  <a:lnTo>
                    <a:pt x="1020" y="2"/>
                  </a:lnTo>
                  <a:lnTo>
                    <a:pt x="1021" y="3"/>
                  </a:lnTo>
                  <a:lnTo>
                    <a:pt x="1022" y="2"/>
                  </a:lnTo>
                  <a:lnTo>
                    <a:pt x="1023" y="3"/>
                  </a:lnTo>
                  <a:lnTo>
                    <a:pt x="1024" y="3"/>
                  </a:lnTo>
                  <a:lnTo>
                    <a:pt x="1025" y="3"/>
                  </a:lnTo>
                  <a:lnTo>
                    <a:pt x="1026" y="2"/>
                  </a:lnTo>
                  <a:lnTo>
                    <a:pt x="1027" y="3"/>
                  </a:lnTo>
                  <a:lnTo>
                    <a:pt x="1028" y="2"/>
                  </a:lnTo>
                  <a:lnTo>
                    <a:pt x="1028" y="2"/>
                  </a:lnTo>
                  <a:lnTo>
                    <a:pt x="1029" y="3"/>
                  </a:lnTo>
                  <a:lnTo>
                    <a:pt x="1030" y="3"/>
                  </a:lnTo>
                  <a:lnTo>
                    <a:pt x="1031" y="2"/>
                  </a:lnTo>
                  <a:lnTo>
                    <a:pt x="1032" y="2"/>
                  </a:lnTo>
                  <a:lnTo>
                    <a:pt x="1033" y="3"/>
                  </a:lnTo>
                  <a:lnTo>
                    <a:pt x="1034" y="2"/>
                  </a:lnTo>
                  <a:lnTo>
                    <a:pt x="1035" y="2"/>
                  </a:lnTo>
                  <a:lnTo>
                    <a:pt x="1035" y="2"/>
                  </a:lnTo>
                  <a:lnTo>
                    <a:pt x="1036" y="2"/>
                  </a:lnTo>
                  <a:lnTo>
                    <a:pt x="1037" y="2"/>
                  </a:lnTo>
                  <a:lnTo>
                    <a:pt x="1038" y="2"/>
                  </a:lnTo>
                  <a:lnTo>
                    <a:pt x="1039" y="2"/>
                  </a:lnTo>
                  <a:lnTo>
                    <a:pt x="1040" y="2"/>
                  </a:lnTo>
                  <a:lnTo>
                    <a:pt x="1041" y="2"/>
                  </a:lnTo>
                  <a:lnTo>
                    <a:pt x="1042" y="1"/>
                  </a:lnTo>
                  <a:lnTo>
                    <a:pt x="1043" y="2"/>
                  </a:lnTo>
                  <a:lnTo>
                    <a:pt x="1043" y="2"/>
                  </a:lnTo>
                  <a:lnTo>
                    <a:pt x="1044" y="1"/>
                  </a:lnTo>
                  <a:lnTo>
                    <a:pt x="1045" y="1"/>
                  </a:lnTo>
                  <a:lnTo>
                    <a:pt x="1046" y="2"/>
                  </a:lnTo>
                  <a:lnTo>
                    <a:pt x="1047" y="1"/>
                  </a:lnTo>
                  <a:lnTo>
                    <a:pt x="1048" y="1"/>
                  </a:lnTo>
                  <a:lnTo>
                    <a:pt x="1049" y="2"/>
                  </a:lnTo>
                  <a:lnTo>
                    <a:pt x="1050" y="1"/>
                  </a:lnTo>
                  <a:lnTo>
                    <a:pt x="1050" y="2"/>
                  </a:lnTo>
                  <a:lnTo>
                    <a:pt x="1051" y="3"/>
                  </a:lnTo>
                  <a:lnTo>
                    <a:pt x="1052" y="2"/>
                  </a:lnTo>
                  <a:lnTo>
                    <a:pt x="1053" y="1"/>
                  </a:lnTo>
                  <a:lnTo>
                    <a:pt x="1054" y="2"/>
                  </a:lnTo>
                  <a:lnTo>
                    <a:pt x="1055" y="2"/>
                  </a:lnTo>
                  <a:lnTo>
                    <a:pt x="1056" y="2"/>
                  </a:lnTo>
                  <a:lnTo>
                    <a:pt x="1057" y="2"/>
                  </a:lnTo>
                  <a:lnTo>
                    <a:pt x="1058" y="2"/>
                  </a:lnTo>
                  <a:lnTo>
                    <a:pt x="1058" y="2"/>
                  </a:lnTo>
                  <a:lnTo>
                    <a:pt x="1059" y="2"/>
                  </a:lnTo>
                  <a:lnTo>
                    <a:pt x="1060" y="1"/>
                  </a:lnTo>
                  <a:lnTo>
                    <a:pt x="1061" y="2"/>
                  </a:lnTo>
                  <a:lnTo>
                    <a:pt x="1062" y="2"/>
                  </a:lnTo>
                  <a:lnTo>
                    <a:pt x="1063" y="1"/>
                  </a:lnTo>
                  <a:lnTo>
                    <a:pt x="1064" y="2"/>
                  </a:lnTo>
                  <a:lnTo>
                    <a:pt x="1065" y="1"/>
                  </a:lnTo>
                  <a:lnTo>
                    <a:pt x="1065" y="1"/>
                  </a:lnTo>
                  <a:lnTo>
                    <a:pt x="1066" y="1"/>
                  </a:lnTo>
                  <a:lnTo>
                    <a:pt x="1067" y="2"/>
                  </a:lnTo>
                  <a:lnTo>
                    <a:pt x="1068" y="2"/>
                  </a:lnTo>
                  <a:lnTo>
                    <a:pt x="1069" y="1"/>
                  </a:lnTo>
                  <a:lnTo>
                    <a:pt x="1070" y="2"/>
                  </a:lnTo>
                  <a:lnTo>
                    <a:pt x="1071" y="2"/>
                  </a:lnTo>
                  <a:lnTo>
                    <a:pt x="1072" y="2"/>
                  </a:lnTo>
                  <a:lnTo>
                    <a:pt x="1073" y="2"/>
                  </a:lnTo>
                  <a:lnTo>
                    <a:pt x="1073" y="2"/>
                  </a:lnTo>
                  <a:lnTo>
                    <a:pt x="1074" y="1"/>
                  </a:lnTo>
                  <a:lnTo>
                    <a:pt x="1075" y="2"/>
                  </a:lnTo>
                  <a:lnTo>
                    <a:pt x="1076" y="2"/>
                  </a:lnTo>
                  <a:lnTo>
                    <a:pt x="1077" y="1"/>
                  </a:lnTo>
                  <a:lnTo>
                    <a:pt x="1078" y="2"/>
                  </a:lnTo>
                  <a:lnTo>
                    <a:pt x="1079" y="2"/>
                  </a:lnTo>
                  <a:lnTo>
                    <a:pt x="1080" y="2"/>
                  </a:lnTo>
                  <a:lnTo>
                    <a:pt x="1080" y="2"/>
                  </a:lnTo>
                  <a:lnTo>
                    <a:pt x="1081" y="3"/>
                  </a:lnTo>
                  <a:lnTo>
                    <a:pt x="1082" y="3"/>
                  </a:lnTo>
                  <a:lnTo>
                    <a:pt x="1083" y="3"/>
                  </a:lnTo>
                  <a:lnTo>
                    <a:pt x="1084" y="3"/>
                  </a:lnTo>
                  <a:lnTo>
                    <a:pt x="1085" y="4"/>
                  </a:lnTo>
                  <a:lnTo>
                    <a:pt x="1086" y="3"/>
                  </a:lnTo>
                  <a:lnTo>
                    <a:pt x="1087" y="5"/>
                  </a:lnTo>
                  <a:lnTo>
                    <a:pt x="1088" y="5"/>
                  </a:lnTo>
                  <a:lnTo>
                    <a:pt x="1088" y="6"/>
                  </a:lnTo>
                  <a:lnTo>
                    <a:pt x="1089" y="5"/>
                  </a:lnTo>
                  <a:lnTo>
                    <a:pt x="1090" y="6"/>
                  </a:lnTo>
                  <a:lnTo>
                    <a:pt x="1091" y="5"/>
                  </a:lnTo>
                  <a:lnTo>
                    <a:pt x="1092" y="7"/>
                  </a:lnTo>
                  <a:lnTo>
                    <a:pt x="1093" y="6"/>
                  </a:lnTo>
                  <a:lnTo>
                    <a:pt x="1094" y="8"/>
                  </a:lnTo>
                  <a:lnTo>
                    <a:pt x="1095" y="7"/>
                  </a:lnTo>
                  <a:lnTo>
                    <a:pt x="1095" y="7"/>
                  </a:lnTo>
                  <a:lnTo>
                    <a:pt x="1096" y="6"/>
                  </a:lnTo>
                  <a:lnTo>
                    <a:pt x="1097" y="5"/>
                  </a:lnTo>
                  <a:lnTo>
                    <a:pt x="1098" y="5"/>
                  </a:lnTo>
                  <a:lnTo>
                    <a:pt x="1099" y="6"/>
                  </a:lnTo>
                  <a:lnTo>
                    <a:pt x="1100" y="5"/>
                  </a:lnTo>
                  <a:lnTo>
                    <a:pt x="1101" y="5"/>
                  </a:lnTo>
                  <a:lnTo>
                    <a:pt x="1102" y="5"/>
                  </a:lnTo>
                  <a:lnTo>
                    <a:pt x="1103" y="5"/>
                  </a:lnTo>
                  <a:lnTo>
                    <a:pt x="1103" y="6"/>
                  </a:lnTo>
                  <a:lnTo>
                    <a:pt x="1104" y="4"/>
                  </a:lnTo>
                  <a:lnTo>
                    <a:pt x="1105" y="5"/>
                  </a:lnTo>
                  <a:lnTo>
                    <a:pt x="1106" y="4"/>
                  </a:lnTo>
                  <a:lnTo>
                    <a:pt x="1107" y="4"/>
                  </a:lnTo>
                  <a:lnTo>
                    <a:pt x="1108" y="5"/>
                  </a:lnTo>
                  <a:lnTo>
                    <a:pt x="1109" y="4"/>
                  </a:lnTo>
                  <a:lnTo>
                    <a:pt x="1110" y="4"/>
                  </a:lnTo>
                  <a:lnTo>
                    <a:pt x="1110" y="4"/>
                  </a:lnTo>
                  <a:lnTo>
                    <a:pt x="1111" y="4"/>
                  </a:lnTo>
                  <a:lnTo>
                    <a:pt x="1112" y="4"/>
                  </a:lnTo>
                  <a:lnTo>
                    <a:pt x="1113" y="4"/>
                  </a:lnTo>
                  <a:lnTo>
                    <a:pt x="1114" y="4"/>
                  </a:lnTo>
                  <a:lnTo>
                    <a:pt x="1115" y="4"/>
                  </a:lnTo>
                  <a:lnTo>
                    <a:pt x="1116" y="3"/>
                  </a:lnTo>
                  <a:lnTo>
                    <a:pt x="1117" y="4"/>
                  </a:lnTo>
                  <a:lnTo>
                    <a:pt x="1118" y="4"/>
                  </a:lnTo>
                  <a:lnTo>
                    <a:pt x="1118" y="4"/>
                  </a:lnTo>
                  <a:lnTo>
                    <a:pt x="1119" y="5"/>
                  </a:lnTo>
                  <a:lnTo>
                    <a:pt x="1120" y="6"/>
                  </a:lnTo>
                  <a:lnTo>
                    <a:pt x="1121" y="7"/>
                  </a:lnTo>
                  <a:lnTo>
                    <a:pt x="1122" y="7"/>
                  </a:lnTo>
                  <a:lnTo>
                    <a:pt x="1123" y="7"/>
                  </a:lnTo>
                  <a:lnTo>
                    <a:pt x="1124" y="6"/>
                  </a:lnTo>
                  <a:lnTo>
                    <a:pt x="1125" y="6"/>
                  </a:lnTo>
                  <a:lnTo>
                    <a:pt x="1125" y="5"/>
                  </a:lnTo>
                  <a:lnTo>
                    <a:pt x="1126" y="5"/>
                  </a:lnTo>
                  <a:lnTo>
                    <a:pt x="1127" y="5"/>
                  </a:lnTo>
                  <a:lnTo>
                    <a:pt x="1128" y="4"/>
                  </a:lnTo>
                  <a:lnTo>
                    <a:pt x="1129" y="4"/>
                  </a:lnTo>
                  <a:lnTo>
                    <a:pt x="1130" y="5"/>
                  </a:lnTo>
                  <a:lnTo>
                    <a:pt x="1131" y="6"/>
                  </a:lnTo>
                  <a:lnTo>
                    <a:pt x="1132" y="8"/>
                  </a:lnTo>
                  <a:lnTo>
                    <a:pt x="1133" y="10"/>
                  </a:lnTo>
                  <a:lnTo>
                    <a:pt x="1133" y="12"/>
                  </a:lnTo>
                  <a:lnTo>
                    <a:pt x="1134" y="12"/>
                  </a:lnTo>
                  <a:lnTo>
                    <a:pt x="1135" y="14"/>
                  </a:lnTo>
                  <a:lnTo>
                    <a:pt x="1136" y="17"/>
                  </a:lnTo>
                  <a:lnTo>
                    <a:pt x="1137" y="17"/>
                  </a:lnTo>
                  <a:lnTo>
                    <a:pt x="1138" y="15"/>
                  </a:lnTo>
                  <a:lnTo>
                    <a:pt x="1139" y="15"/>
                  </a:lnTo>
                  <a:lnTo>
                    <a:pt x="1140" y="15"/>
                  </a:lnTo>
                  <a:lnTo>
                    <a:pt x="1140" y="14"/>
                  </a:lnTo>
                  <a:lnTo>
                    <a:pt x="1141" y="14"/>
                  </a:lnTo>
                  <a:lnTo>
                    <a:pt x="1142" y="14"/>
                  </a:lnTo>
                  <a:lnTo>
                    <a:pt x="1143" y="13"/>
                  </a:lnTo>
                  <a:lnTo>
                    <a:pt x="1144" y="13"/>
                  </a:lnTo>
                  <a:lnTo>
                    <a:pt x="1145" y="12"/>
                  </a:lnTo>
                  <a:lnTo>
                    <a:pt x="1146" y="11"/>
                  </a:lnTo>
                  <a:lnTo>
                    <a:pt x="1147" y="10"/>
                  </a:lnTo>
                  <a:lnTo>
                    <a:pt x="1148" y="10"/>
                  </a:lnTo>
                  <a:lnTo>
                    <a:pt x="1148" y="8"/>
                  </a:lnTo>
                  <a:lnTo>
                    <a:pt x="1149" y="7"/>
                  </a:lnTo>
                  <a:lnTo>
                    <a:pt x="1150" y="7"/>
                  </a:lnTo>
                  <a:lnTo>
                    <a:pt x="1151" y="7"/>
                  </a:lnTo>
                  <a:lnTo>
                    <a:pt x="1152" y="7"/>
                  </a:lnTo>
                  <a:lnTo>
                    <a:pt x="1153" y="5"/>
                  </a:lnTo>
                  <a:lnTo>
                    <a:pt x="1154" y="5"/>
                  </a:lnTo>
                  <a:lnTo>
                    <a:pt x="1155" y="4"/>
                  </a:lnTo>
                  <a:lnTo>
                    <a:pt x="1155" y="5"/>
                  </a:lnTo>
                  <a:lnTo>
                    <a:pt x="1156" y="5"/>
                  </a:lnTo>
                  <a:lnTo>
                    <a:pt x="1157" y="4"/>
                  </a:lnTo>
                  <a:lnTo>
                    <a:pt x="1158" y="4"/>
                  </a:lnTo>
                  <a:lnTo>
                    <a:pt x="1159" y="4"/>
                  </a:lnTo>
                  <a:lnTo>
                    <a:pt x="1160" y="3"/>
                  </a:lnTo>
                  <a:lnTo>
                    <a:pt x="1161" y="3"/>
                  </a:lnTo>
                  <a:lnTo>
                    <a:pt x="1162" y="3"/>
                  </a:lnTo>
                  <a:lnTo>
                    <a:pt x="1162" y="4"/>
                  </a:lnTo>
                  <a:lnTo>
                    <a:pt x="1163" y="5"/>
                  </a:lnTo>
                  <a:lnTo>
                    <a:pt x="1164" y="4"/>
                  </a:lnTo>
                  <a:lnTo>
                    <a:pt x="1165" y="5"/>
                  </a:lnTo>
                  <a:lnTo>
                    <a:pt x="1166" y="7"/>
                  </a:lnTo>
                  <a:lnTo>
                    <a:pt x="1167" y="7"/>
                  </a:lnTo>
                  <a:lnTo>
                    <a:pt x="1168" y="8"/>
                  </a:lnTo>
                  <a:lnTo>
                    <a:pt x="1169" y="8"/>
                  </a:lnTo>
                  <a:lnTo>
                    <a:pt x="1170" y="8"/>
                  </a:lnTo>
                  <a:lnTo>
                    <a:pt x="1170" y="7"/>
                  </a:lnTo>
                  <a:lnTo>
                    <a:pt x="1171" y="6"/>
                  </a:lnTo>
                  <a:lnTo>
                    <a:pt x="1172" y="6"/>
                  </a:lnTo>
                  <a:lnTo>
                    <a:pt x="1173" y="5"/>
                  </a:lnTo>
                  <a:lnTo>
                    <a:pt x="1174" y="5"/>
                  </a:lnTo>
                  <a:lnTo>
                    <a:pt x="1175" y="3"/>
                  </a:lnTo>
                  <a:lnTo>
                    <a:pt x="1176" y="3"/>
                  </a:lnTo>
                  <a:lnTo>
                    <a:pt x="1177" y="3"/>
                  </a:lnTo>
                  <a:lnTo>
                    <a:pt x="1177" y="2"/>
                  </a:lnTo>
                  <a:lnTo>
                    <a:pt x="1178" y="2"/>
                  </a:lnTo>
                  <a:lnTo>
                    <a:pt x="1179" y="2"/>
                  </a:lnTo>
                  <a:lnTo>
                    <a:pt x="1180" y="2"/>
                  </a:lnTo>
                  <a:lnTo>
                    <a:pt x="1181" y="2"/>
                  </a:lnTo>
                  <a:lnTo>
                    <a:pt x="1182" y="2"/>
                  </a:lnTo>
                  <a:lnTo>
                    <a:pt x="1183" y="2"/>
                  </a:lnTo>
                  <a:lnTo>
                    <a:pt x="1184" y="2"/>
                  </a:lnTo>
                  <a:lnTo>
                    <a:pt x="1185" y="1"/>
                  </a:lnTo>
                  <a:lnTo>
                    <a:pt x="1185" y="2"/>
                  </a:lnTo>
                  <a:lnTo>
                    <a:pt x="1186" y="1"/>
                  </a:lnTo>
                  <a:lnTo>
                    <a:pt x="1187" y="2"/>
                  </a:lnTo>
                  <a:lnTo>
                    <a:pt x="1188" y="1"/>
                  </a:lnTo>
                  <a:lnTo>
                    <a:pt x="1189" y="2"/>
                  </a:lnTo>
                  <a:lnTo>
                    <a:pt x="1190" y="2"/>
                  </a:lnTo>
                  <a:lnTo>
                    <a:pt x="1191" y="2"/>
                  </a:lnTo>
                  <a:lnTo>
                    <a:pt x="1192" y="2"/>
                  </a:lnTo>
                  <a:lnTo>
                    <a:pt x="1192" y="1"/>
                  </a:lnTo>
                  <a:lnTo>
                    <a:pt x="1193" y="2"/>
                  </a:lnTo>
                  <a:lnTo>
                    <a:pt x="1194" y="2"/>
                  </a:lnTo>
                  <a:lnTo>
                    <a:pt x="1195" y="2"/>
                  </a:lnTo>
                  <a:lnTo>
                    <a:pt x="1196" y="2"/>
                  </a:lnTo>
                  <a:lnTo>
                    <a:pt x="1197" y="2"/>
                  </a:lnTo>
                  <a:lnTo>
                    <a:pt x="1198" y="2"/>
                  </a:lnTo>
                  <a:lnTo>
                    <a:pt x="1199" y="1"/>
                  </a:lnTo>
                  <a:lnTo>
                    <a:pt x="1200" y="2"/>
                  </a:lnTo>
                  <a:lnTo>
                    <a:pt x="1200" y="2"/>
                  </a:lnTo>
                  <a:lnTo>
                    <a:pt x="1201" y="2"/>
                  </a:lnTo>
                  <a:lnTo>
                    <a:pt x="1202" y="2"/>
                  </a:lnTo>
                  <a:lnTo>
                    <a:pt x="1203" y="2"/>
                  </a:lnTo>
                  <a:lnTo>
                    <a:pt x="1204" y="4"/>
                  </a:lnTo>
                  <a:lnTo>
                    <a:pt x="1205" y="3"/>
                  </a:lnTo>
                  <a:lnTo>
                    <a:pt x="1206" y="4"/>
                  </a:lnTo>
                  <a:lnTo>
                    <a:pt x="1207" y="4"/>
                  </a:lnTo>
                  <a:lnTo>
                    <a:pt x="1207" y="4"/>
                  </a:lnTo>
                  <a:lnTo>
                    <a:pt x="1208" y="4"/>
                  </a:lnTo>
                  <a:lnTo>
                    <a:pt x="1209" y="4"/>
                  </a:lnTo>
                  <a:lnTo>
                    <a:pt x="1210" y="3"/>
                  </a:lnTo>
                  <a:lnTo>
                    <a:pt x="1211" y="3"/>
                  </a:lnTo>
                  <a:lnTo>
                    <a:pt x="1212" y="4"/>
                  </a:lnTo>
                  <a:lnTo>
                    <a:pt x="1213" y="3"/>
                  </a:lnTo>
                  <a:lnTo>
                    <a:pt x="1214" y="3"/>
                  </a:lnTo>
                  <a:lnTo>
                    <a:pt x="1215" y="3"/>
                  </a:lnTo>
                  <a:lnTo>
                    <a:pt x="1215" y="3"/>
                  </a:lnTo>
                  <a:lnTo>
                    <a:pt x="1216" y="3"/>
                  </a:lnTo>
                  <a:lnTo>
                    <a:pt x="1217" y="3"/>
                  </a:lnTo>
                  <a:lnTo>
                    <a:pt x="1218" y="3"/>
                  </a:lnTo>
                  <a:lnTo>
                    <a:pt x="1219" y="3"/>
                  </a:lnTo>
                  <a:lnTo>
                    <a:pt x="1220" y="3"/>
                  </a:lnTo>
                  <a:lnTo>
                    <a:pt x="1221" y="3"/>
                  </a:lnTo>
                  <a:lnTo>
                    <a:pt x="1222" y="2"/>
                  </a:lnTo>
                  <a:lnTo>
                    <a:pt x="1222" y="2"/>
                  </a:lnTo>
                  <a:lnTo>
                    <a:pt x="1223" y="2"/>
                  </a:lnTo>
                  <a:lnTo>
                    <a:pt x="1224" y="2"/>
                  </a:lnTo>
                  <a:lnTo>
                    <a:pt x="1225" y="2"/>
                  </a:lnTo>
                  <a:lnTo>
                    <a:pt x="1226" y="2"/>
                  </a:lnTo>
                  <a:lnTo>
                    <a:pt x="1227" y="2"/>
                  </a:lnTo>
                  <a:lnTo>
                    <a:pt x="1228" y="2"/>
                  </a:lnTo>
                  <a:lnTo>
                    <a:pt x="1229" y="2"/>
                  </a:lnTo>
                  <a:lnTo>
                    <a:pt x="1230" y="2"/>
                  </a:lnTo>
                  <a:lnTo>
                    <a:pt x="1230" y="2"/>
                  </a:lnTo>
                  <a:lnTo>
                    <a:pt x="1231" y="2"/>
                  </a:lnTo>
                  <a:lnTo>
                    <a:pt x="1232" y="2"/>
                  </a:lnTo>
                  <a:lnTo>
                    <a:pt x="1233" y="2"/>
                  </a:lnTo>
                  <a:lnTo>
                    <a:pt x="1234" y="2"/>
                  </a:lnTo>
                  <a:lnTo>
                    <a:pt x="1235" y="1"/>
                  </a:lnTo>
                  <a:lnTo>
                    <a:pt x="1236" y="1"/>
                  </a:lnTo>
                  <a:lnTo>
                    <a:pt x="1237" y="2"/>
                  </a:lnTo>
                  <a:lnTo>
                    <a:pt x="1237" y="1"/>
                  </a:lnTo>
                  <a:lnTo>
                    <a:pt x="1238" y="2"/>
                  </a:lnTo>
                  <a:lnTo>
                    <a:pt x="1239" y="1"/>
                  </a:lnTo>
                  <a:lnTo>
                    <a:pt x="1240" y="1"/>
                  </a:lnTo>
                  <a:lnTo>
                    <a:pt x="1241" y="1"/>
                  </a:lnTo>
                  <a:lnTo>
                    <a:pt x="1242" y="1"/>
                  </a:lnTo>
                  <a:lnTo>
                    <a:pt x="1243" y="1"/>
                  </a:lnTo>
                  <a:lnTo>
                    <a:pt x="1244" y="1"/>
                  </a:lnTo>
                  <a:lnTo>
                    <a:pt x="1245" y="2"/>
                  </a:lnTo>
                  <a:lnTo>
                    <a:pt x="1245" y="1"/>
                  </a:lnTo>
                  <a:lnTo>
                    <a:pt x="1246" y="1"/>
                  </a:lnTo>
                  <a:lnTo>
                    <a:pt x="1247" y="1"/>
                  </a:lnTo>
                  <a:lnTo>
                    <a:pt x="1248" y="1"/>
                  </a:lnTo>
                  <a:lnTo>
                    <a:pt x="1249" y="1"/>
                  </a:lnTo>
                  <a:lnTo>
                    <a:pt x="1250" y="1"/>
                  </a:lnTo>
                  <a:lnTo>
                    <a:pt x="1251" y="1"/>
                  </a:lnTo>
                  <a:lnTo>
                    <a:pt x="1252" y="1"/>
                  </a:lnTo>
                  <a:lnTo>
                    <a:pt x="1252" y="1"/>
                  </a:lnTo>
                  <a:lnTo>
                    <a:pt x="1253" y="1"/>
                  </a:lnTo>
                  <a:lnTo>
                    <a:pt x="1254" y="1"/>
                  </a:lnTo>
                  <a:lnTo>
                    <a:pt x="1255" y="1"/>
                  </a:lnTo>
                  <a:lnTo>
                    <a:pt x="1256" y="1"/>
                  </a:lnTo>
                  <a:lnTo>
                    <a:pt x="1257" y="1"/>
                  </a:lnTo>
                  <a:lnTo>
                    <a:pt x="1258" y="1"/>
                  </a:lnTo>
                  <a:lnTo>
                    <a:pt x="1259" y="1"/>
                  </a:lnTo>
                  <a:lnTo>
                    <a:pt x="1260" y="1"/>
                  </a:lnTo>
                  <a:lnTo>
                    <a:pt x="1260" y="1"/>
                  </a:lnTo>
                  <a:lnTo>
                    <a:pt x="1261" y="1"/>
                  </a:lnTo>
                  <a:lnTo>
                    <a:pt x="1262" y="1"/>
                  </a:lnTo>
                  <a:lnTo>
                    <a:pt x="1263" y="1"/>
                  </a:lnTo>
                  <a:lnTo>
                    <a:pt x="1264" y="1"/>
                  </a:lnTo>
                  <a:lnTo>
                    <a:pt x="1265" y="1"/>
                  </a:lnTo>
                  <a:lnTo>
                    <a:pt x="1266" y="1"/>
                  </a:lnTo>
                  <a:lnTo>
                    <a:pt x="1267" y="1"/>
                  </a:lnTo>
                  <a:lnTo>
                    <a:pt x="1267" y="2"/>
                  </a:lnTo>
                  <a:lnTo>
                    <a:pt x="1268" y="1"/>
                  </a:lnTo>
                  <a:lnTo>
                    <a:pt x="1269" y="1"/>
                  </a:lnTo>
                  <a:lnTo>
                    <a:pt x="1270" y="1"/>
                  </a:lnTo>
                  <a:lnTo>
                    <a:pt x="1271" y="1"/>
                  </a:lnTo>
                  <a:lnTo>
                    <a:pt x="1272" y="1"/>
                  </a:lnTo>
                  <a:lnTo>
                    <a:pt x="1273" y="1"/>
                  </a:lnTo>
                  <a:lnTo>
                    <a:pt x="1274" y="1"/>
                  </a:lnTo>
                  <a:lnTo>
                    <a:pt x="1275" y="1"/>
                  </a:lnTo>
                  <a:lnTo>
                    <a:pt x="1275" y="1"/>
                  </a:lnTo>
                  <a:lnTo>
                    <a:pt x="1276" y="1"/>
                  </a:lnTo>
                  <a:lnTo>
                    <a:pt x="1277" y="1"/>
                  </a:lnTo>
                  <a:lnTo>
                    <a:pt x="1278" y="1"/>
                  </a:lnTo>
                  <a:lnTo>
                    <a:pt x="1279" y="1"/>
                  </a:lnTo>
                  <a:lnTo>
                    <a:pt x="1280" y="1"/>
                  </a:lnTo>
                  <a:lnTo>
                    <a:pt x="1281" y="1"/>
                  </a:lnTo>
                  <a:lnTo>
                    <a:pt x="1282" y="1"/>
                  </a:lnTo>
                  <a:lnTo>
                    <a:pt x="1282" y="1"/>
                  </a:lnTo>
                  <a:lnTo>
                    <a:pt x="1283" y="1"/>
                  </a:lnTo>
                  <a:lnTo>
                    <a:pt x="1284" y="1"/>
                  </a:lnTo>
                  <a:lnTo>
                    <a:pt x="1285" y="1"/>
                  </a:lnTo>
                  <a:lnTo>
                    <a:pt x="1286" y="1"/>
                  </a:lnTo>
                  <a:lnTo>
                    <a:pt x="1287" y="1"/>
                  </a:lnTo>
                  <a:lnTo>
                    <a:pt x="1288" y="1"/>
                  </a:lnTo>
                  <a:lnTo>
                    <a:pt x="1289" y="1"/>
                  </a:lnTo>
                  <a:lnTo>
                    <a:pt x="1290" y="1"/>
                  </a:lnTo>
                  <a:lnTo>
                    <a:pt x="1290" y="1"/>
                  </a:lnTo>
                  <a:lnTo>
                    <a:pt x="1291" y="1"/>
                  </a:lnTo>
                  <a:lnTo>
                    <a:pt x="1292" y="1"/>
                  </a:lnTo>
                  <a:lnTo>
                    <a:pt x="1293" y="1"/>
                  </a:lnTo>
                  <a:lnTo>
                    <a:pt x="1294" y="1"/>
                  </a:lnTo>
                  <a:lnTo>
                    <a:pt x="1295" y="1"/>
                  </a:lnTo>
                  <a:lnTo>
                    <a:pt x="1296" y="1"/>
                  </a:lnTo>
                  <a:lnTo>
                    <a:pt x="1297" y="1"/>
                  </a:lnTo>
                  <a:lnTo>
                    <a:pt x="1297" y="2"/>
                  </a:lnTo>
                  <a:lnTo>
                    <a:pt x="1298" y="1"/>
                  </a:lnTo>
                  <a:lnTo>
                    <a:pt x="1299" y="1"/>
                  </a:lnTo>
                  <a:lnTo>
                    <a:pt x="1300" y="1"/>
                  </a:lnTo>
                  <a:lnTo>
                    <a:pt x="1301" y="1"/>
                  </a:lnTo>
                  <a:lnTo>
                    <a:pt x="1302" y="1"/>
                  </a:lnTo>
                  <a:lnTo>
                    <a:pt x="1303" y="1"/>
                  </a:lnTo>
                  <a:lnTo>
                    <a:pt x="1304" y="1"/>
                  </a:lnTo>
                  <a:lnTo>
                    <a:pt x="1305" y="1"/>
                  </a:lnTo>
                  <a:lnTo>
                    <a:pt x="1305" y="1"/>
                  </a:lnTo>
                  <a:lnTo>
                    <a:pt x="1306" y="1"/>
                  </a:lnTo>
                  <a:lnTo>
                    <a:pt x="1307" y="1"/>
                  </a:lnTo>
                  <a:lnTo>
                    <a:pt x="1308" y="1"/>
                  </a:lnTo>
                  <a:lnTo>
                    <a:pt x="1309" y="1"/>
                  </a:lnTo>
                  <a:lnTo>
                    <a:pt x="1310" y="1"/>
                  </a:lnTo>
                  <a:lnTo>
                    <a:pt x="1311" y="1"/>
                  </a:lnTo>
                  <a:lnTo>
                    <a:pt x="1312" y="1"/>
                  </a:lnTo>
                  <a:lnTo>
                    <a:pt x="1312" y="1"/>
                  </a:lnTo>
                  <a:lnTo>
                    <a:pt x="1313" y="1"/>
                  </a:lnTo>
                  <a:lnTo>
                    <a:pt x="1314" y="1"/>
                  </a:lnTo>
                  <a:lnTo>
                    <a:pt x="1315" y="1"/>
                  </a:lnTo>
                  <a:lnTo>
                    <a:pt x="1316" y="1"/>
                  </a:lnTo>
                  <a:lnTo>
                    <a:pt x="1317" y="1"/>
                  </a:lnTo>
                  <a:lnTo>
                    <a:pt x="1318" y="2"/>
                  </a:lnTo>
                  <a:lnTo>
                    <a:pt x="1319" y="1"/>
                  </a:lnTo>
                  <a:lnTo>
                    <a:pt x="1320" y="2"/>
                  </a:lnTo>
                  <a:lnTo>
                    <a:pt x="1320" y="2"/>
                  </a:lnTo>
                  <a:lnTo>
                    <a:pt x="1321" y="2"/>
                  </a:lnTo>
                  <a:lnTo>
                    <a:pt x="1322" y="1"/>
                  </a:lnTo>
                  <a:lnTo>
                    <a:pt x="1323" y="2"/>
                  </a:lnTo>
                  <a:lnTo>
                    <a:pt x="1324" y="2"/>
                  </a:lnTo>
                  <a:lnTo>
                    <a:pt x="1325" y="2"/>
                  </a:lnTo>
                  <a:lnTo>
                    <a:pt x="1326" y="1"/>
                  </a:lnTo>
                  <a:lnTo>
                    <a:pt x="1327" y="1"/>
                  </a:lnTo>
                  <a:lnTo>
                    <a:pt x="1327" y="1"/>
                  </a:lnTo>
                  <a:lnTo>
                    <a:pt x="1328" y="2"/>
                  </a:lnTo>
                  <a:lnTo>
                    <a:pt x="1329" y="1"/>
                  </a:lnTo>
                  <a:lnTo>
                    <a:pt x="1330" y="1"/>
                  </a:lnTo>
                  <a:lnTo>
                    <a:pt x="1331" y="2"/>
                  </a:lnTo>
                  <a:lnTo>
                    <a:pt x="1332" y="1"/>
                  </a:lnTo>
                  <a:lnTo>
                    <a:pt x="1333" y="1"/>
                  </a:lnTo>
                  <a:lnTo>
                    <a:pt x="1334" y="1"/>
                  </a:lnTo>
                  <a:lnTo>
                    <a:pt x="1335" y="1"/>
                  </a:lnTo>
                  <a:lnTo>
                    <a:pt x="1335" y="1"/>
                  </a:lnTo>
                  <a:lnTo>
                    <a:pt x="1336" y="1"/>
                  </a:lnTo>
                  <a:lnTo>
                    <a:pt x="1337" y="1"/>
                  </a:lnTo>
                  <a:lnTo>
                    <a:pt x="1338" y="1"/>
                  </a:lnTo>
                  <a:lnTo>
                    <a:pt x="1339" y="1"/>
                  </a:lnTo>
                  <a:lnTo>
                    <a:pt x="1340" y="1"/>
                  </a:lnTo>
                  <a:lnTo>
                    <a:pt x="1341" y="1"/>
                  </a:lnTo>
                  <a:lnTo>
                    <a:pt x="1342" y="1"/>
                  </a:lnTo>
                  <a:lnTo>
                    <a:pt x="1342" y="1"/>
                  </a:lnTo>
                  <a:lnTo>
                    <a:pt x="1343" y="1"/>
                  </a:lnTo>
                  <a:lnTo>
                    <a:pt x="1344" y="1"/>
                  </a:lnTo>
                  <a:lnTo>
                    <a:pt x="1345" y="1"/>
                  </a:lnTo>
                  <a:lnTo>
                    <a:pt x="1346" y="1"/>
                  </a:lnTo>
                  <a:lnTo>
                    <a:pt x="1347" y="1"/>
                  </a:lnTo>
                  <a:lnTo>
                    <a:pt x="1348" y="1"/>
                  </a:lnTo>
                  <a:lnTo>
                    <a:pt x="1349" y="1"/>
                  </a:lnTo>
                  <a:lnTo>
                    <a:pt x="1349" y="1"/>
                  </a:lnTo>
                  <a:lnTo>
                    <a:pt x="1350" y="1"/>
                  </a:lnTo>
                  <a:lnTo>
                    <a:pt x="1351" y="1"/>
                  </a:lnTo>
                  <a:lnTo>
                    <a:pt x="1352" y="1"/>
                  </a:lnTo>
                  <a:lnTo>
                    <a:pt x="1353" y="1"/>
                  </a:lnTo>
                  <a:lnTo>
                    <a:pt x="1354" y="1"/>
                  </a:lnTo>
                  <a:lnTo>
                    <a:pt x="1355" y="1"/>
                  </a:lnTo>
                  <a:lnTo>
                    <a:pt x="1356" y="1"/>
                  </a:lnTo>
                  <a:lnTo>
                    <a:pt x="1357" y="1"/>
                  </a:lnTo>
                  <a:lnTo>
                    <a:pt x="1357" y="1"/>
                  </a:lnTo>
                  <a:lnTo>
                    <a:pt x="1358" y="1"/>
                  </a:lnTo>
                  <a:lnTo>
                    <a:pt x="1359" y="1"/>
                  </a:lnTo>
                  <a:lnTo>
                    <a:pt x="1360" y="1"/>
                  </a:lnTo>
                  <a:lnTo>
                    <a:pt x="1361" y="1"/>
                  </a:lnTo>
                  <a:lnTo>
                    <a:pt x="1362" y="1"/>
                  </a:lnTo>
                  <a:lnTo>
                    <a:pt x="1363" y="1"/>
                  </a:lnTo>
                  <a:lnTo>
                    <a:pt x="1364" y="1"/>
                  </a:lnTo>
                  <a:lnTo>
                    <a:pt x="1364" y="1"/>
                  </a:lnTo>
                  <a:lnTo>
                    <a:pt x="1365" y="1"/>
                  </a:lnTo>
                  <a:lnTo>
                    <a:pt x="1366" y="0"/>
                  </a:lnTo>
                  <a:lnTo>
                    <a:pt x="1367" y="1"/>
                  </a:lnTo>
                  <a:lnTo>
                    <a:pt x="1368" y="1"/>
                  </a:lnTo>
                  <a:lnTo>
                    <a:pt x="1369" y="1"/>
                  </a:lnTo>
                  <a:lnTo>
                    <a:pt x="1370" y="1"/>
                  </a:lnTo>
                  <a:lnTo>
                    <a:pt x="1371" y="1"/>
                  </a:lnTo>
                  <a:lnTo>
                    <a:pt x="1372" y="2"/>
                  </a:lnTo>
                  <a:lnTo>
                    <a:pt x="1372" y="1"/>
                  </a:lnTo>
                  <a:lnTo>
                    <a:pt x="1373" y="1"/>
                  </a:lnTo>
                  <a:lnTo>
                    <a:pt x="1374" y="1"/>
                  </a:lnTo>
                  <a:lnTo>
                    <a:pt x="1375" y="1"/>
                  </a:lnTo>
                  <a:lnTo>
                    <a:pt x="1376" y="0"/>
                  </a:lnTo>
                  <a:lnTo>
                    <a:pt x="1377" y="1"/>
                  </a:lnTo>
                  <a:lnTo>
                    <a:pt x="1378" y="1"/>
                  </a:lnTo>
                  <a:lnTo>
                    <a:pt x="1379" y="1"/>
                  </a:lnTo>
                  <a:lnTo>
                    <a:pt x="1379" y="1"/>
                  </a:lnTo>
                  <a:lnTo>
                    <a:pt x="1380" y="1"/>
                  </a:lnTo>
                  <a:lnTo>
                    <a:pt x="1381" y="1"/>
                  </a:lnTo>
                  <a:lnTo>
                    <a:pt x="1382" y="1"/>
                  </a:lnTo>
                  <a:lnTo>
                    <a:pt x="1383" y="1"/>
                  </a:lnTo>
                  <a:lnTo>
                    <a:pt x="1384" y="1"/>
                  </a:lnTo>
                  <a:lnTo>
                    <a:pt x="1385" y="1"/>
                  </a:lnTo>
                  <a:lnTo>
                    <a:pt x="1386" y="1"/>
                  </a:lnTo>
                  <a:lnTo>
                    <a:pt x="1387" y="1"/>
                  </a:lnTo>
                  <a:lnTo>
                    <a:pt x="1387" y="1"/>
                  </a:lnTo>
                  <a:lnTo>
                    <a:pt x="1388" y="1"/>
                  </a:lnTo>
                  <a:lnTo>
                    <a:pt x="1389" y="1"/>
                  </a:lnTo>
                  <a:lnTo>
                    <a:pt x="1390" y="2"/>
                  </a:lnTo>
                  <a:lnTo>
                    <a:pt x="1391" y="1"/>
                  </a:lnTo>
                  <a:lnTo>
                    <a:pt x="1392" y="2"/>
                  </a:lnTo>
                  <a:lnTo>
                    <a:pt x="1393" y="2"/>
                  </a:lnTo>
                  <a:lnTo>
                    <a:pt x="1394" y="1"/>
                  </a:lnTo>
                  <a:lnTo>
                    <a:pt x="1394" y="1"/>
                  </a:lnTo>
                  <a:lnTo>
                    <a:pt x="1395" y="1"/>
                  </a:lnTo>
                  <a:lnTo>
                    <a:pt x="1396" y="2"/>
                  </a:lnTo>
                  <a:lnTo>
                    <a:pt x="1397" y="1"/>
                  </a:lnTo>
                  <a:lnTo>
                    <a:pt x="1398" y="1"/>
                  </a:lnTo>
                  <a:lnTo>
                    <a:pt x="1399" y="1"/>
                  </a:lnTo>
                  <a:lnTo>
                    <a:pt x="1400" y="1"/>
                  </a:lnTo>
                  <a:lnTo>
                    <a:pt x="1401" y="1"/>
                  </a:lnTo>
                  <a:lnTo>
                    <a:pt x="1402" y="1"/>
                  </a:lnTo>
                  <a:lnTo>
                    <a:pt x="1402" y="1"/>
                  </a:lnTo>
                  <a:lnTo>
                    <a:pt x="1403" y="1"/>
                  </a:lnTo>
                  <a:lnTo>
                    <a:pt x="1404" y="1"/>
                  </a:lnTo>
                  <a:lnTo>
                    <a:pt x="1405" y="1"/>
                  </a:lnTo>
                  <a:lnTo>
                    <a:pt x="1406" y="1"/>
                  </a:lnTo>
                  <a:lnTo>
                    <a:pt x="1407" y="2"/>
                  </a:lnTo>
                  <a:lnTo>
                    <a:pt x="1408" y="1"/>
                  </a:lnTo>
                  <a:lnTo>
                    <a:pt x="1409" y="1"/>
                  </a:lnTo>
                  <a:lnTo>
                    <a:pt x="1409" y="1"/>
                  </a:lnTo>
                  <a:lnTo>
                    <a:pt x="1410" y="1"/>
                  </a:lnTo>
                  <a:lnTo>
                    <a:pt x="1411" y="1"/>
                  </a:lnTo>
                  <a:lnTo>
                    <a:pt x="1412" y="2"/>
                  </a:lnTo>
                  <a:lnTo>
                    <a:pt x="1413" y="1"/>
                  </a:lnTo>
                  <a:lnTo>
                    <a:pt x="1414" y="1"/>
                  </a:lnTo>
                  <a:lnTo>
                    <a:pt x="1415" y="1"/>
                  </a:lnTo>
                  <a:lnTo>
                    <a:pt x="1416" y="1"/>
                  </a:lnTo>
                  <a:lnTo>
                    <a:pt x="1417" y="1"/>
                  </a:lnTo>
                  <a:lnTo>
                    <a:pt x="1417" y="1"/>
                  </a:lnTo>
                  <a:lnTo>
                    <a:pt x="1418" y="1"/>
                  </a:lnTo>
                  <a:lnTo>
                    <a:pt x="1419" y="1"/>
                  </a:lnTo>
                  <a:lnTo>
                    <a:pt x="1420" y="1"/>
                  </a:lnTo>
                  <a:lnTo>
                    <a:pt x="1421" y="1"/>
                  </a:lnTo>
                  <a:lnTo>
                    <a:pt x="1422" y="1"/>
                  </a:lnTo>
                  <a:lnTo>
                    <a:pt x="1423" y="1"/>
                  </a:lnTo>
                  <a:lnTo>
                    <a:pt x="1424" y="1"/>
                  </a:lnTo>
                  <a:lnTo>
                    <a:pt x="1424" y="1"/>
                  </a:lnTo>
                  <a:lnTo>
                    <a:pt x="1425" y="1"/>
                  </a:lnTo>
                  <a:lnTo>
                    <a:pt x="1426" y="1"/>
                  </a:lnTo>
                  <a:lnTo>
                    <a:pt x="1427" y="1"/>
                  </a:lnTo>
                  <a:lnTo>
                    <a:pt x="1428" y="1"/>
                  </a:lnTo>
                  <a:lnTo>
                    <a:pt x="1429" y="1"/>
                  </a:lnTo>
                  <a:lnTo>
                    <a:pt x="1430" y="1"/>
                  </a:lnTo>
                  <a:lnTo>
                    <a:pt x="1431" y="1"/>
                  </a:lnTo>
                  <a:lnTo>
                    <a:pt x="1432" y="1"/>
                  </a:lnTo>
                  <a:lnTo>
                    <a:pt x="1432" y="1"/>
                  </a:lnTo>
                  <a:lnTo>
                    <a:pt x="1433" y="1"/>
                  </a:lnTo>
                  <a:lnTo>
                    <a:pt x="1434" y="1"/>
                  </a:lnTo>
                  <a:lnTo>
                    <a:pt x="1435" y="1"/>
                  </a:lnTo>
                  <a:lnTo>
                    <a:pt x="1436" y="1"/>
                  </a:lnTo>
                  <a:lnTo>
                    <a:pt x="1437" y="1"/>
                  </a:lnTo>
                  <a:lnTo>
                    <a:pt x="1438" y="1"/>
                  </a:lnTo>
                  <a:lnTo>
                    <a:pt x="1439" y="1"/>
                  </a:lnTo>
                  <a:lnTo>
                    <a:pt x="1439" y="1"/>
                  </a:lnTo>
                  <a:lnTo>
                    <a:pt x="1440" y="1"/>
                  </a:lnTo>
                  <a:lnTo>
                    <a:pt x="1441" y="1"/>
                  </a:lnTo>
                  <a:lnTo>
                    <a:pt x="1442" y="1"/>
                  </a:lnTo>
                  <a:lnTo>
                    <a:pt x="1443" y="1"/>
                  </a:lnTo>
                  <a:lnTo>
                    <a:pt x="1444" y="1"/>
                  </a:lnTo>
                  <a:lnTo>
                    <a:pt x="1445" y="2"/>
                  </a:lnTo>
                  <a:lnTo>
                    <a:pt x="1446" y="1"/>
                  </a:lnTo>
                  <a:lnTo>
                    <a:pt x="1447" y="1"/>
                  </a:lnTo>
                  <a:lnTo>
                    <a:pt x="1447" y="1"/>
                  </a:lnTo>
                  <a:lnTo>
                    <a:pt x="1448" y="1"/>
                  </a:lnTo>
                  <a:lnTo>
                    <a:pt x="1449" y="1"/>
                  </a:lnTo>
                  <a:lnTo>
                    <a:pt x="1450" y="1"/>
                  </a:lnTo>
                  <a:lnTo>
                    <a:pt x="1451" y="1"/>
                  </a:lnTo>
                  <a:lnTo>
                    <a:pt x="1452" y="2"/>
                  </a:lnTo>
                  <a:lnTo>
                    <a:pt x="1453" y="1"/>
                  </a:lnTo>
                  <a:lnTo>
                    <a:pt x="1454" y="2"/>
                  </a:lnTo>
                  <a:lnTo>
                    <a:pt x="1454" y="2"/>
                  </a:lnTo>
                  <a:lnTo>
                    <a:pt x="1455" y="2"/>
                  </a:lnTo>
                  <a:lnTo>
                    <a:pt x="1456" y="2"/>
                  </a:lnTo>
                  <a:lnTo>
                    <a:pt x="1457" y="4"/>
                  </a:lnTo>
                  <a:lnTo>
                    <a:pt x="1458" y="5"/>
                  </a:lnTo>
                  <a:lnTo>
                    <a:pt x="1459" y="6"/>
                  </a:lnTo>
                  <a:lnTo>
                    <a:pt x="1460" y="6"/>
                  </a:lnTo>
                  <a:lnTo>
                    <a:pt x="1461" y="8"/>
                  </a:lnTo>
                  <a:lnTo>
                    <a:pt x="1462" y="6"/>
                  </a:lnTo>
                  <a:lnTo>
                    <a:pt x="1462" y="7"/>
                  </a:lnTo>
                  <a:lnTo>
                    <a:pt x="1463" y="7"/>
                  </a:lnTo>
                  <a:lnTo>
                    <a:pt x="1464" y="6"/>
                  </a:lnTo>
                  <a:lnTo>
                    <a:pt x="1465" y="6"/>
                  </a:lnTo>
                  <a:lnTo>
                    <a:pt x="1466" y="5"/>
                  </a:lnTo>
                  <a:lnTo>
                    <a:pt x="1467" y="4"/>
                  </a:lnTo>
                  <a:lnTo>
                    <a:pt x="1468" y="3"/>
                  </a:lnTo>
                  <a:lnTo>
                    <a:pt x="1469" y="3"/>
                  </a:lnTo>
                  <a:lnTo>
                    <a:pt x="1469" y="3"/>
                  </a:lnTo>
                  <a:lnTo>
                    <a:pt x="1470" y="3"/>
                  </a:lnTo>
                  <a:lnTo>
                    <a:pt x="1471" y="2"/>
                  </a:lnTo>
                  <a:lnTo>
                    <a:pt x="1472" y="3"/>
                  </a:lnTo>
                  <a:lnTo>
                    <a:pt x="1473" y="2"/>
                  </a:lnTo>
                  <a:lnTo>
                    <a:pt x="1474" y="2"/>
                  </a:lnTo>
                  <a:lnTo>
                    <a:pt x="1475" y="1"/>
                  </a:lnTo>
                  <a:lnTo>
                    <a:pt x="1476" y="1"/>
                  </a:lnTo>
                  <a:lnTo>
                    <a:pt x="1477" y="1"/>
                  </a:lnTo>
                  <a:lnTo>
                    <a:pt x="1477" y="2"/>
                  </a:lnTo>
                  <a:lnTo>
                    <a:pt x="1478" y="2"/>
                  </a:lnTo>
                  <a:lnTo>
                    <a:pt x="1479" y="2"/>
                  </a:lnTo>
                  <a:lnTo>
                    <a:pt x="1480" y="1"/>
                  </a:lnTo>
                  <a:lnTo>
                    <a:pt x="1481" y="2"/>
                  </a:lnTo>
                  <a:lnTo>
                    <a:pt x="1482" y="2"/>
                  </a:lnTo>
                  <a:lnTo>
                    <a:pt x="1483" y="2"/>
                  </a:lnTo>
                  <a:lnTo>
                    <a:pt x="1484" y="2"/>
                  </a:lnTo>
                  <a:lnTo>
                    <a:pt x="1484" y="2"/>
                  </a:lnTo>
                  <a:lnTo>
                    <a:pt x="1485" y="2"/>
                  </a:lnTo>
                  <a:lnTo>
                    <a:pt x="1486" y="1"/>
                  </a:lnTo>
                  <a:lnTo>
                    <a:pt x="1487" y="2"/>
                  </a:lnTo>
                  <a:lnTo>
                    <a:pt x="1488" y="1"/>
                  </a:lnTo>
                  <a:lnTo>
                    <a:pt x="1489" y="1"/>
                  </a:lnTo>
                  <a:lnTo>
                    <a:pt x="1490" y="2"/>
                  </a:lnTo>
                  <a:lnTo>
                    <a:pt x="1491" y="1"/>
                  </a:lnTo>
                  <a:lnTo>
                    <a:pt x="1492" y="2"/>
                  </a:lnTo>
                  <a:lnTo>
                    <a:pt x="1492" y="1"/>
                  </a:lnTo>
                  <a:lnTo>
                    <a:pt x="1493" y="1"/>
                  </a:lnTo>
                  <a:lnTo>
                    <a:pt x="1494" y="1"/>
                  </a:lnTo>
                  <a:lnTo>
                    <a:pt x="1495" y="1"/>
                  </a:lnTo>
                  <a:lnTo>
                    <a:pt x="1496" y="1"/>
                  </a:lnTo>
                  <a:lnTo>
                    <a:pt x="1497" y="2"/>
                  </a:lnTo>
                  <a:lnTo>
                    <a:pt x="1498" y="1"/>
                  </a:lnTo>
                  <a:lnTo>
                    <a:pt x="1499" y="1"/>
                  </a:lnTo>
                  <a:lnTo>
                    <a:pt x="1499" y="1"/>
                  </a:lnTo>
                  <a:lnTo>
                    <a:pt x="1500" y="1"/>
                  </a:lnTo>
                  <a:lnTo>
                    <a:pt x="1501" y="1"/>
                  </a:lnTo>
                  <a:lnTo>
                    <a:pt x="1502" y="2"/>
                  </a:lnTo>
                  <a:lnTo>
                    <a:pt x="1503" y="1"/>
                  </a:lnTo>
                  <a:lnTo>
                    <a:pt x="1504" y="2"/>
                  </a:lnTo>
                  <a:lnTo>
                    <a:pt x="1505" y="1"/>
                  </a:lnTo>
                  <a:lnTo>
                    <a:pt x="1506" y="2"/>
                  </a:lnTo>
                  <a:lnTo>
                    <a:pt x="1507" y="1"/>
                  </a:lnTo>
                  <a:lnTo>
                    <a:pt x="1507" y="2"/>
                  </a:lnTo>
                  <a:lnTo>
                    <a:pt x="1508" y="2"/>
                  </a:lnTo>
                  <a:lnTo>
                    <a:pt x="1509" y="1"/>
                  </a:lnTo>
                  <a:lnTo>
                    <a:pt x="1510" y="1"/>
                  </a:lnTo>
                  <a:lnTo>
                    <a:pt x="1511" y="2"/>
                  </a:lnTo>
                  <a:lnTo>
                    <a:pt x="1512" y="2"/>
                  </a:lnTo>
                  <a:lnTo>
                    <a:pt x="1513" y="1"/>
                  </a:lnTo>
                  <a:lnTo>
                    <a:pt x="1514" y="1"/>
                  </a:lnTo>
                  <a:lnTo>
                    <a:pt x="1514" y="2"/>
                  </a:lnTo>
                  <a:lnTo>
                    <a:pt x="1515" y="1"/>
                  </a:lnTo>
                  <a:lnTo>
                    <a:pt x="1516" y="2"/>
                  </a:lnTo>
                  <a:lnTo>
                    <a:pt x="1517" y="1"/>
                  </a:lnTo>
                  <a:lnTo>
                    <a:pt x="1518" y="2"/>
                  </a:lnTo>
                  <a:lnTo>
                    <a:pt x="1519" y="1"/>
                  </a:lnTo>
                  <a:lnTo>
                    <a:pt x="1520" y="2"/>
                  </a:lnTo>
                  <a:lnTo>
                    <a:pt x="1521" y="2"/>
                  </a:lnTo>
                  <a:lnTo>
                    <a:pt x="1522" y="2"/>
                  </a:lnTo>
                  <a:lnTo>
                    <a:pt x="1522" y="2"/>
                  </a:lnTo>
                  <a:lnTo>
                    <a:pt x="1523" y="2"/>
                  </a:lnTo>
                  <a:lnTo>
                    <a:pt x="1524" y="2"/>
                  </a:lnTo>
                  <a:lnTo>
                    <a:pt x="1525" y="2"/>
                  </a:lnTo>
                  <a:lnTo>
                    <a:pt x="1526" y="2"/>
                  </a:lnTo>
                  <a:lnTo>
                    <a:pt x="1527" y="2"/>
                  </a:lnTo>
                  <a:lnTo>
                    <a:pt x="1528" y="2"/>
                  </a:lnTo>
                  <a:lnTo>
                    <a:pt x="1529" y="3"/>
                  </a:lnTo>
                  <a:lnTo>
                    <a:pt x="1529" y="3"/>
                  </a:lnTo>
                  <a:lnTo>
                    <a:pt x="1530" y="2"/>
                  </a:lnTo>
                  <a:lnTo>
                    <a:pt x="1531" y="2"/>
                  </a:lnTo>
                  <a:lnTo>
                    <a:pt x="1532" y="3"/>
                  </a:lnTo>
                  <a:lnTo>
                    <a:pt x="1533" y="3"/>
                  </a:lnTo>
                  <a:lnTo>
                    <a:pt x="1534" y="2"/>
                  </a:lnTo>
                  <a:lnTo>
                    <a:pt x="1535" y="3"/>
                  </a:lnTo>
                  <a:lnTo>
                    <a:pt x="1536" y="3"/>
                  </a:lnTo>
                  <a:lnTo>
                    <a:pt x="1537" y="2"/>
                  </a:lnTo>
                  <a:lnTo>
                    <a:pt x="1537" y="2"/>
                  </a:lnTo>
                  <a:lnTo>
                    <a:pt x="1538" y="3"/>
                  </a:lnTo>
                  <a:lnTo>
                    <a:pt x="1539" y="2"/>
                  </a:lnTo>
                  <a:lnTo>
                    <a:pt x="1540" y="2"/>
                  </a:lnTo>
                  <a:lnTo>
                    <a:pt x="1541" y="2"/>
                  </a:lnTo>
                  <a:lnTo>
                    <a:pt x="1542" y="2"/>
                  </a:lnTo>
                  <a:lnTo>
                    <a:pt x="1543" y="2"/>
                  </a:lnTo>
                  <a:lnTo>
                    <a:pt x="1544" y="2"/>
                  </a:lnTo>
                  <a:lnTo>
                    <a:pt x="1544" y="2"/>
                  </a:lnTo>
                  <a:lnTo>
                    <a:pt x="1545" y="2"/>
                  </a:lnTo>
                  <a:lnTo>
                    <a:pt x="1546" y="2"/>
                  </a:lnTo>
                  <a:lnTo>
                    <a:pt x="1547" y="2"/>
                  </a:lnTo>
                  <a:lnTo>
                    <a:pt x="1548" y="2"/>
                  </a:lnTo>
                  <a:lnTo>
                    <a:pt x="1549" y="2"/>
                  </a:lnTo>
                  <a:lnTo>
                    <a:pt x="1550" y="2"/>
                  </a:lnTo>
                  <a:lnTo>
                    <a:pt x="1551" y="2"/>
                  </a:lnTo>
                  <a:lnTo>
                    <a:pt x="1551" y="2"/>
                  </a:lnTo>
                  <a:lnTo>
                    <a:pt x="1552" y="2"/>
                  </a:lnTo>
                  <a:lnTo>
                    <a:pt x="1553" y="2"/>
                  </a:lnTo>
                  <a:lnTo>
                    <a:pt x="1554" y="3"/>
                  </a:lnTo>
                  <a:lnTo>
                    <a:pt x="1555" y="2"/>
                  </a:lnTo>
                  <a:lnTo>
                    <a:pt x="1556" y="2"/>
                  </a:lnTo>
                  <a:lnTo>
                    <a:pt x="1557" y="2"/>
                  </a:lnTo>
                  <a:lnTo>
                    <a:pt x="1558" y="2"/>
                  </a:lnTo>
                  <a:lnTo>
                    <a:pt x="1559" y="2"/>
                  </a:lnTo>
                  <a:lnTo>
                    <a:pt x="1559" y="2"/>
                  </a:lnTo>
                  <a:lnTo>
                    <a:pt x="1560" y="2"/>
                  </a:lnTo>
                  <a:lnTo>
                    <a:pt x="1561" y="2"/>
                  </a:lnTo>
                  <a:lnTo>
                    <a:pt x="1562" y="2"/>
                  </a:lnTo>
                  <a:lnTo>
                    <a:pt x="1563" y="3"/>
                  </a:lnTo>
                  <a:lnTo>
                    <a:pt x="1564" y="2"/>
                  </a:lnTo>
                  <a:lnTo>
                    <a:pt x="1565" y="2"/>
                  </a:lnTo>
                  <a:lnTo>
                    <a:pt x="1566" y="2"/>
                  </a:lnTo>
                  <a:lnTo>
                    <a:pt x="1566" y="2"/>
                  </a:lnTo>
                  <a:lnTo>
                    <a:pt x="1567" y="1"/>
                  </a:lnTo>
                  <a:lnTo>
                    <a:pt x="1568" y="2"/>
                  </a:lnTo>
                  <a:lnTo>
                    <a:pt x="1569" y="2"/>
                  </a:lnTo>
                  <a:lnTo>
                    <a:pt x="1570" y="2"/>
                  </a:lnTo>
                  <a:lnTo>
                    <a:pt x="1571" y="2"/>
                  </a:lnTo>
                  <a:lnTo>
                    <a:pt x="1572" y="2"/>
                  </a:lnTo>
                  <a:lnTo>
                    <a:pt x="1573" y="2"/>
                  </a:lnTo>
                  <a:lnTo>
                    <a:pt x="1574" y="1"/>
                  </a:lnTo>
                  <a:lnTo>
                    <a:pt x="1574" y="1"/>
                  </a:lnTo>
                  <a:lnTo>
                    <a:pt x="1575" y="2"/>
                  </a:lnTo>
                  <a:lnTo>
                    <a:pt x="1576" y="2"/>
                  </a:lnTo>
                  <a:lnTo>
                    <a:pt x="1577" y="2"/>
                  </a:lnTo>
                  <a:lnTo>
                    <a:pt x="1578" y="2"/>
                  </a:lnTo>
                  <a:lnTo>
                    <a:pt x="1579" y="1"/>
                  </a:lnTo>
                  <a:lnTo>
                    <a:pt x="1580" y="1"/>
                  </a:lnTo>
                  <a:lnTo>
                    <a:pt x="1581" y="1"/>
                  </a:lnTo>
                  <a:lnTo>
                    <a:pt x="1581" y="1"/>
                  </a:lnTo>
                  <a:lnTo>
                    <a:pt x="1582" y="2"/>
                  </a:lnTo>
                  <a:lnTo>
                    <a:pt x="1583" y="2"/>
                  </a:lnTo>
                  <a:lnTo>
                    <a:pt x="1584" y="2"/>
                  </a:lnTo>
                  <a:lnTo>
                    <a:pt x="1585" y="1"/>
                  </a:lnTo>
                  <a:lnTo>
                    <a:pt x="1586" y="1"/>
                  </a:lnTo>
                  <a:lnTo>
                    <a:pt x="1587" y="2"/>
                  </a:lnTo>
                  <a:lnTo>
                    <a:pt x="1588" y="2"/>
                  </a:lnTo>
                  <a:lnTo>
                    <a:pt x="1589" y="2"/>
                  </a:lnTo>
                  <a:lnTo>
                    <a:pt x="1589" y="2"/>
                  </a:lnTo>
                  <a:lnTo>
                    <a:pt x="1590" y="2"/>
                  </a:lnTo>
                  <a:lnTo>
                    <a:pt x="1591" y="2"/>
                  </a:lnTo>
                  <a:lnTo>
                    <a:pt x="1592" y="1"/>
                  </a:lnTo>
                  <a:lnTo>
                    <a:pt x="1593" y="2"/>
                  </a:lnTo>
                  <a:lnTo>
                    <a:pt x="1594" y="2"/>
                  </a:lnTo>
                  <a:lnTo>
                    <a:pt x="1595" y="2"/>
                  </a:lnTo>
                  <a:lnTo>
                    <a:pt x="1596" y="2"/>
                  </a:lnTo>
                  <a:lnTo>
                    <a:pt x="1596" y="2"/>
                  </a:lnTo>
                  <a:lnTo>
                    <a:pt x="1597" y="2"/>
                  </a:lnTo>
                  <a:lnTo>
                    <a:pt x="1598" y="2"/>
                  </a:lnTo>
                  <a:lnTo>
                    <a:pt x="1599" y="2"/>
                  </a:lnTo>
                  <a:lnTo>
                    <a:pt x="1600" y="2"/>
                  </a:lnTo>
                  <a:lnTo>
                    <a:pt x="1601" y="2"/>
                  </a:lnTo>
                  <a:lnTo>
                    <a:pt x="1602" y="2"/>
                  </a:lnTo>
                  <a:lnTo>
                    <a:pt x="1603" y="2"/>
                  </a:lnTo>
                  <a:lnTo>
                    <a:pt x="1604" y="1"/>
                  </a:lnTo>
                  <a:lnTo>
                    <a:pt x="1604" y="2"/>
                  </a:lnTo>
                  <a:lnTo>
                    <a:pt x="1605" y="2"/>
                  </a:lnTo>
                  <a:lnTo>
                    <a:pt x="1606" y="1"/>
                  </a:lnTo>
                  <a:lnTo>
                    <a:pt x="1607" y="2"/>
                  </a:lnTo>
                  <a:lnTo>
                    <a:pt x="1608" y="1"/>
                  </a:lnTo>
                  <a:lnTo>
                    <a:pt x="1609" y="1"/>
                  </a:lnTo>
                  <a:lnTo>
                    <a:pt x="1610" y="2"/>
                  </a:lnTo>
                  <a:lnTo>
                    <a:pt x="1611" y="2"/>
                  </a:lnTo>
                  <a:lnTo>
                    <a:pt x="1611" y="2"/>
                  </a:lnTo>
                  <a:lnTo>
                    <a:pt x="1612" y="1"/>
                  </a:lnTo>
                  <a:lnTo>
                    <a:pt x="1613" y="2"/>
                  </a:lnTo>
                  <a:lnTo>
                    <a:pt x="1614" y="1"/>
                  </a:lnTo>
                  <a:lnTo>
                    <a:pt x="1615" y="1"/>
                  </a:lnTo>
                  <a:lnTo>
                    <a:pt x="1616" y="2"/>
                  </a:lnTo>
                  <a:lnTo>
                    <a:pt x="1617" y="2"/>
                  </a:lnTo>
                  <a:lnTo>
                    <a:pt x="1618" y="2"/>
                  </a:lnTo>
                  <a:lnTo>
                    <a:pt x="1619" y="2"/>
                  </a:lnTo>
                  <a:lnTo>
                    <a:pt x="1619" y="1"/>
                  </a:lnTo>
                  <a:lnTo>
                    <a:pt x="1620" y="1"/>
                  </a:lnTo>
                  <a:lnTo>
                    <a:pt x="1621" y="1"/>
                  </a:lnTo>
                  <a:lnTo>
                    <a:pt x="1622" y="1"/>
                  </a:lnTo>
                  <a:lnTo>
                    <a:pt x="1623" y="1"/>
                  </a:lnTo>
                  <a:lnTo>
                    <a:pt x="1624" y="1"/>
                  </a:lnTo>
                  <a:lnTo>
                    <a:pt x="1625" y="1"/>
                  </a:lnTo>
                  <a:lnTo>
                    <a:pt x="1626" y="1"/>
                  </a:lnTo>
                  <a:lnTo>
                    <a:pt x="1626" y="1"/>
                  </a:lnTo>
                  <a:lnTo>
                    <a:pt x="1627" y="1"/>
                  </a:lnTo>
                  <a:lnTo>
                    <a:pt x="1628" y="1"/>
                  </a:lnTo>
                  <a:lnTo>
                    <a:pt x="1629" y="1"/>
                  </a:lnTo>
                  <a:lnTo>
                    <a:pt x="1630" y="1"/>
                  </a:lnTo>
                  <a:lnTo>
                    <a:pt x="1631" y="1"/>
                  </a:lnTo>
                  <a:lnTo>
                    <a:pt x="1632" y="1"/>
                  </a:lnTo>
                  <a:lnTo>
                    <a:pt x="1633" y="1"/>
                  </a:lnTo>
                  <a:lnTo>
                    <a:pt x="1634" y="2"/>
                  </a:lnTo>
                  <a:lnTo>
                    <a:pt x="1634" y="1"/>
                  </a:lnTo>
                  <a:lnTo>
                    <a:pt x="1635" y="1"/>
                  </a:lnTo>
                  <a:lnTo>
                    <a:pt x="1636" y="2"/>
                  </a:lnTo>
                  <a:lnTo>
                    <a:pt x="1637" y="2"/>
                  </a:lnTo>
                  <a:lnTo>
                    <a:pt x="1638" y="1"/>
                  </a:lnTo>
                  <a:lnTo>
                    <a:pt x="1639" y="1"/>
                  </a:lnTo>
                  <a:lnTo>
                    <a:pt x="1640" y="1"/>
                  </a:lnTo>
                  <a:lnTo>
                    <a:pt x="1641" y="1"/>
                  </a:lnTo>
                  <a:lnTo>
                    <a:pt x="1641" y="2"/>
                  </a:lnTo>
                  <a:lnTo>
                    <a:pt x="1642" y="2"/>
                  </a:lnTo>
                  <a:lnTo>
                    <a:pt x="1643" y="2"/>
                  </a:lnTo>
                  <a:lnTo>
                    <a:pt x="1644" y="2"/>
                  </a:lnTo>
                  <a:lnTo>
                    <a:pt x="1645" y="2"/>
                  </a:lnTo>
                  <a:lnTo>
                    <a:pt x="1646" y="2"/>
                  </a:lnTo>
                  <a:lnTo>
                    <a:pt x="1647" y="3"/>
                  </a:lnTo>
                  <a:lnTo>
                    <a:pt x="1648" y="2"/>
                  </a:lnTo>
                  <a:lnTo>
                    <a:pt x="1649" y="2"/>
                  </a:lnTo>
                  <a:lnTo>
                    <a:pt x="1649" y="2"/>
                  </a:lnTo>
                  <a:lnTo>
                    <a:pt x="1650" y="3"/>
                  </a:lnTo>
                  <a:lnTo>
                    <a:pt x="1651" y="2"/>
                  </a:lnTo>
                  <a:lnTo>
                    <a:pt x="1652" y="2"/>
                  </a:lnTo>
                  <a:lnTo>
                    <a:pt x="1653" y="2"/>
                  </a:lnTo>
                  <a:lnTo>
                    <a:pt x="1654" y="2"/>
                  </a:lnTo>
                  <a:lnTo>
                    <a:pt x="1655" y="2"/>
                  </a:lnTo>
                  <a:lnTo>
                    <a:pt x="1656" y="2"/>
                  </a:lnTo>
                  <a:lnTo>
                    <a:pt x="1656" y="1"/>
                  </a:lnTo>
                  <a:lnTo>
                    <a:pt x="1657" y="2"/>
                  </a:lnTo>
                  <a:lnTo>
                    <a:pt x="1658" y="2"/>
                  </a:lnTo>
                  <a:lnTo>
                    <a:pt x="1659" y="2"/>
                  </a:lnTo>
                  <a:lnTo>
                    <a:pt x="1660" y="2"/>
                  </a:lnTo>
                  <a:lnTo>
                    <a:pt x="1661" y="1"/>
                  </a:lnTo>
                  <a:lnTo>
                    <a:pt x="1662" y="2"/>
                  </a:lnTo>
                  <a:lnTo>
                    <a:pt x="1663" y="2"/>
                  </a:lnTo>
                  <a:lnTo>
                    <a:pt x="1664" y="2"/>
                  </a:lnTo>
                  <a:lnTo>
                    <a:pt x="1664" y="2"/>
                  </a:lnTo>
                  <a:lnTo>
                    <a:pt x="1665" y="2"/>
                  </a:lnTo>
                  <a:lnTo>
                    <a:pt x="1666" y="1"/>
                  </a:lnTo>
                  <a:lnTo>
                    <a:pt x="1667" y="1"/>
                  </a:lnTo>
                  <a:lnTo>
                    <a:pt x="1668" y="2"/>
                  </a:lnTo>
                  <a:lnTo>
                    <a:pt x="1669" y="1"/>
                  </a:lnTo>
                  <a:lnTo>
                    <a:pt x="1670" y="1"/>
                  </a:lnTo>
                  <a:lnTo>
                    <a:pt x="1671" y="1"/>
                  </a:lnTo>
                  <a:lnTo>
                    <a:pt x="1671" y="2"/>
                  </a:lnTo>
                  <a:lnTo>
                    <a:pt x="1672" y="1"/>
                  </a:lnTo>
                  <a:lnTo>
                    <a:pt x="1673" y="2"/>
                  </a:lnTo>
                  <a:lnTo>
                    <a:pt x="1674" y="1"/>
                  </a:lnTo>
                  <a:lnTo>
                    <a:pt x="1675" y="1"/>
                  </a:lnTo>
                  <a:lnTo>
                    <a:pt x="1676" y="1"/>
                  </a:lnTo>
                  <a:lnTo>
                    <a:pt x="1677" y="1"/>
                  </a:lnTo>
                  <a:lnTo>
                    <a:pt x="1678" y="1"/>
                  </a:lnTo>
                  <a:lnTo>
                    <a:pt x="1679" y="1"/>
                  </a:lnTo>
                  <a:lnTo>
                    <a:pt x="1679" y="1"/>
                  </a:lnTo>
                  <a:lnTo>
                    <a:pt x="1680" y="1"/>
                  </a:lnTo>
                  <a:lnTo>
                    <a:pt x="1681" y="1"/>
                  </a:lnTo>
                  <a:lnTo>
                    <a:pt x="1682" y="1"/>
                  </a:lnTo>
                  <a:lnTo>
                    <a:pt x="1683" y="1"/>
                  </a:lnTo>
                  <a:lnTo>
                    <a:pt x="1684" y="1"/>
                  </a:lnTo>
                  <a:lnTo>
                    <a:pt x="1685" y="1"/>
                  </a:lnTo>
                  <a:lnTo>
                    <a:pt x="1686" y="1"/>
                  </a:lnTo>
                  <a:lnTo>
                    <a:pt x="1686" y="2"/>
                  </a:lnTo>
                  <a:lnTo>
                    <a:pt x="1687" y="2"/>
                  </a:lnTo>
                  <a:lnTo>
                    <a:pt x="1688" y="3"/>
                  </a:lnTo>
                  <a:lnTo>
                    <a:pt x="1689" y="5"/>
                  </a:lnTo>
                  <a:lnTo>
                    <a:pt x="1690" y="7"/>
                  </a:lnTo>
                  <a:lnTo>
                    <a:pt x="1691" y="8"/>
                  </a:lnTo>
                  <a:lnTo>
                    <a:pt x="1692" y="10"/>
                  </a:lnTo>
                  <a:lnTo>
                    <a:pt x="1693" y="13"/>
                  </a:lnTo>
                  <a:lnTo>
                    <a:pt x="1694" y="13"/>
                  </a:lnTo>
                  <a:lnTo>
                    <a:pt x="1694" y="15"/>
                  </a:lnTo>
                  <a:lnTo>
                    <a:pt x="1695" y="16"/>
                  </a:lnTo>
                  <a:lnTo>
                    <a:pt x="1696" y="15"/>
                  </a:lnTo>
                  <a:lnTo>
                    <a:pt x="1697" y="14"/>
                  </a:lnTo>
                  <a:lnTo>
                    <a:pt x="1698" y="13"/>
                  </a:lnTo>
                  <a:lnTo>
                    <a:pt x="1699" y="11"/>
                  </a:lnTo>
                  <a:lnTo>
                    <a:pt x="1700" y="9"/>
                  </a:lnTo>
                  <a:lnTo>
                    <a:pt x="1701" y="8"/>
                  </a:lnTo>
                  <a:lnTo>
                    <a:pt x="1701" y="6"/>
                  </a:lnTo>
                  <a:lnTo>
                    <a:pt x="1702" y="6"/>
                  </a:lnTo>
                  <a:lnTo>
                    <a:pt x="1703" y="5"/>
                  </a:lnTo>
                  <a:lnTo>
                    <a:pt x="1704" y="4"/>
                  </a:lnTo>
                  <a:lnTo>
                    <a:pt x="1705" y="4"/>
                  </a:lnTo>
                  <a:lnTo>
                    <a:pt x="1706" y="4"/>
                  </a:lnTo>
                  <a:lnTo>
                    <a:pt x="1707" y="3"/>
                  </a:lnTo>
                  <a:lnTo>
                    <a:pt x="1708" y="4"/>
                  </a:lnTo>
                  <a:lnTo>
                    <a:pt x="1709" y="2"/>
                  </a:lnTo>
                  <a:lnTo>
                    <a:pt x="1709" y="3"/>
                  </a:lnTo>
                  <a:lnTo>
                    <a:pt x="1710" y="3"/>
                  </a:lnTo>
                  <a:lnTo>
                    <a:pt x="1711" y="3"/>
                  </a:lnTo>
                  <a:lnTo>
                    <a:pt x="1712" y="2"/>
                  </a:lnTo>
                  <a:lnTo>
                    <a:pt x="1713" y="2"/>
                  </a:lnTo>
                  <a:lnTo>
                    <a:pt x="1714" y="2"/>
                  </a:lnTo>
                  <a:lnTo>
                    <a:pt x="1715" y="2"/>
                  </a:lnTo>
                  <a:lnTo>
                    <a:pt x="1716" y="2"/>
                  </a:lnTo>
                  <a:lnTo>
                    <a:pt x="1716" y="3"/>
                  </a:lnTo>
                  <a:lnTo>
                    <a:pt x="1717" y="3"/>
                  </a:lnTo>
                  <a:lnTo>
                    <a:pt x="1718" y="3"/>
                  </a:lnTo>
                  <a:lnTo>
                    <a:pt x="1719" y="4"/>
                  </a:lnTo>
                  <a:lnTo>
                    <a:pt x="1720" y="5"/>
                  </a:lnTo>
                  <a:lnTo>
                    <a:pt x="1721" y="6"/>
                  </a:lnTo>
                  <a:lnTo>
                    <a:pt x="1722" y="6"/>
                  </a:lnTo>
                  <a:lnTo>
                    <a:pt x="1723" y="6"/>
                  </a:lnTo>
                  <a:lnTo>
                    <a:pt x="1724" y="6"/>
                  </a:lnTo>
                  <a:lnTo>
                    <a:pt x="1724" y="6"/>
                  </a:lnTo>
                  <a:lnTo>
                    <a:pt x="1725" y="6"/>
                  </a:lnTo>
                  <a:lnTo>
                    <a:pt x="1726" y="5"/>
                  </a:lnTo>
                  <a:lnTo>
                    <a:pt x="1727" y="5"/>
                  </a:lnTo>
                  <a:lnTo>
                    <a:pt x="1728" y="5"/>
                  </a:lnTo>
                  <a:lnTo>
                    <a:pt x="1729" y="4"/>
                  </a:lnTo>
                  <a:lnTo>
                    <a:pt x="1730" y="4"/>
                  </a:lnTo>
                  <a:lnTo>
                    <a:pt x="1731" y="3"/>
                  </a:lnTo>
                  <a:lnTo>
                    <a:pt x="1731" y="3"/>
                  </a:lnTo>
                  <a:lnTo>
                    <a:pt x="1732" y="3"/>
                  </a:lnTo>
                  <a:lnTo>
                    <a:pt x="1733" y="3"/>
                  </a:lnTo>
                  <a:lnTo>
                    <a:pt x="1734" y="2"/>
                  </a:lnTo>
                  <a:lnTo>
                    <a:pt x="1735" y="2"/>
                  </a:lnTo>
                  <a:lnTo>
                    <a:pt x="1736" y="2"/>
                  </a:lnTo>
                  <a:lnTo>
                    <a:pt x="1737" y="2"/>
                  </a:lnTo>
                  <a:lnTo>
                    <a:pt x="1738" y="2"/>
                  </a:lnTo>
                  <a:lnTo>
                    <a:pt x="1739" y="2"/>
                  </a:lnTo>
                  <a:lnTo>
                    <a:pt x="1739" y="2"/>
                  </a:lnTo>
                  <a:lnTo>
                    <a:pt x="1740" y="2"/>
                  </a:lnTo>
                  <a:lnTo>
                    <a:pt x="1741" y="2"/>
                  </a:lnTo>
                  <a:lnTo>
                    <a:pt x="1742" y="1"/>
                  </a:lnTo>
                  <a:lnTo>
                    <a:pt x="1743" y="1"/>
                  </a:lnTo>
                  <a:lnTo>
                    <a:pt x="1744" y="2"/>
                  </a:lnTo>
                  <a:lnTo>
                    <a:pt x="1745" y="1"/>
                  </a:lnTo>
                  <a:lnTo>
                    <a:pt x="1746" y="2"/>
                  </a:lnTo>
                  <a:lnTo>
                    <a:pt x="1746" y="2"/>
                  </a:lnTo>
                  <a:lnTo>
                    <a:pt x="1747" y="2"/>
                  </a:lnTo>
                  <a:lnTo>
                    <a:pt x="1748" y="1"/>
                  </a:lnTo>
                  <a:lnTo>
                    <a:pt x="1749" y="1"/>
                  </a:lnTo>
                  <a:lnTo>
                    <a:pt x="1750" y="2"/>
                  </a:lnTo>
                  <a:lnTo>
                    <a:pt x="1751" y="1"/>
                  </a:lnTo>
                  <a:lnTo>
                    <a:pt x="1752" y="1"/>
                  </a:lnTo>
                  <a:lnTo>
                    <a:pt x="1753" y="1"/>
                  </a:lnTo>
                  <a:lnTo>
                    <a:pt x="1753" y="1"/>
                  </a:lnTo>
                  <a:lnTo>
                    <a:pt x="1754" y="2"/>
                  </a:lnTo>
                  <a:lnTo>
                    <a:pt x="1755" y="1"/>
                  </a:lnTo>
                  <a:lnTo>
                    <a:pt x="1756" y="1"/>
                  </a:lnTo>
                  <a:lnTo>
                    <a:pt x="1757" y="1"/>
                  </a:lnTo>
                  <a:lnTo>
                    <a:pt x="1758" y="1"/>
                  </a:lnTo>
                  <a:lnTo>
                    <a:pt x="1759" y="2"/>
                  </a:lnTo>
                  <a:lnTo>
                    <a:pt x="1760" y="2"/>
                  </a:lnTo>
                  <a:lnTo>
                    <a:pt x="1761" y="1"/>
                  </a:lnTo>
                  <a:lnTo>
                    <a:pt x="1761" y="1"/>
                  </a:lnTo>
                  <a:lnTo>
                    <a:pt x="1762" y="1"/>
                  </a:lnTo>
                  <a:lnTo>
                    <a:pt x="1763" y="1"/>
                  </a:lnTo>
                  <a:lnTo>
                    <a:pt x="1764" y="2"/>
                  </a:lnTo>
                  <a:lnTo>
                    <a:pt x="1765" y="1"/>
                  </a:lnTo>
                  <a:lnTo>
                    <a:pt x="1766" y="2"/>
                  </a:lnTo>
                  <a:lnTo>
                    <a:pt x="1767" y="1"/>
                  </a:lnTo>
                  <a:lnTo>
                    <a:pt x="1768" y="1"/>
                  </a:lnTo>
                  <a:lnTo>
                    <a:pt x="1768" y="1"/>
                  </a:lnTo>
                  <a:lnTo>
                    <a:pt x="1769" y="1"/>
                  </a:lnTo>
                  <a:lnTo>
                    <a:pt x="1770" y="1"/>
                  </a:lnTo>
                  <a:lnTo>
                    <a:pt x="1771" y="1"/>
                  </a:lnTo>
                  <a:lnTo>
                    <a:pt x="1772" y="1"/>
                  </a:lnTo>
                  <a:lnTo>
                    <a:pt x="1773" y="1"/>
                  </a:lnTo>
                  <a:lnTo>
                    <a:pt x="1774" y="1"/>
                  </a:lnTo>
                  <a:lnTo>
                    <a:pt x="1775" y="1"/>
                  </a:lnTo>
                  <a:lnTo>
                    <a:pt x="1776" y="1"/>
                  </a:lnTo>
                  <a:lnTo>
                    <a:pt x="1776" y="1"/>
                  </a:lnTo>
                  <a:lnTo>
                    <a:pt x="1777" y="1"/>
                  </a:lnTo>
                  <a:lnTo>
                    <a:pt x="1778" y="2"/>
                  </a:lnTo>
                  <a:lnTo>
                    <a:pt x="1779" y="1"/>
                  </a:lnTo>
                  <a:lnTo>
                    <a:pt x="1780" y="1"/>
                  </a:lnTo>
                  <a:lnTo>
                    <a:pt x="1781" y="2"/>
                  </a:lnTo>
                  <a:lnTo>
                    <a:pt x="1782" y="2"/>
                  </a:lnTo>
                  <a:lnTo>
                    <a:pt x="1783" y="1"/>
                  </a:lnTo>
                  <a:lnTo>
                    <a:pt x="1783" y="1"/>
                  </a:lnTo>
                  <a:lnTo>
                    <a:pt x="1784" y="1"/>
                  </a:lnTo>
                  <a:lnTo>
                    <a:pt x="1785" y="1"/>
                  </a:lnTo>
                  <a:lnTo>
                    <a:pt x="1786" y="1"/>
                  </a:lnTo>
                  <a:lnTo>
                    <a:pt x="1787" y="1"/>
                  </a:lnTo>
                  <a:lnTo>
                    <a:pt x="1788" y="1"/>
                  </a:lnTo>
                  <a:lnTo>
                    <a:pt x="1789" y="1"/>
                  </a:lnTo>
                  <a:lnTo>
                    <a:pt x="1790" y="1"/>
                  </a:lnTo>
                  <a:lnTo>
                    <a:pt x="1791" y="1"/>
                  </a:lnTo>
                  <a:lnTo>
                    <a:pt x="1791" y="1"/>
                  </a:lnTo>
                  <a:lnTo>
                    <a:pt x="1792" y="2"/>
                  </a:lnTo>
                  <a:lnTo>
                    <a:pt x="1793" y="1"/>
                  </a:lnTo>
                  <a:lnTo>
                    <a:pt x="1794" y="1"/>
                  </a:lnTo>
                  <a:lnTo>
                    <a:pt x="1795" y="1"/>
                  </a:lnTo>
                  <a:lnTo>
                    <a:pt x="1796" y="1"/>
                  </a:lnTo>
                  <a:lnTo>
                    <a:pt x="1797" y="1"/>
                  </a:lnTo>
                  <a:lnTo>
                    <a:pt x="1798" y="1"/>
                  </a:lnTo>
                  <a:lnTo>
                    <a:pt x="1798" y="1"/>
                  </a:lnTo>
                  <a:lnTo>
                    <a:pt x="1799" y="1"/>
                  </a:lnTo>
                  <a:lnTo>
                    <a:pt x="1800" y="1"/>
                  </a:lnTo>
                  <a:lnTo>
                    <a:pt x="1801" y="1"/>
                  </a:lnTo>
                  <a:lnTo>
                    <a:pt x="1802" y="1"/>
                  </a:lnTo>
                  <a:lnTo>
                    <a:pt x="1803" y="2"/>
                  </a:lnTo>
                  <a:lnTo>
                    <a:pt x="1804" y="1"/>
                  </a:lnTo>
                  <a:lnTo>
                    <a:pt x="1805" y="1"/>
                  </a:lnTo>
                  <a:lnTo>
                    <a:pt x="1806" y="1"/>
                  </a:lnTo>
                  <a:lnTo>
                    <a:pt x="1806" y="1"/>
                  </a:lnTo>
                  <a:lnTo>
                    <a:pt x="1807" y="1"/>
                  </a:lnTo>
                  <a:lnTo>
                    <a:pt x="1808" y="1"/>
                  </a:lnTo>
                  <a:lnTo>
                    <a:pt x="1809" y="1"/>
                  </a:lnTo>
                  <a:lnTo>
                    <a:pt x="1810" y="1"/>
                  </a:lnTo>
                  <a:lnTo>
                    <a:pt x="1811" y="1"/>
                  </a:lnTo>
                  <a:lnTo>
                    <a:pt x="1812" y="1"/>
                  </a:lnTo>
                  <a:lnTo>
                    <a:pt x="1813" y="1"/>
                  </a:lnTo>
                  <a:lnTo>
                    <a:pt x="1813" y="1"/>
                  </a:lnTo>
                  <a:lnTo>
                    <a:pt x="1814" y="1"/>
                  </a:lnTo>
                  <a:lnTo>
                    <a:pt x="1815" y="1"/>
                  </a:lnTo>
                  <a:lnTo>
                    <a:pt x="1816" y="1"/>
                  </a:lnTo>
                  <a:lnTo>
                    <a:pt x="1817" y="1"/>
                  </a:lnTo>
                  <a:lnTo>
                    <a:pt x="1818" y="1"/>
                  </a:lnTo>
                  <a:lnTo>
                    <a:pt x="1819" y="2"/>
                  </a:lnTo>
                  <a:lnTo>
                    <a:pt x="1820" y="1"/>
                  </a:lnTo>
                  <a:lnTo>
                    <a:pt x="1821" y="1"/>
                  </a:lnTo>
                  <a:lnTo>
                    <a:pt x="1821" y="1"/>
                  </a:lnTo>
                  <a:lnTo>
                    <a:pt x="1822" y="1"/>
                  </a:lnTo>
                  <a:lnTo>
                    <a:pt x="1823" y="1"/>
                  </a:lnTo>
                  <a:lnTo>
                    <a:pt x="1824" y="1"/>
                  </a:lnTo>
                  <a:lnTo>
                    <a:pt x="1825" y="2"/>
                  </a:lnTo>
                  <a:lnTo>
                    <a:pt x="1826" y="1"/>
                  </a:lnTo>
                  <a:lnTo>
                    <a:pt x="1827" y="1"/>
                  </a:lnTo>
                  <a:lnTo>
                    <a:pt x="1828" y="1"/>
                  </a:lnTo>
                  <a:lnTo>
                    <a:pt x="1828" y="1"/>
                  </a:lnTo>
                  <a:lnTo>
                    <a:pt x="1829" y="1"/>
                  </a:lnTo>
                  <a:lnTo>
                    <a:pt x="1830" y="1"/>
                  </a:lnTo>
                  <a:lnTo>
                    <a:pt x="1831" y="1"/>
                  </a:lnTo>
                  <a:lnTo>
                    <a:pt x="1832" y="1"/>
                  </a:lnTo>
                  <a:lnTo>
                    <a:pt x="1833" y="1"/>
                  </a:lnTo>
                  <a:lnTo>
                    <a:pt x="1834" y="1"/>
                  </a:lnTo>
                  <a:lnTo>
                    <a:pt x="1835" y="2"/>
                  </a:lnTo>
                  <a:lnTo>
                    <a:pt x="1836" y="1"/>
                  </a:lnTo>
                  <a:lnTo>
                    <a:pt x="1836" y="1"/>
                  </a:lnTo>
                  <a:lnTo>
                    <a:pt x="1837" y="1"/>
                  </a:lnTo>
                  <a:lnTo>
                    <a:pt x="1838" y="1"/>
                  </a:lnTo>
                  <a:lnTo>
                    <a:pt x="1839" y="1"/>
                  </a:lnTo>
                  <a:lnTo>
                    <a:pt x="1840" y="1"/>
                  </a:lnTo>
                  <a:lnTo>
                    <a:pt x="1841" y="1"/>
                  </a:lnTo>
                  <a:lnTo>
                    <a:pt x="1842" y="1"/>
                  </a:lnTo>
                  <a:lnTo>
                    <a:pt x="1843" y="1"/>
                  </a:lnTo>
                  <a:lnTo>
                    <a:pt x="1843" y="1"/>
                  </a:lnTo>
                  <a:lnTo>
                    <a:pt x="1844" y="1"/>
                  </a:lnTo>
                  <a:lnTo>
                    <a:pt x="1845" y="1"/>
                  </a:lnTo>
                  <a:lnTo>
                    <a:pt x="1846" y="1"/>
                  </a:lnTo>
                  <a:lnTo>
                    <a:pt x="1847" y="1"/>
                  </a:lnTo>
                  <a:lnTo>
                    <a:pt x="1848" y="1"/>
                  </a:lnTo>
                  <a:lnTo>
                    <a:pt x="1849" y="1"/>
                  </a:lnTo>
                  <a:lnTo>
                    <a:pt x="1850" y="1"/>
                  </a:lnTo>
                  <a:lnTo>
                    <a:pt x="1851" y="1"/>
                  </a:lnTo>
                  <a:lnTo>
                    <a:pt x="1851" y="1"/>
                  </a:lnTo>
                  <a:lnTo>
                    <a:pt x="1852" y="1"/>
                  </a:lnTo>
                  <a:lnTo>
                    <a:pt x="1853" y="1"/>
                  </a:lnTo>
                  <a:lnTo>
                    <a:pt x="1854" y="1"/>
                  </a:lnTo>
                  <a:lnTo>
                    <a:pt x="1855" y="1"/>
                  </a:lnTo>
                  <a:lnTo>
                    <a:pt x="1856" y="1"/>
                  </a:lnTo>
                  <a:lnTo>
                    <a:pt x="1857" y="1"/>
                  </a:lnTo>
                  <a:lnTo>
                    <a:pt x="1858" y="1"/>
                  </a:lnTo>
                  <a:lnTo>
                    <a:pt x="1858" y="1"/>
                  </a:lnTo>
                  <a:lnTo>
                    <a:pt x="1859" y="1"/>
                  </a:lnTo>
                  <a:lnTo>
                    <a:pt x="1860" y="1"/>
                  </a:lnTo>
                  <a:lnTo>
                    <a:pt x="1861" y="2"/>
                  </a:lnTo>
                  <a:lnTo>
                    <a:pt x="1862" y="2"/>
                  </a:lnTo>
                  <a:lnTo>
                    <a:pt x="1863" y="1"/>
                  </a:lnTo>
                  <a:lnTo>
                    <a:pt x="1864" y="1"/>
                  </a:lnTo>
                  <a:lnTo>
                    <a:pt x="1865" y="1"/>
                  </a:lnTo>
                  <a:lnTo>
                    <a:pt x="1866" y="1"/>
                  </a:lnTo>
                  <a:lnTo>
                    <a:pt x="1866" y="1"/>
                  </a:lnTo>
                  <a:lnTo>
                    <a:pt x="1867" y="1"/>
                  </a:lnTo>
                  <a:lnTo>
                    <a:pt x="1868" y="1"/>
                  </a:lnTo>
                  <a:lnTo>
                    <a:pt x="1869" y="1"/>
                  </a:lnTo>
                  <a:lnTo>
                    <a:pt x="1870" y="1"/>
                  </a:lnTo>
                  <a:lnTo>
                    <a:pt x="1871" y="1"/>
                  </a:lnTo>
                  <a:lnTo>
                    <a:pt x="1872" y="1"/>
                  </a:lnTo>
                  <a:lnTo>
                    <a:pt x="1873" y="1"/>
                  </a:lnTo>
                  <a:lnTo>
                    <a:pt x="1873" y="1"/>
                  </a:lnTo>
                  <a:lnTo>
                    <a:pt x="1874" y="2"/>
                  </a:lnTo>
                  <a:lnTo>
                    <a:pt x="1875" y="1"/>
                  </a:lnTo>
                  <a:lnTo>
                    <a:pt x="1876" y="1"/>
                  </a:lnTo>
                  <a:lnTo>
                    <a:pt x="1877" y="1"/>
                  </a:lnTo>
                  <a:lnTo>
                    <a:pt x="1878" y="1"/>
                  </a:lnTo>
                  <a:lnTo>
                    <a:pt x="1879" y="1"/>
                  </a:lnTo>
                  <a:lnTo>
                    <a:pt x="1880" y="1"/>
                  </a:lnTo>
                  <a:lnTo>
                    <a:pt x="1881" y="1"/>
                  </a:lnTo>
                  <a:lnTo>
                    <a:pt x="1881" y="1"/>
                  </a:lnTo>
                  <a:lnTo>
                    <a:pt x="1882" y="1"/>
                  </a:lnTo>
                  <a:lnTo>
                    <a:pt x="1883" y="1"/>
                  </a:lnTo>
                  <a:lnTo>
                    <a:pt x="1884" y="1"/>
                  </a:lnTo>
                  <a:lnTo>
                    <a:pt x="1885" y="1"/>
                  </a:lnTo>
                  <a:lnTo>
                    <a:pt x="1886" y="1"/>
                  </a:lnTo>
                  <a:lnTo>
                    <a:pt x="1887" y="1"/>
                  </a:lnTo>
                  <a:lnTo>
                    <a:pt x="1888" y="1"/>
                  </a:lnTo>
                  <a:lnTo>
                    <a:pt x="1888" y="1"/>
                  </a:lnTo>
                  <a:lnTo>
                    <a:pt x="1889" y="1"/>
                  </a:lnTo>
                  <a:lnTo>
                    <a:pt x="1890" y="1"/>
                  </a:lnTo>
                  <a:lnTo>
                    <a:pt x="1891" y="1"/>
                  </a:lnTo>
                  <a:lnTo>
                    <a:pt x="1892" y="1"/>
                  </a:lnTo>
                  <a:lnTo>
                    <a:pt x="1893" y="1"/>
                  </a:lnTo>
                  <a:lnTo>
                    <a:pt x="1894" y="1"/>
                  </a:lnTo>
                  <a:lnTo>
                    <a:pt x="1895" y="1"/>
                  </a:lnTo>
                  <a:lnTo>
                    <a:pt x="1896" y="1"/>
                  </a:lnTo>
                  <a:lnTo>
                    <a:pt x="1896" y="1"/>
                  </a:lnTo>
                  <a:lnTo>
                    <a:pt x="1897" y="1"/>
                  </a:lnTo>
                  <a:lnTo>
                    <a:pt x="1898" y="1"/>
                  </a:lnTo>
                  <a:lnTo>
                    <a:pt x="1899" y="1"/>
                  </a:lnTo>
                  <a:lnTo>
                    <a:pt x="1900" y="1"/>
                  </a:lnTo>
                  <a:lnTo>
                    <a:pt x="1901" y="1"/>
                  </a:lnTo>
                  <a:lnTo>
                    <a:pt x="1902" y="1"/>
                  </a:lnTo>
                  <a:lnTo>
                    <a:pt x="1903" y="1"/>
                  </a:lnTo>
                  <a:lnTo>
                    <a:pt x="1903" y="1"/>
                  </a:lnTo>
                  <a:lnTo>
                    <a:pt x="1904" y="1"/>
                  </a:lnTo>
                  <a:lnTo>
                    <a:pt x="1905" y="1"/>
                  </a:lnTo>
                  <a:lnTo>
                    <a:pt x="1906" y="1"/>
                  </a:lnTo>
                  <a:lnTo>
                    <a:pt x="1907" y="1"/>
                  </a:lnTo>
                  <a:lnTo>
                    <a:pt x="1908" y="1"/>
                  </a:lnTo>
                  <a:lnTo>
                    <a:pt x="1909" y="1"/>
                  </a:lnTo>
                  <a:lnTo>
                    <a:pt x="1910" y="1"/>
                  </a:lnTo>
                  <a:lnTo>
                    <a:pt x="1911" y="1"/>
                  </a:lnTo>
                  <a:lnTo>
                    <a:pt x="1911" y="1"/>
                  </a:lnTo>
                  <a:lnTo>
                    <a:pt x="1912" y="1"/>
                  </a:lnTo>
                  <a:lnTo>
                    <a:pt x="1913" y="1"/>
                  </a:lnTo>
                  <a:lnTo>
                    <a:pt x="1914" y="1"/>
                  </a:lnTo>
                  <a:lnTo>
                    <a:pt x="1915" y="1"/>
                  </a:lnTo>
                  <a:lnTo>
                    <a:pt x="1916" y="1"/>
                  </a:lnTo>
                  <a:lnTo>
                    <a:pt x="1917" y="1"/>
                  </a:lnTo>
                  <a:lnTo>
                    <a:pt x="1918" y="1"/>
                  </a:lnTo>
                  <a:lnTo>
                    <a:pt x="1918" y="1"/>
                  </a:lnTo>
                  <a:lnTo>
                    <a:pt x="1919" y="1"/>
                  </a:lnTo>
                  <a:lnTo>
                    <a:pt x="1920" y="1"/>
                  </a:lnTo>
                  <a:lnTo>
                    <a:pt x="1921" y="1"/>
                  </a:lnTo>
                  <a:lnTo>
                    <a:pt x="1922" y="1"/>
                  </a:lnTo>
                  <a:lnTo>
                    <a:pt x="1923" y="1"/>
                  </a:lnTo>
                  <a:lnTo>
                    <a:pt x="1924" y="1"/>
                  </a:lnTo>
                  <a:lnTo>
                    <a:pt x="1925" y="1"/>
                  </a:lnTo>
                  <a:lnTo>
                    <a:pt x="1926" y="1"/>
                  </a:lnTo>
                  <a:lnTo>
                    <a:pt x="1926" y="0"/>
                  </a:lnTo>
                  <a:lnTo>
                    <a:pt x="1927" y="1"/>
                  </a:lnTo>
                  <a:lnTo>
                    <a:pt x="1928" y="1"/>
                  </a:lnTo>
                  <a:lnTo>
                    <a:pt x="1929" y="1"/>
                  </a:lnTo>
                  <a:lnTo>
                    <a:pt x="1930" y="1"/>
                  </a:lnTo>
                  <a:lnTo>
                    <a:pt x="1931" y="1"/>
                  </a:lnTo>
                  <a:lnTo>
                    <a:pt x="1932" y="1"/>
                  </a:lnTo>
                  <a:lnTo>
                    <a:pt x="1933" y="1"/>
                  </a:lnTo>
                  <a:lnTo>
                    <a:pt x="1933" y="1"/>
                  </a:lnTo>
                  <a:lnTo>
                    <a:pt x="1934" y="1"/>
                  </a:lnTo>
                  <a:lnTo>
                    <a:pt x="1935" y="1"/>
                  </a:lnTo>
                  <a:lnTo>
                    <a:pt x="1936" y="1"/>
                  </a:lnTo>
                  <a:lnTo>
                    <a:pt x="1937" y="1"/>
                  </a:lnTo>
                  <a:lnTo>
                    <a:pt x="1938" y="2"/>
                  </a:lnTo>
                  <a:lnTo>
                    <a:pt x="1939" y="1"/>
                  </a:lnTo>
                  <a:lnTo>
                    <a:pt x="1940" y="2"/>
                  </a:lnTo>
                  <a:lnTo>
                    <a:pt x="1940" y="2"/>
                  </a:lnTo>
                  <a:lnTo>
                    <a:pt x="1941" y="2"/>
                  </a:lnTo>
                  <a:lnTo>
                    <a:pt x="1942" y="2"/>
                  </a:lnTo>
                  <a:lnTo>
                    <a:pt x="1943" y="2"/>
                  </a:lnTo>
                  <a:lnTo>
                    <a:pt x="1944" y="2"/>
                  </a:lnTo>
                  <a:lnTo>
                    <a:pt x="1945" y="2"/>
                  </a:lnTo>
                  <a:lnTo>
                    <a:pt x="1946" y="2"/>
                  </a:lnTo>
                  <a:lnTo>
                    <a:pt x="1947" y="1"/>
                  </a:lnTo>
                  <a:lnTo>
                    <a:pt x="1948" y="1"/>
                  </a:lnTo>
                  <a:lnTo>
                    <a:pt x="1948" y="2"/>
                  </a:lnTo>
                  <a:lnTo>
                    <a:pt x="1949" y="1"/>
                  </a:lnTo>
                  <a:lnTo>
                    <a:pt x="1950" y="1"/>
                  </a:lnTo>
                  <a:lnTo>
                    <a:pt x="1951" y="1"/>
                  </a:lnTo>
                  <a:lnTo>
                    <a:pt x="1952" y="1"/>
                  </a:lnTo>
                  <a:lnTo>
                    <a:pt x="1953" y="2"/>
                  </a:lnTo>
                  <a:lnTo>
                    <a:pt x="1954" y="1"/>
                  </a:lnTo>
                  <a:lnTo>
                    <a:pt x="1955" y="1"/>
                  </a:lnTo>
                  <a:lnTo>
                    <a:pt x="1955" y="1"/>
                  </a:lnTo>
                  <a:lnTo>
                    <a:pt x="1956" y="1"/>
                  </a:lnTo>
                  <a:lnTo>
                    <a:pt x="1957" y="1"/>
                  </a:lnTo>
                  <a:lnTo>
                    <a:pt x="1958" y="1"/>
                  </a:lnTo>
                  <a:lnTo>
                    <a:pt x="1959" y="1"/>
                  </a:lnTo>
                  <a:lnTo>
                    <a:pt x="1960" y="1"/>
                  </a:lnTo>
                  <a:lnTo>
                    <a:pt x="1961" y="2"/>
                  </a:lnTo>
                  <a:lnTo>
                    <a:pt x="1962" y="2"/>
                  </a:lnTo>
                  <a:lnTo>
                    <a:pt x="1963" y="1"/>
                  </a:lnTo>
                  <a:lnTo>
                    <a:pt x="1963" y="1"/>
                  </a:lnTo>
                  <a:lnTo>
                    <a:pt x="1964" y="2"/>
                  </a:lnTo>
                  <a:lnTo>
                    <a:pt x="1965" y="2"/>
                  </a:lnTo>
                  <a:lnTo>
                    <a:pt x="1966" y="2"/>
                  </a:lnTo>
                  <a:lnTo>
                    <a:pt x="1967" y="2"/>
                  </a:lnTo>
                  <a:lnTo>
                    <a:pt x="1968" y="2"/>
                  </a:lnTo>
                  <a:lnTo>
                    <a:pt x="1969" y="2"/>
                  </a:lnTo>
                  <a:lnTo>
                    <a:pt x="1970" y="2"/>
                  </a:lnTo>
                  <a:lnTo>
                    <a:pt x="1970" y="2"/>
                  </a:lnTo>
                  <a:lnTo>
                    <a:pt x="1971" y="2"/>
                  </a:lnTo>
                  <a:lnTo>
                    <a:pt x="1972" y="2"/>
                  </a:lnTo>
                  <a:lnTo>
                    <a:pt x="1973" y="2"/>
                  </a:lnTo>
                  <a:lnTo>
                    <a:pt x="1974" y="2"/>
                  </a:lnTo>
                  <a:lnTo>
                    <a:pt x="1975" y="2"/>
                  </a:lnTo>
                  <a:lnTo>
                    <a:pt x="1976" y="1"/>
                  </a:lnTo>
                  <a:lnTo>
                    <a:pt x="1977" y="2"/>
                  </a:lnTo>
                  <a:lnTo>
                    <a:pt x="1978" y="2"/>
                  </a:lnTo>
                  <a:lnTo>
                    <a:pt x="1978" y="1"/>
                  </a:lnTo>
                  <a:lnTo>
                    <a:pt x="1979" y="1"/>
                  </a:lnTo>
                  <a:lnTo>
                    <a:pt x="1980" y="1"/>
                  </a:lnTo>
                  <a:lnTo>
                    <a:pt x="1981" y="1"/>
                  </a:lnTo>
                  <a:lnTo>
                    <a:pt x="1982" y="1"/>
                  </a:lnTo>
                  <a:lnTo>
                    <a:pt x="1983" y="2"/>
                  </a:lnTo>
                  <a:lnTo>
                    <a:pt x="1984" y="2"/>
                  </a:lnTo>
                  <a:lnTo>
                    <a:pt x="1985" y="4"/>
                  </a:lnTo>
                  <a:lnTo>
                    <a:pt x="1985" y="6"/>
                  </a:lnTo>
                  <a:lnTo>
                    <a:pt x="1986" y="8"/>
                  </a:lnTo>
                  <a:lnTo>
                    <a:pt x="1987" y="11"/>
                  </a:lnTo>
                  <a:lnTo>
                    <a:pt x="1988" y="15"/>
                  </a:lnTo>
                  <a:lnTo>
                    <a:pt x="1989" y="20"/>
                  </a:lnTo>
                  <a:lnTo>
                    <a:pt x="1990" y="25"/>
                  </a:lnTo>
                  <a:lnTo>
                    <a:pt x="1991" y="32"/>
                  </a:lnTo>
                  <a:lnTo>
                    <a:pt x="1992" y="35"/>
                  </a:lnTo>
                  <a:lnTo>
                    <a:pt x="1993" y="40"/>
                  </a:lnTo>
                  <a:lnTo>
                    <a:pt x="1993" y="40"/>
                  </a:lnTo>
                  <a:lnTo>
                    <a:pt x="1994" y="37"/>
                  </a:lnTo>
                  <a:lnTo>
                    <a:pt x="1995" y="37"/>
                  </a:lnTo>
                  <a:lnTo>
                    <a:pt x="1996" y="31"/>
                  </a:lnTo>
                  <a:lnTo>
                    <a:pt x="1997" y="28"/>
                  </a:lnTo>
                  <a:lnTo>
                    <a:pt x="1998" y="23"/>
                  </a:lnTo>
                  <a:lnTo>
                    <a:pt x="1999" y="19"/>
                  </a:lnTo>
                  <a:lnTo>
                    <a:pt x="2000" y="16"/>
                  </a:lnTo>
                  <a:lnTo>
                    <a:pt x="2000" y="14"/>
                  </a:lnTo>
                  <a:lnTo>
                    <a:pt x="2001" y="10"/>
                  </a:lnTo>
                  <a:lnTo>
                    <a:pt x="2002" y="8"/>
                  </a:lnTo>
                  <a:lnTo>
                    <a:pt x="2003" y="7"/>
                  </a:lnTo>
                  <a:lnTo>
                    <a:pt x="2004" y="6"/>
                  </a:lnTo>
                  <a:lnTo>
                    <a:pt x="2005" y="5"/>
                  </a:lnTo>
                  <a:lnTo>
                    <a:pt x="2006" y="4"/>
                  </a:lnTo>
                  <a:lnTo>
                    <a:pt x="2007" y="4"/>
                  </a:lnTo>
                  <a:lnTo>
                    <a:pt x="2008" y="3"/>
                  </a:lnTo>
                  <a:lnTo>
                    <a:pt x="2008" y="3"/>
                  </a:lnTo>
                  <a:lnTo>
                    <a:pt x="2009" y="3"/>
                  </a:lnTo>
                  <a:lnTo>
                    <a:pt x="2010" y="4"/>
                  </a:lnTo>
                  <a:lnTo>
                    <a:pt x="2011" y="4"/>
                  </a:lnTo>
                  <a:lnTo>
                    <a:pt x="2012" y="4"/>
                  </a:lnTo>
                  <a:lnTo>
                    <a:pt x="2013" y="4"/>
                  </a:lnTo>
                  <a:lnTo>
                    <a:pt x="2014" y="5"/>
                  </a:lnTo>
                  <a:lnTo>
                    <a:pt x="2015" y="5"/>
                  </a:lnTo>
                  <a:lnTo>
                    <a:pt x="2015" y="6"/>
                  </a:lnTo>
                  <a:lnTo>
                    <a:pt x="2016" y="7"/>
                  </a:lnTo>
                  <a:lnTo>
                    <a:pt x="2017" y="6"/>
                  </a:lnTo>
                  <a:lnTo>
                    <a:pt x="2018" y="7"/>
                  </a:lnTo>
                  <a:lnTo>
                    <a:pt x="2019" y="6"/>
                  </a:lnTo>
                  <a:lnTo>
                    <a:pt x="2020" y="6"/>
                  </a:lnTo>
                  <a:lnTo>
                    <a:pt x="2021" y="5"/>
                  </a:lnTo>
                  <a:lnTo>
                    <a:pt x="2022" y="4"/>
                  </a:lnTo>
                  <a:lnTo>
                    <a:pt x="2023" y="4"/>
                  </a:lnTo>
                  <a:lnTo>
                    <a:pt x="2023" y="3"/>
                  </a:lnTo>
                  <a:lnTo>
                    <a:pt x="2024" y="3"/>
                  </a:lnTo>
                  <a:lnTo>
                    <a:pt x="2025" y="3"/>
                  </a:lnTo>
                  <a:lnTo>
                    <a:pt x="2026" y="2"/>
                  </a:lnTo>
                  <a:lnTo>
                    <a:pt x="2027" y="2"/>
                  </a:lnTo>
                  <a:lnTo>
                    <a:pt x="2028" y="2"/>
                  </a:lnTo>
                  <a:lnTo>
                    <a:pt x="2029" y="2"/>
                  </a:lnTo>
                  <a:lnTo>
                    <a:pt x="2030" y="2"/>
                  </a:lnTo>
                  <a:lnTo>
                    <a:pt x="2030" y="2"/>
                  </a:lnTo>
                  <a:lnTo>
                    <a:pt x="2031" y="2"/>
                  </a:lnTo>
                  <a:lnTo>
                    <a:pt x="2032" y="2"/>
                  </a:lnTo>
                  <a:lnTo>
                    <a:pt x="2033" y="2"/>
                  </a:lnTo>
                  <a:lnTo>
                    <a:pt x="2034" y="2"/>
                  </a:lnTo>
                  <a:lnTo>
                    <a:pt x="2035" y="2"/>
                  </a:lnTo>
                  <a:lnTo>
                    <a:pt x="2036" y="2"/>
                  </a:lnTo>
                  <a:lnTo>
                    <a:pt x="2037" y="2"/>
                  </a:lnTo>
                  <a:lnTo>
                    <a:pt x="2038" y="2"/>
                  </a:lnTo>
                  <a:lnTo>
                    <a:pt x="2038" y="2"/>
                  </a:lnTo>
                  <a:lnTo>
                    <a:pt x="2039" y="2"/>
                  </a:lnTo>
                  <a:lnTo>
                    <a:pt x="2040" y="2"/>
                  </a:lnTo>
                  <a:lnTo>
                    <a:pt x="2041" y="1"/>
                  </a:lnTo>
                  <a:lnTo>
                    <a:pt x="2042" y="2"/>
                  </a:lnTo>
                  <a:lnTo>
                    <a:pt x="2043" y="2"/>
                  </a:lnTo>
                  <a:lnTo>
                    <a:pt x="2044" y="2"/>
                  </a:lnTo>
                  <a:lnTo>
                    <a:pt x="2045" y="2"/>
                  </a:lnTo>
                  <a:lnTo>
                    <a:pt x="2045" y="2"/>
                  </a:lnTo>
                  <a:lnTo>
                    <a:pt x="2046" y="2"/>
                  </a:lnTo>
                  <a:lnTo>
                    <a:pt x="2047" y="1"/>
                  </a:lnTo>
                  <a:lnTo>
                    <a:pt x="2048" y="2"/>
                  </a:lnTo>
                  <a:lnTo>
                    <a:pt x="2049" y="2"/>
                  </a:lnTo>
                  <a:lnTo>
                    <a:pt x="2050" y="2"/>
                  </a:lnTo>
                  <a:lnTo>
                    <a:pt x="2051" y="2"/>
                  </a:lnTo>
                  <a:lnTo>
                    <a:pt x="2052" y="2"/>
                  </a:lnTo>
                  <a:lnTo>
                    <a:pt x="2053" y="2"/>
                  </a:lnTo>
                  <a:lnTo>
                    <a:pt x="2053" y="3"/>
                  </a:lnTo>
                  <a:lnTo>
                    <a:pt x="2054" y="3"/>
                  </a:lnTo>
                  <a:lnTo>
                    <a:pt x="2055" y="4"/>
                  </a:lnTo>
                  <a:lnTo>
                    <a:pt x="2056" y="5"/>
                  </a:lnTo>
                  <a:lnTo>
                    <a:pt x="2057" y="5"/>
                  </a:lnTo>
                  <a:lnTo>
                    <a:pt x="2058" y="5"/>
                  </a:lnTo>
                  <a:lnTo>
                    <a:pt x="2059" y="6"/>
                  </a:lnTo>
                  <a:lnTo>
                    <a:pt x="2060" y="6"/>
                  </a:lnTo>
                  <a:lnTo>
                    <a:pt x="2060" y="5"/>
                  </a:lnTo>
                  <a:lnTo>
                    <a:pt x="2061" y="5"/>
                  </a:lnTo>
                  <a:lnTo>
                    <a:pt x="2062" y="5"/>
                  </a:lnTo>
                  <a:lnTo>
                    <a:pt x="2063" y="5"/>
                  </a:lnTo>
                  <a:lnTo>
                    <a:pt x="2064" y="4"/>
                  </a:lnTo>
                  <a:lnTo>
                    <a:pt x="2065" y="3"/>
                  </a:lnTo>
                  <a:lnTo>
                    <a:pt x="2066" y="4"/>
                  </a:lnTo>
                  <a:lnTo>
                    <a:pt x="2067" y="3"/>
                  </a:lnTo>
                  <a:lnTo>
                    <a:pt x="2068" y="3"/>
                  </a:lnTo>
                  <a:lnTo>
                    <a:pt x="2068" y="3"/>
                  </a:lnTo>
                  <a:lnTo>
                    <a:pt x="2069" y="3"/>
                  </a:lnTo>
                  <a:lnTo>
                    <a:pt x="2070" y="3"/>
                  </a:lnTo>
                  <a:lnTo>
                    <a:pt x="2071" y="3"/>
                  </a:lnTo>
                  <a:lnTo>
                    <a:pt x="2072" y="3"/>
                  </a:lnTo>
                  <a:lnTo>
                    <a:pt x="2073" y="3"/>
                  </a:lnTo>
                  <a:lnTo>
                    <a:pt x="2074" y="3"/>
                  </a:lnTo>
                  <a:lnTo>
                    <a:pt x="2075" y="3"/>
                  </a:lnTo>
                  <a:lnTo>
                    <a:pt x="2075" y="3"/>
                  </a:lnTo>
                  <a:lnTo>
                    <a:pt x="2076" y="3"/>
                  </a:lnTo>
                  <a:lnTo>
                    <a:pt x="2077" y="2"/>
                  </a:lnTo>
                  <a:lnTo>
                    <a:pt x="2078" y="2"/>
                  </a:lnTo>
                  <a:lnTo>
                    <a:pt x="2079" y="2"/>
                  </a:lnTo>
                  <a:lnTo>
                    <a:pt x="2080" y="3"/>
                  </a:lnTo>
                  <a:lnTo>
                    <a:pt x="2081" y="3"/>
                  </a:lnTo>
                  <a:lnTo>
                    <a:pt x="2082" y="2"/>
                  </a:lnTo>
                  <a:lnTo>
                    <a:pt x="2083" y="2"/>
                  </a:lnTo>
                  <a:lnTo>
                    <a:pt x="2083" y="2"/>
                  </a:lnTo>
                  <a:lnTo>
                    <a:pt x="2084" y="2"/>
                  </a:lnTo>
                  <a:lnTo>
                    <a:pt x="2085" y="2"/>
                  </a:lnTo>
                  <a:lnTo>
                    <a:pt x="2086" y="2"/>
                  </a:lnTo>
                  <a:lnTo>
                    <a:pt x="2087" y="2"/>
                  </a:lnTo>
                  <a:lnTo>
                    <a:pt x="2088" y="3"/>
                  </a:lnTo>
                  <a:lnTo>
                    <a:pt x="2089" y="3"/>
                  </a:lnTo>
                  <a:lnTo>
                    <a:pt x="2090" y="2"/>
                  </a:lnTo>
                  <a:lnTo>
                    <a:pt x="2090" y="2"/>
                  </a:lnTo>
                  <a:lnTo>
                    <a:pt x="2091" y="2"/>
                  </a:lnTo>
                  <a:lnTo>
                    <a:pt x="2092" y="2"/>
                  </a:lnTo>
                  <a:lnTo>
                    <a:pt x="2093" y="2"/>
                  </a:lnTo>
                  <a:lnTo>
                    <a:pt x="2094" y="2"/>
                  </a:lnTo>
                  <a:lnTo>
                    <a:pt x="2095" y="2"/>
                  </a:lnTo>
                  <a:lnTo>
                    <a:pt x="2096" y="2"/>
                  </a:lnTo>
                  <a:lnTo>
                    <a:pt x="2097" y="3"/>
                  </a:lnTo>
                  <a:lnTo>
                    <a:pt x="2098" y="3"/>
                  </a:lnTo>
                  <a:lnTo>
                    <a:pt x="2098" y="3"/>
                  </a:lnTo>
                  <a:lnTo>
                    <a:pt x="2099" y="2"/>
                  </a:lnTo>
                  <a:lnTo>
                    <a:pt x="2100" y="3"/>
                  </a:lnTo>
                  <a:lnTo>
                    <a:pt x="2101" y="3"/>
                  </a:lnTo>
                  <a:lnTo>
                    <a:pt x="2102" y="3"/>
                  </a:lnTo>
                  <a:lnTo>
                    <a:pt x="2103" y="3"/>
                  </a:lnTo>
                  <a:lnTo>
                    <a:pt x="2104" y="3"/>
                  </a:lnTo>
                  <a:lnTo>
                    <a:pt x="2105" y="3"/>
                  </a:lnTo>
                  <a:lnTo>
                    <a:pt x="2105" y="2"/>
                  </a:lnTo>
                  <a:lnTo>
                    <a:pt x="2106" y="2"/>
                  </a:lnTo>
                  <a:lnTo>
                    <a:pt x="2107" y="3"/>
                  </a:lnTo>
                  <a:lnTo>
                    <a:pt x="2108" y="2"/>
                  </a:lnTo>
                  <a:lnTo>
                    <a:pt x="2109" y="2"/>
                  </a:lnTo>
                  <a:lnTo>
                    <a:pt x="2110" y="2"/>
                  </a:lnTo>
                  <a:lnTo>
                    <a:pt x="2111" y="2"/>
                  </a:lnTo>
                  <a:lnTo>
                    <a:pt x="2112" y="2"/>
                  </a:lnTo>
                  <a:lnTo>
                    <a:pt x="2113" y="2"/>
                  </a:lnTo>
                  <a:lnTo>
                    <a:pt x="2113" y="2"/>
                  </a:lnTo>
                  <a:lnTo>
                    <a:pt x="2114" y="3"/>
                  </a:lnTo>
                  <a:lnTo>
                    <a:pt x="2115" y="2"/>
                  </a:lnTo>
                  <a:lnTo>
                    <a:pt x="2116" y="3"/>
                  </a:lnTo>
                  <a:lnTo>
                    <a:pt x="2117" y="2"/>
                  </a:lnTo>
                  <a:lnTo>
                    <a:pt x="2118" y="2"/>
                  </a:lnTo>
                  <a:lnTo>
                    <a:pt x="2119" y="2"/>
                  </a:lnTo>
                  <a:lnTo>
                    <a:pt x="2120" y="3"/>
                  </a:lnTo>
                  <a:lnTo>
                    <a:pt x="2120" y="2"/>
                  </a:lnTo>
                  <a:lnTo>
                    <a:pt x="2121" y="2"/>
                  </a:lnTo>
                  <a:lnTo>
                    <a:pt x="2122" y="2"/>
                  </a:lnTo>
                  <a:lnTo>
                    <a:pt x="2123" y="2"/>
                  </a:lnTo>
                  <a:lnTo>
                    <a:pt x="2124" y="2"/>
                  </a:lnTo>
                  <a:lnTo>
                    <a:pt x="2125" y="2"/>
                  </a:lnTo>
                  <a:lnTo>
                    <a:pt x="2126" y="3"/>
                  </a:lnTo>
                  <a:lnTo>
                    <a:pt x="2127" y="3"/>
                  </a:lnTo>
                  <a:lnTo>
                    <a:pt x="2128" y="4"/>
                  </a:lnTo>
                  <a:lnTo>
                    <a:pt x="2128" y="4"/>
                  </a:lnTo>
                  <a:lnTo>
                    <a:pt x="2129" y="4"/>
                  </a:lnTo>
                  <a:lnTo>
                    <a:pt x="2130" y="5"/>
                  </a:lnTo>
                  <a:lnTo>
                    <a:pt x="2131" y="6"/>
                  </a:lnTo>
                  <a:lnTo>
                    <a:pt x="2132" y="7"/>
                  </a:lnTo>
                  <a:lnTo>
                    <a:pt x="2133" y="7"/>
                  </a:lnTo>
                  <a:lnTo>
                    <a:pt x="2134" y="7"/>
                  </a:lnTo>
                  <a:lnTo>
                    <a:pt x="2135" y="9"/>
                  </a:lnTo>
                  <a:lnTo>
                    <a:pt x="2135" y="8"/>
                  </a:lnTo>
                  <a:lnTo>
                    <a:pt x="2136" y="8"/>
                  </a:lnTo>
                  <a:lnTo>
                    <a:pt x="2137" y="6"/>
                  </a:lnTo>
                  <a:lnTo>
                    <a:pt x="2138" y="7"/>
                  </a:lnTo>
                  <a:lnTo>
                    <a:pt x="2139" y="6"/>
                  </a:lnTo>
                  <a:lnTo>
                    <a:pt x="2140" y="6"/>
                  </a:lnTo>
                  <a:lnTo>
                    <a:pt x="2141" y="4"/>
                  </a:lnTo>
                  <a:lnTo>
                    <a:pt x="2142" y="4"/>
                  </a:lnTo>
                  <a:lnTo>
                    <a:pt x="2142" y="4"/>
                  </a:lnTo>
                  <a:lnTo>
                    <a:pt x="2143" y="3"/>
                  </a:lnTo>
                  <a:lnTo>
                    <a:pt x="2144" y="3"/>
                  </a:lnTo>
                  <a:lnTo>
                    <a:pt x="2145" y="3"/>
                  </a:lnTo>
                  <a:lnTo>
                    <a:pt x="2146" y="2"/>
                  </a:lnTo>
                  <a:lnTo>
                    <a:pt x="2147" y="2"/>
                  </a:lnTo>
                  <a:lnTo>
                    <a:pt x="2148" y="2"/>
                  </a:lnTo>
                  <a:lnTo>
                    <a:pt x="2149" y="2"/>
                  </a:lnTo>
                  <a:lnTo>
                    <a:pt x="2150" y="2"/>
                  </a:lnTo>
                  <a:lnTo>
                    <a:pt x="2150" y="2"/>
                  </a:lnTo>
                  <a:lnTo>
                    <a:pt x="2151" y="2"/>
                  </a:lnTo>
                  <a:lnTo>
                    <a:pt x="2152" y="2"/>
                  </a:lnTo>
                  <a:lnTo>
                    <a:pt x="2153" y="2"/>
                  </a:lnTo>
                  <a:lnTo>
                    <a:pt x="2154" y="2"/>
                  </a:lnTo>
                  <a:lnTo>
                    <a:pt x="2155" y="1"/>
                  </a:lnTo>
                  <a:lnTo>
                    <a:pt x="2156" y="2"/>
                  </a:lnTo>
                  <a:lnTo>
                    <a:pt x="2157" y="2"/>
                  </a:lnTo>
                  <a:lnTo>
                    <a:pt x="2157" y="2"/>
                  </a:lnTo>
                  <a:lnTo>
                    <a:pt x="2158" y="2"/>
                  </a:lnTo>
                  <a:lnTo>
                    <a:pt x="2159" y="2"/>
                  </a:lnTo>
                  <a:lnTo>
                    <a:pt x="2160" y="3"/>
                  </a:lnTo>
                  <a:lnTo>
                    <a:pt x="2161" y="3"/>
                  </a:lnTo>
                  <a:lnTo>
                    <a:pt x="2162" y="3"/>
                  </a:lnTo>
                  <a:lnTo>
                    <a:pt x="2163" y="3"/>
                  </a:lnTo>
                  <a:lnTo>
                    <a:pt x="2164" y="3"/>
                  </a:lnTo>
                  <a:lnTo>
                    <a:pt x="2165" y="3"/>
                  </a:lnTo>
                  <a:lnTo>
                    <a:pt x="2165" y="3"/>
                  </a:lnTo>
                  <a:lnTo>
                    <a:pt x="2166" y="4"/>
                  </a:lnTo>
                  <a:lnTo>
                    <a:pt x="2167" y="4"/>
                  </a:lnTo>
                  <a:lnTo>
                    <a:pt x="2168" y="4"/>
                  </a:lnTo>
                  <a:lnTo>
                    <a:pt x="2169" y="3"/>
                  </a:lnTo>
                  <a:lnTo>
                    <a:pt x="2170" y="3"/>
                  </a:lnTo>
                  <a:lnTo>
                    <a:pt x="2171" y="3"/>
                  </a:lnTo>
                  <a:lnTo>
                    <a:pt x="2172" y="3"/>
                  </a:lnTo>
                  <a:lnTo>
                    <a:pt x="2172" y="2"/>
                  </a:lnTo>
                  <a:lnTo>
                    <a:pt x="2173" y="3"/>
                  </a:lnTo>
                  <a:lnTo>
                    <a:pt x="2174" y="3"/>
                  </a:lnTo>
                  <a:lnTo>
                    <a:pt x="2175" y="2"/>
                  </a:lnTo>
                  <a:lnTo>
                    <a:pt x="2176" y="3"/>
                  </a:lnTo>
                  <a:lnTo>
                    <a:pt x="2177" y="3"/>
                  </a:lnTo>
                  <a:lnTo>
                    <a:pt x="2178" y="2"/>
                  </a:lnTo>
                  <a:lnTo>
                    <a:pt x="2179" y="3"/>
                  </a:lnTo>
                  <a:lnTo>
                    <a:pt x="2180" y="3"/>
                  </a:lnTo>
                  <a:lnTo>
                    <a:pt x="2180" y="3"/>
                  </a:lnTo>
                  <a:lnTo>
                    <a:pt x="2181" y="2"/>
                  </a:lnTo>
                  <a:lnTo>
                    <a:pt x="2182" y="2"/>
                  </a:lnTo>
                  <a:lnTo>
                    <a:pt x="2183" y="2"/>
                  </a:lnTo>
                  <a:lnTo>
                    <a:pt x="2184" y="2"/>
                  </a:lnTo>
                  <a:lnTo>
                    <a:pt x="2185" y="2"/>
                  </a:lnTo>
                  <a:lnTo>
                    <a:pt x="2186" y="2"/>
                  </a:lnTo>
                  <a:lnTo>
                    <a:pt x="2187" y="2"/>
                  </a:lnTo>
                  <a:lnTo>
                    <a:pt x="2187" y="2"/>
                  </a:lnTo>
                  <a:lnTo>
                    <a:pt x="2188" y="3"/>
                  </a:lnTo>
                  <a:lnTo>
                    <a:pt x="2189" y="2"/>
                  </a:lnTo>
                  <a:lnTo>
                    <a:pt x="2190" y="3"/>
                  </a:lnTo>
                  <a:lnTo>
                    <a:pt x="2191" y="3"/>
                  </a:lnTo>
                  <a:lnTo>
                    <a:pt x="2192" y="3"/>
                  </a:lnTo>
                  <a:lnTo>
                    <a:pt x="2193" y="4"/>
                  </a:lnTo>
                  <a:lnTo>
                    <a:pt x="2194" y="4"/>
                  </a:lnTo>
                  <a:lnTo>
                    <a:pt x="2195" y="3"/>
                  </a:lnTo>
                  <a:lnTo>
                    <a:pt x="2195" y="3"/>
                  </a:lnTo>
                  <a:lnTo>
                    <a:pt x="2196" y="4"/>
                  </a:lnTo>
                  <a:lnTo>
                    <a:pt x="2197" y="4"/>
                  </a:lnTo>
                  <a:lnTo>
                    <a:pt x="2198" y="4"/>
                  </a:lnTo>
                  <a:lnTo>
                    <a:pt x="2199" y="4"/>
                  </a:lnTo>
                  <a:lnTo>
                    <a:pt x="2200" y="4"/>
                  </a:lnTo>
                  <a:lnTo>
                    <a:pt x="2201" y="3"/>
                  </a:lnTo>
                  <a:lnTo>
                    <a:pt x="2202" y="3"/>
                  </a:lnTo>
                  <a:lnTo>
                    <a:pt x="2202" y="4"/>
                  </a:lnTo>
                  <a:lnTo>
                    <a:pt x="2203" y="4"/>
                  </a:lnTo>
                  <a:lnTo>
                    <a:pt x="2204" y="4"/>
                  </a:lnTo>
                  <a:lnTo>
                    <a:pt x="2205" y="4"/>
                  </a:lnTo>
                  <a:lnTo>
                    <a:pt x="2206" y="3"/>
                  </a:lnTo>
                  <a:lnTo>
                    <a:pt x="2207" y="3"/>
                  </a:lnTo>
                  <a:lnTo>
                    <a:pt x="2208" y="4"/>
                  </a:lnTo>
                  <a:lnTo>
                    <a:pt x="2209" y="4"/>
                  </a:lnTo>
                  <a:lnTo>
                    <a:pt x="2210" y="4"/>
                  </a:lnTo>
                  <a:lnTo>
                    <a:pt x="2210" y="3"/>
                  </a:lnTo>
                  <a:lnTo>
                    <a:pt x="2211" y="3"/>
                  </a:lnTo>
                  <a:lnTo>
                    <a:pt x="2212" y="3"/>
                  </a:lnTo>
                  <a:lnTo>
                    <a:pt x="2213" y="2"/>
                  </a:lnTo>
                  <a:lnTo>
                    <a:pt x="2214" y="2"/>
                  </a:lnTo>
                  <a:lnTo>
                    <a:pt x="2215" y="2"/>
                  </a:lnTo>
                  <a:lnTo>
                    <a:pt x="2216" y="2"/>
                  </a:lnTo>
                  <a:lnTo>
                    <a:pt x="2217" y="2"/>
                  </a:lnTo>
                  <a:lnTo>
                    <a:pt x="2217" y="2"/>
                  </a:lnTo>
                  <a:lnTo>
                    <a:pt x="2218" y="2"/>
                  </a:lnTo>
                  <a:lnTo>
                    <a:pt x="2219" y="2"/>
                  </a:lnTo>
                  <a:lnTo>
                    <a:pt x="2220" y="2"/>
                  </a:lnTo>
                  <a:lnTo>
                    <a:pt x="2221" y="2"/>
                  </a:lnTo>
                  <a:lnTo>
                    <a:pt x="2222" y="2"/>
                  </a:lnTo>
                  <a:lnTo>
                    <a:pt x="2223" y="2"/>
                  </a:lnTo>
                  <a:lnTo>
                    <a:pt x="2224" y="2"/>
                  </a:lnTo>
                  <a:lnTo>
                    <a:pt x="2225" y="2"/>
                  </a:lnTo>
                  <a:lnTo>
                    <a:pt x="2225" y="1"/>
                  </a:lnTo>
                  <a:lnTo>
                    <a:pt x="2226" y="2"/>
                  </a:lnTo>
                  <a:lnTo>
                    <a:pt x="2227" y="2"/>
                  </a:lnTo>
                  <a:lnTo>
                    <a:pt x="2228" y="2"/>
                  </a:lnTo>
                  <a:lnTo>
                    <a:pt x="2229" y="2"/>
                  </a:lnTo>
                  <a:lnTo>
                    <a:pt x="2230" y="2"/>
                  </a:lnTo>
                  <a:lnTo>
                    <a:pt x="2231" y="2"/>
                  </a:lnTo>
                  <a:lnTo>
                    <a:pt x="2232" y="2"/>
                  </a:lnTo>
                  <a:lnTo>
                    <a:pt x="2232" y="3"/>
                  </a:lnTo>
                  <a:lnTo>
                    <a:pt x="2233" y="2"/>
                  </a:lnTo>
                  <a:lnTo>
                    <a:pt x="2234" y="3"/>
                  </a:lnTo>
                  <a:lnTo>
                    <a:pt x="2235" y="3"/>
                  </a:lnTo>
                  <a:lnTo>
                    <a:pt x="2236" y="3"/>
                  </a:lnTo>
                  <a:lnTo>
                    <a:pt x="2237" y="5"/>
                  </a:lnTo>
                  <a:lnTo>
                    <a:pt x="2238" y="4"/>
                  </a:lnTo>
                  <a:lnTo>
                    <a:pt x="2239" y="5"/>
                  </a:lnTo>
                  <a:lnTo>
                    <a:pt x="2240" y="4"/>
                  </a:lnTo>
                  <a:lnTo>
                    <a:pt x="2240" y="4"/>
                  </a:lnTo>
                  <a:lnTo>
                    <a:pt x="2241" y="4"/>
                  </a:lnTo>
                  <a:lnTo>
                    <a:pt x="2242" y="4"/>
                  </a:lnTo>
                  <a:lnTo>
                    <a:pt x="2243" y="3"/>
                  </a:lnTo>
                  <a:lnTo>
                    <a:pt x="2244" y="3"/>
                  </a:lnTo>
                  <a:lnTo>
                    <a:pt x="2245" y="3"/>
                  </a:lnTo>
                  <a:lnTo>
                    <a:pt x="2246" y="3"/>
                  </a:lnTo>
                  <a:lnTo>
                    <a:pt x="2247" y="3"/>
                  </a:lnTo>
                  <a:lnTo>
                    <a:pt x="2247" y="3"/>
                  </a:lnTo>
                  <a:lnTo>
                    <a:pt x="2248" y="2"/>
                  </a:lnTo>
                  <a:lnTo>
                    <a:pt x="2249" y="3"/>
                  </a:lnTo>
                  <a:lnTo>
                    <a:pt x="2250" y="3"/>
                  </a:lnTo>
                  <a:lnTo>
                    <a:pt x="2251" y="3"/>
                  </a:lnTo>
                  <a:lnTo>
                    <a:pt x="2252" y="3"/>
                  </a:lnTo>
                  <a:lnTo>
                    <a:pt x="2253" y="3"/>
                  </a:lnTo>
                  <a:lnTo>
                    <a:pt x="2254" y="2"/>
                  </a:lnTo>
                  <a:lnTo>
                    <a:pt x="2255" y="2"/>
                  </a:lnTo>
                  <a:lnTo>
                    <a:pt x="2255" y="2"/>
                  </a:lnTo>
                  <a:lnTo>
                    <a:pt x="2256" y="2"/>
                  </a:lnTo>
                  <a:lnTo>
                    <a:pt x="2257" y="2"/>
                  </a:lnTo>
                  <a:lnTo>
                    <a:pt x="2258" y="2"/>
                  </a:lnTo>
                  <a:lnTo>
                    <a:pt x="2259" y="2"/>
                  </a:lnTo>
                  <a:lnTo>
                    <a:pt x="2260" y="2"/>
                  </a:lnTo>
                  <a:lnTo>
                    <a:pt x="2261" y="1"/>
                  </a:lnTo>
                  <a:lnTo>
                    <a:pt x="2262" y="2"/>
                  </a:lnTo>
                  <a:lnTo>
                    <a:pt x="2262" y="2"/>
                  </a:lnTo>
                  <a:lnTo>
                    <a:pt x="2263" y="1"/>
                  </a:lnTo>
                  <a:lnTo>
                    <a:pt x="2264" y="2"/>
                  </a:lnTo>
                  <a:lnTo>
                    <a:pt x="2265" y="2"/>
                  </a:lnTo>
                  <a:lnTo>
                    <a:pt x="2266" y="2"/>
                  </a:lnTo>
                  <a:lnTo>
                    <a:pt x="2267" y="2"/>
                  </a:lnTo>
                  <a:lnTo>
                    <a:pt x="2268" y="2"/>
                  </a:lnTo>
                  <a:lnTo>
                    <a:pt x="2269" y="2"/>
                  </a:lnTo>
                  <a:lnTo>
                    <a:pt x="2270" y="2"/>
                  </a:lnTo>
                  <a:lnTo>
                    <a:pt x="2270" y="3"/>
                  </a:lnTo>
                  <a:lnTo>
                    <a:pt x="2271" y="3"/>
                  </a:lnTo>
                  <a:lnTo>
                    <a:pt x="2272" y="3"/>
                  </a:lnTo>
                  <a:lnTo>
                    <a:pt x="2273" y="2"/>
                  </a:lnTo>
                  <a:lnTo>
                    <a:pt x="2274" y="3"/>
                  </a:lnTo>
                  <a:lnTo>
                    <a:pt x="2275" y="2"/>
                  </a:lnTo>
                  <a:lnTo>
                    <a:pt x="2276" y="3"/>
                  </a:lnTo>
                  <a:lnTo>
                    <a:pt x="2277" y="3"/>
                  </a:lnTo>
                  <a:lnTo>
                    <a:pt x="2277" y="2"/>
                  </a:lnTo>
                  <a:lnTo>
                    <a:pt x="2278" y="2"/>
                  </a:lnTo>
                  <a:lnTo>
                    <a:pt x="2279" y="2"/>
                  </a:lnTo>
                  <a:lnTo>
                    <a:pt x="2280" y="3"/>
                  </a:lnTo>
                  <a:lnTo>
                    <a:pt x="2281" y="5"/>
                  </a:lnTo>
                  <a:lnTo>
                    <a:pt x="2282" y="8"/>
                  </a:lnTo>
                  <a:lnTo>
                    <a:pt x="2283" y="14"/>
                  </a:lnTo>
                  <a:lnTo>
                    <a:pt x="2284" y="27"/>
                  </a:lnTo>
                  <a:lnTo>
                    <a:pt x="2285" y="43"/>
                  </a:lnTo>
                  <a:lnTo>
                    <a:pt x="2285" y="79"/>
                  </a:lnTo>
                  <a:lnTo>
                    <a:pt x="2286" y="125"/>
                  </a:lnTo>
                  <a:lnTo>
                    <a:pt x="2287" y="196"/>
                  </a:lnTo>
                  <a:lnTo>
                    <a:pt x="2288" y="293"/>
                  </a:lnTo>
                  <a:lnTo>
                    <a:pt x="2289" y="420"/>
                  </a:lnTo>
                  <a:lnTo>
                    <a:pt x="2290" y="570"/>
                  </a:lnTo>
                  <a:lnTo>
                    <a:pt x="2291" y="758"/>
                  </a:lnTo>
                  <a:lnTo>
                    <a:pt x="2292" y="973"/>
                  </a:lnTo>
                  <a:lnTo>
                    <a:pt x="2292" y="1176"/>
                  </a:lnTo>
                  <a:lnTo>
                    <a:pt x="2293" y="1391"/>
                  </a:lnTo>
                  <a:lnTo>
                    <a:pt x="2294" y="1572"/>
                  </a:lnTo>
                  <a:lnTo>
                    <a:pt x="2295" y="1706"/>
                  </a:lnTo>
                  <a:lnTo>
                    <a:pt x="2296" y="1761"/>
                  </a:lnTo>
                  <a:lnTo>
                    <a:pt x="2297" y="1752"/>
                  </a:lnTo>
                  <a:lnTo>
                    <a:pt x="2298" y="1608"/>
                  </a:lnTo>
                  <a:lnTo>
                    <a:pt x="2299" y="1373"/>
                  </a:lnTo>
                  <a:lnTo>
                    <a:pt x="2300" y="1117"/>
                  </a:lnTo>
                  <a:lnTo>
                    <a:pt x="2300" y="831"/>
                  </a:lnTo>
                  <a:lnTo>
                    <a:pt x="2301" y="614"/>
                  </a:lnTo>
                  <a:lnTo>
                    <a:pt x="2302" y="462"/>
                  </a:lnTo>
                  <a:lnTo>
                    <a:pt x="2303" y="333"/>
                  </a:lnTo>
                  <a:lnTo>
                    <a:pt x="2304" y="258"/>
                  </a:lnTo>
                  <a:lnTo>
                    <a:pt x="2305" y="205"/>
                  </a:lnTo>
                  <a:lnTo>
                    <a:pt x="2306" y="168"/>
                  </a:lnTo>
                  <a:lnTo>
                    <a:pt x="2307" y="144"/>
                  </a:lnTo>
                  <a:lnTo>
                    <a:pt x="2307" y="128"/>
                  </a:lnTo>
                  <a:lnTo>
                    <a:pt x="2308" y="117"/>
                  </a:lnTo>
                  <a:lnTo>
                    <a:pt x="2309" y="109"/>
                  </a:lnTo>
                  <a:lnTo>
                    <a:pt x="2310" y="100"/>
                  </a:lnTo>
                  <a:lnTo>
                    <a:pt x="2311" y="92"/>
                  </a:lnTo>
                  <a:lnTo>
                    <a:pt x="2312" y="89"/>
                  </a:lnTo>
                  <a:lnTo>
                    <a:pt x="2313" y="80"/>
                  </a:lnTo>
                  <a:lnTo>
                    <a:pt x="2314" y="79"/>
                  </a:lnTo>
                  <a:lnTo>
                    <a:pt x="2315" y="73"/>
                  </a:lnTo>
                  <a:lnTo>
                    <a:pt x="2315" y="70"/>
                  </a:lnTo>
                  <a:lnTo>
                    <a:pt x="2316" y="66"/>
                  </a:lnTo>
                  <a:lnTo>
                    <a:pt x="2317" y="63"/>
                  </a:lnTo>
                  <a:lnTo>
                    <a:pt x="2318" y="62"/>
                  </a:lnTo>
                  <a:lnTo>
                    <a:pt x="2319" y="56"/>
                  </a:lnTo>
                  <a:lnTo>
                    <a:pt x="2320" y="54"/>
                  </a:lnTo>
                  <a:lnTo>
                    <a:pt x="2321" y="50"/>
                  </a:lnTo>
                  <a:lnTo>
                    <a:pt x="2322" y="52"/>
                  </a:lnTo>
                  <a:lnTo>
                    <a:pt x="2322" y="47"/>
                  </a:lnTo>
                  <a:lnTo>
                    <a:pt x="2323" y="43"/>
                  </a:lnTo>
                  <a:lnTo>
                    <a:pt x="2324" y="43"/>
                  </a:lnTo>
                  <a:lnTo>
                    <a:pt x="2325" y="40"/>
                  </a:lnTo>
                  <a:lnTo>
                    <a:pt x="2326" y="37"/>
                  </a:lnTo>
                  <a:lnTo>
                    <a:pt x="2327" y="37"/>
                  </a:lnTo>
                  <a:lnTo>
                    <a:pt x="2328" y="36"/>
                  </a:lnTo>
                  <a:lnTo>
                    <a:pt x="2329" y="33"/>
                  </a:lnTo>
                  <a:lnTo>
                    <a:pt x="2330" y="32"/>
                  </a:lnTo>
                  <a:lnTo>
                    <a:pt x="2330" y="31"/>
                  </a:lnTo>
                  <a:lnTo>
                    <a:pt x="2331" y="30"/>
                  </a:lnTo>
                  <a:lnTo>
                    <a:pt x="2332" y="30"/>
                  </a:lnTo>
                  <a:lnTo>
                    <a:pt x="2333" y="29"/>
                  </a:lnTo>
                  <a:lnTo>
                    <a:pt x="2334" y="29"/>
                  </a:lnTo>
                  <a:lnTo>
                    <a:pt x="2335" y="27"/>
                  </a:lnTo>
                  <a:lnTo>
                    <a:pt x="2336" y="26"/>
                  </a:lnTo>
                  <a:lnTo>
                    <a:pt x="2337" y="26"/>
                  </a:lnTo>
                  <a:lnTo>
                    <a:pt x="2337" y="26"/>
                  </a:lnTo>
                  <a:lnTo>
                    <a:pt x="2338" y="24"/>
                  </a:lnTo>
                  <a:lnTo>
                    <a:pt x="2339" y="23"/>
                  </a:lnTo>
                  <a:lnTo>
                    <a:pt x="2340" y="23"/>
                  </a:lnTo>
                  <a:lnTo>
                    <a:pt x="2341" y="22"/>
                  </a:lnTo>
                  <a:lnTo>
                    <a:pt x="2342" y="22"/>
                  </a:lnTo>
                  <a:lnTo>
                    <a:pt x="2343" y="20"/>
                  </a:lnTo>
                  <a:lnTo>
                    <a:pt x="2344" y="19"/>
                  </a:lnTo>
                  <a:lnTo>
                    <a:pt x="2344" y="20"/>
                  </a:lnTo>
                  <a:lnTo>
                    <a:pt x="2345" y="20"/>
                  </a:lnTo>
                  <a:lnTo>
                    <a:pt x="2346" y="19"/>
                  </a:lnTo>
                  <a:lnTo>
                    <a:pt x="2347" y="18"/>
                  </a:lnTo>
                  <a:lnTo>
                    <a:pt x="2348" y="17"/>
                  </a:lnTo>
                  <a:lnTo>
                    <a:pt x="2349" y="16"/>
                  </a:lnTo>
                  <a:lnTo>
                    <a:pt x="2350" y="15"/>
                  </a:lnTo>
                  <a:lnTo>
                    <a:pt x="2351" y="16"/>
                  </a:lnTo>
                  <a:lnTo>
                    <a:pt x="2352" y="15"/>
                  </a:lnTo>
                  <a:lnTo>
                    <a:pt x="2352" y="16"/>
                  </a:lnTo>
                  <a:lnTo>
                    <a:pt x="2353" y="15"/>
                  </a:lnTo>
                  <a:lnTo>
                    <a:pt x="2354" y="14"/>
                  </a:lnTo>
                  <a:lnTo>
                    <a:pt x="2355" y="14"/>
                  </a:lnTo>
                  <a:lnTo>
                    <a:pt x="2356" y="15"/>
                  </a:lnTo>
                  <a:lnTo>
                    <a:pt x="2357" y="14"/>
                  </a:lnTo>
                  <a:lnTo>
                    <a:pt x="2358" y="13"/>
                  </a:lnTo>
                  <a:lnTo>
                    <a:pt x="2359" y="14"/>
                  </a:lnTo>
                  <a:lnTo>
                    <a:pt x="2359" y="13"/>
                  </a:lnTo>
                  <a:lnTo>
                    <a:pt x="2360" y="13"/>
                  </a:lnTo>
                  <a:lnTo>
                    <a:pt x="2361" y="13"/>
                  </a:lnTo>
                  <a:lnTo>
                    <a:pt x="2362" y="12"/>
                  </a:lnTo>
                  <a:lnTo>
                    <a:pt x="2363" y="11"/>
                  </a:lnTo>
                  <a:lnTo>
                    <a:pt x="2364" y="12"/>
                  </a:lnTo>
                  <a:lnTo>
                    <a:pt x="2365" y="12"/>
                  </a:lnTo>
                  <a:lnTo>
                    <a:pt x="2366" y="11"/>
                  </a:lnTo>
                  <a:lnTo>
                    <a:pt x="2367" y="11"/>
                  </a:lnTo>
                  <a:lnTo>
                    <a:pt x="2367" y="11"/>
                  </a:lnTo>
                  <a:lnTo>
                    <a:pt x="2368" y="11"/>
                  </a:lnTo>
                  <a:lnTo>
                    <a:pt x="2369" y="10"/>
                  </a:lnTo>
                  <a:lnTo>
                    <a:pt x="2370" y="10"/>
                  </a:lnTo>
                  <a:lnTo>
                    <a:pt x="2371" y="11"/>
                  </a:lnTo>
                  <a:lnTo>
                    <a:pt x="2372" y="11"/>
                  </a:lnTo>
                  <a:lnTo>
                    <a:pt x="2373" y="13"/>
                  </a:lnTo>
                  <a:lnTo>
                    <a:pt x="2374" y="13"/>
                  </a:lnTo>
                  <a:lnTo>
                    <a:pt x="2374" y="14"/>
                  </a:lnTo>
                  <a:lnTo>
                    <a:pt x="2375" y="14"/>
                  </a:lnTo>
                  <a:lnTo>
                    <a:pt x="2376" y="14"/>
                  </a:lnTo>
                  <a:lnTo>
                    <a:pt x="2377" y="14"/>
                  </a:lnTo>
                  <a:lnTo>
                    <a:pt x="2378" y="15"/>
                  </a:lnTo>
                  <a:lnTo>
                    <a:pt x="2379" y="14"/>
                  </a:lnTo>
                  <a:lnTo>
                    <a:pt x="2380" y="14"/>
                  </a:lnTo>
                  <a:lnTo>
                    <a:pt x="2381" y="13"/>
                  </a:lnTo>
                  <a:lnTo>
                    <a:pt x="2382" y="12"/>
                  </a:lnTo>
                  <a:lnTo>
                    <a:pt x="2382" y="11"/>
                  </a:lnTo>
                  <a:lnTo>
                    <a:pt x="2383" y="10"/>
                  </a:lnTo>
                  <a:lnTo>
                    <a:pt x="2384" y="10"/>
                  </a:lnTo>
                  <a:lnTo>
                    <a:pt x="2385" y="9"/>
                  </a:lnTo>
                  <a:lnTo>
                    <a:pt x="2386" y="9"/>
                  </a:lnTo>
                  <a:lnTo>
                    <a:pt x="2387" y="9"/>
                  </a:lnTo>
                  <a:lnTo>
                    <a:pt x="2388" y="8"/>
                  </a:lnTo>
                  <a:lnTo>
                    <a:pt x="2389" y="7"/>
                  </a:lnTo>
                  <a:lnTo>
                    <a:pt x="2389" y="7"/>
                  </a:lnTo>
                  <a:lnTo>
                    <a:pt x="2390" y="7"/>
                  </a:lnTo>
                  <a:lnTo>
                    <a:pt x="2391" y="7"/>
                  </a:lnTo>
                  <a:lnTo>
                    <a:pt x="2392" y="8"/>
                  </a:lnTo>
                  <a:lnTo>
                    <a:pt x="2393" y="8"/>
                  </a:lnTo>
                  <a:lnTo>
                    <a:pt x="2394" y="8"/>
                  </a:lnTo>
                  <a:lnTo>
                    <a:pt x="2395" y="7"/>
                  </a:lnTo>
                  <a:lnTo>
                    <a:pt x="2396" y="7"/>
                  </a:lnTo>
                  <a:lnTo>
                    <a:pt x="2397" y="8"/>
                  </a:lnTo>
                  <a:lnTo>
                    <a:pt x="2397" y="8"/>
                  </a:lnTo>
                  <a:lnTo>
                    <a:pt x="2398" y="9"/>
                  </a:lnTo>
                  <a:lnTo>
                    <a:pt x="2399" y="11"/>
                  </a:lnTo>
                  <a:lnTo>
                    <a:pt x="2400" y="10"/>
                  </a:lnTo>
                  <a:lnTo>
                    <a:pt x="2401" y="9"/>
                  </a:lnTo>
                  <a:lnTo>
                    <a:pt x="2402" y="11"/>
                  </a:lnTo>
                  <a:lnTo>
                    <a:pt x="2403" y="10"/>
                  </a:lnTo>
                  <a:lnTo>
                    <a:pt x="2404" y="10"/>
                  </a:lnTo>
                  <a:lnTo>
                    <a:pt x="2404" y="10"/>
                  </a:lnTo>
                  <a:lnTo>
                    <a:pt x="2405" y="10"/>
                  </a:lnTo>
                  <a:lnTo>
                    <a:pt x="2406" y="9"/>
                  </a:lnTo>
                  <a:lnTo>
                    <a:pt x="2407" y="8"/>
                  </a:lnTo>
                  <a:lnTo>
                    <a:pt x="2408" y="7"/>
                  </a:lnTo>
                  <a:lnTo>
                    <a:pt x="2409" y="7"/>
                  </a:lnTo>
                  <a:lnTo>
                    <a:pt x="2410" y="7"/>
                  </a:lnTo>
                  <a:lnTo>
                    <a:pt x="2411" y="6"/>
                  </a:lnTo>
                  <a:lnTo>
                    <a:pt x="2412" y="6"/>
                  </a:lnTo>
                  <a:lnTo>
                    <a:pt x="2412" y="5"/>
                  </a:lnTo>
                  <a:lnTo>
                    <a:pt x="2413" y="5"/>
                  </a:lnTo>
                  <a:lnTo>
                    <a:pt x="2414" y="5"/>
                  </a:lnTo>
                  <a:lnTo>
                    <a:pt x="2415" y="4"/>
                  </a:lnTo>
                  <a:lnTo>
                    <a:pt x="2416" y="5"/>
                  </a:lnTo>
                  <a:lnTo>
                    <a:pt x="2417" y="5"/>
                  </a:lnTo>
                  <a:lnTo>
                    <a:pt x="2418" y="6"/>
                  </a:lnTo>
                  <a:lnTo>
                    <a:pt x="2419" y="6"/>
                  </a:lnTo>
                  <a:lnTo>
                    <a:pt x="2419" y="5"/>
                  </a:lnTo>
                  <a:lnTo>
                    <a:pt x="2420" y="5"/>
                  </a:lnTo>
                  <a:lnTo>
                    <a:pt x="2421" y="5"/>
                  </a:lnTo>
                  <a:lnTo>
                    <a:pt x="2422" y="6"/>
                  </a:lnTo>
                  <a:lnTo>
                    <a:pt x="2423" y="5"/>
                  </a:lnTo>
                  <a:lnTo>
                    <a:pt x="2424" y="6"/>
                  </a:lnTo>
                  <a:lnTo>
                    <a:pt x="2425" y="7"/>
                  </a:lnTo>
                  <a:lnTo>
                    <a:pt x="2426" y="6"/>
                  </a:lnTo>
                  <a:lnTo>
                    <a:pt x="2427" y="7"/>
                  </a:lnTo>
                  <a:lnTo>
                    <a:pt x="2427" y="6"/>
                  </a:lnTo>
                  <a:lnTo>
                    <a:pt x="2428" y="6"/>
                  </a:lnTo>
                  <a:lnTo>
                    <a:pt x="2429" y="6"/>
                  </a:lnTo>
                  <a:lnTo>
                    <a:pt x="2430" y="6"/>
                  </a:lnTo>
                  <a:lnTo>
                    <a:pt x="2431" y="6"/>
                  </a:lnTo>
                  <a:lnTo>
                    <a:pt x="2432" y="6"/>
                  </a:lnTo>
                  <a:lnTo>
                    <a:pt x="2433" y="5"/>
                  </a:lnTo>
                  <a:lnTo>
                    <a:pt x="2434" y="5"/>
                  </a:lnTo>
                  <a:lnTo>
                    <a:pt x="2434" y="5"/>
                  </a:lnTo>
                  <a:lnTo>
                    <a:pt x="2435" y="6"/>
                  </a:lnTo>
                  <a:lnTo>
                    <a:pt x="2436" y="5"/>
                  </a:lnTo>
                  <a:lnTo>
                    <a:pt x="2437" y="6"/>
                  </a:lnTo>
                  <a:lnTo>
                    <a:pt x="2438" y="4"/>
                  </a:lnTo>
                  <a:lnTo>
                    <a:pt x="2439" y="4"/>
                  </a:lnTo>
                  <a:lnTo>
                    <a:pt x="2440" y="4"/>
                  </a:lnTo>
                  <a:lnTo>
                    <a:pt x="2441" y="5"/>
                  </a:lnTo>
                  <a:lnTo>
                    <a:pt x="2442" y="4"/>
                  </a:lnTo>
                  <a:lnTo>
                    <a:pt x="2442" y="4"/>
                  </a:lnTo>
                  <a:lnTo>
                    <a:pt x="2443" y="4"/>
                  </a:lnTo>
                  <a:lnTo>
                    <a:pt x="2444" y="4"/>
                  </a:lnTo>
                  <a:lnTo>
                    <a:pt x="2445" y="4"/>
                  </a:lnTo>
                  <a:lnTo>
                    <a:pt x="2446" y="4"/>
                  </a:lnTo>
                  <a:lnTo>
                    <a:pt x="2447" y="4"/>
                  </a:lnTo>
                  <a:lnTo>
                    <a:pt x="2448" y="3"/>
                  </a:lnTo>
                  <a:lnTo>
                    <a:pt x="2449" y="4"/>
                  </a:lnTo>
                  <a:lnTo>
                    <a:pt x="2449" y="4"/>
                  </a:lnTo>
                  <a:lnTo>
                    <a:pt x="2450" y="5"/>
                  </a:lnTo>
                  <a:lnTo>
                    <a:pt x="2451" y="4"/>
                  </a:lnTo>
                  <a:lnTo>
                    <a:pt x="2452" y="4"/>
                  </a:lnTo>
                  <a:lnTo>
                    <a:pt x="2453" y="4"/>
                  </a:lnTo>
                  <a:lnTo>
                    <a:pt x="2454" y="5"/>
                  </a:lnTo>
                  <a:lnTo>
                    <a:pt x="2455" y="4"/>
                  </a:lnTo>
                  <a:lnTo>
                    <a:pt x="2456" y="5"/>
                  </a:lnTo>
                  <a:lnTo>
                    <a:pt x="2457" y="6"/>
                  </a:lnTo>
                  <a:lnTo>
                    <a:pt x="2457" y="7"/>
                  </a:lnTo>
                  <a:lnTo>
                    <a:pt x="2458" y="6"/>
                  </a:lnTo>
                  <a:lnTo>
                    <a:pt x="2459" y="8"/>
                  </a:lnTo>
                  <a:lnTo>
                    <a:pt x="2460" y="9"/>
                  </a:lnTo>
                  <a:lnTo>
                    <a:pt x="2461" y="9"/>
                  </a:lnTo>
                  <a:lnTo>
                    <a:pt x="2462" y="10"/>
                  </a:lnTo>
                  <a:lnTo>
                    <a:pt x="2463" y="10"/>
                  </a:lnTo>
                  <a:lnTo>
                    <a:pt x="2464" y="10"/>
                  </a:lnTo>
                  <a:lnTo>
                    <a:pt x="2464" y="9"/>
                  </a:lnTo>
                  <a:lnTo>
                    <a:pt x="2465" y="9"/>
                  </a:lnTo>
                  <a:lnTo>
                    <a:pt x="2466" y="7"/>
                  </a:lnTo>
                  <a:lnTo>
                    <a:pt x="2467" y="7"/>
                  </a:lnTo>
                  <a:lnTo>
                    <a:pt x="2468" y="7"/>
                  </a:lnTo>
                  <a:lnTo>
                    <a:pt x="2469" y="5"/>
                  </a:lnTo>
                  <a:lnTo>
                    <a:pt x="2470" y="6"/>
                  </a:lnTo>
                  <a:lnTo>
                    <a:pt x="2471" y="5"/>
                  </a:lnTo>
                  <a:lnTo>
                    <a:pt x="2472" y="4"/>
                  </a:lnTo>
                  <a:lnTo>
                    <a:pt x="2472" y="5"/>
                  </a:lnTo>
                  <a:lnTo>
                    <a:pt x="2473" y="5"/>
                  </a:lnTo>
                  <a:lnTo>
                    <a:pt x="2474" y="4"/>
                  </a:lnTo>
                  <a:lnTo>
                    <a:pt x="2475" y="4"/>
                  </a:lnTo>
                  <a:lnTo>
                    <a:pt x="2476" y="4"/>
                  </a:lnTo>
                  <a:lnTo>
                    <a:pt x="2477" y="5"/>
                  </a:lnTo>
                  <a:lnTo>
                    <a:pt x="2478" y="5"/>
                  </a:lnTo>
                  <a:lnTo>
                    <a:pt x="2479" y="4"/>
                  </a:lnTo>
                  <a:lnTo>
                    <a:pt x="2479" y="4"/>
                  </a:lnTo>
                  <a:lnTo>
                    <a:pt x="2480" y="3"/>
                  </a:lnTo>
                  <a:lnTo>
                    <a:pt x="2481" y="3"/>
                  </a:lnTo>
                  <a:lnTo>
                    <a:pt x="2482" y="4"/>
                  </a:lnTo>
                  <a:lnTo>
                    <a:pt x="2483" y="3"/>
                  </a:lnTo>
                  <a:lnTo>
                    <a:pt x="2484" y="3"/>
                  </a:lnTo>
                  <a:lnTo>
                    <a:pt x="2485" y="3"/>
                  </a:lnTo>
                  <a:lnTo>
                    <a:pt x="2486" y="3"/>
                  </a:lnTo>
                  <a:lnTo>
                    <a:pt x="2487" y="4"/>
                  </a:lnTo>
                  <a:lnTo>
                    <a:pt x="2487" y="3"/>
                  </a:lnTo>
                  <a:lnTo>
                    <a:pt x="2488" y="3"/>
                  </a:lnTo>
                  <a:lnTo>
                    <a:pt x="2489" y="2"/>
                  </a:lnTo>
                  <a:lnTo>
                    <a:pt x="2490" y="3"/>
                  </a:lnTo>
                  <a:lnTo>
                    <a:pt x="2491" y="4"/>
                  </a:lnTo>
                  <a:lnTo>
                    <a:pt x="2492" y="3"/>
                  </a:lnTo>
                  <a:lnTo>
                    <a:pt x="2493" y="4"/>
                  </a:lnTo>
                  <a:lnTo>
                    <a:pt x="2494" y="5"/>
                  </a:lnTo>
                  <a:lnTo>
                    <a:pt x="2494" y="8"/>
                  </a:lnTo>
                  <a:lnTo>
                    <a:pt x="2495" y="11"/>
                  </a:lnTo>
                  <a:lnTo>
                    <a:pt x="2496" y="15"/>
                  </a:lnTo>
                  <a:lnTo>
                    <a:pt x="2497" y="21"/>
                  </a:lnTo>
                  <a:lnTo>
                    <a:pt x="2498" y="25"/>
                  </a:lnTo>
                  <a:lnTo>
                    <a:pt x="2499" y="31"/>
                  </a:lnTo>
                  <a:lnTo>
                    <a:pt x="2500" y="38"/>
                  </a:lnTo>
                  <a:lnTo>
                    <a:pt x="2501" y="43"/>
                  </a:lnTo>
                  <a:lnTo>
                    <a:pt x="2502" y="45"/>
                  </a:lnTo>
                  <a:lnTo>
                    <a:pt x="2502" y="47"/>
                  </a:lnTo>
                  <a:lnTo>
                    <a:pt x="2503" y="46"/>
                  </a:lnTo>
                  <a:lnTo>
                    <a:pt x="2504" y="42"/>
                  </a:lnTo>
                  <a:lnTo>
                    <a:pt x="2505" y="38"/>
                  </a:lnTo>
                  <a:lnTo>
                    <a:pt x="2506" y="32"/>
                  </a:lnTo>
                  <a:lnTo>
                    <a:pt x="2507" y="27"/>
                  </a:lnTo>
                  <a:lnTo>
                    <a:pt x="2508" y="23"/>
                  </a:lnTo>
                  <a:lnTo>
                    <a:pt x="2509" y="19"/>
                  </a:lnTo>
                  <a:lnTo>
                    <a:pt x="2509" y="17"/>
                  </a:lnTo>
                  <a:lnTo>
                    <a:pt x="2510" y="15"/>
                  </a:lnTo>
                  <a:lnTo>
                    <a:pt x="2511" y="14"/>
                  </a:lnTo>
                  <a:lnTo>
                    <a:pt x="2512" y="13"/>
                  </a:lnTo>
                  <a:lnTo>
                    <a:pt x="2513" y="11"/>
                  </a:lnTo>
                  <a:lnTo>
                    <a:pt x="2514" y="11"/>
                  </a:lnTo>
                  <a:lnTo>
                    <a:pt x="2515" y="11"/>
                  </a:lnTo>
                  <a:lnTo>
                    <a:pt x="2516" y="11"/>
                  </a:lnTo>
                  <a:lnTo>
                    <a:pt x="2517" y="11"/>
                  </a:lnTo>
                  <a:lnTo>
                    <a:pt x="2517" y="10"/>
                  </a:lnTo>
                  <a:lnTo>
                    <a:pt x="2518" y="10"/>
                  </a:lnTo>
                  <a:lnTo>
                    <a:pt x="2519" y="10"/>
                  </a:lnTo>
                  <a:lnTo>
                    <a:pt x="2520" y="9"/>
                  </a:lnTo>
                  <a:lnTo>
                    <a:pt x="2521" y="9"/>
                  </a:lnTo>
                  <a:lnTo>
                    <a:pt x="2522" y="8"/>
                  </a:lnTo>
                  <a:lnTo>
                    <a:pt x="2523" y="8"/>
                  </a:lnTo>
                  <a:lnTo>
                    <a:pt x="2524" y="8"/>
                  </a:lnTo>
                  <a:lnTo>
                    <a:pt x="2524" y="8"/>
                  </a:lnTo>
                  <a:lnTo>
                    <a:pt x="2525" y="8"/>
                  </a:lnTo>
                  <a:lnTo>
                    <a:pt x="2526" y="8"/>
                  </a:lnTo>
                  <a:lnTo>
                    <a:pt x="2527" y="8"/>
                  </a:lnTo>
                  <a:lnTo>
                    <a:pt x="2528" y="7"/>
                  </a:lnTo>
                  <a:lnTo>
                    <a:pt x="2529" y="7"/>
                  </a:lnTo>
                  <a:lnTo>
                    <a:pt x="2530" y="6"/>
                  </a:lnTo>
                  <a:lnTo>
                    <a:pt x="2531" y="7"/>
                  </a:lnTo>
                  <a:lnTo>
                    <a:pt x="2531" y="6"/>
                  </a:lnTo>
                  <a:lnTo>
                    <a:pt x="2532" y="6"/>
                  </a:lnTo>
                  <a:lnTo>
                    <a:pt x="2533" y="5"/>
                  </a:lnTo>
                  <a:lnTo>
                    <a:pt x="2534" y="6"/>
                  </a:lnTo>
                  <a:lnTo>
                    <a:pt x="2535" y="6"/>
                  </a:lnTo>
                  <a:lnTo>
                    <a:pt x="2536" y="6"/>
                  </a:lnTo>
                  <a:lnTo>
                    <a:pt x="2537" y="5"/>
                  </a:lnTo>
                  <a:lnTo>
                    <a:pt x="2538" y="5"/>
                  </a:lnTo>
                  <a:lnTo>
                    <a:pt x="2539" y="5"/>
                  </a:lnTo>
                  <a:lnTo>
                    <a:pt x="2539" y="4"/>
                  </a:lnTo>
                  <a:lnTo>
                    <a:pt x="2540" y="5"/>
                  </a:lnTo>
                  <a:lnTo>
                    <a:pt x="2541" y="5"/>
                  </a:lnTo>
                  <a:lnTo>
                    <a:pt x="2542" y="4"/>
                  </a:lnTo>
                  <a:lnTo>
                    <a:pt x="2543" y="5"/>
                  </a:lnTo>
                  <a:lnTo>
                    <a:pt x="2544" y="5"/>
                  </a:lnTo>
                  <a:lnTo>
                    <a:pt x="2545" y="4"/>
                  </a:lnTo>
                  <a:lnTo>
                    <a:pt x="2546" y="4"/>
                  </a:lnTo>
                  <a:lnTo>
                    <a:pt x="2546" y="4"/>
                  </a:lnTo>
                  <a:lnTo>
                    <a:pt x="2547" y="5"/>
                  </a:lnTo>
                  <a:lnTo>
                    <a:pt x="2548" y="4"/>
                  </a:lnTo>
                  <a:lnTo>
                    <a:pt x="2549" y="4"/>
                  </a:lnTo>
                  <a:lnTo>
                    <a:pt x="2550" y="4"/>
                  </a:lnTo>
                  <a:lnTo>
                    <a:pt x="2551" y="4"/>
                  </a:lnTo>
                  <a:lnTo>
                    <a:pt x="2552" y="3"/>
                  </a:lnTo>
                  <a:lnTo>
                    <a:pt x="2553" y="4"/>
                  </a:lnTo>
                  <a:lnTo>
                    <a:pt x="2554" y="4"/>
                  </a:lnTo>
                  <a:lnTo>
                    <a:pt x="2554" y="3"/>
                  </a:lnTo>
                  <a:lnTo>
                    <a:pt x="2555" y="3"/>
                  </a:lnTo>
                  <a:lnTo>
                    <a:pt x="2556" y="4"/>
                  </a:lnTo>
                  <a:lnTo>
                    <a:pt x="2557" y="4"/>
                  </a:lnTo>
                  <a:lnTo>
                    <a:pt x="2558" y="4"/>
                  </a:lnTo>
                  <a:lnTo>
                    <a:pt x="2559" y="5"/>
                  </a:lnTo>
                  <a:lnTo>
                    <a:pt x="2560" y="4"/>
                  </a:lnTo>
                  <a:lnTo>
                    <a:pt x="2561" y="3"/>
                  </a:lnTo>
                  <a:lnTo>
                    <a:pt x="2561" y="5"/>
                  </a:lnTo>
                  <a:lnTo>
                    <a:pt x="2562" y="5"/>
                  </a:lnTo>
                  <a:lnTo>
                    <a:pt x="2563" y="5"/>
                  </a:lnTo>
                  <a:lnTo>
                    <a:pt x="2564" y="5"/>
                  </a:lnTo>
                  <a:lnTo>
                    <a:pt x="2565" y="6"/>
                  </a:lnTo>
                  <a:lnTo>
                    <a:pt x="2566" y="5"/>
                  </a:lnTo>
                  <a:lnTo>
                    <a:pt x="2567" y="6"/>
                  </a:lnTo>
                  <a:lnTo>
                    <a:pt x="2568" y="5"/>
                  </a:lnTo>
                  <a:lnTo>
                    <a:pt x="2569" y="6"/>
                  </a:lnTo>
                  <a:lnTo>
                    <a:pt x="2569" y="6"/>
                  </a:lnTo>
                  <a:lnTo>
                    <a:pt x="2570" y="6"/>
                  </a:lnTo>
                  <a:lnTo>
                    <a:pt x="2571" y="6"/>
                  </a:lnTo>
                  <a:lnTo>
                    <a:pt x="2572" y="5"/>
                  </a:lnTo>
                  <a:lnTo>
                    <a:pt x="2573" y="5"/>
                  </a:lnTo>
                  <a:lnTo>
                    <a:pt x="2574" y="6"/>
                  </a:lnTo>
                  <a:lnTo>
                    <a:pt x="2575" y="5"/>
                  </a:lnTo>
                  <a:lnTo>
                    <a:pt x="2576" y="5"/>
                  </a:lnTo>
                  <a:lnTo>
                    <a:pt x="2576" y="5"/>
                  </a:lnTo>
                  <a:lnTo>
                    <a:pt x="2577" y="5"/>
                  </a:lnTo>
                  <a:lnTo>
                    <a:pt x="2578" y="4"/>
                  </a:lnTo>
                  <a:lnTo>
                    <a:pt x="2579" y="5"/>
                  </a:lnTo>
                  <a:lnTo>
                    <a:pt x="2580" y="5"/>
                  </a:lnTo>
                  <a:lnTo>
                    <a:pt x="2581" y="4"/>
                  </a:lnTo>
                  <a:lnTo>
                    <a:pt x="2582" y="5"/>
                  </a:lnTo>
                  <a:lnTo>
                    <a:pt x="2583" y="5"/>
                  </a:lnTo>
                  <a:lnTo>
                    <a:pt x="2584" y="5"/>
                  </a:lnTo>
                  <a:lnTo>
                    <a:pt x="2584" y="4"/>
                  </a:lnTo>
                  <a:lnTo>
                    <a:pt x="2585" y="4"/>
                  </a:lnTo>
                  <a:lnTo>
                    <a:pt x="2586" y="4"/>
                  </a:lnTo>
                  <a:lnTo>
                    <a:pt x="2587" y="4"/>
                  </a:lnTo>
                  <a:lnTo>
                    <a:pt x="2588" y="4"/>
                  </a:lnTo>
                  <a:lnTo>
                    <a:pt x="2589" y="4"/>
                  </a:lnTo>
                  <a:lnTo>
                    <a:pt x="2590" y="3"/>
                  </a:lnTo>
                  <a:lnTo>
                    <a:pt x="2591" y="4"/>
                  </a:lnTo>
                  <a:lnTo>
                    <a:pt x="2591" y="4"/>
                  </a:lnTo>
                  <a:lnTo>
                    <a:pt x="2592" y="3"/>
                  </a:lnTo>
                  <a:lnTo>
                    <a:pt x="2593" y="5"/>
                  </a:lnTo>
                  <a:lnTo>
                    <a:pt x="2594" y="4"/>
                  </a:lnTo>
                  <a:lnTo>
                    <a:pt x="2595" y="4"/>
                  </a:lnTo>
                  <a:lnTo>
                    <a:pt x="2596" y="3"/>
                  </a:lnTo>
                  <a:lnTo>
                    <a:pt x="2597" y="4"/>
                  </a:lnTo>
                  <a:lnTo>
                    <a:pt x="2598" y="3"/>
                  </a:lnTo>
                  <a:lnTo>
                    <a:pt x="2599" y="5"/>
                  </a:lnTo>
                  <a:lnTo>
                    <a:pt x="2599" y="4"/>
                  </a:lnTo>
                  <a:lnTo>
                    <a:pt x="2600" y="3"/>
                  </a:lnTo>
                  <a:lnTo>
                    <a:pt x="2601" y="4"/>
                  </a:lnTo>
                  <a:lnTo>
                    <a:pt x="2602" y="4"/>
                  </a:lnTo>
                  <a:lnTo>
                    <a:pt x="2603" y="4"/>
                  </a:lnTo>
                  <a:lnTo>
                    <a:pt x="2604" y="4"/>
                  </a:lnTo>
                  <a:lnTo>
                    <a:pt x="2605" y="3"/>
                  </a:lnTo>
                  <a:lnTo>
                    <a:pt x="2606" y="4"/>
                  </a:lnTo>
                  <a:lnTo>
                    <a:pt x="2606" y="4"/>
                  </a:lnTo>
                  <a:lnTo>
                    <a:pt x="2607" y="4"/>
                  </a:lnTo>
                  <a:lnTo>
                    <a:pt x="2608" y="4"/>
                  </a:lnTo>
                  <a:lnTo>
                    <a:pt x="2609" y="4"/>
                  </a:lnTo>
                  <a:lnTo>
                    <a:pt x="2610" y="3"/>
                  </a:lnTo>
                  <a:lnTo>
                    <a:pt x="2611" y="4"/>
                  </a:lnTo>
                  <a:lnTo>
                    <a:pt x="2612" y="4"/>
                  </a:lnTo>
                  <a:lnTo>
                    <a:pt x="2613" y="4"/>
                  </a:lnTo>
                  <a:lnTo>
                    <a:pt x="2614" y="4"/>
                  </a:lnTo>
                  <a:lnTo>
                    <a:pt x="2614" y="4"/>
                  </a:lnTo>
                  <a:lnTo>
                    <a:pt x="2615" y="4"/>
                  </a:lnTo>
                  <a:lnTo>
                    <a:pt x="2616" y="4"/>
                  </a:lnTo>
                  <a:lnTo>
                    <a:pt x="2617" y="3"/>
                  </a:lnTo>
                  <a:lnTo>
                    <a:pt x="2618" y="3"/>
                  </a:lnTo>
                  <a:lnTo>
                    <a:pt x="2619" y="3"/>
                  </a:lnTo>
                  <a:lnTo>
                    <a:pt x="2620" y="3"/>
                  </a:lnTo>
                  <a:lnTo>
                    <a:pt x="2621" y="3"/>
                  </a:lnTo>
                  <a:lnTo>
                    <a:pt x="2621" y="3"/>
                  </a:lnTo>
                  <a:lnTo>
                    <a:pt x="2622" y="3"/>
                  </a:lnTo>
                  <a:lnTo>
                    <a:pt x="2623" y="4"/>
                  </a:lnTo>
                  <a:lnTo>
                    <a:pt x="2624" y="3"/>
                  </a:lnTo>
                  <a:lnTo>
                    <a:pt x="2625" y="2"/>
                  </a:lnTo>
                  <a:lnTo>
                    <a:pt x="2626" y="3"/>
                  </a:lnTo>
                  <a:lnTo>
                    <a:pt x="2627" y="3"/>
                  </a:lnTo>
                  <a:lnTo>
                    <a:pt x="2628" y="3"/>
                  </a:lnTo>
                  <a:lnTo>
                    <a:pt x="2629" y="3"/>
                  </a:lnTo>
                  <a:lnTo>
                    <a:pt x="2629" y="3"/>
                  </a:lnTo>
                  <a:lnTo>
                    <a:pt x="2630" y="4"/>
                  </a:lnTo>
                  <a:lnTo>
                    <a:pt x="2631" y="3"/>
                  </a:lnTo>
                  <a:lnTo>
                    <a:pt x="2632" y="2"/>
                  </a:lnTo>
                  <a:lnTo>
                    <a:pt x="2633" y="3"/>
                  </a:lnTo>
                  <a:lnTo>
                    <a:pt x="2634" y="3"/>
                  </a:lnTo>
                  <a:lnTo>
                    <a:pt x="2635" y="2"/>
                  </a:lnTo>
                  <a:lnTo>
                    <a:pt x="2636" y="3"/>
                  </a:lnTo>
                  <a:lnTo>
                    <a:pt x="2636" y="2"/>
                  </a:lnTo>
                  <a:lnTo>
                    <a:pt x="2637" y="3"/>
                  </a:lnTo>
                  <a:lnTo>
                    <a:pt x="2638" y="2"/>
                  </a:lnTo>
                  <a:lnTo>
                    <a:pt x="2639" y="3"/>
                  </a:lnTo>
                  <a:lnTo>
                    <a:pt x="2640" y="3"/>
                  </a:lnTo>
                  <a:lnTo>
                    <a:pt x="2641" y="3"/>
                  </a:lnTo>
                  <a:lnTo>
                    <a:pt x="2642" y="3"/>
                  </a:lnTo>
                  <a:lnTo>
                    <a:pt x="2643" y="3"/>
                  </a:lnTo>
                  <a:lnTo>
                    <a:pt x="2644" y="3"/>
                  </a:lnTo>
                  <a:lnTo>
                    <a:pt x="2644" y="4"/>
                  </a:lnTo>
                  <a:lnTo>
                    <a:pt x="2645" y="3"/>
                  </a:lnTo>
                  <a:lnTo>
                    <a:pt x="2646" y="2"/>
                  </a:lnTo>
                  <a:lnTo>
                    <a:pt x="2647" y="3"/>
                  </a:lnTo>
                  <a:lnTo>
                    <a:pt x="2648" y="3"/>
                  </a:lnTo>
                  <a:lnTo>
                    <a:pt x="2649" y="3"/>
                  </a:lnTo>
                  <a:lnTo>
                    <a:pt x="2650" y="3"/>
                  </a:lnTo>
                  <a:lnTo>
                    <a:pt x="2651" y="4"/>
                  </a:lnTo>
                  <a:lnTo>
                    <a:pt x="2651" y="3"/>
                  </a:lnTo>
                  <a:lnTo>
                    <a:pt x="2652" y="2"/>
                  </a:lnTo>
                  <a:lnTo>
                    <a:pt x="2653" y="2"/>
                  </a:lnTo>
                  <a:lnTo>
                    <a:pt x="2654" y="2"/>
                  </a:lnTo>
                  <a:lnTo>
                    <a:pt x="2655" y="3"/>
                  </a:lnTo>
                  <a:lnTo>
                    <a:pt x="2656" y="3"/>
                  </a:lnTo>
                  <a:lnTo>
                    <a:pt x="2657" y="2"/>
                  </a:lnTo>
                  <a:lnTo>
                    <a:pt x="2658" y="2"/>
                  </a:lnTo>
                  <a:lnTo>
                    <a:pt x="2659" y="2"/>
                  </a:lnTo>
                  <a:lnTo>
                    <a:pt x="2659" y="3"/>
                  </a:lnTo>
                  <a:lnTo>
                    <a:pt x="2660" y="2"/>
                  </a:lnTo>
                  <a:lnTo>
                    <a:pt x="2661" y="2"/>
                  </a:lnTo>
                  <a:lnTo>
                    <a:pt x="2662" y="2"/>
                  </a:lnTo>
                  <a:lnTo>
                    <a:pt x="2663" y="3"/>
                  </a:lnTo>
                  <a:lnTo>
                    <a:pt x="2664" y="2"/>
                  </a:lnTo>
                  <a:lnTo>
                    <a:pt x="2665" y="2"/>
                  </a:lnTo>
                  <a:lnTo>
                    <a:pt x="2666" y="2"/>
                  </a:lnTo>
                  <a:lnTo>
                    <a:pt x="2666" y="3"/>
                  </a:lnTo>
                  <a:lnTo>
                    <a:pt x="2667" y="2"/>
                  </a:lnTo>
                  <a:lnTo>
                    <a:pt x="2668" y="3"/>
                  </a:lnTo>
                  <a:lnTo>
                    <a:pt x="2669" y="3"/>
                  </a:lnTo>
                  <a:lnTo>
                    <a:pt x="2670" y="2"/>
                  </a:lnTo>
                  <a:lnTo>
                    <a:pt x="2671" y="2"/>
                  </a:lnTo>
                  <a:lnTo>
                    <a:pt x="2672" y="2"/>
                  </a:lnTo>
                  <a:lnTo>
                    <a:pt x="2673" y="3"/>
                  </a:lnTo>
                  <a:lnTo>
                    <a:pt x="2674" y="3"/>
                  </a:lnTo>
                  <a:lnTo>
                    <a:pt x="2674" y="2"/>
                  </a:lnTo>
                  <a:lnTo>
                    <a:pt x="2675" y="3"/>
                  </a:lnTo>
                  <a:lnTo>
                    <a:pt x="2676" y="2"/>
                  </a:lnTo>
                  <a:lnTo>
                    <a:pt x="2677" y="3"/>
                  </a:lnTo>
                  <a:lnTo>
                    <a:pt x="2678" y="3"/>
                  </a:lnTo>
                  <a:lnTo>
                    <a:pt x="2679" y="3"/>
                  </a:lnTo>
                  <a:lnTo>
                    <a:pt x="2680" y="3"/>
                  </a:lnTo>
                  <a:lnTo>
                    <a:pt x="2681" y="2"/>
                  </a:lnTo>
                  <a:lnTo>
                    <a:pt x="2681" y="2"/>
                  </a:lnTo>
                  <a:lnTo>
                    <a:pt x="2682" y="2"/>
                  </a:lnTo>
                  <a:lnTo>
                    <a:pt x="2683" y="3"/>
                  </a:lnTo>
                  <a:lnTo>
                    <a:pt x="2684" y="2"/>
                  </a:lnTo>
                  <a:lnTo>
                    <a:pt x="2685" y="2"/>
                  </a:lnTo>
                  <a:lnTo>
                    <a:pt x="2686" y="2"/>
                  </a:lnTo>
                  <a:lnTo>
                    <a:pt x="2687" y="3"/>
                  </a:lnTo>
                  <a:lnTo>
                    <a:pt x="2688" y="3"/>
                  </a:lnTo>
                  <a:lnTo>
                    <a:pt x="2689" y="2"/>
                  </a:lnTo>
                  <a:lnTo>
                    <a:pt x="2689" y="2"/>
                  </a:lnTo>
                  <a:lnTo>
                    <a:pt x="2690" y="2"/>
                  </a:lnTo>
                  <a:lnTo>
                    <a:pt x="2691" y="2"/>
                  </a:lnTo>
                  <a:lnTo>
                    <a:pt x="2692" y="2"/>
                  </a:lnTo>
                  <a:lnTo>
                    <a:pt x="2693" y="2"/>
                  </a:lnTo>
                  <a:lnTo>
                    <a:pt x="2694" y="2"/>
                  </a:lnTo>
                  <a:lnTo>
                    <a:pt x="2695" y="2"/>
                  </a:lnTo>
                  <a:lnTo>
                    <a:pt x="2696" y="2"/>
                  </a:lnTo>
                  <a:lnTo>
                    <a:pt x="2696" y="2"/>
                  </a:lnTo>
                  <a:lnTo>
                    <a:pt x="2697" y="3"/>
                  </a:lnTo>
                  <a:lnTo>
                    <a:pt x="2698" y="2"/>
                  </a:lnTo>
                  <a:lnTo>
                    <a:pt x="2699" y="3"/>
                  </a:lnTo>
                  <a:lnTo>
                    <a:pt x="2700" y="2"/>
                  </a:lnTo>
                  <a:lnTo>
                    <a:pt x="2701" y="2"/>
                  </a:lnTo>
                  <a:lnTo>
                    <a:pt x="2702" y="2"/>
                  </a:lnTo>
                  <a:lnTo>
                    <a:pt x="2703" y="3"/>
                  </a:lnTo>
                  <a:lnTo>
                    <a:pt x="2704" y="2"/>
                  </a:lnTo>
                  <a:lnTo>
                    <a:pt x="2704" y="2"/>
                  </a:lnTo>
                  <a:lnTo>
                    <a:pt x="2705" y="2"/>
                  </a:lnTo>
                  <a:lnTo>
                    <a:pt x="2706" y="2"/>
                  </a:lnTo>
                  <a:lnTo>
                    <a:pt x="2707" y="3"/>
                  </a:lnTo>
                  <a:lnTo>
                    <a:pt x="2708" y="3"/>
                  </a:lnTo>
                  <a:lnTo>
                    <a:pt x="2709" y="3"/>
                  </a:lnTo>
                  <a:lnTo>
                    <a:pt x="2710" y="3"/>
                  </a:lnTo>
                  <a:lnTo>
                    <a:pt x="2711" y="3"/>
                  </a:lnTo>
                  <a:lnTo>
                    <a:pt x="2711" y="2"/>
                  </a:lnTo>
                  <a:lnTo>
                    <a:pt x="2712" y="2"/>
                  </a:lnTo>
                  <a:lnTo>
                    <a:pt x="2713" y="2"/>
                  </a:lnTo>
                  <a:lnTo>
                    <a:pt x="2714" y="2"/>
                  </a:lnTo>
                  <a:lnTo>
                    <a:pt x="2715" y="2"/>
                  </a:lnTo>
                  <a:lnTo>
                    <a:pt x="2716" y="2"/>
                  </a:lnTo>
                  <a:lnTo>
                    <a:pt x="2717" y="2"/>
                  </a:lnTo>
                  <a:lnTo>
                    <a:pt x="2718" y="2"/>
                  </a:lnTo>
                  <a:lnTo>
                    <a:pt x="2719" y="2"/>
                  </a:lnTo>
                  <a:lnTo>
                    <a:pt x="2719" y="2"/>
                  </a:lnTo>
                  <a:lnTo>
                    <a:pt x="2720" y="1"/>
                  </a:lnTo>
                  <a:lnTo>
                    <a:pt x="2721" y="2"/>
                  </a:lnTo>
                  <a:lnTo>
                    <a:pt x="2722" y="2"/>
                  </a:lnTo>
                  <a:lnTo>
                    <a:pt x="2723" y="2"/>
                  </a:lnTo>
                  <a:lnTo>
                    <a:pt x="2724" y="2"/>
                  </a:lnTo>
                  <a:lnTo>
                    <a:pt x="2725" y="2"/>
                  </a:lnTo>
                  <a:lnTo>
                    <a:pt x="2726" y="2"/>
                  </a:lnTo>
                  <a:lnTo>
                    <a:pt x="2726" y="2"/>
                  </a:lnTo>
                  <a:lnTo>
                    <a:pt x="2727" y="2"/>
                  </a:lnTo>
                  <a:lnTo>
                    <a:pt x="2728" y="2"/>
                  </a:lnTo>
                  <a:lnTo>
                    <a:pt x="2729" y="2"/>
                  </a:lnTo>
                  <a:lnTo>
                    <a:pt x="2730" y="2"/>
                  </a:lnTo>
                  <a:lnTo>
                    <a:pt x="2731" y="2"/>
                  </a:lnTo>
                  <a:lnTo>
                    <a:pt x="2732" y="2"/>
                  </a:lnTo>
                  <a:lnTo>
                    <a:pt x="2733" y="1"/>
                  </a:lnTo>
                  <a:lnTo>
                    <a:pt x="2733" y="1"/>
                  </a:lnTo>
                  <a:lnTo>
                    <a:pt x="2734" y="2"/>
                  </a:lnTo>
                  <a:lnTo>
                    <a:pt x="2735" y="2"/>
                  </a:lnTo>
                  <a:lnTo>
                    <a:pt x="2736" y="2"/>
                  </a:lnTo>
                  <a:lnTo>
                    <a:pt x="2737" y="2"/>
                  </a:lnTo>
                  <a:lnTo>
                    <a:pt x="2738" y="1"/>
                  </a:lnTo>
                  <a:lnTo>
                    <a:pt x="2739" y="1"/>
                  </a:lnTo>
                  <a:lnTo>
                    <a:pt x="2740" y="1"/>
                  </a:lnTo>
                  <a:lnTo>
                    <a:pt x="2741" y="2"/>
                  </a:lnTo>
                  <a:lnTo>
                    <a:pt x="2741" y="2"/>
                  </a:lnTo>
                  <a:lnTo>
                    <a:pt x="2742" y="2"/>
                  </a:lnTo>
                  <a:lnTo>
                    <a:pt x="2743" y="2"/>
                  </a:lnTo>
                  <a:lnTo>
                    <a:pt x="2744" y="2"/>
                  </a:lnTo>
                  <a:lnTo>
                    <a:pt x="2745" y="1"/>
                  </a:lnTo>
                  <a:lnTo>
                    <a:pt x="2746" y="2"/>
                  </a:lnTo>
                  <a:lnTo>
                    <a:pt x="2747" y="2"/>
                  </a:lnTo>
                  <a:lnTo>
                    <a:pt x="2748" y="3"/>
                  </a:lnTo>
                  <a:lnTo>
                    <a:pt x="2748" y="3"/>
                  </a:lnTo>
                  <a:lnTo>
                    <a:pt x="2749" y="3"/>
                  </a:lnTo>
                  <a:lnTo>
                    <a:pt x="2750" y="3"/>
                  </a:lnTo>
                  <a:lnTo>
                    <a:pt x="2751" y="4"/>
                  </a:lnTo>
                  <a:lnTo>
                    <a:pt x="2752" y="4"/>
                  </a:lnTo>
                  <a:lnTo>
                    <a:pt x="2753" y="3"/>
                  </a:lnTo>
                  <a:lnTo>
                    <a:pt x="2754" y="3"/>
                  </a:lnTo>
                  <a:lnTo>
                    <a:pt x="2755" y="3"/>
                  </a:lnTo>
                  <a:lnTo>
                    <a:pt x="2756" y="2"/>
                  </a:lnTo>
                  <a:lnTo>
                    <a:pt x="2756" y="2"/>
                  </a:lnTo>
                  <a:lnTo>
                    <a:pt x="2757" y="2"/>
                  </a:lnTo>
                  <a:lnTo>
                    <a:pt x="2758" y="2"/>
                  </a:lnTo>
                  <a:lnTo>
                    <a:pt x="2759" y="2"/>
                  </a:lnTo>
                  <a:lnTo>
                    <a:pt x="2760" y="2"/>
                  </a:lnTo>
                  <a:lnTo>
                    <a:pt x="2761" y="2"/>
                  </a:lnTo>
                  <a:lnTo>
                    <a:pt x="2762" y="2"/>
                  </a:lnTo>
                  <a:lnTo>
                    <a:pt x="2763" y="2"/>
                  </a:lnTo>
                  <a:lnTo>
                    <a:pt x="2763" y="2"/>
                  </a:lnTo>
                  <a:lnTo>
                    <a:pt x="2764" y="2"/>
                  </a:lnTo>
                  <a:lnTo>
                    <a:pt x="2765" y="2"/>
                  </a:lnTo>
                  <a:lnTo>
                    <a:pt x="2766" y="1"/>
                  </a:lnTo>
                  <a:lnTo>
                    <a:pt x="2767" y="2"/>
                  </a:lnTo>
                  <a:lnTo>
                    <a:pt x="2768" y="1"/>
                  </a:lnTo>
                  <a:lnTo>
                    <a:pt x="2769" y="1"/>
                  </a:lnTo>
                  <a:lnTo>
                    <a:pt x="2770" y="2"/>
                  </a:lnTo>
                  <a:lnTo>
                    <a:pt x="2771" y="2"/>
                  </a:lnTo>
                  <a:lnTo>
                    <a:pt x="2771" y="2"/>
                  </a:lnTo>
                  <a:lnTo>
                    <a:pt x="2772" y="2"/>
                  </a:lnTo>
                  <a:lnTo>
                    <a:pt x="2773" y="2"/>
                  </a:lnTo>
                  <a:lnTo>
                    <a:pt x="2774" y="2"/>
                  </a:lnTo>
                  <a:lnTo>
                    <a:pt x="2775" y="3"/>
                  </a:lnTo>
                  <a:lnTo>
                    <a:pt x="2776" y="2"/>
                  </a:lnTo>
                  <a:lnTo>
                    <a:pt x="2777" y="2"/>
                  </a:lnTo>
                  <a:lnTo>
                    <a:pt x="2778" y="2"/>
                  </a:lnTo>
                  <a:lnTo>
                    <a:pt x="2778" y="2"/>
                  </a:lnTo>
                  <a:lnTo>
                    <a:pt x="2779" y="2"/>
                  </a:lnTo>
                  <a:lnTo>
                    <a:pt x="2780" y="1"/>
                  </a:lnTo>
                  <a:lnTo>
                    <a:pt x="2781" y="2"/>
                  </a:lnTo>
                  <a:lnTo>
                    <a:pt x="2782" y="2"/>
                  </a:lnTo>
                  <a:lnTo>
                    <a:pt x="2783" y="2"/>
                  </a:lnTo>
                  <a:lnTo>
                    <a:pt x="2784" y="1"/>
                  </a:lnTo>
                  <a:lnTo>
                    <a:pt x="2785" y="1"/>
                  </a:lnTo>
                  <a:lnTo>
                    <a:pt x="2786" y="2"/>
                  </a:lnTo>
                  <a:lnTo>
                    <a:pt x="2786" y="2"/>
                  </a:lnTo>
                  <a:lnTo>
                    <a:pt x="2787" y="2"/>
                  </a:lnTo>
                  <a:lnTo>
                    <a:pt x="2788" y="2"/>
                  </a:lnTo>
                  <a:lnTo>
                    <a:pt x="2789" y="2"/>
                  </a:lnTo>
                  <a:lnTo>
                    <a:pt x="2790" y="1"/>
                  </a:lnTo>
                  <a:lnTo>
                    <a:pt x="2791" y="2"/>
                  </a:lnTo>
                  <a:lnTo>
                    <a:pt x="2792" y="2"/>
                  </a:lnTo>
                  <a:lnTo>
                    <a:pt x="2793" y="2"/>
                  </a:lnTo>
                  <a:lnTo>
                    <a:pt x="2793" y="2"/>
                  </a:lnTo>
                  <a:lnTo>
                    <a:pt x="2794" y="2"/>
                  </a:lnTo>
                  <a:lnTo>
                    <a:pt x="2795" y="2"/>
                  </a:lnTo>
                  <a:lnTo>
                    <a:pt x="2796" y="2"/>
                  </a:lnTo>
                  <a:lnTo>
                    <a:pt x="2797" y="2"/>
                  </a:lnTo>
                  <a:lnTo>
                    <a:pt x="2798" y="1"/>
                  </a:lnTo>
                  <a:lnTo>
                    <a:pt x="2799" y="2"/>
                  </a:lnTo>
                  <a:lnTo>
                    <a:pt x="2800" y="2"/>
                  </a:lnTo>
                  <a:lnTo>
                    <a:pt x="2801" y="1"/>
                  </a:lnTo>
                  <a:lnTo>
                    <a:pt x="2801" y="1"/>
                  </a:lnTo>
                  <a:lnTo>
                    <a:pt x="2802" y="2"/>
                  </a:lnTo>
                  <a:lnTo>
                    <a:pt x="2803" y="2"/>
                  </a:lnTo>
                  <a:lnTo>
                    <a:pt x="2804" y="2"/>
                  </a:lnTo>
                  <a:lnTo>
                    <a:pt x="2805" y="2"/>
                  </a:lnTo>
                  <a:lnTo>
                    <a:pt x="2806" y="2"/>
                  </a:lnTo>
                  <a:lnTo>
                    <a:pt x="2807" y="1"/>
                  </a:lnTo>
                  <a:lnTo>
                    <a:pt x="2808" y="2"/>
                  </a:lnTo>
                  <a:lnTo>
                    <a:pt x="2808" y="1"/>
                  </a:lnTo>
                  <a:lnTo>
                    <a:pt x="2809" y="2"/>
                  </a:lnTo>
                  <a:lnTo>
                    <a:pt x="2810" y="2"/>
                  </a:lnTo>
                  <a:lnTo>
                    <a:pt x="2811" y="1"/>
                  </a:lnTo>
                  <a:lnTo>
                    <a:pt x="2812" y="2"/>
                  </a:lnTo>
                  <a:lnTo>
                    <a:pt x="2813" y="2"/>
                  </a:lnTo>
                  <a:lnTo>
                    <a:pt x="2814" y="2"/>
                  </a:lnTo>
                  <a:lnTo>
                    <a:pt x="2815" y="1"/>
                  </a:lnTo>
                  <a:lnTo>
                    <a:pt x="2816" y="2"/>
                  </a:lnTo>
                  <a:lnTo>
                    <a:pt x="2816" y="1"/>
                  </a:lnTo>
                  <a:lnTo>
                    <a:pt x="2817" y="1"/>
                  </a:lnTo>
                  <a:lnTo>
                    <a:pt x="2818" y="1"/>
                  </a:lnTo>
                  <a:lnTo>
                    <a:pt x="2819" y="1"/>
                  </a:lnTo>
                  <a:lnTo>
                    <a:pt x="2820" y="1"/>
                  </a:lnTo>
                  <a:lnTo>
                    <a:pt x="2821" y="1"/>
                  </a:lnTo>
                  <a:lnTo>
                    <a:pt x="2822" y="2"/>
                  </a:lnTo>
                  <a:lnTo>
                    <a:pt x="2823" y="1"/>
                  </a:lnTo>
                  <a:lnTo>
                    <a:pt x="2823" y="1"/>
                  </a:lnTo>
                  <a:lnTo>
                    <a:pt x="2824" y="1"/>
                  </a:lnTo>
                  <a:lnTo>
                    <a:pt x="2825" y="2"/>
                  </a:lnTo>
                  <a:lnTo>
                    <a:pt x="2826" y="1"/>
                  </a:lnTo>
                  <a:lnTo>
                    <a:pt x="2827" y="2"/>
                  </a:lnTo>
                  <a:lnTo>
                    <a:pt x="2828" y="1"/>
                  </a:lnTo>
                  <a:lnTo>
                    <a:pt x="2829" y="1"/>
                  </a:lnTo>
                  <a:lnTo>
                    <a:pt x="2830" y="2"/>
                  </a:lnTo>
                  <a:lnTo>
                    <a:pt x="2831" y="2"/>
                  </a:lnTo>
                  <a:lnTo>
                    <a:pt x="2831" y="2"/>
                  </a:lnTo>
                  <a:lnTo>
                    <a:pt x="2832" y="2"/>
                  </a:lnTo>
                  <a:lnTo>
                    <a:pt x="2833" y="2"/>
                  </a:lnTo>
                  <a:lnTo>
                    <a:pt x="2834" y="2"/>
                  </a:lnTo>
                  <a:lnTo>
                    <a:pt x="2835" y="3"/>
                  </a:lnTo>
                  <a:lnTo>
                    <a:pt x="2836" y="2"/>
                  </a:lnTo>
                  <a:lnTo>
                    <a:pt x="2837" y="2"/>
                  </a:lnTo>
                  <a:lnTo>
                    <a:pt x="2838" y="2"/>
                  </a:lnTo>
                  <a:lnTo>
                    <a:pt x="2838" y="2"/>
                  </a:lnTo>
                  <a:lnTo>
                    <a:pt x="2839" y="2"/>
                  </a:lnTo>
                  <a:lnTo>
                    <a:pt x="2840" y="1"/>
                  </a:lnTo>
                  <a:lnTo>
                    <a:pt x="2841" y="1"/>
                  </a:lnTo>
                  <a:lnTo>
                    <a:pt x="2842" y="2"/>
                  </a:lnTo>
                  <a:lnTo>
                    <a:pt x="2843" y="2"/>
                  </a:lnTo>
                  <a:lnTo>
                    <a:pt x="2844" y="2"/>
                  </a:lnTo>
                  <a:lnTo>
                    <a:pt x="2845" y="2"/>
                  </a:lnTo>
                  <a:lnTo>
                    <a:pt x="2846" y="1"/>
                  </a:lnTo>
                  <a:lnTo>
                    <a:pt x="2846" y="2"/>
                  </a:lnTo>
                  <a:lnTo>
                    <a:pt x="2847" y="1"/>
                  </a:lnTo>
                  <a:lnTo>
                    <a:pt x="2848" y="1"/>
                  </a:lnTo>
                  <a:lnTo>
                    <a:pt x="2849" y="2"/>
                  </a:lnTo>
                  <a:lnTo>
                    <a:pt x="2850" y="2"/>
                  </a:lnTo>
                  <a:lnTo>
                    <a:pt x="2851" y="2"/>
                  </a:lnTo>
                  <a:lnTo>
                    <a:pt x="2852" y="1"/>
                  </a:lnTo>
                  <a:lnTo>
                    <a:pt x="2853" y="1"/>
                  </a:lnTo>
                  <a:lnTo>
                    <a:pt x="2853" y="1"/>
                  </a:lnTo>
                  <a:lnTo>
                    <a:pt x="2854" y="1"/>
                  </a:lnTo>
                  <a:lnTo>
                    <a:pt x="2855" y="2"/>
                  </a:lnTo>
                  <a:lnTo>
                    <a:pt x="2856" y="1"/>
                  </a:lnTo>
                  <a:lnTo>
                    <a:pt x="2857" y="1"/>
                  </a:lnTo>
                  <a:lnTo>
                    <a:pt x="2858" y="1"/>
                  </a:lnTo>
                  <a:lnTo>
                    <a:pt x="2859" y="1"/>
                  </a:lnTo>
                  <a:lnTo>
                    <a:pt x="2860" y="1"/>
                  </a:lnTo>
                  <a:lnTo>
                    <a:pt x="2861" y="1"/>
                  </a:lnTo>
                  <a:lnTo>
                    <a:pt x="2861" y="1"/>
                  </a:lnTo>
                  <a:lnTo>
                    <a:pt x="2862" y="1"/>
                  </a:lnTo>
                  <a:lnTo>
                    <a:pt x="2863" y="1"/>
                  </a:lnTo>
                  <a:lnTo>
                    <a:pt x="2864" y="2"/>
                  </a:lnTo>
                  <a:lnTo>
                    <a:pt x="2865" y="1"/>
                  </a:lnTo>
                  <a:lnTo>
                    <a:pt x="2866" y="1"/>
                  </a:lnTo>
                  <a:lnTo>
                    <a:pt x="2867" y="1"/>
                  </a:lnTo>
                  <a:lnTo>
                    <a:pt x="2868" y="1"/>
                  </a:lnTo>
                  <a:lnTo>
                    <a:pt x="2868" y="1"/>
                  </a:lnTo>
                  <a:lnTo>
                    <a:pt x="2869" y="2"/>
                  </a:lnTo>
                  <a:lnTo>
                    <a:pt x="2870" y="1"/>
                  </a:lnTo>
                  <a:lnTo>
                    <a:pt x="2871" y="1"/>
                  </a:lnTo>
                  <a:lnTo>
                    <a:pt x="2872" y="1"/>
                  </a:lnTo>
                  <a:lnTo>
                    <a:pt x="2873" y="1"/>
                  </a:lnTo>
                  <a:lnTo>
                    <a:pt x="2874" y="1"/>
                  </a:lnTo>
                  <a:lnTo>
                    <a:pt x="2875" y="1"/>
                  </a:lnTo>
                  <a:lnTo>
                    <a:pt x="2876" y="1"/>
                  </a:lnTo>
                  <a:lnTo>
                    <a:pt x="2876" y="1"/>
                  </a:lnTo>
                  <a:lnTo>
                    <a:pt x="2877" y="1"/>
                  </a:lnTo>
                  <a:lnTo>
                    <a:pt x="2878" y="1"/>
                  </a:lnTo>
                  <a:lnTo>
                    <a:pt x="2879" y="1"/>
                  </a:lnTo>
                  <a:lnTo>
                    <a:pt x="2880" y="1"/>
                  </a:lnTo>
                  <a:lnTo>
                    <a:pt x="2881" y="1"/>
                  </a:lnTo>
                  <a:lnTo>
                    <a:pt x="2882" y="2"/>
                  </a:lnTo>
                  <a:lnTo>
                    <a:pt x="2883" y="1"/>
                  </a:lnTo>
                  <a:lnTo>
                    <a:pt x="2883" y="1"/>
                  </a:lnTo>
                  <a:lnTo>
                    <a:pt x="2884" y="1"/>
                  </a:lnTo>
                  <a:lnTo>
                    <a:pt x="2885" y="1"/>
                  </a:lnTo>
                  <a:lnTo>
                    <a:pt x="2886" y="1"/>
                  </a:lnTo>
                  <a:lnTo>
                    <a:pt x="2887" y="2"/>
                  </a:lnTo>
                  <a:lnTo>
                    <a:pt x="2888" y="1"/>
                  </a:lnTo>
                  <a:lnTo>
                    <a:pt x="2889" y="2"/>
                  </a:lnTo>
                  <a:lnTo>
                    <a:pt x="2890" y="1"/>
                  </a:lnTo>
                  <a:lnTo>
                    <a:pt x="2891" y="2"/>
                  </a:lnTo>
                  <a:lnTo>
                    <a:pt x="2891" y="2"/>
                  </a:lnTo>
                  <a:lnTo>
                    <a:pt x="2892" y="1"/>
                  </a:lnTo>
                  <a:lnTo>
                    <a:pt x="2893" y="1"/>
                  </a:lnTo>
                  <a:lnTo>
                    <a:pt x="2894" y="1"/>
                  </a:lnTo>
                  <a:lnTo>
                    <a:pt x="2895" y="2"/>
                  </a:lnTo>
                  <a:lnTo>
                    <a:pt x="2896" y="2"/>
                  </a:lnTo>
                  <a:lnTo>
                    <a:pt x="2897" y="2"/>
                  </a:lnTo>
                  <a:lnTo>
                    <a:pt x="2898" y="1"/>
                  </a:lnTo>
                  <a:lnTo>
                    <a:pt x="2898" y="1"/>
                  </a:lnTo>
                  <a:lnTo>
                    <a:pt x="2899" y="1"/>
                  </a:lnTo>
                  <a:lnTo>
                    <a:pt x="2900" y="1"/>
                  </a:lnTo>
                  <a:lnTo>
                    <a:pt x="2901" y="1"/>
                  </a:lnTo>
                  <a:lnTo>
                    <a:pt x="2902" y="1"/>
                  </a:lnTo>
                  <a:lnTo>
                    <a:pt x="2903" y="2"/>
                  </a:lnTo>
                  <a:lnTo>
                    <a:pt x="2904" y="1"/>
                  </a:lnTo>
                  <a:lnTo>
                    <a:pt x="2905" y="2"/>
                  </a:lnTo>
                  <a:lnTo>
                    <a:pt x="2906" y="1"/>
                  </a:lnTo>
                  <a:lnTo>
                    <a:pt x="2906" y="2"/>
                  </a:lnTo>
                  <a:lnTo>
                    <a:pt x="2907" y="2"/>
                  </a:lnTo>
                  <a:lnTo>
                    <a:pt x="2908" y="2"/>
                  </a:lnTo>
                  <a:lnTo>
                    <a:pt x="2909" y="2"/>
                  </a:lnTo>
                  <a:lnTo>
                    <a:pt x="2910" y="1"/>
                  </a:lnTo>
                  <a:lnTo>
                    <a:pt x="2911" y="2"/>
                  </a:lnTo>
                  <a:lnTo>
                    <a:pt x="2912" y="1"/>
                  </a:lnTo>
                  <a:lnTo>
                    <a:pt x="2913" y="1"/>
                  </a:lnTo>
                  <a:lnTo>
                    <a:pt x="2913" y="1"/>
                  </a:lnTo>
                  <a:lnTo>
                    <a:pt x="2914" y="1"/>
                  </a:lnTo>
                  <a:lnTo>
                    <a:pt x="2915" y="2"/>
                  </a:lnTo>
                  <a:lnTo>
                    <a:pt x="2916" y="1"/>
                  </a:lnTo>
                  <a:lnTo>
                    <a:pt x="2917" y="2"/>
                  </a:lnTo>
                  <a:lnTo>
                    <a:pt x="2918" y="2"/>
                  </a:lnTo>
                  <a:lnTo>
                    <a:pt x="2919" y="2"/>
                  </a:lnTo>
                  <a:lnTo>
                    <a:pt x="2920" y="2"/>
                  </a:lnTo>
                  <a:lnTo>
                    <a:pt x="2920" y="1"/>
                  </a:lnTo>
                  <a:lnTo>
                    <a:pt x="2921" y="1"/>
                  </a:lnTo>
                  <a:lnTo>
                    <a:pt x="2922" y="1"/>
                  </a:lnTo>
                  <a:lnTo>
                    <a:pt x="2923" y="1"/>
                  </a:lnTo>
                  <a:lnTo>
                    <a:pt x="2924" y="2"/>
                  </a:lnTo>
                  <a:lnTo>
                    <a:pt x="2925" y="2"/>
                  </a:lnTo>
                  <a:lnTo>
                    <a:pt x="2926" y="1"/>
                  </a:lnTo>
                  <a:lnTo>
                    <a:pt x="2927" y="2"/>
                  </a:lnTo>
                  <a:lnTo>
                    <a:pt x="2928" y="1"/>
                  </a:lnTo>
                  <a:lnTo>
                    <a:pt x="2928" y="2"/>
                  </a:lnTo>
                  <a:lnTo>
                    <a:pt x="2929" y="2"/>
                  </a:lnTo>
                  <a:lnTo>
                    <a:pt x="2930" y="2"/>
                  </a:lnTo>
                  <a:lnTo>
                    <a:pt x="2931" y="2"/>
                  </a:lnTo>
                  <a:lnTo>
                    <a:pt x="2932" y="2"/>
                  </a:lnTo>
                  <a:lnTo>
                    <a:pt x="2933" y="1"/>
                  </a:lnTo>
                  <a:lnTo>
                    <a:pt x="2934" y="1"/>
                  </a:lnTo>
                  <a:lnTo>
                    <a:pt x="2935" y="2"/>
                  </a:lnTo>
                  <a:lnTo>
                    <a:pt x="2935" y="2"/>
                  </a:lnTo>
                  <a:lnTo>
                    <a:pt x="2936" y="1"/>
                  </a:lnTo>
                  <a:lnTo>
                    <a:pt x="2937" y="2"/>
                  </a:lnTo>
                  <a:lnTo>
                    <a:pt x="2938" y="2"/>
                  </a:lnTo>
                  <a:lnTo>
                    <a:pt x="2939" y="2"/>
                  </a:lnTo>
                  <a:lnTo>
                    <a:pt x="2940" y="1"/>
                  </a:lnTo>
                  <a:lnTo>
                    <a:pt x="2941" y="1"/>
                  </a:lnTo>
                  <a:lnTo>
                    <a:pt x="2942" y="1"/>
                  </a:lnTo>
                  <a:lnTo>
                    <a:pt x="2943" y="2"/>
                  </a:lnTo>
                  <a:lnTo>
                    <a:pt x="2943" y="1"/>
                  </a:lnTo>
                  <a:lnTo>
                    <a:pt x="2944" y="1"/>
                  </a:lnTo>
                  <a:lnTo>
                    <a:pt x="2945" y="1"/>
                  </a:lnTo>
                  <a:lnTo>
                    <a:pt x="2946" y="1"/>
                  </a:lnTo>
                  <a:lnTo>
                    <a:pt x="2947" y="1"/>
                  </a:lnTo>
                  <a:lnTo>
                    <a:pt x="2948" y="1"/>
                  </a:lnTo>
                  <a:lnTo>
                    <a:pt x="2949" y="1"/>
                  </a:lnTo>
                  <a:lnTo>
                    <a:pt x="2950" y="2"/>
                  </a:lnTo>
                  <a:lnTo>
                    <a:pt x="2950" y="1"/>
                  </a:lnTo>
                  <a:lnTo>
                    <a:pt x="2951" y="1"/>
                  </a:lnTo>
                  <a:lnTo>
                    <a:pt x="2952" y="2"/>
                  </a:lnTo>
                  <a:lnTo>
                    <a:pt x="2953" y="1"/>
                  </a:lnTo>
                  <a:lnTo>
                    <a:pt x="2954" y="1"/>
                  </a:lnTo>
                  <a:lnTo>
                    <a:pt x="2955" y="1"/>
                  </a:lnTo>
                  <a:lnTo>
                    <a:pt x="2956" y="1"/>
                  </a:lnTo>
                  <a:lnTo>
                    <a:pt x="2957" y="1"/>
                  </a:lnTo>
                  <a:lnTo>
                    <a:pt x="2958" y="1"/>
                  </a:lnTo>
                  <a:lnTo>
                    <a:pt x="2958" y="1"/>
                  </a:lnTo>
                  <a:lnTo>
                    <a:pt x="2959" y="1"/>
                  </a:lnTo>
                  <a:lnTo>
                    <a:pt x="2960" y="1"/>
                  </a:lnTo>
                  <a:lnTo>
                    <a:pt x="2961" y="1"/>
                  </a:lnTo>
                  <a:lnTo>
                    <a:pt x="2962" y="1"/>
                  </a:lnTo>
                  <a:lnTo>
                    <a:pt x="2963" y="1"/>
                  </a:lnTo>
                  <a:lnTo>
                    <a:pt x="2964" y="2"/>
                  </a:lnTo>
                  <a:lnTo>
                    <a:pt x="2965" y="2"/>
                  </a:lnTo>
                  <a:lnTo>
                    <a:pt x="2965" y="1"/>
                  </a:lnTo>
                  <a:lnTo>
                    <a:pt x="2966" y="1"/>
                  </a:lnTo>
                  <a:lnTo>
                    <a:pt x="2967" y="2"/>
                  </a:lnTo>
                  <a:lnTo>
                    <a:pt x="2968" y="1"/>
                  </a:lnTo>
                  <a:lnTo>
                    <a:pt x="2969" y="1"/>
                  </a:lnTo>
                  <a:lnTo>
                    <a:pt x="2970" y="1"/>
                  </a:lnTo>
                  <a:lnTo>
                    <a:pt x="2971" y="1"/>
                  </a:lnTo>
                  <a:lnTo>
                    <a:pt x="2972" y="1"/>
                  </a:lnTo>
                  <a:lnTo>
                    <a:pt x="2973" y="1"/>
                  </a:lnTo>
                  <a:lnTo>
                    <a:pt x="2973" y="1"/>
                  </a:lnTo>
                  <a:lnTo>
                    <a:pt x="2974" y="2"/>
                  </a:lnTo>
                  <a:lnTo>
                    <a:pt x="2975" y="1"/>
                  </a:lnTo>
                  <a:lnTo>
                    <a:pt x="2976" y="1"/>
                  </a:lnTo>
                  <a:lnTo>
                    <a:pt x="2977" y="1"/>
                  </a:lnTo>
                  <a:lnTo>
                    <a:pt x="2978" y="2"/>
                  </a:lnTo>
                  <a:lnTo>
                    <a:pt x="2979" y="1"/>
                  </a:lnTo>
                  <a:lnTo>
                    <a:pt x="2980" y="1"/>
                  </a:lnTo>
                  <a:lnTo>
                    <a:pt x="2980" y="2"/>
                  </a:lnTo>
                  <a:lnTo>
                    <a:pt x="2981" y="1"/>
                  </a:lnTo>
                  <a:lnTo>
                    <a:pt x="2982" y="1"/>
                  </a:lnTo>
                  <a:lnTo>
                    <a:pt x="2983" y="2"/>
                  </a:lnTo>
                  <a:lnTo>
                    <a:pt x="2984" y="2"/>
                  </a:lnTo>
                  <a:lnTo>
                    <a:pt x="2985" y="2"/>
                  </a:lnTo>
                  <a:lnTo>
                    <a:pt x="2986" y="2"/>
                  </a:lnTo>
                  <a:lnTo>
                    <a:pt x="2987" y="2"/>
                  </a:lnTo>
                  <a:lnTo>
                    <a:pt x="2988" y="1"/>
                  </a:lnTo>
                  <a:lnTo>
                    <a:pt x="2988" y="2"/>
                  </a:lnTo>
                  <a:lnTo>
                    <a:pt x="2989" y="2"/>
                  </a:lnTo>
                  <a:lnTo>
                    <a:pt x="2990" y="1"/>
                  </a:lnTo>
                  <a:lnTo>
                    <a:pt x="2991" y="2"/>
                  </a:lnTo>
                  <a:lnTo>
                    <a:pt x="2992" y="1"/>
                  </a:lnTo>
                  <a:lnTo>
                    <a:pt x="2993" y="1"/>
                  </a:lnTo>
                  <a:lnTo>
                    <a:pt x="2994" y="1"/>
                  </a:lnTo>
                  <a:lnTo>
                    <a:pt x="2995" y="1"/>
                  </a:lnTo>
                  <a:lnTo>
                    <a:pt x="2995" y="1"/>
                  </a:lnTo>
                  <a:lnTo>
                    <a:pt x="2996" y="1"/>
                  </a:lnTo>
                  <a:lnTo>
                    <a:pt x="2997" y="1"/>
                  </a:lnTo>
                  <a:lnTo>
                    <a:pt x="2998" y="1"/>
                  </a:lnTo>
                  <a:lnTo>
                    <a:pt x="2999" y="2"/>
                  </a:lnTo>
                  <a:lnTo>
                    <a:pt x="3000" y="1"/>
                  </a:lnTo>
                  <a:lnTo>
                    <a:pt x="3001" y="1"/>
                  </a:lnTo>
                  <a:lnTo>
                    <a:pt x="3002" y="1"/>
                  </a:lnTo>
                  <a:lnTo>
                    <a:pt x="3003" y="1"/>
                  </a:lnTo>
                  <a:lnTo>
                    <a:pt x="3003" y="1"/>
                  </a:lnTo>
                  <a:lnTo>
                    <a:pt x="3004" y="1"/>
                  </a:lnTo>
                  <a:lnTo>
                    <a:pt x="3005" y="2"/>
                  </a:lnTo>
                  <a:lnTo>
                    <a:pt x="3006" y="1"/>
                  </a:lnTo>
                  <a:lnTo>
                    <a:pt x="3007" y="1"/>
                  </a:lnTo>
                  <a:lnTo>
                    <a:pt x="3008" y="1"/>
                  </a:lnTo>
                  <a:lnTo>
                    <a:pt x="3009" y="1"/>
                  </a:lnTo>
                  <a:lnTo>
                    <a:pt x="3010" y="1"/>
                  </a:lnTo>
                  <a:lnTo>
                    <a:pt x="3010" y="2"/>
                  </a:lnTo>
                  <a:lnTo>
                    <a:pt x="3011" y="1"/>
                  </a:lnTo>
                  <a:lnTo>
                    <a:pt x="3012" y="2"/>
                  </a:lnTo>
                  <a:lnTo>
                    <a:pt x="3013" y="2"/>
                  </a:lnTo>
                  <a:lnTo>
                    <a:pt x="3014" y="2"/>
                  </a:lnTo>
                  <a:lnTo>
                    <a:pt x="3015" y="1"/>
                  </a:lnTo>
                  <a:lnTo>
                    <a:pt x="3016" y="1"/>
                  </a:lnTo>
                  <a:lnTo>
                    <a:pt x="3017" y="1"/>
                  </a:lnTo>
                  <a:lnTo>
                    <a:pt x="3018" y="2"/>
                  </a:lnTo>
                  <a:lnTo>
                    <a:pt x="3018" y="1"/>
                  </a:lnTo>
                  <a:lnTo>
                    <a:pt x="3019" y="1"/>
                  </a:lnTo>
                  <a:lnTo>
                    <a:pt x="3020" y="2"/>
                  </a:lnTo>
                  <a:lnTo>
                    <a:pt x="3021" y="1"/>
                  </a:lnTo>
                  <a:lnTo>
                    <a:pt x="3022" y="1"/>
                  </a:lnTo>
                  <a:lnTo>
                    <a:pt x="3023" y="1"/>
                  </a:lnTo>
                  <a:lnTo>
                    <a:pt x="3024" y="1"/>
                  </a:lnTo>
                  <a:lnTo>
                    <a:pt x="3025" y="1"/>
                  </a:lnTo>
                  <a:lnTo>
                    <a:pt x="3025" y="1"/>
                  </a:lnTo>
                  <a:lnTo>
                    <a:pt x="3026" y="1"/>
                  </a:lnTo>
                  <a:lnTo>
                    <a:pt x="3027" y="1"/>
                  </a:lnTo>
                  <a:lnTo>
                    <a:pt x="3028" y="2"/>
                  </a:lnTo>
                  <a:lnTo>
                    <a:pt x="3029" y="1"/>
                  </a:lnTo>
                  <a:lnTo>
                    <a:pt x="3030" y="2"/>
                  </a:lnTo>
                  <a:lnTo>
                    <a:pt x="3031" y="1"/>
                  </a:lnTo>
                  <a:lnTo>
                    <a:pt x="3032" y="2"/>
                  </a:lnTo>
                  <a:lnTo>
                    <a:pt x="3033" y="1"/>
                  </a:lnTo>
                  <a:lnTo>
                    <a:pt x="3033" y="1"/>
                  </a:lnTo>
                  <a:lnTo>
                    <a:pt x="3034" y="1"/>
                  </a:lnTo>
                  <a:lnTo>
                    <a:pt x="3035" y="2"/>
                  </a:lnTo>
                  <a:lnTo>
                    <a:pt x="3036" y="1"/>
                  </a:lnTo>
                  <a:lnTo>
                    <a:pt x="3037" y="2"/>
                  </a:lnTo>
                  <a:lnTo>
                    <a:pt x="3038" y="1"/>
                  </a:lnTo>
                  <a:lnTo>
                    <a:pt x="3039" y="2"/>
                  </a:lnTo>
                  <a:lnTo>
                    <a:pt x="3040" y="2"/>
                  </a:lnTo>
                  <a:lnTo>
                    <a:pt x="3040" y="2"/>
                  </a:lnTo>
                  <a:lnTo>
                    <a:pt x="3041" y="1"/>
                  </a:lnTo>
                  <a:lnTo>
                    <a:pt x="3042" y="2"/>
                  </a:lnTo>
                  <a:lnTo>
                    <a:pt x="3043" y="1"/>
                  </a:lnTo>
                  <a:lnTo>
                    <a:pt x="3044" y="2"/>
                  </a:lnTo>
                  <a:lnTo>
                    <a:pt x="3045" y="2"/>
                  </a:lnTo>
                  <a:lnTo>
                    <a:pt x="3046" y="2"/>
                  </a:lnTo>
                  <a:lnTo>
                    <a:pt x="3047" y="2"/>
                  </a:lnTo>
                  <a:lnTo>
                    <a:pt x="3048" y="2"/>
                  </a:lnTo>
                  <a:lnTo>
                    <a:pt x="3048" y="2"/>
                  </a:lnTo>
                  <a:lnTo>
                    <a:pt x="3049" y="1"/>
                  </a:lnTo>
                  <a:lnTo>
                    <a:pt x="3050" y="2"/>
                  </a:lnTo>
                  <a:lnTo>
                    <a:pt x="3051" y="2"/>
                  </a:lnTo>
                  <a:lnTo>
                    <a:pt x="3052" y="1"/>
                  </a:lnTo>
                  <a:lnTo>
                    <a:pt x="3053" y="2"/>
                  </a:lnTo>
                  <a:lnTo>
                    <a:pt x="3054" y="1"/>
                  </a:lnTo>
                  <a:lnTo>
                    <a:pt x="3055" y="1"/>
                  </a:lnTo>
                  <a:lnTo>
                    <a:pt x="3055" y="2"/>
                  </a:lnTo>
                  <a:lnTo>
                    <a:pt x="3056" y="2"/>
                  </a:lnTo>
                  <a:lnTo>
                    <a:pt x="3057" y="1"/>
                  </a:lnTo>
                  <a:lnTo>
                    <a:pt x="3058" y="2"/>
                  </a:lnTo>
                  <a:lnTo>
                    <a:pt x="3059" y="2"/>
                  </a:lnTo>
                  <a:lnTo>
                    <a:pt x="3060" y="2"/>
                  </a:lnTo>
                  <a:lnTo>
                    <a:pt x="3061" y="2"/>
                  </a:lnTo>
                  <a:lnTo>
                    <a:pt x="3062" y="2"/>
                  </a:lnTo>
                  <a:lnTo>
                    <a:pt x="3063" y="2"/>
                  </a:lnTo>
                  <a:lnTo>
                    <a:pt x="3063" y="2"/>
                  </a:lnTo>
                  <a:lnTo>
                    <a:pt x="3064" y="2"/>
                  </a:lnTo>
                  <a:lnTo>
                    <a:pt x="3065" y="1"/>
                  </a:lnTo>
                  <a:lnTo>
                    <a:pt x="3066" y="1"/>
                  </a:lnTo>
                  <a:lnTo>
                    <a:pt x="3067" y="2"/>
                  </a:lnTo>
                  <a:lnTo>
                    <a:pt x="3068" y="1"/>
                  </a:lnTo>
                  <a:lnTo>
                    <a:pt x="3069" y="1"/>
                  </a:lnTo>
                  <a:lnTo>
                    <a:pt x="3070" y="2"/>
                  </a:lnTo>
                  <a:lnTo>
                    <a:pt x="3070" y="1"/>
                  </a:lnTo>
                  <a:lnTo>
                    <a:pt x="3071" y="2"/>
                  </a:lnTo>
                  <a:lnTo>
                    <a:pt x="3072" y="1"/>
                  </a:lnTo>
                  <a:lnTo>
                    <a:pt x="3073" y="1"/>
                  </a:lnTo>
                  <a:lnTo>
                    <a:pt x="3074" y="2"/>
                  </a:lnTo>
                  <a:lnTo>
                    <a:pt x="3075" y="2"/>
                  </a:lnTo>
                  <a:lnTo>
                    <a:pt x="3076" y="1"/>
                  </a:lnTo>
                  <a:lnTo>
                    <a:pt x="3077" y="2"/>
                  </a:lnTo>
                  <a:lnTo>
                    <a:pt x="3078" y="1"/>
                  </a:lnTo>
                  <a:lnTo>
                    <a:pt x="3078" y="2"/>
                  </a:lnTo>
                  <a:lnTo>
                    <a:pt x="3079" y="2"/>
                  </a:lnTo>
                  <a:lnTo>
                    <a:pt x="3080" y="2"/>
                  </a:lnTo>
                  <a:lnTo>
                    <a:pt x="3081" y="2"/>
                  </a:lnTo>
                  <a:lnTo>
                    <a:pt x="3082" y="3"/>
                  </a:lnTo>
                  <a:lnTo>
                    <a:pt x="3083" y="3"/>
                  </a:lnTo>
                  <a:lnTo>
                    <a:pt x="3084" y="4"/>
                  </a:lnTo>
                  <a:lnTo>
                    <a:pt x="3085" y="4"/>
                  </a:lnTo>
                  <a:lnTo>
                    <a:pt x="3085" y="5"/>
                  </a:lnTo>
                  <a:lnTo>
                    <a:pt x="3086" y="4"/>
                  </a:lnTo>
                  <a:lnTo>
                    <a:pt x="3087" y="4"/>
                  </a:lnTo>
                  <a:lnTo>
                    <a:pt x="3088" y="4"/>
                  </a:lnTo>
                  <a:lnTo>
                    <a:pt x="3089" y="4"/>
                  </a:lnTo>
                  <a:lnTo>
                    <a:pt x="3090" y="4"/>
                  </a:lnTo>
                  <a:lnTo>
                    <a:pt x="3091" y="3"/>
                  </a:lnTo>
                  <a:lnTo>
                    <a:pt x="3092" y="4"/>
                  </a:lnTo>
                  <a:lnTo>
                    <a:pt x="3093" y="3"/>
                  </a:lnTo>
                  <a:lnTo>
                    <a:pt x="3093" y="3"/>
                  </a:lnTo>
                  <a:lnTo>
                    <a:pt x="3094" y="3"/>
                  </a:lnTo>
                  <a:lnTo>
                    <a:pt x="3095" y="3"/>
                  </a:lnTo>
                  <a:lnTo>
                    <a:pt x="3096" y="3"/>
                  </a:lnTo>
                  <a:lnTo>
                    <a:pt x="3097" y="3"/>
                  </a:lnTo>
                  <a:lnTo>
                    <a:pt x="3098" y="2"/>
                  </a:lnTo>
                  <a:lnTo>
                    <a:pt x="3099" y="3"/>
                  </a:lnTo>
                  <a:lnTo>
                    <a:pt x="3100" y="2"/>
                  </a:lnTo>
                  <a:lnTo>
                    <a:pt x="3100" y="2"/>
                  </a:lnTo>
                  <a:lnTo>
                    <a:pt x="3101" y="2"/>
                  </a:lnTo>
                  <a:lnTo>
                    <a:pt x="3102" y="2"/>
                  </a:lnTo>
                  <a:lnTo>
                    <a:pt x="3103" y="2"/>
                  </a:lnTo>
                  <a:lnTo>
                    <a:pt x="3104" y="1"/>
                  </a:lnTo>
                  <a:lnTo>
                    <a:pt x="3105" y="2"/>
                  </a:lnTo>
                  <a:lnTo>
                    <a:pt x="3106" y="2"/>
                  </a:lnTo>
                  <a:lnTo>
                    <a:pt x="3107" y="2"/>
                  </a:lnTo>
                  <a:lnTo>
                    <a:pt x="3108" y="1"/>
                  </a:lnTo>
                  <a:lnTo>
                    <a:pt x="3108" y="2"/>
                  </a:lnTo>
                  <a:lnTo>
                    <a:pt x="3109" y="2"/>
                  </a:lnTo>
                  <a:lnTo>
                    <a:pt x="3110" y="1"/>
                  </a:lnTo>
                  <a:lnTo>
                    <a:pt x="3111" y="1"/>
                  </a:lnTo>
                  <a:lnTo>
                    <a:pt x="3112" y="1"/>
                  </a:lnTo>
                  <a:lnTo>
                    <a:pt x="3113" y="2"/>
                  </a:lnTo>
                  <a:lnTo>
                    <a:pt x="3114" y="1"/>
                  </a:lnTo>
                  <a:lnTo>
                    <a:pt x="3115" y="2"/>
                  </a:lnTo>
                  <a:lnTo>
                    <a:pt x="3115" y="1"/>
                  </a:lnTo>
                  <a:lnTo>
                    <a:pt x="3116" y="1"/>
                  </a:lnTo>
                  <a:lnTo>
                    <a:pt x="3117" y="1"/>
                  </a:lnTo>
                  <a:lnTo>
                    <a:pt x="3118" y="1"/>
                  </a:lnTo>
                  <a:lnTo>
                    <a:pt x="3119" y="1"/>
                  </a:lnTo>
                  <a:lnTo>
                    <a:pt x="3120" y="2"/>
                  </a:lnTo>
                  <a:lnTo>
                    <a:pt x="3121" y="1"/>
                  </a:lnTo>
                  <a:lnTo>
                    <a:pt x="3122" y="1"/>
                  </a:lnTo>
                  <a:lnTo>
                    <a:pt x="3122" y="2"/>
                  </a:lnTo>
                  <a:lnTo>
                    <a:pt x="3123" y="1"/>
                  </a:lnTo>
                  <a:lnTo>
                    <a:pt x="3124" y="1"/>
                  </a:lnTo>
                  <a:lnTo>
                    <a:pt x="3125" y="1"/>
                  </a:lnTo>
                  <a:lnTo>
                    <a:pt x="3126" y="1"/>
                  </a:lnTo>
                  <a:lnTo>
                    <a:pt x="3127" y="1"/>
                  </a:lnTo>
                  <a:lnTo>
                    <a:pt x="3128" y="1"/>
                  </a:lnTo>
                  <a:lnTo>
                    <a:pt x="3129" y="1"/>
                  </a:lnTo>
                  <a:lnTo>
                    <a:pt x="3130" y="1"/>
                  </a:lnTo>
                  <a:lnTo>
                    <a:pt x="3130" y="1"/>
                  </a:lnTo>
                  <a:lnTo>
                    <a:pt x="3131" y="1"/>
                  </a:lnTo>
                  <a:lnTo>
                    <a:pt x="3132" y="2"/>
                  </a:lnTo>
                  <a:lnTo>
                    <a:pt x="3133" y="2"/>
                  </a:lnTo>
                  <a:lnTo>
                    <a:pt x="3134" y="1"/>
                  </a:lnTo>
                  <a:lnTo>
                    <a:pt x="3135" y="2"/>
                  </a:lnTo>
                  <a:lnTo>
                    <a:pt x="3136" y="1"/>
                  </a:lnTo>
                  <a:lnTo>
                    <a:pt x="3137" y="2"/>
                  </a:lnTo>
                  <a:lnTo>
                    <a:pt x="3137" y="2"/>
                  </a:lnTo>
                  <a:lnTo>
                    <a:pt x="3138" y="2"/>
                  </a:lnTo>
                  <a:lnTo>
                    <a:pt x="3139" y="2"/>
                  </a:lnTo>
                  <a:lnTo>
                    <a:pt x="3140" y="2"/>
                  </a:lnTo>
                  <a:lnTo>
                    <a:pt x="3141" y="2"/>
                  </a:lnTo>
                  <a:lnTo>
                    <a:pt x="3142" y="1"/>
                  </a:lnTo>
                  <a:lnTo>
                    <a:pt x="3143" y="1"/>
                  </a:lnTo>
                  <a:lnTo>
                    <a:pt x="3144" y="2"/>
                  </a:lnTo>
                  <a:lnTo>
                    <a:pt x="3145" y="2"/>
                  </a:lnTo>
                  <a:lnTo>
                    <a:pt x="3145" y="1"/>
                  </a:lnTo>
                  <a:lnTo>
                    <a:pt x="3146" y="2"/>
                  </a:lnTo>
                  <a:lnTo>
                    <a:pt x="3147" y="1"/>
                  </a:lnTo>
                  <a:lnTo>
                    <a:pt x="3148" y="2"/>
                  </a:lnTo>
                  <a:lnTo>
                    <a:pt x="3149" y="1"/>
                  </a:lnTo>
                  <a:lnTo>
                    <a:pt x="3150" y="1"/>
                  </a:lnTo>
                  <a:lnTo>
                    <a:pt x="3151" y="2"/>
                  </a:lnTo>
                  <a:lnTo>
                    <a:pt x="3152" y="1"/>
                  </a:lnTo>
                  <a:lnTo>
                    <a:pt x="3152" y="2"/>
                  </a:lnTo>
                  <a:lnTo>
                    <a:pt x="3153" y="2"/>
                  </a:lnTo>
                  <a:lnTo>
                    <a:pt x="3154" y="1"/>
                  </a:lnTo>
                  <a:lnTo>
                    <a:pt x="3155" y="2"/>
                  </a:lnTo>
                  <a:lnTo>
                    <a:pt x="3156" y="1"/>
                  </a:lnTo>
                  <a:lnTo>
                    <a:pt x="3157" y="2"/>
                  </a:lnTo>
                  <a:lnTo>
                    <a:pt x="3158" y="2"/>
                  </a:lnTo>
                  <a:lnTo>
                    <a:pt x="3159" y="2"/>
                  </a:lnTo>
                  <a:lnTo>
                    <a:pt x="3160" y="2"/>
                  </a:lnTo>
                  <a:lnTo>
                    <a:pt x="3160" y="1"/>
                  </a:lnTo>
                  <a:lnTo>
                    <a:pt x="3161" y="2"/>
                  </a:lnTo>
                  <a:lnTo>
                    <a:pt x="3162" y="1"/>
                  </a:lnTo>
                  <a:lnTo>
                    <a:pt x="3163" y="1"/>
                  </a:lnTo>
                  <a:lnTo>
                    <a:pt x="3164" y="2"/>
                  </a:lnTo>
                  <a:lnTo>
                    <a:pt x="3165" y="2"/>
                  </a:lnTo>
                  <a:lnTo>
                    <a:pt x="3166" y="1"/>
                  </a:lnTo>
                  <a:lnTo>
                    <a:pt x="3167" y="1"/>
                  </a:lnTo>
                  <a:lnTo>
                    <a:pt x="3167" y="2"/>
                  </a:lnTo>
                  <a:lnTo>
                    <a:pt x="3168" y="2"/>
                  </a:lnTo>
                  <a:lnTo>
                    <a:pt x="3169" y="3"/>
                  </a:lnTo>
                  <a:lnTo>
                    <a:pt x="3170" y="2"/>
                  </a:lnTo>
                  <a:lnTo>
                    <a:pt x="3171" y="1"/>
                  </a:lnTo>
                  <a:lnTo>
                    <a:pt x="3172" y="2"/>
                  </a:lnTo>
                  <a:lnTo>
                    <a:pt x="3173" y="2"/>
                  </a:lnTo>
                  <a:lnTo>
                    <a:pt x="3174" y="2"/>
                  </a:lnTo>
                  <a:lnTo>
                    <a:pt x="3175" y="2"/>
                  </a:lnTo>
                  <a:lnTo>
                    <a:pt x="3175" y="2"/>
                  </a:lnTo>
                  <a:lnTo>
                    <a:pt x="3176" y="2"/>
                  </a:lnTo>
                  <a:lnTo>
                    <a:pt x="3177" y="2"/>
                  </a:lnTo>
                  <a:lnTo>
                    <a:pt x="3178" y="2"/>
                  </a:lnTo>
                  <a:lnTo>
                    <a:pt x="3179" y="2"/>
                  </a:lnTo>
                  <a:lnTo>
                    <a:pt x="3180" y="1"/>
                  </a:lnTo>
                  <a:lnTo>
                    <a:pt x="3181" y="2"/>
                  </a:lnTo>
                  <a:lnTo>
                    <a:pt x="3182" y="2"/>
                  </a:lnTo>
                  <a:lnTo>
                    <a:pt x="3182" y="2"/>
                  </a:lnTo>
                  <a:lnTo>
                    <a:pt x="3183" y="2"/>
                  </a:lnTo>
                  <a:lnTo>
                    <a:pt x="3184" y="2"/>
                  </a:lnTo>
                  <a:lnTo>
                    <a:pt x="3185" y="2"/>
                  </a:lnTo>
                  <a:lnTo>
                    <a:pt x="3186" y="2"/>
                  </a:lnTo>
                  <a:lnTo>
                    <a:pt x="3187" y="2"/>
                  </a:lnTo>
                  <a:lnTo>
                    <a:pt x="3188" y="1"/>
                  </a:lnTo>
                  <a:lnTo>
                    <a:pt x="3189" y="2"/>
                  </a:lnTo>
                  <a:lnTo>
                    <a:pt x="3190" y="1"/>
                  </a:lnTo>
                  <a:lnTo>
                    <a:pt x="3190" y="2"/>
                  </a:lnTo>
                  <a:lnTo>
                    <a:pt x="3191" y="2"/>
                  </a:lnTo>
                  <a:lnTo>
                    <a:pt x="3192" y="2"/>
                  </a:lnTo>
                  <a:lnTo>
                    <a:pt x="3193" y="1"/>
                  </a:lnTo>
                  <a:lnTo>
                    <a:pt x="3194" y="2"/>
                  </a:lnTo>
                  <a:lnTo>
                    <a:pt x="3195" y="3"/>
                  </a:lnTo>
                  <a:lnTo>
                    <a:pt x="3196" y="2"/>
                  </a:lnTo>
                  <a:lnTo>
                    <a:pt x="3197" y="4"/>
                  </a:lnTo>
                  <a:lnTo>
                    <a:pt x="3197" y="3"/>
                  </a:lnTo>
                  <a:lnTo>
                    <a:pt x="3198" y="3"/>
                  </a:lnTo>
                  <a:lnTo>
                    <a:pt x="3199" y="4"/>
                  </a:lnTo>
                  <a:lnTo>
                    <a:pt x="3200" y="4"/>
                  </a:lnTo>
                  <a:lnTo>
                    <a:pt x="3201" y="3"/>
                  </a:lnTo>
                  <a:lnTo>
                    <a:pt x="3202" y="3"/>
                  </a:lnTo>
                  <a:lnTo>
                    <a:pt x="3203" y="3"/>
                  </a:lnTo>
                  <a:lnTo>
                    <a:pt x="3204" y="3"/>
                  </a:lnTo>
                  <a:lnTo>
                    <a:pt x="3205" y="3"/>
                  </a:lnTo>
                  <a:lnTo>
                    <a:pt x="3205" y="2"/>
                  </a:lnTo>
                  <a:lnTo>
                    <a:pt x="3206" y="2"/>
                  </a:lnTo>
                  <a:lnTo>
                    <a:pt x="3207" y="2"/>
                  </a:lnTo>
                  <a:lnTo>
                    <a:pt x="3208" y="2"/>
                  </a:lnTo>
                  <a:lnTo>
                    <a:pt x="3209" y="3"/>
                  </a:lnTo>
                  <a:lnTo>
                    <a:pt x="3210" y="2"/>
                  </a:lnTo>
                  <a:lnTo>
                    <a:pt x="3211" y="2"/>
                  </a:lnTo>
                  <a:lnTo>
                    <a:pt x="3212" y="2"/>
                  </a:lnTo>
                  <a:lnTo>
                    <a:pt x="3212" y="1"/>
                  </a:lnTo>
                  <a:lnTo>
                    <a:pt x="3213" y="3"/>
                  </a:lnTo>
                  <a:lnTo>
                    <a:pt x="3214" y="2"/>
                  </a:lnTo>
                  <a:lnTo>
                    <a:pt x="3215" y="2"/>
                  </a:lnTo>
                  <a:lnTo>
                    <a:pt x="3216" y="3"/>
                  </a:lnTo>
                  <a:lnTo>
                    <a:pt x="3217" y="3"/>
                  </a:lnTo>
                  <a:lnTo>
                    <a:pt x="3218" y="3"/>
                  </a:lnTo>
                  <a:lnTo>
                    <a:pt x="3219" y="4"/>
                  </a:lnTo>
                  <a:lnTo>
                    <a:pt x="3220" y="4"/>
                  </a:lnTo>
                  <a:lnTo>
                    <a:pt x="3220" y="3"/>
                  </a:lnTo>
                  <a:lnTo>
                    <a:pt x="3221" y="4"/>
                  </a:lnTo>
                  <a:lnTo>
                    <a:pt x="3222" y="4"/>
                  </a:lnTo>
                  <a:lnTo>
                    <a:pt x="3223" y="4"/>
                  </a:lnTo>
                  <a:lnTo>
                    <a:pt x="3224" y="4"/>
                  </a:lnTo>
                  <a:lnTo>
                    <a:pt x="3225" y="5"/>
                  </a:lnTo>
                  <a:lnTo>
                    <a:pt x="3226" y="3"/>
                  </a:lnTo>
                  <a:lnTo>
                    <a:pt x="3227" y="4"/>
                  </a:lnTo>
                  <a:lnTo>
                    <a:pt x="3227" y="3"/>
                  </a:lnTo>
                  <a:lnTo>
                    <a:pt x="3228" y="3"/>
                  </a:lnTo>
                  <a:lnTo>
                    <a:pt x="3229" y="2"/>
                  </a:lnTo>
                  <a:lnTo>
                    <a:pt x="3230" y="3"/>
                  </a:lnTo>
                  <a:lnTo>
                    <a:pt x="3231" y="3"/>
                  </a:lnTo>
                  <a:lnTo>
                    <a:pt x="3232" y="2"/>
                  </a:lnTo>
                  <a:lnTo>
                    <a:pt x="3233" y="2"/>
                  </a:lnTo>
                  <a:lnTo>
                    <a:pt x="3234" y="2"/>
                  </a:lnTo>
                  <a:lnTo>
                    <a:pt x="3235" y="2"/>
                  </a:lnTo>
                  <a:lnTo>
                    <a:pt x="3235" y="2"/>
                  </a:lnTo>
                  <a:lnTo>
                    <a:pt x="3236" y="2"/>
                  </a:lnTo>
                  <a:lnTo>
                    <a:pt x="3237" y="2"/>
                  </a:lnTo>
                  <a:lnTo>
                    <a:pt x="3238" y="3"/>
                  </a:lnTo>
                  <a:lnTo>
                    <a:pt x="3239" y="3"/>
                  </a:lnTo>
                  <a:lnTo>
                    <a:pt x="3240" y="2"/>
                  </a:lnTo>
                  <a:lnTo>
                    <a:pt x="3241" y="2"/>
                  </a:lnTo>
                  <a:lnTo>
                    <a:pt x="3242" y="2"/>
                  </a:lnTo>
                  <a:lnTo>
                    <a:pt x="3242" y="2"/>
                  </a:lnTo>
                  <a:lnTo>
                    <a:pt x="3243" y="3"/>
                  </a:lnTo>
                  <a:lnTo>
                    <a:pt x="3244" y="2"/>
                  </a:lnTo>
                  <a:lnTo>
                    <a:pt x="3245" y="2"/>
                  </a:lnTo>
                  <a:lnTo>
                    <a:pt x="3246" y="2"/>
                  </a:lnTo>
                  <a:lnTo>
                    <a:pt x="3247" y="2"/>
                  </a:lnTo>
                  <a:lnTo>
                    <a:pt x="3248" y="2"/>
                  </a:lnTo>
                  <a:lnTo>
                    <a:pt x="3249" y="2"/>
                  </a:lnTo>
                  <a:lnTo>
                    <a:pt x="3250" y="2"/>
                  </a:lnTo>
                  <a:lnTo>
                    <a:pt x="3250" y="2"/>
                  </a:lnTo>
                  <a:lnTo>
                    <a:pt x="3251" y="2"/>
                  </a:lnTo>
                  <a:lnTo>
                    <a:pt x="3252" y="3"/>
                  </a:lnTo>
                  <a:lnTo>
                    <a:pt x="3253" y="2"/>
                  </a:lnTo>
                  <a:lnTo>
                    <a:pt x="3254" y="3"/>
                  </a:lnTo>
                  <a:lnTo>
                    <a:pt x="3255" y="2"/>
                  </a:lnTo>
                  <a:lnTo>
                    <a:pt x="3256" y="3"/>
                  </a:lnTo>
                  <a:lnTo>
                    <a:pt x="3257" y="3"/>
                  </a:lnTo>
                  <a:lnTo>
                    <a:pt x="3257" y="3"/>
                  </a:lnTo>
                  <a:lnTo>
                    <a:pt x="3258" y="2"/>
                  </a:lnTo>
                  <a:lnTo>
                    <a:pt x="3259" y="3"/>
                  </a:lnTo>
                  <a:lnTo>
                    <a:pt x="3260" y="3"/>
                  </a:lnTo>
                  <a:lnTo>
                    <a:pt x="3261" y="3"/>
                  </a:lnTo>
                  <a:lnTo>
                    <a:pt x="3262" y="2"/>
                  </a:lnTo>
                  <a:lnTo>
                    <a:pt x="3263" y="2"/>
                  </a:lnTo>
                  <a:lnTo>
                    <a:pt x="3264" y="2"/>
                  </a:lnTo>
                  <a:lnTo>
                    <a:pt x="3265" y="3"/>
                  </a:lnTo>
                  <a:lnTo>
                    <a:pt x="3265" y="3"/>
                  </a:lnTo>
                  <a:lnTo>
                    <a:pt x="3266" y="2"/>
                  </a:lnTo>
                  <a:lnTo>
                    <a:pt x="3267" y="2"/>
                  </a:lnTo>
                  <a:lnTo>
                    <a:pt x="3268" y="2"/>
                  </a:lnTo>
                  <a:lnTo>
                    <a:pt x="3269" y="2"/>
                  </a:lnTo>
                  <a:lnTo>
                    <a:pt x="3270" y="2"/>
                  </a:lnTo>
                  <a:lnTo>
                    <a:pt x="3271" y="2"/>
                  </a:lnTo>
                  <a:lnTo>
                    <a:pt x="3272" y="2"/>
                  </a:lnTo>
                  <a:lnTo>
                    <a:pt x="3272" y="1"/>
                  </a:lnTo>
                  <a:lnTo>
                    <a:pt x="3273" y="2"/>
                  </a:lnTo>
                  <a:lnTo>
                    <a:pt x="3274" y="2"/>
                  </a:lnTo>
                  <a:lnTo>
                    <a:pt x="3275" y="2"/>
                  </a:lnTo>
                  <a:lnTo>
                    <a:pt x="3276" y="1"/>
                  </a:lnTo>
                  <a:lnTo>
                    <a:pt x="3277" y="2"/>
                  </a:lnTo>
                  <a:lnTo>
                    <a:pt x="3278" y="2"/>
                  </a:lnTo>
                  <a:lnTo>
                    <a:pt x="3279" y="1"/>
                  </a:lnTo>
                  <a:lnTo>
                    <a:pt x="3280" y="1"/>
                  </a:lnTo>
                  <a:lnTo>
                    <a:pt x="3280" y="1"/>
                  </a:lnTo>
                  <a:lnTo>
                    <a:pt x="3281" y="2"/>
                  </a:lnTo>
                  <a:lnTo>
                    <a:pt x="3282" y="2"/>
                  </a:lnTo>
                  <a:lnTo>
                    <a:pt x="3283" y="2"/>
                  </a:lnTo>
                  <a:lnTo>
                    <a:pt x="3284" y="2"/>
                  </a:lnTo>
                  <a:lnTo>
                    <a:pt x="3285" y="2"/>
                  </a:lnTo>
                  <a:lnTo>
                    <a:pt x="3286" y="3"/>
                  </a:lnTo>
                  <a:lnTo>
                    <a:pt x="3287" y="5"/>
                  </a:lnTo>
                  <a:lnTo>
                    <a:pt x="3287" y="8"/>
                  </a:lnTo>
                  <a:lnTo>
                    <a:pt x="3288" y="11"/>
                  </a:lnTo>
                  <a:lnTo>
                    <a:pt x="3289" y="19"/>
                  </a:lnTo>
                  <a:lnTo>
                    <a:pt x="3290" y="29"/>
                  </a:lnTo>
                  <a:lnTo>
                    <a:pt x="3291" y="41"/>
                  </a:lnTo>
                  <a:lnTo>
                    <a:pt x="3292" y="57"/>
                  </a:lnTo>
                  <a:lnTo>
                    <a:pt x="3293" y="73"/>
                  </a:lnTo>
                  <a:lnTo>
                    <a:pt x="3294" y="90"/>
                  </a:lnTo>
                  <a:lnTo>
                    <a:pt x="3295" y="106"/>
                  </a:lnTo>
                  <a:lnTo>
                    <a:pt x="3295" y="113"/>
                  </a:lnTo>
                  <a:lnTo>
                    <a:pt x="3296" y="123"/>
                  </a:lnTo>
                  <a:lnTo>
                    <a:pt x="3297" y="123"/>
                  </a:lnTo>
                  <a:lnTo>
                    <a:pt x="3298" y="120"/>
                  </a:lnTo>
                  <a:lnTo>
                    <a:pt x="3299" y="108"/>
                  </a:lnTo>
                  <a:lnTo>
                    <a:pt x="3300" y="99"/>
                  </a:lnTo>
                  <a:lnTo>
                    <a:pt x="3301" y="87"/>
                  </a:lnTo>
                  <a:lnTo>
                    <a:pt x="3302" y="74"/>
                  </a:lnTo>
                  <a:lnTo>
                    <a:pt x="3302" y="61"/>
                  </a:lnTo>
                  <a:lnTo>
                    <a:pt x="3303" y="56"/>
                  </a:lnTo>
                  <a:lnTo>
                    <a:pt x="3304" y="49"/>
                  </a:lnTo>
                  <a:lnTo>
                    <a:pt x="3305" y="43"/>
                  </a:lnTo>
                  <a:lnTo>
                    <a:pt x="3306" y="38"/>
                  </a:lnTo>
                  <a:lnTo>
                    <a:pt x="3307" y="33"/>
                  </a:lnTo>
                  <a:lnTo>
                    <a:pt x="3308" y="29"/>
                  </a:lnTo>
                  <a:lnTo>
                    <a:pt x="3309" y="26"/>
                  </a:lnTo>
                  <a:lnTo>
                    <a:pt x="3310" y="26"/>
                  </a:lnTo>
                  <a:lnTo>
                    <a:pt x="3310" y="21"/>
                  </a:lnTo>
                  <a:lnTo>
                    <a:pt x="3311" y="21"/>
                  </a:lnTo>
                  <a:lnTo>
                    <a:pt x="3312" y="19"/>
                  </a:lnTo>
                  <a:lnTo>
                    <a:pt x="3313" y="17"/>
                  </a:lnTo>
                  <a:lnTo>
                    <a:pt x="3314" y="15"/>
                  </a:lnTo>
                  <a:lnTo>
                    <a:pt x="3315" y="17"/>
                  </a:lnTo>
                  <a:lnTo>
                    <a:pt x="3316" y="14"/>
                  </a:lnTo>
                  <a:lnTo>
                    <a:pt x="3317" y="15"/>
                  </a:lnTo>
                  <a:lnTo>
                    <a:pt x="3317" y="13"/>
                  </a:lnTo>
                  <a:lnTo>
                    <a:pt x="3318" y="11"/>
                  </a:lnTo>
                  <a:lnTo>
                    <a:pt x="3319" y="11"/>
                  </a:lnTo>
                  <a:lnTo>
                    <a:pt x="3320" y="10"/>
                  </a:lnTo>
                  <a:lnTo>
                    <a:pt x="3321" y="10"/>
                  </a:lnTo>
                  <a:lnTo>
                    <a:pt x="3322" y="10"/>
                  </a:lnTo>
                  <a:lnTo>
                    <a:pt x="3323" y="9"/>
                  </a:lnTo>
                  <a:lnTo>
                    <a:pt x="3324" y="10"/>
                  </a:lnTo>
                  <a:lnTo>
                    <a:pt x="3324" y="8"/>
                  </a:lnTo>
                  <a:lnTo>
                    <a:pt x="3325" y="8"/>
                  </a:lnTo>
                  <a:lnTo>
                    <a:pt x="3326" y="8"/>
                  </a:lnTo>
                  <a:lnTo>
                    <a:pt x="3327" y="7"/>
                  </a:lnTo>
                  <a:lnTo>
                    <a:pt x="3328" y="8"/>
                  </a:lnTo>
                  <a:lnTo>
                    <a:pt x="3329" y="7"/>
                  </a:lnTo>
                  <a:lnTo>
                    <a:pt x="3330" y="7"/>
                  </a:lnTo>
                  <a:lnTo>
                    <a:pt x="3331" y="7"/>
                  </a:lnTo>
                  <a:lnTo>
                    <a:pt x="3332" y="7"/>
                  </a:lnTo>
                  <a:lnTo>
                    <a:pt x="3332" y="6"/>
                  </a:lnTo>
                  <a:lnTo>
                    <a:pt x="3333" y="7"/>
                  </a:lnTo>
                  <a:lnTo>
                    <a:pt x="3334" y="6"/>
                  </a:lnTo>
                  <a:lnTo>
                    <a:pt x="3335" y="6"/>
                  </a:lnTo>
                  <a:lnTo>
                    <a:pt x="3336" y="6"/>
                  </a:lnTo>
                  <a:lnTo>
                    <a:pt x="3337" y="6"/>
                  </a:lnTo>
                  <a:lnTo>
                    <a:pt x="3338" y="6"/>
                  </a:lnTo>
                  <a:lnTo>
                    <a:pt x="3339" y="6"/>
                  </a:lnTo>
                  <a:lnTo>
                    <a:pt x="3339" y="6"/>
                  </a:lnTo>
                  <a:lnTo>
                    <a:pt x="3340" y="5"/>
                  </a:lnTo>
                  <a:lnTo>
                    <a:pt x="3341" y="5"/>
                  </a:lnTo>
                  <a:lnTo>
                    <a:pt x="3342" y="5"/>
                  </a:lnTo>
                  <a:lnTo>
                    <a:pt x="3343" y="5"/>
                  </a:lnTo>
                  <a:lnTo>
                    <a:pt x="3344" y="6"/>
                  </a:lnTo>
                  <a:lnTo>
                    <a:pt x="3345" y="6"/>
                  </a:lnTo>
                  <a:lnTo>
                    <a:pt x="3346" y="4"/>
                  </a:lnTo>
                  <a:lnTo>
                    <a:pt x="3347" y="5"/>
                  </a:lnTo>
                  <a:lnTo>
                    <a:pt x="3347" y="5"/>
                  </a:lnTo>
                  <a:lnTo>
                    <a:pt x="3348" y="4"/>
                  </a:lnTo>
                  <a:lnTo>
                    <a:pt x="3349" y="5"/>
                  </a:lnTo>
                  <a:lnTo>
                    <a:pt x="3350" y="5"/>
                  </a:lnTo>
                  <a:lnTo>
                    <a:pt x="3351" y="6"/>
                  </a:lnTo>
                  <a:lnTo>
                    <a:pt x="3352" y="5"/>
                  </a:lnTo>
                  <a:lnTo>
                    <a:pt x="3353" y="5"/>
                  </a:lnTo>
                  <a:lnTo>
                    <a:pt x="3354" y="4"/>
                  </a:lnTo>
                  <a:lnTo>
                    <a:pt x="3354" y="4"/>
                  </a:lnTo>
                  <a:lnTo>
                    <a:pt x="3355" y="5"/>
                  </a:lnTo>
                  <a:lnTo>
                    <a:pt x="3356" y="5"/>
                  </a:lnTo>
                  <a:lnTo>
                    <a:pt x="3357" y="5"/>
                  </a:lnTo>
                  <a:lnTo>
                    <a:pt x="3358" y="4"/>
                  </a:lnTo>
                  <a:lnTo>
                    <a:pt x="3359" y="5"/>
                  </a:lnTo>
                  <a:lnTo>
                    <a:pt x="3360" y="3"/>
                  </a:lnTo>
                  <a:lnTo>
                    <a:pt x="3361" y="4"/>
                  </a:lnTo>
                  <a:lnTo>
                    <a:pt x="3362" y="4"/>
                  </a:lnTo>
                  <a:lnTo>
                    <a:pt x="3362" y="3"/>
                  </a:lnTo>
                  <a:lnTo>
                    <a:pt x="3363" y="4"/>
                  </a:lnTo>
                  <a:lnTo>
                    <a:pt x="3364" y="4"/>
                  </a:lnTo>
                  <a:lnTo>
                    <a:pt x="3365" y="4"/>
                  </a:lnTo>
                  <a:lnTo>
                    <a:pt x="3366" y="4"/>
                  </a:lnTo>
                  <a:lnTo>
                    <a:pt x="3367" y="2"/>
                  </a:lnTo>
                  <a:lnTo>
                    <a:pt x="3368" y="2"/>
                  </a:lnTo>
                  <a:lnTo>
                    <a:pt x="3369" y="4"/>
                  </a:lnTo>
                  <a:lnTo>
                    <a:pt x="3369" y="2"/>
                  </a:lnTo>
                  <a:lnTo>
                    <a:pt x="3370" y="3"/>
                  </a:lnTo>
                  <a:lnTo>
                    <a:pt x="3371" y="3"/>
                  </a:lnTo>
                  <a:lnTo>
                    <a:pt x="3372" y="2"/>
                  </a:lnTo>
                  <a:lnTo>
                    <a:pt x="3373" y="3"/>
                  </a:lnTo>
                  <a:lnTo>
                    <a:pt x="3374" y="2"/>
                  </a:lnTo>
                  <a:lnTo>
                    <a:pt x="3375" y="3"/>
                  </a:lnTo>
                  <a:lnTo>
                    <a:pt x="3376" y="2"/>
                  </a:lnTo>
                  <a:lnTo>
                    <a:pt x="3377" y="2"/>
                  </a:lnTo>
                  <a:lnTo>
                    <a:pt x="3377" y="3"/>
                  </a:lnTo>
                  <a:lnTo>
                    <a:pt x="3378" y="2"/>
                  </a:lnTo>
                  <a:lnTo>
                    <a:pt x="3379" y="2"/>
                  </a:lnTo>
                  <a:lnTo>
                    <a:pt x="3380" y="2"/>
                  </a:lnTo>
                  <a:lnTo>
                    <a:pt x="3381" y="2"/>
                  </a:lnTo>
                  <a:lnTo>
                    <a:pt x="3382" y="3"/>
                  </a:lnTo>
                  <a:lnTo>
                    <a:pt x="3383" y="3"/>
                  </a:lnTo>
                  <a:lnTo>
                    <a:pt x="3384" y="2"/>
                  </a:lnTo>
                  <a:lnTo>
                    <a:pt x="3384" y="2"/>
                  </a:lnTo>
                  <a:lnTo>
                    <a:pt x="3385" y="2"/>
                  </a:lnTo>
                </a:path>
              </a:pathLst>
            </a:custGeom>
            <a:noFill/>
            <a:ln w="0">
              <a:solidFill>
                <a:srgbClr val="7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Freeform 180"/>
            <p:cNvSpPr>
              <a:spLocks/>
            </p:cNvSpPr>
            <p:nvPr/>
          </p:nvSpPr>
          <p:spPr bwMode="auto">
            <a:xfrm flipV="1">
              <a:off x="3629027" y="496888"/>
              <a:ext cx="2236788" cy="3054350"/>
            </a:xfrm>
            <a:custGeom>
              <a:avLst/>
              <a:gdLst>
                <a:gd name="T0" fmla="*/ 52 w 3386"/>
                <a:gd name="T1" fmla="*/ 2 h 4034"/>
                <a:gd name="T2" fmla="*/ 105 w 3386"/>
                <a:gd name="T3" fmla="*/ 2 h 4034"/>
                <a:gd name="T4" fmla="*/ 158 w 3386"/>
                <a:gd name="T5" fmla="*/ 2 h 4034"/>
                <a:gd name="T6" fmla="*/ 211 w 3386"/>
                <a:gd name="T7" fmla="*/ 1 h 4034"/>
                <a:gd name="T8" fmla="*/ 264 w 3386"/>
                <a:gd name="T9" fmla="*/ 1 h 4034"/>
                <a:gd name="T10" fmla="*/ 317 w 3386"/>
                <a:gd name="T11" fmla="*/ 0 h 4034"/>
                <a:gd name="T12" fmla="*/ 370 w 3386"/>
                <a:gd name="T13" fmla="*/ 1 h 4034"/>
                <a:gd name="T14" fmla="*/ 423 w 3386"/>
                <a:gd name="T15" fmla="*/ 0 h 4034"/>
                <a:gd name="T16" fmla="*/ 476 w 3386"/>
                <a:gd name="T17" fmla="*/ 0 h 4034"/>
                <a:gd name="T18" fmla="*/ 529 w 3386"/>
                <a:gd name="T19" fmla="*/ 0 h 4034"/>
                <a:gd name="T20" fmla="*/ 582 w 3386"/>
                <a:gd name="T21" fmla="*/ 0 h 4034"/>
                <a:gd name="T22" fmla="*/ 635 w 3386"/>
                <a:gd name="T23" fmla="*/ 1 h 4034"/>
                <a:gd name="T24" fmla="*/ 688 w 3386"/>
                <a:gd name="T25" fmla="*/ 0 h 4034"/>
                <a:gd name="T26" fmla="*/ 740 w 3386"/>
                <a:gd name="T27" fmla="*/ 1 h 4034"/>
                <a:gd name="T28" fmla="*/ 793 w 3386"/>
                <a:gd name="T29" fmla="*/ 2 h 4034"/>
                <a:gd name="T30" fmla="*/ 846 w 3386"/>
                <a:gd name="T31" fmla="*/ 3 h 4034"/>
                <a:gd name="T32" fmla="*/ 899 w 3386"/>
                <a:gd name="T33" fmla="*/ 3 h 4034"/>
                <a:gd name="T34" fmla="*/ 952 w 3386"/>
                <a:gd name="T35" fmla="*/ 6 h 4034"/>
                <a:gd name="T36" fmla="*/ 1005 w 3386"/>
                <a:gd name="T37" fmla="*/ 283 h 4034"/>
                <a:gd name="T38" fmla="*/ 1058 w 3386"/>
                <a:gd name="T39" fmla="*/ 24 h 4034"/>
                <a:gd name="T40" fmla="*/ 1111 w 3386"/>
                <a:gd name="T41" fmla="*/ 9 h 4034"/>
                <a:gd name="T42" fmla="*/ 1164 w 3386"/>
                <a:gd name="T43" fmla="*/ 10 h 4034"/>
                <a:gd name="T44" fmla="*/ 1217 w 3386"/>
                <a:gd name="T45" fmla="*/ 9 h 4034"/>
                <a:gd name="T46" fmla="*/ 1270 w 3386"/>
                <a:gd name="T47" fmla="*/ 15 h 4034"/>
                <a:gd name="T48" fmla="*/ 1323 w 3386"/>
                <a:gd name="T49" fmla="*/ 8 h 4034"/>
                <a:gd name="T50" fmla="*/ 1376 w 3386"/>
                <a:gd name="T51" fmla="*/ 10 h 4034"/>
                <a:gd name="T52" fmla="*/ 1428 w 3386"/>
                <a:gd name="T53" fmla="*/ 8 h 4034"/>
                <a:gd name="T54" fmla="*/ 1481 w 3386"/>
                <a:gd name="T55" fmla="*/ 4 h 4034"/>
                <a:gd name="T56" fmla="*/ 1534 w 3386"/>
                <a:gd name="T57" fmla="*/ 6 h 4034"/>
                <a:gd name="T58" fmla="*/ 1587 w 3386"/>
                <a:gd name="T59" fmla="*/ 5 h 4034"/>
                <a:gd name="T60" fmla="*/ 1640 w 3386"/>
                <a:gd name="T61" fmla="*/ 19 h 4034"/>
                <a:gd name="T62" fmla="*/ 1693 w 3386"/>
                <a:gd name="T63" fmla="*/ 12 h 4034"/>
                <a:gd name="T64" fmla="*/ 1746 w 3386"/>
                <a:gd name="T65" fmla="*/ 23 h 4034"/>
                <a:gd name="T66" fmla="*/ 1799 w 3386"/>
                <a:gd name="T67" fmla="*/ 719 h 4034"/>
                <a:gd name="T68" fmla="*/ 1852 w 3386"/>
                <a:gd name="T69" fmla="*/ 91 h 4034"/>
                <a:gd name="T70" fmla="*/ 1905 w 3386"/>
                <a:gd name="T71" fmla="*/ 35 h 4034"/>
                <a:gd name="T72" fmla="*/ 1958 w 3386"/>
                <a:gd name="T73" fmla="*/ 47 h 4034"/>
                <a:gd name="T74" fmla="*/ 2011 w 3386"/>
                <a:gd name="T75" fmla="*/ 23 h 4034"/>
                <a:gd name="T76" fmla="*/ 2064 w 3386"/>
                <a:gd name="T77" fmla="*/ 23 h 4034"/>
                <a:gd name="T78" fmla="*/ 2116 w 3386"/>
                <a:gd name="T79" fmla="*/ 35 h 4034"/>
                <a:gd name="T80" fmla="*/ 2169 w 3386"/>
                <a:gd name="T81" fmla="*/ 23 h 4034"/>
                <a:gd name="T82" fmla="*/ 2222 w 3386"/>
                <a:gd name="T83" fmla="*/ 18 h 4034"/>
                <a:gd name="T84" fmla="*/ 2275 w 3386"/>
                <a:gd name="T85" fmla="*/ 16 h 4034"/>
                <a:gd name="T86" fmla="*/ 2328 w 3386"/>
                <a:gd name="T87" fmla="*/ 19 h 4034"/>
                <a:gd name="T88" fmla="*/ 2381 w 3386"/>
                <a:gd name="T89" fmla="*/ 36 h 4034"/>
                <a:gd name="T90" fmla="*/ 2434 w 3386"/>
                <a:gd name="T91" fmla="*/ 982 h 4034"/>
                <a:gd name="T92" fmla="*/ 2487 w 3386"/>
                <a:gd name="T93" fmla="*/ 700 h 4034"/>
                <a:gd name="T94" fmla="*/ 2540 w 3386"/>
                <a:gd name="T95" fmla="*/ 1622 h 4034"/>
                <a:gd name="T96" fmla="*/ 2593 w 3386"/>
                <a:gd name="T97" fmla="*/ 139 h 4034"/>
                <a:gd name="T98" fmla="*/ 2646 w 3386"/>
                <a:gd name="T99" fmla="*/ 97 h 4034"/>
                <a:gd name="T100" fmla="*/ 2699 w 3386"/>
                <a:gd name="T101" fmla="*/ 68 h 4034"/>
                <a:gd name="T102" fmla="*/ 2752 w 3386"/>
                <a:gd name="T103" fmla="*/ 60 h 4034"/>
                <a:gd name="T104" fmla="*/ 2805 w 3386"/>
                <a:gd name="T105" fmla="*/ 56 h 4034"/>
                <a:gd name="T106" fmla="*/ 2857 w 3386"/>
                <a:gd name="T107" fmla="*/ 53 h 4034"/>
                <a:gd name="T108" fmla="*/ 2910 w 3386"/>
                <a:gd name="T109" fmla="*/ 49 h 4034"/>
                <a:gd name="T110" fmla="*/ 2963 w 3386"/>
                <a:gd name="T111" fmla="*/ 50 h 4034"/>
                <a:gd name="T112" fmla="*/ 3016 w 3386"/>
                <a:gd name="T113" fmla="*/ 98 h 4034"/>
                <a:gd name="T114" fmla="*/ 3069 w 3386"/>
                <a:gd name="T115" fmla="*/ 63 h 4034"/>
                <a:gd name="T116" fmla="*/ 3122 w 3386"/>
                <a:gd name="T117" fmla="*/ 279 h 4034"/>
                <a:gd name="T118" fmla="*/ 3175 w 3386"/>
                <a:gd name="T119" fmla="*/ 89 h 4034"/>
                <a:gd name="T120" fmla="*/ 3228 w 3386"/>
                <a:gd name="T121" fmla="*/ 76 h 4034"/>
                <a:gd name="T122" fmla="*/ 3281 w 3386"/>
                <a:gd name="T123" fmla="*/ 62 h 4034"/>
                <a:gd name="T124" fmla="*/ 3334 w 3386"/>
                <a:gd name="T125" fmla="*/ 46 h 40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3386" h="4034">
                  <a:moveTo>
                    <a:pt x="0" y="1"/>
                  </a:moveTo>
                  <a:lnTo>
                    <a:pt x="1" y="1"/>
                  </a:lnTo>
                  <a:lnTo>
                    <a:pt x="2" y="1"/>
                  </a:lnTo>
                  <a:lnTo>
                    <a:pt x="3" y="1"/>
                  </a:lnTo>
                  <a:lnTo>
                    <a:pt x="4" y="1"/>
                  </a:lnTo>
                  <a:lnTo>
                    <a:pt x="5" y="1"/>
                  </a:lnTo>
                  <a:lnTo>
                    <a:pt x="6" y="0"/>
                  </a:lnTo>
                  <a:lnTo>
                    <a:pt x="7" y="0"/>
                  </a:lnTo>
                  <a:lnTo>
                    <a:pt x="7" y="0"/>
                  </a:lnTo>
                  <a:lnTo>
                    <a:pt x="8" y="1"/>
                  </a:lnTo>
                  <a:lnTo>
                    <a:pt x="9" y="1"/>
                  </a:lnTo>
                  <a:lnTo>
                    <a:pt x="10" y="1"/>
                  </a:lnTo>
                  <a:lnTo>
                    <a:pt x="11" y="1"/>
                  </a:lnTo>
                  <a:lnTo>
                    <a:pt x="12" y="1"/>
                  </a:lnTo>
                  <a:lnTo>
                    <a:pt x="13" y="0"/>
                  </a:lnTo>
                  <a:lnTo>
                    <a:pt x="14" y="1"/>
                  </a:lnTo>
                  <a:lnTo>
                    <a:pt x="14" y="1"/>
                  </a:lnTo>
                  <a:lnTo>
                    <a:pt x="15" y="0"/>
                  </a:lnTo>
                  <a:lnTo>
                    <a:pt x="16" y="1"/>
                  </a:lnTo>
                  <a:lnTo>
                    <a:pt x="17" y="1"/>
                  </a:lnTo>
                  <a:lnTo>
                    <a:pt x="18" y="1"/>
                  </a:lnTo>
                  <a:lnTo>
                    <a:pt x="19" y="0"/>
                  </a:lnTo>
                  <a:lnTo>
                    <a:pt x="20" y="1"/>
                  </a:lnTo>
                  <a:lnTo>
                    <a:pt x="21" y="0"/>
                  </a:lnTo>
                  <a:lnTo>
                    <a:pt x="22" y="1"/>
                  </a:lnTo>
                  <a:lnTo>
                    <a:pt x="22" y="1"/>
                  </a:lnTo>
                  <a:lnTo>
                    <a:pt x="23" y="1"/>
                  </a:lnTo>
                  <a:lnTo>
                    <a:pt x="24" y="1"/>
                  </a:lnTo>
                  <a:lnTo>
                    <a:pt x="25" y="1"/>
                  </a:lnTo>
                  <a:lnTo>
                    <a:pt x="26" y="1"/>
                  </a:lnTo>
                  <a:lnTo>
                    <a:pt x="27" y="1"/>
                  </a:lnTo>
                  <a:lnTo>
                    <a:pt x="28" y="1"/>
                  </a:lnTo>
                  <a:lnTo>
                    <a:pt x="29" y="1"/>
                  </a:lnTo>
                  <a:lnTo>
                    <a:pt x="29" y="2"/>
                  </a:lnTo>
                  <a:lnTo>
                    <a:pt x="30" y="1"/>
                  </a:lnTo>
                  <a:lnTo>
                    <a:pt x="31" y="0"/>
                  </a:lnTo>
                  <a:lnTo>
                    <a:pt x="32" y="1"/>
                  </a:lnTo>
                  <a:lnTo>
                    <a:pt x="33" y="1"/>
                  </a:lnTo>
                  <a:lnTo>
                    <a:pt x="34" y="1"/>
                  </a:lnTo>
                  <a:lnTo>
                    <a:pt x="35" y="0"/>
                  </a:lnTo>
                  <a:lnTo>
                    <a:pt x="36" y="0"/>
                  </a:lnTo>
                  <a:lnTo>
                    <a:pt x="37" y="1"/>
                  </a:lnTo>
                  <a:lnTo>
                    <a:pt x="37" y="1"/>
                  </a:lnTo>
                  <a:lnTo>
                    <a:pt x="38" y="1"/>
                  </a:lnTo>
                  <a:lnTo>
                    <a:pt x="39" y="1"/>
                  </a:lnTo>
                  <a:lnTo>
                    <a:pt x="40" y="1"/>
                  </a:lnTo>
                  <a:lnTo>
                    <a:pt x="41" y="1"/>
                  </a:lnTo>
                  <a:lnTo>
                    <a:pt x="42" y="2"/>
                  </a:lnTo>
                  <a:lnTo>
                    <a:pt x="43" y="2"/>
                  </a:lnTo>
                  <a:lnTo>
                    <a:pt x="44" y="2"/>
                  </a:lnTo>
                  <a:lnTo>
                    <a:pt x="44" y="3"/>
                  </a:lnTo>
                  <a:lnTo>
                    <a:pt x="45" y="3"/>
                  </a:lnTo>
                  <a:lnTo>
                    <a:pt x="46" y="3"/>
                  </a:lnTo>
                  <a:lnTo>
                    <a:pt x="47" y="4"/>
                  </a:lnTo>
                  <a:lnTo>
                    <a:pt x="48" y="4"/>
                  </a:lnTo>
                  <a:lnTo>
                    <a:pt x="49" y="4"/>
                  </a:lnTo>
                  <a:lnTo>
                    <a:pt x="50" y="3"/>
                  </a:lnTo>
                  <a:lnTo>
                    <a:pt x="51" y="3"/>
                  </a:lnTo>
                  <a:lnTo>
                    <a:pt x="52" y="3"/>
                  </a:lnTo>
                  <a:lnTo>
                    <a:pt x="52" y="2"/>
                  </a:lnTo>
                  <a:lnTo>
                    <a:pt x="53" y="2"/>
                  </a:lnTo>
                  <a:lnTo>
                    <a:pt x="54" y="1"/>
                  </a:lnTo>
                  <a:lnTo>
                    <a:pt x="55" y="2"/>
                  </a:lnTo>
                  <a:lnTo>
                    <a:pt x="56" y="2"/>
                  </a:lnTo>
                  <a:lnTo>
                    <a:pt x="57" y="1"/>
                  </a:lnTo>
                  <a:lnTo>
                    <a:pt x="58" y="2"/>
                  </a:lnTo>
                  <a:lnTo>
                    <a:pt x="59" y="1"/>
                  </a:lnTo>
                  <a:lnTo>
                    <a:pt x="59" y="1"/>
                  </a:lnTo>
                  <a:lnTo>
                    <a:pt x="60" y="1"/>
                  </a:lnTo>
                  <a:lnTo>
                    <a:pt x="61" y="1"/>
                  </a:lnTo>
                  <a:lnTo>
                    <a:pt x="62" y="1"/>
                  </a:lnTo>
                  <a:lnTo>
                    <a:pt x="63" y="0"/>
                  </a:lnTo>
                  <a:lnTo>
                    <a:pt x="64" y="1"/>
                  </a:lnTo>
                  <a:lnTo>
                    <a:pt x="65" y="0"/>
                  </a:lnTo>
                  <a:lnTo>
                    <a:pt x="66" y="1"/>
                  </a:lnTo>
                  <a:lnTo>
                    <a:pt x="67" y="0"/>
                  </a:lnTo>
                  <a:lnTo>
                    <a:pt x="67" y="1"/>
                  </a:lnTo>
                  <a:lnTo>
                    <a:pt x="68" y="1"/>
                  </a:lnTo>
                  <a:lnTo>
                    <a:pt x="69" y="1"/>
                  </a:lnTo>
                  <a:lnTo>
                    <a:pt x="70" y="0"/>
                  </a:lnTo>
                  <a:lnTo>
                    <a:pt x="71" y="0"/>
                  </a:lnTo>
                  <a:lnTo>
                    <a:pt x="72" y="0"/>
                  </a:lnTo>
                  <a:lnTo>
                    <a:pt x="73" y="0"/>
                  </a:lnTo>
                  <a:lnTo>
                    <a:pt x="74" y="0"/>
                  </a:lnTo>
                  <a:lnTo>
                    <a:pt x="74" y="0"/>
                  </a:lnTo>
                  <a:lnTo>
                    <a:pt x="75" y="0"/>
                  </a:lnTo>
                  <a:lnTo>
                    <a:pt x="76" y="0"/>
                  </a:lnTo>
                  <a:lnTo>
                    <a:pt x="77" y="0"/>
                  </a:lnTo>
                  <a:lnTo>
                    <a:pt x="78" y="0"/>
                  </a:lnTo>
                  <a:lnTo>
                    <a:pt x="79" y="0"/>
                  </a:lnTo>
                  <a:lnTo>
                    <a:pt x="80" y="0"/>
                  </a:lnTo>
                  <a:lnTo>
                    <a:pt x="81" y="0"/>
                  </a:lnTo>
                  <a:lnTo>
                    <a:pt x="82" y="1"/>
                  </a:lnTo>
                  <a:lnTo>
                    <a:pt x="82" y="1"/>
                  </a:lnTo>
                  <a:lnTo>
                    <a:pt x="83" y="0"/>
                  </a:lnTo>
                  <a:lnTo>
                    <a:pt x="84" y="1"/>
                  </a:lnTo>
                  <a:lnTo>
                    <a:pt x="85" y="1"/>
                  </a:lnTo>
                  <a:lnTo>
                    <a:pt x="86" y="1"/>
                  </a:lnTo>
                  <a:lnTo>
                    <a:pt x="87" y="0"/>
                  </a:lnTo>
                  <a:lnTo>
                    <a:pt x="88" y="1"/>
                  </a:lnTo>
                  <a:lnTo>
                    <a:pt x="89" y="1"/>
                  </a:lnTo>
                  <a:lnTo>
                    <a:pt x="89" y="1"/>
                  </a:lnTo>
                  <a:lnTo>
                    <a:pt x="90" y="1"/>
                  </a:lnTo>
                  <a:lnTo>
                    <a:pt x="91" y="2"/>
                  </a:lnTo>
                  <a:lnTo>
                    <a:pt x="92" y="2"/>
                  </a:lnTo>
                  <a:lnTo>
                    <a:pt x="93" y="2"/>
                  </a:lnTo>
                  <a:lnTo>
                    <a:pt x="94" y="2"/>
                  </a:lnTo>
                  <a:lnTo>
                    <a:pt x="95" y="2"/>
                  </a:lnTo>
                  <a:lnTo>
                    <a:pt x="96" y="2"/>
                  </a:lnTo>
                  <a:lnTo>
                    <a:pt x="97" y="2"/>
                  </a:lnTo>
                  <a:lnTo>
                    <a:pt x="97" y="2"/>
                  </a:lnTo>
                  <a:lnTo>
                    <a:pt x="98" y="2"/>
                  </a:lnTo>
                  <a:lnTo>
                    <a:pt x="99" y="2"/>
                  </a:lnTo>
                  <a:lnTo>
                    <a:pt x="100" y="3"/>
                  </a:lnTo>
                  <a:lnTo>
                    <a:pt x="101" y="2"/>
                  </a:lnTo>
                  <a:lnTo>
                    <a:pt x="102" y="3"/>
                  </a:lnTo>
                  <a:lnTo>
                    <a:pt x="103" y="2"/>
                  </a:lnTo>
                  <a:lnTo>
                    <a:pt x="104" y="2"/>
                  </a:lnTo>
                  <a:lnTo>
                    <a:pt x="104" y="3"/>
                  </a:lnTo>
                  <a:lnTo>
                    <a:pt x="105" y="2"/>
                  </a:lnTo>
                  <a:lnTo>
                    <a:pt x="106" y="3"/>
                  </a:lnTo>
                  <a:lnTo>
                    <a:pt x="107" y="2"/>
                  </a:lnTo>
                  <a:lnTo>
                    <a:pt x="108" y="2"/>
                  </a:lnTo>
                  <a:lnTo>
                    <a:pt x="109" y="2"/>
                  </a:lnTo>
                  <a:lnTo>
                    <a:pt x="110" y="1"/>
                  </a:lnTo>
                  <a:lnTo>
                    <a:pt x="111" y="2"/>
                  </a:lnTo>
                  <a:lnTo>
                    <a:pt x="112" y="2"/>
                  </a:lnTo>
                  <a:lnTo>
                    <a:pt x="112" y="2"/>
                  </a:lnTo>
                  <a:lnTo>
                    <a:pt x="113" y="2"/>
                  </a:lnTo>
                  <a:lnTo>
                    <a:pt x="114" y="2"/>
                  </a:lnTo>
                  <a:lnTo>
                    <a:pt x="115" y="1"/>
                  </a:lnTo>
                  <a:lnTo>
                    <a:pt x="116" y="2"/>
                  </a:lnTo>
                  <a:lnTo>
                    <a:pt x="117" y="2"/>
                  </a:lnTo>
                  <a:lnTo>
                    <a:pt x="118" y="2"/>
                  </a:lnTo>
                  <a:lnTo>
                    <a:pt x="119" y="1"/>
                  </a:lnTo>
                  <a:lnTo>
                    <a:pt x="119" y="1"/>
                  </a:lnTo>
                  <a:lnTo>
                    <a:pt x="120" y="1"/>
                  </a:lnTo>
                  <a:lnTo>
                    <a:pt x="121" y="1"/>
                  </a:lnTo>
                  <a:lnTo>
                    <a:pt x="122" y="1"/>
                  </a:lnTo>
                  <a:lnTo>
                    <a:pt x="123" y="1"/>
                  </a:lnTo>
                  <a:lnTo>
                    <a:pt x="124" y="1"/>
                  </a:lnTo>
                  <a:lnTo>
                    <a:pt x="125" y="1"/>
                  </a:lnTo>
                  <a:lnTo>
                    <a:pt x="126" y="1"/>
                  </a:lnTo>
                  <a:lnTo>
                    <a:pt x="126" y="2"/>
                  </a:lnTo>
                  <a:lnTo>
                    <a:pt x="127" y="2"/>
                  </a:lnTo>
                  <a:lnTo>
                    <a:pt x="128" y="1"/>
                  </a:lnTo>
                  <a:lnTo>
                    <a:pt x="129" y="3"/>
                  </a:lnTo>
                  <a:lnTo>
                    <a:pt x="130" y="3"/>
                  </a:lnTo>
                  <a:lnTo>
                    <a:pt x="131" y="4"/>
                  </a:lnTo>
                  <a:lnTo>
                    <a:pt x="132" y="4"/>
                  </a:lnTo>
                  <a:lnTo>
                    <a:pt x="133" y="3"/>
                  </a:lnTo>
                  <a:lnTo>
                    <a:pt x="134" y="5"/>
                  </a:lnTo>
                  <a:lnTo>
                    <a:pt x="134" y="4"/>
                  </a:lnTo>
                  <a:lnTo>
                    <a:pt x="135" y="5"/>
                  </a:lnTo>
                  <a:lnTo>
                    <a:pt x="136" y="5"/>
                  </a:lnTo>
                  <a:lnTo>
                    <a:pt x="137" y="5"/>
                  </a:lnTo>
                  <a:lnTo>
                    <a:pt x="138" y="4"/>
                  </a:lnTo>
                  <a:lnTo>
                    <a:pt x="139" y="4"/>
                  </a:lnTo>
                  <a:lnTo>
                    <a:pt x="140" y="4"/>
                  </a:lnTo>
                  <a:lnTo>
                    <a:pt x="141" y="4"/>
                  </a:lnTo>
                  <a:lnTo>
                    <a:pt x="141" y="3"/>
                  </a:lnTo>
                  <a:lnTo>
                    <a:pt x="142" y="4"/>
                  </a:lnTo>
                  <a:lnTo>
                    <a:pt x="143" y="3"/>
                  </a:lnTo>
                  <a:lnTo>
                    <a:pt x="144" y="3"/>
                  </a:lnTo>
                  <a:lnTo>
                    <a:pt x="145" y="3"/>
                  </a:lnTo>
                  <a:lnTo>
                    <a:pt x="146" y="3"/>
                  </a:lnTo>
                  <a:lnTo>
                    <a:pt x="147" y="3"/>
                  </a:lnTo>
                  <a:lnTo>
                    <a:pt x="148" y="3"/>
                  </a:lnTo>
                  <a:lnTo>
                    <a:pt x="149" y="3"/>
                  </a:lnTo>
                  <a:lnTo>
                    <a:pt x="149" y="3"/>
                  </a:lnTo>
                  <a:lnTo>
                    <a:pt x="150" y="3"/>
                  </a:lnTo>
                  <a:lnTo>
                    <a:pt x="151" y="2"/>
                  </a:lnTo>
                  <a:lnTo>
                    <a:pt x="152" y="3"/>
                  </a:lnTo>
                  <a:lnTo>
                    <a:pt x="153" y="2"/>
                  </a:lnTo>
                  <a:lnTo>
                    <a:pt x="154" y="2"/>
                  </a:lnTo>
                  <a:lnTo>
                    <a:pt x="155" y="3"/>
                  </a:lnTo>
                  <a:lnTo>
                    <a:pt x="156" y="2"/>
                  </a:lnTo>
                  <a:lnTo>
                    <a:pt x="156" y="2"/>
                  </a:lnTo>
                  <a:lnTo>
                    <a:pt x="157" y="3"/>
                  </a:lnTo>
                  <a:lnTo>
                    <a:pt x="158" y="2"/>
                  </a:lnTo>
                  <a:lnTo>
                    <a:pt x="159" y="2"/>
                  </a:lnTo>
                  <a:lnTo>
                    <a:pt x="160" y="3"/>
                  </a:lnTo>
                  <a:lnTo>
                    <a:pt x="161" y="3"/>
                  </a:lnTo>
                  <a:lnTo>
                    <a:pt x="162" y="2"/>
                  </a:lnTo>
                  <a:lnTo>
                    <a:pt x="163" y="2"/>
                  </a:lnTo>
                  <a:lnTo>
                    <a:pt x="164" y="2"/>
                  </a:lnTo>
                  <a:lnTo>
                    <a:pt x="164" y="2"/>
                  </a:lnTo>
                  <a:lnTo>
                    <a:pt x="165" y="2"/>
                  </a:lnTo>
                  <a:lnTo>
                    <a:pt x="166" y="2"/>
                  </a:lnTo>
                  <a:lnTo>
                    <a:pt x="167" y="1"/>
                  </a:lnTo>
                  <a:lnTo>
                    <a:pt x="168" y="2"/>
                  </a:lnTo>
                  <a:lnTo>
                    <a:pt x="169" y="2"/>
                  </a:lnTo>
                  <a:lnTo>
                    <a:pt x="170" y="2"/>
                  </a:lnTo>
                  <a:lnTo>
                    <a:pt x="171" y="2"/>
                  </a:lnTo>
                  <a:lnTo>
                    <a:pt x="171" y="2"/>
                  </a:lnTo>
                  <a:lnTo>
                    <a:pt x="172" y="1"/>
                  </a:lnTo>
                  <a:lnTo>
                    <a:pt x="173" y="2"/>
                  </a:lnTo>
                  <a:lnTo>
                    <a:pt x="174" y="1"/>
                  </a:lnTo>
                  <a:lnTo>
                    <a:pt x="175" y="2"/>
                  </a:lnTo>
                  <a:lnTo>
                    <a:pt x="176" y="1"/>
                  </a:lnTo>
                  <a:lnTo>
                    <a:pt x="177" y="2"/>
                  </a:lnTo>
                  <a:lnTo>
                    <a:pt x="178" y="1"/>
                  </a:lnTo>
                  <a:lnTo>
                    <a:pt x="179" y="2"/>
                  </a:lnTo>
                  <a:lnTo>
                    <a:pt x="179" y="2"/>
                  </a:lnTo>
                  <a:lnTo>
                    <a:pt x="180" y="2"/>
                  </a:lnTo>
                  <a:lnTo>
                    <a:pt x="181" y="2"/>
                  </a:lnTo>
                  <a:lnTo>
                    <a:pt x="182" y="1"/>
                  </a:lnTo>
                  <a:lnTo>
                    <a:pt x="183" y="2"/>
                  </a:lnTo>
                  <a:lnTo>
                    <a:pt x="184" y="2"/>
                  </a:lnTo>
                  <a:lnTo>
                    <a:pt x="185" y="1"/>
                  </a:lnTo>
                  <a:lnTo>
                    <a:pt x="186" y="2"/>
                  </a:lnTo>
                  <a:lnTo>
                    <a:pt x="186" y="2"/>
                  </a:lnTo>
                  <a:lnTo>
                    <a:pt x="187" y="1"/>
                  </a:lnTo>
                  <a:lnTo>
                    <a:pt x="188" y="2"/>
                  </a:lnTo>
                  <a:lnTo>
                    <a:pt x="189" y="1"/>
                  </a:lnTo>
                  <a:lnTo>
                    <a:pt x="190" y="1"/>
                  </a:lnTo>
                  <a:lnTo>
                    <a:pt x="191" y="2"/>
                  </a:lnTo>
                  <a:lnTo>
                    <a:pt x="192" y="1"/>
                  </a:lnTo>
                  <a:lnTo>
                    <a:pt x="193" y="2"/>
                  </a:lnTo>
                  <a:lnTo>
                    <a:pt x="194" y="2"/>
                  </a:lnTo>
                  <a:lnTo>
                    <a:pt x="194" y="2"/>
                  </a:lnTo>
                  <a:lnTo>
                    <a:pt x="195" y="2"/>
                  </a:lnTo>
                  <a:lnTo>
                    <a:pt x="196" y="1"/>
                  </a:lnTo>
                  <a:lnTo>
                    <a:pt x="197" y="2"/>
                  </a:lnTo>
                  <a:lnTo>
                    <a:pt x="198" y="2"/>
                  </a:lnTo>
                  <a:lnTo>
                    <a:pt x="199" y="2"/>
                  </a:lnTo>
                  <a:lnTo>
                    <a:pt x="200" y="1"/>
                  </a:lnTo>
                  <a:lnTo>
                    <a:pt x="201" y="1"/>
                  </a:lnTo>
                  <a:lnTo>
                    <a:pt x="201" y="1"/>
                  </a:lnTo>
                  <a:lnTo>
                    <a:pt x="202" y="2"/>
                  </a:lnTo>
                  <a:lnTo>
                    <a:pt x="203" y="1"/>
                  </a:lnTo>
                  <a:lnTo>
                    <a:pt x="204" y="1"/>
                  </a:lnTo>
                  <a:lnTo>
                    <a:pt x="205" y="1"/>
                  </a:lnTo>
                  <a:lnTo>
                    <a:pt x="206" y="1"/>
                  </a:lnTo>
                  <a:lnTo>
                    <a:pt x="207" y="1"/>
                  </a:lnTo>
                  <a:lnTo>
                    <a:pt x="208" y="1"/>
                  </a:lnTo>
                  <a:lnTo>
                    <a:pt x="209" y="1"/>
                  </a:lnTo>
                  <a:lnTo>
                    <a:pt x="209" y="1"/>
                  </a:lnTo>
                  <a:lnTo>
                    <a:pt x="210" y="1"/>
                  </a:lnTo>
                  <a:lnTo>
                    <a:pt x="211" y="1"/>
                  </a:lnTo>
                  <a:lnTo>
                    <a:pt x="212" y="1"/>
                  </a:lnTo>
                  <a:lnTo>
                    <a:pt x="213" y="0"/>
                  </a:lnTo>
                  <a:lnTo>
                    <a:pt x="214" y="1"/>
                  </a:lnTo>
                  <a:lnTo>
                    <a:pt x="215" y="1"/>
                  </a:lnTo>
                  <a:lnTo>
                    <a:pt x="216" y="1"/>
                  </a:lnTo>
                  <a:lnTo>
                    <a:pt x="216" y="2"/>
                  </a:lnTo>
                  <a:lnTo>
                    <a:pt x="217" y="1"/>
                  </a:lnTo>
                  <a:lnTo>
                    <a:pt x="218" y="1"/>
                  </a:lnTo>
                  <a:lnTo>
                    <a:pt x="219" y="1"/>
                  </a:lnTo>
                  <a:lnTo>
                    <a:pt x="220" y="1"/>
                  </a:lnTo>
                  <a:lnTo>
                    <a:pt x="221" y="1"/>
                  </a:lnTo>
                  <a:lnTo>
                    <a:pt x="222" y="1"/>
                  </a:lnTo>
                  <a:lnTo>
                    <a:pt x="223" y="2"/>
                  </a:lnTo>
                  <a:lnTo>
                    <a:pt x="224" y="2"/>
                  </a:lnTo>
                  <a:lnTo>
                    <a:pt x="224" y="2"/>
                  </a:lnTo>
                  <a:lnTo>
                    <a:pt x="225" y="1"/>
                  </a:lnTo>
                  <a:lnTo>
                    <a:pt x="226" y="2"/>
                  </a:lnTo>
                  <a:lnTo>
                    <a:pt x="227" y="2"/>
                  </a:lnTo>
                  <a:lnTo>
                    <a:pt x="228" y="2"/>
                  </a:lnTo>
                  <a:lnTo>
                    <a:pt x="229" y="2"/>
                  </a:lnTo>
                  <a:lnTo>
                    <a:pt x="230" y="2"/>
                  </a:lnTo>
                  <a:lnTo>
                    <a:pt x="231" y="1"/>
                  </a:lnTo>
                  <a:lnTo>
                    <a:pt x="231" y="1"/>
                  </a:lnTo>
                  <a:lnTo>
                    <a:pt x="232" y="2"/>
                  </a:lnTo>
                  <a:lnTo>
                    <a:pt x="233" y="2"/>
                  </a:lnTo>
                  <a:lnTo>
                    <a:pt x="234" y="1"/>
                  </a:lnTo>
                  <a:lnTo>
                    <a:pt x="235" y="2"/>
                  </a:lnTo>
                  <a:lnTo>
                    <a:pt x="236" y="1"/>
                  </a:lnTo>
                  <a:lnTo>
                    <a:pt x="237" y="1"/>
                  </a:lnTo>
                  <a:lnTo>
                    <a:pt x="238" y="1"/>
                  </a:lnTo>
                  <a:lnTo>
                    <a:pt x="239" y="2"/>
                  </a:lnTo>
                  <a:lnTo>
                    <a:pt x="239" y="2"/>
                  </a:lnTo>
                  <a:lnTo>
                    <a:pt x="240" y="2"/>
                  </a:lnTo>
                  <a:lnTo>
                    <a:pt x="241" y="3"/>
                  </a:lnTo>
                  <a:lnTo>
                    <a:pt x="242" y="3"/>
                  </a:lnTo>
                  <a:lnTo>
                    <a:pt x="243" y="4"/>
                  </a:lnTo>
                  <a:lnTo>
                    <a:pt x="244" y="3"/>
                  </a:lnTo>
                  <a:lnTo>
                    <a:pt x="245" y="4"/>
                  </a:lnTo>
                  <a:lnTo>
                    <a:pt x="246" y="4"/>
                  </a:lnTo>
                  <a:lnTo>
                    <a:pt x="246" y="3"/>
                  </a:lnTo>
                  <a:lnTo>
                    <a:pt x="247" y="3"/>
                  </a:lnTo>
                  <a:lnTo>
                    <a:pt x="248" y="4"/>
                  </a:lnTo>
                  <a:lnTo>
                    <a:pt x="249" y="3"/>
                  </a:lnTo>
                  <a:lnTo>
                    <a:pt x="250" y="4"/>
                  </a:lnTo>
                  <a:lnTo>
                    <a:pt x="251" y="3"/>
                  </a:lnTo>
                  <a:lnTo>
                    <a:pt x="252" y="2"/>
                  </a:lnTo>
                  <a:lnTo>
                    <a:pt x="253" y="3"/>
                  </a:lnTo>
                  <a:lnTo>
                    <a:pt x="254" y="2"/>
                  </a:lnTo>
                  <a:lnTo>
                    <a:pt x="254" y="3"/>
                  </a:lnTo>
                  <a:lnTo>
                    <a:pt x="255" y="1"/>
                  </a:lnTo>
                  <a:lnTo>
                    <a:pt x="256" y="2"/>
                  </a:lnTo>
                  <a:lnTo>
                    <a:pt x="257" y="2"/>
                  </a:lnTo>
                  <a:lnTo>
                    <a:pt x="258" y="2"/>
                  </a:lnTo>
                  <a:lnTo>
                    <a:pt x="259" y="1"/>
                  </a:lnTo>
                  <a:lnTo>
                    <a:pt x="260" y="1"/>
                  </a:lnTo>
                  <a:lnTo>
                    <a:pt x="261" y="1"/>
                  </a:lnTo>
                  <a:lnTo>
                    <a:pt x="261" y="2"/>
                  </a:lnTo>
                  <a:lnTo>
                    <a:pt x="262" y="1"/>
                  </a:lnTo>
                  <a:lnTo>
                    <a:pt x="263" y="1"/>
                  </a:lnTo>
                  <a:lnTo>
                    <a:pt x="264" y="1"/>
                  </a:lnTo>
                  <a:lnTo>
                    <a:pt x="265" y="1"/>
                  </a:lnTo>
                  <a:lnTo>
                    <a:pt x="266" y="1"/>
                  </a:lnTo>
                  <a:lnTo>
                    <a:pt x="267" y="1"/>
                  </a:lnTo>
                  <a:lnTo>
                    <a:pt x="268" y="1"/>
                  </a:lnTo>
                  <a:lnTo>
                    <a:pt x="269" y="1"/>
                  </a:lnTo>
                  <a:lnTo>
                    <a:pt x="269" y="1"/>
                  </a:lnTo>
                  <a:lnTo>
                    <a:pt x="270" y="1"/>
                  </a:lnTo>
                  <a:lnTo>
                    <a:pt x="271" y="1"/>
                  </a:lnTo>
                  <a:lnTo>
                    <a:pt x="272" y="1"/>
                  </a:lnTo>
                  <a:lnTo>
                    <a:pt x="273" y="0"/>
                  </a:lnTo>
                  <a:lnTo>
                    <a:pt x="274" y="1"/>
                  </a:lnTo>
                  <a:lnTo>
                    <a:pt x="275" y="2"/>
                  </a:lnTo>
                  <a:lnTo>
                    <a:pt x="276" y="1"/>
                  </a:lnTo>
                  <a:lnTo>
                    <a:pt x="276" y="1"/>
                  </a:lnTo>
                  <a:lnTo>
                    <a:pt x="277" y="1"/>
                  </a:lnTo>
                  <a:lnTo>
                    <a:pt x="278" y="0"/>
                  </a:lnTo>
                  <a:lnTo>
                    <a:pt x="279" y="1"/>
                  </a:lnTo>
                  <a:lnTo>
                    <a:pt x="280" y="1"/>
                  </a:lnTo>
                  <a:lnTo>
                    <a:pt x="281" y="1"/>
                  </a:lnTo>
                  <a:lnTo>
                    <a:pt x="282" y="1"/>
                  </a:lnTo>
                  <a:lnTo>
                    <a:pt x="283" y="1"/>
                  </a:lnTo>
                  <a:lnTo>
                    <a:pt x="284" y="1"/>
                  </a:lnTo>
                  <a:lnTo>
                    <a:pt x="284" y="1"/>
                  </a:lnTo>
                  <a:lnTo>
                    <a:pt x="285" y="1"/>
                  </a:lnTo>
                  <a:lnTo>
                    <a:pt x="286" y="1"/>
                  </a:lnTo>
                  <a:lnTo>
                    <a:pt x="287" y="1"/>
                  </a:lnTo>
                  <a:lnTo>
                    <a:pt x="288" y="0"/>
                  </a:lnTo>
                  <a:lnTo>
                    <a:pt x="289" y="1"/>
                  </a:lnTo>
                  <a:lnTo>
                    <a:pt x="290" y="1"/>
                  </a:lnTo>
                  <a:lnTo>
                    <a:pt x="291" y="0"/>
                  </a:lnTo>
                  <a:lnTo>
                    <a:pt x="291" y="0"/>
                  </a:lnTo>
                  <a:lnTo>
                    <a:pt x="292" y="1"/>
                  </a:lnTo>
                  <a:lnTo>
                    <a:pt x="293" y="1"/>
                  </a:lnTo>
                  <a:lnTo>
                    <a:pt x="294" y="1"/>
                  </a:lnTo>
                  <a:lnTo>
                    <a:pt x="295" y="1"/>
                  </a:lnTo>
                  <a:lnTo>
                    <a:pt x="296" y="0"/>
                  </a:lnTo>
                  <a:lnTo>
                    <a:pt x="297" y="1"/>
                  </a:lnTo>
                  <a:lnTo>
                    <a:pt x="298" y="1"/>
                  </a:lnTo>
                  <a:lnTo>
                    <a:pt x="299" y="1"/>
                  </a:lnTo>
                  <a:lnTo>
                    <a:pt x="299" y="1"/>
                  </a:lnTo>
                  <a:lnTo>
                    <a:pt x="300" y="0"/>
                  </a:lnTo>
                  <a:lnTo>
                    <a:pt x="301" y="0"/>
                  </a:lnTo>
                  <a:lnTo>
                    <a:pt x="302" y="1"/>
                  </a:lnTo>
                  <a:lnTo>
                    <a:pt x="303" y="1"/>
                  </a:lnTo>
                  <a:lnTo>
                    <a:pt x="304" y="1"/>
                  </a:lnTo>
                  <a:lnTo>
                    <a:pt x="305" y="1"/>
                  </a:lnTo>
                  <a:lnTo>
                    <a:pt x="306" y="1"/>
                  </a:lnTo>
                  <a:lnTo>
                    <a:pt x="306" y="0"/>
                  </a:lnTo>
                  <a:lnTo>
                    <a:pt x="307" y="1"/>
                  </a:lnTo>
                  <a:lnTo>
                    <a:pt x="308" y="1"/>
                  </a:lnTo>
                  <a:lnTo>
                    <a:pt x="309" y="1"/>
                  </a:lnTo>
                  <a:lnTo>
                    <a:pt x="310" y="1"/>
                  </a:lnTo>
                  <a:lnTo>
                    <a:pt x="311" y="1"/>
                  </a:lnTo>
                  <a:lnTo>
                    <a:pt x="312" y="1"/>
                  </a:lnTo>
                  <a:lnTo>
                    <a:pt x="313" y="1"/>
                  </a:lnTo>
                  <a:lnTo>
                    <a:pt x="314" y="1"/>
                  </a:lnTo>
                  <a:lnTo>
                    <a:pt x="314" y="2"/>
                  </a:lnTo>
                  <a:lnTo>
                    <a:pt x="315" y="1"/>
                  </a:lnTo>
                  <a:lnTo>
                    <a:pt x="316" y="1"/>
                  </a:lnTo>
                  <a:lnTo>
                    <a:pt x="317" y="0"/>
                  </a:lnTo>
                  <a:lnTo>
                    <a:pt x="318" y="1"/>
                  </a:lnTo>
                  <a:lnTo>
                    <a:pt x="319" y="1"/>
                  </a:lnTo>
                  <a:lnTo>
                    <a:pt x="320" y="1"/>
                  </a:lnTo>
                  <a:lnTo>
                    <a:pt x="321" y="1"/>
                  </a:lnTo>
                  <a:lnTo>
                    <a:pt x="321" y="1"/>
                  </a:lnTo>
                  <a:lnTo>
                    <a:pt x="322" y="1"/>
                  </a:lnTo>
                  <a:lnTo>
                    <a:pt x="323" y="0"/>
                  </a:lnTo>
                  <a:lnTo>
                    <a:pt x="324" y="1"/>
                  </a:lnTo>
                  <a:lnTo>
                    <a:pt x="325" y="1"/>
                  </a:lnTo>
                  <a:lnTo>
                    <a:pt x="326" y="1"/>
                  </a:lnTo>
                  <a:lnTo>
                    <a:pt x="327" y="1"/>
                  </a:lnTo>
                  <a:lnTo>
                    <a:pt x="328" y="0"/>
                  </a:lnTo>
                  <a:lnTo>
                    <a:pt x="328" y="1"/>
                  </a:lnTo>
                  <a:lnTo>
                    <a:pt x="329" y="1"/>
                  </a:lnTo>
                  <a:lnTo>
                    <a:pt x="330" y="1"/>
                  </a:lnTo>
                  <a:lnTo>
                    <a:pt x="331" y="0"/>
                  </a:lnTo>
                  <a:lnTo>
                    <a:pt x="332" y="1"/>
                  </a:lnTo>
                  <a:lnTo>
                    <a:pt x="333" y="1"/>
                  </a:lnTo>
                  <a:lnTo>
                    <a:pt x="334" y="0"/>
                  </a:lnTo>
                  <a:lnTo>
                    <a:pt x="335" y="0"/>
                  </a:lnTo>
                  <a:lnTo>
                    <a:pt x="336" y="1"/>
                  </a:lnTo>
                  <a:lnTo>
                    <a:pt x="336" y="1"/>
                  </a:lnTo>
                  <a:lnTo>
                    <a:pt x="337" y="1"/>
                  </a:lnTo>
                  <a:lnTo>
                    <a:pt x="338" y="1"/>
                  </a:lnTo>
                  <a:lnTo>
                    <a:pt x="339" y="0"/>
                  </a:lnTo>
                  <a:lnTo>
                    <a:pt x="340" y="0"/>
                  </a:lnTo>
                  <a:lnTo>
                    <a:pt x="341" y="1"/>
                  </a:lnTo>
                  <a:lnTo>
                    <a:pt x="342" y="1"/>
                  </a:lnTo>
                  <a:lnTo>
                    <a:pt x="343" y="1"/>
                  </a:lnTo>
                  <a:lnTo>
                    <a:pt x="343" y="1"/>
                  </a:lnTo>
                  <a:lnTo>
                    <a:pt x="344" y="1"/>
                  </a:lnTo>
                  <a:lnTo>
                    <a:pt x="345" y="2"/>
                  </a:lnTo>
                  <a:lnTo>
                    <a:pt x="346" y="1"/>
                  </a:lnTo>
                  <a:lnTo>
                    <a:pt x="347" y="1"/>
                  </a:lnTo>
                  <a:lnTo>
                    <a:pt x="348" y="2"/>
                  </a:lnTo>
                  <a:lnTo>
                    <a:pt x="349" y="2"/>
                  </a:lnTo>
                  <a:lnTo>
                    <a:pt x="350" y="1"/>
                  </a:lnTo>
                  <a:lnTo>
                    <a:pt x="351" y="2"/>
                  </a:lnTo>
                  <a:lnTo>
                    <a:pt x="351" y="2"/>
                  </a:lnTo>
                  <a:lnTo>
                    <a:pt x="352" y="2"/>
                  </a:lnTo>
                  <a:lnTo>
                    <a:pt x="353" y="2"/>
                  </a:lnTo>
                  <a:lnTo>
                    <a:pt x="354" y="2"/>
                  </a:lnTo>
                  <a:lnTo>
                    <a:pt x="355" y="0"/>
                  </a:lnTo>
                  <a:lnTo>
                    <a:pt x="356" y="1"/>
                  </a:lnTo>
                  <a:lnTo>
                    <a:pt x="357" y="1"/>
                  </a:lnTo>
                  <a:lnTo>
                    <a:pt x="358" y="1"/>
                  </a:lnTo>
                  <a:lnTo>
                    <a:pt x="358" y="1"/>
                  </a:lnTo>
                  <a:lnTo>
                    <a:pt x="359" y="1"/>
                  </a:lnTo>
                  <a:lnTo>
                    <a:pt x="360" y="1"/>
                  </a:lnTo>
                  <a:lnTo>
                    <a:pt x="361" y="1"/>
                  </a:lnTo>
                  <a:lnTo>
                    <a:pt x="362" y="1"/>
                  </a:lnTo>
                  <a:lnTo>
                    <a:pt x="363" y="1"/>
                  </a:lnTo>
                  <a:lnTo>
                    <a:pt x="364" y="0"/>
                  </a:lnTo>
                  <a:lnTo>
                    <a:pt x="365" y="1"/>
                  </a:lnTo>
                  <a:lnTo>
                    <a:pt x="366" y="1"/>
                  </a:lnTo>
                  <a:lnTo>
                    <a:pt x="366" y="1"/>
                  </a:lnTo>
                  <a:lnTo>
                    <a:pt x="367" y="1"/>
                  </a:lnTo>
                  <a:lnTo>
                    <a:pt x="368" y="0"/>
                  </a:lnTo>
                  <a:lnTo>
                    <a:pt x="369" y="1"/>
                  </a:lnTo>
                  <a:lnTo>
                    <a:pt x="370" y="1"/>
                  </a:lnTo>
                  <a:lnTo>
                    <a:pt x="371" y="1"/>
                  </a:lnTo>
                  <a:lnTo>
                    <a:pt x="372" y="1"/>
                  </a:lnTo>
                  <a:lnTo>
                    <a:pt x="373" y="1"/>
                  </a:lnTo>
                  <a:lnTo>
                    <a:pt x="373" y="1"/>
                  </a:lnTo>
                  <a:lnTo>
                    <a:pt x="374" y="1"/>
                  </a:lnTo>
                  <a:lnTo>
                    <a:pt x="375" y="1"/>
                  </a:lnTo>
                  <a:lnTo>
                    <a:pt x="376" y="1"/>
                  </a:lnTo>
                  <a:lnTo>
                    <a:pt x="377" y="1"/>
                  </a:lnTo>
                  <a:lnTo>
                    <a:pt x="378" y="1"/>
                  </a:lnTo>
                  <a:lnTo>
                    <a:pt x="379" y="1"/>
                  </a:lnTo>
                  <a:lnTo>
                    <a:pt x="380" y="1"/>
                  </a:lnTo>
                  <a:lnTo>
                    <a:pt x="381" y="0"/>
                  </a:lnTo>
                  <a:lnTo>
                    <a:pt x="381" y="1"/>
                  </a:lnTo>
                  <a:lnTo>
                    <a:pt x="382" y="0"/>
                  </a:lnTo>
                  <a:lnTo>
                    <a:pt x="383" y="1"/>
                  </a:lnTo>
                  <a:lnTo>
                    <a:pt x="384" y="1"/>
                  </a:lnTo>
                  <a:lnTo>
                    <a:pt x="385" y="0"/>
                  </a:lnTo>
                  <a:lnTo>
                    <a:pt x="386" y="0"/>
                  </a:lnTo>
                  <a:lnTo>
                    <a:pt x="387" y="0"/>
                  </a:lnTo>
                  <a:lnTo>
                    <a:pt x="388" y="1"/>
                  </a:lnTo>
                  <a:lnTo>
                    <a:pt x="388" y="1"/>
                  </a:lnTo>
                  <a:lnTo>
                    <a:pt x="389" y="1"/>
                  </a:lnTo>
                  <a:lnTo>
                    <a:pt x="390" y="1"/>
                  </a:lnTo>
                  <a:lnTo>
                    <a:pt x="391" y="1"/>
                  </a:lnTo>
                  <a:lnTo>
                    <a:pt x="392" y="1"/>
                  </a:lnTo>
                  <a:lnTo>
                    <a:pt x="393" y="0"/>
                  </a:lnTo>
                  <a:lnTo>
                    <a:pt x="394" y="0"/>
                  </a:lnTo>
                  <a:lnTo>
                    <a:pt x="395" y="0"/>
                  </a:lnTo>
                  <a:lnTo>
                    <a:pt x="396" y="0"/>
                  </a:lnTo>
                  <a:lnTo>
                    <a:pt x="396" y="0"/>
                  </a:lnTo>
                  <a:lnTo>
                    <a:pt x="397" y="0"/>
                  </a:lnTo>
                  <a:lnTo>
                    <a:pt x="398" y="0"/>
                  </a:lnTo>
                  <a:lnTo>
                    <a:pt x="399" y="1"/>
                  </a:lnTo>
                  <a:lnTo>
                    <a:pt x="400" y="0"/>
                  </a:lnTo>
                  <a:lnTo>
                    <a:pt x="401" y="1"/>
                  </a:lnTo>
                  <a:lnTo>
                    <a:pt x="402" y="1"/>
                  </a:lnTo>
                  <a:lnTo>
                    <a:pt x="403" y="0"/>
                  </a:lnTo>
                  <a:lnTo>
                    <a:pt x="403" y="1"/>
                  </a:lnTo>
                  <a:lnTo>
                    <a:pt x="404" y="0"/>
                  </a:lnTo>
                  <a:lnTo>
                    <a:pt x="405" y="1"/>
                  </a:lnTo>
                  <a:lnTo>
                    <a:pt x="406" y="1"/>
                  </a:lnTo>
                  <a:lnTo>
                    <a:pt x="407" y="1"/>
                  </a:lnTo>
                  <a:lnTo>
                    <a:pt x="408" y="0"/>
                  </a:lnTo>
                  <a:lnTo>
                    <a:pt x="409" y="0"/>
                  </a:lnTo>
                  <a:lnTo>
                    <a:pt x="410" y="0"/>
                  </a:lnTo>
                  <a:lnTo>
                    <a:pt x="411" y="1"/>
                  </a:lnTo>
                  <a:lnTo>
                    <a:pt x="411" y="0"/>
                  </a:lnTo>
                  <a:lnTo>
                    <a:pt x="412" y="0"/>
                  </a:lnTo>
                  <a:lnTo>
                    <a:pt x="413" y="1"/>
                  </a:lnTo>
                  <a:lnTo>
                    <a:pt x="414" y="0"/>
                  </a:lnTo>
                  <a:lnTo>
                    <a:pt x="415" y="0"/>
                  </a:lnTo>
                  <a:lnTo>
                    <a:pt x="416" y="0"/>
                  </a:lnTo>
                  <a:lnTo>
                    <a:pt x="417" y="1"/>
                  </a:lnTo>
                  <a:lnTo>
                    <a:pt x="418" y="1"/>
                  </a:lnTo>
                  <a:lnTo>
                    <a:pt x="418" y="0"/>
                  </a:lnTo>
                  <a:lnTo>
                    <a:pt x="419" y="0"/>
                  </a:lnTo>
                  <a:lnTo>
                    <a:pt x="420" y="0"/>
                  </a:lnTo>
                  <a:lnTo>
                    <a:pt x="421" y="1"/>
                  </a:lnTo>
                  <a:lnTo>
                    <a:pt x="422" y="0"/>
                  </a:lnTo>
                  <a:lnTo>
                    <a:pt x="423" y="0"/>
                  </a:lnTo>
                  <a:lnTo>
                    <a:pt x="424" y="0"/>
                  </a:lnTo>
                  <a:lnTo>
                    <a:pt x="425" y="0"/>
                  </a:lnTo>
                  <a:lnTo>
                    <a:pt x="426" y="0"/>
                  </a:lnTo>
                  <a:lnTo>
                    <a:pt x="426" y="0"/>
                  </a:lnTo>
                  <a:lnTo>
                    <a:pt x="427" y="1"/>
                  </a:lnTo>
                  <a:lnTo>
                    <a:pt x="428" y="0"/>
                  </a:lnTo>
                  <a:lnTo>
                    <a:pt x="429" y="1"/>
                  </a:lnTo>
                  <a:lnTo>
                    <a:pt x="430" y="0"/>
                  </a:lnTo>
                  <a:lnTo>
                    <a:pt x="431" y="0"/>
                  </a:lnTo>
                  <a:lnTo>
                    <a:pt x="432" y="1"/>
                  </a:lnTo>
                  <a:lnTo>
                    <a:pt x="433" y="0"/>
                  </a:lnTo>
                  <a:lnTo>
                    <a:pt x="433" y="0"/>
                  </a:lnTo>
                  <a:lnTo>
                    <a:pt x="434" y="1"/>
                  </a:lnTo>
                  <a:lnTo>
                    <a:pt x="435" y="0"/>
                  </a:lnTo>
                  <a:lnTo>
                    <a:pt x="436" y="1"/>
                  </a:lnTo>
                  <a:lnTo>
                    <a:pt x="437" y="0"/>
                  </a:lnTo>
                  <a:lnTo>
                    <a:pt x="438" y="0"/>
                  </a:lnTo>
                  <a:lnTo>
                    <a:pt x="439" y="1"/>
                  </a:lnTo>
                  <a:lnTo>
                    <a:pt x="440" y="0"/>
                  </a:lnTo>
                  <a:lnTo>
                    <a:pt x="441" y="1"/>
                  </a:lnTo>
                  <a:lnTo>
                    <a:pt x="441" y="0"/>
                  </a:lnTo>
                  <a:lnTo>
                    <a:pt x="442" y="0"/>
                  </a:lnTo>
                  <a:lnTo>
                    <a:pt x="443" y="0"/>
                  </a:lnTo>
                  <a:lnTo>
                    <a:pt x="444" y="0"/>
                  </a:lnTo>
                  <a:lnTo>
                    <a:pt x="445" y="1"/>
                  </a:lnTo>
                  <a:lnTo>
                    <a:pt x="446" y="0"/>
                  </a:lnTo>
                  <a:lnTo>
                    <a:pt x="447" y="1"/>
                  </a:lnTo>
                  <a:lnTo>
                    <a:pt x="448" y="0"/>
                  </a:lnTo>
                  <a:lnTo>
                    <a:pt x="448" y="0"/>
                  </a:lnTo>
                  <a:lnTo>
                    <a:pt x="449" y="0"/>
                  </a:lnTo>
                  <a:lnTo>
                    <a:pt x="450" y="1"/>
                  </a:lnTo>
                  <a:lnTo>
                    <a:pt x="451" y="1"/>
                  </a:lnTo>
                  <a:lnTo>
                    <a:pt x="452" y="1"/>
                  </a:lnTo>
                  <a:lnTo>
                    <a:pt x="453" y="0"/>
                  </a:lnTo>
                  <a:lnTo>
                    <a:pt x="454" y="1"/>
                  </a:lnTo>
                  <a:lnTo>
                    <a:pt x="455" y="0"/>
                  </a:lnTo>
                  <a:lnTo>
                    <a:pt x="456" y="0"/>
                  </a:lnTo>
                  <a:lnTo>
                    <a:pt x="456" y="0"/>
                  </a:lnTo>
                  <a:lnTo>
                    <a:pt x="457" y="0"/>
                  </a:lnTo>
                  <a:lnTo>
                    <a:pt x="458" y="1"/>
                  </a:lnTo>
                  <a:lnTo>
                    <a:pt x="459" y="0"/>
                  </a:lnTo>
                  <a:lnTo>
                    <a:pt x="460" y="1"/>
                  </a:lnTo>
                  <a:lnTo>
                    <a:pt x="461" y="1"/>
                  </a:lnTo>
                  <a:lnTo>
                    <a:pt x="462" y="0"/>
                  </a:lnTo>
                  <a:lnTo>
                    <a:pt x="463" y="0"/>
                  </a:lnTo>
                  <a:lnTo>
                    <a:pt x="463" y="0"/>
                  </a:lnTo>
                  <a:lnTo>
                    <a:pt x="464" y="1"/>
                  </a:lnTo>
                  <a:lnTo>
                    <a:pt x="465" y="0"/>
                  </a:lnTo>
                  <a:lnTo>
                    <a:pt x="466" y="0"/>
                  </a:lnTo>
                  <a:lnTo>
                    <a:pt x="467" y="0"/>
                  </a:lnTo>
                  <a:lnTo>
                    <a:pt x="468" y="0"/>
                  </a:lnTo>
                  <a:lnTo>
                    <a:pt x="469" y="0"/>
                  </a:lnTo>
                  <a:lnTo>
                    <a:pt x="470" y="0"/>
                  </a:lnTo>
                  <a:lnTo>
                    <a:pt x="471" y="0"/>
                  </a:lnTo>
                  <a:lnTo>
                    <a:pt x="471" y="0"/>
                  </a:lnTo>
                  <a:lnTo>
                    <a:pt x="472" y="1"/>
                  </a:lnTo>
                  <a:lnTo>
                    <a:pt x="473" y="0"/>
                  </a:lnTo>
                  <a:lnTo>
                    <a:pt x="474" y="1"/>
                  </a:lnTo>
                  <a:lnTo>
                    <a:pt x="475" y="0"/>
                  </a:lnTo>
                  <a:lnTo>
                    <a:pt x="476" y="0"/>
                  </a:lnTo>
                  <a:lnTo>
                    <a:pt x="477" y="1"/>
                  </a:lnTo>
                  <a:lnTo>
                    <a:pt x="478" y="0"/>
                  </a:lnTo>
                  <a:lnTo>
                    <a:pt x="478" y="0"/>
                  </a:lnTo>
                  <a:lnTo>
                    <a:pt x="479" y="1"/>
                  </a:lnTo>
                  <a:lnTo>
                    <a:pt x="480" y="1"/>
                  </a:lnTo>
                  <a:lnTo>
                    <a:pt x="481" y="1"/>
                  </a:lnTo>
                  <a:lnTo>
                    <a:pt x="482" y="0"/>
                  </a:lnTo>
                  <a:lnTo>
                    <a:pt x="483" y="0"/>
                  </a:lnTo>
                  <a:lnTo>
                    <a:pt x="484" y="1"/>
                  </a:lnTo>
                  <a:lnTo>
                    <a:pt x="485" y="0"/>
                  </a:lnTo>
                  <a:lnTo>
                    <a:pt x="486" y="0"/>
                  </a:lnTo>
                  <a:lnTo>
                    <a:pt x="486" y="0"/>
                  </a:lnTo>
                  <a:lnTo>
                    <a:pt x="487" y="1"/>
                  </a:lnTo>
                  <a:lnTo>
                    <a:pt x="488" y="0"/>
                  </a:lnTo>
                  <a:lnTo>
                    <a:pt x="489" y="0"/>
                  </a:lnTo>
                  <a:lnTo>
                    <a:pt x="490" y="0"/>
                  </a:lnTo>
                  <a:lnTo>
                    <a:pt x="491" y="0"/>
                  </a:lnTo>
                  <a:lnTo>
                    <a:pt x="492" y="0"/>
                  </a:lnTo>
                  <a:lnTo>
                    <a:pt x="493" y="0"/>
                  </a:lnTo>
                  <a:lnTo>
                    <a:pt x="493" y="0"/>
                  </a:lnTo>
                  <a:lnTo>
                    <a:pt x="494" y="1"/>
                  </a:lnTo>
                  <a:lnTo>
                    <a:pt x="495" y="0"/>
                  </a:lnTo>
                  <a:lnTo>
                    <a:pt x="496" y="0"/>
                  </a:lnTo>
                  <a:lnTo>
                    <a:pt x="497" y="0"/>
                  </a:lnTo>
                  <a:lnTo>
                    <a:pt x="498" y="1"/>
                  </a:lnTo>
                  <a:lnTo>
                    <a:pt x="499" y="0"/>
                  </a:lnTo>
                  <a:lnTo>
                    <a:pt x="500" y="0"/>
                  </a:lnTo>
                  <a:lnTo>
                    <a:pt x="501" y="0"/>
                  </a:lnTo>
                  <a:lnTo>
                    <a:pt x="501" y="0"/>
                  </a:lnTo>
                  <a:lnTo>
                    <a:pt x="502" y="0"/>
                  </a:lnTo>
                  <a:lnTo>
                    <a:pt x="503" y="0"/>
                  </a:lnTo>
                  <a:lnTo>
                    <a:pt x="504" y="0"/>
                  </a:lnTo>
                  <a:lnTo>
                    <a:pt x="505" y="0"/>
                  </a:lnTo>
                  <a:lnTo>
                    <a:pt x="506" y="0"/>
                  </a:lnTo>
                  <a:lnTo>
                    <a:pt x="507" y="0"/>
                  </a:lnTo>
                  <a:lnTo>
                    <a:pt x="508" y="1"/>
                  </a:lnTo>
                  <a:lnTo>
                    <a:pt x="508" y="0"/>
                  </a:lnTo>
                  <a:lnTo>
                    <a:pt x="509" y="0"/>
                  </a:lnTo>
                  <a:lnTo>
                    <a:pt x="510" y="0"/>
                  </a:lnTo>
                  <a:lnTo>
                    <a:pt x="511" y="0"/>
                  </a:lnTo>
                  <a:lnTo>
                    <a:pt x="512" y="0"/>
                  </a:lnTo>
                  <a:lnTo>
                    <a:pt x="513" y="0"/>
                  </a:lnTo>
                  <a:lnTo>
                    <a:pt x="514" y="1"/>
                  </a:lnTo>
                  <a:lnTo>
                    <a:pt x="515" y="1"/>
                  </a:lnTo>
                  <a:lnTo>
                    <a:pt x="516" y="0"/>
                  </a:lnTo>
                  <a:lnTo>
                    <a:pt x="516" y="0"/>
                  </a:lnTo>
                  <a:lnTo>
                    <a:pt x="517" y="0"/>
                  </a:lnTo>
                  <a:lnTo>
                    <a:pt x="518" y="0"/>
                  </a:lnTo>
                  <a:lnTo>
                    <a:pt x="519" y="1"/>
                  </a:lnTo>
                  <a:lnTo>
                    <a:pt x="520" y="0"/>
                  </a:lnTo>
                  <a:lnTo>
                    <a:pt x="521" y="1"/>
                  </a:lnTo>
                  <a:lnTo>
                    <a:pt x="522" y="0"/>
                  </a:lnTo>
                  <a:lnTo>
                    <a:pt x="523" y="0"/>
                  </a:lnTo>
                  <a:lnTo>
                    <a:pt x="523" y="0"/>
                  </a:lnTo>
                  <a:lnTo>
                    <a:pt x="524" y="1"/>
                  </a:lnTo>
                  <a:lnTo>
                    <a:pt x="525" y="0"/>
                  </a:lnTo>
                  <a:lnTo>
                    <a:pt x="526" y="0"/>
                  </a:lnTo>
                  <a:lnTo>
                    <a:pt x="527" y="0"/>
                  </a:lnTo>
                  <a:lnTo>
                    <a:pt x="528" y="0"/>
                  </a:lnTo>
                  <a:lnTo>
                    <a:pt x="529" y="0"/>
                  </a:lnTo>
                  <a:lnTo>
                    <a:pt x="530" y="1"/>
                  </a:lnTo>
                  <a:lnTo>
                    <a:pt x="530" y="1"/>
                  </a:lnTo>
                  <a:lnTo>
                    <a:pt x="531" y="0"/>
                  </a:lnTo>
                  <a:lnTo>
                    <a:pt x="532" y="0"/>
                  </a:lnTo>
                  <a:lnTo>
                    <a:pt x="533" y="1"/>
                  </a:lnTo>
                  <a:lnTo>
                    <a:pt x="534" y="0"/>
                  </a:lnTo>
                  <a:lnTo>
                    <a:pt x="535" y="0"/>
                  </a:lnTo>
                  <a:lnTo>
                    <a:pt x="536" y="0"/>
                  </a:lnTo>
                  <a:lnTo>
                    <a:pt x="537" y="0"/>
                  </a:lnTo>
                  <a:lnTo>
                    <a:pt x="538" y="0"/>
                  </a:lnTo>
                  <a:lnTo>
                    <a:pt x="538" y="0"/>
                  </a:lnTo>
                  <a:lnTo>
                    <a:pt x="539" y="0"/>
                  </a:lnTo>
                  <a:lnTo>
                    <a:pt x="540" y="1"/>
                  </a:lnTo>
                  <a:lnTo>
                    <a:pt x="541" y="0"/>
                  </a:lnTo>
                  <a:lnTo>
                    <a:pt x="542" y="0"/>
                  </a:lnTo>
                  <a:lnTo>
                    <a:pt x="543" y="0"/>
                  </a:lnTo>
                  <a:lnTo>
                    <a:pt x="544" y="0"/>
                  </a:lnTo>
                  <a:lnTo>
                    <a:pt x="545" y="1"/>
                  </a:lnTo>
                  <a:lnTo>
                    <a:pt x="545" y="1"/>
                  </a:lnTo>
                  <a:lnTo>
                    <a:pt x="546" y="1"/>
                  </a:lnTo>
                  <a:lnTo>
                    <a:pt x="547" y="0"/>
                  </a:lnTo>
                  <a:lnTo>
                    <a:pt x="548" y="1"/>
                  </a:lnTo>
                  <a:lnTo>
                    <a:pt x="549" y="0"/>
                  </a:lnTo>
                  <a:lnTo>
                    <a:pt x="550" y="0"/>
                  </a:lnTo>
                  <a:lnTo>
                    <a:pt x="551" y="0"/>
                  </a:lnTo>
                  <a:lnTo>
                    <a:pt x="552" y="1"/>
                  </a:lnTo>
                  <a:lnTo>
                    <a:pt x="553" y="1"/>
                  </a:lnTo>
                  <a:lnTo>
                    <a:pt x="553" y="1"/>
                  </a:lnTo>
                  <a:lnTo>
                    <a:pt x="554" y="1"/>
                  </a:lnTo>
                  <a:lnTo>
                    <a:pt x="555" y="0"/>
                  </a:lnTo>
                  <a:lnTo>
                    <a:pt x="556" y="0"/>
                  </a:lnTo>
                  <a:lnTo>
                    <a:pt x="557" y="0"/>
                  </a:lnTo>
                  <a:lnTo>
                    <a:pt x="558" y="1"/>
                  </a:lnTo>
                  <a:lnTo>
                    <a:pt x="559" y="1"/>
                  </a:lnTo>
                  <a:lnTo>
                    <a:pt x="560" y="0"/>
                  </a:lnTo>
                  <a:lnTo>
                    <a:pt x="560" y="1"/>
                  </a:lnTo>
                  <a:lnTo>
                    <a:pt x="561" y="0"/>
                  </a:lnTo>
                  <a:lnTo>
                    <a:pt x="562" y="0"/>
                  </a:lnTo>
                  <a:lnTo>
                    <a:pt x="563" y="0"/>
                  </a:lnTo>
                  <a:lnTo>
                    <a:pt x="564" y="1"/>
                  </a:lnTo>
                  <a:lnTo>
                    <a:pt x="565" y="0"/>
                  </a:lnTo>
                  <a:lnTo>
                    <a:pt x="566" y="0"/>
                  </a:lnTo>
                  <a:lnTo>
                    <a:pt x="567" y="0"/>
                  </a:lnTo>
                  <a:lnTo>
                    <a:pt x="568" y="1"/>
                  </a:lnTo>
                  <a:lnTo>
                    <a:pt x="568" y="1"/>
                  </a:lnTo>
                  <a:lnTo>
                    <a:pt x="569" y="1"/>
                  </a:lnTo>
                  <a:lnTo>
                    <a:pt x="570" y="0"/>
                  </a:lnTo>
                  <a:lnTo>
                    <a:pt x="571" y="1"/>
                  </a:lnTo>
                  <a:lnTo>
                    <a:pt x="572" y="1"/>
                  </a:lnTo>
                  <a:lnTo>
                    <a:pt x="573" y="1"/>
                  </a:lnTo>
                  <a:lnTo>
                    <a:pt x="574" y="1"/>
                  </a:lnTo>
                  <a:lnTo>
                    <a:pt x="575" y="1"/>
                  </a:lnTo>
                  <a:lnTo>
                    <a:pt x="575" y="1"/>
                  </a:lnTo>
                  <a:lnTo>
                    <a:pt x="576" y="0"/>
                  </a:lnTo>
                  <a:lnTo>
                    <a:pt x="577" y="0"/>
                  </a:lnTo>
                  <a:lnTo>
                    <a:pt x="578" y="1"/>
                  </a:lnTo>
                  <a:lnTo>
                    <a:pt x="579" y="1"/>
                  </a:lnTo>
                  <a:lnTo>
                    <a:pt x="580" y="1"/>
                  </a:lnTo>
                  <a:lnTo>
                    <a:pt x="581" y="1"/>
                  </a:lnTo>
                  <a:lnTo>
                    <a:pt x="582" y="0"/>
                  </a:lnTo>
                  <a:lnTo>
                    <a:pt x="583" y="0"/>
                  </a:lnTo>
                  <a:lnTo>
                    <a:pt x="583" y="0"/>
                  </a:lnTo>
                  <a:lnTo>
                    <a:pt x="584" y="0"/>
                  </a:lnTo>
                  <a:lnTo>
                    <a:pt x="585" y="1"/>
                  </a:lnTo>
                  <a:lnTo>
                    <a:pt x="586" y="0"/>
                  </a:lnTo>
                  <a:lnTo>
                    <a:pt x="587" y="1"/>
                  </a:lnTo>
                  <a:lnTo>
                    <a:pt x="588" y="1"/>
                  </a:lnTo>
                  <a:lnTo>
                    <a:pt x="589" y="1"/>
                  </a:lnTo>
                  <a:lnTo>
                    <a:pt x="590" y="0"/>
                  </a:lnTo>
                  <a:lnTo>
                    <a:pt x="590" y="1"/>
                  </a:lnTo>
                  <a:lnTo>
                    <a:pt x="591" y="1"/>
                  </a:lnTo>
                  <a:lnTo>
                    <a:pt x="592" y="1"/>
                  </a:lnTo>
                  <a:lnTo>
                    <a:pt x="593" y="1"/>
                  </a:lnTo>
                  <a:lnTo>
                    <a:pt x="594" y="1"/>
                  </a:lnTo>
                  <a:lnTo>
                    <a:pt x="595" y="1"/>
                  </a:lnTo>
                  <a:lnTo>
                    <a:pt x="596" y="1"/>
                  </a:lnTo>
                  <a:lnTo>
                    <a:pt x="597" y="1"/>
                  </a:lnTo>
                  <a:lnTo>
                    <a:pt x="598" y="1"/>
                  </a:lnTo>
                  <a:lnTo>
                    <a:pt x="598" y="1"/>
                  </a:lnTo>
                  <a:lnTo>
                    <a:pt x="599" y="1"/>
                  </a:lnTo>
                  <a:lnTo>
                    <a:pt x="600" y="0"/>
                  </a:lnTo>
                  <a:lnTo>
                    <a:pt x="601" y="0"/>
                  </a:lnTo>
                  <a:lnTo>
                    <a:pt x="602" y="0"/>
                  </a:lnTo>
                  <a:lnTo>
                    <a:pt x="603" y="0"/>
                  </a:lnTo>
                  <a:lnTo>
                    <a:pt x="604" y="1"/>
                  </a:lnTo>
                  <a:lnTo>
                    <a:pt x="605" y="0"/>
                  </a:lnTo>
                  <a:lnTo>
                    <a:pt x="605" y="0"/>
                  </a:lnTo>
                  <a:lnTo>
                    <a:pt x="606" y="1"/>
                  </a:lnTo>
                  <a:lnTo>
                    <a:pt x="607" y="0"/>
                  </a:lnTo>
                  <a:lnTo>
                    <a:pt x="608" y="0"/>
                  </a:lnTo>
                  <a:lnTo>
                    <a:pt x="609" y="1"/>
                  </a:lnTo>
                  <a:lnTo>
                    <a:pt x="610" y="0"/>
                  </a:lnTo>
                  <a:lnTo>
                    <a:pt x="611" y="0"/>
                  </a:lnTo>
                  <a:lnTo>
                    <a:pt x="612" y="0"/>
                  </a:lnTo>
                  <a:lnTo>
                    <a:pt x="613" y="0"/>
                  </a:lnTo>
                  <a:lnTo>
                    <a:pt x="613" y="0"/>
                  </a:lnTo>
                  <a:lnTo>
                    <a:pt x="614" y="1"/>
                  </a:lnTo>
                  <a:lnTo>
                    <a:pt x="615" y="0"/>
                  </a:lnTo>
                  <a:lnTo>
                    <a:pt x="616" y="0"/>
                  </a:lnTo>
                  <a:lnTo>
                    <a:pt x="617" y="1"/>
                  </a:lnTo>
                  <a:lnTo>
                    <a:pt x="618" y="0"/>
                  </a:lnTo>
                  <a:lnTo>
                    <a:pt x="619" y="1"/>
                  </a:lnTo>
                  <a:lnTo>
                    <a:pt x="620" y="0"/>
                  </a:lnTo>
                  <a:lnTo>
                    <a:pt x="620" y="0"/>
                  </a:lnTo>
                  <a:lnTo>
                    <a:pt x="621" y="2"/>
                  </a:lnTo>
                  <a:lnTo>
                    <a:pt x="622" y="1"/>
                  </a:lnTo>
                  <a:lnTo>
                    <a:pt x="623" y="1"/>
                  </a:lnTo>
                  <a:lnTo>
                    <a:pt x="624" y="0"/>
                  </a:lnTo>
                  <a:lnTo>
                    <a:pt x="625" y="1"/>
                  </a:lnTo>
                  <a:lnTo>
                    <a:pt x="626" y="1"/>
                  </a:lnTo>
                  <a:lnTo>
                    <a:pt x="627" y="1"/>
                  </a:lnTo>
                  <a:lnTo>
                    <a:pt x="628" y="1"/>
                  </a:lnTo>
                  <a:lnTo>
                    <a:pt x="628" y="1"/>
                  </a:lnTo>
                  <a:lnTo>
                    <a:pt x="629" y="1"/>
                  </a:lnTo>
                  <a:lnTo>
                    <a:pt x="630" y="1"/>
                  </a:lnTo>
                  <a:lnTo>
                    <a:pt x="631" y="1"/>
                  </a:lnTo>
                  <a:lnTo>
                    <a:pt x="632" y="1"/>
                  </a:lnTo>
                  <a:lnTo>
                    <a:pt x="633" y="1"/>
                  </a:lnTo>
                  <a:lnTo>
                    <a:pt x="634" y="1"/>
                  </a:lnTo>
                  <a:lnTo>
                    <a:pt x="635" y="1"/>
                  </a:lnTo>
                  <a:lnTo>
                    <a:pt x="635" y="1"/>
                  </a:lnTo>
                  <a:lnTo>
                    <a:pt x="636" y="0"/>
                  </a:lnTo>
                  <a:lnTo>
                    <a:pt x="637" y="1"/>
                  </a:lnTo>
                  <a:lnTo>
                    <a:pt x="638" y="1"/>
                  </a:lnTo>
                  <a:lnTo>
                    <a:pt x="639" y="1"/>
                  </a:lnTo>
                  <a:lnTo>
                    <a:pt x="640" y="1"/>
                  </a:lnTo>
                  <a:lnTo>
                    <a:pt x="641" y="1"/>
                  </a:lnTo>
                  <a:lnTo>
                    <a:pt x="642" y="2"/>
                  </a:lnTo>
                  <a:lnTo>
                    <a:pt x="643" y="0"/>
                  </a:lnTo>
                  <a:lnTo>
                    <a:pt x="643" y="0"/>
                  </a:lnTo>
                  <a:lnTo>
                    <a:pt x="644" y="1"/>
                  </a:lnTo>
                  <a:lnTo>
                    <a:pt x="645" y="1"/>
                  </a:lnTo>
                  <a:lnTo>
                    <a:pt x="646" y="1"/>
                  </a:lnTo>
                  <a:lnTo>
                    <a:pt x="647" y="1"/>
                  </a:lnTo>
                  <a:lnTo>
                    <a:pt x="648" y="1"/>
                  </a:lnTo>
                  <a:lnTo>
                    <a:pt x="649" y="1"/>
                  </a:lnTo>
                  <a:lnTo>
                    <a:pt x="650" y="1"/>
                  </a:lnTo>
                  <a:lnTo>
                    <a:pt x="650" y="2"/>
                  </a:lnTo>
                  <a:lnTo>
                    <a:pt x="651" y="2"/>
                  </a:lnTo>
                  <a:lnTo>
                    <a:pt x="652" y="1"/>
                  </a:lnTo>
                  <a:lnTo>
                    <a:pt x="653" y="2"/>
                  </a:lnTo>
                  <a:lnTo>
                    <a:pt x="654" y="2"/>
                  </a:lnTo>
                  <a:lnTo>
                    <a:pt x="655" y="3"/>
                  </a:lnTo>
                  <a:lnTo>
                    <a:pt x="656" y="2"/>
                  </a:lnTo>
                  <a:lnTo>
                    <a:pt x="657" y="2"/>
                  </a:lnTo>
                  <a:lnTo>
                    <a:pt x="658" y="2"/>
                  </a:lnTo>
                  <a:lnTo>
                    <a:pt x="658" y="2"/>
                  </a:lnTo>
                  <a:lnTo>
                    <a:pt x="659" y="2"/>
                  </a:lnTo>
                  <a:lnTo>
                    <a:pt x="660" y="2"/>
                  </a:lnTo>
                  <a:lnTo>
                    <a:pt x="661" y="2"/>
                  </a:lnTo>
                  <a:lnTo>
                    <a:pt x="662" y="2"/>
                  </a:lnTo>
                  <a:lnTo>
                    <a:pt x="663" y="2"/>
                  </a:lnTo>
                  <a:lnTo>
                    <a:pt x="664" y="1"/>
                  </a:lnTo>
                  <a:lnTo>
                    <a:pt x="665" y="1"/>
                  </a:lnTo>
                  <a:lnTo>
                    <a:pt x="665" y="1"/>
                  </a:lnTo>
                  <a:lnTo>
                    <a:pt x="666" y="1"/>
                  </a:lnTo>
                  <a:lnTo>
                    <a:pt x="667" y="2"/>
                  </a:lnTo>
                  <a:lnTo>
                    <a:pt x="668" y="2"/>
                  </a:lnTo>
                  <a:lnTo>
                    <a:pt x="669" y="1"/>
                  </a:lnTo>
                  <a:lnTo>
                    <a:pt x="670" y="2"/>
                  </a:lnTo>
                  <a:lnTo>
                    <a:pt x="671" y="1"/>
                  </a:lnTo>
                  <a:lnTo>
                    <a:pt x="672" y="1"/>
                  </a:lnTo>
                  <a:lnTo>
                    <a:pt x="673" y="2"/>
                  </a:lnTo>
                  <a:lnTo>
                    <a:pt x="673" y="2"/>
                  </a:lnTo>
                  <a:lnTo>
                    <a:pt x="674" y="1"/>
                  </a:lnTo>
                  <a:lnTo>
                    <a:pt x="675" y="2"/>
                  </a:lnTo>
                  <a:lnTo>
                    <a:pt x="676" y="3"/>
                  </a:lnTo>
                  <a:lnTo>
                    <a:pt x="677" y="2"/>
                  </a:lnTo>
                  <a:lnTo>
                    <a:pt x="678" y="2"/>
                  </a:lnTo>
                  <a:lnTo>
                    <a:pt x="679" y="2"/>
                  </a:lnTo>
                  <a:lnTo>
                    <a:pt x="680" y="2"/>
                  </a:lnTo>
                  <a:lnTo>
                    <a:pt x="680" y="3"/>
                  </a:lnTo>
                  <a:lnTo>
                    <a:pt x="681" y="2"/>
                  </a:lnTo>
                  <a:lnTo>
                    <a:pt x="682" y="2"/>
                  </a:lnTo>
                  <a:lnTo>
                    <a:pt x="683" y="2"/>
                  </a:lnTo>
                  <a:lnTo>
                    <a:pt x="684" y="1"/>
                  </a:lnTo>
                  <a:lnTo>
                    <a:pt x="685" y="1"/>
                  </a:lnTo>
                  <a:lnTo>
                    <a:pt x="686" y="1"/>
                  </a:lnTo>
                  <a:lnTo>
                    <a:pt x="687" y="1"/>
                  </a:lnTo>
                  <a:lnTo>
                    <a:pt x="688" y="0"/>
                  </a:lnTo>
                  <a:lnTo>
                    <a:pt x="688" y="1"/>
                  </a:lnTo>
                  <a:lnTo>
                    <a:pt x="689" y="1"/>
                  </a:lnTo>
                  <a:lnTo>
                    <a:pt x="690" y="1"/>
                  </a:lnTo>
                  <a:lnTo>
                    <a:pt x="691" y="1"/>
                  </a:lnTo>
                  <a:lnTo>
                    <a:pt x="692" y="2"/>
                  </a:lnTo>
                  <a:lnTo>
                    <a:pt x="693" y="3"/>
                  </a:lnTo>
                  <a:lnTo>
                    <a:pt x="694" y="3"/>
                  </a:lnTo>
                  <a:lnTo>
                    <a:pt x="695" y="4"/>
                  </a:lnTo>
                  <a:lnTo>
                    <a:pt x="695" y="6"/>
                  </a:lnTo>
                  <a:lnTo>
                    <a:pt x="696" y="8"/>
                  </a:lnTo>
                  <a:lnTo>
                    <a:pt x="697" y="10"/>
                  </a:lnTo>
                  <a:lnTo>
                    <a:pt x="698" y="12"/>
                  </a:lnTo>
                  <a:lnTo>
                    <a:pt x="699" y="13"/>
                  </a:lnTo>
                  <a:lnTo>
                    <a:pt x="700" y="14"/>
                  </a:lnTo>
                  <a:lnTo>
                    <a:pt x="701" y="15"/>
                  </a:lnTo>
                  <a:lnTo>
                    <a:pt x="702" y="14"/>
                  </a:lnTo>
                  <a:lnTo>
                    <a:pt x="703" y="14"/>
                  </a:lnTo>
                  <a:lnTo>
                    <a:pt x="703" y="12"/>
                  </a:lnTo>
                  <a:lnTo>
                    <a:pt x="704" y="10"/>
                  </a:lnTo>
                  <a:lnTo>
                    <a:pt x="705" y="9"/>
                  </a:lnTo>
                  <a:lnTo>
                    <a:pt x="706" y="8"/>
                  </a:lnTo>
                  <a:lnTo>
                    <a:pt x="707" y="6"/>
                  </a:lnTo>
                  <a:lnTo>
                    <a:pt x="708" y="6"/>
                  </a:lnTo>
                  <a:lnTo>
                    <a:pt x="709" y="5"/>
                  </a:lnTo>
                  <a:lnTo>
                    <a:pt x="710" y="4"/>
                  </a:lnTo>
                  <a:lnTo>
                    <a:pt x="710" y="4"/>
                  </a:lnTo>
                  <a:lnTo>
                    <a:pt x="711" y="3"/>
                  </a:lnTo>
                  <a:lnTo>
                    <a:pt x="712" y="3"/>
                  </a:lnTo>
                  <a:lnTo>
                    <a:pt x="713" y="2"/>
                  </a:lnTo>
                  <a:lnTo>
                    <a:pt x="714" y="3"/>
                  </a:lnTo>
                  <a:lnTo>
                    <a:pt x="715" y="2"/>
                  </a:lnTo>
                  <a:lnTo>
                    <a:pt x="716" y="3"/>
                  </a:lnTo>
                  <a:lnTo>
                    <a:pt x="717" y="2"/>
                  </a:lnTo>
                  <a:lnTo>
                    <a:pt x="717" y="3"/>
                  </a:lnTo>
                  <a:lnTo>
                    <a:pt x="718" y="3"/>
                  </a:lnTo>
                  <a:lnTo>
                    <a:pt x="719" y="3"/>
                  </a:lnTo>
                  <a:lnTo>
                    <a:pt x="720" y="3"/>
                  </a:lnTo>
                  <a:lnTo>
                    <a:pt x="721" y="2"/>
                  </a:lnTo>
                  <a:lnTo>
                    <a:pt x="722" y="2"/>
                  </a:lnTo>
                  <a:lnTo>
                    <a:pt x="723" y="2"/>
                  </a:lnTo>
                  <a:lnTo>
                    <a:pt x="724" y="2"/>
                  </a:lnTo>
                  <a:lnTo>
                    <a:pt x="725" y="1"/>
                  </a:lnTo>
                  <a:lnTo>
                    <a:pt x="725" y="1"/>
                  </a:lnTo>
                  <a:lnTo>
                    <a:pt x="726" y="2"/>
                  </a:lnTo>
                  <a:lnTo>
                    <a:pt x="727" y="1"/>
                  </a:lnTo>
                  <a:lnTo>
                    <a:pt x="728" y="1"/>
                  </a:lnTo>
                  <a:lnTo>
                    <a:pt x="729" y="1"/>
                  </a:lnTo>
                  <a:lnTo>
                    <a:pt x="730" y="1"/>
                  </a:lnTo>
                  <a:lnTo>
                    <a:pt x="731" y="1"/>
                  </a:lnTo>
                  <a:lnTo>
                    <a:pt x="732" y="1"/>
                  </a:lnTo>
                  <a:lnTo>
                    <a:pt x="732" y="1"/>
                  </a:lnTo>
                  <a:lnTo>
                    <a:pt x="733" y="1"/>
                  </a:lnTo>
                  <a:lnTo>
                    <a:pt x="734" y="1"/>
                  </a:lnTo>
                  <a:lnTo>
                    <a:pt x="735" y="1"/>
                  </a:lnTo>
                  <a:lnTo>
                    <a:pt x="736" y="1"/>
                  </a:lnTo>
                  <a:lnTo>
                    <a:pt x="737" y="0"/>
                  </a:lnTo>
                  <a:lnTo>
                    <a:pt x="738" y="1"/>
                  </a:lnTo>
                  <a:lnTo>
                    <a:pt x="739" y="1"/>
                  </a:lnTo>
                  <a:lnTo>
                    <a:pt x="740" y="1"/>
                  </a:lnTo>
                  <a:lnTo>
                    <a:pt x="740" y="1"/>
                  </a:lnTo>
                  <a:lnTo>
                    <a:pt x="741" y="1"/>
                  </a:lnTo>
                  <a:lnTo>
                    <a:pt x="742" y="1"/>
                  </a:lnTo>
                  <a:lnTo>
                    <a:pt x="743" y="1"/>
                  </a:lnTo>
                  <a:lnTo>
                    <a:pt x="744" y="1"/>
                  </a:lnTo>
                  <a:lnTo>
                    <a:pt x="745" y="1"/>
                  </a:lnTo>
                  <a:lnTo>
                    <a:pt x="746" y="1"/>
                  </a:lnTo>
                  <a:lnTo>
                    <a:pt x="747" y="1"/>
                  </a:lnTo>
                  <a:lnTo>
                    <a:pt x="747" y="2"/>
                  </a:lnTo>
                  <a:lnTo>
                    <a:pt x="748" y="2"/>
                  </a:lnTo>
                  <a:lnTo>
                    <a:pt x="749" y="2"/>
                  </a:lnTo>
                  <a:lnTo>
                    <a:pt x="750" y="1"/>
                  </a:lnTo>
                  <a:lnTo>
                    <a:pt x="751" y="2"/>
                  </a:lnTo>
                  <a:lnTo>
                    <a:pt x="752" y="1"/>
                  </a:lnTo>
                  <a:lnTo>
                    <a:pt x="753" y="2"/>
                  </a:lnTo>
                  <a:lnTo>
                    <a:pt x="754" y="2"/>
                  </a:lnTo>
                  <a:lnTo>
                    <a:pt x="755" y="1"/>
                  </a:lnTo>
                  <a:lnTo>
                    <a:pt x="755" y="2"/>
                  </a:lnTo>
                  <a:lnTo>
                    <a:pt x="756" y="2"/>
                  </a:lnTo>
                  <a:lnTo>
                    <a:pt x="757" y="2"/>
                  </a:lnTo>
                  <a:lnTo>
                    <a:pt x="758" y="0"/>
                  </a:lnTo>
                  <a:lnTo>
                    <a:pt x="759" y="1"/>
                  </a:lnTo>
                  <a:lnTo>
                    <a:pt x="760" y="1"/>
                  </a:lnTo>
                  <a:lnTo>
                    <a:pt x="761" y="1"/>
                  </a:lnTo>
                  <a:lnTo>
                    <a:pt x="762" y="1"/>
                  </a:lnTo>
                  <a:lnTo>
                    <a:pt x="762" y="1"/>
                  </a:lnTo>
                  <a:lnTo>
                    <a:pt x="763" y="1"/>
                  </a:lnTo>
                  <a:lnTo>
                    <a:pt x="764" y="1"/>
                  </a:lnTo>
                  <a:lnTo>
                    <a:pt x="765" y="1"/>
                  </a:lnTo>
                  <a:lnTo>
                    <a:pt x="766" y="1"/>
                  </a:lnTo>
                  <a:lnTo>
                    <a:pt x="767" y="0"/>
                  </a:lnTo>
                  <a:lnTo>
                    <a:pt x="768" y="2"/>
                  </a:lnTo>
                  <a:lnTo>
                    <a:pt x="769" y="1"/>
                  </a:lnTo>
                  <a:lnTo>
                    <a:pt x="770" y="1"/>
                  </a:lnTo>
                  <a:lnTo>
                    <a:pt x="770" y="0"/>
                  </a:lnTo>
                  <a:lnTo>
                    <a:pt x="771" y="1"/>
                  </a:lnTo>
                  <a:lnTo>
                    <a:pt x="772" y="1"/>
                  </a:lnTo>
                  <a:lnTo>
                    <a:pt x="773" y="0"/>
                  </a:lnTo>
                  <a:lnTo>
                    <a:pt x="774" y="0"/>
                  </a:lnTo>
                  <a:lnTo>
                    <a:pt x="775" y="1"/>
                  </a:lnTo>
                  <a:lnTo>
                    <a:pt x="776" y="0"/>
                  </a:lnTo>
                  <a:lnTo>
                    <a:pt x="777" y="1"/>
                  </a:lnTo>
                  <a:lnTo>
                    <a:pt x="777" y="1"/>
                  </a:lnTo>
                  <a:lnTo>
                    <a:pt x="778" y="1"/>
                  </a:lnTo>
                  <a:lnTo>
                    <a:pt x="779" y="1"/>
                  </a:lnTo>
                  <a:lnTo>
                    <a:pt x="780" y="1"/>
                  </a:lnTo>
                  <a:lnTo>
                    <a:pt x="781" y="1"/>
                  </a:lnTo>
                  <a:lnTo>
                    <a:pt x="782" y="1"/>
                  </a:lnTo>
                  <a:lnTo>
                    <a:pt x="783" y="1"/>
                  </a:lnTo>
                  <a:lnTo>
                    <a:pt x="784" y="2"/>
                  </a:lnTo>
                  <a:lnTo>
                    <a:pt x="785" y="0"/>
                  </a:lnTo>
                  <a:lnTo>
                    <a:pt x="785" y="1"/>
                  </a:lnTo>
                  <a:lnTo>
                    <a:pt x="786" y="1"/>
                  </a:lnTo>
                  <a:lnTo>
                    <a:pt x="787" y="1"/>
                  </a:lnTo>
                  <a:lnTo>
                    <a:pt x="788" y="1"/>
                  </a:lnTo>
                  <a:lnTo>
                    <a:pt x="789" y="1"/>
                  </a:lnTo>
                  <a:lnTo>
                    <a:pt x="790" y="1"/>
                  </a:lnTo>
                  <a:lnTo>
                    <a:pt x="791" y="2"/>
                  </a:lnTo>
                  <a:lnTo>
                    <a:pt x="792" y="2"/>
                  </a:lnTo>
                  <a:lnTo>
                    <a:pt x="792" y="2"/>
                  </a:lnTo>
                  <a:lnTo>
                    <a:pt x="793" y="2"/>
                  </a:lnTo>
                  <a:lnTo>
                    <a:pt x="794" y="3"/>
                  </a:lnTo>
                  <a:lnTo>
                    <a:pt x="795" y="3"/>
                  </a:lnTo>
                  <a:lnTo>
                    <a:pt x="796" y="3"/>
                  </a:lnTo>
                  <a:lnTo>
                    <a:pt x="797" y="3"/>
                  </a:lnTo>
                  <a:lnTo>
                    <a:pt x="798" y="4"/>
                  </a:lnTo>
                  <a:lnTo>
                    <a:pt x="799" y="4"/>
                  </a:lnTo>
                  <a:lnTo>
                    <a:pt x="800" y="4"/>
                  </a:lnTo>
                  <a:lnTo>
                    <a:pt x="800" y="4"/>
                  </a:lnTo>
                  <a:lnTo>
                    <a:pt x="801" y="3"/>
                  </a:lnTo>
                  <a:lnTo>
                    <a:pt x="802" y="3"/>
                  </a:lnTo>
                  <a:lnTo>
                    <a:pt x="803" y="3"/>
                  </a:lnTo>
                  <a:lnTo>
                    <a:pt x="804" y="2"/>
                  </a:lnTo>
                  <a:lnTo>
                    <a:pt x="805" y="3"/>
                  </a:lnTo>
                  <a:lnTo>
                    <a:pt x="806" y="3"/>
                  </a:lnTo>
                  <a:lnTo>
                    <a:pt x="807" y="1"/>
                  </a:lnTo>
                  <a:lnTo>
                    <a:pt x="807" y="2"/>
                  </a:lnTo>
                  <a:lnTo>
                    <a:pt x="808" y="2"/>
                  </a:lnTo>
                  <a:lnTo>
                    <a:pt x="809" y="1"/>
                  </a:lnTo>
                  <a:lnTo>
                    <a:pt x="810" y="2"/>
                  </a:lnTo>
                  <a:lnTo>
                    <a:pt x="811" y="2"/>
                  </a:lnTo>
                  <a:lnTo>
                    <a:pt x="812" y="2"/>
                  </a:lnTo>
                  <a:lnTo>
                    <a:pt x="813" y="1"/>
                  </a:lnTo>
                  <a:lnTo>
                    <a:pt x="814" y="1"/>
                  </a:lnTo>
                  <a:lnTo>
                    <a:pt x="815" y="1"/>
                  </a:lnTo>
                  <a:lnTo>
                    <a:pt x="815" y="1"/>
                  </a:lnTo>
                  <a:lnTo>
                    <a:pt x="816" y="1"/>
                  </a:lnTo>
                  <a:lnTo>
                    <a:pt x="817" y="1"/>
                  </a:lnTo>
                  <a:lnTo>
                    <a:pt x="818" y="1"/>
                  </a:lnTo>
                  <a:lnTo>
                    <a:pt x="819" y="1"/>
                  </a:lnTo>
                  <a:lnTo>
                    <a:pt x="820" y="0"/>
                  </a:lnTo>
                  <a:lnTo>
                    <a:pt x="821" y="1"/>
                  </a:lnTo>
                  <a:lnTo>
                    <a:pt x="822" y="0"/>
                  </a:lnTo>
                  <a:lnTo>
                    <a:pt x="822" y="1"/>
                  </a:lnTo>
                  <a:lnTo>
                    <a:pt x="823" y="1"/>
                  </a:lnTo>
                  <a:lnTo>
                    <a:pt x="824" y="0"/>
                  </a:lnTo>
                  <a:lnTo>
                    <a:pt x="825" y="0"/>
                  </a:lnTo>
                  <a:lnTo>
                    <a:pt x="826" y="0"/>
                  </a:lnTo>
                  <a:lnTo>
                    <a:pt x="827" y="1"/>
                  </a:lnTo>
                  <a:lnTo>
                    <a:pt x="828" y="0"/>
                  </a:lnTo>
                  <a:lnTo>
                    <a:pt x="829" y="1"/>
                  </a:lnTo>
                  <a:lnTo>
                    <a:pt x="830" y="1"/>
                  </a:lnTo>
                  <a:lnTo>
                    <a:pt x="830" y="1"/>
                  </a:lnTo>
                  <a:lnTo>
                    <a:pt x="831" y="1"/>
                  </a:lnTo>
                  <a:lnTo>
                    <a:pt x="832" y="2"/>
                  </a:lnTo>
                  <a:lnTo>
                    <a:pt x="833" y="2"/>
                  </a:lnTo>
                  <a:lnTo>
                    <a:pt x="834" y="2"/>
                  </a:lnTo>
                  <a:lnTo>
                    <a:pt x="835" y="2"/>
                  </a:lnTo>
                  <a:lnTo>
                    <a:pt x="836" y="2"/>
                  </a:lnTo>
                  <a:lnTo>
                    <a:pt x="837" y="2"/>
                  </a:lnTo>
                  <a:lnTo>
                    <a:pt x="837" y="2"/>
                  </a:lnTo>
                  <a:lnTo>
                    <a:pt x="838" y="3"/>
                  </a:lnTo>
                  <a:lnTo>
                    <a:pt x="839" y="3"/>
                  </a:lnTo>
                  <a:lnTo>
                    <a:pt x="840" y="2"/>
                  </a:lnTo>
                  <a:lnTo>
                    <a:pt x="841" y="2"/>
                  </a:lnTo>
                  <a:lnTo>
                    <a:pt x="842" y="2"/>
                  </a:lnTo>
                  <a:lnTo>
                    <a:pt x="843" y="2"/>
                  </a:lnTo>
                  <a:lnTo>
                    <a:pt x="844" y="3"/>
                  </a:lnTo>
                  <a:lnTo>
                    <a:pt x="845" y="2"/>
                  </a:lnTo>
                  <a:lnTo>
                    <a:pt x="845" y="3"/>
                  </a:lnTo>
                  <a:lnTo>
                    <a:pt x="846" y="3"/>
                  </a:lnTo>
                  <a:lnTo>
                    <a:pt x="847" y="2"/>
                  </a:lnTo>
                  <a:lnTo>
                    <a:pt x="848" y="2"/>
                  </a:lnTo>
                  <a:lnTo>
                    <a:pt x="849" y="2"/>
                  </a:lnTo>
                  <a:lnTo>
                    <a:pt x="850" y="2"/>
                  </a:lnTo>
                  <a:lnTo>
                    <a:pt x="851" y="2"/>
                  </a:lnTo>
                  <a:lnTo>
                    <a:pt x="852" y="3"/>
                  </a:lnTo>
                  <a:lnTo>
                    <a:pt x="852" y="3"/>
                  </a:lnTo>
                  <a:lnTo>
                    <a:pt x="853" y="2"/>
                  </a:lnTo>
                  <a:lnTo>
                    <a:pt x="854" y="3"/>
                  </a:lnTo>
                  <a:lnTo>
                    <a:pt x="855" y="3"/>
                  </a:lnTo>
                  <a:lnTo>
                    <a:pt x="856" y="3"/>
                  </a:lnTo>
                  <a:lnTo>
                    <a:pt x="857" y="3"/>
                  </a:lnTo>
                  <a:lnTo>
                    <a:pt x="858" y="3"/>
                  </a:lnTo>
                  <a:lnTo>
                    <a:pt x="859" y="3"/>
                  </a:lnTo>
                  <a:lnTo>
                    <a:pt x="860" y="3"/>
                  </a:lnTo>
                  <a:lnTo>
                    <a:pt x="860" y="3"/>
                  </a:lnTo>
                  <a:lnTo>
                    <a:pt x="861" y="3"/>
                  </a:lnTo>
                  <a:lnTo>
                    <a:pt x="862" y="2"/>
                  </a:lnTo>
                  <a:lnTo>
                    <a:pt x="863" y="3"/>
                  </a:lnTo>
                  <a:lnTo>
                    <a:pt x="864" y="4"/>
                  </a:lnTo>
                  <a:lnTo>
                    <a:pt x="865" y="3"/>
                  </a:lnTo>
                  <a:lnTo>
                    <a:pt x="866" y="2"/>
                  </a:lnTo>
                  <a:lnTo>
                    <a:pt x="867" y="3"/>
                  </a:lnTo>
                  <a:lnTo>
                    <a:pt x="867" y="3"/>
                  </a:lnTo>
                  <a:lnTo>
                    <a:pt x="868" y="4"/>
                  </a:lnTo>
                  <a:lnTo>
                    <a:pt x="869" y="3"/>
                  </a:lnTo>
                  <a:lnTo>
                    <a:pt x="870" y="3"/>
                  </a:lnTo>
                  <a:lnTo>
                    <a:pt x="871" y="3"/>
                  </a:lnTo>
                  <a:lnTo>
                    <a:pt x="872" y="3"/>
                  </a:lnTo>
                  <a:lnTo>
                    <a:pt x="873" y="4"/>
                  </a:lnTo>
                  <a:lnTo>
                    <a:pt x="874" y="4"/>
                  </a:lnTo>
                  <a:lnTo>
                    <a:pt x="875" y="3"/>
                  </a:lnTo>
                  <a:lnTo>
                    <a:pt x="875" y="4"/>
                  </a:lnTo>
                  <a:lnTo>
                    <a:pt x="876" y="4"/>
                  </a:lnTo>
                  <a:lnTo>
                    <a:pt x="877" y="5"/>
                  </a:lnTo>
                  <a:lnTo>
                    <a:pt x="878" y="6"/>
                  </a:lnTo>
                  <a:lnTo>
                    <a:pt x="879" y="6"/>
                  </a:lnTo>
                  <a:lnTo>
                    <a:pt x="880" y="7"/>
                  </a:lnTo>
                  <a:lnTo>
                    <a:pt x="881" y="6"/>
                  </a:lnTo>
                  <a:lnTo>
                    <a:pt x="882" y="8"/>
                  </a:lnTo>
                  <a:lnTo>
                    <a:pt x="882" y="8"/>
                  </a:lnTo>
                  <a:lnTo>
                    <a:pt x="883" y="7"/>
                  </a:lnTo>
                  <a:lnTo>
                    <a:pt x="884" y="8"/>
                  </a:lnTo>
                  <a:lnTo>
                    <a:pt x="885" y="7"/>
                  </a:lnTo>
                  <a:lnTo>
                    <a:pt x="886" y="7"/>
                  </a:lnTo>
                  <a:lnTo>
                    <a:pt x="887" y="6"/>
                  </a:lnTo>
                  <a:lnTo>
                    <a:pt x="888" y="6"/>
                  </a:lnTo>
                  <a:lnTo>
                    <a:pt x="889" y="6"/>
                  </a:lnTo>
                  <a:lnTo>
                    <a:pt x="890" y="7"/>
                  </a:lnTo>
                  <a:lnTo>
                    <a:pt x="890" y="5"/>
                  </a:lnTo>
                  <a:lnTo>
                    <a:pt x="891" y="5"/>
                  </a:lnTo>
                  <a:lnTo>
                    <a:pt x="892" y="5"/>
                  </a:lnTo>
                  <a:lnTo>
                    <a:pt x="893" y="5"/>
                  </a:lnTo>
                  <a:lnTo>
                    <a:pt x="894" y="5"/>
                  </a:lnTo>
                  <a:lnTo>
                    <a:pt x="895" y="4"/>
                  </a:lnTo>
                  <a:lnTo>
                    <a:pt x="896" y="4"/>
                  </a:lnTo>
                  <a:lnTo>
                    <a:pt x="897" y="3"/>
                  </a:lnTo>
                  <a:lnTo>
                    <a:pt x="897" y="4"/>
                  </a:lnTo>
                  <a:lnTo>
                    <a:pt x="898" y="3"/>
                  </a:lnTo>
                  <a:lnTo>
                    <a:pt x="899" y="3"/>
                  </a:lnTo>
                  <a:lnTo>
                    <a:pt x="900" y="3"/>
                  </a:lnTo>
                  <a:lnTo>
                    <a:pt x="901" y="4"/>
                  </a:lnTo>
                  <a:lnTo>
                    <a:pt x="902" y="5"/>
                  </a:lnTo>
                  <a:lnTo>
                    <a:pt x="903" y="4"/>
                  </a:lnTo>
                  <a:lnTo>
                    <a:pt x="904" y="4"/>
                  </a:lnTo>
                  <a:lnTo>
                    <a:pt x="905" y="6"/>
                  </a:lnTo>
                  <a:lnTo>
                    <a:pt x="905" y="5"/>
                  </a:lnTo>
                  <a:lnTo>
                    <a:pt x="906" y="6"/>
                  </a:lnTo>
                  <a:lnTo>
                    <a:pt x="907" y="8"/>
                  </a:lnTo>
                  <a:lnTo>
                    <a:pt x="908" y="10"/>
                  </a:lnTo>
                  <a:lnTo>
                    <a:pt x="909" y="11"/>
                  </a:lnTo>
                  <a:lnTo>
                    <a:pt x="910" y="13"/>
                  </a:lnTo>
                  <a:lnTo>
                    <a:pt x="911" y="15"/>
                  </a:lnTo>
                  <a:lnTo>
                    <a:pt x="912" y="16"/>
                  </a:lnTo>
                  <a:lnTo>
                    <a:pt x="912" y="17"/>
                  </a:lnTo>
                  <a:lnTo>
                    <a:pt x="913" y="18"/>
                  </a:lnTo>
                  <a:lnTo>
                    <a:pt x="914" y="20"/>
                  </a:lnTo>
                  <a:lnTo>
                    <a:pt x="915" y="19"/>
                  </a:lnTo>
                  <a:lnTo>
                    <a:pt x="916" y="19"/>
                  </a:lnTo>
                  <a:lnTo>
                    <a:pt x="917" y="19"/>
                  </a:lnTo>
                  <a:lnTo>
                    <a:pt x="918" y="18"/>
                  </a:lnTo>
                  <a:lnTo>
                    <a:pt x="919" y="19"/>
                  </a:lnTo>
                  <a:lnTo>
                    <a:pt x="919" y="17"/>
                  </a:lnTo>
                  <a:lnTo>
                    <a:pt x="920" y="17"/>
                  </a:lnTo>
                  <a:lnTo>
                    <a:pt x="921" y="16"/>
                  </a:lnTo>
                  <a:lnTo>
                    <a:pt x="922" y="15"/>
                  </a:lnTo>
                  <a:lnTo>
                    <a:pt x="923" y="14"/>
                  </a:lnTo>
                  <a:lnTo>
                    <a:pt x="924" y="14"/>
                  </a:lnTo>
                  <a:lnTo>
                    <a:pt x="925" y="13"/>
                  </a:lnTo>
                  <a:lnTo>
                    <a:pt x="926" y="12"/>
                  </a:lnTo>
                  <a:lnTo>
                    <a:pt x="927" y="11"/>
                  </a:lnTo>
                  <a:lnTo>
                    <a:pt x="927" y="10"/>
                  </a:lnTo>
                  <a:lnTo>
                    <a:pt x="928" y="10"/>
                  </a:lnTo>
                  <a:lnTo>
                    <a:pt x="929" y="10"/>
                  </a:lnTo>
                  <a:lnTo>
                    <a:pt x="930" y="9"/>
                  </a:lnTo>
                  <a:lnTo>
                    <a:pt x="931" y="8"/>
                  </a:lnTo>
                  <a:lnTo>
                    <a:pt x="932" y="9"/>
                  </a:lnTo>
                  <a:lnTo>
                    <a:pt x="933" y="8"/>
                  </a:lnTo>
                  <a:lnTo>
                    <a:pt x="934" y="7"/>
                  </a:lnTo>
                  <a:lnTo>
                    <a:pt x="934" y="8"/>
                  </a:lnTo>
                  <a:lnTo>
                    <a:pt x="935" y="8"/>
                  </a:lnTo>
                  <a:lnTo>
                    <a:pt x="936" y="7"/>
                  </a:lnTo>
                  <a:lnTo>
                    <a:pt x="937" y="7"/>
                  </a:lnTo>
                  <a:lnTo>
                    <a:pt x="938" y="7"/>
                  </a:lnTo>
                  <a:lnTo>
                    <a:pt x="939" y="7"/>
                  </a:lnTo>
                  <a:lnTo>
                    <a:pt x="940" y="6"/>
                  </a:lnTo>
                  <a:lnTo>
                    <a:pt x="941" y="7"/>
                  </a:lnTo>
                  <a:lnTo>
                    <a:pt x="942" y="7"/>
                  </a:lnTo>
                  <a:lnTo>
                    <a:pt x="942" y="7"/>
                  </a:lnTo>
                  <a:lnTo>
                    <a:pt x="943" y="6"/>
                  </a:lnTo>
                  <a:lnTo>
                    <a:pt x="944" y="7"/>
                  </a:lnTo>
                  <a:lnTo>
                    <a:pt x="945" y="6"/>
                  </a:lnTo>
                  <a:lnTo>
                    <a:pt x="946" y="6"/>
                  </a:lnTo>
                  <a:lnTo>
                    <a:pt x="947" y="5"/>
                  </a:lnTo>
                  <a:lnTo>
                    <a:pt x="948" y="6"/>
                  </a:lnTo>
                  <a:lnTo>
                    <a:pt x="949" y="6"/>
                  </a:lnTo>
                  <a:lnTo>
                    <a:pt x="949" y="6"/>
                  </a:lnTo>
                  <a:lnTo>
                    <a:pt x="950" y="6"/>
                  </a:lnTo>
                  <a:lnTo>
                    <a:pt x="951" y="6"/>
                  </a:lnTo>
                  <a:lnTo>
                    <a:pt x="952" y="6"/>
                  </a:lnTo>
                  <a:lnTo>
                    <a:pt x="953" y="6"/>
                  </a:lnTo>
                  <a:lnTo>
                    <a:pt x="954" y="6"/>
                  </a:lnTo>
                  <a:lnTo>
                    <a:pt x="955" y="5"/>
                  </a:lnTo>
                  <a:lnTo>
                    <a:pt x="956" y="5"/>
                  </a:lnTo>
                  <a:lnTo>
                    <a:pt x="957" y="5"/>
                  </a:lnTo>
                  <a:lnTo>
                    <a:pt x="957" y="5"/>
                  </a:lnTo>
                  <a:lnTo>
                    <a:pt x="958" y="5"/>
                  </a:lnTo>
                  <a:lnTo>
                    <a:pt x="959" y="6"/>
                  </a:lnTo>
                  <a:lnTo>
                    <a:pt x="960" y="4"/>
                  </a:lnTo>
                  <a:lnTo>
                    <a:pt x="961" y="5"/>
                  </a:lnTo>
                  <a:lnTo>
                    <a:pt x="962" y="5"/>
                  </a:lnTo>
                  <a:lnTo>
                    <a:pt x="963" y="5"/>
                  </a:lnTo>
                  <a:lnTo>
                    <a:pt x="964" y="4"/>
                  </a:lnTo>
                  <a:lnTo>
                    <a:pt x="964" y="5"/>
                  </a:lnTo>
                  <a:lnTo>
                    <a:pt x="965" y="5"/>
                  </a:lnTo>
                  <a:lnTo>
                    <a:pt x="966" y="6"/>
                  </a:lnTo>
                  <a:lnTo>
                    <a:pt x="967" y="5"/>
                  </a:lnTo>
                  <a:lnTo>
                    <a:pt x="968" y="5"/>
                  </a:lnTo>
                  <a:lnTo>
                    <a:pt x="969" y="6"/>
                  </a:lnTo>
                  <a:lnTo>
                    <a:pt x="970" y="7"/>
                  </a:lnTo>
                  <a:lnTo>
                    <a:pt x="971" y="7"/>
                  </a:lnTo>
                  <a:lnTo>
                    <a:pt x="972" y="6"/>
                  </a:lnTo>
                  <a:lnTo>
                    <a:pt x="972" y="6"/>
                  </a:lnTo>
                  <a:lnTo>
                    <a:pt x="973" y="6"/>
                  </a:lnTo>
                  <a:lnTo>
                    <a:pt x="974" y="6"/>
                  </a:lnTo>
                  <a:lnTo>
                    <a:pt x="975" y="7"/>
                  </a:lnTo>
                  <a:lnTo>
                    <a:pt x="976" y="7"/>
                  </a:lnTo>
                  <a:lnTo>
                    <a:pt x="977" y="9"/>
                  </a:lnTo>
                  <a:lnTo>
                    <a:pt x="978" y="9"/>
                  </a:lnTo>
                  <a:lnTo>
                    <a:pt x="979" y="10"/>
                  </a:lnTo>
                  <a:lnTo>
                    <a:pt x="979" y="9"/>
                  </a:lnTo>
                  <a:lnTo>
                    <a:pt x="980" y="9"/>
                  </a:lnTo>
                  <a:lnTo>
                    <a:pt x="981" y="9"/>
                  </a:lnTo>
                  <a:lnTo>
                    <a:pt x="982" y="8"/>
                  </a:lnTo>
                  <a:lnTo>
                    <a:pt x="983" y="8"/>
                  </a:lnTo>
                  <a:lnTo>
                    <a:pt x="984" y="8"/>
                  </a:lnTo>
                  <a:lnTo>
                    <a:pt x="985" y="7"/>
                  </a:lnTo>
                  <a:lnTo>
                    <a:pt x="986" y="6"/>
                  </a:lnTo>
                  <a:lnTo>
                    <a:pt x="987" y="6"/>
                  </a:lnTo>
                  <a:lnTo>
                    <a:pt x="987" y="7"/>
                  </a:lnTo>
                  <a:lnTo>
                    <a:pt x="988" y="7"/>
                  </a:lnTo>
                  <a:lnTo>
                    <a:pt x="989" y="8"/>
                  </a:lnTo>
                  <a:lnTo>
                    <a:pt x="990" y="12"/>
                  </a:lnTo>
                  <a:lnTo>
                    <a:pt x="991" y="14"/>
                  </a:lnTo>
                  <a:lnTo>
                    <a:pt x="992" y="17"/>
                  </a:lnTo>
                  <a:lnTo>
                    <a:pt x="993" y="21"/>
                  </a:lnTo>
                  <a:lnTo>
                    <a:pt x="994" y="29"/>
                  </a:lnTo>
                  <a:lnTo>
                    <a:pt x="994" y="34"/>
                  </a:lnTo>
                  <a:lnTo>
                    <a:pt x="995" y="48"/>
                  </a:lnTo>
                  <a:lnTo>
                    <a:pt x="996" y="57"/>
                  </a:lnTo>
                  <a:lnTo>
                    <a:pt x="997" y="75"/>
                  </a:lnTo>
                  <a:lnTo>
                    <a:pt x="998" y="94"/>
                  </a:lnTo>
                  <a:lnTo>
                    <a:pt x="999" y="108"/>
                  </a:lnTo>
                  <a:lnTo>
                    <a:pt x="1000" y="131"/>
                  </a:lnTo>
                  <a:lnTo>
                    <a:pt x="1001" y="153"/>
                  </a:lnTo>
                  <a:lnTo>
                    <a:pt x="1002" y="174"/>
                  </a:lnTo>
                  <a:lnTo>
                    <a:pt x="1002" y="202"/>
                  </a:lnTo>
                  <a:lnTo>
                    <a:pt x="1003" y="229"/>
                  </a:lnTo>
                  <a:lnTo>
                    <a:pt x="1004" y="259"/>
                  </a:lnTo>
                  <a:lnTo>
                    <a:pt x="1005" y="283"/>
                  </a:lnTo>
                  <a:lnTo>
                    <a:pt x="1006" y="309"/>
                  </a:lnTo>
                  <a:lnTo>
                    <a:pt x="1007" y="333"/>
                  </a:lnTo>
                  <a:lnTo>
                    <a:pt x="1008" y="367"/>
                  </a:lnTo>
                  <a:lnTo>
                    <a:pt x="1009" y="395"/>
                  </a:lnTo>
                  <a:lnTo>
                    <a:pt x="1009" y="434"/>
                  </a:lnTo>
                  <a:lnTo>
                    <a:pt x="1010" y="475"/>
                  </a:lnTo>
                  <a:lnTo>
                    <a:pt x="1011" y="504"/>
                  </a:lnTo>
                  <a:lnTo>
                    <a:pt x="1012" y="532"/>
                  </a:lnTo>
                  <a:lnTo>
                    <a:pt x="1013" y="584"/>
                  </a:lnTo>
                  <a:lnTo>
                    <a:pt x="1014" y="615"/>
                  </a:lnTo>
                  <a:lnTo>
                    <a:pt x="1015" y="668"/>
                  </a:lnTo>
                  <a:lnTo>
                    <a:pt x="1016" y="693"/>
                  </a:lnTo>
                  <a:lnTo>
                    <a:pt x="1017" y="716"/>
                  </a:lnTo>
                  <a:lnTo>
                    <a:pt x="1017" y="736"/>
                  </a:lnTo>
                  <a:lnTo>
                    <a:pt x="1018" y="758"/>
                  </a:lnTo>
                  <a:lnTo>
                    <a:pt x="1019" y="757"/>
                  </a:lnTo>
                  <a:lnTo>
                    <a:pt x="1020" y="721"/>
                  </a:lnTo>
                  <a:lnTo>
                    <a:pt x="1021" y="627"/>
                  </a:lnTo>
                  <a:lnTo>
                    <a:pt x="1022" y="492"/>
                  </a:lnTo>
                  <a:lnTo>
                    <a:pt x="1023" y="353"/>
                  </a:lnTo>
                  <a:lnTo>
                    <a:pt x="1024" y="256"/>
                  </a:lnTo>
                  <a:lnTo>
                    <a:pt x="1024" y="198"/>
                  </a:lnTo>
                  <a:lnTo>
                    <a:pt x="1025" y="169"/>
                  </a:lnTo>
                  <a:lnTo>
                    <a:pt x="1026" y="144"/>
                  </a:lnTo>
                  <a:lnTo>
                    <a:pt x="1027" y="133"/>
                  </a:lnTo>
                  <a:lnTo>
                    <a:pt x="1028" y="124"/>
                  </a:lnTo>
                  <a:lnTo>
                    <a:pt x="1029" y="115"/>
                  </a:lnTo>
                  <a:lnTo>
                    <a:pt x="1030" y="110"/>
                  </a:lnTo>
                  <a:lnTo>
                    <a:pt x="1031" y="104"/>
                  </a:lnTo>
                  <a:lnTo>
                    <a:pt x="1032" y="101"/>
                  </a:lnTo>
                  <a:lnTo>
                    <a:pt x="1032" y="93"/>
                  </a:lnTo>
                  <a:lnTo>
                    <a:pt x="1033" y="88"/>
                  </a:lnTo>
                  <a:lnTo>
                    <a:pt x="1034" y="83"/>
                  </a:lnTo>
                  <a:lnTo>
                    <a:pt x="1035" y="76"/>
                  </a:lnTo>
                  <a:lnTo>
                    <a:pt x="1036" y="71"/>
                  </a:lnTo>
                  <a:lnTo>
                    <a:pt x="1037" y="68"/>
                  </a:lnTo>
                  <a:lnTo>
                    <a:pt x="1038" y="62"/>
                  </a:lnTo>
                  <a:lnTo>
                    <a:pt x="1039" y="58"/>
                  </a:lnTo>
                  <a:lnTo>
                    <a:pt x="1039" y="53"/>
                  </a:lnTo>
                  <a:lnTo>
                    <a:pt x="1040" y="53"/>
                  </a:lnTo>
                  <a:lnTo>
                    <a:pt x="1041" y="50"/>
                  </a:lnTo>
                  <a:lnTo>
                    <a:pt x="1042" y="45"/>
                  </a:lnTo>
                  <a:lnTo>
                    <a:pt x="1043" y="42"/>
                  </a:lnTo>
                  <a:lnTo>
                    <a:pt x="1044" y="39"/>
                  </a:lnTo>
                  <a:lnTo>
                    <a:pt x="1045" y="38"/>
                  </a:lnTo>
                  <a:lnTo>
                    <a:pt x="1046" y="36"/>
                  </a:lnTo>
                  <a:lnTo>
                    <a:pt x="1047" y="34"/>
                  </a:lnTo>
                  <a:lnTo>
                    <a:pt x="1047" y="33"/>
                  </a:lnTo>
                  <a:lnTo>
                    <a:pt x="1048" y="30"/>
                  </a:lnTo>
                  <a:lnTo>
                    <a:pt x="1049" y="30"/>
                  </a:lnTo>
                  <a:lnTo>
                    <a:pt x="1050" y="30"/>
                  </a:lnTo>
                  <a:lnTo>
                    <a:pt x="1051" y="28"/>
                  </a:lnTo>
                  <a:lnTo>
                    <a:pt x="1052" y="26"/>
                  </a:lnTo>
                  <a:lnTo>
                    <a:pt x="1053" y="27"/>
                  </a:lnTo>
                  <a:lnTo>
                    <a:pt x="1054" y="27"/>
                  </a:lnTo>
                  <a:lnTo>
                    <a:pt x="1054" y="25"/>
                  </a:lnTo>
                  <a:lnTo>
                    <a:pt x="1055" y="26"/>
                  </a:lnTo>
                  <a:lnTo>
                    <a:pt x="1056" y="24"/>
                  </a:lnTo>
                  <a:lnTo>
                    <a:pt x="1057" y="25"/>
                  </a:lnTo>
                  <a:lnTo>
                    <a:pt x="1058" y="24"/>
                  </a:lnTo>
                  <a:lnTo>
                    <a:pt x="1059" y="24"/>
                  </a:lnTo>
                  <a:lnTo>
                    <a:pt x="1060" y="21"/>
                  </a:lnTo>
                  <a:lnTo>
                    <a:pt x="1061" y="24"/>
                  </a:lnTo>
                  <a:lnTo>
                    <a:pt x="1062" y="22"/>
                  </a:lnTo>
                  <a:lnTo>
                    <a:pt x="1062" y="23"/>
                  </a:lnTo>
                  <a:lnTo>
                    <a:pt x="1063" y="23"/>
                  </a:lnTo>
                  <a:lnTo>
                    <a:pt x="1064" y="20"/>
                  </a:lnTo>
                  <a:lnTo>
                    <a:pt x="1065" y="21"/>
                  </a:lnTo>
                  <a:lnTo>
                    <a:pt x="1066" y="19"/>
                  </a:lnTo>
                  <a:lnTo>
                    <a:pt x="1067" y="19"/>
                  </a:lnTo>
                  <a:lnTo>
                    <a:pt x="1068" y="19"/>
                  </a:lnTo>
                  <a:lnTo>
                    <a:pt x="1069" y="18"/>
                  </a:lnTo>
                  <a:lnTo>
                    <a:pt x="1069" y="18"/>
                  </a:lnTo>
                  <a:lnTo>
                    <a:pt x="1070" y="17"/>
                  </a:lnTo>
                  <a:lnTo>
                    <a:pt x="1071" y="18"/>
                  </a:lnTo>
                  <a:lnTo>
                    <a:pt x="1072" y="17"/>
                  </a:lnTo>
                  <a:lnTo>
                    <a:pt x="1073" y="17"/>
                  </a:lnTo>
                  <a:lnTo>
                    <a:pt x="1074" y="15"/>
                  </a:lnTo>
                  <a:lnTo>
                    <a:pt x="1075" y="15"/>
                  </a:lnTo>
                  <a:lnTo>
                    <a:pt x="1076" y="16"/>
                  </a:lnTo>
                  <a:lnTo>
                    <a:pt x="1077" y="14"/>
                  </a:lnTo>
                  <a:lnTo>
                    <a:pt x="1077" y="14"/>
                  </a:lnTo>
                  <a:lnTo>
                    <a:pt x="1078" y="14"/>
                  </a:lnTo>
                  <a:lnTo>
                    <a:pt x="1079" y="15"/>
                  </a:lnTo>
                  <a:lnTo>
                    <a:pt x="1080" y="14"/>
                  </a:lnTo>
                  <a:lnTo>
                    <a:pt x="1081" y="15"/>
                  </a:lnTo>
                  <a:lnTo>
                    <a:pt x="1082" y="15"/>
                  </a:lnTo>
                  <a:lnTo>
                    <a:pt x="1083" y="15"/>
                  </a:lnTo>
                  <a:lnTo>
                    <a:pt x="1084" y="14"/>
                  </a:lnTo>
                  <a:lnTo>
                    <a:pt x="1084" y="13"/>
                  </a:lnTo>
                  <a:lnTo>
                    <a:pt x="1085" y="13"/>
                  </a:lnTo>
                  <a:lnTo>
                    <a:pt x="1086" y="13"/>
                  </a:lnTo>
                  <a:lnTo>
                    <a:pt x="1087" y="13"/>
                  </a:lnTo>
                  <a:lnTo>
                    <a:pt x="1088" y="13"/>
                  </a:lnTo>
                  <a:lnTo>
                    <a:pt x="1089" y="12"/>
                  </a:lnTo>
                  <a:lnTo>
                    <a:pt x="1090" y="11"/>
                  </a:lnTo>
                  <a:lnTo>
                    <a:pt x="1091" y="11"/>
                  </a:lnTo>
                  <a:lnTo>
                    <a:pt x="1092" y="13"/>
                  </a:lnTo>
                  <a:lnTo>
                    <a:pt x="1092" y="13"/>
                  </a:lnTo>
                  <a:lnTo>
                    <a:pt x="1093" y="10"/>
                  </a:lnTo>
                  <a:lnTo>
                    <a:pt x="1094" y="11"/>
                  </a:lnTo>
                  <a:lnTo>
                    <a:pt x="1095" y="11"/>
                  </a:lnTo>
                  <a:lnTo>
                    <a:pt x="1096" y="10"/>
                  </a:lnTo>
                  <a:lnTo>
                    <a:pt x="1097" y="11"/>
                  </a:lnTo>
                  <a:lnTo>
                    <a:pt x="1098" y="11"/>
                  </a:lnTo>
                  <a:lnTo>
                    <a:pt x="1099" y="11"/>
                  </a:lnTo>
                  <a:lnTo>
                    <a:pt x="1099" y="11"/>
                  </a:lnTo>
                  <a:lnTo>
                    <a:pt x="1100" y="11"/>
                  </a:lnTo>
                  <a:lnTo>
                    <a:pt x="1101" y="10"/>
                  </a:lnTo>
                  <a:lnTo>
                    <a:pt x="1102" y="10"/>
                  </a:lnTo>
                  <a:lnTo>
                    <a:pt x="1103" y="11"/>
                  </a:lnTo>
                  <a:lnTo>
                    <a:pt x="1104" y="11"/>
                  </a:lnTo>
                  <a:lnTo>
                    <a:pt x="1105" y="10"/>
                  </a:lnTo>
                  <a:lnTo>
                    <a:pt x="1106" y="9"/>
                  </a:lnTo>
                  <a:lnTo>
                    <a:pt x="1106" y="10"/>
                  </a:lnTo>
                  <a:lnTo>
                    <a:pt x="1107" y="10"/>
                  </a:lnTo>
                  <a:lnTo>
                    <a:pt x="1108" y="10"/>
                  </a:lnTo>
                  <a:lnTo>
                    <a:pt x="1109" y="10"/>
                  </a:lnTo>
                  <a:lnTo>
                    <a:pt x="1110" y="10"/>
                  </a:lnTo>
                  <a:lnTo>
                    <a:pt x="1111" y="9"/>
                  </a:lnTo>
                  <a:lnTo>
                    <a:pt x="1112" y="10"/>
                  </a:lnTo>
                  <a:lnTo>
                    <a:pt x="1113" y="10"/>
                  </a:lnTo>
                  <a:lnTo>
                    <a:pt x="1114" y="9"/>
                  </a:lnTo>
                  <a:lnTo>
                    <a:pt x="1114" y="9"/>
                  </a:lnTo>
                  <a:lnTo>
                    <a:pt x="1115" y="9"/>
                  </a:lnTo>
                  <a:lnTo>
                    <a:pt x="1116" y="9"/>
                  </a:lnTo>
                  <a:lnTo>
                    <a:pt x="1117" y="9"/>
                  </a:lnTo>
                  <a:lnTo>
                    <a:pt x="1118" y="9"/>
                  </a:lnTo>
                  <a:lnTo>
                    <a:pt x="1119" y="9"/>
                  </a:lnTo>
                  <a:lnTo>
                    <a:pt x="1120" y="8"/>
                  </a:lnTo>
                  <a:lnTo>
                    <a:pt x="1121" y="8"/>
                  </a:lnTo>
                  <a:lnTo>
                    <a:pt x="1121" y="9"/>
                  </a:lnTo>
                  <a:lnTo>
                    <a:pt x="1122" y="8"/>
                  </a:lnTo>
                  <a:lnTo>
                    <a:pt x="1123" y="8"/>
                  </a:lnTo>
                  <a:lnTo>
                    <a:pt x="1124" y="9"/>
                  </a:lnTo>
                  <a:lnTo>
                    <a:pt x="1125" y="8"/>
                  </a:lnTo>
                  <a:lnTo>
                    <a:pt x="1126" y="9"/>
                  </a:lnTo>
                  <a:lnTo>
                    <a:pt x="1127" y="8"/>
                  </a:lnTo>
                  <a:lnTo>
                    <a:pt x="1128" y="8"/>
                  </a:lnTo>
                  <a:lnTo>
                    <a:pt x="1129" y="8"/>
                  </a:lnTo>
                  <a:lnTo>
                    <a:pt x="1129" y="8"/>
                  </a:lnTo>
                  <a:lnTo>
                    <a:pt x="1130" y="8"/>
                  </a:lnTo>
                  <a:lnTo>
                    <a:pt x="1131" y="8"/>
                  </a:lnTo>
                  <a:lnTo>
                    <a:pt x="1132" y="7"/>
                  </a:lnTo>
                  <a:lnTo>
                    <a:pt x="1133" y="8"/>
                  </a:lnTo>
                  <a:lnTo>
                    <a:pt x="1134" y="7"/>
                  </a:lnTo>
                  <a:lnTo>
                    <a:pt x="1135" y="8"/>
                  </a:lnTo>
                  <a:lnTo>
                    <a:pt x="1136" y="7"/>
                  </a:lnTo>
                  <a:lnTo>
                    <a:pt x="1136" y="7"/>
                  </a:lnTo>
                  <a:lnTo>
                    <a:pt x="1137" y="8"/>
                  </a:lnTo>
                  <a:lnTo>
                    <a:pt x="1138" y="8"/>
                  </a:lnTo>
                  <a:lnTo>
                    <a:pt x="1139" y="8"/>
                  </a:lnTo>
                  <a:lnTo>
                    <a:pt x="1140" y="7"/>
                  </a:lnTo>
                  <a:lnTo>
                    <a:pt x="1141" y="7"/>
                  </a:lnTo>
                  <a:lnTo>
                    <a:pt x="1142" y="7"/>
                  </a:lnTo>
                  <a:lnTo>
                    <a:pt x="1143" y="7"/>
                  </a:lnTo>
                  <a:lnTo>
                    <a:pt x="1144" y="7"/>
                  </a:lnTo>
                  <a:lnTo>
                    <a:pt x="1144" y="8"/>
                  </a:lnTo>
                  <a:lnTo>
                    <a:pt x="1145" y="9"/>
                  </a:lnTo>
                  <a:lnTo>
                    <a:pt x="1146" y="8"/>
                  </a:lnTo>
                  <a:lnTo>
                    <a:pt x="1147" y="8"/>
                  </a:lnTo>
                  <a:lnTo>
                    <a:pt x="1148" y="8"/>
                  </a:lnTo>
                  <a:lnTo>
                    <a:pt x="1149" y="7"/>
                  </a:lnTo>
                  <a:lnTo>
                    <a:pt x="1150" y="9"/>
                  </a:lnTo>
                  <a:lnTo>
                    <a:pt x="1151" y="8"/>
                  </a:lnTo>
                  <a:lnTo>
                    <a:pt x="1151" y="8"/>
                  </a:lnTo>
                  <a:lnTo>
                    <a:pt x="1152" y="8"/>
                  </a:lnTo>
                  <a:lnTo>
                    <a:pt x="1153" y="7"/>
                  </a:lnTo>
                  <a:lnTo>
                    <a:pt x="1154" y="8"/>
                  </a:lnTo>
                  <a:lnTo>
                    <a:pt x="1155" y="7"/>
                  </a:lnTo>
                  <a:lnTo>
                    <a:pt x="1156" y="7"/>
                  </a:lnTo>
                  <a:lnTo>
                    <a:pt x="1157" y="8"/>
                  </a:lnTo>
                  <a:lnTo>
                    <a:pt x="1158" y="8"/>
                  </a:lnTo>
                  <a:lnTo>
                    <a:pt x="1159" y="9"/>
                  </a:lnTo>
                  <a:lnTo>
                    <a:pt x="1159" y="9"/>
                  </a:lnTo>
                  <a:lnTo>
                    <a:pt x="1160" y="8"/>
                  </a:lnTo>
                  <a:lnTo>
                    <a:pt x="1161" y="9"/>
                  </a:lnTo>
                  <a:lnTo>
                    <a:pt x="1162" y="9"/>
                  </a:lnTo>
                  <a:lnTo>
                    <a:pt x="1163" y="9"/>
                  </a:lnTo>
                  <a:lnTo>
                    <a:pt x="1164" y="10"/>
                  </a:lnTo>
                  <a:lnTo>
                    <a:pt x="1165" y="11"/>
                  </a:lnTo>
                  <a:lnTo>
                    <a:pt x="1166" y="10"/>
                  </a:lnTo>
                  <a:lnTo>
                    <a:pt x="1166" y="10"/>
                  </a:lnTo>
                  <a:lnTo>
                    <a:pt x="1167" y="9"/>
                  </a:lnTo>
                  <a:lnTo>
                    <a:pt x="1168" y="10"/>
                  </a:lnTo>
                  <a:lnTo>
                    <a:pt x="1169" y="8"/>
                  </a:lnTo>
                  <a:lnTo>
                    <a:pt x="1170" y="10"/>
                  </a:lnTo>
                  <a:lnTo>
                    <a:pt x="1171" y="11"/>
                  </a:lnTo>
                  <a:lnTo>
                    <a:pt x="1172" y="11"/>
                  </a:lnTo>
                  <a:lnTo>
                    <a:pt x="1173" y="11"/>
                  </a:lnTo>
                  <a:lnTo>
                    <a:pt x="1174" y="11"/>
                  </a:lnTo>
                  <a:lnTo>
                    <a:pt x="1174" y="11"/>
                  </a:lnTo>
                  <a:lnTo>
                    <a:pt x="1175" y="11"/>
                  </a:lnTo>
                  <a:lnTo>
                    <a:pt x="1176" y="12"/>
                  </a:lnTo>
                  <a:lnTo>
                    <a:pt x="1177" y="13"/>
                  </a:lnTo>
                  <a:lnTo>
                    <a:pt x="1178" y="11"/>
                  </a:lnTo>
                  <a:lnTo>
                    <a:pt x="1179" y="12"/>
                  </a:lnTo>
                  <a:lnTo>
                    <a:pt x="1180" y="12"/>
                  </a:lnTo>
                  <a:lnTo>
                    <a:pt x="1181" y="13"/>
                  </a:lnTo>
                  <a:lnTo>
                    <a:pt x="1181" y="12"/>
                  </a:lnTo>
                  <a:lnTo>
                    <a:pt x="1182" y="11"/>
                  </a:lnTo>
                  <a:lnTo>
                    <a:pt x="1183" y="11"/>
                  </a:lnTo>
                  <a:lnTo>
                    <a:pt x="1184" y="11"/>
                  </a:lnTo>
                  <a:lnTo>
                    <a:pt x="1185" y="9"/>
                  </a:lnTo>
                  <a:lnTo>
                    <a:pt x="1186" y="10"/>
                  </a:lnTo>
                  <a:lnTo>
                    <a:pt x="1187" y="9"/>
                  </a:lnTo>
                  <a:lnTo>
                    <a:pt x="1188" y="9"/>
                  </a:lnTo>
                  <a:lnTo>
                    <a:pt x="1189" y="10"/>
                  </a:lnTo>
                  <a:lnTo>
                    <a:pt x="1189" y="10"/>
                  </a:lnTo>
                  <a:lnTo>
                    <a:pt x="1190" y="8"/>
                  </a:lnTo>
                  <a:lnTo>
                    <a:pt x="1191" y="10"/>
                  </a:lnTo>
                  <a:lnTo>
                    <a:pt x="1192" y="9"/>
                  </a:lnTo>
                  <a:lnTo>
                    <a:pt x="1193" y="8"/>
                  </a:lnTo>
                  <a:lnTo>
                    <a:pt x="1194" y="9"/>
                  </a:lnTo>
                  <a:lnTo>
                    <a:pt x="1195" y="9"/>
                  </a:lnTo>
                  <a:lnTo>
                    <a:pt x="1196" y="8"/>
                  </a:lnTo>
                  <a:lnTo>
                    <a:pt x="1196" y="9"/>
                  </a:lnTo>
                  <a:lnTo>
                    <a:pt x="1197" y="8"/>
                  </a:lnTo>
                  <a:lnTo>
                    <a:pt x="1198" y="8"/>
                  </a:lnTo>
                  <a:lnTo>
                    <a:pt x="1199" y="8"/>
                  </a:lnTo>
                  <a:lnTo>
                    <a:pt x="1200" y="7"/>
                  </a:lnTo>
                  <a:lnTo>
                    <a:pt x="1201" y="8"/>
                  </a:lnTo>
                  <a:lnTo>
                    <a:pt x="1202" y="8"/>
                  </a:lnTo>
                  <a:lnTo>
                    <a:pt x="1203" y="9"/>
                  </a:lnTo>
                  <a:lnTo>
                    <a:pt x="1204" y="10"/>
                  </a:lnTo>
                  <a:lnTo>
                    <a:pt x="1204" y="8"/>
                  </a:lnTo>
                  <a:lnTo>
                    <a:pt x="1205" y="8"/>
                  </a:lnTo>
                  <a:lnTo>
                    <a:pt x="1206" y="9"/>
                  </a:lnTo>
                  <a:lnTo>
                    <a:pt x="1207" y="8"/>
                  </a:lnTo>
                  <a:lnTo>
                    <a:pt x="1208" y="8"/>
                  </a:lnTo>
                  <a:lnTo>
                    <a:pt x="1209" y="8"/>
                  </a:lnTo>
                  <a:lnTo>
                    <a:pt x="1210" y="9"/>
                  </a:lnTo>
                  <a:lnTo>
                    <a:pt x="1211" y="8"/>
                  </a:lnTo>
                  <a:lnTo>
                    <a:pt x="1211" y="8"/>
                  </a:lnTo>
                  <a:lnTo>
                    <a:pt x="1212" y="8"/>
                  </a:lnTo>
                  <a:lnTo>
                    <a:pt x="1213" y="8"/>
                  </a:lnTo>
                  <a:lnTo>
                    <a:pt x="1214" y="8"/>
                  </a:lnTo>
                  <a:lnTo>
                    <a:pt x="1215" y="9"/>
                  </a:lnTo>
                  <a:lnTo>
                    <a:pt x="1216" y="8"/>
                  </a:lnTo>
                  <a:lnTo>
                    <a:pt x="1217" y="9"/>
                  </a:lnTo>
                  <a:lnTo>
                    <a:pt x="1218" y="9"/>
                  </a:lnTo>
                  <a:lnTo>
                    <a:pt x="1219" y="8"/>
                  </a:lnTo>
                  <a:lnTo>
                    <a:pt x="1219" y="8"/>
                  </a:lnTo>
                  <a:lnTo>
                    <a:pt x="1220" y="7"/>
                  </a:lnTo>
                  <a:lnTo>
                    <a:pt x="1221" y="7"/>
                  </a:lnTo>
                  <a:lnTo>
                    <a:pt x="1222" y="7"/>
                  </a:lnTo>
                  <a:lnTo>
                    <a:pt x="1223" y="6"/>
                  </a:lnTo>
                  <a:lnTo>
                    <a:pt x="1224" y="6"/>
                  </a:lnTo>
                  <a:lnTo>
                    <a:pt x="1225" y="8"/>
                  </a:lnTo>
                  <a:lnTo>
                    <a:pt x="1226" y="6"/>
                  </a:lnTo>
                  <a:lnTo>
                    <a:pt x="1226" y="7"/>
                  </a:lnTo>
                  <a:lnTo>
                    <a:pt x="1227" y="6"/>
                  </a:lnTo>
                  <a:lnTo>
                    <a:pt x="1228" y="6"/>
                  </a:lnTo>
                  <a:lnTo>
                    <a:pt x="1229" y="6"/>
                  </a:lnTo>
                  <a:lnTo>
                    <a:pt x="1230" y="7"/>
                  </a:lnTo>
                  <a:lnTo>
                    <a:pt x="1231" y="6"/>
                  </a:lnTo>
                  <a:lnTo>
                    <a:pt x="1232" y="7"/>
                  </a:lnTo>
                  <a:lnTo>
                    <a:pt x="1233" y="7"/>
                  </a:lnTo>
                  <a:lnTo>
                    <a:pt x="1234" y="6"/>
                  </a:lnTo>
                  <a:lnTo>
                    <a:pt x="1234" y="7"/>
                  </a:lnTo>
                  <a:lnTo>
                    <a:pt x="1235" y="7"/>
                  </a:lnTo>
                  <a:lnTo>
                    <a:pt x="1236" y="7"/>
                  </a:lnTo>
                  <a:lnTo>
                    <a:pt x="1237" y="7"/>
                  </a:lnTo>
                  <a:lnTo>
                    <a:pt x="1238" y="9"/>
                  </a:lnTo>
                  <a:lnTo>
                    <a:pt x="1239" y="8"/>
                  </a:lnTo>
                  <a:lnTo>
                    <a:pt x="1240" y="9"/>
                  </a:lnTo>
                  <a:lnTo>
                    <a:pt x="1241" y="8"/>
                  </a:lnTo>
                  <a:lnTo>
                    <a:pt x="1241" y="9"/>
                  </a:lnTo>
                  <a:lnTo>
                    <a:pt x="1242" y="9"/>
                  </a:lnTo>
                  <a:lnTo>
                    <a:pt x="1243" y="9"/>
                  </a:lnTo>
                  <a:lnTo>
                    <a:pt x="1244" y="9"/>
                  </a:lnTo>
                  <a:lnTo>
                    <a:pt x="1245" y="9"/>
                  </a:lnTo>
                  <a:lnTo>
                    <a:pt x="1246" y="10"/>
                  </a:lnTo>
                  <a:lnTo>
                    <a:pt x="1247" y="10"/>
                  </a:lnTo>
                  <a:lnTo>
                    <a:pt x="1248" y="10"/>
                  </a:lnTo>
                  <a:lnTo>
                    <a:pt x="1249" y="10"/>
                  </a:lnTo>
                  <a:lnTo>
                    <a:pt x="1249" y="10"/>
                  </a:lnTo>
                  <a:lnTo>
                    <a:pt x="1250" y="12"/>
                  </a:lnTo>
                  <a:lnTo>
                    <a:pt x="1251" y="12"/>
                  </a:lnTo>
                  <a:lnTo>
                    <a:pt x="1252" y="15"/>
                  </a:lnTo>
                  <a:lnTo>
                    <a:pt x="1253" y="18"/>
                  </a:lnTo>
                  <a:lnTo>
                    <a:pt x="1254" y="19"/>
                  </a:lnTo>
                  <a:lnTo>
                    <a:pt x="1255" y="21"/>
                  </a:lnTo>
                  <a:lnTo>
                    <a:pt x="1256" y="24"/>
                  </a:lnTo>
                  <a:lnTo>
                    <a:pt x="1256" y="24"/>
                  </a:lnTo>
                  <a:lnTo>
                    <a:pt x="1257" y="25"/>
                  </a:lnTo>
                  <a:lnTo>
                    <a:pt x="1258" y="26"/>
                  </a:lnTo>
                  <a:lnTo>
                    <a:pt x="1259" y="24"/>
                  </a:lnTo>
                  <a:lnTo>
                    <a:pt x="1260" y="23"/>
                  </a:lnTo>
                  <a:lnTo>
                    <a:pt x="1261" y="24"/>
                  </a:lnTo>
                  <a:lnTo>
                    <a:pt x="1262" y="23"/>
                  </a:lnTo>
                  <a:lnTo>
                    <a:pt x="1263" y="21"/>
                  </a:lnTo>
                  <a:lnTo>
                    <a:pt x="1264" y="20"/>
                  </a:lnTo>
                  <a:lnTo>
                    <a:pt x="1264" y="19"/>
                  </a:lnTo>
                  <a:lnTo>
                    <a:pt x="1265" y="18"/>
                  </a:lnTo>
                  <a:lnTo>
                    <a:pt x="1266" y="17"/>
                  </a:lnTo>
                  <a:lnTo>
                    <a:pt x="1267" y="15"/>
                  </a:lnTo>
                  <a:lnTo>
                    <a:pt x="1268" y="16"/>
                  </a:lnTo>
                  <a:lnTo>
                    <a:pt x="1269" y="15"/>
                  </a:lnTo>
                  <a:lnTo>
                    <a:pt x="1270" y="15"/>
                  </a:lnTo>
                  <a:lnTo>
                    <a:pt x="1271" y="17"/>
                  </a:lnTo>
                  <a:lnTo>
                    <a:pt x="1271" y="16"/>
                  </a:lnTo>
                  <a:lnTo>
                    <a:pt x="1272" y="15"/>
                  </a:lnTo>
                  <a:lnTo>
                    <a:pt x="1273" y="13"/>
                  </a:lnTo>
                  <a:lnTo>
                    <a:pt x="1274" y="15"/>
                  </a:lnTo>
                  <a:lnTo>
                    <a:pt x="1275" y="16"/>
                  </a:lnTo>
                  <a:lnTo>
                    <a:pt x="1276" y="14"/>
                  </a:lnTo>
                  <a:lnTo>
                    <a:pt x="1277" y="16"/>
                  </a:lnTo>
                  <a:lnTo>
                    <a:pt x="1278" y="14"/>
                  </a:lnTo>
                  <a:lnTo>
                    <a:pt x="1279" y="15"/>
                  </a:lnTo>
                  <a:lnTo>
                    <a:pt x="1279" y="14"/>
                  </a:lnTo>
                  <a:lnTo>
                    <a:pt x="1280" y="14"/>
                  </a:lnTo>
                  <a:lnTo>
                    <a:pt x="1281" y="14"/>
                  </a:lnTo>
                  <a:lnTo>
                    <a:pt x="1282" y="14"/>
                  </a:lnTo>
                  <a:lnTo>
                    <a:pt x="1283" y="15"/>
                  </a:lnTo>
                  <a:lnTo>
                    <a:pt x="1284" y="15"/>
                  </a:lnTo>
                  <a:lnTo>
                    <a:pt x="1285" y="17"/>
                  </a:lnTo>
                  <a:lnTo>
                    <a:pt x="1286" y="15"/>
                  </a:lnTo>
                  <a:lnTo>
                    <a:pt x="1286" y="17"/>
                  </a:lnTo>
                  <a:lnTo>
                    <a:pt x="1287" y="17"/>
                  </a:lnTo>
                  <a:lnTo>
                    <a:pt x="1288" y="17"/>
                  </a:lnTo>
                  <a:lnTo>
                    <a:pt x="1289" y="18"/>
                  </a:lnTo>
                  <a:lnTo>
                    <a:pt x="1290" y="17"/>
                  </a:lnTo>
                  <a:lnTo>
                    <a:pt x="1291" y="17"/>
                  </a:lnTo>
                  <a:lnTo>
                    <a:pt x="1292" y="18"/>
                  </a:lnTo>
                  <a:lnTo>
                    <a:pt x="1293" y="15"/>
                  </a:lnTo>
                  <a:lnTo>
                    <a:pt x="1294" y="16"/>
                  </a:lnTo>
                  <a:lnTo>
                    <a:pt x="1294" y="16"/>
                  </a:lnTo>
                  <a:lnTo>
                    <a:pt x="1295" y="15"/>
                  </a:lnTo>
                  <a:lnTo>
                    <a:pt x="1296" y="14"/>
                  </a:lnTo>
                  <a:lnTo>
                    <a:pt x="1297" y="14"/>
                  </a:lnTo>
                  <a:lnTo>
                    <a:pt x="1298" y="12"/>
                  </a:lnTo>
                  <a:lnTo>
                    <a:pt x="1299" y="12"/>
                  </a:lnTo>
                  <a:lnTo>
                    <a:pt x="1300" y="13"/>
                  </a:lnTo>
                  <a:lnTo>
                    <a:pt x="1301" y="13"/>
                  </a:lnTo>
                  <a:lnTo>
                    <a:pt x="1301" y="12"/>
                  </a:lnTo>
                  <a:lnTo>
                    <a:pt x="1302" y="11"/>
                  </a:lnTo>
                  <a:lnTo>
                    <a:pt x="1303" y="11"/>
                  </a:lnTo>
                  <a:lnTo>
                    <a:pt x="1304" y="12"/>
                  </a:lnTo>
                  <a:lnTo>
                    <a:pt x="1305" y="13"/>
                  </a:lnTo>
                  <a:lnTo>
                    <a:pt x="1306" y="11"/>
                  </a:lnTo>
                  <a:lnTo>
                    <a:pt x="1307" y="11"/>
                  </a:lnTo>
                  <a:lnTo>
                    <a:pt x="1308" y="11"/>
                  </a:lnTo>
                  <a:lnTo>
                    <a:pt x="1308" y="10"/>
                  </a:lnTo>
                  <a:lnTo>
                    <a:pt x="1309" y="10"/>
                  </a:lnTo>
                  <a:lnTo>
                    <a:pt x="1310" y="10"/>
                  </a:lnTo>
                  <a:lnTo>
                    <a:pt x="1311" y="9"/>
                  </a:lnTo>
                  <a:lnTo>
                    <a:pt x="1312" y="10"/>
                  </a:lnTo>
                  <a:lnTo>
                    <a:pt x="1313" y="9"/>
                  </a:lnTo>
                  <a:lnTo>
                    <a:pt x="1314" y="10"/>
                  </a:lnTo>
                  <a:lnTo>
                    <a:pt x="1315" y="8"/>
                  </a:lnTo>
                  <a:lnTo>
                    <a:pt x="1316" y="9"/>
                  </a:lnTo>
                  <a:lnTo>
                    <a:pt x="1316" y="8"/>
                  </a:lnTo>
                  <a:lnTo>
                    <a:pt x="1317" y="9"/>
                  </a:lnTo>
                  <a:lnTo>
                    <a:pt x="1318" y="8"/>
                  </a:lnTo>
                  <a:lnTo>
                    <a:pt x="1319" y="8"/>
                  </a:lnTo>
                  <a:lnTo>
                    <a:pt x="1320" y="8"/>
                  </a:lnTo>
                  <a:lnTo>
                    <a:pt x="1321" y="8"/>
                  </a:lnTo>
                  <a:lnTo>
                    <a:pt x="1322" y="8"/>
                  </a:lnTo>
                  <a:lnTo>
                    <a:pt x="1323" y="8"/>
                  </a:lnTo>
                  <a:lnTo>
                    <a:pt x="1323" y="8"/>
                  </a:lnTo>
                  <a:lnTo>
                    <a:pt x="1324" y="6"/>
                  </a:lnTo>
                  <a:lnTo>
                    <a:pt x="1325" y="8"/>
                  </a:lnTo>
                  <a:lnTo>
                    <a:pt x="1326" y="8"/>
                  </a:lnTo>
                  <a:lnTo>
                    <a:pt x="1327" y="8"/>
                  </a:lnTo>
                  <a:lnTo>
                    <a:pt x="1328" y="7"/>
                  </a:lnTo>
                  <a:lnTo>
                    <a:pt x="1329" y="7"/>
                  </a:lnTo>
                  <a:lnTo>
                    <a:pt x="1330" y="6"/>
                  </a:lnTo>
                  <a:lnTo>
                    <a:pt x="1331" y="7"/>
                  </a:lnTo>
                  <a:lnTo>
                    <a:pt x="1331" y="7"/>
                  </a:lnTo>
                  <a:lnTo>
                    <a:pt x="1332" y="7"/>
                  </a:lnTo>
                  <a:lnTo>
                    <a:pt x="1333" y="7"/>
                  </a:lnTo>
                  <a:lnTo>
                    <a:pt x="1334" y="7"/>
                  </a:lnTo>
                  <a:lnTo>
                    <a:pt x="1335" y="6"/>
                  </a:lnTo>
                  <a:lnTo>
                    <a:pt x="1336" y="7"/>
                  </a:lnTo>
                  <a:lnTo>
                    <a:pt x="1337" y="6"/>
                  </a:lnTo>
                  <a:lnTo>
                    <a:pt x="1338" y="6"/>
                  </a:lnTo>
                  <a:lnTo>
                    <a:pt x="1338" y="7"/>
                  </a:lnTo>
                  <a:lnTo>
                    <a:pt x="1339" y="6"/>
                  </a:lnTo>
                  <a:lnTo>
                    <a:pt x="1340" y="6"/>
                  </a:lnTo>
                  <a:lnTo>
                    <a:pt x="1341" y="5"/>
                  </a:lnTo>
                  <a:lnTo>
                    <a:pt x="1342" y="6"/>
                  </a:lnTo>
                  <a:lnTo>
                    <a:pt x="1343" y="6"/>
                  </a:lnTo>
                  <a:lnTo>
                    <a:pt x="1344" y="6"/>
                  </a:lnTo>
                  <a:lnTo>
                    <a:pt x="1345" y="5"/>
                  </a:lnTo>
                  <a:lnTo>
                    <a:pt x="1346" y="7"/>
                  </a:lnTo>
                  <a:lnTo>
                    <a:pt x="1346" y="6"/>
                  </a:lnTo>
                  <a:lnTo>
                    <a:pt x="1347" y="6"/>
                  </a:lnTo>
                  <a:lnTo>
                    <a:pt x="1348" y="7"/>
                  </a:lnTo>
                  <a:lnTo>
                    <a:pt x="1349" y="6"/>
                  </a:lnTo>
                  <a:lnTo>
                    <a:pt x="1350" y="5"/>
                  </a:lnTo>
                  <a:lnTo>
                    <a:pt x="1351" y="6"/>
                  </a:lnTo>
                  <a:lnTo>
                    <a:pt x="1352" y="5"/>
                  </a:lnTo>
                  <a:lnTo>
                    <a:pt x="1353" y="5"/>
                  </a:lnTo>
                  <a:lnTo>
                    <a:pt x="1353" y="6"/>
                  </a:lnTo>
                  <a:lnTo>
                    <a:pt x="1354" y="6"/>
                  </a:lnTo>
                  <a:lnTo>
                    <a:pt x="1355" y="5"/>
                  </a:lnTo>
                  <a:lnTo>
                    <a:pt x="1356" y="5"/>
                  </a:lnTo>
                  <a:lnTo>
                    <a:pt x="1357" y="5"/>
                  </a:lnTo>
                  <a:lnTo>
                    <a:pt x="1358" y="5"/>
                  </a:lnTo>
                  <a:lnTo>
                    <a:pt x="1359" y="5"/>
                  </a:lnTo>
                  <a:lnTo>
                    <a:pt x="1360" y="5"/>
                  </a:lnTo>
                  <a:lnTo>
                    <a:pt x="1361" y="5"/>
                  </a:lnTo>
                  <a:lnTo>
                    <a:pt x="1361" y="5"/>
                  </a:lnTo>
                  <a:lnTo>
                    <a:pt x="1362" y="4"/>
                  </a:lnTo>
                  <a:lnTo>
                    <a:pt x="1363" y="5"/>
                  </a:lnTo>
                  <a:lnTo>
                    <a:pt x="1364" y="5"/>
                  </a:lnTo>
                  <a:lnTo>
                    <a:pt x="1365" y="6"/>
                  </a:lnTo>
                  <a:lnTo>
                    <a:pt x="1366" y="5"/>
                  </a:lnTo>
                  <a:lnTo>
                    <a:pt x="1367" y="6"/>
                  </a:lnTo>
                  <a:lnTo>
                    <a:pt x="1368" y="6"/>
                  </a:lnTo>
                  <a:lnTo>
                    <a:pt x="1368" y="5"/>
                  </a:lnTo>
                  <a:lnTo>
                    <a:pt x="1369" y="6"/>
                  </a:lnTo>
                  <a:lnTo>
                    <a:pt x="1370" y="6"/>
                  </a:lnTo>
                  <a:lnTo>
                    <a:pt x="1371" y="8"/>
                  </a:lnTo>
                  <a:lnTo>
                    <a:pt x="1372" y="8"/>
                  </a:lnTo>
                  <a:lnTo>
                    <a:pt x="1373" y="9"/>
                  </a:lnTo>
                  <a:lnTo>
                    <a:pt x="1374" y="10"/>
                  </a:lnTo>
                  <a:lnTo>
                    <a:pt x="1375" y="9"/>
                  </a:lnTo>
                  <a:lnTo>
                    <a:pt x="1376" y="10"/>
                  </a:lnTo>
                  <a:lnTo>
                    <a:pt x="1376" y="11"/>
                  </a:lnTo>
                  <a:lnTo>
                    <a:pt x="1377" y="11"/>
                  </a:lnTo>
                  <a:lnTo>
                    <a:pt x="1378" y="10"/>
                  </a:lnTo>
                  <a:lnTo>
                    <a:pt x="1379" y="10"/>
                  </a:lnTo>
                  <a:lnTo>
                    <a:pt x="1380" y="8"/>
                  </a:lnTo>
                  <a:lnTo>
                    <a:pt x="1381" y="8"/>
                  </a:lnTo>
                  <a:lnTo>
                    <a:pt x="1382" y="8"/>
                  </a:lnTo>
                  <a:lnTo>
                    <a:pt x="1383" y="7"/>
                  </a:lnTo>
                  <a:lnTo>
                    <a:pt x="1383" y="7"/>
                  </a:lnTo>
                  <a:lnTo>
                    <a:pt x="1384" y="7"/>
                  </a:lnTo>
                  <a:lnTo>
                    <a:pt x="1385" y="7"/>
                  </a:lnTo>
                  <a:lnTo>
                    <a:pt x="1386" y="6"/>
                  </a:lnTo>
                  <a:lnTo>
                    <a:pt x="1387" y="6"/>
                  </a:lnTo>
                  <a:lnTo>
                    <a:pt x="1388" y="6"/>
                  </a:lnTo>
                  <a:lnTo>
                    <a:pt x="1389" y="5"/>
                  </a:lnTo>
                  <a:lnTo>
                    <a:pt x="1390" y="5"/>
                  </a:lnTo>
                  <a:lnTo>
                    <a:pt x="1391" y="5"/>
                  </a:lnTo>
                  <a:lnTo>
                    <a:pt x="1391" y="6"/>
                  </a:lnTo>
                  <a:lnTo>
                    <a:pt x="1392" y="6"/>
                  </a:lnTo>
                  <a:lnTo>
                    <a:pt x="1393" y="6"/>
                  </a:lnTo>
                  <a:lnTo>
                    <a:pt x="1394" y="7"/>
                  </a:lnTo>
                  <a:lnTo>
                    <a:pt x="1395" y="5"/>
                  </a:lnTo>
                  <a:lnTo>
                    <a:pt x="1396" y="6"/>
                  </a:lnTo>
                  <a:lnTo>
                    <a:pt x="1397" y="6"/>
                  </a:lnTo>
                  <a:lnTo>
                    <a:pt x="1398" y="7"/>
                  </a:lnTo>
                  <a:lnTo>
                    <a:pt x="1398" y="6"/>
                  </a:lnTo>
                  <a:lnTo>
                    <a:pt x="1399" y="8"/>
                  </a:lnTo>
                  <a:lnTo>
                    <a:pt x="1400" y="8"/>
                  </a:lnTo>
                  <a:lnTo>
                    <a:pt x="1401" y="7"/>
                  </a:lnTo>
                  <a:lnTo>
                    <a:pt x="1402" y="9"/>
                  </a:lnTo>
                  <a:lnTo>
                    <a:pt x="1403" y="8"/>
                  </a:lnTo>
                  <a:lnTo>
                    <a:pt x="1404" y="9"/>
                  </a:lnTo>
                  <a:lnTo>
                    <a:pt x="1405" y="7"/>
                  </a:lnTo>
                  <a:lnTo>
                    <a:pt x="1406" y="10"/>
                  </a:lnTo>
                  <a:lnTo>
                    <a:pt x="1406" y="8"/>
                  </a:lnTo>
                  <a:lnTo>
                    <a:pt x="1407" y="8"/>
                  </a:lnTo>
                  <a:lnTo>
                    <a:pt x="1408" y="8"/>
                  </a:lnTo>
                  <a:lnTo>
                    <a:pt x="1409" y="7"/>
                  </a:lnTo>
                  <a:lnTo>
                    <a:pt x="1410" y="7"/>
                  </a:lnTo>
                  <a:lnTo>
                    <a:pt x="1411" y="8"/>
                  </a:lnTo>
                  <a:lnTo>
                    <a:pt x="1412" y="6"/>
                  </a:lnTo>
                  <a:lnTo>
                    <a:pt x="1413" y="8"/>
                  </a:lnTo>
                  <a:lnTo>
                    <a:pt x="1413" y="7"/>
                  </a:lnTo>
                  <a:lnTo>
                    <a:pt x="1414" y="6"/>
                  </a:lnTo>
                  <a:lnTo>
                    <a:pt x="1415" y="6"/>
                  </a:lnTo>
                  <a:lnTo>
                    <a:pt x="1416" y="7"/>
                  </a:lnTo>
                  <a:lnTo>
                    <a:pt x="1417" y="7"/>
                  </a:lnTo>
                  <a:lnTo>
                    <a:pt x="1418" y="6"/>
                  </a:lnTo>
                  <a:lnTo>
                    <a:pt x="1419" y="6"/>
                  </a:lnTo>
                  <a:lnTo>
                    <a:pt x="1420" y="7"/>
                  </a:lnTo>
                  <a:lnTo>
                    <a:pt x="1421" y="7"/>
                  </a:lnTo>
                  <a:lnTo>
                    <a:pt x="1421" y="7"/>
                  </a:lnTo>
                  <a:lnTo>
                    <a:pt x="1422" y="6"/>
                  </a:lnTo>
                  <a:lnTo>
                    <a:pt x="1423" y="6"/>
                  </a:lnTo>
                  <a:lnTo>
                    <a:pt x="1424" y="6"/>
                  </a:lnTo>
                  <a:lnTo>
                    <a:pt x="1425" y="7"/>
                  </a:lnTo>
                  <a:lnTo>
                    <a:pt x="1426" y="7"/>
                  </a:lnTo>
                  <a:lnTo>
                    <a:pt x="1427" y="7"/>
                  </a:lnTo>
                  <a:lnTo>
                    <a:pt x="1428" y="6"/>
                  </a:lnTo>
                  <a:lnTo>
                    <a:pt x="1428" y="8"/>
                  </a:lnTo>
                  <a:lnTo>
                    <a:pt x="1429" y="8"/>
                  </a:lnTo>
                  <a:lnTo>
                    <a:pt x="1430" y="7"/>
                  </a:lnTo>
                  <a:lnTo>
                    <a:pt x="1431" y="8"/>
                  </a:lnTo>
                  <a:lnTo>
                    <a:pt x="1432" y="8"/>
                  </a:lnTo>
                  <a:lnTo>
                    <a:pt x="1433" y="8"/>
                  </a:lnTo>
                  <a:lnTo>
                    <a:pt x="1434" y="7"/>
                  </a:lnTo>
                  <a:lnTo>
                    <a:pt x="1435" y="7"/>
                  </a:lnTo>
                  <a:lnTo>
                    <a:pt x="1436" y="8"/>
                  </a:lnTo>
                  <a:lnTo>
                    <a:pt x="1436" y="7"/>
                  </a:lnTo>
                  <a:lnTo>
                    <a:pt x="1437" y="8"/>
                  </a:lnTo>
                  <a:lnTo>
                    <a:pt x="1438" y="7"/>
                  </a:lnTo>
                  <a:lnTo>
                    <a:pt x="1439" y="7"/>
                  </a:lnTo>
                  <a:lnTo>
                    <a:pt x="1440" y="8"/>
                  </a:lnTo>
                  <a:lnTo>
                    <a:pt x="1441" y="8"/>
                  </a:lnTo>
                  <a:lnTo>
                    <a:pt x="1442" y="7"/>
                  </a:lnTo>
                  <a:lnTo>
                    <a:pt x="1443" y="6"/>
                  </a:lnTo>
                  <a:lnTo>
                    <a:pt x="1443" y="6"/>
                  </a:lnTo>
                  <a:lnTo>
                    <a:pt x="1444" y="6"/>
                  </a:lnTo>
                  <a:lnTo>
                    <a:pt x="1445" y="6"/>
                  </a:lnTo>
                  <a:lnTo>
                    <a:pt x="1446" y="6"/>
                  </a:lnTo>
                  <a:lnTo>
                    <a:pt x="1447" y="7"/>
                  </a:lnTo>
                  <a:lnTo>
                    <a:pt x="1448" y="5"/>
                  </a:lnTo>
                  <a:lnTo>
                    <a:pt x="1449" y="5"/>
                  </a:lnTo>
                  <a:lnTo>
                    <a:pt x="1450" y="5"/>
                  </a:lnTo>
                  <a:lnTo>
                    <a:pt x="1451" y="5"/>
                  </a:lnTo>
                  <a:lnTo>
                    <a:pt x="1451" y="5"/>
                  </a:lnTo>
                  <a:lnTo>
                    <a:pt x="1452" y="5"/>
                  </a:lnTo>
                  <a:lnTo>
                    <a:pt x="1453" y="4"/>
                  </a:lnTo>
                  <a:lnTo>
                    <a:pt x="1454" y="4"/>
                  </a:lnTo>
                  <a:lnTo>
                    <a:pt x="1455" y="4"/>
                  </a:lnTo>
                  <a:lnTo>
                    <a:pt x="1456" y="4"/>
                  </a:lnTo>
                  <a:lnTo>
                    <a:pt x="1457" y="5"/>
                  </a:lnTo>
                  <a:lnTo>
                    <a:pt x="1458" y="4"/>
                  </a:lnTo>
                  <a:lnTo>
                    <a:pt x="1458" y="4"/>
                  </a:lnTo>
                  <a:lnTo>
                    <a:pt x="1459" y="4"/>
                  </a:lnTo>
                  <a:lnTo>
                    <a:pt x="1460" y="5"/>
                  </a:lnTo>
                  <a:lnTo>
                    <a:pt x="1461" y="3"/>
                  </a:lnTo>
                  <a:lnTo>
                    <a:pt x="1462" y="5"/>
                  </a:lnTo>
                  <a:lnTo>
                    <a:pt x="1463" y="5"/>
                  </a:lnTo>
                  <a:lnTo>
                    <a:pt x="1464" y="5"/>
                  </a:lnTo>
                  <a:lnTo>
                    <a:pt x="1465" y="5"/>
                  </a:lnTo>
                  <a:lnTo>
                    <a:pt x="1466" y="4"/>
                  </a:lnTo>
                  <a:lnTo>
                    <a:pt x="1466" y="4"/>
                  </a:lnTo>
                  <a:lnTo>
                    <a:pt x="1467" y="5"/>
                  </a:lnTo>
                  <a:lnTo>
                    <a:pt x="1468" y="5"/>
                  </a:lnTo>
                  <a:lnTo>
                    <a:pt x="1469" y="6"/>
                  </a:lnTo>
                  <a:lnTo>
                    <a:pt x="1470" y="5"/>
                  </a:lnTo>
                  <a:lnTo>
                    <a:pt x="1471" y="5"/>
                  </a:lnTo>
                  <a:lnTo>
                    <a:pt x="1472" y="5"/>
                  </a:lnTo>
                  <a:lnTo>
                    <a:pt x="1473" y="5"/>
                  </a:lnTo>
                  <a:lnTo>
                    <a:pt x="1473" y="6"/>
                  </a:lnTo>
                  <a:lnTo>
                    <a:pt x="1474" y="5"/>
                  </a:lnTo>
                  <a:lnTo>
                    <a:pt x="1475" y="5"/>
                  </a:lnTo>
                  <a:lnTo>
                    <a:pt x="1476" y="5"/>
                  </a:lnTo>
                  <a:lnTo>
                    <a:pt x="1477" y="5"/>
                  </a:lnTo>
                  <a:lnTo>
                    <a:pt x="1478" y="4"/>
                  </a:lnTo>
                  <a:lnTo>
                    <a:pt x="1479" y="5"/>
                  </a:lnTo>
                  <a:lnTo>
                    <a:pt x="1480" y="4"/>
                  </a:lnTo>
                  <a:lnTo>
                    <a:pt x="1481" y="4"/>
                  </a:lnTo>
                  <a:lnTo>
                    <a:pt x="1481" y="4"/>
                  </a:lnTo>
                  <a:lnTo>
                    <a:pt x="1482" y="3"/>
                  </a:lnTo>
                  <a:lnTo>
                    <a:pt x="1483" y="4"/>
                  </a:lnTo>
                  <a:lnTo>
                    <a:pt x="1484" y="4"/>
                  </a:lnTo>
                  <a:lnTo>
                    <a:pt x="1485" y="4"/>
                  </a:lnTo>
                  <a:lnTo>
                    <a:pt x="1486" y="4"/>
                  </a:lnTo>
                  <a:lnTo>
                    <a:pt x="1487" y="4"/>
                  </a:lnTo>
                  <a:lnTo>
                    <a:pt x="1488" y="4"/>
                  </a:lnTo>
                  <a:lnTo>
                    <a:pt x="1488" y="3"/>
                  </a:lnTo>
                  <a:lnTo>
                    <a:pt x="1489" y="5"/>
                  </a:lnTo>
                  <a:lnTo>
                    <a:pt x="1490" y="4"/>
                  </a:lnTo>
                  <a:lnTo>
                    <a:pt x="1491" y="5"/>
                  </a:lnTo>
                  <a:lnTo>
                    <a:pt x="1492" y="4"/>
                  </a:lnTo>
                  <a:lnTo>
                    <a:pt x="1493" y="4"/>
                  </a:lnTo>
                  <a:lnTo>
                    <a:pt x="1494" y="4"/>
                  </a:lnTo>
                  <a:lnTo>
                    <a:pt x="1495" y="4"/>
                  </a:lnTo>
                  <a:lnTo>
                    <a:pt x="1496" y="4"/>
                  </a:lnTo>
                  <a:lnTo>
                    <a:pt x="1496" y="4"/>
                  </a:lnTo>
                  <a:lnTo>
                    <a:pt x="1497" y="4"/>
                  </a:lnTo>
                  <a:lnTo>
                    <a:pt x="1498" y="4"/>
                  </a:lnTo>
                  <a:lnTo>
                    <a:pt x="1499" y="4"/>
                  </a:lnTo>
                  <a:lnTo>
                    <a:pt x="1500" y="4"/>
                  </a:lnTo>
                  <a:lnTo>
                    <a:pt x="1501" y="4"/>
                  </a:lnTo>
                  <a:lnTo>
                    <a:pt x="1502" y="4"/>
                  </a:lnTo>
                  <a:lnTo>
                    <a:pt x="1503" y="4"/>
                  </a:lnTo>
                  <a:lnTo>
                    <a:pt x="1503" y="4"/>
                  </a:lnTo>
                  <a:lnTo>
                    <a:pt x="1504" y="4"/>
                  </a:lnTo>
                  <a:lnTo>
                    <a:pt x="1505" y="4"/>
                  </a:lnTo>
                  <a:lnTo>
                    <a:pt x="1506" y="5"/>
                  </a:lnTo>
                  <a:lnTo>
                    <a:pt x="1507" y="5"/>
                  </a:lnTo>
                  <a:lnTo>
                    <a:pt x="1508" y="5"/>
                  </a:lnTo>
                  <a:lnTo>
                    <a:pt x="1509" y="6"/>
                  </a:lnTo>
                  <a:lnTo>
                    <a:pt x="1510" y="5"/>
                  </a:lnTo>
                  <a:lnTo>
                    <a:pt x="1510" y="6"/>
                  </a:lnTo>
                  <a:lnTo>
                    <a:pt x="1511" y="7"/>
                  </a:lnTo>
                  <a:lnTo>
                    <a:pt x="1512" y="6"/>
                  </a:lnTo>
                  <a:lnTo>
                    <a:pt x="1513" y="5"/>
                  </a:lnTo>
                  <a:lnTo>
                    <a:pt x="1514" y="5"/>
                  </a:lnTo>
                  <a:lnTo>
                    <a:pt x="1515" y="6"/>
                  </a:lnTo>
                  <a:lnTo>
                    <a:pt x="1516" y="4"/>
                  </a:lnTo>
                  <a:lnTo>
                    <a:pt x="1517" y="4"/>
                  </a:lnTo>
                  <a:lnTo>
                    <a:pt x="1518" y="5"/>
                  </a:lnTo>
                  <a:lnTo>
                    <a:pt x="1518" y="4"/>
                  </a:lnTo>
                  <a:lnTo>
                    <a:pt x="1519" y="5"/>
                  </a:lnTo>
                  <a:lnTo>
                    <a:pt x="1520" y="4"/>
                  </a:lnTo>
                  <a:lnTo>
                    <a:pt x="1521" y="4"/>
                  </a:lnTo>
                  <a:lnTo>
                    <a:pt x="1522" y="4"/>
                  </a:lnTo>
                  <a:lnTo>
                    <a:pt x="1523" y="5"/>
                  </a:lnTo>
                  <a:lnTo>
                    <a:pt x="1524" y="5"/>
                  </a:lnTo>
                  <a:lnTo>
                    <a:pt x="1525" y="6"/>
                  </a:lnTo>
                  <a:lnTo>
                    <a:pt x="1525" y="6"/>
                  </a:lnTo>
                  <a:lnTo>
                    <a:pt x="1526" y="7"/>
                  </a:lnTo>
                  <a:lnTo>
                    <a:pt x="1527" y="8"/>
                  </a:lnTo>
                  <a:lnTo>
                    <a:pt x="1528" y="8"/>
                  </a:lnTo>
                  <a:lnTo>
                    <a:pt x="1529" y="8"/>
                  </a:lnTo>
                  <a:lnTo>
                    <a:pt x="1530" y="7"/>
                  </a:lnTo>
                  <a:lnTo>
                    <a:pt x="1531" y="8"/>
                  </a:lnTo>
                  <a:lnTo>
                    <a:pt x="1532" y="7"/>
                  </a:lnTo>
                  <a:lnTo>
                    <a:pt x="1533" y="7"/>
                  </a:lnTo>
                  <a:lnTo>
                    <a:pt x="1533" y="7"/>
                  </a:lnTo>
                  <a:lnTo>
                    <a:pt x="1534" y="6"/>
                  </a:lnTo>
                  <a:lnTo>
                    <a:pt x="1535" y="7"/>
                  </a:lnTo>
                  <a:lnTo>
                    <a:pt x="1536" y="5"/>
                  </a:lnTo>
                  <a:lnTo>
                    <a:pt x="1537" y="6"/>
                  </a:lnTo>
                  <a:lnTo>
                    <a:pt x="1538" y="6"/>
                  </a:lnTo>
                  <a:lnTo>
                    <a:pt x="1539" y="6"/>
                  </a:lnTo>
                  <a:lnTo>
                    <a:pt x="1540" y="6"/>
                  </a:lnTo>
                  <a:lnTo>
                    <a:pt x="1540" y="5"/>
                  </a:lnTo>
                  <a:lnTo>
                    <a:pt x="1541" y="6"/>
                  </a:lnTo>
                  <a:lnTo>
                    <a:pt x="1542" y="5"/>
                  </a:lnTo>
                  <a:lnTo>
                    <a:pt x="1543" y="5"/>
                  </a:lnTo>
                  <a:lnTo>
                    <a:pt x="1544" y="5"/>
                  </a:lnTo>
                  <a:lnTo>
                    <a:pt x="1545" y="5"/>
                  </a:lnTo>
                  <a:lnTo>
                    <a:pt x="1546" y="4"/>
                  </a:lnTo>
                  <a:lnTo>
                    <a:pt x="1547" y="5"/>
                  </a:lnTo>
                  <a:lnTo>
                    <a:pt x="1548" y="4"/>
                  </a:lnTo>
                  <a:lnTo>
                    <a:pt x="1548" y="4"/>
                  </a:lnTo>
                  <a:lnTo>
                    <a:pt x="1549" y="5"/>
                  </a:lnTo>
                  <a:lnTo>
                    <a:pt x="1550" y="4"/>
                  </a:lnTo>
                  <a:lnTo>
                    <a:pt x="1551" y="4"/>
                  </a:lnTo>
                  <a:lnTo>
                    <a:pt x="1552" y="5"/>
                  </a:lnTo>
                  <a:lnTo>
                    <a:pt x="1553" y="5"/>
                  </a:lnTo>
                  <a:lnTo>
                    <a:pt x="1554" y="5"/>
                  </a:lnTo>
                  <a:lnTo>
                    <a:pt x="1555" y="5"/>
                  </a:lnTo>
                  <a:lnTo>
                    <a:pt x="1555" y="6"/>
                  </a:lnTo>
                  <a:lnTo>
                    <a:pt x="1556" y="8"/>
                  </a:lnTo>
                  <a:lnTo>
                    <a:pt x="1557" y="8"/>
                  </a:lnTo>
                  <a:lnTo>
                    <a:pt x="1558" y="8"/>
                  </a:lnTo>
                  <a:lnTo>
                    <a:pt x="1559" y="9"/>
                  </a:lnTo>
                  <a:lnTo>
                    <a:pt x="1560" y="10"/>
                  </a:lnTo>
                  <a:lnTo>
                    <a:pt x="1561" y="11"/>
                  </a:lnTo>
                  <a:lnTo>
                    <a:pt x="1562" y="12"/>
                  </a:lnTo>
                  <a:lnTo>
                    <a:pt x="1563" y="11"/>
                  </a:lnTo>
                  <a:lnTo>
                    <a:pt x="1563" y="12"/>
                  </a:lnTo>
                  <a:lnTo>
                    <a:pt x="1564" y="10"/>
                  </a:lnTo>
                  <a:lnTo>
                    <a:pt x="1565" y="9"/>
                  </a:lnTo>
                  <a:lnTo>
                    <a:pt x="1566" y="9"/>
                  </a:lnTo>
                  <a:lnTo>
                    <a:pt x="1567" y="8"/>
                  </a:lnTo>
                  <a:lnTo>
                    <a:pt x="1568" y="8"/>
                  </a:lnTo>
                  <a:lnTo>
                    <a:pt x="1569" y="7"/>
                  </a:lnTo>
                  <a:lnTo>
                    <a:pt x="1570" y="6"/>
                  </a:lnTo>
                  <a:lnTo>
                    <a:pt x="1570" y="6"/>
                  </a:lnTo>
                  <a:lnTo>
                    <a:pt x="1571" y="5"/>
                  </a:lnTo>
                  <a:lnTo>
                    <a:pt x="1572" y="6"/>
                  </a:lnTo>
                  <a:lnTo>
                    <a:pt x="1573" y="6"/>
                  </a:lnTo>
                  <a:lnTo>
                    <a:pt x="1574" y="6"/>
                  </a:lnTo>
                  <a:lnTo>
                    <a:pt x="1575" y="5"/>
                  </a:lnTo>
                  <a:lnTo>
                    <a:pt x="1576" y="6"/>
                  </a:lnTo>
                  <a:lnTo>
                    <a:pt x="1577" y="5"/>
                  </a:lnTo>
                  <a:lnTo>
                    <a:pt x="1578" y="5"/>
                  </a:lnTo>
                  <a:lnTo>
                    <a:pt x="1578" y="5"/>
                  </a:lnTo>
                  <a:lnTo>
                    <a:pt x="1579" y="5"/>
                  </a:lnTo>
                  <a:lnTo>
                    <a:pt x="1580" y="5"/>
                  </a:lnTo>
                  <a:lnTo>
                    <a:pt x="1581" y="5"/>
                  </a:lnTo>
                  <a:lnTo>
                    <a:pt x="1582" y="4"/>
                  </a:lnTo>
                  <a:lnTo>
                    <a:pt x="1583" y="5"/>
                  </a:lnTo>
                  <a:lnTo>
                    <a:pt x="1584" y="4"/>
                  </a:lnTo>
                  <a:lnTo>
                    <a:pt x="1585" y="5"/>
                  </a:lnTo>
                  <a:lnTo>
                    <a:pt x="1585" y="5"/>
                  </a:lnTo>
                  <a:lnTo>
                    <a:pt x="1586" y="5"/>
                  </a:lnTo>
                  <a:lnTo>
                    <a:pt x="1587" y="5"/>
                  </a:lnTo>
                  <a:lnTo>
                    <a:pt x="1588" y="4"/>
                  </a:lnTo>
                  <a:lnTo>
                    <a:pt x="1589" y="4"/>
                  </a:lnTo>
                  <a:lnTo>
                    <a:pt x="1590" y="4"/>
                  </a:lnTo>
                  <a:lnTo>
                    <a:pt x="1591" y="4"/>
                  </a:lnTo>
                  <a:lnTo>
                    <a:pt x="1592" y="4"/>
                  </a:lnTo>
                  <a:lnTo>
                    <a:pt x="1593" y="4"/>
                  </a:lnTo>
                  <a:lnTo>
                    <a:pt x="1593" y="4"/>
                  </a:lnTo>
                  <a:lnTo>
                    <a:pt x="1594" y="4"/>
                  </a:lnTo>
                  <a:lnTo>
                    <a:pt x="1595" y="3"/>
                  </a:lnTo>
                  <a:lnTo>
                    <a:pt x="1596" y="4"/>
                  </a:lnTo>
                  <a:lnTo>
                    <a:pt x="1597" y="3"/>
                  </a:lnTo>
                  <a:lnTo>
                    <a:pt x="1598" y="4"/>
                  </a:lnTo>
                  <a:lnTo>
                    <a:pt x="1599" y="4"/>
                  </a:lnTo>
                  <a:lnTo>
                    <a:pt x="1600" y="4"/>
                  </a:lnTo>
                  <a:lnTo>
                    <a:pt x="1600" y="4"/>
                  </a:lnTo>
                  <a:lnTo>
                    <a:pt x="1601" y="3"/>
                  </a:lnTo>
                  <a:lnTo>
                    <a:pt x="1602" y="3"/>
                  </a:lnTo>
                  <a:lnTo>
                    <a:pt x="1603" y="4"/>
                  </a:lnTo>
                  <a:lnTo>
                    <a:pt x="1604" y="4"/>
                  </a:lnTo>
                  <a:lnTo>
                    <a:pt x="1605" y="3"/>
                  </a:lnTo>
                  <a:lnTo>
                    <a:pt x="1606" y="4"/>
                  </a:lnTo>
                  <a:lnTo>
                    <a:pt x="1607" y="4"/>
                  </a:lnTo>
                  <a:lnTo>
                    <a:pt x="1608" y="4"/>
                  </a:lnTo>
                  <a:lnTo>
                    <a:pt x="1608" y="4"/>
                  </a:lnTo>
                  <a:lnTo>
                    <a:pt x="1609" y="3"/>
                  </a:lnTo>
                  <a:lnTo>
                    <a:pt x="1610" y="3"/>
                  </a:lnTo>
                  <a:lnTo>
                    <a:pt x="1611" y="3"/>
                  </a:lnTo>
                  <a:lnTo>
                    <a:pt x="1612" y="3"/>
                  </a:lnTo>
                  <a:lnTo>
                    <a:pt x="1613" y="4"/>
                  </a:lnTo>
                  <a:lnTo>
                    <a:pt x="1614" y="3"/>
                  </a:lnTo>
                  <a:lnTo>
                    <a:pt x="1615" y="4"/>
                  </a:lnTo>
                  <a:lnTo>
                    <a:pt x="1615" y="4"/>
                  </a:lnTo>
                  <a:lnTo>
                    <a:pt x="1616" y="3"/>
                  </a:lnTo>
                  <a:lnTo>
                    <a:pt x="1617" y="3"/>
                  </a:lnTo>
                  <a:lnTo>
                    <a:pt x="1618" y="3"/>
                  </a:lnTo>
                  <a:lnTo>
                    <a:pt x="1619" y="3"/>
                  </a:lnTo>
                  <a:lnTo>
                    <a:pt x="1620" y="4"/>
                  </a:lnTo>
                  <a:lnTo>
                    <a:pt x="1621" y="4"/>
                  </a:lnTo>
                  <a:lnTo>
                    <a:pt x="1622" y="3"/>
                  </a:lnTo>
                  <a:lnTo>
                    <a:pt x="1623" y="4"/>
                  </a:lnTo>
                  <a:lnTo>
                    <a:pt x="1623" y="3"/>
                  </a:lnTo>
                  <a:lnTo>
                    <a:pt x="1624" y="3"/>
                  </a:lnTo>
                  <a:lnTo>
                    <a:pt x="1625" y="3"/>
                  </a:lnTo>
                  <a:lnTo>
                    <a:pt x="1626" y="3"/>
                  </a:lnTo>
                  <a:lnTo>
                    <a:pt x="1627" y="4"/>
                  </a:lnTo>
                  <a:lnTo>
                    <a:pt x="1628" y="3"/>
                  </a:lnTo>
                  <a:lnTo>
                    <a:pt x="1629" y="4"/>
                  </a:lnTo>
                  <a:lnTo>
                    <a:pt x="1630" y="4"/>
                  </a:lnTo>
                  <a:lnTo>
                    <a:pt x="1630" y="4"/>
                  </a:lnTo>
                  <a:lnTo>
                    <a:pt x="1631" y="5"/>
                  </a:lnTo>
                  <a:lnTo>
                    <a:pt x="1632" y="5"/>
                  </a:lnTo>
                  <a:lnTo>
                    <a:pt x="1633" y="6"/>
                  </a:lnTo>
                  <a:lnTo>
                    <a:pt x="1634" y="6"/>
                  </a:lnTo>
                  <a:lnTo>
                    <a:pt x="1635" y="8"/>
                  </a:lnTo>
                  <a:lnTo>
                    <a:pt x="1636" y="9"/>
                  </a:lnTo>
                  <a:lnTo>
                    <a:pt x="1637" y="12"/>
                  </a:lnTo>
                  <a:lnTo>
                    <a:pt x="1638" y="14"/>
                  </a:lnTo>
                  <a:lnTo>
                    <a:pt x="1638" y="16"/>
                  </a:lnTo>
                  <a:lnTo>
                    <a:pt x="1639" y="20"/>
                  </a:lnTo>
                  <a:lnTo>
                    <a:pt x="1640" y="19"/>
                  </a:lnTo>
                  <a:lnTo>
                    <a:pt x="1641" y="20"/>
                  </a:lnTo>
                  <a:lnTo>
                    <a:pt x="1642" y="21"/>
                  </a:lnTo>
                  <a:lnTo>
                    <a:pt x="1643" y="20"/>
                  </a:lnTo>
                  <a:lnTo>
                    <a:pt x="1644" y="20"/>
                  </a:lnTo>
                  <a:lnTo>
                    <a:pt x="1645" y="18"/>
                  </a:lnTo>
                  <a:lnTo>
                    <a:pt x="1645" y="19"/>
                  </a:lnTo>
                  <a:lnTo>
                    <a:pt x="1646" y="17"/>
                  </a:lnTo>
                  <a:lnTo>
                    <a:pt x="1647" y="18"/>
                  </a:lnTo>
                  <a:lnTo>
                    <a:pt x="1648" y="17"/>
                  </a:lnTo>
                  <a:lnTo>
                    <a:pt x="1649" y="17"/>
                  </a:lnTo>
                  <a:lnTo>
                    <a:pt x="1650" y="18"/>
                  </a:lnTo>
                  <a:lnTo>
                    <a:pt x="1651" y="17"/>
                  </a:lnTo>
                  <a:lnTo>
                    <a:pt x="1652" y="18"/>
                  </a:lnTo>
                  <a:lnTo>
                    <a:pt x="1653" y="18"/>
                  </a:lnTo>
                  <a:lnTo>
                    <a:pt x="1653" y="20"/>
                  </a:lnTo>
                  <a:lnTo>
                    <a:pt x="1654" y="21"/>
                  </a:lnTo>
                  <a:lnTo>
                    <a:pt x="1655" y="21"/>
                  </a:lnTo>
                  <a:lnTo>
                    <a:pt x="1656" y="24"/>
                  </a:lnTo>
                  <a:lnTo>
                    <a:pt x="1657" y="24"/>
                  </a:lnTo>
                  <a:lnTo>
                    <a:pt x="1658" y="24"/>
                  </a:lnTo>
                  <a:lnTo>
                    <a:pt x="1659" y="25"/>
                  </a:lnTo>
                  <a:lnTo>
                    <a:pt x="1660" y="26"/>
                  </a:lnTo>
                  <a:lnTo>
                    <a:pt x="1660" y="28"/>
                  </a:lnTo>
                  <a:lnTo>
                    <a:pt x="1661" y="27"/>
                  </a:lnTo>
                  <a:lnTo>
                    <a:pt x="1662" y="26"/>
                  </a:lnTo>
                  <a:lnTo>
                    <a:pt x="1663" y="26"/>
                  </a:lnTo>
                  <a:lnTo>
                    <a:pt x="1664" y="22"/>
                  </a:lnTo>
                  <a:lnTo>
                    <a:pt x="1665" y="21"/>
                  </a:lnTo>
                  <a:lnTo>
                    <a:pt x="1666" y="20"/>
                  </a:lnTo>
                  <a:lnTo>
                    <a:pt x="1667" y="18"/>
                  </a:lnTo>
                  <a:lnTo>
                    <a:pt x="1668" y="16"/>
                  </a:lnTo>
                  <a:lnTo>
                    <a:pt x="1668" y="14"/>
                  </a:lnTo>
                  <a:lnTo>
                    <a:pt x="1669" y="12"/>
                  </a:lnTo>
                  <a:lnTo>
                    <a:pt x="1670" y="11"/>
                  </a:lnTo>
                  <a:lnTo>
                    <a:pt x="1671" y="11"/>
                  </a:lnTo>
                  <a:lnTo>
                    <a:pt x="1672" y="9"/>
                  </a:lnTo>
                  <a:lnTo>
                    <a:pt x="1673" y="9"/>
                  </a:lnTo>
                  <a:lnTo>
                    <a:pt x="1674" y="9"/>
                  </a:lnTo>
                  <a:lnTo>
                    <a:pt x="1675" y="9"/>
                  </a:lnTo>
                  <a:lnTo>
                    <a:pt x="1675" y="8"/>
                  </a:lnTo>
                  <a:lnTo>
                    <a:pt x="1676" y="8"/>
                  </a:lnTo>
                  <a:lnTo>
                    <a:pt x="1677" y="11"/>
                  </a:lnTo>
                  <a:lnTo>
                    <a:pt x="1678" y="11"/>
                  </a:lnTo>
                  <a:lnTo>
                    <a:pt x="1679" y="11"/>
                  </a:lnTo>
                  <a:lnTo>
                    <a:pt x="1680" y="11"/>
                  </a:lnTo>
                  <a:lnTo>
                    <a:pt x="1681" y="13"/>
                  </a:lnTo>
                  <a:lnTo>
                    <a:pt x="1682" y="13"/>
                  </a:lnTo>
                  <a:lnTo>
                    <a:pt x="1683" y="13"/>
                  </a:lnTo>
                  <a:lnTo>
                    <a:pt x="1683" y="12"/>
                  </a:lnTo>
                  <a:lnTo>
                    <a:pt x="1684" y="13"/>
                  </a:lnTo>
                  <a:lnTo>
                    <a:pt x="1685" y="14"/>
                  </a:lnTo>
                  <a:lnTo>
                    <a:pt x="1686" y="13"/>
                  </a:lnTo>
                  <a:lnTo>
                    <a:pt x="1687" y="13"/>
                  </a:lnTo>
                  <a:lnTo>
                    <a:pt x="1688" y="14"/>
                  </a:lnTo>
                  <a:lnTo>
                    <a:pt x="1689" y="13"/>
                  </a:lnTo>
                  <a:lnTo>
                    <a:pt x="1690" y="13"/>
                  </a:lnTo>
                  <a:lnTo>
                    <a:pt x="1690" y="14"/>
                  </a:lnTo>
                  <a:lnTo>
                    <a:pt x="1691" y="12"/>
                  </a:lnTo>
                  <a:lnTo>
                    <a:pt x="1692" y="13"/>
                  </a:lnTo>
                  <a:lnTo>
                    <a:pt x="1693" y="12"/>
                  </a:lnTo>
                  <a:lnTo>
                    <a:pt x="1694" y="12"/>
                  </a:lnTo>
                  <a:lnTo>
                    <a:pt x="1695" y="12"/>
                  </a:lnTo>
                  <a:lnTo>
                    <a:pt x="1696" y="12"/>
                  </a:lnTo>
                  <a:lnTo>
                    <a:pt x="1697" y="12"/>
                  </a:lnTo>
                  <a:lnTo>
                    <a:pt x="1697" y="15"/>
                  </a:lnTo>
                  <a:lnTo>
                    <a:pt x="1698" y="13"/>
                  </a:lnTo>
                  <a:lnTo>
                    <a:pt x="1699" y="15"/>
                  </a:lnTo>
                  <a:lnTo>
                    <a:pt x="1700" y="16"/>
                  </a:lnTo>
                  <a:lnTo>
                    <a:pt x="1701" y="18"/>
                  </a:lnTo>
                  <a:lnTo>
                    <a:pt x="1702" y="22"/>
                  </a:lnTo>
                  <a:lnTo>
                    <a:pt x="1703" y="24"/>
                  </a:lnTo>
                  <a:lnTo>
                    <a:pt x="1704" y="29"/>
                  </a:lnTo>
                  <a:lnTo>
                    <a:pt x="1705" y="33"/>
                  </a:lnTo>
                  <a:lnTo>
                    <a:pt x="1705" y="36"/>
                  </a:lnTo>
                  <a:lnTo>
                    <a:pt x="1706" y="41"/>
                  </a:lnTo>
                  <a:lnTo>
                    <a:pt x="1707" y="44"/>
                  </a:lnTo>
                  <a:lnTo>
                    <a:pt x="1708" y="47"/>
                  </a:lnTo>
                  <a:lnTo>
                    <a:pt x="1709" y="52"/>
                  </a:lnTo>
                  <a:lnTo>
                    <a:pt x="1710" y="57"/>
                  </a:lnTo>
                  <a:lnTo>
                    <a:pt x="1711" y="58"/>
                  </a:lnTo>
                  <a:lnTo>
                    <a:pt x="1712" y="63"/>
                  </a:lnTo>
                  <a:lnTo>
                    <a:pt x="1712" y="68"/>
                  </a:lnTo>
                  <a:lnTo>
                    <a:pt x="1713" y="71"/>
                  </a:lnTo>
                  <a:lnTo>
                    <a:pt x="1714" y="76"/>
                  </a:lnTo>
                  <a:lnTo>
                    <a:pt x="1715" y="79"/>
                  </a:lnTo>
                  <a:lnTo>
                    <a:pt x="1716" y="79"/>
                  </a:lnTo>
                  <a:lnTo>
                    <a:pt x="1717" y="83"/>
                  </a:lnTo>
                  <a:lnTo>
                    <a:pt x="1718" y="84"/>
                  </a:lnTo>
                  <a:lnTo>
                    <a:pt x="1719" y="85"/>
                  </a:lnTo>
                  <a:lnTo>
                    <a:pt x="1720" y="88"/>
                  </a:lnTo>
                  <a:lnTo>
                    <a:pt x="1720" y="87"/>
                  </a:lnTo>
                  <a:lnTo>
                    <a:pt x="1721" y="84"/>
                  </a:lnTo>
                  <a:lnTo>
                    <a:pt x="1722" y="83"/>
                  </a:lnTo>
                  <a:lnTo>
                    <a:pt x="1723" y="79"/>
                  </a:lnTo>
                  <a:lnTo>
                    <a:pt x="1724" y="77"/>
                  </a:lnTo>
                  <a:lnTo>
                    <a:pt x="1725" y="72"/>
                  </a:lnTo>
                  <a:lnTo>
                    <a:pt x="1726" y="68"/>
                  </a:lnTo>
                  <a:lnTo>
                    <a:pt x="1727" y="67"/>
                  </a:lnTo>
                  <a:lnTo>
                    <a:pt x="1727" y="62"/>
                  </a:lnTo>
                  <a:lnTo>
                    <a:pt x="1728" y="60"/>
                  </a:lnTo>
                  <a:lnTo>
                    <a:pt x="1729" y="55"/>
                  </a:lnTo>
                  <a:lnTo>
                    <a:pt x="1730" y="56"/>
                  </a:lnTo>
                  <a:lnTo>
                    <a:pt x="1731" y="51"/>
                  </a:lnTo>
                  <a:lnTo>
                    <a:pt x="1732" y="48"/>
                  </a:lnTo>
                  <a:lnTo>
                    <a:pt x="1733" y="42"/>
                  </a:lnTo>
                  <a:lnTo>
                    <a:pt x="1734" y="41"/>
                  </a:lnTo>
                  <a:lnTo>
                    <a:pt x="1735" y="40"/>
                  </a:lnTo>
                  <a:lnTo>
                    <a:pt x="1735" y="39"/>
                  </a:lnTo>
                  <a:lnTo>
                    <a:pt x="1736" y="38"/>
                  </a:lnTo>
                  <a:lnTo>
                    <a:pt x="1737" y="34"/>
                  </a:lnTo>
                  <a:lnTo>
                    <a:pt x="1738" y="32"/>
                  </a:lnTo>
                  <a:lnTo>
                    <a:pt x="1739" y="31"/>
                  </a:lnTo>
                  <a:lnTo>
                    <a:pt x="1740" y="27"/>
                  </a:lnTo>
                  <a:lnTo>
                    <a:pt x="1741" y="26"/>
                  </a:lnTo>
                  <a:lnTo>
                    <a:pt x="1742" y="26"/>
                  </a:lnTo>
                  <a:lnTo>
                    <a:pt x="1742" y="25"/>
                  </a:lnTo>
                  <a:lnTo>
                    <a:pt x="1743" y="24"/>
                  </a:lnTo>
                  <a:lnTo>
                    <a:pt x="1744" y="26"/>
                  </a:lnTo>
                  <a:lnTo>
                    <a:pt x="1745" y="21"/>
                  </a:lnTo>
                  <a:lnTo>
                    <a:pt x="1746" y="23"/>
                  </a:lnTo>
                  <a:lnTo>
                    <a:pt x="1747" y="22"/>
                  </a:lnTo>
                  <a:lnTo>
                    <a:pt x="1748" y="22"/>
                  </a:lnTo>
                  <a:lnTo>
                    <a:pt x="1749" y="20"/>
                  </a:lnTo>
                  <a:lnTo>
                    <a:pt x="1750" y="18"/>
                  </a:lnTo>
                  <a:lnTo>
                    <a:pt x="1750" y="19"/>
                  </a:lnTo>
                  <a:lnTo>
                    <a:pt x="1751" y="18"/>
                  </a:lnTo>
                  <a:lnTo>
                    <a:pt x="1752" y="19"/>
                  </a:lnTo>
                  <a:lnTo>
                    <a:pt x="1753" y="17"/>
                  </a:lnTo>
                  <a:lnTo>
                    <a:pt x="1754" y="17"/>
                  </a:lnTo>
                  <a:lnTo>
                    <a:pt x="1755" y="18"/>
                  </a:lnTo>
                  <a:lnTo>
                    <a:pt x="1756" y="17"/>
                  </a:lnTo>
                  <a:lnTo>
                    <a:pt x="1757" y="16"/>
                  </a:lnTo>
                  <a:lnTo>
                    <a:pt x="1757" y="16"/>
                  </a:lnTo>
                  <a:lnTo>
                    <a:pt x="1758" y="17"/>
                  </a:lnTo>
                  <a:lnTo>
                    <a:pt x="1759" y="14"/>
                  </a:lnTo>
                  <a:lnTo>
                    <a:pt x="1760" y="15"/>
                  </a:lnTo>
                  <a:lnTo>
                    <a:pt x="1761" y="13"/>
                  </a:lnTo>
                  <a:lnTo>
                    <a:pt x="1762" y="14"/>
                  </a:lnTo>
                  <a:lnTo>
                    <a:pt x="1763" y="15"/>
                  </a:lnTo>
                  <a:lnTo>
                    <a:pt x="1764" y="14"/>
                  </a:lnTo>
                  <a:lnTo>
                    <a:pt x="1765" y="14"/>
                  </a:lnTo>
                  <a:lnTo>
                    <a:pt x="1765" y="13"/>
                  </a:lnTo>
                  <a:lnTo>
                    <a:pt x="1766" y="14"/>
                  </a:lnTo>
                  <a:lnTo>
                    <a:pt x="1767" y="14"/>
                  </a:lnTo>
                  <a:lnTo>
                    <a:pt x="1768" y="14"/>
                  </a:lnTo>
                  <a:lnTo>
                    <a:pt x="1769" y="13"/>
                  </a:lnTo>
                  <a:lnTo>
                    <a:pt x="1770" y="14"/>
                  </a:lnTo>
                  <a:lnTo>
                    <a:pt x="1771" y="14"/>
                  </a:lnTo>
                  <a:lnTo>
                    <a:pt x="1772" y="16"/>
                  </a:lnTo>
                  <a:lnTo>
                    <a:pt x="1772" y="16"/>
                  </a:lnTo>
                  <a:lnTo>
                    <a:pt x="1773" y="14"/>
                  </a:lnTo>
                  <a:lnTo>
                    <a:pt x="1774" y="15"/>
                  </a:lnTo>
                  <a:lnTo>
                    <a:pt x="1775" y="16"/>
                  </a:lnTo>
                  <a:lnTo>
                    <a:pt x="1776" y="15"/>
                  </a:lnTo>
                  <a:lnTo>
                    <a:pt x="1777" y="16"/>
                  </a:lnTo>
                  <a:lnTo>
                    <a:pt x="1778" y="16"/>
                  </a:lnTo>
                  <a:lnTo>
                    <a:pt x="1779" y="18"/>
                  </a:lnTo>
                  <a:lnTo>
                    <a:pt x="1780" y="19"/>
                  </a:lnTo>
                  <a:lnTo>
                    <a:pt x="1780" y="23"/>
                  </a:lnTo>
                  <a:lnTo>
                    <a:pt x="1781" y="30"/>
                  </a:lnTo>
                  <a:lnTo>
                    <a:pt x="1782" y="35"/>
                  </a:lnTo>
                  <a:lnTo>
                    <a:pt x="1783" y="44"/>
                  </a:lnTo>
                  <a:lnTo>
                    <a:pt x="1784" y="54"/>
                  </a:lnTo>
                  <a:lnTo>
                    <a:pt x="1785" y="69"/>
                  </a:lnTo>
                  <a:lnTo>
                    <a:pt x="1786" y="91"/>
                  </a:lnTo>
                  <a:lnTo>
                    <a:pt x="1787" y="115"/>
                  </a:lnTo>
                  <a:lnTo>
                    <a:pt x="1787" y="144"/>
                  </a:lnTo>
                  <a:lnTo>
                    <a:pt x="1788" y="175"/>
                  </a:lnTo>
                  <a:lnTo>
                    <a:pt x="1789" y="207"/>
                  </a:lnTo>
                  <a:lnTo>
                    <a:pt x="1790" y="239"/>
                  </a:lnTo>
                  <a:lnTo>
                    <a:pt x="1791" y="284"/>
                  </a:lnTo>
                  <a:lnTo>
                    <a:pt x="1792" y="326"/>
                  </a:lnTo>
                  <a:lnTo>
                    <a:pt x="1793" y="364"/>
                  </a:lnTo>
                  <a:lnTo>
                    <a:pt x="1794" y="419"/>
                  </a:lnTo>
                  <a:lnTo>
                    <a:pt x="1795" y="468"/>
                  </a:lnTo>
                  <a:lnTo>
                    <a:pt x="1795" y="513"/>
                  </a:lnTo>
                  <a:lnTo>
                    <a:pt x="1796" y="563"/>
                  </a:lnTo>
                  <a:lnTo>
                    <a:pt x="1797" y="619"/>
                  </a:lnTo>
                  <a:lnTo>
                    <a:pt x="1798" y="657"/>
                  </a:lnTo>
                  <a:lnTo>
                    <a:pt x="1799" y="719"/>
                  </a:lnTo>
                  <a:lnTo>
                    <a:pt x="1800" y="768"/>
                  </a:lnTo>
                  <a:lnTo>
                    <a:pt x="1801" y="824"/>
                  </a:lnTo>
                  <a:lnTo>
                    <a:pt x="1802" y="886"/>
                  </a:lnTo>
                  <a:lnTo>
                    <a:pt x="1802" y="946"/>
                  </a:lnTo>
                  <a:lnTo>
                    <a:pt x="1803" y="1005"/>
                  </a:lnTo>
                  <a:lnTo>
                    <a:pt x="1804" y="1045"/>
                  </a:lnTo>
                  <a:lnTo>
                    <a:pt x="1805" y="1096"/>
                  </a:lnTo>
                  <a:lnTo>
                    <a:pt x="1806" y="1186"/>
                  </a:lnTo>
                  <a:lnTo>
                    <a:pt x="1807" y="1297"/>
                  </a:lnTo>
                  <a:lnTo>
                    <a:pt x="1808" y="1342"/>
                  </a:lnTo>
                  <a:lnTo>
                    <a:pt x="1809" y="1358"/>
                  </a:lnTo>
                  <a:lnTo>
                    <a:pt x="1810" y="1427"/>
                  </a:lnTo>
                  <a:lnTo>
                    <a:pt x="1810" y="1498"/>
                  </a:lnTo>
                  <a:lnTo>
                    <a:pt x="1811" y="1546"/>
                  </a:lnTo>
                  <a:lnTo>
                    <a:pt x="1812" y="1598"/>
                  </a:lnTo>
                  <a:lnTo>
                    <a:pt x="1813" y="1695"/>
                  </a:lnTo>
                  <a:lnTo>
                    <a:pt x="1814" y="1751"/>
                  </a:lnTo>
                  <a:lnTo>
                    <a:pt x="1815" y="1823"/>
                  </a:lnTo>
                  <a:lnTo>
                    <a:pt x="1816" y="1893"/>
                  </a:lnTo>
                  <a:lnTo>
                    <a:pt x="1817" y="1907"/>
                  </a:lnTo>
                  <a:lnTo>
                    <a:pt x="1817" y="1934"/>
                  </a:lnTo>
                  <a:lnTo>
                    <a:pt x="1818" y="2018"/>
                  </a:lnTo>
                  <a:lnTo>
                    <a:pt x="1819" y="2129"/>
                  </a:lnTo>
                  <a:lnTo>
                    <a:pt x="1820" y="2210"/>
                  </a:lnTo>
                  <a:lnTo>
                    <a:pt x="1821" y="2253"/>
                  </a:lnTo>
                  <a:lnTo>
                    <a:pt x="1822" y="2340"/>
                  </a:lnTo>
                  <a:lnTo>
                    <a:pt x="1823" y="2443"/>
                  </a:lnTo>
                  <a:lnTo>
                    <a:pt x="1824" y="2496"/>
                  </a:lnTo>
                  <a:lnTo>
                    <a:pt x="1825" y="2499"/>
                  </a:lnTo>
                  <a:lnTo>
                    <a:pt x="1825" y="2282"/>
                  </a:lnTo>
                  <a:lnTo>
                    <a:pt x="1826" y="1744"/>
                  </a:lnTo>
                  <a:lnTo>
                    <a:pt x="1827" y="1103"/>
                  </a:lnTo>
                  <a:lnTo>
                    <a:pt x="1828" y="651"/>
                  </a:lnTo>
                  <a:lnTo>
                    <a:pt x="1829" y="438"/>
                  </a:lnTo>
                  <a:lnTo>
                    <a:pt x="1830" y="349"/>
                  </a:lnTo>
                  <a:lnTo>
                    <a:pt x="1831" y="300"/>
                  </a:lnTo>
                  <a:lnTo>
                    <a:pt x="1832" y="273"/>
                  </a:lnTo>
                  <a:lnTo>
                    <a:pt x="1832" y="258"/>
                  </a:lnTo>
                  <a:lnTo>
                    <a:pt x="1833" y="247"/>
                  </a:lnTo>
                  <a:lnTo>
                    <a:pt x="1834" y="249"/>
                  </a:lnTo>
                  <a:lnTo>
                    <a:pt x="1835" y="244"/>
                  </a:lnTo>
                  <a:lnTo>
                    <a:pt x="1836" y="232"/>
                  </a:lnTo>
                  <a:lnTo>
                    <a:pt x="1837" y="221"/>
                  </a:lnTo>
                  <a:lnTo>
                    <a:pt x="1838" y="210"/>
                  </a:lnTo>
                  <a:lnTo>
                    <a:pt x="1839" y="194"/>
                  </a:lnTo>
                  <a:lnTo>
                    <a:pt x="1840" y="173"/>
                  </a:lnTo>
                  <a:lnTo>
                    <a:pt x="1840" y="164"/>
                  </a:lnTo>
                  <a:lnTo>
                    <a:pt x="1841" y="148"/>
                  </a:lnTo>
                  <a:lnTo>
                    <a:pt x="1842" y="146"/>
                  </a:lnTo>
                  <a:lnTo>
                    <a:pt x="1843" y="137"/>
                  </a:lnTo>
                  <a:lnTo>
                    <a:pt x="1844" y="129"/>
                  </a:lnTo>
                  <a:lnTo>
                    <a:pt x="1845" y="126"/>
                  </a:lnTo>
                  <a:lnTo>
                    <a:pt x="1846" y="118"/>
                  </a:lnTo>
                  <a:lnTo>
                    <a:pt x="1847" y="115"/>
                  </a:lnTo>
                  <a:lnTo>
                    <a:pt x="1847" y="110"/>
                  </a:lnTo>
                  <a:lnTo>
                    <a:pt x="1848" y="108"/>
                  </a:lnTo>
                  <a:lnTo>
                    <a:pt x="1849" y="105"/>
                  </a:lnTo>
                  <a:lnTo>
                    <a:pt x="1850" y="100"/>
                  </a:lnTo>
                  <a:lnTo>
                    <a:pt x="1851" y="94"/>
                  </a:lnTo>
                  <a:lnTo>
                    <a:pt x="1852" y="91"/>
                  </a:lnTo>
                  <a:lnTo>
                    <a:pt x="1853" y="89"/>
                  </a:lnTo>
                  <a:lnTo>
                    <a:pt x="1854" y="86"/>
                  </a:lnTo>
                  <a:lnTo>
                    <a:pt x="1855" y="84"/>
                  </a:lnTo>
                  <a:lnTo>
                    <a:pt x="1855" y="80"/>
                  </a:lnTo>
                  <a:lnTo>
                    <a:pt x="1856" y="77"/>
                  </a:lnTo>
                  <a:lnTo>
                    <a:pt x="1857" y="76"/>
                  </a:lnTo>
                  <a:lnTo>
                    <a:pt x="1858" y="75"/>
                  </a:lnTo>
                  <a:lnTo>
                    <a:pt x="1859" y="73"/>
                  </a:lnTo>
                  <a:lnTo>
                    <a:pt x="1860" y="70"/>
                  </a:lnTo>
                  <a:lnTo>
                    <a:pt x="1861" y="67"/>
                  </a:lnTo>
                  <a:lnTo>
                    <a:pt x="1862" y="66"/>
                  </a:lnTo>
                  <a:lnTo>
                    <a:pt x="1862" y="64"/>
                  </a:lnTo>
                  <a:lnTo>
                    <a:pt x="1863" y="64"/>
                  </a:lnTo>
                  <a:lnTo>
                    <a:pt x="1864" y="65"/>
                  </a:lnTo>
                  <a:lnTo>
                    <a:pt x="1865" y="63"/>
                  </a:lnTo>
                  <a:lnTo>
                    <a:pt x="1866" y="60"/>
                  </a:lnTo>
                  <a:lnTo>
                    <a:pt x="1867" y="60"/>
                  </a:lnTo>
                  <a:lnTo>
                    <a:pt x="1868" y="59"/>
                  </a:lnTo>
                  <a:lnTo>
                    <a:pt x="1869" y="59"/>
                  </a:lnTo>
                  <a:lnTo>
                    <a:pt x="1870" y="59"/>
                  </a:lnTo>
                  <a:lnTo>
                    <a:pt x="1870" y="56"/>
                  </a:lnTo>
                  <a:lnTo>
                    <a:pt x="1871" y="55"/>
                  </a:lnTo>
                  <a:lnTo>
                    <a:pt x="1872" y="55"/>
                  </a:lnTo>
                  <a:lnTo>
                    <a:pt x="1873" y="56"/>
                  </a:lnTo>
                  <a:lnTo>
                    <a:pt x="1874" y="53"/>
                  </a:lnTo>
                  <a:lnTo>
                    <a:pt x="1875" y="51"/>
                  </a:lnTo>
                  <a:lnTo>
                    <a:pt x="1876" y="52"/>
                  </a:lnTo>
                  <a:lnTo>
                    <a:pt x="1877" y="53"/>
                  </a:lnTo>
                  <a:lnTo>
                    <a:pt x="1877" y="50"/>
                  </a:lnTo>
                  <a:lnTo>
                    <a:pt x="1878" y="50"/>
                  </a:lnTo>
                  <a:lnTo>
                    <a:pt x="1879" y="53"/>
                  </a:lnTo>
                  <a:lnTo>
                    <a:pt x="1880" y="51"/>
                  </a:lnTo>
                  <a:lnTo>
                    <a:pt x="1881" y="50"/>
                  </a:lnTo>
                  <a:lnTo>
                    <a:pt x="1882" y="50"/>
                  </a:lnTo>
                  <a:lnTo>
                    <a:pt x="1883" y="51"/>
                  </a:lnTo>
                  <a:lnTo>
                    <a:pt x="1884" y="50"/>
                  </a:lnTo>
                  <a:lnTo>
                    <a:pt x="1885" y="47"/>
                  </a:lnTo>
                  <a:lnTo>
                    <a:pt x="1885" y="47"/>
                  </a:lnTo>
                  <a:lnTo>
                    <a:pt x="1886" y="45"/>
                  </a:lnTo>
                  <a:lnTo>
                    <a:pt x="1887" y="45"/>
                  </a:lnTo>
                  <a:lnTo>
                    <a:pt x="1888" y="45"/>
                  </a:lnTo>
                  <a:lnTo>
                    <a:pt x="1889" y="42"/>
                  </a:lnTo>
                  <a:lnTo>
                    <a:pt x="1890" y="42"/>
                  </a:lnTo>
                  <a:lnTo>
                    <a:pt x="1891" y="44"/>
                  </a:lnTo>
                  <a:lnTo>
                    <a:pt x="1892" y="44"/>
                  </a:lnTo>
                  <a:lnTo>
                    <a:pt x="1892" y="43"/>
                  </a:lnTo>
                  <a:lnTo>
                    <a:pt x="1893" y="42"/>
                  </a:lnTo>
                  <a:lnTo>
                    <a:pt x="1894" y="41"/>
                  </a:lnTo>
                  <a:lnTo>
                    <a:pt x="1895" y="40"/>
                  </a:lnTo>
                  <a:lnTo>
                    <a:pt x="1896" y="40"/>
                  </a:lnTo>
                  <a:lnTo>
                    <a:pt x="1897" y="40"/>
                  </a:lnTo>
                  <a:lnTo>
                    <a:pt x="1898" y="38"/>
                  </a:lnTo>
                  <a:lnTo>
                    <a:pt x="1899" y="37"/>
                  </a:lnTo>
                  <a:lnTo>
                    <a:pt x="1899" y="41"/>
                  </a:lnTo>
                  <a:lnTo>
                    <a:pt x="1900" y="38"/>
                  </a:lnTo>
                  <a:lnTo>
                    <a:pt x="1901" y="40"/>
                  </a:lnTo>
                  <a:lnTo>
                    <a:pt x="1902" y="39"/>
                  </a:lnTo>
                  <a:lnTo>
                    <a:pt x="1903" y="36"/>
                  </a:lnTo>
                  <a:lnTo>
                    <a:pt x="1904" y="35"/>
                  </a:lnTo>
                  <a:lnTo>
                    <a:pt x="1905" y="35"/>
                  </a:lnTo>
                  <a:lnTo>
                    <a:pt x="1906" y="35"/>
                  </a:lnTo>
                  <a:lnTo>
                    <a:pt x="1907" y="36"/>
                  </a:lnTo>
                  <a:lnTo>
                    <a:pt x="1907" y="36"/>
                  </a:lnTo>
                  <a:lnTo>
                    <a:pt x="1908" y="38"/>
                  </a:lnTo>
                  <a:lnTo>
                    <a:pt x="1909" y="34"/>
                  </a:lnTo>
                  <a:lnTo>
                    <a:pt x="1910" y="35"/>
                  </a:lnTo>
                  <a:lnTo>
                    <a:pt x="1911" y="37"/>
                  </a:lnTo>
                  <a:lnTo>
                    <a:pt x="1912" y="35"/>
                  </a:lnTo>
                  <a:lnTo>
                    <a:pt x="1913" y="36"/>
                  </a:lnTo>
                  <a:lnTo>
                    <a:pt x="1914" y="38"/>
                  </a:lnTo>
                  <a:lnTo>
                    <a:pt x="1914" y="39"/>
                  </a:lnTo>
                  <a:lnTo>
                    <a:pt x="1915" y="42"/>
                  </a:lnTo>
                  <a:lnTo>
                    <a:pt x="1916" y="43"/>
                  </a:lnTo>
                  <a:lnTo>
                    <a:pt x="1917" y="41"/>
                  </a:lnTo>
                  <a:lnTo>
                    <a:pt x="1918" y="43"/>
                  </a:lnTo>
                  <a:lnTo>
                    <a:pt x="1919" y="43"/>
                  </a:lnTo>
                  <a:lnTo>
                    <a:pt x="1920" y="44"/>
                  </a:lnTo>
                  <a:lnTo>
                    <a:pt x="1921" y="44"/>
                  </a:lnTo>
                  <a:lnTo>
                    <a:pt x="1922" y="42"/>
                  </a:lnTo>
                  <a:lnTo>
                    <a:pt x="1922" y="40"/>
                  </a:lnTo>
                  <a:lnTo>
                    <a:pt x="1923" y="39"/>
                  </a:lnTo>
                  <a:lnTo>
                    <a:pt x="1924" y="39"/>
                  </a:lnTo>
                  <a:lnTo>
                    <a:pt x="1925" y="39"/>
                  </a:lnTo>
                  <a:lnTo>
                    <a:pt x="1926" y="38"/>
                  </a:lnTo>
                  <a:lnTo>
                    <a:pt x="1927" y="38"/>
                  </a:lnTo>
                  <a:lnTo>
                    <a:pt x="1928" y="38"/>
                  </a:lnTo>
                  <a:lnTo>
                    <a:pt x="1929" y="36"/>
                  </a:lnTo>
                  <a:lnTo>
                    <a:pt x="1929" y="37"/>
                  </a:lnTo>
                  <a:lnTo>
                    <a:pt x="1930" y="35"/>
                  </a:lnTo>
                  <a:lnTo>
                    <a:pt x="1931" y="38"/>
                  </a:lnTo>
                  <a:lnTo>
                    <a:pt x="1932" y="35"/>
                  </a:lnTo>
                  <a:lnTo>
                    <a:pt x="1933" y="35"/>
                  </a:lnTo>
                  <a:lnTo>
                    <a:pt x="1934" y="37"/>
                  </a:lnTo>
                  <a:lnTo>
                    <a:pt x="1935" y="36"/>
                  </a:lnTo>
                  <a:lnTo>
                    <a:pt x="1936" y="35"/>
                  </a:lnTo>
                  <a:lnTo>
                    <a:pt x="1937" y="36"/>
                  </a:lnTo>
                  <a:lnTo>
                    <a:pt x="1937" y="39"/>
                  </a:lnTo>
                  <a:lnTo>
                    <a:pt x="1938" y="41"/>
                  </a:lnTo>
                  <a:lnTo>
                    <a:pt x="1939" y="39"/>
                  </a:lnTo>
                  <a:lnTo>
                    <a:pt x="1940" y="43"/>
                  </a:lnTo>
                  <a:lnTo>
                    <a:pt x="1941" y="42"/>
                  </a:lnTo>
                  <a:lnTo>
                    <a:pt x="1942" y="46"/>
                  </a:lnTo>
                  <a:lnTo>
                    <a:pt x="1943" y="51"/>
                  </a:lnTo>
                  <a:lnTo>
                    <a:pt x="1944" y="54"/>
                  </a:lnTo>
                  <a:lnTo>
                    <a:pt x="1944" y="56"/>
                  </a:lnTo>
                  <a:lnTo>
                    <a:pt x="1945" y="60"/>
                  </a:lnTo>
                  <a:lnTo>
                    <a:pt x="1946" y="64"/>
                  </a:lnTo>
                  <a:lnTo>
                    <a:pt x="1947" y="67"/>
                  </a:lnTo>
                  <a:lnTo>
                    <a:pt x="1948" y="71"/>
                  </a:lnTo>
                  <a:lnTo>
                    <a:pt x="1949" y="71"/>
                  </a:lnTo>
                  <a:lnTo>
                    <a:pt x="1950" y="73"/>
                  </a:lnTo>
                  <a:lnTo>
                    <a:pt x="1951" y="72"/>
                  </a:lnTo>
                  <a:lnTo>
                    <a:pt x="1952" y="66"/>
                  </a:lnTo>
                  <a:lnTo>
                    <a:pt x="1952" y="63"/>
                  </a:lnTo>
                  <a:lnTo>
                    <a:pt x="1953" y="62"/>
                  </a:lnTo>
                  <a:lnTo>
                    <a:pt x="1954" y="57"/>
                  </a:lnTo>
                  <a:lnTo>
                    <a:pt x="1955" y="54"/>
                  </a:lnTo>
                  <a:lnTo>
                    <a:pt x="1956" y="51"/>
                  </a:lnTo>
                  <a:lnTo>
                    <a:pt x="1957" y="50"/>
                  </a:lnTo>
                  <a:lnTo>
                    <a:pt x="1958" y="47"/>
                  </a:lnTo>
                  <a:lnTo>
                    <a:pt x="1959" y="45"/>
                  </a:lnTo>
                  <a:lnTo>
                    <a:pt x="1959" y="45"/>
                  </a:lnTo>
                  <a:lnTo>
                    <a:pt x="1960" y="45"/>
                  </a:lnTo>
                  <a:lnTo>
                    <a:pt x="1961" y="43"/>
                  </a:lnTo>
                  <a:lnTo>
                    <a:pt x="1962" y="41"/>
                  </a:lnTo>
                  <a:lnTo>
                    <a:pt x="1963" y="40"/>
                  </a:lnTo>
                  <a:lnTo>
                    <a:pt x="1964" y="38"/>
                  </a:lnTo>
                  <a:lnTo>
                    <a:pt x="1965" y="39"/>
                  </a:lnTo>
                  <a:lnTo>
                    <a:pt x="1966" y="38"/>
                  </a:lnTo>
                  <a:lnTo>
                    <a:pt x="1967" y="36"/>
                  </a:lnTo>
                  <a:lnTo>
                    <a:pt x="1967" y="36"/>
                  </a:lnTo>
                  <a:lnTo>
                    <a:pt x="1968" y="34"/>
                  </a:lnTo>
                  <a:lnTo>
                    <a:pt x="1969" y="37"/>
                  </a:lnTo>
                  <a:lnTo>
                    <a:pt x="1970" y="33"/>
                  </a:lnTo>
                  <a:lnTo>
                    <a:pt x="1971" y="34"/>
                  </a:lnTo>
                  <a:lnTo>
                    <a:pt x="1972" y="32"/>
                  </a:lnTo>
                  <a:lnTo>
                    <a:pt x="1973" y="31"/>
                  </a:lnTo>
                  <a:lnTo>
                    <a:pt x="1974" y="30"/>
                  </a:lnTo>
                  <a:lnTo>
                    <a:pt x="1974" y="31"/>
                  </a:lnTo>
                  <a:lnTo>
                    <a:pt x="1975" y="32"/>
                  </a:lnTo>
                  <a:lnTo>
                    <a:pt x="1976" y="28"/>
                  </a:lnTo>
                  <a:lnTo>
                    <a:pt x="1977" y="29"/>
                  </a:lnTo>
                  <a:lnTo>
                    <a:pt x="1978" y="30"/>
                  </a:lnTo>
                  <a:lnTo>
                    <a:pt x="1979" y="28"/>
                  </a:lnTo>
                  <a:lnTo>
                    <a:pt x="1980" y="29"/>
                  </a:lnTo>
                  <a:lnTo>
                    <a:pt x="1981" y="28"/>
                  </a:lnTo>
                  <a:lnTo>
                    <a:pt x="1982" y="27"/>
                  </a:lnTo>
                  <a:lnTo>
                    <a:pt x="1982" y="26"/>
                  </a:lnTo>
                  <a:lnTo>
                    <a:pt x="1983" y="29"/>
                  </a:lnTo>
                  <a:lnTo>
                    <a:pt x="1984" y="28"/>
                  </a:lnTo>
                  <a:lnTo>
                    <a:pt x="1985" y="27"/>
                  </a:lnTo>
                  <a:lnTo>
                    <a:pt x="1986" y="28"/>
                  </a:lnTo>
                  <a:lnTo>
                    <a:pt x="1987" y="28"/>
                  </a:lnTo>
                  <a:lnTo>
                    <a:pt x="1988" y="29"/>
                  </a:lnTo>
                  <a:lnTo>
                    <a:pt x="1989" y="28"/>
                  </a:lnTo>
                  <a:lnTo>
                    <a:pt x="1989" y="27"/>
                  </a:lnTo>
                  <a:lnTo>
                    <a:pt x="1990" y="29"/>
                  </a:lnTo>
                  <a:lnTo>
                    <a:pt x="1991" y="27"/>
                  </a:lnTo>
                  <a:lnTo>
                    <a:pt x="1992" y="30"/>
                  </a:lnTo>
                  <a:lnTo>
                    <a:pt x="1993" y="29"/>
                  </a:lnTo>
                  <a:lnTo>
                    <a:pt x="1994" y="30"/>
                  </a:lnTo>
                  <a:lnTo>
                    <a:pt x="1995" y="28"/>
                  </a:lnTo>
                  <a:lnTo>
                    <a:pt x="1996" y="29"/>
                  </a:lnTo>
                  <a:lnTo>
                    <a:pt x="1997" y="27"/>
                  </a:lnTo>
                  <a:lnTo>
                    <a:pt x="1997" y="30"/>
                  </a:lnTo>
                  <a:lnTo>
                    <a:pt x="1998" y="28"/>
                  </a:lnTo>
                  <a:lnTo>
                    <a:pt x="1999" y="27"/>
                  </a:lnTo>
                  <a:lnTo>
                    <a:pt x="2000" y="28"/>
                  </a:lnTo>
                  <a:lnTo>
                    <a:pt x="2001" y="27"/>
                  </a:lnTo>
                  <a:lnTo>
                    <a:pt x="2002" y="25"/>
                  </a:lnTo>
                  <a:lnTo>
                    <a:pt x="2003" y="28"/>
                  </a:lnTo>
                  <a:lnTo>
                    <a:pt x="2004" y="27"/>
                  </a:lnTo>
                  <a:lnTo>
                    <a:pt x="2004" y="26"/>
                  </a:lnTo>
                  <a:lnTo>
                    <a:pt x="2005" y="25"/>
                  </a:lnTo>
                  <a:lnTo>
                    <a:pt x="2006" y="24"/>
                  </a:lnTo>
                  <a:lnTo>
                    <a:pt x="2007" y="25"/>
                  </a:lnTo>
                  <a:lnTo>
                    <a:pt x="2008" y="26"/>
                  </a:lnTo>
                  <a:lnTo>
                    <a:pt x="2009" y="26"/>
                  </a:lnTo>
                  <a:lnTo>
                    <a:pt x="2010" y="23"/>
                  </a:lnTo>
                  <a:lnTo>
                    <a:pt x="2011" y="23"/>
                  </a:lnTo>
                  <a:lnTo>
                    <a:pt x="2012" y="22"/>
                  </a:lnTo>
                  <a:lnTo>
                    <a:pt x="2012" y="23"/>
                  </a:lnTo>
                  <a:lnTo>
                    <a:pt x="2013" y="23"/>
                  </a:lnTo>
                  <a:lnTo>
                    <a:pt x="2014" y="24"/>
                  </a:lnTo>
                  <a:lnTo>
                    <a:pt x="2015" y="25"/>
                  </a:lnTo>
                  <a:lnTo>
                    <a:pt x="2016" y="25"/>
                  </a:lnTo>
                  <a:lnTo>
                    <a:pt x="2017" y="24"/>
                  </a:lnTo>
                  <a:lnTo>
                    <a:pt x="2018" y="24"/>
                  </a:lnTo>
                  <a:lnTo>
                    <a:pt x="2019" y="24"/>
                  </a:lnTo>
                  <a:lnTo>
                    <a:pt x="2019" y="25"/>
                  </a:lnTo>
                  <a:lnTo>
                    <a:pt x="2020" y="24"/>
                  </a:lnTo>
                  <a:lnTo>
                    <a:pt x="2021" y="28"/>
                  </a:lnTo>
                  <a:lnTo>
                    <a:pt x="2022" y="28"/>
                  </a:lnTo>
                  <a:lnTo>
                    <a:pt x="2023" y="31"/>
                  </a:lnTo>
                  <a:lnTo>
                    <a:pt x="2024" y="32"/>
                  </a:lnTo>
                  <a:lnTo>
                    <a:pt x="2025" y="34"/>
                  </a:lnTo>
                  <a:lnTo>
                    <a:pt x="2026" y="36"/>
                  </a:lnTo>
                  <a:lnTo>
                    <a:pt x="2027" y="37"/>
                  </a:lnTo>
                  <a:lnTo>
                    <a:pt x="2027" y="39"/>
                  </a:lnTo>
                  <a:lnTo>
                    <a:pt x="2028" y="38"/>
                  </a:lnTo>
                  <a:lnTo>
                    <a:pt x="2029" y="38"/>
                  </a:lnTo>
                  <a:lnTo>
                    <a:pt x="2030" y="38"/>
                  </a:lnTo>
                  <a:lnTo>
                    <a:pt x="2031" y="38"/>
                  </a:lnTo>
                  <a:lnTo>
                    <a:pt x="2032" y="35"/>
                  </a:lnTo>
                  <a:lnTo>
                    <a:pt x="2033" y="34"/>
                  </a:lnTo>
                  <a:lnTo>
                    <a:pt x="2034" y="33"/>
                  </a:lnTo>
                  <a:lnTo>
                    <a:pt x="2034" y="32"/>
                  </a:lnTo>
                  <a:lnTo>
                    <a:pt x="2035" y="35"/>
                  </a:lnTo>
                  <a:lnTo>
                    <a:pt x="2036" y="32"/>
                  </a:lnTo>
                  <a:lnTo>
                    <a:pt x="2037" y="33"/>
                  </a:lnTo>
                  <a:lnTo>
                    <a:pt x="2038" y="31"/>
                  </a:lnTo>
                  <a:lnTo>
                    <a:pt x="2039" y="29"/>
                  </a:lnTo>
                  <a:lnTo>
                    <a:pt x="2040" y="30"/>
                  </a:lnTo>
                  <a:lnTo>
                    <a:pt x="2041" y="30"/>
                  </a:lnTo>
                  <a:lnTo>
                    <a:pt x="2042" y="30"/>
                  </a:lnTo>
                  <a:lnTo>
                    <a:pt x="2042" y="27"/>
                  </a:lnTo>
                  <a:lnTo>
                    <a:pt x="2043" y="30"/>
                  </a:lnTo>
                  <a:lnTo>
                    <a:pt x="2044" y="32"/>
                  </a:lnTo>
                  <a:lnTo>
                    <a:pt x="2045" y="28"/>
                  </a:lnTo>
                  <a:lnTo>
                    <a:pt x="2046" y="28"/>
                  </a:lnTo>
                  <a:lnTo>
                    <a:pt x="2047" y="27"/>
                  </a:lnTo>
                  <a:lnTo>
                    <a:pt x="2048" y="28"/>
                  </a:lnTo>
                  <a:lnTo>
                    <a:pt x="2049" y="27"/>
                  </a:lnTo>
                  <a:lnTo>
                    <a:pt x="2049" y="26"/>
                  </a:lnTo>
                  <a:lnTo>
                    <a:pt x="2050" y="26"/>
                  </a:lnTo>
                  <a:lnTo>
                    <a:pt x="2051" y="24"/>
                  </a:lnTo>
                  <a:lnTo>
                    <a:pt x="2052" y="26"/>
                  </a:lnTo>
                  <a:lnTo>
                    <a:pt x="2053" y="23"/>
                  </a:lnTo>
                  <a:lnTo>
                    <a:pt x="2054" y="23"/>
                  </a:lnTo>
                  <a:lnTo>
                    <a:pt x="2055" y="24"/>
                  </a:lnTo>
                  <a:lnTo>
                    <a:pt x="2056" y="24"/>
                  </a:lnTo>
                  <a:lnTo>
                    <a:pt x="2057" y="23"/>
                  </a:lnTo>
                  <a:lnTo>
                    <a:pt x="2057" y="23"/>
                  </a:lnTo>
                  <a:lnTo>
                    <a:pt x="2058" y="24"/>
                  </a:lnTo>
                  <a:lnTo>
                    <a:pt x="2059" y="24"/>
                  </a:lnTo>
                  <a:lnTo>
                    <a:pt x="2060" y="25"/>
                  </a:lnTo>
                  <a:lnTo>
                    <a:pt x="2061" y="22"/>
                  </a:lnTo>
                  <a:lnTo>
                    <a:pt x="2062" y="23"/>
                  </a:lnTo>
                  <a:lnTo>
                    <a:pt x="2063" y="23"/>
                  </a:lnTo>
                  <a:lnTo>
                    <a:pt x="2064" y="23"/>
                  </a:lnTo>
                  <a:lnTo>
                    <a:pt x="2064" y="22"/>
                  </a:lnTo>
                  <a:lnTo>
                    <a:pt x="2065" y="23"/>
                  </a:lnTo>
                  <a:lnTo>
                    <a:pt x="2066" y="23"/>
                  </a:lnTo>
                  <a:lnTo>
                    <a:pt x="2067" y="23"/>
                  </a:lnTo>
                  <a:lnTo>
                    <a:pt x="2068" y="21"/>
                  </a:lnTo>
                  <a:lnTo>
                    <a:pt x="2069" y="21"/>
                  </a:lnTo>
                  <a:lnTo>
                    <a:pt x="2070" y="20"/>
                  </a:lnTo>
                  <a:lnTo>
                    <a:pt x="2071" y="22"/>
                  </a:lnTo>
                  <a:lnTo>
                    <a:pt x="2072" y="21"/>
                  </a:lnTo>
                  <a:lnTo>
                    <a:pt x="2072" y="22"/>
                  </a:lnTo>
                  <a:lnTo>
                    <a:pt x="2073" y="20"/>
                  </a:lnTo>
                  <a:lnTo>
                    <a:pt x="2074" y="21"/>
                  </a:lnTo>
                  <a:lnTo>
                    <a:pt x="2075" y="22"/>
                  </a:lnTo>
                  <a:lnTo>
                    <a:pt x="2076" y="22"/>
                  </a:lnTo>
                  <a:lnTo>
                    <a:pt x="2077" y="23"/>
                  </a:lnTo>
                  <a:lnTo>
                    <a:pt x="2078" y="21"/>
                  </a:lnTo>
                  <a:lnTo>
                    <a:pt x="2079" y="23"/>
                  </a:lnTo>
                  <a:lnTo>
                    <a:pt x="2079" y="21"/>
                  </a:lnTo>
                  <a:lnTo>
                    <a:pt x="2080" y="24"/>
                  </a:lnTo>
                  <a:lnTo>
                    <a:pt x="2081" y="23"/>
                  </a:lnTo>
                  <a:lnTo>
                    <a:pt x="2082" y="23"/>
                  </a:lnTo>
                  <a:lnTo>
                    <a:pt x="2083" y="22"/>
                  </a:lnTo>
                  <a:lnTo>
                    <a:pt x="2084" y="22"/>
                  </a:lnTo>
                  <a:lnTo>
                    <a:pt x="2085" y="22"/>
                  </a:lnTo>
                  <a:lnTo>
                    <a:pt x="2086" y="22"/>
                  </a:lnTo>
                  <a:lnTo>
                    <a:pt x="2086" y="21"/>
                  </a:lnTo>
                  <a:lnTo>
                    <a:pt x="2087" y="23"/>
                  </a:lnTo>
                  <a:lnTo>
                    <a:pt x="2088" y="23"/>
                  </a:lnTo>
                  <a:lnTo>
                    <a:pt x="2089" y="20"/>
                  </a:lnTo>
                  <a:lnTo>
                    <a:pt x="2090" y="22"/>
                  </a:lnTo>
                  <a:lnTo>
                    <a:pt x="2091" y="22"/>
                  </a:lnTo>
                  <a:lnTo>
                    <a:pt x="2092" y="22"/>
                  </a:lnTo>
                  <a:lnTo>
                    <a:pt x="2093" y="23"/>
                  </a:lnTo>
                  <a:lnTo>
                    <a:pt x="2094" y="20"/>
                  </a:lnTo>
                  <a:lnTo>
                    <a:pt x="2094" y="21"/>
                  </a:lnTo>
                  <a:lnTo>
                    <a:pt x="2095" y="22"/>
                  </a:lnTo>
                  <a:lnTo>
                    <a:pt x="2096" y="22"/>
                  </a:lnTo>
                  <a:lnTo>
                    <a:pt x="2097" y="21"/>
                  </a:lnTo>
                  <a:lnTo>
                    <a:pt x="2098" y="22"/>
                  </a:lnTo>
                  <a:lnTo>
                    <a:pt x="2099" y="22"/>
                  </a:lnTo>
                  <a:lnTo>
                    <a:pt x="2100" y="22"/>
                  </a:lnTo>
                  <a:lnTo>
                    <a:pt x="2101" y="20"/>
                  </a:lnTo>
                  <a:lnTo>
                    <a:pt x="2101" y="22"/>
                  </a:lnTo>
                  <a:lnTo>
                    <a:pt x="2102" y="21"/>
                  </a:lnTo>
                  <a:lnTo>
                    <a:pt x="2103" y="22"/>
                  </a:lnTo>
                  <a:lnTo>
                    <a:pt x="2104" y="22"/>
                  </a:lnTo>
                  <a:lnTo>
                    <a:pt x="2105" y="25"/>
                  </a:lnTo>
                  <a:lnTo>
                    <a:pt x="2106" y="24"/>
                  </a:lnTo>
                  <a:lnTo>
                    <a:pt x="2107" y="28"/>
                  </a:lnTo>
                  <a:lnTo>
                    <a:pt x="2108" y="28"/>
                  </a:lnTo>
                  <a:lnTo>
                    <a:pt x="2109" y="28"/>
                  </a:lnTo>
                  <a:lnTo>
                    <a:pt x="2109" y="33"/>
                  </a:lnTo>
                  <a:lnTo>
                    <a:pt x="2110" y="34"/>
                  </a:lnTo>
                  <a:lnTo>
                    <a:pt x="2111" y="36"/>
                  </a:lnTo>
                  <a:lnTo>
                    <a:pt x="2112" y="39"/>
                  </a:lnTo>
                  <a:lnTo>
                    <a:pt x="2113" y="40"/>
                  </a:lnTo>
                  <a:lnTo>
                    <a:pt x="2114" y="41"/>
                  </a:lnTo>
                  <a:lnTo>
                    <a:pt x="2115" y="41"/>
                  </a:lnTo>
                  <a:lnTo>
                    <a:pt x="2116" y="40"/>
                  </a:lnTo>
                  <a:lnTo>
                    <a:pt x="2116" y="35"/>
                  </a:lnTo>
                  <a:lnTo>
                    <a:pt x="2117" y="36"/>
                  </a:lnTo>
                  <a:lnTo>
                    <a:pt x="2118" y="35"/>
                  </a:lnTo>
                  <a:lnTo>
                    <a:pt x="2119" y="35"/>
                  </a:lnTo>
                  <a:lnTo>
                    <a:pt x="2120" y="33"/>
                  </a:lnTo>
                  <a:lnTo>
                    <a:pt x="2121" y="33"/>
                  </a:lnTo>
                  <a:lnTo>
                    <a:pt x="2122" y="30"/>
                  </a:lnTo>
                  <a:lnTo>
                    <a:pt x="2123" y="28"/>
                  </a:lnTo>
                  <a:lnTo>
                    <a:pt x="2124" y="29"/>
                  </a:lnTo>
                  <a:lnTo>
                    <a:pt x="2124" y="28"/>
                  </a:lnTo>
                  <a:lnTo>
                    <a:pt x="2125" y="27"/>
                  </a:lnTo>
                  <a:lnTo>
                    <a:pt x="2126" y="27"/>
                  </a:lnTo>
                  <a:lnTo>
                    <a:pt x="2127" y="26"/>
                  </a:lnTo>
                  <a:lnTo>
                    <a:pt x="2128" y="25"/>
                  </a:lnTo>
                  <a:lnTo>
                    <a:pt x="2129" y="25"/>
                  </a:lnTo>
                  <a:lnTo>
                    <a:pt x="2130" y="23"/>
                  </a:lnTo>
                  <a:lnTo>
                    <a:pt x="2131" y="23"/>
                  </a:lnTo>
                  <a:lnTo>
                    <a:pt x="2131" y="22"/>
                  </a:lnTo>
                  <a:lnTo>
                    <a:pt x="2132" y="22"/>
                  </a:lnTo>
                  <a:lnTo>
                    <a:pt x="2133" y="22"/>
                  </a:lnTo>
                  <a:lnTo>
                    <a:pt x="2134" y="20"/>
                  </a:lnTo>
                  <a:lnTo>
                    <a:pt x="2135" y="22"/>
                  </a:lnTo>
                  <a:lnTo>
                    <a:pt x="2136" y="20"/>
                  </a:lnTo>
                  <a:lnTo>
                    <a:pt x="2137" y="19"/>
                  </a:lnTo>
                  <a:lnTo>
                    <a:pt x="2138" y="21"/>
                  </a:lnTo>
                  <a:lnTo>
                    <a:pt x="2139" y="21"/>
                  </a:lnTo>
                  <a:lnTo>
                    <a:pt x="2139" y="20"/>
                  </a:lnTo>
                  <a:lnTo>
                    <a:pt x="2140" y="19"/>
                  </a:lnTo>
                  <a:lnTo>
                    <a:pt x="2141" y="19"/>
                  </a:lnTo>
                  <a:lnTo>
                    <a:pt x="2142" y="20"/>
                  </a:lnTo>
                  <a:lnTo>
                    <a:pt x="2143" y="21"/>
                  </a:lnTo>
                  <a:lnTo>
                    <a:pt x="2144" y="20"/>
                  </a:lnTo>
                  <a:lnTo>
                    <a:pt x="2145" y="20"/>
                  </a:lnTo>
                  <a:lnTo>
                    <a:pt x="2146" y="20"/>
                  </a:lnTo>
                  <a:lnTo>
                    <a:pt x="2146" y="20"/>
                  </a:lnTo>
                  <a:lnTo>
                    <a:pt x="2147" y="20"/>
                  </a:lnTo>
                  <a:lnTo>
                    <a:pt x="2148" y="21"/>
                  </a:lnTo>
                  <a:lnTo>
                    <a:pt x="2149" y="21"/>
                  </a:lnTo>
                  <a:lnTo>
                    <a:pt x="2150" y="22"/>
                  </a:lnTo>
                  <a:lnTo>
                    <a:pt x="2151" y="20"/>
                  </a:lnTo>
                  <a:lnTo>
                    <a:pt x="2152" y="21"/>
                  </a:lnTo>
                  <a:lnTo>
                    <a:pt x="2153" y="20"/>
                  </a:lnTo>
                  <a:lnTo>
                    <a:pt x="2154" y="25"/>
                  </a:lnTo>
                  <a:lnTo>
                    <a:pt x="2154" y="23"/>
                  </a:lnTo>
                  <a:lnTo>
                    <a:pt x="2155" y="22"/>
                  </a:lnTo>
                  <a:lnTo>
                    <a:pt x="2156" y="26"/>
                  </a:lnTo>
                  <a:lnTo>
                    <a:pt x="2157" y="24"/>
                  </a:lnTo>
                  <a:lnTo>
                    <a:pt x="2158" y="25"/>
                  </a:lnTo>
                  <a:lnTo>
                    <a:pt x="2159" y="28"/>
                  </a:lnTo>
                  <a:lnTo>
                    <a:pt x="2160" y="26"/>
                  </a:lnTo>
                  <a:lnTo>
                    <a:pt x="2161" y="30"/>
                  </a:lnTo>
                  <a:lnTo>
                    <a:pt x="2161" y="27"/>
                  </a:lnTo>
                  <a:lnTo>
                    <a:pt x="2162" y="27"/>
                  </a:lnTo>
                  <a:lnTo>
                    <a:pt x="2163" y="27"/>
                  </a:lnTo>
                  <a:lnTo>
                    <a:pt x="2164" y="27"/>
                  </a:lnTo>
                  <a:lnTo>
                    <a:pt x="2165" y="27"/>
                  </a:lnTo>
                  <a:lnTo>
                    <a:pt x="2166" y="28"/>
                  </a:lnTo>
                  <a:lnTo>
                    <a:pt x="2167" y="25"/>
                  </a:lnTo>
                  <a:lnTo>
                    <a:pt x="2168" y="25"/>
                  </a:lnTo>
                  <a:lnTo>
                    <a:pt x="2169" y="25"/>
                  </a:lnTo>
                  <a:lnTo>
                    <a:pt x="2169" y="23"/>
                  </a:lnTo>
                  <a:lnTo>
                    <a:pt x="2170" y="25"/>
                  </a:lnTo>
                  <a:lnTo>
                    <a:pt x="2171" y="24"/>
                  </a:lnTo>
                  <a:lnTo>
                    <a:pt x="2172" y="23"/>
                  </a:lnTo>
                  <a:lnTo>
                    <a:pt x="2173" y="23"/>
                  </a:lnTo>
                  <a:lnTo>
                    <a:pt x="2174" y="23"/>
                  </a:lnTo>
                  <a:lnTo>
                    <a:pt x="2175" y="21"/>
                  </a:lnTo>
                  <a:lnTo>
                    <a:pt x="2176" y="22"/>
                  </a:lnTo>
                  <a:lnTo>
                    <a:pt x="2176" y="22"/>
                  </a:lnTo>
                  <a:lnTo>
                    <a:pt x="2177" y="22"/>
                  </a:lnTo>
                  <a:lnTo>
                    <a:pt x="2178" y="21"/>
                  </a:lnTo>
                  <a:lnTo>
                    <a:pt x="2179" y="21"/>
                  </a:lnTo>
                  <a:lnTo>
                    <a:pt x="2180" y="21"/>
                  </a:lnTo>
                  <a:lnTo>
                    <a:pt x="2181" y="20"/>
                  </a:lnTo>
                  <a:lnTo>
                    <a:pt x="2182" y="21"/>
                  </a:lnTo>
                  <a:lnTo>
                    <a:pt x="2183" y="19"/>
                  </a:lnTo>
                  <a:lnTo>
                    <a:pt x="2184" y="20"/>
                  </a:lnTo>
                  <a:lnTo>
                    <a:pt x="2184" y="20"/>
                  </a:lnTo>
                  <a:lnTo>
                    <a:pt x="2185" y="20"/>
                  </a:lnTo>
                  <a:lnTo>
                    <a:pt x="2186" y="20"/>
                  </a:lnTo>
                  <a:lnTo>
                    <a:pt x="2187" y="20"/>
                  </a:lnTo>
                  <a:lnTo>
                    <a:pt x="2188" y="20"/>
                  </a:lnTo>
                  <a:lnTo>
                    <a:pt x="2189" y="18"/>
                  </a:lnTo>
                  <a:lnTo>
                    <a:pt x="2190" y="20"/>
                  </a:lnTo>
                  <a:lnTo>
                    <a:pt x="2191" y="18"/>
                  </a:lnTo>
                  <a:lnTo>
                    <a:pt x="2191" y="18"/>
                  </a:lnTo>
                  <a:lnTo>
                    <a:pt x="2192" y="18"/>
                  </a:lnTo>
                  <a:lnTo>
                    <a:pt x="2193" y="19"/>
                  </a:lnTo>
                  <a:lnTo>
                    <a:pt x="2194" y="17"/>
                  </a:lnTo>
                  <a:lnTo>
                    <a:pt x="2195" y="18"/>
                  </a:lnTo>
                  <a:lnTo>
                    <a:pt x="2196" y="19"/>
                  </a:lnTo>
                  <a:lnTo>
                    <a:pt x="2197" y="19"/>
                  </a:lnTo>
                  <a:lnTo>
                    <a:pt x="2198" y="19"/>
                  </a:lnTo>
                  <a:lnTo>
                    <a:pt x="2199" y="19"/>
                  </a:lnTo>
                  <a:lnTo>
                    <a:pt x="2199" y="19"/>
                  </a:lnTo>
                  <a:lnTo>
                    <a:pt x="2200" y="19"/>
                  </a:lnTo>
                  <a:lnTo>
                    <a:pt x="2201" y="20"/>
                  </a:lnTo>
                  <a:lnTo>
                    <a:pt x="2202" y="21"/>
                  </a:lnTo>
                  <a:lnTo>
                    <a:pt x="2203" y="19"/>
                  </a:lnTo>
                  <a:lnTo>
                    <a:pt x="2204" y="20"/>
                  </a:lnTo>
                  <a:lnTo>
                    <a:pt x="2205" y="18"/>
                  </a:lnTo>
                  <a:lnTo>
                    <a:pt x="2206" y="18"/>
                  </a:lnTo>
                  <a:lnTo>
                    <a:pt x="2206" y="18"/>
                  </a:lnTo>
                  <a:lnTo>
                    <a:pt x="2207" y="18"/>
                  </a:lnTo>
                  <a:lnTo>
                    <a:pt x="2208" y="16"/>
                  </a:lnTo>
                  <a:lnTo>
                    <a:pt x="2209" y="17"/>
                  </a:lnTo>
                  <a:lnTo>
                    <a:pt x="2210" y="18"/>
                  </a:lnTo>
                  <a:lnTo>
                    <a:pt x="2211" y="20"/>
                  </a:lnTo>
                  <a:lnTo>
                    <a:pt x="2212" y="17"/>
                  </a:lnTo>
                  <a:lnTo>
                    <a:pt x="2213" y="19"/>
                  </a:lnTo>
                  <a:lnTo>
                    <a:pt x="2214" y="18"/>
                  </a:lnTo>
                  <a:lnTo>
                    <a:pt x="2214" y="18"/>
                  </a:lnTo>
                  <a:lnTo>
                    <a:pt x="2215" y="17"/>
                  </a:lnTo>
                  <a:lnTo>
                    <a:pt x="2216" y="17"/>
                  </a:lnTo>
                  <a:lnTo>
                    <a:pt x="2217" y="16"/>
                  </a:lnTo>
                  <a:lnTo>
                    <a:pt x="2218" y="17"/>
                  </a:lnTo>
                  <a:lnTo>
                    <a:pt x="2219" y="19"/>
                  </a:lnTo>
                  <a:lnTo>
                    <a:pt x="2220" y="18"/>
                  </a:lnTo>
                  <a:lnTo>
                    <a:pt x="2221" y="18"/>
                  </a:lnTo>
                  <a:lnTo>
                    <a:pt x="2221" y="17"/>
                  </a:lnTo>
                  <a:lnTo>
                    <a:pt x="2222" y="18"/>
                  </a:lnTo>
                  <a:lnTo>
                    <a:pt x="2223" y="17"/>
                  </a:lnTo>
                  <a:lnTo>
                    <a:pt x="2224" y="19"/>
                  </a:lnTo>
                  <a:lnTo>
                    <a:pt x="2225" y="18"/>
                  </a:lnTo>
                  <a:lnTo>
                    <a:pt x="2226" y="21"/>
                  </a:lnTo>
                  <a:lnTo>
                    <a:pt x="2227" y="20"/>
                  </a:lnTo>
                  <a:lnTo>
                    <a:pt x="2228" y="18"/>
                  </a:lnTo>
                  <a:lnTo>
                    <a:pt x="2229" y="18"/>
                  </a:lnTo>
                  <a:lnTo>
                    <a:pt x="2229" y="18"/>
                  </a:lnTo>
                  <a:lnTo>
                    <a:pt x="2230" y="18"/>
                  </a:lnTo>
                  <a:lnTo>
                    <a:pt x="2231" y="18"/>
                  </a:lnTo>
                  <a:lnTo>
                    <a:pt x="2232" y="16"/>
                  </a:lnTo>
                  <a:lnTo>
                    <a:pt x="2233" y="17"/>
                  </a:lnTo>
                  <a:lnTo>
                    <a:pt x="2234" y="15"/>
                  </a:lnTo>
                  <a:lnTo>
                    <a:pt x="2235" y="17"/>
                  </a:lnTo>
                  <a:lnTo>
                    <a:pt x="2236" y="15"/>
                  </a:lnTo>
                  <a:lnTo>
                    <a:pt x="2236" y="18"/>
                  </a:lnTo>
                  <a:lnTo>
                    <a:pt x="2237" y="16"/>
                  </a:lnTo>
                  <a:lnTo>
                    <a:pt x="2238" y="16"/>
                  </a:lnTo>
                  <a:lnTo>
                    <a:pt x="2239" y="16"/>
                  </a:lnTo>
                  <a:lnTo>
                    <a:pt x="2240" y="15"/>
                  </a:lnTo>
                  <a:lnTo>
                    <a:pt x="2241" y="17"/>
                  </a:lnTo>
                  <a:lnTo>
                    <a:pt x="2242" y="16"/>
                  </a:lnTo>
                  <a:lnTo>
                    <a:pt x="2243" y="18"/>
                  </a:lnTo>
                  <a:lnTo>
                    <a:pt x="2244" y="17"/>
                  </a:lnTo>
                  <a:lnTo>
                    <a:pt x="2244" y="16"/>
                  </a:lnTo>
                  <a:lnTo>
                    <a:pt x="2245" y="16"/>
                  </a:lnTo>
                  <a:lnTo>
                    <a:pt x="2246" y="16"/>
                  </a:lnTo>
                  <a:lnTo>
                    <a:pt x="2247" y="14"/>
                  </a:lnTo>
                  <a:lnTo>
                    <a:pt x="2248" y="15"/>
                  </a:lnTo>
                  <a:lnTo>
                    <a:pt x="2249" y="15"/>
                  </a:lnTo>
                  <a:lnTo>
                    <a:pt x="2250" y="15"/>
                  </a:lnTo>
                  <a:lnTo>
                    <a:pt x="2251" y="16"/>
                  </a:lnTo>
                  <a:lnTo>
                    <a:pt x="2251" y="15"/>
                  </a:lnTo>
                  <a:lnTo>
                    <a:pt x="2252" y="17"/>
                  </a:lnTo>
                  <a:lnTo>
                    <a:pt x="2253" y="15"/>
                  </a:lnTo>
                  <a:lnTo>
                    <a:pt x="2254" y="15"/>
                  </a:lnTo>
                  <a:lnTo>
                    <a:pt x="2255" y="16"/>
                  </a:lnTo>
                  <a:lnTo>
                    <a:pt x="2256" y="16"/>
                  </a:lnTo>
                  <a:lnTo>
                    <a:pt x="2257" y="16"/>
                  </a:lnTo>
                  <a:lnTo>
                    <a:pt x="2258" y="15"/>
                  </a:lnTo>
                  <a:lnTo>
                    <a:pt x="2259" y="15"/>
                  </a:lnTo>
                  <a:lnTo>
                    <a:pt x="2259" y="14"/>
                  </a:lnTo>
                  <a:lnTo>
                    <a:pt x="2260" y="15"/>
                  </a:lnTo>
                  <a:lnTo>
                    <a:pt x="2261" y="16"/>
                  </a:lnTo>
                  <a:lnTo>
                    <a:pt x="2262" y="16"/>
                  </a:lnTo>
                  <a:lnTo>
                    <a:pt x="2263" y="14"/>
                  </a:lnTo>
                  <a:lnTo>
                    <a:pt x="2264" y="15"/>
                  </a:lnTo>
                  <a:lnTo>
                    <a:pt x="2265" y="15"/>
                  </a:lnTo>
                  <a:lnTo>
                    <a:pt x="2266" y="14"/>
                  </a:lnTo>
                  <a:lnTo>
                    <a:pt x="2266" y="16"/>
                  </a:lnTo>
                  <a:lnTo>
                    <a:pt x="2267" y="15"/>
                  </a:lnTo>
                  <a:lnTo>
                    <a:pt x="2268" y="13"/>
                  </a:lnTo>
                  <a:lnTo>
                    <a:pt x="2269" y="14"/>
                  </a:lnTo>
                  <a:lnTo>
                    <a:pt x="2270" y="14"/>
                  </a:lnTo>
                  <a:lnTo>
                    <a:pt x="2271" y="14"/>
                  </a:lnTo>
                  <a:lnTo>
                    <a:pt x="2272" y="14"/>
                  </a:lnTo>
                  <a:lnTo>
                    <a:pt x="2273" y="15"/>
                  </a:lnTo>
                  <a:lnTo>
                    <a:pt x="2274" y="14"/>
                  </a:lnTo>
                  <a:lnTo>
                    <a:pt x="2274" y="16"/>
                  </a:lnTo>
                  <a:lnTo>
                    <a:pt x="2275" y="16"/>
                  </a:lnTo>
                  <a:lnTo>
                    <a:pt x="2276" y="18"/>
                  </a:lnTo>
                  <a:lnTo>
                    <a:pt x="2277" y="19"/>
                  </a:lnTo>
                  <a:lnTo>
                    <a:pt x="2278" y="20"/>
                  </a:lnTo>
                  <a:lnTo>
                    <a:pt x="2279" y="23"/>
                  </a:lnTo>
                  <a:lnTo>
                    <a:pt x="2280" y="24"/>
                  </a:lnTo>
                  <a:lnTo>
                    <a:pt x="2281" y="26"/>
                  </a:lnTo>
                  <a:lnTo>
                    <a:pt x="2281" y="32"/>
                  </a:lnTo>
                  <a:lnTo>
                    <a:pt x="2282" y="37"/>
                  </a:lnTo>
                  <a:lnTo>
                    <a:pt x="2283" y="44"/>
                  </a:lnTo>
                  <a:lnTo>
                    <a:pt x="2284" y="46"/>
                  </a:lnTo>
                  <a:lnTo>
                    <a:pt x="2285" y="50"/>
                  </a:lnTo>
                  <a:lnTo>
                    <a:pt x="2286" y="52"/>
                  </a:lnTo>
                  <a:lnTo>
                    <a:pt x="2287" y="50"/>
                  </a:lnTo>
                  <a:lnTo>
                    <a:pt x="2288" y="49"/>
                  </a:lnTo>
                  <a:lnTo>
                    <a:pt x="2288" y="46"/>
                  </a:lnTo>
                  <a:lnTo>
                    <a:pt x="2289" y="41"/>
                  </a:lnTo>
                  <a:lnTo>
                    <a:pt x="2290" y="36"/>
                  </a:lnTo>
                  <a:lnTo>
                    <a:pt x="2291" y="35"/>
                  </a:lnTo>
                  <a:lnTo>
                    <a:pt x="2292" y="32"/>
                  </a:lnTo>
                  <a:lnTo>
                    <a:pt x="2293" y="28"/>
                  </a:lnTo>
                  <a:lnTo>
                    <a:pt x="2294" y="25"/>
                  </a:lnTo>
                  <a:lnTo>
                    <a:pt x="2295" y="25"/>
                  </a:lnTo>
                  <a:lnTo>
                    <a:pt x="2296" y="23"/>
                  </a:lnTo>
                  <a:lnTo>
                    <a:pt x="2296" y="24"/>
                  </a:lnTo>
                  <a:lnTo>
                    <a:pt x="2297" y="23"/>
                  </a:lnTo>
                  <a:lnTo>
                    <a:pt x="2298" y="24"/>
                  </a:lnTo>
                  <a:lnTo>
                    <a:pt x="2299" y="25"/>
                  </a:lnTo>
                  <a:lnTo>
                    <a:pt x="2300" y="26"/>
                  </a:lnTo>
                  <a:lnTo>
                    <a:pt x="2301" y="28"/>
                  </a:lnTo>
                  <a:lnTo>
                    <a:pt x="2302" y="28"/>
                  </a:lnTo>
                  <a:lnTo>
                    <a:pt x="2303" y="29"/>
                  </a:lnTo>
                  <a:lnTo>
                    <a:pt x="2303" y="29"/>
                  </a:lnTo>
                  <a:lnTo>
                    <a:pt x="2304" y="29"/>
                  </a:lnTo>
                  <a:lnTo>
                    <a:pt x="2305" y="29"/>
                  </a:lnTo>
                  <a:lnTo>
                    <a:pt x="2306" y="26"/>
                  </a:lnTo>
                  <a:lnTo>
                    <a:pt x="2307" y="26"/>
                  </a:lnTo>
                  <a:lnTo>
                    <a:pt x="2308" y="26"/>
                  </a:lnTo>
                  <a:lnTo>
                    <a:pt x="2309" y="25"/>
                  </a:lnTo>
                  <a:lnTo>
                    <a:pt x="2310" y="23"/>
                  </a:lnTo>
                  <a:lnTo>
                    <a:pt x="2311" y="25"/>
                  </a:lnTo>
                  <a:lnTo>
                    <a:pt x="2311" y="24"/>
                  </a:lnTo>
                  <a:lnTo>
                    <a:pt x="2312" y="23"/>
                  </a:lnTo>
                  <a:lnTo>
                    <a:pt x="2313" y="23"/>
                  </a:lnTo>
                  <a:lnTo>
                    <a:pt x="2314" y="22"/>
                  </a:lnTo>
                  <a:lnTo>
                    <a:pt x="2315" y="22"/>
                  </a:lnTo>
                  <a:lnTo>
                    <a:pt x="2316" y="23"/>
                  </a:lnTo>
                  <a:lnTo>
                    <a:pt x="2317" y="23"/>
                  </a:lnTo>
                  <a:lnTo>
                    <a:pt x="2318" y="20"/>
                  </a:lnTo>
                  <a:lnTo>
                    <a:pt x="2318" y="21"/>
                  </a:lnTo>
                  <a:lnTo>
                    <a:pt x="2319" y="21"/>
                  </a:lnTo>
                  <a:lnTo>
                    <a:pt x="2320" y="20"/>
                  </a:lnTo>
                  <a:lnTo>
                    <a:pt x="2321" y="18"/>
                  </a:lnTo>
                  <a:lnTo>
                    <a:pt x="2322" y="19"/>
                  </a:lnTo>
                  <a:lnTo>
                    <a:pt x="2323" y="18"/>
                  </a:lnTo>
                  <a:lnTo>
                    <a:pt x="2324" y="18"/>
                  </a:lnTo>
                  <a:lnTo>
                    <a:pt x="2325" y="17"/>
                  </a:lnTo>
                  <a:lnTo>
                    <a:pt x="2326" y="18"/>
                  </a:lnTo>
                  <a:lnTo>
                    <a:pt x="2326" y="19"/>
                  </a:lnTo>
                  <a:lnTo>
                    <a:pt x="2327" y="19"/>
                  </a:lnTo>
                  <a:lnTo>
                    <a:pt x="2328" y="19"/>
                  </a:lnTo>
                  <a:lnTo>
                    <a:pt x="2329" y="17"/>
                  </a:lnTo>
                  <a:lnTo>
                    <a:pt x="2330" y="18"/>
                  </a:lnTo>
                  <a:lnTo>
                    <a:pt x="2331" y="18"/>
                  </a:lnTo>
                  <a:lnTo>
                    <a:pt x="2332" y="18"/>
                  </a:lnTo>
                  <a:lnTo>
                    <a:pt x="2333" y="18"/>
                  </a:lnTo>
                  <a:lnTo>
                    <a:pt x="2333" y="18"/>
                  </a:lnTo>
                  <a:lnTo>
                    <a:pt x="2334" y="17"/>
                  </a:lnTo>
                  <a:lnTo>
                    <a:pt x="2335" y="19"/>
                  </a:lnTo>
                  <a:lnTo>
                    <a:pt x="2336" y="18"/>
                  </a:lnTo>
                  <a:lnTo>
                    <a:pt x="2337" y="17"/>
                  </a:lnTo>
                  <a:lnTo>
                    <a:pt x="2338" y="17"/>
                  </a:lnTo>
                  <a:lnTo>
                    <a:pt x="2339" y="18"/>
                  </a:lnTo>
                  <a:lnTo>
                    <a:pt x="2340" y="18"/>
                  </a:lnTo>
                  <a:lnTo>
                    <a:pt x="2341" y="18"/>
                  </a:lnTo>
                  <a:lnTo>
                    <a:pt x="2341" y="18"/>
                  </a:lnTo>
                  <a:lnTo>
                    <a:pt x="2342" y="16"/>
                  </a:lnTo>
                  <a:lnTo>
                    <a:pt x="2343" y="18"/>
                  </a:lnTo>
                  <a:lnTo>
                    <a:pt x="2344" y="18"/>
                  </a:lnTo>
                  <a:lnTo>
                    <a:pt x="2345" y="18"/>
                  </a:lnTo>
                  <a:lnTo>
                    <a:pt x="2346" y="18"/>
                  </a:lnTo>
                  <a:lnTo>
                    <a:pt x="2347" y="19"/>
                  </a:lnTo>
                  <a:lnTo>
                    <a:pt x="2348" y="19"/>
                  </a:lnTo>
                  <a:lnTo>
                    <a:pt x="2348" y="17"/>
                  </a:lnTo>
                  <a:lnTo>
                    <a:pt x="2349" y="19"/>
                  </a:lnTo>
                  <a:lnTo>
                    <a:pt x="2350" y="18"/>
                  </a:lnTo>
                  <a:lnTo>
                    <a:pt x="2351" y="16"/>
                  </a:lnTo>
                  <a:lnTo>
                    <a:pt x="2352" y="18"/>
                  </a:lnTo>
                  <a:lnTo>
                    <a:pt x="2353" y="18"/>
                  </a:lnTo>
                  <a:lnTo>
                    <a:pt x="2354" y="18"/>
                  </a:lnTo>
                  <a:lnTo>
                    <a:pt x="2355" y="18"/>
                  </a:lnTo>
                  <a:lnTo>
                    <a:pt x="2356" y="19"/>
                  </a:lnTo>
                  <a:lnTo>
                    <a:pt x="2356" y="18"/>
                  </a:lnTo>
                  <a:lnTo>
                    <a:pt x="2357" y="17"/>
                  </a:lnTo>
                  <a:lnTo>
                    <a:pt x="2358" y="18"/>
                  </a:lnTo>
                  <a:lnTo>
                    <a:pt x="2359" y="18"/>
                  </a:lnTo>
                  <a:lnTo>
                    <a:pt x="2360" y="17"/>
                  </a:lnTo>
                  <a:lnTo>
                    <a:pt x="2361" y="18"/>
                  </a:lnTo>
                  <a:lnTo>
                    <a:pt x="2362" y="18"/>
                  </a:lnTo>
                  <a:lnTo>
                    <a:pt x="2363" y="18"/>
                  </a:lnTo>
                  <a:lnTo>
                    <a:pt x="2363" y="20"/>
                  </a:lnTo>
                  <a:lnTo>
                    <a:pt x="2364" y="22"/>
                  </a:lnTo>
                  <a:lnTo>
                    <a:pt x="2365" y="22"/>
                  </a:lnTo>
                  <a:lnTo>
                    <a:pt x="2366" y="25"/>
                  </a:lnTo>
                  <a:lnTo>
                    <a:pt x="2367" y="25"/>
                  </a:lnTo>
                  <a:lnTo>
                    <a:pt x="2368" y="27"/>
                  </a:lnTo>
                  <a:lnTo>
                    <a:pt x="2369" y="28"/>
                  </a:lnTo>
                  <a:lnTo>
                    <a:pt x="2370" y="30"/>
                  </a:lnTo>
                  <a:lnTo>
                    <a:pt x="2371" y="30"/>
                  </a:lnTo>
                  <a:lnTo>
                    <a:pt x="2371" y="31"/>
                  </a:lnTo>
                  <a:lnTo>
                    <a:pt x="2372" y="32"/>
                  </a:lnTo>
                  <a:lnTo>
                    <a:pt x="2373" y="32"/>
                  </a:lnTo>
                  <a:lnTo>
                    <a:pt x="2374" y="32"/>
                  </a:lnTo>
                  <a:lnTo>
                    <a:pt x="2375" y="35"/>
                  </a:lnTo>
                  <a:lnTo>
                    <a:pt x="2376" y="34"/>
                  </a:lnTo>
                  <a:lnTo>
                    <a:pt x="2377" y="34"/>
                  </a:lnTo>
                  <a:lnTo>
                    <a:pt x="2378" y="35"/>
                  </a:lnTo>
                  <a:lnTo>
                    <a:pt x="2378" y="36"/>
                  </a:lnTo>
                  <a:lnTo>
                    <a:pt x="2379" y="35"/>
                  </a:lnTo>
                  <a:lnTo>
                    <a:pt x="2380" y="37"/>
                  </a:lnTo>
                  <a:lnTo>
                    <a:pt x="2381" y="36"/>
                  </a:lnTo>
                  <a:lnTo>
                    <a:pt x="2382" y="35"/>
                  </a:lnTo>
                  <a:lnTo>
                    <a:pt x="2383" y="35"/>
                  </a:lnTo>
                  <a:lnTo>
                    <a:pt x="2384" y="33"/>
                  </a:lnTo>
                  <a:lnTo>
                    <a:pt x="2385" y="36"/>
                  </a:lnTo>
                  <a:lnTo>
                    <a:pt x="2386" y="34"/>
                  </a:lnTo>
                  <a:lnTo>
                    <a:pt x="2386" y="35"/>
                  </a:lnTo>
                  <a:lnTo>
                    <a:pt x="2387" y="35"/>
                  </a:lnTo>
                  <a:lnTo>
                    <a:pt x="2388" y="34"/>
                  </a:lnTo>
                  <a:lnTo>
                    <a:pt x="2389" y="33"/>
                  </a:lnTo>
                  <a:lnTo>
                    <a:pt x="2390" y="36"/>
                  </a:lnTo>
                  <a:lnTo>
                    <a:pt x="2391" y="34"/>
                  </a:lnTo>
                  <a:lnTo>
                    <a:pt x="2392" y="34"/>
                  </a:lnTo>
                  <a:lnTo>
                    <a:pt x="2393" y="34"/>
                  </a:lnTo>
                  <a:lnTo>
                    <a:pt x="2393" y="35"/>
                  </a:lnTo>
                  <a:lnTo>
                    <a:pt x="2394" y="33"/>
                  </a:lnTo>
                  <a:lnTo>
                    <a:pt x="2395" y="34"/>
                  </a:lnTo>
                  <a:lnTo>
                    <a:pt x="2396" y="35"/>
                  </a:lnTo>
                  <a:lnTo>
                    <a:pt x="2397" y="32"/>
                  </a:lnTo>
                  <a:lnTo>
                    <a:pt x="2398" y="31"/>
                  </a:lnTo>
                  <a:lnTo>
                    <a:pt x="2399" y="32"/>
                  </a:lnTo>
                  <a:lnTo>
                    <a:pt x="2400" y="32"/>
                  </a:lnTo>
                  <a:lnTo>
                    <a:pt x="2401" y="33"/>
                  </a:lnTo>
                  <a:lnTo>
                    <a:pt x="2401" y="32"/>
                  </a:lnTo>
                  <a:lnTo>
                    <a:pt x="2402" y="34"/>
                  </a:lnTo>
                  <a:lnTo>
                    <a:pt x="2403" y="38"/>
                  </a:lnTo>
                  <a:lnTo>
                    <a:pt x="2404" y="39"/>
                  </a:lnTo>
                  <a:lnTo>
                    <a:pt x="2405" y="45"/>
                  </a:lnTo>
                  <a:lnTo>
                    <a:pt x="2406" y="48"/>
                  </a:lnTo>
                  <a:lnTo>
                    <a:pt x="2407" y="59"/>
                  </a:lnTo>
                  <a:lnTo>
                    <a:pt x="2408" y="68"/>
                  </a:lnTo>
                  <a:lnTo>
                    <a:pt x="2408" y="80"/>
                  </a:lnTo>
                  <a:lnTo>
                    <a:pt x="2409" y="97"/>
                  </a:lnTo>
                  <a:lnTo>
                    <a:pt x="2410" y="119"/>
                  </a:lnTo>
                  <a:lnTo>
                    <a:pt x="2411" y="139"/>
                  </a:lnTo>
                  <a:lnTo>
                    <a:pt x="2412" y="164"/>
                  </a:lnTo>
                  <a:lnTo>
                    <a:pt x="2413" y="195"/>
                  </a:lnTo>
                  <a:lnTo>
                    <a:pt x="2414" y="221"/>
                  </a:lnTo>
                  <a:lnTo>
                    <a:pt x="2415" y="252"/>
                  </a:lnTo>
                  <a:lnTo>
                    <a:pt x="2416" y="286"/>
                  </a:lnTo>
                  <a:lnTo>
                    <a:pt x="2416" y="325"/>
                  </a:lnTo>
                  <a:lnTo>
                    <a:pt x="2417" y="353"/>
                  </a:lnTo>
                  <a:lnTo>
                    <a:pt x="2418" y="371"/>
                  </a:lnTo>
                  <a:lnTo>
                    <a:pt x="2419" y="390"/>
                  </a:lnTo>
                  <a:lnTo>
                    <a:pt x="2420" y="426"/>
                  </a:lnTo>
                  <a:lnTo>
                    <a:pt x="2421" y="452"/>
                  </a:lnTo>
                  <a:lnTo>
                    <a:pt x="2422" y="480"/>
                  </a:lnTo>
                  <a:lnTo>
                    <a:pt x="2423" y="512"/>
                  </a:lnTo>
                  <a:lnTo>
                    <a:pt x="2423" y="524"/>
                  </a:lnTo>
                  <a:lnTo>
                    <a:pt x="2424" y="560"/>
                  </a:lnTo>
                  <a:lnTo>
                    <a:pt x="2425" y="596"/>
                  </a:lnTo>
                  <a:lnTo>
                    <a:pt x="2426" y="616"/>
                  </a:lnTo>
                  <a:lnTo>
                    <a:pt x="2427" y="641"/>
                  </a:lnTo>
                  <a:lnTo>
                    <a:pt x="2428" y="670"/>
                  </a:lnTo>
                  <a:lnTo>
                    <a:pt x="2429" y="688"/>
                  </a:lnTo>
                  <a:lnTo>
                    <a:pt x="2430" y="740"/>
                  </a:lnTo>
                  <a:lnTo>
                    <a:pt x="2431" y="799"/>
                  </a:lnTo>
                  <a:lnTo>
                    <a:pt x="2431" y="847"/>
                  </a:lnTo>
                  <a:lnTo>
                    <a:pt x="2432" y="913"/>
                  </a:lnTo>
                  <a:lnTo>
                    <a:pt x="2433" y="947"/>
                  </a:lnTo>
                  <a:lnTo>
                    <a:pt x="2434" y="982"/>
                  </a:lnTo>
                  <a:lnTo>
                    <a:pt x="2435" y="1034"/>
                  </a:lnTo>
                  <a:lnTo>
                    <a:pt x="2436" y="1086"/>
                  </a:lnTo>
                  <a:lnTo>
                    <a:pt x="2437" y="1140"/>
                  </a:lnTo>
                  <a:lnTo>
                    <a:pt x="2438" y="1185"/>
                  </a:lnTo>
                  <a:lnTo>
                    <a:pt x="2438" y="1244"/>
                  </a:lnTo>
                  <a:lnTo>
                    <a:pt x="2439" y="1343"/>
                  </a:lnTo>
                  <a:lnTo>
                    <a:pt x="2440" y="1420"/>
                  </a:lnTo>
                  <a:lnTo>
                    <a:pt x="2441" y="1500"/>
                  </a:lnTo>
                  <a:lnTo>
                    <a:pt x="2442" y="1525"/>
                  </a:lnTo>
                  <a:lnTo>
                    <a:pt x="2443" y="1602"/>
                  </a:lnTo>
                  <a:lnTo>
                    <a:pt x="2444" y="1641"/>
                  </a:lnTo>
                  <a:lnTo>
                    <a:pt x="2445" y="1686"/>
                  </a:lnTo>
                  <a:lnTo>
                    <a:pt x="2446" y="1717"/>
                  </a:lnTo>
                  <a:lnTo>
                    <a:pt x="2446" y="1804"/>
                  </a:lnTo>
                  <a:lnTo>
                    <a:pt x="2447" y="1859"/>
                  </a:lnTo>
                  <a:lnTo>
                    <a:pt x="2448" y="1926"/>
                  </a:lnTo>
                  <a:lnTo>
                    <a:pt x="2449" y="1995"/>
                  </a:lnTo>
                  <a:lnTo>
                    <a:pt x="2450" y="2015"/>
                  </a:lnTo>
                  <a:lnTo>
                    <a:pt x="2451" y="2068"/>
                  </a:lnTo>
                  <a:lnTo>
                    <a:pt x="2452" y="2145"/>
                  </a:lnTo>
                  <a:lnTo>
                    <a:pt x="2453" y="2242"/>
                  </a:lnTo>
                  <a:lnTo>
                    <a:pt x="2453" y="2327"/>
                  </a:lnTo>
                  <a:lnTo>
                    <a:pt x="2454" y="2333"/>
                  </a:lnTo>
                  <a:lnTo>
                    <a:pt x="2455" y="2370"/>
                  </a:lnTo>
                  <a:lnTo>
                    <a:pt x="2456" y="2416"/>
                  </a:lnTo>
                  <a:lnTo>
                    <a:pt x="2457" y="2393"/>
                  </a:lnTo>
                  <a:lnTo>
                    <a:pt x="2458" y="2393"/>
                  </a:lnTo>
                  <a:lnTo>
                    <a:pt x="2459" y="2428"/>
                  </a:lnTo>
                  <a:lnTo>
                    <a:pt x="2460" y="2511"/>
                  </a:lnTo>
                  <a:lnTo>
                    <a:pt x="2461" y="2587"/>
                  </a:lnTo>
                  <a:lnTo>
                    <a:pt x="2461" y="2649"/>
                  </a:lnTo>
                  <a:lnTo>
                    <a:pt x="2462" y="2719"/>
                  </a:lnTo>
                  <a:lnTo>
                    <a:pt x="2463" y="2770"/>
                  </a:lnTo>
                  <a:lnTo>
                    <a:pt x="2464" y="2854"/>
                  </a:lnTo>
                  <a:lnTo>
                    <a:pt x="2465" y="2927"/>
                  </a:lnTo>
                  <a:lnTo>
                    <a:pt x="2466" y="3019"/>
                  </a:lnTo>
                  <a:lnTo>
                    <a:pt x="2467" y="3077"/>
                  </a:lnTo>
                  <a:lnTo>
                    <a:pt x="2468" y="3081"/>
                  </a:lnTo>
                  <a:lnTo>
                    <a:pt x="2468" y="3192"/>
                  </a:lnTo>
                  <a:lnTo>
                    <a:pt x="2469" y="3377"/>
                  </a:lnTo>
                  <a:lnTo>
                    <a:pt x="2470" y="3451"/>
                  </a:lnTo>
                  <a:lnTo>
                    <a:pt x="2471" y="3470"/>
                  </a:lnTo>
                  <a:lnTo>
                    <a:pt x="2472" y="3522"/>
                  </a:lnTo>
                  <a:lnTo>
                    <a:pt x="2473" y="3615"/>
                  </a:lnTo>
                  <a:lnTo>
                    <a:pt x="2474" y="3717"/>
                  </a:lnTo>
                  <a:lnTo>
                    <a:pt x="2475" y="3787"/>
                  </a:lnTo>
                  <a:lnTo>
                    <a:pt x="2476" y="3924"/>
                  </a:lnTo>
                  <a:lnTo>
                    <a:pt x="2476" y="4034"/>
                  </a:lnTo>
                  <a:lnTo>
                    <a:pt x="2477" y="4006"/>
                  </a:lnTo>
                  <a:lnTo>
                    <a:pt x="2478" y="3923"/>
                  </a:lnTo>
                  <a:lnTo>
                    <a:pt x="2479" y="4026"/>
                  </a:lnTo>
                  <a:lnTo>
                    <a:pt x="2480" y="3836"/>
                  </a:lnTo>
                  <a:lnTo>
                    <a:pt x="2481" y="3200"/>
                  </a:lnTo>
                  <a:lnTo>
                    <a:pt x="2482" y="2405"/>
                  </a:lnTo>
                  <a:lnTo>
                    <a:pt x="2483" y="1639"/>
                  </a:lnTo>
                  <a:lnTo>
                    <a:pt x="2483" y="1259"/>
                  </a:lnTo>
                  <a:lnTo>
                    <a:pt x="2484" y="1061"/>
                  </a:lnTo>
                  <a:lnTo>
                    <a:pt x="2485" y="926"/>
                  </a:lnTo>
                  <a:lnTo>
                    <a:pt x="2486" y="807"/>
                  </a:lnTo>
                  <a:lnTo>
                    <a:pt x="2487" y="700"/>
                  </a:lnTo>
                  <a:lnTo>
                    <a:pt x="2488" y="610"/>
                  </a:lnTo>
                  <a:lnTo>
                    <a:pt x="2489" y="531"/>
                  </a:lnTo>
                  <a:lnTo>
                    <a:pt x="2490" y="475"/>
                  </a:lnTo>
                  <a:lnTo>
                    <a:pt x="2490" y="425"/>
                  </a:lnTo>
                  <a:lnTo>
                    <a:pt x="2491" y="395"/>
                  </a:lnTo>
                  <a:lnTo>
                    <a:pt x="2492" y="370"/>
                  </a:lnTo>
                  <a:lnTo>
                    <a:pt x="2493" y="343"/>
                  </a:lnTo>
                  <a:lnTo>
                    <a:pt x="2494" y="327"/>
                  </a:lnTo>
                  <a:lnTo>
                    <a:pt x="2495" y="315"/>
                  </a:lnTo>
                  <a:lnTo>
                    <a:pt x="2496" y="311"/>
                  </a:lnTo>
                  <a:lnTo>
                    <a:pt x="2497" y="294"/>
                  </a:lnTo>
                  <a:lnTo>
                    <a:pt x="2498" y="290"/>
                  </a:lnTo>
                  <a:lnTo>
                    <a:pt x="2498" y="282"/>
                  </a:lnTo>
                  <a:lnTo>
                    <a:pt x="2499" y="278"/>
                  </a:lnTo>
                  <a:lnTo>
                    <a:pt x="2500" y="271"/>
                  </a:lnTo>
                  <a:lnTo>
                    <a:pt x="2501" y="264"/>
                  </a:lnTo>
                  <a:lnTo>
                    <a:pt x="2502" y="260"/>
                  </a:lnTo>
                  <a:lnTo>
                    <a:pt x="2503" y="257"/>
                  </a:lnTo>
                  <a:lnTo>
                    <a:pt x="2504" y="247"/>
                  </a:lnTo>
                  <a:lnTo>
                    <a:pt x="2505" y="245"/>
                  </a:lnTo>
                  <a:lnTo>
                    <a:pt x="2505" y="244"/>
                  </a:lnTo>
                  <a:lnTo>
                    <a:pt x="2506" y="232"/>
                  </a:lnTo>
                  <a:lnTo>
                    <a:pt x="2507" y="232"/>
                  </a:lnTo>
                  <a:lnTo>
                    <a:pt x="2508" y="226"/>
                  </a:lnTo>
                  <a:lnTo>
                    <a:pt x="2509" y="221"/>
                  </a:lnTo>
                  <a:lnTo>
                    <a:pt x="2510" y="216"/>
                  </a:lnTo>
                  <a:lnTo>
                    <a:pt x="2511" y="214"/>
                  </a:lnTo>
                  <a:lnTo>
                    <a:pt x="2512" y="211"/>
                  </a:lnTo>
                  <a:lnTo>
                    <a:pt x="2513" y="210"/>
                  </a:lnTo>
                  <a:lnTo>
                    <a:pt x="2513" y="200"/>
                  </a:lnTo>
                  <a:lnTo>
                    <a:pt x="2514" y="203"/>
                  </a:lnTo>
                  <a:lnTo>
                    <a:pt x="2515" y="200"/>
                  </a:lnTo>
                  <a:lnTo>
                    <a:pt x="2516" y="195"/>
                  </a:lnTo>
                  <a:lnTo>
                    <a:pt x="2517" y="197"/>
                  </a:lnTo>
                  <a:lnTo>
                    <a:pt x="2518" y="193"/>
                  </a:lnTo>
                  <a:lnTo>
                    <a:pt x="2519" y="187"/>
                  </a:lnTo>
                  <a:lnTo>
                    <a:pt x="2520" y="192"/>
                  </a:lnTo>
                  <a:lnTo>
                    <a:pt x="2520" y="197"/>
                  </a:lnTo>
                  <a:lnTo>
                    <a:pt x="2521" y="195"/>
                  </a:lnTo>
                  <a:lnTo>
                    <a:pt x="2522" y="199"/>
                  </a:lnTo>
                  <a:lnTo>
                    <a:pt x="2523" y="210"/>
                  </a:lnTo>
                  <a:lnTo>
                    <a:pt x="2524" y="221"/>
                  </a:lnTo>
                  <a:lnTo>
                    <a:pt x="2525" y="251"/>
                  </a:lnTo>
                  <a:lnTo>
                    <a:pt x="2526" y="275"/>
                  </a:lnTo>
                  <a:lnTo>
                    <a:pt x="2527" y="311"/>
                  </a:lnTo>
                  <a:lnTo>
                    <a:pt x="2528" y="360"/>
                  </a:lnTo>
                  <a:lnTo>
                    <a:pt x="2528" y="402"/>
                  </a:lnTo>
                  <a:lnTo>
                    <a:pt x="2529" y="454"/>
                  </a:lnTo>
                  <a:lnTo>
                    <a:pt x="2530" y="521"/>
                  </a:lnTo>
                  <a:lnTo>
                    <a:pt x="2531" y="596"/>
                  </a:lnTo>
                  <a:lnTo>
                    <a:pt x="2532" y="659"/>
                  </a:lnTo>
                  <a:lnTo>
                    <a:pt x="2533" y="763"/>
                  </a:lnTo>
                  <a:lnTo>
                    <a:pt x="2534" y="875"/>
                  </a:lnTo>
                  <a:lnTo>
                    <a:pt x="2535" y="960"/>
                  </a:lnTo>
                  <a:lnTo>
                    <a:pt x="2535" y="1059"/>
                  </a:lnTo>
                  <a:lnTo>
                    <a:pt x="2536" y="1170"/>
                  </a:lnTo>
                  <a:lnTo>
                    <a:pt x="2537" y="1277"/>
                  </a:lnTo>
                  <a:lnTo>
                    <a:pt x="2538" y="1356"/>
                  </a:lnTo>
                  <a:lnTo>
                    <a:pt x="2539" y="1496"/>
                  </a:lnTo>
                  <a:lnTo>
                    <a:pt x="2540" y="1622"/>
                  </a:lnTo>
                  <a:lnTo>
                    <a:pt x="2541" y="1694"/>
                  </a:lnTo>
                  <a:lnTo>
                    <a:pt x="2542" y="1772"/>
                  </a:lnTo>
                  <a:lnTo>
                    <a:pt x="2543" y="1872"/>
                  </a:lnTo>
                  <a:lnTo>
                    <a:pt x="2543" y="1926"/>
                  </a:lnTo>
                  <a:lnTo>
                    <a:pt x="2544" y="1964"/>
                  </a:lnTo>
                  <a:lnTo>
                    <a:pt x="2545" y="1980"/>
                  </a:lnTo>
                  <a:lnTo>
                    <a:pt x="2546" y="1871"/>
                  </a:lnTo>
                  <a:lnTo>
                    <a:pt x="2547" y="1626"/>
                  </a:lnTo>
                  <a:lnTo>
                    <a:pt x="2548" y="1263"/>
                  </a:lnTo>
                  <a:lnTo>
                    <a:pt x="2549" y="914"/>
                  </a:lnTo>
                  <a:lnTo>
                    <a:pt x="2550" y="668"/>
                  </a:lnTo>
                  <a:lnTo>
                    <a:pt x="2550" y="507"/>
                  </a:lnTo>
                  <a:lnTo>
                    <a:pt x="2551" y="417"/>
                  </a:lnTo>
                  <a:lnTo>
                    <a:pt x="2552" y="364"/>
                  </a:lnTo>
                  <a:lnTo>
                    <a:pt x="2553" y="330"/>
                  </a:lnTo>
                  <a:lnTo>
                    <a:pt x="2554" y="304"/>
                  </a:lnTo>
                  <a:lnTo>
                    <a:pt x="2555" y="280"/>
                  </a:lnTo>
                  <a:lnTo>
                    <a:pt x="2556" y="266"/>
                  </a:lnTo>
                  <a:lnTo>
                    <a:pt x="2557" y="255"/>
                  </a:lnTo>
                  <a:lnTo>
                    <a:pt x="2558" y="241"/>
                  </a:lnTo>
                  <a:lnTo>
                    <a:pt x="2558" y="233"/>
                  </a:lnTo>
                  <a:lnTo>
                    <a:pt x="2559" y="222"/>
                  </a:lnTo>
                  <a:lnTo>
                    <a:pt x="2560" y="212"/>
                  </a:lnTo>
                  <a:lnTo>
                    <a:pt x="2561" y="208"/>
                  </a:lnTo>
                  <a:lnTo>
                    <a:pt x="2562" y="202"/>
                  </a:lnTo>
                  <a:lnTo>
                    <a:pt x="2563" y="196"/>
                  </a:lnTo>
                  <a:lnTo>
                    <a:pt x="2564" y="193"/>
                  </a:lnTo>
                  <a:lnTo>
                    <a:pt x="2565" y="182"/>
                  </a:lnTo>
                  <a:lnTo>
                    <a:pt x="2565" y="177"/>
                  </a:lnTo>
                  <a:lnTo>
                    <a:pt x="2566" y="178"/>
                  </a:lnTo>
                  <a:lnTo>
                    <a:pt x="2567" y="176"/>
                  </a:lnTo>
                  <a:lnTo>
                    <a:pt x="2568" y="173"/>
                  </a:lnTo>
                  <a:lnTo>
                    <a:pt x="2569" y="170"/>
                  </a:lnTo>
                  <a:lnTo>
                    <a:pt x="2570" y="167"/>
                  </a:lnTo>
                  <a:lnTo>
                    <a:pt x="2571" y="164"/>
                  </a:lnTo>
                  <a:lnTo>
                    <a:pt x="2572" y="165"/>
                  </a:lnTo>
                  <a:lnTo>
                    <a:pt x="2573" y="162"/>
                  </a:lnTo>
                  <a:lnTo>
                    <a:pt x="2573" y="158"/>
                  </a:lnTo>
                  <a:lnTo>
                    <a:pt x="2574" y="156"/>
                  </a:lnTo>
                  <a:lnTo>
                    <a:pt x="2575" y="154"/>
                  </a:lnTo>
                  <a:lnTo>
                    <a:pt x="2576" y="152"/>
                  </a:lnTo>
                  <a:lnTo>
                    <a:pt x="2577" y="151"/>
                  </a:lnTo>
                  <a:lnTo>
                    <a:pt x="2578" y="152"/>
                  </a:lnTo>
                  <a:lnTo>
                    <a:pt x="2579" y="150"/>
                  </a:lnTo>
                  <a:lnTo>
                    <a:pt x="2580" y="151"/>
                  </a:lnTo>
                  <a:lnTo>
                    <a:pt x="2580" y="149"/>
                  </a:lnTo>
                  <a:lnTo>
                    <a:pt x="2581" y="156"/>
                  </a:lnTo>
                  <a:lnTo>
                    <a:pt x="2582" y="155"/>
                  </a:lnTo>
                  <a:lnTo>
                    <a:pt x="2583" y="154"/>
                  </a:lnTo>
                  <a:lnTo>
                    <a:pt x="2584" y="152"/>
                  </a:lnTo>
                  <a:lnTo>
                    <a:pt x="2585" y="156"/>
                  </a:lnTo>
                  <a:lnTo>
                    <a:pt x="2586" y="153"/>
                  </a:lnTo>
                  <a:lnTo>
                    <a:pt x="2587" y="149"/>
                  </a:lnTo>
                  <a:lnTo>
                    <a:pt x="2588" y="147"/>
                  </a:lnTo>
                  <a:lnTo>
                    <a:pt x="2588" y="144"/>
                  </a:lnTo>
                  <a:lnTo>
                    <a:pt x="2589" y="142"/>
                  </a:lnTo>
                  <a:lnTo>
                    <a:pt x="2590" y="148"/>
                  </a:lnTo>
                  <a:lnTo>
                    <a:pt x="2591" y="143"/>
                  </a:lnTo>
                  <a:lnTo>
                    <a:pt x="2592" y="141"/>
                  </a:lnTo>
                  <a:lnTo>
                    <a:pt x="2593" y="139"/>
                  </a:lnTo>
                  <a:lnTo>
                    <a:pt x="2594" y="138"/>
                  </a:lnTo>
                  <a:lnTo>
                    <a:pt x="2595" y="136"/>
                  </a:lnTo>
                  <a:lnTo>
                    <a:pt x="2595" y="134"/>
                  </a:lnTo>
                  <a:lnTo>
                    <a:pt x="2596" y="134"/>
                  </a:lnTo>
                  <a:lnTo>
                    <a:pt x="2597" y="128"/>
                  </a:lnTo>
                  <a:lnTo>
                    <a:pt x="2598" y="126"/>
                  </a:lnTo>
                  <a:lnTo>
                    <a:pt x="2599" y="127"/>
                  </a:lnTo>
                  <a:lnTo>
                    <a:pt x="2600" y="122"/>
                  </a:lnTo>
                  <a:lnTo>
                    <a:pt x="2601" y="123"/>
                  </a:lnTo>
                  <a:lnTo>
                    <a:pt x="2602" y="116"/>
                  </a:lnTo>
                  <a:lnTo>
                    <a:pt x="2603" y="116"/>
                  </a:lnTo>
                  <a:lnTo>
                    <a:pt x="2603" y="116"/>
                  </a:lnTo>
                  <a:lnTo>
                    <a:pt x="2604" y="114"/>
                  </a:lnTo>
                  <a:lnTo>
                    <a:pt x="2605" y="117"/>
                  </a:lnTo>
                  <a:lnTo>
                    <a:pt x="2606" y="114"/>
                  </a:lnTo>
                  <a:lnTo>
                    <a:pt x="2607" y="114"/>
                  </a:lnTo>
                  <a:lnTo>
                    <a:pt x="2608" y="113"/>
                  </a:lnTo>
                  <a:lnTo>
                    <a:pt x="2609" y="109"/>
                  </a:lnTo>
                  <a:lnTo>
                    <a:pt x="2610" y="111"/>
                  </a:lnTo>
                  <a:lnTo>
                    <a:pt x="2610" y="110"/>
                  </a:lnTo>
                  <a:lnTo>
                    <a:pt x="2611" y="108"/>
                  </a:lnTo>
                  <a:lnTo>
                    <a:pt x="2612" y="108"/>
                  </a:lnTo>
                  <a:lnTo>
                    <a:pt x="2613" y="109"/>
                  </a:lnTo>
                  <a:lnTo>
                    <a:pt x="2614" y="104"/>
                  </a:lnTo>
                  <a:lnTo>
                    <a:pt x="2615" y="104"/>
                  </a:lnTo>
                  <a:lnTo>
                    <a:pt x="2616" y="104"/>
                  </a:lnTo>
                  <a:lnTo>
                    <a:pt x="2617" y="105"/>
                  </a:lnTo>
                  <a:lnTo>
                    <a:pt x="2618" y="103"/>
                  </a:lnTo>
                  <a:lnTo>
                    <a:pt x="2618" y="98"/>
                  </a:lnTo>
                  <a:lnTo>
                    <a:pt x="2619" y="103"/>
                  </a:lnTo>
                  <a:lnTo>
                    <a:pt x="2620" y="98"/>
                  </a:lnTo>
                  <a:lnTo>
                    <a:pt x="2621" y="101"/>
                  </a:lnTo>
                  <a:lnTo>
                    <a:pt x="2622" y="96"/>
                  </a:lnTo>
                  <a:lnTo>
                    <a:pt x="2623" y="97"/>
                  </a:lnTo>
                  <a:lnTo>
                    <a:pt x="2624" y="100"/>
                  </a:lnTo>
                  <a:lnTo>
                    <a:pt x="2625" y="95"/>
                  </a:lnTo>
                  <a:lnTo>
                    <a:pt x="2625" y="99"/>
                  </a:lnTo>
                  <a:lnTo>
                    <a:pt x="2626" y="97"/>
                  </a:lnTo>
                  <a:lnTo>
                    <a:pt x="2627" y="94"/>
                  </a:lnTo>
                  <a:lnTo>
                    <a:pt x="2628" y="93"/>
                  </a:lnTo>
                  <a:lnTo>
                    <a:pt x="2629" y="93"/>
                  </a:lnTo>
                  <a:lnTo>
                    <a:pt x="2630" y="97"/>
                  </a:lnTo>
                  <a:lnTo>
                    <a:pt x="2631" y="95"/>
                  </a:lnTo>
                  <a:lnTo>
                    <a:pt x="2632" y="96"/>
                  </a:lnTo>
                  <a:lnTo>
                    <a:pt x="2633" y="93"/>
                  </a:lnTo>
                  <a:lnTo>
                    <a:pt x="2633" y="92"/>
                  </a:lnTo>
                  <a:lnTo>
                    <a:pt x="2634" y="95"/>
                  </a:lnTo>
                  <a:lnTo>
                    <a:pt x="2635" y="93"/>
                  </a:lnTo>
                  <a:lnTo>
                    <a:pt x="2636" y="94"/>
                  </a:lnTo>
                  <a:lnTo>
                    <a:pt x="2637" y="90"/>
                  </a:lnTo>
                  <a:lnTo>
                    <a:pt x="2638" y="93"/>
                  </a:lnTo>
                  <a:lnTo>
                    <a:pt x="2639" y="94"/>
                  </a:lnTo>
                  <a:lnTo>
                    <a:pt x="2640" y="88"/>
                  </a:lnTo>
                  <a:lnTo>
                    <a:pt x="2640" y="92"/>
                  </a:lnTo>
                  <a:lnTo>
                    <a:pt x="2641" y="92"/>
                  </a:lnTo>
                  <a:lnTo>
                    <a:pt x="2642" y="93"/>
                  </a:lnTo>
                  <a:lnTo>
                    <a:pt x="2643" y="95"/>
                  </a:lnTo>
                  <a:lnTo>
                    <a:pt x="2644" y="95"/>
                  </a:lnTo>
                  <a:lnTo>
                    <a:pt x="2645" y="93"/>
                  </a:lnTo>
                  <a:lnTo>
                    <a:pt x="2646" y="97"/>
                  </a:lnTo>
                  <a:lnTo>
                    <a:pt x="2647" y="96"/>
                  </a:lnTo>
                  <a:lnTo>
                    <a:pt x="2648" y="98"/>
                  </a:lnTo>
                  <a:lnTo>
                    <a:pt x="2648" y="98"/>
                  </a:lnTo>
                  <a:lnTo>
                    <a:pt x="2649" y="104"/>
                  </a:lnTo>
                  <a:lnTo>
                    <a:pt x="2650" y="102"/>
                  </a:lnTo>
                  <a:lnTo>
                    <a:pt x="2651" y="103"/>
                  </a:lnTo>
                  <a:lnTo>
                    <a:pt x="2652" y="103"/>
                  </a:lnTo>
                  <a:lnTo>
                    <a:pt x="2653" y="100"/>
                  </a:lnTo>
                  <a:lnTo>
                    <a:pt x="2654" y="97"/>
                  </a:lnTo>
                  <a:lnTo>
                    <a:pt x="2655" y="94"/>
                  </a:lnTo>
                  <a:lnTo>
                    <a:pt x="2655" y="92"/>
                  </a:lnTo>
                  <a:lnTo>
                    <a:pt x="2656" y="91"/>
                  </a:lnTo>
                  <a:lnTo>
                    <a:pt x="2657" y="88"/>
                  </a:lnTo>
                  <a:lnTo>
                    <a:pt x="2658" y="87"/>
                  </a:lnTo>
                  <a:lnTo>
                    <a:pt x="2659" y="84"/>
                  </a:lnTo>
                  <a:lnTo>
                    <a:pt x="2660" y="81"/>
                  </a:lnTo>
                  <a:lnTo>
                    <a:pt x="2661" y="84"/>
                  </a:lnTo>
                  <a:lnTo>
                    <a:pt x="2662" y="81"/>
                  </a:lnTo>
                  <a:lnTo>
                    <a:pt x="2663" y="83"/>
                  </a:lnTo>
                  <a:lnTo>
                    <a:pt x="2663" y="79"/>
                  </a:lnTo>
                  <a:lnTo>
                    <a:pt x="2664" y="84"/>
                  </a:lnTo>
                  <a:lnTo>
                    <a:pt x="2665" y="82"/>
                  </a:lnTo>
                  <a:lnTo>
                    <a:pt x="2666" y="81"/>
                  </a:lnTo>
                  <a:lnTo>
                    <a:pt x="2667" y="79"/>
                  </a:lnTo>
                  <a:lnTo>
                    <a:pt x="2668" y="81"/>
                  </a:lnTo>
                  <a:lnTo>
                    <a:pt x="2669" y="82"/>
                  </a:lnTo>
                  <a:lnTo>
                    <a:pt x="2670" y="79"/>
                  </a:lnTo>
                  <a:lnTo>
                    <a:pt x="2670" y="77"/>
                  </a:lnTo>
                  <a:lnTo>
                    <a:pt x="2671" y="78"/>
                  </a:lnTo>
                  <a:lnTo>
                    <a:pt x="2672" y="77"/>
                  </a:lnTo>
                  <a:lnTo>
                    <a:pt x="2673" y="80"/>
                  </a:lnTo>
                  <a:lnTo>
                    <a:pt x="2674" y="76"/>
                  </a:lnTo>
                  <a:lnTo>
                    <a:pt x="2675" y="78"/>
                  </a:lnTo>
                  <a:lnTo>
                    <a:pt x="2676" y="78"/>
                  </a:lnTo>
                  <a:lnTo>
                    <a:pt x="2677" y="77"/>
                  </a:lnTo>
                  <a:lnTo>
                    <a:pt x="2677" y="77"/>
                  </a:lnTo>
                  <a:lnTo>
                    <a:pt x="2678" y="77"/>
                  </a:lnTo>
                  <a:lnTo>
                    <a:pt x="2679" y="74"/>
                  </a:lnTo>
                  <a:lnTo>
                    <a:pt x="2680" y="76"/>
                  </a:lnTo>
                  <a:lnTo>
                    <a:pt x="2681" y="76"/>
                  </a:lnTo>
                  <a:lnTo>
                    <a:pt x="2682" y="77"/>
                  </a:lnTo>
                  <a:lnTo>
                    <a:pt x="2683" y="78"/>
                  </a:lnTo>
                  <a:lnTo>
                    <a:pt x="2684" y="79"/>
                  </a:lnTo>
                  <a:lnTo>
                    <a:pt x="2685" y="74"/>
                  </a:lnTo>
                  <a:lnTo>
                    <a:pt x="2685" y="77"/>
                  </a:lnTo>
                  <a:lnTo>
                    <a:pt x="2686" y="75"/>
                  </a:lnTo>
                  <a:lnTo>
                    <a:pt x="2687" y="78"/>
                  </a:lnTo>
                  <a:lnTo>
                    <a:pt x="2688" y="71"/>
                  </a:lnTo>
                  <a:lnTo>
                    <a:pt x="2689" y="72"/>
                  </a:lnTo>
                  <a:lnTo>
                    <a:pt x="2690" y="72"/>
                  </a:lnTo>
                  <a:lnTo>
                    <a:pt x="2691" y="71"/>
                  </a:lnTo>
                  <a:lnTo>
                    <a:pt x="2692" y="70"/>
                  </a:lnTo>
                  <a:lnTo>
                    <a:pt x="2692" y="71"/>
                  </a:lnTo>
                  <a:lnTo>
                    <a:pt x="2693" y="71"/>
                  </a:lnTo>
                  <a:lnTo>
                    <a:pt x="2694" y="73"/>
                  </a:lnTo>
                  <a:lnTo>
                    <a:pt x="2695" y="72"/>
                  </a:lnTo>
                  <a:lnTo>
                    <a:pt x="2696" y="70"/>
                  </a:lnTo>
                  <a:lnTo>
                    <a:pt x="2697" y="69"/>
                  </a:lnTo>
                  <a:lnTo>
                    <a:pt x="2698" y="69"/>
                  </a:lnTo>
                  <a:lnTo>
                    <a:pt x="2699" y="68"/>
                  </a:lnTo>
                  <a:lnTo>
                    <a:pt x="2700" y="70"/>
                  </a:lnTo>
                  <a:lnTo>
                    <a:pt x="2700" y="68"/>
                  </a:lnTo>
                  <a:lnTo>
                    <a:pt x="2701" y="68"/>
                  </a:lnTo>
                  <a:lnTo>
                    <a:pt x="2702" y="70"/>
                  </a:lnTo>
                  <a:lnTo>
                    <a:pt x="2703" y="70"/>
                  </a:lnTo>
                  <a:lnTo>
                    <a:pt x="2704" y="69"/>
                  </a:lnTo>
                  <a:lnTo>
                    <a:pt x="2705" y="70"/>
                  </a:lnTo>
                  <a:lnTo>
                    <a:pt x="2706" y="70"/>
                  </a:lnTo>
                  <a:lnTo>
                    <a:pt x="2707" y="71"/>
                  </a:lnTo>
                  <a:lnTo>
                    <a:pt x="2707" y="72"/>
                  </a:lnTo>
                  <a:lnTo>
                    <a:pt x="2708" y="70"/>
                  </a:lnTo>
                  <a:lnTo>
                    <a:pt x="2709" y="68"/>
                  </a:lnTo>
                  <a:lnTo>
                    <a:pt x="2710" y="69"/>
                  </a:lnTo>
                  <a:lnTo>
                    <a:pt x="2711" y="69"/>
                  </a:lnTo>
                  <a:lnTo>
                    <a:pt x="2712" y="71"/>
                  </a:lnTo>
                  <a:lnTo>
                    <a:pt x="2713" y="68"/>
                  </a:lnTo>
                  <a:lnTo>
                    <a:pt x="2714" y="67"/>
                  </a:lnTo>
                  <a:lnTo>
                    <a:pt x="2715" y="66"/>
                  </a:lnTo>
                  <a:lnTo>
                    <a:pt x="2715" y="65"/>
                  </a:lnTo>
                  <a:lnTo>
                    <a:pt x="2716" y="66"/>
                  </a:lnTo>
                  <a:lnTo>
                    <a:pt x="2717" y="65"/>
                  </a:lnTo>
                  <a:lnTo>
                    <a:pt x="2718" y="67"/>
                  </a:lnTo>
                  <a:lnTo>
                    <a:pt x="2719" y="66"/>
                  </a:lnTo>
                  <a:lnTo>
                    <a:pt x="2720" y="65"/>
                  </a:lnTo>
                  <a:lnTo>
                    <a:pt x="2721" y="64"/>
                  </a:lnTo>
                  <a:lnTo>
                    <a:pt x="2722" y="63"/>
                  </a:lnTo>
                  <a:lnTo>
                    <a:pt x="2722" y="66"/>
                  </a:lnTo>
                  <a:lnTo>
                    <a:pt x="2723" y="64"/>
                  </a:lnTo>
                  <a:lnTo>
                    <a:pt x="2724" y="65"/>
                  </a:lnTo>
                  <a:lnTo>
                    <a:pt x="2725" y="64"/>
                  </a:lnTo>
                  <a:lnTo>
                    <a:pt x="2726" y="64"/>
                  </a:lnTo>
                  <a:lnTo>
                    <a:pt x="2727" y="66"/>
                  </a:lnTo>
                  <a:lnTo>
                    <a:pt x="2728" y="69"/>
                  </a:lnTo>
                  <a:lnTo>
                    <a:pt x="2729" y="66"/>
                  </a:lnTo>
                  <a:lnTo>
                    <a:pt x="2730" y="63"/>
                  </a:lnTo>
                  <a:lnTo>
                    <a:pt x="2730" y="64"/>
                  </a:lnTo>
                  <a:lnTo>
                    <a:pt x="2731" y="64"/>
                  </a:lnTo>
                  <a:lnTo>
                    <a:pt x="2732" y="67"/>
                  </a:lnTo>
                  <a:lnTo>
                    <a:pt x="2733" y="65"/>
                  </a:lnTo>
                  <a:lnTo>
                    <a:pt x="2734" y="65"/>
                  </a:lnTo>
                  <a:lnTo>
                    <a:pt x="2735" y="65"/>
                  </a:lnTo>
                  <a:lnTo>
                    <a:pt x="2736" y="65"/>
                  </a:lnTo>
                  <a:lnTo>
                    <a:pt x="2737" y="64"/>
                  </a:lnTo>
                  <a:lnTo>
                    <a:pt x="2737" y="65"/>
                  </a:lnTo>
                  <a:lnTo>
                    <a:pt x="2738" y="65"/>
                  </a:lnTo>
                  <a:lnTo>
                    <a:pt x="2739" y="63"/>
                  </a:lnTo>
                  <a:lnTo>
                    <a:pt x="2740" y="65"/>
                  </a:lnTo>
                  <a:lnTo>
                    <a:pt x="2741" y="61"/>
                  </a:lnTo>
                  <a:lnTo>
                    <a:pt x="2742" y="64"/>
                  </a:lnTo>
                  <a:lnTo>
                    <a:pt x="2743" y="61"/>
                  </a:lnTo>
                  <a:lnTo>
                    <a:pt x="2744" y="64"/>
                  </a:lnTo>
                  <a:lnTo>
                    <a:pt x="2745" y="64"/>
                  </a:lnTo>
                  <a:lnTo>
                    <a:pt x="2745" y="61"/>
                  </a:lnTo>
                  <a:lnTo>
                    <a:pt x="2746" y="64"/>
                  </a:lnTo>
                  <a:lnTo>
                    <a:pt x="2747" y="61"/>
                  </a:lnTo>
                  <a:lnTo>
                    <a:pt x="2748" y="61"/>
                  </a:lnTo>
                  <a:lnTo>
                    <a:pt x="2749" y="61"/>
                  </a:lnTo>
                  <a:lnTo>
                    <a:pt x="2750" y="62"/>
                  </a:lnTo>
                  <a:lnTo>
                    <a:pt x="2751" y="60"/>
                  </a:lnTo>
                  <a:lnTo>
                    <a:pt x="2752" y="60"/>
                  </a:lnTo>
                  <a:lnTo>
                    <a:pt x="2752" y="61"/>
                  </a:lnTo>
                  <a:lnTo>
                    <a:pt x="2753" y="58"/>
                  </a:lnTo>
                  <a:lnTo>
                    <a:pt x="2754" y="61"/>
                  </a:lnTo>
                  <a:lnTo>
                    <a:pt x="2755" y="58"/>
                  </a:lnTo>
                  <a:lnTo>
                    <a:pt x="2756" y="58"/>
                  </a:lnTo>
                  <a:lnTo>
                    <a:pt x="2757" y="59"/>
                  </a:lnTo>
                  <a:lnTo>
                    <a:pt x="2758" y="58"/>
                  </a:lnTo>
                  <a:lnTo>
                    <a:pt x="2759" y="60"/>
                  </a:lnTo>
                  <a:lnTo>
                    <a:pt x="2760" y="60"/>
                  </a:lnTo>
                  <a:lnTo>
                    <a:pt x="2760" y="60"/>
                  </a:lnTo>
                  <a:lnTo>
                    <a:pt x="2761" y="57"/>
                  </a:lnTo>
                  <a:lnTo>
                    <a:pt x="2762" y="60"/>
                  </a:lnTo>
                  <a:lnTo>
                    <a:pt x="2763" y="58"/>
                  </a:lnTo>
                  <a:lnTo>
                    <a:pt x="2764" y="58"/>
                  </a:lnTo>
                  <a:lnTo>
                    <a:pt x="2765" y="56"/>
                  </a:lnTo>
                  <a:lnTo>
                    <a:pt x="2766" y="58"/>
                  </a:lnTo>
                  <a:lnTo>
                    <a:pt x="2767" y="58"/>
                  </a:lnTo>
                  <a:lnTo>
                    <a:pt x="2767" y="56"/>
                  </a:lnTo>
                  <a:lnTo>
                    <a:pt x="2768" y="61"/>
                  </a:lnTo>
                  <a:lnTo>
                    <a:pt x="2769" y="59"/>
                  </a:lnTo>
                  <a:lnTo>
                    <a:pt x="2770" y="60"/>
                  </a:lnTo>
                  <a:lnTo>
                    <a:pt x="2771" y="57"/>
                  </a:lnTo>
                  <a:lnTo>
                    <a:pt x="2772" y="58"/>
                  </a:lnTo>
                  <a:lnTo>
                    <a:pt x="2773" y="58"/>
                  </a:lnTo>
                  <a:lnTo>
                    <a:pt x="2774" y="59"/>
                  </a:lnTo>
                  <a:lnTo>
                    <a:pt x="2775" y="60"/>
                  </a:lnTo>
                  <a:lnTo>
                    <a:pt x="2775" y="62"/>
                  </a:lnTo>
                  <a:lnTo>
                    <a:pt x="2776" y="60"/>
                  </a:lnTo>
                  <a:lnTo>
                    <a:pt x="2777" y="60"/>
                  </a:lnTo>
                  <a:lnTo>
                    <a:pt x="2778" y="58"/>
                  </a:lnTo>
                  <a:lnTo>
                    <a:pt x="2779" y="57"/>
                  </a:lnTo>
                  <a:lnTo>
                    <a:pt x="2780" y="58"/>
                  </a:lnTo>
                  <a:lnTo>
                    <a:pt x="2781" y="59"/>
                  </a:lnTo>
                  <a:lnTo>
                    <a:pt x="2782" y="60"/>
                  </a:lnTo>
                  <a:lnTo>
                    <a:pt x="2782" y="61"/>
                  </a:lnTo>
                  <a:lnTo>
                    <a:pt x="2783" y="58"/>
                  </a:lnTo>
                  <a:lnTo>
                    <a:pt x="2784" y="59"/>
                  </a:lnTo>
                  <a:lnTo>
                    <a:pt x="2785" y="56"/>
                  </a:lnTo>
                  <a:lnTo>
                    <a:pt x="2786" y="57"/>
                  </a:lnTo>
                  <a:lnTo>
                    <a:pt x="2787" y="58"/>
                  </a:lnTo>
                  <a:lnTo>
                    <a:pt x="2788" y="56"/>
                  </a:lnTo>
                  <a:lnTo>
                    <a:pt x="2789" y="56"/>
                  </a:lnTo>
                  <a:lnTo>
                    <a:pt x="2790" y="57"/>
                  </a:lnTo>
                  <a:lnTo>
                    <a:pt x="2790" y="59"/>
                  </a:lnTo>
                  <a:lnTo>
                    <a:pt x="2791" y="58"/>
                  </a:lnTo>
                  <a:lnTo>
                    <a:pt x="2792" y="55"/>
                  </a:lnTo>
                  <a:lnTo>
                    <a:pt x="2793" y="56"/>
                  </a:lnTo>
                  <a:lnTo>
                    <a:pt x="2794" y="56"/>
                  </a:lnTo>
                  <a:lnTo>
                    <a:pt x="2795" y="56"/>
                  </a:lnTo>
                  <a:lnTo>
                    <a:pt x="2796" y="58"/>
                  </a:lnTo>
                  <a:lnTo>
                    <a:pt x="2797" y="55"/>
                  </a:lnTo>
                  <a:lnTo>
                    <a:pt x="2797" y="54"/>
                  </a:lnTo>
                  <a:lnTo>
                    <a:pt x="2798" y="57"/>
                  </a:lnTo>
                  <a:lnTo>
                    <a:pt x="2799" y="57"/>
                  </a:lnTo>
                  <a:lnTo>
                    <a:pt x="2800" y="55"/>
                  </a:lnTo>
                  <a:lnTo>
                    <a:pt x="2801" y="56"/>
                  </a:lnTo>
                  <a:lnTo>
                    <a:pt x="2802" y="55"/>
                  </a:lnTo>
                  <a:lnTo>
                    <a:pt x="2803" y="57"/>
                  </a:lnTo>
                  <a:lnTo>
                    <a:pt x="2804" y="57"/>
                  </a:lnTo>
                  <a:lnTo>
                    <a:pt x="2805" y="56"/>
                  </a:lnTo>
                  <a:lnTo>
                    <a:pt x="2805" y="55"/>
                  </a:lnTo>
                  <a:lnTo>
                    <a:pt x="2806" y="55"/>
                  </a:lnTo>
                  <a:lnTo>
                    <a:pt x="2807" y="54"/>
                  </a:lnTo>
                  <a:lnTo>
                    <a:pt x="2808" y="55"/>
                  </a:lnTo>
                  <a:lnTo>
                    <a:pt x="2809" y="54"/>
                  </a:lnTo>
                  <a:lnTo>
                    <a:pt x="2810" y="53"/>
                  </a:lnTo>
                  <a:lnTo>
                    <a:pt x="2811" y="56"/>
                  </a:lnTo>
                  <a:lnTo>
                    <a:pt x="2812" y="52"/>
                  </a:lnTo>
                  <a:lnTo>
                    <a:pt x="2812" y="53"/>
                  </a:lnTo>
                  <a:lnTo>
                    <a:pt x="2813" y="55"/>
                  </a:lnTo>
                  <a:lnTo>
                    <a:pt x="2814" y="56"/>
                  </a:lnTo>
                  <a:lnTo>
                    <a:pt x="2815" y="53"/>
                  </a:lnTo>
                  <a:lnTo>
                    <a:pt x="2816" y="53"/>
                  </a:lnTo>
                  <a:lnTo>
                    <a:pt x="2817" y="53"/>
                  </a:lnTo>
                  <a:lnTo>
                    <a:pt x="2818" y="54"/>
                  </a:lnTo>
                  <a:lnTo>
                    <a:pt x="2819" y="54"/>
                  </a:lnTo>
                  <a:lnTo>
                    <a:pt x="2820" y="56"/>
                  </a:lnTo>
                  <a:lnTo>
                    <a:pt x="2820" y="55"/>
                  </a:lnTo>
                  <a:lnTo>
                    <a:pt x="2821" y="54"/>
                  </a:lnTo>
                  <a:lnTo>
                    <a:pt x="2822" y="55"/>
                  </a:lnTo>
                  <a:lnTo>
                    <a:pt x="2823" y="52"/>
                  </a:lnTo>
                  <a:lnTo>
                    <a:pt x="2824" y="52"/>
                  </a:lnTo>
                  <a:lnTo>
                    <a:pt x="2825" y="53"/>
                  </a:lnTo>
                  <a:lnTo>
                    <a:pt x="2826" y="51"/>
                  </a:lnTo>
                  <a:lnTo>
                    <a:pt x="2827" y="51"/>
                  </a:lnTo>
                  <a:lnTo>
                    <a:pt x="2827" y="54"/>
                  </a:lnTo>
                  <a:lnTo>
                    <a:pt x="2828" y="52"/>
                  </a:lnTo>
                  <a:lnTo>
                    <a:pt x="2829" y="54"/>
                  </a:lnTo>
                  <a:lnTo>
                    <a:pt x="2830" y="52"/>
                  </a:lnTo>
                  <a:lnTo>
                    <a:pt x="2831" y="55"/>
                  </a:lnTo>
                  <a:lnTo>
                    <a:pt x="2832" y="53"/>
                  </a:lnTo>
                  <a:lnTo>
                    <a:pt x="2833" y="52"/>
                  </a:lnTo>
                  <a:lnTo>
                    <a:pt x="2834" y="51"/>
                  </a:lnTo>
                  <a:lnTo>
                    <a:pt x="2835" y="51"/>
                  </a:lnTo>
                  <a:lnTo>
                    <a:pt x="2835" y="50"/>
                  </a:lnTo>
                  <a:lnTo>
                    <a:pt x="2836" y="50"/>
                  </a:lnTo>
                  <a:lnTo>
                    <a:pt x="2837" y="50"/>
                  </a:lnTo>
                  <a:lnTo>
                    <a:pt x="2838" y="50"/>
                  </a:lnTo>
                  <a:lnTo>
                    <a:pt x="2839" y="51"/>
                  </a:lnTo>
                  <a:lnTo>
                    <a:pt x="2840" y="49"/>
                  </a:lnTo>
                  <a:lnTo>
                    <a:pt x="2841" y="49"/>
                  </a:lnTo>
                  <a:lnTo>
                    <a:pt x="2842" y="49"/>
                  </a:lnTo>
                  <a:lnTo>
                    <a:pt x="2842" y="50"/>
                  </a:lnTo>
                  <a:lnTo>
                    <a:pt x="2843" y="50"/>
                  </a:lnTo>
                  <a:lnTo>
                    <a:pt x="2844" y="49"/>
                  </a:lnTo>
                  <a:lnTo>
                    <a:pt x="2845" y="50"/>
                  </a:lnTo>
                  <a:lnTo>
                    <a:pt x="2846" y="49"/>
                  </a:lnTo>
                  <a:lnTo>
                    <a:pt x="2847" y="50"/>
                  </a:lnTo>
                  <a:lnTo>
                    <a:pt x="2848" y="53"/>
                  </a:lnTo>
                  <a:lnTo>
                    <a:pt x="2849" y="51"/>
                  </a:lnTo>
                  <a:lnTo>
                    <a:pt x="2850" y="49"/>
                  </a:lnTo>
                  <a:lnTo>
                    <a:pt x="2850" y="50"/>
                  </a:lnTo>
                  <a:lnTo>
                    <a:pt x="2851" y="52"/>
                  </a:lnTo>
                  <a:lnTo>
                    <a:pt x="2852" y="51"/>
                  </a:lnTo>
                  <a:lnTo>
                    <a:pt x="2853" y="50"/>
                  </a:lnTo>
                  <a:lnTo>
                    <a:pt x="2854" y="51"/>
                  </a:lnTo>
                  <a:lnTo>
                    <a:pt x="2855" y="51"/>
                  </a:lnTo>
                  <a:lnTo>
                    <a:pt x="2856" y="49"/>
                  </a:lnTo>
                  <a:lnTo>
                    <a:pt x="2857" y="54"/>
                  </a:lnTo>
                  <a:lnTo>
                    <a:pt x="2857" y="53"/>
                  </a:lnTo>
                  <a:lnTo>
                    <a:pt x="2858" y="53"/>
                  </a:lnTo>
                  <a:lnTo>
                    <a:pt x="2859" y="53"/>
                  </a:lnTo>
                  <a:lnTo>
                    <a:pt x="2860" y="52"/>
                  </a:lnTo>
                  <a:lnTo>
                    <a:pt x="2861" y="54"/>
                  </a:lnTo>
                  <a:lnTo>
                    <a:pt x="2862" y="53"/>
                  </a:lnTo>
                  <a:lnTo>
                    <a:pt x="2863" y="54"/>
                  </a:lnTo>
                  <a:lnTo>
                    <a:pt x="2864" y="53"/>
                  </a:lnTo>
                  <a:lnTo>
                    <a:pt x="2865" y="51"/>
                  </a:lnTo>
                  <a:lnTo>
                    <a:pt x="2865" y="49"/>
                  </a:lnTo>
                  <a:lnTo>
                    <a:pt x="2866" y="50"/>
                  </a:lnTo>
                  <a:lnTo>
                    <a:pt x="2867" y="51"/>
                  </a:lnTo>
                  <a:lnTo>
                    <a:pt x="2868" y="52"/>
                  </a:lnTo>
                  <a:lnTo>
                    <a:pt x="2869" y="50"/>
                  </a:lnTo>
                  <a:lnTo>
                    <a:pt x="2870" y="51"/>
                  </a:lnTo>
                  <a:lnTo>
                    <a:pt x="2871" y="50"/>
                  </a:lnTo>
                  <a:lnTo>
                    <a:pt x="2872" y="51"/>
                  </a:lnTo>
                  <a:lnTo>
                    <a:pt x="2872" y="49"/>
                  </a:lnTo>
                  <a:lnTo>
                    <a:pt x="2873" y="50"/>
                  </a:lnTo>
                  <a:lnTo>
                    <a:pt x="2874" y="52"/>
                  </a:lnTo>
                  <a:lnTo>
                    <a:pt x="2875" y="50"/>
                  </a:lnTo>
                  <a:lnTo>
                    <a:pt x="2876" y="50"/>
                  </a:lnTo>
                  <a:lnTo>
                    <a:pt x="2877" y="50"/>
                  </a:lnTo>
                  <a:lnTo>
                    <a:pt x="2878" y="49"/>
                  </a:lnTo>
                  <a:lnTo>
                    <a:pt x="2879" y="48"/>
                  </a:lnTo>
                  <a:lnTo>
                    <a:pt x="2879" y="51"/>
                  </a:lnTo>
                  <a:lnTo>
                    <a:pt x="2880" y="49"/>
                  </a:lnTo>
                  <a:lnTo>
                    <a:pt x="2881" y="50"/>
                  </a:lnTo>
                  <a:lnTo>
                    <a:pt x="2882" y="47"/>
                  </a:lnTo>
                  <a:lnTo>
                    <a:pt x="2883" y="50"/>
                  </a:lnTo>
                  <a:lnTo>
                    <a:pt x="2884" y="48"/>
                  </a:lnTo>
                  <a:lnTo>
                    <a:pt x="2885" y="46"/>
                  </a:lnTo>
                  <a:lnTo>
                    <a:pt x="2886" y="48"/>
                  </a:lnTo>
                  <a:lnTo>
                    <a:pt x="2887" y="48"/>
                  </a:lnTo>
                  <a:lnTo>
                    <a:pt x="2887" y="47"/>
                  </a:lnTo>
                  <a:lnTo>
                    <a:pt x="2888" y="48"/>
                  </a:lnTo>
                  <a:lnTo>
                    <a:pt x="2889" y="45"/>
                  </a:lnTo>
                  <a:lnTo>
                    <a:pt x="2890" y="47"/>
                  </a:lnTo>
                  <a:lnTo>
                    <a:pt x="2891" y="47"/>
                  </a:lnTo>
                  <a:lnTo>
                    <a:pt x="2892" y="47"/>
                  </a:lnTo>
                  <a:lnTo>
                    <a:pt x="2893" y="49"/>
                  </a:lnTo>
                  <a:lnTo>
                    <a:pt x="2894" y="47"/>
                  </a:lnTo>
                  <a:lnTo>
                    <a:pt x="2894" y="47"/>
                  </a:lnTo>
                  <a:lnTo>
                    <a:pt x="2895" y="47"/>
                  </a:lnTo>
                  <a:lnTo>
                    <a:pt x="2896" y="47"/>
                  </a:lnTo>
                  <a:lnTo>
                    <a:pt x="2897" y="48"/>
                  </a:lnTo>
                  <a:lnTo>
                    <a:pt x="2898" y="47"/>
                  </a:lnTo>
                  <a:lnTo>
                    <a:pt x="2899" y="48"/>
                  </a:lnTo>
                  <a:lnTo>
                    <a:pt x="2900" y="46"/>
                  </a:lnTo>
                  <a:lnTo>
                    <a:pt x="2901" y="48"/>
                  </a:lnTo>
                  <a:lnTo>
                    <a:pt x="2902" y="48"/>
                  </a:lnTo>
                  <a:lnTo>
                    <a:pt x="2902" y="46"/>
                  </a:lnTo>
                  <a:lnTo>
                    <a:pt x="2903" y="46"/>
                  </a:lnTo>
                  <a:lnTo>
                    <a:pt x="2904" y="48"/>
                  </a:lnTo>
                  <a:lnTo>
                    <a:pt x="2905" y="47"/>
                  </a:lnTo>
                  <a:lnTo>
                    <a:pt x="2906" y="45"/>
                  </a:lnTo>
                  <a:lnTo>
                    <a:pt x="2907" y="47"/>
                  </a:lnTo>
                  <a:lnTo>
                    <a:pt x="2908" y="45"/>
                  </a:lnTo>
                  <a:lnTo>
                    <a:pt x="2909" y="48"/>
                  </a:lnTo>
                  <a:lnTo>
                    <a:pt x="2909" y="46"/>
                  </a:lnTo>
                  <a:lnTo>
                    <a:pt x="2910" y="49"/>
                  </a:lnTo>
                  <a:lnTo>
                    <a:pt x="2911" y="43"/>
                  </a:lnTo>
                  <a:lnTo>
                    <a:pt x="2912" y="46"/>
                  </a:lnTo>
                  <a:lnTo>
                    <a:pt x="2913" y="44"/>
                  </a:lnTo>
                  <a:lnTo>
                    <a:pt x="2914" y="45"/>
                  </a:lnTo>
                  <a:lnTo>
                    <a:pt x="2915" y="44"/>
                  </a:lnTo>
                  <a:lnTo>
                    <a:pt x="2916" y="46"/>
                  </a:lnTo>
                  <a:lnTo>
                    <a:pt x="2917" y="45"/>
                  </a:lnTo>
                  <a:lnTo>
                    <a:pt x="2917" y="45"/>
                  </a:lnTo>
                  <a:lnTo>
                    <a:pt x="2918" y="45"/>
                  </a:lnTo>
                  <a:lnTo>
                    <a:pt x="2919" y="46"/>
                  </a:lnTo>
                  <a:lnTo>
                    <a:pt x="2920" y="45"/>
                  </a:lnTo>
                  <a:lnTo>
                    <a:pt x="2921" y="45"/>
                  </a:lnTo>
                  <a:lnTo>
                    <a:pt x="2922" y="43"/>
                  </a:lnTo>
                  <a:lnTo>
                    <a:pt x="2923" y="43"/>
                  </a:lnTo>
                  <a:lnTo>
                    <a:pt x="2924" y="44"/>
                  </a:lnTo>
                  <a:lnTo>
                    <a:pt x="2924" y="43"/>
                  </a:lnTo>
                  <a:lnTo>
                    <a:pt x="2925" y="45"/>
                  </a:lnTo>
                  <a:lnTo>
                    <a:pt x="2926" y="46"/>
                  </a:lnTo>
                  <a:lnTo>
                    <a:pt x="2927" y="47"/>
                  </a:lnTo>
                  <a:lnTo>
                    <a:pt x="2928" y="43"/>
                  </a:lnTo>
                  <a:lnTo>
                    <a:pt x="2929" y="46"/>
                  </a:lnTo>
                  <a:lnTo>
                    <a:pt x="2930" y="47"/>
                  </a:lnTo>
                  <a:lnTo>
                    <a:pt x="2931" y="44"/>
                  </a:lnTo>
                  <a:lnTo>
                    <a:pt x="2932" y="47"/>
                  </a:lnTo>
                  <a:lnTo>
                    <a:pt x="2932" y="49"/>
                  </a:lnTo>
                  <a:lnTo>
                    <a:pt x="2933" y="48"/>
                  </a:lnTo>
                  <a:lnTo>
                    <a:pt x="2934" y="46"/>
                  </a:lnTo>
                  <a:lnTo>
                    <a:pt x="2935" y="46"/>
                  </a:lnTo>
                  <a:lnTo>
                    <a:pt x="2936" y="44"/>
                  </a:lnTo>
                  <a:lnTo>
                    <a:pt x="2937" y="42"/>
                  </a:lnTo>
                  <a:lnTo>
                    <a:pt x="2938" y="42"/>
                  </a:lnTo>
                  <a:lnTo>
                    <a:pt x="2939" y="44"/>
                  </a:lnTo>
                  <a:lnTo>
                    <a:pt x="2939" y="43"/>
                  </a:lnTo>
                  <a:lnTo>
                    <a:pt x="2940" y="43"/>
                  </a:lnTo>
                  <a:lnTo>
                    <a:pt x="2941" y="42"/>
                  </a:lnTo>
                  <a:lnTo>
                    <a:pt x="2942" y="45"/>
                  </a:lnTo>
                  <a:lnTo>
                    <a:pt x="2943" y="43"/>
                  </a:lnTo>
                  <a:lnTo>
                    <a:pt x="2944" y="44"/>
                  </a:lnTo>
                  <a:lnTo>
                    <a:pt x="2945" y="43"/>
                  </a:lnTo>
                  <a:lnTo>
                    <a:pt x="2946" y="44"/>
                  </a:lnTo>
                  <a:lnTo>
                    <a:pt x="2947" y="40"/>
                  </a:lnTo>
                  <a:lnTo>
                    <a:pt x="2947" y="44"/>
                  </a:lnTo>
                  <a:lnTo>
                    <a:pt x="2948" y="42"/>
                  </a:lnTo>
                  <a:lnTo>
                    <a:pt x="2949" y="42"/>
                  </a:lnTo>
                  <a:lnTo>
                    <a:pt x="2950" y="44"/>
                  </a:lnTo>
                  <a:lnTo>
                    <a:pt x="2951" y="43"/>
                  </a:lnTo>
                  <a:lnTo>
                    <a:pt x="2952" y="43"/>
                  </a:lnTo>
                  <a:lnTo>
                    <a:pt x="2953" y="42"/>
                  </a:lnTo>
                  <a:lnTo>
                    <a:pt x="2954" y="42"/>
                  </a:lnTo>
                  <a:lnTo>
                    <a:pt x="2954" y="43"/>
                  </a:lnTo>
                  <a:lnTo>
                    <a:pt x="2955" y="44"/>
                  </a:lnTo>
                  <a:lnTo>
                    <a:pt x="2956" y="43"/>
                  </a:lnTo>
                  <a:lnTo>
                    <a:pt x="2957" y="42"/>
                  </a:lnTo>
                  <a:lnTo>
                    <a:pt x="2958" y="43"/>
                  </a:lnTo>
                  <a:lnTo>
                    <a:pt x="2959" y="43"/>
                  </a:lnTo>
                  <a:lnTo>
                    <a:pt x="2960" y="41"/>
                  </a:lnTo>
                  <a:lnTo>
                    <a:pt x="2961" y="43"/>
                  </a:lnTo>
                  <a:lnTo>
                    <a:pt x="2962" y="44"/>
                  </a:lnTo>
                  <a:lnTo>
                    <a:pt x="2962" y="47"/>
                  </a:lnTo>
                  <a:lnTo>
                    <a:pt x="2963" y="50"/>
                  </a:lnTo>
                  <a:lnTo>
                    <a:pt x="2964" y="54"/>
                  </a:lnTo>
                  <a:lnTo>
                    <a:pt x="2965" y="59"/>
                  </a:lnTo>
                  <a:lnTo>
                    <a:pt x="2966" y="61"/>
                  </a:lnTo>
                  <a:lnTo>
                    <a:pt x="2967" y="74"/>
                  </a:lnTo>
                  <a:lnTo>
                    <a:pt x="2968" y="85"/>
                  </a:lnTo>
                  <a:lnTo>
                    <a:pt x="2969" y="97"/>
                  </a:lnTo>
                  <a:lnTo>
                    <a:pt x="2969" y="108"/>
                  </a:lnTo>
                  <a:lnTo>
                    <a:pt x="2970" y="117"/>
                  </a:lnTo>
                  <a:lnTo>
                    <a:pt x="2971" y="124"/>
                  </a:lnTo>
                  <a:lnTo>
                    <a:pt x="2972" y="132"/>
                  </a:lnTo>
                  <a:lnTo>
                    <a:pt x="2973" y="135"/>
                  </a:lnTo>
                  <a:lnTo>
                    <a:pt x="2974" y="132"/>
                  </a:lnTo>
                  <a:lnTo>
                    <a:pt x="2975" y="126"/>
                  </a:lnTo>
                  <a:lnTo>
                    <a:pt x="2976" y="116"/>
                  </a:lnTo>
                  <a:lnTo>
                    <a:pt x="2977" y="106"/>
                  </a:lnTo>
                  <a:lnTo>
                    <a:pt x="2977" y="96"/>
                  </a:lnTo>
                  <a:lnTo>
                    <a:pt x="2978" y="92"/>
                  </a:lnTo>
                  <a:lnTo>
                    <a:pt x="2979" y="90"/>
                  </a:lnTo>
                  <a:lnTo>
                    <a:pt x="2980" y="84"/>
                  </a:lnTo>
                  <a:lnTo>
                    <a:pt x="2981" y="80"/>
                  </a:lnTo>
                  <a:lnTo>
                    <a:pt x="2982" y="83"/>
                  </a:lnTo>
                  <a:lnTo>
                    <a:pt x="2983" y="86"/>
                  </a:lnTo>
                  <a:lnTo>
                    <a:pt x="2984" y="90"/>
                  </a:lnTo>
                  <a:lnTo>
                    <a:pt x="2984" y="93"/>
                  </a:lnTo>
                  <a:lnTo>
                    <a:pt x="2985" y="101"/>
                  </a:lnTo>
                  <a:lnTo>
                    <a:pt x="2986" y="107"/>
                  </a:lnTo>
                  <a:lnTo>
                    <a:pt x="2987" y="107"/>
                  </a:lnTo>
                  <a:lnTo>
                    <a:pt x="2988" y="113"/>
                  </a:lnTo>
                  <a:lnTo>
                    <a:pt x="2989" y="113"/>
                  </a:lnTo>
                  <a:lnTo>
                    <a:pt x="2990" y="117"/>
                  </a:lnTo>
                  <a:lnTo>
                    <a:pt x="2991" y="115"/>
                  </a:lnTo>
                  <a:lnTo>
                    <a:pt x="2992" y="112"/>
                  </a:lnTo>
                  <a:lnTo>
                    <a:pt x="2992" y="111"/>
                  </a:lnTo>
                  <a:lnTo>
                    <a:pt x="2993" y="107"/>
                  </a:lnTo>
                  <a:lnTo>
                    <a:pt x="2994" y="96"/>
                  </a:lnTo>
                  <a:lnTo>
                    <a:pt x="2995" y="94"/>
                  </a:lnTo>
                  <a:lnTo>
                    <a:pt x="2996" y="89"/>
                  </a:lnTo>
                  <a:lnTo>
                    <a:pt x="2997" y="86"/>
                  </a:lnTo>
                  <a:lnTo>
                    <a:pt x="2998" y="86"/>
                  </a:lnTo>
                  <a:lnTo>
                    <a:pt x="2999" y="80"/>
                  </a:lnTo>
                  <a:lnTo>
                    <a:pt x="2999" y="79"/>
                  </a:lnTo>
                  <a:lnTo>
                    <a:pt x="3000" y="81"/>
                  </a:lnTo>
                  <a:lnTo>
                    <a:pt x="3001" y="82"/>
                  </a:lnTo>
                  <a:lnTo>
                    <a:pt x="3002" y="87"/>
                  </a:lnTo>
                  <a:lnTo>
                    <a:pt x="3003" y="92"/>
                  </a:lnTo>
                  <a:lnTo>
                    <a:pt x="3004" y="99"/>
                  </a:lnTo>
                  <a:lnTo>
                    <a:pt x="3005" y="106"/>
                  </a:lnTo>
                  <a:lnTo>
                    <a:pt x="3006" y="115"/>
                  </a:lnTo>
                  <a:lnTo>
                    <a:pt x="3007" y="124"/>
                  </a:lnTo>
                  <a:lnTo>
                    <a:pt x="3007" y="130"/>
                  </a:lnTo>
                  <a:lnTo>
                    <a:pt x="3008" y="135"/>
                  </a:lnTo>
                  <a:lnTo>
                    <a:pt x="3009" y="136"/>
                  </a:lnTo>
                  <a:lnTo>
                    <a:pt x="3010" y="138"/>
                  </a:lnTo>
                  <a:lnTo>
                    <a:pt x="3011" y="136"/>
                  </a:lnTo>
                  <a:lnTo>
                    <a:pt x="3012" y="131"/>
                  </a:lnTo>
                  <a:lnTo>
                    <a:pt x="3013" y="125"/>
                  </a:lnTo>
                  <a:lnTo>
                    <a:pt x="3014" y="119"/>
                  </a:lnTo>
                  <a:lnTo>
                    <a:pt x="3014" y="110"/>
                  </a:lnTo>
                  <a:lnTo>
                    <a:pt x="3015" y="102"/>
                  </a:lnTo>
                  <a:lnTo>
                    <a:pt x="3016" y="98"/>
                  </a:lnTo>
                  <a:lnTo>
                    <a:pt x="3017" y="91"/>
                  </a:lnTo>
                  <a:lnTo>
                    <a:pt x="3018" y="88"/>
                  </a:lnTo>
                  <a:lnTo>
                    <a:pt x="3019" y="84"/>
                  </a:lnTo>
                  <a:lnTo>
                    <a:pt x="3020" y="83"/>
                  </a:lnTo>
                  <a:lnTo>
                    <a:pt x="3021" y="78"/>
                  </a:lnTo>
                  <a:lnTo>
                    <a:pt x="3022" y="75"/>
                  </a:lnTo>
                  <a:lnTo>
                    <a:pt x="3022" y="76"/>
                  </a:lnTo>
                  <a:lnTo>
                    <a:pt x="3023" y="76"/>
                  </a:lnTo>
                  <a:lnTo>
                    <a:pt x="3024" y="76"/>
                  </a:lnTo>
                  <a:lnTo>
                    <a:pt x="3025" y="73"/>
                  </a:lnTo>
                  <a:lnTo>
                    <a:pt x="3026" y="73"/>
                  </a:lnTo>
                  <a:lnTo>
                    <a:pt x="3027" y="73"/>
                  </a:lnTo>
                  <a:lnTo>
                    <a:pt x="3028" y="80"/>
                  </a:lnTo>
                  <a:lnTo>
                    <a:pt x="3029" y="80"/>
                  </a:lnTo>
                  <a:lnTo>
                    <a:pt x="3029" y="84"/>
                  </a:lnTo>
                  <a:lnTo>
                    <a:pt x="3030" y="89"/>
                  </a:lnTo>
                  <a:lnTo>
                    <a:pt x="3031" y="94"/>
                  </a:lnTo>
                  <a:lnTo>
                    <a:pt x="3032" y="101"/>
                  </a:lnTo>
                  <a:lnTo>
                    <a:pt x="3033" y="107"/>
                  </a:lnTo>
                  <a:lnTo>
                    <a:pt x="3034" y="112"/>
                  </a:lnTo>
                  <a:lnTo>
                    <a:pt x="3035" y="123"/>
                  </a:lnTo>
                  <a:lnTo>
                    <a:pt x="3036" y="127"/>
                  </a:lnTo>
                  <a:lnTo>
                    <a:pt x="3037" y="127"/>
                  </a:lnTo>
                  <a:lnTo>
                    <a:pt x="3037" y="138"/>
                  </a:lnTo>
                  <a:lnTo>
                    <a:pt x="3038" y="131"/>
                  </a:lnTo>
                  <a:lnTo>
                    <a:pt x="3039" y="129"/>
                  </a:lnTo>
                  <a:lnTo>
                    <a:pt x="3040" y="130"/>
                  </a:lnTo>
                  <a:lnTo>
                    <a:pt x="3041" y="126"/>
                  </a:lnTo>
                  <a:lnTo>
                    <a:pt x="3042" y="120"/>
                  </a:lnTo>
                  <a:lnTo>
                    <a:pt x="3043" y="111"/>
                  </a:lnTo>
                  <a:lnTo>
                    <a:pt x="3044" y="106"/>
                  </a:lnTo>
                  <a:lnTo>
                    <a:pt x="3044" y="100"/>
                  </a:lnTo>
                  <a:lnTo>
                    <a:pt x="3045" y="95"/>
                  </a:lnTo>
                  <a:lnTo>
                    <a:pt x="3046" y="94"/>
                  </a:lnTo>
                  <a:lnTo>
                    <a:pt x="3047" y="88"/>
                  </a:lnTo>
                  <a:lnTo>
                    <a:pt x="3048" y="88"/>
                  </a:lnTo>
                  <a:lnTo>
                    <a:pt x="3049" y="86"/>
                  </a:lnTo>
                  <a:lnTo>
                    <a:pt x="3050" y="80"/>
                  </a:lnTo>
                  <a:lnTo>
                    <a:pt x="3051" y="80"/>
                  </a:lnTo>
                  <a:lnTo>
                    <a:pt x="3052" y="76"/>
                  </a:lnTo>
                  <a:lnTo>
                    <a:pt x="3052" y="77"/>
                  </a:lnTo>
                  <a:lnTo>
                    <a:pt x="3053" y="75"/>
                  </a:lnTo>
                  <a:lnTo>
                    <a:pt x="3054" y="73"/>
                  </a:lnTo>
                  <a:lnTo>
                    <a:pt x="3055" y="73"/>
                  </a:lnTo>
                  <a:lnTo>
                    <a:pt x="3056" y="70"/>
                  </a:lnTo>
                  <a:lnTo>
                    <a:pt x="3057" y="71"/>
                  </a:lnTo>
                  <a:lnTo>
                    <a:pt x="3058" y="73"/>
                  </a:lnTo>
                  <a:lnTo>
                    <a:pt x="3059" y="70"/>
                  </a:lnTo>
                  <a:lnTo>
                    <a:pt x="3059" y="69"/>
                  </a:lnTo>
                  <a:lnTo>
                    <a:pt x="3060" y="68"/>
                  </a:lnTo>
                  <a:lnTo>
                    <a:pt x="3061" y="69"/>
                  </a:lnTo>
                  <a:lnTo>
                    <a:pt x="3062" y="68"/>
                  </a:lnTo>
                  <a:lnTo>
                    <a:pt x="3063" y="69"/>
                  </a:lnTo>
                  <a:lnTo>
                    <a:pt x="3064" y="67"/>
                  </a:lnTo>
                  <a:lnTo>
                    <a:pt x="3065" y="66"/>
                  </a:lnTo>
                  <a:lnTo>
                    <a:pt x="3066" y="69"/>
                  </a:lnTo>
                  <a:lnTo>
                    <a:pt x="3067" y="65"/>
                  </a:lnTo>
                  <a:lnTo>
                    <a:pt x="3067" y="64"/>
                  </a:lnTo>
                  <a:lnTo>
                    <a:pt x="3068" y="65"/>
                  </a:lnTo>
                  <a:lnTo>
                    <a:pt x="3069" y="63"/>
                  </a:lnTo>
                  <a:lnTo>
                    <a:pt x="3070" y="61"/>
                  </a:lnTo>
                  <a:lnTo>
                    <a:pt x="3071" y="65"/>
                  </a:lnTo>
                  <a:lnTo>
                    <a:pt x="3072" y="61"/>
                  </a:lnTo>
                  <a:lnTo>
                    <a:pt x="3073" y="60"/>
                  </a:lnTo>
                  <a:lnTo>
                    <a:pt x="3074" y="60"/>
                  </a:lnTo>
                  <a:lnTo>
                    <a:pt x="3074" y="59"/>
                  </a:lnTo>
                  <a:lnTo>
                    <a:pt x="3075" y="62"/>
                  </a:lnTo>
                  <a:lnTo>
                    <a:pt x="3076" y="60"/>
                  </a:lnTo>
                  <a:lnTo>
                    <a:pt x="3077" y="58"/>
                  </a:lnTo>
                  <a:lnTo>
                    <a:pt x="3078" y="55"/>
                  </a:lnTo>
                  <a:lnTo>
                    <a:pt x="3079" y="58"/>
                  </a:lnTo>
                  <a:lnTo>
                    <a:pt x="3080" y="58"/>
                  </a:lnTo>
                  <a:lnTo>
                    <a:pt x="3081" y="59"/>
                  </a:lnTo>
                  <a:lnTo>
                    <a:pt x="3081" y="58"/>
                  </a:lnTo>
                  <a:lnTo>
                    <a:pt x="3082" y="59"/>
                  </a:lnTo>
                  <a:lnTo>
                    <a:pt x="3083" y="60"/>
                  </a:lnTo>
                  <a:lnTo>
                    <a:pt x="3084" y="62"/>
                  </a:lnTo>
                  <a:lnTo>
                    <a:pt x="3085" y="63"/>
                  </a:lnTo>
                  <a:lnTo>
                    <a:pt x="3086" y="67"/>
                  </a:lnTo>
                  <a:lnTo>
                    <a:pt x="3087" y="74"/>
                  </a:lnTo>
                  <a:lnTo>
                    <a:pt x="3088" y="79"/>
                  </a:lnTo>
                  <a:lnTo>
                    <a:pt x="3089" y="86"/>
                  </a:lnTo>
                  <a:lnTo>
                    <a:pt x="3089" y="91"/>
                  </a:lnTo>
                  <a:lnTo>
                    <a:pt x="3090" y="97"/>
                  </a:lnTo>
                  <a:lnTo>
                    <a:pt x="3091" y="104"/>
                  </a:lnTo>
                  <a:lnTo>
                    <a:pt x="3092" y="108"/>
                  </a:lnTo>
                  <a:lnTo>
                    <a:pt x="3093" y="117"/>
                  </a:lnTo>
                  <a:lnTo>
                    <a:pt x="3094" y="119"/>
                  </a:lnTo>
                  <a:lnTo>
                    <a:pt x="3095" y="122"/>
                  </a:lnTo>
                  <a:lnTo>
                    <a:pt x="3096" y="124"/>
                  </a:lnTo>
                  <a:lnTo>
                    <a:pt x="3096" y="134"/>
                  </a:lnTo>
                  <a:lnTo>
                    <a:pt x="3097" y="132"/>
                  </a:lnTo>
                  <a:lnTo>
                    <a:pt x="3098" y="140"/>
                  </a:lnTo>
                  <a:lnTo>
                    <a:pt x="3099" y="147"/>
                  </a:lnTo>
                  <a:lnTo>
                    <a:pt x="3100" y="152"/>
                  </a:lnTo>
                  <a:lnTo>
                    <a:pt x="3101" y="159"/>
                  </a:lnTo>
                  <a:lnTo>
                    <a:pt x="3102" y="177"/>
                  </a:lnTo>
                  <a:lnTo>
                    <a:pt x="3103" y="192"/>
                  </a:lnTo>
                  <a:lnTo>
                    <a:pt x="3104" y="216"/>
                  </a:lnTo>
                  <a:lnTo>
                    <a:pt x="3104" y="250"/>
                  </a:lnTo>
                  <a:lnTo>
                    <a:pt x="3105" y="280"/>
                  </a:lnTo>
                  <a:lnTo>
                    <a:pt x="3106" y="320"/>
                  </a:lnTo>
                  <a:lnTo>
                    <a:pt x="3107" y="368"/>
                  </a:lnTo>
                  <a:lnTo>
                    <a:pt x="3108" y="424"/>
                  </a:lnTo>
                  <a:lnTo>
                    <a:pt x="3109" y="472"/>
                  </a:lnTo>
                  <a:lnTo>
                    <a:pt x="3110" y="540"/>
                  </a:lnTo>
                  <a:lnTo>
                    <a:pt x="3111" y="576"/>
                  </a:lnTo>
                  <a:lnTo>
                    <a:pt x="3111" y="628"/>
                  </a:lnTo>
                  <a:lnTo>
                    <a:pt x="3112" y="667"/>
                  </a:lnTo>
                  <a:lnTo>
                    <a:pt x="3113" y="700"/>
                  </a:lnTo>
                  <a:lnTo>
                    <a:pt x="3114" y="726"/>
                  </a:lnTo>
                  <a:lnTo>
                    <a:pt x="3115" y="724"/>
                  </a:lnTo>
                  <a:lnTo>
                    <a:pt x="3116" y="718"/>
                  </a:lnTo>
                  <a:lnTo>
                    <a:pt x="3117" y="669"/>
                  </a:lnTo>
                  <a:lnTo>
                    <a:pt x="3118" y="598"/>
                  </a:lnTo>
                  <a:lnTo>
                    <a:pt x="3119" y="518"/>
                  </a:lnTo>
                  <a:lnTo>
                    <a:pt x="3119" y="442"/>
                  </a:lnTo>
                  <a:lnTo>
                    <a:pt x="3120" y="380"/>
                  </a:lnTo>
                  <a:lnTo>
                    <a:pt x="3121" y="323"/>
                  </a:lnTo>
                  <a:lnTo>
                    <a:pt x="3122" y="279"/>
                  </a:lnTo>
                  <a:lnTo>
                    <a:pt x="3123" y="251"/>
                  </a:lnTo>
                  <a:lnTo>
                    <a:pt x="3124" y="231"/>
                  </a:lnTo>
                  <a:lnTo>
                    <a:pt x="3125" y="219"/>
                  </a:lnTo>
                  <a:lnTo>
                    <a:pt x="3126" y="209"/>
                  </a:lnTo>
                  <a:lnTo>
                    <a:pt x="3126" y="198"/>
                  </a:lnTo>
                  <a:lnTo>
                    <a:pt x="3127" y="189"/>
                  </a:lnTo>
                  <a:lnTo>
                    <a:pt x="3128" y="186"/>
                  </a:lnTo>
                  <a:lnTo>
                    <a:pt x="3129" y="179"/>
                  </a:lnTo>
                  <a:lnTo>
                    <a:pt x="3130" y="179"/>
                  </a:lnTo>
                  <a:lnTo>
                    <a:pt x="3131" y="172"/>
                  </a:lnTo>
                  <a:lnTo>
                    <a:pt x="3132" y="165"/>
                  </a:lnTo>
                  <a:lnTo>
                    <a:pt x="3133" y="161"/>
                  </a:lnTo>
                  <a:lnTo>
                    <a:pt x="3134" y="155"/>
                  </a:lnTo>
                  <a:lnTo>
                    <a:pt x="3134" y="149"/>
                  </a:lnTo>
                  <a:lnTo>
                    <a:pt x="3135" y="145"/>
                  </a:lnTo>
                  <a:lnTo>
                    <a:pt x="3136" y="136"/>
                  </a:lnTo>
                  <a:lnTo>
                    <a:pt x="3137" y="135"/>
                  </a:lnTo>
                  <a:lnTo>
                    <a:pt x="3138" y="127"/>
                  </a:lnTo>
                  <a:lnTo>
                    <a:pt x="3139" y="125"/>
                  </a:lnTo>
                  <a:lnTo>
                    <a:pt x="3140" y="122"/>
                  </a:lnTo>
                  <a:lnTo>
                    <a:pt x="3141" y="124"/>
                  </a:lnTo>
                  <a:lnTo>
                    <a:pt x="3141" y="115"/>
                  </a:lnTo>
                  <a:lnTo>
                    <a:pt x="3142" y="113"/>
                  </a:lnTo>
                  <a:lnTo>
                    <a:pt x="3143" y="112"/>
                  </a:lnTo>
                  <a:lnTo>
                    <a:pt x="3144" y="105"/>
                  </a:lnTo>
                  <a:lnTo>
                    <a:pt x="3145" y="108"/>
                  </a:lnTo>
                  <a:lnTo>
                    <a:pt x="3146" y="103"/>
                  </a:lnTo>
                  <a:lnTo>
                    <a:pt x="3147" y="103"/>
                  </a:lnTo>
                  <a:lnTo>
                    <a:pt x="3148" y="101"/>
                  </a:lnTo>
                  <a:lnTo>
                    <a:pt x="3149" y="102"/>
                  </a:lnTo>
                  <a:lnTo>
                    <a:pt x="3149" y="101"/>
                  </a:lnTo>
                  <a:lnTo>
                    <a:pt x="3150" y="103"/>
                  </a:lnTo>
                  <a:lnTo>
                    <a:pt x="3151" y="101"/>
                  </a:lnTo>
                  <a:lnTo>
                    <a:pt x="3152" y="97"/>
                  </a:lnTo>
                  <a:lnTo>
                    <a:pt x="3153" y="97"/>
                  </a:lnTo>
                  <a:lnTo>
                    <a:pt x="3154" y="99"/>
                  </a:lnTo>
                  <a:lnTo>
                    <a:pt x="3155" y="96"/>
                  </a:lnTo>
                  <a:lnTo>
                    <a:pt x="3156" y="96"/>
                  </a:lnTo>
                  <a:lnTo>
                    <a:pt x="3156" y="96"/>
                  </a:lnTo>
                  <a:lnTo>
                    <a:pt x="3157" y="91"/>
                  </a:lnTo>
                  <a:lnTo>
                    <a:pt x="3158" y="91"/>
                  </a:lnTo>
                  <a:lnTo>
                    <a:pt x="3159" y="91"/>
                  </a:lnTo>
                  <a:lnTo>
                    <a:pt x="3160" y="90"/>
                  </a:lnTo>
                  <a:lnTo>
                    <a:pt x="3161" y="88"/>
                  </a:lnTo>
                  <a:lnTo>
                    <a:pt x="3162" y="87"/>
                  </a:lnTo>
                  <a:lnTo>
                    <a:pt x="3163" y="89"/>
                  </a:lnTo>
                  <a:lnTo>
                    <a:pt x="3164" y="86"/>
                  </a:lnTo>
                  <a:lnTo>
                    <a:pt x="3164" y="89"/>
                  </a:lnTo>
                  <a:lnTo>
                    <a:pt x="3165" y="86"/>
                  </a:lnTo>
                  <a:lnTo>
                    <a:pt x="3166" y="83"/>
                  </a:lnTo>
                  <a:lnTo>
                    <a:pt x="3167" y="83"/>
                  </a:lnTo>
                  <a:lnTo>
                    <a:pt x="3168" y="85"/>
                  </a:lnTo>
                  <a:lnTo>
                    <a:pt x="3169" y="82"/>
                  </a:lnTo>
                  <a:lnTo>
                    <a:pt x="3170" y="80"/>
                  </a:lnTo>
                  <a:lnTo>
                    <a:pt x="3171" y="83"/>
                  </a:lnTo>
                  <a:lnTo>
                    <a:pt x="3171" y="80"/>
                  </a:lnTo>
                  <a:lnTo>
                    <a:pt x="3172" y="82"/>
                  </a:lnTo>
                  <a:lnTo>
                    <a:pt x="3173" y="83"/>
                  </a:lnTo>
                  <a:lnTo>
                    <a:pt x="3174" y="87"/>
                  </a:lnTo>
                  <a:lnTo>
                    <a:pt x="3175" y="89"/>
                  </a:lnTo>
                  <a:lnTo>
                    <a:pt x="3176" y="96"/>
                  </a:lnTo>
                  <a:lnTo>
                    <a:pt x="3177" y="105"/>
                  </a:lnTo>
                  <a:lnTo>
                    <a:pt x="3178" y="110"/>
                  </a:lnTo>
                  <a:lnTo>
                    <a:pt x="3179" y="120"/>
                  </a:lnTo>
                  <a:lnTo>
                    <a:pt x="3179" y="129"/>
                  </a:lnTo>
                  <a:lnTo>
                    <a:pt x="3180" y="139"/>
                  </a:lnTo>
                  <a:lnTo>
                    <a:pt x="3181" y="158"/>
                  </a:lnTo>
                  <a:lnTo>
                    <a:pt x="3182" y="175"/>
                  </a:lnTo>
                  <a:lnTo>
                    <a:pt x="3183" y="200"/>
                  </a:lnTo>
                  <a:lnTo>
                    <a:pt x="3184" y="223"/>
                  </a:lnTo>
                  <a:lnTo>
                    <a:pt x="3185" y="246"/>
                  </a:lnTo>
                  <a:lnTo>
                    <a:pt x="3186" y="273"/>
                  </a:lnTo>
                  <a:lnTo>
                    <a:pt x="3186" y="290"/>
                  </a:lnTo>
                  <a:lnTo>
                    <a:pt x="3187" y="305"/>
                  </a:lnTo>
                  <a:lnTo>
                    <a:pt x="3188" y="324"/>
                  </a:lnTo>
                  <a:lnTo>
                    <a:pt x="3189" y="333"/>
                  </a:lnTo>
                  <a:lnTo>
                    <a:pt x="3190" y="336"/>
                  </a:lnTo>
                  <a:lnTo>
                    <a:pt x="3191" y="325"/>
                  </a:lnTo>
                  <a:lnTo>
                    <a:pt x="3192" y="305"/>
                  </a:lnTo>
                  <a:lnTo>
                    <a:pt x="3193" y="277"/>
                  </a:lnTo>
                  <a:lnTo>
                    <a:pt x="3194" y="249"/>
                  </a:lnTo>
                  <a:lnTo>
                    <a:pt x="3194" y="219"/>
                  </a:lnTo>
                  <a:lnTo>
                    <a:pt x="3195" y="200"/>
                  </a:lnTo>
                  <a:lnTo>
                    <a:pt x="3196" y="184"/>
                  </a:lnTo>
                  <a:lnTo>
                    <a:pt x="3197" y="168"/>
                  </a:lnTo>
                  <a:lnTo>
                    <a:pt x="3198" y="154"/>
                  </a:lnTo>
                  <a:lnTo>
                    <a:pt x="3199" y="151"/>
                  </a:lnTo>
                  <a:lnTo>
                    <a:pt x="3200" y="143"/>
                  </a:lnTo>
                  <a:lnTo>
                    <a:pt x="3201" y="138"/>
                  </a:lnTo>
                  <a:lnTo>
                    <a:pt x="3201" y="127"/>
                  </a:lnTo>
                  <a:lnTo>
                    <a:pt x="3202" y="123"/>
                  </a:lnTo>
                  <a:lnTo>
                    <a:pt x="3203" y="120"/>
                  </a:lnTo>
                  <a:lnTo>
                    <a:pt x="3204" y="115"/>
                  </a:lnTo>
                  <a:lnTo>
                    <a:pt x="3205" y="114"/>
                  </a:lnTo>
                  <a:lnTo>
                    <a:pt x="3206" y="111"/>
                  </a:lnTo>
                  <a:lnTo>
                    <a:pt x="3207" y="106"/>
                  </a:lnTo>
                  <a:lnTo>
                    <a:pt x="3208" y="106"/>
                  </a:lnTo>
                  <a:lnTo>
                    <a:pt x="3209" y="103"/>
                  </a:lnTo>
                  <a:lnTo>
                    <a:pt x="3209" y="100"/>
                  </a:lnTo>
                  <a:lnTo>
                    <a:pt x="3210" y="100"/>
                  </a:lnTo>
                  <a:lnTo>
                    <a:pt x="3211" y="99"/>
                  </a:lnTo>
                  <a:lnTo>
                    <a:pt x="3212" y="95"/>
                  </a:lnTo>
                  <a:lnTo>
                    <a:pt x="3213" y="95"/>
                  </a:lnTo>
                  <a:lnTo>
                    <a:pt x="3214" y="93"/>
                  </a:lnTo>
                  <a:lnTo>
                    <a:pt x="3215" y="91"/>
                  </a:lnTo>
                  <a:lnTo>
                    <a:pt x="3216" y="88"/>
                  </a:lnTo>
                  <a:lnTo>
                    <a:pt x="3216" y="85"/>
                  </a:lnTo>
                  <a:lnTo>
                    <a:pt x="3217" y="88"/>
                  </a:lnTo>
                  <a:lnTo>
                    <a:pt x="3218" y="85"/>
                  </a:lnTo>
                  <a:lnTo>
                    <a:pt x="3219" y="86"/>
                  </a:lnTo>
                  <a:lnTo>
                    <a:pt x="3220" y="81"/>
                  </a:lnTo>
                  <a:lnTo>
                    <a:pt x="3221" y="83"/>
                  </a:lnTo>
                  <a:lnTo>
                    <a:pt x="3222" y="79"/>
                  </a:lnTo>
                  <a:lnTo>
                    <a:pt x="3223" y="82"/>
                  </a:lnTo>
                  <a:lnTo>
                    <a:pt x="3224" y="79"/>
                  </a:lnTo>
                  <a:lnTo>
                    <a:pt x="3224" y="80"/>
                  </a:lnTo>
                  <a:lnTo>
                    <a:pt x="3225" y="78"/>
                  </a:lnTo>
                  <a:lnTo>
                    <a:pt x="3226" y="76"/>
                  </a:lnTo>
                  <a:lnTo>
                    <a:pt x="3227" y="79"/>
                  </a:lnTo>
                  <a:lnTo>
                    <a:pt x="3228" y="76"/>
                  </a:lnTo>
                  <a:lnTo>
                    <a:pt x="3229" y="75"/>
                  </a:lnTo>
                  <a:lnTo>
                    <a:pt x="3230" y="75"/>
                  </a:lnTo>
                  <a:lnTo>
                    <a:pt x="3231" y="72"/>
                  </a:lnTo>
                  <a:lnTo>
                    <a:pt x="3231" y="74"/>
                  </a:lnTo>
                  <a:lnTo>
                    <a:pt x="3232" y="73"/>
                  </a:lnTo>
                  <a:lnTo>
                    <a:pt x="3233" y="74"/>
                  </a:lnTo>
                  <a:lnTo>
                    <a:pt x="3234" y="69"/>
                  </a:lnTo>
                  <a:lnTo>
                    <a:pt x="3235" y="72"/>
                  </a:lnTo>
                  <a:lnTo>
                    <a:pt x="3236" y="70"/>
                  </a:lnTo>
                  <a:lnTo>
                    <a:pt x="3237" y="70"/>
                  </a:lnTo>
                  <a:lnTo>
                    <a:pt x="3238" y="72"/>
                  </a:lnTo>
                  <a:lnTo>
                    <a:pt x="3239" y="72"/>
                  </a:lnTo>
                  <a:lnTo>
                    <a:pt x="3239" y="72"/>
                  </a:lnTo>
                  <a:lnTo>
                    <a:pt x="3240" y="68"/>
                  </a:lnTo>
                  <a:lnTo>
                    <a:pt x="3241" y="69"/>
                  </a:lnTo>
                  <a:lnTo>
                    <a:pt x="3242" y="69"/>
                  </a:lnTo>
                  <a:lnTo>
                    <a:pt x="3243" y="71"/>
                  </a:lnTo>
                  <a:lnTo>
                    <a:pt x="3244" y="66"/>
                  </a:lnTo>
                  <a:lnTo>
                    <a:pt x="3245" y="67"/>
                  </a:lnTo>
                  <a:lnTo>
                    <a:pt x="3246" y="66"/>
                  </a:lnTo>
                  <a:lnTo>
                    <a:pt x="3246" y="65"/>
                  </a:lnTo>
                  <a:lnTo>
                    <a:pt x="3247" y="67"/>
                  </a:lnTo>
                  <a:lnTo>
                    <a:pt x="3248" y="69"/>
                  </a:lnTo>
                  <a:lnTo>
                    <a:pt x="3249" y="67"/>
                  </a:lnTo>
                  <a:lnTo>
                    <a:pt x="3250" y="66"/>
                  </a:lnTo>
                  <a:lnTo>
                    <a:pt x="3251" y="65"/>
                  </a:lnTo>
                  <a:lnTo>
                    <a:pt x="3252" y="65"/>
                  </a:lnTo>
                  <a:lnTo>
                    <a:pt x="3253" y="66"/>
                  </a:lnTo>
                  <a:lnTo>
                    <a:pt x="3254" y="61"/>
                  </a:lnTo>
                  <a:lnTo>
                    <a:pt x="3254" y="66"/>
                  </a:lnTo>
                  <a:lnTo>
                    <a:pt x="3255" y="66"/>
                  </a:lnTo>
                  <a:lnTo>
                    <a:pt x="3256" y="65"/>
                  </a:lnTo>
                  <a:lnTo>
                    <a:pt x="3257" y="62"/>
                  </a:lnTo>
                  <a:lnTo>
                    <a:pt x="3258" y="63"/>
                  </a:lnTo>
                  <a:lnTo>
                    <a:pt x="3259" y="63"/>
                  </a:lnTo>
                  <a:lnTo>
                    <a:pt x="3260" y="64"/>
                  </a:lnTo>
                  <a:lnTo>
                    <a:pt x="3261" y="61"/>
                  </a:lnTo>
                  <a:lnTo>
                    <a:pt x="3261" y="60"/>
                  </a:lnTo>
                  <a:lnTo>
                    <a:pt x="3262" y="61"/>
                  </a:lnTo>
                  <a:lnTo>
                    <a:pt x="3263" y="63"/>
                  </a:lnTo>
                  <a:lnTo>
                    <a:pt x="3264" y="61"/>
                  </a:lnTo>
                  <a:lnTo>
                    <a:pt x="3265" y="62"/>
                  </a:lnTo>
                  <a:lnTo>
                    <a:pt x="3266" y="63"/>
                  </a:lnTo>
                  <a:lnTo>
                    <a:pt x="3267" y="54"/>
                  </a:lnTo>
                  <a:lnTo>
                    <a:pt x="3268" y="58"/>
                  </a:lnTo>
                  <a:lnTo>
                    <a:pt x="3268" y="59"/>
                  </a:lnTo>
                  <a:lnTo>
                    <a:pt x="3269" y="57"/>
                  </a:lnTo>
                  <a:lnTo>
                    <a:pt x="3270" y="57"/>
                  </a:lnTo>
                  <a:lnTo>
                    <a:pt x="3271" y="56"/>
                  </a:lnTo>
                  <a:lnTo>
                    <a:pt x="3272" y="58"/>
                  </a:lnTo>
                  <a:lnTo>
                    <a:pt x="3273" y="57"/>
                  </a:lnTo>
                  <a:lnTo>
                    <a:pt x="3274" y="57"/>
                  </a:lnTo>
                  <a:lnTo>
                    <a:pt x="3275" y="60"/>
                  </a:lnTo>
                  <a:lnTo>
                    <a:pt x="3276" y="59"/>
                  </a:lnTo>
                  <a:lnTo>
                    <a:pt x="3276" y="59"/>
                  </a:lnTo>
                  <a:lnTo>
                    <a:pt x="3277" y="59"/>
                  </a:lnTo>
                  <a:lnTo>
                    <a:pt x="3278" y="62"/>
                  </a:lnTo>
                  <a:lnTo>
                    <a:pt x="3279" y="60"/>
                  </a:lnTo>
                  <a:lnTo>
                    <a:pt x="3280" y="62"/>
                  </a:lnTo>
                  <a:lnTo>
                    <a:pt x="3281" y="62"/>
                  </a:lnTo>
                  <a:lnTo>
                    <a:pt x="3282" y="63"/>
                  </a:lnTo>
                  <a:lnTo>
                    <a:pt x="3283" y="62"/>
                  </a:lnTo>
                  <a:lnTo>
                    <a:pt x="3283" y="63"/>
                  </a:lnTo>
                  <a:lnTo>
                    <a:pt x="3284" y="60"/>
                  </a:lnTo>
                  <a:lnTo>
                    <a:pt x="3285" y="62"/>
                  </a:lnTo>
                  <a:lnTo>
                    <a:pt x="3286" y="61"/>
                  </a:lnTo>
                  <a:lnTo>
                    <a:pt x="3287" y="61"/>
                  </a:lnTo>
                  <a:lnTo>
                    <a:pt x="3288" y="62"/>
                  </a:lnTo>
                  <a:lnTo>
                    <a:pt x="3289" y="59"/>
                  </a:lnTo>
                  <a:lnTo>
                    <a:pt x="3290" y="59"/>
                  </a:lnTo>
                  <a:lnTo>
                    <a:pt x="3291" y="58"/>
                  </a:lnTo>
                  <a:lnTo>
                    <a:pt x="3291" y="59"/>
                  </a:lnTo>
                  <a:lnTo>
                    <a:pt x="3292" y="57"/>
                  </a:lnTo>
                  <a:lnTo>
                    <a:pt x="3293" y="57"/>
                  </a:lnTo>
                  <a:lnTo>
                    <a:pt x="3294" y="55"/>
                  </a:lnTo>
                  <a:lnTo>
                    <a:pt x="3295" y="55"/>
                  </a:lnTo>
                  <a:lnTo>
                    <a:pt x="3296" y="59"/>
                  </a:lnTo>
                  <a:lnTo>
                    <a:pt x="3297" y="60"/>
                  </a:lnTo>
                  <a:lnTo>
                    <a:pt x="3298" y="62"/>
                  </a:lnTo>
                  <a:lnTo>
                    <a:pt x="3298" y="66"/>
                  </a:lnTo>
                  <a:lnTo>
                    <a:pt x="3299" y="66"/>
                  </a:lnTo>
                  <a:lnTo>
                    <a:pt x="3300" y="67"/>
                  </a:lnTo>
                  <a:lnTo>
                    <a:pt x="3301" y="71"/>
                  </a:lnTo>
                  <a:lnTo>
                    <a:pt x="3302" y="70"/>
                  </a:lnTo>
                  <a:lnTo>
                    <a:pt x="3303" y="72"/>
                  </a:lnTo>
                  <a:lnTo>
                    <a:pt x="3304" y="75"/>
                  </a:lnTo>
                  <a:lnTo>
                    <a:pt x="3305" y="72"/>
                  </a:lnTo>
                  <a:lnTo>
                    <a:pt x="3306" y="68"/>
                  </a:lnTo>
                  <a:lnTo>
                    <a:pt x="3306" y="64"/>
                  </a:lnTo>
                  <a:lnTo>
                    <a:pt x="3307" y="63"/>
                  </a:lnTo>
                  <a:lnTo>
                    <a:pt x="3308" y="62"/>
                  </a:lnTo>
                  <a:lnTo>
                    <a:pt x="3309" y="57"/>
                  </a:lnTo>
                  <a:lnTo>
                    <a:pt x="3310" y="54"/>
                  </a:lnTo>
                  <a:lnTo>
                    <a:pt x="3311" y="53"/>
                  </a:lnTo>
                  <a:lnTo>
                    <a:pt x="3312" y="54"/>
                  </a:lnTo>
                  <a:lnTo>
                    <a:pt x="3313" y="55"/>
                  </a:lnTo>
                  <a:lnTo>
                    <a:pt x="3313" y="50"/>
                  </a:lnTo>
                  <a:lnTo>
                    <a:pt x="3314" y="52"/>
                  </a:lnTo>
                  <a:lnTo>
                    <a:pt x="3315" y="51"/>
                  </a:lnTo>
                  <a:lnTo>
                    <a:pt x="3316" y="49"/>
                  </a:lnTo>
                  <a:lnTo>
                    <a:pt x="3317" y="50"/>
                  </a:lnTo>
                  <a:lnTo>
                    <a:pt x="3318" y="49"/>
                  </a:lnTo>
                  <a:lnTo>
                    <a:pt x="3319" y="48"/>
                  </a:lnTo>
                  <a:lnTo>
                    <a:pt x="3320" y="51"/>
                  </a:lnTo>
                  <a:lnTo>
                    <a:pt x="3321" y="51"/>
                  </a:lnTo>
                  <a:lnTo>
                    <a:pt x="3321" y="48"/>
                  </a:lnTo>
                  <a:lnTo>
                    <a:pt x="3322" y="50"/>
                  </a:lnTo>
                  <a:lnTo>
                    <a:pt x="3323" y="51"/>
                  </a:lnTo>
                  <a:lnTo>
                    <a:pt x="3324" y="48"/>
                  </a:lnTo>
                  <a:lnTo>
                    <a:pt x="3325" y="49"/>
                  </a:lnTo>
                  <a:lnTo>
                    <a:pt x="3326" y="47"/>
                  </a:lnTo>
                  <a:lnTo>
                    <a:pt x="3327" y="50"/>
                  </a:lnTo>
                  <a:lnTo>
                    <a:pt x="3328" y="50"/>
                  </a:lnTo>
                  <a:lnTo>
                    <a:pt x="3328" y="50"/>
                  </a:lnTo>
                  <a:lnTo>
                    <a:pt x="3329" y="49"/>
                  </a:lnTo>
                  <a:lnTo>
                    <a:pt x="3330" y="50"/>
                  </a:lnTo>
                  <a:lnTo>
                    <a:pt x="3331" y="47"/>
                  </a:lnTo>
                  <a:lnTo>
                    <a:pt x="3332" y="47"/>
                  </a:lnTo>
                  <a:lnTo>
                    <a:pt x="3333" y="47"/>
                  </a:lnTo>
                  <a:lnTo>
                    <a:pt x="3334" y="46"/>
                  </a:lnTo>
                  <a:lnTo>
                    <a:pt x="3335" y="49"/>
                  </a:lnTo>
                  <a:lnTo>
                    <a:pt x="3336" y="48"/>
                  </a:lnTo>
                  <a:lnTo>
                    <a:pt x="3336" y="48"/>
                  </a:lnTo>
                  <a:lnTo>
                    <a:pt x="3337" y="49"/>
                  </a:lnTo>
                  <a:lnTo>
                    <a:pt x="3338" y="47"/>
                  </a:lnTo>
                  <a:lnTo>
                    <a:pt x="3339" y="47"/>
                  </a:lnTo>
                  <a:lnTo>
                    <a:pt x="3340" y="45"/>
                  </a:lnTo>
                  <a:lnTo>
                    <a:pt x="3341" y="48"/>
                  </a:lnTo>
                  <a:lnTo>
                    <a:pt x="3342" y="45"/>
                  </a:lnTo>
                  <a:lnTo>
                    <a:pt x="3343" y="44"/>
                  </a:lnTo>
                  <a:lnTo>
                    <a:pt x="3343" y="45"/>
                  </a:lnTo>
                  <a:lnTo>
                    <a:pt x="3344" y="43"/>
                  </a:lnTo>
                  <a:lnTo>
                    <a:pt x="3345" y="45"/>
                  </a:lnTo>
                  <a:lnTo>
                    <a:pt x="3346" y="45"/>
                  </a:lnTo>
                  <a:lnTo>
                    <a:pt x="3347" y="45"/>
                  </a:lnTo>
                  <a:lnTo>
                    <a:pt x="3348" y="46"/>
                  </a:lnTo>
                  <a:lnTo>
                    <a:pt x="3349" y="42"/>
                  </a:lnTo>
                  <a:lnTo>
                    <a:pt x="3350" y="45"/>
                  </a:lnTo>
                  <a:lnTo>
                    <a:pt x="3351" y="44"/>
                  </a:lnTo>
                  <a:lnTo>
                    <a:pt x="3351" y="45"/>
                  </a:lnTo>
                  <a:lnTo>
                    <a:pt x="3352" y="45"/>
                  </a:lnTo>
                  <a:lnTo>
                    <a:pt x="3353" y="46"/>
                  </a:lnTo>
                  <a:lnTo>
                    <a:pt x="3354" y="44"/>
                  </a:lnTo>
                  <a:lnTo>
                    <a:pt x="3355" y="46"/>
                  </a:lnTo>
                  <a:lnTo>
                    <a:pt x="3356" y="44"/>
                  </a:lnTo>
                  <a:lnTo>
                    <a:pt x="3357" y="43"/>
                  </a:lnTo>
                  <a:lnTo>
                    <a:pt x="3358" y="45"/>
                  </a:lnTo>
                  <a:lnTo>
                    <a:pt x="3358" y="43"/>
                  </a:lnTo>
                  <a:lnTo>
                    <a:pt x="3359" y="42"/>
                  </a:lnTo>
                  <a:lnTo>
                    <a:pt x="3360" y="44"/>
                  </a:lnTo>
                  <a:lnTo>
                    <a:pt x="3361" y="41"/>
                  </a:lnTo>
                  <a:lnTo>
                    <a:pt x="3362" y="42"/>
                  </a:lnTo>
                  <a:lnTo>
                    <a:pt x="3363" y="43"/>
                  </a:lnTo>
                  <a:lnTo>
                    <a:pt x="3364" y="44"/>
                  </a:lnTo>
                  <a:lnTo>
                    <a:pt x="3365" y="45"/>
                  </a:lnTo>
                  <a:lnTo>
                    <a:pt x="3366" y="43"/>
                  </a:lnTo>
                  <a:lnTo>
                    <a:pt x="3366" y="41"/>
                  </a:lnTo>
                  <a:lnTo>
                    <a:pt x="3367" y="44"/>
                  </a:lnTo>
                  <a:lnTo>
                    <a:pt x="3368" y="44"/>
                  </a:lnTo>
                  <a:lnTo>
                    <a:pt x="3369" y="44"/>
                  </a:lnTo>
                  <a:lnTo>
                    <a:pt x="3370" y="43"/>
                  </a:lnTo>
                  <a:lnTo>
                    <a:pt x="3371" y="44"/>
                  </a:lnTo>
                  <a:lnTo>
                    <a:pt x="3372" y="43"/>
                  </a:lnTo>
                  <a:lnTo>
                    <a:pt x="3373" y="42"/>
                  </a:lnTo>
                  <a:lnTo>
                    <a:pt x="3373" y="40"/>
                  </a:lnTo>
                  <a:lnTo>
                    <a:pt x="3374" y="41"/>
                  </a:lnTo>
                  <a:lnTo>
                    <a:pt x="3375" y="43"/>
                  </a:lnTo>
                  <a:lnTo>
                    <a:pt x="3376" y="42"/>
                  </a:lnTo>
                  <a:lnTo>
                    <a:pt x="3377" y="46"/>
                  </a:lnTo>
                  <a:lnTo>
                    <a:pt x="3378" y="46"/>
                  </a:lnTo>
                  <a:lnTo>
                    <a:pt x="3379" y="41"/>
                  </a:lnTo>
                  <a:lnTo>
                    <a:pt x="3380" y="44"/>
                  </a:lnTo>
                  <a:lnTo>
                    <a:pt x="3381" y="42"/>
                  </a:lnTo>
                  <a:lnTo>
                    <a:pt x="3381" y="43"/>
                  </a:lnTo>
                  <a:lnTo>
                    <a:pt x="3382" y="43"/>
                  </a:lnTo>
                  <a:lnTo>
                    <a:pt x="3383" y="41"/>
                  </a:lnTo>
                  <a:lnTo>
                    <a:pt x="3384" y="43"/>
                  </a:lnTo>
                  <a:lnTo>
                    <a:pt x="3385" y="46"/>
                  </a:lnTo>
                  <a:lnTo>
                    <a:pt x="3386" y="40"/>
                  </a:lnTo>
                </a:path>
              </a:pathLst>
            </a:custGeom>
            <a:noFill/>
            <a:ln w="0">
              <a:solidFill>
                <a:srgbClr val="7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Freeform 181"/>
            <p:cNvSpPr>
              <a:spLocks/>
            </p:cNvSpPr>
            <p:nvPr/>
          </p:nvSpPr>
          <p:spPr bwMode="auto">
            <a:xfrm flipV="1">
              <a:off x="5865814" y="3479800"/>
              <a:ext cx="520700" cy="55563"/>
            </a:xfrm>
            <a:custGeom>
              <a:avLst/>
              <a:gdLst>
                <a:gd name="T0" fmla="*/ 12 w 789"/>
                <a:gd name="T1" fmla="*/ 21 h 71"/>
                <a:gd name="T2" fmla="*/ 25 w 789"/>
                <a:gd name="T3" fmla="*/ 21 h 71"/>
                <a:gd name="T4" fmla="*/ 39 w 789"/>
                <a:gd name="T5" fmla="*/ 17 h 71"/>
                <a:gd name="T6" fmla="*/ 52 w 789"/>
                <a:gd name="T7" fmla="*/ 16 h 71"/>
                <a:gd name="T8" fmla="*/ 65 w 789"/>
                <a:gd name="T9" fmla="*/ 13 h 71"/>
                <a:gd name="T10" fmla="*/ 78 w 789"/>
                <a:gd name="T11" fmla="*/ 15 h 71"/>
                <a:gd name="T12" fmla="*/ 92 w 789"/>
                <a:gd name="T13" fmla="*/ 15 h 71"/>
                <a:gd name="T14" fmla="*/ 105 w 789"/>
                <a:gd name="T15" fmla="*/ 13 h 71"/>
                <a:gd name="T16" fmla="*/ 118 w 789"/>
                <a:gd name="T17" fmla="*/ 13 h 71"/>
                <a:gd name="T18" fmla="*/ 131 w 789"/>
                <a:gd name="T19" fmla="*/ 10 h 71"/>
                <a:gd name="T20" fmla="*/ 144 w 789"/>
                <a:gd name="T21" fmla="*/ 12 h 71"/>
                <a:gd name="T22" fmla="*/ 158 w 789"/>
                <a:gd name="T23" fmla="*/ 9 h 71"/>
                <a:gd name="T24" fmla="*/ 171 w 789"/>
                <a:gd name="T25" fmla="*/ 11 h 71"/>
                <a:gd name="T26" fmla="*/ 184 w 789"/>
                <a:gd name="T27" fmla="*/ 8 h 71"/>
                <a:gd name="T28" fmla="*/ 197 w 789"/>
                <a:gd name="T29" fmla="*/ 10 h 71"/>
                <a:gd name="T30" fmla="*/ 211 w 789"/>
                <a:gd name="T31" fmla="*/ 8 h 71"/>
                <a:gd name="T32" fmla="*/ 224 w 789"/>
                <a:gd name="T33" fmla="*/ 15 h 71"/>
                <a:gd name="T34" fmla="*/ 237 w 789"/>
                <a:gd name="T35" fmla="*/ 7 h 71"/>
                <a:gd name="T36" fmla="*/ 250 w 789"/>
                <a:gd name="T37" fmla="*/ 7 h 71"/>
                <a:gd name="T38" fmla="*/ 264 w 789"/>
                <a:gd name="T39" fmla="*/ 5 h 71"/>
                <a:gd name="T40" fmla="*/ 277 w 789"/>
                <a:gd name="T41" fmla="*/ 6 h 71"/>
                <a:gd name="T42" fmla="*/ 290 w 789"/>
                <a:gd name="T43" fmla="*/ 5 h 71"/>
                <a:gd name="T44" fmla="*/ 303 w 789"/>
                <a:gd name="T45" fmla="*/ 9 h 71"/>
                <a:gd name="T46" fmla="*/ 316 w 789"/>
                <a:gd name="T47" fmla="*/ 9 h 71"/>
                <a:gd name="T48" fmla="*/ 330 w 789"/>
                <a:gd name="T49" fmla="*/ 13 h 71"/>
                <a:gd name="T50" fmla="*/ 343 w 789"/>
                <a:gd name="T51" fmla="*/ 58 h 71"/>
                <a:gd name="T52" fmla="*/ 356 w 789"/>
                <a:gd name="T53" fmla="*/ 41 h 71"/>
                <a:gd name="T54" fmla="*/ 369 w 789"/>
                <a:gd name="T55" fmla="*/ 31 h 71"/>
                <a:gd name="T56" fmla="*/ 383 w 789"/>
                <a:gd name="T57" fmla="*/ 26 h 71"/>
                <a:gd name="T58" fmla="*/ 396 w 789"/>
                <a:gd name="T59" fmla="*/ 20 h 71"/>
                <a:gd name="T60" fmla="*/ 409 w 789"/>
                <a:gd name="T61" fmla="*/ 17 h 71"/>
                <a:gd name="T62" fmla="*/ 422 w 789"/>
                <a:gd name="T63" fmla="*/ 18 h 71"/>
                <a:gd name="T64" fmla="*/ 436 w 789"/>
                <a:gd name="T65" fmla="*/ 14 h 71"/>
                <a:gd name="T66" fmla="*/ 449 w 789"/>
                <a:gd name="T67" fmla="*/ 16 h 71"/>
                <a:gd name="T68" fmla="*/ 462 w 789"/>
                <a:gd name="T69" fmla="*/ 12 h 71"/>
                <a:gd name="T70" fmla="*/ 475 w 789"/>
                <a:gd name="T71" fmla="*/ 12 h 71"/>
                <a:gd name="T72" fmla="*/ 488 w 789"/>
                <a:gd name="T73" fmla="*/ 11 h 71"/>
                <a:gd name="T74" fmla="*/ 502 w 789"/>
                <a:gd name="T75" fmla="*/ 9 h 71"/>
                <a:gd name="T76" fmla="*/ 515 w 789"/>
                <a:gd name="T77" fmla="*/ 10 h 71"/>
                <a:gd name="T78" fmla="*/ 528 w 789"/>
                <a:gd name="T79" fmla="*/ 10 h 71"/>
                <a:gd name="T80" fmla="*/ 541 w 789"/>
                <a:gd name="T81" fmla="*/ 10 h 71"/>
                <a:gd name="T82" fmla="*/ 555 w 789"/>
                <a:gd name="T83" fmla="*/ 9 h 71"/>
                <a:gd name="T84" fmla="*/ 568 w 789"/>
                <a:gd name="T85" fmla="*/ 7 h 71"/>
                <a:gd name="T86" fmla="*/ 581 w 789"/>
                <a:gd name="T87" fmla="*/ 4 h 71"/>
                <a:gd name="T88" fmla="*/ 594 w 789"/>
                <a:gd name="T89" fmla="*/ 5 h 71"/>
                <a:gd name="T90" fmla="*/ 608 w 789"/>
                <a:gd name="T91" fmla="*/ 7 h 71"/>
                <a:gd name="T92" fmla="*/ 621 w 789"/>
                <a:gd name="T93" fmla="*/ 5 h 71"/>
                <a:gd name="T94" fmla="*/ 634 w 789"/>
                <a:gd name="T95" fmla="*/ 5 h 71"/>
                <a:gd name="T96" fmla="*/ 647 w 789"/>
                <a:gd name="T97" fmla="*/ 5 h 71"/>
                <a:gd name="T98" fmla="*/ 661 w 789"/>
                <a:gd name="T99" fmla="*/ 4 h 71"/>
                <a:gd name="T100" fmla="*/ 674 w 789"/>
                <a:gd name="T101" fmla="*/ 5 h 71"/>
                <a:gd name="T102" fmla="*/ 687 w 789"/>
                <a:gd name="T103" fmla="*/ 3 h 71"/>
                <a:gd name="T104" fmla="*/ 700 w 789"/>
                <a:gd name="T105" fmla="*/ 4 h 71"/>
                <a:gd name="T106" fmla="*/ 713 w 789"/>
                <a:gd name="T107" fmla="*/ 1 h 71"/>
                <a:gd name="T108" fmla="*/ 727 w 789"/>
                <a:gd name="T109" fmla="*/ 3 h 71"/>
                <a:gd name="T110" fmla="*/ 740 w 789"/>
                <a:gd name="T111" fmla="*/ 3 h 71"/>
                <a:gd name="T112" fmla="*/ 753 w 789"/>
                <a:gd name="T113" fmla="*/ 3 h 71"/>
                <a:gd name="T114" fmla="*/ 766 w 789"/>
                <a:gd name="T115" fmla="*/ 2 h 71"/>
                <a:gd name="T116" fmla="*/ 780 w 789"/>
                <a:gd name="T117" fmla="*/ 2 h 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789" h="71">
                  <a:moveTo>
                    <a:pt x="0" y="20"/>
                  </a:moveTo>
                  <a:lnTo>
                    <a:pt x="1" y="23"/>
                  </a:lnTo>
                  <a:lnTo>
                    <a:pt x="2" y="21"/>
                  </a:lnTo>
                  <a:lnTo>
                    <a:pt x="2" y="24"/>
                  </a:lnTo>
                  <a:lnTo>
                    <a:pt x="3" y="21"/>
                  </a:lnTo>
                  <a:lnTo>
                    <a:pt x="4" y="23"/>
                  </a:lnTo>
                  <a:lnTo>
                    <a:pt x="5" y="20"/>
                  </a:lnTo>
                  <a:lnTo>
                    <a:pt x="6" y="21"/>
                  </a:lnTo>
                  <a:lnTo>
                    <a:pt x="7" y="20"/>
                  </a:lnTo>
                  <a:lnTo>
                    <a:pt x="8" y="22"/>
                  </a:lnTo>
                  <a:lnTo>
                    <a:pt x="9" y="20"/>
                  </a:lnTo>
                  <a:lnTo>
                    <a:pt x="10" y="20"/>
                  </a:lnTo>
                  <a:lnTo>
                    <a:pt x="10" y="20"/>
                  </a:lnTo>
                  <a:lnTo>
                    <a:pt x="11" y="20"/>
                  </a:lnTo>
                  <a:lnTo>
                    <a:pt x="12" y="21"/>
                  </a:lnTo>
                  <a:lnTo>
                    <a:pt x="13" y="19"/>
                  </a:lnTo>
                  <a:lnTo>
                    <a:pt x="14" y="22"/>
                  </a:lnTo>
                  <a:lnTo>
                    <a:pt x="15" y="19"/>
                  </a:lnTo>
                  <a:lnTo>
                    <a:pt x="16" y="22"/>
                  </a:lnTo>
                  <a:lnTo>
                    <a:pt x="17" y="20"/>
                  </a:lnTo>
                  <a:lnTo>
                    <a:pt x="17" y="20"/>
                  </a:lnTo>
                  <a:lnTo>
                    <a:pt x="18" y="20"/>
                  </a:lnTo>
                  <a:lnTo>
                    <a:pt x="19" y="21"/>
                  </a:lnTo>
                  <a:lnTo>
                    <a:pt x="20" y="20"/>
                  </a:lnTo>
                  <a:lnTo>
                    <a:pt x="21" y="22"/>
                  </a:lnTo>
                  <a:lnTo>
                    <a:pt x="22" y="20"/>
                  </a:lnTo>
                  <a:lnTo>
                    <a:pt x="23" y="20"/>
                  </a:lnTo>
                  <a:lnTo>
                    <a:pt x="24" y="20"/>
                  </a:lnTo>
                  <a:lnTo>
                    <a:pt x="25" y="19"/>
                  </a:lnTo>
                  <a:lnTo>
                    <a:pt x="25" y="21"/>
                  </a:lnTo>
                  <a:lnTo>
                    <a:pt x="26" y="19"/>
                  </a:lnTo>
                  <a:lnTo>
                    <a:pt x="27" y="20"/>
                  </a:lnTo>
                  <a:lnTo>
                    <a:pt x="28" y="17"/>
                  </a:lnTo>
                  <a:lnTo>
                    <a:pt x="29" y="17"/>
                  </a:lnTo>
                  <a:lnTo>
                    <a:pt x="30" y="21"/>
                  </a:lnTo>
                  <a:lnTo>
                    <a:pt x="31" y="20"/>
                  </a:lnTo>
                  <a:lnTo>
                    <a:pt x="32" y="21"/>
                  </a:lnTo>
                  <a:lnTo>
                    <a:pt x="32" y="18"/>
                  </a:lnTo>
                  <a:lnTo>
                    <a:pt x="33" y="16"/>
                  </a:lnTo>
                  <a:lnTo>
                    <a:pt x="34" y="18"/>
                  </a:lnTo>
                  <a:lnTo>
                    <a:pt x="35" y="20"/>
                  </a:lnTo>
                  <a:lnTo>
                    <a:pt x="36" y="16"/>
                  </a:lnTo>
                  <a:lnTo>
                    <a:pt x="37" y="19"/>
                  </a:lnTo>
                  <a:lnTo>
                    <a:pt x="38" y="17"/>
                  </a:lnTo>
                  <a:lnTo>
                    <a:pt x="39" y="17"/>
                  </a:lnTo>
                  <a:lnTo>
                    <a:pt x="40" y="18"/>
                  </a:lnTo>
                  <a:lnTo>
                    <a:pt x="40" y="19"/>
                  </a:lnTo>
                  <a:lnTo>
                    <a:pt x="41" y="16"/>
                  </a:lnTo>
                  <a:lnTo>
                    <a:pt x="42" y="17"/>
                  </a:lnTo>
                  <a:lnTo>
                    <a:pt x="43" y="17"/>
                  </a:lnTo>
                  <a:lnTo>
                    <a:pt x="44" y="18"/>
                  </a:lnTo>
                  <a:lnTo>
                    <a:pt x="45" y="17"/>
                  </a:lnTo>
                  <a:lnTo>
                    <a:pt x="46" y="16"/>
                  </a:lnTo>
                  <a:lnTo>
                    <a:pt x="47" y="17"/>
                  </a:lnTo>
                  <a:lnTo>
                    <a:pt x="47" y="14"/>
                  </a:lnTo>
                  <a:lnTo>
                    <a:pt x="48" y="18"/>
                  </a:lnTo>
                  <a:lnTo>
                    <a:pt x="49" y="17"/>
                  </a:lnTo>
                  <a:lnTo>
                    <a:pt x="50" y="18"/>
                  </a:lnTo>
                  <a:lnTo>
                    <a:pt x="51" y="15"/>
                  </a:lnTo>
                  <a:lnTo>
                    <a:pt x="52" y="16"/>
                  </a:lnTo>
                  <a:lnTo>
                    <a:pt x="53" y="14"/>
                  </a:lnTo>
                  <a:lnTo>
                    <a:pt x="54" y="16"/>
                  </a:lnTo>
                  <a:lnTo>
                    <a:pt x="55" y="17"/>
                  </a:lnTo>
                  <a:lnTo>
                    <a:pt x="55" y="16"/>
                  </a:lnTo>
                  <a:lnTo>
                    <a:pt x="56" y="17"/>
                  </a:lnTo>
                  <a:lnTo>
                    <a:pt x="57" y="17"/>
                  </a:lnTo>
                  <a:lnTo>
                    <a:pt x="58" y="15"/>
                  </a:lnTo>
                  <a:lnTo>
                    <a:pt x="59" y="15"/>
                  </a:lnTo>
                  <a:lnTo>
                    <a:pt x="60" y="15"/>
                  </a:lnTo>
                  <a:lnTo>
                    <a:pt x="61" y="15"/>
                  </a:lnTo>
                  <a:lnTo>
                    <a:pt x="62" y="15"/>
                  </a:lnTo>
                  <a:lnTo>
                    <a:pt x="62" y="15"/>
                  </a:lnTo>
                  <a:lnTo>
                    <a:pt x="63" y="13"/>
                  </a:lnTo>
                  <a:lnTo>
                    <a:pt x="64" y="15"/>
                  </a:lnTo>
                  <a:lnTo>
                    <a:pt x="65" y="13"/>
                  </a:lnTo>
                  <a:lnTo>
                    <a:pt x="66" y="15"/>
                  </a:lnTo>
                  <a:lnTo>
                    <a:pt x="67" y="15"/>
                  </a:lnTo>
                  <a:lnTo>
                    <a:pt x="68" y="16"/>
                  </a:lnTo>
                  <a:lnTo>
                    <a:pt x="69" y="15"/>
                  </a:lnTo>
                  <a:lnTo>
                    <a:pt x="70" y="14"/>
                  </a:lnTo>
                  <a:lnTo>
                    <a:pt x="70" y="15"/>
                  </a:lnTo>
                  <a:lnTo>
                    <a:pt x="71" y="15"/>
                  </a:lnTo>
                  <a:lnTo>
                    <a:pt x="72" y="14"/>
                  </a:lnTo>
                  <a:lnTo>
                    <a:pt x="73" y="15"/>
                  </a:lnTo>
                  <a:lnTo>
                    <a:pt x="74" y="14"/>
                  </a:lnTo>
                  <a:lnTo>
                    <a:pt x="75" y="13"/>
                  </a:lnTo>
                  <a:lnTo>
                    <a:pt x="76" y="14"/>
                  </a:lnTo>
                  <a:lnTo>
                    <a:pt x="77" y="14"/>
                  </a:lnTo>
                  <a:lnTo>
                    <a:pt x="77" y="15"/>
                  </a:lnTo>
                  <a:lnTo>
                    <a:pt x="78" y="15"/>
                  </a:lnTo>
                  <a:lnTo>
                    <a:pt x="79" y="15"/>
                  </a:lnTo>
                  <a:lnTo>
                    <a:pt x="80" y="15"/>
                  </a:lnTo>
                  <a:lnTo>
                    <a:pt x="81" y="14"/>
                  </a:lnTo>
                  <a:lnTo>
                    <a:pt x="82" y="15"/>
                  </a:lnTo>
                  <a:lnTo>
                    <a:pt x="83" y="16"/>
                  </a:lnTo>
                  <a:lnTo>
                    <a:pt x="84" y="14"/>
                  </a:lnTo>
                  <a:lnTo>
                    <a:pt x="84" y="14"/>
                  </a:lnTo>
                  <a:lnTo>
                    <a:pt x="85" y="13"/>
                  </a:lnTo>
                  <a:lnTo>
                    <a:pt x="86" y="12"/>
                  </a:lnTo>
                  <a:lnTo>
                    <a:pt x="87" y="12"/>
                  </a:lnTo>
                  <a:lnTo>
                    <a:pt x="88" y="13"/>
                  </a:lnTo>
                  <a:lnTo>
                    <a:pt x="89" y="15"/>
                  </a:lnTo>
                  <a:lnTo>
                    <a:pt x="90" y="13"/>
                  </a:lnTo>
                  <a:lnTo>
                    <a:pt x="91" y="11"/>
                  </a:lnTo>
                  <a:lnTo>
                    <a:pt x="92" y="15"/>
                  </a:lnTo>
                  <a:lnTo>
                    <a:pt x="92" y="12"/>
                  </a:lnTo>
                  <a:lnTo>
                    <a:pt x="93" y="13"/>
                  </a:lnTo>
                  <a:lnTo>
                    <a:pt x="94" y="14"/>
                  </a:lnTo>
                  <a:lnTo>
                    <a:pt x="95" y="13"/>
                  </a:lnTo>
                  <a:lnTo>
                    <a:pt x="96" y="14"/>
                  </a:lnTo>
                  <a:lnTo>
                    <a:pt x="97" y="13"/>
                  </a:lnTo>
                  <a:lnTo>
                    <a:pt x="98" y="12"/>
                  </a:lnTo>
                  <a:lnTo>
                    <a:pt x="99" y="13"/>
                  </a:lnTo>
                  <a:lnTo>
                    <a:pt x="99" y="11"/>
                  </a:lnTo>
                  <a:lnTo>
                    <a:pt x="100" y="13"/>
                  </a:lnTo>
                  <a:lnTo>
                    <a:pt x="101" y="12"/>
                  </a:lnTo>
                  <a:lnTo>
                    <a:pt x="102" y="13"/>
                  </a:lnTo>
                  <a:lnTo>
                    <a:pt x="103" y="11"/>
                  </a:lnTo>
                  <a:lnTo>
                    <a:pt x="104" y="13"/>
                  </a:lnTo>
                  <a:lnTo>
                    <a:pt x="105" y="13"/>
                  </a:lnTo>
                  <a:lnTo>
                    <a:pt x="106" y="15"/>
                  </a:lnTo>
                  <a:lnTo>
                    <a:pt x="107" y="11"/>
                  </a:lnTo>
                  <a:lnTo>
                    <a:pt x="107" y="13"/>
                  </a:lnTo>
                  <a:lnTo>
                    <a:pt x="108" y="12"/>
                  </a:lnTo>
                  <a:lnTo>
                    <a:pt x="109" y="12"/>
                  </a:lnTo>
                  <a:lnTo>
                    <a:pt x="110" y="12"/>
                  </a:lnTo>
                  <a:lnTo>
                    <a:pt x="111" y="12"/>
                  </a:lnTo>
                  <a:lnTo>
                    <a:pt x="112" y="12"/>
                  </a:lnTo>
                  <a:lnTo>
                    <a:pt x="113" y="12"/>
                  </a:lnTo>
                  <a:lnTo>
                    <a:pt x="114" y="13"/>
                  </a:lnTo>
                  <a:lnTo>
                    <a:pt x="114" y="11"/>
                  </a:lnTo>
                  <a:lnTo>
                    <a:pt x="115" y="12"/>
                  </a:lnTo>
                  <a:lnTo>
                    <a:pt x="116" y="11"/>
                  </a:lnTo>
                  <a:lnTo>
                    <a:pt x="117" y="14"/>
                  </a:lnTo>
                  <a:lnTo>
                    <a:pt x="118" y="13"/>
                  </a:lnTo>
                  <a:lnTo>
                    <a:pt x="119" y="13"/>
                  </a:lnTo>
                  <a:lnTo>
                    <a:pt x="120" y="12"/>
                  </a:lnTo>
                  <a:lnTo>
                    <a:pt x="121" y="12"/>
                  </a:lnTo>
                  <a:lnTo>
                    <a:pt x="122" y="13"/>
                  </a:lnTo>
                  <a:lnTo>
                    <a:pt x="122" y="12"/>
                  </a:lnTo>
                  <a:lnTo>
                    <a:pt x="123" y="11"/>
                  </a:lnTo>
                  <a:lnTo>
                    <a:pt x="124" y="11"/>
                  </a:lnTo>
                  <a:lnTo>
                    <a:pt x="125" y="11"/>
                  </a:lnTo>
                  <a:lnTo>
                    <a:pt x="126" y="12"/>
                  </a:lnTo>
                  <a:lnTo>
                    <a:pt x="127" y="12"/>
                  </a:lnTo>
                  <a:lnTo>
                    <a:pt x="128" y="12"/>
                  </a:lnTo>
                  <a:lnTo>
                    <a:pt x="129" y="10"/>
                  </a:lnTo>
                  <a:lnTo>
                    <a:pt x="129" y="10"/>
                  </a:lnTo>
                  <a:lnTo>
                    <a:pt x="130" y="11"/>
                  </a:lnTo>
                  <a:lnTo>
                    <a:pt x="131" y="10"/>
                  </a:lnTo>
                  <a:lnTo>
                    <a:pt x="132" y="12"/>
                  </a:lnTo>
                  <a:lnTo>
                    <a:pt x="133" y="10"/>
                  </a:lnTo>
                  <a:lnTo>
                    <a:pt x="134" y="11"/>
                  </a:lnTo>
                  <a:lnTo>
                    <a:pt x="135" y="11"/>
                  </a:lnTo>
                  <a:lnTo>
                    <a:pt x="136" y="11"/>
                  </a:lnTo>
                  <a:lnTo>
                    <a:pt x="137" y="11"/>
                  </a:lnTo>
                  <a:lnTo>
                    <a:pt x="137" y="10"/>
                  </a:lnTo>
                  <a:lnTo>
                    <a:pt x="138" y="11"/>
                  </a:lnTo>
                  <a:lnTo>
                    <a:pt x="139" y="10"/>
                  </a:lnTo>
                  <a:lnTo>
                    <a:pt x="140" y="12"/>
                  </a:lnTo>
                  <a:lnTo>
                    <a:pt x="141" y="12"/>
                  </a:lnTo>
                  <a:lnTo>
                    <a:pt x="142" y="12"/>
                  </a:lnTo>
                  <a:lnTo>
                    <a:pt x="143" y="10"/>
                  </a:lnTo>
                  <a:lnTo>
                    <a:pt x="144" y="11"/>
                  </a:lnTo>
                  <a:lnTo>
                    <a:pt x="144" y="12"/>
                  </a:lnTo>
                  <a:lnTo>
                    <a:pt x="145" y="12"/>
                  </a:lnTo>
                  <a:lnTo>
                    <a:pt x="146" y="10"/>
                  </a:lnTo>
                  <a:lnTo>
                    <a:pt x="147" y="12"/>
                  </a:lnTo>
                  <a:lnTo>
                    <a:pt x="148" y="9"/>
                  </a:lnTo>
                  <a:lnTo>
                    <a:pt x="149" y="10"/>
                  </a:lnTo>
                  <a:lnTo>
                    <a:pt x="150" y="10"/>
                  </a:lnTo>
                  <a:lnTo>
                    <a:pt x="151" y="9"/>
                  </a:lnTo>
                  <a:lnTo>
                    <a:pt x="152" y="11"/>
                  </a:lnTo>
                  <a:lnTo>
                    <a:pt x="152" y="10"/>
                  </a:lnTo>
                  <a:lnTo>
                    <a:pt x="153" y="11"/>
                  </a:lnTo>
                  <a:lnTo>
                    <a:pt x="154" y="9"/>
                  </a:lnTo>
                  <a:lnTo>
                    <a:pt x="155" y="8"/>
                  </a:lnTo>
                  <a:lnTo>
                    <a:pt x="156" y="10"/>
                  </a:lnTo>
                  <a:lnTo>
                    <a:pt x="157" y="11"/>
                  </a:lnTo>
                  <a:lnTo>
                    <a:pt x="158" y="9"/>
                  </a:lnTo>
                  <a:lnTo>
                    <a:pt x="159" y="10"/>
                  </a:lnTo>
                  <a:lnTo>
                    <a:pt x="159" y="11"/>
                  </a:lnTo>
                  <a:lnTo>
                    <a:pt x="160" y="9"/>
                  </a:lnTo>
                  <a:lnTo>
                    <a:pt x="161" y="9"/>
                  </a:lnTo>
                  <a:lnTo>
                    <a:pt x="162" y="11"/>
                  </a:lnTo>
                  <a:lnTo>
                    <a:pt x="163" y="10"/>
                  </a:lnTo>
                  <a:lnTo>
                    <a:pt x="164" y="10"/>
                  </a:lnTo>
                  <a:lnTo>
                    <a:pt x="165" y="11"/>
                  </a:lnTo>
                  <a:lnTo>
                    <a:pt x="166" y="11"/>
                  </a:lnTo>
                  <a:lnTo>
                    <a:pt x="167" y="8"/>
                  </a:lnTo>
                  <a:lnTo>
                    <a:pt x="167" y="9"/>
                  </a:lnTo>
                  <a:lnTo>
                    <a:pt x="168" y="10"/>
                  </a:lnTo>
                  <a:lnTo>
                    <a:pt x="169" y="9"/>
                  </a:lnTo>
                  <a:lnTo>
                    <a:pt x="170" y="9"/>
                  </a:lnTo>
                  <a:lnTo>
                    <a:pt x="171" y="11"/>
                  </a:lnTo>
                  <a:lnTo>
                    <a:pt x="172" y="10"/>
                  </a:lnTo>
                  <a:lnTo>
                    <a:pt x="173" y="9"/>
                  </a:lnTo>
                  <a:lnTo>
                    <a:pt x="174" y="9"/>
                  </a:lnTo>
                  <a:lnTo>
                    <a:pt x="174" y="9"/>
                  </a:lnTo>
                  <a:lnTo>
                    <a:pt x="175" y="9"/>
                  </a:lnTo>
                  <a:lnTo>
                    <a:pt x="176" y="8"/>
                  </a:lnTo>
                  <a:lnTo>
                    <a:pt x="177" y="8"/>
                  </a:lnTo>
                  <a:lnTo>
                    <a:pt x="178" y="8"/>
                  </a:lnTo>
                  <a:lnTo>
                    <a:pt x="179" y="10"/>
                  </a:lnTo>
                  <a:lnTo>
                    <a:pt x="180" y="10"/>
                  </a:lnTo>
                  <a:lnTo>
                    <a:pt x="181" y="8"/>
                  </a:lnTo>
                  <a:lnTo>
                    <a:pt x="182" y="8"/>
                  </a:lnTo>
                  <a:lnTo>
                    <a:pt x="182" y="10"/>
                  </a:lnTo>
                  <a:lnTo>
                    <a:pt x="183" y="9"/>
                  </a:lnTo>
                  <a:lnTo>
                    <a:pt x="184" y="8"/>
                  </a:lnTo>
                  <a:lnTo>
                    <a:pt x="185" y="11"/>
                  </a:lnTo>
                  <a:lnTo>
                    <a:pt x="186" y="7"/>
                  </a:lnTo>
                  <a:lnTo>
                    <a:pt x="187" y="7"/>
                  </a:lnTo>
                  <a:lnTo>
                    <a:pt x="188" y="7"/>
                  </a:lnTo>
                  <a:lnTo>
                    <a:pt x="189" y="8"/>
                  </a:lnTo>
                  <a:lnTo>
                    <a:pt x="189" y="8"/>
                  </a:lnTo>
                  <a:lnTo>
                    <a:pt x="190" y="11"/>
                  </a:lnTo>
                  <a:lnTo>
                    <a:pt x="191" y="7"/>
                  </a:lnTo>
                  <a:lnTo>
                    <a:pt x="192" y="9"/>
                  </a:lnTo>
                  <a:lnTo>
                    <a:pt x="193" y="7"/>
                  </a:lnTo>
                  <a:lnTo>
                    <a:pt x="194" y="10"/>
                  </a:lnTo>
                  <a:lnTo>
                    <a:pt x="195" y="8"/>
                  </a:lnTo>
                  <a:lnTo>
                    <a:pt x="196" y="9"/>
                  </a:lnTo>
                  <a:lnTo>
                    <a:pt x="197" y="9"/>
                  </a:lnTo>
                  <a:lnTo>
                    <a:pt x="197" y="10"/>
                  </a:lnTo>
                  <a:lnTo>
                    <a:pt x="198" y="10"/>
                  </a:lnTo>
                  <a:lnTo>
                    <a:pt x="199" y="10"/>
                  </a:lnTo>
                  <a:lnTo>
                    <a:pt x="200" y="9"/>
                  </a:lnTo>
                  <a:lnTo>
                    <a:pt x="201" y="8"/>
                  </a:lnTo>
                  <a:lnTo>
                    <a:pt x="202" y="9"/>
                  </a:lnTo>
                  <a:lnTo>
                    <a:pt x="203" y="10"/>
                  </a:lnTo>
                  <a:lnTo>
                    <a:pt x="204" y="10"/>
                  </a:lnTo>
                  <a:lnTo>
                    <a:pt x="204" y="8"/>
                  </a:lnTo>
                  <a:lnTo>
                    <a:pt x="205" y="7"/>
                  </a:lnTo>
                  <a:lnTo>
                    <a:pt x="206" y="7"/>
                  </a:lnTo>
                  <a:lnTo>
                    <a:pt x="207" y="7"/>
                  </a:lnTo>
                  <a:lnTo>
                    <a:pt x="208" y="7"/>
                  </a:lnTo>
                  <a:lnTo>
                    <a:pt x="209" y="7"/>
                  </a:lnTo>
                  <a:lnTo>
                    <a:pt x="210" y="9"/>
                  </a:lnTo>
                  <a:lnTo>
                    <a:pt x="211" y="8"/>
                  </a:lnTo>
                  <a:lnTo>
                    <a:pt x="212" y="9"/>
                  </a:lnTo>
                  <a:lnTo>
                    <a:pt x="212" y="10"/>
                  </a:lnTo>
                  <a:lnTo>
                    <a:pt x="213" y="8"/>
                  </a:lnTo>
                  <a:lnTo>
                    <a:pt x="214" y="8"/>
                  </a:lnTo>
                  <a:lnTo>
                    <a:pt x="215" y="9"/>
                  </a:lnTo>
                  <a:lnTo>
                    <a:pt x="216" y="9"/>
                  </a:lnTo>
                  <a:lnTo>
                    <a:pt x="217" y="9"/>
                  </a:lnTo>
                  <a:lnTo>
                    <a:pt x="218" y="11"/>
                  </a:lnTo>
                  <a:lnTo>
                    <a:pt x="219" y="13"/>
                  </a:lnTo>
                  <a:lnTo>
                    <a:pt x="219" y="14"/>
                  </a:lnTo>
                  <a:lnTo>
                    <a:pt x="220" y="12"/>
                  </a:lnTo>
                  <a:lnTo>
                    <a:pt x="221" y="16"/>
                  </a:lnTo>
                  <a:lnTo>
                    <a:pt x="222" y="15"/>
                  </a:lnTo>
                  <a:lnTo>
                    <a:pt x="223" y="16"/>
                  </a:lnTo>
                  <a:lnTo>
                    <a:pt x="224" y="15"/>
                  </a:lnTo>
                  <a:lnTo>
                    <a:pt x="225" y="17"/>
                  </a:lnTo>
                  <a:lnTo>
                    <a:pt x="226" y="15"/>
                  </a:lnTo>
                  <a:lnTo>
                    <a:pt x="227" y="15"/>
                  </a:lnTo>
                  <a:lnTo>
                    <a:pt x="227" y="13"/>
                  </a:lnTo>
                  <a:lnTo>
                    <a:pt x="228" y="12"/>
                  </a:lnTo>
                  <a:lnTo>
                    <a:pt x="229" y="12"/>
                  </a:lnTo>
                  <a:lnTo>
                    <a:pt x="230" y="11"/>
                  </a:lnTo>
                  <a:lnTo>
                    <a:pt x="231" y="11"/>
                  </a:lnTo>
                  <a:lnTo>
                    <a:pt x="232" y="10"/>
                  </a:lnTo>
                  <a:lnTo>
                    <a:pt x="233" y="8"/>
                  </a:lnTo>
                  <a:lnTo>
                    <a:pt x="234" y="10"/>
                  </a:lnTo>
                  <a:lnTo>
                    <a:pt x="234" y="10"/>
                  </a:lnTo>
                  <a:lnTo>
                    <a:pt x="235" y="9"/>
                  </a:lnTo>
                  <a:lnTo>
                    <a:pt x="236" y="9"/>
                  </a:lnTo>
                  <a:lnTo>
                    <a:pt x="237" y="7"/>
                  </a:lnTo>
                  <a:lnTo>
                    <a:pt x="238" y="8"/>
                  </a:lnTo>
                  <a:lnTo>
                    <a:pt x="239" y="9"/>
                  </a:lnTo>
                  <a:lnTo>
                    <a:pt x="240" y="9"/>
                  </a:lnTo>
                  <a:lnTo>
                    <a:pt x="241" y="8"/>
                  </a:lnTo>
                  <a:lnTo>
                    <a:pt x="242" y="9"/>
                  </a:lnTo>
                  <a:lnTo>
                    <a:pt x="242" y="9"/>
                  </a:lnTo>
                  <a:lnTo>
                    <a:pt x="243" y="7"/>
                  </a:lnTo>
                  <a:lnTo>
                    <a:pt x="244" y="7"/>
                  </a:lnTo>
                  <a:lnTo>
                    <a:pt x="245" y="8"/>
                  </a:lnTo>
                  <a:lnTo>
                    <a:pt x="246" y="7"/>
                  </a:lnTo>
                  <a:lnTo>
                    <a:pt x="247" y="7"/>
                  </a:lnTo>
                  <a:lnTo>
                    <a:pt x="248" y="7"/>
                  </a:lnTo>
                  <a:lnTo>
                    <a:pt x="249" y="6"/>
                  </a:lnTo>
                  <a:lnTo>
                    <a:pt x="249" y="7"/>
                  </a:lnTo>
                  <a:lnTo>
                    <a:pt x="250" y="7"/>
                  </a:lnTo>
                  <a:lnTo>
                    <a:pt x="251" y="7"/>
                  </a:lnTo>
                  <a:lnTo>
                    <a:pt x="252" y="6"/>
                  </a:lnTo>
                  <a:lnTo>
                    <a:pt x="253" y="6"/>
                  </a:lnTo>
                  <a:lnTo>
                    <a:pt x="254" y="6"/>
                  </a:lnTo>
                  <a:lnTo>
                    <a:pt x="255" y="6"/>
                  </a:lnTo>
                  <a:lnTo>
                    <a:pt x="256" y="5"/>
                  </a:lnTo>
                  <a:lnTo>
                    <a:pt x="257" y="6"/>
                  </a:lnTo>
                  <a:lnTo>
                    <a:pt x="257" y="8"/>
                  </a:lnTo>
                  <a:lnTo>
                    <a:pt x="258" y="7"/>
                  </a:lnTo>
                  <a:lnTo>
                    <a:pt x="259" y="8"/>
                  </a:lnTo>
                  <a:lnTo>
                    <a:pt x="260" y="6"/>
                  </a:lnTo>
                  <a:lnTo>
                    <a:pt x="261" y="7"/>
                  </a:lnTo>
                  <a:lnTo>
                    <a:pt x="262" y="6"/>
                  </a:lnTo>
                  <a:lnTo>
                    <a:pt x="263" y="5"/>
                  </a:lnTo>
                  <a:lnTo>
                    <a:pt x="264" y="5"/>
                  </a:lnTo>
                  <a:lnTo>
                    <a:pt x="264" y="5"/>
                  </a:lnTo>
                  <a:lnTo>
                    <a:pt x="265" y="5"/>
                  </a:lnTo>
                  <a:lnTo>
                    <a:pt x="266" y="7"/>
                  </a:lnTo>
                  <a:lnTo>
                    <a:pt x="267" y="7"/>
                  </a:lnTo>
                  <a:lnTo>
                    <a:pt x="268" y="5"/>
                  </a:lnTo>
                  <a:lnTo>
                    <a:pt x="269" y="6"/>
                  </a:lnTo>
                  <a:lnTo>
                    <a:pt x="270" y="5"/>
                  </a:lnTo>
                  <a:lnTo>
                    <a:pt x="271" y="8"/>
                  </a:lnTo>
                  <a:lnTo>
                    <a:pt x="271" y="6"/>
                  </a:lnTo>
                  <a:lnTo>
                    <a:pt x="272" y="7"/>
                  </a:lnTo>
                  <a:lnTo>
                    <a:pt x="273" y="5"/>
                  </a:lnTo>
                  <a:lnTo>
                    <a:pt x="274" y="5"/>
                  </a:lnTo>
                  <a:lnTo>
                    <a:pt x="275" y="6"/>
                  </a:lnTo>
                  <a:lnTo>
                    <a:pt x="276" y="7"/>
                  </a:lnTo>
                  <a:lnTo>
                    <a:pt x="277" y="6"/>
                  </a:lnTo>
                  <a:lnTo>
                    <a:pt x="278" y="7"/>
                  </a:lnTo>
                  <a:lnTo>
                    <a:pt x="279" y="6"/>
                  </a:lnTo>
                  <a:lnTo>
                    <a:pt x="279" y="5"/>
                  </a:lnTo>
                  <a:lnTo>
                    <a:pt x="280" y="7"/>
                  </a:lnTo>
                  <a:lnTo>
                    <a:pt x="281" y="6"/>
                  </a:lnTo>
                  <a:lnTo>
                    <a:pt x="282" y="8"/>
                  </a:lnTo>
                  <a:lnTo>
                    <a:pt x="283" y="5"/>
                  </a:lnTo>
                  <a:lnTo>
                    <a:pt x="284" y="6"/>
                  </a:lnTo>
                  <a:lnTo>
                    <a:pt x="285" y="8"/>
                  </a:lnTo>
                  <a:lnTo>
                    <a:pt x="286" y="6"/>
                  </a:lnTo>
                  <a:lnTo>
                    <a:pt x="286" y="8"/>
                  </a:lnTo>
                  <a:lnTo>
                    <a:pt x="287" y="6"/>
                  </a:lnTo>
                  <a:lnTo>
                    <a:pt x="288" y="6"/>
                  </a:lnTo>
                  <a:lnTo>
                    <a:pt x="289" y="7"/>
                  </a:lnTo>
                  <a:lnTo>
                    <a:pt x="290" y="5"/>
                  </a:lnTo>
                  <a:lnTo>
                    <a:pt x="291" y="7"/>
                  </a:lnTo>
                  <a:lnTo>
                    <a:pt x="292" y="6"/>
                  </a:lnTo>
                  <a:lnTo>
                    <a:pt x="293" y="8"/>
                  </a:lnTo>
                  <a:lnTo>
                    <a:pt x="294" y="7"/>
                  </a:lnTo>
                  <a:lnTo>
                    <a:pt x="294" y="6"/>
                  </a:lnTo>
                  <a:lnTo>
                    <a:pt x="295" y="7"/>
                  </a:lnTo>
                  <a:lnTo>
                    <a:pt x="296" y="8"/>
                  </a:lnTo>
                  <a:lnTo>
                    <a:pt x="297" y="7"/>
                  </a:lnTo>
                  <a:lnTo>
                    <a:pt x="298" y="7"/>
                  </a:lnTo>
                  <a:lnTo>
                    <a:pt x="299" y="7"/>
                  </a:lnTo>
                  <a:lnTo>
                    <a:pt x="300" y="7"/>
                  </a:lnTo>
                  <a:lnTo>
                    <a:pt x="301" y="9"/>
                  </a:lnTo>
                  <a:lnTo>
                    <a:pt x="301" y="7"/>
                  </a:lnTo>
                  <a:lnTo>
                    <a:pt x="302" y="5"/>
                  </a:lnTo>
                  <a:lnTo>
                    <a:pt x="303" y="9"/>
                  </a:lnTo>
                  <a:lnTo>
                    <a:pt x="304" y="7"/>
                  </a:lnTo>
                  <a:lnTo>
                    <a:pt x="305" y="8"/>
                  </a:lnTo>
                  <a:lnTo>
                    <a:pt x="306" y="6"/>
                  </a:lnTo>
                  <a:lnTo>
                    <a:pt x="307" y="7"/>
                  </a:lnTo>
                  <a:lnTo>
                    <a:pt x="308" y="6"/>
                  </a:lnTo>
                  <a:lnTo>
                    <a:pt x="309" y="8"/>
                  </a:lnTo>
                  <a:lnTo>
                    <a:pt x="309" y="7"/>
                  </a:lnTo>
                  <a:lnTo>
                    <a:pt x="310" y="8"/>
                  </a:lnTo>
                  <a:lnTo>
                    <a:pt x="311" y="9"/>
                  </a:lnTo>
                  <a:lnTo>
                    <a:pt x="312" y="8"/>
                  </a:lnTo>
                  <a:lnTo>
                    <a:pt x="313" y="8"/>
                  </a:lnTo>
                  <a:lnTo>
                    <a:pt x="314" y="7"/>
                  </a:lnTo>
                  <a:lnTo>
                    <a:pt x="315" y="6"/>
                  </a:lnTo>
                  <a:lnTo>
                    <a:pt x="316" y="9"/>
                  </a:lnTo>
                  <a:lnTo>
                    <a:pt x="316" y="9"/>
                  </a:lnTo>
                  <a:lnTo>
                    <a:pt x="317" y="9"/>
                  </a:lnTo>
                  <a:lnTo>
                    <a:pt x="318" y="8"/>
                  </a:lnTo>
                  <a:lnTo>
                    <a:pt x="319" y="8"/>
                  </a:lnTo>
                  <a:lnTo>
                    <a:pt x="320" y="9"/>
                  </a:lnTo>
                  <a:lnTo>
                    <a:pt x="321" y="9"/>
                  </a:lnTo>
                  <a:lnTo>
                    <a:pt x="322" y="7"/>
                  </a:lnTo>
                  <a:lnTo>
                    <a:pt x="323" y="9"/>
                  </a:lnTo>
                  <a:lnTo>
                    <a:pt x="324" y="8"/>
                  </a:lnTo>
                  <a:lnTo>
                    <a:pt x="324" y="11"/>
                  </a:lnTo>
                  <a:lnTo>
                    <a:pt x="325" y="8"/>
                  </a:lnTo>
                  <a:lnTo>
                    <a:pt x="326" y="10"/>
                  </a:lnTo>
                  <a:lnTo>
                    <a:pt x="327" y="10"/>
                  </a:lnTo>
                  <a:lnTo>
                    <a:pt x="328" y="10"/>
                  </a:lnTo>
                  <a:lnTo>
                    <a:pt x="329" y="7"/>
                  </a:lnTo>
                  <a:lnTo>
                    <a:pt x="330" y="13"/>
                  </a:lnTo>
                  <a:lnTo>
                    <a:pt x="331" y="11"/>
                  </a:lnTo>
                  <a:lnTo>
                    <a:pt x="331" y="10"/>
                  </a:lnTo>
                  <a:lnTo>
                    <a:pt x="332" y="13"/>
                  </a:lnTo>
                  <a:lnTo>
                    <a:pt x="333" y="14"/>
                  </a:lnTo>
                  <a:lnTo>
                    <a:pt x="334" y="14"/>
                  </a:lnTo>
                  <a:lnTo>
                    <a:pt x="335" y="14"/>
                  </a:lnTo>
                  <a:lnTo>
                    <a:pt x="336" y="17"/>
                  </a:lnTo>
                  <a:lnTo>
                    <a:pt x="337" y="18"/>
                  </a:lnTo>
                  <a:lnTo>
                    <a:pt x="338" y="21"/>
                  </a:lnTo>
                  <a:lnTo>
                    <a:pt x="339" y="27"/>
                  </a:lnTo>
                  <a:lnTo>
                    <a:pt x="339" y="32"/>
                  </a:lnTo>
                  <a:lnTo>
                    <a:pt x="340" y="38"/>
                  </a:lnTo>
                  <a:lnTo>
                    <a:pt x="341" y="43"/>
                  </a:lnTo>
                  <a:lnTo>
                    <a:pt x="342" y="50"/>
                  </a:lnTo>
                  <a:lnTo>
                    <a:pt x="343" y="58"/>
                  </a:lnTo>
                  <a:lnTo>
                    <a:pt x="344" y="63"/>
                  </a:lnTo>
                  <a:lnTo>
                    <a:pt x="345" y="68"/>
                  </a:lnTo>
                  <a:lnTo>
                    <a:pt x="346" y="69"/>
                  </a:lnTo>
                  <a:lnTo>
                    <a:pt x="346" y="71"/>
                  </a:lnTo>
                  <a:lnTo>
                    <a:pt x="347" y="68"/>
                  </a:lnTo>
                  <a:lnTo>
                    <a:pt x="348" y="65"/>
                  </a:lnTo>
                  <a:lnTo>
                    <a:pt x="349" y="67"/>
                  </a:lnTo>
                  <a:lnTo>
                    <a:pt x="350" y="67"/>
                  </a:lnTo>
                  <a:lnTo>
                    <a:pt x="351" y="59"/>
                  </a:lnTo>
                  <a:lnTo>
                    <a:pt x="352" y="58"/>
                  </a:lnTo>
                  <a:lnTo>
                    <a:pt x="353" y="54"/>
                  </a:lnTo>
                  <a:lnTo>
                    <a:pt x="354" y="51"/>
                  </a:lnTo>
                  <a:lnTo>
                    <a:pt x="354" y="51"/>
                  </a:lnTo>
                  <a:lnTo>
                    <a:pt x="355" y="46"/>
                  </a:lnTo>
                  <a:lnTo>
                    <a:pt x="356" y="41"/>
                  </a:lnTo>
                  <a:lnTo>
                    <a:pt x="357" y="44"/>
                  </a:lnTo>
                  <a:lnTo>
                    <a:pt x="358" y="42"/>
                  </a:lnTo>
                  <a:lnTo>
                    <a:pt x="359" y="38"/>
                  </a:lnTo>
                  <a:lnTo>
                    <a:pt x="360" y="38"/>
                  </a:lnTo>
                  <a:lnTo>
                    <a:pt x="361" y="37"/>
                  </a:lnTo>
                  <a:lnTo>
                    <a:pt x="361" y="36"/>
                  </a:lnTo>
                  <a:lnTo>
                    <a:pt x="362" y="34"/>
                  </a:lnTo>
                  <a:lnTo>
                    <a:pt x="363" y="34"/>
                  </a:lnTo>
                  <a:lnTo>
                    <a:pt x="364" y="35"/>
                  </a:lnTo>
                  <a:lnTo>
                    <a:pt x="365" y="33"/>
                  </a:lnTo>
                  <a:lnTo>
                    <a:pt x="366" y="32"/>
                  </a:lnTo>
                  <a:lnTo>
                    <a:pt x="367" y="32"/>
                  </a:lnTo>
                  <a:lnTo>
                    <a:pt x="368" y="32"/>
                  </a:lnTo>
                  <a:lnTo>
                    <a:pt x="369" y="36"/>
                  </a:lnTo>
                  <a:lnTo>
                    <a:pt x="369" y="31"/>
                  </a:lnTo>
                  <a:lnTo>
                    <a:pt x="370" y="32"/>
                  </a:lnTo>
                  <a:lnTo>
                    <a:pt x="371" y="34"/>
                  </a:lnTo>
                  <a:lnTo>
                    <a:pt x="372" y="30"/>
                  </a:lnTo>
                  <a:lnTo>
                    <a:pt x="373" y="31"/>
                  </a:lnTo>
                  <a:lnTo>
                    <a:pt x="374" y="30"/>
                  </a:lnTo>
                  <a:lnTo>
                    <a:pt x="375" y="29"/>
                  </a:lnTo>
                  <a:lnTo>
                    <a:pt x="376" y="27"/>
                  </a:lnTo>
                  <a:lnTo>
                    <a:pt x="376" y="27"/>
                  </a:lnTo>
                  <a:lnTo>
                    <a:pt x="377" y="28"/>
                  </a:lnTo>
                  <a:lnTo>
                    <a:pt x="378" y="26"/>
                  </a:lnTo>
                  <a:lnTo>
                    <a:pt x="379" y="25"/>
                  </a:lnTo>
                  <a:lnTo>
                    <a:pt x="380" y="27"/>
                  </a:lnTo>
                  <a:lnTo>
                    <a:pt x="381" y="24"/>
                  </a:lnTo>
                  <a:lnTo>
                    <a:pt x="382" y="24"/>
                  </a:lnTo>
                  <a:lnTo>
                    <a:pt x="383" y="26"/>
                  </a:lnTo>
                  <a:lnTo>
                    <a:pt x="384" y="25"/>
                  </a:lnTo>
                  <a:lnTo>
                    <a:pt x="384" y="21"/>
                  </a:lnTo>
                  <a:lnTo>
                    <a:pt x="385" y="24"/>
                  </a:lnTo>
                  <a:lnTo>
                    <a:pt x="386" y="23"/>
                  </a:lnTo>
                  <a:lnTo>
                    <a:pt x="387" y="23"/>
                  </a:lnTo>
                  <a:lnTo>
                    <a:pt x="388" y="24"/>
                  </a:lnTo>
                  <a:lnTo>
                    <a:pt x="389" y="22"/>
                  </a:lnTo>
                  <a:lnTo>
                    <a:pt x="390" y="26"/>
                  </a:lnTo>
                  <a:lnTo>
                    <a:pt x="391" y="22"/>
                  </a:lnTo>
                  <a:lnTo>
                    <a:pt x="391" y="22"/>
                  </a:lnTo>
                  <a:lnTo>
                    <a:pt x="392" y="19"/>
                  </a:lnTo>
                  <a:lnTo>
                    <a:pt x="393" y="22"/>
                  </a:lnTo>
                  <a:lnTo>
                    <a:pt x="394" y="24"/>
                  </a:lnTo>
                  <a:lnTo>
                    <a:pt x="395" y="22"/>
                  </a:lnTo>
                  <a:lnTo>
                    <a:pt x="396" y="20"/>
                  </a:lnTo>
                  <a:lnTo>
                    <a:pt x="397" y="22"/>
                  </a:lnTo>
                  <a:lnTo>
                    <a:pt x="398" y="20"/>
                  </a:lnTo>
                  <a:lnTo>
                    <a:pt x="399" y="20"/>
                  </a:lnTo>
                  <a:lnTo>
                    <a:pt x="399" y="19"/>
                  </a:lnTo>
                  <a:lnTo>
                    <a:pt x="400" y="18"/>
                  </a:lnTo>
                  <a:lnTo>
                    <a:pt x="401" y="20"/>
                  </a:lnTo>
                  <a:lnTo>
                    <a:pt x="402" y="19"/>
                  </a:lnTo>
                  <a:lnTo>
                    <a:pt x="403" y="20"/>
                  </a:lnTo>
                  <a:lnTo>
                    <a:pt x="404" y="18"/>
                  </a:lnTo>
                  <a:lnTo>
                    <a:pt x="405" y="18"/>
                  </a:lnTo>
                  <a:lnTo>
                    <a:pt x="406" y="20"/>
                  </a:lnTo>
                  <a:lnTo>
                    <a:pt x="406" y="18"/>
                  </a:lnTo>
                  <a:lnTo>
                    <a:pt x="407" y="18"/>
                  </a:lnTo>
                  <a:lnTo>
                    <a:pt x="408" y="19"/>
                  </a:lnTo>
                  <a:lnTo>
                    <a:pt x="409" y="17"/>
                  </a:lnTo>
                  <a:lnTo>
                    <a:pt x="410" y="19"/>
                  </a:lnTo>
                  <a:lnTo>
                    <a:pt x="411" y="20"/>
                  </a:lnTo>
                  <a:lnTo>
                    <a:pt x="412" y="19"/>
                  </a:lnTo>
                  <a:lnTo>
                    <a:pt x="413" y="19"/>
                  </a:lnTo>
                  <a:lnTo>
                    <a:pt x="414" y="19"/>
                  </a:lnTo>
                  <a:lnTo>
                    <a:pt x="414" y="19"/>
                  </a:lnTo>
                  <a:lnTo>
                    <a:pt x="415" y="20"/>
                  </a:lnTo>
                  <a:lnTo>
                    <a:pt x="416" y="20"/>
                  </a:lnTo>
                  <a:lnTo>
                    <a:pt x="417" y="21"/>
                  </a:lnTo>
                  <a:lnTo>
                    <a:pt x="418" y="20"/>
                  </a:lnTo>
                  <a:lnTo>
                    <a:pt x="419" y="19"/>
                  </a:lnTo>
                  <a:lnTo>
                    <a:pt x="420" y="21"/>
                  </a:lnTo>
                  <a:lnTo>
                    <a:pt x="421" y="19"/>
                  </a:lnTo>
                  <a:lnTo>
                    <a:pt x="421" y="21"/>
                  </a:lnTo>
                  <a:lnTo>
                    <a:pt x="422" y="18"/>
                  </a:lnTo>
                  <a:lnTo>
                    <a:pt x="423" y="20"/>
                  </a:lnTo>
                  <a:lnTo>
                    <a:pt x="424" y="19"/>
                  </a:lnTo>
                  <a:lnTo>
                    <a:pt x="425" y="19"/>
                  </a:lnTo>
                  <a:lnTo>
                    <a:pt x="426" y="17"/>
                  </a:lnTo>
                  <a:lnTo>
                    <a:pt x="427" y="17"/>
                  </a:lnTo>
                  <a:lnTo>
                    <a:pt x="428" y="20"/>
                  </a:lnTo>
                  <a:lnTo>
                    <a:pt x="429" y="18"/>
                  </a:lnTo>
                  <a:lnTo>
                    <a:pt x="429" y="17"/>
                  </a:lnTo>
                  <a:lnTo>
                    <a:pt x="430" y="17"/>
                  </a:lnTo>
                  <a:lnTo>
                    <a:pt x="431" y="17"/>
                  </a:lnTo>
                  <a:lnTo>
                    <a:pt x="432" y="17"/>
                  </a:lnTo>
                  <a:lnTo>
                    <a:pt x="433" y="16"/>
                  </a:lnTo>
                  <a:lnTo>
                    <a:pt x="434" y="17"/>
                  </a:lnTo>
                  <a:lnTo>
                    <a:pt x="435" y="17"/>
                  </a:lnTo>
                  <a:lnTo>
                    <a:pt x="436" y="14"/>
                  </a:lnTo>
                  <a:lnTo>
                    <a:pt x="436" y="16"/>
                  </a:lnTo>
                  <a:lnTo>
                    <a:pt x="437" y="16"/>
                  </a:lnTo>
                  <a:lnTo>
                    <a:pt x="438" y="17"/>
                  </a:lnTo>
                  <a:lnTo>
                    <a:pt x="439" y="18"/>
                  </a:lnTo>
                  <a:lnTo>
                    <a:pt x="440" y="15"/>
                  </a:lnTo>
                  <a:lnTo>
                    <a:pt x="441" y="16"/>
                  </a:lnTo>
                  <a:lnTo>
                    <a:pt x="442" y="19"/>
                  </a:lnTo>
                  <a:lnTo>
                    <a:pt x="443" y="15"/>
                  </a:lnTo>
                  <a:lnTo>
                    <a:pt x="444" y="17"/>
                  </a:lnTo>
                  <a:lnTo>
                    <a:pt x="444" y="16"/>
                  </a:lnTo>
                  <a:lnTo>
                    <a:pt x="445" y="16"/>
                  </a:lnTo>
                  <a:lnTo>
                    <a:pt x="446" y="15"/>
                  </a:lnTo>
                  <a:lnTo>
                    <a:pt x="447" y="15"/>
                  </a:lnTo>
                  <a:lnTo>
                    <a:pt x="448" y="16"/>
                  </a:lnTo>
                  <a:lnTo>
                    <a:pt x="449" y="16"/>
                  </a:lnTo>
                  <a:lnTo>
                    <a:pt x="450" y="16"/>
                  </a:lnTo>
                  <a:lnTo>
                    <a:pt x="451" y="14"/>
                  </a:lnTo>
                  <a:lnTo>
                    <a:pt x="451" y="17"/>
                  </a:lnTo>
                  <a:lnTo>
                    <a:pt x="452" y="15"/>
                  </a:lnTo>
                  <a:lnTo>
                    <a:pt x="453" y="15"/>
                  </a:lnTo>
                  <a:lnTo>
                    <a:pt x="454" y="13"/>
                  </a:lnTo>
                  <a:lnTo>
                    <a:pt x="455" y="15"/>
                  </a:lnTo>
                  <a:lnTo>
                    <a:pt x="456" y="14"/>
                  </a:lnTo>
                  <a:lnTo>
                    <a:pt x="457" y="15"/>
                  </a:lnTo>
                  <a:lnTo>
                    <a:pt x="458" y="14"/>
                  </a:lnTo>
                  <a:lnTo>
                    <a:pt x="459" y="16"/>
                  </a:lnTo>
                  <a:lnTo>
                    <a:pt x="459" y="14"/>
                  </a:lnTo>
                  <a:lnTo>
                    <a:pt x="460" y="15"/>
                  </a:lnTo>
                  <a:lnTo>
                    <a:pt x="461" y="14"/>
                  </a:lnTo>
                  <a:lnTo>
                    <a:pt x="462" y="12"/>
                  </a:lnTo>
                  <a:lnTo>
                    <a:pt x="463" y="12"/>
                  </a:lnTo>
                  <a:lnTo>
                    <a:pt x="464" y="14"/>
                  </a:lnTo>
                  <a:lnTo>
                    <a:pt x="465" y="13"/>
                  </a:lnTo>
                  <a:lnTo>
                    <a:pt x="466" y="12"/>
                  </a:lnTo>
                  <a:lnTo>
                    <a:pt x="466" y="14"/>
                  </a:lnTo>
                  <a:lnTo>
                    <a:pt x="467" y="15"/>
                  </a:lnTo>
                  <a:lnTo>
                    <a:pt x="468" y="12"/>
                  </a:lnTo>
                  <a:lnTo>
                    <a:pt x="469" y="12"/>
                  </a:lnTo>
                  <a:lnTo>
                    <a:pt x="470" y="14"/>
                  </a:lnTo>
                  <a:lnTo>
                    <a:pt x="471" y="12"/>
                  </a:lnTo>
                  <a:lnTo>
                    <a:pt x="472" y="12"/>
                  </a:lnTo>
                  <a:lnTo>
                    <a:pt x="473" y="12"/>
                  </a:lnTo>
                  <a:lnTo>
                    <a:pt x="473" y="12"/>
                  </a:lnTo>
                  <a:lnTo>
                    <a:pt x="474" y="11"/>
                  </a:lnTo>
                  <a:lnTo>
                    <a:pt x="475" y="12"/>
                  </a:lnTo>
                  <a:lnTo>
                    <a:pt x="476" y="11"/>
                  </a:lnTo>
                  <a:lnTo>
                    <a:pt x="477" y="11"/>
                  </a:lnTo>
                  <a:lnTo>
                    <a:pt x="478" y="14"/>
                  </a:lnTo>
                  <a:lnTo>
                    <a:pt x="479" y="13"/>
                  </a:lnTo>
                  <a:lnTo>
                    <a:pt x="480" y="11"/>
                  </a:lnTo>
                  <a:lnTo>
                    <a:pt x="481" y="12"/>
                  </a:lnTo>
                  <a:lnTo>
                    <a:pt x="481" y="10"/>
                  </a:lnTo>
                  <a:lnTo>
                    <a:pt x="482" y="12"/>
                  </a:lnTo>
                  <a:lnTo>
                    <a:pt x="483" y="12"/>
                  </a:lnTo>
                  <a:lnTo>
                    <a:pt x="484" y="12"/>
                  </a:lnTo>
                  <a:lnTo>
                    <a:pt x="485" y="11"/>
                  </a:lnTo>
                  <a:lnTo>
                    <a:pt x="486" y="12"/>
                  </a:lnTo>
                  <a:lnTo>
                    <a:pt x="487" y="12"/>
                  </a:lnTo>
                  <a:lnTo>
                    <a:pt x="488" y="12"/>
                  </a:lnTo>
                  <a:lnTo>
                    <a:pt x="488" y="11"/>
                  </a:lnTo>
                  <a:lnTo>
                    <a:pt x="489" y="11"/>
                  </a:lnTo>
                  <a:lnTo>
                    <a:pt x="490" y="10"/>
                  </a:lnTo>
                  <a:lnTo>
                    <a:pt x="491" y="9"/>
                  </a:lnTo>
                  <a:lnTo>
                    <a:pt x="492" y="11"/>
                  </a:lnTo>
                  <a:lnTo>
                    <a:pt x="493" y="10"/>
                  </a:lnTo>
                  <a:lnTo>
                    <a:pt x="494" y="12"/>
                  </a:lnTo>
                  <a:lnTo>
                    <a:pt x="495" y="10"/>
                  </a:lnTo>
                  <a:lnTo>
                    <a:pt x="496" y="11"/>
                  </a:lnTo>
                  <a:lnTo>
                    <a:pt x="496" y="12"/>
                  </a:lnTo>
                  <a:lnTo>
                    <a:pt x="497" y="9"/>
                  </a:lnTo>
                  <a:lnTo>
                    <a:pt x="498" y="10"/>
                  </a:lnTo>
                  <a:lnTo>
                    <a:pt x="499" y="10"/>
                  </a:lnTo>
                  <a:lnTo>
                    <a:pt x="500" y="10"/>
                  </a:lnTo>
                  <a:lnTo>
                    <a:pt x="501" y="10"/>
                  </a:lnTo>
                  <a:lnTo>
                    <a:pt x="502" y="9"/>
                  </a:lnTo>
                  <a:lnTo>
                    <a:pt x="503" y="8"/>
                  </a:lnTo>
                  <a:lnTo>
                    <a:pt x="503" y="11"/>
                  </a:lnTo>
                  <a:lnTo>
                    <a:pt x="504" y="12"/>
                  </a:lnTo>
                  <a:lnTo>
                    <a:pt x="505" y="12"/>
                  </a:lnTo>
                  <a:lnTo>
                    <a:pt x="506" y="12"/>
                  </a:lnTo>
                  <a:lnTo>
                    <a:pt x="507" y="10"/>
                  </a:lnTo>
                  <a:lnTo>
                    <a:pt x="508" y="9"/>
                  </a:lnTo>
                  <a:lnTo>
                    <a:pt x="509" y="10"/>
                  </a:lnTo>
                  <a:lnTo>
                    <a:pt x="510" y="10"/>
                  </a:lnTo>
                  <a:lnTo>
                    <a:pt x="511" y="11"/>
                  </a:lnTo>
                  <a:lnTo>
                    <a:pt x="511" y="10"/>
                  </a:lnTo>
                  <a:lnTo>
                    <a:pt x="512" y="12"/>
                  </a:lnTo>
                  <a:lnTo>
                    <a:pt x="513" y="9"/>
                  </a:lnTo>
                  <a:lnTo>
                    <a:pt x="514" y="11"/>
                  </a:lnTo>
                  <a:lnTo>
                    <a:pt x="515" y="10"/>
                  </a:lnTo>
                  <a:lnTo>
                    <a:pt x="516" y="11"/>
                  </a:lnTo>
                  <a:lnTo>
                    <a:pt x="517" y="11"/>
                  </a:lnTo>
                  <a:lnTo>
                    <a:pt x="518" y="12"/>
                  </a:lnTo>
                  <a:lnTo>
                    <a:pt x="518" y="14"/>
                  </a:lnTo>
                  <a:lnTo>
                    <a:pt x="519" y="13"/>
                  </a:lnTo>
                  <a:lnTo>
                    <a:pt x="520" y="13"/>
                  </a:lnTo>
                  <a:lnTo>
                    <a:pt x="521" y="13"/>
                  </a:lnTo>
                  <a:lnTo>
                    <a:pt x="522" y="15"/>
                  </a:lnTo>
                  <a:lnTo>
                    <a:pt x="523" y="12"/>
                  </a:lnTo>
                  <a:lnTo>
                    <a:pt x="524" y="13"/>
                  </a:lnTo>
                  <a:lnTo>
                    <a:pt x="525" y="12"/>
                  </a:lnTo>
                  <a:lnTo>
                    <a:pt x="526" y="11"/>
                  </a:lnTo>
                  <a:lnTo>
                    <a:pt x="526" y="10"/>
                  </a:lnTo>
                  <a:lnTo>
                    <a:pt x="527" y="9"/>
                  </a:lnTo>
                  <a:lnTo>
                    <a:pt x="528" y="10"/>
                  </a:lnTo>
                  <a:lnTo>
                    <a:pt x="529" y="10"/>
                  </a:lnTo>
                  <a:lnTo>
                    <a:pt x="530" y="10"/>
                  </a:lnTo>
                  <a:lnTo>
                    <a:pt x="531" y="9"/>
                  </a:lnTo>
                  <a:lnTo>
                    <a:pt x="532" y="11"/>
                  </a:lnTo>
                  <a:lnTo>
                    <a:pt x="533" y="10"/>
                  </a:lnTo>
                  <a:lnTo>
                    <a:pt x="533" y="10"/>
                  </a:lnTo>
                  <a:lnTo>
                    <a:pt x="534" y="10"/>
                  </a:lnTo>
                  <a:lnTo>
                    <a:pt x="535" y="10"/>
                  </a:lnTo>
                  <a:lnTo>
                    <a:pt x="536" y="11"/>
                  </a:lnTo>
                  <a:lnTo>
                    <a:pt x="537" y="11"/>
                  </a:lnTo>
                  <a:lnTo>
                    <a:pt x="538" y="11"/>
                  </a:lnTo>
                  <a:lnTo>
                    <a:pt x="539" y="10"/>
                  </a:lnTo>
                  <a:lnTo>
                    <a:pt x="540" y="11"/>
                  </a:lnTo>
                  <a:lnTo>
                    <a:pt x="541" y="10"/>
                  </a:lnTo>
                  <a:lnTo>
                    <a:pt x="541" y="10"/>
                  </a:lnTo>
                  <a:lnTo>
                    <a:pt x="542" y="12"/>
                  </a:lnTo>
                  <a:lnTo>
                    <a:pt x="543" y="10"/>
                  </a:lnTo>
                  <a:lnTo>
                    <a:pt x="544" y="9"/>
                  </a:lnTo>
                  <a:lnTo>
                    <a:pt x="545" y="10"/>
                  </a:lnTo>
                  <a:lnTo>
                    <a:pt x="546" y="11"/>
                  </a:lnTo>
                  <a:lnTo>
                    <a:pt x="547" y="9"/>
                  </a:lnTo>
                  <a:lnTo>
                    <a:pt x="548" y="10"/>
                  </a:lnTo>
                  <a:lnTo>
                    <a:pt x="548" y="9"/>
                  </a:lnTo>
                  <a:lnTo>
                    <a:pt x="549" y="8"/>
                  </a:lnTo>
                  <a:lnTo>
                    <a:pt x="550" y="7"/>
                  </a:lnTo>
                  <a:lnTo>
                    <a:pt x="551" y="8"/>
                  </a:lnTo>
                  <a:lnTo>
                    <a:pt x="552" y="9"/>
                  </a:lnTo>
                  <a:lnTo>
                    <a:pt x="553" y="7"/>
                  </a:lnTo>
                  <a:lnTo>
                    <a:pt x="554" y="9"/>
                  </a:lnTo>
                  <a:lnTo>
                    <a:pt x="555" y="9"/>
                  </a:lnTo>
                  <a:lnTo>
                    <a:pt x="556" y="8"/>
                  </a:lnTo>
                  <a:lnTo>
                    <a:pt x="556" y="10"/>
                  </a:lnTo>
                  <a:lnTo>
                    <a:pt x="557" y="8"/>
                  </a:lnTo>
                  <a:lnTo>
                    <a:pt x="558" y="9"/>
                  </a:lnTo>
                  <a:lnTo>
                    <a:pt x="559" y="7"/>
                  </a:lnTo>
                  <a:lnTo>
                    <a:pt x="560" y="9"/>
                  </a:lnTo>
                  <a:lnTo>
                    <a:pt x="561" y="8"/>
                  </a:lnTo>
                  <a:lnTo>
                    <a:pt x="562" y="9"/>
                  </a:lnTo>
                  <a:lnTo>
                    <a:pt x="563" y="8"/>
                  </a:lnTo>
                  <a:lnTo>
                    <a:pt x="563" y="8"/>
                  </a:lnTo>
                  <a:lnTo>
                    <a:pt x="564" y="8"/>
                  </a:lnTo>
                  <a:lnTo>
                    <a:pt x="565" y="8"/>
                  </a:lnTo>
                  <a:lnTo>
                    <a:pt x="566" y="7"/>
                  </a:lnTo>
                  <a:lnTo>
                    <a:pt x="567" y="6"/>
                  </a:lnTo>
                  <a:lnTo>
                    <a:pt x="568" y="7"/>
                  </a:lnTo>
                  <a:lnTo>
                    <a:pt x="569" y="6"/>
                  </a:lnTo>
                  <a:lnTo>
                    <a:pt x="570" y="6"/>
                  </a:lnTo>
                  <a:lnTo>
                    <a:pt x="571" y="8"/>
                  </a:lnTo>
                  <a:lnTo>
                    <a:pt x="571" y="6"/>
                  </a:lnTo>
                  <a:lnTo>
                    <a:pt x="572" y="7"/>
                  </a:lnTo>
                  <a:lnTo>
                    <a:pt x="573" y="8"/>
                  </a:lnTo>
                  <a:lnTo>
                    <a:pt x="574" y="5"/>
                  </a:lnTo>
                  <a:lnTo>
                    <a:pt x="575" y="7"/>
                  </a:lnTo>
                  <a:lnTo>
                    <a:pt x="576" y="5"/>
                  </a:lnTo>
                  <a:lnTo>
                    <a:pt x="577" y="6"/>
                  </a:lnTo>
                  <a:lnTo>
                    <a:pt x="578" y="6"/>
                  </a:lnTo>
                  <a:lnTo>
                    <a:pt x="578" y="6"/>
                  </a:lnTo>
                  <a:lnTo>
                    <a:pt x="579" y="7"/>
                  </a:lnTo>
                  <a:lnTo>
                    <a:pt x="580" y="7"/>
                  </a:lnTo>
                  <a:lnTo>
                    <a:pt x="581" y="4"/>
                  </a:lnTo>
                  <a:lnTo>
                    <a:pt x="582" y="7"/>
                  </a:lnTo>
                  <a:lnTo>
                    <a:pt x="583" y="6"/>
                  </a:lnTo>
                  <a:lnTo>
                    <a:pt x="584" y="7"/>
                  </a:lnTo>
                  <a:lnTo>
                    <a:pt x="585" y="7"/>
                  </a:lnTo>
                  <a:lnTo>
                    <a:pt x="586" y="5"/>
                  </a:lnTo>
                  <a:lnTo>
                    <a:pt x="586" y="7"/>
                  </a:lnTo>
                  <a:lnTo>
                    <a:pt x="587" y="7"/>
                  </a:lnTo>
                  <a:lnTo>
                    <a:pt x="588" y="7"/>
                  </a:lnTo>
                  <a:lnTo>
                    <a:pt x="589" y="6"/>
                  </a:lnTo>
                  <a:lnTo>
                    <a:pt x="590" y="5"/>
                  </a:lnTo>
                  <a:lnTo>
                    <a:pt x="591" y="6"/>
                  </a:lnTo>
                  <a:lnTo>
                    <a:pt x="592" y="5"/>
                  </a:lnTo>
                  <a:lnTo>
                    <a:pt x="593" y="6"/>
                  </a:lnTo>
                  <a:lnTo>
                    <a:pt x="593" y="6"/>
                  </a:lnTo>
                  <a:lnTo>
                    <a:pt x="594" y="5"/>
                  </a:lnTo>
                  <a:lnTo>
                    <a:pt x="595" y="5"/>
                  </a:lnTo>
                  <a:lnTo>
                    <a:pt x="596" y="6"/>
                  </a:lnTo>
                  <a:lnTo>
                    <a:pt x="597" y="7"/>
                  </a:lnTo>
                  <a:lnTo>
                    <a:pt x="598" y="4"/>
                  </a:lnTo>
                  <a:lnTo>
                    <a:pt x="599" y="5"/>
                  </a:lnTo>
                  <a:lnTo>
                    <a:pt x="600" y="6"/>
                  </a:lnTo>
                  <a:lnTo>
                    <a:pt x="601" y="6"/>
                  </a:lnTo>
                  <a:lnTo>
                    <a:pt x="601" y="5"/>
                  </a:lnTo>
                  <a:lnTo>
                    <a:pt x="602" y="7"/>
                  </a:lnTo>
                  <a:lnTo>
                    <a:pt x="603" y="6"/>
                  </a:lnTo>
                  <a:lnTo>
                    <a:pt x="604" y="5"/>
                  </a:lnTo>
                  <a:lnTo>
                    <a:pt x="605" y="4"/>
                  </a:lnTo>
                  <a:lnTo>
                    <a:pt x="606" y="6"/>
                  </a:lnTo>
                  <a:lnTo>
                    <a:pt x="607" y="7"/>
                  </a:lnTo>
                  <a:lnTo>
                    <a:pt x="608" y="7"/>
                  </a:lnTo>
                  <a:lnTo>
                    <a:pt x="608" y="7"/>
                  </a:lnTo>
                  <a:lnTo>
                    <a:pt x="609" y="5"/>
                  </a:lnTo>
                  <a:lnTo>
                    <a:pt x="610" y="4"/>
                  </a:lnTo>
                  <a:lnTo>
                    <a:pt x="611" y="7"/>
                  </a:lnTo>
                  <a:lnTo>
                    <a:pt x="612" y="4"/>
                  </a:lnTo>
                  <a:lnTo>
                    <a:pt x="613" y="6"/>
                  </a:lnTo>
                  <a:lnTo>
                    <a:pt x="614" y="6"/>
                  </a:lnTo>
                  <a:lnTo>
                    <a:pt x="615" y="4"/>
                  </a:lnTo>
                  <a:lnTo>
                    <a:pt x="616" y="6"/>
                  </a:lnTo>
                  <a:lnTo>
                    <a:pt x="616" y="5"/>
                  </a:lnTo>
                  <a:lnTo>
                    <a:pt x="617" y="8"/>
                  </a:lnTo>
                  <a:lnTo>
                    <a:pt x="618" y="7"/>
                  </a:lnTo>
                  <a:lnTo>
                    <a:pt x="619" y="6"/>
                  </a:lnTo>
                  <a:lnTo>
                    <a:pt x="620" y="7"/>
                  </a:lnTo>
                  <a:lnTo>
                    <a:pt x="621" y="5"/>
                  </a:lnTo>
                  <a:lnTo>
                    <a:pt x="622" y="6"/>
                  </a:lnTo>
                  <a:lnTo>
                    <a:pt x="623" y="5"/>
                  </a:lnTo>
                  <a:lnTo>
                    <a:pt x="623" y="4"/>
                  </a:lnTo>
                  <a:lnTo>
                    <a:pt x="624" y="6"/>
                  </a:lnTo>
                  <a:lnTo>
                    <a:pt x="625" y="5"/>
                  </a:lnTo>
                  <a:lnTo>
                    <a:pt x="626" y="5"/>
                  </a:lnTo>
                  <a:lnTo>
                    <a:pt x="627" y="7"/>
                  </a:lnTo>
                  <a:lnTo>
                    <a:pt x="628" y="4"/>
                  </a:lnTo>
                  <a:lnTo>
                    <a:pt x="629" y="6"/>
                  </a:lnTo>
                  <a:lnTo>
                    <a:pt x="630" y="6"/>
                  </a:lnTo>
                  <a:lnTo>
                    <a:pt x="631" y="5"/>
                  </a:lnTo>
                  <a:lnTo>
                    <a:pt x="631" y="6"/>
                  </a:lnTo>
                  <a:lnTo>
                    <a:pt x="632" y="6"/>
                  </a:lnTo>
                  <a:lnTo>
                    <a:pt x="633" y="6"/>
                  </a:lnTo>
                  <a:lnTo>
                    <a:pt x="634" y="5"/>
                  </a:lnTo>
                  <a:lnTo>
                    <a:pt x="635" y="4"/>
                  </a:lnTo>
                  <a:lnTo>
                    <a:pt x="636" y="6"/>
                  </a:lnTo>
                  <a:lnTo>
                    <a:pt x="637" y="3"/>
                  </a:lnTo>
                  <a:lnTo>
                    <a:pt x="638" y="6"/>
                  </a:lnTo>
                  <a:lnTo>
                    <a:pt x="638" y="4"/>
                  </a:lnTo>
                  <a:lnTo>
                    <a:pt x="639" y="4"/>
                  </a:lnTo>
                  <a:lnTo>
                    <a:pt x="640" y="4"/>
                  </a:lnTo>
                  <a:lnTo>
                    <a:pt x="641" y="6"/>
                  </a:lnTo>
                  <a:lnTo>
                    <a:pt x="642" y="5"/>
                  </a:lnTo>
                  <a:lnTo>
                    <a:pt x="643" y="4"/>
                  </a:lnTo>
                  <a:lnTo>
                    <a:pt x="644" y="6"/>
                  </a:lnTo>
                  <a:lnTo>
                    <a:pt x="645" y="5"/>
                  </a:lnTo>
                  <a:lnTo>
                    <a:pt x="646" y="6"/>
                  </a:lnTo>
                  <a:lnTo>
                    <a:pt x="646" y="5"/>
                  </a:lnTo>
                  <a:lnTo>
                    <a:pt x="647" y="5"/>
                  </a:lnTo>
                  <a:lnTo>
                    <a:pt x="648" y="6"/>
                  </a:lnTo>
                  <a:lnTo>
                    <a:pt x="649" y="3"/>
                  </a:lnTo>
                  <a:lnTo>
                    <a:pt x="650" y="3"/>
                  </a:lnTo>
                  <a:lnTo>
                    <a:pt x="651" y="4"/>
                  </a:lnTo>
                  <a:lnTo>
                    <a:pt x="652" y="6"/>
                  </a:lnTo>
                  <a:lnTo>
                    <a:pt x="653" y="4"/>
                  </a:lnTo>
                  <a:lnTo>
                    <a:pt x="653" y="4"/>
                  </a:lnTo>
                  <a:lnTo>
                    <a:pt x="654" y="4"/>
                  </a:lnTo>
                  <a:lnTo>
                    <a:pt x="655" y="4"/>
                  </a:lnTo>
                  <a:lnTo>
                    <a:pt x="656" y="3"/>
                  </a:lnTo>
                  <a:lnTo>
                    <a:pt x="657" y="4"/>
                  </a:lnTo>
                  <a:lnTo>
                    <a:pt x="658" y="5"/>
                  </a:lnTo>
                  <a:lnTo>
                    <a:pt x="659" y="5"/>
                  </a:lnTo>
                  <a:lnTo>
                    <a:pt x="660" y="5"/>
                  </a:lnTo>
                  <a:lnTo>
                    <a:pt x="661" y="4"/>
                  </a:lnTo>
                  <a:lnTo>
                    <a:pt x="661" y="6"/>
                  </a:lnTo>
                  <a:lnTo>
                    <a:pt x="662" y="3"/>
                  </a:lnTo>
                  <a:lnTo>
                    <a:pt x="663" y="5"/>
                  </a:lnTo>
                  <a:lnTo>
                    <a:pt x="664" y="4"/>
                  </a:lnTo>
                  <a:lnTo>
                    <a:pt x="665" y="5"/>
                  </a:lnTo>
                  <a:lnTo>
                    <a:pt x="666" y="5"/>
                  </a:lnTo>
                  <a:lnTo>
                    <a:pt x="667" y="5"/>
                  </a:lnTo>
                  <a:lnTo>
                    <a:pt x="668" y="5"/>
                  </a:lnTo>
                  <a:lnTo>
                    <a:pt x="668" y="4"/>
                  </a:lnTo>
                  <a:lnTo>
                    <a:pt x="669" y="4"/>
                  </a:lnTo>
                  <a:lnTo>
                    <a:pt x="670" y="6"/>
                  </a:lnTo>
                  <a:lnTo>
                    <a:pt x="671" y="4"/>
                  </a:lnTo>
                  <a:lnTo>
                    <a:pt x="672" y="5"/>
                  </a:lnTo>
                  <a:lnTo>
                    <a:pt x="673" y="5"/>
                  </a:lnTo>
                  <a:lnTo>
                    <a:pt x="674" y="5"/>
                  </a:lnTo>
                  <a:lnTo>
                    <a:pt x="675" y="4"/>
                  </a:lnTo>
                  <a:lnTo>
                    <a:pt x="675" y="5"/>
                  </a:lnTo>
                  <a:lnTo>
                    <a:pt x="676" y="5"/>
                  </a:lnTo>
                  <a:lnTo>
                    <a:pt x="677" y="4"/>
                  </a:lnTo>
                  <a:lnTo>
                    <a:pt x="678" y="5"/>
                  </a:lnTo>
                  <a:lnTo>
                    <a:pt x="679" y="4"/>
                  </a:lnTo>
                  <a:lnTo>
                    <a:pt x="680" y="4"/>
                  </a:lnTo>
                  <a:lnTo>
                    <a:pt x="681" y="4"/>
                  </a:lnTo>
                  <a:lnTo>
                    <a:pt x="682" y="3"/>
                  </a:lnTo>
                  <a:lnTo>
                    <a:pt x="683" y="5"/>
                  </a:lnTo>
                  <a:lnTo>
                    <a:pt x="683" y="3"/>
                  </a:lnTo>
                  <a:lnTo>
                    <a:pt x="684" y="4"/>
                  </a:lnTo>
                  <a:lnTo>
                    <a:pt x="685" y="5"/>
                  </a:lnTo>
                  <a:lnTo>
                    <a:pt x="686" y="3"/>
                  </a:lnTo>
                  <a:lnTo>
                    <a:pt x="687" y="3"/>
                  </a:lnTo>
                  <a:lnTo>
                    <a:pt x="688" y="4"/>
                  </a:lnTo>
                  <a:lnTo>
                    <a:pt x="689" y="3"/>
                  </a:lnTo>
                  <a:lnTo>
                    <a:pt x="690" y="3"/>
                  </a:lnTo>
                  <a:lnTo>
                    <a:pt x="690" y="4"/>
                  </a:lnTo>
                  <a:lnTo>
                    <a:pt x="691" y="5"/>
                  </a:lnTo>
                  <a:lnTo>
                    <a:pt x="692" y="5"/>
                  </a:lnTo>
                  <a:lnTo>
                    <a:pt x="693" y="4"/>
                  </a:lnTo>
                  <a:lnTo>
                    <a:pt x="694" y="4"/>
                  </a:lnTo>
                  <a:lnTo>
                    <a:pt x="695" y="4"/>
                  </a:lnTo>
                  <a:lnTo>
                    <a:pt x="696" y="3"/>
                  </a:lnTo>
                  <a:lnTo>
                    <a:pt x="697" y="3"/>
                  </a:lnTo>
                  <a:lnTo>
                    <a:pt x="698" y="3"/>
                  </a:lnTo>
                  <a:lnTo>
                    <a:pt x="698" y="3"/>
                  </a:lnTo>
                  <a:lnTo>
                    <a:pt x="699" y="2"/>
                  </a:lnTo>
                  <a:lnTo>
                    <a:pt x="700" y="4"/>
                  </a:lnTo>
                  <a:lnTo>
                    <a:pt x="701" y="3"/>
                  </a:lnTo>
                  <a:lnTo>
                    <a:pt x="702" y="4"/>
                  </a:lnTo>
                  <a:lnTo>
                    <a:pt x="703" y="3"/>
                  </a:lnTo>
                  <a:lnTo>
                    <a:pt x="704" y="3"/>
                  </a:lnTo>
                  <a:lnTo>
                    <a:pt x="705" y="1"/>
                  </a:lnTo>
                  <a:lnTo>
                    <a:pt x="705" y="3"/>
                  </a:lnTo>
                  <a:lnTo>
                    <a:pt x="706" y="2"/>
                  </a:lnTo>
                  <a:lnTo>
                    <a:pt x="707" y="4"/>
                  </a:lnTo>
                  <a:lnTo>
                    <a:pt x="708" y="2"/>
                  </a:lnTo>
                  <a:lnTo>
                    <a:pt x="709" y="5"/>
                  </a:lnTo>
                  <a:lnTo>
                    <a:pt x="710" y="3"/>
                  </a:lnTo>
                  <a:lnTo>
                    <a:pt x="711" y="3"/>
                  </a:lnTo>
                  <a:lnTo>
                    <a:pt x="712" y="4"/>
                  </a:lnTo>
                  <a:lnTo>
                    <a:pt x="713" y="4"/>
                  </a:lnTo>
                  <a:lnTo>
                    <a:pt x="713" y="1"/>
                  </a:lnTo>
                  <a:lnTo>
                    <a:pt x="714" y="4"/>
                  </a:lnTo>
                  <a:lnTo>
                    <a:pt x="715" y="3"/>
                  </a:lnTo>
                  <a:lnTo>
                    <a:pt x="716" y="2"/>
                  </a:lnTo>
                  <a:lnTo>
                    <a:pt x="717" y="3"/>
                  </a:lnTo>
                  <a:lnTo>
                    <a:pt x="718" y="3"/>
                  </a:lnTo>
                  <a:lnTo>
                    <a:pt x="719" y="4"/>
                  </a:lnTo>
                  <a:lnTo>
                    <a:pt x="720" y="1"/>
                  </a:lnTo>
                  <a:lnTo>
                    <a:pt x="720" y="3"/>
                  </a:lnTo>
                  <a:lnTo>
                    <a:pt x="721" y="1"/>
                  </a:lnTo>
                  <a:lnTo>
                    <a:pt x="722" y="3"/>
                  </a:lnTo>
                  <a:lnTo>
                    <a:pt x="723" y="2"/>
                  </a:lnTo>
                  <a:lnTo>
                    <a:pt x="724" y="4"/>
                  </a:lnTo>
                  <a:lnTo>
                    <a:pt x="725" y="3"/>
                  </a:lnTo>
                  <a:lnTo>
                    <a:pt x="726" y="3"/>
                  </a:lnTo>
                  <a:lnTo>
                    <a:pt x="727" y="3"/>
                  </a:lnTo>
                  <a:lnTo>
                    <a:pt x="728" y="2"/>
                  </a:lnTo>
                  <a:lnTo>
                    <a:pt x="728" y="3"/>
                  </a:lnTo>
                  <a:lnTo>
                    <a:pt x="729" y="3"/>
                  </a:lnTo>
                  <a:lnTo>
                    <a:pt x="730" y="3"/>
                  </a:lnTo>
                  <a:lnTo>
                    <a:pt x="731" y="2"/>
                  </a:lnTo>
                  <a:lnTo>
                    <a:pt x="732" y="2"/>
                  </a:lnTo>
                  <a:lnTo>
                    <a:pt x="733" y="4"/>
                  </a:lnTo>
                  <a:lnTo>
                    <a:pt x="734" y="4"/>
                  </a:lnTo>
                  <a:lnTo>
                    <a:pt x="735" y="2"/>
                  </a:lnTo>
                  <a:lnTo>
                    <a:pt x="735" y="4"/>
                  </a:lnTo>
                  <a:lnTo>
                    <a:pt x="736" y="2"/>
                  </a:lnTo>
                  <a:lnTo>
                    <a:pt x="737" y="4"/>
                  </a:lnTo>
                  <a:lnTo>
                    <a:pt x="738" y="3"/>
                  </a:lnTo>
                  <a:lnTo>
                    <a:pt x="739" y="4"/>
                  </a:lnTo>
                  <a:lnTo>
                    <a:pt x="740" y="3"/>
                  </a:lnTo>
                  <a:lnTo>
                    <a:pt x="741" y="3"/>
                  </a:lnTo>
                  <a:lnTo>
                    <a:pt x="742" y="2"/>
                  </a:lnTo>
                  <a:lnTo>
                    <a:pt x="743" y="3"/>
                  </a:lnTo>
                  <a:lnTo>
                    <a:pt x="743" y="2"/>
                  </a:lnTo>
                  <a:lnTo>
                    <a:pt x="744" y="4"/>
                  </a:lnTo>
                  <a:lnTo>
                    <a:pt x="745" y="2"/>
                  </a:lnTo>
                  <a:lnTo>
                    <a:pt x="746" y="3"/>
                  </a:lnTo>
                  <a:lnTo>
                    <a:pt x="747" y="2"/>
                  </a:lnTo>
                  <a:lnTo>
                    <a:pt x="748" y="2"/>
                  </a:lnTo>
                  <a:lnTo>
                    <a:pt x="749" y="3"/>
                  </a:lnTo>
                  <a:lnTo>
                    <a:pt x="750" y="2"/>
                  </a:lnTo>
                  <a:lnTo>
                    <a:pt x="750" y="3"/>
                  </a:lnTo>
                  <a:lnTo>
                    <a:pt x="751" y="3"/>
                  </a:lnTo>
                  <a:lnTo>
                    <a:pt x="752" y="2"/>
                  </a:lnTo>
                  <a:lnTo>
                    <a:pt x="753" y="3"/>
                  </a:lnTo>
                  <a:lnTo>
                    <a:pt x="754" y="1"/>
                  </a:lnTo>
                  <a:lnTo>
                    <a:pt x="755" y="5"/>
                  </a:lnTo>
                  <a:lnTo>
                    <a:pt x="756" y="2"/>
                  </a:lnTo>
                  <a:lnTo>
                    <a:pt x="757" y="1"/>
                  </a:lnTo>
                  <a:lnTo>
                    <a:pt x="758" y="3"/>
                  </a:lnTo>
                  <a:lnTo>
                    <a:pt x="758" y="1"/>
                  </a:lnTo>
                  <a:lnTo>
                    <a:pt x="759" y="2"/>
                  </a:lnTo>
                  <a:lnTo>
                    <a:pt x="760" y="3"/>
                  </a:lnTo>
                  <a:lnTo>
                    <a:pt x="761" y="2"/>
                  </a:lnTo>
                  <a:lnTo>
                    <a:pt x="762" y="0"/>
                  </a:lnTo>
                  <a:lnTo>
                    <a:pt x="763" y="3"/>
                  </a:lnTo>
                  <a:lnTo>
                    <a:pt x="764" y="3"/>
                  </a:lnTo>
                  <a:lnTo>
                    <a:pt x="765" y="2"/>
                  </a:lnTo>
                  <a:lnTo>
                    <a:pt x="765" y="2"/>
                  </a:lnTo>
                  <a:lnTo>
                    <a:pt x="766" y="2"/>
                  </a:lnTo>
                  <a:lnTo>
                    <a:pt x="767" y="1"/>
                  </a:lnTo>
                  <a:lnTo>
                    <a:pt x="768" y="0"/>
                  </a:lnTo>
                  <a:lnTo>
                    <a:pt x="769" y="1"/>
                  </a:lnTo>
                  <a:lnTo>
                    <a:pt x="770" y="2"/>
                  </a:lnTo>
                  <a:lnTo>
                    <a:pt x="771" y="2"/>
                  </a:lnTo>
                  <a:lnTo>
                    <a:pt x="772" y="1"/>
                  </a:lnTo>
                  <a:lnTo>
                    <a:pt x="773" y="1"/>
                  </a:lnTo>
                  <a:lnTo>
                    <a:pt x="773" y="2"/>
                  </a:lnTo>
                  <a:lnTo>
                    <a:pt x="774" y="0"/>
                  </a:lnTo>
                  <a:lnTo>
                    <a:pt x="775" y="2"/>
                  </a:lnTo>
                  <a:lnTo>
                    <a:pt x="776" y="1"/>
                  </a:lnTo>
                  <a:lnTo>
                    <a:pt x="777" y="1"/>
                  </a:lnTo>
                  <a:lnTo>
                    <a:pt x="778" y="2"/>
                  </a:lnTo>
                  <a:lnTo>
                    <a:pt x="779" y="1"/>
                  </a:lnTo>
                  <a:lnTo>
                    <a:pt x="780" y="2"/>
                  </a:lnTo>
                  <a:lnTo>
                    <a:pt x="780" y="1"/>
                  </a:lnTo>
                  <a:lnTo>
                    <a:pt x="781" y="1"/>
                  </a:lnTo>
                  <a:lnTo>
                    <a:pt x="782" y="2"/>
                  </a:lnTo>
                  <a:lnTo>
                    <a:pt x="783" y="1"/>
                  </a:lnTo>
                  <a:lnTo>
                    <a:pt x="784" y="1"/>
                  </a:lnTo>
                  <a:lnTo>
                    <a:pt x="785" y="1"/>
                  </a:lnTo>
                  <a:lnTo>
                    <a:pt x="786" y="1"/>
                  </a:lnTo>
                  <a:lnTo>
                    <a:pt x="787" y="1"/>
                  </a:lnTo>
                  <a:lnTo>
                    <a:pt x="788" y="4"/>
                  </a:lnTo>
                  <a:lnTo>
                    <a:pt x="788" y="3"/>
                  </a:lnTo>
                  <a:lnTo>
                    <a:pt x="789" y="3"/>
                  </a:lnTo>
                  <a:lnTo>
                    <a:pt x="789" y="3"/>
                  </a:lnTo>
                </a:path>
              </a:pathLst>
            </a:custGeom>
            <a:noFill/>
            <a:ln w="0">
              <a:solidFill>
                <a:srgbClr val="7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84" name="TextBox 183"/>
          <p:cNvSpPr txBox="1"/>
          <p:nvPr/>
        </p:nvSpPr>
        <p:spPr>
          <a:xfrm>
            <a:off x="2971800" y="6964690"/>
            <a:ext cx="16466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tention time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min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/>
          <p:cNvSpPr txBox="1"/>
          <p:nvPr/>
        </p:nvSpPr>
        <p:spPr>
          <a:xfrm rot="16200000">
            <a:off x="-576050" y="3396863"/>
            <a:ext cx="20233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undance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TIC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185"/>
          <p:cNvSpPr txBox="1"/>
          <p:nvPr/>
        </p:nvSpPr>
        <p:spPr>
          <a:xfrm>
            <a:off x="297105" y="7203282"/>
            <a:ext cx="63246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2.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resentative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GC-MS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romatograms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xane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tracts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de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ninfected and </a:t>
            </a:r>
            <a:r>
              <a:rPr lang="en-US" sz="12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hytophthora</a:t>
            </a:r>
            <a:r>
              <a:rPr 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ctorum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infected </a:t>
            </a:r>
            <a:r>
              <a:rPr 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Populus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trichocarpa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oots and </a:t>
            </a:r>
            <a:r>
              <a:rPr lang="de-DE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de-DE" sz="12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ctorum</a:t>
            </a:r>
            <a:r>
              <a:rPr lang="de-DE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celium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, 1-hexanol; 2, 1,8-cineole*; 3, benzylalcohol*; 4, salicylaldehyde*; 5, (</a:t>
            </a:r>
            <a:r>
              <a:rPr lang="de-DE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-4-nonenal; 6, 2-phenylethanol*; 7, </a:t>
            </a:r>
            <a:r>
              <a:rPr lang="el-G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erpineol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; 8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aminatio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oftener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; 9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lemol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; 10, (1</a:t>
            </a:r>
            <a:r>
              <a:rPr lang="de-DE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5</a:t>
            </a:r>
            <a:r>
              <a:rPr lang="de-DE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7</a:t>
            </a:r>
            <a:r>
              <a:rPr lang="de-DE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10</a:t>
            </a:r>
            <a:r>
              <a:rPr lang="de-DE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-guaia-4(15)-en-11-ol + (1</a:t>
            </a:r>
            <a:r>
              <a:rPr lang="de-DE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7</a:t>
            </a:r>
            <a:r>
              <a:rPr lang="de-DE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10</a:t>
            </a:r>
            <a:r>
              <a:rPr lang="de-DE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-guaia-4-en-11-ol; 11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ristaldehyd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; 12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ristic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; 13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identifi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mpou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; 14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ntadecanoic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; 15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lmitic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; 16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leic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; 17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earic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; 18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identifi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mpou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; IS, internal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andar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nylacetat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mpounds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k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sterisks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dentifi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uthentic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andards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TIC,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o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Box 186"/>
          <p:cNvSpPr txBox="1"/>
          <p:nvPr/>
        </p:nvSpPr>
        <p:spPr>
          <a:xfrm>
            <a:off x="2759076" y="2055654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TextBox 187"/>
          <p:cNvSpPr txBox="1"/>
          <p:nvPr/>
        </p:nvSpPr>
        <p:spPr>
          <a:xfrm>
            <a:off x="2755900" y="3881279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TextBox 188"/>
          <p:cNvSpPr txBox="1"/>
          <p:nvPr/>
        </p:nvSpPr>
        <p:spPr>
          <a:xfrm>
            <a:off x="2755900" y="5257800"/>
            <a:ext cx="3048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89"/>
          <p:cNvSpPr txBox="1"/>
          <p:nvPr/>
        </p:nvSpPr>
        <p:spPr>
          <a:xfrm>
            <a:off x="1462479" y="644509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TextBox 190"/>
          <p:cNvSpPr txBox="1"/>
          <p:nvPr/>
        </p:nvSpPr>
        <p:spPr>
          <a:xfrm>
            <a:off x="1460500" y="4914900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TextBox 191"/>
          <p:cNvSpPr txBox="1"/>
          <p:nvPr/>
        </p:nvSpPr>
        <p:spPr>
          <a:xfrm>
            <a:off x="1764102" y="630539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TextBox 192"/>
          <p:cNvSpPr txBox="1"/>
          <p:nvPr/>
        </p:nvSpPr>
        <p:spPr>
          <a:xfrm>
            <a:off x="1766183" y="4844996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TextBox 193"/>
          <p:cNvSpPr txBox="1"/>
          <p:nvPr/>
        </p:nvSpPr>
        <p:spPr>
          <a:xfrm>
            <a:off x="1992702" y="638159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TextBox 194"/>
          <p:cNvSpPr txBox="1"/>
          <p:nvPr/>
        </p:nvSpPr>
        <p:spPr>
          <a:xfrm>
            <a:off x="1965323" y="494040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TextBox 196"/>
          <p:cNvSpPr txBox="1"/>
          <p:nvPr/>
        </p:nvSpPr>
        <p:spPr>
          <a:xfrm>
            <a:off x="1524000" y="4672053"/>
            <a:ext cx="4667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+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TextBox 198"/>
          <p:cNvSpPr txBox="1"/>
          <p:nvPr/>
        </p:nvSpPr>
        <p:spPr>
          <a:xfrm>
            <a:off x="2070100" y="4927600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TextBox 201"/>
          <p:cNvSpPr txBox="1"/>
          <p:nvPr/>
        </p:nvSpPr>
        <p:spPr>
          <a:xfrm>
            <a:off x="3453202" y="639429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TextBox 202"/>
          <p:cNvSpPr txBox="1"/>
          <p:nvPr/>
        </p:nvSpPr>
        <p:spPr>
          <a:xfrm>
            <a:off x="3451223" y="4927600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TextBox 203"/>
          <p:cNvSpPr txBox="1"/>
          <p:nvPr/>
        </p:nvSpPr>
        <p:spPr>
          <a:xfrm>
            <a:off x="3454400" y="3251200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TextBox 204"/>
          <p:cNvSpPr txBox="1"/>
          <p:nvPr/>
        </p:nvSpPr>
        <p:spPr>
          <a:xfrm>
            <a:off x="3581400" y="4953000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TextBox 205"/>
          <p:cNvSpPr txBox="1"/>
          <p:nvPr/>
        </p:nvSpPr>
        <p:spPr>
          <a:xfrm>
            <a:off x="3811834" y="49149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TextBox 206"/>
          <p:cNvSpPr txBox="1"/>
          <p:nvPr/>
        </p:nvSpPr>
        <p:spPr>
          <a:xfrm>
            <a:off x="3996250" y="48514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TextBox 207"/>
          <p:cNvSpPr txBox="1"/>
          <p:nvPr/>
        </p:nvSpPr>
        <p:spPr>
          <a:xfrm>
            <a:off x="4035425" y="63831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TextBox 208"/>
          <p:cNvSpPr txBox="1"/>
          <p:nvPr/>
        </p:nvSpPr>
        <p:spPr>
          <a:xfrm>
            <a:off x="4119270" y="45974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TextBox 209"/>
          <p:cNvSpPr txBox="1"/>
          <p:nvPr/>
        </p:nvSpPr>
        <p:spPr>
          <a:xfrm>
            <a:off x="4127500" y="27940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TextBox 210"/>
          <p:cNvSpPr txBox="1"/>
          <p:nvPr/>
        </p:nvSpPr>
        <p:spPr>
          <a:xfrm>
            <a:off x="4271670" y="479074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TextBox 211"/>
          <p:cNvSpPr txBox="1"/>
          <p:nvPr/>
        </p:nvSpPr>
        <p:spPr>
          <a:xfrm>
            <a:off x="4424070" y="48718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TextBox 212"/>
          <p:cNvSpPr txBox="1"/>
          <p:nvPr/>
        </p:nvSpPr>
        <p:spPr>
          <a:xfrm>
            <a:off x="4394200" y="64135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TextBox 213"/>
          <p:cNvSpPr txBox="1"/>
          <p:nvPr/>
        </p:nvSpPr>
        <p:spPr>
          <a:xfrm>
            <a:off x="4660317" y="569753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TextBox 214"/>
          <p:cNvSpPr txBox="1"/>
          <p:nvPr/>
        </p:nvSpPr>
        <p:spPr>
          <a:xfrm>
            <a:off x="4779670" y="37288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TextBox 215"/>
          <p:cNvSpPr txBox="1"/>
          <p:nvPr/>
        </p:nvSpPr>
        <p:spPr>
          <a:xfrm>
            <a:off x="4671720" y="14986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TextBox 216"/>
          <p:cNvSpPr txBox="1"/>
          <p:nvPr/>
        </p:nvSpPr>
        <p:spPr>
          <a:xfrm>
            <a:off x="5068595" y="44781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TextBox 217"/>
          <p:cNvSpPr txBox="1"/>
          <p:nvPr/>
        </p:nvSpPr>
        <p:spPr>
          <a:xfrm>
            <a:off x="5250865" y="201295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TextBox 218"/>
          <p:cNvSpPr txBox="1"/>
          <p:nvPr/>
        </p:nvSpPr>
        <p:spPr>
          <a:xfrm>
            <a:off x="5102225" y="3760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TextBox 219"/>
          <p:cNvSpPr txBox="1"/>
          <p:nvPr/>
        </p:nvSpPr>
        <p:spPr>
          <a:xfrm>
            <a:off x="5059070" y="63831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TextBox 220"/>
          <p:cNvSpPr txBox="1"/>
          <p:nvPr/>
        </p:nvSpPr>
        <p:spPr>
          <a:xfrm>
            <a:off x="5194300" y="48260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TextBox 221"/>
          <p:cNvSpPr txBox="1"/>
          <p:nvPr/>
        </p:nvSpPr>
        <p:spPr>
          <a:xfrm>
            <a:off x="5511800" y="28144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TextBox 222"/>
          <p:cNvSpPr txBox="1"/>
          <p:nvPr/>
        </p:nvSpPr>
        <p:spPr>
          <a:xfrm>
            <a:off x="1397163" y="368300"/>
            <a:ext cx="17967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de-DE" sz="12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ctorum</a:t>
            </a:r>
            <a:r>
              <a:rPr lang="de-DE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celium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TextBox 223"/>
          <p:cNvSpPr txBox="1"/>
          <p:nvPr/>
        </p:nvSpPr>
        <p:spPr>
          <a:xfrm>
            <a:off x="1390990" y="3568700"/>
            <a:ext cx="21141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de-DE" sz="12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ctorum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-infected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oots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TextBox 224"/>
          <p:cNvSpPr txBox="1"/>
          <p:nvPr/>
        </p:nvSpPr>
        <p:spPr>
          <a:xfrm>
            <a:off x="1397000" y="5209401"/>
            <a:ext cx="1391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infected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oots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38" name="Group 1537"/>
          <p:cNvGrpSpPr/>
          <p:nvPr/>
        </p:nvGrpSpPr>
        <p:grpSpPr>
          <a:xfrm>
            <a:off x="1384302" y="5468144"/>
            <a:ext cx="5003802" cy="1173955"/>
            <a:chOff x="-5384800" y="4132263"/>
            <a:chExt cx="5241925" cy="2322513"/>
          </a:xfrm>
        </p:grpSpPr>
        <p:sp>
          <p:nvSpPr>
            <p:cNvPr id="1535" name="Freeform 565"/>
            <p:cNvSpPr>
              <a:spLocks/>
            </p:cNvSpPr>
            <p:nvPr/>
          </p:nvSpPr>
          <p:spPr bwMode="auto">
            <a:xfrm flipV="1">
              <a:off x="-5384800" y="4132263"/>
              <a:ext cx="2352675" cy="2322513"/>
            </a:xfrm>
            <a:custGeom>
              <a:avLst/>
              <a:gdLst>
                <a:gd name="T0" fmla="*/ 52 w 3386"/>
                <a:gd name="T1" fmla="*/ 6 h 7279"/>
                <a:gd name="T2" fmla="*/ 105 w 3386"/>
                <a:gd name="T3" fmla="*/ 3 h 7279"/>
                <a:gd name="T4" fmla="*/ 158 w 3386"/>
                <a:gd name="T5" fmla="*/ 2 h 7279"/>
                <a:gd name="T6" fmla="*/ 211 w 3386"/>
                <a:gd name="T7" fmla="*/ 4 h 7279"/>
                <a:gd name="T8" fmla="*/ 264 w 3386"/>
                <a:gd name="T9" fmla="*/ 10 h 7279"/>
                <a:gd name="T10" fmla="*/ 317 w 3386"/>
                <a:gd name="T11" fmla="*/ 10 h 7279"/>
                <a:gd name="T12" fmla="*/ 370 w 3386"/>
                <a:gd name="T13" fmla="*/ 13 h 7279"/>
                <a:gd name="T14" fmla="*/ 423 w 3386"/>
                <a:gd name="T15" fmla="*/ 15 h 7279"/>
                <a:gd name="T16" fmla="*/ 476 w 3386"/>
                <a:gd name="T17" fmla="*/ 69 h 7279"/>
                <a:gd name="T18" fmla="*/ 528 w 3386"/>
                <a:gd name="T19" fmla="*/ 55 h 7279"/>
                <a:gd name="T20" fmla="*/ 581 w 3386"/>
                <a:gd name="T21" fmla="*/ 10 h 7279"/>
                <a:gd name="T22" fmla="*/ 634 w 3386"/>
                <a:gd name="T23" fmla="*/ 4 h 7279"/>
                <a:gd name="T24" fmla="*/ 687 w 3386"/>
                <a:gd name="T25" fmla="*/ 16 h 7279"/>
                <a:gd name="T26" fmla="*/ 740 w 3386"/>
                <a:gd name="T27" fmla="*/ 15 h 7279"/>
                <a:gd name="T28" fmla="*/ 793 w 3386"/>
                <a:gd name="T29" fmla="*/ 70 h 7279"/>
                <a:gd name="T30" fmla="*/ 846 w 3386"/>
                <a:gd name="T31" fmla="*/ 33 h 7279"/>
                <a:gd name="T32" fmla="*/ 899 w 3386"/>
                <a:gd name="T33" fmla="*/ 22 h 7279"/>
                <a:gd name="T34" fmla="*/ 952 w 3386"/>
                <a:gd name="T35" fmla="*/ 15 h 7279"/>
                <a:gd name="T36" fmla="*/ 1005 w 3386"/>
                <a:gd name="T37" fmla="*/ 8 h 7279"/>
                <a:gd name="T38" fmla="*/ 1058 w 3386"/>
                <a:gd name="T39" fmla="*/ 9 h 7279"/>
                <a:gd name="T40" fmla="*/ 1111 w 3386"/>
                <a:gd name="T41" fmla="*/ 162 h 7279"/>
                <a:gd name="T42" fmla="*/ 1164 w 3386"/>
                <a:gd name="T43" fmla="*/ 29 h 7279"/>
                <a:gd name="T44" fmla="*/ 1216 w 3386"/>
                <a:gd name="T45" fmla="*/ 17 h 7279"/>
                <a:gd name="T46" fmla="*/ 1269 w 3386"/>
                <a:gd name="T47" fmla="*/ 4 h 7279"/>
                <a:gd name="T48" fmla="*/ 1322 w 3386"/>
                <a:gd name="T49" fmla="*/ 5 h 7279"/>
                <a:gd name="T50" fmla="*/ 1375 w 3386"/>
                <a:gd name="T51" fmla="*/ 14 h 7279"/>
                <a:gd name="T52" fmla="*/ 1428 w 3386"/>
                <a:gd name="T53" fmla="*/ 12 h 7279"/>
                <a:gd name="T54" fmla="*/ 1481 w 3386"/>
                <a:gd name="T55" fmla="*/ 13 h 7279"/>
                <a:gd name="T56" fmla="*/ 1534 w 3386"/>
                <a:gd name="T57" fmla="*/ 10 h 7279"/>
                <a:gd name="T58" fmla="*/ 1587 w 3386"/>
                <a:gd name="T59" fmla="*/ 6 h 7279"/>
                <a:gd name="T60" fmla="*/ 1640 w 3386"/>
                <a:gd name="T61" fmla="*/ 45 h 7279"/>
                <a:gd name="T62" fmla="*/ 1693 w 3386"/>
                <a:gd name="T63" fmla="*/ 22 h 7279"/>
                <a:gd name="T64" fmla="*/ 1746 w 3386"/>
                <a:gd name="T65" fmla="*/ 6 h 7279"/>
                <a:gd name="T66" fmla="*/ 1799 w 3386"/>
                <a:gd name="T67" fmla="*/ 6 h 7279"/>
                <a:gd name="T68" fmla="*/ 1852 w 3386"/>
                <a:gd name="T69" fmla="*/ 6 h 7279"/>
                <a:gd name="T70" fmla="*/ 1904 w 3386"/>
                <a:gd name="T71" fmla="*/ 1 h 7279"/>
                <a:gd name="T72" fmla="*/ 1957 w 3386"/>
                <a:gd name="T73" fmla="*/ 6 h 7279"/>
                <a:gd name="T74" fmla="*/ 2010 w 3386"/>
                <a:gd name="T75" fmla="*/ 22 h 7279"/>
                <a:gd name="T76" fmla="*/ 2063 w 3386"/>
                <a:gd name="T77" fmla="*/ 10 h 7279"/>
                <a:gd name="T78" fmla="*/ 2116 w 3386"/>
                <a:gd name="T79" fmla="*/ 5 h 7279"/>
                <a:gd name="T80" fmla="*/ 2169 w 3386"/>
                <a:gd name="T81" fmla="*/ 4 h 7279"/>
                <a:gd name="T82" fmla="*/ 2222 w 3386"/>
                <a:gd name="T83" fmla="*/ 3 h 7279"/>
                <a:gd name="T84" fmla="*/ 2275 w 3386"/>
                <a:gd name="T85" fmla="*/ 8 h 7279"/>
                <a:gd name="T86" fmla="*/ 2328 w 3386"/>
                <a:gd name="T87" fmla="*/ 105 h 7279"/>
                <a:gd name="T88" fmla="*/ 2381 w 3386"/>
                <a:gd name="T89" fmla="*/ 25 h 7279"/>
                <a:gd name="T90" fmla="*/ 2434 w 3386"/>
                <a:gd name="T91" fmla="*/ 14 h 7279"/>
                <a:gd name="T92" fmla="*/ 2487 w 3386"/>
                <a:gd name="T93" fmla="*/ 8 h 7279"/>
                <a:gd name="T94" fmla="*/ 2540 w 3386"/>
                <a:gd name="T95" fmla="*/ 16 h 7279"/>
                <a:gd name="T96" fmla="*/ 2593 w 3386"/>
                <a:gd name="T97" fmla="*/ 7 h 7279"/>
                <a:gd name="T98" fmla="*/ 2645 w 3386"/>
                <a:gd name="T99" fmla="*/ 8 h 7279"/>
                <a:gd name="T100" fmla="*/ 2698 w 3386"/>
                <a:gd name="T101" fmla="*/ 3 h 7279"/>
                <a:gd name="T102" fmla="*/ 2751 w 3386"/>
                <a:gd name="T103" fmla="*/ 9 h 7279"/>
                <a:gd name="T104" fmla="*/ 2804 w 3386"/>
                <a:gd name="T105" fmla="*/ 3 h 7279"/>
                <a:gd name="T106" fmla="*/ 2857 w 3386"/>
                <a:gd name="T107" fmla="*/ 7 h 7279"/>
                <a:gd name="T108" fmla="*/ 2910 w 3386"/>
                <a:gd name="T109" fmla="*/ 7 h 7279"/>
                <a:gd name="T110" fmla="*/ 2963 w 3386"/>
                <a:gd name="T111" fmla="*/ 3 h 7279"/>
                <a:gd name="T112" fmla="*/ 3016 w 3386"/>
                <a:gd name="T113" fmla="*/ 3 h 7279"/>
                <a:gd name="T114" fmla="*/ 3069 w 3386"/>
                <a:gd name="T115" fmla="*/ 3 h 7279"/>
                <a:gd name="T116" fmla="*/ 3122 w 3386"/>
                <a:gd name="T117" fmla="*/ 52 h 7279"/>
                <a:gd name="T118" fmla="*/ 3175 w 3386"/>
                <a:gd name="T119" fmla="*/ 31 h 7279"/>
                <a:gd name="T120" fmla="*/ 3228 w 3386"/>
                <a:gd name="T121" fmla="*/ 20 h 7279"/>
                <a:gd name="T122" fmla="*/ 3281 w 3386"/>
                <a:gd name="T123" fmla="*/ 17 h 7279"/>
                <a:gd name="T124" fmla="*/ 3333 w 3386"/>
                <a:gd name="T125" fmla="*/ 13 h 72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3386" h="7279">
                  <a:moveTo>
                    <a:pt x="0" y="1"/>
                  </a:moveTo>
                  <a:lnTo>
                    <a:pt x="1" y="2"/>
                  </a:lnTo>
                  <a:lnTo>
                    <a:pt x="2" y="2"/>
                  </a:lnTo>
                  <a:lnTo>
                    <a:pt x="3" y="4"/>
                  </a:lnTo>
                  <a:lnTo>
                    <a:pt x="4" y="1"/>
                  </a:lnTo>
                  <a:lnTo>
                    <a:pt x="4" y="2"/>
                  </a:lnTo>
                  <a:lnTo>
                    <a:pt x="5" y="4"/>
                  </a:lnTo>
                  <a:lnTo>
                    <a:pt x="6" y="3"/>
                  </a:lnTo>
                  <a:lnTo>
                    <a:pt x="7" y="4"/>
                  </a:lnTo>
                  <a:lnTo>
                    <a:pt x="8" y="5"/>
                  </a:lnTo>
                  <a:lnTo>
                    <a:pt x="9" y="4"/>
                  </a:lnTo>
                  <a:lnTo>
                    <a:pt x="10" y="1"/>
                  </a:lnTo>
                  <a:lnTo>
                    <a:pt x="11" y="1"/>
                  </a:lnTo>
                  <a:lnTo>
                    <a:pt x="12" y="2"/>
                  </a:lnTo>
                  <a:lnTo>
                    <a:pt x="12" y="2"/>
                  </a:lnTo>
                  <a:lnTo>
                    <a:pt x="13" y="2"/>
                  </a:lnTo>
                  <a:lnTo>
                    <a:pt x="14" y="2"/>
                  </a:lnTo>
                  <a:lnTo>
                    <a:pt x="15" y="2"/>
                  </a:lnTo>
                  <a:lnTo>
                    <a:pt x="16" y="3"/>
                  </a:lnTo>
                  <a:lnTo>
                    <a:pt x="17" y="1"/>
                  </a:lnTo>
                  <a:lnTo>
                    <a:pt x="18" y="3"/>
                  </a:lnTo>
                  <a:lnTo>
                    <a:pt x="19" y="3"/>
                  </a:lnTo>
                  <a:lnTo>
                    <a:pt x="19" y="4"/>
                  </a:lnTo>
                  <a:lnTo>
                    <a:pt x="20" y="2"/>
                  </a:lnTo>
                  <a:lnTo>
                    <a:pt x="21" y="2"/>
                  </a:lnTo>
                  <a:lnTo>
                    <a:pt x="22" y="2"/>
                  </a:lnTo>
                  <a:lnTo>
                    <a:pt x="23" y="1"/>
                  </a:lnTo>
                  <a:lnTo>
                    <a:pt x="24" y="2"/>
                  </a:lnTo>
                  <a:lnTo>
                    <a:pt x="25" y="0"/>
                  </a:lnTo>
                  <a:lnTo>
                    <a:pt x="26" y="0"/>
                  </a:lnTo>
                  <a:lnTo>
                    <a:pt x="27" y="2"/>
                  </a:lnTo>
                  <a:lnTo>
                    <a:pt x="27" y="1"/>
                  </a:lnTo>
                  <a:lnTo>
                    <a:pt x="28" y="1"/>
                  </a:lnTo>
                  <a:lnTo>
                    <a:pt x="29" y="3"/>
                  </a:lnTo>
                  <a:lnTo>
                    <a:pt x="30" y="1"/>
                  </a:lnTo>
                  <a:lnTo>
                    <a:pt x="31" y="0"/>
                  </a:lnTo>
                  <a:lnTo>
                    <a:pt x="32" y="2"/>
                  </a:lnTo>
                  <a:lnTo>
                    <a:pt x="33" y="1"/>
                  </a:lnTo>
                  <a:lnTo>
                    <a:pt x="34" y="2"/>
                  </a:lnTo>
                  <a:lnTo>
                    <a:pt x="34" y="2"/>
                  </a:lnTo>
                  <a:lnTo>
                    <a:pt x="35" y="2"/>
                  </a:lnTo>
                  <a:lnTo>
                    <a:pt x="36" y="1"/>
                  </a:lnTo>
                  <a:lnTo>
                    <a:pt x="37" y="3"/>
                  </a:lnTo>
                  <a:lnTo>
                    <a:pt x="38" y="3"/>
                  </a:lnTo>
                  <a:lnTo>
                    <a:pt x="39" y="3"/>
                  </a:lnTo>
                  <a:lnTo>
                    <a:pt x="40" y="4"/>
                  </a:lnTo>
                  <a:lnTo>
                    <a:pt x="41" y="3"/>
                  </a:lnTo>
                  <a:lnTo>
                    <a:pt x="42" y="1"/>
                  </a:lnTo>
                  <a:lnTo>
                    <a:pt x="42" y="4"/>
                  </a:lnTo>
                  <a:lnTo>
                    <a:pt x="43" y="2"/>
                  </a:lnTo>
                  <a:lnTo>
                    <a:pt x="44" y="3"/>
                  </a:lnTo>
                  <a:lnTo>
                    <a:pt x="45" y="1"/>
                  </a:lnTo>
                  <a:lnTo>
                    <a:pt x="46" y="2"/>
                  </a:lnTo>
                  <a:lnTo>
                    <a:pt x="47" y="2"/>
                  </a:lnTo>
                  <a:lnTo>
                    <a:pt x="48" y="2"/>
                  </a:lnTo>
                  <a:lnTo>
                    <a:pt x="49" y="4"/>
                  </a:lnTo>
                  <a:lnTo>
                    <a:pt x="49" y="3"/>
                  </a:lnTo>
                  <a:lnTo>
                    <a:pt x="50" y="3"/>
                  </a:lnTo>
                  <a:lnTo>
                    <a:pt x="51" y="3"/>
                  </a:lnTo>
                  <a:lnTo>
                    <a:pt x="52" y="6"/>
                  </a:lnTo>
                  <a:lnTo>
                    <a:pt x="53" y="6"/>
                  </a:lnTo>
                  <a:lnTo>
                    <a:pt x="54" y="6"/>
                  </a:lnTo>
                  <a:lnTo>
                    <a:pt x="55" y="5"/>
                  </a:lnTo>
                  <a:lnTo>
                    <a:pt x="56" y="6"/>
                  </a:lnTo>
                  <a:lnTo>
                    <a:pt x="57" y="6"/>
                  </a:lnTo>
                  <a:lnTo>
                    <a:pt x="57" y="2"/>
                  </a:lnTo>
                  <a:lnTo>
                    <a:pt x="58" y="5"/>
                  </a:lnTo>
                  <a:lnTo>
                    <a:pt x="59" y="4"/>
                  </a:lnTo>
                  <a:lnTo>
                    <a:pt x="60" y="4"/>
                  </a:lnTo>
                  <a:lnTo>
                    <a:pt x="61" y="3"/>
                  </a:lnTo>
                  <a:lnTo>
                    <a:pt x="62" y="3"/>
                  </a:lnTo>
                  <a:lnTo>
                    <a:pt x="63" y="3"/>
                  </a:lnTo>
                  <a:lnTo>
                    <a:pt x="64" y="4"/>
                  </a:lnTo>
                  <a:lnTo>
                    <a:pt x="64" y="4"/>
                  </a:lnTo>
                  <a:lnTo>
                    <a:pt x="65" y="3"/>
                  </a:lnTo>
                  <a:lnTo>
                    <a:pt x="66" y="2"/>
                  </a:lnTo>
                  <a:lnTo>
                    <a:pt x="67" y="5"/>
                  </a:lnTo>
                  <a:lnTo>
                    <a:pt x="68" y="3"/>
                  </a:lnTo>
                  <a:lnTo>
                    <a:pt x="69" y="4"/>
                  </a:lnTo>
                  <a:lnTo>
                    <a:pt x="70" y="0"/>
                  </a:lnTo>
                  <a:lnTo>
                    <a:pt x="71" y="2"/>
                  </a:lnTo>
                  <a:lnTo>
                    <a:pt x="72" y="5"/>
                  </a:lnTo>
                  <a:lnTo>
                    <a:pt x="72" y="2"/>
                  </a:lnTo>
                  <a:lnTo>
                    <a:pt x="73" y="1"/>
                  </a:lnTo>
                  <a:lnTo>
                    <a:pt x="74" y="2"/>
                  </a:lnTo>
                  <a:lnTo>
                    <a:pt x="75" y="4"/>
                  </a:lnTo>
                  <a:lnTo>
                    <a:pt x="76" y="0"/>
                  </a:lnTo>
                  <a:lnTo>
                    <a:pt x="77" y="1"/>
                  </a:lnTo>
                  <a:lnTo>
                    <a:pt x="78" y="2"/>
                  </a:lnTo>
                  <a:lnTo>
                    <a:pt x="79" y="2"/>
                  </a:lnTo>
                  <a:lnTo>
                    <a:pt x="79" y="2"/>
                  </a:lnTo>
                  <a:lnTo>
                    <a:pt x="80" y="2"/>
                  </a:lnTo>
                  <a:lnTo>
                    <a:pt x="81" y="3"/>
                  </a:lnTo>
                  <a:lnTo>
                    <a:pt x="82" y="3"/>
                  </a:lnTo>
                  <a:lnTo>
                    <a:pt x="83" y="3"/>
                  </a:lnTo>
                  <a:lnTo>
                    <a:pt x="84" y="3"/>
                  </a:lnTo>
                  <a:lnTo>
                    <a:pt x="85" y="2"/>
                  </a:lnTo>
                  <a:lnTo>
                    <a:pt x="86" y="2"/>
                  </a:lnTo>
                  <a:lnTo>
                    <a:pt x="87" y="3"/>
                  </a:lnTo>
                  <a:lnTo>
                    <a:pt x="87" y="3"/>
                  </a:lnTo>
                  <a:lnTo>
                    <a:pt x="88" y="4"/>
                  </a:lnTo>
                  <a:lnTo>
                    <a:pt x="89" y="5"/>
                  </a:lnTo>
                  <a:lnTo>
                    <a:pt x="90" y="2"/>
                  </a:lnTo>
                  <a:lnTo>
                    <a:pt x="91" y="4"/>
                  </a:lnTo>
                  <a:lnTo>
                    <a:pt x="92" y="6"/>
                  </a:lnTo>
                  <a:lnTo>
                    <a:pt x="93" y="6"/>
                  </a:lnTo>
                  <a:lnTo>
                    <a:pt x="94" y="7"/>
                  </a:lnTo>
                  <a:lnTo>
                    <a:pt x="94" y="7"/>
                  </a:lnTo>
                  <a:lnTo>
                    <a:pt x="95" y="3"/>
                  </a:lnTo>
                  <a:lnTo>
                    <a:pt x="96" y="5"/>
                  </a:lnTo>
                  <a:lnTo>
                    <a:pt x="97" y="7"/>
                  </a:lnTo>
                  <a:lnTo>
                    <a:pt x="98" y="4"/>
                  </a:lnTo>
                  <a:lnTo>
                    <a:pt x="99" y="3"/>
                  </a:lnTo>
                  <a:lnTo>
                    <a:pt x="100" y="2"/>
                  </a:lnTo>
                  <a:lnTo>
                    <a:pt x="101" y="2"/>
                  </a:lnTo>
                  <a:lnTo>
                    <a:pt x="102" y="4"/>
                  </a:lnTo>
                  <a:lnTo>
                    <a:pt x="102" y="4"/>
                  </a:lnTo>
                  <a:lnTo>
                    <a:pt x="103" y="4"/>
                  </a:lnTo>
                  <a:lnTo>
                    <a:pt x="104" y="4"/>
                  </a:lnTo>
                  <a:lnTo>
                    <a:pt x="105" y="3"/>
                  </a:lnTo>
                  <a:lnTo>
                    <a:pt x="106" y="5"/>
                  </a:lnTo>
                  <a:lnTo>
                    <a:pt x="107" y="3"/>
                  </a:lnTo>
                  <a:lnTo>
                    <a:pt x="108" y="5"/>
                  </a:lnTo>
                  <a:lnTo>
                    <a:pt x="109" y="4"/>
                  </a:lnTo>
                  <a:lnTo>
                    <a:pt x="109" y="6"/>
                  </a:lnTo>
                  <a:lnTo>
                    <a:pt x="110" y="4"/>
                  </a:lnTo>
                  <a:lnTo>
                    <a:pt x="111" y="6"/>
                  </a:lnTo>
                  <a:lnTo>
                    <a:pt x="112" y="7"/>
                  </a:lnTo>
                  <a:lnTo>
                    <a:pt x="113" y="3"/>
                  </a:lnTo>
                  <a:lnTo>
                    <a:pt x="114" y="4"/>
                  </a:lnTo>
                  <a:lnTo>
                    <a:pt x="115" y="5"/>
                  </a:lnTo>
                  <a:lnTo>
                    <a:pt x="116" y="7"/>
                  </a:lnTo>
                  <a:lnTo>
                    <a:pt x="117" y="5"/>
                  </a:lnTo>
                  <a:lnTo>
                    <a:pt x="117" y="6"/>
                  </a:lnTo>
                  <a:lnTo>
                    <a:pt x="118" y="8"/>
                  </a:lnTo>
                  <a:lnTo>
                    <a:pt x="119" y="4"/>
                  </a:lnTo>
                  <a:lnTo>
                    <a:pt x="120" y="3"/>
                  </a:lnTo>
                  <a:lnTo>
                    <a:pt x="121" y="4"/>
                  </a:lnTo>
                  <a:lnTo>
                    <a:pt x="122" y="4"/>
                  </a:lnTo>
                  <a:lnTo>
                    <a:pt x="123" y="3"/>
                  </a:lnTo>
                  <a:lnTo>
                    <a:pt x="124" y="4"/>
                  </a:lnTo>
                  <a:lnTo>
                    <a:pt x="124" y="5"/>
                  </a:lnTo>
                  <a:lnTo>
                    <a:pt x="125" y="3"/>
                  </a:lnTo>
                  <a:lnTo>
                    <a:pt x="126" y="2"/>
                  </a:lnTo>
                  <a:lnTo>
                    <a:pt x="127" y="1"/>
                  </a:lnTo>
                  <a:lnTo>
                    <a:pt x="128" y="1"/>
                  </a:lnTo>
                  <a:lnTo>
                    <a:pt x="129" y="1"/>
                  </a:lnTo>
                  <a:lnTo>
                    <a:pt x="130" y="1"/>
                  </a:lnTo>
                  <a:lnTo>
                    <a:pt x="131" y="2"/>
                  </a:lnTo>
                  <a:lnTo>
                    <a:pt x="131" y="1"/>
                  </a:lnTo>
                  <a:lnTo>
                    <a:pt x="132" y="4"/>
                  </a:lnTo>
                  <a:lnTo>
                    <a:pt x="133" y="4"/>
                  </a:lnTo>
                  <a:lnTo>
                    <a:pt x="134" y="4"/>
                  </a:lnTo>
                  <a:lnTo>
                    <a:pt x="135" y="4"/>
                  </a:lnTo>
                  <a:lnTo>
                    <a:pt x="136" y="5"/>
                  </a:lnTo>
                  <a:lnTo>
                    <a:pt x="137" y="5"/>
                  </a:lnTo>
                  <a:lnTo>
                    <a:pt x="138" y="7"/>
                  </a:lnTo>
                  <a:lnTo>
                    <a:pt x="139" y="5"/>
                  </a:lnTo>
                  <a:lnTo>
                    <a:pt x="139" y="6"/>
                  </a:lnTo>
                  <a:lnTo>
                    <a:pt x="140" y="6"/>
                  </a:lnTo>
                  <a:lnTo>
                    <a:pt x="141" y="7"/>
                  </a:lnTo>
                  <a:lnTo>
                    <a:pt x="142" y="8"/>
                  </a:lnTo>
                  <a:lnTo>
                    <a:pt x="143" y="9"/>
                  </a:lnTo>
                  <a:lnTo>
                    <a:pt x="144" y="7"/>
                  </a:lnTo>
                  <a:lnTo>
                    <a:pt x="145" y="5"/>
                  </a:lnTo>
                  <a:lnTo>
                    <a:pt x="146" y="8"/>
                  </a:lnTo>
                  <a:lnTo>
                    <a:pt x="146" y="4"/>
                  </a:lnTo>
                  <a:lnTo>
                    <a:pt x="147" y="8"/>
                  </a:lnTo>
                  <a:lnTo>
                    <a:pt x="148" y="6"/>
                  </a:lnTo>
                  <a:lnTo>
                    <a:pt x="149" y="4"/>
                  </a:lnTo>
                  <a:lnTo>
                    <a:pt x="150" y="3"/>
                  </a:lnTo>
                  <a:lnTo>
                    <a:pt x="151" y="2"/>
                  </a:lnTo>
                  <a:lnTo>
                    <a:pt x="152" y="4"/>
                  </a:lnTo>
                  <a:lnTo>
                    <a:pt x="153" y="4"/>
                  </a:lnTo>
                  <a:lnTo>
                    <a:pt x="154" y="2"/>
                  </a:lnTo>
                  <a:lnTo>
                    <a:pt x="154" y="3"/>
                  </a:lnTo>
                  <a:lnTo>
                    <a:pt x="155" y="1"/>
                  </a:lnTo>
                  <a:lnTo>
                    <a:pt x="156" y="1"/>
                  </a:lnTo>
                  <a:lnTo>
                    <a:pt x="157" y="3"/>
                  </a:lnTo>
                  <a:lnTo>
                    <a:pt x="158" y="2"/>
                  </a:lnTo>
                  <a:lnTo>
                    <a:pt x="159" y="2"/>
                  </a:lnTo>
                  <a:lnTo>
                    <a:pt x="160" y="3"/>
                  </a:lnTo>
                  <a:lnTo>
                    <a:pt x="161" y="2"/>
                  </a:lnTo>
                  <a:lnTo>
                    <a:pt x="161" y="3"/>
                  </a:lnTo>
                  <a:lnTo>
                    <a:pt x="162" y="2"/>
                  </a:lnTo>
                  <a:lnTo>
                    <a:pt x="163" y="2"/>
                  </a:lnTo>
                  <a:lnTo>
                    <a:pt x="164" y="3"/>
                  </a:lnTo>
                  <a:lnTo>
                    <a:pt x="165" y="5"/>
                  </a:lnTo>
                  <a:lnTo>
                    <a:pt x="166" y="4"/>
                  </a:lnTo>
                  <a:lnTo>
                    <a:pt x="167" y="4"/>
                  </a:lnTo>
                  <a:lnTo>
                    <a:pt x="168" y="4"/>
                  </a:lnTo>
                  <a:lnTo>
                    <a:pt x="169" y="5"/>
                  </a:lnTo>
                  <a:lnTo>
                    <a:pt x="169" y="5"/>
                  </a:lnTo>
                  <a:lnTo>
                    <a:pt x="170" y="5"/>
                  </a:lnTo>
                  <a:lnTo>
                    <a:pt x="171" y="8"/>
                  </a:lnTo>
                  <a:lnTo>
                    <a:pt x="172" y="8"/>
                  </a:lnTo>
                  <a:lnTo>
                    <a:pt x="173" y="8"/>
                  </a:lnTo>
                  <a:lnTo>
                    <a:pt x="174" y="7"/>
                  </a:lnTo>
                  <a:lnTo>
                    <a:pt x="175" y="8"/>
                  </a:lnTo>
                  <a:lnTo>
                    <a:pt x="176" y="6"/>
                  </a:lnTo>
                  <a:lnTo>
                    <a:pt x="176" y="6"/>
                  </a:lnTo>
                  <a:lnTo>
                    <a:pt x="177" y="4"/>
                  </a:lnTo>
                  <a:lnTo>
                    <a:pt x="178" y="4"/>
                  </a:lnTo>
                  <a:lnTo>
                    <a:pt x="179" y="2"/>
                  </a:lnTo>
                  <a:lnTo>
                    <a:pt x="180" y="5"/>
                  </a:lnTo>
                  <a:lnTo>
                    <a:pt x="181" y="4"/>
                  </a:lnTo>
                  <a:lnTo>
                    <a:pt x="182" y="6"/>
                  </a:lnTo>
                  <a:lnTo>
                    <a:pt x="183" y="7"/>
                  </a:lnTo>
                  <a:lnTo>
                    <a:pt x="184" y="9"/>
                  </a:lnTo>
                  <a:lnTo>
                    <a:pt x="184" y="9"/>
                  </a:lnTo>
                  <a:lnTo>
                    <a:pt x="185" y="11"/>
                  </a:lnTo>
                  <a:lnTo>
                    <a:pt x="186" y="11"/>
                  </a:lnTo>
                  <a:lnTo>
                    <a:pt x="187" y="12"/>
                  </a:lnTo>
                  <a:lnTo>
                    <a:pt x="188" y="11"/>
                  </a:lnTo>
                  <a:lnTo>
                    <a:pt x="189" y="12"/>
                  </a:lnTo>
                  <a:lnTo>
                    <a:pt x="190" y="8"/>
                  </a:lnTo>
                  <a:lnTo>
                    <a:pt x="191" y="10"/>
                  </a:lnTo>
                  <a:lnTo>
                    <a:pt x="191" y="7"/>
                  </a:lnTo>
                  <a:lnTo>
                    <a:pt x="192" y="3"/>
                  </a:lnTo>
                  <a:lnTo>
                    <a:pt x="193" y="6"/>
                  </a:lnTo>
                  <a:lnTo>
                    <a:pt x="194" y="8"/>
                  </a:lnTo>
                  <a:lnTo>
                    <a:pt x="195" y="3"/>
                  </a:lnTo>
                  <a:lnTo>
                    <a:pt x="196" y="5"/>
                  </a:lnTo>
                  <a:lnTo>
                    <a:pt x="197" y="5"/>
                  </a:lnTo>
                  <a:lnTo>
                    <a:pt x="198" y="5"/>
                  </a:lnTo>
                  <a:lnTo>
                    <a:pt x="199" y="5"/>
                  </a:lnTo>
                  <a:lnTo>
                    <a:pt x="199" y="5"/>
                  </a:lnTo>
                  <a:lnTo>
                    <a:pt x="200" y="5"/>
                  </a:lnTo>
                  <a:lnTo>
                    <a:pt x="201" y="5"/>
                  </a:lnTo>
                  <a:lnTo>
                    <a:pt x="202" y="3"/>
                  </a:lnTo>
                  <a:lnTo>
                    <a:pt x="203" y="3"/>
                  </a:lnTo>
                  <a:lnTo>
                    <a:pt x="204" y="5"/>
                  </a:lnTo>
                  <a:lnTo>
                    <a:pt x="205" y="3"/>
                  </a:lnTo>
                  <a:lnTo>
                    <a:pt x="206" y="3"/>
                  </a:lnTo>
                  <a:lnTo>
                    <a:pt x="206" y="3"/>
                  </a:lnTo>
                  <a:lnTo>
                    <a:pt x="207" y="4"/>
                  </a:lnTo>
                  <a:lnTo>
                    <a:pt x="208" y="8"/>
                  </a:lnTo>
                  <a:lnTo>
                    <a:pt x="209" y="7"/>
                  </a:lnTo>
                  <a:lnTo>
                    <a:pt x="210" y="3"/>
                  </a:lnTo>
                  <a:lnTo>
                    <a:pt x="211" y="4"/>
                  </a:lnTo>
                  <a:lnTo>
                    <a:pt x="212" y="5"/>
                  </a:lnTo>
                  <a:lnTo>
                    <a:pt x="213" y="5"/>
                  </a:lnTo>
                  <a:lnTo>
                    <a:pt x="214" y="6"/>
                  </a:lnTo>
                  <a:lnTo>
                    <a:pt x="214" y="4"/>
                  </a:lnTo>
                  <a:lnTo>
                    <a:pt x="215" y="6"/>
                  </a:lnTo>
                  <a:lnTo>
                    <a:pt x="216" y="5"/>
                  </a:lnTo>
                  <a:lnTo>
                    <a:pt x="217" y="6"/>
                  </a:lnTo>
                  <a:lnTo>
                    <a:pt x="218" y="4"/>
                  </a:lnTo>
                  <a:lnTo>
                    <a:pt x="219" y="5"/>
                  </a:lnTo>
                  <a:lnTo>
                    <a:pt x="220" y="4"/>
                  </a:lnTo>
                  <a:lnTo>
                    <a:pt x="221" y="6"/>
                  </a:lnTo>
                  <a:lnTo>
                    <a:pt x="221" y="3"/>
                  </a:lnTo>
                  <a:lnTo>
                    <a:pt x="222" y="5"/>
                  </a:lnTo>
                  <a:lnTo>
                    <a:pt x="223" y="4"/>
                  </a:lnTo>
                  <a:lnTo>
                    <a:pt x="224" y="3"/>
                  </a:lnTo>
                  <a:lnTo>
                    <a:pt x="225" y="2"/>
                  </a:lnTo>
                  <a:lnTo>
                    <a:pt x="226" y="2"/>
                  </a:lnTo>
                  <a:lnTo>
                    <a:pt x="227" y="6"/>
                  </a:lnTo>
                  <a:lnTo>
                    <a:pt x="228" y="3"/>
                  </a:lnTo>
                  <a:lnTo>
                    <a:pt x="229" y="5"/>
                  </a:lnTo>
                  <a:lnTo>
                    <a:pt x="229" y="4"/>
                  </a:lnTo>
                  <a:lnTo>
                    <a:pt x="230" y="3"/>
                  </a:lnTo>
                  <a:lnTo>
                    <a:pt x="231" y="3"/>
                  </a:lnTo>
                  <a:lnTo>
                    <a:pt x="232" y="3"/>
                  </a:lnTo>
                  <a:lnTo>
                    <a:pt x="233" y="6"/>
                  </a:lnTo>
                  <a:lnTo>
                    <a:pt x="234" y="3"/>
                  </a:lnTo>
                  <a:lnTo>
                    <a:pt x="235" y="4"/>
                  </a:lnTo>
                  <a:lnTo>
                    <a:pt x="236" y="4"/>
                  </a:lnTo>
                  <a:lnTo>
                    <a:pt x="236" y="3"/>
                  </a:lnTo>
                  <a:lnTo>
                    <a:pt x="237" y="3"/>
                  </a:lnTo>
                  <a:lnTo>
                    <a:pt x="238" y="6"/>
                  </a:lnTo>
                  <a:lnTo>
                    <a:pt x="239" y="4"/>
                  </a:lnTo>
                  <a:lnTo>
                    <a:pt x="240" y="8"/>
                  </a:lnTo>
                  <a:lnTo>
                    <a:pt x="241" y="5"/>
                  </a:lnTo>
                  <a:lnTo>
                    <a:pt x="242" y="5"/>
                  </a:lnTo>
                  <a:lnTo>
                    <a:pt x="243" y="9"/>
                  </a:lnTo>
                  <a:lnTo>
                    <a:pt x="244" y="8"/>
                  </a:lnTo>
                  <a:lnTo>
                    <a:pt x="244" y="6"/>
                  </a:lnTo>
                  <a:lnTo>
                    <a:pt x="245" y="4"/>
                  </a:lnTo>
                  <a:lnTo>
                    <a:pt x="246" y="4"/>
                  </a:lnTo>
                  <a:lnTo>
                    <a:pt x="247" y="5"/>
                  </a:lnTo>
                  <a:lnTo>
                    <a:pt x="248" y="2"/>
                  </a:lnTo>
                  <a:lnTo>
                    <a:pt x="249" y="6"/>
                  </a:lnTo>
                  <a:lnTo>
                    <a:pt x="250" y="4"/>
                  </a:lnTo>
                  <a:lnTo>
                    <a:pt x="251" y="4"/>
                  </a:lnTo>
                  <a:lnTo>
                    <a:pt x="251" y="4"/>
                  </a:lnTo>
                  <a:lnTo>
                    <a:pt x="252" y="4"/>
                  </a:lnTo>
                  <a:lnTo>
                    <a:pt x="253" y="5"/>
                  </a:lnTo>
                  <a:lnTo>
                    <a:pt x="254" y="4"/>
                  </a:lnTo>
                  <a:lnTo>
                    <a:pt x="255" y="8"/>
                  </a:lnTo>
                  <a:lnTo>
                    <a:pt x="256" y="6"/>
                  </a:lnTo>
                  <a:lnTo>
                    <a:pt x="257" y="12"/>
                  </a:lnTo>
                  <a:lnTo>
                    <a:pt x="258" y="14"/>
                  </a:lnTo>
                  <a:lnTo>
                    <a:pt x="259" y="12"/>
                  </a:lnTo>
                  <a:lnTo>
                    <a:pt x="259" y="12"/>
                  </a:lnTo>
                  <a:lnTo>
                    <a:pt x="260" y="14"/>
                  </a:lnTo>
                  <a:lnTo>
                    <a:pt x="261" y="11"/>
                  </a:lnTo>
                  <a:lnTo>
                    <a:pt x="262" y="13"/>
                  </a:lnTo>
                  <a:lnTo>
                    <a:pt x="263" y="12"/>
                  </a:lnTo>
                  <a:lnTo>
                    <a:pt x="264" y="10"/>
                  </a:lnTo>
                  <a:lnTo>
                    <a:pt x="265" y="8"/>
                  </a:lnTo>
                  <a:lnTo>
                    <a:pt x="266" y="11"/>
                  </a:lnTo>
                  <a:lnTo>
                    <a:pt x="266" y="8"/>
                  </a:lnTo>
                  <a:lnTo>
                    <a:pt x="267" y="9"/>
                  </a:lnTo>
                  <a:lnTo>
                    <a:pt x="268" y="12"/>
                  </a:lnTo>
                  <a:lnTo>
                    <a:pt x="269" y="10"/>
                  </a:lnTo>
                  <a:lnTo>
                    <a:pt x="270" y="10"/>
                  </a:lnTo>
                  <a:lnTo>
                    <a:pt x="271" y="8"/>
                  </a:lnTo>
                  <a:lnTo>
                    <a:pt x="272" y="7"/>
                  </a:lnTo>
                  <a:lnTo>
                    <a:pt x="273" y="8"/>
                  </a:lnTo>
                  <a:lnTo>
                    <a:pt x="274" y="6"/>
                  </a:lnTo>
                  <a:lnTo>
                    <a:pt x="274" y="7"/>
                  </a:lnTo>
                  <a:lnTo>
                    <a:pt x="275" y="8"/>
                  </a:lnTo>
                  <a:lnTo>
                    <a:pt x="276" y="7"/>
                  </a:lnTo>
                  <a:lnTo>
                    <a:pt x="277" y="7"/>
                  </a:lnTo>
                  <a:lnTo>
                    <a:pt x="278" y="12"/>
                  </a:lnTo>
                  <a:lnTo>
                    <a:pt x="279" y="17"/>
                  </a:lnTo>
                  <a:lnTo>
                    <a:pt x="280" y="28"/>
                  </a:lnTo>
                  <a:lnTo>
                    <a:pt x="281" y="46"/>
                  </a:lnTo>
                  <a:lnTo>
                    <a:pt x="281" y="65"/>
                  </a:lnTo>
                  <a:lnTo>
                    <a:pt x="282" y="92"/>
                  </a:lnTo>
                  <a:lnTo>
                    <a:pt x="283" y="112"/>
                  </a:lnTo>
                  <a:lnTo>
                    <a:pt x="284" y="119"/>
                  </a:lnTo>
                  <a:lnTo>
                    <a:pt x="285" y="119"/>
                  </a:lnTo>
                  <a:lnTo>
                    <a:pt x="286" y="113"/>
                  </a:lnTo>
                  <a:lnTo>
                    <a:pt x="287" y="96"/>
                  </a:lnTo>
                  <a:lnTo>
                    <a:pt x="288" y="81"/>
                  </a:lnTo>
                  <a:lnTo>
                    <a:pt x="289" y="61"/>
                  </a:lnTo>
                  <a:lnTo>
                    <a:pt x="289" y="49"/>
                  </a:lnTo>
                  <a:lnTo>
                    <a:pt x="290" y="40"/>
                  </a:lnTo>
                  <a:lnTo>
                    <a:pt x="291" y="35"/>
                  </a:lnTo>
                  <a:lnTo>
                    <a:pt x="292" y="31"/>
                  </a:lnTo>
                  <a:lnTo>
                    <a:pt x="293" y="28"/>
                  </a:lnTo>
                  <a:lnTo>
                    <a:pt x="294" y="29"/>
                  </a:lnTo>
                  <a:lnTo>
                    <a:pt x="295" y="27"/>
                  </a:lnTo>
                  <a:lnTo>
                    <a:pt x="296" y="26"/>
                  </a:lnTo>
                  <a:lnTo>
                    <a:pt x="296" y="20"/>
                  </a:lnTo>
                  <a:lnTo>
                    <a:pt x="297" y="23"/>
                  </a:lnTo>
                  <a:lnTo>
                    <a:pt x="298" y="21"/>
                  </a:lnTo>
                  <a:lnTo>
                    <a:pt x="299" y="21"/>
                  </a:lnTo>
                  <a:lnTo>
                    <a:pt x="300" y="16"/>
                  </a:lnTo>
                  <a:lnTo>
                    <a:pt x="301" y="15"/>
                  </a:lnTo>
                  <a:lnTo>
                    <a:pt x="302" y="20"/>
                  </a:lnTo>
                  <a:lnTo>
                    <a:pt x="303" y="19"/>
                  </a:lnTo>
                  <a:lnTo>
                    <a:pt x="304" y="15"/>
                  </a:lnTo>
                  <a:lnTo>
                    <a:pt x="304" y="19"/>
                  </a:lnTo>
                  <a:lnTo>
                    <a:pt x="305" y="15"/>
                  </a:lnTo>
                  <a:lnTo>
                    <a:pt x="306" y="17"/>
                  </a:lnTo>
                  <a:lnTo>
                    <a:pt x="307" y="13"/>
                  </a:lnTo>
                  <a:lnTo>
                    <a:pt x="308" y="14"/>
                  </a:lnTo>
                  <a:lnTo>
                    <a:pt x="309" y="13"/>
                  </a:lnTo>
                  <a:lnTo>
                    <a:pt x="310" y="11"/>
                  </a:lnTo>
                  <a:lnTo>
                    <a:pt x="311" y="8"/>
                  </a:lnTo>
                  <a:lnTo>
                    <a:pt x="311" y="9"/>
                  </a:lnTo>
                  <a:lnTo>
                    <a:pt x="312" y="8"/>
                  </a:lnTo>
                  <a:lnTo>
                    <a:pt x="313" y="9"/>
                  </a:lnTo>
                  <a:lnTo>
                    <a:pt x="314" y="8"/>
                  </a:lnTo>
                  <a:lnTo>
                    <a:pt x="315" y="12"/>
                  </a:lnTo>
                  <a:lnTo>
                    <a:pt x="316" y="14"/>
                  </a:lnTo>
                  <a:lnTo>
                    <a:pt x="317" y="10"/>
                  </a:lnTo>
                  <a:lnTo>
                    <a:pt x="318" y="12"/>
                  </a:lnTo>
                  <a:lnTo>
                    <a:pt x="318" y="14"/>
                  </a:lnTo>
                  <a:lnTo>
                    <a:pt x="319" y="18"/>
                  </a:lnTo>
                  <a:lnTo>
                    <a:pt x="320" y="15"/>
                  </a:lnTo>
                  <a:lnTo>
                    <a:pt x="321" y="18"/>
                  </a:lnTo>
                  <a:lnTo>
                    <a:pt x="322" y="15"/>
                  </a:lnTo>
                  <a:lnTo>
                    <a:pt x="323" y="14"/>
                  </a:lnTo>
                  <a:lnTo>
                    <a:pt x="324" y="11"/>
                  </a:lnTo>
                  <a:lnTo>
                    <a:pt x="325" y="9"/>
                  </a:lnTo>
                  <a:lnTo>
                    <a:pt x="326" y="7"/>
                  </a:lnTo>
                  <a:lnTo>
                    <a:pt x="326" y="11"/>
                  </a:lnTo>
                  <a:lnTo>
                    <a:pt x="327" y="9"/>
                  </a:lnTo>
                  <a:lnTo>
                    <a:pt x="328" y="6"/>
                  </a:lnTo>
                  <a:lnTo>
                    <a:pt x="329" y="7"/>
                  </a:lnTo>
                  <a:lnTo>
                    <a:pt x="330" y="6"/>
                  </a:lnTo>
                  <a:lnTo>
                    <a:pt x="331" y="10"/>
                  </a:lnTo>
                  <a:lnTo>
                    <a:pt x="332" y="5"/>
                  </a:lnTo>
                  <a:lnTo>
                    <a:pt x="333" y="5"/>
                  </a:lnTo>
                  <a:lnTo>
                    <a:pt x="333" y="4"/>
                  </a:lnTo>
                  <a:lnTo>
                    <a:pt x="334" y="8"/>
                  </a:lnTo>
                  <a:lnTo>
                    <a:pt x="335" y="6"/>
                  </a:lnTo>
                  <a:lnTo>
                    <a:pt x="336" y="6"/>
                  </a:lnTo>
                  <a:lnTo>
                    <a:pt x="337" y="7"/>
                  </a:lnTo>
                  <a:lnTo>
                    <a:pt x="338" y="6"/>
                  </a:lnTo>
                  <a:lnTo>
                    <a:pt x="339" y="7"/>
                  </a:lnTo>
                  <a:lnTo>
                    <a:pt x="340" y="5"/>
                  </a:lnTo>
                  <a:lnTo>
                    <a:pt x="341" y="5"/>
                  </a:lnTo>
                  <a:lnTo>
                    <a:pt x="341" y="5"/>
                  </a:lnTo>
                  <a:lnTo>
                    <a:pt x="342" y="6"/>
                  </a:lnTo>
                  <a:lnTo>
                    <a:pt x="343" y="8"/>
                  </a:lnTo>
                  <a:lnTo>
                    <a:pt x="344" y="5"/>
                  </a:lnTo>
                  <a:lnTo>
                    <a:pt x="345" y="6"/>
                  </a:lnTo>
                  <a:lnTo>
                    <a:pt x="346" y="5"/>
                  </a:lnTo>
                  <a:lnTo>
                    <a:pt x="347" y="5"/>
                  </a:lnTo>
                  <a:lnTo>
                    <a:pt x="348" y="6"/>
                  </a:lnTo>
                  <a:lnTo>
                    <a:pt x="348" y="6"/>
                  </a:lnTo>
                  <a:lnTo>
                    <a:pt x="349" y="4"/>
                  </a:lnTo>
                  <a:lnTo>
                    <a:pt x="350" y="5"/>
                  </a:lnTo>
                  <a:lnTo>
                    <a:pt x="351" y="6"/>
                  </a:lnTo>
                  <a:lnTo>
                    <a:pt x="352" y="7"/>
                  </a:lnTo>
                  <a:lnTo>
                    <a:pt x="353" y="8"/>
                  </a:lnTo>
                  <a:lnTo>
                    <a:pt x="354" y="9"/>
                  </a:lnTo>
                  <a:lnTo>
                    <a:pt x="355" y="9"/>
                  </a:lnTo>
                  <a:lnTo>
                    <a:pt x="356" y="11"/>
                  </a:lnTo>
                  <a:lnTo>
                    <a:pt x="356" y="13"/>
                  </a:lnTo>
                  <a:lnTo>
                    <a:pt x="357" y="14"/>
                  </a:lnTo>
                  <a:lnTo>
                    <a:pt x="358" y="13"/>
                  </a:lnTo>
                  <a:lnTo>
                    <a:pt x="359" y="16"/>
                  </a:lnTo>
                  <a:lnTo>
                    <a:pt x="360" y="14"/>
                  </a:lnTo>
                  <a:lnTo>
                    <a:pt x="361" y="15"/>
                  </a:lnTo>
                  <a:lnTo>
                    <a:pt x="362" y="10"/>
                  </a:lnTo>
                  <a:lnTo>
                    <a:pt x="363" y="11"/>
                  </a:lnTo>
                  <a:lnTo>
                    <a:pt x="363" y="15"/>
                  </a:lnTo>
                  <a:lnTo>
                    <a:pt x="364" y="9"/>
                  </a:lnTo>
                  <a:lnTo>
                    <a:pt x="365" y="12"/>
                  </a:lnTo>
                  <a:lnTo>
                    <a:pt x="366" y="11"/>
                  </a:lnTo>
                  <a:lnTo>
                    <a:pt x="367" y="11"/>
                  </a:lnTo>
                  <a:lnTo>
                    <a:pt x="368" y="10"/>
                  </a:lnTo>
                  <a:lnTo>
                    <a:pt x="369" y="11"/>
                  </a:lnTo>
                  <a:lnTo>
                    <a:pt x="370" y="13"/>
                  </a:lnTo>
                  <a:lnTo>
                    <a:pt x="371" y="12"/>
                  </a:lnTo>
                  <a:lnTo>
                    <a:pt x="371" y="12"/>
                  </a:lnTo>
                  <a:lnTo>
                    <a:pt x="372" y="12"/>
                  </a:lnTo>
                  <a:lnTo>
                    <a:pt x="373" y="11"/>
                  </a:lnTo>
                  <a:lnTo>
                    <a:pt x="374" y="9"/>
                  </a:lnTo>
                  <a:lnTo>
                    <a:pt x="375" y="10"/>
                  </a:lnTo>
                  <a:lnTo>
                    <a:pt x="376" y="10"/>
                  </a:lnTo>
                  <a:lnTo>
                    <a:pt x="377" y="11"/>
                  </a:lnTo>
                  <a:lnTo>
                    <a:pt x="378" y="9"/>
                  </a:lnTo>
                  <a:lnTo>
                    <a:pt x="378" y="8"/>
                  </a:lnTo>
                  <a:lnTo>
                    <a:pt x="379" y="8"/>
                  </a:lnTo>
                  <a:lnTo>
                    <a:pt x="380" y="7"/>
                  </a:lnTo>
                  <a:lnTo>
                    <a:pt x="381" y="10"/>
                  </a:lnTo>
                  <a:lnTo>
                    <a:pt x="382" y="9"/>
                  </a:lnTo>
                  <a:lnTo>
                    <a:pt x="383" y="10"/>
                  </a:lnTo>
                  <a:lnTo>
                    <a:pt x="384" y="12"/>
                  </a:lnTo>
                  <a:lnTo>
                    <a:pt x="385" y="12"/>
                  </a:lnTo>
                  <a:lnTo>
                    <a:pt x="386" y="15"/>
                  </a:lnTo>
                  <a:lnTo>
                    <a:pt x="386" y="11"/>
                  </a:lnTo>
                  <a:lnTo>
                    <a:pt x="387" y="9"/>
                  </a:lnTo>
                  <a:lnTo>
                    <a:pt x="388" y="7"/>
                  </a:lnTo>
                  <a:lnTo>
                    <a:pt x="389" y="10"/>
                  </a:lnTo>
                  <a:lnTo>
                    <a:pt x="390" y="9"/>
                  </a:lnTo>
                  <a:lnTo>
                    <a:pt x="391" y="7"/>
                  </a:lnTo>
                  <a:lnTo>
                    <a:pt x="392" y="10"/>
                  </a:lnTo>
                  <a:lnTo>
                    <a:pt x="393" y="9"/>
                  </a:lnTo>
                  <a:lnTo>
                    <a:pt x="393" y="9"/>
                  </a:lnTo>
                  <a:lnTo>
                    <a:pt x="394" y="12"/>
                  </a:lnTo>
                  <a:lnTo>
                    <a:pt x="395" y="11"/>
                  </a:lnTo>
                  <a:lnTo>
                    <a:pt x="396" y="9"/>
                  </a:lnTo>
                  <a:lnTo>
                    <a:pt x="397" y="9"/>
                  </a:lnTo>
                  <a:lnTo>
                    <a:pt x="398" y="11"/>
                  </a:lnTo>
                  <a:lnTo>
                    <a:pt x="399" y="12"/>
                  </a:lnTo>
                  <a:lnTo>
                    <a:pt x="400" y="11"/>
                  </a:lnTo>
                  <a:lnTo>
                    <a:pt x="401" y="14"/>
                  </a:lnTo>
                  <a:lnTo>
                    <a:pt x="401" y="13"/>
                  </a:lnTo>
                  <a:lnTo>
                    <a:pt x="402" y="14"/>
                  </a:lnTo>
                  <a:lnTo>
                    <a:pt x="403" y="17"/>
                  </a:lnTo>
                  <a:lnTo>
                    <a:pt x="404" y="19"/>
                  </a:lnTo>
                  <a:lnTo>
                    <a:pt x="405" y="21"/>
                  </a:lnTo>
                  <a:lnTo>
                    <a:pt x="406" y="20"/>
                  </a:lnTo>
                  <a:lnTo>
                    <a:pt x="407" y="17"/>
                  </a:lnTo>
                  <a:lnTo>
                    <a:pt x="408" y="14"/>
                  </a:lnTo>
                  <a:lnTo>
                    <a:pt x="408" y="14"/>
                  </a:lnTo>
                  <a:lnTo>
                    <a:pt x="409" y="11"/>
                  </a:lnTo>
                  <a:lnTo>
                    <a:pt x="410" y="10"/>
                  </a:lnTo>
                  <a:lnTo>
                    <a:pt x="411" y="9"/>
                  </a:lnTo>
                  <a:lnTo>
                    <a:pt x="412" y="9"/>
                  </a:lnTo>
                  <a:lnTo>
                    <a:pt x="413" y="8"/>
                  </a:lnTo>
                  <a:lnTo>
                    <a:pt x="414" y="7"/>
                  </a:lnTo>
                  <a:lnTo>
                    <a:pt x="415" y="9"/>
                  </a:lnTo>
                  <a:lnTo>
                    <a:pt x="416" y="9"/>
                  </a:lnTo>
                  <a:lnTo>
                    <a:pt x="416" y="8"/>
                  </a:lnTo>
                  <a:lnTo>
                    <a:pt x="417" y="11"/>
                  </a:lnTo>
                  <a:lnTo>
                    <a:pt x="418" y="12"/>
                  </a:lnTo>
                  <a:lnTo>
                    <a:pt x="419" y="10"/>
                  </a:lnTo>
                  <a:lnTo>
                    <a:pt x="420" y="13"/>
                  </a:lnTo>
                  <a:lnTo>
                    <a:pt x="421" y="15"/>
                  </a:lnTo>
                  <a:lnTo>
                    <a:pt x="422" y="14"/>
                  </a:lnTo>
                  <a:lnTo>
                    <a:pt x="423" y="15"/>
                  </a:lnTo>
                  <a:lnTo>
                    <a:pt x="423" y="16"/>
                  </a:lnTo>
                  <a:lnTo>
                    <a:pt x="424" y="13"/>
                  </a:lnTo>
                  <a:lnTo>
                    <a:pt x="425" y="10"/>
                  </a:lnTo>
                  <a:lnTo>
                    <a:pt x="426" y="12"/>
                  </a:lnTo>
                  <a:lnTo>
                    <a:pt x="427" y="13"/>
                  </a:lnTo>
                  <a:lnTo>
                    <a:pt x="428" y="13"/>
                  </a:lnTo>
                  <a:lnTo>
                    <a:pt x="429" y="14"/>
                  </a:lnTo>
                  <a:lnTo>
                    <a:pt x="430" y="18"/>
                  </a:lnTo>
                  <a:lnTo>
                    <a:pt x="431" y="18"/>
                  </a:lnTo>
                  <a:lnTo>
                    <a:pt x="431" y="17"/>
                  </a:lnTo>
                  <a:lnTo>
                    <a:pt x="432" y="18"/>
                  </a:lnTo>
                  <a:lnTo>
                    <a:pt x="433" y="17"/>
                  </a:lnTo>
                  <a:lnTo>
                    <a:pt x="434" y="17"/>
                  </a:lnTo>
                  <a:lnTo>
                    <a:pt x="435" y="18"/>
                  </a:lnTo>
                  <a:lnTo>
                    <a:pt x="436" y="15"/>
                  </a:lnTo>
                  <a:lnTo>
                    <a:pt x="437" y="15"/>
                  </a:lnTo>
                  <a:lnTo>
                    <a:pt x="438" y="14"/>
                  </a:lnTo>
                  <a:lnTo>
                    <a:pt x="438" y="16"/>
                  </a:lnTo>
                  <a:lnTo>
                    <a:pt x="439" y="12"/>
                  </a:lnTo>
                  <a:lnTo>
                    <a:pt x="440" y="13"/>
                  </a:lnTo>
                  <a:lnTo>
                    <a:pt x="441" y="12"/>
                  </a:lnTo>
                  <a:lnTo>
                    <a:pt x="442" y="11"/>
                  </a:lnTo>
                  <a:lnTo>
                    <a:pt x="443" y="8"/>
                  </a:lnTo>
                  <a:lnTo>
                    <a:pt x="444" y="10"/>
                  </a:lnTo>
                  <a:lnTo>
                    <a:pt x="445" y="10"/>
                  </a:lnTo>
                  <a:lnTo>
                    <a:pt x="446" y="10"/>
                  </a:lnTo>
                  <a:lnTo>
                    <a:pt x="446" y="12"/>
                  </a:lnTo>
                  <a:lnTo>
                    <a:pt x="447" y="13"/>
                  </a:lnTo>
                  <a:lnTo>
                    <a:pt x="448" y="16"/>
                  </a:lnTo>
                  <a:lnTo>
                    <a:pt x="449" y="15"/>
                  </a:lnTo>
                  <a:lnTo>
                    <a:pt x="450" y="15"/>
                  </a:lnTo>
                  <a:lnTo>
                    <a:pt x="451" y="14"/>
                  </a:lnTo>
                  <a:lnTo>
                    <a:pt x="452" y="12"/>
                  </a:lnTo>
                  <a:lnTo>
                    <a:pt x="453" y="12"/>
                  </a:lnTo>
                  <a:lnTo>
                    <a:pt x="453" y="8"/>
                  </a:lnTo>
                  <a:lnTo>
                    <a:pt x="454" y="7"/>
                  </a:lnTo>
                  <a:lnTo>
                    <a:pt x="455" y="8"/>
                  </a:lnTo>
                  <a:lnTo>
                    <a:pt x="456" y="6"/>
                  </a:lnTo>
                  <a:lnTo>
                    <a:pt x="457" y="6"/>
                  </a:lnTo>
                  <a:lnTo>
                    <a:pt x="458" y="4"/>
                  </a:lnTo>
                  <a:lnTo>
                    <a:pt x="459" y="5"/>
                  </a:lnTo>
                  <a:lnTo>
                    <a:pt x="460" y="7"/>
                  </a:lnTo>
                  <a:lnTo>
                    <a:pt x="461" y="10"/>
                  </a:lnTo>
                  <a:lnTo>
                    <a:pt x="461" y="12"/>
                  </a:lnTo>
                  <a:lnTo>
                    <a:pt x="462" y="19"/>
                  </a:lnTo>
                  <a:lnTo>
                    <a:pt x="463" y="28"/>
                  </a:lnTo>
                  <a:lnTo>
                    <a:pt x="464" y="41"/>
                  </a:lnTo>
                  <a:lnTo>
                    <a:pt x="465" y="54"/>
                  </a:lnTo>
                  <a:lnTo>
                    <a:pt x="466" y="67"/>
                  </a:lnTo>
                  <a:lnTo>
                    <a:pt x="467" y="77"/>
                  </a:lnTo>
                  <a:lnTo>
                    <a:pt x="468" y="77"/>
                  </a:lnTo>
                  <a:lnTo>
                    <a:pt x="468" y="80"/>
                  </a:lnTo>
                  <a:lnTo>
                    <a:pt x="469" y="80"/>
                  </a:lnTo>
                  <a:lnTo>
                    <a:pt x="470" y="78"/>
                  </a:lnTo>
                  <a:lnTo>
                    <a:pt x="471" y="68"/>
                  </a:lnTo>
                  <a:lnTo>
                    <a:pt x="472" y="63"/>
                  </a:lnTo>
                  <a:lnTo>
                    <a:pt x="473" y="63"/>
                  </a:lnTo>
                  <a:lnTo>
                    <a:pt x="474" y="58"/>
                  </a:lnTo>
                  <a:lnTo>
                    <a:pt x="475" y="70"/>
                  </a:lnTo>
                  <a:lnTo>
                    <a:pt x="476" y="69"/>
                  </a:lnTo>
                  <a:lnTo>
                    <a:pt x="476" y="72"/>
                  </a:lnTo>
                  <a:lnTo>
                    <a:pt x="477" y="71"/>
                  </a:lnTo>
                  <a:lnTo>
                    <a:pt x="478" y="65"/>
                  </a:lnTo>
                  <a:lnTo>
                    <a:pt x="479" y="57"/>
                  </a:lnTo>
                  <a:lnTo>
                    <a:pt x="480" y="48"/>
                  </a:lnTo>
                  <a:lnTo>
                    <a:pt x="481" y="40"/>
                  </a:lnTo>
                  <a:lnTo>
                    <a:pt x="482" y="34"/>
                  </a:lnTo>
                  <a:lnTo>
                    <a:pt x="483" y="28"/>
                  </a:lnTo>
                  <a:lnTo>
                    <a:pt x="483" y="27"/>
                  </a:lnTo>
                  <a:lnTo>
                    <a:pt x="484" y="24"/>
                  </a:lnTo>
                  <a:lnTo>
                    <a:pt x="485" y="18"/>
                  </a:lnTo>
                  <a:lnTo>
                    <a:pt x="486" y="16"/>
                  </a:lnTo>
                  <a:lnTo>
                    <a:pt x="487" y="17"/>
                  </a:lnTo>
                  <a:lnTo>
                    <a:pt x="488" y="13"/>
                  </a:lnTo>
                  <a:lnTo>
                    <a:pt x="489" y="15"/>
                  </a:lnTo>
                  <a:lnTo>
                    <a:pt x="490" y="14"/>
                  </a:lnTo>
                  <a:lnTo>
                    <a:pt x="491" y="18"/>
                  </a:lnTo>
                  <a:lnTo>
                    <a:pt x="491" y="15"/>
                  </a:lnTo>
                  <a:lnTo>
                    <a:pt x="492" y="14"/>
                  </a:lnTo>
                  <a:lnTo>
                    <a:pt x="493" y="12"/>
                  </a:lnTo>
                  <a:lnTo>
                    <a:pt x="494" y="15"/>
                  </a:lnTo>
                  <a:lnTo>
                    <a:pt x="495" y="17"/>
                  </a:lnTo>
                  <a:lnTo>
                    <a:pt x="496" y="16"/>
                  </a:lnTo>
                  <a:lnTo>
                    <a:pt x="497" y="15"/>
                  </a:lnTo>
                  <a:lnTo>
                    <a:pt x="498" y="16"/>
                  </a:lnTo>
                  <a:lnTo>
                    <a:pt x="498" y="14"/>
                  </a:lnTo>
                  <a:lnTo>
                    <a:pt x="499" y="18"/>
                  </a:lnTo>
                  <a:lnTo>
                    <a:pt x="500" y="17"/>
                  </a:lnTo>
                  <a:lnTo>
                    <a:pt x="501" y="14"/>
                  </a:lnTo>
                  <a:lnTo>
                    <a:pt x="502" y="13"/>
                  </a:lnTo>
                  <a:lnTo>
                    <a:pt x="503" y="15"/>
                  </a:lnTo>
                  <a:lnTo>
                    <a:pt x="504" y="13"/>
                  </a:lnTo>
                  <a:lnTo>
                    <a:pt x="505" y="13"/>
                  </a:lnTo>
                  <a:lnTo>
                    <a:pt x="506" y="18"/>
                  </a:lnTo>
                  <a:lnTo>
                    <a:pt x="506" y="15"/>
                  </a:lnTo>
                  <a:lnTo>
                    <a:pt x="507" y="18"/>
                  </a:lnTo>
                  <a:lnTo>
                    <a:pt x="508" y="16"/>
                  </a:lnTo>
                  <a:lnTo>
                    <a:pt x="509" y="15"/>
                  </a:lnTo>
                  <a:lnTo>
                    <a:pt x="510" y="14"/>
                  </a:lnTo>
                  <a:lnTo>
                    <a:pt x="511" y="15"/>
                  </a:lnTo>
                  <a:lnTo>
                    <a:pt x="512" y="13"/>
                  </a:lnTo>
                  <a:lnTo>
                    <a:pt x="513" y="14"/>
                  </a:lnTo>
                  <a:lnTo>
                    <a:pt x="513" y="14"/>
                  </a:lnTo>
                  <a:lnTo>
                    <a:pt x="514" y="13"/>
                  </a:lnTo>
                  <a:lnTo>
                    <a:pt x="515" y="14"/>
                  </a:lnTo>
                  <a:lnTo>
                    <a:pt x="516" y="13"/>
                  </a:lnTo>
                  <a:lnTo>
                    <a:pt x="517" y="13"/>
                  </a:lnTo>
                  <a:lnTo>
                    <a:pt x="518" y="13"/>
                  </a:lnTo>
                  <a:lnTo>
                    <a:pt x="519" y="13"/>
                  </a:lnTo>
                  <a:lnTo>
                    <a:pt x="520" y="17"/>
                  </a:lnTo>
                  <a:lnTo>
                    <a:pt x="520" y="16"/>
                  </a:lnTo>
                  <a:lnTo>
                    <a:pt x="521" y="18"/>
                  </a:lnTo>
                  <a:lnTo>
                    <a:pt x="522" y="20"/>
                  </a:lnTo>
                  <a:lnTo>
                    <a:pt x="523" y="28"/>
                  </a:lnTo>
                  <a:lnTo>
                    <a:pt x="524" y="36"/>
                  </a:lnTo>
                  <a:lnTo>
                    <a:pt x="525" y="38"/>
                  </a:lnTo>
                  <a:lnTo>
                    <a:pt x="526" y="45"/>
                  </a:lnTo>
                  <a:lnTo>
                    <a:pt x="527" y="50"/>
                  </a:lnTo>
                  <a:lnTo>
                    <a:pt x="528" y="54"/>
                  </a:lnTo>
                  <a:lnTo>
                    <a:pt x="528" y="55"/>
                  </a:lnTo>
                  <a:lnTo>
                    <a:pt x="529" y="49"/>
                  </a:lnTo>
                  <a:lnTo>
                    <a:pt x="530" y="47"/>
                  </a:lnTo>
                  <a:lnTo>
                    <a:pt x="531" y="39"/>
                  </a:lnTo>
                  <a:lnTo>
                    <a:pt x="532" y="32"/>
                  </a:lnTo>
                  <a:lnTo>
                    <a:pt x="533" y="38"/>
                  </a:lnTo>
                  <a:lnTo>
                    <a:pt x="534" y="36"/>
                  </a:lnTo>
                  <a:lnTo>
                    <a:pt x="535" y="37"/>
                  </a:lnTo>
                  <a:lnTo>
                    <a:pt x="535" y="44"/>
                  </a:lnTo>
                  <a:lnTo>
                    <a:pt x="536" y="56"/>
                  </a:lnTo>
                  <a:lnTo>
                    <a:pt x="537" y="70"/>
                  </a:lnTo>
                  <a:lnTo>
                    <a:pt x="538" y="77"/>
                  </a:lnTo>
                  <a:lnTo>
                    <a:pt x="539" y="83"/>
                  </a:lnTo>
                  <a:lnTo>
                    <a:pt x="540" y="95"/>
                  </a:lnTo>
                  <a:lnTo>
                    <a:pt x="541" y="91"/>
                  </a:lnTo>
                  <a:lnTo>
                    <a:pt x="542" y="92"/>
                  </a:lnTo>
                  <a:lnTo>
                    <a:pt x="543" y="79"/>
                  </a:lnTo>
                  <a:lnTo>
                    <a:pt x="543" y="65"/>
                  </a:lnTo>
                  <a:lnTo>
                    <a:pt x="544" y="55"/>
                  </a:lnTo>
                  <a:lnTo>
                    <a:pt x="545" y="41"/>
                  </a:lnTo>
                  <a:lnTo>
                    <a:pt x="546" y="40"/>
                  </a:lnTo>
                  <a:lnTo>
                    <a:pt x="547" y="32"/>
                  </a:lnTo>
                  <a:lnTo>
                    <a:pt x="548" y="25"/>
                  </a:lnTo>
                  <a:lnTo>
                    <a:pt x="549" y="21"/>
                  </a:lnTo>
                  <a:lnTo>
                    <a:pt x="550" y="18"/>
                  </a:lnTo>
                  <a:lnTo>
                    <a:pt x="550" y="20"/>
                  </a:lnTo>
                  <a:lnTo>
                    <a:pt x="551" y="20"/>
                  </a:lnTo>
                  <a:lnTo>
                    <a:pt x="552" y="21"/>
                  </a:lnTo>
                  <a:lnTo>
                    <a:pt x="553" y="22"/>
                  </a:lnTo>
                  <a:lnTo>
                    <a:pt x="554" y="17"/>
                  </a:lnTo>
                  <a:lnTo>
                    <a:pt x="555" y="19"/>
                  </a:lnTo>
                  <a:lnTo>
                    <a:pt x="556" y="15"/>
                  </a:lnTo>
                  <a:lnTo>
                    <a:pt x="557" y="22"/>
                  </a:lnTo>
                  <a:lnTo>
                    <a:pt x="558" y="21"/>
                  </a:lnTo>
                  <a:lnTo>
                    <a:pt x="558" y="24"/>
                  </a:lnTo>
                  <a:lnTo>
                    <a:pt x="559" y="26"/>
                  </a:lnTo>
                  <a:lnTo>
                    <a:pt x="560" y="30"/>
                  </a:lnTo>
                  <a:lnTo>
                    <a:pt x="561" y="30"/>
                  </a:lnTo>
                  <a:lnTo>
                    <a:pt x="562" y="32"/>
                  </a:lnTo>
                  <a:lnTo>
                    <a:pt x="563" y="30"/>
                  </a:lnTo>
                  <a:lnTo>
                    <a:pt x="564" y="32"/>
                  </a:lnTo>
                  <a:lnTo>
                    <a:pt x="565" y="27"/>
                  </a:lnTo>
                  <a:lnTo>
                    <a:pt x="565" y="29"/>
                  </a:lnTo>
                  <a:lnTo>
                    <a:pt x="566" y="23"/>
                  </a:lnTo>
                  <a:lnTo>
                    <a:pt x="567" y="25"/>
                  </a:lnTo>
                  <a:lnTo>
                    <a:pt x="568" y="21"/>
                  </a:lnTo>
                  <a:lnTo>
                    <a:pt x="569" y="19"/>
                  </a:lnTo>
                  <a:lnTo>
                    <a:pt x="570" y="18"/>
                  </a:lnTo>
                  <a:lnTo>
                    <a:pt x="571" y="15"/>
                  </a:lnTo>
                  <a:lnTo>
                    <a:pt x="572" y="16"/>
                  </a:lnTo>
                  <a:lnTo>
                    <a:pt x="573" y="13"/>
                  </a:lnTo>
                  <a:lnTo>
                    <a:pt x="573" y="16"/>
                  </a:lnTo>
                  <a:lnTo>
                    <a:pt x="574" y="12"/>
                  </a:lnTo>
                  <a:lnTo>
                    <a:pt x="575" y="12"/>
                  </a:lnTo>
                  <a:lnTo>
                    <a:pt x="576" y="9"/>
                  </a:lnTo>
                  <a:lnTo>
                    <a:pt x="577" y="9"/>
                  </a:lnTo>
                  <a:lnTo>
                    <a:pt x="578" y="10"/>
                  </a:lnTo>
                  <a:lnTo>
                    <a:pt x="579" y="13"/>
                  </a:lnTo>
                  <a:lnTo>
                    <a:pt x="580" y="10"/>
                  </a:lnTo>
                  <a:lnTo>
                    <a:pt x="580" y="14"/>
                  </a:lnTo>
                  <a:lnTo>
                    <a:pt x="581" y="10"/>
                  </a:lnTo>
                  <a:lnTo>
                    <a:pt x="582" y="16"/>
                  </a:lnTo>
                  <a:lnTo>
                    <a:pt x="583" y="14"/>
                  </a:lnTo>
                  <a:lnTo>
                    <a:pt x="584" y="14"/>
                  </a:lnTo>
                  <a:lnTo>
                    <a:pt x="585" y="17"/>
                  </a:lnTo>
                  <a:lnTo>
                    <a:pt x="586" y="13"/>
                  </a:lnTo>
                  <a:lnTo>
                    <a:pt x="587" y="14"/>
                  </a:lnTo>
                  <a:lnTo>
                    <a:pt x="588" y="13"/>
                  </a:lnTo>
                  <a:lnTo>
                    <a:pt x="588" y="10"/>
                  </a:lnTo>
                  <a:lnTo>
                    <a:pt x="589" y="11"/>
                  </a:lnTo>
                  <a:lnTo>
                    <a:pt x="590" y="9"/>
                  </a:lnTo>
                  <a:lnTo>
                    <a:pt x="591" y="10"/>
                  </a:lnTo>
                  <a:lnTo>
                    <a:pt x="592" y="11"/>
                  </a:lnTo>
                  <a:lnTo>
                    <a:pt x="593" y="7"/>
                  </a:lnTo>
                  <a:lnTo>
                    <a:pt x="594" y="6"/>
                  </a:lnTo>
                  <a:lnTo>
                    <a:pt x="595" y="6"/>
                  </a:lnTo>
                  <a:lnTo>
                    <a:pt x="595" y="5"/>
                  </a:lnTo>
                  <a:lnTo>
                    <a:pt x="596" y="8"/>
                  </a:lnTo>
                  <a:lnTo>
                    <a:pt x="597" y="2"/>
                  </a:lnTo>
                  <a:lnTo>
                    <a:pt x="598" y="5"/>
                  </a:lnTo>
                  <a:lnTo>
                    <a:pt x="599" y="4"/>
                  </a:lnTo>
                  <a:lnTo>
                    <a:pt x="600" y="4"/>
                  </a:lnTo>
                  <a:lnTo>
                    <a:pt x="601" y="6"/>
                  </a:lnTo>
                  <a:lnTo>
                    <a:pt x="602" y="7"/>
                  </a:lnTo>
                  <a:lnTo>
                    <a:pt x="603" y="8"/>
                  </a:lnTo>
                  <a:lnTo>
                    <a:pt x="603" y="11"/>
                  </a:lnTo>
                  <a:lnTo>
                    <a:pt x="604" y="14"/>
                  </a:lnTo>
                  <a:lnTo>
                    <a:pt x="605" y="12"/>
                  </a:lnTo>
                  <a:lnTo>
                    <a:pt x="606" y="15"/>
                  </a:lnTo>
                  <a:lnTo>
                    <a:pt x="607" y="17"/>
                  </a:lnTo>
                  <a:lnTo>
                    <a:pt x="608" y="17"/>
                  </a:lnTo>
                  <a:lnTo>
                    <a:pt x="609" y="15"/>
                  </a:lnTo>
                  <a:lnTo>
                    <a:pt x="610" y="13"/>
                  </a:lnTo>
                  <a:lnTo>
                    <a:pt x="610" y="13"/>
                  </a:lnTo>
                  <a:lnTo>
                    <a:pt x="611" y="11"/>
                  </a:lnTo>
                  <a:lnTo>
                    <a:pt x="612" y="10"/>
                  </a:lnTo>
                  <a:lnTo>
                    <a:pt x="613" y="9"/>
                  </a:lnTo>
                  <a:lnTo>
                    <a:pt x="614" y="6"/>
                  </a:lnTo>
                  <a:lnTo>
                    <a:pt x="615" y="7"/>
                  </a:lnTo>
                  <a:lnTo>
                    <a:pt x="616" y="8"/>
                  </a:lnTo>
                  <a:lnTo>
                    <a:pt x="617" y="5"/>
                  </a:lnTo>
                  <a:lnTo>
                    <a:pt x="618" y="4"/>
                  </a:lnTo>
                  <a:lnTo>
                    <a:pt x="618" y="6"/>
                  </a:lnTo>
                  <a:lnTo>
                    <a:pt x="619" y="5"/>
                  </a:lnTo>
                  <a:lnTo>
                    <a:pt x="620" y="7"/>
                  </a:lnTo>
                  <a:lnTo>
                    <a:pt x="621" y="6"/>
                  </a:lnTo>
                  <a:lnTo>
                    <a:pt x="622" y="8"/>
                  </a:lnTo>
                  <a:lnTo>
                    <a:pt x="623" y="5"/>
                  </a:lnTo>
                  <a:lnTo>
                    <a:pt x="624" y="6"/>
                  </a:lnTo>
                  <a:lnTo>
                    <a:pt x="625" y="5"/>
                  </a:lnTo>
                  <a:lnTo>
                    <a:pt x="625" y="7"/>
                  </a:lnTo>
                  <a:lnTo>
                    <a:pt x="626" y="6"/>
                  </a:lnTo>
                  <a:lnTo>
                    <a:pt x="627" y="4"/>
                  </a:lnTo>
                  <a:lnTo>
                    <a:pt x="628" y="5"/>
                  </a:lnTo>
                  <a:lnTo>
                    <a:pt x="629" y="4"/>
                  </a:lnTo>
                  <a:lnTo>
                    <a:pt x="630" y="6"/>
                  </a:lnTo>
                  <a:lnTo>
                    <a:pt x="631" y="7"/>
                  </a:lnTo>
                  <a:lnTo>
                    <a:pt x="632" y="6"/>
                  </a:lnTo>
                  <a:lnTo>
                    <a:pt x="633" y="5"/>
                  </a:lnTo>
                  <a:lnTo>
                    <a:pt x="633" y="5"/>
                  </a:lnTo>
                  <a:lnTo>
                    <a:pt x="634" y="4"/>
                  </a:lnTo>
                  <a:lnTo>
                    <a:pt x="635" y="4"/>
                  </a:lnTo>
                  <a:lnTo>
                    <a:pt x="636" y="4"/>
                  </a:lnTo>
                  <a:lnTo>
                    <a:pt x="637" y="5"/>
                  </a:lnTo>
                  <a:lnTo>
                    <a:pt x="638" y="4"/>
                  </a:lnTo>
                  <a:lnTo>
                    <a:pt x="639" y="4"/>
                  </a:lnTo>
                  <a:lnTo>
                    <a:pt x="640" y="6"/>
                  </a:lnTo>
                  <a:lnTo>
                    <a:pt x="640" y="6"/>
                  </a:lnTo>
                  <a:lnTo>
                    <a:pt x="641" y="9"/>
                  </a:lnTo>
                  <a:lnTo>
                    <a:pt x="642" y="7"/>
                  </a:lnTo>
                  <a:lnTo>
                    <a:pt x="643" y="8"/>
                  </a:lnTo>
                  <a:lnTo>
                    <a:pt x="644" y="8"/>
                  </a:lnTo>
                  <a:lnTo>
                    <a:pt x="645" y="9"/>
                  </a:lnTo>
                  <a:lnTo>
                    <a:pt x="646" y="8"/>
                  </a:lnTo>
                  <a:lnTo>
                    <a:pt x="647" y="10"/>
                  </a:lnTo>
                  <a:lnTo>
                    <a:pt x="648" y="9"/>
                  </a:lnTo>
                  <a:lnTo>
                    <a:pt x="648" y="10"/>
                  </a:lnTo>
                  <a:lnTo>
                    <a:pt x="649" y="9"/>
                  </a:lnTo>
                  <a:lnTo>
                    <a:pt x="650" y="9"/>
                  </a:lnTo>
                  <a:lnTo>
                    <a:pt x="651" y="7"/>
                  </a:lnTo>
                  <a:lnTo>
                    <a:pt x="652" y="6"/>
                  </a:lnTo>
                  <a:lnTo>
                    <a:pt x="653" y="7"/>
                  </a:lnTo>
                  <a:lnTo>
                    <a:pt x="654" y="9"/>
                  </a:lnTo>
                  <a:lnTo>
                    <a:pt x="655" y="9"/>
                  </a:lnTo>
                  <a:lnTo>
                    <a:pt x="655" y="9"/>
                  </a:lnTo>
                  <a:lnTo>
                    <a:pt x="656" y="8"/>
                  </a:lnTo>
                  <a:lnTo>
                    <a:pt x="657" y="9"/>
                  </a:lnTo>
                  <a:lnTo>
                    <a:pt x="658" y="10"/>
                  </a:lnTo>
                  <a:lnTo>
                    <a:pt x="659" y="10"/>
                  </a:lnTo>
                  <a:lnTo>
                    <a:pt x="660" y="14"/>
                  </a:lnTo>
                  <a:lnTo>
                    <a:pt x="661" y="13"/>
                  </a:lnTo>
                  <a:lnTo>
                    <a:pt x="662" y="16"/>
                  </a:lnTo>
                  <a:lnTo>
                    <a:pt x="663" y="16"/>
                  </a:lnTo>
                  <a:lnTo>
                    <a:pt x="663" y="12"/>
                  </a:lnTo>
                  <a:lnTo>
                    <a:pt x="664" y="14"/>
                  </a:lnTo>
                  <a:lnTo>
                    <a:pt x="665" y="10"/>
                  </a:lnTo>
                  <a:lnTo>
                    <a:pt x="666" y="9"/>
                  </a:lnTo>
                  <a:lnTo>
                    <a:pt x="667" y="10"/>
                  </a:lnTo>
                  <a:lnTo>
                    <a:pt x="668" y="8"/>
                  </a:lnTo>
                  <a:lnTo>
                    <a:pt x="669" y="7"/>
                  </a:lnTo>
                  <a:lnTo>
                    <a:pt x="670" y="7"/>
                  </a:lnTo>
                  <a:lnTo>
                    <a:pt x="670" y="7"/>
                  </a:lnTo>
                  <a:lnTo>
                    <a:pt x="671" y="3"/>
                  </a:lnTo>
                  <a:lnTo>
                    <a:pt x="672" y="6"/>
                  </a:lnTo>
                  <a:lnTo>
                    <a:pt x="673" y="5"/>
                  </a:lnTo>
                  <a:lnTo>
                    <a:pt x="674" y="6"/>
                  </a:lnTo>
                  <a:lnTo>
                    <a:pt x="675" y="5"/>
                  </a:lnTo>
                  <a:lnTo>
                    <a:pt x="676" y="2"/>
                  </a:lnTo>
                  <a:lnTo>
                    <a:pt x="677" y="4"/>
                  </a:lnTo>
                  <a:lnTo>
                    <a:pt x="678" y="3"/>
                  </a:lnTo>
                  <a:lnTo>
                    <a:pt x="678" y="4"/>
                  </a:lnTo>
                  <a:lnTo>
                    <a:pt x="679" y="4"/>
                  </a:lnTo>
                  <a:lnTo>
                    <a:pt x="680" y="3"/>
                  </a:lnTo>
                  <a:lnTo>
                    <a:pt x="681" y="5"/>
                  </a:lnTo>
                  <a:lnTo>
                    <a:pt x="682" y="5"/>
                  </a:lnTo>
                  <a:lnTo>
                    <a:pt x="683" y="6"/>
                  </a:lnTo>
                  <a:lnTo>
                    <a:pt x="684" y="5"/>
                  </a:lnTo>
                  <a:lnTo>
                    <a:pt x="685" y="10"/>
                  </a:lnTo>
                  <a:lnTo>
                    <a:pt x="685" y="10"/>
                  </a:lnTo>
                  <a:lnTo>
                    <a:pt x="686" y="12"/>
                  </a:lnTo>
                  <a:lnTo>
                    <a:pt x="687" y="16"/>
                  </a:lnTo>
                  <a:lnTo>
                    <a:pt x="688" y="18"/>
                  </a:lnTo>
                  <a:lnTo>
                    <a:pt x="689" y="21"/>
                  </a:lnTo>
                  <a:lnTo>
                    <a:pt x="690" y="24"/>
                  </a:lnTo>
                  <a:lnTo>
                    <a:pt x="691" y="40"/>
                  </a:lnTo>
                  <a:lnTo>
                    <a:pt x="692" y="42"/>
                  </a:lnTo>
                  <a:lnTo>
                    <a:pt x="693" y="58"/>
                  </a:lnTo>
                  <a:lnTo>
                    <a:pt x="693" y="65"/>
                  </a:lnTo>
                  <a:lnTo>
                    <a:pt x="694" y="86"/>
                  </a:lnTo>
                  <a:lnTo>
                    <a:pt x="695" y="99"/>
                  </a:lnTo>
                  <a:lnTo>
                    <a:pt x="696" y="96"/>
                  </a:lnTo>
                  <a:lnTo>
                    <a:pt x="697" y="94"/>
                  </a:lnTo>
                  <a:lnTo>
                    <a:pt x="698" y="91"/>
                  </a:lnTo>
                  <a:lnTo>
                    <a:pt x="699" y="84"/>
                  </a:lnTo>
                  <a:lnTo>
                    <a:pt x="700" y="76"/>
                  </a:lnTo>
                  <a:lnTo>
                    <a:pt x="700" y="68"/>
                  </a:lnTo>
                  <a:lnTo>
                    <a:pt x="701" y="64"/>
                  </a:lnTo>
                  <a:lnTo>
                    <a:pt x="702" y="61"/>
                  </a:lnTo>
                  <a:lnTo>
                    <a:pt x="703" y="57"/>
                  </a:lnTo>
                  <a:lnTo>
                    <a:pt x="704" y="57"/>
                  </a:lnTo>
                  <a:lnTo>
                    <a:pt x="705" y="54"/>
                  </a:lnTo>
                  <a:lnTo>
                    <a:pt x="706" y="54"/>
                  </a:lnTo>
                  <a:lnTo>
                    <a:pt x="707" y="55"/>
                  </a:lnTo>
                  <a:lnTo>
                    <a:pt x="708" y="45"/>
                  </a:lnTo>
                  <a:lnTo>
                    <a:pt x="708" y="45"/>
                  </a:lnTo>
                  <a:lnTo>
                    <a:pt x="709" y="44"/>
                  </a:lnTo>
                  <a:lnTo>
                    <a:pt x="710" y="39"/>
                  </a:lnTo>
                  <a:lnTo>
                    <a:pt x="711" y="32"/>
                  </a:lnTo>
                  <a:lnTo>
                    <a:pt x="712" y="30"/>
                  </a:lnTo>
                  <a:lnTo>
                    <a:pt x="713" y="25"/>
                  </a:lnTo>
                  <a:lnTo>
                    <a:pt x="714" y="23"/>
                  </a:lnTo>
                  <a:lnTo>
                    <a:pt x="715" y="21"/>
                  </a:lnTo>
                  <a:lnTo>
                    <a:pt x="715" y="24"/>
                  </a:lnTo>
                  <a:lnTo>
                    <a:pt x="716" y="26"/>
                  </a:lnTo>
                  <a:lnTo>
                    <a:pt x="717" y="24"/>
                  </a:lnTo>
                  <a:lnTo>
                    <a:pt x="718" y="24"/>
                  </a:lnTo>
                  <a:lnTo>
                    <a:pt x="719" y="24"/>
                  </a:lnTo>
                  <a:lnTo>
                    <a:pt x="720" y="24"/>
                  </a:lnTo>
                  <a:lnTo>
                    <a:pt x="721" y="23"/>
                  </a:lnTo>
                  <a:lnTo>
                    <a:pt x="722" y="21"/>
                  </a:lnTo>
                  <a:lnTo>
                    <a:pt x="722" y="19"/>
                  </a:lnTo>
                  <a:lnTo>
                    <a:pt x="723" y="16"/>
                  </a:lnTo>
                  <a:lnTo>
                    <a:pt x="724" y="17"/>
                  </a:lnTo>
                  <a:lnTo>
                    <a:pt x="725" y="16"/>
                  </a:lnTo>
                  <a:lnTo>
                    <a:pt x="726" y="16"/>
                  </a:lnTo>
                  <a:lnTo>
                    <a:pt x="727" y="16"/>
                  </a:lnTo>
                  <a:lnTo>
                    <a:pt x="728" y="19"/>
                  </a:lnTo>
                  <a:lnTo>
                    <a:pt x="729" y="15"/>
                  </a:lnTo>
                  <a:lnTo>
                    <a:pt x="730" y="18"/>
                  </a:lnTo>
                  <a:lnTo>
                    <a:pt x="730" y="16"/>
                  </a:lnTo>
                  <a:lnTo>
                    <a:pt x="731" y="16"/>
                  </a:lnTo>
                  <a:lnTo>
                    <a:pt x="732" y="16"/>
                  </a:lnTo>
                  <a:lnTo>
                    <a:pt x="733" y="15"/>
                  </a:lnTo>
                  <a:lnTo>
                    <a:pt x="734" y="18"/>
                  </a:lnTo>
                  <a:lnTo>
                    <a:pt x="735" y="15"/>
                  </a:lnTo>
                  <a:lnTo>
                    <a:pt x="736" y="14"/>
                  </a:lnTo>
                  <a:lnTo>
                    <a:pt x="737" y="14"/>
                  </a:lnTo>
                  <a:lnTo>
                    <a:pt x="737" y="15"/>
                  </a:lnTo>
                  <a:lnTo>
                    <a:pt x="738" y="15"/>
                  </a:lnTo>
                  <a:lnTo>
                    <a:pt x="739" y="15"/>
                  </a:lnTo>
                  <a:lnTo>
                    <a:pt x="740" y="15"/>
                  </a:lnTo>
                  <a:lnTo>
                    <a:pt x="741" y="13"/>
                  </a:lnTo>
                  <a:lnTo>
                    <a:pt x="742" y="16"/>
                  </a:lnTo>
                  <a:lnTo>
                    <a:pt x="743" y="13"/>
                  </a:lnTo>
                  <a:lnTo>
                    <a:pt x="744" y="12"/>
                  </a:lnTo>
                  <a:lnTo>
                    <a:pt x="745" y="14"/>
                  </a:lnTo>
                  <a:lnTo>
                    <a:pt x="745" y="15"/>
                  </a:lnTo>
                  <a:lnTo>
                    <a:pt x="746" y="15"/>
                  </a:lnTo>
                  <a:lnTo>
                    <a:pt x="747" y="13"/>
                  </a:lnTo>
                  <a:lnTo>
                    <a:pt x="748" y="12"/>
                  </a:lnTo>
                  <a:lnTo>
                    <a:pt x="749" y="13"/>
                  </a:lnTo>
                  <a:lnTo>
                    <a:pt x="750" y="14"/>
                  </a:lnTo>
                  <a:lnTo>
                    <a:pt x="751" y="12"/>
                  </a:lnTo>
                  <a:lnTo>
                    <a:pt x="752" y="9"/>
                  </a:lnTo>
                  <a:lnTo>
                    <a:pt x="752" y="12"/>
                  </a:lnTo>
                  <a:lnTo>
                    <a:pt x="753" y="14"/>
                  </a:lnTo>
                  <a:lnTo>
                    <a:pt x="754" y="15"/>
                  </a:lnTo>
                  <a:lnTo>
                    <a:pt x="755" y="12"/>
                  </a:lnTo>
                  <a:lnTo>
                    <a:pt x="756" y="12"/>
                  </a:lnTo>
                  <a:lnTo>
                    <a:pt x="757" y="13"/>
                  </a:lnTo>
                  <a:lnTo>
                    <a:pt x="758" y="15"/>
                  </a:lnTo>
                  <a:lnTo>
                    <a:pt x="759" y="16"/>
                  </a:lnTo>
                  <a:lnTo>
                    <a:pt x="760" y="21"/>
                  </a:lnTo>
                  <a:lnTo>
                    <a:pt x="760" y="38"/>
                  </a:lnTo>
                  <a:lnTo>
                    <a:pt x="761" y="65"/>
                  </a:lnTo>
                  <a:lnTo>
                    <a:pt x="762" y="122"/>
                  </a:lnTo>
                  <a:lnTo>
                    <a:pt x="763" y="204"/>
                  </a:lnTo>
                  <a:lnTo>
                    <a:pt x="764" y="332"/>
                  </a:lnTo>
                  <a:lnTo>
                    <a:pt x="765" y="499"/>
                  </a:lnTo>
                  <a:lnTo>
                    <a:pt x="766" y="637"/>
                  </a:lnTo>
                  <a:lnTo>
                    <a:pt x="767" y="757"/>
                  </a:lnTo>
                  <a:lnTo>
                    <a:pt x="767" y="839"/>
                  </a:lnTo>
                  <a:lnTo>
                    <a:pt x="768" y="858"/>
                  </a:lnTo>
                  <a:lnTo>
                    <a:pt x="769" y="816"/>
                  </a:lnTo>
                  <a:lnTo>
                    <a:pt x="770" y="724"/>
                  </a:lnTo>
                  <a:lnTo>
                    <a:pt x="771" y="597"/>
                  </a:lnTo>
                  <a:lnTo>
                    <a:pt x="772" y="501"/>
                  </a:lnTo>
                  <a:lnTo>
                    <a:pt x="773" y="426"/>
                  </a:lnTo>
                  <a:lnTo>
                    <a:pt x="774" y="346"/>
                  </a:lnTo>
                  <a:lnTo>
                    <a:pt x="775" y="295"/>
                  </a:lnTo>
                  <a:lnTo>
                    <a:pt x="775" y="254"/>
                  </a:lnTo>
                  <a:lnTo>
                    <a:pt x="776" y="219"/>
                  </a:lnTo>
                  <a:lnTo>
                    <a:pt x="777" y="190"/>
                  </a:lnTo>
                  <a:lnTo>
                    <a:pt x="778" y="176"/>
                  </a:lnTo>
                  <a:lnTo>
                    <a:pt x="779" y="159"/>
                  </a:lnTo>
                  <a:lnTo>
                    <a:pt x="780" y="142"/>
                  </a:lnTo>
                  <a:lnTo>
                    <a:pt x="781" y="136"/>
                  </a:lnTo>
                  <a:lnTo>
                    <a:pt x="782" y="127"/>
                  </a:lnTo>
                  <a:lnTo>
                    <a:pt x="782" y="111"/>
                  </a:lnTo>
                  <a:lnTo>
                    <a:pt x="783" y="110"/>
                  </a:lnTo>
                  <a:lnTo>
                    <a:pt x="784" y="97"/>
                  </a:lnTo>
                  <a:lnTo>
                    <a:pt x="785" y="94"/>
                  </a:lnTo>
                  <a:lnTo>
                    <a:pt x="786" y="85"/>
                  </a:lnTo>
                  <a:lnTo>
                    <a:pt x="787" y="87"/>
                  </a:lnTo>
                  <a:lnTo>
                    <a:pt x="788" y="82"/>
                  </a:lnTo>
                  <a:lnTo>
                    <a:pt x="789" y="75"/>
                  </a:lnTo>
                  <a:lnTo>
                    <a:pt x="790" y="73"/>
                  </a:lnTo>
                  <a:lnTo>
                    <a:pt x="790" y="73"/>
                  </a:lnTo>
                  <a:lnTo>
                    <a:pt x="791" y="73"/>
                  </a:lnTo>
                  <a:lnTo>
                    <a:pt x="792" y="69"/>
                  </a:lnTo>
                  <a:lnTo>
                    <a:pt x="793" y="70"/>
                  </a:lnTo>
                  <a:lnTo>
                    <a:pt x="794" y="68"/>
                  </a:lnTo>
                  <a:lnTo>
                    <a:pt x="795" y="67"/>
                  </a:lnTo>
                  <a:lnTo>
                    <a:pt x="796" y="74"/>
                  </a:lnTo>
                  <a:lnTo>
                    <a:pt x="797" y="80"/>
                  </a:lnTo>
                  <a:lnTo>
                    <a:pt x="797" y="99"/>
                  </a:lnTo>
                  <a:lnTo>
                    <a:pt x="798" y="103"/>
                  </a:lnTo>
                  <a:lnTo>
                    <a:pt x="799" y="106"/>
                  </a:lnTo>
                  <a:lnTo>
                    <a:pt x="800" y="104"/>
                  </a:lnTo>
                  <a:lnTo>
                    <a:pt x="801" y="104"/>
                  </a:lnTo>
                  <a:lnTo>
                    <a:pt x="802" y="109"/>
                  </a:lnTo>
                  <a:lnTo>
                    <a:pt x="803" y="107"/>
                  </a:lnTo>
                  <a:lnTo>
                    <a:pt x="804" y="98"/>
                  </a:lnTo>
                  <a:lnTo>
                    <a:pt x="805" y="104"/>
                  </a:lnTo>
                  <a:lnTo>
                    <a:pt x="805" y="100"/>
                  </a:lnTo>
                  <a:lnTo>
                    <a:pt x="806" y="96"/>
                  </a:lnTo>
                  <a:lnTo>
                    <a:pt x="807" y="98"/>
                  </a:lnTo>
                  <a:lnTo>
                    <a:pt x="808" y="94"/>
                  </a:lnTo>
                  <a:lnTo>
                    <a:pt x="809" y="93"/>
                  </a:lnTo>
                  <a:lnTo>
                    <a:pt x="810" y="92"/>
                  </a:lnTo>
                  <a:lnTo>
                    <a:pt x="811" y="91"/>
                  </a:lnTo>
                  <a:lnTo>
                    <a:pt x="812" y="85"/>
                  </a:lnTo>
                  <a:lnTo>
                    <a:pt x="812" y="79"/>
                  </a:lnTo>
                  <a:lnTo>
                    <a:pt x="813" y="81"/>
                  </a:lnTo>
                  <a:lnTo>
                    <a:pt x="814" y="81"/>
                  </a:lnTo>
                  <a:lnTo>
                    <a:pt x="815" y="76"/>
                  </a:lnTo>
                  <a:lnTo>
                    <a:pt x="816" y="73"/>
                  </a:lnTo>
                  <a:lnTo>
                    <a:pt x="817" y="71"/>
                  </a:lnTo>
                  <a:lnTo>
                    <a:pt x="818" y="69"/>
                  </a:lnTo>
                  <a:lnTo>
                    <a:pt x="819" y="66"/>
                  </a:lnTo>
                  <a:lnTo>
                    <a:pt x="820" y="67"/>
                  </a:lnTo>
                  <a:lnTo>
                    <a:pt x="820" y="66"/>
                  </a:lnTo>
                  <a:lnTo>
                    <a:pt x="821" y="66"/>
                  </a:lnTo>
                  <a:lnTo>
                    <a:pt x="822" y="59"/>
                  </a:lnTo>
                  <a:lnTo>
                    <a:pt x="823" y="56"/>
                  </a:lnTo>
                  <a:lnTo>
                    <a:pt x="824" y="57"/>
                  </a:lnTo>
                  <a:lnTo>
                    <a:pt x="825" y="60"/>
                  </a:lnTo>
                  <a:lnTo>
                    <a:pt x="826" y="56"/>
                  </a:lnTo>
                  <a:lnTo>
                    <a:pt x="827" y="54"/>
                  </a:lnTo>
                  <a:lnTo>
                    <a:pt x="827" y="53"/>
                  </a:lnTo>
                  <a:lnTo>
                    <a:pt x="828" y="49"/>
                  </a:lnTo>
                  <a:lnTo>
                    <a:pt x="829" y="47"/>
                  </a:lnTo>
                  <a:lnTo>
                    <a:pt x="830" y="52"/>
                  </a:lnTo>
                  <a:lnTo>
                    <a:pt x="831" y="47"/>
                  </a:lnTo>
                  <a:lnTo>
                    <a:pt x="832" y="49"/>
                  </a:lnTo>
                  <a:lnTo>
                    <a:pt x="833" y="49"/>
                  </a:lnTo>
                  <a:lnTo>
                    <a:pt x="834" y="51"/>
                  </a:lnTo>
                  <a:lnTo>
                    <a:pt x="835" y="50"/>
                  </a:lnTo>
                  <a:lnTo>
                    <a:pt x="835" y="49"/>
                  </a:lnTo>
                  <a:lnTo>
                    <a:pt x="836" y="48"/>
                  </a:lnTo>
                  <a:lnTo>
                    <a:pt x="837" y="49"/>
                  </a:lnTo>
                  <a:lnTo>
                    <a:pt x="838" y="52"/>
                  </a:lnTo>
                  <a:lnTo>
                    <a:pt x="839" y="44"/>
                  </a:lnTo>
                  <a:lnTo>
                    <a:pt x="840" y="43"/>
                  </a:lnTo>
                  <a:lnTo>
                    <a:pt x="841" y="41"/>
                  </a:lnTo>
                  <a:lnTo>
                    <a:pt x="842" y="40"/>
                  </a:lnTo>
                  <a:lnTo>
                    <a:pt x="842" y="36"/>
                  </a:lnTo>
                  <a:lnTo>
                    <a:pt x="843" y="36"/>
                  </a:lnTo>
                  <a:lnTo>
                    <a:pt x="844" y="34"/>
                  </a:lnTo>
                  <a:lnTo>
                    <a:pt x="845" y="31"/>
                  </a:lnTo>
                  <a:lnTo>
                    <a:pt x="846" y="33"/>
                  </a:lnTo>
                  <a:lnTo>
                    <a:pt x="847" y="28"/>
                  </a:lnTo>
                  <a:lnTo>
                    <a:pt x="848" y="31"/>
                  </a:lnTo>
                  <a:lnTo>
                    <a:pt x="849" y="32"/>
                  </a:lnTo>
                  <a:lnTo>
                    <a:pt x="850" y="23"/>
                  </a:lnTo>
                  <a:lnTo>
                    <a:pt x="850" y="26"/>
                  </a:lnTo>
                  <a:lnTo>
                    <a:pt x="851" y="22"/>
                  </a:lnTo>
                  <a:lnTo>
                    <a:pt x="852" y="24"/>
                  </a:lnTo>
                  <a:lnTo>
                    <a:pt x="853" y="26"/>
                  </a:lnTo>
                  <a:lnTo>
                    <a:pt x="854" y="24"/>
                  </a:lnTo>
                  <a:lnTo>
                    <a:pt x="855" y="20"/>
                  </a:lnTo>
                  <a:lnTo>
                    <a:pt x="856" y="18"/>
                  </a:lnTo>
                  <a:lnTo>
                    <a:pt x="857" y="21"/>
                  </a:lnTo>
                  <a:lnTo>
                    <a:pt x="857" y="16"/>
                  </a:lnTo>
                  <a:lnTo>
                    <a:pt x="858" y="19"/>
                  </a:lnTo>
                  <a:lnTo>
                    <a:pt x="859" y="19"/>
                  </a:lnTo>
                  <a:lnTo>
                    <a:pt x="860" y="15"/>
                  </a:lnTo>
                  <a:lnTo>
                    <a:pt x="861" y="18"/>
                  </a:lnTo>
                  <a:lnTo>
                    <a:pt x="862" y="20"/>
                  </a:lnTo>
                  <a:lnTo>
                    <a:pt x="863" y="24"/>
                  </a:lnTo>
                  <a:lnTo>
                    <a:pt x="864" y="24"/>
                  </a:lnTo>
                  <a:lnTo>
                    <a:pt x="865" y="34"/>
                  </a:lnTo>
                  <a:lnTo>
                    <a:pt x="865" y="39"/>
                  </a:lnTo>
                  <a:lnTo>
                    <a:pt x="866" y="44"/>
                  </a:lnTo>
                  <a:lnTo>
                    <a:pt x="867" y="50"/>
                  </a:lnTo>
                  <a:lnTo>
                    <a:pt x="868" y="55"/>
                  </a:lnTo>
                  <a:lnTo>
                    <a:pt x="869" y="65"/>
                  </a:lnTo>
                  <a:lnTo>
                    <a:pt x="870" y="56"/>
                  </a:lnTo>
                  <a:lnTo>
                    <a:pt x="871" y="63"/>
                  </a:lnTo>
                  <a:lnTo>
                    <a:pt x="872" y="54"/>
                  </a:lnTo>
                  <a:lnTo>
                    <a:pt x="872" y="51"/>
                  </a:lnTo>
                  <a:lnTo>
                    <a:pt x="873" y="39"/>
                  </a:lnTo>
                  <a:lnTo>
                    <a:pt x="874" y="36"/>
                  </a:lnTo>
                  <a:lnTo>
                    <a:pt x="875" y="34"/>
                  </a:lnTo>
                  <a:lnTo>
                    <a:pt x="876" y="33"/>
                  </a:lnTo>
                  <a:lnTo>
                    <a:pt x="877" y="28"/>
                  </a:lnTo>
                  <a:lnTo>
                    <a:pt x="878" y="27"/>
                  </a:lnTo>
                  <a:lnTo>
                    <a:pt x="879" y="22"/>
                  </a:lnTo>
                  <a:lnTo>
                    <a:pt x="880" y="21"/>
                  </a:lnTo>
                  <a:lnTo>
                    <a:pt x="880" y="19"/>
                  </a:lnTo>
                  <a:lnTo>
                    <a:pt x="881" y="23"/>
                  </a:lnTo>
                  <a:lnTo>
                    <a:pt x="882" y="21"/>
                  </a:lnTo>
                  <a:lnTo>
                    <a:pt x="883" y="22"/>
                  </a:lnTo>
                  <a:lnTo>
                    <a:pt x="884" y="20"/>
                  </a:lnTo>
                  <a:lnTo>
                    <a:pt x="885" y="21"/>
                  </a:lnTo>
                  <a:lnTo>
                    <a:pt x="886" y="20"/>
                  </a:lnTo>
                  <a:lnTo>
                    <a:pt x="887" y="23"/>
                  </a:lnTo>
                  <a:lnTo>
                    <a:pt x="887" y="21"/>
                  </a:lnTo>
                  <a:lnTo>
                    <a:pt x="888" y="15"/>
                  </a:lnTo>
                  <a:lnTo>
                    <a:pt x="889" y="17"/>
                  </a:lnTo>
                  <a:lnTo>
                    <a:pt x="890" y="16"/>
                  </a:lnTo>
                  <a:lnTo>
                    <a:pt x="891" y="19"/>
                  </a:lnTo>
                  <a:lnTo>
                    <a:pt x="892" y="19"/>
                  </a:lnTo>
                  <a:lnTo>
                    <a:pt x="893" y="15"/>
                  </a:lnTo>
                  <a:lnTo>
                    <a:pt x="894" y="17"/>
                  </a:lnTo>
                  <a:lnTo>
                    <a:pt x="895" y="17"/>
                  </a:lnTo>
                  <a:lnTo>
                    <a:pt x="895" y="17"/>
                  </a:lnTo>
                  <a:lnTo>
                    <a:pt x="896" y="17"/>
                  </a:lnTo>
                  <a:lnTo>
                    <a:pt x="897" y="20"/>
                  </a:lnTo>
                  <a:lnTo>
                    <a:pt x="898" y="20"/>
                  </a:lnTo>
                  <a:lnTo>
                    <a:pt x="899" y="22"/>
                  </a:lnTo>
                  <a:lnTo>
                    <a:pt x="900" y="25"/>
                  </a:lnTo>
                  <a:lnTo>
                    <a:pt x="901" y="25"/>
                  </a:lnTo>
                  <a:lnTo>
                    <a:pt x="902" y="26"/>
                  </a:lnTo>
                  <a:lnTo>
                    <a:pt x="902" y="29"/>
                  </a:lnTo>
                  <a:lnTo>
                    <a:pt x="903" y="26"/>
                  </a:lnTo>
                  <a:lnTo>
                    <a:pt x="904" y="24"/>
                  </a:lnTo>
                  <a:lnTo>
                    <a:pt x="905" y="29"/>
                  </a:lnTo>
                  <a:lnTo>
                    <a:pt x="906" y="27"/>
                  </a:lnTo>
                  <a:lnTo>
                    <a:pt x="907" y="23"/>
                  </a:lnTo>
                  <a:lnTo>
                    <a:pt x="908" y="23"/>
                  </a:lnTo>
                  <a:lnTo>
                    <a:pt x="909" y="19"/>
                  </a:lnTo>
                  <a:lnTo>
                    <a:pt x="909" y="17"/>
                  </a:lnTo>
                  <a:lnTo>
                    <a:pt x="910" y="18"/>
                  </a:lnTo>
                  <a:lnTo>
                    <a:pt x="911" y="12"/>
                  </a:lnTo>
                  <a:lnTo>
                    <a:pt x="912" y="14"/>
                  </a:lnTo>
                  <a:lnTo>
                    <a:pt x="913" y="11"/>
                  </a:lnTo>
                  <a:lnTo>
                    <a:pt x="914" y="12"/>
                  </a:lnTo>
                  <a:lnTo>
                    <a:pt x="915" y="11"/>
                  </a:lnTo>
                  <a:lnTo>
                    <a:pt x="916" y="11"/>
                  </a:lnTo>
                  <a:lnTo>
                    <a:pt x="917" y="11"/>
                  </a:lnTo>
                  <a:lnTo>
                    <a:pt x="917" y="9"/>
                  </a:lnTo>
                  <a:lnTo>
                    <a:pt x="918" y="10"/>
                  </a:lnTo>
                  <a:lnTo>
                    <a:pt x="919" y="11"/>
                  </a:lnTo>
                  <a:lnTo>
                    <a:pt x="920" y="8"/>
                  </a:lnTo>
                  <a:lnTo>
                    <a:pt x="921" y="7"/>
                  </a:lnTo>
                  <a:lnTo>
                    <a:pt x="922" y="9"/>
                  </a:lnTo>
                  <a:lnTo>
                    <a:pt x="923" y="8"/>
                  </a:lnTo>
                  <a:lnTo>
                    <a:pt x="924" y="9"/>
                  </a:lnTo>
                  <a:lnTo>
                    <a:pt x="924" y="6"/>
                  </a:lnTo>
                  <a:lnTo>
                    <a:pt x="925" y="7"/>
                  </a:lnTo>
                  <a:lnTo>
                    <a:pt x="926" y="10"/>
                  </a:lnTo>
                  <a:lnTo>
                    <a:pt x="927" y="8"/>
                  </a:lnTo>
                  <a:lnTo>
                    <a:pt x="928" y="6"/>
                  </a:lnTo>
                  <a:lnTo>
                    <a:pt x="929" y="10"/>
                  </a:lnTo>
                  <a:lnTo>
                    <a:pt x="930" y="14"/>
                  </a:lnTo>
                  <a:lnTo>
                    <a:pt x="931" y="9"/>
                  </a:lnTo>
                  <a:lnTo>
                    <a:pt x="932" y="9"/>
                  </a:lnTo>
                  <a:lnTo>
                    <a:pt x="932" y="14"/>
                  </a:lnTo>
                  <a:lnTo>
                    <a:pt x="933" y="11"/>
                  </a:lnTo>
                  <a:lnTo>
                    <a:pt x="934" y="13"/>
                  </a:lnTo>
                  <a:lnTo>
                    <a:pt x="935" y="13"/>
                  </a:lnTo>
                  <a:lnTo>
                    <a:pt x="936" y="10"/>
                  </a:lnTo>
                  <a:lnTo>
                    <a:pt x="937" y="13"/>
                  </a:lnTo>
                  <a:lnTo>
                    <a:pt x="938" y="12"/>
                  </a:lnTo>
                  <a:lnTo>
                    <a:pt x="939" y="15"/>
                  </a:lnTo>
                  <a:lnTo>
                    <a:pt x="939" y="14"/>
                  </a:lnTo>
                  <a:lnTo>
                    <a:pt x="940" y="16"/>
                  </a:lnTo>
                  <a:lnTo>
                    <a:pt x="941" y="14"/>
                  </a:lnTo>
                  <a:lnTo>
                    <a:pt x="942" y="17"/>
                  </a:lnTo>
                  <a:lnTo>
                    <a:pt x="943" y="17"/>
                  </a:lnTo>
                  <a:lnTo>
                    <a:pt x="944" y="21"/>
                  </a:lnTo>
                  <a:lnTo>
                    <a:pt x="945" y="19"/>
                  </a:lnTo>
                  <a:lnTo>
                    <a:pt x="946" y="18"/>
                  </a:lnTo>
                  <a:lnTo>
                    <a:pt x="947" y="16"/>
                  </a:lnTo>
                  <a:lnTo>
                    <a:pt x="947" y="19"/>
                  </a:lnTo>
                  <a:lnTo>
                    <a:pt x="948" y="16"/>
                  </a:lnTo>
                  <a:lnTo>
                    <a:pt x="949" y="18"/>
                  </a:lnTo>
                  <a:lnTo>
                    <a:pt x="950" y="16"/>
                  </a:lnTo>
                  <a:lnTo>
                    <a:pt x="951" y="13"/>
                  </a:lnTo>
                  <a:lnTo>
                    <a:pt x="952" y="15"/>
                  </a:lnTo>
                  <a:lnTo>
                    <a:pt x="953" y="14"/>
                  </a:lnTo>
                  <a:lnTo>
                    <a:pt x="954" y="18"/>
                  </a:lnTo>
                  <a:lnTo>
                    <a:pt x="954" y="16"/>
                  </a:lnTo>
                  <a:lnTo>
                    <a:pt x="955" y="13"/>
                  </a:lnTo>
                  <a:lnTo>
                    <a:pt x="956" y="13"/>
                  </a:lnTo>
                  <a:lnTo>
                    <a:pt x="957" y="14"/>
                  </a:lnTo>
                  <a:lnTo>
                    <a:pt x="958" y="12"/>
                  </a:lnTo>
                  <a:lnTo>
                    <a:pt x="959" y="14"/>
                  </a:lnTo>
                  <a:lnTo>
                    <a:pt x="960" y="10"/>
                  </a:lnTo>
                  <a:lnTo>
                    <a:pt x="961" y="10"/>
                  </a:lnTo>
                  <a:lnTo>
                    <a:pt x="962" y="11"/>
                  </a:lnTo>
                  <a:lnTo>
                    <a:pt x="962" y="11"/>
                  </a:lnTo>
                  <a:lnTo>
                    <a:pt x="963" y="11"/>
                  </a:lnTo>
                  <a:lnTo>
                    <a:pt x="964" y="12"/>
                  </a:lnTo>
                  <a:lnTo>
                    <a:pt x="965" y="13"/>
                  </a:lnTo>
                  <a:lnTo>
                    <a:pt x="966" y="11"/>
                  </a:lnTo>
                  <a:lnTo>
                    <a:pt x="967" y="10"/>
                  </a:lnTo>
                  <a:lnTo>
                    <a:pt x="968" y="8"/>
                  </a:lnTo>
                  <a:lnTo>
                    <a:pt x="969" y="13"/>
                  </a:lnTo>
                  <a:lnTo>
                    <a:pt x="969" y="12"/>
                  </a:lnTo>
                  <a:lnTo>
                    <a:pt x="970" y="9"/>
                  </a:lnTo>
                  <a:lnTo>
                    <a:pt x="971" y="9"/>
                  </a:lnTo>
                  <a:lnTo>
                    <a:pt x="972" y="9"/>
                  </a:lnTo>
                  <a:lnTo>
                    <a:pt x="973" y="8"/>
                  </a:lnTo>
                  <a:lnTo>
                    <a:pt x="974" y="7"/>
                  </a:lnTo>
                  <a:lnTo>
                    <a:pt x="975" y="8"/>
                  </a:lnTo>
                  <a:lnTo>
                    <a:pt x="976" y="5"/>
                  </a:lnTo>
                  <a:lnTo>
                    <a:pt x="977" y="6"/>
                  </a:lnTo>
                  <a:lnTo>
                    <a:pt x="977" y="5"/>
                  </a:lnTo>
                  <a:lnTo>
                    <a:pt x="978" y="8"/>
                  </a:lnTo>
                  <a:lnTo>
                    <a:pt x="979" y="5"/>
                  </a:lnTo>
                  <a:lnTo>
                    <a:pt x="980" y="5"/>
                  </a:lnTo>
                  <a:lnTo>
                    <a:pt x="981" y="7"/>
                  </a:lnTo>
                  <a:lnTo>
                    <a:pt x="982" y="6"/>
                  </a:lnTo>
                  <a:lnTo>
                    <a:pt x="983" y="7"/>
                  </a:lnTo>
                  <a:lnTo>
                    <a:pt x="984" y="5"/>
                  </a:lnTo>
                  <a:lnTo>
                    <a:pt x="984" y="6"/>
                  </a:lnTo>
                  <a:lnTo>
                    <a:pt x="985" y="6"/>
                  </a:lnTo>
                  <a:lnTo>
                    <a:pt x="986" y="10"/>
                  </a:lnTo>
                  <a:lnTo>
                    <a:pt x="987" y="8"/>
                  </a:lnTo>
                  <a:lnTo>
                    <a:pt x="988" y="10"/>
                  </a:lnTo>
                  <a:lnTo>
                    <a:pt x="989" y="5"/>
                  </a:lnTo>
                  <a:lnTo>
                    <a:pt x="990" y="6"/>
                  </a:lnTo>
                  <a:lnTo>
                    <a:pt x="991" y="7"/>
                  </a:lnTo>
                  <a:lnTo>
                    <a:pt x="992" y="7"/>
                  </a:lnTo>
                  <a:lnTo>
                    <a:pt x="992" y="8"/>
                  </a:lnTo>
                  <a:lnTo>
                    <a:pt x="993" y="8"/>
                  </a:lnTo>
                  <a:lnTo>
                    <a:pt x="994" y="10"/>
                  </a:lnTo>
                  <a:lnTo>
                    <a:pt x="995" y="12"/>
                  </a:lnTo>
                  <a:lnTo>
                    <a:pt x="996" y="10"/>
                  </a:lnTo>
                  <a:lnTo>
                    <a:pt x="997" y="11"/>
                  </a:lnTo>
                  <a:lnTo>
                    <a:pt x="998" y="12"/>
                  </a:lnTo>
                  <a:lnTo>
                    <a:pt x="999" y="13"/>
                  </a:lnTo>
                  <a:lnTo>
                    <a:pt x="999" y="12"/>
                  </a:lnTo>
                  <a:lnTo>
                    <a:pt x="1000" y="8"/>
                  </a:lnTo>
                  <a:lnTo>
                    <a:pt x="1001" y="11"/>
                  </a:lnTo>
                  <a:lnTo>
                    <a:pt x="1002" y="8"/>
                  </a:lnTo>
                  <a:lnTo>
                    <a:pt x="1003" y="7"/>
                  </a:lnTo>
                  <a:lnTo>
                    <a:pt x="1004" y="6"/>
                  </a:lnTo>
                  <a:lnTo>
                    <a:pt x="1005" y="8"/>
                  </a:lnTo>
                  <a:lnTo>
                    <a:pt x="1006" y="7"/>
                  </a:lnTo>
                  <a:lnTo>
                    <a:pt x="1007" y="7"/>
                  </a:lnTo>
                  <a:lnTo>
                    <a:pt x="1007" y="5"/>
                  </a:lnTo>
                  <a:lnTo>
                    <a:pt x="1008" y="6"/>
                  </a:lnTo>
                  <a:lnTo>
                    <a:pt x="1009" y="5"/>
                  </a:lnTo>
                  <a:lnTo>
                    <a:pt x="1010" y="3"/>
                  </a:lnTo>
                  <a:lnTo>
                    <a:pt x="1011" y="5"/>
                  </a:lnTo>
                  <a:lnTo>
                    <a:pt x="1012" y="6"/>
                  </a:lnTo>
                  <a:lnTo>
                    <a:pt x="1013" y="5"/>
                  </a:lnTo>
                  <a:lnTo>
                    <a:pt x="1014" y="4"/>
                  </a:lnTo>
                  <a:lnTo>
                    <a:pt x="1014" y="6"/>
                  </a:lnTo>
                  <a:lnTo>
                    <a:pt x="1015" y="8"/>
                  </a:lnTo>
                  <a:lnTo>
                    <a:pt x="1016" y="8"/>
                  </a:lnTo>
                  <a:lnTo>
                    <a:pt x="1017" y="9"/>
                  </a:lnTo>
                  <a:lnTo>
                    <a:pt x="1018" y="12"/>
                  </a:lnTo>
                  <a:lnTo>
                    <a:pt x="1019" y="10"/>
                  </a:lnTo>
                  <a:lnTo>
                    <a:pt x="1020" y="11"/>
                  </a:lnTo>
                  <a:lnTo>
                    <a:pt x="1021" y="9"/>
                  </a:lnTo>
                  <a:lnTo>
                    <a:pt x="1022" y="10"/>
                  </a:lnTo>
                  <a:lnTo>
                    <a:pt x="1022" y="8"/>
                  </a:lnTo>
                  <a:lnTo>
                    <a:pt x="1023" y="12"/>
                  </a:lnTo>
                  <a:lnTo>
                    <a:pt x="1024" y="8"/>
                  </a:lnTo>
                  <a:lnTo>
                    <a:pt x="1025" y="10"/>
                  </a:lnTo>
                  <a:lnTo>
                    <a:pt x="1026" y="6"/>
                  </a:lnTo>
                  <a:lnTo>
                    <a:pt x="1027" y="8"/>
                  </a:lnTo>
                  <a:lnTo>
                    <a:pt x="1028" y="6"/>
                  </a:lnTo>
                  <a:lnTo>
                    <a:pt x="1029" y="5"/>
                  </a:lnTo>
                  <a:lnTo>
                    <a:pt x="1029" y="6"/>
                  </a:lnTo>
                  <a:lnTo>
                    <a:pt x="1030" y="8"/>
                  </a:lnTo>
                  <a:lnTo>
                    <a:pt x="1031" y="10"/>
                  </a:lnTo>
                  <a:lnTo>
                    <a:pt x="1032" y="8"/>
                  </a:lnTo>
                  <a:lnTo>
                    <a:pt x="1033" y="9"/>
                  </a:lnTo>
                  <a:lnTo>
                    <a:pt x="1034" y="8"/>
                  </a:lnTo>
                  <a:lnTo>
                    <a:pt x="1035" y="7"/>
                  </a:lnTo>
                  <a:lnTo>
                    <a:pt x="1036" y="8"/>
                  </a:lnTo>
                  <a:lnTo>
                    <a:pt x="1037" y="6"/>
                  </a:lnTo>
                  <a:lnTo>
                    <a:pt x="1037" y="9"/>
                  </a:lnTo>
                  <a:lnTo>
                    <a:pt x="1038" y="7"/>
                  </a:lnTo>
                  <a:lnTo>
                    <a:pt x="1039" y="7"/>
                  </a:lnTo>
                  <a:lnTo>
                    <a:pt x="1040" y="4"/>
                  </a:lnTo>
                  <a:lnTo>
                    <a:pt x="1041" y="8"/>
                  </a:lnTo>
                  <a:lnTo>
                    <a:pt x="1042" y="8"/>
                  </a:lnTo>
                  <a:lnTo>
                    <a:pt x="1043" y="10"/>
                  </a:lnTo>
                  <a:lnTo>
                    <a:pt x="1044" y="9"/>
                  </a:lnTo>
                  <a:lnTo>
                    <a:pt x="1044" y="11"/>
                  </a:lnTo>
                  <a:lnTo>
                    <a:pt x="1045" y="13"/>
                  </a:lnTo>
                  <a:lnTo>
                    <a:pt x="1046" y="11"/>
                  </a:lnTo>
                  <a:lnTo>
                    <a:pt x="1047" y="10"/>
                  </a:lnTo>
                  <a:lnTo>
                    <a:pt x="1048" y="10"/>
                  </a:lnTo>
                  <a:lnTo>
                    <a:pt x="1049" y="11"/>
                  </a:lnTo>
                  <a:lnTo>
                    <a:pt x="1050" y="9"/>
                  </a:lnTo>
                  <a:lnTo>
                    <a:pt x="1051" y="8"/>
                  </a:lnTo>
                  <a:lnTo>
                    <a:pt x="1052" y="10"/>
                  </a:lnTo>
                  <a:lnTo>
                    <a:pt x="1052" y="8"/>
                  </a:lnTo>
                  <a:lnTo>
                    <a:pt x="1053" y="6"/>
                  </a:lnTo>
                  <a:lnTo>
                    <a:pt x="1054" y="9"/>
                  </a:lnTo>
                  <a:lnTo>
                    <a:pt x="1055" y="6"/>
                  </a:lnTo>
                  <a:lnTo>
                    <a:pt x="1056" y="5"/>
                  </a:lnTo>
                  <a:lnTo>
                    <a:pt x="1057" y="5"/>
                  </a:lnTo>
                  <a:lnTo>
                    <a:pt x="1058" y="9"/>
                  </a:lnTo>
                  <a:lnTo>
                    <a:pt x="1059" y="7"/>
                  </a:lnTo>
                  <a:lnTo>
                    <a:pt x="1059" y="5"/>
                  </a:lnTo>
                  <a:lnTo>
                    <a:pt x="1060" y="5"/>
                  </a:lnTo>
                  <a:lnTo>
                    <a:pt x="1061" y="6"/>
                  </a:lnTo>
                  <a:lnTo>
                    <a:pt x="1062" y="8"/>
                  </a:lnTo>
                  <a:lnTo>
                    <a:pt x="1063" y="6"/>
                  </a:lnTo>
                  <a:lnTo>
                    <a:pt x="1064" y="12"/>
                  </a:lnTo>
                  <a:lnTo>
                    <a:pt x="1065" y="10"/>
                  </a:lnTo>
                  <a:lnTo>
                    <a:pt x="1066" y="10"/>
                  </a:lnTo>
                  <a:lnTo>
                    <a:pt x="1067" y="11"/>
                  </a:lnTo>
                  <a:lnTo>
                    <a:pt x="1067" y="7"/>
                  </a:lnTo>
                  <a:lnTo>
                    <a:pt x="1068" y="10"/>
                  </a:lnTo>
                  <a:lnTo>
                    <a:pt x="1069" y="12"/>
                  </a:lnTo>
                  <a:lnTo>
                    <a:pt x="1070" y="10"/>
                  </a:lnTo>
                  <a:lnTo>
                    <a:pt x="1071" y="10"/>
                  </a:lnTo>
                  <a:lnTo>
                    <a:pt x="1072" y="11"/>
                  </a:lnTo>
                  <a:lnTo>
                    <a:pt x="1073" y="15"/>
                  </a:lnTo>
                  <a:lnTo>
                    <a:pt x="1074" y="20"/>
                  </a:lnTo>
                  <a:lnTo>
                    <a:pt x="1074" y="34"/>
                  </a:lnTo>
                  <a:lnTo>
                    <a:pt x="1075" y="51"/>
                  </a:lnTo>
                  <a:lnTo>
                    <a:pt x="1076" y="67"/>
                  </a:lnTo>
                  <a:lnTo>
                    <a:pt x="1077" y="103"/>
                  </a:lnTo>
                  <a:lnTo>
                    <a:pt x="1078" y="139"/>
                  </a:lnTo>
                  <a:lnTo>
                    <a:pt x="1079" y="177"/>
                  </a:lnTo>
                  <a:lnTo>
                    <a:pt x="1080" y="208"/>
                  </a:lnTo>
                  <a:lnTo>
                    <a:pt x="1081" y="223"/>
                  </a:lnTo>
                  <a:lnTo>
                    <a:pt x="1082" y="258"/>
                  </a:lnTo>
                  <a:lnTo>
                    <a:pt x="1082" y="256"/>
                  </a:lnTo>
                  <a:lnTo>
                    <a:pt x="1083" y="261"/>
                  </a:lnTo>
                  <a:lnTo>
                    <a:pt x="1084" y="268"/>
                  </a:lnTo>
                  <a:lnTo>
                    <a:pt x="1085" y="268"/>
                  </a:lnTo>
                  <a:lnTo>
                    <a:pt x="1086" y="250"/>
                  </a:lnTo>
                  <a:lnTo>
                    <a:pt x="1087" y="240"/>
                  </a:lnTo>
                  <a:lnTo>
                    <a:pt x="1088" y="244"/>
                  </a:lnTo>
                  <a:lnTo>
                    <a:pt x="1089" y="238"/>
                  </a:lnTo>
                  <a:lnTo>
                    <a:pt x="1089" y="234"/>
                  </a:lnTo>
                  <a:lnTo>
                    <a:pt x="1090" y="233"/>
                  </a:lnTo>
                  <a:lnTo>
                    <a:pt x="1091" y="232"/>
                  </a:lnTo>
                  <a:lnTo>
                    <a:pt x="1092" y="240"/>
                  </a:lnTo>
                  <a:lnTo>
                    <a:pt x="1093" y="239"/>
                  </a:lnTo>
                  <a:lnTo>
                    <a:pt x="1094" y="264"/>
                  </a:lnTo>
                  <a:lnTo>
                    <a:pt x="1095" y="266"/>
                  </a:lnTo>
                  <a:lnTo>
                    <a:pt x="1096" y="269"/>
                  </a:lnTo>
                  <a:lnTo>
                    <a:pt x="1097" y="255"/>
                  </a:lnTo>
                  <a:lnTo>
                    <a:pt x="1097" y="279"/>
                  </a:lnTo>
                  <a:lnTo>
                    <a:pt x="1098" y="274"/>
                  </a:lnTo>
                  <a:lnTo>
                    <a:pt x="1099" y="280"/>
                  </a:lnTo>
                  <a:lnTo>
                    <a:pt x="1100" y="264"/>
                  </a:lnTo>
                  <a:lnTo>
                    <a:pt x="1101" y="255"/>
                  </a:lnTo>
                  <a:lnTo>
                    <a:pt x="1102" y="255"/>
                  </a:lnTo>
                  <a:lnTo>
                    <a:pt x="1103" y="247"/>
                  </a:lnTo>
                  <a:lnTo>
                    <a:pt x="1104" y="241"/>
                  </a:lnTo>
                  <a:lnTo>
                    <a:pt x="1104" y="219"/>
                  </a:lnTo>
                  <a:lnTo>
                    <a:pt x="1105" y="220"/>
                  </a:lnTo>
                  <a:lnTo>
                    <a:pt x="1106" y="213"/>
                  </a:lnTo>
                  <a:lnTo>
                    <a:pt x="1107" y="205"/>
                  </a:lnTo>
                  <a:lnTo>
                    <a:pt x="1108" y="192"/>
                  </a:lnTo>
                  <a:lnTo>
                    <a:pt x="1109" y="183"/>
                  </a:lnTo>
                  <a:lnTo>
                    <a:pt x="1110" y="171"/>
                  </a:lnTo>
                  <a:lnTo>
                    <a:pt x="1111" y="162"/>
                  </a:lnTo>
                  <a:lnTo>
                    <a:pt x="1111" y="162"/>
                  </a:lnTo>
                  <a:lnTo>
                    <a:pt x="1112" y="145"/>
                  </a:lnTo>
                  <a:lnTo>
                    <a:pt x="1113" y="141"/>
                  </a:lnTo>
                  <a:lnTo>
                    <a:pt x="1114" y="131"/>
                  </a:lnTo>
                  <a:lnTo>
                    <a:pt x="1115" y="122"/>
                  </a:lnTo>
                  <a:lnTo>
                    <a:pt x="1116" y="124"/>
                  </a:lnTo>
                  <a:lnTo>
                    <a:pt x="1117" y="116"/>
                  </a:lnTo>
                  <a:lnTo>
                    <a:pt x="1118" y="113"/>
                  </a:lnTo>
                  <a:lnTo>
                    <a:pt x="1119" y="106"/>
                  </a:lnTo>
                  <a:lnTo>
                    <a:pt x="1119" y="104"/>
                  </a:lnTo>
                  <a:lnTo>
                    <a:pt x="1120" y="103"/>
                  </a:lnTo>
                  <a:lnTo>
                    <a:pt x="1121" y="91"/>
                  </a:lnTo>
                  <a:lnTo>
                    <a:pt x="1122" y="87"/>
                  </a:lnTo>
                  <a:lnTo>
                    <a:pt x="1123" y="84"/>
                  </a:lnTo>
                  <a:lnTo>
                    <a:pt x="1124" y="75"/>
                  </a:lnTo>
                  <a:lnTo>
                    <a:pt x="1125" y="73"/>
                  </a:lnTo>
                  <a:lnTo>
                    <a:pt x="1126" y="67"/>
                  </a:lnTo>
                  <a:lnTo>
                    <a:pt x="1126" y="65"/>
                  </a:lnTo>
                  <a:lnTo>
                    <a:pt x="1127" y="65"/>
                  </a:lnTo>
                  <a:lnTo>
                    <a:pt x="1128" y="70"/>
                  </a:lnTo>
                  <a:lnTo>
                    <a:pt x="1129" y="69"/>
                  </a:lnTo>
                  <a:lnTo>
                    <a:pt x="1130" y="75"/>
                  </a:lnTo>
                  <a:lnTo>
                    <a:pt x="1131" y="82"/>
                  </a:lnTo>
                  <a:lnTo>
                    <a:pt x="1132" y="82"/>
                  </a:lnTo>
                  <a:lnTo>
                    <a:pt x="1133" y="92"/>
                  </a:lnTo>
                  <a:lnTo>
                    <a:pt x="1134" y="92"/>
                  </a:lnTo>
                  <a:lnTo>
                    <a:pt x="1134" y="99"/>
                  </a:lnTo>
                  <a:lnTo>
                    <a:pt x="1135" y="97"/>
                  </a:lnTo>
                  <a:lnTo>
                    <a:pt x="1136" y="103"/>
                  </a:lnTo>
                  <a:lnTo>
                    <a:pt x="1137" y="98"/>
                  </a:lnTo>
                  <a:lnTo>
                    <a:pt x="1138" y="104"/>
                  </a:lnTo>
                  <a:lnTo>
                    <a:pt x="1139" y="101"/>
                  </a:lnTo>
                  <a:lnTo>
                    <a:pt x="1140" y="95"/>
                  </a:lnTo>
                  <a:lnTo>
                    <a:pt x="1141" y="82"/>
                  </a:lnTo>
                  <a:lnTo>
                    <a:pt x="1141" y="78"/>
                  </a:lnTo>
                  <a:lnTo>
                    <a:pt x="1142" y="68"/>
                  </a:lnTo>
                  <a:lnTo>
                    <a:pt x="1143" y="64"/>
                  </a:lnTo>
                  <a:lnTo>
                    <a:pt x="1144" y="54"/>
                  </a:lnTo>
                  <a:lnTo>
                    <a:pt x="1145" y="53"/>
                  </a:lnTo>
                  <a:lnTo>
                    <a:pt x="1146" y="44"/>
                  </a:lnTo>
                  <a:lnTo>
                    <a:pt x="1147" y="47"/>
                  </a:lnTo>
                  <a:lnTo>
                    <a:pt x="1148" y="36"/>
                  </a:lnTo>
                  <a:lnTo>
                    <a:pt x="1149" y="40"/>
                  </a:lnTo>
                  <a:lnTo>
                    <a:pt x="1149" y="39"/>
                  </a:lnTo>
                  <a:lnTo>
                    <a:pt x="1150" y="37"/>
                  </a:lnTo>
                  <a:lnTo>
                    <a:pt x="1151" y="34"/>
                  </a:lnTo>
                  <a:lnTo>
                    <a:pt x="1152" y="31"/>
                  </a:lnTo>
                  <a:lnTo>
                    <a:pt x="1153" y="32"/>
                  </a:lnTo>
                  <a:lnTo>
                    <a:pt x="1154" y="27"/>
                  </a:lnTo>
                  <a:lnTo>
                    <a:pt x="1155" y="26"/>
                  </a:lnTo>
                  <a:lnTo>
                    <a:pt x="1156" y="26"/>
                  </a:lnTo>
                  <a:lnTo>
                    <a:pt x="1156" y="26"/>
                  </a:lnTo>
                  <a:lnTo>
                    <a:pt x="1157" y="27"/>
                  </a:lnTo>
                  <a:lnTo>
                    <a:pt x="1158" y="27"/>
                  </a:lnTo>
                  <a:lnTo>
                    <a:pt x="1159" y="25"/>
                  </a:lnTo>
                  <a:lnTo>
                    <a:pt x="1160" y="26"/>
                  </a:lnTo>
                  <a:lnTo>
                    <a:pt x="1161" y="28"/>
                  </a:lnTo>
                  <a:lnTo>
                    <a:pt x="1162" y="29"/>
                  </a:lnTo>
                  <a:lnTo>
                    <a:pt x="1163" y="31"/>
                  </a:lnTo>
                  <a:lnTo>
                    <a:pt x="1164" y="29"/>
                  </a:lnTo>
                  <a:lnTo>
                    <a:pt x="1164" y="30"/>
                  </a:lnTo>
                  <a:lnTo>
                    <a:pt x="1165" y="32"/>
                  </a:lnTo>
                  <a:lnTo>
                    <a:pt x="1166" y="30"/>
                  </a:lnTo>
                  <a:lnTo>
                    <a:pt x="1167" y="24"/>
                  </a:lnTo>
                  <a:lnTo>
                    <a:pt x="1168" y="27"/>
                  </a:lnTo>
                  <a:lnTo>
                    <a:pt x="1169" y="21"/>
                  </a:lnTo>
                  <a:lnTo>
                    <a:pt x="1170" y="18"/>
                  </a:lnTo>
                  <a:lnTo>
                    <a:pt x="1171" y="19"/>
                  </a:lnTo>
                  <a:lnTo>
                    <a:pt x="1171" y="18"/>
                  </a:lnTo>
                  <a:lnTo>
                    <a:pt x="1172" y="13"/>
                  </a:lnTo>
                  <a:lnTo>
                    <a:pt x="1173" y="14"/>
                  </a:lnTo>
                  <a:lnTo>
                    <a:pt x="1174" y="13"/>
                  </a:lnTo>
                  <a:lnTo>
                    <a:pt x="1175" y="12"/>
                  </a:lnTo>
                  <a:lnTo>
                    <a:pt x="1176" y="11"/>
                  </a:lnTo>
                  <a:lnTo>
                    <a:pt x="1177" y="9"/>
                  </a:lnTo>
                  <a:lnTo>
                    <a:pt x="1178" y="8"/>
                  </a:lnTo>
                  <a:lnTo>
                    <a:pt x="1179" y="11"/>
                  </a:lnTo>
                  <a:lnTo>
                    <a:pt x="1179" y="9"/>
                  </a:lnTo>
                  <a:lnTo>
                    <a:pt x="1180" y="10"/>
                  </a:lnTo>
                  <a:lnTo>
                    <a:pt x="1181" y="11"/>
                  </a:lnTo>
                  <a:lnTo>
                    <a:pt x="1182" y="14"/>
                  </a:lnTo>
                  <a:lnTo>
                    <a:pt x="1183" y="18"/>
                  </a:lnTo>
                  <a:lnTo>
                    <a:pt x="1184" y="17"/>
                  </a:lnTo>
                  <a:lnTo>
                    <a:pt x="1185" y="19"/>
                  </a:lnTo>
                  <a:lnTo>
                    <a:pt x="1186" y="19"/>
                  </a:lnTo>
                  <a:lnTo>
                    <a:pt x="1186" y="22"/>
                  </a:lnTo>
                  <a:lnTo>
                    <a:pt x="1187" y="21"/>
                  </a:lnTo>
                  <a:lnTo>
                    <a:pt x="1188" y="18"/>
                  </a:lnTo>
                  <a:lnTo>
                    <a:pt x="1189" y="18"/>
                  </a:lnTo>
                  <a:lnTo>
                    <a:pt x="1190" y="19"/>
                  </a:lnTo>
                  <a:lnTo>
                    <a:pt x="1191" y="17"/>
                  </a:lnTo>
                  <a:lnTo>
                    <a:pt x="1192" y="18"/>
                  </a:lnTo>
                  <a:lnTo>
                    <a:pt x="1193" y="19"/>
                  </a:lnTo>
                  <a:lnTo>
                    <a:pt x="1194" y="14"/>
                  </a:lnTo>
                  <a:lnTo>
                    <a:pt x="1194" y="14"/>
                  </a:lnTo>
                  <a:lnTo>
                    <a:pt x="1195" y="19"/>
                  </a:lnTo>
                  <a:lnTo>
                    <a:pt x="1196" y="15"/>
                  </a:lnTo>
                  <a:lnTo>
                    <a:pt x="1197" y="15"/>
                  </a:lnTo>
                  <a:lnTo>
                    <a:pt x="1198" y="17"/>
                  </a:lnTo>
                  <a:lnTo>
                    <a:pt x="1199" y="16"/>
                  </a:lnTo>
                  <a:lnTo>
                    <a:pt x="1200" y="15"/>
                  </a:lnTo>
                  <a:lnTo>
                    <a:pt x="1201" y="20"/>
                  </a:lnTo>
                  <a:lnTo>
                    <a:pt x="1201" y="17"/>
                  </a:lnTo>
                  <a:lnTo>
                    <a:pt x="1202" y="21"/>
                  </a:lnTo>
                  <a:lnTo>
                    <a:pt x="1203" y="18"/>
                  </a:lnTo>
                  <a:lnTo>
                    <a:pt x="1204" y="19"/>
                  </a:lnTo>
                  <a:lnTo>
                    <a:pt x="1205" y="17"/>
                  </a:lnTo>
                  <a:lnTo>
                    <a:pt x="1206" y="17"/>
                  </a:lnTo>
                  <a:lnTo>
                    <a:pt x="1207" y="15"/>
                  </a:lnTo>
                  <a:lnTo>
                    <a:pt x="1208" y="16"/>
                  </a:lnTo>
                  <a:lnTo>
                    <a:pt x="1209" y="16"/>
                  </a:lnTo>
                  <a:lnTo>
                    <a:pt x="1209" y="15"/>
                  </a:lnTo>
                  <a:lnTo>
                    <a:pt x="1210" y="15"/>
                  </a:lnTo>
                  <a:lnTo>
                    <a:pt x="1211" y="13"/>
                  </a:lnTo>
                  <a:lnTo>
                    <a:pt x="1212" y="13"/>
                  </a:lnTo>
                  <a:lnTo>
                    <a:pt x="1213" y="18"/>
                  </a:lnTo>
                  <a:lnTo>
                    <a:pt x="1214" y="16"/>
                  </a:lnTo>
                  <a:lnTo>
                    <a:pt x="1215" y="19"/>
                  </a:lnTo>
                  <a:lnTo>
                    <a:pt x="1216" y="17"/>
                  </a:lnTo>
                  <a:lnTo>
                    <a:pt x="1216" y="17"/>
                  </a:lnTo>
                  <a:lnTo>
                    <a:pt x="1217" y="15"/>
                  </a:lnTo>
                  <a:lnTo>
                    <a:pt x="1218" y="12"/>
                  </a:lnTo>
                  <a:lnTo>
                    <a:pt x="1219" y="17"/>
                  </a:lnTo>
                  <a:lnTo>
                    <a:pt x="1220" y="13"/>
                  </a:lnTo>
                  <a:lnTo>
                    <a:pt x="1221" y="13"/>
                  </a:lnTo>
                  <a:lnTo>
                    <a:pt x="1222" y="13"/>
                  </a:lnTo>
                  <a:lnTo>
                    <a:pt x="1223" y="12"/>
                  </a:lnTo>
                  <a:lnTo>
                    <a:pt x="1224" y="12"/>
                  </a:lnTo>
                  <a:lnTo>
                    <a:pt x="1224" y="13"/>
                  </a:lnTo>
                  <a:lnTo>
                    <a:pt x="1225" y="12"/>
                  </a:lnTo>
                  <a:lnTo>
                    <a:pt x="1226" y="12"/>
                  </a:lnTo>
                  <a:lnTo>
                    <a:pt x="1227" y="10"/>
                  </a:lnTo>
                  <a:lnTo>
                    <a:pt x="1228" y="9"/>
                  </a:lnTo>
                  <a:lnTo>
                    <a:pt x="1229" y="13"/>
                  </a:lnTo>
                  <a:lnTo>
                    <a:pt x="1230" y="8"/>
                  </a:lnTo>
                  <a:lnTo>
                    <a:pt x="1231" y="9"/>
                  </a:lnTo>
                  <a:lnTo>
                    <a:pt x="1231" y="8"/>
                  </a:lnTo>
                  <a:lnTo>
                    <a:pt x="1232" y="8"/>
                  </a:lnTo>
                  <a:lnTo>
                    <a:pt x="1233" y="10"/>
                  </a:lnTo>
                  <a:lnTo>
                    <a:pt x="1234" y="9"/>
                  </a:lnTo>
                  <a:lnTo>
                    <a:pt x="1235" y="6"/>
                  </a:lnTo>
                  <a:lnTo>
                    <a:pt x="1236" y="7"/>
                  </a:lnTo>
                  <a:lnTo>
                    <a:pt x="1237" y="8"/>
                  </a:lnTo>
                  <a:lnTo>
                    <a:pt x="1238" y="6"/>
                  </a:lnTo>
                  <a:lnTo>
                    <a:pt x="1239" y="6"/>
                  </a:lnTo>
                  <a:lnTo>
                    <a:pt x="1239" y="7"/>
                  </a:lnTo>
                  <a:lnTo>
                    <a:pt x="1240" y="6"/>
                  </a:lnTo>
                  <a:lnTo>
                    <a:pt x="1241" y="5"/>
                  </a:lnTo>
                  <a:lnTo>
                    <a:pt x="1242" y="7"/>
                  </a:lnTo>
                  <a:lnTo>
                    <a:pt x="1243" y="5"/>
                  </a:lnTo>
                  <a:lnTo>
                    <a:pt x="1244" y="7"/>
                  </a:lnTo>
                  <a:lnTo>
                    <a:pt x="1245" y="7"/>
                  </a:lnTo>
                  <a:lnTo>
                    <a:pt x="1246" y="8"/>
                  </a:lnTo>
                  <a:lnTo>
                    <a:pt x="1246" y="8"/>
                  </a:lnTo>
                  <a:lnTo>
                    <a:pt x="1247" y="7"/>
                  </a:lnTo>
                  <a:lnTo>
                    <a:pt x="1248" y="4"/>
                  </a:lnTo>
                  <a:lnTo>
                    <a:pt x="1249" y="6"/>
                  </a:lnTo>
                  <a:lnTo>
                    <a:pt x="1250" y="5"/>
                  </a:lnTo>
                  <a:lnTo>
                    <a:pt x="1251" y="5"/>
                  </a:lnTo>
                  <a:lnTo>
                    <a:pt x="1252" y="5"/>
                  </a:lnTo>
                  <a:lnTo>
                    <a:pt x="1253" y="6"/>
                  </a:lnTo>
                  <a:lnTo>
                    <a:pt x="1254" y="6"/>
                  </a:lnTo>
                  <a:lnTo>
                    <a:pt x="1254" y="2"/>
                  </a:lnTo>
                  <a:lnTo>
                    <a:pt x="1255" y="5"/>
                  </a:lnTo>
                  <a:lnTo>
                    <a:pt x="1256" y="5"/>
                  </a:lnTo>
                  <a:lnTo>
                    <a:pt x="1257" y="4"/>
                  </a:lnTo>
                  <a:lnTo>
                    <a:pt x="1258" y="6"/>
                  </a:lnTo>
                  <a:lnTo>
                    <a:pt x="1259" y="7"/>
                  </a:lnTo>
                  <a:lnTo>
                    <a:pt x="1260" y="4"/>
                  </a:lnTo>
                  <a:lnTo>
                    <a:pt x="1261" y="3"/>
                  </a:lnTo>
                  <a:lnTo>
                    <a:pt x="1261" y="5"/>
                  </a:lnTo>
                  <a:lnTo>
                    <a:pt x="1262" y="8"/>
                  </a:lnTo>
                  <a:lnTo>
                    <a:pt x="1263" y="4"/>
                  </a:lnTo>
                  <a:lnTo>
                    <a:pt x="1264" y="3"/>
                  </a:lnTo>
                  <a:lnTo>
                    <a:pt x="1265" y="2"/>
                  </a:lnTo>
                  <a:lnTo>
                    <a:pt x="1266" y="5"/>
                  </a:lnTo>
                  <a:lnTo>
                    <a:pt x="1267" y="5"/>
                  </a:lnTo>
                  <a:lnTo>
                    <a:pt x="1268" y="3"/>
                  </a:lnTo>
                  <a:lnTo>
                    <a:pt x="1269" y="4"/>
                  </a:lnTo>
                  <a:lnTo>
                    <a:pt x="1269" y="4"/>
                  </a:lnTo>
                  <a:lnTo>
                    <a:pt x="1270" y="5"/>
                  </a:lnTo>
                  <a:lnTo>
                    <a:pt x="1271" y="5"/>
                  </a:lnTo>
                  <a:lnTo>
                    <a:pt x="1272" y="6"/>
                  </a:lnTo>
                  <a:lnTo>
                    <a:pt x="1273" y="3"/>
                  </a:lnTo>
                  <a:lnTo>
                    <a:pt x="1274" y="3"/>
                  </a:lnTo>
                  <a:lnTo>
                    <a:pt x="1275" y="5"/>
                  </a:lnTo>
                  <a:lnTo>
                    <a:pt x="1276" y="5"/>
                  </a:lnTo>
                  <a:lnTo>
                    <a:pt x="1276" y="2"/>
                  </a:lnTo>
                  <a:lnTo>
                    <a:pt x="1277" y="3"/>
                  </a:lnTo>
                  <a:lnTo>
                    <a:pt x="1278" y="3"/>
                  </a:lnTo>
                  <a:lnTo>
                    <a:pt x="1279" y="3"/>
                  </a:lnTo>
                  <a:lnTo>
                    <a:pt x="1280" y="1"/>
                  </a:lnTo>
                  <a:lnTo>
                    <a:pt x="1281" y="5"/>
                  </a:lnTo>
                  <a:lnTo>
                    <a:pt x="1282" y="3"/>
                  </a:lnTo>
                  <a:lnTo>
                    <a:pt x="1283" y="3"/>
                  </a:lnTo>
                  <a:lnTo>
                    <a:pt x="1284" y="7"/>
                  </a:lnTo>
                  <a:lnTo>
                    <a:pt x="1284" y="2"/>
                  </a:lnTo>
                  <a:lnTo>
                    <a:pt x="1285" y="4"/>
                  </a:lnTo>
                  <a:lnTo>
                    <a:pt x="1286" y="4"/>
                  </a:lnTo>
                  <a:lnTo>
                    <a:pt x="1287" y="3"/>
                  </a:lnTo>
                  <a:lnTo>
                    <a:pt x="1288" y="3"/>
                  </a:lnTo>
                  <a:lnTo>
                    <a:pt x="1289" y="5"/>
                  </a:lnTo>
                  <a:lnTo>
                    <a:pt x="1290" y="4"/>
                  </a:lnTo>
                  <a:lnTo>
                    <a:pt x="1291" y="4"/>
                  </a:lnTo>
                  <a:lnTo>
                    <a:pt x="1291" y="2"/>
                  </a:lnTo>
                  <a:lnTo>
                    <a:pt x="1292" y="3"/>
                  </a:lnTo>
                  <a:lnTo>
                    <a:pt x="1293" y="4"/>
                  </a:lnTo>
                  <a:lnTo>
                    <a:pt x="1294" y="3"/>
                  </a:lnTo>
                  <a:lnTo>
                    <a:pt x="1295" y="3"/>
                  </a:lnTo>
                  <a:lnTo>
                    <a:pt x="1296" y="1"/>
                  </a:lnTo>
                  <a:lnTo>
                    <a:pt x="1297" y="2"/>
                  </a:lnTo>
                  <a:lnTo>
                    <a:pt x="1298" y="4"/>
                  </a:lnTo>
                  <a:lnTo>
                    <a:pt x="1298" y="2"/>
                  </a:lnTo>
                  <a:lnTo>
                    <a:pt x="1299" y="4"/>
                  </a:lnTo>
                  <a:lnTo>
                    <a:pt x="1300" y="3"/>
                  </a:lnTo>
                  <a:lnTo>
                    <a:pt x="1301" y="3"/>
                  </a:lnTo>
                  <a:lnTo>
                    <a:pt x="1302" y="4"/>
                  </a:lnTo>
                  <a:lnTo>
                    <a:pt x="1303" y="3"/>
                  </a:lnTo>
                  <a:lnTo>
                    <a:pt x="1304" y="4"/>
                  </a:lnTo>
                  <a:lnTo>
                    <a:pt x="1305" y="1"/>
                  </a:lnTo>
                  <a:lnTo>
                    <a:pt x="1306" y="4"/>
                  </a:lnTo>
                  <a:lnTo>
                    <a:pt x="1306" y="5"/>
                  </a:lnTo>
                  <a:lnTo>
                    <a:pt x="1307" y="5"/>
                  </a:lnTo>
                  <a:lnTo>
                    <a:pt x="1308" y="5"/>
                  </a:lnTo>
                  <a:lnTo>
                    <a:pt x="1309" y="4"/>
                  </a:lnTo>
                  <a:lnTo>
                    <a:pt x="1310" y="5"/>
                  </a:lnTo>
                  <a:lnTo>
                    <a:pt x="1311" y="4"/>
                  </a:lnTo>
                  <a:lnTo>
                    <a:pt x="1312" y="6"/>
                  </a:lnTo>
                  <a:lnTo>
                    <a:pt x="1313" y="4"/>
                  </a:lnTo>
                  <a:lnTo>
                    <a:pt x="1313" y="6"/>
                  </a:lnTo>
                  <a:lnTo>
                    <a:pt x="1314" y="4"/>
                  </a:lnTo>
                  <a:lnTo>
                    <a:pt x="1315" y="6"/>
                  </a:lnTo>
                  <a:lnTo>
                    <a:pt x="1316" y="5"/>
                  </a:lnTo>
                  <a:lnTo>
                    <a:pt x="1317" y="3"/>
                  </a:lnTo>
                  <a:lnTo>
                    <a:pt x="1318" y="4"/>
                  </a:lnTo>
                  <a:lnTo>
                    <a:pt x="1319" y="5"/>
                  </a:lnTo>
                  <a:lnTo>
                    <a:pt x="1320" y="6"/>
                  </a:lnTo>
                  <a:lnTo>
                    <a:pt x="1321" y="5"/>
                  </a:lnTo>
                  <a:lnTo>
                    <a:pt x="1321" y="5"/>
                  </a:lnTo>
                  <a:lnTo>
                    <a:pt x="1322" y="5"/>
                  </a:lnTo>
                  <a:lnTo>
                    <a:pt x="1323" y="4"/>
                  </a:lnTo>
                  <a:lnTo>
                    <a:pt x="1324" y="6"/>
                  </a:lnTo>
                  <a:lnTo>
                    <a:pt x="1325" y="6"/>
                  </a:lnTo>
                  <a:lnTo>
                    <a:pt x="1326" y="3"/>
                  </a:lnTo>
                  <a:lnTo>
                    <a:pt x="1327" y="6"/>
                  </a:lnTo>
                  <a:lnTo>
                    <a:pt x="1328" y="5"/>
                  </a:lnTo>
                  <a:lnTo>
                    <a:pt x="1328" y="6"/>
                  </a:lnTo>
                  <a:lnTo>
                    <a:pt x="1329" y="5"/>
                  </a:lnTo>
                  <a:lnTo>
                    <a:pt x="1330" y="5"/>
                  </a:lnTo>
                  <a:lnTo>
                    <a:pt x="1331" y="5"/>
                  </a:lnTo>
                  <a:lnTo>
                    <a:pt x="1332" y="5"/>
                  </a:lnTo>
                  <a:lnTo>
                    <a:pt x="1333" y="7"/>
                  </a:lnTo>
                  <a:lnTo>
                    <a:pt x="1334" y="5"/>
                  </a:lnTo>
                  <a:lnTo>
                    <a:pt x="1335" y="4"/>
                  </a:lnTo>
                  <a:lnTo>
                    <a:pt x="1336" y="5"/>
                  </a:lnTo>
                  <a:lnTo>
                    <a:pt x="1336" y="3"/>
                  </a:lnTo>
                  <a:lnTo>
                    <a:pt x="1337" y="6"/>
                  </a:lnTo>
                  <a:lnTo>
                    <a:pt x="1338" y="4"/>
                  </a:lnTo>
                  <a:lnTo>
                    <a:pt x="1339" y="5"/>
                  </a:lnTo>
                  <a:lnTo>
                    <a:pt x="1340" y="6"/>
                  </a:lnTo>
                  <a:lnTo>
                    <a:pt x="1341" y="6"/>
                  </a:lnTo>
                  <a:lnTo>
                    <a:pt x="1342" y="3"/>
                  </a:lnTo>
                  <a:lnTo>
                    <a:pt x="1343" y="3"/>
                  </a:lnTo>
                  <a:lnTo>
                    <a:pt x="1343" y="5"/>
                  </a:lnTo>
                  <a:lnTo>
                    <a:pt x="1344" y="7"/>
                  </a:lnTo>
                  <a:lnTo>
                    <a:pt x="1345" y="5"/>
                  </a:lnTo>
                  <a:lnTo>
                    <a:pt x="1346" y="4"/>
                  </a:lnTo>
                  <a:lnTo>
                    <a:pt x="1347" y="5"/>
                  </a:lnTo>
                  <a:lnTo>
                    <a:pt x="1348" y="4"/>
                  </a:lnTo>
                  <a:lnTo>
                    <a:pt x="1349" y="4"/>
                  </a:lnTo>
                  <a:lnTo>
                    <a:pt x="1350" y="5"/>
                  </a:lnTo>
                  <a:lnTo>
                    <a:pt x="1351" y="5"/>
                  </a:lnTo>
                  <a:lnTo>
                    <a:pt x="1351" y="5"/>
                  </a:lnTo>
                  <a:lnTo>
                    <a:pt x="1352" y="6"/>
                  </a:lnTo>
                  <a:lnTo>
                    <a:pt x="1353" y="5"/>
                  </a:lnTo>
                  <a:lnTo>
                    <a:pt x="1354" y="4"/>
                  </a:lnTo>
                  <a:lnTo>
                    <a:pt x="1355" y="4"/>
                  </a:lnTo>
                  <a:lnTo>
                    <a:pt x="1356" y="6"/>
                  </a:lnTo>
                  <a:lnTo>
                    <a:pt x="1357" y="5"/>
                  </a:lnTo>
                  <a:lnTo>
                    <a:pt x="1358" y="4"/>
                  </a:lnTo>
                  <a:lnTo>
                    <a:pt x="1358" y="4"/>
                  </a:lnTo>
                  <a:lnTo>
                    <a:pt x="1359" y="7"/>
                  </a:lnTo>
                  <a:lnTo>
                    <a:pt x="1360" y="5"/>
                  </a:lnTo>
                  <a:lnTo>
                    <a:pt x="1361" y="6"/>
                  </a:lnTo>
                  <a:lnTo>
                    <a:pt x="1362" y="7"/>
                  </a:lnTo>
                  <a:lnTo>
                    <a:pt x="1363" y="9"/>
                  </a:lnTo>
                  <a:lnTo>
                    <a:pt x="1364" y="8"/>
                  </a:lnTo>
                  <a:lnTo>
                    <a:pt x="1365" y="10"/>
                  </a:lnTo>
                  <a:lnTo>
                    <a:pt x="1366" y="13"/>
                  </a:lnTo>
                  <a:lnTo>
                    <a:pt x="1366" y="14"/>
                  </a:lnTo>
                  <a:lnTo>
                    <a:pt x="1367" y="15"/>
                  </a:lnTo>
                  <a:lnTo>
                    <a:pt x="1368" y="9"/>
                  </a:lnTo>
                  <a:lnTo>
                    <a:pt x="1369" y="10"/>
                  </a:lnTo>
                  <a:lnTo>
                    <a:pt x="1370" y="11"/>
                  </a:lnTo>
                  <a:lnTo>
                    <a:pt x="1371" y="12"/>
                  </a:lnTo>
                  <a:lnTo>
                    <a:pt x="1372" y="12"/>
                  </a:lnTo>
                  <a:lnTo>
                    <a:pt x="1373" y="13"/>
                  </a:lnTo>
                  <a:lnTo>
                    <a:pt x="1373" y="9"/>
                  </a:lnTo>
                  <a:lnTo>
                    <a:pt x="1374" y="10"/>
                  </a:lnTo>
                  <a:lnTo>
                    <a:pt x="1375" y="14"/>
                  </a:lnTo>
                  <a:lnTo>
                    <a:pt x="1376" y="9"/>
                  </a:lnTo>
                  <a:lnTo>
                    <a:pt x="1377" y="8"/>
                  </a:lnTo>
                  <a:lnTo>
                    <a:pt x="1378" y="6"/>
                  </a:lnTo>
                  <a:lnTo>
                    <a:pt x="1379" y="13"/>
                  </a:lnTo>
                  <a:lnTo>
                    <a:pt x="1380" y="7"/>
                  </a:lnTo>
                  <a:lnTo>
                    <a:pt x="1381" y="11"/>
                  </a:lnTo>
                  <a:lnTo>
                    <a:pt x="1381" y="14"/>
                  </a:lnTo>
                  <a:lnTo>
                    <a:pt x="1382" y="16"/>
                  </a:lnTo>
                  <a:lnTo>
                    <a:pt x="1383" y="21"/>
                  </a:lnTo>
                  <a:lnTo>
                    <a:pt x="1384" y="24"/>
                  </a:lnTo>
                  <a:lnTo>
                    <a:pt x="1385" y="30"/>
                  </a:lnTo>
                  <a:lnTo>
                    <a:pt x="1386" y="34"/>
                  </a:lnTo>
                  <a:lnTo>
                    <a:pt x="1387" y="36"/>
                  </a:lnTo>
                  <a:lnTo>
                    <a:pt x="1388" y="38"/>
                  </a:lnTo>
                  <a:lnTo>
                    <a:pt x="1388" y="42"/>
                  </a:lnTo>
                  <a:lnTo>
                    <a:pt x="1389" y="42"/>
                  </a:lnTo>
                  <a:lnTo>
                    <a:pt x="1390" y="43"/>
                  </a:lnTo>
                  <a:lnTo>
                    <a:pt x="1391" y="39"/>
                  </a:lnTo>
                  <a:lnTo>
                    <a:pt x="1392" y="39"/>
                  </a:lnTo>
                  <a:lnTo>
                    <a:pt x="1393" y="35"/>
                  </a:lnTo>
                  <a:lnTo>
                    <a:pt x="1394" y="35"/>
                  </a:lnTo>
                  <a:lnTo>
                    <a:pt x="1395" y="29"/>
                  </a:lnTo>
                  <a:lnTo>
                    <a:pt x="1396" y="31"/>
                  </a:lnTo>
                  <a:lnTo>
                    <a:pt x="1396" y="29"/>
                  </a:lnTo>
                  <a:lnTo>
                    <a:pt x="1397" y="26"/>
                  </a:lnTo>
                  <a:lnTo>
                    <a:pt x="1398" y="27"/>
                  </a:lnTo>
                  <a:lnTo>
                    <a:pt x="1399" y="27"/>
                  </a:lnTo>
                  <a:lnTo>
                    <a:pt x="1400" y="22"/>
                  </a:lnTo>
                  <a:lnTo>
                    <a:pt x="1401" y="25"/>
                  </a:lnTo>
                  <a:lnTo>
                    <a:pt x="1402" y="23"/>
                  </a:lnTo>
                  <a:lnTo>
                    <a:pt x="1403" y="25"/>
                  </a:lnTo>
                  <a:lnTo>
                    <a:pt x="1403" y="19"/>
                  </a:lnTo>
                  <a:lnTo>
                    <a:pt x="1404" y="21"/>
                  </a:lnTo>
                  <a:lnTo>
                    <a:pt x="1405" y="17"/>
                  </a:lnTo>
                  <a:lnTo>
                    <a:pt x="1406" y="21"/>
                  </a:lnTo>
                  <a:lnTo>
                    <a:pt x="1407" y="19"/>
                  </a:lnTo>
                  <a:lnTo>
                    <a:pt x="1408" y="16"/>
                  </a:lnTo>
                  <a:lnTo>
                    <a:pt x="1409" y="14"/>
                  </a:lnTo>
                  <a:lnTo>
                    <a:pt x="1410" y="13"/>
                  </a:lnTo>
                  <a:lnTo>
                    <a:pt x="1411" y="12"/>
                  </a:lnTo>
                  <a:lnTo>
                    <a:pt x="1411" y="12"/>
                  </a:lnTo>
                  <a:lnTo>
                    <a:pt x="1412" y="13"/>
                  </a:lnTo>
                  <a:lnTo>
                    <a:pt x="1413" y="12"/>
                  </a:lnTo>
                  <a:lnTo>
                    <a:pt x="1414" y="14"/>
                  </a:lnTo>
                  <a:lnTo>
                    <a:pt x="1415" y="10"/>
                  </a:lnTo>
                  <a:lnTo>
                    <a:pt x="1416" y="14"/>
                  </a:lnTo>
                  <a:lnTo>
                    <a:pt x="1417" y="11"/>
                  </a:lnTo>
                  <a:lnTo>
                    <a:pt x="1418" y="13"/>
                  </a:lnTo>
                  <a:lnTo>
                    <a:pt x="1418" y="14"/>
                  </a:lnTo>
                  <a:lnTo>
                    <a:pt x="1419" y="13"/>
                  </a:lnTo>
                  <a:lnTo>
                    <a:pt x="1420" y="17"/>
                  </a:lnTo>
                  <a:lnTo>
                    <a:pt x="1421" y="15"/>
                  </a:lnTo>
                  <a:lnTo>
                    <a:pt x="1422" y="17"/>
                  </a:lnTo>
                  <a:lnTo>
                    <a:pt x="1423" y="15"/>
                  </a:lnTo>
                  <a:lnTo>
                    <a:pt x="1424" y="13"/>
                  </a:lnTo>
                  <a:lnTo>
                    <a:pt x="1425" y="15"/>
                  </a:lnTo>
                  <a:lnTo>
                    <a:pt x="1426" y="14"/>
                  </a:lnTo>
                  <a:lnTo>
                    <a:pt x="1426" y="12"/>
                  </a:lnTo>
                  <a:lnTo>
                    <a:pt x="1427" y="14"/>
                  </a:lnTo>
                  <a:lnTo>
                    <a:pt x="1428" y="12"/>
                  </a:lnTo>
                  <a:lnTo>
                    <a:pt x="1429" y="9"/>
                  </a:lnTo>
                  <a:lnTo>
                    <a:pt x="1430" y="9"/>
                  </a:lnTo>
                  <a:lnTo>
                    <a:pt x="1431" y="13"/>
                  </a:lnTo>
                  <a:lnTo>
                    <a:pt x="1432" y="12"/>
                  </a:lnTo>
                  <a:lnTo>
                    <a:pt x="1433" y="12"/>
                  </a:lnTo>
                  <a:lnTo>
                    <a:pt x="1433" y="10"/>
                  </a:lnTo>
                  <a:lnTo>
                    <a:pt x="1434" y="9"/>
                  </a:lnTo>
                  <a:lnTo>
                    <a:pt x="1435" y="9"/>
                  </a:lnTo>
                  <a:lnTo>
                    <a:pt x="1436" y="9"/>
                  </a:lnTo>
                  <a:lnTo>
                    <a:pt x="1437" y="10"/>
                  </a:lnTo>
                  <a:lnTo>
                    <a:pt x="1438" y="10"/>
                  </a:lnTo>
                  <a:lnTo>
                    <a:pt x="1439" y="8"/>
                  </a:lnTo>
                  <a:lnTo>
                    <a:pt x="1440" y="10"/>
                  </a:lnTo>
                  <a:lnTo>
                    <a:pt x="1441" y="6"/>
                  </a:lnTo>
                  <a:lnTo>
                    <a:pt x="1441" y="7"/>
                  </a:lnTo>
                  <a:lnTo>
                    <a:pt x="1442" y="10"/>
                  </a:lnTo>
                  <a:lnTo>
                    <a:pt x="1443" y="5"/>
                  </a:lnTo>
                  <a:lnTo>
                    <a:pt x="1444" y="6"/>
                  </a:lnTo>
                  <a:lnTo>
                    <a:pt x="1445" y="10"/>
                  </a:lnTo>
                  <a:lnTo>
                    <a:pt x="1446" y="5"/>
                  </a:lnTo>
                  <a:lnTo>
                    <a:pt x="1447" y="8"/>
                  </a:lnTo>
                  <a:lnTo>
                    <a:pt x="1448" y="7"/>
                  </a:lnTo>
                  <a:lnTo>
                    <a:pt x="1448" y="8"/>
                  </a:lnTo>
                  <a:lnTo>
                    <a:pt x="1449" y="8"/>
                  </a:lnTo>
                  <a:lnTo>
                    <a:pt x="1450" y="10"/>
                  </a:lnTo>
                  <a:lnTo>
                    <a:pt x="1451" y="14"/>
                  </a:lnTo>
                  <a:lnTo>
                    <a:pt x="1452" y="16"/>
                  </a:lnTo>
                  <a:lnTo>
                    <a:pt x="1453" y="25"/>
                  </a:lnTo>
                  <a:lnTo>
                    <a:pt x="1454" y="27"/>
                  </a:lnTo>
                  <a:lnTo>
                    <a:pt x="1455" y="41"/>
                  </a:lnTo>
                  <a:lnTo>
                    <a:pt x="1456" y="43"/>
                  </a:lnTo>
                  <a:lnTo>
                    <a:pt x="1456" y="49"/>
                  </a:lnTo>
                  <a:lnTo>
                    <a:pt x="1457" y="52"/>
                  </a:lnTo>
                  <a:lnTo>
                    <a:pt x="1458" y="56"/>
                  </a:lnTo>
                  <a:lnTo>
                    <a:pt x="1459" y="59"/>
                  </a:lnTo>
                  <a:lnTo>
                    <a:pt x="1460" y="56"/>
                  </a:lnTo>
                  <a:lnTo>
                    <a:pt x="1461" y="52"/>
                  </a:lnTo>
                  <a:lnTo>
                    <a:pt x="1462" y="47"/>
                  </a:lnTo>
                  <a:lnTo>
                    <a:pt x="1463" y="38"/>
                  </a:lnTo>
                  <a:lnTo>
                    <a:pt x="1463" y="45"/>
                  </a:lnTo>
                  <a:lnTo>
                    <a:pt x="1464" y="40"/>
                  </a:lnTo>
                  <a:lnTo>
                    <a:pt x="1465" y="31"/>
                  </a:lnTo>
                  <a:lnTo>
                    <a:pt x="1466" y="29"/>
                  </a:lnTo>
                  <a:lnTo>
                    <a:pt x="1467" y="33"/>
                  </a:lnTo>
                  <a:lnTo>
                    <a:pt x="1468" y="30"/>
                  </a:lnTo>
                  <a:lnTo>
                    <a:pt x="1469" y="29"/>
                  </a:lnTo>
                  <a:lnTo>
                    <a:pt x="1470" y="23"/>
                  </a:lnTo>
                  <a:lnTo>
                    <a:pt x="1471" y="24"/>
                  </a:lnTo>
                  <a:lnTo>
                    <a:pt x="1471" y="26"/>
                  </a:lnTo>
                  <a:lnTo>
                    <a:pt x="1472" y="22"/>
                  </a:lnTo>
                  <a:lnTo>
                    <a:pt x="1473" y="20"/>
                  </a:lnTo>
                  <a:lnTo>
                    <a:pt x="1474" y="23"/>
                  </a:lnTo>
                  <a:lnTo>
                    <a:pt x="1475" y="21"/>
                  </a:lnTo>
                  <a:lnTo>
                    <a:pt x="1476" y="23"/>
                  </a:lnTo>
                  <a:lnTo>
                    <a:pt x="1477" y="18"/>
                  </a:lnTo>
                  <a:lnTo>
                    <a:pt x="1478" y="21"/>
                  </a:lnTo>
                  <a:lnTo>
                    <a:pt x="1478" y="15"/>
                  </a:lnTo>
                  <a:lnTo>
                    <a:pt x="1479" y="17"/>
                  </a:lnTo>
                  <a:lnTo>
                    <a:pt x="1480" y="16"/>
                  </a:lnTo>
                  <a:lnTo>
                    <a:pt x="1481" y="13"/>
                  </a:lnTo>
                  <a:lnTo>
                    <a:pt x="1482" y="16"/>
                  </a:lnTo>
                  <a:lnTo>
                    <a:pt x="1483" y="12"/>
                  </a:lnTo>
                  <a:lnTo>
                    <a:pt x="1484" y="10"/>
                  </a:lnTo>
                  <a:lnTo>
                    <a:pt x="1485" y="11"/>
                  </a:lnTo>
                  <a:lnTo>
                    <a:pt x="1486" y="10"/>
                  </a:lnTo>
                  <a:lnTo>
                    <a:pt x="1486" y="11"/>
                  </a:lnTo>
                  <a:lnTo>
                    <a:pt x="1487" y="12"/>
                  </a:lnTo>
                  <a:lnTo>
                    <a:pt x="1488" y="9"/>
                  </a:lnTo>
                  <a:lnTo>
                    <a:pt x="1489" y="12"/>
                  </a:lnTo>
                  <a:lnTo>
                    <a:pt x="1490" y="9"/>
                  </a:lnTo>
                  <a:lnTo>
                    <a:pt x="1491" y="12"/>
                  </a:lnTo>
                  <a:lnTo>
                    <a:pt x="1492" y="10"/>
                  </a:lnTo>
                  <a:lnTo>
                    <a:pt x="1493" y="5"/>
                  </a:lnTo>
                  <a:lnTo>
                    <a:pt x="1493" y="9"/>
                  </a:lnTo>
                  <a:lnTo>
                    <a:pt x="1494" y="4"/>
                  </a:lnTo>
                  <a:lnTo>
                    <a:pt x="1495" y="7"/>
                  </a:lnTo>
                  <a:lnTo>
                    <a:pt x="1496" y="9"/>
                  </a:lnTo>
                  <a:lnTo>
                    <a:pt x="1497" y="10"/>
                  </a:lnTo>
                  <a:lnTo>
                    <a:pt x="1498" y="9"/>
                  </a:lnTo>
                  <a:lnTo>
                    <a:pt x="1499" y="10"/>
                  </a:lnTo>
                  <a:lnTo>
                    <a:pt x="1500" y="12"/>
                  </a:lnTo>
                  <a:lnTo>
                    <a:pt x="1500" y="10"/>
                  </a:lnTo>
                  <a:lnTo>
                    <a:pt x="1501" y="10"/>
                  </a:lnTo>
                  <a:lnTo>
                    <a:pt x="1502" y="12"/>
                  </a:lnTo>
                  <a:lnTo>
                    <a:pt x="1503" y="9"/>
                  </a:lnTo>
                  <a:lnTo>
                    <a:pt x="1504" y="10"/>
                  </a:lnTo>
                  <a:lnTo>
                    <a:pt x="1505" y="9"/>
                  </a:lnTo>
                  <a:lnTo>
                    <a:pt x="1506" y="12"/>
                  </a:lnTo>
                  <a:lnTo>
                    <a:pt x="1507" y="10"/>
                  </a:lnTo>
                  <a:lnTo>
                    <a:pt x="1508" y="8"/>
                  </a:lnTo>
                  <a:lnTo>
                    <a:pt x="1508" y="5"/>
                  </a:lnTo>
                  <a:lnTo>
                    <a:pt x="1509" y="7"/>
                  </a:lnTo>
                  <a:lnTo>
                    <a:pt x="1510" y="8"/>
                  </a:lnTo>
                  <a:lnTo>
                    <a:pt x="1511" y="5"/>
                  </a:lnTo>
                  <a:lnTo>
                    <a:pt x="1512" y="5"/>
                  </a:lnTo>
                  <a:lnTo>
                    <a:pt x="1513" y="4"/>
                  </a:lnTo>
                  <a:lnTo>
                    <a:pt x="1514" y="9"/>
                  </a:lnTo>
                  <a:lnTo>
                    <a:pt x="1515" y="7"/>
                  </a:lnTo>
                  <a:lnTo>
                    <a:pt x="1515" y="8"/>
                  </a:lnTo>
                  <a:lnTo>
                    <a:pt x="1516" y="7"/>
                  </a:lnTo>
                  <a:lnTo>
                    <a:pt x="1517" y="10"/>
                  </a:lnTo>
                  <a:lnTo>
                    <a:pt x="1518" y="9"/>
                  </a:lnTo>
                  <a:lnTo>
                    <a:pt x="1519" y="9"/>
                  </a:lnTo>
                  <a:lnTo>
                    <a:pt x="1520" y="8"/>
                  </a:lnTo>
                  <a:lnTo>
                    <a:pt x="1521" y="9"/>
                  </a:lnTo>
                  <a:lnTo>
                    <a:pt x="1522" y="9"/>
                  </a:lnTo>
                  <a:lnTo>
                    <a:pt x="1523" y="10"/>
                  </a:lnTo>
                  <a:lnTo>
                    <a:pt x="1523" y="6"/>
                  </a:lnTo>
                  <a:lnTo>
                    <a:pt x="1524" y="10"/>
                  </a:lnTo>
                  <a:lnTo>
                    <a:pt x="1525" y="9"/>
                  </a:lnTo>
                  <a:lnTo>
                    <a:pt x="1526" y="9"/>
                  </a:lnTo>
                  <a:lnTo>
                    <a:pt x="1527" y="9"/>
                  </a:lnTo>
                  <a:lnTo>
                    <a:pt x="1528" y="9"/>
                  </a:lnTo>
                  <a:lnTo>
                    <a:pt x="1529" y="7"/>
                  </a:lnTo>
                  <a:lnTo>
                    <a:pt x="1530" y="8"/>
                  </a:lnTo>
                  <a:lnTo>
                    <a:pt x="1530" y="9"/>
                  </a:lnTo>
                  <a:lnTo>
                    <a:pt x="1531" y="9"/>
                  </a:lnTo>
                  <a:lnTo>
                    <a:pt x="1532" y="9"/>
                  </a:lnTo>
                  <a:lnTo>
                    <a:pt x="1533" y="8"/>
                  </a:lnTo>
                  <a:lnTo>
                    <a:pt x="1534" y="10"/>
                  </a:lnTo>
                  <a:lnTo>
                    <a:pt x="1535" y="10"/>
                  </a:lnTo>
                  <a:lnTo>
                    <a:pt x="1536" y="7"/>
                  </a:lnTo>
                  <a:lnTo>
                    <a:pt x="1537" y="8"/>
                  </a:lnTo>
                  <a:lnTo>
                    <a:pt x="1538" y="9"/>
                  </a:lnTo>
                  <a:lnTo>
                    <a:pt x="1538" y="10"/>
                  </a:lnTo>
                  <a:lnTo>
                    <a:pt x="1539" y="8"/>
                  </a:lnTo>
                  <a:lnTo>
                    <a:pt x="1540" y="7"/>
                  </a:lnTo>
                  <a:lnTo>
                    <a:pt x="1541" y="9"/>
                  </a:lnTo>
                  <a:lnTo>
                    <a:pt x="1542" y="9"/>
                  </a:lnTo>
                  <a:lnTo>
                    <a:pt x="1543" y="8"/>
                  </a:lnTo>
                  <a:lnTo>
                    <a:pt x="1544" y="8"/>
                  </a:lnTo>
                  <a:lnTo>
                    <a:pt x="1545" y="9"/>
                  </a:lnTo>
                  <a:lnTo>
                    <a:pt x="1545" y="5"/>
                  </a:lnTo>
                  <a:lnTo>
                    <a:pt x="1546" y="9"/>
                  </a:lnTo>
                  <a:lnTo>
                    <a:pt x="1547" y="9"/>
                  </a:lnTo>
                  <a:lnTo>
                    <a:pt x="1548" y="7"/>
                  </a:lnTo>
                  <a:lnTo>
                    <a:pt x="1549" y="9"/>
                  </a:lnTo>
                  <a:lnTo>
                    <a:pt x="1550" y="9"/>
                  </a:lnTo>
                  <a:lnTo>
                    <a:pt x="1551" y="10"/>
                  </a:lnTo>
                  <a:lnTo>
                    <a:pt x="1552" y="10"/>
                  </a:lnTo>
                  <a:lnTo>
                    <a:pt x="1553" y="11"/>
                  </a:lnTo>
                  <a:lnTo>
                    <a:pt x="1553" y="8"/>
                  </a:lnTo>
                  <a:lnTo>
                    <a:pt x="1554" y="8"/>
                  </a:lnTo>
                  <a:lnTo>
                    <a:pt x="1555" y="9"/>
                  </a:lnTo>
                  <a:lnTo>
                    <a:pt x="1556" y="7"/>
                  </a:lnTo>
                  <a:lnTo>
                    <a:pt x="1557" y="6"/>
                  </a:lnTo>
                  <a:lnTo>
                    <a:pt x="1558" y="8"/>
                  </a:lnTo>
                  <a:lnTo>
                    <a:pt x="1559" y="7"/>
                  </a:lnTo>
                  <a:lnTo>
                    <a:pt x="1560" y="9"/>
                  </a:lnTo>
                  <a:lnTo>
                    <a:pt x="1560" y="8"/>
                  </a:lnTo>
                  <a:lnTo>
                    <a:pt x="1561" y="8"/>
                  </a:lnTo>
                  <a:lnTo>
                    <a:pt x="1562" y="9"/>
                  </a:lnTo>
                  <a:lnTo>
                    <a:pt x="1563" y="9"/>
                  </a:lnTo>
                  <a:lnTo>
                    <a:pt x="1564" y="8"/>
                  </a:lnTo>
                  <a:lnTo>
                    <a:pt x="1565" y="9"/>
                  </a:lnTo>
                  <a:lnTo>
                    <a:pt x="1566" y="8"/>
                  </a:lnTo>
                  <a:lnTo>
                    <a:pt x="1567" y="6"/>
                  </a:lnTo>
                  <a:lnTo>
                    <a:pt x="1568" y="5"/>
                  </a:lnTo>
                  <a:lnTo>
                    <a:pt x="1568" y="7"/>
                  </a:lnTo>
                  <a:lnTo>
                    <a:pt x="1569" y="8"/>
                  </a:lnTo>
                  <a:lnTo>
                    <a:pt x="1570" y="7"/>
                  </a:lnTo>
                  <a:lnTo>
                    <a:pt x="1571" y="4"/>
                  </a:lnTo>
                  <a:lnTo>
                    <a:pt x="1572" y="7"/>
                  </a:lnTo>
                  <a:lnTo>
                    <a:pt x="1573" y="5"/>
                  </a:lnTo>
                  <a:lnTo>
                    <a:pt x="1574" y="5"/>
                  </a:lnTo>
                  <a:lnTo>
                    <a:pt x="1575" y="4"/>
                  </a:lnTo>
                  <a:lnTo>
                    <a:pt x="1575" y="6"/>
                  </a:lnTo>
                  <a:lnTo>
                    <a:pt x="1576" y="6"/>
                  </a:lnTo>
                  <a:lnTo>
                    <a:pt x="1577" y="5"/>
                  </a:lnTo>
                  <a:lnTo>
                    <a:pt x="1578" y="6"/>
                  </a:lnTo>
                  <a:lnTo>
                    <a:pt x="1579" y="3"/>
                  </a:lnTo>
                  <a:lnTo>
                    <a:pt x="1580" y="8"/>
                  </a:lnTo>
                  <a:lnTo>
                    <a:pt x="1581" y="5"/>
                  </a:lnTo>
                  <a:lnTo>
                    <a:pt x="1582" y="7"/>
                  </a:lnTo>
                  <a:lnTo>
                    <a:pt x="1583" y="4"/>
                  </a:lnTo>
                  <a:lnTo>
                    <a:pt x="1583" y="7"/>
                  </a:lnTo>
                  <a:lnTo>
                    <a:pt x="1584" y="5"/>
                  </a:lnTo>
                  <a:lnTo>
                    <a:pt x="1585" y="4"/>
                  </a:lnTo>
                  <a:lnTo>
                    <a:pt x="1586" y="6"/>
                  </a:lnTo>
                  <a:lnTo>
                    <a:pt x="1587" y="6"/>
                  </a:lnTo>
                  <a:lnTo>
                    <a:pt x="1588" y="6"/>
                  </a:lnTo>
                  <a:lnTo>
                    <a:pt x="1589" y="7"/>
                  </a:lnTo>
                  <a:lnTo>
                    <a:pt x="1590" y="2"/>
                  </a:lnTo>
                  <a:lnTo>
                    <a:pt x="1590" y="5"/>
                  </a:lnTo>
                  <a:lnTo>
                    <a:pt x="1591" y="4"/>
                  </a:lnTo>
                  <a:lnTo>
                    <a:pt x="1592" y="4"/>
                  </a:lnTo>
                  <a:lnTo>
                    <a:pt x="1593" y="4"/>
                  </a:lnTo>
                  <a:lnTo>
                    <a:pt x="1594" y="5"/>
                  </a:lnTo>
                  <a:lnTo>
                    <a:pt x="1595" y="4"/>
                  </a:lnTo>
                  <a:lnTo>
                    <a:pt x="1596" y="5"/>
                  </a:lnTo>
                  <a:lnTo>
                    <a:pt x="1597" y="5"/>
                  </a:lnTo>
                  <a:lnTo>
                    <a:pt x="1598" y="5"/>
                  </a:lnTo>
                  <a:lnTo>
                    <a:pt x="1598" y="6"/>
                  </a:lnTo>
                  <a:lnTo>
                    <a:pt x="1599" y="5"/>
                  </a:lnTo>
                  <a:lnTo>
                    <a:pt x="1600" y="6"/>
                  </a:lnTo>
                  <a:lnTo>
                    <a:pt x="1601" y="5"/>
                  </a:lnTo>
                  <a:lnTo>
                    <a:pt x="1602" y="7"/>
                  </a:lnTo>
                  <a:lnTo>
                    <a:pt x="1603" y="6"/>
                  </a:lnTo>
                  <a:lnTo>
                    <a:pt x="1604" y="5"/>
                  </a:lnTo>
                  <a:lnTo>
                    <a:pt x="1605" y="5"/>
                  </a:lnTo>
                  <a:lnTo>
                    <a:pt x="1605" y="6"/>
                  </a:lnTo>
                  <a:lnTo>
                    <a:pt x="1606" y="5"/>
                  </a:lnTo>
                  <a:lnTo>
                    <a:pt x="1607" y="6"/>
                  </a:lnTo>
                  <a:lnTo>
                    <a:pt x="1608" y="6"/>
                  </a:lnTo>
                  <a:lnTo>
                    <a:pt x="1609" y="7"/>
                  </a:lnTo>
                  <a:lnTo>
                    <a:pt x="1610" y="6"/>
                  </a:lnTo>
                  <a:lnTo>
                    <a:pt x="1611" y="6"/>
                  </a:lnTo>
                  <a:lnTo>
                    <a:pt x="1612" y="5"/>
                  </a:lnTo>
                  <a:lnTo>
                    <a:pt x="1613" y="4"/>
                  </a:lnTo>
                  <a:lnTo>
                    <a:pt x="1613" y="3"/>
                  </a:lnTo>
                  <a:lnTo>
                    <a:pt x="1614" y="4"/>
                  </a:lnTo>
                  <a:lnTo>
                    <a:pt x="1615" y="3"/>
                  </a:lnTo>
                  <a:lnTo>
                    <a:pt x="1616" y="4"/>
                  </a:lnTo>
                  <a:lnTo>
                    <a:pt x="1617" y="3"/>
                  </a:lnTo>
                  <a:lnTo>
                    <a:pt x="1618" y="3"/>
                  </a:lnTo>
                  <a:lnTo>
                    <a:pt x="1619" y="3"/>
                  </a:lnTo>
                  <a:lnTo>
                    <a:pt x="1620" y="3"/>
                  </a:lnTo>
                  <a:lnTo>
                    <a:pt x="1620" y="2"/>
                  </a:lnTo>
                  <a:lnTo>
                    <a:pt x="1621" y="3"/>
                  </a:lnTo>
                  <a:lnTo>
                    <a:pt x="1622" y="4"/>
                  </a:lnTo>
                  <a:lnTo>
                    <a:pt x="1623" y="2"/>
                  </a:lnTo>
                  <a:lnTo>
                    <a:pt x="1624" y="4"/>
                  </a:lnTo>
                  <a:lnTo>
                    <a:pt x="1625" y="2"/>
                  </a:lnTo>
                  <a:lnTo>
                    <a:pt x="1626" y="6"/>
                  </a:lnTo>
                  <a:lnTo>
                    <a:pt x="1627" y="5"/>
                  </a:lnTo>
                  <a:lnTo>
                    <a:pt x="1628" y="8"/>
                  </a:lnTo>
                  <a:lnTo>
                    <a:pt x="1628" y="8"/>
                  </a:lnTo>
                  <a:lnTo>
                    <a:pt x="1629" y="16"/>
                  </a:lnTo>
                  <a:lnTo>
                    <a:pt x="1630" y="21"/>
                  </a:lnTo>
                  <a:lnTo>
                    <a:pt x="1631" y="27"/>
                  </a:lnTo>
                  <a:lnTo>
                    <a:pt x="1632" y="29"/>
                  </a:lnTo>
                  <a:lnTo>
                    <a:pt x="1633" y="38"/>
                  </a:lnTo>
                  <a:lnTo>
                    <a:pt x="1634" y="50"/>
                  </a:lnTo>
                  <a:lnTo>
                    <a:pt x="1635" y="53"/>
                  </a:lnTo>
                  <a:lnTo>
                    <a:pt x="1635" y="61"/>
                  </a:lnTo>
                  <a:lnTo>
                    <a:pt x="1636" y="63"/>
                  </a:lnTo>
                  <a:lnTo>
                    <a:pt x="1637" y="63"/>
                  </a:lnTo>
                  <a:lnTo>
                    <a:pt x="1638" y="60"/>
                  </a:lnTo>
                  <a:lnTo>
                    <a:pt x="1639" y="55"/>
                  </a:lnTo>
                  <a:lnTo>
                    <a:pt x="1640" y="45"/>
                  </a:lnTo>
                  <a:lnTo>
                    <a:pt x="1641" y="41"/>
                  </a:lnTo>
                  <a:lnTo>
                    <a:pt x="1642" y="38"/>
                  </a:lnTo>
                  <a:lnTo>
                    <a:pt x="1643" y="31"/>
                  </a:lnTo>
                  <a:lnTo>
                    <a:pt x="1643" y="28"/>
                  </a:lnTo>
                  <a:lnTo>
                    <a:pt x="1644" y="26"/>
                  </a:lnTo>
                  <a:lnTo>
                    <a:pt x="1645" y="21"/>
                  </a:lnTo>
                  <a:lnTo>
                    <a:pt x="1646" y="17"/>
                  </a:lnTo>
                  <a:lnTo>
                    <a:pt x="1647" y="15"/>
                  </a:lnTo>
                  <a:lnTo>
                    <a:pt x="1648" y="17"/>
                  </a:lnTo>
                  <a:lnTo>
                    <a:pt x="1649" y="16"/>
                  </a:lnTo>
                  <a:lnTo>
                    <a:pt x="1650" y="18"/>
                  </a:lnTo>
                  <a:lnTo>
                    <a:pt x="1650" y="14"/>
                  </a:lnTo>
                  <a:lnTo>
                    <a:pt x="1651" y="12"/>
                  </a:lnTo>
                  <a:lnTo>
                    <a:pt x="1652" y="11"/>
                  </a:lnTo>
                  <a:lnTo>
                    <a:pt x="1653" y="12"/>
                  </a:lnTo>
                  <a:lnTo>
                    <a:pt x="1654" y="14"/>
                  </a:lnTo>
                  <a:lnTo>
                    <a:pt x="1655" y="11"/>
                  </a:lnTo>
                  <a:lnTo>
                    <a:pt x="1656" y="11"/>
                  </a:lnTo>
                  <a:lnTo>
                    <a:pt x="1657" y="12"/>
                  </a:lnTo>
                  <a:lnTo>
                    <a:pt x="1658" y="12"/>
                  </a:lnTo>
                  <a:lnTo>
                    <a:pt x="1658" y="10"/>
                  </a:lnTo>
                  <a:lnTo>
                    <a:pt x="1659" y="12"/>
                  </a:lnTo>
                  <a:lnTo>
                    <a:pt x="1660" y="10"/>
                  </a:lnTo>
                  <a:lnTo>
                    <a:pt x="1661" y="8"/>
                  </a:lnTo>
                  <a:lnTo>
                    <a:pt x="1662" y="9"/>
                  </a:lnTo>
                  <a:lnTo>
                    <a:pt x="1663" y="8"/>
                  </a:lnTo>
                  <a:lnTo>
                    <a:pt x="1664" y="7"/>
                  </a:lnTo>
                  <a:lnTo>
                    <a:pt x="1665" y="8"/>
                  </a:lnTo>
                  <a:lnTo>
                    <a:pt x="1665" y="5"/>
                  </a:lnTo>
                  <a:lnTo>
                    <a:pt x="1666" y="4"/>
                  </a:lnTo>
                  <a:lnTo>
                    <a:pt x="1667" y="7"/>
                  </a:lnTo>
                  <a:lnTo>
                    <a:pt x="1668" y="7"/>
                  </a:lnTo>
                  <a:lnTo>
                    <a:pt x="1669" y="7"/>
                  </a:lnTo>
                  <a:lnTo>
                    <a:pt x="1670" y="4"/>
                  </a:lnTo>
                  <a:lnTo>
                    <a:pt x="1671" y="8"/>
                  </a:lnTo>
                  <a:lnTo>
                    <a:pt x="1672" y="8"/>
                  </a:lnTo>
                  <a:lnTo>
                    <a:pt x="1673" y="8"/>
                  </a:lnTo>
                  <a:lnTo>
                    <a:pt x="1673" y="8"/>
                  </a:lnTo>
                  <a:lnTo>
                    <a:pt x="1674" y="2"/>
                  </a:lnTo>
                  <a:lnTo>
                    <a:pt x="1675" y="7"/>
                  </a:lnTo>
                  <a:lnTo>
                    <a:pt x="1676" y="6"/>
                  </a:lnTo>
                  <a:lnTo>
                    <a:pt x="1677" y="6"/>
                  </a:lnTo>
                  <a:lnTo>
                    <a:pt x="1678" y="5"/>
                  </a:lnTo>
                  <a:lnTo>
                    <a:pt x="1679" y="7"/>
                  </a:lnTo>
                  <a:lnTo>
                    <a:pt x="1680" y="6"/>
                  </a:lnTo>
                  <a:lnTo>
                    <a:pt x="1680" y="9"/>
                  </a:lnTo>
                  <a:lnTo>
                    <a:pt x="1681" y="6"/>
                  </a:lnTo>
                  <a:lnTo>
                    <a:pt x="1682" y="10"/>
                  </a:lnTo>
                  <a:lnTo>
                    <a:pt x="1683" y="11"/>
                  </a:lnTo>
                  <a:lnTo>
                    <a:pt x="1684" y="9"/>
                  </a:lnTo>
                  <a:lnTo>
                    <a:pt x="1685" y="18"/>
                  </a:lnTo>
                  <a:lnTo>
                    <a:pt x="1686" y="15"/>
                  </a:lnTo>
                  <a:lnTo>
                    <a:pt x="1687" y="19"/>
                  </a:lnTo>
                  <a:lnTo>
                    <a:pt x="1688" y="26"/>
                  </a:lnTo>
                  <a:lnTo>
                    <a:pt x="1688" y="26"/>
                  </a:lnTo>
                  <a:lnTo>
                    <a:pt x="1689" y="26"/>
                  </a:lnTo>
                  <a:lnTo>
                    <a:pt x="1690" y="26"/>
                  </a:lnTo>
                  <a:lnTo>
                    <a:pt x="1691" y="27"/>
                  </a:lnTo>
                  <a:lnTo>
                    <a:pt x="1692" y="20"/>
                  </a:lnTo>
                  <a:lnTo>
                    <a:pt x="1693" y="22"/>
                  </a:lnTo>
                  <a:lnTo>
                    <a:pt x="1694" y="19"/>
                  </a:lnTo>
                  <a:lnTo>
                    <a:pt x="1695" y="20"/>
                  </a:lnTo>
                  <a:lnTo>
                    <a:pt x="1695" y="17"/>
                  </a:lnTo>
                  <a:lnTo>
                    <a:pt x="1696" y="13"/>
                  </a:lnTo>
                  <a:lnTo>
                    <a:pt x="1697" y="12"/>
                  </a:lnTo>
                  <a:lnTo>
                    <a:pt x="1698" y="12"/>
                  </a:lnTo>
                  <a:lnTo>
                    <a:pt x="1699" y="9"/>
                  </a:lnTo>
                  <a:lnTo>
                    <a:pt x="1700" y="7"/>
                  </a:lnTo>
                  <a:lnTo>
                    <a:pt x="1701" y="8"/>
                  </a:lnTo>
                  <a:lnTo>
                    <a:pt x="1702" y="8"/>
                  </a:lnTo>
                  <a:lnTo>
                    <a:pt x="1702" y="6"/>
                  </a:lnTo>
                  <a:lnTo>
                    <a:pt x="1703" y="7"/>
                  </a:lnTo>
                  <a:lnTo>
                    <a:pt x="1704" y="5"/>
                  </a:lnTo>
                  <a:lnTo>
                    <a:pt x="1705" y="5"/>
                  </a:lnTo>
                  <a:lnTo>
                    <a:pt x="1706" y="7"/>
                  </a:lnTo>
                  <a:lnTo>
                    <a:pt x="1707" y="5"/>
                  </a:lnTo>
                  <a:lnTo>
                    <a:pt x="1708" y="6"/>
                  </a:lnTo>
                  <a:lnTo>
                    <a:pt x="1709" y="4"/>
                  </a:lnTo>
                  <a:lnTo>
                    <a:pt x="1710" y="6"/>
                  </a:lnTo>
                  <a:lnTo>
                    <a:pt x="1710" y="5"/>
                  </a:lnTo>
                  <a:lnTo>
                    <a:pt x="1711" y="7"/>
                  </a:lnTo>
                  <a:lnTo>
                    <a:pt x="1712" y="6"/>
                  </a:lnTo>
                  <a:lnTo>
                    <a:pt x="1713" y="9"/>
                  </a:lnTo>
                  <a:lnTo>
                    <a:pt x="1714" y="10"/>
                  </a:lnTo>
                  <a:lnTo>
                    <a:pt x="1715" y="13"/>
                  </a:lnTo>
                  <a:lnTo>
                    <a:pt x="1716" y="14"/>
                  </a:lnTo>
                  <a:lnTo>
                    <a:pt x="1717" y="18"/>
                  </a:lnTo>
                  <a:lnTo>
                    <a:pt x="1717" y="20"/>
                  </a:lnTo>
                  <a:lnTo>
                    <a:pt x="1718" y="21"/>
                  </a:lnTo>
                  <a:lnTo>
                    <a:pt x="1719" y="21"/>
                  </a:lnTo>
                  <a:lnTo>
                    <a:pt x="1720" y="16"/>
                  </a:lnTo>
                  <a:lnTo>
                    <a:pt x="1721" y="17"/>
                  </a:lnTo>
                  <a:lnTo>
                    <a:pt x="1722" y="16"/>
                  </a:lnTo>
                  <a:lnTo>
                    <a:pt x="1723" y="15"/>
                  </a:lnTo>
                  <a:lnTo>
                    <a:pt x="1724" y="14"/>
                  </a:lnTo>
                  <a:lnTo>
                    <a:pt x="1725" y="17"/>
                  </a:lnTo>
                  <a:lnTo>
                    <a:pt x="1725" y="9"/>
                  </a:lnTo>
                  <a:lnTo>
                    <a:pt x="1726" y="10"/>
                  </a:lnTo>
                  <a:lnTo>
                    <a:pt x="1727" y="8"/>
                  </a:lnTo>
                  <a:lnTo>
                    <a:pt x="1728" y="9"/>
                  </a:lnTo>
                  <a:lnTo>
                    <a:pt x="1729" y="10"/>
                  </a:lnTo>
                  <a:lnTo>
                    <a:pt x="1730" y="7"/>
                  </a:lnTo>
                  <a:lnTo>
                    <a:pt x="1731" y="7"/>
                  </a:lnTo>
                  <a:lnTo>
                    <a:pt x="1732" y="8"/>
                  </a:lnTo>
                  <a:lnTo>
                    <a:pt x="1732" y="5"/>
                  </a:lnTo>
                  <a:lnTo>
                    <a:pt x="1733" y="5"/>
                  </a:lnTo>
                  <a:lnTo>
                    <a:pt x="1734" y="4"/>
                  </a:lnTo>
                  <a:lnTo>
                    <a:pt x="1735" y="4"/>
                  </a:lnTo>
                  <a:lnTo>
                    <a:pt x="1736" y="7"/>
                  </a:lnTo>
                  <a:lnTo>
                    <a:pt x="1737" y="6"/>
                  </a:lnTo>
                  <a:lnTo>
                    <a:pt x="1738" y="7"/>
                  </a:lnTo>
                  <a:lnTo>
                    <a:pt x="1739" y="7"/>
                  </a:lnTo>
                  <a:lnTo>
                    <a:pt x="1740" y="7"/>
                  </a:lnTo>
                  <a:lnTo>
                    <a:pt x="1740" y="5"/>
                  </a:lnTo>
                  <a:lnTo>
                    <a:pt x="1741" y="5"/>
                  </a:lnTo>
                  <a:lnTo>
                    <a:pt x="1742" y="4"/>
                  </a:lnTo>
                  <a:lnTo>
                    <a:pt x="1743" y="5"/>
                  </a:lnTo>
                  <a:lnTo>
                    <a:pt x="1744" y="4"/>
                  </a:lnTo>
                  <a:lnTo>
                    <a:pt x="1745" y="5"/>
                  </a:lnTo>
                  <a:lnTo>
                    <a:pt x="1746" y="6"/>
                  </a:lnTo>
                  <a:lnTo>
                    <a:pt x="1747" y="2"/>
                  </a:lnTo>
                  <a:lnTo>
                    <a:pt x="1747" y="4"/>
                  </a:lnTo>
                  <a:lnTo>
                    <a:pt x="1748" y="4"/>
                  </a:lnTo>
                  <a:lnTo>
                    <a:pt x="1749" y="7"/>
                  </a:lnTo>
                  <a:lnTo>
                    <a:pt x="1750" y="4"/>
                  </a:lnTo>
                  <a:lnTo>
                    <a:pt x="1751" y="5"/>
                  </a:lnTo>
                  <a:lnTo>
                    <a:pt x="1752" y="3"/>
                  </a:lnTo>
                  <a:lnTo>
                    <a:pt x="1753" y="4"/>
                  </a:lnTo>
                  <a:lnTo>
                    <a:pt x="1754" y="7"/>
                  </a:lnTo>
                  <a:lnTo>
                    <a:pt x="1755" y="3"/>
                  </a:lnTo>
                  <a:lnTo>
                    <a:pt x="1755" y="3"/>
                  </a:lnTo>
                  <a:lnTo>
                    <a:pt x="1756" y="5"/>
                  </a:lnTo>
                  <a:lnTo>
                    <a:pt x="1757" y="4"/>
                  </a:lnTo>
                  <a:lnTo>
                    <a:pt x="1758" y="4"/>
                  </a:lnTo>
                  <a:lnTo>
                    <a:pt x="1759" y="7"/>
                  </a:lnTo>
                  <a:lnTo>
                    <a:pt x="1760" y="5"/>
                  </a:lnTo>
                  <a:lnTo>
                    <a:pt x="1761" y="6"/>
                  </a:lnTo>
                  <a:lnTo>
                    <a:pt x="1762" y="10"/>
                  </a:lnTo>
                  <a:lnTo>
                    <a:pt x="1762" y="10"/>
                  </a:lnTo>
                  <a:lnTo>
                    <a:pt x="1763" y="17"/>
                  </a:lnTo>
                  <a:lnTo>
                    <a:pt x="1764" y="16"/>
                  </a:lnTo>
                  <a:lnTo>
                    <a:pt x="1765" y="17"/>
                  </a:lnTo>
                  <a:lnTo>
                    <a:pt x="1766" y="21"/>
                  </a:lnTo>
                  <a:lnTo>
                    <a:pt x="1767" y="20"/>
                  </a:lnTo>
                  <a:lnTo>
                    <a:pt x="1768" y="24"/>
                  </a:lnTo>
                  <a:lnTo>
                    <a:pt x="1769" y="23"/>
                  </a:lnTo>
                  <a:lnTo>
                    <a:pt x="1770" y="24"/>
                  </a:lnTo>
                  <a:lnTo>
                    <a:pt x="1770" y="24"/>
                  </a:lnTo>
                  <a:lnTo>
                    <a:pt x="1771" y="20"/>
                  </a:lnTo>
                  <a:lnTo>
                    <a:pt x="1772" y="22"/>
                  </a:lnTo>
                  <a:lnTo>
                    <a:pt x="1773" y="16"/>
                  </a:lnTo>
                  <a:lnTo>
                    <a:pt x="1774" y="14"/>
                  </a:lnTo>
                  <a:lnTo>
                    <a:pt x="1775" y="13"/>
                  </a:lnTo>
                  <a:lnTo>
                    <a:pt x="1776" y="12"/>
                  </a:lnTo>
                  <a:lnTo>
                    <a:pt x="1777" y="11"/>
                  </a:lnTo>
                  <a:lnTo>
                    <a:pt x="1777" y="12"/>
                  </a:lnTo>
                  <a:lnTo>
                    <a:pt x="1778" y="10"/>
                  </a:lnTo>
                  <a:lnTo>
                    <a:pt x="1779" y="10"/>
                  </a:lnTo>
                  <a:lnTo>
                    <a:pt x="1780" y="9"/>
                  </a:lnTo>
                  <a:lnTo>
                    <a:pt x="1781" y="11"/>
                  </a:lnTo>
                  <a:lnTo>
                    <a:pt x="1782" y="11"/>
                  </a:lnTo>
                  <a:lnTo>
                    <a:pt x="1783" y="8"/>
                  </a:lnTo>
                  <a:lnTo>
                    <a:pt x="1784" y="8"/>
                  </a:lnTo>
                  <a:lnTo>
                    <a:pt x="1785" y="10"/>
                  </a:lnTo>
                  <a:lnTo>
                    <a:pt x="1785" y="11"/>
                  </a:lnTo>
                  <a:lnTo>
                    <a:pt x="1786" y="9"/>
                  </a:lnTo>
                  <a:lnTo>
                    <a:pt x="1787" y="9"/>
                  </a:lnTo>
                  <a:lnTo>
                    <a:pt x="1788" y="11"/>
                  </a:lnTo>
                  <a:lnTo>
                    <a:pt x="1789" y="10"/>
                  </a:lnTo>
                  <a:lnTo>
                    <a:pt x="1790" y="9"/>
                  </a:lnTo>
                  <a:lnTo>
                    <a:pt x="1791" y="8"/>
                  </a:lnTo>
                  <a:lnTo>
                    <a:pt x="1792" y="7"/>
                  </a:lnTo>
                  <a:lnTo>
                    <a:pt x="1792" y="5"/>
                  </a:lnTo>
                  <a:lnTo>
                    <a:pt x="1793" y="7"/>
                  </a:lnTo>
                  <a:lnTo>
                    <a:pt x="1794" y="8"/>
                  </a:lnTo>
                  <a:lnTo>
                    <a:pt x="1795" y="7"/>
                  </a:lnTo>
                  <a:lnTo>
                    <a:pt x="1796" y="7"/>
                  </a:lnTo>
                  <a:lnTo>
                    <a:pt x="1797" y="5"/>
                  </a:lnTo>
                  <a:lnTo>
                    <a:pt x="1798" y="7"/>
                  </a:lnTo>
                  <a:lnTo>
                    <a:pt x="1799" y="6"/>
                  </a:lnTo>
                  <a:lnTo>
                    <a:pt x="1800" y="7"/>
                  </a:lnTo>
                  <a:lnTo>
                    <a:pt x="1800" y="6"/>
                  </a:lnTo>
                  <a:lnTo>
                    <a:pt x="1801" y="7"/>
                  </a:lnTo>
                  <a:lnTo>
                    <a:pt x="1802" y="5"/>
                  </a:lnTo>
                  <a:lnTo>
                    <a:pt x="1803" y="6"/>
                  </a:lnTo>
                  <a:lnTo>
                    <a:pt x="1804" y="6"/>
                  </a:lnTo>
                  <a:lnTo>
                    <a:pt x="1805" y="6"/>
                  </a:lnTo>
                  <a:lnTo>
                    <a:pt x="1806" y="5"/>
                  </a:lnTo>
                  <a:lnTo>
                    <a:pt x="1807" y="3"/>
                  </a:lnTo>
                  <a:lnTo>
                    <a:pt x="1807" y="6"/>
                  </a:lnTo>
                  <a:lnTo>
                    <a:pt x="1808" y="6"/>
                  </a:lnTo>
                  <a:lnTo>
                    <a:pt x="1809" y="6"/>
                  </a:lnTo>
                  <a:lnTo>
                    <a:pt x="1810" y="7"/>
                  </a:lnTo>
                  <a:lnTo>
                    <a:pt x="1811" y="6"/>
                  </a:lnTo>
                  <a:lnTo>
                    <a:pt x="1812" y="8"/>
                  </a:lnTo>
                  <a:lnTo>
                    <a:pt x="1813" y="8"/>
                  </a:lnTo>
                  <a:lnTo>
                    <a:pt x="1814" y="8"/>
                  </a:lnTo>
                  <a:lnTo>
                    <a:pt x="1815" y="5"/>
                  </a:lnTo>
                  <a:lnTo>
                    <a:pt x="1815" y="7"/>
                  </a:lnTo>
                  <a:lnTo>
                    <a:pt x="1816" y="5"/>
                  </a:lnTo>
                  <a:lnTo>
                    <a:pt x="1817" y="5"/>
                  </a:lnTo>
                  <a:lnTo>
                    <a:pt x="1818" y="6"/>
                  </a:lnTo>
                  <a:lnTo>
                    <a:pt x="1819" y="6"/>
                  </a:lnTo>
                  <a:lnTo>
                    <a:pt x="1820" y="5"/>
                  </a:lnTo>
                  <a:lnTo>
                    <a:pt x="1821" y="4"/>
                  </a:lnTo>
                  <a:lnTo>
                    <a:pt x="1822" y="4"/>
                  </a:lnTo>
                  <a:lnTo>
                    <a:pt x="1822" y="4"/>
                  </a:lnTo>
                  <a:lnTo>
                    <a:pt x="1823" y="7"/>
                  </a:lnTo>
                  <a:lnTo>
                    <a:pt x="1824" y="4"/>
                  </a:lnTo>
                  <a:lnTo>
                    <a:pt x="1825" y="5"/>
                  </a:lnTo>
                  <a:lnTo>
                    <a:pt x="1826" y="4"/>
                  </a:lnTo>
                  <a:lnTo>
                    <a:pt x="1827" y="3"/>
                  </a:lnTo>
                  <a:lnTo>
                    <a:pt x="1828" y="5"/>
                  </a:lnTo>
                  <a:lnTo>
                    <a:pt x="1829" y="5"/>
                  </a:lnTo>
                  <a:lnTo>
                    <a:pt x="1830" y="3"/>
                  </a:lnTo>
                  <a:lnTo>
                    <a:pt x="1830" y="4"/>
                  </a:lnTo>
                  <a:lnTo>
                    <a:pt x="1831" y="9"/>
                  </a:lnTo>
                  <a:lnTo>
                    <a:pt x="1832" y="5"/>
                  </a:lnTo>
                  <a:lnTo>
                    <a:pt x="1833" y="3"/>
                  </a:lnTo>
                  <a:lnTo>
                    <a:pt x="1834" y="3"/>
                  </a:lnTo>
                  <a:lnTo>
                    <a:pt x="1835" y="5"/>
                  </a:lnTo>
                  <a:lnTo>
                    <a:pt x="1836" y="3"/>
                  </a:lnTo>
                  <a:lnTo>
                    <a:pt x="1837" y="4"/>
                  </a:lnTo>
                  <a:lnTo>
                    <a:pt x="1837" y="5"/>
                  </a:lnTo>
                  <a:lnTo>
                    <a:pt x="1838" y="6"/>
                  </a:lnTo>
                  <a:lnTo>
                    <a:pt x="1839" y="4"/>
                  </a:lnTo>
                  <a:lnTo>
                    <a:pt x="1840" y="5"/>
                  </a:lnTo>
                  <a:lnTo>
                    <a:pt x="1841" y="5"/>
                  </a:lnTo>
                  <a:lnTo>
                    <a:pt x="1842" y="7"/>
                  </a:lnTo>
                  <a:lnTo>
                    <a:pt x="1843" y="4"/>
                  </a:lnTo>
                  <a:lnTo>
                    <a:pt x="1844" y="5"/>
                  </a:lnTo>
                  <a:lnTo>
                    <a:pt x="1845" y="7"/>
                  </a:lnTo>
                  <a:lnTo>
                    <a:pt x="1845" y="4"/>
                  </a:lnTo>
                  <a:lnTo>
                    <a:pt x="1846" y="7"/>
                  </a:lnTo>
                  <a:lnTo>
                    <a:pt x="1847" y="5"/>
                  </a:lnTo>
                  <a:lnTo>
                    <a:pt x="1848" y="5"/>
                  </a:lnTo>
                  <a:lnTo>
                    <a:pt x="1849" y="3"/>
                  </a:lnTo>
                  <a:lnTo>
                    <a:pt x="1850" y="7"/>
                  </a:lnTo>
                  <a:lnTo>
                    <a:pt x="1851" y="8"/>
                  </a:lnTo>
                  <a:lnTo>
                    <a:pt x="1852" y="6"/>
                  </a:lnTo>
                  <a:lnTo>
                    <a:pt x="1852" y="8"/>
                  </a:lnTo>
                  <a:lnTo>
                    <a:pt x="1853" y="8"/>
                  </a:lnTo>
                  <a:lnTo>
                    <a:pt x="1854" y="7"/>
                  </a:lnTo>
                  <a:lnTo>
                    <a:pt x="1855" y="4"/>
                  </a:lnTo>
                  <a:lnTo>
                    <a:pt x="1856" y="5"/>
                  </a:lnTo>
                  <a:lnTo>
                    <a:pt x="1857" y="5"/>
                  </a:lnTo>
                  <a:lnTo>
                    <a:pt x="1858" y="6"/>
                  </a:lnTo>
                  <a:lnTo>
                    <a:pt x="1859" y="6"/>
                  </a:lnTo>
                  <a:lnTo>
                    <a:pt x="1860" y="5"/>
                  </a:lnTo>
                  <a:lnTo>
                    <a:pt x="1860" y="3"/>
                  </a:lnTo>
                  <a:lnTo>
                    <a:pt x="1861" y="5"/>
                  </a:lnTo>
                  <a:lnTo>
                    <a:pt x="1862" y="4"/>
                  </a:lnTo>
                  <a:lnTo>
                    <a:pt x="1863" y="7"/>
                  </a:lnTo>
                  <a:lnTo>
                    <a:pt x="1864" y="5"/>
                  </a:lnTo>
                  <a:lnTo>
                    <a:pt x="1865" y="5"/>
                  </a:lnTo>
                  <a:lnTo>
                    <a:pt x="1866" y="4"/>
                  </a:lnTo>
                  <a:lnTo>
                    <a:pt x="1867" y="6"/>
                  </a:lnTo>
                  <a:lnTo>
                    <a:pt x="1867" y="2"/>
                  </a:lnTo>
                  <a:lnTo>
                    <a:pt x="1868" y="3"/>
                  </a:lnTo>
                  <a:lnTo>
                    <a:pt x="1869" y="3"/>
                  </a:lnTo>
                  <a:lnTo>
                    <a:pt x="1870" y="4"/>
                  </a:lnTo>
                  <a:lnTo>
                    <a:pt x="1871" y="4"/>
                  </a:lnTo>
                  <a:lnTo>
                    <a:pt x="1872" y="2"/>
                  </a:lnTo>
                  <a:lnTo>
                    <a:pt x="1873" y="3"/>
                  </a:lnTo>
                  <a:lnTo>
                    <a:pt x="1874" y="3"/>
                  </a:lnTo>
                  <a:lnTo>
                    <a:pt x="1875" y="4"/>
                  </a:lnTo>
                  <a:lnTo>
                    <a:pt x="1875" y="2"/>
                  </a:lnTo>
                  <a:lnTo>
                    <a:pt x="1876" y="4"/>
                  </a:lnTo>
                  <a:lnTo>
                    <a:pt x="1877" y="2"/>
                  </a:lnTo>
                  <a:lnTo>
                    <a:pt x="1878" y="2"/>
                  </a:lnTo>
                  <a:lnTo>
                    <a:pt x="1879" y="2"/>
                  </a:lnTo>
                  <a:lnTo>
                    <a:pt x="1880" y="5"/>
                  </a:lnTo>
                  <a:lnTo>
                    <a:pt x="1881" y="6"/>
                  </a:lnTo>
                  <a:lnTo>
                    <a:pt x="1882" y="5"/>
                  </a:lnTo>
                  <a:lnTo>
                    <a:pt x="1882" y="5"/>
                  </a:lnTo>
                  <a:lnTo>
                    <a:pt x="1883" y="1"/>
                  </a:lnTo>
                  <a:lnTo>
                    <a:pt x="1884" y="4"/>
                  </a:lnTo>
                  <a:lnTo>
                    <a:pt x="1885" y="5"/>
                  </a:lnTo>
                  <a:lnTo>
                    <a:pt x="1886" y="3"/>
                  </a:lnTo>
                  <a:lnTo>
                    <a:pt x="1887" y="4"/>
                  </a:lnTo>
                  <a:lnTo>
                    <a:pt x="1888" y="1"/>
                  </a:lnTo>
                  <a:lnTo>
                    <a:pt x="1889" y="4"/>
                  </a:lnTo>
                  <a:lnTo>
                    <a:pt x="1889" y="3"/>
                  </a:lnTo>
                  <a:lnTo>
                    <a:pt x="1890" y="2"/>
                  </a:lnTo>
                  <a:lnTo>
                    <a:pt x="1891" y="3"/>
                  </a:lnTo>
                  <a:lnTo>
                    <a:pt x="1892" y="3"/>
                  </a:lnTo>
                  <a:lnTo>
                    <a:pt x="1893" y="4"/>
                  </a:lnTo>
                  <a:lnTo>
                    <a:pt x="1894" y="2"/>
                  </a:lnTo>
                  <a:lnTo>
                    <a:pt x="1895" y="4"/>
                  </a:lnTo>
                  <a:lnTo>
                    <a:pt x="1896" y="4"/>
                  </a:lnTo>
                  <a:lnTo>
                    <a:pt x="1897" y="5"/>
                  </a:lnTo>
                  <a:lnTo>
                    <a:pt x="1897" y="5"/>
                  </a:lnTo>
                  <a:lnTo>
                    <a:pt x="1898" y="7"/>
                  </a:lnTo>
                  <a:lnTo>
                    <a:pt x="1899" y="6"/>
                  </a:lnTo>
                  <a:lnTo>
                    <a:pt x="1900" y="7"/>
                  </a:lnTo>
                  <a:lnTo>
                    <a:pt x="1901" y="7"/>
                  </a:lnTo>
                  <a:lnTo>
                    <a:pt x="1902" y="9"/>
                  </a:lnTo>
                  <a:lnTo>
                    <a:pt x="1903" y="6"/>
                  </a:lnTo>
                  <a:lnTo>
                    <a:pt x="1904" y="6"/>
                  </a:lnTo>
                  <a:lnTo>
                    <a:pt x="1904" y="1"/>
                  </a:lnTo>
                  <a:lnTo>
                    <a:pt x="1905" y="5"/>
                  </a:lnTo>
                  <a:lnTo>
                    <a:pt x="1906" y="5"/>
                  </a:lnTo>
                  <a:lnTo>
                    <a:pt x="1907" y="5"/>
                  </a:lnTo>
                  <a:lnTo>
                    <a:pt x="1908" y="7"/>
                  </a:lnTo>
                  <a:lnTo>
                    <a:pt x="1909" y="6"/>
                  </a:lnTo>
                  <a:lnTo>
                    <a:pt x="1910" y="7"/>
                  </a:lnTo>
                  <a:lnTo>
                    <a:pt x="1911" y="4"/>
                  </a:lnTo>
                  <a:lnTo>
                    <a:pt x="1912" y="4"/>
                  </a:lnTo>
                  <a:lnTo>
                    <a:pt x="1912" y="6"/>
                  </a:lnTo>
                  <a:lnTo>
                    <a:pt x="1913" y="5"/>
                  </a:lnTo>
                  <a:lnTo>
                    <a:pt x="1914" y="5"/>
                  </a:lnTo>
                  <a:lnTo>
                    <a:pt x="1915" y="4"/>
                  </a:lnTo>
                  <a:lnTo>
                    <a:pt x="1916" y="5"/>
                  </a:lnTo>
                  <a:lnTo>
                    <a:pt x="1917" y="5"/>
                  </a:lnTo>
                  <a:lnTo>
                    <a:pt x="1918" y="7"/>
                  </a:lnTo>
                  <a:lnTo>
                    <a:pt x="1919" y="6"/>
                  </a:lnTo>
                  <a:lnTo>
                    <a:pt x="1919" y="3"/>
                  </a:lnTo>
                  <a:lnTo>
                    <a:pt x="1920" y="4"/>
                  </a:lnTo>
                  <a:lnTo>
                    <a:pt x="1921" y="5"/>
                  </a:lnTo>
                  <a:lnTo>
                    <a:pt x="1922" y="5"/>
                  </a:lnTo>
                  <a:lnTo>
                    <a:pt x="1923" y="6"/>
                  </a:lnTo>
                  <a:lnTo>
                    <a:pt x="1924" y="6"/>
                  </a:lnTo>
                  <a:lnTo>
                    <a:pt x="1925" y="5"/>
                  </a:lnTo>
                  <a:lnTo>
                    <a:pt x="1926" y="6"/>
                  </a:lnTo>
                  <a:lnTo>
                    <a:pt x="1927" y="2"/>
                  </a:lnTo>
                  <a:lnTo>
                    <a:pt x="1927" y="5"/>
                  </a:lnTo>
                  <a:lnTo>
                    <a:pt x="1928" y="5"/>
                  </a:lnTo>
                  <a:lnTo>
                    <a:pt x="1929" y="6"/>
                  </a:lnTo>
                  <a:lnTo>
                    <a:pt x="1930" y="5"/>
                  </a:lnTo>
                  <a:lnTo>
                    <a:pt x="1931" y="8"/>
                  </a:lnTo>
                  <a:lnTo>
                    <a:pt x="1932" y="7"/>
                  </a:lnTo>
                  <a:lnTo>
                    <a:pt x="1933" y="9"/>
                  </a:lnTo>
                  <a:lnTo>
                    <a:pt x="1934" y="6"/>
                  </a:lnTo>
                  <a:lnTo>
                    <a:pt x="1934" y="8"/>
                  </a:lnTo>
                  <a:lnTo>
                    <a:pt x="1935" y="7"/>
                  </a:lnTo>
                  <a:lnTo>
                    <a:pt x="1936" y="8"/>
                  </a:lnTo>
                  <a:lnTo>
                    <a:pt x="1937" y="10"/>
                  </a:lnTo>
                  <a:lnTo>
                    <a:pt x="1938" y="10"/>
                  </a:lnTo>
                  <a:lnTo>
                    <a:pt x="1939" y="9"/>
                  </a:lnTo>
                  <a:lnTo>
                    <a:pt x="1940" y="14"/>
                  </a:lnTo>
                  <a:lnTo>
                    <a:pt x="1941" y="10"/>
                  </a:lnTo>
                  <a:lnTo>
                    <a:pt x="1942" y="10"/>
                  </a:lnTo>
                  <a:lnTo>
                    <a:pt x="1942" y="7"/>
                  </a:lnTo>
                  <a:lnTo>
                    <a:pt x="1943" y="7"/>
                  </a:lnTo>
                  <a:lnTo>
                    <a:pt x="1944" y="7"/>
                  </a:lnTo>
                  <a:lnTo>
                    <a:pt x="1945" y="7"/>
                  </a:lnTo>
                  <a:lnTo>
                    <a:pt x="1946" y="7"/>
                  </a:lnTo>
                  <a:lnTo>
                    <a:pt x="1947" y="8"/>
                  </a:lnTo>
                  <a:lnTo>
                    <a:pt x="1948" y="9"/>
                  </a:lnTo>
                  <a:lnTo>
                    <a:pt x="1949" y="10"/>
                  </a:lnTo>
                  <a:lnTo>
                    <a:pt x="1949" y="8"/>
                  </a:lnTo>
                  <a:lnTo>
                    <a:pt x="1950" y="6"/>
                  </a:lnTo>
                  <a:lnTo>
                    <a:pt x="1951" y="7"/>
                  </a:lnTo>
                  <a:lnTo>
                    <a:pt x="1952" y="5"/>
                  </a:lnTo>
                  <a:lnTo>
                    <a:pt x="1953" y="8"/>
                  </a:lnTo>
                  <a:lnTo>
                    <a:pt x="1954" y="5"/>
                  </a:lnTo>
                  <a:lnTo>
                    <a:pt x="1955" y="4"/>
                  </a:lnTo>
                  <a:lnTo>
                    <a:pt x="1956" y="6"/>
                  </a:lnTo>
                  <a:lnTo>
                    <a:pt x="1957" y="8"/>
                  </a:lnTo>
                  <a:lnTo>
                    <a:pt x="1957" y="6"/>
                  </a:lnTo>
                  <a:lnTo>
                    <a:pt x="1958" y="6"/>
                  </a:lnTo>
                  <a:lnTo>
                    <a:pt x="1959" y="9"/>
                  </a:lnTo>
                  <a:lnTo>
                    <a:pt x="1960" y="7"/>
                  </a:lnTo>
                  <a:lnTo>
                    <a:pt x="1961" y="7"/>
                  </a:lnTo>
                  <a:lnTo>
                    <a:pt x="1962" y="7"/>
                  </a:lnTo>
                  <a:lnTo>
                    <a:pt x="1963" y="4"/>
                  </a:lnTo>
                  <a:lnTo>
                    <a:pt x="1964" y="7"/>
                  </a:lnTo>
                  <a:lnTo>
                    <a:pt x="1964" y="10"/>
                  </a:lnTo>
                  <a:lnTo>
                    <a:pt x="1965" y="8"/>
                  </a:lnTo>
                  <a:lnTo>
                    <a:pt x="1966" y="9"/>
                  </a:lnTo>
                  <a:lnTo>
                    <a:pt x="1967" y="7"/>
                  </a:lnTo>
                  <a:lnTo>
                    <a:pt x="1968" y="8"/>
                  </a:lnTo>
                  <a:lnTo>
                    <a:pt x="1969" y="6"/>
                  </a:lnTo>
                  <a:lnTo>
                    <a:pt x="1970" y="7"/>
                  </a:lnTo>
                  <a:lnTo>
                    <a:pt x="1971" y="7"/>
                  </a:lnTo>
                  <a:lnTo>
                    <a:pt x="1972" y="7"/>
                  </a:lnTo>
                  <a:lnTo>
                    <a:pt x="1972" y="5"/>
                  </a:lnTo>
                  <a:lnTo>
                    <a:pt x="1973" y="4"/>
                  </a:lnTo>
                  <a:lnTo>
                    <a:pt x="1974" y="5"/>
                  </a:lnTo>
                  <a:lnTo>
                    <a:pt x="1975" y="5"/>
                  </a:lnTo>
                  <a:lnTo>
                    <a:pt x="1976" y="5"/>
                  </a:lnTo>
                  <a:lnTo>
                    <a:pt x="1977" y="5"/>
                  </a:lnTo>
                  <a:lnTo>
                    <a:pt x="1978" y="6"/>
                  </a:lnTo>
                  <a:lnTo>
                    <a:pt x="1979" y="6"/>
                  </a:lnTo>
                  <a:lnTo>
                    <a:pt x="1979" y="8"/>
                  </a:lnTo>
                  <a:lnTo>
                    <a:pt x="1980" y="9"/>
                  </a:lnTo>
                  <a:lnTo>
                    <a:pt x="1981" y="11"/>
                  </a:lnTo>
                  <a:lnTo>
                    <a:pt x="1982" y="16"/>
                  </a:lnTo>
                  <a:lnTo>
                    <a:pt x="1983" y="15"/>
                  </a:lnTo>
                  <a:lnTo>
                    <a:pt x="1984" y="22"/>
                  </a:lnTo>
                  <a:lnTo>
                    <a:pt x="1985" y="26"/>
                  </a:lnTo>
                  <a:lnTo>
                    <a:pt x="1986" y="34"/>
                  </a:lnTo>
                  <a:lnTo>
                    <a:pt x="1987" y="44"/>
                  </a:lnTo>
                  <a:lnTo>
                    <a:pt x="1987" y="47"/>
                  </a:lnTo>
                  <a:lnTo>
                    <a:pt x="1988" y="51"/>
                  </a:lnTo>
                  <a:lnTo>
                    <a:pt x="1989" y="48"/>
                  </a:lnTo>
                  <a:lnTo>
                    <a:pt x="1990" y="51"/>
                  </a:lnTo>
                  <a:lnTo>
                    <a:pt x="1991" y="48"/>
                  </a:lnTo>
                  <a:lnTo>
                    <a:pt x="1992" y="41"/>
                  </a:lnTo>
                  <a:lnTo>
                    <a:pt x="1993" y="39"/>
                  </a:lnTo>
                  <a:lnTo>
                    <a:pt x="1994" y="34"/>
                  </a:lnTo>
                  <a:lnTo>
                    <a:pt x="1994" y="25"/>
                  </a:lnTo>
                  <a:lnTo>
                    <a:pt x="1995" y="21"/>
                  </a:lnTo>
                  <a:lnTo>
                    <a:pt x="1996" y="18"/>
                  </a:lnTo>
                  <a:lnTo>
                    <a:pt x="1997" y="16"/>
                  </a:lnTo>
                  <a:lnTo>
                    <a:pt x="1998" y="14"/>
                  </a:lnTo>
                  <a:lnTo>
                    <a:pt x="1999" y="11"/>
                  </a:lnTo>
                  <a:lnTo>
                    <a:pt x="2000" y="8"/>
                  </a:lnTo>
                  <a:lnTo>
                    <a:pt x="2001" y="10"/>
                  </a:lnTo>
                  <a:lnTo>
                    <a:pt x="2002" y="7"/>
                  </a:lnTo>
                  <a:lnTo>
                    <a:pt x="2002" y="8"/>
                  </a:lnTo>
                  <a:lnTo>
                    <a:pt x="2003" y="6"/>
                  </a:lnTo>
                  <a:lnTo>
                    <a:pt x="2004" y="9"/>
                  </a:lnTo>
                  <a:lnTo>
                    <a:pt x="2005" y="9"/>
                  </a:lnTo>
                  <a:lnTo>
                    <a:pt x="2006" y="11"/>
                  </a:lnTo>
                  <a:lnTo>
                    <a:pt x="2007" y="11"/>
                  </a:lnTo>
                  <a:lnTo>
                    <a:pt x="2008" y="15"/>
                  </a:lnTo>
                  <a:lnTo>
                    <a:pt x="2009" y="16"/>
                  </a:lnTo>
                  <a:lnTo>
                    <a:pt x="2009" y="16"/>
                  </a:lnTo>
                  <a:lnTo>
                    <a:pt x="2010" y="22"/>
                  </a:lnTo>
                  <a:lnTo>
                    <a:pt x="2011" y="23"/>
                  </a:lnTo>
                  <a:lnTo>
                    <a:pt x="2012" y="23"/>
                  </a:lnTo>
                  <a:lnTo>
                    <a:pt x="2013" y="26"/>
                  </a:lnTo>
                  <a:lnTo>
                    <a:pt x="2014" y="27"/>
                  </a:lnTo>
                  <a:lnTo>
                    <a:pt x="2015" y="23"/>
                  </a:lnTo>
                  <a:lnTo>
                    <a:pt x="2016" y="18"/>
                  </a:lnTo>
                  <a:lnTo>
                    <a:pt x="2017" y="23"/>
                  </a:lnTo>
                  <a:lnTo>
                    <a:pt x="2017" y="18"/>
                  </a:lnTo>
                  <a:lnTo>
                    <a:pt x="2018" y="15"/>
                  </a:lnTo>
                  <a:lnTo>
                    <a:pt x="2019" y="11"/>
                  </a:lnTo>
                  <a:lnTo>
                    <a:pt x="2020" y="12"/>
                  </a:lnTo>
                  <a:lnTo>
                    <a:pt x="2021" y="12"/>
                  </a:lnTo>
                  <a:lnTo>
                    <a:pt x="2022" y="8"/>
                  </a:lnTo>
                  <a:lnTo>
                    <a:pt x="2023" y="8"/>
                  </a:lnTo>
                  <a:lnTo>
                    <a:pt x="2024" y="7"/>
                  </a:lnTo>
                  <a:lnTo>
                    <a:pt x="2024" y="11"/>
                  </a:lnTo>
                  <a:lnTo>
                    <a:pt x="2025" y="9"/>
                  </a:lnTo>
                  <a:lnTo>
                    <a:pt x="2026" y="7"/>
                  </a:lnTo>
                  <a:lnTo>
                    <a:pt x="2027" y="6"/>
                  </a:lnTo>
                  <a:lnTo>
                    <a:pt x="2028" y="7"/>
                  </a:lnTo>
                  <a:lnTo>
                    <a:pt x="2029" y="8"/>
                  </a:lnTo>
                  <a:lnTo>
                    <a:pt x="2030" y="5"/>
                  </a:lnTo>
                  <a:lnTo>
                    <a:pt x="2031" y="8"/>
                  </a:lnTo>
                  <a:lnTo>
                    <a:pt x="2032" y="5"/>
                  </a:lnTo>
                  <a:lnTo>
                    <a:pt x="2032" y="6"/>
                  </a:lnTo>
                  <a:lnTo>
                    <a:pt x="2033" y="5"/>
                  </a:lnTo>
                  <a:lnTo>
                    <a:pt x="2034" y="6"/>
                  </a:lnTo>
                  <a:lnTo>
                    <a:pt x="2035" y="6"/>
                  </a:lnTo>
                  <a:lnTo>
                    <a:pt x="2036" y="5"/>
                  </a:lnTo>
                  <a:lnTo>
                    <a:pt x="2037" y="4"/>
                  </a:lnTo>
                  <a:lnTo>
                    <a:pt x="2038" y="8"/>
                  </a:lnTo>
                  <a:lnTo>
                    <a:pt x="2039" y="5"/>
                  </a:lnTo>
                  <a:lnTo>
                    <a:pt x="2039" y="7"/>
                  </a:lnTo>
                  <a:lnTo>
                    <a:pt x="2040" y="6"/>
                  </a:lnTo>
                  <a:lnTo>
                    <a:pt x="2041" y="4"/>
                  </a:lnTo>
                  <a:lnTo>
                    <a:pt x="2042" y="9"/>
                  </a:lnTo>
                  <a:lnTo>
                    <a:pt x="2043" y="6"/>
                  </a:lnTo>
                  <a:lnTo>
                    <a:pt x="2044" y="8"/>
                  </a:lnTo>
                  <a:lnTo>
                    <a:pt x="2045" y="6"/>
                  </a:lnTo>
                  <a:lnTo>
                    <a:pt x="2046" y="6"/>
                  </a:lnTo>
                  <a:lnTo>
                    <a:pt x="2047" y="5"/>
                  </a:lnTo>
                  <a:lnTo>
                    <a:pt x="2047" y="4"/>
                  </a:lnTo>
                  <a:lnTo>
                    <a:pt x="2048" y="8"/>
                  </a:lnTo>
                  <a:lnTo>
                    <a:pt x="2049" y="9"/>
                  </a:lnTo>
                  <a:lnTo>
                    <a:pt x="2050" y="8"/>
                  </a:lnTo>
                  <a:lnTo>
                    <a:pt x="2051" y="10"/>
                  </a:lnTo>
                  <a:lnTo>
                    <a:pt x="2052" y="11"/>
                  </a:lnTo>
                  <a:lnTo>
                    <a:pt x="2053" y="8"/>
                  </a:lnTo>
                  <a:lnTo>
                    <a:pt x="2054" y="8"/>
                  </a:lnTo>
                  <a:lnTo>
                    <a:pt x="2054" y="9"/>
                  </a:lnTo>
                  <a:lnTo>
                    <a:pt x="2055" y="13"/>
                  </a:lnTo>
                  <a:lnTo>
                    <a:pt x="2056" y="11"/>
                  </a:lnTo>
                  <a:lnTo>
                    <a:pt x="2057" y="15"/>
                  </a:lnTo>
                  <a:lnTo>
                    <a:pt x="2058" y="10"/>
                  </a:lnTo>
                  <a:lnTo>
                    <a:pt x="2059" y="12"/>
                  </a:lnTo>
                  <a:lnTo>
                    <a:pt x="2060" y="9"/>
                  </a:lnTo>
                  <a:lnTo>
                    <a:pt x="2061" y="11"/>
                  </a:lnTo>
                  <a:lnTo>
                    <a:pt x="2062" y="9"/>
                  </a:lnTo>
                  <a:lnTo>
                    <a:pt x="2062" y="9"/>
                  </a:lnTo>
                  <a:lnTo>
                    <a:pt x="2063" y="10"/>
                  </a:lnTo>
                  <a:lnTo>
                    <a:pt x="2064" y="9"/>
                  </a:lnTo>
                  <a:lnTo>
                    <a:pt x="2065" y="9"/>
                  </a:lnTo>
                  <a:lnTo>
                    <a:pt x="2066" y="4"/>
                  </a:lnTo>
                  <a:lnTo>
                    <a:pt x="2067" y="5"/>
                  </a:lnTo>
                  <a:lnTo>
                    <a:pt x="2068" y="7"/>
                  </a:lnTo>
                  <a:lnTo>
                    <a:pt x="2069" y="6"/>
                  </a:lnTo>
                  <a:lnTo>
                    <a:pt x="2069" y="6"/>
                  </a:lnTo>
                  <a:lnTo>
                    <a:pt x="2070" y="7"/>
                  </a:lnTo>
                  <a:lnTo>
                    <a:pt x="2071" y="7"/>
                  </a:lnTo>
                  <a:lnTo>
                    <a:pt x="2072" y="7"/>
                  </a:lnTo>
                  <a:lnTo>
                    <a:pt x="2073" y="6"/>
                  </a:lnTo>
                  <a:lnTo>
                    <a:pt x="2074" y="7"/>
                  </a:lnTo>
                  <a:lnTo>
                    <a:pt x="2075" y="8"/>
                  </a:lnTo>
                  <a:lnTo>
                    <a:pt x="2076" y="4"/>
                  </a:lnTo>
                  <a:lnTo>
                    <a:pt x="2077" y="7"/>
                  </a:lnTo>
                  <a:lnTo>
                    <a:pt x="2077" y="5"/>
                  </a:lnTo>
                  <a:lnTo>
                    <a:pt x="2078" y="8"/>
                  </a:lnTo>
                  <a:lnTo>
                    <a:pt x="2079" y="9"/>
                  </a:lnTo>
                  <a:lnTo>
                    <a:pt x="2080" y="7"/>
                  </a:lnTo>
                  <a:lnTo>
                    <a:pt x="2081" y="7"/>
                  </a:lnTo>
                  <a:lnTo>
                    <a:pt x="2082" y="8"/>
                  </a:lnTo>
                  <a:lnTo>
                    <a:pt x="2083" y="7"/>
                  </a:lnTo>
                  <a:lnTo>
                    <a:pt x="2084" y="7"/>
                  </a:lnTo>
                  <a:lnTo>
                    <a:pt x="2084" y="4"/>
                  </a:lnTo>
                  <a:lnTo>
                    <a:pt x="2085" y="5"/>
                  </a:lnTo>
                  <a:lnTo>
                    <a:pt x="2086" y="7"/>
                  </a:lnTo>
                  <a:lnTo>
                    <a:pt x="2087" y="5"/>
                  </a:lnTo>
                  <a:lnTo>
                    <a:pt x="2088" y="4"/>
                  </a:lnTo>
                  <a:lnTo>
                    <a:pt x="2089" y="5"/>
                  </a:lnTo>
                  <a:lnTo>
                    <a:pt x="2090" y="7"/>
                  </a:lnTo>
                  <a:lnTo>
                    <a:pt x="2091" y="5"/>
                  </a:lnTo>
                  <a:lnTo>
                    <a:pt x="2091" y="6"/>
                  </a:lnTo>
                  <a:lnTo>
                    <a:pt x="2092" y="5"/>
                  </a:lnTo>
                  <a:lnTo>
                    <a:pt x="2093" y="6"/>
                  </a:lnTo>
                  <a:lnTo>
                    <a:pt x="2094" y="7"/>
                  </a:lnTo>
                  <a:lnTo>
                    <a:pt x="2095" y="9"/>
                  </a:lnTo>
                  <a:lnTo>
                    <a:pt x="2096" y="7"/>
                  </a:lnTo>
                  <a:lnTo>
                    <a:pt x="2097" y="8"/>
                  </a:lnTo>
                  <a:lnTo>
                    <a:pt x="2098" y="4"/>
                  </a:lnTo>
                  <a:lnTo>
                    <a:pt x="2099" y="9"/>
                  </a:lnTo>
                  <a:lnTo>
                    <a:pt x="2099" y="5"/>
                  </a:lnTo>
                  <a:lnTo>
                    <a:pt x="2100" y="7"/>
                  </a:lnTo>
                  <a:lnTo>
                    <a:pt x="2101" y="6"/>
                  </a:lnTo>
                  <a:lnTo>
                    <a:pt x="2102" y="5"/>
                  </a:lnTo>
                  <a:lnTo>
                    <a:pt x="2103" y="5"/>
                  </a:lnTo>
                  <a:lnTo>
                    <a:pt x="2104" y="4"/>
                  </a:lnTo>
                  <a:lnTo>
                    <a:pt x="2105" y="7"/>
                  </a:lnTo>
                  <a:lnTo>
                    <a:pt x="2106" y="6"/>
                  </a:lnTo>
                  <a:lnTo>
                    <a:pt x="2106" y="4"/>
                  </a:lnTo>
                  <a:lnTo>
                    <a:pt x="2107" y="7"/>
                  </a:lnTo>
                  <a:lnTo>
                    <a:pt x="2108" y="5"/>
                  </a:lnTo>
                  <a:lnTo>
                    <a:pt x="2109" y="4"/>
                  </a:lnTo>
                  <a:lnTo>
                    <a:pt x="2110" y="5"/>
                  </a:lnTo>
                  <a:lnTo>
                    <a:pt x="2111" y="5"/>
                  </a:lnTo>
                  <a:lnTo>
                    <a:pt x="2112" y="6"/>
                  </a:lnTo>
                  <a:lnTo>
                    <a:pt x="2113" y="8"/>
                  </a:lnTo>
                  <a:lnTo>
                    <a:pt x="2114" y="6"/>
                  </a:lnTo>
                  <a:lnTo>
                    <a:pt x="2114" y="6"/>
                  </a:lnTo>
                  <a:lnTo>
                    <a:pt x="2115" y="5"/>
                  </a:lnTo>
                  <a:lnTo>
                    <a:pt x="2116" y="5"/>
                  </a:lnTo>
                  <a:lnTo>
                    <a:pt x="2117" y="6"/>
                  </a:lnTo>
                  <a:lnTo>
                    <a:pt x="2118" y="6"/>
                  </a:lnTo>
                  <a:lnTo>
                    <a:pt x="2119" y="5"/>
                  </a:lnTo>
                  <a:lnTo>
                    <a:pt x="2120" y="7"/>
                  </a:lnTo>
                  <a:lnTo>
                    <a:pt x="2121" y="9"/>
                  </a:lnTo>
                  <a:lnTo>
                    <a:pt x="2121" y="5"/>
                  </a:lnTo>
                  <a:lnTo>
                    <a:pt x="2122" y="9"/>
                  </a:lnTo>
                  <a:lnTo>
                    <a:pt x="2123" y="11"/>
                  </a:lnTo>
                  <a:lnTo>
                    <a:pt x="2124" y="10"/>
                  </a:lnTo>
                  <a:lnTo>
                    <a:pt x="2125" y="12"/>
                  </a:lnTo>
                  <a:lnTo>
                    <a:pt x="2126" y="14"/>
                  </a:lnTo>
                  <a:lnTo>
                    <a:pt x="2127" y="16"/>
                  </a:lnTo>
                  <a:lnTo>
                    <a:pt x="2128" y="18"/>
                  </a:lnTo>
                  <a:lnTo>
                    <a:pt x="2129" y="21"/>
                  </a:lnTo>
                  <a:lnTo>
                    <a:pt x="2129" y="19"/>
                  </a:lnTo>
                  <a:lnTo>
                    <a:pt x="2130" y="23"/>
                  </a:lnTo>
                  <a:lnTo>
                    <a:pt x="2131" y="21"/>
                  </a:lnTo>
                  <a:lnTo>
                    <a:pt x="2132" y="20"/>
                  </a:lnTo>
                  <a:lnTo>
                    <a:pt x="2133" y="18"/>
                  </a:lnTo>
                  <a:lnTo>
                    <a:pt x="2134" y="20"/>
                  </a:lnTo>
                  <a:lnTo>
                    <a:pt x="2135" y="14"/>
                  </a:lnTo>
                  <a:lnTo>
                    <a:pt x="2136" y="16"/>
                  </a:lnTo>
                  <a:lnTo>
                    <a:pt x="2136" y="15"/>
                  </a:lnTo>
                  <a:lnTo>
                    <a:pt x="2137" y="14"/>
                  </a:lnTo>
                  <a:lnTo>
                    <a:pt x="2138" y="10"/>
                  </a:lnTo>
                  <a:lnTo>
                    <a:pt x="2139" y="12"/>
                  </a:lnTo>
                  <a:lnTo>
                    <a:pt x="2140" y="6"/>
                  </a:lnTo>
                  <a:lnTo>
                    <a:pt x="2141" y="10"/>
                  </a:lnTo>
                  <a:lnTo>
                    <a:pt x="2142" y="7"/>
                  </a:lnTo>
                  <a:lnTo>
                    <a:pt x="2143" y="5"/>
                  </a:lnTo>
                  <a:lnTo>
                    <a:pt x="2144" y="8"/>
                  </a:lnTo>
                  <a:lnTo>
                    <a:pt x="2144" y="5"/>
                  </a:lnTo>
                  <a:lnTo>
                    <a:pt x="2145" y="3"/>
                  </a:lnTo>
                  <a:lnTo>
                    <a:pt x="2146" y="5"/>
                  </a:lnTo>
                  <a:lnTo>
                    <a:pt x="2147" y="4"/>
                  </a:lnTo>
                  <a:lnTo>
                    <a:pt x="2148" y="6"/>
                  </a:lnTo>
                  <a:lnTo>
                    <a:pt x="2149" y="2"/>
                  </a:lnTo>
                  <a:lnTo>
                    <a:pt x="2150" y="4"/>
                  </a:lnTo>
                  <a:lnTo>
                    <a:pt x="2151" y="8"/>
                  </a:lnTo>
                  <a:lnTo>
                    <a:pt x="2151" y="8"/>
                  </a:lnTo>
                  <a:lnTo>
                    <a:pt x="2152" y="4"/>
                  </a:lnTo>
                  <a:lnTo>
                    <a:pt x="2153" y="2"/>
                  </a:lnTo>
                  <a:lnTo>
                    <a:pt x="2154" y="5"/>
                  </a:lnTo>
                  <a:lnTo>
                    <a:pt x="2155" y="6"/>
                  </a:lnTo>
                  <a:lnTo>
                    <a:pt x="2156" y="4"/>
                  </a:lnTo>
                  <a:lnTo>
                    <a:pt x="2157" y="3"/>
                  </a:lnTo>
                  <a:lnTo>
                    <a:pt x="2158" y="3"/>
                  </a:lnTo>
                  <a:lnTo>
                    <a:pt x="2159" y="5"/>
                  </a:lnTo>
                  <a:lnTo>
                    <a:pt x="2159" y="3"/>
                  </a:lnTo>
                  <a:lnTo>
                    <a:pt x="2160" y="5"/>
                  </a:lnTo>
                  <a:lnTo>
                    <a:pt x="2161" y="4"/>
                  </a:lnTo>
                  <a:lnTo>
                    <a:pt x="2162" y="4"/>
                  </a:lnTo>
                  <a:lnTo>
                    <a:pt x="2163" y="5"/>
                  </a:lnTo>
                  <a:lnTo>
                    <a:pt x="2164" y="7"/>
                  </a:lnTo>
                  <a:lnTo>
                    <a:pt x="2165" y="5"/>
                  </a:lnTo>
                  <a:lnTo>
                    <a:pt x="2166" y="4"/>
                  </a:lnTo>
                  <a:lnTo>
                    <a:pt x="2166" y="4"/>
                  </a:lnTo>
                  <a:lnTo>
                    <a:pt x="2167" y="5"/>
                  </a:lnTo>
                  <a:lnTo>
                    <a:pt x="2168" y="4"/>
                  </a:lnTo>
                  <a:lnTo>
                    <a:pt x="2169" y="4"/>
                  </a:lnTo>
                  <a:lnTo>
                    <a:pt x="2170" y="6"/>
                  </a:lnTo>
                  <a:lnTo>
                    <a:pt x="2171" y="5"/>
                  </a:lnTo>
                  <a:lnTo>
                    <a:pt x="2172" y="5"/>
                  </a:lnTo>
                  <a:lnTo>
                    <a:pt x="2173" y="8"/>
                  </a:lnTo>
                  <a:lnTo>
                    <a:pt x="2174" y="7"/>
                  </a:lnTo>
                  <a:lnTo>
                    <a:pt x="2174" y="8"/>
                  </a:lnTo>
                  <a:lnTo>
                    <a:pt x="2175" y="7"/>
                  </a:lnTo>
                  <a:lnTo>
                    <a:pt x="2176" y="8"/>
                  </a:lnTo>
                  <a:lnTo>
                    <a:pt x="2177" y="11"/>
                  </a:lnTo>
                  <a:lnTo>
                    <a:pt x="2178" y="8"/>
                  </a:lnTo>
                  <a:lnTo>
                    <a:pt x="2179" y="9"/>
                  </a:lnTo>
                  <a:lnTo>
                    <a:pt x="2180" y="7"/>
                  </a:lnTo>
                  <a:lnTo>
                    <a:pt x="2181" y="8"/>
                  </a:lnTo>
                  <a:lnTo>
                    <a:pt x="2181" y="10"/>
                  </a:lnTo>
                  <a:lnTo>
                    <a:pt x="2182" y="8"/>
                  </a:lnTo>
                  <a:lnTo>
                    <a:pt x="2183" y="9"/>
                  </a:lnTo>
                  <a:lnTo>
                    <a:pt x="2184" y="10"/>
                  </a:lnTo>
                  <a:lnTo>
                    <a:pt x="2185" y="12"/>
                  </a:lnTo>
                  <a:lnTo>
                    <a:pt x="2186" y="14"/>
                  </a:lnTo>
                  <a:lnTo>
                    <a:pt x="2187" y="16"/>
                  </a:lnTo>
                  <a:lnTo>
                    <a:pt x="2188" y="18"/>
                  </a:lnTo>
                  <a:lnTo>
                    <a:pt x="2189" y="19"/>
                  </a:lnTo>
                  <a:lnTo>
                    <a:pt x="2189" y="16"/>
                  </a:lnTo>
                  <a:lnTo>
                    <a:pt x="2190" y="21"/>
                  </a:lnTo>
                  <a:lnTo>
                    <a:pt x="2191" y="19"/>
                  </a:lnTo>
                  <a:lnTo>
                    <a:pt x="2192" y="18"/>
                  </a:lnTo>
                  <a:lnTo>
                    <a:pt x="2193" y="18"/>
                  </a:lnTo>
                  <a:lnTo>
                    <a:pt x="2194" y="15"/>
                  </a:lnTo>
                  <a:lnTo>
                    <a:pt x="2195" y="17"/>
                  </a:lnTo>
                  <a:lnTo>
                    <a:pt x="2196" y="14"/>
                  </a:lnTo>
                  <a:lnTo>
                    <a:pt x="2196" y="18"/>
                  </a:lnTo>
                  <a:lnTo>
                    <a:pt x="2197" y="12"/>
                  </a:lnTo>
                  <a:lnTo>
                    <a:pt x="2198" y="13"/>
                  </a:lnTo>
                  <a:lnTo>
                    <a:pt x="2199" y="14"/>
                  </a:lnTo>
                  <a:lnTo>
                    <a:pt x="2200" y="16"/>
                  </a:lnTo>
                  <a:lnTo>
                    <a:pt x="2201" y="14"/>
                  </a:lnTo>
                  <a:lnTo>
                    <a:pt x="2202" y="12"/>
                  </a:lnTo>
                  <a:lnTo>
                    <a:pt x="2203" y="12"/>
                  </a:lnTo>
                  <a:lnTo>
                    <a:pt x="2204" y="10"/>
                  </a:lnTo>
                  <a:lnTo>
                    <a:pt x="2204" y="11"/>
                  </a:lnTo>
                  <a:lnTo>
                    <a:pt x="2205" y="11"/>
                  </a:lnTo>
                  <a:lnTo>
                    <a:pt x="2206" y="6"/>
                  </a:lnTo>
                  <a:lnTo>
                    <a:pt x="2207" y="7"/>
                  </a:lnTo>
                  <a:lnTo>
                    <a:pt x="2208" y="7"/>
                  </a:lnTo>
                  <a:lnTo>
                    <a:pt x="2209" y="9"/>
                  </a:lnTo>
                  <a:lnTo>
                    <a:pt x="2210" y="7"/>
                  </a:lnTo>
                  <a:lnTo>
                    <a:pt x="2211" y="5"/>
                  </a:lnTo>
                  <a:lnTo>
                    <a:pt x="2211" y="3"/>
                  </a:lnTo>
                  <a:lnTo>
                    <a:pt x="2212" y="4"/>
                  </a:lnTo>
                  <a:lnTo>
                    <a:pt x="2213" y="5"/>
                  </a:lnTo>
                  <a:lnTo>
                    <a:pt x="2214" y="6"/>
                  </a:lnTo>
                  <a:lnTo>
                    <a:pt x="2215" y="6"/>
                  </a:lnTo>
                  <a:lnTo>
                    <a:pt x="2216" y="6"/>
                  </a:lnTo>
                  <a:lnTo>
                    <a:pt x="2217" y="3"/>
                  </a:lnTo>
                  <a:lnTo>
                    <a:pt x="2218" y="6"/>
                  </a:lnTo>
                  <a:lnTo>
                    <a:pt x="2219" y="2"/>
                  </a:lnTo>
                  <a:lnTo>
                    <a:pt x="2219" y="5"/>
                  </a:lnTo>
                  <a:lnTo>
                    <a:pt x="2220" y="4"/>
                  </a:lnTo>
                  <a:lnTo>
                    <a:pt x="2221" y="3"/>
                  </a:lnTo>
                  <a:lnTo>
                    <a:pt x="2222" y="3"/>
                  </a:lnTo>
                  <a:lnTo>
                    <a:pt x="2223" y="5"/>
                  </a:lnTo>
                  <a:lnTo>
                    <a:pt x="2224" y="3"/>
                  </a:lnTo>
                  <a:lnTo>
                    <a:pt x="2225" y="5"/>
                  </a:lnTo>
                  <a:lnTo>
                    <a:pt x="2226" y="3"/>
                  </a:lnTo>
                  <a:lnTo>
                    <a:pt x="2226" y="4"/>
                  </a:lnTo>
                  <a:lnTo>
                    <a:pt x="2227" y="3"/>
                  </a:lnTo>
                  <a:lnTo>
                    <a:pt x="2228" y="6"/>
                  </a:lnTo>
                  <a:lnTo>
                    <a:pt x="2229" y="8"/>
                  </a:lnTo>
                  <a:lnTo>
                    <a:pt x="2230" y="9"/>
                  </a:lnTo>
                  <a:lnTo>
                    <a:pt x="2231" y="8"/>
                  </a:lnTo>
                  <a:lnTo>
                    <a:pt x="2232" y="10"/>
                  </a:lnTo>
                  <a:lnTo>
                    <a:pt x="2233" y="12"/>
                  </a:lnTo>
                  <a:lnTo>
                    <a:pt x="2234" y="9"/>
                  </a:lnTo>
                  <a:lnTo>
                    <a:pt x="2234" y="14"/>
                  </a:lnTo>
                  <a:lnTo>
                    <a:pt x="2235" y="8"/>
                  </a:lnTo>
                  <a:lnTo>
                    <a:pt x="2236" y="10"/>
                  </a:lnTo>
                  <a:lnTo>
                    <a:pt x="2237" y="10"/>
                  </a:lnTo>
                  <a:lnTo>
                    <a:pt x="2238" y="8"/>
                  </a:lnTo>
                  <a:lnTo>
                    <a:pt x="2239" y="6"/>
                  </a:lnTo>
                  <a:lnTo>
                    <a:pt x="2240" y="6"/>
                  </a:lnTo>
                  <a:lnTo>
                    <a:pt x="2241" y="9"/>
                  </a:lnTo>
                  <a:lnTo>
                    <a:pt x="2241" y="6"/>
                  </a:lnTo>
                  <a:lnTo>
                    <a:pt x="2242" y="7"/>
                  </a:lnTo>
                  <a:lnTo>
                    <a:pt x="2243" y="8"/>
                  </a:lnTo>
                  <a:lnTo>
                    <a:pt x="2244" y="8"/>
                  </a:lnTo>
                  <a:lnTo>
                    <a:pt x="2245" y="10"/>
                  </a:lnTo>
                  <a:lnTo>
                    <a:pt x="2246" y="8"/>
                  </a:lnTo>
                  <a:lnTo>
                    <a:pt x="2247" y="7"/>
                  </a:lnTo>
                  <a:lnTo>
                    <a:pt x="2248" y="7"/>
                  </a:lnTo>
                  <a:lnTo>
                    <a:pt x="2249" y="7"/>
                  </a:lnTo>
                  <a:lnTo>
                    <a:pt x="2249" y="5"/>
                  </a:lnTo>
                  <a:lnTo>
                    <a:pt x="2250" y="8"/>
                  </a:lnTo>
                  <a:lnTo>
                    <a:pt x="2251" y="6"/>
                  </a:lnTo>
                  <a:lnTo>
                    <a:pt x="2252" y="5"/>
                  </a:lnTo>
                  <a:lnTo>
                    <a:pt x="2253" y="6"/>
                  </a:lnTo>
                  <a:lnTo>
                    <a:pt x="2254" y="4"/>
                  </a:lnTo>
                  <a:lnTo>
                    <a:pt x="2255" y="6"/>
                  </a:lnTo>
                  <a:lnTo>
                    <a:pt x="2256" y="4"/>
                  </a:lnTo>
                  <a:lnTo>
                    <a:pt x="2256" y="2"/>
                  </a:lnTo>
                  <a:lnTo>
                    <a:pt x="2257" y="2"/>
                  </a:lnTo>
                  <a:lnTo>
                    <a:pt x="2258" y="3"/>
                  </a:lnTo>
                  <a:lnTo>
                    <a:pt x="2259" y="5"/>
                  </a:lnTo>
                  <a:lnTo>
                    <a:pt x="2260" y="2"/>
                  </a:lnTo>
                  <a:lnTo>
                    <a:pt x="2261" y="4"/>
                  </a:lnTo>
                  <a:lnTo>
                    <a:pt x="2262" y="6"/>
                  </a:lnTo>
                  <a:lnTo>
                    <a:pt x="2263" y="3"/>
                  </a:lnTo>
                  <a:lnTo>
                    <a:pt x="2264" y="5"/>
                  </a:lnTo>
                  <a:lnTo>
                    <a:pt x="2264" y="6"/>
                  </a:lnTo>
                  <a:lnTo>
                    <a:pt x="2265" y="6"/>
                  </a:lnTo>
                  <a:lnTo>
                    <a:pt x="2266" y="9"/>
                  </a:lnTo>
                  <a:lnTo>
                    <a:pt x="2267" y="7"/>
                  </a:lnTo>
                  <a:lnTo>
                    <a:pt x="2268" y="9"/>
                  </a:lnTo>
                  <a:lnTo>
                    <a:pt x="2269" y="11"/>
                  </a:lnTo>
                  <a:lnTo>
                    <a:pt x="2270" y="8"/>
                  </a:lnTo>
                  <a:lnTo>
                    <a:pt x="2271" y="8"/>
                  </a:lnTo>
                  <a:lnTo>
                    <a:pt x="2271" y="6"/>
                  </a:lnTo>
                  <a:lnTo>
                    <a:pt x="2272" y="9"/>
                  </a:lnTo>
                  <a:lnTo>
                    <a:pt x="2273" y="7"/>
                  </a:lnTo>
                  <a:lnTo>
                    <a:pt x="2274" y="8"/>
                  </a:lnTo>
                  <a:lnTo>
                    <a:pt x="2275" y="8"/>
                  </a:lnTo>
                  <a:lnTo>
                    <a:pt x="2276" y="12"/>
                  </a:lnTo>
                  <a:lnTo>
                    <a:pt x="2277" y="17"/>
                  </a:lnTo>
                  <a:lnTo>
                    <a:pt x="2278" y="31"/>
                  </a:lnTo>
                  <a:lnTo>
                    <a:pt x="2279" y="59"/>
                  </a:lnTo>
                  <a:lnTo>
                    <a:pt x="2279" y="102"/>
                  </a:lnTo>
                  <a:lnTo>
                    <a:pt x="2280" y="185"/>
                  </a:lnTo>
                  <a:lnTo>
                    <a:pt x="2281" y="324"/>
                  </a:lnTo>
                  <a:lnTo>
                    <a:pt x="2282" y="524"/>
                  </a:lnTo>
                  <a:lnTo>
                    <a:pt x="2283" y="825"/>
                  </a:lnTo>
                  <a:lnTo>
                    <a:pt x="2284" y="1255"/>
                  </a:lnTo>
                  <a:lnTo>
                    <a:pt x="2285" y="1767"/>
                  </a:lnTo>
                  <a:lnTo>
                    <a:pt x="2286" y="2454"/>
                  </a:lnTo>
                  <a:lnTo>
                    <a:pt x="2286" y="3195"/>
                  </a:lnTo>
                  <a:lnTo>
                    <a:pt x="2287" y="4108"/>
                  </a:lnTo>
                  <a:lnTo>
                    <a:pt x="2288" y="4962"/>
                  </a:lnTo>
                  <a:lnTo>
                    <a:pt x="2289" y="5745"/>
                  </a:lnTo>
                  <a:lnTo>
                    <a:pt x="2290" y="6524"/>
                  </a:lnTo>
                  <a:lnTo>
                    <a:pt x="2291" y="7202"/>
                  </a:lnTo>
                  <a:lnTo>
                    <a:pt x="2292" y="7279"/>
                  </a:lnTo>
                  <a:lnTo>
                    <a:pt x="2293" y="6851"/>
                  </a:lnTo>
                  <a:lnTo>
                    <a:pt x="2293" y="6250"/>
                  </a:lnTo>
                  <a:lnTo>
                    <a:pt x="2294" y="5463"/>
                  </a:lnTo>
                  <a:lnTo>
                    <a:pt x="2295" y="4331"/>
                  </a:lnTo>
                  <a:lnTo>
                    <a:pt x="2296" y="3275"/>
                  </a:lnTo>
                  <a:lnTo>
                    <a:pt x="2297" y="2485"/>
                  </a:lnTo>
                  <a:lnTo>
                    <a:pt x="2298" y="1830"/>
                  </a:lnTo>
                  <a:lnTo>
                    <a:pt x="2299" y="1385"/>
                  </a:lnTo>
                  <a:lnTo>
                    <a:pt x="2300" y="1048"/>
                  </a:lnTo>
                  <a:lnTo>
                    <a:pt x="2301" y="846"/>
                  </a:lnTo>
                  <a:lnTo>
                    <a:pt x="2301" y="695"/>
                  </a:lnTo>
                  <a:lnTo>
                    <a:pt x="2302" y="605"/>
                  </a:lnTo>
                  <a:lnTo>
                    <a:pt x="2303" y="536"/>
                  </a:lnTo>
                  <a:lnTo>
                    <a:pt x="2304" y="496"/>
                  </a:lnTo>
                  <a:lnTo>
                    <a:pt x="2305" y="440"/>
                  </a:lnTo>
                  <a:lnTo>
                    <a:pt x="2306" y="400"/>
                  </a:lnTo>
                  <a:lnTo>
                    <a:pt x="2307" y="365"/>
                  </a:lnTo>
                  <a:lnTo>
                    <a:pt x="2308" y="345"/>
                  </a:lnTo>
                  <a:lnTo>
                    <a:pt x="2308" y="312"/>
                  </a:lnTo>
                  <a:lnTo>
                    <a:pt x="2309" y="297"/>
                  </a:lnTo>
                  <a:lnTo>
                    <a:pt x="2310" y="263"/>
                  </a:lnTo>
                  <a:lnTo>
                    <a:pt x="2311" y="253"/>
                  </a:lnTo>
                  <a:lnTo>
                    <a:pt x="2312" y="238"/>
                  </a:lnTo>
                  <a:lnTo>
                    <a:pt x="2313" y="224"/>
                  </a:lnTo>
                  <a:lnTo>
                    <a:pt x="2314" y="212"/>
                  </a:lnTo>
                  <a:lnTo>
                    <a:pt x="2315" y="198"/>
                  </a:lnTo>
                  <a:lnTo>
                    <a:pt x="2316" y="188"/>
                  </a:lnTo>
                  <a:lnTo>
                    <a:pt x="2316" y="188"/>
                  </a:lnTo>
                  <a:lnTo>
                    <a:pt x="2317" y="183"/>
                  </a:lnTo>
                  <a:lnTo>
                    <a:pt x="2318" y="182"/>
                  </a:lnTo>
                  <a:lnTo>
                    <a:pt x="2319" y="179"/>
                  </a:lnTo>
                  <a:lnTo>
                    <a:pt x="2320" y="165"/>
                  </a:lnTo>
                  <a:lnTo>
                    <a:pt x="2321" y="159"/>
                  </a:lnTo>
                  <a:lnTo>
                    <a:pt x="2322" y="162"/>
                  </a:lnTo>
                  <a:lnTo>
                    <a:pt x="2323" y="144"/>
                  </a:lnTo>
                  <a:lnTo>
                    <a:pt x="2323" y="133"/>
                  </a:lnTo>
                  <a:lnTo>
                    <a:pt x="2324" y="120"/>
                  </a:lnTo>
                  <a:lnTo>
                    <a:pt x="2325" y="124"/>
                  </a:lnTo>
                  <a:lnTo>
                    <a:pt x="2326" y="122"/>
                  </a:lnTo>
                  <a:lnTo>
                    <a:pt x="2327" y="121"/>
                  </a:lnTo>
                  <a:lnTo>
                    <a:pt x="2328" y="105"/>
                  </a:lnTo>
                  <a:lnTo>
                    <a:pt x="2329" y="108"/>
                  </a:lnTo>
                  <a:lnTo>
                    <a:pt x="2330" y="104"/>
                  </a:lnTo>
                  <a:lnTo>
                    <a:pt x="2331" y="100"/>
                  </a:lnTo>
                  <a:lnTo>
                    <a:pt x="2331" y="95"/>
                  </a:lnTo>
                  <a:lnTo>
                    <a:pt x="2332" y="95"/>
                  </a:lnTo>
                  <a:lnTo>
                    <a:pt x="2333" y="83"/>
                  </a:lnTo>
                  <a:lnTo>
                    <a:pt x="2334" y="93"/>
                  </a:lnTo>
                  <a:lnTo>
                    <a:pt x="2335" y="89"/>
                  </a:lnTo>
                  <a:lnTo>
                    <a:pt x="2336" y="85"/>
                  </a:lnTo>
                  <a:lnTo>
                    <a:pt x="2337" y="81"/>
                  </a:lnTo>
                  <a:lnTo>
                    <a:pt x="2338" y="78"/>
                  </a:lnTo>
                  <a:lnTo>
                    <a:pt x="2338" y="79"/>
                  </a:lnTo>
                  <a:lnTo>
                    <a:pt x="2339" y="75"/>
                  </a:lnTo>
                  <a:lnTo>
                    <a:pt x="2340" y="73"/>
                  </a:lnTo>
                  <a:lnTo>
                    <a:pt x="2341" y="71"/>
                  </a:lnTo>
                  <a:lnTo>
                    <a:pt x="2342" y="66"/>
                  </a:lnTo>
                  <a:lnTo>
                    <a:pt x="2343" y="66"/>
                  </a:lnTo>
                  <a:lnTo>
                    <a:pt x="2344" y="66"/>
                  </a:lnTo>
                  <a:lnTo>
                    <a:pt x="2345" y="65"/>
                  </a:lnTo>
                  <a:lnTo>
                    <a:pt x="2346" y="57"/>
                  </a:lnTo>
                  <a:lnTo>
                    <a:pt x="2346" y="63"/>
                  </a:lnTo>
                  <a:lnTo>
                    <a:pt x="2347" y="59"/>
                  </a:lnTo>
                  <a:lnTo>
                    <a:pt x="2348" y="55"/>
                  </a:lnTo>
                  <a:lnTo>
                    <a:pt x="2349" y="53"/>
                  </a:lnTo>
                  <a:lnTo>
                    <a:pt x="2350" y="52"/>
                  </a:lnTo>
                  <a:lnTo>
                    <a:pt x="2351" y="53"/>
                  </a:lnTo>
                  <a:lnTo>
                    <a:pt x="2352" y="53"/>
                  </a:lnTo>
                  <a:lnTo>
                    <a:pt x="2353" y="48"/>
                  </a:lnTo>
                  <a:lnTo>
                    <a:pt x="2353" y="47"/>
                  </a:lnTo>
                  <a:lnTo>
                    <a:pt x="2354" y="48"/>
                  </a:lnTo>
                  <a:lnTo>
                    <a:pt x="2355" y="48"/>
                  </a:lnTo>
                  <a:lnTo>
                    <a:pt x="2356" y="46"/>
                  </a:lnTo>
                  <a:lnTo>
                    <a:pt x="2357" y="45"/>
                  </a:lnTo>
                  <a:lnTo>
                    <a:pt x="2358" y="44"/>
                  </a:lnTo>
                  <a:lnTo>
                    <a:pt x="2359" y="46"/>
                  </a:lnTo>
                  <a:lnTo>
                    <a:pt x="2360" y="41"/>
                  </a:lnTo>
                  <a:lnTo>
                    <a:pt x="2361" y="42"/>
                  </a:lnTo>
                  <a:lnTo>
                    <a:pt x="2361" y="39"/>
                  </a:lnTo>
                  <a:lnTo>
                    <a:pt x="2362" y="39"/>
                  </a:lnTo>
                  <a:lnTo>
                    <a:pt x="2363" y="39"/>
                  </a:lnTo>
                  <a:lnTo>
                    <a:pt x="2364" y="38"/>
                  </a:lnTo>
                  <a:lnTo>
                    <a:pt x="2365" y="40"/>
                  </a:lnTo>
                  <a:lnTo>
                    <a:pt x="2366" y="40"/>
                  </a:lnTo>
                  <a:lnTo>
                    <a:pt x="2367" y="36"/>
                  </a:lnTo>
                  <a:lnTo>
                    <a:pt x="2368" y="43"/>
                  </a:lnTo>
                  <a:lnTo>
                    <a:pt x="2368" y="38"/>
                  </a:lnTo>
                  <a:lnTo>
                    <a:pt x="2369" y="42"/>
                  </a:lnTo>
                  <a:lnTo>
                    <a:pt x="2370" y="48"/>
                  </a:lnTo>
                  <a:lnTo>
                    <a:pt x="2371" y="45"/>
                  </a:lnTo>
                  <a:lnTo>
                    <a:pt x="2372" y="54"/>
                  </a:lnTo>
                  <a:lnTo>
                    <a:pt x="2373" y="45"/>
                  </a:lnTo>
                  <a:lnTo>
                    <a:pt x="2374" y="47"/>
                  </a:lnTo>
                  <a:lnTo>
                    <a:pt x="2375" y="47"/>
                  </a:lnTo>
                  <a:lnTo>
                    <a:pt x="2376" y="43"/>
                  </a:lnTo>
                  <a:lnTo>
                    <a:pt x="2376" y="41"/>
                  </a:lnTo>
                  <a:lnTo>
                    <a:pt x="2377" y="35"/>
                  </a:lnTo>
                  <a:lnTo>
                    <a:pt x="2378" y="33"/>
                  </a:lnTo>
                  <a:lnTo>
                    <a:pt x="2379" y="34"/>
                  </a:lnTo>
                  <a:lnTo>
                    <a:pt x="2380" y="34"/>
                  </a:lnTo>
                  <a:lnTo>
                    <a:pt x="2381" y="25"/>
                  </a:lnTo>
                  <a:lnTo>
                    <a:pt x="2382" y="28"/>
                  </a:lnTo>
                  <a:lnTo>
                    <a:pt x="2383" y="27"/>
                  </a:lnTo>
                  <a:lnTo>
                    <a:pt x="2383" y="25"/>
                  </a:lnTo>
                  <a:lnTo>
                    <a:pt x="2384" y="23"/>
                  </a:lnTo>
                  <a:lnTo>
                    <a:pt x="2385" y="24"/>
                  </a:lnTo>
                  <a:lnTo>
                    <a:pt x="2386" y="26"/>
                  </a:lnTo>
                  <a:lnTo>
                    <a:pt x="2387" y="22"/>
                  </a:lnTo>
                  <a:lnTo>
                    <a:pt x="2388" y="21"/>
                  </a:lnTo>
                  <a:lnTo>
                    <a:pt x="2389" y="23"/>
                  </a:lnTo>
                  <a:lnTo>
                    <a:pt x="2390" y="23"/>
                  </a:lnTo>
                  <a:lnTo>
                    <a:pt x="2391" y="29"/>
                  </a:lnTo>
                  <a:lnTo>
                    <a:pt x="2391" y="25"/>
                  </a:lnTo>
                  <a:lnTo>
                    <a:pt x="2392" y="29"/>
                  </a:lnTo>
                  <a:lnTo>
                    <a:pt x="2393" y="26"/>
                  </a:lnTo>
                  <a:lnTo>
                    <a:pt x="2394" y="28"/>
                  </a:lnTo>
                  <a:lnTo>
                    <a:pt x="2395" y="31"/>
                  </a:lnTo>
                  <a:lnTo>
                    <a:pt x="2396" y="34"/>
                  </a:lnTo>
                  <a:lnTo>
                    <a:pt x="2397" y="32"/>
                  </a:lnTo>
                  <a:lnTo>
                    <a:pt x="2398" y="35"/>
                  </a:lnTo>
                  <a:lnTo>
                    <a:pt x="2398" y="33"/>
                  </a:lnTo>
                  <a:lnTo>
                    <a:pt x="2399" y="33"/>
                  </a:lnTo>
                  <a:lnTo>
                    <a:pt x="2400" y="35"/>
                  </a:lnTo>
                  <a:lnTo>
                    <a:pt x="2401" y="28"/>
                  </a:lnTo>
                  <a:lnTo>
                    <a:pt x="2402" y="26"/>
                  </a:lnTo>
                  <a:lnTo>
                    <a:pt x="2403" y="25"/>
                  </a:lnTo>
                  <a:lnTo>
                    <a:pt x="2404" y="25"/>
                  </a:lnTo>
                  <a:lnTo>
                    <a:pt x="2405" y="26"/>
                  </a:lnTo>
                  <a:lnTo>
                    <a:pt x="2406" y="18"/>
                  </a:lnTo>
                  <a:lnTo>
                    <a:pt x="2406" y="18"/>
                  </a:lnTo>
                  <a:lnTo>
                    <a:pt x="2407" y="20"/>
                  </a:lnTo>
                  <a:lnTo>
                    <a:pt x="2408" y="19"/>
                  </a:lnTo>
                  <a:lnTo>
                    <a:pt x="2409" y="20"/>
                  </a:lnTo>
                  <a:lnTo>
                    <a:pt x="2410" y="18"/>
                  </a:lnTo>
                  <a:lnTo>
                    <a:pt x="2411" y="17"/>
                  </a:lnTo>
                  <a:lnTo>
                    <a:pt x="2412" y="17"/>
                  </a:lnTo>
                  <a:lnTo>
                    <a:pt x="2413" y="12"/>
                  </a:lnTo>
                  <a:lnTo>
                    <a:pt x="2413" y="16"/>
                  </a:lnTo>
                  <a:lnTo>
                    <a:pt x="2414" y="17"/>
                  </a:lnTo>
                  <a:lnTo>
                    <a:pt x="2415" y="17"/>
                  </a:lnTo>
                  <a:lnTo>
                    <a:pt x="2416" y="17"/>
                  </a:lnTo>
                  <a:lnTo>
                    <a:pt x="2417" y="17"/>
                  </a:lnTo>
                  <a:lnTo>
                    <a:pt x="2418" y="18"/>
                  </a:lnTo>
                  <a:lnTo>
                    <a:pt x="2419" y="17"/>
                  </a:lnTo>
                  <a:lnTo>
                    <a:pt x="2420" y="17"/>
                  </a:lnTo>
                  <a:lnTo>
                    <a:pt x="2421" y="18"/>
                  </a:lnTo>
                  <a:lnTo>
                    <a:pt x="2421" y="17"/>
                  </a:lnTo>
                  <a:lnTo>
                    <a:pt x="2422" y="21"/>
                  </a:lnTo>
                  <a:lnTo>
                    <a:pt x="2423" y="16"/>
                  </a:lnTo>
                  <a:lnTo>
                    <a:pt x="2424" y="20"/>
                  </a:lnTo>
                  <a:lnTo>
                    <a:pt x="2425" y="17"/>
                  </a:lnTo>
                  <a:lnTo>
                    <a:pt x="2426" y="16"/>
                  </a:lnTo>
                  <a:lnTo>
                    <a:pt x="2427" y="15"/>
                  </a:lnTo>
                  <a:lnTo>
                    <a:pt x="2428" y="14"/>
                  </a:lnTo>
                  <a:lnTo>
                    <a:pt x="2428" y="14"/>
                  </a:lnTo>
                  <a:lnTo>
                    <a:pt x="2429" y="16"/>
                  </a:lnTo>
                  <a:lnTo>
                    <a:pt x="2430" y="16"/>
                  </a:lnTo>
                  <a:lnTo>
                    <a:pt x="2431" y="14"/>
                  </a:lnTo>
                  <a:lnTo>
                    <a:pt x="2432" y="14"/>
                  </a:lnTo>
                  <a:lnTo>
                    <a:pt x="2433" y="15"/>
                  </a:lnTo>
                  <a:lnTo>
                    <a:pt x="2434" y="14"/>
                  </a:lnTo>
                  <a:lnTo>
                    <a:pt x="2435" y="10"/>
                  </a:lnTo>
                  <a:lnTo>
                    <a:pt x="2436" y="11"/>
                  </a:lnTo>
                  <a:lnTo>
                    <a:pt x="2436" y="13"/>
                  </a:lnTo>
                  <a:lnTo>
                    <a:pt x="2437" y="12"/>
                  </a:lnTo>
                  <a:lnTo>
                    <a:pt x="2438" y="10"/>
                  </a:lnTo>
                  <a:lnTo>
                    <a:pt x="2439" y="12"/>
                  </a:lnTo>
                  <a:lnTo>
                    <a:pt x="2440" y="11"/>
                  </a:lnTo>
                  <a:lnTo>
                    <a:pt x="2441" y="12"/>
                  </a:lnTo>
                  <a:lnTo>
                    <a:pt x="2442" y="8"/>
                  </a:lnTo>
                  <a:lnTo>
                    <a:pt x="2443" y="9"/>
                  </a:lnTo>
                  <a:lnTo>
                    <a:pt x="2443" y="9"/>
                  </a:lnTo>
                  <a:lnTo>
                    <a:pt x="2444" y="8"/>
                  </a:lnTo>
                  <a:lnTo>
                    <a:pt x="2445" y="8"/>
                  </a:lnTo>
                  <a:lnTo>
                    <a:pt x="2446" y="9"/>
                  </a:lnTo>
                  <a:lnTo>
                    <a:pt x="2447" y="7"/>
                  </a:lnTo>
                  <a:lnTo>
                    <a:pt x="2448" y="13"/>
                  </a:lnTo>
                  <a:lnTo>
                    <a:pt x="2449" y="11"/>
                  </a:lnTo>
                  <a:lnTo>
                    <a:pt x="2450" y="13"/>
                  </a:lnTo>
                  <a:lnTo>
                    <a:pt x="2451" y="11"/>
                  </a:lnTo>
                  <a:lnTo>
                    <a:pt x="2451" y="13"/>
                  </a:lnTo>
                  <a:lnTo>
                    <a:pt x="2452" y="15"/>
                  </a:lnTo>
                  <a:lnTo>
                    <a:pt x="2453" y="16"/>
                  </a:lnTo>
                  <a:lnTo>
                    <a:pt x="2454" y="20"/>
                  </a:lnTo>
                  <a:lnTo>
                    <a:pt x="2455" y="19"/>
                  </a:lnTo>
                  <a:lnTo>
                    <a:pt x="2456" y="22"/>
                  </a:lnTo>
                  <a:lnTo>
                    <a:pt x="2457" y="24"/>
                  </a:lnTo>
                  <a:lnTo>
                    <a:pt x="2458" y="26"/>
                  </a:lnTo>
                  <a:lnTo>
                    <a:pt x="2458" y="25"/>
                  </a:lnTo>
                  <a:lnTo>
                    <a:pt x="2459" y="25"/>
                  </a:lnTo>
                  <a:lnTo>
                    <a:pt x="2460" y="24"/>
                  </a:lnTo>
                  <a:lnTo>
                    <a:pt x="2461" y="24"/>
                  </a:lnTo>
                  <a:lnTo>
                    <a:pt x="2462" y="18"/>
                  </a:lnTo>
                  <a:lnTo>
                    <a:pt x="2463" y="19"/>
                  </a:lnTo>
                  <a:lnTo>
                    <a:pt x="2464" y="15"/>
                  </a:lnTo>
                  <a:lnTo>
                    <a:pt x="2465" y="14"/>
                  </a:lnTo>
                  <a:lnTo>
                    <a:pt x="2466" y="13"/>
                  </a:lnTo>
                  <a:lnTo>
                    <a:pt x="2466" y="14"/>
                  </a:lnTo>
                  <a:lnTo>
                    <a:pt x="2467" y="10"/>
                  </a:lnTo>
                  <a:lnTo>
                    <a:pt x="2468" y="13"/>
                  </a:lnTo>
                  <a:lnTo>
                    <a:pt x="2469" y="11"/>
                  </a:lnTo>
                  <a:lnTo>
                    <a:pt x="2470" y="12"/>
                  </a:lnTo>
                  <a:lnTo>
                    <a:pt x="2471" y="13"/>
                  </a:lnTo>
                  <a:lnTo>
                    <a:pt x="2472" y="13"/>
                  </a:lnTo>
                  <a:lnTo>
                    <a:pt x="2473" y="14"/>
                  </a:lnTo>
                  <a:lnTo>
                    <a:pt x="2473" y="13"/>
                  </a:lnTo>
                  <a:lnTo>
                    <a:pt x="2474" y="12"/>
                  </a:lnTo>
                  <a:lnTo>
                    <a:pt x="2475" y="11"/>
                  </a:lnTo>
                  <a:lnTo>
                    <a:pt x="2476" y="10"/>
                  </a:lnTo>
                  <a:lnTo>
                    <a:pt x="2477" y="8"/>
                  </a:lnTo>
                  <a:lnTo>
                    <a:pt x="2478" y="9"/>
                  </a:lnTo>
                  <a:lnTo>
                    <a:pt x="2479" y="10"/>
                  </a:lnTo>
                  <a:lnTo>
                    <a:pt x="2480" y="8"/>
                  </a:lnTo>
                  <a:lnTo>
                    <a:pt x="2480" y="6"/>
                  </a:lnTo>
                  <a:lnTo>
                    <a:pt x="2481" y="9"/>
                  </a:lnTo>
                  <a:lnTo>
                    <a:pt x="2482" y="6"/>
                  </a:lnTo>
                  <a:lnTo>
                    <a:pt x="2483" y="8"/>
                  </a:lnTo>
                  <a:lnTo>
                    <a:pt x="2484" y="6"/>
                  </a:lnTo>
                  <a:lnTo>
                    <a:pt x="2485" y="8"/>
                  </a:lnTo>
                  <a:lnTo>
                    <a:pt x="2486" y="6"/>
                  </a:lnTo>
                  <a:lnTo>
                    <a:pt x="2487" y="8"/>
                  </a:lnTo>
                  <a:lnTo>
                    <a:pt x="2488" y="11"/>
                  </a:lnTo>
                  <a:lnTo>
                    <a:pt x="2488" y="17"/>
                  </a:lnTo>
                  <a:lnTo>
                    <a:pt x="2489" y="24"/>
                  </a:lnTo>
                  <a:lnTo>
                    <a:pt x="2490" y="29"/>
                  </a:lnTo>
                  <a:lnTo>
                    <a:pt x="2491" y="58"/>
                  </a:lnTo>
                  <a:lnTo>
                    <a:pt x="2492" y="77"/>
                  </a:lnTo>
                  <a:lnTo>
                    <a:pt x="2493" y="104"/>
                  </a:lnTo>
                  <a:lnTo>
                    <a:pt x="2494" y="134"/>
                  </a:lnTo>
                  <a:lnTo>
                    <a:pt x="2495" y="165"/>
                  </a:lnTo>
                  <a:lnTo>
                    <a:pt x="2495" y="208"/>
                  </a:lnTo>
                  <a:lnTo>
                    <a:pt x="2496" y="226"/>
                  </a:lnTo>
                  <a:lnTo>
                    <a:pt x="2497" y="249"/>
                  </a:lnTo>
                  <a:lnTo>
                    <a:pt x="2498" y="261"/>
                  </a:lnTo>
                  <a:lnTo>
                    <a:pt x="2499" y="252"/>
                  </a:lnTo>
                  <a:lnTo>
                    <a:pt x="2500" y="224"/>
                  </a:lnTo>
                  <a:lnTo>
                    <a:pt x="2501" y="199"/>
                  </a:lnTo>
                  <a:lnTo>
                    <a:pt x="2502" y="163"/>
                  </a:lnTo>
                  <a:lnTo>
                    <a:pt x="2503" y="142"/>
                  </a:lnTo>
                  <a:lnTo>
                    <a:pt x="2503" y="118"/>
                  </a:lnTo>
                  <a:lnTo>
                    <a:pt x="2504" y="105"/>
                  </a:lnTo>
                  <a:lnTo>
                    <a:pt x="2505" y="88"/>
                  </a:lnTo>
                  <a:lnTo>
                    <a:pt x="2506" y="77"/>
                  </a:lnTo>
                  <a:lnTo>
                    <a:pt x="2507" y="68"/>
                  </a:lnTo>
                  <a:lnTo>
                    <a:pt x="2508" y="66"/>
                  </a:lnTo>
                  <a:lnTo>
                    <a:pt x="2509" y="62"/>
                  </a:lnTo>
                  <a:lnTo>
                    <a:pt x="2510" y="60"/>
                  </a:lnTo>
                  <a:lnTo>
                    <a:pt x="2510" y="51"/>
                  </a:lnTo>
                  <a:lnTo>
                    <a:pt x="2511" y="53"/>
                  </a:lnTo>
                  <a:lnTo>
                    <a:pt x="2512" y="48"/>
                  </a:lnTo>
                  <a:lnTo>
                    <a:pt x="2513" y="51"/>
                  </a:lnTo>
                  <a:lnTo>
                    <a:pt x="2514" y="44"/>
                  </a:lnTo>
                  <a:lnTo>
                    <a:pt x="2515" y="45"/>
                  </a:lnTo>
                  <a:lnTo>
                    <a:pt x="2516" y="43"/>
                  </a:lnTo>
                  <a:lnTo>
                    <a:pt x="2517" y="39"/>
                  </a:lnTo>
                  <a:lnTo>
                    <a:pt x="2518" y="37"/>
                  </a:lnTo>
                  <a:lnTo>
                    <a:pt x="2518" y="37"/>
                  </a:lnTo>
                  <a:lnTo>
                    <a:pt x="2519" y="31"/>
                  </a:lnTo>
                  <a:lnTo>
                    <a:pt x="2520" y="34"/>
                  </a:lnTo>
                  <a:lnTo>
                    <a:pt x="2521" y="31"/>
                  </a:lnTo>
                  <a:lnTo>
                    <a:pt x="2522" y="33"/>
                  </a:lnTo>
                  <a:lnTo>
                    <a:pt x="2523" y="33"/>
                  </a:lnTo>
                  <a:lnTo>
                    <a:pt x="2524" y="31"/>
                  </a:lnTo>
                  <a:lnTo>
                    <a:pt x="2525" y="33"/>
                  </a:lnTo>
                  <a:lnTo>
                    <a:pt x="2525" y="28"/>
                  </a:lnTo>
                  <a:lnTo>
                    <a:pt x="2526" y="29"/>
                  </a:lnTo>
                  <a:lnTo>
                    <a:pt x="2527" y="30"/>
                  </a:lnTo>
                  <a:lnTo>
                    <a:pt x="2528" y="27"/>
                  </a:lnTo>
                  <a:lnTo>
                    <a:pt x="2529" y="27"/>
                  </a:lnTo>
                  <a:lnTo>
                    <a:pt x="2530" y="26"/>
                  </a:lnTo>
                  <a:lnTo>
                    <a:pt x="2531" y="25"/>
                  </a:lnTo>
                  <a:lnTo>
                    <a:pt x="2532" y="24"/>
                  </a:lnTo>
                  <a:lnTo>
                    <a:pt x="2533" y="20"/>
                  </a:lnTo>
                  <a:lnTo>
                    <a:pt x="2533" y="24"/>
                  </a:lnTo>
                  <a:lnTo>
                    <a:pt x="2534" y="19"/>
                  </a:lnTo>
                  <a:lnTo>
                    <a:pt x="2535" y="19"/>
                  </a:lnTo>
                  <a:lnTo>
                    <a:pt x="2536" y="23"/>
                  </a:lnTo>
                  <a:lnTo>
                    <a:pt x="2537" y="20"/>
                  </a:lnTo>
                  <a:lnTo>
                    <a:pt x="2538" y="15"/>
                  </a:lnTo>
                  <a:lnTo>
                    <a:pt x="2539" y="18"/>
                  </a:lnTo>
                  <a:lnTo>
                    <a:pt x="2540" y="16"/>
                  </a:lnTo>
                  <a:lnTo>
                    <a:pt x="2540" y="16"/>
                  </a:lnTo>
                  <a:lnTo>
                    <a:pt x="2541" y="20"/>
                  </a:lnTo>
                  <a:lnTo>
                    <a:pt x="2542" y="17"/>
                  </a:lnTo>
                  <a:lnTo>
                    <a:pt x="2543" y="17"/>
                  </a:lnTo>
                  <a:lnTo>
                    <a:pt x="2544" y="18"/>
                  </a:lnTo>
                  <a:lnTo>
                    <a:pt x="2545" y="15"/>
                  </a:lnTo>
                  <a:lnTo>
                    <a:pt x="2546" y="13"/>
                  </a:lnTo>
                  <a:lnTo>
                    <a:pt x="2547" y="15"/>
                  </a:lnTo>
                  <a:lnTo>
                    <a:pt x="2548" y="12"/>
                  </a:lnTo>
                  <a:lnTo>
                    <a:pt x="2548" y="16"/>
                  </a:lnTo>
                  <a:lnTo>
                    <a:pt x="2549" y="15"/>
                  </a:lnTo>
                  <a:lnTo>
                    <a:pt x="2550" y="14"/>
                  </a:lnTo>
                  <a:lnTo>
                    <a:pt x="2551" y="12"/>
                  </a:lnTo>
                  <a:lnTo>
                    <a:pt x="2552" y="13"/>
                  </a:lnTo>
                  <a:lnTo>
                    <a:pt x="2553" y="14"/>
                  </a:lnTo>
                  <a:lnTo>
                    <a:pt x="2554" y="17"/>
                  </a:lnTo>
                  <a:lnTo>
                    <a:pt x="2555" y="11"/>
                  </a:lnTo>
                  <a:lnTo>
                    <a:pt x="2555" y="13"/>
                  </a:lnTo>
                  <a:lnTo>
                    <a:pt x="2556" y="15"/>
                  </a:lnTo>
                  <a:lnTo>
                    <a:pt x="2557" y="15"/>
                  </a:lnTo>
                  <a:lnTo>
                    <a:pt x="2558" y="17"/>
                  </a:lnTo>
                  <a:lnTo>
                    <a:pt x="2559" y="14"/>
                  </a:lnTo>
                  <a:lnTo>
                    <a:pt x="2560" y="10"/>
                  </a:lnTo>
                  <a:lnTo>
                    <a:pt x="2561" y="14"/>
                  </a:lnTo>
                  <a:lnTo>
                    <a:pt x="2562" y="10"/>
                  </a:lnTo>
                  <a:lnTo>
                    <a:pt x="2563" y="15"/>
                  </a:lnTo>
                  <a:lnTo>
                    <a:pt x="2563" y="12"/>
                  </a:lnTo>
                  <a:lnTo>
                    <a:pt x="2564" y="14"/>
                  </a:lnTo>
                  <a:lnTo>
                    <a:pt x="2565" y="13"/>
                  </a:lnTo>
                  <a:lnTo>
                    <a:pt x="2566" y="9"/>
                  </a:lnTo>
                  <a:lnTo>
                    <a:pt x="2567" y="11"/>
                  </a:lnTo>
                  <a:lnTo>
                    <a:pt x="2568" y="14"/>
                  </a:lnTo>
                  <a:lnTo>
                    <a:pt x="2569" y="13"/>
                  </a:lnTo>
                  <a:lnTo>
                    <a:pt x="2570" y="15"/>
                  </a:lnTo>
                  <a:lnTo>
                    <a:pt x="2570" y="10"/>
                  </a:lnTo>
                  <a:lnTo>
                    <a:pt x="2571" y="11"/>
                  </a:lnTo>
                  <a:lnTo>
                    <a:pt x="2572" y="10"/>
                  </a:lnTo>
                  <a:lnTo>
                    <a:pt x="2573" y="12"/>
                  </a:lnTo>
                  <a:lnTo>
                    <a:pt x="2574" y="13"/>
                  </a:lnTo>
                  <a:lnTo>
                    <a:pt x="2575" y="13"/>
                  </a:lnTo>
                  <a:lnTo>
                    <a:pt x="2576" y="10"/>
                  </a:lnTo>
                  <a:lnTo>
                    <a:pt x="2577" y="14"/>
                  </a:lnTo>
                  <a:lnTo>
                    <a:pt x="2578" y="11"/>
                  </a:lnTo>
                  <a:lnTo>
                    <a:pt x="2578" y="10"/>
                  </a:lnTo>
                  <a:lnTo>
                    <a:pt x="2579" y="12"/>
                  </a:lnTo>
                  <a:lnTo>
                    <a:pt x="2580" y="11"/>
                  </a:lnTo>
                  <a:lnTo>
                    <a:pt x="2581" y="9"/>
                  </a:lnTo>
                  <a:lnTo>
                    <a:pt x="2582" y="9"/>
                  </a:lnTo>
                  <a:lnTo>
                    <a:pt x="2583" y="11"/>
                  </a:lnTo>
                  <a:lnTo>
                    <a:pt x="2584" y="11"/>
                  </a:lnTo>
                  <a:lnTo>
                    <a:pt x="2585" y="7"/>
                  </a:lnTo>
                  <a:lnTo>
                    <a:pt x="2585" y="11"/>
                  </a:lnTo>
                  <a:lnTo>
                    <a:pt x="2586" y="10"/>
                  </a:lnTo>
                  <a:lnTo>
                    <a:pt x="2587" y="8"/>
                  </a:lnTo>
                  <a:lnTo>
                    <a:pt x="2588" y="11"/>
                  </a:lnTo>
                  <a:lnTo>
                    <a:pt x="2589" y="7"/>
                  </a:lnTo>
                  <a:lnTo>
                    <a:pt x="2590" y="9"/>
                  </a:lnTo>
                  <a:lnTo>
                    <a:pt x="2591" y="8"/>
                  </a:lnTo>
                  <a:lnTo>
                    <a:pt x="2592" y="8"/>
                  </a:lnTo>
                  <a:lnTo>
                    <a:pt x="2593" y="7"/>
                  </a:lnTo>
                  <a:lnTo>
                    <a:pt x="2593" y="9"/>
                  </a:lnTo>
                  <a:lnTo>
                    <a:pt x="2594" y="10"/>
                  </a:lnTo>
                  <a:lnTo>
                    <a:pt x="2595" y="8"/>
                  </a:lnTo>
                  <a:lnTo>
                    <a:pt x="2596" y="13"/>
                  </a:lnTo>
                  <a:lnTo>
                    <a:pt x="2597" y="10"/>
                  </a:lnTo>
                  <a:lnTo>
                    <a:pt x="2598" y="10"/>
                  </a:lnTo>
                  <a:lnTo>
                    <a:pt x="2599" y="10"/>
                  </a:lnTo>
                  <a:lnTo>
                    <a:pt x="2600" y="10"/>
                  </a:lnTo>
                  <a:lnTo>
                    <a:pt x="2600" y="8"/>
                  </a:lnTo>
                  <a:lnTo>
                    <a:pt x="2601" y="9"/>
                  </a:lnTo>
                  <a:lnTo>
                    <a:pt x="2602" y="7"/>
                  </a:lnTo>
                  <a:lnTo>
                    <a:pt x="2603" y="8"/>
                  </a:lnTo>
                  <a:lnTo>
                    <a:pt x="2604" y="8"/>
                  </a:lnTo>
                  <a:lnTo>
                    <a:pt x="2605" y="10"/>
                  </a:lnTo>
                  <a:lnTo>
                    <a:pt x="2606" y="10"/>
                  </a:lnTo>
                  <a:lnTo>
                    <a:pt x="2607" y="9"/>
                  </a:lnTo>
                  <a:lnTo>
                    <a:pt x="2608" y="7"/>
                  </a:lnTo>
                  <a:lnTo>
                    <a:pt x="2608" y="10"/>
                  </a:lnTo>
                  <a:lnTo>
                    <a:pt x="2609" y="7"/>
                  </a:lnTo>
                  <a:lnTo>
                    <a:pt x="2610" y="8"/>
                  </a:lnTo>
                  <a:lnTo>
                    <a:pt x="2611" y="7"/>
                  </a:lnTo>
                  <a:lnTo>
                    <a:pt x="2612" y="8"/>
                  </a:lnTo>
                  <a:lnTo>
                    <a:pt x="2613" y="9"/>
                  </a:lnTo>
                  <a:lnTo>
                    <a:pt x="2614" y="7"/>
                  </a:lnTo>
                  <a:lnTo>
                    <a:pt x="2615" y="10"/>
                  </a:lnTo>
                  <a:lnTo>
                    <a:pt x="2615" y="10"/>
                  </a:lnTo>
                  <a:lnTo>
                    <a:pt x="2616" y="6"/>
                  </a:lnTo>
                  <a:lnTo>
                    <a:pt x="2617" y="9"/>
                  </a:lnTo>
                  <a:lnTo>
                    <a:pt x="2618" y="8"/>
                  </a:lnTo>
                  <a:lnTo>
                    <a:pt x="2619" y="6"/>
                  </a:lnTo>
                  <a:lnTo>
                    <a:pt x="2620" y="9"/>
                  </a:lnTo>
                  <a:lnTo>
                    <a:pt x="2621" y="9"/>
                  </a:lnTo>
                  <a:lnTo>
                    <a:pt x="2622" y="6"/>
                  </a:lnTo>
                  <a:lnTo>
                    <a:pt x="2623" y="8"/>
                  </a:lnTo>
                  <a:lnTo>
                    <a:pt x="2623" y="7"/>
                  </a:lnTo>
                  <a:lnTo>
                    <a:pt x="2624" y="7"/>
                  </a:lnTo>
                  <a:lnTo>
                    <a:pt x="2625" y="6"/>
                  </a:lnTo>
                  <a:lnTo>
                    <a:pt x="2626" y="8"/>
                  </a:lnTo>
                  <a:lnTo>
                    <a:pt x="2627" y="7"/>
                  </a:lnTo>
                  <a:lnTo>
                    <a:pt x="2628" y="5"/>
                  </a:lnTo>
                  <a:lnTo>
                    <a:pt x="2629" y="9"/>
                  </a:lnTo>
                  <a:lnTo>
                    <a:pt x="2630" y="6"/>
                  </a:lnTo>
                  <a:lnTo>
                    <a:pt x="2630" y="5"/>
                  </a:lnTo>
                  <a:lnTo>
                    <a:pt x="2631" y="5"/>
                  </a:lnTo>
                  <a:lnTo>
                    <a:pt x="2632" y="5"/>
                  </a:lnTo>
                  <a:lnTo>
                    <a:pt x="2633" y="5"/>
                  </a:lnTo>
                  <a:lnTo>
                    <a:pt x="2634" y="9"/>
                  </a:lnTo>
                  <a:lnTo>
                    <a:pt x="2635" y="10"/>
                  </a:lnTo>
                  <a:lnTo>
                    <a:pt x="2636" y="10"/>
                  </a:lnTo>
                  <a:lnTo>
                    <a:pt x="2637" y="7"/>
                  </a:lnTo>
                  <a:lnTo>
                    <a:pt x="2638" y="11"/>
                  </a:lnTo>
                  <a:lnTo>
                    <a:pt x="2638" y="5"/>
                  </a:lnTo>
                  <a:lnTo>
                    <a:pt x="2639" y="11"/>
                  </a:lnTo>
                  <a:lnTo>
                    <a:pt x="2640" y="7"/>
                  </a:lnTo>
                  <a:lnTo>
                    <a:pt x="2641" y="8"/>
                  </a:lnTo>
                  <a:lnTo>
                    <a:pt x="2642" y="7"/>
                  </a:lnTo>
                  <a:lnTo>
                    <a:pt x="2643" y="6"/>
                  </a:lnTo>
                  <a:lnTo>
                    <a:pt x="2644" y="8"/>
                  </a:lnTo>
                  <a:lnTo>
                    <a:pt x="2645" y="6"/>
                  </a:lnTo>
                  <a:lnTo>
                    <a:pt x="2645" y="8"/>
                  </a:lnTo>
                  <a:lnTo>
                    <a:pt x="2646" y="7"/>
                  </a:lnTo>
                  <a:lnTo>
                    <a:pt x="2647" y="7"/>
                  </a:lnTo>
                  <a:lnTo>
                    <a:pt x="2648" y="6"/>
                  </a:lnTo>
                  <a:lnTo>
                    <a:pt x="2649" y="5"/>
                  </a:lnTo>
                  <a:lnTo>
                    <a:pt x="2650" y="5"/>
                  </a:lnTo>
                  <a:lnTo>
                    <a:pt x="2651" y="9"/>
                  </a:lnTo>
                  <a:lnTo>
                    <a:pt x="2652" y="6"/>
                  </a:lnTo>
                  <a:lnTo>
                    <a:pt x="2653" y="3"/>
                  </a:lnTo>
                  <a:lnTo>
                    <a:pt x="2653" y="5"/>
                  </a:lnTo>
                  <a:lnTo>
                    <a:pt x="2654" y="5"/>
                  </a:lnTo>
                  <a:lnTo>
                    <a:pt x="2655" y="5"/>
                  </a:lnTo>
                  <a:lnTo>
                    <a:pt x="2656" y="6"/>
                  </a:lnTo>
                  <a:lnTo>
                    <a:pt x="2657" y="5"/>
                  </a:lnTo>
                  <a:lnTo>
                    <a:pt x="2658" y="4"/>
                  </a:lnTo>
                  <a:lnTo>
                    <a:pt x="2659" y="7"/>
                  </a:lnTo>
                  <a:lnTo>
                    <a:pt x="2660" y="6"/>
                  </a:lnTo>
                  <a:lnTo>
                    <a:pt x="2660" y="4"/>
                  </a:lnTo>
                  <a:lnTo>
                    <a:pt x="2661" y="3"/>
                  </a:lnTo>
                  <a:lnTo>
                    <a:pt x="2662" y="4"/>
                  </a:lnTo>
                  <a:lnTo>
                    <a:pt x="2663" y="2"/>
                  </a:lnTo>
                  <a:lnTo>
                    <a:pt x="2664" y="2"/>
                  </a:lnTo>
                  <a:lnTo>
                    <a:pt x="2665" y="4"/>
                  </a:lnTo>
                  <a:lnTo>
                    <a:pt x="2666" y="5"/>
                  </a:lnTo>
                  <a:lnTo>
                    <a:pt x="2667" y="7"/>
                  </a:lnTo>
                  <a:lnTo>
                    <a:pt x="2668" y="5"/>
                  </a:lnTo>
                  <a:lnTo>
                    <a:pt x="2668" y="5"/>
                  </a:lnTo>
                  <a:lnTo>
                    <a:pt x="2669" y="2"/>
                  </a:lnTo>
                  <a:lnTo>
                    <a:pt x="2670" y="5"/>
                  </a:lnTo>
                  <a:lnTo>
                    <a:pt x="2671" y="4"/>
                  </a:lnTo>
                  <a:lnTo>
                    <a:pt x="2672" y="6"/>
                  </a:lnTo>
                  <a:lnTo>
                    <a:pt x="2673" y="5"/>
                  </a:lnTo>
                  <a:lnTo>
                    <a:pt x="2674" y="4"/>
                  </a:lnTo>
                  <a:lnTo>
                    <a:pt x="2675" y="5"/>
                  </a:lnTo>
                  <a:lnTo>
                    <a:pt x="2675" y="5"/>
                  </a:lnTo>
                  <a:lnTo>
                    <a:pt x="2676" y="4"/>
                  </a:lnTo>
                  <a:lnTo>
                    <a:pt x="2677" y="3"/>
                  </a:lnTo>
                  <a:lnTo>
                    <a:pt x="2678" y="2"/>
                  </a:lnTo>
                  <a:lnTo>
                    <a:pt x="2679" y="3"/>
                  </a:lnTo>
                  <a:lnTo>
                    <a:pt x="2680" y="5"/>
                  </a:lnTo>
                  <a:lnTo>
                    <a:pt x="2681" y="7"/>
                  </a:lnTo>
                  <a:lnTo>
                    <a:pt x="2682" y="6"/>
                  </a:lnTo>
                  <a:lnTo>
                    <a:pt x="2682" y="3"/>
                  </a:lnTo>
                  <a:lnTo>
                    <a:pt x="2683" y="3"/>
                  </a:lnTo>
                  <a:lnTo>
                    <a:pt x="2684" y="4"/>
                  </a:lnTo>
                  <a:lnTo>
                    <a:pt x="2685" y="3"/>
                  </a:lnTo>
                  <a:lnTo>
                    <a:pt x="2686" y="4"/>
                  </a:lnTo>
                  <a:lnTo>
                    <a:pt x="2687" y="3"/>
                  </a:lnTo>
                  <a:lnTo>
                    <a:pt x="2688" y="5"/>
                  </a:lnTo>
                  <a:lnTo>
                    <a:pt x="2689" y="6"/>
                  </a:lnTo>
                  <a:lnTo>
                    <a:pt x="2690" y="5"/>
                  </a:lnTo>
                  <a:lnTo>
                    <a:pt x="2690" y="2"/>
                  </a:lnTo>
                  <a:lnTo>
                    <a:pt x="2691" y="3"/>
                  </a:lnTo>
                  <a:lnTo>
                    <a:pt x="2692" y="5"/>
                  </a:lnTo>
                  <a:lnTo>
                    <a:pt x="2693" y="4"/>
                  </a:lnTo>
                  <a:lnTo>
                    <a:pt x="2694" y="7"/>
                  </a:lnTo>
                  <a:lnTo>
                    <a:pt x="2695" y="2"/>
                  </a:lnTo>
                  <a:lnTo>
                    <a:pt x="2696" y="2"/>
                  </a:lnTo>
                  <a:lnTo>
                    <a:pt x="2697" y="3"/>
                  </a:lnTo>
                  <a:lnTo>
                    <a:pt x="2697" y="4"/>
                  </a:lnTo>
                  <a:lnTo>
                    <a:pt x="2698" y="3"/>
                  </a:lnTo>
                  <a:lnTo>
                    <a:pt x="2699" y="3"/>
                  </a:lnTo>
                  <a:lnTo>
                    <a:pt x="2700" y="4"/>
                  </a:lnTo>
                  <a:lnTo>
                    <a:pt x="2701" y="2"/>
                  </a:lnTo>
                  <a:lnTo>
                    <a:pt x="2702" y="4"/>
                  </a:lnTo>
                  <a:lnTo>
                    <a:pt x="2703" y="5"/>
                  </a:lnTo>
                  <a:lnTo>
                    <a:pt x="2704" y="4"/>
                  </a:lnTo>
                  <a:lnTo>
                    <a:pt x="2705" y="9"/>
                  </a:lnTo>
                  <a:lnTo>
                    <a:pt x="2705" y="8"/>
                  </a:lnTo>
                  <a:lnTo>
                    <a:pt x="2706" y="7"/>
                  </a:lnTo>
                  <a:lnTo>
                    <a:pt x="2707" y="5"/>
                  </a:lnTo>
                  <a:lnTo>
                    <a:pt x="2708" y="6"/>
                  </a:lnTo>
                  <a:lnTo>
                    <a:pt x="2709" y="7"/>
                  </a:lnTo>
                  <a:lnTo>
                    <a:pt x="2710" y="6"/>
                  </a:lnTo>
                  <a:lnTo>
                    <a:pt x="2711" y="4"/>
                  </a:lnTo>
                  <a:lnTo>
                    <a:pt x="2712" y="3"/>
                  </a:lnTo>
                  <a:lnTo>
                    <a:pt x="2712" y="4"/>
                  </a:lnTo>
                  <a:lnTo>
                    <a:pt x="2713" y="6"/>
                  </a:lnTo>
                  <a:lnTo>
                    <a:pt x="2714" y="3"/>
                  </a:lnTo>
                  <a:lnTo>
                    <a:pt x="2715" y="4"/>
                  </a:lnTo>
                  <a:lnTo>
                    <a:pt x="2716" y="4"/>
                  </a:lnTo>
                  <a:lnTo>
                    <a:pt x="2717" y="2"/>
                  </a:lnTo>
                  <a:lnTo>
                    <a:pt x="2718" y="5"/>
                  </a:lnTo>
                  <a:lnTo>
                    <a:pt x="2719" y="2"/>
                  </a:lnTo>
                  <a:lnTo>
                    <a:pt x="2720" y="4"/>
                  </a:lnTo>
                  <a:lnTo>
                    <a:pt x="2720" y="3"/>
                  </a:lnTo>
                  <a:lnTo>
                    <a:pt x="2721" y="4"/>
                  </a:lnTo>
                  <a:lnTo>
                    <a:pt x="2722" y="2"/>
                  </a:lnTo>
                  <a:lnTo>
                    <a:pt x="2723" y="5"/>
                  </a:lnTo>
                  <a:lnTo>
                    <a:pt x="2724" y="5"/>
                  </a:lnTo>
                  <a:lnTo>
                    <a:pt x="2725" y="6"/>
                  </a:lnTo>
                  <a:lnTo>
                    <a:pt x="2726" y="3"/>
                  </a:lnTo>
                  <a:lnTo>
                    <a:pt x="2727" y="4"/>
                  </a:lnTo>
                  <a:lnTo>
                    <a:pt x="2727" y="4"/>
                  </a:lnTo>
                  <a:lnTo>
                    <a:pt x="2728" y="2"/>
                  </a:lnTo>
                  <a:lnTo>
                    <a:pt x="2729" y="3"/>
                  </a:lnTo>
                  <a:lnTo>
                    <a:pt x="2730" y="5"/>
                  </a:lnTo>
                  <a:lnTo>
                    <a:pt x="2731" y="4"/>
                  </a:lnTo>
                  <a:lnTo>
                    <a:pt x="2732" y="3"/>
                  </a:lnTo>
                  <a:lnTo>
                    <a:pt x="2733" y="4"/>
                  </a:lnTo>
                  <a:lnTo>
                    <a:pt x="2734" y="3"/>
                  </a:lnTo>
                  <a:lnTo>
                    <a:pt x="2735" y="4"/>
                  </a:lnTo>
                  <a:lnTo>
                    <a:pt x="2735" y="5"/>
                  </a:lnTo>
                  <a:lnTo>
                    <a:pt x="2736" y="4"/>
                  </a:lnTo>
                  <a:lnTo>
                    <a:pt x="2737" y="2"/>
                  </a:lnTo>
                  <a:lnTo>
                    <a:pt x="2738" y="4"/>
                  </a:lnTo>
                  <a:lnTo>
                    <a:pt x="2739" y="4"/>
                  </a:lnTo>
                  <a:lnTo>
                    <a:pt x="2740" y="4"/>
                  </a:lnTo>
                  <a:lnTo>
                    <a:pt x="2741" y="3"/>
                  </a:lnTo>
                  <a:lnTo>
                    <a:pt x="2742" y="8"/>
                  </a:lnTo>
                  <a:lnTo>
                    <a:pt x="2742" y="8"/>
                  </a:lnTo>
                  <a:lnTo>
                    <a:pt x="2743" y="5"/>
                  </a:lnTo>
                  <a:lnTo>
                    <a:pt x="2744" y="8"/>
                  </a:lnTo>
                  <a:lnTo>
                    <a:pt x="2745" y="9"/>
                  </a:lnTo>
                  <a:lnTo>
                    <a:pt x="2746" y="10"/>
                  </a:lnTo>
                  <a:lnTo>
                    <a:pt x="2747" y="12"/>
                  </a:lnTo>
                  <a:lnTo>
                    <a:pt x="2748" y="14"/>
                  </a:lnTo>
                  <a:lnTo>
                    <a:pt x="2749" y="11"/>
                  </a:lnTo>
                  <a:lnTo>
                    <a:pt x="2750" y="9"/>
                  </a:lnTo>
                  <a:lnTo>
                    <a:pt x="2750" y="8"/>
                  </a:lnTo>
                  <a:lnTo>
                    <a:pt x="2751" y="9"/>
                  </a:lnTo>
                  <a:lnTo>
                    <a:pt x="2752" y="6"/>
                  </a:lnTo>
                  <a:lnTo>
                    <a:pt x="2753" y="7"/>
                  </a:lnTo>
                  <a:lnTo>
                    <a:pt x="2754" y="6"/>
                  </a:lnTo>
                  <a:lnTo>
                    <a:pt x="2755" y="6"/>
                  </a:lnTo>
                  <a:lnTo>
                    <a:pt x="2756" y="5"/>
                  </a:lnTo>
                  <a:lnTo>
                    <a:pt x="2757" y="5"/>
                  </a:lnTo>
                  <a:lnTo>
                    <a:pt x="2757" y="4"/>
                  </a:lnTo>
                  <a:lnTo>
                    <a:pt x="2758" y="5"/>
                  </a:lnTo>
                  <a:lnTo>
                    <a:pt x="2759" y="4"/>
                  </a:lnTo>
                  <a:lnTo>
                    <a:pt x="2760" y="6"/>
                  </a:lnTo>
                  <a:lnTo>
                    <a:pt x="2761" y="5"/>
                  </a:lnTo>
                  <a:lnTo>
                    <a:pt x="2762" y="5"/>
                  </a:lnTo>
                  <a:lnTo>
                    <a:pt x="2763" y="6"/>
                  </a:lnTo>
                  <a:lnTo>
                    <a:pt x="2764" y="10"/>
                  </a:lnTo>
                  <a:lnTo>
                    <a:pt x="2765" y="9"/>
                  </a:lnTo>
                  <a:lnTo>
                    <a:pt x="2765" y="8"/>
                  </a:lnTo>
                  <a:lnTo>
                    <a:pt x="2766" y="12"/>
                  </a:lnTo>
                  <a:lnTo>
                    <a:pt x="2767" y="10"/>
                  </a:lnTo>
                  <a:lnTo>
                    <a:pt x="2768" y="11"/>
                  </a:lnTo>
                  <a:lnTo>
                    <a:pt x="2769" y="13"/>
                  </a:lnTo>
                  <a:lnTo>
                    <a:pt x="2770" y="11"/>
                  </a:lnTo>
                  <a:lnTo>
                    <a:pt x="2771" y="12"/>
                  </a:lnTo>
                  <a:lnTo>
                    <a:pt x="2772" y="10"/>
                  </a:lnTo>
                  <a:lnTo>
                    <a:pt x="2772" y="7"/>
                  </a:lnTo>
                  <a:lnTo>
                    <a:pt x="2773" y="8"/>
                  </a:lnTo>
                  <a:lnTo>
                    <a:pt x="2774" y="8"/>
                  </a:lnTo>
                  <a:lnTo>
                    <a:pt x="2775" y="7"/>
                  </a:lnTo>
                  <a:lnTo>
                    <a:pt x="2776" y="4"/>
                  </a:lnTo>
                  <a:lnTo>
                    <a:pt x="2777" y="6"/>
                  </a:lnTo>
                  <a:lnTo>
                    <a:pt x="2778" y="6"/>
                  </a:lnTo>
                  <a:lnTo>
                    <a:pt x="2779" y="4"/>
                  </a:lnTo>
                  <a:lnTo>
                    <a:pt x="2780" y="6"/>
                  </a:lnTo>
                  <a:lnTo>
                    <a:pt x="2780" y="3"/>
                  </a:lnTo>
                  <a:lnTo>
                    <a:pt x="2781" y="6"/>
                  </a:lnTo>
                  <a:lnTo>
                    <a:pt x="2782" y="8"/>
                  </a:lnTo>
                  <a:lnTo>
                    <a:pt x="2783" y="5"/>
                  </a:lnTo>
                  <a:lnTo>
                    <a:pt x="2784" y="5"/>
                  </a:lnTo>
                  <a:lnTo>
                    <a:pt x="2785" y="5"/>
                  </a:lnTo>
                  <a:lnTo>
                    <a:pt x="2786" y="3"/>
                  </a:lnTo>
                  <a:lnTo>
                    <a:pt x="2787" y="6"/>
                  </a:lnTo>
                  <a:lnTo>
                    <a:pt x="2787" y="7"/>
                  </a:lnTo>
                  <a:lnTo>
                    <a:pt x="2788" y="5"/>
                  </a:lnTo>
                  <a:lnTo>
                    <a:pt x="2789" y="7"/>
                  </a:lnTo>
                  <a:lnTo>
                    <a:pt x="2790" y="6"/>
                  </a:lnTo>
                  <a:lnTo>
                    <a:pt x="2791" y="7"/>
                  </a:lnTo>
                  <a:lnTo>
                    <a:pt x="2792" y="5"/>
                  </a:lnTo>
                  <a:lnTo>
                    <a:pt x="2793" y="5"/>
                  </a:lnTo>
                  <a:lnTo>
                    <a:pt x="2794" y="5"/>
                  </a:lnTo>
                  <a:lnTo>
                    <a:pt x="2795" y="3"/>
                  </a:lnTo>
                  <a:lnTo>
                    <a:pt x="2795" y="1"/>
                  </a:lnTo>
                  <a:lnTo>
                    <a:pt x="2796" y="4"/>
                  </a:lnTo>
                  <a:lnTo>
                    <a:pt x="2797" y="2"/>
                  </a:lnTo>
                  <a:lnTo>
                    <a:pt x="2798" y="4"/>
                  </a:lnTo>
                  <a:lnTo>
                    <a:pt x="2799" y="5"/>
                  </a:lnTo>
                  <a:lnTo>
                    <a:pt x="2800" y="3"/>
                  </a:lnTo>
                  <a:lnTo>
                    <a:pt x="2801" y="4"/>
                  </a:lnTo>
                  <a:lnTo>
                    <a:pt x="2802" y="3"/>
                  </a:lnTo>
                  <a:lnTo>
                    <a:pt x="2802" y="2"/>
                  </a:lnTo>
                  <a:lnTo>
                    <a:pt x="2803" y="3"/>
                  </a:lnTo>
                  <a:lnTo>
                    <a:pt x="2804" y="3"/>
                  </a:lnTo>
                  <a:lnTo>
                    <a:pt x="2805" y="6"/>
                  </a:lnTo>
                  <a:lnTo>
                    <a:pt x="2806" y="3"/>
                  </a:lnTo>
                  <a:lnTo>
                    <a:pt x="2807" y="3"/>
                  </a:lnTo>
                  <a:lnTo>
                    <a:pt x="2808" y="3"/>
                  </a:lnTo>
                  <a:lnTo>
                    <a:pt x="2809" y="2"/>
                  </a:lnTo>
                  <a:lnTo>
                    <a:pt x="2810" y="4"/>
                  </a:lnTo>
                  <a:lnTo>
                    <a:pt x="2810" y="0"/>
                  </a:lnTo>
                  <a:lnTo>
                    <a:pt x="2811" y="3"/>
                  </a:lnTo>
                  <a:lnTo>
                    <a:pt x="2812" y="4"/>
                  </a:lnTo>
                  <a:lnTo>
                    <a:pt x="2813" y="4"/>
                  </a:lnTo>
                  <a:lnTo>
                    <a:pt x="2814" y="3"/>
                  </a:lnTo>
                  <a:lnTo>
                    <a:pt x="2815" y="5"/>
                  </a:lnTo>
                  <a:lnTo>
                    <a:pt x="2816" y="3"/>
                  </a:lnTo>
                  <a:lnTo>
                    <a:pt x="2817" y="1"/>
                  </a:lnTo>
                  <a:lnTo>
                    <a:pt x="2817" y="3"/>
                  </a:lnTo>
                  <a:lnTo>
                    <a:pt x="2818" y="2"/>
                  </a:lnTo>
                  <a:lnTo>
                    <a:pt x="2819" y="4"/>
                  </a:lnTo>
                  <a:lnTo>
                    <a:pt x="2820" y="5"/>
                  </a:lnTo>
                  <a:lnTo>
                    <a:pt x="2821" y="5"/>
                  </a:lnTo>
                  <a:lnTo>
                    <a:pt x="2822" y="4"/>
                  </a:lnTo>
                  <a:lnTo>
                    <a:pt x="2823" y="3"/>
                  </a:lnTo>
                  <a:lnTo>
                    <a:pt x="2824" y="6"/>
                  </a:lnTo>
                  <a:lnTo>
                    <a:pt x="2825" y="3"/>
                  </a:lnTo>
                  <a:lnTo>
                    <a:pt x="2825" y="7"/>
                  </a:lnTo>
                  <a:lnTo>
                    <a:pt x="2826" y="6"/>
                  </a:lnTo>
                  <a:lnTo>
                    <a:pt x="2827" y="6"/>
                  </a:lnTo>
                  <a:lnTo>
                    <a:pt x="2828" y="5"/>
                  </a:lnTo>
                  <a:lnTo>
                    <a:pt x="2829" y="8"/>
                  </a:lnTo>
                  <a:lnTo>
                    <a:pt x="2830" y="6"/>
                  </a:lnTo>
                  <a:lnTo>
                    <a:pt x="2831" y="9"/>
                  </a:lnTo>
                  <a:lnTo>
                    <a:pt x="2832" y="6"/>
                  </a:lnTo>
                  <a:lnTo>
                    <a:pt x="2832" y="7"/>
                  </a:lnTo>
                  <a:lnTo>
                    <a:pt x="2833" y="7"/>
                  </a:lnTo>
                  <a:lnTo>
                    <a:pt x="2834" y="7"/>
                  </a:lnTo>
                  <a:lnTo>
                    <a:pt x="2835" y="4"/>
                  </a:lnTo>
                  <a:lnTo>
                    <a:pt x="2836" y="5"/>
                  </a:lnTo>
                  <a:lnTo>
                    <a:pt x="2837" y="5"/>
                  </a:lnTo>
                  <a:lnTo>
                    <a:pt x="2838" y="2"/>
                  </a:lnTo>
                  <a:lnTo>
                    <a:pt x="2839" y="7"/>
                  </a:lnTo>
                  <a:lnTo>
                    <a:pt x="2840" y="4"/>
                  </a:lnTo>
                  <a:lnTo>
                    <a:pt x="2840" y="4"/>
                  </a:lnTo>
                  <a:lnTo>
                    <a:pt x="2841" y="4"/>
                  </a:lnTo>
                  <a:lnTo>
                    <a:pt x="2842" y="4"/>
                  </a:lnTo>
                  <a:lnTo>
                    <a:pt x="2843" y="7"/>
                  </a:lnTo>
                  <a:lnTo>
                    <a:pt x="2844" y="2"/>
                  </a:lnTo>
                  <a:lnTo>
                    <a:pt x="2845" y="6"/>
                  </a:lnTo>
                  <a:lnTo>
                    <a:pt x="2846" y="5"/>
                  </a:lnTo>
                  <a:lnTo>
                    <a:pt x="2847" y="5"/>
                  </a:lnTo>
                  <a:lnTo>
                    <a:pt x="2847" y="2"/>
                  </a:lnTo>
                  <a:lnTo>
                    <a:pt x="2848" y="4"/>
                  </a:lnTo>
                  <a:lnTo>
                    <a:pt x="2849" y="3"/>
                  </a:lnTo>
                  <a:lnTo>
                    <a:pt x="2850" y="4"/>
                  </a:lnTo>
                  <a:lnTo>
                    <a:pt x="2851" y="4"/>
                  </a:lnTo>
                  <a:lnTo>
                    <a:pt x="2852" y="3"/>
                  </a:lnTo>
                  <a:lnTo>
                    <a:pt x="2853" y="4"/>
                  </a:lnTo>
                  <a:lnTo>
                    <a:pt x="2854" y="5"/>
                  </a:lnTo>
                  <a:lnTo>
                    <a:pt x="2855" y="5"/>
                  </a:lnTo>
                  <a:lnTo>
                    <a:pt x="2855" y="4"/>
                  </a:lnTo>
                  <a:lnTo>
                    <a:pt x="2856" y="2"/>
                  </a:lnTo>
                  <a:lnTo>
                    <a:pt x="2857" y="7"/>
                  </a:lnTo>
                  <a:lnTo>
                    <a:pt x="2858" y="5"/>
                  </a:lnTo>
                  <a:lnTo>
                    <a:pt x="2859" y="7"/>
                  </a:lnTo>
                  <a:lnTo>
                    <a:pt x="2860" y="5"/>
                  </a:lnTo>
                  <a:lnTo>
                    <a:pt x="2861" y="6"/>
                  </a:lnTo>
                  <a:lnTo>
                    <a:pt x="2862" y="6"/>
                  </a:lnTo>
                  <a:lnTo>
                    <a:pt x="2862" y="5"/>
                  </a:lnTo>
                  <a:lnTo>
                    <a:pt x="2863" y="4"/>
                  </a:lnTo>
                  <a:lnTo>
                    <a:pt x="2864" y="4"/>
                  </a:lnTo>
                  <a:lnTo>
                    <a:pt x="2865" y="5"/>
                  </a:lnTo>
                  <a:lnTo>
                    <a:pt x="2866" y="3"/>
                  </a:lnTo>
                  <a:lnTo>
                    <a:pt x="2867" y="3"/>
                  </a:lnTo>
                  <a:lnTo>
                    <a:pt x="2868" y="5"/>
                  </a:lnTo>
                  <a:lnTo>
                    <a:pt x="2869" y="4"/>
                  </a:lnTo>
                  <a:lnTo>
                    <a:pt x="2869" y="3"/>
                  </a:lnTo>
                  <a:lnTo>
                    <a:pt x="2870" y="2"/>
                  </a:lnTo>
                  <a:lnTo>
                    <a:pt x="2871" y="4"/>
                  </a:lnTo>
                  <a:lnTo>
                    <a:pt x="2872" y="2"/>
                  </a:lnTo>
                  <a:lnTo>
                    <a:pt x="2873" y="3"/>
                  </a:lnTo>
                  <a:lnTo>
                    <a:pt x="2874" y="5"/>
                  </a:lnTo>
                  <a:lnTo>
                    <a:pt x="2875" y="3"/>
                  </a:lnTo>
                  <a:lnTo>
                    <a:pt x="2876" y="3"/>
                  </a:lnTo>
                  <a:lnTo>
                    <a:pt x="2877" y="2"/>
                  </a:lnTo>
                  <a:lnTo>
                    <a:pt x="2877" y="4"/>
                  </a:lnTo>
                  <a:lnTo>
                    <a:pt x="2878" y="3"/>
                  </a:lnTo>
                  <a:lnTo>
                    <a:pt x="2879" y="3"/>
                  </a:lnTo>
                  <a:lnTo>
                    <a:pt x="2880" y="4"/>
                  </a:lnTo>
                  <a:lnTo>
                    <a:pt x="2881" y="2"/>
                  </a:lnTo>
                  <a:lnTo>
                    <a:pt x="2882" y="1"/>
                  </a:lnTo>
                  <a:lnTo>
                    <a:pt x="2883" y="4"/>
                  </a:lnTo>
                  <a:lnTo>
                    <a:pt x="2884" y="3"/>
                  </a:lnTo>
                  <a:lnTo>
                    <a:pt x="2884" y="1"/>
                  </a:lnTo>
                  <a:lnTo>
                    <a:pt x="2885" y="2"/>
                  </a:lnTo>
                  <a:lnTo>
                    <a:pt x="2886" y="1"/>
                  </a:lnTo>
                  <a:lnTo>
                    <a:pt x="2887" y="1"/>
                  </a:lnTo>
                  <a:lnTo>
                    <a:pt x="2888" y="1"/>
                  </a:lnTo>
                  <a:lnTo>
                    <a:pt x="2889" y="3"/>
                  </a:lnTo>
                  <a:lnTo>
                    <a:pt x="2890" y="4"/>
                  </a:lnTo>
                  <a:lnTo>
                    <a:pt x="2891" y="3"/>
                  </a:lnTo>
                  <a:lnTo>
                    <a:pt x="2892" y="3"/>
                  </a:lnTo>
                  <a:lnTo>
                    <a:pt x="2892" y="2"/>
                  </a:lnTo>
                  <a:lnTo>
                    <a:pt x="2893" y="2"/>
                  </a:lnTo>
                  <a:lnTo>
                    <a:pt x="2894" y="3"/>
                  </a:lnTo>
                  <a:lnTo>
                    <a:pt x="2895" y="3"/>
                  </a:lnTo>
                  <a:lnTo>
                    <a:pt x="2896" y="1"/>
                  </a:lnTo>
                  <a:lnTo>
                    <a:pt x="2897" y="1"/>
                  </a:lnTo>
                  <a:lnTo>
                    <a:pt x="2898" y="1"/>
                  </a:lnTo>
                  <a:lnTo>
                    <a:pt x="2899" y="1"/>
                  </a:lnTo>
                  <a:lnTo>
                    <a:pt x="2899" y="3"/>
                  </a:lnTo>
                  <a:lnTo>
                    <a:pt x="2900" y="3"/>
                  </a:lnTo>
                  <a:lnTo>
                    <a:pt x="2901" y="2"/>
                  </a:lnTo>
                  <a:lnTo>
                    <a:pt x="2902" y="4"/>
                  </a:lnTo>
                  <a:lnTo>
                    <a:pt x="2903" y="4"/>
                  </a:lnTo>
                  <a:lnTo>
                    <a:pt x="2904" y="1"/>
                  </a:lnTo>
                  <a:lnTo>
                    <a:pt x="2905" y="6"/>
                  </a:lnTo>
                  <a:lnTo>
                    <a:pt x="2906" y="4"/>
                  </a:lnTo>
                  <a:lnTo>
                    <a:pt x="2907" y="3"/>
                  </a:lnTo>
                  <a:lnTo>
                    <a:pt x="2907" y="5"/>
                  </a:lnTo>
                  <a:lnTo>
                    <a:pt x="2908" y="3"/>
                  </a:lnTo>
                  <a:lnTo>
                    <a:pt x="2909" y="6"/>
                  </a:lnTo>
                  <a:lnTo>
                    <a:pt x="2910" y="7"/>
                  </a:lnTo>
                  <a:lnTo>
                    <a:pt x="2911" y="9"/>
                  </a:lnTo>
                  <a:lnTo>
                    <a:pt x="2912" y="9"/>
                  </a:lnTo>
                  <a:lnTo>
                    <a:pt x="2913" y="9"/>
                  </a:lnTo>
                  <a:lnTo>
                    <a:pt x="2914" y="11"/>
                  </a:lnTo>
                  <a:lnTo>
                    <a:pt x="2914" y="9"/>
                  </a:lnTo>
                  <a:lnTo>
                    <a:pt x="2915" y="11"/>
                  </a:lnTo>
                  <a:lnTo>
                    <a:pt x="2916" y="12"/>
                  </a:lnTo>
                  <a:lnTo>
                    <a:pt x="2917" y="11"/>
                  </a:lnTo>
                  <a:lnTo>
                    <a:pt x="2918" y="13"/>
                  </a:lnTo>
                  <a:lnTo>
                    <a:pt x="2919" y="13"/>
                  </a:lnTo>
                  <a:lnTo>
                    <a:pt x="2920" y="10"/>
                  </a:lnTo>
                  <a:lnTo>
                    <a:pt x="2921" y="9"/>
                  </a:lnTo>
                  <a:lnTo>
                    <a:pt x="2922" y="10"/>
                  </a:lnTo>
                  <a:lnTo>
                    <a:pt x="2922" y="8"/>
                  </a:lnTo>
                  <a:lnTo>
                    <a:pt x="2923" y="8"/>
                  </a:lnTo>
                  <a:lnTo>
                    <a:pt x="2924" y="6"/>
                  </a:lnTo>
                  <a:lnTo>
                    <a:pt x="2925" y="10"/>
                  </a:lnTo>
                  <a:lnTo>
                    <a:pt x="2926" y="5"/>
                  </a:lnTo>
                  <a:lnTo>
                    <a:pt x="2927" y="8"/>
                  </a:lnTo>
                  <a:lnTo>
                    <a:pt x="2928" y="8"/>
                  </a:lnTo>
                  <a:lnTo>
                    <a:pt x="2929" y="10"/>
                  </a:lnTo>
                  <a:lnTo>
                    <a:pt x="2929" y="11"/>
                  </a:lnTo>
                  <a:lnTo>
                    <a:pt x="2930" y="6"/>
                  </a:lnTo>
                  <a:lnTo>
                    <a:pt x="2931" y="7"/>
                  </a:lnTo>
                  <a:lnTo>
                    <a:pt x="2932" y="7"/>
                  </a:lnTo>
                  <a:lnTo>
                    <a:pt x="2933" y="7"/>
                  </a:lnTo>
                  <a:lnTo>
                    <a:pt x="2934" y="7"/>
                  </a:lnTo>
                  <a:lnTo>
                    <a:pt x="2935" y="6"/>
                  </a:lnTo>
                  <a:lnTo>
                    <a:pt x="2936" y="6"/>
                  </a:lnTo>
                  <a:lnTo>
                    <a:pt x="2937" y="6"/>
                  </a:lnTo>
                  <a:lnTo>
                    <a:pt x="2937" y="4"/>
                  </a:lnTo>
                  <a:lnTo>
                    <a:pt x="2938" y="4"/>
                  </a:lnTo>
                  <a:lnTo>
                    <a:pt x="2939" y="7"/>
                  </a:lnTo>
                  <a:lnTo>
                    <a:pt x="2940" y="5"/>
                  </a:lnTo>
                  <a:lnTo>
                    <a:pt x="2941" y="7"/>
                  </a:lnTo>
                  <a:lnTo>
                    <a:pt x="2942" y="7"/>
                  </a:lnTo>
                  <a:lnTo>
                    <a:pt x="2943" y="5"/>
                  </a:lnTo>
                  <a:lnTo>
                    <a:pt x="2944" y="4"/>
                  </a:lnTo>
                  <a:lnTo>
                    <a:pt x="2944" y="6"/>
                  </a:lnTo>
                  <a:lnTo>
                    <a:pt x="2945" y="3"/>
                  </a:lnTo>
                  <a:lnTo>
                    <a:pt x="2946" y="7"/>
                  </a:lnTo>
                  <a:lnTo>
                    <a:pt x="2947" y="6"/>
                  </a:lnTo>
                  <a:lnTo>
                    <a:pt x="2948" y="3"/>
                  </a:lnTo>
                  <a:lnTo>
                    <a:pt x="2949" y="4"/>
                  </a:lnTo>
                  <a:lnTo>
                    <a:pt x="2950" y="4"/>
                  </a:lnTo>
                  <a:lnTo>
                    <a:pt x="2951" y="5"/>
                  </a:lnTo>
                  <a:lnTo>
                    <a:pt x="2952" y="2"/>
                  </a:lnTo>
                  <a:lnTo>
                    <a:pt x="2952" y="2"/>
                  </a:lnTo>
                  <a:lnTo>
                    <a:pt x="2953" y="4"/>
                  </a:lnTo>
                  <a:lnTo>
                    <a:pt x="2954" y="4"/>
                  </a:lnTo>
                  <a:lnTo>
                    <a:pt x="2955" y="3"/>
                  </a:lnTo>
                  <a:lnTo>
                    <a:pt x="2956" y="4"/>
                  </a:lnTo>
                  <a:lnTo>
                    <a:pt x="2957" y="3"/>
                  </a:lnTo>
                  <a:lnTo>
                    <a:pt x="2958" y="3"/>
                  </a:lnTo>
                  <a:lnTo>
                    <a:pt x="2959" y="3"/>
                  </a:lnTo>
                  <a:lnTo>
                    <a:pt x="2959" y="4"/>
                  </a:lnTo>
                  <a:lnTo>
                    <a:pt x="2960" y="2"/>
                  </a:lnTo>
                  <a:lnTo>
                    <a:pt x="2961" y="5"/>
                  </a:lnTo>
                  <a:lnTo>
                    <a:pt x="2962" y="4"/>
                  </a:lnTo>
                  <a:lnTo>
                    <a:pt x="2963" y="3"/>
                  </a:lnTo>
                  <a:lnTo>
                    <a:pt x="2964" y="5"/>
                  </a:lnTo>
                  <a:lnTo>
                    <a:pt x="2965" y="2"/>
                  </a:lnTo>
                  <a:lnTo>
                    <a:pt x="2966" y="4"/>
                  </a:lnTo>
                  <a:lnTo>
                    <a:pt x="2967" y="2"/>
                  </a:lnTo>
                  <a:lnTo>
                    <a:pt x="2967" y="2"/>
                  </a:lnTo>
                  <a:lnTo>
                    <a:pt x="2968" y="2"/>
                  </a:lnTo>
                  <a:lnTo>
                    <a:pt x="2969" y="3"/>
                  </a:lnTo>
                  <a:lnTo>
                    <a:pt x="2970" y="4"/>
                  </a:lnTo>
                  <a:lnTo>
                    <a:pt x="2971" y="1"/>
                  </a:lnTo>
                  <a:lnTo>
                    <a:pt x="2972" y="3"/>
                  </a:lnTo>
                  <a:lnTo>
                    <a:pt x="2973" y="3"/>
                  </a:lnTo>
                  <a:lnTo>
                    <a:pt x="2974" y="2"/>
                  </a:lnTo>
                  <a:lnTo>
                    <a:pt x="2974" y="4"/>
                  </a:lnTo>
                  <a:lnTo>
                    <a:pt x="2975" y="1"/>
                  </a:lnTo>
                  <a:lnTo>
                    <a:pt x="2976" y="4"/>
                  </a:lnTo>
                  <a:lnTo>
                    <a:pt x="2977" y="4"/>
                  </a:lnTo>
                  <a:lnTo>
                    <a:pt x="2978" y="3"/>
                  </a:lnTo>
                  <a:lnTo>
                    <a:pt x="2979" y="6"/>
                  </a:lnTo>
                  <a:lnTo>
                    <a:pt x="2980" y="5"/>
                  </a:lnTo>
                  <a:lnTo>
                    <a:pt x="2981" y="4"/>
                  </a:lnTo>
                  <a:lnTo>
                    <a:pt x="2982" y="3"/>
                  </a:lnTo>
                  <a:lnTo>
                    <a:pt x="2982" y="4"/>
                  </a:lnTo>
                  <a:lnTo>
                    <a:pt x="2983" y="2"/>
                  </a:lnTo>
                  <a:lnTo>
                    <a:pt x="2984" y="4"/>
                  </a:lnTo>
                  <a:lnTo>
                    <a:pt x="2985" y="3"/>
                  </a:lnTo>
                  <a:lnTo>
                    <a:pt x="2986" y="4"/>
                  </a:lnTo>
                  <a:lnTo>
                    <a:pt x="2987" y="3"/>
                  </a:lnTo>
                  <a:lnTo>
                    <a:pt x="2988" y="5"/>
                  </a:lnTo>
                  <a:lnTo>
                    <a:pt x="2989" y="4"/>
                  </a:lnTo>
                  <a:lnTo>
                    <a:pt x="2989" y="5"/>
                  </a:lnTo>
                  <a:lnTo>
                    <a:pt x="2990" y="5"/>
                  </a:lnTo>
                  <a:lnTo>
                    <a:pt x="2991" y="5"/>
                  </a:lnTo>
                  <a:lnTo>
                    <a:pt x="2992" y="2"/>
                  </a:lnTo>
                  <a:lnTo>
                    <a:pt x="2993" y="2"/>
                  </a:lnTo>
                  <a:lnTo>
                    <a:pt x="2994" y="3"/>
                  </a:lnTo>
                  <a:lnTo>
                    <a:pt x="2995" y="4"/>
                  </a:lnTo>
                  <a:lnTo>
                    <a:pt x="2996" y="3"/>
                  </a:lnTo>
                  <a:lnTo>
                    <a:pt x="2997" y="4"/>
                  </a:lnTo>
                  <a:lnTo>
                    <a:pt x="2997" y="4"/>
                  </a:lnTo>
                  <a:lnTo>
                    <a:pt x="2998" y="4"/>
                  </a:lnTo>
                  <a:lnTo>
                    <a:pt x="2999" y="5"/>
                  </a:lnTo>
                  <a:lnTo>
                    <a:pt x="3000" y="2"/>
                  </a:lnTo>
                  <a:lnTo>
                    <a:pt x="3001" y="3"/>
                  </a:lnTo>
                  <a:lnTo>
                    <a:pt x="3002" y="2"/>
                  </a:lnTo>
                  <a:lnTo>
                    <a:pt x="3003" y="5"/>
                  </a:lnTo>
                  <a:lnTo>
                    <a:pt x="3004" y="3"/>
                  </a:lnTo>
                  <a:lnTo>
                    <a:pt x="3004" y="2"/>
                  </a:lnTo>
                  <a:lnTo>
                    <a:pt x="3005" y="4"/>
                  </a:lnTo>
                  <a:lnTo>
                    <a:pt x="3006" y="3"/>
                  </a:lnTo>
                  <a:lnTo>
                    <a:pt x="3007" y="4"/>
                  </a:lnTo>
                  <a:lnTo>
                    <a:pt x="3008" y="5"/>
                  </a:lnTo>
                  <a:lnTo>
                    <a:pt x="3009" y="4"/>
                  </a:lnTo>
                  <a:lnTo>
                    <a:pt x="3010" y="3"/>
                  </a:lnTo>
                  <a:lnTo>
                    <a:pt x="3011" y="3"/>
                  </a:lnTo>
                  <a:lnTo>
                    <a:pt x="3012" y="4"/>
                  </a:lnTo>
                  <a:lnTo>
                    <a:pt x="3012" y="3"/>
                  </a:lnTo>
                  <a:lnTo>
                    <a:pt x="3013" y="2"/>
                  </a:lnTo>
                  <a:lnTo>
                    <a:pt x="3014" y="2"/>
                  </a:lnTo>
                  <a:lnTo>
                    <a:pt x="3015" y="2"/>
                  </a:lnTo>
                  <a:lnTo>
                    <a:pt x="3016" y="3"/>
                  </a:lnTo>
                  <a:lnTo>
                    <a:pt x="3017" y="2"/>
                  </a:lnTo>
                  <a:lnTo>
                    <a:pt x="3018" y="3"/>
                  </a:lnTo>
                  <a:lnTo>
                    <a:pt x="3019" y="4"/>
                  </a:lnTo>
                  <a:lnTo>
                    <a:pt x="3019" y="3"/>
                  </a:lnTo>
                  <a:lnTo>
                    <a:pt x="3020" y="3"/>
                  </a:lnTo>
                  <a:lnTo>
                    <a:pt x="3021" y="2"/>
                  </a:lnTo>
                  <a:lnTo>
                    <a:pt x="3022" y="3"/>
                  </a:lnTo>
                  <a:lnTo>
                    <a:pt x="3023" y="2"/>
                  </a:lnTo>
                  <a:lnTo>
                    <a:pt x="3024" y="3"/>
                  </a:lnTo>
                  <a:lnTo>
                    <a:pt x="3025" y="3"/>
                  </a:lnTo>
                  <a:lnTo>
                    <a:pt x="3026" y="3"/>
                  </a:lnTo>
                  <a:lnTo>
                    <a:pt x="3027" y="3"/>
                  </a:lnTo>
                  <a:lnTo>
                    <a:pt x="3027" y="2"/>
                  </a:lnTo>
                  <a:lnTo>
                    <a:pt x="3028" y="2"/>
                  </a:lnTo>
                  <a:lnTo>
                    <a:pt x="3029" y="1"/>
                  </a:lnTo>
                  <a:lnTo>
                    <a:pt x="3030" y="3"/>
                  </a:lnTo>
                  <a:lnTo>
                    <a:pt x="3031" y="0"/>
                  </a:lnTo>
                  <a:lnTo>
                    <a:pt x="3032" y="4"/>
                  </a:lnTo>
                  <a:lnTo>
                    <a:pt x="3033" y="1"/>
                  </a:lnTo>
                  <a:lnTo>
                    <a:pt x="3034" y="6"/>
                  </a:lnTo>
                  <a:lnTo>
                    <a:pt x="3034" y="4"/>
                  </a:lnTo>
                  <a:lnTo>
                    <a:pt x="3035" y="2"/>
                  </a:lnTo>
                  <a:lnTo>
                    <a:pt x="3036" y="4"/>
                  </a:lnTo>
                  <a:lnTo>
                    <a:pt x="3037" y="1"/>
                  </a:lnTo>
                  <a:lnTo>
                    <a:pt x="3038" y="2"/>
                  </a:lnTo>
                  <a:lnTo>
                    <a:pt x="3039" y="3"/>
                  </a:lnTo>
                  <a:lnTo>
                    <a:pt x="3040" y="4"/>
                  </a:lnTo>
                  <a:lnTo>
                    <a:pt x="3041" y="1"/>
                  </a:lnTo>
                  <a:lnTo>
                    <a:pt x="3042" y="1"/>
                  </a:lnTo>
                  <a:lnTo>
                    <a:pt x="3042" y="2"/>
                  </a:lnTo>
                  <a:lnTo>
                    <a:pt x="3043" y="2"/>
                  </a:lnTo>
                  <a:lnTo>
                    <a:pt x="3044" y="2"/>
                  </a:lnTo>
                  <a:lnTo>
                    <a:pt x="3045" y="1"/>
                  </a:lnTo>
                  <a:lnTo>
                    <a:pt x="3046" y="4"/>
                  </a:lnTo>
                  <a:lnTo>
                    <a:pt x="3047" y="3"/>
                  </a:lnTo>
                  <a:lnTo>
                    <a:pt x="3048" y="1"/>
                  </a:lnTo>
                  <a:lnTo>
                    <a:pt x="3049" y="1"/>
                  </a:lnTo>
                  <a:lnTo>
                    <a:pt x="3049" y="2"/>
                  </a:lnTo>
                  <a:lnTo>
                    <a:pt x="3050" y="3"/>
                  </a:lnTo>
                  <a:lnTo>
                    <a:pt x="3051" y="2"/>
                  </a:lnTo>
                  <a:lnTo>
                    <a:pt x="3052" y="2"/>
                  </a:lnTo>
                  <a:lnTo>
                    <a:pt x="3053" y="4"/>
                  </a:lnTo>
                  <a:lnTo>
                    <a:pt x="3054" y="5"/>
                  </a:lnTo>
                  <a:lnTo>
                    <a:pt x="3055" y="5"/>
                  </a:lnTo>
                  <a:lnTo>
                    <a:pt x="3056" y="2"/>
                  </a:lnTo>
                  <a:lnTo>
                    <a:pt x="3057" y="4"/>
                  </a:lnTo>
                  <a:lnTo>
                    <a:pt x="3057" y="4"/>
                  </a:lnTo>
                  <a:lnTo>
                    <a:pt x="3058" y="4"/>
                  </a:lnTo>
                  <a:lnTo>
                    <a:pt x="3059" y="2"/>
                  </a:lnTo>
                  <a:lnTo>
                    <a:pt x="3060" y="2"/>
                  </a:lnTo>
                  <a:lnTo>
                    <a:pt x="3061" y="2"/>
                  </a:lnTo>
                  <a:lnTo>
                    <a:pt x="3062" y="4"/>
                  </a:lnTo>
                  <a:lnTo>
                    <a:pt x="3063" y="3"/>
                  </a:lnTo>
                  <a:lnTo>
                    <a:pt x="3064" y="2"/>
                  </a:lnTo>
                  <a:lnTo>
                    <a:pt x="3064" y="3"/>
                  </a:lnTo>
                  <a:lnTo>
                    <a:pt x="3065" y="5"/>
                  </a:lnTo>
                  <a:lnTo>
                    <a:pt x="3066" y="3"/>
                  </a:lnTo>
                  <a:lnTo>
                    <a:pt x="3067" y="1"/>
                  </a:lnTo>
                  <a:lnTo>
                    <a:pt x="3068" y="3"/>
                  </a:lnTo>
                  <a:lnTo>
                    <a:pt x="3069" y="3"/>
                  </a:lnTo>
                  <a:lnTo>
                    <a:pt x="3070" y="3"/>
                  </a:lnTo>
                  <a:lnTo>
                    <a:pt x="3071" y="3"/>
                  </a:lnTo>
                  <a:lnTo>
                    <a:pt x="3071" y="3"/>
                  </a:lnTo>
                  <a:lnTo>
                    <a:pt x="3072" y="2"/>
                  </a:lnTo>
                  <a:lnTo>
                    <a:pt x="3073" y="3"/>
                  </a:lnTo>
                  <a:lnTo>
                    <a:pt x="3074" y="2"/>
                  </a:lnTo>
                  <a:lnTo>
                    <a:pt x="3075" y="3"/>
                  </a:lnTo>
                  <a:lnTo>
                    <a:pt x="3076" y="5"/>
                  </a:lnTo>
                  <a:lnTo>
                    <a:pt x="3077" y="3"/>
                  </a:lnTo>
                  <a:lnTo>
                    <a:pt x="3078" y="5"/>
                  </a:lnTo>
                  <a:lnTo>
                    <a:pt x="3079" y="7"/>
                  </a:lnTo>
                  <a:lnTo>
                    <a:pt x="3079" y="4"/>
                  </a:lnTo>
                  <a:lnTo>
                    <a:pt x="3080" y="5"/>
                  </a:lnTo>
                  <a:lnTo>
                    <a:pt x="3081" y="4"/>
                  </a:lnTo>
                  <a:lnTo>
                    <a:pt x="3082" y="6"/>
                  </a:lnTo>
                  <a:lnTo>
                    <a:pt x="3083" y="6"/>
                  </a:lnTo>
                  <a:lnTo>
                    <a:pt x="3084" y="4"/>
                  </a:lnTo>
                  <a:lnTo>
                    <a:pt x="3085" y="3"/>
                  </a:lnTo>
                  <a:lnTo>
                    <a:pt x="3086" y="4"/>
                  </a:lnTo>
                  <a:lnTo>
                    <a:pt x="3086" y="4"/>
                  </a:lnTo>
                  <a:lnTo>
                    <a:pt x="3087" y="6"/>
                  </a:lnTo>
                  <a:lnTo>
                    <a:pt x="3088" y="3"/>
                  </a:lnTo>
                  <a:lnTo>
                    <a:pt x="3089" y="2"/>
                  </a:lnTo>
                  <a:lnTo>
                    <a:pt x="3090" y="5"/>
                  </a:lnTo>
                  <a:lnTo>
                    <a:pt x="3091" y="5"/>
                  </a:lnTo>
                  <a:lnTo>
                    <a:pt x="3092" y="6"/>
                  </a:lnTo>
                  <a:lnTo>
                    <a:pt x="3093" y="5"/>
                  </a:lnTo>
                  <a:lnTo>
                    <a:pt x="3094" y="5"/>
                  </a:lnTo>
                  <a:lnTo>
                    <a:pt x="3094" y="5"/>
                  </a:lnTo>
                  <a:lnTo>
                    <a:pt x="3095" y="4"/>
                  </a:lnTo>
                  <a:lnTo>
                    <a:pt x="3096" y="5"/>
                  </a:lnTo>
                  <a:lnTo>
                    <a:pt x="3097" y="5"/>
                  </a:lnTo>
                  <a:lnTo>
                    <a:pt x="3098" y="3"/>
                  </a:lnTo>
                  <a:lnTo>
                    <a:pt x="3099" y="3"/>
                  </a:lnTo>
                  <a:lnTo>
                    <a:pt x="3100" y="4"/>
                  </a:lnTo>
                  <a:lnTo>
                    <a:pt x="3101" y="4"/>
                  </a:lnTo>
                  <a:lnTo>
                    <a:pt x="3101" y="0"/>
                  </a:lnTo>
                  <a:lnTo>
                    <a:pt x="3102" y="3"/>
                  </a:lnTo>
                  <a:lnTo>
                    <a:pt x="3103" y="5"/>
                  </a:lnTo>
                  <a:lnTo>
                    <a:pt x="3104" y="1"/>
                  </a:lnTo>
                  <a:lnTo>
                    <a:pt x="3105" y="2"/>
                  </a:lnTo>
                  <a:lnTo>
                    <a:pt x="3106" y="2"/>
                  </a:lnTo>
                  <a:lnTo>
                    <a:pt x="3107" y="4"/>
                  </a:lnTo>
                  <a:lnTo>
                    <a:pt x="3108" y="2"/>
                  </a:lnTo>
                  <a:lnTo>
                    <a:pt x="3109" y="3"/>
                  </a:lnTo>
                  <a:lnTo>
                    <a:pt x="3109" y="3"/>
                  </a:lnTo>
                  <a:lnTo>
                    <a:pt x="3110" y="4"/>
                  </a:lnTo>
                  <a:lnTo>
                    <a:pt x="3111" y="1"/>
                  </a:lnTo>
                  <a:lnTo>
                    <a:pt x="3112" y="3"/>
                  </a:lnTo>
                  <a:lnTo>
                    <a:pt x="3113" y="3"/>
                  </a:lnTo>
                  <a:lnTo>
                    <a:pt x="3114" y="6"/>
                  </a:lnTo>
                  <a:lnTo>
                    <a:pt x="3115" y="3"/>
                  </a:lnTo>
                  <a:lnTo>
                    <a:pt x="3116" y="7"/>
                  </a:lnTo>
                  <a:lnTo>
                    <a:pt x="3116" y="12"/>
                  </a:lnTo>
                  <a:lnTo>
                    <a:pt x="3117" y="15"/>
                  </a:lnTo>
                  <a:lnTo>
                    <a:pt x="3118" y="18"/>
                  </a:lnTo>
                  <a:lnTo>
                    <a:pt x="3119" y="21"/>
                  </a:lnTo>
                  <a:lnTo>
                    <a:pt x="3120" y="32"/>
                  </a:lnTo>
                  <a:lnTo>
                    <a:pt x="3121" y="35"/>
                  </a:lnTo>
                  <a:lnTo>
                    <a:pt x="3122" y="52"/>
                  </a:lnTo>
                  <a:lnTo>
                    <a:pt x="3123" y="53"/>
                  </a:lnTo>
                  <a:lnTo>
                    <a:pt x="3124" y="59"/>
                  </a:lnTo>
                  <a:lnTo>
                    <a:pt x="3124" y="69"/>
                  </a:lnTo>
                  <a:lnTo>
                    <a:pt x="3125" y="73"/>
                  </a:lnTo>
                  <a:lnTo>
                    <a:pt x="3126" y="88"/>
                  </a:lnTo>
                  <a:lnTo>
                    <a:pt x="3127" y="88"/>
                  </a:lnTo>
                  <a:lnTo>
                    <a:pt x="3128" y="86"/>
                  </a:lnTo>
                  <a:lnTo>
                    <a:pt x="3129" y="84"/>
                  </a:lnTo>
                  <a:lnTo>
                    <a:pt x="3130" y="84"/>
                  </a:lnTo>
                  <a:lnTo>
                    <a:pt x="3131" y="84"/>
                  </a:lnTo>
                  <a:lnTo>
                    <a:pt x="3131" y="83"/>
                  </a:lnTo>
                  <a:lnTo>
                    <a:pt x="3132" y="86"/>
                  </a:lnTo>
                  <a:lnTo>
                    <a:pt x="3133" y="83"/>
                  </a:lnTo>
                  <a:lnTo>
                    <a:pt x="3134" y="75"/>
                  </a:lnTo>
                  <a:lnTo>
                    <a:pt x="3135" y="82"/>
                  </a:lnTo>
                  <a:lnTo>
                    <a:pt x="3136" y="78"/>
                  </a:lnTo>
                  <a:lnTo>
                    <a:pt x="3137" y="74"/>
                  </a:lnTo>
                  <a:lnTo>
                    <a:pt x="3138" y="76"/>
                  </a:lnTo>
                  <a:lnTo>
                    <a:pt x="3139" y="72"/>
                  </a:lnTo>
                  <a:lnTo>
                    <a:pt x="3139" y="69"/>
                  </a:lnTo>
                  <a:lnTo>
                    <a:pt x="3140" y="70"/>
                  </a:lnTo>
                  <a:lnTo>
                    <a:pt x="3141" y="65"/>
                  </a:lnTo>
                  <a:lnTo>
                    <a:pt x="3142" y="64"/>
                  </a:lnTo>
                  <a:lnTo>
                    <a:pt x="3143" y="61"/>
                  </a:lnTo>
                  <a:lnTo>
                    <a:pt x="3144" y="65"/>
                  </a:lnTo>
                  <a:lnTo>
                    <a:pt x="3145" y="55"/>
                  </a:lnTo>
                  <a:lnTo>
                    <a:pt x="3146" y="58"/>
                  </a:lnTo>
                  <a:lnTo>
                    <a:pt x="3146" y="60"/>
                  </a:lnTo>
                  <a:lnTo>
                    <a:pt x="3147" y="61"/>
                  </a:lnTo>
                  <a:lnTo>
                    <a:pt x="3148" y="52"/>
                  </a:lnTo>
                  <a:lnTo>
                    <a:pt x="3149" y="54"/>
                  </a:lnTo>
                  <a:lnTo>
                    <a:pt x="3150" y="52"/>
                  </a:lnTo>
                  <a:lnTo>
                    <a:pt x="3151" y="53"/>
                  </a:lnTo>
                  <a:lnTo>
                    <a:pt x="3152" y="49"/>
                  </a:lnTo>
                  <a:lnTo>
                    <a:pt x="3153" y="50"/>
                  </a:lnTo>
                  <a:lnTo>
                    <a:pt x="3154" y="51"/>
                  </a:lnTo>
                  <a:lnTo>
                    <a:pt x="3154" y="45"/>
                  </a:lnTo>
                  <a:lnTo>
                    <a:pt x="3155" y="50"/>
                  </a:lnTo>
                  <a:lnTo>
                    <a:pt x="3156" y="44"/>
                  </a:lnTo>
                  <a:lnTo>
                    <a:pt x="3157" y="48"/>
                  </a:lnTo>
                  <a:lnTo>
                    <a:pt x="3158" y="49"/>
                  </a:lnTo>
                  <a:lnTo>
                    <a:pt x="3159" y="44"/>
                  </a:lnTo>
                  <a:lnTo>
                    <a:pt x="3160" y="40"/>
                  </a:lnTo>
                  <a:lnTo>
                    <a:pt x="3161" y="41"/>
                  </a:lnTo>
                  <a:lnTo>
                    <a:pt x="3161" y="39"/>
                  </a:lnTo>
                  <a:lnTo>
                    <a:pt x="3162" y="44"/>
                  </a:lnTo>
                  <a:lnTo>
                    <a:pt x="3163" y="43"/>
                  </a:lnTo>
                  <a:lnTo>
                    <a:pt x="3164" y="40"/>
                  </a:lnTo>
                  <a:lnTo>
                    <a:pt x="3165" y="37"/>
                  </a:lnTo>
                  <a:lnTo>
                    <a:pt x="3166" y="40"/>
                  </a:lnTo>
                  <a:lnTo>
                    <a:pt x="3167" y="36"/>
                  </a:lnTo>
                  <a:lnTo>
                    <a:pt x="3168" y="36"/>
                  </a:lnTo>
                  <a:lnTo>
                    <a:pt x="3169" y="36"/>
                  </a:lnTo>
                  <a:lnTo>
                    <a:pt x="3169" y="37"/>
                  </a:lnTo>
                  <a:lnTo>
                    <a:pt x="3170" y="32"/>
                  </a:lnTo>
                  <a:lnTo>
                    <a:pt x="3171" y="32"/>
                  </a:lnTo>
                  <a:lnTo>
                    <a:pt x="3172" y="33"/>
                  </a:lnTo>
                  <a:lnTo>
                    <a:pt x="3173" y="33"/>
                  </a:lnTo>
                  <a:lnTo>
                    <a:pt x="3174" y="34"/>
                  </a:lnTo>
                  <a:lnTo>
                    <a:pt x="3175" y="31"/>
                  </a:lnTo>
                  <a:lnTo>
                    <a:pt x="3176" y="32"/>
                  </a:lnTo>
                  <a:lnTo>
                    <a:pt x="3176" y="31"/>
                  </a:lnTo>
                  <a:lnTo>
                    <a:pt x="3177" y="28"/>
                  </a:lnTo>
                  <a:lnTo>
                    <a:pt x="3178" y="25"/>
                  </a:lnTo>
                  <a:lnTo>
                    <a:pt x="3179" y="32"/>
                  </a:lnTo>
                  <a:lnTo>
                    <a:pt x="3180" y="30"/>
                  </a:lnTo>
                  <a:lnTo>
                    <a:pt x="3181" y="27"/>
                  </a:lnTo>
                  <a:lnTo>
                    <a:pt x="3182" y="34"/>
                  </a:lnTo>
                  <a:lnTo>
                    <a:pt x="3183" y="25"/>
                  </a:lnTo>
                  <a:lnTo>
                    <a:pt x="3184" y="29"/>
                  </a:lnTo>
                  <a:lnTo>
                    <a:pt x="3184" y="28"/>
                  </a:lnTo>
                  <a:lnTo>
                    <a:pt x="3185" y="27"/>
                  </a:lnTo>
                  <a:lnTo>
                    <a:pt x="3186" y="26"/>
                  </a:lnTo>
                  <a:lnTo>
                    <a:pt x="3187" y="25"/>
                  </a:lnTo>
                  <a:lnTo>
                    <a:pt x="3188" y="23"/>
                  </a:lnTo>
                  <a:lnTo>
                    <a:pt x="3189" y="24"/>
                  </a:lnTo>
                  <a:lnTo>
                    <a:pt x="3190" y="26"/>
                  </a:lnTo>
                  <a:lnTo>
                    <a:pt x="3191" y="24"/>
                  </a:lnTo>
                  <a:lnTo>
                    <a:pt x="3191" y="26"/>
                  </a:lnTo>
                  <a:lnTo>
                    <a:pt x="3192" y="32"/>
                  </a:lnTo>
                  <a:lnTo>
                    <a:pt x="3193" y="25"/>
                  </a:lnTo>
                  <a:lnTo>
                    <a:pt x="3194" y="30"/>
                  </a:lnTo>
                  <a:lnTo>
                    <a:pt x="3195" y="27"/>
                  </a:lnTo>
                  <a:lnTo>
                    <a:pt x="3196" y="34"/>
                  </a:lnTo>
                  <a:lnTo>
                    <a:pt x="3197" y="29"/>
                  </a:lnTo>
                  <a:lnTo>
                    <a:pt x="3198" y="30"/>
                  </a:lnTo>
                  <a:lnTo>
                    <a:pt x="3199" y="27"/>
                  </a:lnTo>
                  <a:lnTo>
                    <a:pt x="3199" y="27"/>
                  </a:lnTo>
                  <a:lnTo>
                    <a:pt x="3200" y="27"/>
                  </a:lnTo>
                  <a:lnTo>
                    <a:pt x="3201" y="24"/>
                  </a:lnTo>
                  <a:lnTo>
                    <a:pt x="3202" y="26"/>
                  </a:lnTo>
                  <a:lnTo>
                    <a:pt x="3203" y="23"/>
                  </a:lnTo>
                  <a:lnTo>
                    <a:pt x="3204" y="20"/>
                  </a:lnTo>
                  <a:lnTo>
                    <a:pt x="3205" y="23"/>
                  </a:lnTo>
                  <a:lnTo>
                    <a:pt x="3206" y="21"/>
                  </a:lnTo>
                  <a:lnTo>
                    <a:pt x="3206" y="21"/>
                  </a:lnTo>
                  <a:lnTo>
                    <a:pt x="3207" y="20"/>
                  </a:lnTo>
                  <a:lnTo>
                    <a:pt x="3208" y="24"/>
                  </a:lnTo>
                  <a:lnTo>
                    <a:pt x="3209" y="24"/>
                  </a:lnTo>
                  <a:lnTo>
                    <a:pt x="3210" y="20"/>
                  </a:lnTo>
                  <a:lnTo>
                    <a:pt x="3211" y="22"/>
                  </a:lnTo>
                  <a:lnTo>
                    <a:pt x="3212" y="24"/>
                  </a:lnTo>
                  <a:lnTo>
                    <a:pt x="3213" y="21"/>
                  </a:lnTo>
                  <a:lnTo>
                    <a:pt x="3214" y="26"/>
                  </a:lnTo>
                  <a:lnTo>
                    <a:pt x="3214" y="25"/>
                  </a:lnTo>
                  <a:lnTo>
                    <a:pt x="3215" y="25"/>
                  </a:lnTo>
                  <a:lnTo>
                    <a:pt x="3216" y="28"/>
                  </a:lnTo>
                  <a:lnTo>
                    <a:pt x="3217" y="25"/>
                  </a:lnTo>
                  <a:lnTo>
                    <a:pt x="3218" y="25"/>
                  </a:lnTo>
                  <a:lnTo>
                    <a:pt x="3219" y="23"/>
                  </a:lnTo>
                  <a:lnTo>
                    <a:pt x="3220" y="26"/>
                  </a:lnTo>
                  <a:lnTo>
                    <a:pt x="3221" y="26"/>
                  </a:lnTo>
                  <a:lnTo>
                    <a:pt x="3221" y="25"/>
                  </a:lnTo>
                  <a:lnTo>
                    <a:pt x="3222" y="24"/>
                  </a:lnTo>
                  <a:lnTo>
                    <a:pt x="3223" y="21"/>
                  </a:lnTo>
                  <a:lnTo>
                    <a:pt x="3224" y="17"/>
                  </a:lnTo>
                  <a:lnTo>
                    <a:pt x="3225" y="18"/>
                  </a:lnTo>
                  <a:lnTo>
                    <a:pt x="3226" y="18"/>
                  </a:lnTo>
                  <a:lnTo>
                    <a:pt x="3227" y="23"/>
                  </a:lnTo>
                  <a:lnTo>
                    <a:pt x="3228" y="20"/>
                  </a:lnTo>
                  <a:lnTo>
                    <a:pt x="3229" y="19"/>
                  </a:lnTo>
                  <a:lnTo>
                    <a:pt x="3229" y="20"/>
                  </a:lnTo>
                  <a:lnTo>
                    <a:pt x="3230" y="20"/>
                  </a:lnTo>
                  <a:lnTo>
                    <a:pt x="3231" y="21"/>
                  </a:lnTo>
                  <a:lnTo>
                    <a:pt x="3232" y="18"/>
                  </a:lnTo>
                  <a:lnTo>
                    <a:pt x="3233" y="16"/>
                  </a:lnTo>
                  <a:lnTo>
                    <a:pt x="3234" y="18"/>
                  </a:lnTo>
                  <a:lnTo>
                    <a:pt x="3235" y="20"/>
                  </a:lnTo>
                  <a:lnTo>
                    <a:pt x="3236" y="19"/>
                  </a:lnTo>
                  <a:lnTo>
                    <a:pt x="3236" y="20"/>
                  </a:lnTo>
                  <a:lnTo>
                    <a:pt x="3237" y="18"/>
                  </a:lnTo>
                  <a:lnTo>
                    <a:pt x="3238" y="17"/>
                  </a:lnTo>
                  <a:lnTo>
                    <a:pt x="3239" y="15"/>
                  </a:lnTo>
                  <a:lnTo>
                    <a:pt x="3240" y="15"/>
                  </a:lnTo>
                  <a:lnTo>
                    <a:pt x="3241" y="18"/>
                  </a:lnTo>
                  <a:lnTo>
                    <a:pt x="3242" y="19"/>
                  </a:lnTo>
                  <a:lnTo>
                    <a:pt x="3243" y="14"/>
                  </a:lnTo>
                  <a:lnTo>
                    <a:pt x="3244" y="16"/>
                  </a:lnTo>
                  <a:lnTo>
                    <a:pt x="3244" y="16"/>
                  </a:lnTo>
                  <a:lnTo>
                    <a:pt x="3245" y="19"/>
                  </a:lnTo>
                  <a:lnTo>
                    <a:pt x="3246" y="16"/>
                  </a:lnTo>
                  <a:lnTo>
                    <a:pt x="3247" y="20"/>
                  </a:lnTo>
                  <a:lnTo>
                    <a:pt x="3248" y="15"/>
                  </a:lnTo>
                  <a:lnTo>
                    <a:pt x="3249" y="18"/>
                  </a:lnTo>
                  <a:lnTo>
                    <a:pt x="3250" y="19"/>
                  </a:lnTo>
                  <a:lnTo>
                    <a:pt x="3251" y="17"/>
                  </a:lnTo>
                  <a:lnTo>
                    <a:pt x="3251" y="19"/>
                  </a:lnTo>
                  <a:lnTo>
                    <a:pt x="3252" y="16"/>
                  </a:lnTo>
                  <a:lnTo>
                    <a:pt x="3253" y="19"/>
                  </a:lnTo>
                  <a:lnTo>
                    <a:pt x="3254" y="19"/>
                  </a:lnTo>
                  <a:lnTo>
                    <a:pt x="3255" y="16"/>
                  </a:lnTo>
                  <a:lnTo>
                    <a:pt x="3256" y="15"/>
                  </a:lnTo>
                  <a:lnTo>
                    <a:pt x="3257" y="17"/>
                  </a:lnTo>
                  <a:lnTo>
                    <a:pt x="3258" y="16"/>
                  </a:lnTo>
                  <a:lnTo>
                    <a:pt x="3259" y="17"/>
                  </a:lnTo>
                  <a:lnTo>
                    <a:pt x="3259" y="17"/>
                  </a:lnTo>
                  <a:lnTo>
                    <a:pt x="3260" y="17"/>
                  </a:lnTo>
                  <a:lnTo>
                    <a:pt x="3261" y="17"/>
                  </a:lnTo>
                  <a:lnTo>
                    <a:pt x="3262" y="15"/>
                  </a:lnTo>
                  <a:lnTo>
                    <a:pt x="3263" y="14"/>
                  </a:lnTo>
                  <a:lnTo>
                    <a:pt x="3264" y="17"/>
                  </a:lnTo>
                  <a:lnTo>
                    <a:pt x="3265" y="15"/>
                  </a:lnTo>
                  <a:lnTo>
                    <a:pt x="3266" y="14"/>
                  </a:lnTo>
                  <a:lnTo>
                    <a:pt x="3266" y="16"/>
                  </a:lnTo>
                  <a:lnTo>
                    <a:pt x="3267" y="11"/>
                  </a:lnTo>
                  <a:lnTo>
                    <a:pt x="3268" y="15"/>
                  </a:lnTo>
                  <a:lnTo>
                    <a:pt x="3269" y="15"/>
                  </a:lnTo>
                  <a:lnTo>
                    <a:pt x="3270" y="17"/>
                  </a:lnTo>
                  <a:lnTo>
                    <a:pt x="3271" y="13"/>
                  </a:lnTo>
                  <a:lnTo>
                    <a:pt x="3272" y="15"/>
                  </a:lnTo>
                  <a:lnTo>
                    <a:pt x="3273" y="15"/>
                  </a:lnTo>
                  <a:lnTo>
                    <a:pt x="3273" y="14"/>
                  </a:lnTo>
                  <a:lnTo>
                    <a:pt x="3274" y="13"/>
                  </a:lnTo>
                  <a:lnTo>
                    <a:pt x="3275" y="15"/>
                  </a:lnTo>
                  <a:lnTo>
                    <a:pt x="3276" y="14"/>
                  </a:lnTo>
                  <a:lnTo>
                    <a:pt x="3277" y="13"/>
                  </a:lnTo>
                  <a:lnTo>
                    <a:pt x="3278" y="16"/>
                  </a:lnTo>
                  <a:lnTo>
                    <a:pt x="3279" y="17"/>
                  </a:lnTo>
                  <a:lnTo>
                    <a:pt x="3280" y="16"/>
                  </a:lnTo>
                  <a:lnTo>
                    <a:pt x="3281" y="17"/>
                  </a:lnTo>
                  <a:lnTo>
                    <a:pt x="3281" y="20"/>
                  </a:lnTo>
                  <a:lnTo>
                    <a:pt x="3282" y="19"/>
                  </a:lnTo>
                  <a:lnTo>
                    <a:pt x="3283" y="22"/>
                  </a:lnTo>
                  <a:lnTo>
                    <a:pt x="3284" y="27"/>
                  </a:lnTo>
                  <a:lnTo>
                    <a:pt x="3285" y="34"/>
                  </a:lnTo>
                  <a:lnTo>
                    <a:pt x="3286" y="43"/>
                  </a:lnTo>
                  <a:lnTo>
                    <a:pt x="3287" y="60"/>
                  </a:lnTo>
                  <a:lnTo>
                    <a:pt x="3288" y="72"/>
                  </a:lnTo>
                  <a:lnTo>
                    <a:pt x="3288" y="92"/>
                  </a:lnTo>
                  <a:lnTo>
                    <a:pt x="3289" y="114"/>
                  </a:lnTo>
                  <a:lnTo>
                    <a:pt x="3290" y="130"/>
                  </a:lnTo>
                  <a:lnTo>
                    <a:pt x="3291" y="138"/>
                  </a:lnTo>
                  <a:lnTo>
                    <a:pt x="3292" y="142"/>
                  </a:lnTo>
                  <a:lnTo>
                    <a:pt x="3293" y="137"/>
                  </a:lnTo>
                  <a:lnTo>
                    <a:pt x="3294" y="144"/>
                  </a:lnTo>
                  <a:lnTo>
                    <a:pt x="3295" y="134"/>
                  </a:lnTo>
                  <a:lnTo>
                    <a:pt x="3296" y="116"/>
                  </a:lnTo>
                  <a:lnTo>
                    <a:pt x="3296" y="109"/>
                  </a:lnTo>
                  <a:lnTo>
                    <a:pt x="3297" y="97"/>
                  </a:lnTo>
                  <a:lnTo>
                    <a:pt x="3298" y="81"/>
                  </a:lnTo>
                  <a:lnTo>
                    <a:pt x="3299" y="78"/>
                  </a:lnTo>
                  <a:lnTo>
                    <a:pt x="3300" y="62"/>
                  </a:lnTo>
                  <a:lnTo>
                    <a:pt x="3301" y="55"/>
                  </a:lnTo>
                  <a:lnTo>
                    <a:pt x="3302" y="58"/>
                  </a:lnTo>
                  <a:lnTo>
                    <a:pt x="3303" y="52"/>
                  </a:lnTo>
                  <a:lnTo>
                    <a:pt x="3303" y="51"/>
                  </a:lnTo>
                  <a:lnTo>
                    <a:pt x="3304" y="42"/>
                  </a:lnTo>
                  <a:lnTo>
                    <a:pt x="3305" y="37"/>
                  </a:lnTo>
                  <a:lnTo>
                    <a:pt x="3306" y="33"/>
                  </a:lnTo>
                  <a:lnTo>
                    <a:pt x="3307" y="34"/>
                  </a:lnTo>
                  <a:lnTo>
                    <a:pt x="3308" y="35"/>
                  </a:lnTo>
                  <a:lnTo>
                    <a:pt x="3309" y="32"/>
                  </a:lnTo>
                  <a:lnTo>
                    <a:pt x="3310" y="32"/>
                  </a:lnTo>
                  <a:lnTo>
                    <a:pt x="3311" y="29"/>
                  </a:lnTo>
                  <a:lnTo>
                    <a:pt x="3311" y="26"/>
                  </a:lnTo>
                  <a:lnTo>
                    <a:pt x="3312" y="27"/>
                  </a:lnTo>
                  <a:lnTo>
                    <a:pt x="3313" y="25"/>
                  </a:lnTo>
                  <a:lnTo>
                    <a:pt x="3314" y="25"/>
                  </a:lnTo>
                  <a:lnTo>
                    <a:pt x="3315" y="25"/>
                  </a:lnTo>
                  <a:lnTo>
                    <a:pt x="3316" y="21"/>
                  </a:lnTo>
                  <a:lnTo>
                    <a:pt x="3317" y="21"/>
                  </a:lnTo>
                  <a:lnTo>
                    <a:pt x="3318" y="20"/>
                  </a:lnTo>
                  <a:lnTo>
                    <a:pt x="3318" y="20"/>
                  </a:lnTo>
                  <a:lnTo>
                    <a:pt x="3319" y="21"/>
                  </a:lnTo>
                  <a:lnTo>
                    <a:pt x="3320" y="21"/>
                  </a:lnTo>
                  <a:lnTo>
                    <a:pt x="3321" y="20"/>
                  </a:lnTo>
                  <a:lnTo>
                    <a:pt x="3322" y="17"/>
                  </a:lnTo>
                  <a:lnTo>
                    <a:pt x="3323" y="19"/>
                  </a:lnTo>
                  <a:lnTo>
                    <a:pt x="3324" y="18"/>
                  </a:lnTo>
                  <a:lnTo>
                    <a:pt x="3325" y="19"/>
                  </a:lnTo>
                  <a:lnTo>
                    <a:pt x="3326" y="18"/>
                  </a:lnTo>
                  <a:lnTo>
                    <a:pt x="3326" y="15"/>
                  </a:lnTo>
                  <a:lnTo>
                    <a:pt x="3327" y="17"/>
                  </a:lnTo>
                  <a:lnTo>
                    <a:pt x="3328" y="19"/>
                  </a:lnTo>
                  <a:lnTo>
                    <a:pt x="3329" y="17"/>
                  </a:lnTo>
                  <a:lnTo>
                    <a:pt x="3330" y="15"/>
                  </a:lnTo>
                  <a:lnTo>
                    <a:pt x="3331" y="13"/>
                  </a:lnTo>
                  <a:lnTo>
                    <a:pt x="3332" y="17"/>
                  </a:lnTo>
                  <a:lnTo>
                    <a:pt x="3333" y="13"/>
                  </a:lnTo>
                  <a:lnTo>
                    <a:pt x="3333" y="13"/>
                  </a:lnTo>
                  <a:lnTo>
                    <a:pt x="3334" y="12"/>
                  </a:lnTo>
                  <a:lnTo>
                    <a:pt x="3335" y="13"/>
                  </a:lnTo>
                  <a:lnTo>
                    <a:pt x="3336" y="12"/>
                  </a:lnTo>
                  <a:lnTo>
                    <a:pt x="3337" y="12"/>
                  </a:lnTo>
                  <a:lnTo>
                    <a:pt x="3338" y="15"/>
                  </a:lnTo>
                  <a:lnTo>
                    <a:pt x="3339" y="14"/>
                  </a:lnTo>
                  <a:lnTo>
                    <a:pt x="3340" y="12"/>
                  </a:lnTo>
                  <a:lnTo>
                    <a:pt x="3341" y="11"/>
                  </a:lnTo>
                  <a:lnTo>
                    <a:pt x="3341" y="12"/>
                  </a:lnTo>
                  <a:lnTo>
                    <a:pt x="3342" y="14"/>
                  </a:lnTo>
                  <a:lnTo>
                    <a:pt x="3343" y="11"/>
                  </a:lnTo>
                  <a:lnTo>
                    <a:pt x="3344" y="12"/>
                  </a:lnTo>
                  <a:lnTo>
                    <a:pt x="3345" y="15"/>
                  </a:lnTo>
                  <a:lnTo>
                    <a:pt x="3346" y="13"/>
                  </a:lnTo>
                  <a:lnTo>
                    <a:pt x="3347" y="13"/>
                  </a:lnTo>
                  <a:lnTo>
                    <a:pt x="3348" y="10"/>
                  </a:lnTo>
                  <a:lnTo>
                    <a:pt x="3348" y="11"/>
                  </a:lnTo>
                  <a:lnTo>
                    <a:pt x="3349" y="16"/>
                  </a:lnTo>
                  <a:lnTo>
                    <a:pt x="3350" y="14"/>
                  </a:lnTo>
                  <a:lnTo>
                    <a:pt x="3351" y="15"/>
                  </a:lnTo>
                  <a:lnTo>
                    <a:pt x="3352" y="15"/>
                  </a:lnTo>
                  <a:lnTo>
                    <a:pt x="3353" y="13"/>
                  </a:lnTo>
                  <a:lnTo>
                    <a:pt x="3354" y="12"/>
                  </a:lnTo>
                  <a:lnTo>
                    <a:pt x="3355" y="10"/>
                  </a:lnTo>
                  <a:lnTo>
                    <a:pt x="3356" y="14"/>
                  </a:lnTo>
                  <a:lnTo>
                    <a:pt x="3356" y="11"/>
                  </a:lnTo>
                  <a:lnTo>
                    <a:pt x="3357" y="13"/>
                  </a:lnTo>
                  <a:lnTo>
                    <a:pt x="3358" y="12"/>
                  </a:lnTo>
                  <a:lnTo>
                    <a:pt x="3359" y="12"/>
                  </a:lnTo>
                  <a:lnTo>
                    <a:pt x="3360" y="11"/>
                  </a:lnTo>
                  <a:lnTo>
                    <a:pt x="3361" y="8"/>
                  </a:lnTo>
                  <a:lnTo>
                    <a:pt x="3362" y="10"/>
                  </a:lnTo>
                  <a:lnTo>
                    <a:pt x="3363" y="11"/>
                  </a:lnTo>
                  <a:lnTo>
                    <a:pt x="3363" y="8"/>
                  </a:lnTo>
                  <a:lnTo>
                    <a:pt x="3364" y="9"/>
                  </a:lnTo>
                  <a:lnTo>
                    <a:pt x="3365" y="14"/>
                  </a:lnTo>
                  <a:lnTo>
                    <a:pt x="3366" y="10"/>
                  </a:lnTo>
                  <a:lnTo>
                    <a:pt x="3367" y="9"/>
                  </a:lnTo>
                  <a:lnTo>
                    <a:pt x="3368" y="9"/>
                  </a:lnTo>
                  <a:lnTo>
                    <a:pt x="3369" y="9"/>
                  </a:lnTo>
                  <a:lnTo>
                    <a:pt x="3370" y="8"/>
                  </a:lnTo>
                  <a:lnTo>
                    <a:pt x="3371" y="8"/>
                  </a:lnTo>
                  <a:lnTo>
                    <a:pt x="3371" y="8"/>
                  </a:lnTo>
                  <a:lnTo>
                    <a:pt x="3372" y="10"/>
                  </a:lnTo>
                  <a:lnTo>
                    <a:pt x="3373" y="8"/>
                  </a:lnTo>
                  <a:lnTo>
                    <a:pt x="3374" y="7"/>
                  </a:lnTo>
                  <a:lnTo>
                    <a:pt x="3375" y="9"/>
                  </a:lnTo>
                  <a:lnTo>
                    <a:pt x="3376" y="8"/>
                  </a:lnTo>
                  <a:lnTo>
                    <a:pt x="3377" y="7"/>
                  </a:lnTo>
                  <a:lnTo>
                    <a:pt x="3378" y="8"/>
                  </a:lnTo>
                  <a:lnTo>
                    <a:pt x="3378" y="8"/>
                  </a:lnTo>
                  <a:lnTo>
                    <a:pt x="3379" y="9"/>
                  </a:lnTo>
                  <a:lnTo>
                    <a:pt x="3380" y="8"/>
                  </a:lnTo>
                  <a:lnTo>
                    <a:pt x="3381" y="9"/>
                  </a:lnTo>
                  <a:lnTo>
                    <a:pt x="3382" y="9"/>
                  </a:lnTo>
                  <a:lnTo>
                    <a:pt x="3383" y="6"/>
                  </a:lnTo>
                  <a:lnTo>
                    <a:pt x="3384" y="9"/>
                  </a:lnTo>
                  <a:lnTo>
                    <a:pt x="3385" y="10"/>
                  </a:lnTo>
                  <a:lnTo>
                    <a:pt x="3386" y="5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36" name="Freeform 566"/>
            <p:cNvSpPr>
              <a:spLocks/>
            </p:cNvSpPr>
            <p:nvPr/>
          </p:nvSpPr>
          <p:spPr bwMode="auto">
            <a:xfrm flipV="1">
              <a:off x="-3032125" y="5016500"/>
              <a:ext cx="2352675" cy="1438275"/>
            </a:xfrm>
            <a:custGeom>
              <a:avLst/>
              <a:gdLst>
                <a:gd name="T0" fmla="*/ 52 w 3385"/>
                <a:gd name="T1" fmla="*/ 7 h 4511"/>
                <a:gd name="T2" fmla="*/ 104 w 3385"/>
                <a:gd name="T3" fmla="*/ 7 h 4511"/>
                <a:gd name="T4" fmla="*/ 157 w 3385"/>
                <a:gd name="T5" fmla="*/ 3 h 4511"/>
                <a:gd name="T6" fmla="*/ 210 w 3385"/>
                <a:gd name="T7" fmla="*/ 19 h 4511"/>
                <a:gd name="T8" fmla="*/ 263 w 3385"/>
                <a:gd name="T9" fmla="*/ 7 h 4511"/>
                <a:gd name="T10" fmla="*/ 316 w 3385"/>
                <a:gd name="T11" fmla="*/ 9 h 4511"/>
                <a:gd name="T12" fmla="*/ 369 w 3385"/>
                <a:gd name="T13" fmla="*/ 12 h 4511"/>
                <a:gd name="T14" fmla="*/ 422 w 3385"/>
                <a:gd name="T15" fmla="*/ 2 h 4511"/>
                <a:gd name="T16" fmla="*/ 475 w 3385"/>
                <a:gd name="T17" fmla="*/ 1 h 4511"/>
                <a:gd name="T18" fmla="*/ 528 w 3385"/>
                <a:gd name="T19" fmla="*/ 2 h 4511"/>
                <a:gd name="T20" fmla="*/ 581 w 3385"/>
                <a:gd name="T21" fmla="*/ 2 h 4511"/>
                <a:gd name="T22" fmla="*/ 634 w 3385"/>
                <a:gd name="T23" fmla="*/ 7 h 4511"/>
                <a:gd name="T24" fmla="*/ 687 w 3385"/>
                <a:gd name="T25" fmla="*/ 4 h 4511"/>
                <a:gd name="T26" fmla="*/ 740 w 3385"/>
                <a:gd name="T27" fmla="*/ 8 h 4511"/>
                <a:gd name="T28" fmla="*/ 793 w 3385"/>
                <a:gd name="T29" fmla="*/ 13 h 4511"/>
                <a:gd name="T30" fmla="*/ 845 w 3385"/>
                <a:gd name="T31" fmla="*/ 18 h 4511"/>
                <a:gd name="T32" fmla="*/ 898 w 3385"/>
                <a:gd name="T33" fmla="*/ 2 h 4511"/>
                <a:gd name="T34" fmla="*/ 951 w 3385"/>
                <a:gd name="T35" fmla="*/ 4 h 4511"/>
                <a:gd name="T36" fmla="*/ 1004 w 3385"/>
                <a:gd name="T37" fmla="*/ 17 h 4511"/>
                <a:gd name="T38" fmla="*/ 1057 w 3385"/>
                <a:gd name="T39" fmla="*/ 9 h 4511"/>
                <a:gd name="T40" fmla="*/ 1110 w 3385"/>
                <a:gd name="T41" fmla="*/ 4 h 4511"/>
                <a:gd name="T42" fmla="*/ 1163 w 3385"/>
                <a:gd name="T43" fmla="*/ 8 h 4511"/>
                <a:gd name="T44" fmla="*/ 1216 w 3385"/>
                <a:gd name="T45" fmla="*/ 4 h 4511"/>
                <a:gd name="T46" fmla="*/ 1269 w 3385"/>
                <a:gd name="T47" fmla="*/ 8 h 4511"/>
                <a:gd name="T48" fmla="*/ 1322 w 3385"/>
                <a:gd name="T49" fmla="*/ 16 h 4511"/>
                <a:gd name="T50" fmla="*/ 1375 w 3385"/>
                <a:gd name="T51" fmla="*/ 25 h 4511"/>
                <a:gd name="T52" fmla="*/ 1428 w 3385"/>
                <a:gd name="T53" fmla="*/ 38 h 4511"/>
                <a:gd name="T54" fmla="*/ 1481 w 3385"/>
                <a:gd name="T55" fmla="*/ 14 h 4511"/>
                <a:gd name="T56" fmla="*/ 1533 w 3385"/>
                <a:gd name="T57" fmla="*/ 63 h 4511"/>
                <a:gd name="T58" fmla="*/ 1586 w 3385"/>
                <a:gd name="T59" fmla="*/ 8 h 4511"/>
                <a:gd name="T60" fmla="*/ 1639 w 3385"/>
                <a:gd name="T61" fmla="*/ 28 h 4511"/>
                <a:gd name="T62" fmla="*/ 1692 w 3385"/>
                <a:gd name="T63" fmla="*/ 8 h 4511"/>
                <a:gd name="T64" fmla="*/ 1745 w 3385"/>
                <a:gd name="T65" fmla="*/ 25 h 4511"/>
                <a:gd name="T66" fmla="*/ 1798 w 3385"/>
                <a:gd name="T67" fmla="*/ 3736 h 4511"/>
                <a:gd name="T68" fmla="*/ 1851 w 3385"/>
                <a:gd name="T69" fmla="*/ 124 h 4511"/>
                <a:gd name="T70" fmla="*/ 1904 w 3385"/>
                <a:gd name="T71" fmla="*/ 62 h 4511"/>
                <a:gd name="T72" fmla="*/ 1957 w 3385"/>
                <a:gd name="T73" fmla="*/ 51 h 4511"/>
                <a:gd name="T74" fmla="*/ 2010 w 3385"/>
                <a:gd name="T75" fmla="*/ 34 h 4511"/>
                <a:gd name="T76" fmla="*/ 2063 w 3385"/>
                <a:gd name="T77" fmla="*/ 43 h 4511"/>
                <a:gd name="T78" fmla="*/ 2116 w 3385"/>
                <a:gd name="T79" fmla="*/ 51 h 4511"/>
                <a:gd name="T80" fmla="*/ 2169 w 3385"/>
                <a:gd name="T81" fmla="*/ 47 h 4511"/>
                <a:gd name="T82" fmla="*/ 2222 w 3385"/>
                <a:gd name="T83" fmla="*/ 37 h 4511"/>
                <a:gd name="T84" fmla="*/ 2274 w 3385"/>
                <a:gd name="T85" fmla="*/ 53 h 4511"/>
                <a:gd name="T86" fmla="*/ 2327 w 3385"/>
                <a:gd name="T87" fmla="*/ 32 h 4511"/>
                <a:gd name="T88" fmla="*/ 2380 w 3385"/>
                <a:gd name="T89" fmla="*/ 32 h 4511"/>
                <a:gd name="T90" fmla="*/ 2433 w 3385"/>
                <a:gd name="T91" fmla="*/ 381 h 4511"/>
                <a:gd name="T92" fmla="*/ 2486 w 3385"/>
                <a:gd name="T93" fmla="*/ 82 h 4511"/>
                <a:gd name="T94" fmla="*/ 2539 w 3385"/>
                <a:gd name="T95" fmla="*/ 128 h 4511"/>
                <a:gd name="T96" fmla="*/ 2592 w 3385"/>
                <a:gd name="T97" fmla="*/ 77 h 4511"/>
                <a:gd name="T98" fmla="*/ 2645 w 3385"/>
                <a:gd name="T99" fmla="*/ 108 h 4511"/>
                <a:gd name="T100" fmla="*/ 2698 w 3385"/>
                <a:gd name="T101" fmla="*/ 52 h 4511"/>
                <a:gd name="T102" fmla="*/ 2751 w 3385"/>
                <a:gd name="T103" fmla="*/ 38 h 4511"/>
                <a:gd name="T104" fmla="*/ 2804 w 3385"/>
                <a:gd name="T105" fmla="*/ 38 h 4511"/>
                <a:gd name="T106" fmla="*/ 2857 w 3385"/>
                <a:gd name="T107" fmla="*/ 28 h 4511"/>
                <a:gd name="T108" fmla="*/ 2910 w 3385"/>
                <a:gd name="T109" fmla="*/ 35 h 4511"/>
                <a:gd name="T110" fmla="*/ 2962 w 3385"/>
                <a:gd name="T111" fmla="*/ 186 h 4511"/>
                <a:gd name="T112" fmla="*/ 3015 w 3385"/>
                <a:gd name="T113" fmla="*/ 30 h 4511"/>
                <a:gd name="T114" fmla="*/ 3068 w 3385"/>
                <a:gd name="T115" fmla="*/ 25 h 4511"/>
                <a:gd name="T116" fmla="*/ 3121 w 3385"/>
                <a:gd name="T117" fmla="*/ 25 h 4511"/>
                <a:gd name="T118" fmla="*/ 3174 w 3385"/>
                <a:gd name="T119" fmla="*/ 591 h 4511"/>
                <a:gd name="T120" fmla="*/ 3227 w 3385"/>
                <a:gd name="T121" fmla="*/ 146 h 4511"/>
                <a:gd name="T122" fmla="*/ 3280 w 3385"/>
                <a:gd name="T123" fmla="*/ 92 h 4511"/>
                <a:gd name="T124" fmla="*/ 3333 w 3385"/>
                <a:gd name="T125" fmla="*/ 50 h 45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3385" h="4511">
                  <a:moveTo>
                    <a:pt x="0" y="4"/>
                  </a:moveTo>
                  <a:lnTo>
                    <a:pt x="0" y="6"/>
                  </a:lnTo>
                  <a:lnTo>
                    <a:pt x="1" y="4"/>
                  </a:lnTo>
                  <a:lnTo>
                    <a:pt x="2" y="7"/>
                  </a:lnTo>
                  <a:lnTo>
                    <a:pt x="3" y="7"/>
                  </a:lnTo>
                  <a:lnTo>
                    <a:pt x="4" y="6"/>
                  </a:lnTo>
                  <a:lnTo>
                    <a:pt x="5" y="5"/>
                  </a:lnTo>
                  <a:lnTo>
                    <a:pt x="6" y="7"/>
                  </a:lnTo>
                  <a:lnTo>
                    <a:pt x="7" y="5"/>
                  </a:lnTo>
                  <a:lnTo>
                    <a:pt x="7" y="5"/>
                  </a:lnTo>
                  <a:lnTo>
                    <a:pt x="8" y="6"/>
                  </a:lnTo>
                  <a:lnTo>
                    <a:pt x="9" y="10"/>
                  </a:lnTo>
                  <a:lnTo>
                    <a:pt x="10" y="8"/>
                  </a:lnTo>
                  <a:lnTo>
                    <a:pt x="11" y="10"/>
                  </a:lnTo>
                  <a:lnTo>
                    <a:pt x="12" y="12"/>
                  </a:lnTo>
                  <a:lnTo>
                    <a:pt x="13" y="9"/>
                  </a:lnTo>
                  <a:lnTo>
                    <a:pt x="14" y="9"/>
                  </a:lnTo>
                  <a:lnTo>
                    <a:pt x="15" y="8"/>
                  </a:lnTo>
                  <a:lnTo>
                    <a:pt x="15" y="11"/>
                  </a:lnTo>
                  <a:lnTo>
                    <a:pt x="16" y="10"/>
                  </a:lnTo>
                  <a:lnTo>
                    <a:pt x="17" y="6"/>
                  </a:lnTo>
                  <a:lnTo>
                    <a:pt x="18" y="11"/>
                  </a:lnTo>
                  <a:lnTo>
                    <a:pt x="19" y="11"/>
                  </a:lnTo>
                  <a:lnTo>
                    <a:pt x="20" y="8"/>
                  </a:lnTo>
                  <a:lnTo>
                    <a:pt x="21" y="8"/>
                  </a:lnTo>
                  <a:lnTo>
                    <a:pt x="22" y="8"/>
                  </a:lnTo>
                  <a:lnTo>
                    <a:pt x="22" y="6"/>
                  </a:lnTo>
                  <a:lnTo>
                    <a:pt x="23" y="9"/>
                  </a:lnTo>
                  <a:lnTo>
                    <a:pt x="24" y="7"/>
                  </a:lnTo>
                  <a:lnTo>
                    <a:pt x="25" y="7"/>
                  </a:lnTo>
                  <a:lnTo>
                    <a:pt x="26" y="7"/>
                  </a:lnTo>
                  <a:lnTo>
                    <a:pt x="27" y="7"/>
                  </a:lnTo>
                  <a:lnTo>
                    <a:pt x="28" y="9"/>
                  </a:lnTo>
                  <a:lnTo>
                    <a:pt x="29" y="6"/>
                  </a:lnTo>
                  <a:lnTo>
                    <a:pt x="30" y="7"/>
                  </a:lnTo>
                  <a:lnTo>
                    <a:pt x="30" y="6"/>
                  </a:lnTo>
                  <a:lnTo>
                    <a:pt x="31" y="6"/>
                  </a:lnTo>
                  <a:lnTo>
                    <a:pt x="32" y="5"/>
                  </a:lnTo>
                  <a:lnTo>
                    <a:pt x="33" y="7"/>
                  </a:lnTo>
                  <a:lnTo>
                    <a:pt x="34" y="7"/>
                  </a:lnTo>
                  <a:lnTo>
                    <a:pt x="35" y="5"/>
                  </a:lnTo>
                  <a:lnTo>
                    <a:pt x="36" y="8"/>
                  </a:lnTo>
                  <a:lnTo>
                    <a:pt x="37" y="7"/>
                  </a:lnTo>
                  <a:lnTo>
                    <a:pt x="37" y="14"/>
                  </a:lnTo>
                  <a:lnTo>
                    <a:pt x="38" y="10"/>
                  </a:lnTo>
                  <a:lnTo>
                    <a:pt x="39" y="14"/>
                  </a:lnTo>
                  <a:lnTo>
                    <a:pt x="40" y="17"/>
                  </a:lnTo>
                  <a:lnTo>
                    <a:pt x="41" y="15"/>
                  </a:lnTo>
                  <a:lnTo>
                    <a:pt x="42" y="14"/>
                  </a:lnTo>
                  <a:lnTo>
                    <a:pt x="43" y="15"/>
                  </a:lnTo>
                  <a:lnTo>
                    <a:pt x="44" y="17"/>
                  </a:lnTo>
                  <a:lnTo>
                    <a:pt x="45" y="16"/>
                  </a:lnTo>
                  <a:lnTo>
                    <a:pt x="45" y="13"/>
                  </a:lnTo>
                  <a:lnTo>
                    <a:pt x="46" y="9"/>
                  </a:lnTo>
                  <a:lnTo>
                    <a:pt x="47" y="11"/>
                  </a:lnTo>
                  <a:lnTo>
                    <a:pt x="48" y="10"/>
                  </a:lnTo>
                  <a:lnTo>
                    <a:pt x="49" y="8"/>
                  </a:lnTo>
                  <a:lnTo>
                    <a:pt x="50" y="7"/>
                  </a:lnTo>
                  <a:lnTo>
                    <a:pt x="51" y="10"/>
                  </a:lnTo>
                  <a:lnTo>
                    <a:pt x="52" y="7"/>
                  </a:lnTo>
                  <a:lnTo>
                    <a:pt x="52" y="8"/>
                  </a:lnTo>
                  <a:lnTo>
                    <a:pt x="53" y="8"/>
                  </a:lnTo>
                  <a:lnTo>
                    <a:pt x="54" y="7"/>
                  </a:lnTo>
                  <a:lnTo>
                    <a:pt x="55" y="8"/>
                  </a:lnTo>
                  <a:lnTo>
                    <a:pt x="56" y="5"/>
                  </a:lnTo>
                  <a:lnTo>
                    <a:pt x="57" y="7"/>
                  </a:lnTo>
                  <a:lnTo>
                    <a:pt x="58" y="5"/>
                  </a:lnTo>
                  <a:lnTo>
                    <a:pt x="59" y="4"/>
                  </a:lnTo>
                  <a:lnTo>
                    <a:pt x="60" y="4"/>
                  </a:lnTo>
                  <a:lnTo>
                    <a:pt x="60" y="3"/>
                  </a:lnTo>
                  <a:lnTo>
                    <a:pt x="61" y="5"/>
                  </a:lnTo>
                  <a:lnTo>
                    <a:pt x="62" y="5"/>
                  </a:lnTo>
                  <a:lnTo>
                    <a:pt x="63" y="4"/>
                  </a:lnTo>
                  <a:lnTo>
                    <a:pt x="64" y="3"/>
                  </a:lnTo>
                  <a:lnTo>
                    <a:pt x="65" y="4"/>
                  </a:lnTo>
                  <a:lnTo>
                    <a:pt x="66" y="5"/>
                  </a:lnTo>
                  <a:lnTo>
                    <a:pt x="67" y="4"/>
                  </a:lnTo>
                  <a:lnTo>
                    <a:pt x="67" y="5"/>
                  </a:lnTo>
                  <a:lnTo>
                    <a:pt x="68" y="4"/>
                  </a:lnTo>
                  <a:lnTo>
                    <a:pt x="69" y="5"/>
                  </a:lnTo>
                  <a:lnTo>
                    <a:pt x="70" y="4"/>
                  </a:lnTo>
                  <a:lnTo>
                    <a:pt x="71" y="3"/>
                  </a:lnTo>
                  <a:lnTo>
                    <a:pt x="72" y="5"/>
                  </a:lnTo>
                  <a:lnTo>
                    <a:pt x="73" y="3"/>
                  </a:lnTo>
                  <a:lnTo>
                    <a:pt x="74" y="3"/>
                  </a:lnTo>
                  <a:lnTo>
                    <a:pt x="74" y="3"/>
                  </a:lnTo>
                  <a:lnTo>
                    <a:pt x="75" y="3"/>
                  </a:lnTo>
                  <a:lnTo>
                    <a:pt x="76" y="3"/>
                  </a:lnTo>
                  <a:lnTo>
                    <a:pt x="77" y="5"/>
                  </a:lnTo>
                  <a:lnTo>
                    <a:pt x="78" y="2"/>
                  </a:lnTo>
                  <a:lnTo>
                    <a:pt x="79" y="3"/>
                  </a:lnTo>
                  <a:lnTo>
                    <a:pt x="80" y="5"/>
                  </a:lnTo>
                  <a:lnTo>
                    <a:pt x="81" y="5"/>
                  </a:lnTo>
                  <a:lnTo>
                    <a:pt x="82" y="4"/>
                  </a:lnTo>
                  <a:lnTo>
                    <a:pt x="82" y="6"/>
                  </a:lnTo>
                  <a:lnTo>
                    <a:pt x="83" y="5"/>
                  </a:lnTo>
                  <a:lnTo>
                    <a:pt x="84" y="5"/>
                  </a:lnTo>
                  <a:lnTo>
                    <a:pt x="85" y="7"/>
                  </a:lnTo>
                  <a:lnTo>
                    <a:pt x="86" y="8"/>
                  </a:lnTo>
                  <a:lnTo>
                    <a:pt x="87" y="8"/>
                  </a:lnTo>
                  <a:lnTo>
                    <a:pt x="88" y="10"/>
                  </a:lnTo>
                  <a:lnTo>
                    <a:pt x="89" y="7"/>
                  </a:lnTo>
                  <a:lnTo>
                    <a:pt x="89" y="9"/>
                  </a:lnTo>
                  <a:lnTo>
                    <a:pt x="90" y="8"/>
                  </a:lnTo>
                  <a:lnTo>
                    <a:pt x="91" y="9"/>
                  </a:lnTo>
                  <a:lnTo>
                    <a:pt x="92" y="5"/>
                  </a:lnTo>
                  <a:lnTo>
                    <a:pt x="93" y="5"/>
                  </a:lnTo>
                  <a:lnTo>
                    <a:pt x="94" y="7"/>
                  </a:lnTo>
                  <a:lnTo>
                    <a:pt x="95" y="3"/>
                  </a:lnTo>
                  <a:lnTo>
                    <a:pt x="96" y="7"/>
                  </a:lnTo>
                  <a:lnTo>
                    <a:pt x="97" y="5"/>
                  </a:lnTo>
                  <a:lnTo>
                    <a:pt x="97" y="5"/>
                  </a:lnTo>
                  <a:lnTo>
                    <a:pt x="98" y="5"/>
                  </a:lnTo>
                  <a:lnTo>
                    <a:pt x="99" y="8"/>
                  </a:lnTo>
                  <a:lnTo>
                    <a:pt x="100" y="5"/>
                  </a:lnTo>
                  <a:lnTo>
                    <a:pt x="101" y="7"/>
                  </a:lnTo>
                  <a:lnTo>
                    <a:pt x="102" y="6"/>
                  </a:lnTo>
                  <a:lnTo>
                    <a:pt x="103" y="7"/>
                  </a:lnTo>
                  <a:lnTo>
                    <a:pt x="104" y="6"/>
                  </a:lnTo>
                  <a:lnTo>
                    <a:pt x="104" y="7"/>
                  </a:lnTo>
                  <a:lnTo>
                    <a:pt x="105" y="4"/>
                  </a:lnTo>
                  <a:lnTo>
                    <a:pt x="106" y="3"/>
                  </a:lnTo>
                  <a:lnTo>
                    <a:pt x="107" y="6"/>
                  </a:lnTo>
                  <a:lnTo>
                    <a:pt x="108" y="5"/>
                  </a:lnTo>
                  <a:lnTo>
                    <a:pt x="109" y="5"/>
                  </a:lnTo>
                  <a:lnTo>
                    <a:pt x="110" y="7"/>
                  </a:lnTo>
                  <a:lnTo>
                    <a:pt x="111" y="5"/>
                  </a:lnTo>
                  <a:lnTo>
                    <a:pt x="112" y="4"/>
                  </a:lnTo>
                  <a:lnTo>
                    <a:pt x="112" y="2"/>
                  </a:lnTo>
                  <a:lnTo>
                    <a:pt x="113" y="7"/>
                  </a:lnTo>
                  <a:lnTo>
                    <a:pt x="114" y="2"/>
                  </a:lnTo>
                  <a:lnTo>
                    <a:pt x="115" y="3"/>
                  </a:lnTo>
                  <a:lnTo>
                    <a:pt x="116" y="3"/>
                  </a:lnTo>
                  <a:lnTo>
                    <a:pt x="117" y="5"/>
                  </a:lnTo>
                  <a:lnTo>
                    <a:pt x="118" y="5"/>
                  </a:lnTo>
                  <a:lnTo>
                    <a:pt x="119" y="3"/>
                  </a:lnTo>
                  <a:lnTo>
                    <a:pt x="119" y="5"/>
                  </a:lnTo>
                  <a:lnTo>
                    <a:pt x="120" y="6"/>
                  </a:lnTo>
                  <a:lnTo>
                    <a:pt x="121" y="5"/>
                  </a:lnTo>
                  <a:lnTo>
                    <a:pt x="122" y="8"/>
                  </a:lnTo>
                  <a:lnTo>
                    <a:pt x="123" y="6"/>
                  </a:lnTo>
                  <a:lnTo>
                    <a:pt x="124" y="6"/>
                  </a:lnTo>
                  <a:lnTo>
                    <a:pt x="125" y="7"/>
                  </a:lnTo>
                  <a:lnTo>
                    <a:pt x="126" y="7"/>
                  </a:lnTo>
                  <a:lnTo>
                    <a:pt x="127" y="8"/>
                  </a:lnTo>
                  <a:lnTo>
                    <a:pt x="127" y="10"/>
                  </a:lnTo>
                  <a:lnTo>
                    <a:pt x="128" y="9"/>
                  </a:lnTo>
                  <a:lnTo>
                    <a:pt x="129" y="10"/>
                  </a:lnTo>
                  <a:lnTo>
                    <a:pt x="130" y="8"/>
                  </a:lnTo>
                  <a:lnTo>
                    <a:pt x="131" y="9"/>
                  </a:lnTo>
                  <a:lnTo>
                    <a:pt x="132" y="9"/>
                  </a:lnTo>
                  <a:lnTo>
                    <a:pt x="133" y="8"/>
                  </a:lnTo>
                  <a:lnTo>
                    <a:pt x="134" y="9"/>
                  </a:lnTo>
                  <a:lnTo>
                    <a:pt x="134" y="10"/>
                  </a:lnTo>
                  <a:lnTo>
                    <a:pt x="135" y="10"/>
                  </a:lnTo>
                  <a:lnTo>
                    <a:pt x="136" y="7"/>
                  </a:lnTo>
                  <a:lnTo>
                    <a:pt x="137" y="7"/>
                  </a:lnTo>
                  <a:lnTo>
                    <a:pt x="138" y="7"/>
                  </a:lnTo>
                  <a:lnTo>
                    <a:pt x="139" y="5"/>
                  </a:lnTo>
                  <a:lnTo>
                    <a:pt x="140" y="5"/>
                  </a:lnTo>
                  <a:lnTo>
                    <a:pt x="141" y="5"/>
                  </a:lnTo>
                  <a:lnTo>
                    <a:pt x="142" y="9"/>
                  </a:lnTo>
                  <a:lnTo>
                    <a:pt x="142" y="6"/>
                  </a:lnTo>
                  <a:lnTo>
                    <a:pt x="143" y="4"/>
                  </a:lnTo>
                  <a:lnTo>
                    <a:pt x="144" y="7"/>
                  </a:lnTo>
                  <a:lnTo>
                    <a:pt x="145" y="6"/>
                  </a:lnTo>
                  <a:lnTo>
                    <a:pt x="146" y="3"/>
                  </a:lnTo>
                  <a:lnTo>
                    <a:pt x="147" y="5"/>
                  </a:lnTo>
                  <a:lnTo>
                    <a:pt x="148" y="5"/>
                  </a:lnTo>
                  <a:lnTo>
                    <a:pt x="149" y="6"/>
                  </a:lnTo>
                  <a:lnTo>
                    <a:pt x="149" y="4"/>
                  </a:lnTo>
                  <a:lnTo>
                    <a:pt x="150" y="7"/>
                  </a:lnTo>
                  <a:lnTo>
                    <a:pt x="151" y="5"/>
                  </a:lnTo>
                  <a:lnTo>
                    <a:pt x="152" y="6"/>
                  </a:lnTo>
                  <a:lnTo>
                    <a:pt x="153" y="4"/>
                  </a:lnTo>
                  <a:lnTo>
                    <a:pt x="154" y="8"/>
                  </a:lnTo>
                  <a:lnTo>
                    <a:pt x="155" y="3"/>
                  </a:lnTo>
                  <a:lnTo>
                    <a:pt x="156" y="4"/>
                  </a:lnTo>
                  <a:lnTo>
                    <a:pt x="157" y="4"/>
                  </a:lnTo>
                  <a:lnTo>
                    <a:pt x="157" y="3"/>
                  </a:lnTo>
                  <a:lnTo>
                    <a:pt x="158" y="4"/>
                  </a:lnTo>
                  <a:lnTo>
                    <a:pt x="159" y="4"/>
                  </a:lnTo>
                  <a:lnTo>
                    <a:pt x="160" y="4"/>
                  </a:lnTo>
                  <a:lnTo>
                    <a:pt x="161" y="2"/>
                  </a:lnTo>
                  <a:lnTo>
                    <a:pt x="162" y="4"/>
                  </a:lnTo>
                  <a:lnTo>
                    <a:pt x="163" y="5"/>
                  </a:lnTo>
                  <a:lnTo>
                    <a:pt x="164" y="3"/>
                  </a:lnTo>
                  <a:lnTo>
                    <a:pt x="164" y="5"/>
                  </a:lnTo>
                  <a:lnTo>
                    <a:pt x="165" y="3"/>
                  </a:lnTo>
                  <a:lnTo>
                    <a:pt x="166" y="6"/>
                  </a:lnTo>
                  <a:lnTo>
                    <a:pt x="167" y="3"/>
                  </a:lnTo>
                  <a:lnTo>
                    <a:pt x="168" y="3"/>
                  </a:lnTo>
                  <a:lnTo>
                    <a:pt x="169" y="4"/>
                  </a:lnTo>
                  <a:lnTo>
                    <a:pt x="170" y="4"/>
                  </a:lnTo>
                  <a:lnTo>
                    <a:pt x="171" y="6"/>
                  </a:lnTo>
                  <a:lnTo>
                    <a:pt x="172" y="4"/>
                  </a:lnTo>
                  <a:lnTo>
                    <a:pt x="172" y="8"/>
                  </a:lnTo>
                  <a:lnTo>
                    <a:pt x="173" y="7"/>
                  </a:lnTo>
                  <a:lnTo>
                    <a:pt x="174" y="9"/>
                  </a:lnTo>
                  <a:lnTo>
                    <a:pt x="175" y="8"/>
                  </a:lnTo>
                  <a:lnTo>
                    <a:pt x="176" y="6"/>
                  </a:lnTo>
                  <a:lnTo>
                    <a:pt x="177" y="7"/>
                  </a:lnTo>
                  <a:lnTo>
                    <a:pt x="178" y="7"/>
                  </a:lnTo>
                  <a:lnTo>
                    <a:pt x="179" y="9"/>
                  </a:lnTo>
                  <a:lnTo>
                    <a:pt x="179" y="9"/>
                  </a:lnTo>
                  <a:lnTo>
                    <a:pt x="180" y="6"/>
                  </a:lnTo>
                  <a:lnTo>
                    <a:pt x="181" y="8"/>
                  </a:lnTo>
                  <a:lnTo>
                    <a:pt x="182" y="9"/>
                  </a:lnTo>
                  <a:lnTo>
                    <a:pt x="183" y="8"/>
                  </a:lnTo>
                  <a:lnTo>
                    <a:pt x="184" y="10"/>
                  </a:lnTo>
                  <a:lnTo>
                    <a:pt x="185" y="10"/>
                  </a:lnTo>
                  <a:lnTo>
                    <a:pt x="186" y="9"/>
                  </a:lnTo>
                  <a:lnTo>
                    <a:pt x="187" y="9"/>
                  </a:lnTo>
                  <a:lnTo>
                    <a:pt x="187" y="10"/>
                  </a:lnTo>
                  <a:lnTo>
                    <a:pt x="188" y="9"/>
                  </a:lnTo>
                  <a:lnTo>
                    <a:pt x="189" y="15"/>
                  </a:lnTo>
                  <a:lnTo>
                    <a:pt x="190" y="14"/>
                  </a:lnTo>
                  <a:lnTo>
                    <a:pt x="191" y="17"/>
                  </a:lnTo>
                  <a:lnTo>
                    <a:pt x="192" y="16"/>
                  </a:lnTo>
                  <a:lnTo>
                    <a:pt x="193" y="15"/>
                  </a:lnTo>
                  <a:lnTo>
                    <a:pt x="194" y="21"/>
                  </a:lnTo>
                  <a:lnTo>
                    <a:pt x="194" y="20"/>
                  </a:lnTo>
                  <a:lnTo>
                    <a:pt x="195" y="22"/>
                  </a:lnTo>
                  <a:lnTo>
                    <a:pt x="196" y="20"/>
                  </a:lnTo>
                  <a:lnTo>
                    <a:pt x="197" y="21"/>
                  </a:lnTo>
                  <a:lnTo>
                    <a:pt x="198" y="21"/>
                  </a:lnTo>
                  <a:lnTo>
                    <a:pt x="199" y="23"/>
                  </a:lnTo>
                  <a:lnTo>
                    <a:pt x="200" y="24"/>
                  </a:lnTo>
                  <a:lnTo>
                    <a:pt x="201" y="21"/>
                  </a:lnTo>
                  <a:lnTo>
                    <a:pt x="202" y="22"/>
                  </a:lnTo>
                  <a:lnTo>
                    <a:pt x="202" y="23"/>
                  </a:lnTo>
                  <a:lnTo>
                    <a:pt x="203" y="20"/>
                  </a:lnTo>
                  <a:lnTo>
                    <a:pt x="204" y="23"/>
                  </a:lnTo>
                  <a:lnTo>
                    <a:pt x="205" y="20"/>
                  </a:lnTo>
                  <a:lnTo>
                    <a:pt x="206" y="23"/>
                  </a:lnTo>
                  <a:lnTo>
                    <a:pt x="207" y="24"/>
                  </a:lnTo>
                  <a:lnTo>
                    <a:pt x="208" y="20"/>
                  </a:lnTo>
                  <a:lnTo>
                    <a:pt x="209" y="23"/>
                  </a:lnTo>
                  <a:lnTo>
                    <a:pt x="209" y="17"/>
                  </a:lnTo>
                  <a:lnTo>
                    <a:pt x="210" y="19"/>
                  </a:lnTo>
                  <a:lnTo>
                    <a:pt x="211" y="19"/>
                  </a:lnTo>
                  <a:lnTo>
                    <a:pt x="212" y="22"/>
                  </a:lnTo>
                  <a:lnTo>
                    <a:pt x="213" y="20"/>
                  </a:lnTo>
                  <a:lnTo>
                    <a:pt x="214" y="17"/>
                  </a:lnTo>
                  <a:lnTo>
                    <a:pt x="215" y="18"/>
                  </a:lnTo>
                  <a:lnTo>
                    <a:pt x="216" y="19"/>
                  </a:lnTo>
                  <a:lnTo>
                    <a:pt x="217" y="16"/>
                  </a:lnTo>
                  <a:lnTo>
                    <a:pt x="217" y="14"/>
                  </a:lnTo>
                  <a:lnTo>
                    <a:pt x="218" y="14"/>
                  </a:lnTo>
                  <a:lnTo>
                    <a:pt x="219" y="17"/>
                  </a:lnTo>
                  <a:lnTo>
                    <a:pt x="220" y="17"/>
                  </a:lnTo>
                  <a:lnTo>
                    <a:pt x="221" y="15"/>
                  </a:lnTo>
                  <a:lnTo>
                    <a:pt x="222" y="16"/>
                  </a:lnTo>
                  <a:lnTo>
                    <a:pt x="223" y="13"/>
                  </a:lnTo>
                  <a:lnTo>
                    <a:pt x="224" y="13"/>
                  </a:lnTo>
                  <a:lnTo>
                    <a:pt x="224" y="14"/>
                  </a:lnTo>
                  <a:lnTo>
                    <a:pt x="225" y="14"/>
                  </a:lnTo>
                  <a:lnTo>
                    <a:pt x="226" y="13"/>
                  </a:lnTo>
                  <a:lnTo>
                    <a:pt x="227" y="14"/>
                  </a:lnTo>
                  <a:lnTo>
                    <a:pt x="228" y="12"/>
                  </a:lnTo>
                  <a:lnTo>
                    <a:pt x="229" y="16"/>
                  </a:lnTo>
                  <a:lnTo>
                    <a:pt x="230" y="16"/>
                  </a:lnTo>
                  <a:lnTo>
                    <a:pt x="231" y="14"/>
                  </a:lnTo>
                  <a:lnTo>
                    <a:pt x="232" y="15"/>
                  </a:lnTo>
                  <a:lnTo>
                    <a:pt x="232" y="15"/>
                  </a:lnTo>
                  <a:lnTo>
                    <a:pt x="233" y="15"/>
                  </a:lnTo>
                  <a:lnTo>
                    <a:pt x="234" y="15"/>
                  </a:lnTo>
                  <a:lnTo>
                    <a:pt x="235" y="15"/>
                  </a:lnTo>
                  <a:lnTo>
                    <a:pt x="236" y="13"/>
                  </a:lnTo>
                  <a:lnTo>
                    <a:pt x="237" y="13"/>
                  </a:lnTo>
                  <a:lnTo>
                    <a:pt x="238" y="11"/>
                  </a:lnTo>
                  <a:lnTo>
                    <a:pt x="239" y="14"/>
                  </a:lnTo>
                  <a:lnTo>
                    <a:pt x="239" y="13"/>
                  </a:lnTo>
                  <a:lnTo>
                    <a:pt x="240" y="11"/>
                  </a:lnTo>
                  <a:lnTo>
                    <a:pt x="241" y="13"/>
                  </a:lnTo>
                  <a:lnTo>
                    <a:pt x="242" y="12"/>
                  </a:lnTo>
                  <a:lnTo>
                    <a:pt x="243" y="13"/>
                  </a:lnTo>
                  <a:lnTo>
                    <a:pt x="244" y="13"/>
                  </a:lnTo>
                  <a:lnTo>
                    <a:pt x="245" y="7"/>
                  </a:lnTo>
                  <a:lnTo>
                    <a:pt x="246" y="12"/>
                  </a:lnTo>
                  <a:lnTo>
                    <a:pt x="247" y="11"/>
                  </a:lnTo>
                  <a:lnTo>
                    <a:pt x="247" y="9"/>
                  </a:lnTo>
                  <a:lnTo>
                    <a:pt x="248" y="9"/>
                  </a:lnTo>
                  <a:lnTo>
                    <a:pt x="249" y="12"/>
                  </a:lnTo>
                  <a:lnTo>
                    <a:pt x="250" y="8"/>
                  </a:lnTo>
                  <a:lnTo>
                    <a:pt x="251" y="7"/>
                  </a:lnTo>
                  <a:lnTo>
                    <a:pt x="252" y="10"/>
                  </a:lnTo>
                  <a:lnTo>
                    <a:pt x="253" y="10"/>
                  </a:lnTo>
                  <a:lnTo>
                    <a:pt x="254" y="9"/>
                  </a:lnTo>
                  <a:lnTo>
                    <a:pt x="254" y="9"/>
                  </a:lnTo>
                  <a:lnTo>
                    <a:pt x="255" y="8"/>
                  </a:lnTo>
                  <a:lnTo>
                    <a:pt x="256" y="6"/>
                  </a:lnTo>
                  <a:lnTo>
                    <a:pt x="257" y="8"/>
                  </a:lnTo>
                  <a:lnTo>
                    <a:pt x="258" y="7"/>
                  </a:lnTo>
                  <a:lnTo>
                    <a:pt x="259" y="8"/>
                  </a:lnTo>
                  <a:lnTo>
                    <a:pt x="260" y="9"/>
                  </a:lnTo>
                  <a:lnTo>
                    <a:pt x="261" y="9"/>
                  </a:lnTo>
                  <a:lnTo>
                    <a:pt x="262" y="6"/>
                  </a:lnTo>
                  <a:lnTo>
                    <a:pt x="262" y="7"/>
                  </a:lnTo>
                  <a:lnTo>
                    <a:pt x="263" y="7"/>
                  </a:lnTo>
                  <a:lnTo>
                    <a:pt x="264" y="7"/>
                  </a:lnTo>
                  <a:lnTo>
                    <a:pt x="265" y="7"/>
                  </a:lnTo>
                  <a:lnTo>
                    <a:pt x="266" y="4"/>
                  </a:lnTo>
                  <a:lnTo>
                    <a:pt x="267" y="7"/>
                  </a:lnTo>
                  <a:lnTo>
                    <a:pt x="268" y="10"/>
                  </a:lnTo>
                  <a:lnTo>
                    <a:pt x="269" y="7"/>
                  </a:lnTo>
                  <a:lnTo>
                    <a:pt x="269" y="8"/>
                  </a:lnTo>
                  <a:lnTo>
                    <a:pt x="270" y="5"/>
                  </a:lnTo>
                  <a:lnTo>
                    <a:pt x="271" y="8"/>
                  </a:lnTo>
                  <a:lnTo>
                    <a:pt x="272" y="8"/>
                  </a:lnTo>
                  <a:lnTo>
                    <a:pt x="273" y="6"/>
                  </a:lnTo>
                  <a:lnTo>
                    <a:pt x="274" y="6"/>
                  </a:lnTo>
                  <a:lnTo>
                    <a:pt x="275" y="7"/>
                  </a:lnTo>
                  <a:lnTo>
                    <a:pt x="276" y="7"/>
                  </a:lnTo>
                  <a:lnTo>
                    <a:pt x="276" y="8"/>
                  </a:lnTo>
                  <a:lnTo>
                    <a:pt x="277" y="5"/>
                  </a:lnTo>
                  <a:lnTo>
                    <a:pt x="278" y="8"/>
                  </a:lnTo>
                  <a:lnTo>
                    <a:pt x="279" y="5"/>
                  </a:lnTo>
                  <a:lnTo>
                    <a:pt x="280" y="9"/>
                  </a:lnTo>
                  <a:lnTo>
                    <a:pt x="281" y="6"/>
                  </a:lnTo>
                  <a:lnTo>
                    <a:pt x="282" y="8"/>
                  </a:lnTo>
                  <a:lnTo>
                    <a:pt x="283" y="6"/>
                  </a:lnTo>
                  <a:lnTo>
                    <a:pt x="284" y="7"/>
                  </a:lnTo>
                  <a:lnTo>
                    <a:pt x="284" y="9"/>
                  </a:lnTo>
                  <a:lnTo>
                    <a:pt x="285" y="9"/>
                  </a:lnTo>
                  <a:lnTo>
                    <a:pt x="286" y="4"/>
                  </a:lnTo>
                  <a:lnTo>
                    <a:pt x="287" y="8"/>
                  </a:lnTo>
                  <a:lnTo>
                    <a:pt x="288" y="9"/>
                  </a:lnTo>
                  <a:lnTo>
                    <a:pt x="289" y="10"/>
                  </a:lnTo>
                  <a:lnTo>
                    <a:pt x="290" y="8"/>
                  </a:lnTo>
                  <a:lnTo>
                    <a:pt x="291" y="9"/>
                  </a:lnTo>
                  <a:lnTo>
                    <a:pt x="291" y="9"/>
                  </a:lnTo>
                  <a:lnTo>
                    <a:pt x="292" y="8"/>
                  </a:lnTo>
                  <a:lnTo>
                    <a:pt x="293" y="8"/>
                  </a:lnTo>
                  <a:lnTo>
                    <a:pt x="294" y="7"/>
                  </a:lnTo>
                  <a:lnTo>
                    <a:pt x="295" y="7"/>
                  </a:lnTo>
                  <a:lnTo>
                    <a:pt x="296" y="5"/>
                  </a:lnTo>
                  <a:lnTo>
                    <a:pt x="297" y="8"/>
                  </a:lnTo>
                  <a:lnTo>
                    <a:pt x="298" y="6"/>
                  </a:lnTo>
                  <a:lnTo>
                    <a:pt x="299" y="7"/>
                  </a:lnTo>
                  <a:lnTo>
                    <a:pt x="299" y="7"/>
                  </a:lnTo>
                  <a:lnTo>
                    <a:pt x="300" y="10"/>
                  </a:lnTo>
                  <a:lnTo>
                    <a:pt x="301" y="8"/>
                  </a:lnTo>
                  <a:lnTo>
                    <a:pt x="302" y="10"/>
                  </a:lnTo>
                  <a:lnTo>
                    <a:pt x="303" y="9"/>
                  </a:lnTo>
                  <a:lnTo>
                    <a:pt x="304" y="11"/>
                  </a:lnTo>
                  <a:lnTo>
                    <a:pt x="305" y="13"/>
                  </a:lnTo>
                  <a:lnTo>
                    <a:pt x="306" y="12"/>
                  </a:lnTo>
                  <a:lnTo>
                    <a:pt x="306" y="12"/>
                  </a:lnTo>
                  <a:lnTo>
                    <a:pt x="307" y="9"/>
                  </a:lnTo>
                  <a:lnTo>
                    <a:pt x="308" y="9"/>
                  </a:lnTo>
                  <a:lnTo>
                    <a:pt x="309" y="12"/>
                  </a:lnTo>
                  <a:lnTo>
                    <a:pt x="310" y="8"/>
                  </a:lnTo>
                  <a:lnTo>
                    <a:pt x="311" y="8"/>
                  </a:lnTo>
                  <a:lnTo>
                    <a:pt x="312" y="5"/>
                  </a:lnTo>
                  <a:lnTo>
                    <a:pt x="313" y="7"/>
                  </a:lnTo>
                  <a:lnTo>
                    <a:pt x="314" y="8"/>
                  </a:lnTo>
                  <a:lnTo>
                    <a:pt x="314" y="7"/>
                  </a:lnTo>
                  <a:lnTo>
                    <a:pt x="315" y="8"/>
                  </a:lnTo>
                  <a:lnTo>
                    <a:pt x="316" y="9"/>
                  </a:lnTo>
                  <a:lnTo>
                    <a:pt x="317" y="7"/>
                  </a:lnTo>
                  <a:lnTo>
                    <a:pt x="318" y="5"/>
                  </a:lnTo>
                  <a:lnTo>
                    <a:pt x="319" y="6"/>
                  </a:lnTo>
                  <a:lnTo>
                    <a:pt x="320" y="5"/>
                  </a:lnTo>
                  <a:lnTo>
                    <a:pt x="321" y="4"/>
                  </a:lnTo>
                  <a:lnTo>
                    <a:pt x="321" y="5"/>
                  </a:lnTo>
                  <a:lnTo>
                    <a:pt x="322" y="4"/>
                  </a:lnTo>
                  <a:lnTo>
                    <a:pt x="323" y="7"/>
                  </a:lnTo>
                  <a:lnTo>
                    <a:pt x="324" y="5"/>
                  </a:lnTo>
                  <a:lnTo>
                    <a:pt x="325" y="6"/>
                  </a:lnTo>
                  <a:lnTo>
                    <a:pt x="326" y="3"/>
                  </a:lnTo>
                  <a:lnTo>
                    <a:pt x="327" y="7"/>
                  </a:lnTo>
                  <a:lnTo>
                    <a:pt x="328" y="6"/>
                  </a:lnTo>
                  <a:lnTo>
                    <a:pt x="329" y="6"/>
                  </a:lnTo>
                  <a:lnTo>
                    <a:pt x="329" y="4"/>
                  </a:lnTo>
                  <a:lnTo>
                    <a:pt x="330" y="5"/>
                  </a:lnTo>
                  <a:lnTo>
                    <a:pt x="331" y="5"/>
                  </a:lnTo>
                  <a:lnTo>
                    <a:pt x="332" y="4"/>
                  </a:lnTo>
                  <a:lnTo>
                    <a:pt x="333" y="3"/>
                  </a:lnTo>
                  <a:lnTo>
                    <a:pt x="334" y="3"/>
                  </a:lnTo>
                  <a:lnTo>
                    <a:pt x="335" y="7"/>
                  </a:lnTo>
                  <a:lnTo>
                    <a:pt x="336" y="5"/>
                  </a:lnTo>
                  <a:lnTo>
                    <a:pt x="336" y="4"/>
                  </a:lnTo>
                  <a:lnTo>
                    <a:pt x="337" y="5"/>
                  </a:lnTo>
                  <a:lnTo>
                    <a:pt x="338" y="3"/>
                  </a:lnTo>
                  <a:lnTo>
                    <a:pt x="339" y="4"/>
                  </a:lnTo>
                  <a:lnTo>
                    <a:pt x="340" y="3"/>
                  </a:lnTo>
                  <a:lnTo>
                    <a:pt x="341" y="6"/>
                  </a:lnTo>
                  <a:lnTo>
                    <a:pt x="342" y="3"/>
                  </a:lnTo>
                  <a:lnTo>
                    <a:pt x="343" y="2"/>
                  </a:lnTo>
                  <a:lnTo>
                    <a:pt x="344" y="5"/>
                  </a:lnTo>
                  <a:lnTo>
                    <a:pt x="344" y="4"/>
                  </a:lnTo>
                  <a:lnTo>
                    <a:pt x="345" y="5"/>
                  </a:lnTo>
                  <a:lnTo>
                    <a:pt x="346" y="4"/>
                  </a:lnTo>
                  <a:lnTo>
                    <a:pt x="347" y="4"/>
                  </a:lnTo>
                  <a:lnTo>
                    <a:pt x="348" y="5"/>
                  </a:lnTo>
                  <a:lnTo>
                    <a:pt x="349" y="3"/>
                  </a:lnTo>
                  <a:lnTo>
                    <a:pt x="350" y="5"/>
                  </a:lnTo>
                  <a:lnTo>
                    <a:pt x="351" y="3"/>
                  </a:lnTo>
                  <a:lnTo>
                    <a:pt x="351" y="4"/>
                  </a:lnTo>
                  <a:lnTo>
                    <a:pt x="352" y="3"/>
                  </a:lnTo>
                  <a:lnTo>
                    <a:pt x="353" y="3"/>
                  </a:lnTo>
                  <a:lnTo>
                    <a:pt x="354" y="5"/>
                  </a:lnTo>
                  <a:lnTo>
                    <a:pt x="355" y="6"/>
                  </a:lnTo>
                  <a:lnTo>
                    <a:pt x="356" y="5"/>
                  </a:lnTo>
                  <a:lnTo>
                    <a:pt x="357" y="8"/>
                  </a:lnTo>
                  <a:lnTo>
                    <a:pt x="358" y="9"/>
                  </a:lnTo>
                  <a:lnTo>
                    <a:pt x="359" y="15"/>
                  </a:lnTo>
                  <a:lnTo>
                    <a:pt x="359" y="12"/>
                  </a:lnTo>
                  <a:lnTo>
                    <a:pt x="360" y="16"/>
                  </a:lnTo>
                  <a:lnTo>
                    <a:pt x="361" y="21"/>
                  </a:lnTo>
                  <a:lnTo>
                    <a:pt x="362" y="20"/>
                  </a:lnTo>
                  <a:lnTo>
                    <a:pt x="363" y="19"/>
                  </a:lnTo>
                  <a:lnTo>
                    <a:pt x="364" y="21"/>
                  </a:lnTo>
                  <a:lnTo>
                    <a:pt x="365" y="17"/>
                  </a:lnTo>
                  <a:lnTo>
                    <a:pt x="366" y="21"/>
                  </a:lnTo>
                  <a:lnTo>
                    <a:pt x="366" y="17"/>
                  </a:lnTo>
                  <a:lnTo>
                    <a:pt x="367" y="19"/>
                  </a:lnTo>
                  <a:lnTo>
                    <a:pt x="368" y="15"/>
                  </a:lnTo>
                  <a:lnTo>
                    <a:pt x="369" y="12"/>
                  </a:lnTo>
                  <a:lnTo>
                    <a:pt x="370" y="15"/>
                  </a:lnTo>
                  <a:lnTo>
                    <a:pt x="371" y="11"/>
                  </a:lnTo>
                  <a:lnTo>
                    <a:pt x="372" y="10"/>
                  </a:lnTo>
                  <a:lnTo>
                    <a:pt x="373" y="11"/>
                  </a:lnTo>
                  <a:lnTo>
                    <a:pt x="374" y="6"/>
                  </a:lnTo>
                  <a:lnTo>
                    <a:pt x="374" y="9"/>
                  </a:lnTo>
                  <a:lnTo>
                    <a:pt x="375" y="6"/>
                  </a:lnTo>
                  <a:lnTo>
                    <a:pt x="376" y="7"/>
                  </a:lnTo>
                  <a:lnTo>
                    <a:pt x="377" y="6"/>
                  </a:lnTo>
                  <a:lnTo>
                    <a:pt x="378" y="5"/>
                  </a:lnTo>
                  <a:lnTo>
                    <a:pt x="379" y="4"/>
                  </a:lnTo>
                  <a:lnTo>
                    <a:pt x="380" y="5"/>
                  </a:lnTo>
                  <a:lnTo>
                    <a:pt x="381" y="6"/>
                  </a:lnTo>
                  <a:lnTo>
                    <a:pt x="381" y="5"/>
                  </a:lnTo>
                  <a:lnTo>
                    <a:pt x="382" y="3"/>
                  </a:lnTo>
                  <a:lnTo>
                    <a:pt x="383" y="4"/>
                  </a:lnTo>
                  <a:lnTo>
                    <a:pt x="384" y="4"/>
                  </a:lnTo>
                  <a:lnTo>
                    <a:pt x="385" y="3"/>
                  </a:lnTo>
                  <a:lnTo>
                    <a:pt x="386" y="6"/>
                  </a:lnTo>
                  <a:lnTo>
                    <a:pt x="387" y="2"/>
                  </a:lnTo>
                  <a:lnTo>
                    <a:pt x="388" y="3"/>
                  </a:lnTo>
                  <a:lnTo>
                    <a:pt x="389" y="3"/>
                  </a:lnTo>
                  <a:lnTo>
                    <a:pt x="389" y="5"/>
                  </a:lnTo>
                  <a:lnTo>
                    <a:pt x="390" y="4"/>
                  </a:lnTo>
                  <a:lnTo>
                    <a:pt x="391" y="1"/>
                  </a:lnTo>
                  <a:lnTo>
                    <a:pt x="392" y="3"/>
                  </a:lnTo>
                  <a:lnTo>
                    <a:pt x="393" y="3"/>
                  </a:lnTo>
                  <a:lnTo>
                    <a:pt x="394" y="2"/>
                  </a:lnTo>
                  <a:lnTo>
                    <a:pt x="395" y="1"/>
                  </a:lnTo>
                  <a:lnTo>
                    <a:pt x="396" y="2"/>
                  </a:lnTo>
                  <a:lnTo>
                    <a:pt x="396" y="4"/>
                  </a:lnTo>
                  <a:lnTo>
                    <a:pt x="397" y="4"/>
                  </a:lnTo>
                  <a:lnTo>
                    <a:pt x="398" y="3"/>
                  </a:lnTo>
                  <a:lnTo>
                    <a:pt x="399" y="4"/>
                  </a:lnTo>
                  <a:lnTo>
                    <a:pt x="400" y="4"/>
                  </a:lnTo>
                  <a:lnTo>
                    <a:pt x="401" y="4"/>
                  </a:lnTo>
                  <a:lnTo>
                    <a:pt x="402" y="2"/>
                  </a:lnTo>
                  <a:lnTo>
                    <a:pt x="403" y="2"/>
                  </a:lnTo>
                  <a:lnTo>
                    <a:pt x="404" y="1"/>
                  </a:lnTo>
                  <a:lnTo>
                    <a:pt x="404" y="4"/>
                  </a:lnTo>
                  <a:lnTo>
                    <a:pt x="405" y="2"/>
                  </a:lnTo>
                  <a:lnTo>
                    <a:pt x="406" y="3"/>
                  </a:lnTo>
                  <a:lnTo>
                    <a:pt x="407" y="4"/>
                  </a:lnTo>
                  <a:lnTo>
                    <a:pt x="408" y="1"/>
                  </a:lnTo>
                  <a:lnTo>
                    <a:pt x="409" y="4"/>
                  </a:lnTo>
                  <a:lnTo>
                    <a:pt x="410" y="3"/>
                  </a:lnTo>
                  <a:lnTo>
                    <a:pt x="411" y="7"/>
                  </a:lnTo>
                  <a:lnTo>
                    <a:pt x="411" y="2"/>
                  </a:lnTo>
                  <a:lnTo>
                    <a:pt x="412" y="3"/>
                  </a:lnTo>
                  <a:lnTo>
                    <a:pt x="413" y="3"/>
                  </a:lnTo>
                  <a:lnTo>
                    <a:pt x="414" y="4"/>
                  </a:lnTo>
                  <a:lnTo>
                    <a:pt x="415" y="5"/>
                  </a:lnTo>
                  <a:lnTo>
                    <a:pt x="416" y="3"/>
                  </a:lnTo>
                  <a:lnTo>
                    <a:pt x="417" y="2"/>
                  </a:lnTo>
                  <a:lnTo>
                    <a:pt x="418" y="5"/>
                  </a:lnTo>
                  <a:lnTo>
                    <a:pt x="419" y="4"/>
                  </a:lnTo>
                  <a:lnTo>
                    <a:pt x="419" y="3"/>
                  </a:lnTo>
                  <a:lnTo>
                    <a:pt x="420" y="6"/>
                  </a:lnTo>
                  <a:lnTo>
                    <a:pt x="421" y="4"/>
                  </a:lnTo>
                  <a:lnTo>
                    <a:pt x="422" y="2"/>
                  </a:lnTo>
                  <a:lnTo>
                    <a:pt x="423" y="2"/>
                  </a:lnTo>
                  <a:lnTo>
                    <a:pt x="424" y="1"/>
                  </a:lnTo>
                  <a:lnTo>
                    <a:pt x="425" y="3"/>
                  </a:lnTo>
                  <a:lnTo>
                    <a:pt x="426" y="2"/>
                  </a:lnTo>
                  <a:lnTo>
                    <a:pt x="426" y="4"/>
                  </a:lnTo>
                  <a:lnTo>
                    <a:pt x="427" y="3"/>
                  </a:lnTo>
                  <a:lnTo>
                    <a:pt x="428" y="1"/>
                  </a:lnTo>
                  <a:lnTo>
                    <a:pt x="429" y="2"/>
                  </a:lnTo>
                  <a:lnTo>
                    <a:pt x="430" y="2"/>
                  </a:lnTo>
                  <a:lnTo>
                    <a:pt x="431" y="0"/>
                  </a:lnTo>
                  <a:lnTo>
                    <a:pt x="432" y="3"/>
                  </a:lnTo>
                  <a:lnTo>
                    <a:pt x="433" y="1"/>
                  </a:lnTo>
                  <a:lnTo>
                    <a:pt x="434" y="3"/>
                  </a:lnTo>
                  <a:lnTo>
                    <a:pt x="434" y="0"/>
                  </a:lnTo>
                  <a:lnTo>
                    <a:pt x="435" y="1"/>
                  </a:lnTo>
                  <a:lnTo>
                    <a:pt x="436" y="2"/>
                  </a:lnTo>
                  <a:lnTo>
                    <a:pt x="437" y="2"/>
                  </a:lnTo>
                  <a:lnTo>
                    <a:pt x="438" y="1"/>
                  </a:lnTo>
                  <a:lnTo>
                    <a:pt x="439" y="2"/>
                  </a:lnTo>
                  <a:lnTo>
                    <a:pt x="440" y="3"/>
                  </a:lnTo>
                  <a:lnTo>
                    <a:pt x="441" y="4"/>
                  </a:lnTo>
                  <a:lnTo>
                    <a:pt x="441" y="1"/>
                  </a:lnTo>
                  <a:lnTo>
                    <a:pt x="442" y="1"/>
                  </a:lnTo>
                  <a:lnTo>
                    <a:pt x="443" y="4"/>
                  </a:lnTo>
                  <a:lnTo>
                    <a:pt x="444" y="2"/>
                  </a:lnTo>
                  <a:lnTo>
                    <a:pt x="445" y="1"/>
                  </a:lnTo>
                  <a:lnTo>
                    <a:pt x="446" y="1"/>
                  </a:lnTo>
                  <a:lnTo>
                    <a:pt x="447" y="1"/>
                  </a:lnTo>
                  <a:lnTo>
                    <a:pt x="448" y="1"/>
                  </a:lnTo>
                  <a:lnTo>
                    <a:pt x="449" y="1"/>
                  </a:lnTo>
                  <a:lnTo>
                    <a:pt x="449" y="2"/>
                  </a:lnTo>
                  <a:lnTo>
                    <a:pt x="450" y="2"/>
                  </a:lnTo>
                  <a:lnTo>
                    <a:pt x="451" y="2"/>
                  </a:lnTo>
                  <a:lnTo>
                    <a:pt x="452" y="2"/>
                  </a:lnTo>
                  <a:lnTo>
                    <a:pt x="453" y="2"/>
                  </a:lnTo>
                  <a:lnTo>
                    <a:pt x="454" y="2"/>
                  </a:lnTo>
                  <a:lnTo>
                    <a:pt x="455" y="4"/>
                  </a:lnTo>
                  <a:lnTo>
                    <a:pt x="456" y="0"/>
                  </a:lnTo>
                  <a:lnTo>
                    <a:pt x="456" y="3"/>
                  </a:lnTo>
                  <a:lnTo>
                    <a:pt x="457" y="3"/>
                  </a:lnTo>
                  <a:lnTo>
                    <a:pt x="458" y="2"/>
                  </a:lnTo>
                  <a:lnTo>
                    <a:pt x="459" y="2"/>
                  </a:lnTo>
                  <a:lnTo>
                    <a:pt x="460" y="0"/>
                  </a:lnTo>
                  <a:lnTo>
                    <a:pt x="461" y="2"/>
                  </a:lnTo>
                  <a:lnTo>
                    <a:pt x="462" y="0"/>
                  </a:lnTo>
                  <a:lnTo>
                    <a:pt x="463" y="4"/>
                  </a:lnTo>
                  <a:lnTo>
                    <a:pt x="464" y="5"/>
                  </a:lnTo>
                  <a:lnTo>
                    <a:pt x="464" y="5"/>
                  </a:lnTo>
                  <a:lnTo>
                    <a:pt x="465" y="2"/>
                  </a:lnTo>
                  <a:lnTo>
                    <a:pt x="466" y="1"/>
                  </a:lnTo>
                  <a:lnTo>
                    <a:pt x="467" y="5"/>
                  </a:lnTo>
                  <a:lnTo>
                    <a:pt x="468" y="3"/>
                  </a:lnTo>
                  <a:lnTo>
                    <a:pt x="469" y="2"/>
                  </a:lnTo>
                  <a:lnTo>
                    <a:pt x="470" y="4"/>
                  </a:lnTo>
                  <a:lnTo>
                    <a:pt x="471" y="1"/>
                  </a:lnTo>
                  <a:lnTo>
                    <a:pt x="471" y="1"/>
                  </a:lnTo>
                  <a:lnTo>
                    <a:pt x="472" y="1"/>
                  </a:lnTo>
                  <a:lnTo>
                    <a:pt x="473" y="2"/>
                  </a:lnTo>
                  <a:lnTo>
                    <a:pt x="474" y="3"/>
                  </a:lnTo>
                  <a:lnTo>
                    <a:pt x="475" y="1"/>
                  </a:lnTo>
                  <a:lnTo>
                    <a:pt x="476" y="3"/>
                  </a:lnTo>
                  <a:lnTo>
                    <a:pt x="477" y="1"/>
                  </a:lnTo>
                  <a:lnTo>
                    <a:pt x="478" y="2"/>
                  </a:lnTo>
                  <a:lnTo>
                    <a:pt x="478" y="0"/>
                  </a:lnTo>
                  <a:lnTo>
                    <a:pt x="479" y="0"/>
                  </a:lnTo>
                  <a:lnTo>
                    <a:pt x="480" y="1"/>
                  </a:lnTo>
                  <a:lnTo>
                    <a:pt x="481" y="0"/>
                  </a:lnTo>
                  <a:lnTo>
                    <a:pt x="482" y="3"/>
                  </a:lnTo>
                  <a:lnTo>
                    <a:pt x="483" y="3"/>
                  </a:lnTo>
                  <a:lnTo>
                    <a:pt x="484" y="1"/>
                  </a:lnTo>
                  <a:lnTo>
                    <a:pt x="485" y="1"/>
                  </a:lnTo>
                  <a:lnTo>
                    <a:pt x="486" y="2"/>
                  </a:lnTo>
                  <a:lnTo>
                    <a:pt x="486" y="2"/>
                  </a:lnTo>
                  <a:lnTo>
                    <a:pt x="487" y="0"/>
                  </a:lnTo>
                  <a:lnTo>
                    <a:pt x="488" y="1"/>
                  </a:lnTo>
                  <a:lnTo>
                    <a:pt x="489" y="2"/>
                  </a:lnTo>
                  <a:lnTo>
                    <a:pt x="490" y="1"/>
                  </a:lnTo>
                  <a:lnTo>
                    <a:pt x="491" y="2"/>
                  </a:lnTo>
                  <a:lnTo>
                    <a:pt x="492" y="1"/>
                  </a:lnTo>
                  <a:lnTo>
                    <a:pt x="493" y="1"/>
                  </a:lnTo>
                  <a:lnTo>
                    <a:pt x="493" y="3"/>
                  </a:lnTo>
                  <a:lnTo>
                    <a:pt x="494" y="2"/>
                  </a:lnTo>
                  <a:lnTo>
                    <a:pt x="495" y="0"/>
                  </a:lnTo>
                  <a:lnTo>
                    <a:pt x="496" y="2"/>
                  </a:lnTo>
                  <a:lnTo>
                    <a:pt x="497" y="0"/>
                  </a:lnTo>
                  <a:lnTo>
                    <a:pt x="498" y="1"/>
                  </a:lnTo>
                  <a:lnTo>
                    <a:pt x="499" y="3"/>
                  </a:lnTo>
                  <a:lnTo>
                    <a:pt x="500" y="1"/>
                  </a:lnTo>
                  <a:lnTo>
                    <a:pt x="501" y="2"/>
                  </a:lnTo>
                  <a:lnTo>
                    <a:pt x="501" y="2"/>
                  </a:lnTo>
                  <a:lnTo>
                    <a:pt x="502" y="5"/>
                  </a:lnTo>
                  <a:lnTo>
                    <a:pt x="503" y="0"/>
                  </a:lnTo>
                  <a:lnTo>
                    <a:pt x="504" y="2"/>
                  </a:lnTo>
                  <a:lnTo>
                    <a:pt x="505" y="3"/>
                  </a:lnTo>
                  <a:lnTo>
                    <a:pt x="506" y="0"/>
                  </a:lnTo>
                  <a:lnTo>
                    <a:pt x="507" y="3"/>
                  </a:lnTo>
                  <a:lnTo>
                    <a:pt x="508" y="0"/>
                  </a:lnTo>
                  <a:lnTo>
                    <a:pt x="508" y="2"/>
                  </a:lnTo>
                  <a:lnTo>
                    <a:pt x="509" y="1"/>
                  </a:lnTo>
                  <a:lnTo>
                    <a:pt x="510" y="2"/>
                  </a:lnTo>
                  <a:lnTo>
                    <a:pt x="511" y="4"/>
                  </a:lnTo>
                  <a:lnTo>
                    <a:pt x="512" y="1"/>
                  </a:lnTo>
                  <a:lnTo>
                    <a:pt x="513" y="2"/>
                  </a:lnTo>
                  <a:lnTo>
                    <a:pt x="514" y="0"/>
                  </a:lnTo>
                  <a:lnTo>
                    <a:pt x="515" y="3"/>
                  </a:lnTo>
                  <a:lnTo>
                    <a:pt x="516" y="1"/>
                  </a:lnTo>
                  <a:lnTo>
                    <a:pt x="516" y="1"/>
                  </a:lnTo>
                  <a:lnTo>
                    <a:pt x="517" y="1"/>
                  </a:lnTo>
                  <a:lnTo>
                    <a:pt x="518" y="2"/>
                  </a:lnTo>
                  <a:lnTo>
                    <a:pt x="519" y="2"/>
                  </a:lnTo>
                  <a:lnTo>
                    <a:pt x="520" y="0"/>
                  </a:lnTo>
                  <a:lnTo>
                    <a:pt x="521" y="0"/>
                  </a:lnTo>
                  <a:lnTo>
                    <a:pt x="522" y="2"/>
                  </a:lnTo>
                  <a:lnTo>
                    <a:pt x="523" y="2"/>
                  </a:lnTo>
                  <a:lnTo>
                    <a:pt x="523" y="0"/>
                  </a:lnTo>
                  <a:lnTo>
                    <a:pt x="524" y="3"/>
                  </a:lnTo>
                  <a:lnTo>
                    <a:pt x="525" y="3"/>
                  </a:lnTo>
                  <a:lnTo>
                    <a:pt x="526" y="2"/>
                  </a:lnTo>
                  <a:lnTo>
                    <a:pt x="527" y="2"/>
                  </a:lnTo>
                  <a:lnTo>
                    <a:pt x="528" y="2"/>
                  </a:lnTo>
                  <a:lnTo>
                    <a:pt x="529" y="4"/>
                  </a:lnTo>
                  <a:lnTo>
                    <a:pt x="530" y="4"/>
                  </a:lnTo>
                  <a:lnTo>
                    <a:pt x="531" y="5"/>
                  </a:lnTo>
                  <a:lnTo>
                    <a:pt x="531" y="6"/>
                  </a:lnTo>
                  <a:lnTo>
                    <a:pt x="532" y="4"/>
                  </a:lnTo>
                  <a:lnTo>
                    <a:pt x="533" y="1"/>
                  </a:lnTo>
                  <a:lnTo>
                    <a:pt x="534" y="5"/>
                  </a:lnTo>
                  <a:lnTo>
                    <a:pt x="535" y="0"/>
                  </a:lnTo>
                  <a:lnTo>
                    <a:pt x="536" y="4"/>
                  </a:lnTo>
                  <a:lnTo>
                    <a:pt x="537" y="1"/>
                  </a:lnTo>
                  <a:lnTo>
                    <a:pt x="538" y="4"/>
                  </a:lnTo>
                  <a:lnTo>
                    <a:pt x="538" y="3"/>
                  </a:lnTo>
                  <a:lnTo>
                    <a:pt x="539" y="1"/>
                  </a:lnTo>
                  <a:lnTo>
                    <a:pt x="540" y="4"/>
                  </a:lnTo>
                  <a:lnTo>
                    <a:pt x="541" y="2"/>
                  </a:lnTo>
                  <a:lnTo>
                    <a:pt x="542" y="1"/>
                  </a:lnTo>
                  <a:lnTo>
                    <a:pt x="543" y="1"/>
                  </a:lnTo>
                  <a:lnTo>
                    <a:pt x="544" y="3"/>
                  </a:lnTo>
                  <a:lnTo>
                    <a:pt x="545" y="3"/>
                  </a:lnTo>
                  <a:lnTo>
                    <a:pt x="546" y="2"/>
                  </a:lnTo>
                  <a:lnTo>
                    <a:pt x="546" y="4"/>
                  </a:lnTo>
                  <a:lnTo>
                    <a:pt x="547" y="4"/>
                  </a:lnTo>
                  <a:lnTo>
                    <a:pt x="548" y="3"/>
                  </a:lnTo>
                  <a:lnTo>
                    <a:pt x="549" y="5"/>
                  </a:lnTo>
                  <a:lnTo>
                    <a:pt x="550" y="5"/>
                  </a:lnTo>
                  <a:lnTo>
                    <a:pt x="551" y="5"/>
                  </a:lnTo>
                  <a:lnTo>
                    <a:pt x="552" y="6"/>
                  </a:lnTo>
                  <a:lnTo>
                    <a:pt x="553" y="7"/>
                  </a:lnTo>
                  <a:lnTo>
                    <a:pt x="553" y="6"/>
                  </a:lnTo>
                  <a:lnTo>
                    <a:pt x="554" y="5"/>
                  </a:lnTo>
                  <a:lnTo>
                    <a:pt x="555" y="6"/>
                  </a:lnTo>
                  <a:lnTo>
                    <a:pt x="556" y="6"/>
                  </a:lnTo>
                  <a:lnTo>
                    <a:pt x="557" y="7"/>
                  </a:lnTo>
                  <a:lnTo>
                    <a:pt x="558" y="7"/>
                  </a:lnTo>
                  <a:lnTo>
                    <a:pt x="559" y="5"/>
                  </a:lnTo>
                  <a:lnTo>
                    <a:pt x="560" y="6"/>
                  </a:lnTo>
                  <a:lnTo>
                    <a:pt x="561" y="6"/>
                  </a:lnTo>
                  <a:lnTo>
                    <a:pt x="561" y="5"/>
                  </a:lnTo>
                  <a:lnTo>
                    <a:pt x="562" y="3"/>
                  </a:lnTo>
                  <a:lnTo>
                    <a:pt x="563" y="3"/>
                  </a:lnTo>
                  <a:lnTo>
                    <a:pt x="564" y="3"/>
                  </a:lnTo>
                  <a:lnTo>
                    <a:pt x="565" y="4"/>
                  </a:lnTo>
                  <a:lnTo>
                    <a:pt x="566" y="3"/>
                  </a:lnTo>
                  <a:lnTo>
                    <a:pt x="567" y="3"/>
                  </a:lnTo>
                  <a:lnTo>
                    <a:pt x="568" y="4"/>
                  </a:lnTo>
                  <a:lnTo>
                    <a:pt x="568" y="5"/>
                  </a:lnTo>
                  <a:lnTo>
                    <a:pt x="569" y="6"/>
                  </a:lnTo>
                  <a:lnTo>
                    <a:pt x="570" y="4"/>
                  </a:lnTo>
                  <a:lnTo>
                    <a:pt x="571" y="3"/>
                  </a:lnTo>
                  <a:lnTo>
                    <a:pt x="572" y="4"/>
                  </a:lnTo>
                  <a:lnTo>
                    <a:pt x="573" y="5"/>
                  </a:lnTo>
                  <a:lnTo>
                    <a:pt x="574" y="2"/>
                  </a:lnTo>
                  <a:lnTo>
                    <a:pt x="575" y="5"/>
                  </a:lnTo>
                  <a:lnTo>
                    <a:pt x="576" y="6"/>
                  </a:lnTo>
                  <a:lnTo>
                    <a:pt x="576" y="4"/>
                  </a:lnTo>
                  <a:lnTo>
                    <a:pt x="577" y="4"/>
                  </a:lnTo>
                  <a:lnTo>
                    <a:pt x="578" y="3"/>
                  </a:lnTo>
                  <a:lnTo>
                    <a:pt x="579" y="5"/>
                  </a:lnTo>
                  <a:lnTo>
                    <a:pt x="580" y="3"/>
                  </a:lnTo>
                  <a:lnTo>
                    <a:pt x="581" y="2"/>
                  </a:lnTo>
                  <a:lnTo>
                    <a:pt x="582" y="4"/>
                  </a:lnTo>
                  <a:lnTo>
                    <a:pt x="583" y="5"/>
                  </a:lnTo>
                  <a:lnTo>
                    <a:pt x="583" y="3"/>
                  </a:lnTo>
                  <a:lnTo>
                    <a:pt x="584" y="6"/>
                  </a:lnTo>
                  <a:lnTo>
                    <a:pt x="585" y="4"/>
                  </a:lnTo>
                  <a:lnTo>
                    <a:pt x="586" y="7"/>
                  </a:lnTo>
                  <a:lnTo>
                    <a:pt x="587" y="3"/>
                  </a:lnTo>
                  <a:lnTo>
                    <a:pt x="588" y="5"/>
                  </a:lnTo>
                  <a:lnTo>
                    <a:pt x="589" y="6"/>
                  </a:lnTo>
                  <a:lnTo>
                    <a:pt x="590" y="5"/>
                  </a:lnTo>
                  <a:lnTo>
                    <a:pt x="591" y="5"/>
                  </a:lnTo>
                  <a:lnTo>
                    <a:pt x="591" y="6"/>
                  </a:lnTo>
                  <a:lnTo>
                    <a:pt x="592" y="2"/>
                  </a:lnTo>
                  <a:lnTo>
                    <a:pt x="593" y="3"/>
                  </a:lnTo>
                  <a:lnTo>
                    <a:pt x="594" y="3"/>
                  </a:lnTo>
                  <a:lnTo>
                    <a:pt x="595" y="2"/>
                  </a:lnTo>
                  <a:lnTo>
                    <a:pt x="596" y="2"/>
                  </a:lnTo>
                  <a:lnTo>
                    <a:pt x="597" y="4"/>
                  </a:lnTo>
                  <a:lnTo>
                    <a:pt x="598" y="2"/>
                  </a:lnTo>
                  <a:lnTo>
                    <a:pt x="598" y="2"/>
                  </a:lnTo>
                  <a:lnTo>
                    <a:pt x="599" y="3"/>
                  </a:lnTo>
                  <a:lnTo>
                    <a:pt x="600" y="3"/>
                  </a:lnTo>
                  <a:lnTo>
                    <a:pt x="601" y="2"/>
                  </a:lnTo>
                  <a:lnTo>
                    <a:pt x="602" y="1"/>
                  </a:lnTo>
                  <a:lnTo>
                    <a:pt x="603" y="4"/>
                  </a:lnTo>
                  <a:lnTo>
                    <a:pt x="604" y="4"/>
                  </a:lnTo>
                  <a:lnTo>
                    <a:pt x="605" y="5"/>
                  </a:lnTo>
                  <a:lnTo>
                    <a:pt x="606" y="2"/>
                  </a:lnTo>
                  <a:lnTo>
                    <a:pt x="606" y="5"/>
                  </a:lnTo>
                  <a:lnTo>
                    <a:pt x="607" y="4"/>
                  </a:lnTo>
                  <a:lnTo>
                    <a:pt x="608" y="5"/>
                  </a:lnTo>
                  <a:lnTo>
                    <a:pt x="609" y="5"/>
                  </a:lnTo>
                  <a:lnTo>
                    <a:pt x="610" y="2"/>
                  </a:lnTo>
                  <a:lnTo>
                    <a:pt x="611" y="3"/>
                  </a:lnTo>
                  <a:lnTo>
                    <a:pt x="612" y="4"/>
                  </a:lnTo>
                  <a:lnTo>
                    <a:pt x="613" y="2"/>
                  </a:lnTo>
                  <a:lnTo>
                    <a:pt x="613" y="5"/>
                  </a:lnTo>
                  <a:lnTo>
                    <a:pt x="614" y="1"/>
                  </a:lnTo>
                  <a:lnTo>
                    <a:pt x="615" y="2"/>
                  </a:lnTo>
                  <a:lnTo>
                    <a:pt x="616" y="2"/>
                  </a:lnTo>
                  <a:lnTo>
                    <a:pt x="617" y="4"/>
                  </a:lnTo>
                  <a:lnTo>
                    <a:pt x="618" y="4"/>
                  </a:lnTo>
                  <a:lnTo>
                    <a:pt x="619" y="3"/>
                  </a:lnTo>
                  <a:lnTo>
                    <a:pt x="620" y="5"/>
                  </a:lnTo>
                  <a:lnTo>
                    <a:pt x="621" y="5"/>
                  </a:lnTo>
                  <a:lnTo>
                    <a:pt x="621" y="6"/>
                  </a:lnTo>
                  <a:lnTo>
                    <a:pt x="622" y="7"/>
                  </a:lnTo>
                  <a:lnTo>
                    <a:pt x="623" y="7"/>
                  </a:lnTo>
                  <a:lnTo>
                    <a:pt x="624" y="5"/>
                  </a:lnTo>
                  <a:lnTo>
                    <a:pt x="625" y="5"/>
                  </a:lnTo>
                  <a:lnTo>
                    <a:pt x="626" y="8"/>
                  </a:lnTo>
                  <a:lnTo>
                    <a:pt x="627" y="8"/>
                  </a:lnTo>
                  <a:lnTo>
                    <a:pt x="628" y="7"/>
                  </a:lnTo>
                  <a:lnTo>
                    <a:pt x="628" y="5"/>
                  </a:lnTo>
                  <a:lnTo>
                    <a:pt x="629" y="5"/>
                  </a:lnTo>
                  <a:lnTo>
                    <a:pt x="630" y="5"/>
                  </a:lnTo>
                  <a:lnTo>
                    <a:pt x="631" y="6"/>
                  </a:lnTo>
                  <a:lnTo>
                    <a:pt x="632" y="7"/>
                  </a:lnTo>
                  <a:lnTo>
                    <a:pt x="633" y="4"/>
                  </a:lnTo>
                  <a:lnTo>
                    <a:pt x="634" y="7"/>
                  </a:lnTo>
                  <a:lnTo>
                    <a:pt x="635" y="4"/>
                  </a:lnTo>
                  <a:lnTo>
                    <a:pt x="636" y="4"/>
                  </a:lnTo>
                  <a:lnTo>
                    <a:pt x="636" y="8"/>
                  </a:lnTo>
                  <a:lnTo>
                    <a:pt x="637" y="9"/>
                  </a:lnTo>
                  <a:lnTo>
                    <a:pt x="638" y="7"/>
                  </a:lnTo>
                  <a:lnTo>
                    <a:pt x="639" y="10"/>
                  </a:lnTo>
                  <a:lnTo>
                    <a:pt x="640" y="4"/>
                  </a:lnTo>
                  <a:lnTo>
                    <a:pt x="641" y="11"/>
                  </a:lnTo>
                  <a:lnTo>
                    <a:pt x="642" y="8"/>
                  </a:lnTo>
                  <a:lnTo>
                    <a:pt x="643" y="4"/>
                  </a:lnTo>
                  <a:lnTo>
                    <a:pt x="643" y="7"/>
                  </a:lnTo>
                  <a:lnTo>
                    <a:pt x="644" y="6"/>
                  </a:lnTo>
                  <a:lnTo>
                    <a:pt x="645" y="4"/>
                  </a:lnTo>
                  <a:lnTo>
                    <a:pt x="646" y="5"/>
                  </a:lnTo>
                  <a:lnTo>
                    <a:pt x="647" y="5"/>
                  </a:lnTo>
                  <a:lnTo>
                    <a:pt x="648" y="7"/>
                  </a:lnTo>
                  <a:lnTo>
                    <a:pt x="649" y="7"/>
                  </a:lnTo>
                  <a:lnTo>
                    <a:pt x="650" y="7"/>
                  </a:lnTo>
                  <a:lnTo>
                    <a:pt x="651" y="7"/>
                  </a:lnTo>
                  <a:lnTo>
                    <a:pt x="651" y="5"/>
                  </a:lnTo>
                  <a:lnTo>
                    <a:pt x="652" y="8"/>
                  </a:lnTo>
                  <a:lnTo>
                    <a:pt x="653" y="6"/>
                  </a:lnTo>
                  <a:lnTo>
                    <a:pt x="654" y="7"/>
                  </a:lnTo>
                  <a:lnTo>
                    <a:pt x="655" y="3"/>
                  </a:lnTo>
                  <a:lnTo>
                    <a:pt x="656" y="5"/>
                  </a:lnTo>
                  <a:lnTo>
                    <a:pt x="657" y="5"/>
                  </a:lnTo>
                  <a:lnTo>
                    <a:pt x="658" y="4"/>
                  </a:lnTo>
                  <a:lnTo>
                    <a:pt x="658" y="7"/>
                  </a:lnTo>
                  <a:lnTo>
                    <a:pt x="659" y="5"/>
                  </a:lnTo>
                  <a:lnTo>
                    <a:pt x="660" y="6"/>
                  </a:lnTo>
                  <a:lnTo>
                    <a:pt x="661" y="3"/>
                  </a:lnTo>
                  <a:lnTo>
                    <a:pt x="662" y="4"/>
                  </a:lnTo>
                  <a:lnTo>
                    <a:pt x="663" y="4"/>
                  </a:lnTo>
                  <a:lnTo>
                    <a:pt x="664" y="4"/>
                  </a:lnTo>
                  <a:lnTo>
                    <a:pt x="665" y="2"/>
                  </a:lnTo>
                  <a:lnTo>
                    <a:pt x="665" y="3"/>
                  </a:lnTo>
                  <a:lnTo>
                    <a:pt x="666" y="3"/>
                  </a:lnTo>
                  <a:lnTo>
                    <a:pt x="667" y="3"/>
                  </a:lnTo>
                  <a:lnTo>
                    <a:pt x="668" y="4"/>
                  </a:lnTo>
                  <a:lnTo>
                    <a:pt x="669" y="4"/>
                  </a:lnTo>
                  <a:lnTo>
                    <a:pt x="670" y="7"/>
                  </a:lnTo>
                  <a:lnTo>
                    <a:pt x="671" y="4"/>
                  </a:lnTo>
                  <a:lnTo>
                    <a:pt x="672" y="5"/>
                  </a:lnTo>
                  <a:lnTo>
                    <a:pt x="673" y="6"/>
                  </a:lnTo>
                  <a:lnTo>
                    <a:pt x="673" y="3"/>
                  </a:lnTo>
                  <a:lnTo>
                    <a:pt x="674" y="6"/>
                  </a:lnTo>
                  <a:lnTo>
                    <a:pt x="675" y="4"/>
                  </a:lnTo>
                  <a:lnTo>
                    <a:pt x="676" y="4"/>
                  </a:lnTo>
                  <a:lnTo>
                    <a:pt x="677" y="5"/>
                  </a:lnTo>
                  <a:lnTo>
                    <a:pt x="678" y="5"/>
                  </a:lnTo>
                  <a:lnTo>
                    <a:pt x="679" y="3"/>
                  </a:lnTo>
                  <a:lnTo>
                    <a:pt x="680" y="3"/>
                  </a:lnTo>
                  <a:lnTo>
                    <a:pt x="680" y="5"/>
                  </a:lnTo>
                  <a:lnTo>
                    <a:pt x="681" y="4"/>
                  </a:lnTo>
                  <a:lnTo>
                    <a:pt x="682" y="2"/>
                  </a:lnTo>
                  <a:lnTo>
                    <a:pt x="683" y="3"/>
                  </a:lnTo>
                  <a:lnTo>
                    <a:pt x="684" y="5"/>
                  </a:lnTo>
                  <a:lnTo>
                    <a:pt x="685" y="4"/>
                  </a:lnTo>
                  <a:lnTo>
                    <a:pt x="686" y="6"/>
                  </a:lnTo>
                  <a:lnTo>
                    <a:pt x="687" y="4"/>
                  </a:lnTo>
                  <a:lnTo>
                    <a:pt x="688" y="5"/>
                  </a:lnTo>
                  <a:lnTo>
                    <a:pt x="688" y="3"/>
                  </a:lnTo>
                  <a:lnTo>
                    <a:pt x="689" y="4"/>
                  </a:lnTo>
                  <a:lnTo>
                    <a:pt x="690" y="3"/>
                  </a:lnTo>
                  <a:lnTo>
                    <a:pt x="691" y="1"/>
                  </a:lnTo>
                  <a:lnTo>
                    <a:pt x="692" y="4"/>
                  </a:lnTo>
                  <a:lnTo>
                    <a:pt x="693" y="3"/>
                  </a:lnTo>
                  <a:lnTo>
                    <a:pt x="694" y="5"/>
                  </a:lnTo>
                  <a:lnTo>
                    <a:pt x="695" y="2"/>
                  </a:lnTo>
                  <a:lnTo>
                    <a:pt x="695" y="4"/>
                  </a:lnTo>
                  <a:lnTo>
                    <a:pt x="696" y="0"/>
                  </a:lnTo>
                  <a:lnTo>
                    <a:pt x="697" y="5"/>
                  </a:lnTo>
                  <a:lnTo>
                    <a:pt x="698" y="4"/>
                  </a:lnTo>
                  <a:lnTo>
                    <a:pt x="699" y="3"/>
                  </a:lnTo>
                  <a:lnTo>
                    <a:pt x="700" y="2"/>
                  </a:lnTo>
                  <a:lnTo>
                    <a:pt x="701" y="1"/>
                  </a:lnTo>
                  <a:lnTo>
                    <a:pt x="702" y="1"/>
                  </a:lnTo>
                  <a:lnTo>
                    <a:pt x="703" y="1"/>
                  </a:lnTo>
                  <a:lnTo>
                    <a:pt x="703" y="3"/>
                  </a:lnTo>
                  <a:lnTo>
                    <a:pt x="704" y="5"/>
                  </a:lnTo>
                  <a:lnTo>
                    <a:pt x="705" y="3"/>
                  </a:lnTo>
                  <a:lnTo>
                    <a:pt x="706" y="2"/>
                  </a:lnTo>
                  <a:lnTo>
                    <a:pt x="707" y="4"/>
                  </a:lnTo>
                  <a:lnTo>
                    <a:pt x="708" y="4"/>
                  </a:lnTo>
                  <a:lnTo>
                    <a:pt x="709" y="4"/>
                  </a:lnTo>
                  <a:lnTo>
                    <a:pt x="710" y="4"/>
                  </a:lnTo>
                  <a:lnTo>
                    <a:pt x="710" y="4"/>
                  </a:lnTo>
                  <a:lnTo>
                    <a:pt x="711" y="5"/>
                  </a:lnTo>
                  <a:lnTo>
                    <a:pt x="712" y="7"/>
                  </a:lnTo>
                  <a:lnTo>
                    <a:pt x="713" y="5"/>
                  </a:lnTo>
                  <a:lnTo>
                    <a:pt x="714" y="3"/>
                  </a:lnTo>
                  <a:lnTo>
                    <a:pt x="715" y="9"/>
                  </a:lnTo>
                  <a:lnTo>
                    <a:pt x="716" y="9"/>
                  </a:lnTo>
                  <a:lnTo>
                    <a:pt x="717" y="8"/>
                  </a:lnTo>
                  <a:lnTo>
                    <a:pt x="718" y="9"/>
                  </a:lnTo>
                  <a:lnTo>
                    <a:pt x="718" y="10"/>
                  </a:lnTo>
                  <a:lnTo>
                    <a:pt x="719" y="9"/>
                  </a:lnTo>
                  <a:lnTo>
                    <a:pt x="720" y="10"/>
                  </a:lnTo>
                  <a:lnTo>
                    <a:pt x="721" y="8"/>
                  </a:lnTo>
                  <a:lnTo>
                    <a:pt x="722" y="7"/>
                  </a:lnTo>
                  <a:lnTo>
                    <a:pt x="723" y="7"/>
                  </a:lnTo>
                  <a:lnTo>
                    <a:pt x="724" y="10"/>
                  </a:lnTo>
                  <a:lnTo>
                    <a:pt x="725" y="4"/>
                  </a:lnTo>
                  <a:lnTo>
                    <a:pt x="725" y="5"/>
                  </a:lnTo>
                  <a:lnTo>
                    <a:pt x="726" y="6"/>
                  </a:lnTo>
                  <a:lnTo>
                    <a:pt x="727" y="8"/>
                  </a:lnTo>
                  <a:lnTo>
                    <a:pt x="728" y="5"/>
                  </a:lnTo>
                  <a:lnTo>
                    <a:pt x="729" y="5"/>
                  </a:lnTo>
                  <a:lnTo>
                    <a:pt x="730" y="5"/>
                  </a:lnTo>
                  <a:lnTo>
                    <a:pt x="731" y="7"/>
                  </a:lnTo>
                  <a:lnTo>
                    <a:pt x="732" y="5"/>
                  </a:lnTo>
                  <a:lnTo>
                    <a:pt x="733" y="6"/>
                  </a:lnTo>
                  <a:lnTo>
                    <a:pt x="733" y="4"/>
                  </a:lnTo>
                  <a:lnTo>
                    <a:pt x="734" y="6"/>
                  </a:lnTo>
                  <a:lnTo>
                    <a:pt x="735" y="6"/>
                  </a:lnTo>
                  <a:lnTo>
                    <a:pt x="736" y="6"/>
                  </a:lnTo>
                  <a:lnTo>
                    <a:pt x="737" y="7"/>
                  </a:lnTo>
                  <a:lnTo>
                    <a:pt x="738" y="8"/>
                  </a:lnTo>
                  <a:lnTo>
                    <a:pt x="739" y="5"/>
                  </a:lnTo>
                  <a:lnTo>
                    <a:pt x="740" y="8"/>
                  </a:lnTo>
                  <a:lnTo>
                    <a:pt x="740" y="7"/>
                  </a:lnTo>
                  <a:lnTo>
                    <a:pt x="741" y="5"/>
                  </a:lnTo>
                  <a:lnTo>
                    <a:pt x="742" y="5"/>
                  </a:lnTo>
                  <a:lnTo>
                    <a:pt x="743" y="6"/>
                  </a:lnTo>
                  <a:lnTo>
                    <a:pt x="744" y="5"/>
                  </a:lnTo>
                  <a:lnTo>
                    <a:pt x="745" y="5"/>
                  </a:lnTo>
                  <a:lnTo>
                    <a:pt x="746" y="7"/>
                  </a:lnTo>
                  <a:lnTo>
                    <a:pt x="747" y="5"/>
                  </a:lnTo>
                  <a:lnTo>
                    <a:pt x="748" y="5"/>
                  </a:lnTo>
                  <a:lnTo>
                    <a:pt x="748" y="7"/>
                  </a:lnTo>
                  <a:lnTo>
                    <a:pt x="749" y="3"/>
                  </a:lnTo>
                  <a:lnTo>
                    <a:pt x="750" y="6"/>
                  </a:lnTo>
                  <a:lnTo>
                    <a:pt x="751" y="3"/>
                  </a:lnTo>
                  <a:lnTo>
                    <a:pt x="752" y="5"/>
                  </a:lnTo>
                  <a:lnTo>
                    <a:pt x="753" y="5"/>
                  </a:lnTo>
                  <a:lnTo>
                    <a:pt x="754" y="6"/>
                  </a:lnTo>
                  <a:lnTo>
                    <a:pt x="755" y="3"/>
                  </a:lnTo>
                  <a:lnTo>
                    <a:pt x="755" y="5"/>
                  </a:lnTo>
                  <a:lnTo>
                    <a:pt x="756" y="5"/>
                  </a:lnTo>
                  <a:lnTo>
                    <a:pt x="757" y="3"/>
                  </a:lnTo>
                  <a:lnTo>
                    <a:pt x="758" y="4"/>
                  </a:lnTo>
                  <a:lnTo>
                    <a:pt x="759" y="4"/>
                  </a:lnTo>
                  <a:lnTo>
                    <a:pt x="760" y="5"/>
                  </a:lnTo>
                  <a:lnTo>
                    <a:pt x="761" y="6"/>
                  </a:lnTo>
                  <a:lnTo>
                    <a:pt x="762" y="5"/>
                  </a:lnTo>
                  <a:lnTo>
                    <a:pt x="763" y="3"/>
                  </a:lnTo>
                  <a:lnTo>
                    <a:pt x="763" y="3"/>
                  </a:lnTo>
                  <a:lnTo>
                    <a:pt x="764" y="2"/>
                  </a:lnTo>
                  <a:lnTo>
                    <a:pt x="765" y="4"/>
                  </a:lnTo>
                  <a:lnTo>
                    <a:pt x="766" y="4"/>
                  </a:lnTo>
                  <a:lnTo>
                    <a:pt x="767" y="4"/>
                  </a:lnTo>
                  <a:lnTo>
                    <a:pt x="768" y="6"/>
                  </a:lnTo>
                  <a:lnTo>
                    <a:pt x="769" y="3"/>
                  </a:lnTo>
                  <a:lnTo>
                    <a:pt x="770" y="4"/>
                  </a:lnTo>
                  <a:lnTo>
                    <a:pt x="770" y="5"/>
                  </a:lnTo>
                  <a:lnTo>
                    <a:pt x="771" y="4"/>
                  </a:lnTo>
                  <a:lnTo>
                    <a:pt x="772" y="4"/>
                  </a:lnTo>
                  <a:lnTo>
                    <a:pt x="773" y="5"/>
                  </a:lnTo>
                  <a:lnTo>
                    <a:pt x="774" y="6"/>
                  </a:lnTo>
                  <a:lnTo>
                    <a:pt x="775" y="6"/>
                  </a:lnTo>
                  <a:lnTo>
                    <a:pt x="776" y="3"/>
                  </a:lnTo>
                  <a:lnTo>
                    <a:pt x="777" y="4"/>
                  </a:lnTo>
                  <a:lnTo>
                    <a:pt x="778" y="4"/>
                  </a:lnTo>
                  <a:lnTo>
                    <a:pt x="778" y="5"/>
                  </a:lnTo>
                  <a:lnTo>
                    <a:pt x="779" y="8"/>
                  </a:lnTo>
                  <a:lnTo>
                    <a:pt x="780" y="5"/>
                  </a:lnTo>
                  <a:lnTo>
                    <a:pt x="781" y="5"/>
                  </a:lnTo>
                  <a:lnTo>
                    <a:pt x="782" y="7"/>
                  </a:lnTo>
                  <a:lnTo>
                    <a:pt x="783" y="5"/>
                  </a:lnTo>
                  <a:lnTo>
                    <a:pt x="784" y="4"/>
                  </a:lnTo>
                  <a:lnTo>
                    <a:pt x="785" y="6"/>
                  </a:lnTo>
                  <a:lnTo>
                    <a:pt x="785" y="5"/>
                  </a:lnTo>
                  <a:lnTo>
                    <a:pt x="786" y="4"/>
                  </a:lnTo>
                  <a:lnTo>
                    <a:pt x="787" y="9"/>
                  </a:lnTo>
                  <a:lnTo>
                    <a:pt x="788" y="8"/>
                  </a:lnTo>
                  <a:lnTo>
                    <a:pt x="789" y="11"/>
                  </a:lnTo>
                  <a:lnTo>
                    <a:pt x="790" y="10"/>
                  </a:lnTo>
                  <a:lnTo>
                    <a:pt x="791" y="14"/>
                  </a:lnTo>
                  <a:lnTo>
                    <a:pt x="792" y="15"/>
                  </a:lnTo>
                  <a:lnTo>
                    <a:pt x="793" y="13"/>
                  </a:lnTo>
                  <a:lnTo>
                    <a:pt x="793" y="15"/>
                  </a:lnTo>
                  <a:lnTo>
                    <a:pt x="794" y="15"/>
                  </a:lnTo>
                  <a:lnTo>
                    <a:pt x="795" y="18"/>
                  </a:lnTo>
                  <a:lnTo>
                    <a:pt x="796" y="19"/>
                  </a:lnTo>
                  <a:lnTo>
                    <a:pt x="797" y="24"/>
                  </a:lnTo>
                  <a:lnTo>
                    <a:pt x="798" y="31"/>
                  </a:lnTo>
                  <a:lnTo>
                    <a:pt x="799" y="43"/>
                  </a:lnTo>
                  <a:lnTo>
                    <a:pt x="800" y="65"/>
                  </a:lnTo>
                  <a:lnTo>
                    <a:pt x="800" y="84"/>
                  </a:lnTo>
                  <a:lnTo>
                    <a:pt x="801" y="117"/>
                  </a:lnTo>
                  <a:lnTo>
                    <a:pt x="802" y="150"/>
                  </a:lnTo>
                  <a:lnTo>
                    <a:pt x="803" y="185"/>
                  </a:lnTo>
                  <a:lnTo>
                    <a:pt x="804" y="219"/>
                  </a:lnTo>
                  <a:lnTo>
                    <a:pt x="805" y="238"/>
                  </a:lnTo>
                  <a:lnTo>
                    <a:pt x="806" y="251"/>
                  </a:lnTo>
                  <a:lnTo>
                    <a:pt x="807" y="242"/>
                  </a:lnTo>
                  <a:lnTo>
                    <a:pt x="808" y="241"/>
                  </a:lnTo>
                  <a:lnTo>
                    <a:pt x="808" y="208"/>
                  </a:lnTo>
                  <a:lnTo>
                    <a:pt x="809" y="199"/>
                  </a:lnTo>
                  <a:lnTo>
                    <a:pt x="810" y="173"/>
                  </a:lnTo>
                  <a:lnTo>
                    <a:pt x="811" y="152"/>
                  </a:lnTo>
                  <a:lnTo>
                    <a:pt x="812" y="125"/>
                  </a:lnTo>
                  <a:lnTo>
                    <a:pt x="813" y="102"/>
                  </a:lnTo>
                  <a:lnTo>
                    <a:pt x="814" y="87"/>
                  </a:lnTo>
                  <a:lnTo>
                    <a:pt x="815" y="76"/>
                  </a:lnTo>
                  <a:lnTo>
                    <a:pt x="815" y="64"/>
                  </a:lnTo>
                  <a:lnTo>
                    <a:pt x="816" y="57"/>
                  </a:lnTo>
                  <a:lnTo>
                    <a:pt x="817" y="49"/>
                  </a:lnTo>
                  <a:lnTo>
                    <a:pt x="818" y="51"/>
                  </a:lnTo>
                  <a:lnTo>
                    <a:pt x="819" y="44"/>
                  </a:lnTo>
                  <a:lnTo>
                    <a:pt x="820" y="39"/>
                  </a:lnTo>
                  <a:lnTo>
                    <a:pt x="821" y="35"/>
                  </a:lnTo>
                  <a:lnTo>
                    <a:pt x="822" y="32"/>
                  </a:lnTo>
                  <a:lnTo>
                    <a:pt x="823" y="35"/>
                  </a:lnTo>
                  <a:lnTo>
                    <a:pt x="823" y="32"/>
                  </a:lnTo>
                  <a:lnTo>
                    <a:pt x="824" y="30"/>
                  </a:lnTo>
                  <a:lnTo>
                    <a:pt x="825" y="30"/>
                  </a:lnTo>
                  <a:lnTo>
                    <a:pt x="826" y="30"/>
                  </a:lnTo>
                  <a:lnTo>
                    <a:pt x="827" y="31"/>
                  </a:lnTo>
                  <a:lnTo>
                    <a:pt x="828" y="30"/>
                  </a:lnTo>
                  <a:lnTo>
                    <a:pt x="829" y="27"/>
                  </a:lnTo>
                  <a:lnTo>
                    <a:pt x="830" y="27"/>
                  </a:lnTo>
                  <a:lnTo>
                    <a:pt x="830" y="26"/>
                  </a:lnTo>
                  <a:lnTo>
                    <a:pt x="831" y="27"/>
                  </a:lnTo>
                  <a:lnTo>
                    <a:pt x="832" y="27"/>
                  </a:lnTo>
                  <a:lnTo>
                    <a:pt x="833" y="24"/>
                  </a:lnTo>
                  <a:lnTo>
                    <a:pt x="834" y="27"/>
                  </a:lnTo>
                  <a:lnTo>
                    <a:pt x="835" y="19"/>
                  </a:lnTo>
                  <a:lnTo>
                    <a:pt x="836" y="24"/>
                  </a:lnTo>
                  <a:lnTo>
                    <a:pt x="837" y="21"/>
                  </a:lnTo>
                  <a:lnTo>
                    <a:pt x="838" y="21"/>
                  </a:lnTo>
                  <a:lnTo>
                    <a:pt x="838" y="22"/>
                  </a:lnTo>
                  <a:lnTo>
                    <a:pt x="839" y="21"/>
                  </a:lnTo>
                  <a:lnTo>
                    <a:pt x="840" y="16"/>
                  </a:lnTo>
                  <a:lnTo>
                    <a:pt x="841" y="16"/>
                  </a:lnTo>
                  <a:lnTo>
                    <a:pt x="842" y="15"/>
                  </a:lnTo>
                  <a:lnTo>
                    <a:pt x="843" y="14"/>
                  </a:lnTo>
                  <a:lnTo>
                    <a:pt x="844" y="12"/>
                  </a:lnTo>
                  <a:lnTo>
                    <a:pt x="845" y="17"/>
                  </a:lnTo>
                  <a:lnTo>
                    <a:pt x="845" y="18"/>
                  </a:lnTo>
                  <a:lnTo>
                    <a:pt x="846" y="13"/>
                  </a:lnTo>
                  <a:lnTo>
                    <a:pt x="847" y="15"/>
                  </a:lnTo>
                  <a:lnTo>
                    <a:pt x="848" y="14"/>
                  </a:lnTo>
                  <a:lnTo>
                    <a:pt x="849" y="15"/>
                  </a:lnTo>
                  <a:lnTo>
                    <a:pt x="850" y="12"/>
                  </a:lnTo>
                  <a:lnTo>
                    <a:pt x="851" y="13"/>
                  </a:lnTo>
                  <a:lnTo>
                    <a:pt x="852" y="12"/>
                  </a:lnTo>
                  <a:lnTo>
                    <a:pt x="853" y="12"/>
                  </a:lnTo>
                  <a:lnTo>
                    <a:pt x="853" y="11"/>
                  </a:lnTo>
                  <a:lnTo>
                    <a:pt x="854" y="10"/>
                  </a:lnTo>
                  <a:lnTo>
                    <a:pt x="855" y="9"/>
                  </a:lnTo>
                  <a:lnTo>
                    <a:pt x="856" y="11"/>
                  </a:lnTo>
                  <a:lnTo>
                    <a:pt x="857" y="7"/>
                  </a:lnTo>
                  <a:lnTo>
                    <a:pt x="858" y="5"/>
                  </a:lnTo>
                  <a:lnTo>
                    <a:pt x="859" y="6"/>
                  </a:lnTo>
                  <a:lnTo>
                    <a:pt x="860" y="7"/>
                  </a:lnTo>
                  <a:lnTo>
                    <a:pt x="860" y="9"/>
                  </a:lnTo>
                  <a:lnTo>
                    <a:pt x="861" y="10"/>
                  </a:lnTo>
                  <a:lnTo>
                    <a:pt x="862" y="6"/>
                  </a:lnTo>
                  <a:lnTo>
                    <a:pt x="863" y="4"/>
                  </a:lnTo>
                  <a:lnTo>
                    <a:pt x="864" y="6"/>
                  </a:lnTo>
                  <a:lnTo>
                    <a:pt x="865" y="6"/>
                  </a:lnTo>
                  <a:lnTo>
                    <a:pt x="866" y="5"/>
                  </a:lnTo>
                  <a:lnTo>
                    <a:pt x="867" y="5"/>
                  </a:lnTo>
                  <a:lnTo>
                    <a:pt x="867" y="2"/>
                  </a:lnTo>
                  <a:lnTo>
                    <a:pt x="868" y="5"/>
                  </a:lnTo>
                  <a:lnTo>
                    <a:pt x="869" y="5"/>
                  </a:lnTo>
                  <a:lnTo>
                    <a:pt x="870" y="6"/>
                  </a:lnTo>
                  <a:lnTo>
                    <a:pt x="871" y="3"/>
                  </a:lnTo>
                  <a:lnTo>
                    <a:pt x="872" y="6"/>
                  </a:lnTo>
                  <a:lnTo>
                    <a:pt x="873" y="4"/>
                  </a:lnTo>
                  <a:lnTo>
                    <a:pt x="874" y="2"/>
                  </a:lnTo>
                  <a:lnTo>
                    <a:pt x="875" y="3"/>
                  </a:lnTo>
                  <a:lnTo>
                    <a:pt x="875" y="4"/>
                  </a:lnTo>
                  <a:lnTo>
                    <a:pt x="876" y="5"/>
                  </a:lnTo>
                  <a:lnTo>
                    <a:pt x="877" y="3"/>
                  </a:lnTo>
                  <a:lnTo>
                    <a:pt x="878" y="6"/>
                  </a:lnTo>
                  <a:lnTo>
                    <a:pt x="879" y="2"/>
                  </a:lnTo>
                  <a:lnTo>
                    <a:pt x="880" y="2"/>
                  </a:lnTo>
                  <a:lnTo>
                    <a:pt x="881" y="2"/>
                  </a:lnTo>
                  <a:lnTo>
                    <a:pt x="882" y="4"/>
                  </a:lnTo>
                  <a:lnTo>
                    <a:pt x="882" y="4"/>
                  </a:lnTo>
                  <a:lnTo>
                    <a:pt x="883" y="5"/>
                  </a:lnTo>
                  <a:lnTo>
                    <a:pt x="884" y="4"/>
                  </a:lnTo>
                  <a:lnTo>
                    <a:pt x="885" y="3"/>
                  </a:lnTo>
                  <a:lnTo>
                    <a:pt x="886" y="3"/>
                  </a:lnTo>
                  <a:lnTo>
                    <a:pt x="887" y="2"/>
                  </a:lnTo>
                  <a:lnTo>
                    <a:pt x="888" y="2"/>
                  </a:lnTo>
                  <a:lnTo>
                    <a:pt x="889" y="2"/>
                  </a:lnTo>
                  <a:lnTo>
                    <a:pt x="890" y="4"/>
                  </a:lnTo>
                  <a:lnTo>
                    <a:pt x="890" y="5"/>
                  </a:lnTo>
                  <a:lnTo>
                    <a:pt x="891" y="3"/>
                  </a:lnTo>
                  <a:lnTo>
                    <a:pt x="892" y="2"/>
                  </a:lnTo>
                  <a:lnTo>
                    <a:pt x="893" y="4"/>
                  </a:lnTo>
                  <a:lnTo>
                    <a:pt x="894" y="3"/>
                  </a:lnTo>
                  <a:lnTo>
                    <a:pt x="895" y="3"/>
                  </a:lnTo>
                  <a:lnTo>
                    <a:pt x="896" y="2"/>
                  </a:lnTo>
                  <a:lnTo>
                    <a:pt x="897" y="2"/>
                  </a:lnTo>
                  <a:lnTo>
                    <a:pt x="897" y="3"/>
                  </a:lnTo>
                  <a:lnTo>
                    <a:pt x="898" y="2"/>
                  </a:lnTo>
                  <a:lnTo>
                    <a:pt x="899" y="3"/>
                  </a:lnTo>
                  <a:lnTo>
                    <a:pt x="900" y="4"/>
                  </a:lnTo>
                  <a:lnTo>
                    <a:pt x="901" y="4"/>
                  </a:lnTo>
                  <a:lnTo>
                    <a:pt x="902" y="3"/>
                  </a:lnTo>
                  <a:lnTo>
                    <a:pt x="903" y="3"/>
                  </a:lnTo>
                  <a:lnTo>
                    <a:pt x="904" y="4"/>
                  </a:lnTo>
                  <a:lnTo>
                    <a:pt x="905" y="2"/>
                  </a:lnTo>
                  <a:lnTo>
                    <a:pt x="905" y="6"/>
                  </a:lnTo>
                  <a:lnTo>
                    <a:pt x="906" y="4"/>
                  </a:lnTo>
                  <a:lnTo>
                    <a:pt x="907" y="2"/>
                  </a:lnTo>
                  <a:lnTo>
                    <a:pt x="908" y="4"/>
                  </a:lnTo>
                  <a:lnTo>
                    <a:pt x="909" y="4"/>
                  </a:lnTo>
                  <a:lnTo>
                    <a:pt x="910" y="1"/>
                  </a:lnTo>
                  <a:lnTo>
                    <a:pt x="911" y="5"/>
                  </a:lnTo>
                  <a:lnTo>
                    <a:pt x="912" y="5"/>
                  </a:lnTo>
                  <a:lnTo>
                    <a:pt x="912" y="5"/>
                  </a:lnTo>
                  <a:lnTo>
                    <a:pt x="913" y="7"/>
                  </a:lnTo>
                  <a:lnTo>
                    <a:pt x="914" y="7"/>
                  </a:lnTo>
                  <a:lnTo>
                    <a:pt x="915" y="7"/>
                  </a:lnTo>
                  <a:lnTo>
                    <a:pt x="916" y="6"/>
                  </a:lnTo>
                  <a:lnTo>
                    <a:pt x="917" y="6"/>
                  </a:lnTo>
                  <a:lnTo>
                    <a:pt x="918" y="7"/>
                  </a:lnTo>
                  <a:lnTo>
                    <a:pt x="919" y="4"/>
                  </a:lnTo>
                  <a:lnTo>
                    <a:pt x="920" y="6"/>
                  </a:lnTo>
                  <a:lnTo>
                    <a:pt x="920" y="3"/>
                  </a:lnTo>
                  <a:lnTo>
                    <a:pt x="921" y="4"/>
                  </a:lnTo>
                  <a:lnTo>
                    <a:pt x="922" y="3"/>
                  </a:lnTo>
                  <a:lnTo>
                    <a:pt x="923" y="4"/>
                  </a:lnTo>
                  <a:lnTo>
                    <a:pt x="924" y="6"/>
                  </a:lnTo>
                  <a:lnTo>
                    <a:pt x="925" y="3"/>
                  </a:lnTo>
                  <a:lnTo>
                    <a:pt x="926" y="4"/>
                  </a:lnTo>
                  <a:lnTo>
                    <a:pt x="927" y="4"/>
                  </a:lnTo>
                  <a:lnTo>
                    <a:pt x="927" y="3"/>
                  </a:lnTo>
                  <a:lnTo>
                    <a:pt x="928" y="4"/>
                  </a:lnTo>
                  <a:lnTo>
                    <a:pt x="929" y="3"/>
                  </a:lnTo>
                  <a:lnTo>
                    <a:pt x="930" y="5"/>
                  </a:lnTo>
                  <a:lnTo>
                    <a:pt x="931" y="4"/>
                  </a:lnTo>
                  <a:lnTo>
                    <a:pt x="932" y="3"/>
                  </a:lnTo>
                  <a:lnTo>
                    <a:pt x="933" y="4"/>
                  </a:lnTo>
                  <a:lnTo>
                    <a:pt x="934" y="4"/>
                  </a:lnTo>
                  <a:lnTo>
                    <a:pt x="935" y="3"/>
                  </a:lnTo>
                  <a:lnTo>
                    <a:pt x="935" y="4"/>
                  </a:lnTo>
                  <a:lnTo>
                    <a:pt x="936" y="4"/>
                  </a:lnTo>
                  <a:lnTo>
                    <a:pt x="937" y="6"/>
                  </a:lnTo>
                  <a:lnTo>
                    <a:pt x="938" y="3"/>
                  </a:lnTo>
                  <a:lnTo>
                    <a:pt x="939" y="4"/>
                  </a:lnTo>
                  <a:lnTo>
                    <a:pt x="940" y="6"/>
                  </a:lnTo>
                  <a:lnTo>
                    <a:pt x="941" y="2"/>
                  </a:lnTo>
                  <a:lnTo>
                    <a:pt x="942" y="6"/>
                  </a:lnTo>
                  <a:lnTo>
                    <a:pt x="942" y="2"/>
                  </a:lnTo>
                  <a:lnTo>
                    <a:pt x="943" y="1"/>
                  </a:lnTo>
                  <a:lnTo>
                    <a:pt x="944" y="4"/>
                  </a:lnTo>
                  <a:lnTo>
                    <a:pt x="945" y="2"/>
                  </a:lnTo>
                  <a:lnTo>
                    <a:pt x="946" y="4"/>
                  </a:lnTo>
                  <a:lnTo>
                    <a:pt x="947" y="4"/>
                  </a:lnTo>
                  <a:lnTo>
                    <a:pt x="948" y="5"/>
                  </a:lnTo>
                  <a:lnTo>
                    <a:pt x="949" y="3"/>
                  </a:lnTo>
                  <a:lnTo>
                    <a:pt x="950" y="4"/>
                  </a:lnTo>
                  <a:lnTo>
                    <a:pt x="950" y="3"/>
                  </a:lnTo>
                  <a:lnTo>
                    <a:pt x="951" y="4"/>
                  </a:lnTo>
                  <a:lnTo>
                    <a:pt x="952" y="5"/>
                  </a:lnTo>
                  <a:lnTo>
                    <a:pt x="953" y="6"/>
                  </a:lnTo>
                  <a:lnTo>
                    <a:pt x="954" y="4"/>
                  </a:lnTo>
                  <a:lnTo>
                    <a:pt x="955" y="4"/>
                  </a:lnTo>
                  <a:lnTo>
                    <a:pt x="956" y="5"/>
                  </a:lnTo>
                  <a:lnTo>
                    <a:pt x="957" y="6"/>
                  </a:lnTo>
                  <a:lnTo>
                    <a:pt x="957" y="4"/>
                  </a:lnTo>
                  <a:lnTo>
                    <a:pt x="958" y="7"/>
                  </a:lnTo>
                  <a:lnTo>
                    <a:pt x="959" y="4"/>
                  </a:lnTo>
                  <a:lnTo>
                    <a:pt x="960" y="7"/>
                  </a:lnTo>
                  <a:lnTo>
                    <a:pt x="961" y="8"/>
                  </a:lnTo>
                  <a:lnTo>
                    <a:pt x="962" y="8"/>
                  </a:lnTo>
                  <a:lnTo>
                    <a:pt x="963" y="8"/>
                  </a:lnTo>
                  <a:lnTo>
                    <a:pt x="964" y="11"/>
                  </a:lnTo>
                  <a:lnTo>
                    <a:pt x="965" y="7"/>
                  </a:lnTo>
                  <a:lnTo>
                    <a:pt x="965" y="11"/>
                  </a:lnTo>
                  <a:lnTo>
                    <a:pt x="966" y="10"/>
                  </a:lnTo>
                  <a:lnTo>
                    <a:pt x="967" y="11"/>
                  </a:lnTo>
                  <a:lnTo>
                    <a:pt x="968" y="11"/>
                  </a:lnTo>
                  <a:lnTo>
                    <a:pt x="969" y="17"/>
                  </a:lnTo>
                  <a:lnTo>
                    <a:pt x="970" y="17"/>
                  </a:lnTo>
                  <a:lnTo>
                    <a:pt x="971" y="17"/>
                  </a:lnTo>
                  <a:lnTo>
                    <a:pt x="972" y="21"/>
                  </a:lnTo>
                  <a:lnTo>
                    <a:pt x="972" y="19"/>
                  </a:lnTo>
                  <a:lnTo>
                    <a:pt x="973" y="18"/>
                  </a:lnTo>
                  <a:lnTo>
                    <a:pt x="974" y="22"/>
                  </a:lnTo>
                  <a:lnTo>
                    <a:pt x="975" y="23"/>
                  </a:lnTo>
                  <a:lnTo>
                    <a:pt x="976" y="23"/>
                  </a:lnTo>
                  <a:lnTo>
                    <a:pt x="977" y="22"/>
                  </a:lnTo>
                  <a:lnTo>
                    <a:pt x="978" y="22"/>
                  </a:lnTo>
                  <a:lnTo>
                    <a:pt x="979" y="21"/>
                  </a:lnTo>
                  <a:lnTo>
                    <a:pt x="980" y="19"/>
                  </a:lnTo>
                  <a:lnTo>
                    <a:pt x="980" y="15"/>
                  </a:lnTo>
                  <a:lnTo>
                    <a:pt x="981" y="11"/>
                  </a:lnTo>
                  <a:lnTo>
                    <a:pt x="982" y="12"/>
                  </a:lnTo>
                  <a:lnTo>
                    <a:pt x="983" y="12"/>
                  </a:lnTo>
                  <a:lnTo>
                    <a:pt x="984" y="13"/>
                  </a:lnTo>
                  <a:lnTo>
                    <a:pt x="985" y="14"/>
                  </a:lnTo>
                  <a:lnTo>
                    <a:pt x="986" y="10"/>
                  </a:lnTo>
                  <a:lnTo>
                    <a:pt x="987" y="13"/>
                  </a:lnTo>
                  <a:lnTo>
                    <a:pt x="987" y="17"/>
                  </a:lnTo>
                  <a:lnTo>
                    <a:pt x="988" y="14"/>
                  </a:lnTo>
                  <a:lnTo>
                    <a:pt x="989" y="19"/>
                  </a:lnTo>
                  <a:lnTo>
                    <a:pt x="990" y="19"/>
                  </a:lnTo>
                  <a:lnTo>
                    <a:pt x="991" y="21"/>
                  </a:lnTo>
                  <a:lnTo>
                    <a:pt x="992" y="21"/>
                  </a:lnTo>
                  <a:lnTo>
                    <a:pt x="993" y="26"/>
                  </a:lnTo>
                  <a:lnTo>
                    <a:pt x="994" y="22"/>
                  </a:lnTo>
                  <a:lnTo>
                    <a:pt x="995" y="24"/>
                  </a:lnTo>
                  <a:lnTo>
                    <a:pt x="995" y="22"/>
                  </a:lnTo>
                  <a:lnTo>
                    <a:pt x="996" y="21"/>
                  </a:lnTo>
                  <a:lnTo>
                    <a:pt x="997" y="21"/>
                  </a:lnTo>
                  <a:lnTo>
                    <a:pt x="998" y="19"/>
                  </a:lnTo>
                  <a:lnTo>
                    <a:pt x="999" y="19"/>
                  </a:lnTo>
                  <a:lnTo>
                    <a:pt x="1000" y="17"/>
                  </a:lnTo>
                  <a:lnTo>
                    <a:pt x="1001" y="17"/>
                  </a:lnTo>
                  <a:lnTo>
                    <a:pt x="1002" y="17"/>
                  </a:lnTo>
                  <a:lnTo>
                    <a:pt x="1002" y="17"/>
                  </a:lnTo>
                  <a:lnTo>
                    <a:pt x="1003" y="17"/>
                  </a:lnTo>
                  <a:lnTo>
                    <a:pt x="1004" y="17"/>
                  </a:lnTo>
                  <a:lnTo>
                    <a:pt x="1005" y="14"/>
                  </a:lnTo>
                  <a:lnTo>
                    <a:pt x="1006" y="16"/>
                  </a:lnTo>
                  <a:lnTo>
                    <a:pt x="1007" y="15"/>
                  </a:lnTo>
                  <a:lnTo>
                    <a:pt x="1008" y="14"/>
                  </a:lnTo>
                  <a:lnTo>
                    <a:pt x="1009" y="19"/>
                  </a:lnTo>
                  <a:lnTo>
                    <a:pt x="1010" y="18"/>
                  </a:lnTo>
                  <a:lnTo>
                    <a:pt x="1010" y="18"/>
                  </a:lnTo>
                  <a:lnTo>
                    <a:pt x="1011" y="19"/>
                  </a:lnTo>
                  <a:lnTo>
                    <a:pt x="1012" y="23"/>
                  </a:lnTo>
                  <a:lnTo>
                    <a:pt x="1013" y="20"/>
                  </a:lnTo>
                  <a:lnTo>
                    <a:pt x="1014" y="15"/>
                  </a:lnTo>
                  <a:lnTo>
                    <a:pt x="1015" y="18"/>
                  </a:lnTo>
                  <a:lnTo>
                    <a:pt x="1016" y="18"/>
                  </a:lnTo>
                  <a:lnTo>
                    <a:pt x="1017" y="15"/>
                  </a:lnTo>
                  <a:lnTo>
                    <a:pt x="1017" y="15"/>
                  </a:lnTo>
                  <a:lnTo>
                    <a:pt x="1018" y="18"/>
                  </a:lnTo>
                  <a:lnTo>
                    <a:pt x="1019" y="18"/>
                  </a:lnTo>
                  <a:lnTo>
                    <a:pt x="1020" y="19"/>
                  </a:lnTo>
                  <a:lnTo>
                    <a:pt x="1021" y="15"/>
                  </a:lnTo>
                  <a:lnTo>
                    <a:pt x="1022" y="15"/>
                  </a:lnTo>
                  <a:lnTo>
                    <a:pt x="1023" y="18"/>
                  </a:lnTo>
                  <a:lnTo>
                    <a:pt x="1024" y="19"/>
                  </a:lnTo>
                  <a:lnTo>
                    <a:pt x="1025" y="17"/>
                  </a:lnTo>
                  <a:lnTo>
                    <a:pt x="1025" y="17"/>
                  </a:lnTo>
                  <a:lnTo>
                    <a:pt x="1026" y="16"/>
                  </a:lnTo>
                  <a:lnTo>
                    <a:pt x="1027" y="16"/>
                  </a:lnTo>
                  <a:lnTo>
                    <a:pt x="1028" y="20"/>
                  </a:lnTo>
                  <a:lnTo>
                    <a:pt x="1029" y="14"/>
                  </a:lnTo>
                  <a:lnTo>
                    <a:pt x="1030" y="16"/>
                  </a:lnTo>
                  <a:lnTo>
                    <a:pt x="1031" y="20"/>
                  </a:lnTo>
                  <a:lnTo>
                    <a:pt x="1032" y="15"/>
                  </a:lnTo>
                  <a:lnTo>
                    <a:pt x="1032" y="17"/>
                  </a:lnTo>
                  <a:lnTo>
                    <a:pt x="1033" y="17"/>
                  </a:lnTo>
                  <a:lnTo>
                    <a:pt x="1034" y="15"/>
                  </a:lnTo>
                  <a:lnTo>
                    <a:pt x="1035" y="13"/>
                  </a:lnTo>
                  <a:lnTo>
                    <a:pt x="1036" y="13"/>
                  </a:lnTo>
                  <a:lnTo>
                    <a:pt x="1037" y="10"/>
                  </a:lnTo>
                  <a:lnTo>
                    <a:pt x="1038" y="14"/>
                  </a:lnTo>
                  <a:lnTo>
                    <a:pt x="1039" y="10"/>
                  </a:lnTo>
                  <a:lnTo>
                    <a:pt x="1040" y="11"/>
                  </a:lnTo>
                  <a:lnTo>
                    <a:pt x="1040" y="12"/>
                  </a:lnTo>
                  <a:lnTo>
                    <a:pt x="1041" y="12"/>
                  </a:lnTo>
                  <a:lnTo>
                    <a:pt x="1042" y="9"/>
                  </a:lnTo>
                  <a:lnTo>
                    <a:pt x="1043" y="10"/>
                  </a:lnTo>
                  <a:lnTo>
                    <a:pt x="1044" y="14"/>
                  </a:lnTo>
                  <a:lnTo>
                    <a:pt x="1045" y="11"/>
                  </a:lnTo>
                  <a:lnTo>
                    <a:pt x="1046" y="10"/>
                  </a:lnTo>
                  <a:lnTo>
                    <a:pt x="1047" y="12"/>
                  </a:lnTo>
                  <a:lnTo>
                    <a:pt x="1047" y="11"/>
                  </a:lnTo>
                  <a:lnTo>
                    <a:pt x="1048" y="11"/>
                  </a:lnTo>
                  <a:lnTo>
                    <a:pt x="1049" y="10"/>
                  </a:lnTo>
                  <a:lnTo>
                    <a:pt x="1050" y="15"/>
                  </a:lnTo>
                  <a:lnTo>
                    <a:pt x="1051" y="14"/>
                  </a:lnTo>
                  <a:lnTo>
                    <a:pt x="1052" y="12"/>
                  </a:lnTo>
                  <a:lnTo>
                    <a:pt x="1053" y="10"/>
                  </a:lnTo>
                  <a:lnTo>
                    <a:pt x="1054" y="11"/>
                  </a:lnTo>
                  <a:lnTo>
                    <a:pt x="1054" y="11"/>
                  </a:lnTo>
                  <a:lnTo>
                    <a:pt x="1055" y="12"/>
                  </a:lnTo>
                  <a:lnTo>
                    <a:pt x="1056" y="11"/>
                  </a:lnTo>
                  <a:lnTo>
                    <a:pt x="1057" y="9"/>
                  </a:lnTo>
                  <a:lnTo>
                    <a:pt x="1058" y="10"/>
                  </a:lnTo>
                  <a:lnTo>
                    <a:pt x="1059" y="14"/>
                  </a:lnTo>
                  <a:lnTo>
                    <a:pt x="1060" y="9"/>
                  </a:lnTo>
                  <a:lnTo>
                    <a:pt x="1061" y="9"/>
                  </a:lnTo>
                  <a:lnTo>
                    <a:pt x="1062" y="11"/>
                  </a:lnTo>
                  <a:lnTo>
                    <a:pt x="1062" y="6"/>
                  </a:lnTo>
                  <a:lnTo>
                    <a:pt x="1063" y="12"/>
                  </a:lnTo>
                  <a:lnTo>
                    <a:pt x="1064" y="9"/>
                  </a:lnTo>
                  <a:lnTo>
                    <a:pt x="1065" y="12"/>
                  </a:lnTo>
                  <a:lnTo>
                    <a:pt x="1066" y="14"/>
                  </a:lnTo>
                  <a:lnTo>
                    <a:pt x="1067" y="12"/>
                  </a:lnTo>
                  <a:lnTo>
                    <a:pt x="1068" y="12"/>
                  </a:lnTo>
                  <a:lnTo>
                    <a:pt x="1069" y="12"/>
                  </a:lnTo>
                  <a:lnTo>
                    <a:pt x="1069" y="11"/>
                  </a:lnTo>
                  <a:lnTo>
                    <a:pt x="1070" y="14"/>
                  </a:lnTo>
                  <a:lnTo>
                    <a:pt x="1071" y="10"/>
                  </a:lnTo>
                  <a:lnTo>
                    <a:pt x="1072" y="13"/>
                  </a:lnTo>
                  <a:lnTo>
                    <a:pt x="1073" y="9"/>
                  </a:lnTo>
                  <a:lnTo>
                    <a:pt x="1074" y="14"/>
                  </a:lnTo>
                  <a:lnTo>
                    <a:pt x="1075" y="11"/>
                  </a:lnTo>
                  <a:lnTo>
                    <a:pt x="1076" y="14"/>
                  </a:lnTo>
                  <a:lnTo>
                    <a:pt x="1077" y="10"/>
                  </a:lnTo>
                  <a:lnTo>
                    <a:pt x="1077" y="12"/>
                  </a:lnTo>
                  <a:lnTo>
                    <a:pt x="1078" y="7"/>
                  </a:lnTo>
                  <a:lnTo>
                    <a:pt x="1079" y="8"/>
                  </a:lnTo>
                  <a:lnTo>
                    <a:pt x="1080" y="11"/>
                  </a:lnTo>
                  <a:lnTo>
                    <a:pt x="1081" y="8"/>
                  </a:lnTo>
                  <a:lnTo>
                    <a:pt x="1082" y="10"/>
                  </a:lnTo>
                  <a:lnTo>
                    <a:pt x="1083" y="9"/>
                  </a:lnTo>
                  <a:lnTo>
                    <a:pt x="1084" y="6"/>
                  </a:lnTo>
                  <a:lnTo>
                    <a:pt x="1084" y="8"/>
                  </a:lnTo>
                  <a:lnTo>
                    <a:pt x="1085" y="9"/>
                  </a:lnTo>
                  <a:lnTo>
                    <a:pt x="1086" y="10"/>
                  </a:lnTo>
                  <a:lnTo>
                    <a:pt x="1087" y="8"/>
                  </a:lnTo>
                  <a:lnTo>
                    <a:pt x="1088" y="7"/>
                  </a:lnTo>
                  <a:lnTo>
                    <a:pt x="1089" y="8"/>
                  </a:lnTo>
                  <a:lnTo>
                    <a:pt x="1090" y="8"/>
                  </a:lnTo>
                  <a:lnTo>
                    <a:pt x="1091" y="10"/>
                  </a:lnTo>
                  <a:lnTo>
                    <a:pt x="1092" y="8"/>
                  </a:lnTo>
                  <a:lnTo>
                    <a:pt x="1092" y="11"/>
                  </a:lnTo>
                  <a:lnTo>
                    <a:pt x="1093" y="9"/>
                  </a:lnTo>
                  <a:lnTo>
                    <a:pt x="1094" y="8"/>
                  </a:lnTo>
                  <a:lnTo>
                    <a:pt x="1095" y="7"/>
                  </a:lnTo>
                  <a:lnTo>
                    <a:pt x="1096" y="8"/>
                  </a:lnTo>
                  <a:lnTo>
                    <a:pt x="1097" y="7"/>
                  </a:lnTo>
                  <a:lnTo>
                    <a:pt x="1098" y="5"/>
                  </a:lnTo>
                  <a:lnTo>
                    <a:pt x="1099" y="8"/>
                  </a:lnTo>
                  <a:lnTo>
                    <a:pt x="1099" y="8"/>
                  </a:lnTo>
                  <a:lnTo>
                    <a:pt x="1100" y="6"/>
                  </a:lnTo>
                  <a:lnTo>
                    <a:pt x="1101" y="6"/>
                  </a:lnTo>
                  <a:lnTo>
                    <a:pt x="1102" y="6"/>
                  </a:lnTo>
                  <a:lnTo>
                    <a:pt x="1103" y="9"/>
                  </a:lnTo>
                  <a:lnTo>
                    <a:pt x="1104" y="5"/>
                  </a:lnTo>
                  <a:lnTo>
                    <a:pt x="1105" y="4"/>
                  </a:lnTo>
                  <a:lnTo>
                    <a:pt x="1106" y="8"/>
                  </a:lnTo>
                  <a:lnTo>
                    <a:pt x="1107" y="6"/>
                  </a:lnTo>
                  <a:lnTo>
                    <a:pt x="1107" y="8"/>
                  </a:lnTo>
                  <a:lnTo>
                    <a:pt x="1108" y="5"/>
                  </a:lnTo>
                  <a:lnTo>
                    <a:pt x="1109" y="8"/>
                  </a:lnTo>
                  <a:lnTo>
                    <a:pt x="1110" y="4"/>
                  </a:lnTo>
                  <a:lnTo>
                    <a:pt x="1111" y="8"/>
                  </a:lnTo>
                  <a:lnTo>
                    <a:pt x="1112" y="9"/>
                  </a:lnTo>
                  <a:lnTo>
                    <a:pt x="1113" y="6"/>
                  </a:lnTo>
                  <a:lnTo>
                    <a:pt x="1114" y="7"/>
                  </a:lnTo>
                  <a:lnTo>
                    <a:pt x="1114" y="7"/>
                  </a:lnTo>
                  <a:lnTo>
                    <a:pt x="1115" y="5"/>
                  </a:lnTo>
                  <a:lnTo>
                    <a:pt x="1116" y="6"/>
                  </a:lnTo>
                  <a:lnTo>
                    <a:pt x="1117" y="5"/>
                  </a:lnTo>
                  <a:lnTo>
                    <a:pt x="1118" y="6"/>
                  </a:lnTo>
                  <a:lnTo>
                    <a:pt x="1119" y="4"/>
                  </a:lnTo>
                  <a:lnTo>
                    <a:pt x="1120" y="3"/>
                  </a:lnTo>
                  <a:lnTo>
                    <a:pt x="1121" y="3"/>
                  </a:lnTo>
                  <a:lnTo>
                    <a:pt x="1122" y="4"/>
                  </a:lnTo>
                  <a:lnTo>
                    <a:pt x="1122" y="8"/>
                  </a:lnTo>
                  <a:lnTo>
                    <a:pt x="1123" y="6"/>
                  </a:lnTo>
                  <a:lnTo>
                    <a:pt x="1124" y="6"/>
                  </a:lnTo>
                  <a:lnTo>
                    <a:pt x="1125" y="4"/>
                  </a:lnTo>
                  <a:lnTo>
                    <a:pt x="1126" y="7"/>
                  </a:lnTo>
                  <a:lnTo>
                    <a:pt x="1127" y="7"/>
                  </a:lnTo>
                  <a:lnTo>
                    <a:pt x="1128" y="3"/>
                  </a:lnTo>
                  <a:lnTo>
                    <a:pt x="1129" y="3"/>
                  </a:lnTo>
                  <a:lnTo>
                    <a:pt x="1129" y="4"/>
                  </a:lnTo>
                  <a:lnTo>
                    <a:pt x="1130" y="6"/>
                  </a:lnTo>
                  <a:lnTo>
                    <a:pt x="1131" y="5"/>
                  </a:lnTo>
                  <a:lnTo>
                    <a:pt x="1132" y="5"/>
                  </a:lnTo>
                  <a:lnTo>
                    <a:pt x="1133" y="4"/>
                  </a:lnTo>
                  <a:lnTo>
                    <a:pt x="1134" y="5"/>
                  </a:lnTo>
                  <a:lnTo>
                    <a:pt x="1135" y="6"/>
                  </a:lnTo>
                  <a:lnTo>
                    <a:pt x="1136" y="8"/>
                  </a:lnTo>
                  <a:lnTo>
                    <a:pt x="1137" y="5"/>
                  </a:lnTo>
                  <a:lnTo>
                    <a:pt x="1137" y="5"/>
                  </a:lnTo>
                  <a:lnTo>
                    <a:pt x="1138" y="7"/>
                  </a:lnTo>
                  <a:lnTo>
                    <a:pt x="1139" y="7"/>
                  </a:lnTo>
                  <a:lnTo>
                    <a:pt x="1140" y="7"/>
                  </a:lnTo>
                  <a:lnTo>
                    <a:pt x="1141" y="11"/>
                  </a:lnTo>
                  <a:lnTo>
                    <a:pt x="1142" y="5"/>
                  </a:lnTo>
                  <a:lnTo>
                    <a:pt x="1143" y="8"/>
                  </a:lnTo>
                  <a:lnTo>
                    <a:pt x="1144" y="8"/>
                  </a:lnTo>
                  <a:lnTo>
                    <a:pt x="1144" y="6"/>
                  </a:lnTo>
                  <a:lnTo>
                    <a:pt x="1145" y="7"/>
                  </a:lnTo>
                  <a:lnTo>
                    <a:pt x="1146" y="6"/>
                  </a:lnTo>
                  <a:lnTo>
                    <a:pt x="1147" y="4"/>
                  </a:lnTo>
                  <a:lnTo>
                    <a:pt x="1148" y="4"/>
                  </a:lnTo>
                  <a:lnTo>
                    <a:pt x="1149" y="6"/>
                  </a:lnTo>
                  <a:lnTo>
                    <a:pt x="1150" y="4"/>
                  </a:lnTo>
                  <a:lnTo>
                    <a:pt x="1151" y="7"/>
                  </a:lnTo>
                  <a:lnTo>
                    <a:pt x="1152" y="5"/>
                  </a:lnTo>
                  <a:lnTo>
                    <a:pt x="1152" y="5"/>
                  </a:lnTo>
                  <a:lnTo>
                    <a:pt x="1153" y="3"/>
                  </a:lnTo>
                  <a:lnTo>
                    <a:pt x="1154" y="4"/>
                  </a:lnTo>
                  <a:lnTo>
                    <a:pt x="1155" y="6"/>
                  </a:lnTo>
                  <a:lnTo>
                    <a:pt x="1156" y="6"/>
                  </a:lnTo>
                  <a:lnTo>
                    <a:pt x="1157" y="7"/>
                  </a:lnTo>
                  <a:lnTo>
                    <a:pt x="1158" y="8"/>
                  </a:lnTo>
                  <a:lnTo>
                    <a:pt x="1159" y="9"/>
                  </a:lnTo>
                  <a:lnTo>
                    <a:pt x="1159" y="8"/>
                  </a:lnTo>
                  <a:lnTo>
                    <a:pt x="1160" y="10"/>
                  </a:lnTo>
                  <a:lnTo>
                    <a:pt x="1161" y="9"/>
                  </a:lnTo>
                  <a:lnTo>
                    <a:pt x="1162" y="8"/>
                  </a:lnTo>
                  <a:lnTo>
                    <a:pt x="1163" y="8"/>
                  </a:lnTo>
                  <a:lnTo>
                    <a:pt x="1164" y="7"/>
                  </a:lnTo>
                  <a:lnTo>
                    <a:pt x="1165" y="8"/>
                  </a:lnTo>
                  <a:lnTo>
                    <a:pt x="1166" y="5"/>
                  </a:lnTo>
                  <a:lnTo>
                    <a:pt x="1167" y="5"/>
                  </a:lnTo>
                  <a:lnTo>
                    <a:pt x="1167" y="7"/>
                  </a:lnTo>
                  <a:lnTo>
                    <a:pt x="1168" y="6"/>
                  </a:lnTo>
                  <a:lnTo>
                    <a:pt x="1169" y="8"/>
                  </a:lnTo>
                  <a:lnTo>
                    <a:pt x="1170" y="5"/>
                  </a:lnTo>
                  <a:lnTo>
                    <a:pt x="1171" y="6"/>
                  </a:lnTo>
                  <a:lnTo>
                    <a:pt x="1172" y="4"/>
                  </a:lnTo>
                  <a:lnTo>
                    <a:pt x="1173" y="7"/>
                  </a:lnTo>
                  <a:lnTo>
                    <a:pt x="1174" y="4"/>
                  </a:lnTo>
                  <a:lnTo>
                    <a:pt x="1174" y="5"/>
                  </a:lnTo>
                  <a:lnTo>
                    <a:pt x="1175" y="6"/>
                  </a:lnTo>
                  <a:lnTo>
                    <a:pt x="1176" y="4"/>
                  </a:lnTo>
                  <a:lnTo>
                    <a:pt x="1177" y="5"/>
                  </a:lnTo>
                  <a:lnTo>
                    <a:pt x="1178" y="4"/>
                  </a:lnTo>
                  <a:lnTo>
                    <a:pt x="1179" y="4"/>
                  </a:lnTo>
                  <a:lnTo>
                    <a:pt x="1180" y="6"/>
                  </a:lnTo>
                  <a:lnTo>
                    <a:pt x="1181" y="5"/>
                  </a:lnTo>
                  <a:lnTo>
                    <a:pt x="1182" y="2"/>
                  </a:lnTo>
                  <a:lnTo>
                    <a:pt x="1182" y="4"/>
                  </a:lnTo>
                  <a:lnTo>
                    <a:pt x="1183" y="2"/>
                  </a:lnTo>
                  <a:lnTo>
                    <a:pt x="1184" y="3"/>
                  </a:lnTo>
                  <a:lnTo>
                    <a:pt x="1185" y="10"/>
                  </a:lnTo>
                  <a:lnTo>
                    <a:pt x="1186" y="4"/>
                  </a:lnTo>
                  <a:lnTo>
                    <a:pt x="1187" y="4"/>
                  </a:lnTo>
                  <a:lnTo>
                    <a:pt x="1188" y="7"/>
                  </a:lnTo>
                  <a:lnTo>
                    <a:pt x="1189" y="3"/>
                  </a:lnTo>
                  <a:lnTo>
                    <a:pt x="1189" y="2"/>
                  </a:lnTo>
                  <a:lnTo>
                    <a:pt x="1190" y="6"/>
                  </a:lnTo>
                  <a:lnTo>
                    <a:pt x="1191" y="7"/>
                  </a:lnTo>
                  <a:lnTo>
                    <a:pt x="1192" y="4"/>
                  </a:lnTo>
                  <a:lnTo>
                    <a:pt x="1193" y="5"/>
                  </a:lnTo>
                  <a:lnTo>
                    <a:pt x="1194" y="3"/>
                  </a:lnTo>
                  <a:lnTo>
                    <a:pt x="1195" y="4"/>
                  </a:lnTo>
                  <a:lnTo>
                    <a:pt x="1196" y="5"/>
                  </a:lnTo>
                  <a:lnTo>
                    <a:pt x="1197" y="6"/>
                  </a:lnTo>
                  <a:lnTo>
                    <a:pt x="1197" y="4"/>
                  </a:lnTo>
                  <a:lnTo>
                    <a:pt x="1198" y="4"/>
                  </a:lnTo>
                  <a:lnTo>
                    <a:pt x="1199" y="4"/>
                  </a:lnTo>
                  <a:lnTo>
                    <a:pt x="1200" y="2"/>
                  </a:lnTo>
                  <a:lnTo>
                    <a:pt x="1201" y="5"/>
                  </a:lnTo>
                  <a:lnTo>
                    <a:pt x="1202" y="5"/>
                  </a:lnTo>
                  <a:lnTo>
                    <a:pt x="1203" y="7"/>
                  </a:lnTo>
                  <a:lnTo>
                    <a:pt x="1204" y="6"/>
                  </a:lnTo>
                  <a:lnTo>
                    <a:pt x="1204" y="8"/>
                  </a:lnTo>
                  <a:lnTo>
                    <a:pt x="1205" y="8"/>
                  </a:lnTo>
                  <a:lnTo>
                    <a:pt x="1206" y="8"/>
                  </a:lnTo>
                  <a:lnTo>
                    <a:pt x="1207" y="9"/>
                  </a:lnTo>
                  <a:lnTo>
                    <a:pt x="1208" y="7"/>
                  </a:lnTo>
                  <a:lnTo>
                    <a:pt x="1209" y="6"/>
                  </a:lnTo>
                  <a:lnTo>
                    <a:pt x="1210" y="6"/>
                  </a:lnTo>
                  <a:lnTo>
                    <a:pt x="1211" y="7"/>
                  </a:lnTo>
                  <a:lnTo>
                    <a:pt x="1212" y="8"/>
                  </a:lnTo>
                  <a:lnTo>
                    <a:pt x="1212" y="5"/>
                  </a:lnTo>
                  <a:lnTo>
                    <a:pt x="1213" y="6"/>
                  </a:lnTo>
                  <a:lnTo>
                    <a:pt x="1214" y="5"/>
                  </a:lnTo>
                  <a:lnTo>
                    <a:pt x="1215" y="4"/>
                  </a:lnTo>
                  <a:lnTo>
                    <a:pt x="1216" y="4"/>
                  </a:lnTo>
                  <a:lnTo>
                    <a:pt x="1217" y="3"/>
                  </a:lnTo>
                  <a:lnTo>
                    <a:pt x="1218" y="4"/>
                  </a:lnTo>
                  <a:lnTo>
                    <a:pt x="1219" y="7"/>
                  </a:lnTo>
                  <a:lnTo>
                    <a:pt x="1219" y="4"/>
                  </a:lnTo>
                  <a:lnTo>
                    <a:pt x="1220" y="4"/>
                  </a:lnTo>
                  <a:lnTo>
                    <a:pt x="1221" y="2"/>
                  </a:lnTo>
                  <a:lnTo>
                    <a:pt x="1222" y="7"/>
                  </a:lnTo>
                  <a:lnTo>
                    <a:pt x="1223" y="7"/>
                  </a:lnTo>
                  <a:lnTo>
                    <a:pt x="1224" y="6"/>
                  </a:lnTo>
                  <a:lnTo>
                    <a:pt x="1225" y="6"/>
                  </a:lnTo>
                  <a:lnTo>
                    <a:pt x="1226" y="9"/>
                  </a:lnTo>
                  <a:lnTo>
                    <a:pt x="1227" y="10"/>
                  </a:lnTo>
                  <a:lnTo>
                    <a:pt x="1227" y="10"/>
                  </a:lnTo>
                  <a:lnTo>
                    <a:pt x="1228" y="7"/>
                  </a:lnTo>
                  <a:lnTo>
                    <a:pt x="1229" y="9"/>
                  </a:lnTo>
                  <a:lnTo>
                    <a:pt x="1230" y="5"/>
                  </a:lnTo>
                  <a:lnTo>
                    <a:pt x="1231" y="8"/>
                  </a:lnTo>
                  <a:lnTo>
                    <a:pt x="1232" y="8"/>
                  </a:lnTo>
                  <a:lnTo>
                    <a:pt x="1233" y="6"/>
                  </a:lnTo>
                  <a:lnTo>
                    <a:pt x="1234" y="5"/>
                  </a:lnTo>
                  <a:lnTo>
                    <a:pt x="1234" y="4"/>
                  </a:lnTo>
                  <a:lnTo>
                    <a:pt x="1235" y="4"/>
                  </a:lnTo>
                  <a:lnTo>
                    <a:pt x="1236" y="5"/>
                  </a:lnTo>
                  <a:lnTo>
                    <a:pt x="1237" y="4"/>
                  </a:lnTo>
                  <a:lnTo>
                    <a:pt x="1238" y="6"/>
                  </a:lnTo>
                  <a:lnTo>
                    <a:pt x="1239" y="3"/>
                  </a:lnTo>
                  <a:lnTo>
                    <a:pt x="1240" y="3"/>
                  </a:lnTo>
                  <a:lnTo>
                    <a:pt x="1241" y="1"/>
                  </a:lnTo>
                  <a:lnTo>
                    <a:pt x="1242" y="3"/>
                  </a:lnTo>
                  <a:lnTo>
                    <a:pt x="1242" y="3"/>
                  </a:lnTo>
                  <a:lnTo>
                    <a:pt x="1243" y="6"/>
                  </a:lnTo>
                  <a:lnTo>
                    <a:pt x="1244" y="5"/>
                  </a:lnTo>
                  <a:lnTo>
                    <a:pt x="1245" y="6"/>
                  </a:lnTo>
                  <a:lnTo>
                    <a:pt x="1246" y="5"/>
                  </a:lnTo>
                  <a:lnTo>
                    <a:pt x="1247" y="8"/>
                  </a:lnTo>
                  <a:lnTo>
                    <a:pt x="1248" y="6"/>
                  </a:lnTo>
                  <a:lnTo>
                    <a:pt x="1249" y="7"/>
                  </a:lnTo>
                  <a:lnTo>
                    <a:pt x="1249" y="7"/>
                  </a:lnTo>
                  <a:lnTo>
                    <a:pt x="1250" y="7"/>
                  </a:lnTo>
                  <a:lnTo>
                    <a:pt x="1251" y="8"/>
                  </a:lnTo>
                  <a:lnTo>
                    <a:pt x="1252" y="9"/>
                  </a:lnTo>
                  <a:lnTo>
                    <a:pt x="1253" y="6"/>
                  </a:lnTo>
                  <a:lnTo>
                    <a:pt x="1254" y="7"/>
                  </a:lnTo>
                  <a:lnTo>
                    <a:pt x="1255" y="9"/>
                  </a:lnTo>
                  <a:lnTo>
                    <a:pt x="1256" y="7"/>
                  </a:lnTo>
                  <a:lnTo>
                    <a:pt x="1256" y="6"/>
                  </a:lnTo>
                  <a:lnTo>
                    <a:pt x="1257" y="7"/>
                  </a:lnTo>
                  <a:lnTo>
                    <a:pt x="1258" y="6"/>
                  </a:lnTo>
                  <a:lnTo>
                    <a:pt x="1259" y="6"/>
                  </a:lnTo>
                  <a:lnTo>
                    <a:pt x="1260" y="6"/>
                  </a:lnTo>
                  <a:lnTo>
                    <a:pt x="1261" y="4"/>
                  </a:lnTo>
                  <a:lnTo>
                    <a:pt x="1262" y="8"/>
                  </a:lnTo>
                  <a:lnTo>
                    <a:pt x="1263" y="7"/>
                  </a:lnTo>
                  <a:lnTo>
                    <a:pt x="1264" y="5"/>
                  </a:lnTo>
                  <a:lnTo>
                    <a:pt x="1264" y="7"/>
                  </a:lnTo>
                  <a:lnTo>
                    <a:pt x="1265" y="6"/>
                  </a:lnTo>
                  <a:lnTo>
                    <a:pt x="1266" y="10"/>
                  </a:lnTo>
                  <a:lnTo>
                    <a:pt x="1267" y="8"/>
                  </a:lnTo>
                  <a:lnTo>
                    <a:pt x="1268" y="10"/>
                  </a:lnTo>
                  <a:lnTo>
                    <a:pt x="1269" y="8"/>
                  </a:lnTo>
                  <a:lnTo>
                    <a:pt x="1270" y="6"/>
                  </a:lnTo>
                  <a:lnTo>
                    <a:pt x="1271" y="7"/>
                  </a:lnTo>
                  <a:lnTo>
                    <a:pt x="1271" y="9"/>
                  </a:lnTo>
                  <a:lnTo>
                    <a:pt x="1272" y="12"/>
                  </a:lnTo>
                  <a:lnTo>
                    <a:pt x="1273" y="8"/>
                  </a:lnTo>
                  <a:lnTo>
                    <a:pt x="1274" y="9"/>
                  </a:lnTo>
                  <a:lnTo>
                    <a:pt x="1275" y="7"/>
                  </a:lnTo>
                  <a:lnTo>
                    <a:pt x="1276" y="8"/>
                  </a:lnTo>
                  <a:lnTo>
                    <a:pt x="1277" y="8"/>
                  </a:lnTo>
                  <a:lnTo>
                    <a:pt x="1278" y="8"/>
                  </a:lnTo>
                  <a:lnTo>
                    <a:pt x="1279" y="6"/>
                  </a:lnTo>
                  <a:lnTo>
                    <a:pt x="1279" y="6"/>
                  </a:lnTo>
                  <a:lnTo>
                    <a:pt x="1280" y="12"/>
                  </a:lnTo>
                  <a:lnTo>
                    <a:pt x="1281" y="8"/>
                  </a:lnTo>
                  <a:lnTo>
                    <a:pt x="1282" y="9"/>
                  </a:lnTo>
                  <a:lnTo>
                    <a:pt x="1283" y="7"/>
                  </a:lnTo>
                  <a:lnTo>
                    <a:pt x="1284" y="7"/>
                  </a:lnTo>
                  <a:lnTo>
                    <a:pt x="1285" y="10"/>
                  </a:lnTo>
                  <a:lnTo>
                    <a:pt x="1286" y="9"/>
                  </a:lnTo>
                  <a:lnTo>
                    <a:pt x="1286" y="8"/>
                  </a:lnTo>
                  <a:lnTo>
                    <a:pt x="1287" y="8"/>
                  </a:lnTo>
                  <a:lnTo>
                    <a:pt x="1288" y="9"/>
                  </a:lnTo>
                  <a:lnTo>
                    <a:pt x="1289" y="11"/>
                  </a:lnTo>
                  <a:lnTo>
                    <a:pt x="1290" y="8"/>
                  </a:lnTo>
                  <a:lnTo>
                    <a:pt x="1291" y="7"/>
                  </a:lnTo>
                  <a:lnTo>
                    <a:pt x="1292" y="6"/>
                  </a:lnTo>
                  <a:lnTo>
                    <a:pt x="1293" y="7"/>
                  </a:lnTo>
                  <a:lnTo>
                    <a:pt x="1294" y="8"/>
                  </a:lnTo>
                  <a:lnTo>
                    <a:pt x="1294" y="7"/>
                  </a:lnTo>
                  <a:lnTo>
                    <a:pt x="1295" y="13"/>
                  </a:lnTo>
                  <a:lnTo>
                    <a:pt x="1296" y="8"/>
                  </a:lnTo>
                  <a:lnTo>
                    <a:pt x="1297" y="7"/>
                  </a:lnTo>
                  <a:lnTo>
                    <a:pt x="1298" y="10"/>
                  </a:lnTo>
                  <a:lnTo>
                    <a:pt x="1299" y="12"/>
                  </a:lnTo>
                  <a:lnTo>
                    <a:pt x="1300" y="12"/>
                  </a:lnTo>
                  <a:lnTo>
                    <a:pt x="1301" y="6"/>
                  </a:lnTo>
                  <a:lnTo>
                    <a:pt x="1301" y="10"/>
                  </a:lnTo>
                  <a:lnTo>
                    <a:pt x="1302" y="9"/>
                  </a:lnTo>
                  <a:lnTo>
                    <a:pt x="1303" y="11"/>
                  </a:lnTo>
                  <a:lnTo>
                    <a:pt x="1304" y="12"/>
                  </a:lnTo>
                  <a:lnTo>
                    <a:pt x="1305" y="11"/>
                  </a:lnTo>
                  <a:lnTo>
                    <a:pt x="1306" y="11"/>
                  </a:lnTo>
                  <a:lnTo>
                    <a:pt x="1307" y="12"/>
                  </a:lnTo>
                  <a:lnTo>
                    <a:pt x="1308" y="13"/>
                  </a:lnTo>
                  <a:lnTo>
                    <a:pt x="1309" y="16"/>
                  </a:lnTo>
                  <a:lnTo>
                    <a:pt x="1309" y="16"/>
                  </a:lnTo>
                  <a:lnTo>
                    <a:pt x="1310" y="11"/>
                  </a:lnTo>
                  <a:lnTo>
                    <a:pt x="1311" y="17"/>
                  </a:lnTo>
                  <a:lnTo>
                    <a:pt x="1312" y="16"/>
                  </a:lnTo>
                  <a:lnTo>
                    <a:pt x="1313" y="17"/>
                  </a:lnTo>
                  <a:lnTo>
                    <a:pt x="1314" y="15"/>
                  </a:lnTo>
                  <a:lnTo>
                    <a:pt x="1315" y="17"/>
                  </a:lnTo>
                  <a:lnTo>
                    <a:pt x="1316" y="14"/>
                  </a:lnTo>
                  <a:lnTo>
                    <a:pt x="1316" y="13"/>
                  </a:lnTo>
                  <a:lnTo>
                    <a:pt x="1317" y="15"/>
                  </a:lnTo>
                  <a:lnTo>
                    <a:pt x="1318" y="16"/>
                  </a:lnTo>
                  <a:lnTo>
                    <a:pt x="1319" y="15"/>
                  </a:lnTo>
                  <a:lnTo>
                    <a:pt x="1320" y="17"/>
                  </a:lnTo>
                  <a:lnTo>
                    <a:pt x="1321" y="14"/>
                  </a:lnTo>
                  <a:lnTo>
                    <a:pt x="1322" y="16"/>
                  </a:lnTo>
                  <a:lnTo>
                    <a:pt x="1323" y="14"/>
                  </a:lnTo>
                  <a:lnTo>
                    <a:pt x="1324" y="14"/>
                  </a:lnTo>
                  <a:lnTo>
                    <a:pt x="1324" y="19"/>
                  </a:lnTo>
                  <a:lnTo>
                    <a:pt x="1325" y="16"/>
                  </a:lnTo>
                  <a:lnTo>
                    <a:pt x="1326" y="15"/>
                  </a:lnTo>
                  <a:lnTo>
                    <a:pt x="1327" y="15"/>
                  </a:lnTo>
                  <a:lnTo>
                    <a:pt x="1328" y="21"/>
                  </a:lnTo>
                  <a:lnTo>
                    <a:pt x="1329" y="22"/>
                  </a:lnTo>
                  <a:lnTo>
                    <a:pt x="1330" y="25"/>
                  </a:lnTo>
                  <a:lnTo>
                    <a:pt x="1331" y="28"/>
                  </a:lnTo>
                  <a:lnTo>
                    <a:pt x="1331" y="26"/>
                  </a:lnTo>
                  <a:lnTo>
                    <a:pt x="1332" y="30"/>
                  </a:lnTo>
                  <a:lnTo>
                    <a:pt x="1333" y="26"/>
                  </a:lnTo>
                  <a:lnTo>
                    <a:pt x="1334" y="29"/>
                  </a:lnTo>
                  <a:lnTo>
                    <a:pt x="1335" y="28"/>
                  </a:lnTo>
                  <a:lnTo>
                    <a:pt x="1336" y="25"/>
                  </a:lnTo>
                  <a:lnTo>
                    <a:pt x="1337" y="21"/>
                  </a:lnTo>
                  <a:lnTo>
                    <a:pt x="1338" y="24"/>
                  </a:lnTo>
                  <a:lnTo>
                    <a:pt x="1339" y="24"/>
                  </a:lnTo>
                  <a:lnTo>
                    <a:pt x="1339" y="24"/>
                  </a:lnTo>
                  <a:lnTo>
                    <a:pt x="1340" y="25"/>
                  </a:lnTo>
                  <a:lnTo>
                    <a:pt x="1341" y="24"/>
                  </a:lnTo>
                  <a:lnTo>
                    <a:pt x="1342" y="21"/>
                  </a:lnTo>
                  <a:lnTo>
                    <a:pt x="1343" y="21"/>
                  </a:lnTo>
                  <a:lnTo>
                    <a:pt x="1344" y="18"/>
                  </a:lnTo>
                  <a:lnTo>
                    <a:pt x="1345" y="21"/>
                  </a:lnTo>
                  <a:lnTo>
                    <a:pt x="1346" y="21"/>
                  </a:lnTo>
                  <a:lnTo>
                    <a:pt x="1346" y="15"/>
                  </a:lnTo>
                  <a:lnTo>
                    <a:pt x="1347" y="15"/>
                  </a:lnTo>
                  <a:lnTo>
                    <a:pt x="1348" y="17"/>
                  </a:lnTo>
                  <a:lnTo>
                    <a:pt x="1349" y="13"/>
                  </a:lnTo>
                  <a:lnTo>
                    <a:pt x="1350" y="12"/>
                  </a:lnTo>
                  <a:lnTo>
                    <a:pt x="1351" y="15"/>
                  </a:lnTo>
                  <a:lnTo>
                    <a:pt x="1352" y="16"/>
                  </a:lnTo>
                  <a:lnTo>
                    <a:pt x="1353" y="14"/>
                  </a:lnTo>
                  <a:lnTo>
                    <a:pt x="1354" y="12"/>
                  </a:lnTo>
                  <a:lnTo>
                    <a:pt x="1354" y="11"/>
                  </a:lnTo>
                  <a:lnTo>
                    <a:pt x="1355" y="14"/>
                  </a:lnTo>
                  <a:lnTo>
                    <a:pt x="1356" y="13"/>
                  </a:lnTo>
                  <a:lnTo>
                    <a:pt x="1357" y="13"/>
                  </a:lnTo>
                  <a:lnTo>
                    <a:pt x="1358" y="11"/>
                  </a:lnTo>
                  <a:lnTo>
                    <a:pt x="1359" y="11"/>
                  </a:lnTo>
                  <a:lnTo>
                    <a:pt x="1360" y="14"/>
                  </a:lnTo>
                  <a:lnTo>
                    <a:pt x="1361" y="12"/>
                  </a:lnTo>
                  <a:lnTo>
                    <a:pt x="1361" y="13"/>
                  </a:lnTo>
                  <a:lnTo>
                    <a:pt x="1362" y="11"/>
                  </a:lnTo>
                  <a:lnTo>
                    <a:pt x="1363" y="13"/>
                  </a:lnTo>
                  <a:lnTo>
                    <a:pt x="1364" y="16"/>
                  </a:lnTo>
                  <a:lnTo>
                    <a:pt x="1365" y="18"/>
                  </a:lnTo>
                  <a:lnTo>
                    <a:pt x="1366" y="22"/>
                  </a:lnTo>
                  <a:lnTo>
                    <a:pt x="1367" y="25"/>
                  </a:lnTo>
                  <a:lnTo>
                    <a:pt x="1368" y="30"/>
                  </a:lnTo>
                  <a:lnTo>
                    <a:pt x="1369" y="29"/>
                  </a:lnTo>
                  <a:lnTo>
                    <a:pt x="1369" y="28"/>
                  </a:lnTo>
                  <a:lnTo>
                    <a:pt x="1370" y="32"/>
                  </a:lnTo>
                  <a:lnTo>
                    <a:pt x="1371" y="29"/>
                  </a:lnTo>
                  <a:lnTo>
                    <a:pt x="1372" y="30"/>
                  </a:lnTo>
                  <a:lnTo>
                    <a:pt x="1373" y="28"/>
                  </a:lnTo>
                  <a:lnTo>
                    <a:pt x="1374" y="26"/>
                  </a:lnTo>
                  <a:lnTo>
                    <a:pt x="1375" y="25"/>
                  </a:lnTo>
                  <a:lnTo>
                    <a:pt x="1376" y="25"/>
                  </a:lnTo>
                  <a:lnTo>
                    <a:pt x="1376" y="22"/>
                  </a:lnTo>
                  <a:lnTo>
                    <a:pt x="1377" y="20"/>
                  </a:lnTo>
                  <a:lnTo>
                    <a:pt x="1378" y="18"/>
                  </a:lnTo>
                  <a:lnTo>
                    <a:pt x="1379" y="21"/>
                  </a:lnTo>
                  <a:lnTo>
                    <a:pt x="1380" y="15"/>
                  </a:lnTo>
                  <a:lnTo>
                    <a:pt x="1381" y="18"/>
                  </a:lnTo>
                  <a:lnTo>
                    <a:pt x="1382" y="15"/>
                  </a:lnTo>
                  <a:lnTo>
                    <a:pt x="1383" y="13"/>
                  </a:lnTo>
                  <a:lnTo>
                    <a:pt x="1384" y="9"/>
                  </a:lnTo>
                  <a:lnTo>
                    <a:pt x="1384" y="13"/>
                  </a:lnTo>
                  <a:lnTo>
                    <a:pt x="1385" y="11"/>
                  </a:lnTo>
                  <a:lnTo>
                    <a:pt x="1386" y="17"/>
                  </a:lnTo>
                  <a:lnTo>
                    <a:pt x="1387" y="19"/>
                  </a:lnTo>
                  <a:lnTo>
                    <a:pt x="1388" y="22"/>
                  </a:lnTo>
                  <a:lnTo>
                    <a:pt x="1389" y="27"/>
                  </a:lnTo>
                  <a:lnTo>
                    <a:pt x="1390" y="37"/>
                  </a:lnTo>
                  <a:lnTo>
                    <a:pt x="1391" y="41"/>
                  </a:lnTo>
                  <a:lnTo>
                    <a:pt x="1391" y="59"/>
                  </a:lnTo>
                  <a:lnTo>
                    <a:pt x="1392" y="71"/>
                  </a:lnTo>
                  <a:lnTo>
                    <a:pt x="1393" y="90"/>
                  </a:lnTo>
                  <a:lnTo>
                    <a:pt x="1394" y="104"/>
                  </a:lnTo>
                  <a:lnTo>
                    <a:pt x="1395" y="124"/>
                  </a:lnTo>
                  <a:lnTo>
                    <a:pt x="1396" y="138"/>
                  </a:lnTo>
                  <a:lnTo>
                    <a:pt x="1397" y="158"/>
                  </a:lnTo>
                  <a:lnTo>
                    <a:pt x="1398" y="173"/>
                  </a:lnTo>
                  <a:lnTo>
                    <a:pt x="1399" y="173"/>
                  </a:lnTo>
                  <a:lnTo>
                    <a:pt x="1399" y="180"/>
                  </a:lnTo>
                  <a:lnTo>
                    <a:pt x="1400" y="179"/>
                  </a:lnTo>
                  <a:lnTo>
                    <a:pt x="1401" y="170"/>
                  </a:lnTo>
                  <a:lnTo>
                    <a:pt x="1402" y="157"/>
                  </a:lnTo>
                  <a:lnTo>
                    <a:pt x="1403" y="155"/>
                  </a:lnTo>
                  <a:lnTo>
                    <a:pt x="1404" y="138"/>
                  </a:lnTo>
                  <a:lnTo>
                    <a:pt x="1405" y="132"/>
                  </a:lnTo>
                  <a:lnTo>
                    <a:pt x="1406" y="119"/>
                  </a:lnTo>
                  <a:lnTo>
                    <a:pt x="1406" y="116"/>
                  </a:lnTo>
                  <a:lnTo>
                    <a:pt x="1407" y="109"/>
                  </a:lnTo>
                  <a:lnTo>
                    <a:pt x="1408" y="104"/>
                  </a:lnTo>
                  <a:lnTo>
                    <a:pt x="1409" y="92"/>
                  </a:lnTo>
                  <a:lnTo>
                    <a:pt x="1410" y="88"/>
                  </a:lnTo>
                  <a:lnTo>
                    <a:pt x="1411" y="84"/>
                  </a:lnTo>
                  <a:lnTo>
                    <a:pt x="1412" y="74"/>
                  </a:lnTo>
                  <a:lnTo>
                    <a:pt x="1413" y="75"/>
                  </a:lnTo>
                  <a:lnTo>
                    <a:pt x="1414" y="67"/>
                  </a:lnTo>
                  <a:lnTo>
                    <a:pt x="1414" y="56"/>
                  </a:lnTo>
                  <a:lnTo>
                    <a:pt x="1415" y="55"/>
                  </a:lnTo>
                  <a:lnTo>
                    <a:pt x="1416" y="54"/>
                  </a:lnTo>
                  <a:lnTo>
                    <a:pt x="1417" y="51"/>
                  </a:lnTo>
                  <a:lnTo>
                    <a:pt x="1418" y="44"/>
                  </a:lnTo>
                  <a:lnTo>
                    <a:pt x="1419" y="48"/>
                  </a:lnTo>
                  <a:lnTo>
                    <a:pt x="1420" y="43"/>
                  </a:lnTo>
                  <a:lnTo>
                    <a:pt x="1421" y="41"/>
                  </a:lnTo>
                  <a:lnTo>
                    <a:pt x="1421" y="44"/>
                  </a:lnTo>
                  <a:lnTo>
                    <a:pt x="1422" y="43"/>
                  </a:lnTo>
                  <a:lnTo>
                    <a:pt x="1423" y="39"/>
                  </a:lnTo>
                  <a:lnTo>
                    <a:pt x="1424" y="39"/>
                  </a:lnTo>
                  <a:lnTo>
                    <a:pt x="1425" y="37"/>
                  </a:lnTo>
                  <a:lnTo>
                    <a:pt x="1426" y="36"/>
                  </a:lnTo>
                  <a:lnTo>
                    <a:pt x="1427" y="37"/>
                  </a:lnTo>
                  <a:lnTo>
                    <a:pt x="1428" y="38"/>
                  </a:lnTo>
                  <a:lnTo>
                    <a:pt x="1429" y="33"/>
                  </a:lnTo>
                  <a:lnTo>
                    <a:pt x="1429" y="34"/>
                  </a:lnTo>
                  <a:lnTo>
                    <a:pt x="1430" y="37"/>
                  </a:lnTo>
                  <a:lnTo>
                    <a:pt x="1431" y="35"/>
                  </a:lnTo>
                  <a:lnTo>
                    <a:pt x="1432" y="33"/>
                  </a:lnTo>
                  <a:lnTo>
                    <a:pt x="1433" y="36"/>
                  </a:lnTo>
                  <a:lnTo>
                    <a:pt x="1434" y="34"/>
                  </a:lnTo>
                  <a:lnTo>
                    <a:pt x="1435" y="37"/>
                  </a:lnTo>
                  <a:lnTo>
                    <a:pt x="1436" y="36"/>
                  </a:lnTo>
                  <a:lnTo>
                    <a:pt x="1436" y="37"/>
                  </a:lnTo>
                  <a:lnTo>
                    <a:pt x="1437" y="37"/>
                  </a:lnTo>
                  <a:lnTo>
                    <a:pt x="1438" y="33"/>
                  </a:lnTo>
                  <a:lnTo>
                    <a:pt x="1439" y="36"/>
                  </a:lnTo>
                  <a:lnTo>
                    <a:pt x="1440" y="35"/>
                  </a:lnTo>
                  <a:lnTo>
                    <a:pt x="1441" y="35"/>
                  </a:lnTo>
                  <a:lnTo>
                    <a:pt x="1442" y="37"/>
                  </a:lnTo>
                  <a:lnTo>
                    <a:pt x="1443" y="35"/>
                  </a:lnTo>
                  <a:lnTo>
                    <a:pt x="1444" y="35"/>
                  </a:lnTo>
                  <a:lnTo>
                    <a:pt x="1444" y="34"/>
                  </a:lnTo>
                  <a:lnTo>
                    <a:pt x="1445" y="31"/>
                  </a:lnTo>
                  <a:lnTo>
                    <a:pt x="1446" y="32"/>
                  </a:lnTo>
                  <a:lnTo>
                    <a:pt x="1447" y="33"/>
                  </a:lnTo>
                  <a:lnTo>
                    <a:pt x="1448" y="32"/>
                  </a:lnTo>
                  <a:lnTo>
                    <a:pt x="1449" y="35"/>
                  </a:lnTo>
                  <a:lnTo>
                    <a:pt x="1450" y="28"/>
                  </a:lnTo>
                  <a:lnTo>
                    <a:pt x="1451" y="29"/>
                  </a:lnTo>
                  <a:lnTo>
                    <a:pt x="1451" y="26"/>
                  </a:lnTo>
                  <a:lnTo>
                    <a:pt x="1452" y="26"/>
                  </a:lnTo>
                  <a:lnTo>
                    <a:pt x="1453" y="26"/>
                  </a:lnTo>
                  <a:lnTo>
                    <a:pt x="1454" y="25"/>
                  </a:lnTo>
                  <a:lnTo>
                    <a:pt x="1455" y="26"/>
                  </a:lnTo>
                  <a:lnTo>
                    <a:pt x="1456" y="26"/>
                  </a:lnTo>
                  <a:lnTo>
                    <a:pt x="1457" y="19"/>
                  </a:lnTo>
                  <a:lnTo>
                    <a:pt x="1458" y="18"/>
                  </a:lnTo>
                  <a:lnTo>
                    <a:pt x="1458" y="21"/>
                  </a:lnTo>
                  <a:lnTo>
                    <a:pt x="1459" y="16"/>
                  </a:lnTo>
                  <a:lnTo>
                    <a:pt x="1460" y="17"/>
                  </a:lnTo>
                  <a:lnTo>
                    <a:pt x="1461" y="16"/>
                  </a:lnTo>
                  <a:lnTo>
                    <a:pt x="1462" y="15"/>
                  </a:lnTo>
                  <a:lnTo>
                    <a:pt x="1463" y="18"/>
                  </a:lnTo>
                  <a:lnTo>
                    <a:pt x="1464" y="12"/>
                  </a:lnTo>
                  <a:lnTo>
                    <a:pt x="1465" y="16"/>
                  </a:lnTo>
                  <a:lnTo>
                    <a:pt x="1466" y="14"/>
                  </a:lnTo>
                  <a:lnTo>
                    <a:pt x="1466" y="16"/>
                  </a:lnTo>
                  <a:lnTo>
                    <a:pt x="1467" y="15"/>
                  </a:lnTo>
                  <a:lnTo>
                    <a:pt x="1468" y="13"/>
                  </a:lnTo>
                  <a:lnTo>
                    <a:pt x="1469" y="18"/>
                  </a:lnTo>
                  <a:lnTo>
                    <a:pt x="1470" y="10"/>
                  </a:lnTo>
                  <a:lnTo>
                    <a:pt x="1471" y="13"/>
                  </a:lnTo>
                  <a:lnTo>
                    <a:pt x="1472" y="12"/>
                  </a:lnTo>
                  <a:lnTo>
                    <a:pt x="1473" y="10"/>
                  </a:lnTo>
                  <a:lnTo>
                    <a:pt x="1473" y="10"/>
                  </a:lnTo>
                  <a:lnTo>
                    <a:pt x="1474" y="15"/>
                  </a:lnTo>
                  <a:lnTo>
                    <a:pt x="1475" y="14"/>
                  </a:lnTo>
                  <a:lnTo>
                    <a:pt x="1476" y="16"/>
                  </a:lnTo>
                  <a:lnTo>
                    <a:pt x="1477" y="15"/>
                  </a:lnTo>
                  <a:lnTo>
                    <a:pt x="1478" y="16"/>
                  </a:lnTo>
                  <a:lnTo>
                    <a:pt x="1479" y="11"/>
                  </a:lnTo>
                  <a:lnTo>
                    <a:pt x="1480" y="8"/>
                  </a:lnTo>
                  <a:lnTo>
                    <a:pt x="1481" y="14"/>
                  </a:lnTo>
                  <a:lnTo>
                    <a:pt x="1481" y="11"/>
                  </a:lnTo>
                  <a:lnTo>
                    <a:pt x="1482" y="9"/>
                  </a:lnTo>
                  <a:lnTo>
                    <a:pt x="1483" y="12"/>
                  </a:lnTo>
                  <a:lnTo>
                    <a:pt x="1484" y="12"/>
                  </a:lnTo>
                  <a:lnTo>
                    <a:pt x="1485" y="12"/>
                  </a:lnTo>
                  <a:lnTo>
                    <a:pt x="1486" y="9"/>
                  </a:lnTo>
                  <a:lnTo>
                    <a:pt x="1487" y="12"/>
                  </a:lnTo>
                  <a:lnTo>
                    <a:pt x="1488" y="10"/>
                  </a:lnTo>
                  <a:lnTo>
                    <a:pt x="1488" y="12"/>
                  </a:lnTo>
                  <a:lnTo>
                    <a:pt x="1489" y="9"/>
                  </a:lnTo>
                  <a:lnTo>
                    <a:pt x="1490" y="11"/>
                  </a:lnTo>
                  <a:lnTo>
                    <a:pt x="1491" y="12"/>
                  </a:lnTo>
                  <a:lnTo>
                    <a:pt x="1492" y="13"/>
                  </a:lnTo>
                  <a:lnTo>
                    <a:pt x="1493" y="8"/>
                  </a:lnTo>
                  <a:lnTo>
                    <a:pt x="1494" y="12"/>
                  </a:lnTo>
                  <a:lnTo>
                    <a:pt x="1495" y="12"/>
                  </a:lnTo>
                  <a:lnTo>
                    <a:pt x="1496" y="9"/>
                  </a:lnTo>
                  <a:lnTo>
                    <a:pt x="1496" y="12"/>
                  </a:lnTo>
                  <a:lnTo>
                    <a:pt x="1497" y="10"/>
                  </a:lnTo>
                  <a:lnTo>
                    <a:pt x="1498" y="12"/>
                  </a:lnTo>
                  <a:lnTo>
                    <a:pt x="1499" y="15"/>
                  </a:lnTo>
                  <a:lnTo>
                    <a:pt x="1500" y="15"/>
                  </a:lnTo>
                  <a:lnTo>
                    <a:pt x="1501" y="19"/>
                  </a:lnTo>
                  <a:lnTo>
                    <a:pt x="1502" y="17"/>
                  </a:lnTo>
                  <a:lnTo>
                    <a:pt x="1503" y="21"/>
                  </a:lnTo>
                  <a:lnTo>
                    <a:pt x="1503" y="25"/>
                  </a:lnTo>
                  <a:lnTo>
                    <a:pt x="1504" y="27"/>
                  </a:lnTo>
                  <a:lnTo>
                    <a:pt x="1505" y="29"/>
                  </a:lnTo>
                  <a:lnTo>
                    <a:pt x="1506" y="33"/>
                  </a:lnTo>
                  <a:lnTo>
                    <a:pt x="1507" y="38"/>
                  </a:lnTo>
                  <a:lnTo>
                    <a:pt x="1508" y="38"/>
                  </a:lnTo>
                  <a:lnTo>
                    <a:pt x="1509" y="33"/>
                  </a:lnTo>
                  <a:lnTo>
                    <a:pt x="1510" y="36"/>
                  </a:lnTo>
                  <a:lnTo>
                    <a:pt x="1511" y="42"/>
                  </a:lnTo>
                  <a:lnTo>
                    <a:pt x="1511" y="44"/>
                  </a:lnTo>
                  <a:lnTo>
                    <a:pt x="1512" y="32"/>
                  </a:lnTo>
                  <a:lnTo>
                    <a:pt x="1513" y="34"/>
                  </a:lnTo>
                  <a:lnTo>
                    <a:pt x="1514" y="31"/>
                  </a:lnTo>
                  <a:lnTo>
                    <a:pt x="1515" y="32"/>
                  </a:lnTo>
                  <a:lnTo>
                    <a:pt x="1516" y="23"/>
                  </a:lnTo>
                  <a:lnTo>
                    <a:pt x="1517" y="23"/>
                  </a:lnTo>
                  <a:lnTo>
                    <a:pt x="1518" y="24"/>
                  </a:lnTo>
                  <a:lnTo>
                    <a:pt x="1518" y="22"/>
                  </a:lnTo>
                  <a:lnTo>
                    <a:pt x="1519" y="19"/>
                  </a:lnTo>
                  <a:lnTo>
                    <a:pt x="1520" y="18"/>
                  </a:lnTo>
                  <a:lnTo>
                    <a:pt x="1521" y="19"/>
                  </a:lnTo>
                  <a:lnTo>
                    <a:pt x="1522" y="19"/>
                  </a:lnTo>
                  <a:lnTo>
                    <a:pt x="1523" y="20"/>
                  </a:lnTo>
                  <a:lnTo>
                    <a:pt x="1524" y="25"/>
                  </a:lnTo>
                  <a:lnTo>
                    <a:pt x="1525" y="19"/>
                  </a:lnTo>
                  <a:lnTo>
                    <a:pt x="1526" y="25"/>
                  </a:lnTo>
                  <a:lnTo>
                    <a:pt x="1526" y="24"/>
                  </a:lnTo>
                  <a:lnTo>
                    <a:pt x="1527" y="31"/>
                  </a:lnTo>
                  <a:lnTo>
                    <a:pt x="1528" y="35"/>
                  </a:lnTo>
                  <a:lnTo>
                    <a:pt x="1529" y="38"/>
                  </a:lnTo>
                  <a:lnTo>
                    <a:pt x="1530" y="45"/>
                  </a:lnTo>
                  <a:lnTo>
                    <a:pt x="1531" y="53"/>
                  </a:lnTo>
                  <a:lnTo>
                    <a:pt x="1532" y="48"/>
                  </a:lnTo>
                  <a:lnTo>
                    <a:pt x="1533" y="53"/>
                  </a:lnTo>
                  <a:lnTo>
                    <a:pt x="1533" y="63"/>
                  </a:lnTo>
                  <a:lnTo>
                    <a:pt x="1534" y="57"/>
                  </a:lnTo>
                  <a:lnTo>
                    <a:pt x="1535" y="58"/>
                  </a:lnTo>
                  <a:lnTo>
                    <a:pt x="1536" y="55"/>
                  </a:lnTo>
                  <a:lnTo>
                    <a:pt x="1537" y="52"/>
                  </a:lnTo>
                  <a:lnTo>
                    <a:pt x="1538" y="49"/>
                  </a:lnTo>
                  <a:lnTo>
                    <a:pt x="1539" y="44"/>
                  </a:lnTo>
                  <a:lnTo>
                    <a:pt x="1540" y="40"/>
                  </a:lnTo>
                  <a:lnTo>
                    <a:pt x="1541" y="32"/>
                  </a:lnTo>
                  <a:lnTo>
                    <a:pt x="1541" y="29"/>
                  </a:lnTo>
                  <a:lnTo>
                    <a:pt x="1542" y="30"/>
                  </a:lnTo>
                  <a:lnTo>
                    <a:pt x="1543" y="27"/>
                  </a:lnTo>
                  <a:lnTo>
                    <a:pt x="1544" y="26"/>
                  </a:lnTo>
                  <a:lnTo>
                    <a:pt x="1545" y="26"/>
                  </a:lnTo>
                  <a:lnTo>
                    <a:pt x="1546" y="23"/>
                  </a:lnTo>
                  <a:lnTo>
                    <a:pt x="1547" y="26"/>
                  </a:lnTo>
                  <a:lnTo>
                    <a:pt x="1548" y="23"/>
                  </a:lnTo>
                  <a:lnTo>
                    <a:pt x="1548" y="24"/>
                  </a:lnTo>
                  <a:lnTo>
                    <a:pt x="1549" y="20"/>
                  </a:lnTo>
                  <a:lnTo>
                    <a:pt x="1550" y="22"/>
                  </a:lnTo>
                  <a:lnTo>
                    <a:pt x="1551" y="19"/>
                  </a:lnTo>
                  <a:lnTo>
                    <a:pt x="1552" y="19"/>
                  </a:lnTo>
                  <a:lnTo>
                    <a:pt x="1553" y="19"/>
                  </a:lnTo>
                  <a:lnTo>
                    <a:pt x="1554" y="16"/>
                  </a:lnTo>
                  <a:lnTo>
                    <a:pt x="1555" y="19"/>
                  </a:lnTo>
                  <a:lnTo>
                    <a:pt x="1556" y="17"/>
                  </a:lnTo>
                  <a:lnTo>
                    <a:pt x="1556" y="17"/>
                  </a:lnTo>
                  <a:lnTo>
                    <a:pt x="1557" y="15"/>
                  </a:lnTo>
                  <a:lnTo>
                    <a:pt x="1558" y="19"/>
                  </a:lnTo>
                  <a:lnTo>
                    <a:pt x="1559" y="20"/>
                  </a:lnTo>
                  <a:lnTo>
                    <a:pt x="1560" y="16"/>
                  </a:lnTo>
                  <a:lnTo>
                    <a:pt x="1561" y="16"/>
                  </a:lnTo>
                  <a:lnTo>
                    <a:pt x="1562" y="14"/>
                  </a:lnTo>
                  <a:lnTo>
                    <a:pt x="1563" y="15"/>
                  </a:lnTo>
                  <a:lnTo>
                    <a:pt x="1563" y="12"/>
                  </a:lnTo>
                  <a:lnTo>
                    <a:pt x="1564" y="14"/>
                  </a:lnTo>
                  <a:lnTo>
                    <a:pt x="1565" y="10"/>
                  </a:lnTo>
                  <a:lnTo>
                    <a:pt x="1566" y="11"/>
                  </a:lnTo>
                  <a:lnTo>
                    <a:pt x="1567" y="12"/>
                  </a:lnTo>
                  <a:lnTo>
                    <a:pt x="1568" y="8"/>
                  </a:lnTo>
                  <a:lnTo>
                    <a:pt x="1569" y="11"/>
                  </a:lnTo>
                  <a:lnTo>
                    <a:pt x="1570" y="11"/>
                  </a:lnTo>
                  <a:lnTo>
                    <a:pt x="1571" y="12"/>
                  </a:lnTo>
                  <a:lnTo>
                    <a:pt x="1571" y="10"/>
                  </a:lnTo>
                  <a:lnTo>
                    <a:pt x="1572" y="9"/>
                  </a:lnTo>
                  <a:lnTo>
                    <a:pt x="1573" y="14"/>
                  </a:lnTo>
                  <a:lnTo>
                    <a:pt x="1574" y="9"/>
                  </a:lnTo>
                  <a:lnTo>
                    <a:pt x="1575" y="11"/>
                  </a:lnTo>
                  <a:lnTo>
                    <a:pt x="1576" y="10"/>
                  </a:lnTo>
                  <a:lnTo>
                    <a:pt x="1577" y="10"/>
                  </a:lnTo>
                  <a:lnTo>
                    <a:pt x="1578" y="7"/>
                  </a:lnTo>
                  <a:lnTo>
                    <a:pt x="1578" y="8"/>
                  </a:lnTo>
                  <a:lnTo>
                    <a:pt x="1579" y="8"/>
                  </a:lnTo>
                  <a:lnTo>
                    <a:pt x="1580" y="8"/>
                  </a:lnTo>
                  <a:lnTo>
                    <a:pt x="1581" y="13"/>
                  </a:lnTo>
                  <a:lnTo>
                    <a:pt x="1582" y="8"/>
                  </a:lnTo>
                  <a:lnTo>
                    <a:pt x="1583" y="9"/>
                  </a:lnTo>
                  <a:lnTo>
                    <a:pt x="1584" y="11"/>
                  </a:lnTo>
                  <a:lnTo>
                    <a:pt x="1585" y="10"/>
                  </a:lnTo>
                  <a:lnTo>
                    <a:pt x="1586" y="9"/>
                  </a:lnTo>
                  <a:lnTo>
                    <a:pt x="1586" y="8"/>
                  </a:lnTo>
                  <a:lnTo>
                    <a:pt x="1587" y="10"/>
                  </a:lnTo>
                  <a:lnTo>
                    <a:pt x="1588" y="9"/>
                  </a:lnTo>
                  <a:lnTo>
                    <a:pt x="1589" y="8"/>
                  </a:lnTo>
                  <a:lnTo>
                    <a:pt x="1590" y="8"/>
                  </a:lnTo>
                  <a:lnTo>
                    <a:pt x="1591" y="9"/>
                  </a:lnTo>
                  <a:lnTo>
                    <a:pt x="1592" y="8"/>
                  </a:lnTo>
                  <a:lnTo>
                    <a:pt x="1593" y="6"/>
                  </a:lnTo>
                  <a:lnTo>
                    <a:pt x="1593" y="7"/>
                  </a:lnTo>
                  <a:lnTo>
                    <a:pt x="1594" y="11"/>
                  </a:lnTo>
                  <a:lnTo>
                    <a:pt x="1595" y="9"/>
                  </a:lnTo>
                  <a:lnTo>
                    <a:pt x="1596" y="7"/>
                  </a:lnTo>
                  <a:lnTo>
                    <a:pt x="1597" y="8"/>
                  </a:lnTo>
                  <a:lnTo>
                    <a:pt x="1598" y="8"/>
                  </a:lnTo>
                  <a:lnTo>
                    <a:pt x="1599" y="9"/>
                  </a:lnTo>
                  <a:lnTo>
                    <a:pt x="1600" y="7"/>
                  </a:lnTo>
                  <a:lnTo>
                    <a:pt x="1601" y="7"/>
                  </a:lnTo>
                  <a:lnTo>
                    <a:pt x="1601" y="8"/>
                  </a:lnTo>
                  <a:lnTo>
                    <a:pt x="1602" y="8"/>
                  </a:lnTo>
                  <a:lnTo>
                    <a:pt x="1603" y="12"/>
                  </a:lnTo>
                  <a:lnTo>
                    <a:pt x="1604" y="6"/>
                  </a:lnTo>
                  <a:lnTo>
                    <a:pt x="1605" y="8"/>
                  </a:lnTo>
                  <a:lnTo>
                    <a:pt x="1606" y="7"/>
                  </a:lnTo>
                  <a:lnTo>
                    <a:pt x="1607" y="11"/>
                  </a:lnTo>
                  <a:lnTo>
                    <a:pt x="1608" y="5"/>
                  </a:lnTo>
                  <a:lnTo>
                    <a:pt x="1608" y="7"/>
                  </a:lnTo>
                  <a:lnTo>
                    <a:pt x="1609" y="5"/>
                  </a:lnTo>
                  <a:lnTo>
                    <a:pt x="1610" y="7"/>
                  </a:lnTo>
                  <a:lnTo>
                    <a:pt x="1611" y="10"/>
                  </a:lnTo>
                  <a:lnTo>
                    <a:pt x="1612" y="9"/>
                  </a:lnTo>
                  <a:lnTo>
                    <a:pt x="1613" y="4"/>
                  </a:lnTo>
                  <a:lnTo>
                    <a:pt x="1614" y="7"/>
                  </a:lnTo>
                  <a:lnTo>
                    <a:pt x="1615" y="8"/>
                  </a:lnTo>
                  <a:lnTo>
                    <a:pt x="1616" y="7"/>
                  </a:lnTo>
                  <a:lnTo>
                    <a:pt x="1616" y="7"/>
                  </a:lnTo>
                  <a:lnTo>
                    <a:pt x="1617" y="7"/>
                  </a:lnTo>
                  <a:lnTo>
                    <a:pt x="1618" y="7"/>
                  </a:lnTo>
                  <a:lnTo>
                    <a:pt x="1619" y="9"/>
                  </a:lnTo>
                  <a:lnTo>
                    <a:pt x="1620" y="10"/>
                  </a:lnTo>
                  <a:lnTo>
                    <a:pt x="1621" y="9"/>
                  </a:lnTo>
                  <a:lnTo>
                    <a:pt x="1622" y="8"/>
                  </a:lnTo>
                  <a:lnTo>
                    <a:pt x="1623" y="8"/>
                  </a:lnTo>
                  <a:lnTo>
                    <a:pt x="1623" y="9"/>
                  </a:lnTo>
                  <a:lnTo>
                    <a:pt x="1624" y="10"/>
                  </a:lnTo>
                  <a:lnTo>
                    <a:pt x="1625" y="15"/>
                  </a:lnTo>
                  <a:lnTo>
                    <a:pt x="1626" y="13"/>
                  </a:lnTo>
                  <a:lnTo>
                    <a:pt x="1627" y="12"/>
                  </a:lnTo>
                  <a:lnTo>
                    <a:pt x="1628" y="15"/>
                  </a:lnTo>
                  <a:lnTo>
                    <a:pt x="1629" y="18"/>
                  </a:lnTo>
                  <a:lnTo>
                    <a:pt x="1630" y="20"/>
                  </a:lnTo>
                  <a:lnTo>
                    <a:pt x="1631" y="25"/>
                  </a:lnTo>
                  <a:lnTo>
                    <a:pt x="1631" y="28"/>
                  </a:lnTo>
                  <a:lnTo>
                    <a:pt x="1632" y="27"/>
                  </a:lnTo>
                  <a:lnTo>
                    <a:pt x="1633" y="30"/>
                  </a:lnTo>
                  <a:lnTo>
                    <a:pt x="1634" y="33"/>
                  </a:lnTo>
                  <a:lnTo>
                    <a:pt x="1635" y="37"/>
                  </a:lnTo>
                  <a:lnTo>
                    <a:pt x="1636" y="41"/>
                  </a:lnTo>
                  <a:lnTo>
                    <a:pt x="1637" y="37"/>
                  </a:lnTo>
                  <a:lnTo>
                    <a:pt x="1638" y="37"/>
                  </a:lnTo>
                  <a:lnTo>
                    <a:pt x="1638" y="35"/>
                  </a:lnTo>
                  <a:lnTo>
                    <a:pt x="1639" y="28"/>
                  </a:lnTo>
                  <a:lnTo>
                    <a:pt x="1640" y="30"/>
                  </a:lnTo>
                  <a:lnTo>
                    <a:pt x="1641" y="24"/>
                  </a:lnTo>
                  <a:lnTo>
                    <a:pt x="1642" y="22"/>
                  </a:lnTo>
                  <a:lnTo>
                    <a:pt x="1643" y="25"/>
                  </a:lnTo>
                  <a:lnTo>
                    <a:pt x="1644" y="18"/>
                  </a:lnTo>
                  <a:lnTo>
                    <a:pt x="1645" y="19"/>
                  </a:lnTo>
                  <a:lnTo>
                    <a:pt x="1645" y="19"/>
                  </a:lnTo>
                  <a:lnTo>
                    <a:pt x="1646" y="20"/>
                  </a:lnTo>
                  <a:lnTo>
                    <a:pt x="1647" y="22"/>
                  </a:lnTo>
                  <a:lnTo>
                    <a:pt x="1648" y="20"/>
                  </a:lnTo>
                  <a:lnTo>
                    <a:pt x="1649" y="25"/>
                  </a:lnTo>
                  <a:lnTo>
                    <a:pt x="1650" y="32"/>
                  </a:lnTo>
                  <a:lnTo>
                    <a:pt x="1651" y="36"/>
                  </a:lnTo>
                  <a:lnTo>
                    <a:pt x="1652" y="38"/>
                  </a:lnTo>
                  <a:lnTo>
                    <a:pt x="1653" y="44"/>
                  </a:lnTo>
                  <a:lnTo>
                    <a:pt x="1653" y="46"/>
                  </a:lnTo>
                  <a:lnTo>
                    <a:pt x="1654" y="44"/>
                  </a:lnTo>
                  <a:lnTo>
                    <a:pt x="1655" y="47"/>
                  </a:lnTo>
                  <a:lnTo>
                    <a:pt x="1656" y="48"/>
                  </a:lnTo>
                  <a:lnTo>
                    <a:pt x="1657" y="54"/>
                  </a:lnTo>
                  <a:lnTo>
                    <a:pt x="1658" y="50"/>
                  </a:lnTo>
                  <a:lnTo>
                    <a:pt x="1659" y="42"/>
                  </a:lnTo>
                  <a:lnTo>
                    <a:pt x="1660" y="41"/>
                  </a:lnTo>
                  <a:lnTo>
                    <a:pt x="1660" y="33"/>
                  </a:lnTo>
                  <a:lnTo>
                    <a:pt x="1661" y="34"/>
                  </a:lnTo>
                  <a:lnTo>
                    <a:pt x="1662" y="27"/>
                  </a:lnTo>
                  <a:lnTo>
                    <a:pt x="1663" y="20"/>
                  </a:lnTo>
                  <a:lnTo>
                    <a:pt x="1664" y="25"/>
                  </a:lnTo>
                  <a:lnTo>
                    <a:pt x="1665" y="15"/>
                  </a:lnTo>
                  <a:lnTo>
                    <a:pt x="1666" y="15"/>
                  </a:lnTo>
                  <a:lnTo>
                    <a:pt x="1667" y="17"/>
                  </a:lnTo>
                  <a:lnTo>
                    <a:pt x="1668" y="16"/>
                  </a:lnTo>
                  <a:lnTo>
                    <a:pt x="1668" y="15"/>
                  </a:lnTo>
                  <a:lnTo>
                    <a:pt x="1669" y="12"/>
                  </a:lnTo>
                  <a:lnTo>
                    <a:pt x="1670" y="15"/>
                  </a:lnTo>
                  <a:lnTo>
                    <a:pt x="1671" y="13"/>
                  </a:lnTo>
                  <a:lnTo>
                    <a:pt x="1672" y="14"/>
                  </a:lnTo>
                  <a:lnTo>
                    <a:pt x="1673" y="11"/>
                  </a:lnTo>
                  <a:lnTo>
                    <a:pt x="1674" y="12"/>
                  </a:lnTo>
                  <a:lnTo>
                    <a:pt x="1675" y="13"/>
                  </a:lnTo>
                  <a:lnTo>
                    <a:pt x="1675" y="12"/>
                  </a:lnTo>
                  <a:lnTo>
                    <a:pt x="1676" y="13"/>
                  </a:lnTo>
                  <a:lnTo>
                    <a:pt x="1677" y="12"/>
                  </a:lnTo>
                  <a:lnTo>
                    <a:pt x="1678" y="10"/>
                  </a:lnTo>
                  <a:lnTo>
                    <a:pt x="1679" y="11"/>
                  </a:lnTo>
                  <a:lnTo>
                    <a:pt x="1680" y="11"/>
                  </a:lnTo>
                  <a:lnTo>
                    <a:pt x="1681" y="11"/>
                  </a:lnTo>
                  <a:lnTo>
                    <a:pt x="1682" y="7"/>
                  </a:lnTo>
                  <a:lnTo>
                    <a:pt x="1683" y="16"/>
                  </a:lnTo>
                  <a:lnTo>
                    <a:pt x="1683" y="13"/>
                  </a:lnTo>
                  <a:lnTo>
                    <a:pt x="1684" y="13"/>
                  </a:lnTo>
                  <a:lnTo>
                    <a:pt x="1685" y="12"/>
                  </a:lnTo>
                  <a:lnTo>
                    <a:pt x="1686" y="16"/>
                  </a:lnTo>
                  <a:lnTo>
                    <a:pt x="1687" y="11"/>
                  </a:lnTo>
                  <a:lnTo>
                    <a:pt x="1688" y="10"/>
                  </a:lnTo>
                  <a:lnTo>
                    <a:pt x="1689" y="9"/>
                  </a:lnTo>
                  <a:lnTo>
                    <a:pt x="1690" y="13"/>
                  </a:lnTo>
                  <a:lnTo>
                    <a:pt x="1690" y="9"/>
                  </a:lnTo>
                  <a:lnTo>
                    <a:pt x="1691" y="13"/>
                  </a:lnTo>
                  <a:lnTo>
                    <a:pt x="1692" y="8"/>
                  </a:lnTo>
                  <a:lnTo>
                    <a:pt x="1693" y="13"/>
                  </a:lnTo>
                  <a:lnTo>
                    <a:pt x="1694" y="13"/>
                  </a:lnTo>
                  <a:lnTo>
                    <a:pt x="1695" y="10"/>
                  </a:lnTo>
                  <a:lnTo>
                    <a:pt x="1696" y="12"/>
                  </a:lnTo>
                  <a:lnTo>
                    <a:pt x="1697" y="13"/>
                  </a:lnTo>
                  <a:lnTo>
                    <a:pt x="1698" y="11"/>
                  </a:lnTo>
                  <a:lnTo>
                    <a:pt x="1698" y="17"/>
                  </a:lnTo>
                  <a:lnTo>
                    <a:pt x="1699" y="17"/>
                  </a:lnTo>
                  <a:lnTo>
                    <a:pt x="1700" y="18"/>
                  </a:lnTo>
                  <a:lnTo>
                    <a:pt x="1701" y="21"/>
                  </a:lnTo>
                  <a:lnTo>
                    <a:pt x="1702" y="18"/>
                  </a:lnTo>
                  <a:lnTo>
                    <a:pt x="1703" y="28"/>
                  </a:lnTo>
                  <a:lnTo>
                    <a:pt x="1704" y="25"/>
                  </a:lnTo>
                  <a:lnTo>
                    <a:pt x="1705" y="34"/>
                  </a:lnTo>
                  <a:lnTo>
                    <a:pt x="1705" y="32"/>
                  </a:lnTo>
                  <a:lnTo>
                    <a:pt x="1706" y="35"/>
                  </a:lnTo>
                  <a:lnTo>
                    <a:pt x="1707" y="38"/>
                  </a:lnTo>
                  <a:lnTo>
                    <a:pt x="1708" y="43"/>
                  </a:lnTo>
                  <a:lnTo>
                    <a:pt x="1709" y="47"/>
                  </a:lnTo>
                  <a:lnTo>
                    <a:pt x="1710" y="47"/>
                  </a:lnTo>
                  <a:lnTo>
                    <a:pt x="1711" y="48"/>
                  </a:lnTo>
                  <a:lnTo>
                    <a:pt x="1712" y="55"/>
                  </a:lnTo>
                  <a:lnTo>
                    <a:pt x="1713" y="53"/>
                  </a:lnTo>
                  <a:lnTo>
                    <a:pt x="1713" y="53"/>
                  </a:lnTo>
                  <a:lnTo>
                    <a:pt x="1714" y="51"/>
                  </a:lnTo>
                  <a:lnTo>
                    <a:pt x="1715" y="50"/>
                  </a:lnTo>
                  <a:lnTo>
                    <a:pt x="1716" y="48"/>
                  </a:lnTo>
                  <a:lnTo>
                    <a:pt x="1717" y="46"/>
                  </a:lnTo>
                  <a:lnTo>
                    <a:pt x="1718" y="43"/>
                  </a:lnTo>
                  <a:lnTo>
                    <a:pt x="1719" y="48"/>
                  </a:lnTo>
                  <a:lnTo>
                    <a:pt x="1720" y="47"/>
                  </a:lnTo>
                  <a:lnTo>
                    <a:pt x="1720" y="38"/>
                  </a:lnTo>
                  <a:lnTo>
                    <a:pt x="1721" y="42"/>
                  </a:lnTo>
                  <a:lnTo>
                    <a:pt x="1722" y="42"/>
                  </a:lnTo>
                  <a:lnTo>
                    <a:pt x="1723" y="39"/>
                  </a:lnTo>
                  <a:lnTo>
                    <a:pt x="1724" y="41"/>
                  </a:lnTo>
                  <a:lnTo>
                    <a:pt x="1725" y="42"/>
                  </a:lnTo>
                  <a:lnTo>
                    <a:pt x="1726" y="37"/>
                  </a:lnTo>
                  <a:lnTo>
                    <a:pt x="1727" y="42"/>
                  </a:lnTo>
                  <a:lnTo>
                    <a:pt x="1728" y="34"/>
                  </a:lnTo>
                  <a:lnTo>
                    <a:pt x="1728" y="35"/>
                  </a:lnTo>
                  <a:lnTo>
                    <a:pt x="1729" y="31"/>
                  </a:lnTo>
                  <a:lnTo>
                    <a:pt x="1730" y="31"/>
                  </a:lnTo>
                  <a:lnTo>
                    <a:pt x="1731" y="31"/>
                  </a:lnTo>
                  <a:lnTo>
                    <a:pt x="1732" y="32"/>
                  </a:lnTo>
                  <a:lnTo>
                    <a:pt x="1733" y="28"/>
                  </a:lnTo>
                  <a:lnTo>
                    <a:pt x="1734" y="29"/>
                  </a:lnTo>
                  <a:lnTo>
                    <a:pt x="1735" y="23"/>
                  </a:lnTo>
                  <a:lnTo>
                    <a:pt x="1735" y="28"/>
                  </a:lnTo>
                  <a:lnTo>
                    <a:pt x="1736" y="27"/>
                  </a:lnTo>
                  <a:lnTo>
                    <a:pt x="1737" y="27"/>
                  </a:lnTo>
                  <a:lnTo>
                    <a:pt x="1738" y="27"/>
                  </a:lnTo>
                  <a:lnTo>
                    <a:pt x="1739" y="24"/>
                  </a:lnTo>
                  <a:lnTo>
                    <a:pt x="1740" y="26"/>
                  </a:lnTo>
                  <a:lnTo>
                    <a:pt x="1741" y="23"/>
                  </a:lnTo>
                  <a:lnTo>
                    <a:pt x="1742" y="26"/>
                  </a:lnTo>
                  <a:lnTo>
                    <a:pt x="1743" y="23"/>
                  </a:lnTo>
                  <a:lnTo>
                    <a:pt x="1743" y="23"/>
                  </a:lnTo>
                  <a:lnTo>
                    <a:pt x="1744" y="27"/>
                  </a:lnTo>
                  <a:lnTo>
                    <a:pt x="1745" y="25"/>
                  </a:lnTo>
                  <a:lnTo>
                    <a:pt x="1746" y="21"/>
                  </a:lnTo>
                  <a:lnTo>
                    <a:pt x="1747" y="28"/>
                  </a:lnTo>
                  <a:lnTo>
                    <a:pt x="1748" y="21"/>
                  </a:lnTo>
                  <a:lnTo>
                    <a:pt x="1749" y="23"/>
                  </a:lnTo>
                  <a:lnTo>
                    <a:pt x="1750" y="26"/>
                  </a:lnTo>
                  <a:lnTo>
                    <a:pt x="1750" y="21"/>
                  </a:lnTo>
                  <a:lnTo>
                    <a:pt x="1751" y="18"/>
                  </a:lnTo>
                  <a:lnTo>
                    <a:pt x="1752" y="22"/>
                  </a:lnTo>
                  <a:lnTo>
                    <a:pt x="1753" y="23"/>
                  </a:lnTo>
                  <a:lnTo>
                    <a:pt x="1754" y="19"/>
                  </a:lnTo>
                  <a:lnTo>
                    <a:pt x="1755" y="20"/>
                  </a:lnTo>
                  <a:lnTo>
                    <a:pt x="1756" y="21"/>
                  </a:lnTo>
                  <a:lnTo>
                    <a:pt x="1757" y="24"/>
                  </a:lnTo>
                  <a:lnTo>
                    <a:pt x="1758" y="22"/>
                  </a:lnTo>
                  <a:lnTo>
                    <a:pt x="1758" y="20"/>
                  </a:lnTo>
                  <a:lnTo>
                    <a:pt x="1759" y="20"/>
                  </a:lnTo>
                  <a:lnTo>
                    <a:pt x="1760" y="22"/>
                  </a:lnTo>
                  <a:lnTo>
                    <a:pt x="1761" y="22"/>
                  </a:lnTo>
                  <a:lnTo>
                    <a:pt x="1762" y="21"/>
                  </a:lnTo>
                  <a:lnTo>
                    <a:pt x="1763" y="20"/>
                  </a:lnTo>
                  <a:lnTo>
                    <a:pt x="1764" y="22"/>
                  </a:lnTo>
                  <a:lnTo>
                    <a:pt x="1765" y="24"/>
                  </a:lnTo>
                  <a:lnTo>
                    <a:pt x="1765" y="22"/>
                  </a:lnTo>
                  <a:lnTo>
                    <a:pt x="1766" y="26"/>
                  </a:lnTo>
                  <a:lnTo>
                    <a:pt x="1767" y="22"/>
                  </a:lnTo>
                  <a:lnTo>
                    <a:pt x="1768" y="25"/>
                  </a:lnTo>
                  <a:lnTo>
                    <a:pt x="1769" y="23"/>
                  </a:lnTo>
                  <a:lnTo>
                    <a:pt x="1770" y="29"/>
                  </a:lnTo>
                  <a:lnTo>
                    <a:pt x="1771" y="28"/>
                  </a:lnTo>
                  <a:lnTo>
                    <a:pt x="1772" y="25"/>
                  </a:lnTo>
                  <a:lnTo>
                    <a:pt x="1773" y="35"/>
                  </a:lnTo>
                  <a:lnTo>
                    <a:pt x="1773" y="37"/>
                  </a:lnTo>
                  <a:lnTo>
                    <a:pt x="1774" y="39"/>
                  </a:lnTo>
                  <a:lnTo>
                    <a:pt x="1775" y="54"/>
                  </a:lnTo>
                  <a:lnTo>
                    <a:pt x="1776" y="70"/>
                  </a:lnTo>
                  <a:lnTo>
                    <a:pt x="1777" y="89"/>
                  </a:lnTo>
                  <a:lnTo>
                    <a:pt x="1778" y="133"/>
                  </a:lnTo>
                  <a:lnTo>
                    <a:pt x="1779" y="168"/>
                  </a:lnTo>
                  <a:lnTo>
                    <a:pt x="1780" y="213"/>
                  </a:lnTo>
                  <a:lnTo>
                    <a:pt x="1780" y="268"/>
                  </a:lnTo>
                  <a:lnTo>
                    <a:pt x="1781" y="347"/>
                  </a:lnTo>
                  <a:lnTo>
                    <a:pt x="1782" y="438"/>
                  </a:lnTo>
                  <a:lnTo>
                    <a:pt x="1783" y="547"/>
                  </a:lnTo>
                  <a:lnTo>
                    <a:pt x="1784" y="663"/>
                  </a:lnTo>
                  <a:lnTo>
                    <a:pt x="1785" y="804"/>
                  </a:lnTo>
                  <a:lnTo>
                    <a:pt x="1786" y="922"/>
                  </a:lnTo>
                  <a:lnTo>
                    <a:pt x="1787" y="1095"/>
                  </a:lnTo>
                  <a:lnTo>
                    <a:pt x="1788" y="1273"/>
                  </a:lnTo>
                  <a:lnTo>
                    <a:pt x="1788" y="1471"/>
                  </a:lnTo>
                  <a:lnTo>
                    <a:pt x="1789" y="1586"/>
                  </a:lnTo>
                  <a:lnTo>
                    <a:pt x="1790" y="1723"/>
                  </a:lnTo>
                  <a:lnTo>
                    <a:pt x="1791" y="1892"/>
                  </a:lnTo>
                  <a:lnTo>
                    <a:pt x="1792" y="2089"/>
                  </a:lnTo>
                  <a:lnTo>
                    <a:pt x="1793" y="2313"/>
                  </a:lnTo>
                  <a:lnTo>
                    <a:pt x="1794" y="2525"/>
                  </a:lnTo>
                  <a:lnTo>
                    <a:pt x="1795" y="2760"/>
                  </a:lnTo>
                  <a:lnTo>
                    <a:pt x="1795" y="3016"/>
                  </a:lnTo>
                  <a:lnTo>
                    <a:pt x="1796" y="3263"/>
                  </a:lnTo>
                  <a:lnTo>
                    <a:pt x="1797" y="3435"/>
                  </a:lnTo>
                  <a:lnTo>
                    <a:pt x="1798" y="3736"/>
                  </a:lnTo>
                  <a:lnTo>
                    <a:pt x="1799" y="3914"/>
                  </a:lnTo>
                  <a:lnTo>
                    <a:pt x="1800" y="4152"/>
                  </a:lnTo>
                  <a:lnTo>
                    <a:pt x="1801" y="4353"/>
                  </a:lnTo>
                  <a:lnTo>
                    <a:pt x="1802" y="4511"/>
                  </a:lnTo>
                  <a:lnTo>
                    <a:pt x="1803" y="4496"/>
                  </a:lnTo>
                  <a:lnTo>
                    <a:pt x="1803" y="4139"/>
                  </a:lnTo>
                  <a:lnTo>
                    <a:pt x="1804" y="3352"/>
                  </a:lnTo>
                  <a:lnTo>
                    <a:pt x="1805" y="2415"/>
                  </a:lnTo>
                  <a:lnTo>
                    <a:pt x="1806" y="1701"/>
                  </a:lnTo>
                  <a:lnTo>
                    <a:pt x="1807" y="1215"/>
                  </a:lnTo>
                  <a:lnTo>
                    <a:pt x="1808" y="924"/>
                  </a:lnTo>
                  <a:lnTo>
                    <a:pt x="1809" y="782"/>
                  </a:lnTo>
                  <a:lnTo>
                    <a:pt x="1810" y="667"/>
                  </a:lnTo>
                  <a:lnTo>
                    <a:pt x="1810" y="593"/>
                  </a:lnTo>
                  <a:lnTo>
                    <a:pt x="1811" y="550"/>
                  </a:lnTo>
                  <a:lnTo>
                    <a:pt x="1812" y="505"/>
                  </a:lnTo>
                  <a:lnTo>
                    <a:pt x="1813" y="485"/>
                  </a:lnTo>
                  <a:lnTo>
                    <a:pt x="1814" y="446"/>
                  </a:lnTo>
                  <a:lnTo>
                    <a:pt x="1815" y="431"/>
                  </a:lnTo>
                  <a:lnTo>
                    <a:pt x="1816" y="419"/>
                  </a:lnTo>
                  <a:lnTo>
                    <a:pt x="1817" y="393"/>
                  </a:lnTo>
                  <a:lnTo>
                    <a:pt x="1818" y="381"/>
                  </a:lnTo>
                  <a:lnTo>
                    <a:pt x="1818" y="354"/>
                  </a:lnTo>
                  <a:lnTo>
                    <a:pt x="1819" y="337"/>
                  </a:lnTo>
                  <a:lnTo>
                    <a:pt x="1820" y="314"/>
                  </a:lnTo>
                  <a:lnTo>
                    <a:pt x="1821" y="301"/>
                  </a:lnTo>
                  <a:lnTo>
                    <a:pt x="1822" y="290"/>
                  </a:lnTo>
                  <a:lnTo>
                    <a:pt x="1823" y="263"/>
                  </a:lnTo>
                  <a:lnTo>
                    <a:pt x="1824" y="258"/>
                  </a:lnTo>
                  <a:lnTo>
                    <a:pt x="1825" y="253"/>
                  </a:lnTo>
                  <a:lnTo>
                    <a:pt x="1825" y="238"/>
                  </a:lnTo>
                  <a:lnTo>
                    <a:pt x="1826" y="234"/>
                  </a:lnTo>
                  <a:lnTo>
                    <a:pt x="1827" y="227"/>
                  </a:lnTo>
                  <a:lnTo>
                    <a:pt x="1828" y="221"/>
                  </a:lnTo>
                  <a:lnTo>
                    <a:pt x="1829" y="209"/>
                  </a:lnTo>
                  <a:lnTo>
                    <a:pt x="1830" y="203"/>
                  </a:lnTo>
                  <a:lnTo>
                    <a:pt x="1831" y="203"/>
                  </a:lnTo>
                  <a:lnTo>
                    <a:pt x="1832" y="195"/>
                  </a:lnTo>
                  <a:lnTo>
                    <a:pt x="1833" y="180"/>
                  </a:lnTo>
                  <a:lnTo>
                    <a:pt x="1833" y="179"/>
                  </a:lnTo>
                  <a:lnTo>
                    <a:pt x="1834" y="180"/>
                  </a:lnTo>
                  <a:lnTo>
                    <a:pt x="1835" y="173"/>
                  </a:lnTo>
                  <a:lnTo>
                    <a:pt x="1836" y="171"/>
                  </a:lnTo>
                  <a:lnTo>
                    <a:pt x="1837" y="163"/>
                  </a:lnTo>
                  <a:lnTo>
                    <a:pt x="1838" y="169"/>
                  </a:lnTo>
                  <a:lnTo>
                    <a:pt x="1839" y="160"/>
                  </a:lnTo>
                  <a:lnTo>
                    <a:pt x="1840" y="160"/>
                  </a:lnTo>
                  <a:lnTo>
                    <a:pt x="1840" y="158"/>
                  </a:lnTo>
                  <a:lnTo>
                    <a:pt x="1841" y="153"/>
                  </a:lnTo>
                  <a:lnTo>
                    <a:pt x="1842" y="149"/>
                  </a:lnTo>
                  <a:lnTo>
                    <a:pt x="1843" y="143"/>
                  </a:lnTo>
                  <a:lnTo>
                    <a:pt x="1844" y="145"/>
                  </a:lnTo>
                  <a:lnTo>
                    <a:pt x="1845" y="141"/>
                  </a:lnTo>
                  <a:lnTo>
                    <a:pt x="1846" y="143"/>
                  </a:lnTo>
                  <a:lnTo>
                    <a:pt x="1847" y="140"/>
                  </a:lnTo>
                  <a:lnTo>
                    <a:pt x="1847" y="129"/>
                  </a:lnTo>
                  <a:lnTo>
                    <a:pt x="1848" y="135"/>
                  </a:lnTo>
                  <a:lnTo>
                    <a:pt x="1849" y="127"/>
                  </a:lnTo>
                  <a:lnTo>
                    <a:pt x="1850" y="121"/>
                  </a:lnTo>
                  <a:lnTo>
                    <a:pt x="1851" y="124"/>
                  </a:lnTo>
                  <a:lnTo>
                    <a:pt x="1852" y="118"/>
                  </a:lnTo>
                  <a:lnTo>
                    <a:pt x="1853" y="115"/>
                  </a:lnTo>
                  <a:lnTo>
                    <a:pt x="1854" y="114"/>
                  </a:lnTo>
                  <a:lnTo>
                    <a:pt x="1855" y="109"/>
                  </a:lnTo>
                  <a:lnTo>
                    <a:pt x="1855" y="114"/>
                  </a:lnTo>
                  <a:lnTo>
                    <a:pt x="1856" y="106"/>
                  </a:lnTo>
                  <a:lnTo>
                    <a:pt x="1857" y="104"/>
                  </a:lnTo>
                  <a:lnTo>
                    <a:pt x="1858" y="108"/>
                  </a:lnTo>
                  <a:lnTo>
                    <a:pt x="1859" y="107"/>
                  </a:lnTo>
                  <a:lnTo>
                    <a:pt x="1860" y="110"/>
                  </a:lnTo>
                  <a:lnTo>
                    <a:pt x="1861" y="106"/>
                  </a:lnTo>
                  <a:lnTo>
                    <a:pt x="1862" y="107"/>
                  </a:lnTo>
                  <a:lnTo>
                    <a:pt x="1862" y="100"/>
                  </a:lnTo>
                  <a:lnTo>
                    <a:pt x="1863" y="99"/>
                  </a:lnTo>
                  <a:lnTo>
                    <a:pt x="1864" y="98"/>
                  </a:lnTo>
                  <a:lnTo>
                    <a:pt x="1865" y="92"/>
                  </a:lnTo>
                  <a:lnTo>
                    <a:pt x="1866" y="101"/>
                  </a:lnTo>
                  <a:lnTo>
                    <a:pt x="1867" y="91"/>
                  </a:lnTo>
                  <a:lnTo>
                    <a:pt x="1868" y="88"/>
                  </a:lnTo>
                  <a:lnTo>
                    <a:pt x="1869" y="96"/>
                  </a:lnTo>
                  <a:lnTo>
                    <a:pt x="1870" y="90"/>
                  </a:lnTo>
                  <a:lnTo>
                    <a:pt x="1870" y="90"/>
                  </a:lnTo>
                  <a:lnTo>
                    <a:pt x="1871" y="94"/>
                  </a:lnTo>
                  <a:lnTo>
                    <a:pt x="1872" y="92"/>
                  </a:lnTo>
                  <a:lnTo>
                    <a:pt x="1873" y="98"/>
                  </a:lnTo>
                  <a:lnTo>
                    <a:pt x="1874" y="98"/>
                  </a:lnTo>
                  <a:lnTo>
                    <a:pt x="1875" y="91"/>
                  </a:lnTo>
                  <a:lnTo>
                    <a:pt x="1876" y="92"/>
                  </a:lnTo>
                  <a:lnTo>
                    <a:pt x="1877" y="93"/>
                  </a:lnTo>
                  <a:lnTo>
                    <a:pt x="1877" y="91"/>
                  </a:lnTo>
                  <a:lnTo>
                    <a:pt x="1878" y="93"/>
                  </a:lnTo>
                  <a:lnTo>
                    <a:pt x="1879" y="88"/>
                  </a:lnTo>
                  <a:lnTo>
                    <a:pt x="1880" y="91"/>
                  </a:lnTo>
                  <a:lnTo>
                    <a:pt x="1881" y="81"/>
                  </a:lnTo>
                  <a:lnTo>
                    <a:pt x="1882" y="82"/>
                  </a:lnTo>
                  <a:lnTo>
                    <a:pt x="1883" y="77"/>
                  </a:lnTo>
                  <a:lnTo>
                    <a:pt x="1884" y="80"/>
                  </a:lnTo>
                  <a:lnTo>
                    <a:pt x="1885" y="80"/>
                  </a:lnTo>
                  <a:lnTo>
                    <a:pt x="1885" y="72"/>
                  </a:lnTo>
                  <a:lnTo>
                    <a:pt x="1886" y="75"/>
                  </a:lnTo>
                  <a:lnTo>
                    <a:pt x="1887" y="64"/>
                  </a:lnTo>
                  <a:lnTo>
                    <a:pt x="1888" y="72"/>
                  </a:lnTo>
                  <a:lnTo>
                    <a:pt x="1889" y="73"/>
                  </a:lnTo>
                  <a:lnTo>
                    <a:pt x="1890" y="69"/>
                  </a:lnTo>
                  <a:lnTo>
                    <a:pt x="1891" y="74"/>
                  </a:lnTo>
                  <a:lnTo>
                    <a:pt x="1892" y="68"/>
                  </a:lnTo>
                  <a:lnTo>
                    <a:pt x="1892" y="73"/>
                  </a:lnTo>
                  <a:lnTo>
                    <a:pt x="1893" y="71"/>
                  </a:lnTo>
                  <a:lnTo>
                    <a:pt x="1894" y="71"/>
                  </a:lnTo>
                  <a:lnTo>
                    <a:pt x="1895" y="73"/>
                  </a:lnTo>
                  <a:lnTo>
                    <a:pt x="1896" y="67"/>
                  </a:lnTo>
                  <a:lnTo>
                    <a:pt x="1897" y="64"/>
                  </a:lnTo>
                  <a:lnTo>
                    <a:pt x="1898" y="65"/>
                  </a:lnTo>
                  <a:lnTo>
                    <a:pt x="1899" y="68"/>
                  </a:lnTo>
                  <a:lnTo>
                    <a:pt x="1900" y="67"/>
                  </a:lnTo>
                  <a:lnTo>
                    <a:pt x="1900" y="63"/>
                  </a:lnTo>
                  <a:lnTo>
                    <a:pt x="1901" y="65"/>
                  </a:lnTo>
                  <a:lnTo>
                    <a:pt x="1902" y="69"/>
                  </a:lnTo>
                  <a:lnTo>
                    <a:pt x="1903" y="61"/>
                  </a:lnTo>
                  <a:lnTo>
                    <a:pt x="1904" y="62"/>
                  </a:lnTo>
                  <a:lnTo>
                    <a:pt x="1905" y="62"/>
                  </a:lnTo>
                  <a:lnTo>
                    <a:pt x="1906" y="65"/>
                  </a:lnTo>
                  <a:lnTo>
                    <a:pt x="1907" y="68"/>
                  </a:lnTo>
                  <a:lnTo>
                    <a:pt x="1907" y="65"/>
                  </a:lnTo>
                  <a:lnTo>
                    <a:pt x="1908" y="69"/>
                  </a:lnTo>
                  <a:lnTo>
                    <a:pt x="1909" y="66"/>
                  </a:lnTo>
                  <a:lnTo>
                    <a:pt x="1910" y="64"/>
                  </a:lnTo>
                  <a:lnTo>
                    <a:pt x="1911" y="62"/>
                  </a:lnTo>
                  <a:lnTo>
                    <a:pt x="1912" y="66"/>
                  </a:lnTo>
                  <a:lnTo>
                    <a:pt x="1913" y="71"/>
                  </a:lnTo>
                  <a:lnTo>
                    <a:pt x="1914" y="68"/>
                  </a:lnTo>
                  <a:lnTo>
                    <a:pt x="1915" y="69"/>
                  </a:lnTo>
                  <a:lnTo>
                    <a:pt x="1915" y="69"/>
                  </a:lnTo>
                  <a:lnTo>
                    <a:pt x="1916" y="65"/>
                  </a:lnTo>
                  <a:lnTo>
                    <a:pt x="1917" y="63"/>
                  </a:lnTo>
                  <a:lnTo>
                    <a:pt x="1918" y="62"/>
                  </a:lnTo>
                  <a:lnTo>
                    <a:pt x="1919" y="63"/>
                  </a:lnTo>
                  <a:lnTo>
                    <a:pt x="1920" y="58"/>
                  </a:lnTo>
                  <a:lnTo>
                    <a:pt x="1921" y="58"/>
                  </a:lnTo>
                  <a:lnTo>
                    <a:pt x="1922" y="60"/>
                  </a:lnTo>
                  <a:lnTo>
                    <a:pt x="1922" y="52"/>
                  </a:lnTo>
                  <a:lnTo>
                    <a:pt x="1923" y="56"/>
                  </a:lnTo>
                  <a:lnTo>
                    <a:pt x="1924" y="55"/>
                  </a:lnTo>
                  <a:lnTo>
                    <a:pt x="1925" y="56"/>
                  </a:lnTo>
                  <a:lnTo>
                    <a:pt x="1926" y="56"/>
                  </a:lnTo>
                  <a:lnTo>
                    <a:pt x="1927" y="53"/>
                  </a:lnTo>
                  <a:lnTo>
                    <a:pt x="1928" y="55"/>
                  </a:lnTo>
                  <a:lnTo>
                    <a:pt x="1929" y="64"/>
                  </a:lnTo>
                  <a:lnTo>
                    <a:pt x="1930" y="70"/>
                  </a:lnTo>
                  <a:lnTo>
                    <a:pt x="1930" y="65"/>
                  </a:lnTo>
                  <a:lnTo>
                    <a:pt x="1931" y="68"/>
                  </a:lnTo>
                  <a:lnTo>
                    <a:pt x="1932" y="70"/>
                  </a:lnTo>
                  <a:lnTo>
                    <a:pt x="1933" y="71"/>
                  </a:lnTo>
                  <a:lnTo>
                    <a:pt x="1934" y="77"/>
                  </a:lnTo>
                  <a:lnTo>
                    <a:pt x="1935" y="84"/>
                  </a:lnTo>
                  <a:lnTo>
                    <a:pt x="1936" y="83"/>
                  </a:lnTo>
                  <a:lnTo>
                    <a:pt x="1937" y="85"/>
                  </a:lnTo>
                  <a:lnTo>
                    <a:pt x="1937" y="74"/>
                  </a:lnTo>
                  <a:lnTo>
                    <a:pt x="1938" y="86"/>
                  </a:lnTo>
                  <a:lnTo>
                    <a:pt x="1939" y="76"/>
                  </a:lnTo>
                  <a:lnTo>
                    <a:pt x="1940" y="73"/>
                  </a:lnTo>
                  <a:lnTo>
                    <a:pt x="1941" y="64"/>
                  </a:lnTo>
                  <a:lnTo>
                    <a:pt x="1942" y="64"/>
                  </a:lnTo>
                  <a:lnTo>
                    <a:pt x="1943" y="61"/>
                  </a:lnTo>
                  <a:lnTo>
                    <a:pt x="1944" y="53"/>
                  </a:lnTo>
                  <a:lnTo>
                    <a:pt x="1945" y="54"/>
                  </a:lnTo>
                  <a:lnTo>
                    <a:pt x="1945" y="56"/>
                  </a:lnTo>
                  <a:lnTo>
                    <a:pt x="1946" y="55"/>
                  </a:lnTo>
                  <a:lnTo>
                    <a:pt x="1947" y="50"/>
                  </a:lnTo>
                  <a:lnTo>
                    <a:pt x="1948" y="49"/>
                  </a:lnTo>
                  <a:lnTo>
                    <a:pt x="1949" y="52"/>
                  </a:lnTo>
                  <a:lnTo>
                    <a:pt x="1950" y="55"/>
                  </a:lnTo>
                  <a:lnTo>
                    <a:pt x="1951" y="51"/>
                  </a:lnTo>
                  <a:lnTo>
                    <a:pt x="1952" y="50"/>
                  </a:lnTo>
                  <a:lnTo>
                    <a:pt x="1952" y="51"/>
                  </a:lnTo>
                  <a:lnTo>
                    <a:pt x="1953" y="50"/>
                  </a:lnTo>
                  <a:lnTo>
                    <a:pt x="1954" y="52"/>
                  </a:lnTo>
                  <a:lnTo>
                    <a:pt x="1955" y="50"/>
                  </a:lnTo>
                  <a:lnTo>
                    <a:pt x="1956" y="50"/>
                  </a:lnTo>
                  <a:lnTo>
                    <a:pt x="1957" y="51"/>
                  </a:lnTo>
                  <a:lnTo>
                    <a:pt x="1958" y="55"/>
                  </a:lnTo>
                  <a:lnTo>
                    <a:pt x="1959" y="52"/>
                  </a:lnTo>
                  <a:lnTo>
                    <a:pt x="1960" y="55"/>
                  </a:lnTo>
                  <a:lnTo>
                    <a:pt x="1960" y="53"/>
                  </a:lnTo>
                  <a:lnTo>
                    <a:pt x="1961" y="53"/>
                  </a:lnTo>
                  <a:lnTo>
                    <a:pt x="1962" y="53"/>
                  </a:lnTo>
                  <a:lnTo>
                    <a:pt x="1963" y="47"/>
                  </a:lnTo>
                  <a:lnTo>
                    <a:pt x="1964" y="51"/>
                  </a:lnTo>
                  <a:lnTo>
                    <a:pt x="1965" y="42"/>
                  </a:lnTo>
                  <a:lnTo>
                    <a:pt x="1966" y="51"/>
                  </a:lnTo>
                  <a:lnTo>
                    <a:pt x="1967" y="44"/>
                  </a:lnTo>
                  <a:lnTo>
                    <a:pt x="1967" y="44"/>
                  </a:lnTo>
                  <a:lnTo>
                    <a:pt x="1968" y="43"/>
                  </a:lnTo>
                  <a:lnTo>
                    <a:pt x="1969" y="43"/>
                  </a:lnTo>
                  <a:lnTo>
                    <a:pt x="1970" y="44"/>
                  </a:lnTo>
                  <a:lnTo>
                    <a:pt x="1971" y="42"/>
                  </a:lnTo>
                  <a:lnTo>
                    <a:pt x="1972" y="42"/>
                  </a:lnTo>
                  <a:lnTo>
                    <a:pt x="1973" y="41"/>
                  </a:lnTo>
                  <a:lnTo>
                    <a:pt x="1974" y="43"/>
                  </a:lnTo>
                  <a:lnTo>
                    <a:pt x="1975" y="46"/>
                  </a:lnTo>
                  <a:lnTo>
                    <a:pt x="1975" y="47"/>
                  </a:lnTo>
                  <a:lnTo>
                    <a:pt x="1976" y="42"/>
                  </a:lnTo>
                  <a:lnTo>
                    <a:pt x="1977" y="40"/>
                  </a:lnTo>
                  <a:lnTo>
                    <a:pt x="1978" y="41"/>
                  </a:lnTo>
                  <a:lnTo>
                    <a:pt x="1979" y="40"/>
                  </a:lnTo>
                  <a:lnTo>
                    <a:pt x="1980" y="43"/>
                  </a:lnTo>
                  <a:lnTo>
                    <a:pt x="1981" y="42"/>
                  </a:lnTo>
                  <a:lnTo>
                    <a:pt x="1982" y="42"/>
                  </a:lnTo>
                  <a:lnTo>
                    <a:pt x="1982" y="48"/>
                  </a:lnTo>
                  <a:lnTo>
                    <a:pt x="1983" y="45"/>
                  </a:lnTo>
                  <a:lnTo>
                    <a:pt x="1984" y="46"/>
                  </a:lnTo>
                  <a:lnTo>
                    <a:pt x="1985" y="49"/>
                  </a:lnTo>
                  <a:lnTo>
                    <a:pt x="1986" y="42"/>
                  </a:lnTo>
                  <a:lnTo>
                    <a:pt x="1987" y="43"/>
                  </a:lnTo>
                  <a:lnTo>
                    <a:pt x="1988" y="49"/>
                  </a:lnTo>
                  <a:lnTo>
                    <a:pt x="1989" y="46"/>
                  </a:lnTo>
                  <a:lnTo>
                    <a:pt x="1990" y="47"/>
                  </a:lnTo>
                  <a:lnTo>
                    <a:pt x="1990" y="54"/>
                  </a:lnTo>
                  <a:lnTo>
                    <a:pt x="1991" y="44"/>
                  </a:lnTo>
                  <a:lnTo>
                    <a:pt x="1992" y="48"/>
                  </a:lnTo>
                  <a:lnTo>
                    <a:pt x="1993" y="49"/>
                  </a:lnTo>
                  <a:lnTo>
                    <a:pt x="1994" y="43"/>
                  </a:lnTo>
                  <a:lnTo>
                    <a:pt x="1995" y="44"/>
                  </a:lnTo>
                  <a:lnTo>
                    <a:pt x="1996" y="43"/>
                  </a:lnTo>
                  <a:lnTo>
                    <a:pt x="1997" y="44"/>
                  </a:lnTo>
                  <a:lnTo>
                    <a:pt x="1997" y="47"/>
                  </a:lnTo>
                  <a:lnTo>
                    <a:pt x="1998" y="41"/>
                  </a:lnTo>
                  <a:lnTo>
                    <a:pt x="1999" y="44"/>
                  </a:lnTo>
                  <a:lnTo>
                    <a:pt x="2000" y="48"/>
                  </a:lnTo>
                  <a:lnTo>
                    <a:pt x="2001" y="40"/>
                  </a:lnTo>
                  <a:lnTo>
                    <a:pt x="2002" y="45"/>
                  </a:lnTo>
                  <a:lnTo>
                    <a:pt x="2003" y="35"/>
                  </a:lnTo>
                  <a:lnTo>
                    <a:pt x="2004" y="39"/>
                  </a:lnTo>
                  <a:lnTo>
                    <a:pt x="2005" y="35"/>
                  </a:lnTo>
                  <a:lnTo>
                    <a:pt x="2005" y="35"/>
                  </a:lnTo>
                  <a:lnTo>
                    <a:pt x="2006" y="37"/>
                  </a:lnTo>
                  <a:lnTo>
                    <a:pt x="2007" y="36"/>
                  </a:lnTo>
                  <a:lnTo>
                    <a:pt x="2008" y="32"/>
                  </a:lnTo>
                  <a:lnTo>
                    <a:pt x="2009" y="38"/>
                  </a:lnTo>
                  <a:lnTo>
                    <a:pt x="2010" y="34"/>
                  </a:lnTo>
                  <a:lnTo>
                    <a:pt x="2011" y="39"/>
                  </a:lnTo>
                  <a:lnTo>
                    <a:pt x="2012" y="40"/>
                  </a:lnTo>
                  <a:lnTo>
                    <a:pt x="2012" y="36"/>
                  </a:lnTo>
                  <a:lnTo>
                    <a:pt x="2013" y="38"/>
                  </a:lnTo>
                  <a:lnTo>
                    <a:pt x="2014" y="37"/>
                  </a:lnTo>
                  <a:lnTo>
                    <a:pt x="2015" y="36"/>
                  </a:lnTo>
                  <a:lnTo>
                    <a:pt x="2016" y="35"/>
                  </a:lnTo>
                  <a:lnTo>
                    <a:pt x="2017" y="37"/>
                  </a:lnTo>
                  <a:lnTo>
                    <a:pt x="2018" y="36"/>
                  </a:lnTo>
                  <a:lnTo>
                    <a:pt x="2019" y="39"/>
                  </a:lnTo>
                  <a:lnTo>
                    <a:pt x="2020" y="43"/>
                  </a:lnTo>
                  <a:lnTo>
                    <a:pt x="2020" y="34"/>
                  </a:lnTo>
                  <a:lnTo>
                    <a:pt x="2021" y="34"/>
                  </a:lnTo>
                  <a:lnTo>
                    <a:pt x="2022" y="37"/>
                  </a:lnTo>
                  <a:lnTo>
                    <a:pt x="2023" y="42"/>
                  </a:lnTo>
                  <a:lnTo>
                    <a:pt x="2024" y="41"/>
                  </a:lnTo>
                  <a:lnTo>
                    <a:pt x="2025" y="39"/>
                  </a:lnTo>
                  <a:lnTo>
                    <a:pt x="2026" y="43"/>
                  </a:lnTo>
                  <a:lnTo>
                    <a:pt x="2027" y="37"/>
                  </a:lnTo>
                  <a:lnTo>
                    <a:pt x="2027" y="41"/>
                  </a:lnTo>
                  <a:lnTo>
                    <a:pt x="2028" y="43"/>
                  </a:lnTo>
                  <a:lnTo>
                    <a:pt x="2029" y="42"/>
                  </a:lnTo>
                  <a:lnTo>
                    <a:pt x="2030" y="44"/>
                  </a:lnTo>
                  <a:lnTo>
                    <a:pt x="2031" y="39"/>
                  </a:lnTo>
                  <a:lnTo>
                    <a:pt x="2032" y="38"/>
                  </a:lnTo>
                  <a:lnTo>
                    <a:pt x="2033" y="38"/>
                  </a:lnTo>
                  <a:lnTo>
                    <a:pt x="2034" y="48"/>
                  </a:lnTo>
                  <a:lnTo>
                    <a:pt x="2034" y="43"/>
                  </a:lnTo>
                  <a:lnTo>
                    <a:pt x="2035" y="42"/>
                  </a:lnTo>
                  <a:lnTo>
                    <a:pt x="2036" y="35"/>
                  </a:lnTo>
                  <a:lnTo>
                    <a:pt x="2037" y="46"/>
                  </a:lnTo>
                  <a:lnTo>
                    <a:pt x="2038" y="43"/>
                  </a:lnTo>
                  <a:lnTo>
                    <a:pt x="2039" y="44"/>
                  </a:lnTo>
                  <a:lnTo>
                    <a:pt x="2040" y="43"/>
                  </a:lnTo>
                  <a:lnTo>
                    <a:pt x="2041" y="43"/>
                  </a:lnTo>
                  <a:lnTo>
                    <a:pt x="2042" y="42"/>
                  </a:lnTo>
                  <a:lnTo>
                    <a:pt x="2042" y="44"/>
                  </a:lnTo>
                  <a:lnTo>
                    <a:pt x="2043" y="46"/>
                  </a:lnTo>
                  <a:lnTo>
                    <a:pt x="2044" y="53"/>
                  </a:lnTo>
                  <a:lnTo>
                    <a:pt x="2045" y="46"/>
                  </a:lnTo>
                  <a:lnTo>
                    <a:pt x="2046" y="47"/>
                  </a:lnTo>
                  <a:lnTo>
                    <a:pt x="2047" y="41"/>
                  </a:lnTo>
                  <a:lnTo>
                    <a:pt x="2048" y="52"/>
                  </a:lnTo>
                  <a:lnTo>
                    <a:pt x="2049" y="48"/>
                  </a:lnTo>
                  <a:lnTo>
                    <a:pt x="2049" y="46"/>
                  </a:lnTo>
                  <a:lnTo>
                    <a:pt x="2050" y="46"/>
                  </a:lnTo>
                  <a:lnTo>
                    <a:pt x="2051" y="42"/>
                  </a:lnTo>
                  <a:lnTo>
                    <a:pt x="2052" y="43"/>
                  </a:lnTo>
                  <a:lnTo>
                    <a:pt x="2053" y="42"/>
                  </a:lnTo>
                  <a:lnTo>
                    <a:pt x="2054" y="38"/>
                  </a:lnTo>
                  <a:lnTo>
                    <a:pt x="2055" y="40"/>
                  </a:lnTo>
                  <a:lnTo>
                    <a:pt x="2056" y="39"/>
                  </a:lnTo>
                  <a:lnTo>
                    <a:pt x="2057" y="41"/>
                  </a:lnTo>
                  <a:lnTo>
                    <a:pt x="2057" y="38"/>
                  </a:lnTo>
                  <a:lnTo>
                    <a:pt x="2058" y="38"/>
                  </a:lnTo>
                  <a:lnTo>
                    <a:pt x="2059" y="40"/>
                  </a:lnTo>
                  <a:lnTo>
                    <a:pt x="2060" y="39"/>
                  </a:lnTo>
                  <a:lnTo>
                    <a:pt x="2061" y="40"/>
                  </a:lnTo>
                  <a:lnTo>
                    <a:pt x="2062" y="40"/>
                  </a:lnTo>
                  <a:lnTo>
                    <a:pt x="2063" y="43"/>
                  </a:lnTo>
                  <a:lnTo>
                    <a:pt x="2064" y="39"/>
                  </a:lnTo>
                  <a:lnTo>
                    <a:pt x="2064" y="43"/>
                  </a:lnTo>
                  <a:lnTo>
                    <a:pt x="2065" y="47"/>
                  </a:lnTo>
                  <a:lnTo>
                    <a:pt x="2066" y="40"/>
                  </a:lnTo>
                  <a:lnTo>
                    <a:pt x="2067" y="45"/>
                  </a:lnTo>
                  <a:lnTo>
                    <a:pt x="2068" y="50"/>
                  </a:lnTo>
                  <a:lnTo>
                    <a:pt x="2069" y="49"/>
                  </a:lnTo>
                  <a:lnTo>
                    <a:pt x="2070" y="47"/>
                  </a:lnTo>
                  <a:lnTo>
                    <a:pt x="2071" y="43"/>
                  </a:lnTo>
                  <a:lnTo>
                    <a:pt x="2072" y="51"/>
                  </a:lnTo>
                  <a:lnTo>
                    <a:pt x="2072" y="44"/>
                  </a:lnTo>
                  <a:lnTo>
                    <a:pt x="2073" y="41"/>
                  </a:lnTo>
                  <a:lnTo>
                    <a:pt x="2074" y="38"/>
                  </a:lnTo>
                  <a:lnTo>
                    <a:pt x="2075" y="45"/>
                  </a:lnTo>
                  <a:lnTo>
                    <a:pt x="2076" y="42"/>
                  </a:lnTo>
                  <a:lnTo>
                    <a:pt x="2077" y="41"/>
                  </a:lnTo>
                  <a:lnTo>
                    <a:pt x="2078" y="40"/>
                  </a:lnTo>
                  <a:lnTo>
                    <a:pt x="2079" y="39"/>
                  </a:lnTo>
                  <a:lnTo>
                    <a:pt x="2079" y="41"/>
                  </a:lnTo>
                  <a:lnTo>
                    <a:pt x="2080" y="43"/>
                  </a:lnTo>
                  <a:lnTo>
                    <a:pt x="2081" y="41"/>
                  </a:lnTo>
                  <a:lnTo>
                    <a:pt x="2082" y="39"/>
                  </a:lnTo>
                  <a:lnTo>
                    <a:pt x="2083" y="42"/>
                  </a:lnTo>
                  <a:lnTo>
                    <a:pt x="2084" y="41"/>
                  </a:lnTo>
                  <a:lnTo>
                    <a:pt x="2085" y="43"/>
                  </a:lnTo>
                  <a:lnTo>
                    <a:pt x="2086" y="46"/>
                  </a:lnTo>
                  <a:lnTo>
                    <a:pt x="2087" y="55"/>
                  </a:lnTo>
                  <a:lnTo>
                    <a:pt x="2087" y="50"/>
                  </a:lnTo>
                  <a:lnTo>
                    <a:pt x="2088" y="58"/>
                  </a:lnTo>
                  <a:lnTo>
                    <a:pt x="2089" y="71"/>
                  </a:lnTo>
                  <a:lnTo>
                    <a:pt x="2090" y="79"/>
                  </a:lnTo>
                  <a:lnTo>
                    <a:pt x="2091" y="95"/>
                  </a:lnTo>
                  <a:lnTo>
                    <a:pt x="2092" y="116"/>
                  </a:lnTo>
                  <a:lnTo>
                    <a:pt x="2093" y="129"/>
                  </a:lnTo>
                  <a:lnTo>
                    <a:pt x="2094" y="154"/>
                  </a:lnTo>
                  <a:lnTo>
                    <a:pt x="2094" y="173"/>
                  </a:lnTo>
                  <a:lnTo>
                    <a:pt x="2095" y="188"/>
                  </a:lnTo>
                  <a:lnTo>
                    <a:pt x="2096" y="198"/>
                  </a:lnTo>
                  <a:lnTo>
                    <a:pt x="2097" y="212"/>
                  </a:lnTo>
                  <a:lnTo>
                    <a:pt x="2098" y="205"/>
                  </a:lnTo>
                  <a:lnTo>
                    <a:pt x="2099" y="195"/>
                  </a:lnTo>
                  <a:lnTo>
                    <a:pt x="2100" y="199"/>
                  </a:lnTo>
                  <a:lnTo>
                    <a:pt x="2101" y="168"/>
                  </a:lnTo>
                  <a:lnTo>
                    <a:pt x="2102" y="149"/>
                  </a:lnTo>
                  <a:lnTo>
                    <a:pt x="2102" y="140"/>
                  </a:lnTo>
                  <a:lnTo>
                    <a:pt x="2103" y="131"/>
                  </a:lnTo>
                  <a:lnTo>
                    <a:pt x="2104" y="124"/>
                  </a:lnTo>
                  <a:lnTo>
                    <a:pt x="2105" y="106"/>
                  </a:lnTo>
                  <a:lnTo>
                    <a:pt x="2106" y="93"/>
                  </a:lnTo>
                  <a:lnTo>
                    <a:pt x="2107" y="92"/>
                  </a:lnTo>
                  <a:lnTo>
                    <a:pt x="2108" y="88"/>
                  </a:lnTo>
                  <a:lnTo>
                    <a:pt x="2109" y="81"/>
                  </a:lnTo>
                  <a:lnTo>
                    <a:pt x="2109" y="78"/>
                  </a:lnTo>
                  <a:lnTo>
                    <a:pt x="2110" y="70"/>
                  </a:lnTo>
                  <a:lnTo>
                    <a:pt x="2111" y="71"/>
                  </a:lnTo>
                  <a:lnTo>
                    <a:pt x="2112" y="66"/>
                  </a:lnTo>
                  <a:lnTo>
                    <a:pt x="2113" y="57"/>
                  </a:lnTo>
                  <a:lnTo>
                    <a:pt x="2114" y="63"/>
                  </a:lnTo>
                  <a:lnTo>
                    <a:pt x="2115" y="56"/>
                  </a:lnTo>
                  <a:lnTo>
                    <a:pt x="2116" y="51"/>
                  </a:lnTo>
                  <a:lnTo>
                    <a:pt x="2117" y="49"/>
                  </a:lnTo>
                  <a:lnTo>
                    <a:pt x="2117" y="49"/>
                  </a:lnTo>
                  <a:lnTo>
                    <a:pt x="2118" y="50"/>
                  </a:lnTo>
                  <a:lnTo>
                    <a:pt x="2119" y="46"/>
                  </a:lnTo>
                  <a:lnTo>
                    <a:pt x="2120" y="47"/>
                  </a:lnTo>
                  <a:lnTo>
                    <a:pt x="2121" y="43"/>
                  </a:lnTo>
                  <a:lnTo>
                    <a:pt x="2122" y="47"/>
                  </a:lnTo>
                  <a:lnTo>
                    <a:pt x="2123" y="44"/>
                  </a:lnTo>
                  <a:lnTo>
                    <a:pt x="2124" y="38"/>
                  </a:lnTo>
                  <a:lnTo>
                    <a:pt x="2124" y="37"/>
                  </a:lnTo>
                  <a:lnTo>
                    <a:pt x="2125" y="39"/>
                  </a:lnTo>
                  <a:lnTo>
                    <a:pt x="2126" y="35"/>
                  </a:lnTo>
                  <a:lnTo>
                    <a:pt x="2127" y="38"/>
                  </a:lnTo>
                  <a:lnTo>
                    <a:pt x="2128" y="39"/>
                  </a:lnTo>
                  <a:lnTo>
                    <a:pt x="2129" y="36"/>
                  </a:lnTo>
                  <a:lnTo>
                    <a:pt x="2130" y="36"/>
                  </a:lnTo>
                  <a:lnTo>
                    <a:pt x="2131" y="38"/>
                  </a:lnTo>
                  <a:lnTo>
                    <a:pt x="2132" y="31"/>
                  </a:lnTo>
                  <a:lnTo>
                    <a:pt x="2132" y="32"/>
                  </a:lnTo>
                  <a:lnTo>
                    <a:pt x="2133" y="28"/>
                  </a:lnTo>
                  <a:lnTo>
                    <a:pt x="2134" y="29"/>
                  </a:lnTo>
                  <a:lnTo>
                    <a:pt x="2135" y="34"/>
                  </a:lnTo>
                  <a:lnTo>
                    <a:pt x="2136" y="30"/>
                  </a:lnTo>
                  <a:lnTo>
                    <a:pt x="2137" y="29"/>
                  </a:lnTo>
                  <a:lnTo>
                    <a:pt x="2138" y="34"/>
                  </a:lnTo>
                  <a:lnTo>
                    <a:pt x="2139" y="30"/>
                  </a:lnTo>
                  <a:lnTo>
                    <a:pt x="2139" y="31"/>
                  </a:lnTo>
                  <a:lnTo>
                    <a:pt x="2140" y="36"/>
                  </a:lnTo>
                  <a:lnTo>
                    <a:pt x="2141" y="33"/>
                  </a:lnTo>
                  <a:lnTo>
                    <a:pt x="2142" y="36"/>
                  </a:lnTo>
                  <a:lnTo>
                    <a:pt x="2143" y="34"/>
                  </a:lnTo>
                  <a:lnTo>
                    <a:pt x="2144" y="37"/>
                  </a:lnTo>
                  <a:lnTo>
                    <a:pt x="2145" y="38"/>
                  </a:lnTo>
                  <a:lnTo>
                    <a:pt x="2146" y="39"/>
                  </a:lnTo>
                  <a:lnTo>
                    <a:pt x="2147" y="43"/>
                  </a:lnTo>
                  <a:lnTo>
                    <a:pt x="2147" y="48"/>
                  </a:lnTo>
                  <a:lnTo>
                    <a:pt x="2148" y="51"/>
                  </a:lnTo>
                  <a:lnTo>
                    <a:pt x="2149" y="56"/>
                  </a:lnTo>
                  <a:lnTo>
                    <a:pt x="2150" y="61"/>
                  </a:lnTo>
                  <a:lnTo>
                    <a:pt x="2151" y="68"/>
                  </a:lnTo>
                  <a:lnTo>
                    <a:pt x="2152" y="69"/>
                  </a:lnTo>
                  <a:lnTo>
                    <a:pt x="2153" y="72"/>
                  </a:lnTo>
                  <a:lnTo>
                    <a:pt x="2154" y="72"/>
                  </a:lnTo>
                  <a:lnTo>
                    <a:pt x="2154" y="70"/>
                  </a:lnTo>
                  <a:lnTo>
                    <a:pt x="2155" y="69"/>
                  </a:lnTo>
                  <a:lnTo>
                    <a:pt x="2156" y="68"/>
                  </a:lnTo>
                  <a:lnTo>
                    <a:pt x="2157" y="63"/>
                  </a:lnTo>
                  <a:lnTo>
                    <a:pt x="2158" y="63"/>
                  </a:lnTo>
                  <a:lnTo>
                    <a:pt x="2159" y="61"/>
                  </a:lnTo>
                  <a:lnTo>
                    <a:pt x="2160" y="60"/>
                  </a:lnTo>
                  <a:lnTo>
                    <a:pt x="2161" y="59"/>
                  </a:lnTo>
                  <a:lnTo>
                    <a:pt x="2162" y="48"/>
                  </a:lnTo>
                  <a:lnTo>
                    <a:pt x="2162" y="56"/>
                  </a:lnTo>
                  <a:lnTo>
                    <a:pt x="2163" y="45"/>
                  </a:lnTo>
                  <a:lnTo>
                    <a:pt x="2164" y="52"/>
                  </a:lnTo>
                  <a:lnTo>
                    <a:pt x="2165" y="49"/>
                  </a:lnTo>
                  <a:lnTo>
                    <a:pt x="2166" y="44"/>
                  </a:lnTo>
                  <a:lnTo>
                    <a:pt x="2167" y="47"/>
                  </a:lnTo>
                  <a:lnTo>
                    <a:pt x="2168" y="48"/>
                  </a:lnTo>
                  <a:lnTo>
                    <a:pt x="2169" y="47"/>
                  </a:lnTo>
                  <a:lnTo>
                    <a:pt x="2169" y="53"/>
                  </a:lnTo>
                  <a:lnTo>
                    <a:pt x="2170" y="44"/>
                  </a:lnTo>
                  <a:lnTo>
                    <a:pt x="2171" y="44"/>
                  </a:lnTo>
                  <a:lnTo>
                    <a:pt x="2172" y="46"/>
                  </a:lnTo>
                  <a:lnTo>
                    <a:pt x="2173" y="43"/>
                  </a:lnTo>
                  <a:lnTo>
                    <a:pt x="2174" y="48"/>
                  </a:lnTo>
                  <a:lnTo>
                    <a:pt x="2175" y="46"/>
                  </a:lnTo>
                  <a:lnTo>
                    <a:pt x="2176" y="46"/>
                  </a:lnTo>
                  <a:lnTo>
                    <a:pt x="2177" y="48"/>
                  </a:lnTo>
                  <a:lnTo>
                    <a:pt x="2177" y="41"/>
                  </a:lnTo>
                  <a:lnTo>
                    <a:pt x="2178" y="42"/>
                  </a:lnTo>
                  <a:lnTo>
                    <a:pt x="2179" y="41"/>
                  </a:lnTo>
                  <a:lnTo>
                    <a:pt x="2180" y="42"/>
                  </a:lnTo>
                  <a:lnTo>
                    <a:pt x="2181" y="41"/>
                  </a:lnTo>
                  <a:lnTo>
                    <a:pt x="2182" y="36"/>
                  </a:lnTo>
                  <a:lnTo>
                    <a:pt x="2183" y="40"/>
                  </a:lnTo>
                  <a:lnTo>
                    <a:pt x="2184" y="38"/>
                  </a:lnTo>
                  <a:lnTo>
                    <a:pt x="2184" y="36"/>
                  </a:lnTo>
                  <a:lnTo>
                    <a:pt x="2185" y="45"/>
                  </a:lnTo>
                  <a:lnTo>
                    <a:pt x="2186" y="41"/>
                  </a:lnTo>
                  <a:lnTo>
                    <a:pt x="2187" y="45"/>
                  </a:lnTo>
                  <a:lnTo>
                    <a:pt x="2188" y="42"/>
                  </a:lnTo>
                  <a:lnTo>
                    <a:pt x="2189" y="36"/>
                  </a:lnTo>
                  <a:lnTo>
                    <a:pt x="2190" y="40"/>
                  </a:lnTo>
                  <a:lnTo>
                    <a:pt x="2191" y="43"/>
                  </a:lnTo>
                  <a:lnTo>
                    <a:pt x="2192" y="47"/>
                  </a:lnTo>
                  <a:lnTo>
                    <a:pt x="2192" y="43"/>
                  </a:lnTo>
                  <a:lnTo>
                    <a:pt x="2193" y="38"/>
                  </a:lnTo>
                  <a:lnTo>
                    <a:pt x="2194" y="45"/>
                  </a:lnTo>
                  <a:lnTo>
                    <a:pt x="2195" y="42"/>
                  </a:lnTo>
                  <a:lnTo>
                    <a:pt x="2196" y="37"/>
                  </a:lnTo>
                  <a:lnTo>
                    <a:pt x="2197" y="38"/>
                  </a:lnTo>
                  <a:lnTo>
                    <a:pt x="2198" y="36"/>
                  </a:lnTo>
                  <a:lnTo>
                    <a:pt x="2199" y="38"/>
                  </a:lnTo>
                  <a:lnTo>
                    <a:pt x="2199" y="40"/>
                  </a:lnTo>
                  <a:lnTo>
                    <a:pt x="2200" y="39"/>
                  </a:lnTo>
                  <a:lnTo>
                    <a:pt x="2201" y="34"/>
                  </a:lnTo>
                  <a:lnTo>
                    <a:pt x="2202" y="35"/>
                  </a:lnTo>
                  <a:lnTo>
                    <a:pt x="2203" y="36"/>
                  </a:lnTo>
                  <a:lnTo>
                    <a:pt x="2204" y="34"/>
                  </a:lnTo>
                  <a:lnTo>
                    <a:pt x="2205" y="36"/>
                  </a:lnTo>
                  <a:lnTo>
                    <a:pt x="2206" y="33"/>
                  </a:lnTo>
                  <a:lnTo>
                    <a:pt x="2207" y="34"/>
                  </a:lnTo>
                  <a:lnTo>
                    <a:pt x="2207" y="39"/>
                  </a:lnTo>
                  <a:lnTo>
                    <a:pt x="2208" y="36"/>
                  </a:lnTo>
                  <a:lnTo>
                    <a:pt x="2209" y="32"/>
                  </a:lnTo>
                  <a:lnTo>
                    <a:pt x="2210" y="39"/>
                  </a:lnTo>
                  <a:lnTo>
                    <a:pt x="2211" y="36"/>
                  </a:lnTo>
                  <a:lnTo>
                    <a:pt x="2212" y="31"/>
                  </a:lnTo>
                  <a:lnTo>
                    <a:pt x="2213" y="35"/>
                  </a:lnTo>
                  <a:lnTo>
                    <a:pt x="2214" y="38"/>
                  </a:lnTo>
                  <a:lnTo>
                    <a:pt x="2214" y="31"/>
                  </a:lnTo>
                  <a:lnTo>
                    <a:pt x="2215" y="33"/>
                  </a:lnTo>
                  <a:lnTo>
                    <a:pt x="2216" y="31"/>
                  </a:lnTo>
                  <a:lnTo>
                    <a:pt x="2217" y="32"/>
                  </a:lnTo>
                  <a:lnTo>
                    <a:pt x="2218" y="39"/>
                  </a:lnTo>
                  <a:lnTo>
                    <a:pt x="2219" y="34"/>
                  </a:lnTo>
                  <a:lnTo>
                    <a:pt x="2220" y="33"/>
                  </a:lnTo>
                  <a:lnTo>
                    <a:pt x="2221" y="37"/>
                  </a:lnTo>
                  <a:lnTo>
                    <a:pt x="2222" y="37"/>
                  </a:lnTo>
                  <a:lnTo>
                    <a:pt x="2222" y="33"/>
                  </a:lnTo>
                  <a:lnTo>
                    <a:pt x="2223" y="36"/>
                  </a:lnTo>
                  <a:lnTo>
                    <a:pt x="2224" y="34"/>
                  </a:lnTo>
                  <a:lnTo>
                    <a:pt x="2225" y="38"/>
                  </a:lnTo>
                  <a:lnTo>
                    <a:pt x="2226" y="33"/>
                  </a:lnTo>
                  <a:lnTo>
                    <a:pt x="2227" y="36"/>
                  </a:lnTo>
                  <a:lnTo>
                    <a:pt x="2228" y="32"/>
                  </a:lnTo>
                  <a:lnTo>
                    <a:pt x="2229" y="35"/>
                  </a:lnTo>
                  <a:lnTo>
                    <a:pt x="2229" y="31"/>
                  </a:lnTo>
                  <a:lnTo>
                    <a:pt x="2230" y="27"/>
                  </a:lnTo>
                  <a:lnTo>
                    <a:pt x="2231" y="35"/>
                  </a:lnTo>
                  <a:lnTo>
                    <a:pt x="2232" y="30"/>
                  </a:lnTo>
                  <a:lnTo>
                    <a:pt x="2233" y="26"/>
                  </a:lnTo>
                  <a:lnTo>
                    <a:pt x="2234" y="29"/>
                  </a:lnTo>
                  <a:lnTo>
                    <a:pt x="2235" y="27"/>
                  </a:lnTo>
                  <a:lnTo>
                    <a:pt x="2236" y="23"/>
                  </a:lnTo>
                  <a:lnTo>
                    <a:pt x="2236" y="24"/>
                  </a:lnTo>
                  <a:lnTo>
                    <a:pt x="2237" y="27"/>
                  </a:lnTo>
                  <a:lnTo>
                    <a:pt x="2238" y="23"/>
                  </a:lnTo>
                  <a:lnTo>
                    <a:pt x="2239" y="27"/>
                  </a:lnTo>
                  <a:lnTo>
                    <a:pt x="2240" y="23"/>
                  </a:lnTo>
                  <a:lnTo>
                    <a:pt x="2241" y="27"/>
                  </a:lnTo>
                  <a:lnTo>
                    <a:pt x="2242" y="25"/>
                  </a:lnTo>
                  <a:lnTo>
                    <a:pt x="2243" y="28"/>
                  </a:lnTo>
                  <a:lnTo>
                    <a:pt x="2244" y="24"/>
                  </a:lnTo>
                  <a:lnTo>
                    <a:pt x="2244" y="23"/>
                  </a:lnTo>
                  <a:lnTo>
                    <a:pt x="2245" y="28"/>
                  </a:lnTo>
                  <a:lnTo>
                    <a:pt x="2246" y="25"/>
                  </a:lnTo>
                  <a:lnTo>
                    <a:pt x="2247" y="24"/>
                  </a:lnTo>
                  <a:lnTo>
                    <a:pt x="2248" y="28"/>
                  </a:lnTo>
                  <a:lnTo>
                    <a:pt x="2249" y="24"/>
                  </a:lnTo>
                  <a:lnTo>
                    <a:pt x="2250" y="25"/>
                  </a:lnTo>
                  <a:lnTo>
                    <a:pt x="2251" y="25"/>
                  </a:lnTo>
                  <a:lnTo>
                    <a:pt x="2251" y="26"/>
                  </a:lnTo>
                  <a:lnTo>
                    <a:pt x="2252" y="25"/>
                  </a:lnTo>
                  <a:lnTo>
                    <a:pt x="2253" y="24"/>
                  </a:lnTo>
                  <a:lnTo>
                    <a:pt x="2254" y="25"/>
                  </a:lnTo>
                  <a:lnTo>
                    <a:pt x="2255" y="23"/>
                  </a:lnTo>
                  <a:lnTo>
                    <a:pt x="2256" y="25"/>
                  </a:lnTo>
                  <a:lnTo>
                    <a:pt x="2257" y="25"/>
                  </a:lnTo>
                  <a:lnTo>
                    <a:pt x="2258" y="23"/>
                  </a:lnTo>
                  <a:lnTo>
                    <a:pt x="2259" y="27"/>
                  </a:lnTo>
                  <a:lnTo>
                    <a:pt x="2259" y="25"/>
                  </a:lnTo>
                  <a:lnTo>
                    <a:pt x="2260" y="25"/>
                  </a:lnTo>
                  <a:lnTo>
                    <a:pt x="2261" y="27"/>
                  </a:lnTo>
                  <a:lnTo>
                    <a:pt x="2262" y="31"/>
                  </a:lnTo>
                  <a:lnTo>
                    <a:pt x="2263" y="26"/>
                  </a:lnTo>
                  <a:lnTo>
                    <a:pt x="2264" y="26"/>
                  </a:lnTo>
                  <a:lnTo>
                    <a:pt x="2265" y="34"/>
                  </a:lnTo>
                  <a:lnTo>
                    <a:pt x="2266" y="31"/>
                  </a:lnTo>
                  <a:lnTo>
                    <a:pt x="2266" y="32"/>
                  </a:lnTo>
                  <a:lnTo>
                    <a:pt x="2267" y="29"/>
                  </a:lnTo>
                  <a:lnTo>
                    <a:pt x="2268" y="28"/>
                  </a:lnTo>
                  <a:lnTo>
                    <a:pt x="2269" y="30"/>
                  </a:lnTo>
                  <a:lnTo>
                    <a:pt x="2270" y="28"/>
                  </a:lnTo>
                  <a:lnTo>
                    <a:pt x="2271" y="31"/>
                  </a:lnTo>
                  <a:lnTo>
                    <a:pt x="2272" y="38"/>
                  </a:lnTo>
                  <a:lnTo>
                    <a:pt x="2273" y="41"/>
                  </a:lnTo>
                  <a:lnTo>
                    <a:pt x="2274" y="50"/>
                  </a:lnTo>
                  <a:lnTo>
                    <a:pt x="2274" y="53"/>
                  </a:lnTo>
                  <a:lnTo>
                    <a:pt x="2275" y="75"/>
                  </a:lnTo>
                  <a:lnTo>
                    <a:pt x="2276" y="76"/>
                  </a:lnTo>
                  <a:lnTo>
                    <a:pt x="2277" y="91"/>
                  </a:lnTo>
                  <a:lnTo>
                    <a:pt x="2278" y="106"/>
                  </a:lnTo>
                  <a:lnTo>
                    <a:pt x="2279" y="121"/>
                  </a:lnTo>
                  <a:lnTo>
                    <a:pt x="2280" y="129"/>
                  </a:lnTo>
                  <a:lnTo>
                    <a:pt x="2281" y="141"/>
                  </a:lnTo>
                  <a:lnTo>
                    <a:pt x="2281" y="139"/>
                  </a:lnTo>
                  <a:lnTo>
                    <a:pt x="2282" y="135"/>
                  </a:lnTo>
                  <a:lnTo>
                    <a:pt x="2283" y="128"/>
                  </a:lnTo>
                  <a:lnTo>
                    <a:pt x="2284" y="115"/>
                  </a:lnTo>
                  <a:lnTo>
                    <a:pt x="2285" y="106"/>
                  </a:lnTo>
                  <a:lnTo>
                    <a:pt x="2286" y="95"/>
                  </a:lnTo>
                  <a:lnTo>
                    <a:pt x="2287" y="82"/>
                  </a:lnTo>
                  <a:lnTo>
                    <a:pt x="2288" y="60"/>
                  </a:lnTo>
                  <a:lnTo>
                    <a:pt x="2289" y="61"/>
                  </a:lnTo>
                  <a:lnTo>
                    <a:pt x="2289" y="54"/>
                  </a:lnTo>
                  <a:lnTo>
                    <a:pt x="2290" y="50"/>
                  </a:lnTo>
                  <a:lnTo>
                    <a:pt x="2291" y="46"/>
                  </a:lnTo>
                  <a:lnTo>
                    <a:pt x="2292" y="50"/>
                  </a:lnTo>
                  <a:lnTo>
                    <a:pt x="2293" y="52"/>
                  </a:lnTo>
                  <a:lnTo>
                    <a:pt x="2294" y="60"/>
                  </a:lnTo>
                  <a:lnTo>
                    <a:pt x="2295" y="59"/>
                  </a:lnTo>
                  <a:lnTo>
                    <a:pt x="2296" y="58"/>
                  </a:lnTo>
                  <a:lnTo>
                    <a:pt x="2296" y="59"/>
                  </a:lnTo>
                  <a:lnTo>
                    <a:pt x="2297" y="57"/>
                  </a:lnTo>
                  <a:lnTo>
                    <a:pt x="2298" y="69"/>
                  </a:lnTo>
                  <a:lnTo>
                    <a:pt x="2299" y="66"/>
                  </a:lnTo>
                  <a:lnTo>
                    <a:pt x="2300" y="61"/>
                  </a:lnTo>
                  <a:lnTo>
                    <a:pt x="2301" y="61"/>
                  </a:lnTo>
                  <a:lnTo>
                    <a:pt x="2302" y="52"/>
                  </a:lnTo>
                  <a:lnTo>
                    <a:pt x="2303" y="57"/>
                  </a:lnTo>
                  <a:lnTo>
                    <a:pt x="2304" y="49"/>
                  </a:lnTo>
                  <a:lnTo>
                    <a:pt x="2304" y="46"/>
                  </a:lnTo>
                  <a:lnTo>
                    <a:pt x="2305" y="39"/>
                  </a:lnTo>
                  <a:lnTo>
                    <a:pt x="2306" y="36"/>
                  </a:lnTo>
                  <a:lnTo>
                    <a:pt x="2307" y="37"/>
                  </a:lnTo>
                  <a:lnTo>
                    <a:pt x="2308" y="37"/>
                  </a:lnTo>
                  <a:lnTo>
                    <a:pt x="2309" y="36"/>
                  </a:lnTo>
                  <a:lnTo>
                    <a:pt x="2310" y="31"/>
                  </a:lnTo>
                  <a:lnTo>
                    <a:pt x="2311" y="33"/>
                  </a:lnTo>
                  <a:lnTo>
                    <a:pt x="2311" y="33"/>
                  </a:lnTo>
                  <a:lnTo>
                    <a:pt x="2312" y="30"/>
                  </a:lnTo>
                  <a:lnTo>
                    <a:pt x="2313" y="33"/>
                  </a:lnTo>
                  <a:lnTo>
                    <a:pt x="2314" y="29"/>
                  </a:lnTo>
                  <a:lnTo>
                    <a:pt x="2315" y="27"/>
                  </a:lnTo>
                  <a:lnTo>
                    <a:pt x="2316" y="31"/>
                  </a:lnTo>
                  <a:lnTo>
                    <a:pt x="2317" y="28"/>
                  </a:lnTo>
                  <a:lnTo>
                    <a:pt x="2318" y="28"/>
                  </a:lnTo>
                  <a:lnTo>
                    <a:pt x="2319" y="32"/>
                  </a:lnTo>
                  <a:lnTo>
                    <a:pt x="2319" y="28"/>
                  </a:lnTo>
                  <a:lnTo>
                    <a:pt x="2320" y="27"/>
                  </a:lnTo>
                  <a:lnTo>
                    <a:pt x="2321" y="26"/>
                  </a:lnTo>
                  <a:lnTo>
                    <a:pt x="2322" y="32"/>
                  </a:lnTo>
                  <a:lnTo>
                    <a:pt x="2323" y="30"/>
                  </a:lnTo>
                  <a:lnTo>
                    <a:pt x="2324" y="29"/>
                  </a:lnTo>
                  <a:lnTo>
                    <a:pt x="2325" y="33"/>
                  </a:lnTo>
                  <a:lnTo>
                    <a:pt x="2326" y="28"/>
                  </a:lnTo>
                  <a:lnTo>
                    <a:pt x="2326" y="29"/>
                  </a:lnTo>
                  <a:lnTo>
                    <a:pt x="2327" y="32"/>
                  </a:lnTo>
                  <a:lnTo>
                    <a:pt x="2328" y="31"/>
                  </a:lnTo>
                  <a:lnTo>
                    <a:pt x="2329" y="32"/>
                  </a:lnTo>
                  <a:lnTo>
                    <a:pt x="2330" y="32"/>
                  </a:lnTo>
                  <a:lnTo>
                    <a:pt x="2331" y="26"/>
                  </a:lnTo>
                  <a:lnTo>
                    <a:pt x="2332" y="25"/>
                  </a:lnTo>
                  <a:lnTo>
                    <a:pt x="2333" y="27"/>
                  </a:lnTo>
                  <a:lnTo>
                    <a:pt x="2334" y="26"/>
                  </a:lnTo>
                  <a:lnTo>
                    <a:pt x="2334" y="26"/>
                  </a:lnTo>
                  <a:lnTo>
                    <a:pt x="2335" y="27"/>
                  </a:lnTo>
                  <a:lnTo>
                    <a:pt x="2336" y="25"/>
                  </a:lnTo>
                  <a:lnTo>
                    <a:pt x="2337" y="25"/>
                  </a:lnTo>
                  <a:lnTo>
                    <a:pt x="2338" y="28"/>
                  </a:lnTo>
                  <a:lnTo>
                    <a:pt x="2339" y="28"/>
                  </a:lnTo>
                  <a:lnTo>
                    <a:pt x="2340" y="25"/>
                  </a:lnTo>
                  <a:lnTo>
                    <a:pt x="2341" y="23"/>
                  </a:lnTo>
                  <a:lnTo>
                    <a:pt x="2341" y="30"/>
                  </a:lnTo>
                  <a:lnTo>
                    <a:pt x="2342" y="24"/>
                  </a:lnTo>
                  <a:lnTo>
                    <a:pt x="2343" y="26"/>
                  </a:lnTo>
                  <a:lnTo>
                    <a:pt x="2344" y="26"/>
                  </a:lnTo>
                  <a:lnTo>
                    <a:pt x="2345" y="27"/>
                  </a:lnTo>
                  <a:lnTo>
                    <a:pt x="2346" y="30"/>
                  </a:lnTo>
                  <a:lnTo>
                    <a:pt x="2347" y="25"/>
                  </a:lnTo>
                  <a:lnTo>
                    <a:pt x="2348" y="26"/>
                  </a:lnTo>
                  <a:lnTo>
                    <a:pt x="2349" y="27"/>
                  </a:lnTo>
                  <a:lnTo>
                    <a:pt x="2349" y="26"/>
                  </a:lnTo>
                  <a:lnTo>
                    <a:pt x="2350" y="28"/>
                  </a:lnTo>
                  <a:lnTo>
                    <a:pt x="2351" y="25"/>
                  </a:lnTo>
                  <a:lnTo>
                    <a:pt x="2352" y="26"/>
                  </a:lnTo>
                  <a:lnTo>
                    <a:pt x="2353" y="30"/>
                  </a:lnTo>
                  <a:lnTo>
                    <a:pt x="2354" y="26"/>
                  </a:lnTo>
                  <a:lnTo>
                    <a:pt x="2355" y="23"/>
                  </a:lnTo>
                  <a:lnTo>
                    <a:pt x="2356" y="27"/>
                  </a:lnTo>
                  <a:lnTo>
                    <a:pt x="2356" y="25"/>
                  </a:lnTo>
                  <a:lnTo>
                    <a:pt x="2357" y="23"/>
                  </a:lnTo>
                  <a:lnTo>
                    <a:pt x="2358" y="22"/>
                  </a:lnTo>
                  <a:lnTo>
                    <a:pt x="2359" y="23"/>
                  </a:lnTo>
                  <a:lnTo>
                    <a:pt x="2360" y="22"/>
                  </a:lnTo>
                  <a:lnTo>
                    <a:pt x="2361" y="23"/>
                  </a:lnTo>
                  <a:lnTo>
                    <a:pt x="2362" y="23"/>
                  </a:lnTo>
                  <a:lnTo>
                    <a:pt x="2363" y="26"/>
                  </a:lnTo>
                  <a:lnTo>
                    <a:pt x="2364" y="28"/>
                  </a:lnTo>
                  <a:lnTo>
                    <a:pt x="2364" y="23"/>
                  </a:lnTo>
                  <a:lnTo>
                    <a:pt x="2365" y="25"/>
                  </a:lnTo>
                  <a:lnTo>
                    <a:pt x="2366" y="24"/>
                  </a:lnTo>
                  <a:lnTo>
                    <a:pt x="2367" y="27"/>
                  </a:lnTo>
                  <a:lnTo>
                    <a:pt x="2368" y="25"/>
                  </a:lnTo>
                  <a:lnTo>
                    <a:pt x="2369" y="23"/>
                  </a:lnTo>
                  <a:lnTo>
                    <a:pt x="2370" y="27"/>
                  </a:lnTo>
                  <a:lnTo>
                    <a:pt x="2371" y="29"/>
                  </a:lnTo>
                  <a:lnTo>
                    <a:pt x="2371" y="25"/>
                  </a:lnTo>
                  <a:lnTo>
                    <a:pt x="2372" y="27"/>
                  </a:lnTo>
                  <a:lnTo>
                    <a:pt x="2373" y="24"/>
                  </a:lnTo>
                  <a:lnTo>
                    <a:pt x="2374" y="29"/>
                  </a:lnTo>
                  <a:lnTo>
                    <a:pt x="2375" y="32"/>
                  </a:lnTo>
                  <a:lnTo>
                    <a:pt x="2376" y="28"/>
                  </a:lnTo>
                  <a:lnTo>
                    <a:pt x="2377" y="30"/>
                  </a:lnTo>
                  <a:lnTo>
                    <a:pt x="2378" y="31"/>
                  </a:lnTo>
                  <a:lnTo>
                    <a:pt x="2379" y="29"/>
                  </a:lnTo>
                  <a:lnTo>
                    <a:pt x="2379" y="28"/>
                  </a:lnTo>
                  <a:lnTo>
                    <a:pt x="2380" y="32"/>
                  </a:lnTo>
                  <a:lnTo>
                    <a:pt x="2381" y="28"/>
                  </a:lnTo>
                  <a:lnTo>
                    <a:pt x="2382" y="31"/>
                  </a:lnTo>
                  <a:lnTo>
                    <a:pt x="2383" y="31"/>
                  </a:lnTo>
                  <a:lnTo>
                    <a:pt x="2384" y="33"/>
                  </a:lnTo>
                  <a:lnTo>
                    <a:pt x="2385" y="27"/>
                  </a:lnTo>
                  <a:lnTo>
                    <a:pt x="2386" y="31"/>
                  </a:lnTo>
                  <a:lnTo>
                    <a:pt x="2386" y="28"/>
                  </a:lnTo>
                  <a:lnTo>
                    <a:pt x="2387" y="31"/>
                  </a:lnTo>
                  <a:lnTo>
                    <a:pt x="2388" y="31"/>
                  </a:lnTo>
                  <a:lnTo>
                    <a:pt x="2389" y="29"/>
                  </a:lnTo>
                  <a:lnTo>
                    <a:pt x="2390" y="28"/>
                  </a:lnTo>
                  <a:lnTo>
                    <a:pt x="2391" y="27"/>
                  </a:lnTo>
                  <a:lnTo>
                    <a:pt x="2392" y="33"/>
                  </a:lnTo>
                  <a:lnTo>
                    <a:pt x="2393" y="28"/>
                  </a:lnTo>
                  <a:lnTo>
                    <a:pt x="2394" y="32"/>
                  </a:lnTo>
                  <a:lnTo>
                    <a:pt x="2394" y="31"/>
                  </a:lnTo>
                  <a:lnTo>
                    <a:pt x="2395" y="33"/>
                  </a:lnTo>
                  <a:lnTo>
                    <a:pt x="2396" y="36"/>
                  </a:lnTo>
                  <a:lnTo>
                    <a:pt x="2397" y="37"/>
                  </a:lnTo>
                  <a:lnTo>
                    <a:pt x="2398" y="43"/>
                  </a:lnTo>
                  <a:lnTo>
                    <a:pt x="2399" y="53"/>
                  </a:lnTo>
                  <a:lnTo>
                    <a:pt x="2400" y="64"/>
                  </a:lnTo>
                  <a:lnTo>
                    <a:pt x="2401" y="83"/>
                  </a:lnTo>
                  <a:lnTo>
                    <a:pt x="2401" y="99"/>
                  </a:lnTo>
                  <a:lnTo>
                    <a:pt x="2402" y="122"/>
                  </a:lnTo>
                  <a:lnTo>
                    <a:pt x="2403" y="148"/>
                  </a:lnTo>
                  <a:lnTo>
                    <a:pt x="2404" y="170"/>
                  </a:lnTo>
                  <a:lnTo>
                    <a:pt x="2405" y="193"/>
                  </a:lnTo>
                  <a:lnTo>
                    <a:pt x="2406" y="206"/>
                  </a:lnTo>
                  <a:lnTo>
                    <a:pt x="2407" y="248"/>
                  </a:lnTo>
                  <a:lnTo>
                    <a:pt x="2408" y="252"/>
                  </a:lnTo>
                  <a:lnTo>
                    <a:pt x="2409" y="260"/>
                  </a:lnTo>
                  <a:lnTo>
                    <a:pt x="2409" y="274"/>
                  </a:lnTo>
                  <a:lnTo>
                    <a:pt x="2410" y="257"/>
                  </a:lnTo>
                  <a:lnTo>
                    <a:pt x="2411" y="253"/>
                  </a:lnTo>
                  <a:lnTo>
                    <a:pt x="2412" y="229"/>
                  </a:lnTo>
                  <a:lnTo>
                    <a:pt x="2413" y="212"/>
                  </a:lnTo>
                  <a:lnTo>
                    <a:pt x="2414" y="193"/>
                  </a:lnTo>
                  <a:lnTo>
                    <a:pt x="2415" y="187"/>
                  </a:lnTo>
                  <a:lnTo>
                    <a:pt x="2416" y="178"/>
                  </a:lnTo>
                  <a:lnTo>
                    <a:pt x="2416" y="169"/>
                  </a:lnTo>
                  <a:lnTo>
                    <a:pt x="2417" y="178"/>
                  </a:lnTo>
                  <a:lnTo>
                    <a:pt x="2418" y="173"/>
                  </a:lnTo>
                  <a:lnTo>
                    <a:pt x="2419" y="185"/>
                  </a:lnTo>
                  <a:lnTo>
                    <a:pt x="2420" y="198"/>
                  </a:lnTo>
                  <a:lnTo>
                    <a:pt x="2421" y="208"/>
                  </a:lnTo>
                  <a:lnTo>
                    <a:pt x="2422" y="245"/>
                  </a:lnTo>
                  <a:lnTo>
                    <a:pt x="2423" y="270"/>
                  </a:lnTo>
                  <a:lnTo>
                    <a:pt x="2424" y="314"/>
                  </a:lnTo>
                  <a:lnTo>
                    <a:pt x="2424" y="337"/>
                  </a:lnTo>
                  <a:lnTo>
                    <a:pt x="2425" y="370"/>
                  </a:lnTo>
                  <a:lnTo>
                    <a:pt x="2426" y="410"/>
                  </a:lnTo>
                  <a:lnTo>
                    <a:pt x="2427" y="423"/>
                  </a:lnTo>
                  <a:lnTo>
                    <a:pt x="2428" y="451"/>
                  </a:lnTo>
                  <a:lnTo>
                    <a:pt x="2429" y="449"/>
                  </a:lnTo>
                  <a:lnTo>
                    <a:pt x="2430" y="454"/>
                  </a:lnTo>
                  <a:lnTo>
                    <a:pt x="2431" y="429"/>
                  </a:lnTo>
                  <a:lnTo>
                    <a:pt x="2431" y="410"/>
                  </a:lnTo>
                  <a:lnTo>
                    <a:pt x="2432" y="409"/>
                  </a:lnTo>
                  <a:lnTo>
                    <a:pt x="2433" y="381"/>
                  </a:lnTo>
                  <a:lnTo>
                    <a:pt x="2434" y="364"/>
                  </a:lnTo>
                  <a:lnTo>
                    <a:pt x="2435" y="347"/>
                  </a:lnTo>
                  <a:lnTo>
                    <a:pt x="2436" y="329"/>
                  </a:lnTo>
                  <a:lnTo>
                    <a:pt x="2437" y="330"/>
                  </a:lnTo>
                  <a:lnTo>
                    <a:pt x="2438" y="322"/>
                  </a:lnTo>
                  <a:lnTo>
                    <a:pt x="2438" y="317"/>
                  </a:lnTo>
                  <a:lnTo>
                    <a:pt x="2439" y="306"/>
                  </a:lnTo>
                  <a:lnTo>
                    <a:pt x="2440" y="312"/>
                  </a:lnTo>
                  <a:lnTo>
                    <a:pt x="2441" y="308"/>
                  </a:lnTo>
                  <a:lnTo>
                    <a:pt x="2442" y="298"/>
                  </a:lnTo>
                  <a:lnTo>
                    <a:pt x="2443" y="290"/>
                  </a:lnTo>
                  <a:lnTo>
                    <a:pt x="2444" y="283"/>
                  </a:lnTo>
                  <a:lnTo>
                    <a:pt x="2445" y="263"/>
                  </a:lnTo>
                  <a:lnTo>
                    <a:pt x="2446" y="248"/>
                  </a:lnTo>
                  <a:lnTo>
                    <a:pt x="2446" y="247"/>
                  </a:lnTo>
                  <a:lnTo>
                    <a:pt x="2447" y="225"/>
                  </a:lnTo>
                  <a:lnTo>
                    <a:pt x="2448" y="212"/>
                  </a:lnTo>
                  <a:lnTo>
                    <a:pt x="2449" y="201"/>
                  </a:lnTo>
                  <a:lnTo>
                    <a:pt x="2450" y="200"/>
                  </a:lnTo>
                  <a:lnTo>
                    <a:pt x="2451" y="184"/>
                  </a:lnTo>
                  <a:lnTo>
                    <a:pt x="2452" y="179"/>
                  </a:lnTo>
                  <a:lnTo>
                    <a:pt x="2453" y="170"/>
                  </a:lnTo>
                  <a:lnTo>
                    <a:pt x="2453" y="161"/>
                  </a:lnTo>
                  <a:lnTo>
                    <a:pt x="2454" y="161"/>
                  </a:lnTo>
                  <a:lnTo>
                    <a:pt x="2455" y="152"/>
                  </a:lnTo>
                  <a:lnTo>
                    <a:pt x="2456" y="140"/>
                  </a:lnTo>
                  <a:lnTo>
                    <a:pt x="2457" y="142"/>
                  </a:lnTo>
                  <a:lnTo>
                    <a:pt x="2458" y="143"/>
                  </a:lnTo>
                  <a:lnTo>
                    <a:pt x="2459" y="142"/>
                  </a:lnTo>
                  <a:lnTo>
                    <a:pt x="2460" y="127"/>
                  </a:lnTo>
                  <a:lnTo>
                    <a:pt x="2461" y="132"/>
                  </a:lnTo>
                  <a:lnTo>
                    <a:pt x="2461" y="127"/>
                  </a:lnTo>
                  <a:lnTo>
                    <a:pt x="2462" y="132"/>
                  </a:lnTo>
                  <a:lnTo>
                    <a:pt x="2463" y="129"/>
                  </a:lnTo>
                  <a:lnTo>
                    <a:pt x="2464" y="121"/>
                  </a:lnTo>
                  <a:lnTo>
                    <a:pt x="2465" y="120"/>
                  </a:lnTo>
                  <a:lnTo>
                    <a:pt x="2466" y="115"/>
                  </a:lnTo>
                  <a:lnTo>
                    <a:pt x="2467" y="114"/>
                  </a:lnTo>
                  <a:lnTo>
                    <a:pt x="2468" y="111"/>
                  </a:lnTo>
                  <a:lnTo>
                    <a:pt x="2468" y="109"/>
                  </a:lnTo>
                  <a:lnTo>
                    <a:pt x="2469" y="103"/>
                  </a:lnTo>
                  <a:lnTo>
                    <a:pt x="2470" y="105"/>
                  </a:lnTo>
                  <a:lnTo>
                    <a:pt x="2471" y="99"/>
                  </a:lnTo>
                  <a:lnTo>
                    <a:pt x="2472" y="104"/>
                  </a:lnTo>
                  <a:lnTo>
                    <a:pt x="2473" y="107"/>
                  </a:lnTo>
                  <a:lnTo>
                    <a:pt x="2474" y="104"/>
                  </a:lnTo>
                  <a:lnTo>
                    <a:pt x="2475" y="102"/>
                  </a:lnTo>
                  <a:lnTo>
                    <a:pt x="2476" y="97"/>
                  </a:lnTo>
                  <a:lnTo>
                    <a:pt x="2476" y="104"/>
                  </a:lnTo>
                  <a:lnTo>
                    <a:pt x="2477" y="104"/>
                  </a:lnTo>
                  <a:lnTo>
                    <a:pt x="2478" y="90"/>
                  </a:lnTo>
                  <a:lnTo>
                    <a:pt x="2479" y="84"/>
                  </a:lnTo>
                  <a:lnTo>
                    <a:pt x="2480" y="91"/>
                  </a:lnTo>
                  <a:lnTo>
                    <a:pt x="2481" y="90"/>
                  </a:lnTo>
                  <a:lnTo>
                    <a:pt x="2482" y="83"/>
                  </a:lnTo>
                  <a:lnTo>
                    <a:pt x="2483" y="82"/>
                  </a:lnTo>
                  <a:lnTo>
                    <a:pt x="2483" y="83"/>
                  </a:lnTo>
                  <a:lnTo>
                    <a:pt x="2484" y="82"/>
                  </a:lnTo>
                  <a:lnTo>
                    <a:pt x="2485" y="81"/>
                  </a:lnTo>
                  <a:lnTo>
                    <a:pt x="2486" y="82"/>
                  </a:lnTo>
                  <a:lnTo>
                    <a:pt x="2487" y="83"/>
                  </a:lnTo>
                  <a:lnTo>
                    <a:pt x="2488" y="75"/>
                  </a:lnTo>
                  <a:lnTo>
                    <a:pt x="2489" y="74"/>
                  </a:lnTo>
                  <a:lnTo>
                    <a:pt x="2490" y="75"/>
                  </a:lnTo>
                  <a:lnTo>
                    <a:pt x="2491" y="72"/>
                  </a:lnTo>
                  <a:lnTo>
                    <a:pt x="2491" y="75"/>
                  </a:lnTo>
                  <a:lnTo>
                    <a:pt x="2492" y="75"/>
                  </a:lnTo>
                  <a:lnTo>
                    <a:pt x="2493" y="72"/>
                  </a:lnTo>
                  <a:lnTo>
                    <a:pt x="2494" y="67"/>
                  </a:lnTo>
                  <a:lnTo>
                    <a:pt x="2495" y="76"/>
                  </a:lnTo>
                  <a:lnTo>
                    <a:pt x="2496" y="72"/>
                  </a:lnTo>
                  <a:lnTo>
                    <a:pt x="2497" y="73"/>
                  </a:lnTo>
                  <a:lnTo>
                    <a:pt x="2498" y="79"/>
                  </a:lnTo>
                  <a:lnTo>
                    <a:pt x="2498" y="76"/>
                  </a:lnTo>
                  <a:lnTo>
                    <a:pt x="2499" y="85"/>
                  </a:lnTo>
                  <a:lnTo>
                    <a:pt x="2500" y="89"/>
                  </a:lnTo>
                  <a:lnTo>
                    <a:pt x="2501" y="91"/>
                  </a:lnTo>
                  <a:lnTo>
                    <a:pt x="2502" y="95"/>
                  </a:lnTo>
                  <a:lnTo>
                    <a:pt x="2503" y="103"/>
                  </a:lnTo>
                  <a:lnTo>
                    <a:pt x="2504" y="111"/>
                  </a:lnTo>
                  <a:lnTo>
                    <a:pt x="2505" y="114"/>
                  </a:lnTo>
                  <a:lnTo>
                    <a:pt x="2506" y="132"/>
                  </a:lnTo>
                  <a:lnTo>
                    <a:pt x="2506" y="135"/>
                  </a:lnTo>
                  <a:lnTo>
                    <a:pt x="2507" y="146"/>
                  </a:lnTo>
                  <a:lnTo>
                    <a:pt x="2508" y="150"/>
                  </a:lnTo>
                  <a:lnTo>
                    <a:pt x="2509" y="153"/>
                  </a:lnTo>
                  <a:lnTo>
                    <a:pt x="2510" y="151"/>
                  </a:lnTo>
                  <a:lnTo>
                    <a:pt x="2511" y="143"/>
                  </a:lnTo>
                  <a:lnTo>
                    <a:pt x="2512" y="156"/>
                  </a:lnTo>
                  <a:lnTo>
                    <a:pt x="2513" y="153"/>
                  </a:lnTo>
                  <a:lnTo>
                    <a:pt x="2513" y="148"/>
                  </a:lnTo>
                  <a:lnTo>
                    <a:pt x="2514" y="136"/>
                  </a:lnTo>
                  <a:lnTo>
                    <a:pt x="2515" y="132"/>
                  </a:lnTo>
                  <a:lnTo>
                    <a:pt x="2516" y="122"/>
                  </a:lnTo>
                  <a:lnTo>
                    <a:pt x="2517" y="118"/>
                  </a:lnTo>
                  <a:lnTo>
                    <a:pt x="2518" y="118"/>
                  </a:lnTo>
                  <a:lnTo>
                    <a:pt x="2519" y="112"/>
                  </a:lnTo>
                  <a:lnTo>
                    <a:pt x="2520" y="112"/>
                  </a:lnTo>
                  <a:lnTo>
                    <a:pt x="2521" y="115"/>
                  </a:lnTo>
                  <a:lnTo>
                    <a:pt x="2521" y="106"/>
                  </a:lnTo>
                  <a:lnTo>
                    <a:pt x="2522" y="104"/>
                  </a:lnTo>
                  <a:lnTo>
                    <a:pt x="2523" y="106"/>
                  </a:lnTo>
                  <a:lnTo>
                    <a:pt x="2524" y="121"/>
                  </a:lnTo>
                  <a:lnTo>
                    <a:pt x="2525" y="116"/>
                  </a:lnTo>
                  <a:lnTo>
                    <a:pt x="2526" y="127"/>
                  </a:lnTo>
                  <a:lnTo>
                    <a:pt x="2527" y="123"/>
                  </a:lnTo>
                  <a:lnTo>
                    <a:pt x="2528" y="142"/>
                  </a:lnTo>
                  <a:lnTo>
                    <a:pt x="2528" y="150"/>
                  </a:lnTo>
                  <a:lnTo>
                    <a:pt x="2529" y="165"/>
                  </a:lnTo>
                  <a:lnTo>
                    <a:pt x="2530" y="172"/>
                  </a:lnTo>
                  <a:lnTo>
                    <a:pt x="2531" y="170"/>
                  </a:lnTo>
                  <a:lnTo>
                    <a:pt x="2532" y="177"/>
                  </a:lnTo>
                  <a:lnTo>
                    <a:pt x="2533" y="181"/>
                  </a:lnTo>
                  <a:lnTo>
                    <a:pt x="2534" y="179"/>
                  </a:lnTo>
                  <a:lnTo>
                    <a:pt x="2535" y="170"/>
                  </a:lnTo>
                  <a:lnTo>
                    <a:pt x="2536" y="166"/>
                  </a:lnTo>
                  <a:lnTo>
                    <a:pt x="2536" y="150"/>
                  </a:lnTo>
                  <a:lnTo>
                    <a:pt x="2537" y="149"/>
                  </a:lnTo>
                  <a:lnTo>
                    <a:pt x="2538" y="138"/>
                  </a:lnTo>
                  <a:lnTo>
                    <a:pt x="2539" y="128"/>
                  </a:lnTo>
                  <a:lnTo>
                    <a:pt x="2540" y="129"/>
                  </a:lnTo>
                  <a:lnTo>
                    <a:pt x="2541" y="121"/>
                  </a:lnTo>
                  <a:lnTo>
                    <a:pt x="2542" y="113"/>
                  </a:lnTo>
                  <a:lnTo>
                    <a:pt x="2543" y="110"/>
                  </a:lnTo>
                  <a:lnTo>
                    <a:pt x="2543" y="108"/>
                  </a:lnTo>
                  <a:lnTo>
                    <a:pt x="2544" y="99"/>
                  </a:lnTo>
                  <a:lnTo>
                    <a:pt x="2545" y="94"/>
                  </a:lnTo>
                  <a:lnTo>
                    <a:pt x="2546" y="91"/>
                  </a:lnTo>
                  <a:lnTo>
                    <a:pt x="2547" y="96"/>
                  </a:lnTo>
                  <a:lnTo>
                    <a:pt x="2548" y="88"/>
                  </a:lnTo>
                  <a:lnTo>
                    <a:pt x="2549" y="87"/>
                  </a:lnTo>
                  <a:lnTo>
                    <a:pt x="2550" y="84"/>
                  </a:lnTo>
                  <a:lnTo>
                    <a:pt x="2551" y="80"/>
                  </a:lnTo>
                  <a:lnTo>
                    <a:pt x="2551" y="77"/>
                  </a:lnTo>
                  <a:lnTo>
                    <a:pt x="2552" y="77"/>
                  </a:lnTo>
                  <a:lnTo>
                    <a:pt x="2553" y="74"/>
                  </a:lnTo>
                  <a:lnTo>
                    <a:pt x="2554" y="73"/>
                  </a:lnTo>
                  <a:lnTo>
                    <a:pt x="2555" y="73"/>
                  </a:lnTo>
                  <a:lnTo>
                    <a:pt x="2556" y="76"/>
                  </a:lnTo>
                  <a:lnTo>
                    <a:pt x="2557" y="73"/>
                  </a:lnTo>
                  <a:lnTo>
                    <a:pt x="2558" y="70"/>
                  </a:lnTo>
                  <a:lnTo>
                    <a:pt x="2558" y="73"/>
                  </a:lnTo>
                  <a:lnTo>
                    <a:pt x="2559" y="81"/>
                  </a:lnTo>
                  <a:lnTo>
                    <a:pt x="2560" y="80"/>
                  </a:lnTo>
                  <a:lnTo>
                    <a:pt x="2561" y="94"/>
                  </a:lnTo>
                  <a:lnTo>
                    <a:pt x="2562" y="106"/>
                  </a:lnTo>
                  <a:lnTo>
                    <a:pt x="2563" y="115"/>
                  </a:lnTo>
                  <a:lnTo>
                    <a:pt x="2564" y="127"/>
                  </a:lnTo>
                  <a:lnTo>
                    <a:pt x="2565" y="144"/>
                  </a:lnTo>
                  <a:lnTo>
                    <a:pt x="2566" y="166"/>
                  </a:lnTo>
                  <a:lnTo>
                    <a:pt x="2566" y="171"/>
                  </a:lnTo>
                  <a:lnTo>
                    <a:pt x="2567" y="177"/>
                  </a:lnTo>
                  <a:lnTo>
                    <a:pt x="2568" y="188"/>
                  </a:lnTo>
                  <a:lnTo>
                    <a:pt x="2569" y="181"/>
                  </a:lnTo>
                  <a:lnTo>
                    <a:pt x="2570" y="181"/>
                  </a:lnTo>
                  <a:lnTo>
                    <a:pt x="2571" y="174"/>
                  </a:lnTo>
                  <a:lnTo>
                    <a:pt x="2572" y="175"/>
                  </a:lnTo>
                  <a:lnTo>
                    <a:pt x="2573" y="177"/>
                  </a:lnTo>
                  <a:lnTo>
                    <a:pt x="2573" y="178"/>
                  </a:lnTo>
                  <a:lnTo>
                    <a:pt x="2574" y="186"/>
                  </a:lnTo>
                  <a:lnTo>
                    <a:pt x="2575" y="183"/>
                  </a:lnTo>
                  <a:lnTo>
                    <a:pt x="2576" y="183"/>
                  </a:lnTo>
                  <a:lnTo>
                    <a:pt x="2577" y="180"/>
                  </a:lnTo>
                  <a:lnTo>
                    <a:pt x="2578" y="176"/>
                  </a:lnTo>
                  <a:lnTo>
                    <a:pt x="2579" y="170"/>
                  </a:lnTo>
                  <a:lnTo>
                    <a:pt x="2580" y="166"/>
                  </a:lnTo>
                  <a:lnTo>
                    <a:pt x="2581" y="155"/>
                  </a:lnTo>
                  <a:lnTo>
                    <a:pt x="2581" y="153"/>
                  </a:lnTo>
                  <a:lnTo>
                    <a:pt x="2582" y="147"/>
                  </a:lnTo>
                  <a:lnTo>
                    <a:pt x="2583" y="135"/>
                  </a:lnTo>
                  <a:lnTo>
                    <a:pt x="2584" y="129"/>
                  </a:lnTo>
                  <a:lnTo>
                    <a:pt x="2585" y="119"/>
                  </a:lnTo>
                  <a:lnTo>
                    <a:pt x="2586" y="117"/>
                  </a:lnTo>
                  <a:lnTo>
                    <a:pt x="2587" y="101"/>
                  </a:lnTo>
                  <a:lnTo>
                    <a:pt x="2588" y="96"/>
                  </a:lnTo>
                  <a:lnTo>
                    <a:pt x="2588" y="94"/>
                  </a:lnTo>
                  <a:lnTo>
                    <a:pt x="2589" y="90"/>
                  </a:lnTo>
                  <a:lnTo>
                    <a:pt x="2590" y="86"/>
                  </a:lnTo>
                  <a:lnTo>
                    <a:pt x="2591" y="85"/>
                  </a:lnTo>
                  <a:lnTo>
                    <a:pt x="2592" y="77"/>
                  </a:lnTo>
                  <a:lnTo>
                    <a:pt x="2593" y="77"/>
                  </a:lnTo>
                  <a:lnTo>
                    <a:pt x="2594" y="78"/>
                  </a:lnTo>
                  <a:lnTo>
                    <a:pt x="2595" y="79"/>
                  </a:lnTo>
                  <a:lnTo>
                    <a:pt x="2596" y="80"/>
                  </a:lnTo>
                  <a:lnTo>
                    <a:pt x="2596" y="73"/>
                  </a:lnTo>
                  <a:lnTo>
                    <a:pt x="2597" y="77"/>
                  </a:lnTo>
                  <a:lnTo>
                    <a:pt x="2598" y="72"/>
                  </a:lnTo>
                  <a:lnTo>
                    <a:pt x="2599" y="73"/>
                  </a:lnTo>
                  <a:lnTo>
                    <a:pt x="2600" y="79"/>
                  </a:lnTo>
                  <a:lnTo>
                    <a:pt x="2601" y="72"/>
                  </a:lnTo>
                  <a:lnTo>
                    <a:pt x="2602" y="82"/>
                  </a:lnTo>
                  <a:lnTo>
                    <a:pt x="2603" y="69"/>
                  </a:lnTo>
                  <a:lnTo>
                    <a:pt x="2603" y="75"/>
                  </a:lnTo>
                  <a:lnTo>
                    <a:pt x="2604" y="68"/>
                  </a:lnTo>
                  <a:lnTo>
                    <a:pt x="2605" y="74"/>
                  </a:lnTo>
                  <a:lnTo>
                    <a:pt x="2606" y="74"/>
                  </a:lnTo>
                  <a:lnTo>
                    <a:pt x="2607" y="67"/>
                  </a:lnTo>
                  <a:lnTo>
                    <a:pt x="2608" y="70"/>
                  </a:lnTo>
                  <a:lnTo>
                    <a:pt x="2609" y="66"/>
                  </a:lnTo>
                  <a:lnTo>
                    <a:pt x="2610" y="63"/>
                  </a:lnTo>
                  <a:lnTo>
                    <a:pt x="2611" y="64"/>
                  </a:lnTo>
                  <a:lnTo>
                    <a:pt x="2611" y="59"/>
                  </a:lnTo>
                  <a:lnTo>
                    <a:pt x="2612" y="57"/>
                  </a:lnTo>
                  <a:lnTo>
                    <a:pt x="2613" y="57"/>
                  </a:lnTo>
                  <a:lnTo>
                    <a:pt x="2614" y="55"/>
                  </a:lnTo>
                  <a:lnTo>
                    <a:pt x="2615" y="56"/>
                  </a:lnTo>
                  <a:lnTo>
                    <a:pt x="2616" y="57"/>
                  </a:lnTo>
                  <a:lnTo>
                    <a:pt x="2617" y="57"/>
                  </a:lnTo>
                  <a:lnTo>
                    <a:pt x="2618" y="55"/>
                  </a:lnTo>
                  <a:lnTo>
                    <a:pt x="2618" y="50"/>
                  </a:lnTo>
                  <a:lnTo>
                    <a:pt x="2619" y="54"/>
                  </a:lnTo>
                  <a:lnTo>
                    <a:pt x="2620" y="52"/>
                  </a:lnTo>
                  <a:lnTo>
                    <a:pt x="2621" y="53"/>
                  </a:lnTo>
                  <a:lnTo>
                    <a:pt x="2622" y="50"/>
                  </a:lnTo>
                  <a:lnTo>
                    <a:pt x="2623" y="49"/>
                  </a:lnTo>
                  <a:lnTo>
                    <a:pt x="2624" y="54"/>
                  </a:lnTo>
                  <a:lnTo>
                    <a:pt x="2625" y="51"/>
                  </a:lnTo>
                  <a:lnTo>
                    <a:pt x="2625" y="54"/>
                  </a:lnTo>
                  <a:lnTo>
                    <a:pt x="2626" y="53"/>
                  </a:lnTo>
                  <a:lnTo>
                    <a:pt x="2627" y="55"/>
                  </a:lnTo>
                  <a:lnTo>
                    <a:pt x="2628" y="57"/>
                  </a:lnTo>
                  <a:lnTo>
                    <a:pt x="2629" y="61"/>
                  </a:lnTo>
                  <a:lnTo>
                    <a:pt x="2630" y="59"/>
                  </a:lnTo>
                  <a:lnTo>
                    <a:pt x="2631" y="57"/>
                  </a:lnTo>
                  <a:lnTo>
                    <a:pt x="2632" y="57"/>
                  </a:lnTo>
                  <a:lnTo>
                    <a:pt x="2633" y="56"/>
                  </a:lnTo>
                  <a:lnTo>
                    <a:pt x="2633" y="59"/>
                  </a:lnTo>
                  <a:lnTo>
                    <a:pt x="2634" y="58"/>
                  </a:lnTo>
                  <a:lnTo>
                    <a:pt x="2635" y="56"/>
                  </a:lnTo>
                  <a:lnTo>
                    <a:pt x="2636" y="61"/>
                  </a:lnTo>
                  <a:lnTo>
                    <a:pt x="2637" y="67"/>
                  </a:lnTo>
                  <a:lnTo>
                    <a:pt x="2638" y="68"/>
                  </a:lnTo>
                  <a:lnTo>
                    <a:pt x="2639" y="72"/>
                  </a:lnTo>
                  <a:lnTo>
                    <a:pt x="2640" y="78"/>
                  </a:lnTo>
                  <a:lnTo>
                    <a:pt x="2640" y="86"/>
                  </a:lnTo>
                  <a:lnTo>
                    <a:pt x="2641" y="92"/>
                  </a:lnTo>
                  <a:lnTo>
                    <a:pt x="2642" y="101"/>
                  </a:lnTo>
                  <a:lnTo>
                    <a:pt x="2643" y="99"/>
                  </a:lnTo>
                  <a:lnTo>
                    <a:pt x="2644" y="112"/>
                  </a:lnTo>
                  <a:lnTo>
                    <a:pt x="2645" y="108"/>
                  </a:lnTo>
                  <a:lnTo>
                    <a:pt x="2646" y="110"/>
                  </a:lnTo>
                  <a:lnTo>
                    <a:pt x="2647" y="102"/>
                  </a:lnTo>
                  <a:lnTo>
                    <a:pt x="2648" y="92"/>
                  </a:lnTo>
                  <a:lnTo>
                    <a:pt x="2648" y="85"/>
                  </a:lnTo>
                  <a:lnTo>
                    <a:pt x="2649" y="82"/>
                  </a:lnTo>
                  <a:lnTo>
                    <a:pt x="2650" y="70"/>
                  </a:lnTo>
                  <a:lnTo>
                    <a:pt x="2651" y="72"/>
                  </a:lnTo>
                  <a:lnTo>
                    <a:pt x="2652" y="63"/>
                  </a:lnTo>
                  <a:lnTo>
                    <a:pt x="2653" y="56"/>
                  </a:lnTo>
                  <a:lnTo>
                    <a:pt x="2654" y="52"/>
                  </a:lnTo>
                  <a:lnTo>
                    <a:pt x="2655" y="53"/>
                  </a:lnTo>
                  <a:lnTo>
                    <a:pt x="2655" y="44"/>
                  </a:lnTo>
                  <a:lnTo>
                    <a:pt x="2656" y="46"/>
                  </a:lnTo>
                  <a:lnTo>
                    <a:pt x="2657" y="54"/>
                  </a:lnTo>
                  <a:lnTo>
                    <a:pt x="2658" y="48"/>
                  </a:lnTo>
                  <a:lnTo>
                    <a:pt x="2659" y="48"/>
                  </a:lnTo>
                  <a:lnTo>
                    <a:pt x="2660" y="47"/>
                  </a:lnTo>
                  <a:lnTo>
                    <a:pt x="2661" y="48"/>
                  </a:lnTo>
                  <a:lnTo>
                    <a:pt x="2662" y="43"/>
                  </a:lnTo>
                  <a:lnTo>
                    <a:pt x="2663" y="44"/>
                  </a:lnTo>
                  <a:lnTo>
                    <a:pt x="2663" y="46"/>
                  </a:lnTo>
                  <a:lnTo>
                    <a:pt x="2664" y="41"/>
                  </a:lnTo>
                  <a:lnTo>
                    <a:pt x="2665" y="39"/>
                  </a:lnTo>
                  <a:lnTo>
                    <a:pt x="2666" y="38"/>
                  </a:lnTo>
                  <a:lnTo>
                    <a:pt x="2667" y="40"/>
                  </a:lnTo>
                  <a:lnTo>
                    <a:pt x="2668" y="38"/>
                  </a:lnTo>
                  <a:lnTo>
                    <a:pt x="2669" y="41"/>
                  </a:lnTo>
                  <a:lnTo>
                    <a:pt x="2670" y="38"/>
                  </a:lnTo>
                  <a:lnTo>
                    <a:pt x="2670" y="42"/>
                  </a:lnTo>
                  <a:lnTo>
                    <a:pt x="2671" y="44"/>
                  </a:lnTo>
                  <a:lnTo>
                    <a:pt x="2672" y="44"/>
                  </a:lnTo>
                  <a:lnTo>
                    <a:pt x="2673" y="43"/>
                  </a:lnTo>
                  <a:lnTo>
                    <a:pt x="2674" y="46"/>
                  </a:lnTo>
                  <a:lnTo>
                    <a:pt x="2675" y="47"/>
                  </a:lnTo>
                  <a:lnTo>
                    <a:pt x="2676" y="50"/>
                  </a:lnTo>
                  <a:lnTo>
                    <a:pt x="2677" y="52"/>
                  </a:lnTo>
                  <a:lnTo>
                    <a:pt x="2678" y="50"/>
                  </a:lnTo>
                  <a:lnTo>
                    <a:pt x="2678" y="52"/>
                  </a:lnTo>
                  <a:lnTo>
                    <a:pt x="2679" y="56"/>
                  </a:lnTo>
                  <a:lnTo>
                    <a:pt x="2680" y="55"/>
                  </a:lnTo>
                  <a:lnTo>
                    <a:pt x="2681" y="60"/>
                  </a:lnTo>
                  <a:lnTo>
                    <a:pt x="2682" y="47"/>
                  </a:lnTo>
                  <a:lnTo>
                    <a:pt x="2683" y="55"/>
                  </a:lnTo>
                  <a:lnTo>
                    <a:pt x="2684" y="50"/>
                  </a:lnTo>
                  <a:lnTo>
                    <a:pt x="2685" y="49"/>
                  </a:lnTo>
                  <a:lnTo>
                    <a:pt x="2685" y="50"/>
                  </a:lnTo>
                  <a:lnTo>
                    <a:pt x="2686" y="52"/>
                  </a:lnTo>
                  <a:lnTo>
                    <a:pt x="2687" y="52"/>
                  </a:lnTo>
                  <a:lnTo>
                    <a:pt x="2688" y="50"/>
                  </a:lnTo>
                  <a:lnTo>
                    <a:pt x="2689" y="50"/>
                  </a:lnTo>
                  <a:lnTo>
                    <a:pt x="2690" y="49"/>
                  </a:lnTo>
                  <a:lnTo>
                    <a:pt x="2691" y="52"/>
                  </a:lnTo>
                  <a:lnTo>
                    <a:pt x="2692" y="51"/>
                  </a:lnTo>
                  <a:lnTo>
                    <a:pt x="2693" y="58"/>
                  </a:lnTo>
                  <a:lnTo>
                    <a:pt x="2693" y="47"/>
                  </a:lnTo>
                  <a:lnTo>
                    <a:pt x="2694" y="49"/>
                  </a:lnTo>
                  <a:lnTo>
                    <a:pt x="2695" y="54"/>
                  </a:lnTo>
                  <a:lnTo>
                    <a:pt x="2696" y="46"/>
                  </a:lnTo>
                  <a:lnTo>
                    <a:pt x="2697" y="52"/>
                  </a:lnTo>
                  <a:lnTo>
                    <a:pt x="2698" y="52"/>
                  </a:lnTo>
                  <a:lnTo>
                    <a:pt x="2699" y="51"/>
                  </a:lnTo>
                  <a:lnTo>
                    <a:pt x="2700" y="49"/>
                  </a:lnTo>
                  <a:lnTo>
                    <a:pt x="2700" y="49"/>
                  </a:lnTo>
                  <a:lnTo>
                    <a:pt x="2701" y="53"/>
                  </a:lnTo>
                  <a:lnTo>
                    <a:pt x="2702" y="54"/>
                  </a:lnTo>
                  <a:lnTo>
                    <a:pt x="2703" y="48"/>
                  </a:lnTo>
                  <a:lnTo>
                    <a:pt x="2704" y="54"/>
                  </a:lnTo>
                  <a:lnTo>
                    <a:pt x="2705" y="54"/>
                  </a:lnTo>
                  <a:lnTo>
                    <a:pt x="2706" y="50"/>
                  </a:lnTo>
                  <a:lnTo>
                    <a:pt x="2707" y="54"/>
                  </a:lnTo>
                  <a:lnTo>
                    <a:pt x="2708" y="47"/>
                  </a:lnTo>
                  <a:lnTo>
                    <a:pt x="2708" y="47"/>
                  </a:lnTo>
                  <a:lnTo>
                    <a:pt x="2709" y="45"/>
                  </a:lnTo>
                  <a:lnTo>
                    <a:pt x="2710" y="39"/>
                  </a:lnTo>
                  <a:lnTo>
                    <a:pt x="2711" y="46"/>
                  </a:lnTo>
                  <a:lnTo>
                    <a:pt x="2712" y="43"/>
                  </a:lnTo>
                  <a:lnTo>
                    <a:pt x="2713" y="40"/>
                  </a:lnTo>
                  <a:lnTo>
                    <a:pt x="2714" y="42"/>
                  </a:lnTo>
                  <a:lnTo>
                    <a:pt x="2715" y="36"/>
                  </a:lnTo>
                  <a:lnTo>
                    <a:pt x="2715" y="41"/>
                  </a:lnTo>
                  <a:lnTo>
                    <a:pt x="2716" y="38"/>
                  </a:lnTo>
                  <a:lnTo>
                    <a:pt x="2717" y="35"/>
                  </a:lnTo>
                  <a:lnTo>
                    <a:pt x="2718" y="37"/>
                  </a:lnTo>
                  <a:lnTo>
                    <a:pt x="2719" y="39"/>
                  </a:lnTo>
                  <a:lnTo>
                    <a:pt x="2720" y="40"/>
                  </a:lnTo>
                  <a:lnTo>
                    <a:pt x="2721" y="37"/>
                  </a:lnTo>
                  <a:lnTo>
                    <a:pt x="2722" y="39"/>
                  </a:lnTo>
                  <a:lnTo>
                    <a:pt x="2723" y="40"/>
                  </a:lnTo>
                  <a:lnTo>
                    <a:pt x="2723" y="38"/>
                  </a:lnTo>
                  <a:lnTo>
                    <a:pt x="2724" y="38"/>
                  </a:lnTo>
                  <a:lnTo>
                    <a:pt x="2725" y="41"/>
                  </a:lnTo>
                  <a:lnTo>
                    <a:pt x="2726" y="39"/>
                  </a:lnTo>
                  <a:lnTo>
                    <a:pt x="2727" y="38"/>
                  </a:lnTo>
                  <a:lnTo>
                    <a:pt x="2728" y="42"/>
                  </a:lnTo>
                  <a:lnTo>
                    <a:pt x="2729" y="42"/>
                  </a:lnTo>
                  <a:lnTo>
                    <a:pt x="2730" y="45"/>
                  </a:lnTo>
                  <a:lnTo>
                    <a:pt x="2730" y="42"/>
                  </a:lnTo>
                  <a:lnTo>
                    <a:pt x="2731" y="40"/>
                  </a:lnTo>
                  <a:lnTo>
                    <a:pt x="2732" y="41"/>
                  </a:lnTo>
                  <a:lnTo>
                    <a:pt x="2733" y="40"/>
                  </a:lnTo>
                  <a:lnTo>
                    <a:pt x="2734" y="45"/>
                  </a:lnTo>
                  <a:lnTo>
                    <a:pt x="2735" y="42"/>
                  </a:lnTo>
                  <a:lnTo>
                    <a:pt x="2736" y="45"/>
                  </a:lnTo>
                  <a:lnTo>
                    <a:pt x="2737" y="43"/>
                  </a:lnTo>
                  <a:lnTo>
                    <a:pt x="2738" y="43"/>
                  </a:lnTo>
                  <a:lnTo>
                    <a:pt x="2738" y="43"/>
                  </a:lnTo>
                  <a:lnTo>
                    <a:pt x="2739" y="39"/>
                  </a:lnTo>
                  <a:lnTo>
                    <a:pt x="2740" y="40"/>
                  </a:lnTo>
                  <a:lnTo>
                    <a:pt x="2741" y="39"/>
                  </a:lnTo>
                  <a:lnTo>
                    <a:pt x="2742" y="41"/>
                  </a:lnTo>
                  <a:lnTo>
                    <a:pt x="2743" y="39"/>
                  </a:lnTo>
                  <a:lnTo>
                    <a:pt x="2744" y="42"/>
                  </a:lnTo>
                  <a:lnTo>
                    <a:pt x="2745" y="41"/>
                  </a:lnTo>
                  <a:lnTo>
                    <a:pt x="2745" y="40"/>
                  </a:lnTo>
                  <a:lnTo>
                    <a:pt x="2746" y="34"/>
                  </a:lnTo>
                  <a:lnTo>
                    <a:pt x="2747" y="35"/>
                  </a:lnTo>
                  <a:lnTo>
                    <a:pt x="2748" y="38"/>
                  </a:lnTo>
                  <a:lnTo>
                    <a:pt x="2749" y="38"/>
                  </a:lnTo>
                  <a:lnTo>
                    <a:pt x="2750" y="36"/>
                  </a:lnTo>
                  <a:lnTo>
                    <a:pt x="2751" y="38"/>
                  </a:lnTo>
                  <a:lnTo>
                    <a:pt x="2752" y="32"/>
                  </a:lnTo>
                  <a:lnTo>
                    <a:pt x="2753" y="38"/>
                  </a:lnTo>
                  <a:lnTo>
                    <a:pt x="2753" y="41"/>
                  </a:lnTo>
                  <a:lnTo>
                    <a:pt x="2754" y="38"/>
                  </a:lnTo>
                  <a:lnTo>
                    <a:pt x="2755" y="43"/>
                  </a:lnTo>
                  <a:lnTo>
                    <a:pt x="2756" y="37"/>
                  </a:lnTo>
                  <a:lnTo>
                    <a:pt x="2757" y="46"/>
                  </a:lnTo>
                  <a:lnTo>
                    <a:pt x="2758" y="35"/>
                  </a:lnTo>
                  <a:lnTo>
                    <a:pt x="2759" y="41"/>
                  </a:lnTo>
                  <a:lnTo>
                    <a:pt x="2760" y="39"/>
                  </a:lnTo>
                  <a:lnTo>
                    <a:pt x="2760" y="40"/>
                  </a:lnTo>
                  <a:lnTo>
                    <a:pt x="2761" y="39"/>
                  </a:lnTo>
                  <a:lnTo>
                    <a:pt x="2762" y="46"/>
                  </a:lnTo>
                  <a:lnTo>
                    <a:pt x="2763" y="40"/>
                  </a:lnTo>
                  <a:lnTo>
                    <a:pt x="2764" y="44"/>
                  </a:lnTo>
                  <a:lnTo>
                    <a:pt x="2765" y="45"/>
                  </a:lnTo>
                  <a:lnTo>
                    <a:pt x="2766" y="40"/>
                  </a:lnTo>
                  <a:lnTo>
                    <a:pt x="2767" y="36"/>
                  </a:lnTo>
                  <a:lnTo>
                    <a:pt x="2768" y="38"/>
                  </a:lnTo>
                  <a:lnTo>
                    <a:pt x="2768" y="38"/>
                  </a:lnTo>
                  <a:lnTo>
                    <a:pt x="2769" y="39"/>
                  </a:lnTo>
                  <a:lnTo>
                    <a:pt x="2770" y="38"/>
                  </a:lnTo>
                  <a:lnTo>
                    <a:pt x="2771" y="39"/>
                  </a:lnTo>
                  <a:lnTo>
                    <a:pt x="2772" y="38"/>
                  </a:lnTo>
                  <a:lnTo>
                    <a:pt x="2773" y="43"/>
                  </a:lnTo>
                  <a:lnTo>
                    <a:pt x="2774" y="41"/>
                  </a:lnTo>
                  <a:lnTo>
                    <a:pt x="2775" y="36"/>
                  </a:lnTo>
                  <a:lnTo>
                    <a:pt x="2775" y="36"/>
                  </a:lnTo>
                  <a:lnTo>
                    <a:pt x="2776" y="35"/>
                  </a:lnTo>
                  <a:lnTo>
                    <a:pt x="2777" y="34"/>
                  </a:lnTo>
                  <a:lnTo>
                    <a:pt x="2778" y="32"/>
                  </a:lnTo>
                  <a:lnTo>
                    <a:pt x="2779" y="35"/>
                  </a:lnTo>
                  <a:lnTo>
                    <a:pt x="2780" y="31"/>
                  </a:lnTo>
                  <a:lnTo>
                    <a:pt x="2781" y="34"/>
                  </a:lnTo>
                  <a:lnTo>
                    <a:pt x="2782" y="34"/>
                  </a:lnTo>
                  <a:lnTo>
                    <a:pt x="2783" y="34"/>
                  </a:lnTo>
                  <a:lnTo>
                    <a:pt x="2783" y="36"/>
                  </a:lnTo>
                  <a:lnTo>
                    <a:pt x="2784" y="30"/>
                  </a:lnTo>
                  <a:lnTo>
                    <a:pt x="2785" y="35"/>
                  </a:lnTo>
                  <a:lnTo>
                    <a:pt x="2786" y="31"/>
                  </a:lnTo>
                  <a:lnTo>
                    <a:pt x="2787" y="35"/>
                  </a:lnTo>
                  <a:lnTo>
                    <a:pt x="2788" y="33"/>
                  </a:lnTo>
                  <a:lnTo>
                    <a:pt x="2789" y="34"/>
                  </a:lnTo>
                  <a:lnTo>
                    <a:pt x="2790" y="37"/>
                  </a:lnTo>
                  <a:lnTo>
                    <a:pt x="2790" y="35"/>
                  </a:lnTo>
                  <a:lnTo>
                    <a:pt x="2791" y="40"/>
                  </a:lnTo>
                  <a:lnTo>
                    <a:pt x="2792" y="35"/>
                  </a:lnTo>
                  <a:lnTo>
                    <a:pt x="2793" y="36"/>
                  </a:lnTo>
                  <a:lnTo>
                    <a:pt x="2794" y="41"/>
                  </a:lnTo>
                  <a:lnTo>
                    <a:pt x="2795" y="34"/>
                  </a:lnTo>
                  <a:lnTo>
                    <a:pt x="2796" y="35"/>
                  </a:lnTo>
                  <a:lnTo>
                    <a:pt x="2797" y="36"/>
                  </a:lnTo>
                  <a:lnTo>
                    <a:pt x="2798" y="35"/>
                  </a:lnTo>
                  <a:lnTo>
                    <a:pt x="2798" y="34"/>
                  </a:lnTo>
                  <a:lnTo>
                    <a:pt x="2799" y="37"/>
                  </a:lnTo>
                  <a:lnTo>
                    <a:pt x="2800" y="37"/>
                  </a:lnTo>
                  <a:lnTo>
                    <a:pt x="2801" y="37"/>
                  </a:lnTo>
                  <a:lnTo>
                    <a:pt x="2802" y="40"/>
                  </a:lnTo>
                  <a:lnTo>
                    <a:pt x="2803" y="36"/>
                  </a:lnTo>
                  <a:lnTo>
                    <a:pt x="2804" y="38"/>
                  </a:lnTo>
                  <a:lnTo>
                    <a:pt x="2805" y="36"/>
                  </a:lnTo>
                  <a:lnTo>
                    <a:pt x="2805" y="39"/>
                  </a:lnTo>
                  <a:lnTo>
                    <a:pt x="2806" y="34"/>
                  </a:lnTo>
                  <a:lnTo>
                    <a:pt x="2807" y="40"/>
                  </a:lnTo>
                  <a:lnTo>
                    <a:pt x="2808" y="35"/>
                  </a:lnTo>
                  <a:lnTo>
                    <a:pt x="2809" y="37"/>
                  </a:lnTo>
                  <a:lnTo>
                    <a:pt x="2810" y="39"/>
                  </a:lnTo>
                  <a:lnTo>
                    <a:pt x="2811" y="39"/>
                  </a:lnTo>
                  <a:lnTo>
                    <a:pt x="2812" y="35"/>
                  </a:lnTo>
                  <a:lnTo>
                    <a:pt x="2813" y="37"/>
                  </a:lnTo>
                  <a:lnTo>
                    <a:pt x="2813" y="34"/>
                  </a:lnTo>
                  <a:lnTo>
                    <a:pt x="2814" y="40"/>
                  </a:lnTo>
                  <a:lnTo>
                    <a:pt x="2815" y="39"/>
                  </a:lnTo>
                  <a:lnTo>
                    <a:pt x="2816" y="41"/>
                  </a:lnTo>
                  <a:lnTo>
                    <a:pt x="2817" y="38"/>
                  </a:lnTo>
                  <a:lnTo>
                    <a:pt x="2818" y="42"/>
                  </a:lnTo>
                  <a:lnTo>
                    <a:pt x="2819" y="38"/>
                  </a:lnTo>
                  <a:lnTo>
                    <a:pt x="2820" y="37"/>
                  </a:lnTo>
                  <a:lnTo>
                    <a:pt x="2820" y="35"/>
                  </a:lnTo>
                  <a:lnTo>
                    <a:pt x="2821" y="37"/>
                  </a:lnTo>
                  <a:lnTo>
                    <a:pt x="2822" y="38"/>
                  </a:lnTo>
                  <a:lnTo>
                    <a:pt x="2823" y="32"/>
                  </a:lnTo>
                  <a:lnTo>
                    <a:pt x="2824" y="31"/>
                  </a:lnTo>
                  <a:lnTo>
                    <a:pt x="2825" y="36"/>
                  </a:lnTo>
                  <a:lnTo>
                    <a:pt x="2826" y="35"/>
                  </a:lnTo>
                  <a:lnTo>
                    <a:pt x="2827" y="36"/>
                  </a:lnTo>
                  <a:lnTo>
                    <a:pt x="2827" y="37"/>
                  </a:lnTo>
                  <a:lnTo>
                    <a:pt x="2828" y="39"/>
                  </a:lnTo>
                  <a:lnTo>
                    <a:pt x="2829" y="36"/>
                  </a:lnTo>
                  <a:lnTo>
                    <a:pt x="2830" y="39"/>
                  </a:lnTo>
                  <a:lnTo>
                    <a:pt x="2831" y="37"/>
                  </a:lnTo>
                  <a:lnTo>
                    <a:pt x="2832" y="33"/>
                  </a:lnTo>
                  <a:lnTo>
                    <a:pt x="2833" y="31"/>
                  </a:lnTo>
                  <a:lnTo>
                    <a:pt x="2834" y="35"/>
                  </a:lnTo>
                  <a:lnTo>
                    <a:pt x="2835" y="37"/>
                  </a:lnTo>
                  <a:lnTo>
                    <a:pt x="2835" y="32"/>
                  </a:lnTo>
                  <a:lnTo>
                    <a:pt x="2836" y="34"/>
                  </a:lnTo>
                  <a:lnTo>
                    <a:pt x="2837" y="30"/>
                  </a:lnTo>
                  <a:lnTo>
                    <a:pt x="2838" y="34"/>
                  </a:lnTo>
                  <a:lnTo>
                    <a:pt x="2839" y="36"/>
                  </a:lnTo>
                  <a:lnTo>
                    <a:pt x="2840" y="35"/>
                  </a:lnTo>
                  <a:lnTo>
                    <a:pt x="2841" y="30"/>
                  </a:lnTo>
                  <a:lnTo>
                    <a:pt x="2842" y="30"/>
                  </a:lnTo>
                  <a:lnTo>
                    <a:pt x="2842" y="36"/>
                  </a:lnTo>
                  <a:lnTo>
                    <a:pt x="2843" y="32"/>
                  </a:lnTo>
                  <a:lnTo>
                    <a:pt x="2844" y="36"/>
                  </a:lnTo>
                  <a:lnTo>
                    <a:pt x="2845" y="36"/>
                  </a:lnTo>
                  <a:lnTo>
                    <a:pt x="2846" y="35"/>
                  </a:lnTo>
                  <a:lnTo>
                    <a:pt x="2847" y="33"/>
                  </a:lnTo>
                  <a:lnTo>
                    <a:pt x="2848" y="31"/>
                  </a:lnTo>
                  <a:lnTo>
                    <a:pt x="2849" y="28"/>
                  </a:lnTo>
                  <a:lnTo>
                    <a:pt x="2850" y="33"/>
                  </a:lnTo>
                  <a:lnTo>
                    <a:pt x="2850" y="31"/>
                  </a:lnTo>
                  <a:lnTo>
                    <a:pt x="2851" y="31"/>
                  </a:lnTo>
                  <a:lnTo>
                    <a:pt x="2852" y="32"/>
                  </a:lnTo>
                  <a:lnTo>
                    <a:pt x="2853" y="30"/>
                  </a:lnTo>
                  <a:lnTo>
                    <a:pt x="2854" y="34"/>
                  </a:lnTo>
                  <a:lnTo>
                    <a:pt x="2855" y="29"/>
                  </a:lnTo>
                  <a:lnTo>
                    <a:pt x="2856" y="32"/>
                  </a:lnTo>
                  <a:lnTo>
                    <a:pt x="2857" y="28"/>
                  </a:lnTo>
                  <a:lnTo>
                    <a:pt x="2857" y="31"/>
                  </a:lnTo>
                  <a:lnTo>
                    <a:pt x="2858" y="32"/>
                  </a:lnTo>
                  <a:lnTo>
                    <a:pt x="2859" y="34"/>
                  </a:lnTo>
                  <a:lnTo>
                    <a:pt x="2860" y="34"/>
                  </a:lnTo>
                  <a:lnTo>
                    <a:pt x="2861" y="33"/>
                  </a:lnTo>
                  <a:lnTo>
                    <a:pt x="2862" y="31"/>
                  </a:lnTo>
                  <a:lnTo>
                    <a:pt x="2863" y="29"/>
                  </a:lnTo>
                  <a:lnTo>
                    <a:pt x="2864" y="35"/>
                  </a:lnTo>
                  <a:lnTo>
                    <a:pt x="2865" y="34"/>
                  </a:lnTo>
                  <a:lnTo>
                    <a:pt x="2865" y="31"/>
                  </a:lnTo>
                  <a:lnTo>
                    <a:pt x="2866" y="33"/>
                  </a:lnTo>
                  <a:lnTo>
                    <a:pt x="2867" y="38"/>
                  </a:lnTo>
                  <a:lnTo>
                    <a:pt x="2868" y="40"/>
                  </a:lnTo>
                  <a:lnTo>
                    <a:pt x="2869" y="31"/>
                  </a:lnTo>
                  <a:lnTo>
                    <a:pt x="2870" y="41"/>
                  </a:lnTo>
                  <a:lnTo>
                    <a:pt x="2871" y="35"/>
                  </a:lnTo>
                  <a:lnTo>
                    <a:pt x="2872" y="41"/>
                  </a:lnTo>
                  <a:lnTo>
                    <a:pt x="2872" y="44"/>
                  </a:lnTo>
                  <a:lnTo>
                    <a:pt x="2873" y="40"/>
                  </a:lnTo>
                  <a:lnTo>
                    <a:pt x="2874" y="43"/>
                  </a:lnTo>
                  <a:lnTo>
                    <a:pt x="2875" y="40"/>
                  </a:lnTo>
                  <a:lnTo>
                    <a:pt x="2876" y="41"/>
                  </a:lnTo>
                  <a:lnTo>
                    <a:pt x="2877" y="44"/>
                  </a:lnTo>
                  <a:lnTo>
                    <a:pt x="2878" y="43"/>
                  </a:lnTo>
                  <a:lnTo>
                    <a:pt x="2879" y="45"/>
                  </a:lnTo>
                  <a:lnTo>
                    <a:pt x="2880" y="42"/>
                  </a:lnTo>
                  <a:lnTo>
                    <a:pt x="2880" y="43"/>
                  </a:lnTo>
                  <a:lnTo>
                    <a:pt x="2881" y="41"/>
                  </a:lnTo>
                  <a:lnTo>
                    <a:pt x="2882" y="42"/>
                  </a:lnTo>
                  <a:lnTo>
                    <a:pt x="2883" y="47"/>
                  </a:lnTo>
                  <a:lnTo>
                    <a:pt x="2884" y="50"/>
                  </a:lnTo>
                  <a:lnTo>
                    <a:pt x="2885" y="51"/>
                  </a:lnTo>
                  <a:lnTo>
                    <a:pt x="2886" y="48"/>
                  </a:lnTo>
                  <a:lnTo>
                    <a:pt x="2887" y="46"/>
                  </a:lnTo>
                  <a:lnTo>
                    <a:pt x="2887" y="44"/>
                  </a:lnTo>
                  <a:lnTo>
                    <a:pt x="2888" y="50"/>
                  </a:lnTo>
                  <a:lnTo>
                    <a:pt x="2889" y="52"/>
                  </a:lnTo>
                  <a:lnTo>
                    <a:pt x="2890" y="47"/>
                  </a:lnTo>
                  <a:lnTo>
                    <a:pt x="2891" y="47"/>
                  </a:lnTo>
                  <a:lnTo>
                    <a:pt x="2892" y="51"/>
                  </a:lnTo>
                  <a:lnTo>
                    <a:pt x="2893" y="43"/>
                  </a:lnTo>
                  <a:lnTo>
                    <a:pt x="2894" y="46"/>
                  </a:lnTo>
                  <a:lnTo>
                    <a:pt x="2895" y="37"/>
                  </a:lnTo>
                  <a:lnTo>
                    <a:pt x="2895" y="40"/>
                  </a:lnTo>
                  <a:lnTo>
                    <a:pt x="2896" y="39"/>
                  </a:lnTo>
                  <a:lnTo>
                    <a:pt x="2897" y="39"/>
                  </a:lnTo>
                  <a:lnTo>
                    <a:pt x="2898" y="39"/>
                  </a:lnTo>
                  <a:lnTo>
                    <a:pt x="2899" y="42"/>
                  </a:lnTo>
                  <a:lnTo>
                    <a:pt x="2900" y="36"/>
                  </a:lnTo>
                  <a:lnTo>
                    <a:pt x="2901" y="39"/>
                  </a:lnTo>
                  <a:lnTo>
                    <a:pt x="2902" y="39"/>
                  </a:lnTo>
                  <a:lnTo>
                    <a:pt x="2902" y="35"/>
                  </a:lnTo>
                  <a:lnTo>
                    <a:pt x="2903" y="37"/>
                  </a:lnTo>
                  <a:lnTo>
                    <a:pt x="2904" y="34"/>
                  </a:lnTo>
                  <a:lnTo>
                    <a:pt x="2905" y="32"/>
                  </a:lnTo>
                  <a:lnTo>
                    <a:pt x="2906" y="37"/>
                  </a:lnTo>
                  <a:lnTo>
                    <a:pt x="2907" y="37"/>
                  </a:lnTo>
                  <a:lnTo>
                    <a:pt x="2908" y="38"/>
                  </a:lnTo>
                  <a:lnTo>
                    <a:pt x="2909" y="35"/>
                  </a:lnTo>
                  <a:lnTo>
                    <a:pt x="2910" y="35"/>
                  </a:lnTo>
                  <a:lnTo>
                    <a:pt x="2910" y="39"/>
                  </a:lnTo>
                  <a:lnTo>
                    <a:pt x="2911" y="36"/>
                  </a:lnTo>
                  <a:lnTo>
                    <a:pt x="2912" y="36"/>
                  </a:lnTo>
                  <a:lnTo>
                    <a:pt x="2913" y="38"/>
                  </a:lnTo>
                  <a:lnTo>
                    <a:pt x="2914" y="37"/>
                  </a:lnTo>
                  <a:lnTo>
                    <a:pt x="2915" y="33"/>
                  </a:lnTo>
                  <a:lnTo>
                    <a:pt x="2916" y="38"/>
                  </a:lnTo>
                  <a:lnTo>
                    <a:pt x="2917" y="33"/>
                  </a:lnTo>
                  <a:lnTo>
                    <a:pt x="2917" y="36"/>
                  </a:lnTo>
                  <a:lnTo>
                    <a:pt x="2918" y="38"/>
                  </a:lnTo>
                  <a:lnTo>
                    <a:pt x="2919" y="30"/>
                  </a:lnTo>
                  <a:lnTo>
                    <a:pt x="2920" y="31"/>
                  </a:lnTo>
                  <a:lnTo>
                    <a:pt x="2921" y="36"/>
                  </a:lnTo>
                  <a:lnTo>
                    <a:pt x="2922" y="37"/>
                  </a:lnTo>
                  <a:lnTo>
                    <a:pt x="2923" y="37"/>
                  </a:lnTo>
                  <a:lnTo>
                    <a:pt x="2924" y="32"/>
                  </a:lnTo>
                  <a:lnTo>
                    <a:pt x="2925" y="30"/>
                  </a:lnTo>
                  <a:lnTo>
                    <a:pt x="2925" y="35"/>
                  </a:lnTo>
                  <a:lnTo>
                    <a:pt x="2926" y="33"/>
                  </a:lnTo>
                  <a:lnTo>
                    <a:pt x="2927" y="32"/>
                  </a:lnTo>
                  <a:lnTo>
                    <a:pt x="2928" y="30"/>
                  </a:lnTo>
                  <a:lnTo>
                    <a:pt x="2929" y="37"/>
                  </a:lnTo>
                  <a:lnTo>
                    <a:pt x="2930" y="33"/>
                  </a:lnTo>
                  <a:lnTo>
                    <a:pt x="2931" y="32"/>
                  </a:lnTo>
                  <a:lnTo>
                    <a:pt x="2932" y="31"/>
                  </a:lnTo>
                  <a:lnTo>
                    <a:pt x="2932" y="32"/>
                  </a:lnTo>
                  <a:lnTo>
                    <a:pt x="2933" y="34"/>
                  </a:lnTo>
                  <a:lnTo>
                    <a:pt x="2934" y="37"/>
                  </a:lnTo>
                  <a:lnTo>
                    <a:pt x="2935" y="33"/>
                  </a:lnTo>
                  <a:lnTo>
                    <a:pt x="2936" y="33"/>
                  </a:lnTo>
                  <a:lnTo>
                    <a:pt x="2937" y="43"/>
                  </a:lnTo>
                  <a:lnTo>
                    <a:pt x="2938" y="34"/>
                  </a:lnTo>
                  <a:lnTo>
                    <a:pt x="2939" y="35"/>
                  </a:lnTo>
                  <a:lnTo>
                    <a:pt x="2940" y="32"/>
                  </a:lnTo>
                  <a:lnTo>
                    <a:pt x="2940" y="29"/>
                  </a:lnTo>
                  <a:lnTo>
                    <a:pt x="2941" y="32"/>
                  </a:lnTo>
                  <a:lnTo>
                    <a:pt x="2942" y="33"/>
                  </a:lnTo>
                  <a:lnTo>
                    <a:pt x="2943" y="31"/>
                  </a:lnTo>
                  <a:lnTo>
                    <a:pt x="2944" y="30"/>
                  </a:lnTo>
                  <a:lnTo>
                    <a:pt x="2945" y="33"/>
                  </a:lnTo>
                  <a:lnTo>
                    <a:pt x="2946" y="30"/>
                  </a:lnTo>
                  <a:lnTo>
                    <a:pt x="2947" y="33"/>
                  </a:lnTo>
                  <a:lnTo>
                    <a:pt x="2947" y="32"/>
                  </a:lnTo>
                  <a:lnTo>
                    <a:pt x="2948" y="29"/>
                  </a:lnTo>
                  <a:lnTo>
                    <a:pt x="2949" y="32"/>
                  </a:lnTo>
                  <a:lnTo>
                    <a:pt x="2950" y="37"/>
                  </a:lnTo>
                  <a:lnTo>
                    <a:pt x="2951" y="31"/>
                  </a:lnTo>
                  <a:lnTo>
                    <a:pt x="2952" y="32"/>
                  </a:lnTo>
                  <a:lnTo>
                    <a:pt x="2953" y="32"/>
                  </a:lnTo>
                  <a:lnTo>
                    <a:pt x="2954" y="31"/>
                  </a:lnTo>
                  <a:lnTo>
                    <a:pt x="2955" y="31"/>
                  </a:lnTo>
                  <a:lnTo>
                    <a:pt x="2955" y="32"/>
                  </a:lnTo>
                  <a:lnTo>
                    <a:pt x="2956" y="37"/>
                  </a:lnTo>
                  <a:lnTo>
                    <a:pt x="2957" y="43"/>
                  </a:lnTo>
                  <a:lnTo>
                    <a:pt x="2958" y="51"/>
                  </a:lnTo>
                  <a:lnTo>
                    <a:pt x="2959" y="62"/>
                  </a:lnTo>
                  <a:lnTo>
                    <a:pt x="2960" y="87"/>
                  </a:lnTo>
                  <a:lnTo>
                    <a:pt x="2961" y="103"/>
                  </a:lnTo>
                  <a:lnTo>
                    <a:pt x="2962" y="140"/>
                  </a:lnTo>
                  <a:lnTo>
                    <a:pt x="2962" y="186"/>
                  </a:lnTo>
                  <a:lnTo>
                    <a:pt x="2963" y="216"/>
                  </a:lnTo>
                  <a:lnTo>
                    <a:pt x="2964" y="251"/>
                  </a:lnTo>
                  <a:lnTo>
                    <a:pt x="2965" y="287"/>
                  </a:lnTo>
                  <a:lnTo>
                    <a:pt x="2966" y="305"/>
                  </a:lnTo>
                  <a:lnTo>
                    <a:pt x="2967" y="314"/>
                  </a:lnTo>
                  <a:lnTo>
                    <a:pt x="2968" y="309"/>
                  </a:lnTo>
                  <a:lnTo>
                    <a:pt x="2969" y="309"/>
                  </a:lnTo>
                  <a:lnTo>
                    <a:pt x="2970" y="277"/>
                  </a:lnTo>
                  <a:lnTo>
                    <a:pt x="2970" y="259"/>
                  </a:lnTo>
                  <a:lnTo>
                    <a:pt x="2971" y="231"/>
                  </a:lnTo>
                  <a:lnTo>
                    <a:pt x="2972" y="206"/>
                  </a:lnTo>
                  <a:lnTo>
                    <a:pt x="2973" y="181"/>
                  </a:lnTo>
                  <a:lnTo>
                    <a:pt x="2974" y="168"/>
                  </a:lnTo>
                  <a:lnTo>
                    <a:pt x="2975" y="156"/>
                  </a:lnTo>
                  <a:lnTo>
                    <a:pt x="2976" y="130"/>
                  </a:lnTo>
                  <a:lnTo>
                    <a:pt x="2977" y="129"/>
                  </a:lnTo>
                  <a:lnTo>
                    <a:pt x="2977" y="117"/>
                  </a:lnTo>
                  <a:lnTo>
                    <a:pt x="2978" y="109"/>
                  </a:lnTo>
                  <a:lnTo>
                    <a:pt x="2979" y="106"/>
                  </a:lnTo>
                  <a:lnTo>
                    <a:pt x="2980" y="107"/>
                  </a:lnTo>
                  <a:lnTo>
                    <a:pt x="2981" y="92"/>
                  </a:lnTo>
                  <a:lnTo>
                    <a:pt x="2982" y="80"/>
                  </a:lnTo>
                  <a:lnTo>
                    <a:pt x="2983" y="71"/>
                  </a:lnTo>
                  <a:lnTo>
                    <a:pt x="2984" y="68"/>
                  </a:lnTo>
                  <a:lnTo>
                    <a:pt x="2985" y="59"/>
                  </a:lnTo>
                  <a:lnTo>
                    <a:pt x="2985" y="54"/>
                  </a:lnTo>
                  <a:lnTo>
                    <a:pt x="2986" y="51"/>
                  </a:lnTo>
                  <a:lnTo>
                    <a:pt x="2987" y="48"/>
                  </a:lnTo>
                  <a:lnTo>
                    <a:pt x="2988" y="44"/>
                  </a:lnTo>
                  <a:lnTo>
                    <a:pt x="2989" y="39"/>
                  </a:lnTo>
                  <a:lnTo>
                    <a:pt x="2990" y="34"/>
                  </a:lnTo>
                  <a:lnTo>
                    <a:pt x="2991" y="40"/>
                  </a:lnTo>
                  <a:lnTo>
                    <a:pt x="2992" y="33"/>
                  </a:lnTo>
                  <a:lnTo>
                    <a:pt x="2992" y="37"/>
                  </a:lnTo>
                  <a:lnTo>
                    <a:pt x="2993" y="38"/>
                  </a:lnTo>
                  <a:lnTo>
                    <a:pt x="2994" y="37"/>
                  </a:lnTo>
                  <a:lnTo>
                    <a:pt x="2995" y="30"/>
                  </a:lnTo>
                  <a:lnTo>
                    <a:pt x="2996" y="32"/>
                  </a:lnTo>
                  <a:lnTo>
                    <a:pt x="2997" y="35"/>
                  </a:lnTo>
                  <a:lnTo>
                    <a:pt x="2998" y="33"/>
                  </a:lnTo>
                  <a:lnTo>
                    <a:pt x="2999" y="31"/>
                  </a:lnTo>
                  <a:lnTo>
                    <a:pt x="3000" y="33"/>
                  </a:lnTo>
                  <a:lnTo>
                    <a:pt x="3000" y="31"/>
                  </a:lnTo>
                  <a:lnTo>
                    <a:pt x="3001" y="25"/>
                  </a:lnTo>
                  <a:lnTo>
                    <a:pt x="3002" y="28"/>
                  </a:lnTo>
                  <a:lnTo>
                    <a:pt x="3003" y="26"/>
                  </a:lnTo>
                  <a:lnTo>
                    <a:pt x="3004" y="31"/>
                  </a:lnTo>
                  <a:lnTo>
                    <a:pt x="3005" y="31"/>
                  </a:lnTo>
                  <a:lnTo>
                    <a:pt x="3006" y="35"/>
                  </a:lnTo>
                  <a:lnTo>
                    <a:pt x="3007" y="30"/>
                  </a:lnTo>
                  <a:lnTo>
                    <a:pt x="3007" y="35"/>
                  </a:lnTo>
                  <a:lnTo>
                    <a:pt x="3008" y="33"/>
                  </a:lnTo>
                  <a:lnTo>
                    <a:pt x="3009" y="27"/>
                  </a:lnTo>
                  <a:lnTo>
                    <a:pt x="3010" y="29"/>
                  </a:lnTo>
                  <a:lnTo>
                    <a:pt x="3011" y="32"/>
                  </a:lnTo>
                  <a:lnTo>
                    <a:pt x="3012" y="34"/>
                  </a:lnTo>
                  <a:lnTo>
                    <a:pt x="3013" y="33"/>
                  </a:lnTo>
                  <a:lnTo>
                    <a:pt x="3014" y="31"/>
                  </a:lnTo>
                  <a:lnTo>
                    <a:pt x="3015" y="34"/>
                  </a:lnTo>
                  <a:lnTo>
                    <a:pt x="3015" y="30"/>
                  </a:lnTo>
                  <a:lnTo>
                    <a:pt x="3016" y="34"/>
                  </a:lnTo>
                  <a:lnTo>
                    <a:pt x="3017" y="32"/>
                  </a:lnTo>
                  <a:lnTo>
                    <a:pt x="3018" y="33"/>
                  </a:lnTo>
                  <a:lnTo>
                    <a:pt x="3019" y="28"/>
                  </a:lnTo>
                  <a:lnTo>
                    <a:pt x="3020" y="32"/>
                  </a:lnTo>
                  <a:lnTo>
                    <a:pt x="3021" y="31"/>
                  </a:lnTo>
                  <a:lnTo>
                    <a:pt x="3022" y="31"/>
                  </a:lnTo>
                  <a:lnTo>
                    <a:pt x="3022" y="35"/>
                  </a:lnTo>
                  <a:lnTo>
                    <a:pt x="3023" y="35"/>
                  </a:lnTo>
                  <a:lnTo>
                    <a:pt x="3024" y="32"/>
                  </a:lnTo>
                  <a:lnTo>
                    <a:pt x="3025" y="35"/>
                  </a:lnTo>
                  <a:lnTo>
                    <a:pt x="3026" y="37"/>
                  </a:lnTo>
                  <a:lnTo>
                    <a:pt x="3027" y="31"/>
                  </a:lnTo>
                  <a:lnTo>
                    <a:pt x="3028" y="36"/>
                  </a:lnTo>
                  <a:lnTo>
                    <a:pt x="3029" y="35"/>
                  </a:lnTo>
                  <a:lnTo>
                    <a:pt x="3029" y="36"/>
                  </a:lnTo>
                  <a:lnTo>
                    <a:pt x="3030" y="39"/>
                  </a:lnTo>
                  <a:lnTo>
                    <a:pt x="3031" y="33"/>
                  </a:lnTo>
                  <a:lnTo>
                    <a:pt x="3032" y="36"/>
                  </a:lnTo>
                  <a:lnTo>
                    <a:pt x="3033" y="39"/>
                  </a:lnTo>
                  <a:lnTo>
                    <a:pt x="3034" y="33"/>
                  </a:lnTo>
                  <a:lnTo>
                    <a:pt x="3035" y="33"/>
                  </a:lnTo>
                  <a:lnTo>
                    <a:pt x="3036" y="29"/>
                  </a:lnTo>
                  <a:lnTo>
                    <a:pt x="3037" y="34"/>
                  </a:lnTo>
                  <a:lnTo>
                    <a:pt x="3037" y="38"/>
                  </a:lnTo>
                  <a:lnTo>
                    <a:pt x="3038" y="39"/>
                  </a:lnTo>
                  <a:lnTo>
                    <a:pt x="3039" y="32"/>
                  </a:lnTo>
                  <a:lnTo>
                    <a:pt x="3040" y="41"/>
                  </a:lnTo>
                  <a:lnTo>
                    <a:pt x="3041" y="37"/>
                  </a:lnTo>
                  <a:lnTo>
                    <a:pt x="3042" y="38"/>
                  </a:lnTo>
                  <a:lnTo>
                    <a:pt x="3043" y="35"/>
                  </a:lnTo>
                  <a:lnTo>
                    <a:pt x="3044" y="33"/>
                  </a:lnTo>
                  <a:lnTo>
                    <a:pt x="3044" y="34"/>
                  </a:lnTo>
                  <a:lnTo>
                    <a:pt x="3045" y="31"/>
                  </a:lnTo>
                  <a:lnTo>
                    <a:pt x="3046" y="30"/>
                  </a:lnTo>
                  <a:lnTo>
                    <a:pt x="3047" y="28"/>
                  </a:lnTo>
                  <a:lnTo>
                    <a:pt x="3048" y="30"/>
                  </a:lnTo>
                  <a:lnTo>
                    <a:pt x="3049" y="32"/>
                  </a:lnTo>
                  <a:lnTo>
                    <a:pt x="3050" y="32"/>
                  </a:lnTo>
                  <a:lnTo>
                    <a:pt x="3051" y="30"/>
                  </a:lnTo>
                  <a:lnTo>
                    <a:pt x="3052" y="30"/>
                  </a:lnTo>
                  <a:lnTo>
                    <a:pt x="3052" y="34"/>
                  </a:lnTo>
                  <a:lnTo>
                    <a:pt x="3053" y="29"/>
                  </a:lnTo>
                  <a:lnTo>
                    <a:pt x="3054" y="28"/>
                  </a:lnTo>
                  <a:lnTo>
                    <a:pt x="3055" y="28"/>
                  </a:lnTo>
                  <a:lnTo>
                    <a:pt x="3056" y="33"/>
                  </a:lnTo>
                  <a:lnTo>
                    <a:pt x="3057" y="34"/>
                  </a:lnTo>
                  <a:lnTo>
                    <a:pt x="3058" y="27"/>
                  </a:lnTo>
                  <a:lnTo>
                    <a:pt x="3059" y="26"/>
                  </a:lnTo>
                  <a:lnTo>
                    <a:pt x="3059" y="29"/>
                  </a:lnTo>
                  <a:lnTo>
                    <a:pt x="3060" y="28"/>
                  </a:lnTo>
                  <a:lnTo>
                    <a:pt x="3061" y="30"/>
                  </a:lnTo>
                  <a:lnTo>
                    <a:pt x="3062" y="30"/>
                  </a:lnTo>
                  <a:lnTo>
                    <a:pt x="3063" y="33"/>
                  </a:lnTo>
                  <a:lnTo>
                    <a:pt x="3064" y="29"/>
                  </a:lnTo>
                  <a:lnTo>
                    <a:pt x="3065" y="28"/>
                  </a:lnTo>
                  <a:lnTo>
                    <a:pt x="3066" y="36"/>
                  </a:lnTo>
                  <a:lnTo>
                    <a:pt x="3067" y="28"/>
                  </a:lnTo>
                  <a:lnTo>
                    <a:pt x="3067" y="29"/>
                  </a:lnTo>
                  <a:lnTo>
                    <a:pt x="3068" y="25"/>
                  </a:lnTo>
                  <a:lnTo>
                    <a:pt x="3069" y="28"/>
                  </a:lnTo>
                  <a:lnTo>
                    <a:pt x="3070" y="25"/>
                  </a:lnTo>
                  <a:lnTo>
                    <a:pt x="3071" y="26"/>
                  </a:lnTo>
                  <a:lnTo>
                    <a:pt x="3072" y="25"/>
                  </a:lnTo>
                  <a:lnTo>
                    <a:pt x="3073" y="24"/>
                  </a:lnTo>
                  <a:lnTo>
                    <a:pt x="3074" y="23"/>
                  </a:lnTo>
                  <a:lnTo>
                    <a:pt x="3074" y="26"/>
                  </a:lnTo>
                  <a:lnTo>
                    <a:pt x="3075" y="26"/>
                  </a:lnTo>
                  <a:lnTo>
                    <a:pt x="3076" y="26"/>
                  </a:lnTo>
                  <a:lnTo>
                    <a:pt x="3077" y="27"/>
                  </a:lnTo>
                  <a:lnTo>
                    <a:pt x="3078" y="28"/>
                  </a:lnTo>
                  <a:lnTo>
                    <a:pt x="3079" y="27"/>
                  </a:lnTo>
                  <a:lnTo>
                    <a:pt x="3080" y="25"/>
                  </a:lnTo>
                  <a:lnTo>
                    <a:pt x="3081" y="25"/>
                  </a:lnTo>
                  <a:lnTo>
                    <a:pt x="3082" y="26"/>
                  </a:lnTo>
                  <a:lnTo>
                    <a:pt x="3082" y="31"/>
                  </a:lnTo>
                  <a:lnTo>
                    <a:pt x="3083" y="29"/>
                  </a:lnTo>
                  <a:lnTo>
                    <a:pt x="3084" y="29"/>
                  </a:lnTo>
                  <a:lnTo>
                    <a:pt x="3085" y="27"/>
                  </a:lnTo>
                  <a:lnTo>
                    <a:pt x="3086" y="30"/>
                  </a:lnTo>
                  <a:lnTo>
                    <a:pt x="3087" y="30"/>
                  </a:lnTo>
                  <a:lnTo>
                    <a:pt x="3088" y="27"/>
                  </a:lnTo>
                  <a:lnTo>
                    <a:pt x="3089" y="24"/>
                  </a:lnTo>
                  <a:lnTo>
                    <a:pt x="3089" y="31"/>
                  </a:lnTo>
                  <a:lnTo>
                    <a:pt x="3090" y="29"/>
                  </a:lnTo>
                  <a:lnTo>
                    <a:pt x="3091" y="29"/>
                  </a:lnTo>
                  <a:lnTo>
                    <a:pt x="3092" y="26"/>
                  </a:lnTo>
                  <a:lnTo>
                    <a:pt x="3093" y="28"/>
                  </a:lnTo>
                  <a:lnTo>
                    <a:pt x="3094" y="29"/>
                  </a:lnTo>
                  <a:lnTo>
                    <a:pt x="3095" y="33"/>
                  </a:lnTo>
                  <a:lnTo>
                    <a:pt x="3096" y="33"/>
                  </a:lnTo>
                  <a:lnTo>
                    <a:pt x="3097" y="36"/>
                  </a:lnTo>
                  <a:lnTo>
                    <a:pt x="3097" y="28"/>
                  </a:lnTo>
                  <a:lnTo>
                    <a:pt x="3098" y="30"/>
                  </a:lnTo>
                  <a:lnTo>
                    <a:pt x="3099" y="32"/>
                  </a:lnTo>
                  <a:lnTo>
                    <a:pt x="3100" y="33"/>
                  </a:lnTo>
                  <a:lnTo>
                    <a:pt x="3101" y="29"/>
                  </a:lnTo>
                  <a:lnTo>
                    <a:pt x="3102" y="28"/>
                  </a:lnTo>
                  <a:lnTo>
                    <a:pt x="3103" y="27"/>
                  </a:lnTo>
                  <a:lnTo>
                    <a:pt x="3104" y="30"/>
                  </a:lnTo>
                  <a:lnTo>
                    <a:pt x="3104" y="30"/>
                  </a:lnTo>
                  <a:lnTo>
                    <a:pt x="3105" y="32"/>
                  </a:lnTo>
                  <a:lnTo>
                    <a:pt x="3106" y="29"/>
                  </a:lnTo>
                  <a:lnTo>
                    <a:pt x="3107" y="31"/>
                  </a:lnTo>
                  <a:lnTo>
                    <a:pt x="3108" y="27"/>
                  </a:lnTo>
                  <a:lnTo>
                    <a:pt x="3109" y="29"/>
                  </a:lnTo>
                  <a:lnTo>
                    <a:pt x="3110" y="30"/>
                  </a:lnTo>
                  <a:lnTo>
                    <a:pt x="3111" y="27"/>
                  </a:lnTo>
                  <a:lnTo>
                    <a:pt x="3112" y="28"/>
                  </a:lnTo>
                  <a:lnTo>
                    <a:pt x="3112" y="24"/>
                  </a:lnTo>
                  <a:lnTo>
                    <a:pt x="3113" y="23"/>
                  </a:lnTo>
                  <a:lnTo>
                    <a:pt x="3114" y="31"/>
                  </a:lnTo>
                  <a:lnTo>
                    <a:pt x="3115" y="26"/>
                  </a:lnTo>
                  <a:lnTo>
                    <a:pt x="3116" y="26"/>
                  </a:lnTo>
                  <a:lnTo>
                    <a:pt x="3117" y="21"/>
                  </a:lnTo>
                  <a:lnTo>
                    <a:pt x="3118" y="24"/>
                  </a:lnTo>
                  <a:lnTo>
                    <a:pt x="3119" y="23"/>
                  </a:lnTo>
                  <a:lnTo>
                    <a:pt x="3119" y="29"/>
                  </a:lnTo>
                  <a:lnTo>
                    <a:pt x="3120" y="23"/>
                  </a:lnTo>
                  <a:lnTo>
                    <a:pt x="3121" y="25"/>
                  </a:lnTo>
                  <a:lnTo>
                    <a:pt x="3122" y="25"/>
                  </a:lnTo>
                  <a:lnTo>
                    <a:pt x="3123" y="26"/>
                  </a:lnTo>
                  <a:lnTo>
                    <a:pt x="3124" y="28"/>
                  </a:lnTo>
                  <a:lnTo>
                    <a:pt x="3125" y="25"/>
                  </a:lnTo>
                  <a:lnTo>
                    <a:pt x="3126" y="26"/>
                  </a:lnTo>
                  <a:lnTo>
                    <a:pt x="3127" y="26"/>
                  </a:lnTo>
                  <a:lnTo>
                    <a:pt x="3127" y="27"/>
                  </a:lnTo>
                  <a:lnTo>
                    <a:pt x="3128" y="28"/>
                  </a:lnTo>
                  <a:lnTo>
                    <a:pt x="3129" y="29"/>
                  </a:lnTo>
                  <a:lnTo>
                    <a:pt x="3130" y="25"/>
                  </a:lnTo>
                  <a:lnTo>
                    <a:pt x="3131" y="21"/>
                  </a:lnTo>
                  <a:lnTo>
                    <a:pt x="3132" y="26"/>
                  </a:lnTo>
                  <a:lnTo>
                    <a:pt x="3133" y="24"/>
                  </a:lnTo>
                  <a:lnTo>
                    <a:pt x="3134" y="25"/>
                  </a:lnTo>
                  <a:lnTo>
                    <a:pt x="3134" y="32"/>
                  </a:lnTo>
                  <a:lnTo>
                    <a:pt x="3135" y="24"/>
                  </a:lnTo>
                  <a:lnTo>
                    <a:pt x="3136" y="33"/>
                  </a:lnTo>
                  <a:lnTo>
                    <a:pt x="3137" y="27"/>
                  </a:lnTo>
                  <a:lnTo>
                    <a:pt x="3138" y="26"/>
                  </a:lnTo>
                  <a:lnTo>
                    <a:pt x="3139" y="28"/>
                  </a:lnTo>
                  <a:lnTo>
                    <a:pt x="3140" y="29"/>
                  </a:lnTo>
                  <a:lnTo>
                    <a:pt x="3141" y="34"/>
                  </a:lnTo>
                  <a:lnTo>
                    <a:pt x="3142" y="33"/>
                  </a:lnTo>
                  <a:lnTo>
                    <a:pt x="3142" y="36"/>
                  </a:lnTo>
                  <a:lnTo>
                    <a:pt x="3143" y="34"/>
                  </a:lnTo>
                  <a:lnTo>
                    <a:pt x="3144" y="40"/>
                  </a:lnTo>
                  <a:lnTo>
                    <a:pt x="3145" y="50"/>
                  </a:lnTo>
                  <a:lnTo>
                    <a:pt x="3146" y="41"/>
                  </a:lnTo>
                  <a:lnTo>
                    <a:pt x="3147" y="43"/>
                  </a:lnTo>
                  <a:lnTo>
                    <a:pt x="3148" y="42"/>
                  </a:lnTo>
                  <a:lnTo>
                    <a:pt x="3149" y="44"/>
                  </a:lnTo>
                  <a:lnTo>
                    <a:pt x="3149" y="43"/>
                  </a:lnTo>
                  <a:lnTo>
                    <a:pt x="3150" y="47"/>
                  </a:lnTo>
                  <a:lnTo>
                    <a:pt x="3151" y="47"/>
                  </a:lnTo>
                  <a:lnTo>
                    <a:pt x="3152" y="47"/>
                  </a:lnTo>
                  <a:lnTo>
                    <a:pt x="3153" y="48"/>
                  </a:lnTo>
                  <a:lnTo>
                    <a:pt x="3154" y="45"/>
                  </a:lnTo>
                  <a:lnTo>
                    <a:pt x="3155" y="41"/>
                  </a:lnTo>
                  <a:lnTo>
                    <a:pt x="3156" y="48"/>
                  </a:lnTo>
                  <a:lnTo>
                    <a:pt x="3157" y="49"/>
                  </a:lnTo>
                  <a:lnTo>
                    <a:pt x="3157" y="53"/>
                  </a:lnTo>
                  <a:lnTo>
                    <a:pt x="3158" y="59"/>
                  </a:lnTo>
                  <a:lnTo>
                    <a:pt x="3159" y="77"/>
                  </a:lnTo>
                  <a:lnTo>
                    <a:pt x="3160" y="96"/>
                  </a:lnTo>
                  <a:lnTo>
                    <a:pt x="3161" y="131"/>
                  </a:lnTo>
                  <a:lnTo>
                    <a:pt x="3162" y="168"/>
                  </a:lnTo>
                  <a:lnTo>
                    <a:pt x="3163" y="213"/>
                  </a:lnTo>
                  <a:lnTo>
                    <a:pt x="3164" y="281"/>
                  </a:lnTo>
                  <a:lnTo>
                    <a:pt x="3164" y="354"/>
                  </a:lnTo>
                  <a:lnTo>
                    <a:pt x="3165" y="446"/>
                  </a:lnTo>
                  <a:lnTo>
                    <a:pt x="3166" y="543"/>
                  </a:lnTo>
                  <a:lnTo>
                    <a:pt x="3167" y="610"/>
                  </a:lnTo>
                  <a:lnTo>
                    <a:pt x="3168" y="702"/>
                  </a:lnTo>
                  <a:lnTo>
                    <a:pt x="3169" y="743"/>
                  </a:lnTo>
                  <a:lnTo>
                    <a:pt x="3170" y="766"/>
                  </a:lnTo>
                  <a:lnTo>
                    <a:pt x="3171" y="754"/>
                  </a:lnTo>
                  <a:lnTo>
                    <a:pt x="3172" y="730"/>
                  </a:lnTo>
                  <a:lnTo>
                    <a:pt x="3172" y="697"/>
                  </a:lnTo>
                  <a:lnTo>
                    <a:pt x="3173" y="648"/>
                  </a:lnTo>
                  <a:lnTo>
                    <a:pt x="3174" y="591"/>
                  </a:lnTo>
                  <a:lnTo>
                    <a:pt x="3175" y="561"/>
                  </a:lnTo>
                  <a:lnTo>
                    <a:pt x="3176" y="521"/>
                  </a:lnTo>
                  <a:lnTo>
                    <a:pt x="3177" y="496"/>
                  </a:lnTo>
                  <a:lnTo>
                    <a:pt x="3178" y="468"/>
                  </a:lnTo>
                  <a:lnTo>
                    <a:pt x="3179" y="436"/>
                  </a:lnTo>
                  <a:lnTo>
                    <a:pt x="3179" y="418"/>
                  </a:lnTo>
                  <a:lnTo>
                    <a:pt x="3180" y="401"/>
                  </a:lnTo>
                  <a:lnTo>
                    <a:pt x="3181" y="381"/>
                  </a:lnTo>
                  <a:lnTo>
                    <a:pt x="3182" y="386"/>
                  </a:lnTo>
                  <a:lnTo>
                    <a:pt x="3183" y="385"/>
                  </a:lnTo>
                  <a:lnTo>
                    <a:pt x="3184" y="391"/>
                  </a:lnTo>
                  <a:lnTo>
                    <a:pt x="3185" y="388"/>
                  </a:lnTo>
                  <a:lnTo>
                    <a:pt x="3186" y="395"/>
                  </a:lnTo>
                  <a:lnTo>
                    <a:pt x="3187" y="393"/>
                  </a:lnTo>
                  <a:lnTo>
                    <a:pt x="3187" y="400"/>
                  </a:lnTo>
                  <a:lnTo>
                    <a:pt x="3188" y="408"/>
                  </a:lnTo>
                  <a:lnTo>
                    <a:pt x="3189" y="415"/>
                  </a:lnTo>
                  <a:lnTo>
                    <a:pt x="3190" y="410"/>
                  </a:lnTo>
                  <a:lnTo>
                    <a:pt x="3191" y="402"/>
                  </a:lnTo>
                  <a:lnTo>
                    <a:pt x="3192" y="368"/>
                  </a:lnTo>
                  <a:lnTo>
                    <a:pt x="3193" y="370"/>
                  </a:lnTo>
                  <a:lnTo>
                    <a:pt x="3194" y="357"/>
                  </a:lnTo>
                  <a:lnTo>
                    <a:pt x="3194" y="346"/>
                  </a:lnTo>
                  <a:lnTo>
                    <a:pt x="3195" y="338"/>
                  </a:lnTo>
                  <a:lnTo>
                    <a:pt x="3196" y="330"/>
                  </a:lnTo>
                  <a:lnTo>
                    <a:pt x="3197" y="329"/>
                  </a:lnTo>
                  <a:lnTo>
                    <a:pt x="3198" y="338"/>
                  </a:lnTo>
                  <a:lnTo>
                    <a:pt x="3199" y="341"/>
                  </a:lnTo>
                  <a:lnTo>
                    <a:pt x="3200" y="340"/>
                  </a:lnTo>
                  <a:lnTo>
                    <a:pt x="3201" y="352"/>
                  </a:lnTo>
                  <a:lnTo>
                    <a:pt x="3202" y="365"/>
                  </a:lnTo>
                  <a:lnTo>
                    <a:pt x="3202" y="369"/>
                  </a:lnTo>
                  <a:lnTo>
                    <a:pt x="3203" y="379"/>
                  </a:lnTo>
                  <a:lnTo>
                    <a:pt x="3204" y="380"/>
                  </a:lnTo>
                  <a:lnTo>
                    <a:pt x="3205" y="381"/>
                  </a:lnTo>
                  <a:lnTo>
                    <a:pt x="3206" y="374"/>
                  </a:lnTo>
                  <a:lnTo>
                    <a:pt x="3207" y="364"/>
                  </a:lnTo>
                  <a:lnTo>
                    <a:pt x="3208" y="352"/>
                  </a:lnTo>
                  <a:lnTo>
                    <a:pt x="3209" y="345"/>
                  </a:lnTo>
                  <a:lnTo>
                    <a:pt x="3209" y="328"/>
                  </a:lnTo>
                  <a:lnTo>
                    <a:pt x="3210" y="314"/>
                  </a:lnTo>
                  <a:lnTo>
                    <a:pt x="3211" y="296"/>
                  </a:lnTo>
                  <a:lnTo>
                    <a:pt x="3212" y="284"/>
                  </a:lnTo>
                  <a:lnTo>
                    <a:pt x="3213" y="269"/>
                  </a:lnTo>
                  <a:lnTo>
                    <a:pt x="3214" y="251"/>
                  </a:lnTo>
                  <a:lnTo>
                    <a:pt x="3215" y="240"/>
                  </a:lnTo>
                  <a:lnTo>
                    <a:pt x="3216" y="231"/>
                  </a:lnTo>
                  <a:lnTo>
                    <a:pt x="3216" y="229"/>
                  </a:lnTo>
                  <a:lnTo>
                    <a:pt x="3217" y="223"/>
                  </a:lnTo>
                  <a:lnTo>
                    <a:pt x="3218" y="215"/>
                  </a:lnTo>
                  <a:lnTo>
                    <a:pt x="3219" y="206"/>
                  </a:lnTo>
                  <a:lnTo>
                    <a:pt x="3220" y="195"/>
                  </a:lnTo>
                  <a:lnTo>
                    <a:pt x="3221" y="192"/>
                  </a:lnTo>
                  <a:lnTo>
                    <a:pt x="3222" y="184"/>
                  </a:lnTo>
                  <a:lnTo>
                    <a:pt x="3223" y="185"/>
                  </a:lnTo>
                  <a:lnTo>
                    <a:pt x="3224" y="173"/>
                  </a:lnTo>
                  <a:lnTo>
                    <a:pt x="3224" y="165"/>
                  </a:lnTo>
                  <a:lnTo>
                    <a:pt x="3225" y="155"/>
                  </a:lnTo>
                  <a:lnTo>
                    <a:pt x="3226" y="160"/>
                  </a:lnTo>
                  <a:lnTo>
                    <a:pt x="3227" y="146"/>
                  </a:lnTo>
                  <a:lnTo>
                    <a:pt x="3228" y="148"/>
                  </a:lnTo>
                  <a:lnTo>
                    <a:pt x="3229" y="148"/>
                  </a:lnTo>
                  <a:lnTo>
                    <a:pt x="3230" y="134"/>
                  </a:lnTo>
                  <a:lnTo>
                    <a:pt x="3231" y="133"/>
                  </a:lnTo>
                  <a:lnTo>
                    <a:pt x="3231" y="131"/>
                  </a:lnTo>
                  <a:lnTo>
                    <a:pt x="3232" y="127"/>
                  </a:lnTo>
                  <a:lnTo>
                    <a:pt x="3233" y="129"/>
                  </a:lnTo>
                  <a:lnTo>
                    <a:pt x="3234" y="132"/>
                  </a:lnTo>
                  <a:lnTo>
                    <a:pt x="3235" y="122"/>
                  </a:lnTo>
                  <a:lnTo>
                    <a:pt x="3236" y="117"/>
                  </a:lnTo>
                  <a:lnTo>
                    <a:pt x="3237" y="119"/>
                  </a:lnTo>
                  <a:lnTo>
                    <a:pt x="3238" y="114"/>
                  </a:lnTo>
                  <a:lnTo>
                    <a:pt x="3239" y="103"/>
                  </a:lnTo>
                  <a:lnTo>
                    <a:pt x="3239" y="107"/>
                  </a:lnTo>
                  <a:lnTo>
                    <a:pt x="3240" y="109"/>
                  </a:lnTo>
                  <a:lnTo>
                    <a:pt x="3241" y="109"/>
                  </a:lnTo>
                  <a:lnTo>
                    <a:pt x="3242" y="112"/>
                  </a:lnTo>
                  <a:lnTo>
                    <a:pt x="3243" y="115"/>
                  </a:lnTo>
                  <a:lnTo>
                    <a:pt x="3244" y="111"/>
                  </a:lnTo>
                  <a:lnTo>
                    <a:pt x="3245" y="118"/>
                  </a:lnTo>
                  <a:lnTo>
                    <a:pt x="3246" y="124"/>
                  </a:lnTo>
                  <a:lnTo>
                    <a:pt x="3246" y="119"/>
                  </a:lnTo>
                  <a:lnTo>
                    <a:pt x="3247" y="122"/>
                  </a:lnTo>
                  <a:lnTo>
                    <a:pt x="3248" y="132"/>
                  </a:lnTo>
                  <a:lnTo>
                    <a:pt x="3249" y="128"/>
                  </a:lnTo>
                  <a:lnTo>
                    <a:pt x="3250" y="134"/>
                  </a:lnTo>
                  <a:lnTo>
                    <a:pt x="3251" y="141"/>
                  </a:lnTo>
                  <a:lnTo>
                    <a:pt x="3252" y="130"/>
                  </a:lnTo>
                  <a:lnTo>
                    <a:pt x="3253" y="129"/>
                  </a:lnTo>
                  <a:lnTo>
                    <a:pt x="3254" y="125"/>
                  </a:lnTo>
                  <a:lnTo>
                    <a:pt x="3254" y="124"/>
                  </a:lnTo>
                  <a:lnTo>
                    <a:pt x="3255" y="122"/>
                  </a:lnTo>
                  <a:lnTo>
                    <a:pt x="3256" y="119"/>
                  </a:lnTo>
                  <a:lnTo>
                    <a:pt x="3257" y="122"/>
                  </a:lnTo>
                  <a:lnTo>
                    <a:pt x="3258" y="116"/>
                  </a:lnTo>
                  <a:lnTo>
                    <a:pt x="3259" y="117"/>
                  </a:lnTo>
                  <a:lnTo>
                    <a:pt x="3260" y="113"/>
                  </a:lnTo>
                  <a:lnTo>
                    <a:pt x="3261" y="106"/>
                  </a:lnTo>
                  <a:lnTo>
                    <a:pt x="3261" y="99"/>
                  </a:lnTo>
                  <a:lnTo>
                    <a:pt x="3262" y="101"/>
                  </a:lnTo>
                  <a:lnTo>
                    <a:pt x="3263" y="94"/>
                  </a:lnTo>
                  <a:lnTo>
                    <a:pt x="3264" y="96"/>
                  </a:lnTo>
                  <a:lnTo>
                    <a:pt x="3265" y="93"/>
                  </a:lnTo>
                  <a:lnTo>
                    <a:pt x="3266" y="93"/>
                  </a:lnTo>
                  <a:lnTo>
                    <a:pt x="3267" y="90"/>
                  </a:lnTo>
                  <a:lnTo>
                    <a:pt x="3268" y="88"/>
                  </a:lnTo>
                  <a:lnTo>
                    <a:pt x="3269" y="95"/>
                  </a:lnTo>
                  <a:lnTo>
                    <a:pt x="3269" y="81"/>
                  </a:lnTo>
                  <a:lnTo>
                    <a:pt x="3270" y="87"/>
                  </a:lnTo>
                  <a:lnTo>
                    <a:pt x="3271" y="90"/>
                  </a:lnTo>
                  <a:lnTo>
                    <a:pt x="3272" y="83"/>
                  </a:lnTo>
                  <a:lnTo>
                    <a:pt x="3273" y="92"/>
                  </a:lnTo>
                  <a:lnTo>
                    <a:pt x="3274" y="85"/>
                  </a:lnTo>
                  <a:lnTo>
                    <a:pt x="3275" y="89"/>
                  </a:lnTo>
                  <a:lnTo>
                    <a:pt x="3276" y="94"/>
                  </a:lnTo>
                  <a:lnTo>
                    <a:pt x="3276" y="95"/>
                  </a:lnTo>
                  <a:lnTo>
                    <a:pt x="3277" y="94"/>
                  </a:lnTo>
                  <a:lnTo>
                    <a:pt x="3278" y="92"/>
                  </a:lnTo>
                  <a:lnTo>
                    <a:pt x="3279" y="89"/>
                  </a:lnTo>
                  <a:lnTo>
                    <a:pt x="3280" y="92"/>
                  </a:lnTo>
                  <a:lnTo>
                    <a:pt x="3281" y="89"/>
                  </a:lnTo>
                  <a:lnTo>
                    <a:pt x="3282" y="86"/>
                  </a:lnTo>
                  <a:lnTo>
                    <a:pt x="3283" y="87"/>
                  </a:lnTo>
                  <a:lnTo>
                    <a:pt x="3284" y="82"/>
                  </a:lnTo>
                  <a:lnTo>
                    <a:pt x="3284" y="75"/>
                  </a:lnTo>
                  <a:lnTo>
                    <a:pt x="3285" y="85"/>
                  </a:lnTo>
                  <a:lnTo>
                    <a:pt x="3286" y="81"/>
                  </a:lnTo>
                  <a:lnTo>
                    <a:pt x="3287" y="84"/>
                  </a:lnTo>
                  <a:lnTo>
                    <a:pt x="3288" y="78"/>
                  </a:lnTo>
                  <a:lnTo>
                    <a:pt x="3289" y="79"/>
                  </a:lnTo>
                  <a:lnTo>
                    <a:pt x="3290" y="79"/>
                  </a:lnTo>
                  <a:lnTo>
                    <a:pt x="3291" y="78"/>
                  </a:lnTo>
                  <a:lnTo>
                    <a:pt x="3291" y="88"/>
                  </a:lnTo>
                  <a:lnTo>
                    <a:pt x="3292" y="90"/>
                  </a:lnTo>
                  <a:lnTo>
                    <a:pt x="3293" y="96"/>
                  </a:lnTo>
                  <a:lnTo>
                    <a:pt x="3294" y="101"/>
                  </a:lnTo>
                  <a:lnTo>
                    <a:pt x="3295" y="110"/>
                  </a:lnTo>
                  <a:lnTo>
                    <a:pt x="3296" y="106"/>
                  </a:lnTo>
                  <a:lnTo>
                    <a:pt x="3297" y="114"/>
                  </a:lnTo>
                  <a:lnTo>
                    <a:pt x="3298" y="119"/>
                  </a:lnTo>
                  <a:lnTo>
                    <a:pt x="3299" y="117"/>
                  </a:lnTo>
                  <a:lnTo>
                    <a:pt x="3299" y="107"/>
                  </a:lnTo>
                  <a:lnTo>
                    <a:pt x="3300" y="106"/>
                  </a:lnTo>
                  <a:lnTo>
                    <a:pt x="3301" y="104"/>
                  </a:lnTo>
                  <a:lnTo>
                    <a:pt x="3302" y="96"/>
                  </a:lnTo>
                  <a:lnTo>
                    <a:pt x="3303" y="92"/>
                  </a:lnTo>
                  <a:lnTo>
                    <a:pt x="3304" y="88"/>
                  </a:lnTo>
                  <a:lnTo>
                    <a:pt x="3305" y="80"/>
                  </a:lnTo>
                  <a:lnTo>
                    <a:pt x="3306" y="68"/>
                  </a:lnTo>
                  <a:lnTo>
                    <a:pt x="3306" y="74"/>
                  </a:lnTo>
                  <a:lnTo>
                    <a:pt x="3307" y="66"/>
                  </a:lnTo>
                  <a:lnTo>
                    <a:pt x="3308" y="60"/>
                  </a:lnTo>
                  <a:lnTo>
                    <a:pt x="3309" y="58"/>
                  </a:lnTo>
                  <a:lnTo>
                    <a:pt x="3310" y="54"/>
                  </a:lnTo>
                  <a:lnTo>
                    <a:pt x="3311" y="57"/>
                  </a:lnTo>
                  <a:lnTo>
                    <a:pt x="3312" y="55"/>
                  </a:lnTo>
                  <a:lnTo>
                    <a:pt x="3313" y="52"/>
                  </a:lnTo>
                  <a:lnTo>
                    <a:pt x="3314" y="52"/>
                  </a:lnTo>
                  <a:lnTo>
                    <a:pt x="3314" y="46"/>
                  </a:lnTo>
                  <a:lnTo>
                    <a:pt x="3315" y="49"/>
                  </a:lnTo>
                  <a:lnTo>
                    <a:pt x="3316" y="49"/>
                  </a:lnTo>
                  <a:lnTo>
                    <a:pt x="3317" y="48"/>
                  </a:lnTo>
                  <a:lnTo>
                    <a:pt x="3318" y="52"/>
                  </a:lnTo>
                  <a:lnTo>
                    <a:pt x="3319" y="51"/>
                  </a:lnTo>
                  <a:lnTo>
                    <a:pt x="3320" y="57"/>
                  </a:lnTo>
                  <a:lnTo>
                    <a:pt x="3321" y="52"/>
                  </a:lnTo>
                  <a:lnTo>
                    <a:pt x="3321" y="49"/>
                  </a:lnTo>
                  <a:lnTo>
                    <a:pt x="3322" y="56"/>
                  </a:lnTo>
                  <a:lnTo>
                    <a:pt x="3323" y="51"/>
                  </a:lnTo>
                  <a:lnTo>
                    <a:pt x="3324" y="56"/>
                  </a:lnTo>
                  <a:lnTo>
                    <a:pt x="3325" y="51"/>
                  </a:lnTo>
                  <a:lnTo>
                    <a:pt x="3326" y="50"/>
                  </a:lnTo>
                  <a:lnTo>
                    <a:pt x="3327" y="58"/>
                  </a:lnTo>
                  <a:lnTo>
                    <a:pt x="3328" y="53"/>
                  </a:lnTo>
                  <a:lnTo>
                    <a:pt x="3329" y="53"/>
                  </a:lnTo>
                  <a:lnTo>
                    <a:pt x="3329" y="48"/>
                  </a:lnTo>
                  <a:lnTo>
                    <a:pt x="3330" y="49"/>
                  </a:lnTo>
                  <a:lnTo>
                    <a:pt x="3331" y="48"/>
                  </a:lnTo>
                  <a:lnTo>
                    <a:pt x="3332" y="53"/>
                  </a:lnTo>
                  <a:lnTo>
                    <a:pt x="3333" y="50"/>
                  </a:lnTo>
                  <a:lnTo>
                    <a:pt x="3334" y="53"/>
                  </a:lnTo>
                  <a:lnTo>
                    <a:pt x="3335" y="52"/>
                  </a:lnTo>
                  <a:lnTo>
                    <a:pt x="3336" y="55"/>
                  </a:lnTo>
                  <a:lnTo>
                    <a:pt x="3336" y="56"/>
                  </a:lnTo>
                  <a:lnTo>
                    <a:pt x="3337" y="54"/>
                  </a:lnTo>
                  <a:lnTo>
                    <a:pt x="3338" y="61"/>
                  </a:lnTo>
                  <a:lnTo>
                    <a:pt x="3339" y="61"/>
                  </a:lnTo>
                  <a:lnTo>
                    <a:pt x="3340" y="55"/>
                  </a:lnTo>
                  <a:lnTo>
                    <a:pt x="3341" y="63"/>
                  </a:lnTo>
                  <a:lnTo>
                    <a:pt x="3342" y="59"/>
                  </a:lnTo>
                  <a:lnTo>
                    <a:pt x="3343" y="66"/>
                  </a:lnTo>
                  <a:lnTo>
                    <a:pt x="3344" y="64"/>
                  </a:lnTo>
                  <a:lnTo>
                    <a:pt x="3344" y="62"/>
                  </a:lnTo>
                  <a:lnTo>
                    <a:pt x="3345" y="66"/>
                  </a:lnTo>
                  <a:lnTo>
                    <a:pt x="3346" y="64"/>
                  </a:lnTo>
                  <a:lnTo>
                    <a:pt x="3347" y="61"/>
                  </a:lnTo>
                  <a:lnTo>
                    <a:pt x="3348" y="62"/>
                  </a:lnTo>
                  <a:lnTo>
                    <a:pt x="3349" y="67"/>
                  </a:lnTo>
                  <a:lnTo>
                    <a:pt x="3350" y="66"/>
                  </a:lnTo>
                  <a:lnTo>
                    <a:pt x="3351" y="69"/>
                  </a:lnTo>
                  <a:lnTo>
                    <a:pt x="3351" y="63"/>
                  </a:lnTo>
                  <a:lnTo>
                    <a:pt x="3352" y="64"/>
                  </a:lnTo>
                  <a:lnTo>
                    <a:pt x="3353" y="57"/>
                  </a:lnTo>
                  <a:lnTo>
                    <a:pt x="3354" y="61"/>
                  </a:lnTo>
                  <a:lnTo>
                    <a:pt x="3355" y="64"/>
                  </a:lnTo>
                  <a:lnTo>
                    <a:pt x="3356" y="59"/>
                  </a:lnTo>
                  <a:lnTo>
                    <a:pt x="3357" y="56"/>
                  </a:lnTo>
                  <a:lnTo>
                    <a:pt x="3358" y="58"/>
                  </a:lnTo>
                  <a:lnTo>
                    <a:pt x="3359" y="58"/>
                  </a:lnTo>
                  <a:lnTo>
                    <a:pt x="3359" y="59"/>
                  </a:lnTo>
                  <a:lnTo>
                    <a:pt x="3360" y="51"/>
                  </a:lnTo>
                  <a:lnTo>
                    <a:pt x="3361" y="55"/>
                  </a:lnTo>
                  <a:lnTo>
                    <a:pt x="3362" y="50"/>
                  </a:lnTo>
                  <a:lnTo>
                    <a:pt x="3363" y="51"/>
                  </a:lnTo>
                  <a:lnTo>
                    <a:pt x="3364" y="54"/>
                  </a:lnTo>
                  <a:lnTo>
                    <a:pt x="3365" y="52"/>
                  </a:lnTo>
                  <a:lnTo>
                    <a:pt x="3366" y="49"/>
                  </a:lnTo>
                  <a:lnTo>
                    <a:pt x="3366" y="52"/>
                  </a:lnTo>
                  <a:lnTo>
                    <a:pt x="3367" y="50"/>
                  </a:lnTo>
                  <a:lnTo>
                    <a:pt x="3368" y="51"/>
                  </a:lnTo>
                  <a:lnTo>
                    <a:pt x="3369" y="50"/>
                  </a:lnTo>
                  <a:lnTo>
                    <a:pt x="3370" y="51"/>
                  </a:lnTo>
                  <a:lnTo>
                    <a:pt x="3371" y="48"/>
                  </a:lnTo>
                  <a:lnTo>
                    <a:pt x="3372" y="48"/>
                  </a:lnTo>
                  <a:lnTo>
                    <a:pt x="3373" y="49"/>
                  </a:lnTo>
                  <a:lnTo>
                    <a:pt x="3374" y="49"/>
                  </a:lnTo>
                  <a:lnTo>
                    <a:pt x="3374" y="51"/>
                  </a:lnTo>
                  <a:lnTo>
                    <a:pt x="3375" y="42"/>
                  </a:lnTo>
                  <a:lnTo>
                    <a:pt x="3376" y="45"/>
                  </a:lnTo>
                  <a:lnTo>
                    <a:pt x="3377" y="47"/>
                  </a:lnTo>
                  <a:lnTo>
                    <a:pt x="3378" y="44"/>
                  </a:lnTo>
                  <a:lnTo>
                    <a:pt x="3379" y="43"/>
                  </a:lnTo>
                  <a:lnTo>
                    <a:pt x="3380" y="43"/>
                  </a:lnTo>
                  <a:lnTo>
                    <a:pt x="3381" y="44"/>
                  </a:lnTo>
                  <a:lnTo>
                    <a:pt x="3381" y="44"/>
                  </a:lnTo>
                  <a:lnTo>
                    <a:pt x="3382" y="45"/>
                  </a:lnTo>
                  <a:lnTo>
                    <a:pt x="3383" y="40"/>
                  </a:lnTo>
                  <a:lnTo>
                    <a:pt x="3384" y="45"/>
                  </a:lnTo>
                  <a:lnTo>
                    <a:pt x="3385" y="45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37" name="Freeform 567"/>
            <p:cNvSpPr>
              <a:spLocks/>
            </p:cNvSpPr>
            <p:nvPr/>
          </p:nvSpPr>
          <p:spPr bwMode="auto">
            <a:xfrm flipV="1">
              <a:off x="-679450" y="6438900"/>
              <a:ext cx="536575" cy="11113"/>
            </a:xfrm>
            <a:custGeom>
              <a:avLst/>
              <a:gdLst>
                <a:gd name="T0" fmla="*/ 11 w 773"/>
                <a:gd name="T1" fmla="*/ 16 h 34"/>
                <a:gd name="T2" fmla="*/ 24 w 773"/>
                <a:gd name="T3" fmla="*/ 20 h 34"/>
                <a:gd name="T4" fmla="*/ 36 w 773"/>
                <a:gd name="T5" fmla="*/ 15 h 34"/>
                <a:gd name="T6" fmla="*/ 48 w 773"/>
                <a:gd name="T7" fmla="*/ 12 h 34"/>
                <a:gd name="T8" fmla="*/ 61 w 773"/>
                <a:gd name="T9" fmla="*/ 9 h 34"/>
                <a:gd name="T10" fmla="*/ 73 w 773"/>
                <a:gd name="T11" fmla="*/ 11 h 34"/>
                <a:gd name="T12" fmla="*/ 86 w 773"/>
                <a:gd name="T13" fmla="*/ 7 h 34"/>
                <a:gd name="T14" fmla="*/ 98 w 773"/>
                <a:gd name="T15" fmla="*/ 7 h 34"/>
                <a:gd name="T16" fmla="*/ 110 w 773"/>
                <a:gd name="T17" fmla="*/ 10 h 34"/>
                <a:gd name="T18" fmla="*/ 123 w 773"/>
                <a:gd name="T19" fmla="*/ 9 h 34"/>
                <a:gd name="T20" fmla="*/ 135 w 773"/>
                <a:gd name="T21" fmla="*/ 7 h 34"/>
                <a:gd name="T22" fmla="*/ 147 w 773"/>
                <a:gd name="T23" fmla="*/ 5 h 34"/>
                <a:gd name="T24" fmla="*/ 160 w 773"/>
                <a:gd name="T25" fmla="*/ 8 h 34"/>
                <a:gd name="T26" fmla="*/ 172 w 773"/>
                <a:gd name="T27" fmla="*/ 11 h 34"/>
                <a:gd name="T28" fmla="*/ 184 w 773"/>
                <a:gd name="T29" fmla="*/ 6 h 34"/>
                <a:gd name="T30" fmla="*/ 197 w 773"/>
                <a:gd name="T31" fmla="*/ 4 h 34"/>
                <a:gd name="T32" fmla="*/ 209 w 773"/>
                <a:gd name="T33" fmla="*/ 10 h 34"/>
                <a:gd name="T34" fmla="*/ 221 w 773"/>
                <a:gd name="T35" fmla="*/ 31 h 34"/>
                <a:gd name="T36" fmla="*/ 234 w 773"/>
                <a:gd name="T37" fmla="*/ 10 h 34"/>
                <a:gd name="T38" fmla="*/ 246 w 773"/>
                <a:gd name="T39" fmla="*/ 10 h 34"/>
                <a:gd name="T40" fmla="*/ 258 w 773"/>
                <a:gd name="T41" fmla="*/ 8 h 34"/>
                <a:gd name="T42" fmla="*/ 271 w 773"/>
                <a:gd name="T43" fmla="*/ 11 h 34"/>
                <a:gd name="T44" fmla="*/ 283 w 773"/>
                <a:gd name="T45" fmla="*/ 12 h 34"/>
                <a:gd name="T46" fmla="*/ 295 w 773"/>
                <a:gd name="T47" fmla="*/ 15 h 34"/>
                <a:gd name="T48" fmla="*/ 308 w 773"/>
                <a:gd name="T49" fmla="*/ 17 h 34"/>
                <a:gd name="T50" fmla="*/ 320 w 773"/>
                <a:gd name="T51" fmla="*/ 23 h 34"/>
                <a:gd name="T52" fmla="*/ 333 w 773"/>
                <a:gd name="T53" fmla="*/ 25 h 34"/>
                <a:gd name="T54" fmla="*/ 345 w 773"/>
                <a:gd name="T55" fmla="*/ 16 h 34"/>
                <a:gd name="T56" fmla="*/ 357 w 773"/>
                <a:gd name="T57" fmla="*/ 21 h 34"/>
                <a:gd name="T58" fmla="*/ 370 w 773"/>
                <a:gd name="T59" fmla="*/ 29 h 34"/>
                <a:gd name="T60" fmla="*/ 382 w 773"/>
                <a:gd name="T61" fmla="*/ 19 h 34"/>
                <a:gd name="T62" fmla="*/ 394 w 773"/>
                <a:gd name="T63" fmla="*/ 20 h 34"/>
                <a:gd name="T64" fmla="*/ 407 w 773"/>
                <a:gd name="T65" fmla="*/ 15 h 34"/>
                <a:gd name="T66" fmla="*/ 419 w 773"/>
                <a:gd name="T67" fmla="*/ 20 h 34"/>
                <a:gd name="T68" fmla="*/ 431 w 773"/>
                <a:gd name="T69" fmla="*/ 20 h 34"/>
                <a:gd name="T70" fmla="*/ 444 w 773"/>
                <a:gd name="T71" fmla="*/ 24 h 34"/>
                <a:gd name="T72" fmla="*/ 456 w 773"/>
                <a:gd name="T73" fmla="*/ 21 h 34"/>
                <a:gd name="T74" fmla="*/ 468 w 773"/>
                <a:gd name="T75" fmla="*/ 19 h 34"/>
                <a:gd name="T76" fmla="*/ 481 w 773"/>
                <a:gd name="T77" fmla="*/ 19 h 34"/>
                <a:gd name="T78" fmla="*/ 493 w 773"/>
                <a:gd name="T79" fmla="*/ 11 h 34"/>
                <a:gd name="T80" fmla="*/ 505 w 773"/>
                <a:gd name="T81" fmla="*/ 12 h 34"/>
                <a:gd name="T82" fmla="*/ 518 w 773"/>
                <a:gd name="T83" fmla="*/ 26 h 34"/>
                <a:gd name="T84" fmla="*/ 530 w 773"/>
                <a:gd name="T85" fmla="*/ 21 h 34"/>
                <a:gd name="T86" fmla="*/ 542 w 773"/>
                <a:gd name="T87" fmla="*/ 13 h 34"/>
                <a:gd name="T88" fmla="*/ 555 w 773"/>
                <a:gd name="T89" fmla="*/ 16 h 34"/>
                <a:gd name="T90" fmla="*/ 567 w 773"/>
                <a:gd name="T91" fmla="*/ 18 h 34"/>
                <a:gd name="T92" fmla="*/ 580 w 773"/>
                <a:gd name="T93" fmla="*/ 10 h 34"/>
                <a:gd name="T94" fmla="*/ 592 w 773"/>
                <a:gd name="T95" fmla="*/ 10 h 34"/>
                <a:gd name="T96" fmla="*/ 604 w 773"/>
                <a:gd name="T97" fmla="*/ 11 h 34"/>
                <a:gd name="T98" fmla="*/ 617 w 773"/>
                <a:gd name="T99" fmla="*/ 11 h 34"/>
                <a:gd name="T100" fmla="*/ 629 w 773"/>
                <a:gd name="T101" fmla="*/ 8 h 34"/>
                <a:gd name="T102" fmla="*/ 641 w 773"/>
                <a:gd name="T103" fmla="*/ 11 h 34"/>
                <a:gd name="T104" fmla="*/ 654 w 773"/>
                <a:gd name="T105" fmla="*/ 11 h 34"/>
                <a:gd name="T106" fmla="*/ 666 w 773"/>
                <a:gd name="T107" fmla="*/ 10 h 34"/>
                <a:gd name="T108" fmla="*/ 678 w 773"/>
                <a:gd name="T109" fmla="*/ 13 h 34"/>
                <a:gd name="T110" fmla="*/ 691 w 773"/>
                <a:gd name="T111" fmla="*/ 8 h 34"/>
                <a:gd name="T112" fmla="*/ 703 w 773"/>
                <a:gd name="T113" fmla="*/ 11 h 34"/>
                <a:gd name="T114" fmla="*/ 715 w 773"/>
                <a:gd name="T115" fmla="*/ 11 h 34"/>
                <a:gd name="T116" fmla="*/ 728 w 773"/>
                <a:gd name="T117" fmla="*/ 12 h 34"/>
                <a:gd name="T118" fmla="*/ 740 w 773"/>
                <a:gd name="T119" fmla="*/ 6 h 34"/>
                <a:gd name="T120" fmla="*/ 752 w 773"/>
                <a:gd name="T121" fmla="*/ 10 h 34"/>
                <a:gd name="T122" fmla="*/ 765 w 773"/>
                <a:gd name="T123" fmla="*/ 7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773" h="34">
                  <a:moveTo>
                    <a:pt x="0" y="27"/>
                  </a:moveTo>
                  <a:lnTo>
                    <a:pt x="1" y="26"/>
                  </a:lnTo>
                  <a:lnTo>
                    <a:pt x="2" y="23"/>
                  </a:lnTo>
                  <a:lnTo>
                    <a:pt x="3" y="26"/>
                  </a:lnTo>
                  <a:lnTo>
                    <a:pt x="4" y="25"/>
                  </a:lnTo>
                  <a:lnTo>
                    <a:pt x="4" y="28"/>
                  </a:lnTo>
                  <a:lnTo>
                    <a:pt x="5" y="21"/>
                  </a:lnTo>
                  <a:lnTo>
                    <a:pt x="6" y="20"/>
                  </a:lnTo>
                  <a:lnTo>
                    <a:pt x="7" y="21"/>
                  </a:lnTo>
                  <a:lnTo>
                    <a:pt x="8" y="17"/>
                  </a:lnTo>
                  <a:lnTo>
                    <a:pt x="9" y="19"/>
                  </a:lnTo>
                  <a:lnTo>
                    <a:pt x="10" y="17"/>
                  </a:lnTo>
                  <a:lnTo>
                    <a:pt x="11" y="17"/>
                  </a:lnTo>
                  <a:lnTo>
                    <a:pt x="11" y="16"/>
                  </a:lnTo>
                  <a:lnTo>
                    <a:pt x="12" y="19"/>
                  </a:lnTo>
                  <a:lnTo>
                    <a:pt x="13" y="21"/>
                  </a:lnTo>
                  <a:lnTo>
                    <a:pt x="14" y="19"/>
                  </a:lnTo>
                  <a:lnTo>
                    <a:pt x="15" y="18"/>
                  </a:lnTo>
                  <a:lnTo>
                    <a:pt x="16" y="17"/>
                  </a:lnTo>
                  <a:lnTo>
                    <a:pt x="17" y="17"/>
                  </a:lnTo>
                  <a:lnTo>
                    <a:pt x="18" y="13"/>
                  </a:lnTo>
                  <a:lnTo>
                    <a:pt x="19" y="18"/>
                  </a:lnTo>
                  <a:lnTo>
                    <a:pt x="19" y="21"/>
                  </a:lnTo>
                  <a:lnTo>
                    <a:pt x="20" y="22"/>
                  </a:lnTo>
                  <a:lnTo>
                    <a:pt x="21" y="20"/>
                  </a:lnTo>
                  <a:lnTo>
                    <a:pt x="22" y="22"/>
                  </a:lnTo>
                  <a:lnTo>
                    <a:pt x="23" y="24"/>
                  </a:lnTo>
                  <a:lnTo>
                    <a:pt x="24" y="20"/>
                  </a:lnTo>
                  <a:lnTo>
                    <a:pt x="25" y="17"/>
                  </a:lnTo>
                  <a:lnTo>
                    <a:pt x="26" y="21"/>
                  </a:lnTo>
                  <a:lnTo>
                    <a:pt x="26" y="19"/>
                  </a:lnTo>
                  <a:lnTo>
                    <a:pt x="27" y="23"/>
                  </a:lnTo>
                  <a:lnTo>
                    <a:pt x="28" y="15"/>
                  </a:lnTo>
                  <a:lnTo>
                    <a:pt x="29" y="19"/>
                  </a:lnTo>
                  <a:lnTo>
                    <a:pt x="30" y="13"/>
                  </a:lnTo>
                  <a:lnTo>
                    <a:pt x="31" y="14"/>
                  </a:lnTo>
                  <a:lnTo>
                    <a:pt x="32" y="14"/>
                  </a:lnTo>
                  <a:lnTo>
                    <a:pt x="33" y="19"/>
                  </a:lnTo>
                  <a:lnTo>
                    <a:pt x="33" y="14"/>
                  </a:lnTo>
                  <a:lnTo>
                    <a:pt x="34" y="12"/>
                  </a:lnTo>
                  <a:lnTo>
                    <a:pt x="35" y="17"/>
                  </a:lnTo>
                  <a:lnTo>
                    <a:pt x="36" y="15"/>
                  </a:lnTo>
                  <a:lnTo>
                    <a:pt x="37" y="12"/>
                  </a:lnTo>
                  <a:lnTo>
                    <a:pt x="38" y="16"/>
                  </a:lnTo>
                  <a:lnTo>
                    <a:pt x="39" y="13"/>
                  </a:lnTo>
                  <a:lnTo>
                    <a:pt x="40" y="14"/>
                  </a:lnTo>
                  <a:lnTo>
                    <a:pt x="41" y="13"/>
                  </a:lnTo>
                  <a:lnTo>
                    <a:pt x="41" y="12"/>
                  </a:lnTo>
                  <a:lnTo>
                    <a:pt x="42" y="12"/>
                  </a:lnTo>
                  <a:lnTo>
                    <a:pt x="43" y="11"/>
                  </a:lnTo>
                  <a:lnTo>
                    <a:pt x="44" y="18"/>
                  </a:lnTo>
                  <a:lnTo>
                    <a:pt x="45" y="13"/>
                  </a:lnTo>
                  <a:lnTo>
                    <a:pt x="46" y="15"/>
                  </a:lnTo>
                  <a:lnTo>
                    <a:pt x="47" y="11"/>
                  </a:lnTo>
                  <a:lnTo>
                    <a:pt x="48" y="13"/>
                  </a:lnTo>
                  <a:lnTo>
                    <a:pt x="48" y="12"/>
                  </a:lnTo>
                  <a:lnTo>
                    <a:pt x="49" y="9"/>
                  </a:lnTo>
                  <a:lnTo>
                    <a:pt x="50" y="11"/>
                  </a:lnTo>
                  <a:lnTo>
                    <a:pt x="51" y="9"/>
                  </a:lnTo>
                  <a:lnTo>
                    <a:pt x="52" y="11"/>
                  </a:lnTo>
                  <a:lnTo>
                    <a:pt x="53" y="16"/>
                  </a:lnTo>
                  <a:lnTo>
                    <a:pt x="54" y="10"/>
                  </a:lnTo>
                  <a:lnTo>
                    <a:pt x="55" y="14"/>
                  </a:lnTo>
                  <a:lnTo>
                    <a:pt x="56" y="11"/>
                  </a:lnTo>
                  <a:lnTo>
                    <a:pt x="56" y="11"/>
                  </a:lnTo>
                  <a:lnTo>
                    <a:pt x="57" y="14"/>
                  </a:lnTo>
                  <a:lnTo>
                    <a:pt x="58" y="12"/>
                  </a:lnTo>
                  <a:lnTo>
                    <a:pt x="59" y="11"/>
                  </a:lnTo>
                  <a:lnTo>
                    <a:pt x="60" y="7"/>
                  </a:lnTo>
                  <a:lnTo>
                    <a:pt x="61" y="9"/>
                  </a:lnTo>
                  <a:lnTo>
                    <a:pt x="62" y="12"/>
                  </a:lnTo>
                  <a:lnTo>
                    <a:pt x="63" y="8"/>
                  </a:lnTo>
                  <a:lnTo>
                    <a:pt x="63" y="14"/>
                  </a:lnTo>
                  <a:lnTo>
                    <a:pt x="64" y="9"/>
                  </a:lnTo>
                  <a:lnTo>
                    <a:pt x="65" y="7"/>
                  </a:lnTo>
                  <a:lnTo>
                    <a:pt x="66" y="9"/>
                  </a:lnTo>
                  <a:lnTo>
                    <a:pt x="67" y="10"/>
                  </a:lnTo>
                  <a:lnTo>
                    <a:pt x="68" y="8"/>
                  </a:lnTo>
                  <a:lnTo>
                    <a:pt x="69" y="12"/>
                  </a:lnTo>
                  <a:lnTo>
                    <a:pt x="70" y="13"/>
                  </a:lnTo>
                  <a:lnTo>
                    <a:pt x="71" y="7"/>
                  </a:lnTo>
                  <a:lnTo>
                    <a:pt x="71" y="8"/>
                  </a:lnTo>
                  <a:lnTo>
                    <a:pt x="72" y="10"/>
                  </a:lnTo>
                  <a:lnTo>
                    <a:pt x="73" y="11"/>
                  </a:lnTo>
                  <a:lnTo>
                    <a:pt x="74" y="10"/>
                  </a:lnTo>
                  <a:lnTo>
                    <a:pt x="75" y="10"/>
                  </a:lnTo>
                  <a:lnTo>
                    <a:pt x="76" y="9"/>
                  </a:lnTo>
                  <a:lnTo>
                    <a:pt x="77" y="11"/>
                  </a:lnTo>
                  <a:lnTo>
                    <a:pt x="78" y="7"/>
                  </a:lnTo>
                  <a:lnTo>
                    <a:pt x="78" y="13"/>
                  </a:lnTo>
                  <a:lnTo>
                    <a:pt x="79" y="7"/>
                  </a:lnTo>
                  <a:lnTo>
                    <a:pt x="80" y="10"/>
                  </a:lnTo>
                  <a:lnTo>
                    <a:pt x="81" y="8"/>
                  </a:lnTo>
                  <a:lnTo>
                    <a:pt x="82" y="9"/>
                  </a:lnTo>
                  <a:lnTo>
                    <a:pt x="83" y="10"/>
                  </a:lnTo>
                  <a:lnTo>
                    <a:pt x="84" y="8"/>
                  </a:lnTo>
                  <a:lnTo>
                    <a:pt x="85" y="4"/>
                  </a:lnTo>
                  <a:lnTo>
                    <a:pt x="86" y="7"/>
                  </a:lnTo>
                  <a:lnTo>
                    <a:pt x="86" y="7"/>
                  </a:lnTo>
                  <a:lnTo>
                    <a:pt x="87" y="7"/>
                  </a:lnTo>
                  <a:lnTo>
                    <a:pt x="88" y="7"/>
                  </a:lnTo>
                  <a:lnTo>
                    <a:pt x="89" y="9"/>
                  </a:lnTo>
                  <a:lnTo>
                    <a:pt x="90" y="12"/>
                  </a:lnTo>
                  <a:lnTo>
                    <a:pt x="91" y="6"/>
                  </a:lnTo>
                  <a:lnTo>
                    <a:pt x="92" y="11"/>
                  </a:lnTo>
                  <a:lnTo>
                    <a:pt x="93" y="8"/>
                  </a:lnTo>
                  <a:lnTo>
                    <a:pt x="93" y="7"/>
                  </a:lnTo>
                  <a:lnTo>
                    <a:pt x="94" y="8"/>
                  </a:lnTo>
                  <a:lnTo>
                    <a:pt x="95" y="2"/>
                  </a:lnTo>
                  <a:lnTo>
                    <a:pt x="96" y="7"/>
                  </a:lnTo>
                  <a:lnTo>
                    <a:pt x="97" y="6"/>
                  </a:lnTo>
                  <a:lnTo>
                    <a:pt x="98" y="7"/>
                  </a:lnTo>
                  <a:lnTo>
                    <a:pt x="99" y="9"/>
                  </a:lnTo>
                  <a:lnTo>
                    <a:pt x="100" y="5"/>
                  </a:lnTo>
                  <a:lnTo>
                    <a:pt x="101" y="8"/>
                  </a:lnTo>
                  <a:lnTo>
                    <a:pt x="101" y="7"/>
                  </a:lnTo>
                  <a:lnTo>
                    <a:pt x="102" y="12"/>
                  </a:lnTo>
                  <a:lnTo>
                    <a:pt x="103" y="11"/>
                  </a:lnTo>
                  <a:lnTo>
                    <a:pt x="104" y="10"/>
                  </a:lnTo>
                  <a:lnTo>
                    <a:pt x="105" y="10"/>
                  </a:lnTo>
                  <a:lnTo>
                    <a:pt x="106" y="9"/>
                  </a:lnTo>
                  <a:lnTo>
                    <a:pt x="107" y="11"/>
                  </a:lnTo>
                  <a:lnTo>
                    <a:pt x="108" y="11"/>
                  </a:lnTo>
                  <a:lnTo>
                    <a:pt x="108" y="6"/>
                  </a:lnTo>
                  <a:lnTo>
                    <a:pt x="109" y="9"/>
                  </a:lnTo>
                  <a:lnTo>
                    <a:pt x="110" y="10"/>
                  </a:lnTo>
                  <a:lnTo>
                    <a:pt x="111" y="8"/>
                  </a:lnTo>
                  <a:lnTo>
                    <a:pt x="112" y="10"/>
                  </a:lnTo>
                  <a:lnTo>
                    <a:pt x="113" y="8"/>
                  </a:lnTo>
                  <a:lnTo>
                    <a:pt x="114" y="8"/>
                  </a:lnTo>
                  <a:lnTo>
                    <a:pt x="115" y="6"/>
                  </a:lnTo>
                  <a:lnTo>
                    <a:pt x="116" y="6"/>
                  </a:lnTo>
                  <a:lnTo>
                    <a:pt x="116" y="7"/>
                  </a:lnTo>
                  <a:lnTo>
                    <a:pt x="117" y="7"/>
                  </a:lnTo>
                  <a:lnTo>
                    <a:pt x="118" y="7"/>
                  </a:lnTo>
                  <a:lnTo>
                    <a:pt x="119" y="7"/>
                  </a:lnTo>
                  <a:lnTo>
                    <a:pt x="120" y="0"/>
                  </a:lnTo>
                  <a:lnTo>
                    <a:pt x="121" y="10"/>
                  </a:lnTo>
                  <a:lnTo>
                    <a:pt x="122" y="6"/>
                  </a:lnTo>
                  <a:lnTo>
                    <a:pt x="123" y="9"/>
                  </a:lnTo>
                  <a:lnTo>
                    <a:pt x="123" y="7"/>
                  </a:lnTo>
                  <a:lnTo>
                    <a:pt x="124" y="8"/>
                  </a:lnTo>
                  <a:lnTo>
                    <a:pt x="125" y="4"/>
                  </a:lnTo>
                  <a:lnTo>
                    <a:pt x="126" y="7"/>
                  </a:lnTo>
                  <a:lnTo>
                    <a:pt x="127" y="8"/>
                  </a:lnTo>
                  <a:lnTo>
                    <a:pt x="128" y="10"/>
                  </a:lnTo>
                  <a:lnTo>
                    <a:pt x="129" y="5"/>
                  </a:lnTo>
                  <a:lnTo>
                    <a:pt x="130" y="6"/>
                  </a:lnTo>
                  <a:lnTo>
                    <a:pt x="131" y="9"/>
                  </a:lnTo>
                  <a:lnTo>
                    <a:pt x="131" y="9"/>
                  </a:lnTo>
                  <a:lnTo>
                    <a:pt x="132" y="8"/>
                  </a:lnTo>
                  <a:lnTo>
                    <a:pt x="133" y="7"/>
                  </a:lnTo>
                  <a:lnTo>
                    <a:pt x="134" y="6"/>
                  </a:lnTo>
                  <a:lnTo>
                    <a:pt x="135" y="7"/>
                  </a:lnTo>
                  <a:lnTo>
                    <a:pt x="136" y="8"/>
                  </a:lnTo>
                  <a:lnTo>
                    <a:pt x="137" y="4"/>
                  </a:lnTo>
                  <a:lnTo>
                    <a:pt x="138" y="10"/>
                  </a:lnTo>
                  <a:lnTo>
                    <a:pt x="138" y="4"/>
                  </a:lnTo>
                  <a:lnTo>
                    <a:pt x="139" y="6"/>
                  </a:lnTo>
                  <a:lnTo>
                    <a:pt x="140" y="9"/>
                  </a:lnTo>
                  <a:lnTo>
                    <a:pt x="141" y="6"/>
                  </a:lnTo>
                  <a:lnTo>
                    <a:pt x="142" y="8"/>
                  </a:lnTo>
                  <a:lnTo>
                    <a:pt x="143" y="10"/>
                  </a:lnTo>
                  <a:lnTo>
                    <a:pt x="144" y="9"/>
                  </a:lnTo>
                  <a:lnTo>
                    <a:pt x="145" y="8"/>
                  </a:lnTo>
                  <a:lnTo>
                    <a:pt x="146" y="6"/>
                  </a:lnTo>
                  <a:lnTo>
                    <a:pt x="146" y="7"/>
                  </a:lnTo>
                  <a:lnTo>
                    <a:pt x="147" y="5"/>
                  </a:lnTo>
                  <a:lnTo>
                    <a:pt x="148" y="5"/>
                  </a:lnTo>
                  <a:lnTo>
                    <a:pt x="149" y="3"/>
                  </a:lnTo>
                  <a:lnTo>
                    <a:pt x="150" y="4"/>
                  </a:lnTo>
                  <a:lnTo>
                    <a:pt x="151" y="5"/>
                  </a:lnTo>
                  <a:lnTo>
                    <a:pt x="152" y="10"/>
                  </a:lnTo>
                  <a:lnTo>
                    <a:pt x="153" y="3"/>
                  </a:lnTo>
                  <a:lnTo>
                    <a:pt x="153" y="7"/>
                  </a:lnTo>
                  <a:lnTo>
                    <a:pt x="154" y="10"/>
                  </a:lnTo>
                  <a:lnTo>
                    <a:pt x="155" y="4"/>
                  </a:lnTo>
                  <a:lnTo>
                    <a:pt x="156" y="7"/>
                  </a:lnTo>
                  <a:lnTo>
                    <a:pt x="157" y="9"/>
                  </a:lnTo>
                  <a:lnTo>
                    <a:pt x="158" y="7"/>
                  </a:lnTo>
                  <a:lnTo>
                    <a:pt x="159" y="7"/>
                  </a:lnTo>
                  <a:lnTo>
                    <a:pt x="160" y="8"/>
                  </a:lnTo>
                  <a:lnTo>
                    <a:pt x="161" y="4"/>
                  </a:lnTo>
                  <a:lnTo>
                    <a:pt x="161" y="5"/>
                  </a:lnTo>
                  <a:lnTo>
                    <a:pt x="162" y="8"/>
                  </a:lnTo>
                  <a:lnTo>
                    <a:pt x="163" y="5"/>
                  </a:lnTo>
                  <a:lnTo>
                    <a:pt x="164" y="5"/>
                  </a:lnTo>
                  <a:lnTo>
                    <a:pt x="165" y="5"/>
                  </a:lnTo>
                  <a:lnTo>
                    <a:pt x="166" y="7"/>
                  </a:lnTo>
                  <a:lnTo>
                    <a:pt x="167" y="6"/>
                  </a:lnTo>
                  <a:lnTo>
                    <a:pt x="168" y="8"/>
                  </a:lnTo>
                  <a:lnTo>
                    <a:pt x="168" y="6"/>
                  </a:lnTo>
                  <a:lnTo>
                    <a:pt x="169" y="6"/>
                  </a:lnTo>
                  <a:lnTo>
                    <a:pt x="170" y="3"/>
                  </a:lnTo>
                  <a:lnTo>
                    <a:pt x="171" y="7"/>
                  </a:lnTo>
                  <a:lnTo>
                    <a:pt x="172" y="11"/>
                  </a:lnTo>
                  <a:lnTo>
                    <a:pt x="173" y="6"/>
                  </a:lnTo>
                  <a:lnTo>
                    <a:pt x="174" y="11"/>
                  </a:lnTo>
                  <a:lnTo>
                    <a:pt x="175" y="5"/>
                  </a:lnTo>
                  <a:lnTo>
                    <a:pt x="176" y="7"/>
                  </a:lnTo>
                  <a:lnTo>
                    <a:pt x="176" y="5"/>
                  </a:lnTo>
                  <a:lnTo>
                    <a:pt x="177" y="5"/>
                  </a:lnTo>
                  <a:lnTo>
                    <a:pt x="178" y="3"/>
                  </a:lnTo>
                  <a:lnTo>
                    <a:pt x="179" y="8"/>
                  </a:lnTo>
                  <a:lnTo>
                    <a:pt x="180" y="5"/>
                  </a:lnTo>
                  <a:lnTo>
                    <a:pt x="181" y="8"/>
                  </a:lnTo>
                  <a:lnTo>
                    <a:pt x="182" y="6"/>
                  </a:lnTo>
                  <a:lnTo>
                    <a:pt x="183" y="8"/>
                  </a:lnTo>
                  <a:lnTo>
                    <a:pt x="183" y="4"/>
                  </a:lnTo>
                  <a:lnTo>
                    <a:pt x="184" y="6"/>
                  </a:lnTo>
                  <a:lnTo>
                    <a:pt x="185" y="8"/>
                  </a:lnTo>
                  <a:lnTo>
                    <a:pt x="186" y="5"/>
                  </a:lnTo>
                  <a:lnTo>
                    <a:pt x="187" y="8"/>
                  </a:lnTo>
                  <a:lnTo>
                    <a:pt x="188" y="5"/>
                  </a:lnTo>
                  <a:lnTo>
                    <a:pt x="189" y="5"/>
                  </a:lnTo>
                  <a:lnTo>
                    <a:pt x="190" y="8"/>
                  </a:lnTo>
                  <a:lnTo>
                    <a:pt x="191" y="8"/>
                  </a:lnTo>
                  <a:lnTo>
                    <a:pt x="191" y="5"/>
                  </a:lnTo>
                  <a:lnTo>
                    <a:pt x="192" y="8"/>
                  </a:lnTo>
                  <a:lnTo>
                    <a:pt x="193" y="5"/>
                  </a:lnTo>
                  <a:lnTo>
                    <a:pt x="194" y="5"/>
                  </a:lnTo>
                  <a:lnTo>
                    <a:pt x="195" y="7"/>
                  </a:lnTo>
                  <a:lnTo>
                    <a:pt x="196" y="7"/>
                  </a:lnTo>
                  <a:lnTo>
                    <a:pt x="197" y="4"/>
                  </a:lnTo>
                  <a:lnTo>
                    <a:pt x="198" y="7"/>
                  </a:lnTo>
                  <a:lnTo>
                    <a:pt x="198" y="7"/>
                  </a:lnTo>
                  <a:lnTo>
                    <a:pt x="199" y="4"/>
                  </a:lnTo>
                  <a:lnTo>
                    <a:pt x="200" y="3"/>
                  </a:lnTo>
                  <a:lnTo>
                    <a:pt x="201" y="4"/>
                  </a:lnTo>
                  <a:lnTo>
                    <a:pt x="202" y="7"/>
                  </a:lnTo>
                  <a:lnTo>
                    <a:pt x="203" y="8"/>
                  </a:lnTo>
                  <a:lnTo>
                    <a:pt x="204" y="3"/>
                  </a:lnTo>
                  <a:lnTo>
                    <a:pt x="205" y="4"/>
                  </a:lnTo>
                  <a:lnTo>
                    <a:pt x="206" y="9"/>
                  </a:lnTo>
                  <a:lnTo>
                    <a:pt x="206" y="5"/>
                  </a:lnTo>
                  <a:lnTo>
                    <a:pt x="207" y="8"/>
                  </a:lnTo>
                  <a:lnTo>
                    <a:pt x="208" y="5"/>
                  </a:lnTo>
                  <a:lnTo>
                    <a:pt x="209" y="10"/>
                  </a:lnTo>
                  <a:lnTo>
                    <a:pt x="210" y="6"/>
                  </a:lnTo>
                  <a:lnTo>
                    <a:pt x="211" y="5"/>
                  </a:lnTo>
                  <a:lnTo>
                    <a:pt x="212" y="9"/>
                  </a:lnTo>
                  <a:lnTo>
                    <a:pt x="213" y="8"/>
                  </a:lnTo>
                  <a:lnTo>
                    <a:pt x="213" y="14"/>
                  </a:lnTo>
                  <a:lnTo>
                    <a:pt x="214" y="13"/>
                  </a:lnTo>
                  <a:lnTo>
                    <a:pt x="215" y="19"/>
                  </a:lnTo>
                  <a:lnTo>
                    <a:pt x="216" y="18"/>
                  </a:lnTo>
                  <a:lnTo>
                    <a:pt x="217" y="21"/>
                  </a:lnTo>
                  <a:lnTo>
                    <a:pt x="218" y="27"/>
                  </a:lnTo>
                  <a:lnTo>
                    <a:pt x="219" y="24"/>
                  </a:lnTo>
                  <a:lnTo>
                    <a:pt x="220" y="26"/>
                  </a:lnTo>
                  <a:lnTo>
                    <a:pt x="220" y="34"/>
                  </a:lnTo>
                  <a:lnTo>
                    <a:pt x="221" y="31"/>
                  </a:lnTo>
                  <a:lnTo>
                    <a:pt x="222" y="26"/>
                  </a:lnTo>
                  <a:lnTo>
                    <a:pt x="223" y="26"/>
                  </a:lnTo>
                  <a:lnTo>
                    <a:pt x="224" y="24"/>
                  </a:lnTo>
                  <a:lnTo>
                    <a:pt x="225" y="21"/>
                  </a:lnTo>
                  <a:lnTo>
                    <a:pt x="226" y="25"/>
                  </a:lnTo>
                  <a:lnTo>
                    <a:pt x="227" y="18"/>
                  </a:lnTo>
                  <a:lnTo>
                    <a:pt x="228" y="13"/>
                  </a:lnTo>
                  <a:lnTo>
                    <a:pt x="228" y="15"/>
                  </a:lnTo>
                  <a:lnTo>
                    <a:pt x="229" y="13"/>
                  </a:lnTo>
                  <a:lnTo>
                    <a:pt x="230" y="12"/>
                  </a:lnTo>
                  <a:lnTo>
                    <a:pt x="231" y="12"/>
                  </a:lnTo>
                  <a:lnTo>
                    <a:pt x="232" y="12"/>
                  </a:lnTo>
                  <a:lnTo>
                    <a:pt x="233" y="12"/>
                  </a:lnTo>
                  <a:lnTo>
                    <a:pt x="234" y="10"/>
                  </a:lnTo>
                  <a:lnTo>
                    <a:pt x="235" y="11"/>
                  </a:lnTo>
                  <a:lnTo>
                    <a:pt x="235" y="10"/>
                  </a:lnTo>
                  <a:lnTo>
                    <a:pt x="236" y="10"/>
                  </a:lnTo>
                  <a:lnTo>
                    <a:pt x="237" y="8"/>
                  </a:lnTo>
                  <a:lnTo>
                    <a:pt x="238" y="13"/>
                  </a:lnTo>
                  <a:lnTo>
                    <a:pt x="239" y="6"/>
                  </a:lnTo>
                  <a:lnTo>
                    <a:pt x="240" y="7"/>
                  </a:lnTo>
                  <a:lnTo>
                    <a:pt x="241" y="12"/>
                  </a:lnTo>
                  <a:lnTo>
                    <a:pt x="242" y="9"/>
                  </a:lnTo>
                  <a:lnTo>
                    <a:pt x="243" y="5"/>
                  </a:lnTo>
                  <a:lnTo>
                    <a:pt x="243" y="8"/>
                  </a:lnTo>
                  <a:lnTo>
                    <a:pt x="244" y="10"/>
                  </a:lnTo>
                  <a:lnTo>
                    <a:pt x="245" y="8"/>
                  </a:lnTo>
                  <a:lnTo>
                    <a:pt x="246" y="10"/>
                  </a:lnTo>
                  <a:lnTo>
                    <a:pt x="247" y="8"/>
                  </a:lnTo>
                  <a:lnTo>
                    <a:pt x="248" y="3"/>
                  </a:lnTo>
                  <a:lnTo>
                    <a:pt x="249" y="11"/>
                  </a:lnTo>
                  <a:lnTo>
                    <a:pt x="250" y="8"/>
                  </a:lnTo>
                  <a:lnTo>
                    <a:pt x="250" y="6"/>
                  </a:lnTo>
                  <a:lnTo>
                    <a:pt x="251" y="7"/>
                  </a:lnTo>
                  <a:lnTo>
                    <a:pt x="252" y="10"/>
                  </a:lnTo>
                  <a:lnTo>
                    <a:pt x="253" y="10"/>
                  </a:lnTo>
                  <a:lnTo>
                    <a:pt x="254" y="8"/>
                  </a:lnTo>
                  <a:lnTo>
                    <a:pt x="255" y="5"/>
                  </a:lnTo>
                  <a:lnTo>
                    <a:pt x="256" y="7"/>
                  </a:lnTo>
                  <a:lnTo>
                    <a:pt x="257" y="12"/>
                  </a:lnTo>
                  <a:lnTo>
                    <a:pt x="258" y="7"/>
                  </a:lnTo>
                  <a:lnTo>
                    <a:pt x="258" y="8"/>
                  </a:lnTo>
                  <a:lnTo>
                    <a:pt x="259" y="9"/>
                  </a:lnTo>
                  <a:lnTo>
                    <a:pt x="260" y="8"/>
                  </a:lnTo>
                  <a:lnTo>
                    <a:pt x="261" y="7"/>
                  </a:lnTo>
                  <a:lnTo>
                    <a:pt x="262" y="7"/>
                  </a:lnTo>
                  <a:lnTo>
                    <a:pt x="263" y="7"/>
                  </a:lnTo>
                  <a:lnTo>
                    <a:pt x="264" y="9"/>
                  </a:lnTo>
                  <a:lnTo>
                    <a:pt x="265" y="5"/>
                  </a:lnTo>
                  <a:lnTo>
                    <a:pt x="265" y="3"/>
                  </a:lnTo>
                  <a:lnTo>
                    <a:pt x="266" y="8"/>
                  </a:lnTo>
                  <a:lnTo>
                    <a:pt x="267" y="8"/>
                  </a:lnTo>
                  <a:lnTo>
                    <a:pt x="268" y="7"/>
                  </a:lnTo>
                  <a:lnTo>
                    <a:pt x="269" y="9"/>
                  </a:lnTo>
                  <a:lnTo>
                    <a:pt x="270" y="7"/>
                  </a:lnTo>
                  <a:lnTo>
                    <a:pt x="271" y="11"/>
                  </a:lnTo>
                  <a:lnTo>
                    <a:pt x="272" y="6"/>
                  </a:lnTo>
                  <a:lnTo>
                    <a:pt x="273" y="10"/>
                  </a:lnTo>
                  <a:lnTo>
                    <a:pt x="273" y="5"/>
                  </a:lnTo>
                  <a:lnTo>
                    <a:pt x="274" y="12"/>
                  </a:lnTo>
                  <a:lnTo>
                    <a:pt x="275" y="12"/>
                  </a:lnTo>
                  <a:lnTo>
                    <a:pt x="276" y="10"/>
                  </a:lnTo>
                  <a:lnTo>
                    <a:pt x="277" y="8"/>
                  </a:lnTo>
                  <a:lnTo>
                    <a:pt x="278" y="10"/>
                  </a:lnTo>
                  <a:lnTo>
                    <a:pt x="279" y="12"/>
                  </a:lnTo>
                  <a:lnTo>
                    <a:pt x="280" y="10"/>
                  </a:lnTo>
                  <a:lnTo>
                    <a:pt x="280" y="11"/>
                  </a:lnTo>
                  <a:lnTo>
                    <a:pt x="281" y="15"/>
                  </a:lnTo>
                  <a:lnTo>
                    <a:pt x="282" y="10"/>
                  </a:lnTo>
                  <a:lnTo>
                    <a:pt x="283" y="12"/>
                  </a:lnTo>
                  <a:lnTo>
                    <a:pt x="284" y="12"/>
                  </a:lnTo>
                  <a:lnTo>
                    <a:pt x="285" y="10"/>
                  </a:lnTo>
                  <a:lnTo>
                    <a:pt x="286" y="11"/>
                  </a:lnTo>
                  <a:lnTo>
                    <a:pt x="287" y="17"/>
                  </a:lnTo>
                  <a:lnTo>
                    <a:pt x="288" y="14"/>
                  </a:lnTo>
                  <a:lnTo>
                    <a:pt x="288" y="10"/>
                  </a:lnTo>
                  <a:lnTo>
                    <a:pt x="289" y="10"/>
                  </a:lnTo>
                  <a:lnTo>
                    <a:pt x="290" y="10"/>
                  </a:lnTo>
                  <a:lnTo>
                    <a:pt x="291" y="14"/>
                  </a:lnTo>
                  <a:lnTo>
                    <a:pt x="292" y="12"/>
                  </a:lnTo>
                  <a:lnTo>
                    <a:pt x="293" y="19"/>
                  </a:lnTo>
                  <a:lnTo>
                    <a:pt x="294" y="15"/>
                  </a:lnTo>
                  <a:lnTo>
                    <a:pt x="295" y="13"/>
                  </a:lnTo>
                  <a:lnTo>
                    <a:pt x="295" y="15"/>
                  </a:lnTo>
                  <a:lnTo>
                    <a:pt x="296" y="15"/>
                  </a:lnTo>
                  <a:lnTo>
                    <a:pt x="297" y="16"/>
                  </a:lnTo>
                  <a:lnTo>
                    <a:pt x="298" y="15"/>
                  </a:lnTo>
                  <a:lnTo>
                    <a:pt x="299" y="10"/>
                  </a:lnTo>
                  <a:lnTo>
                    <a:pt x="300" y="14"/>
                  </a:lnTo>
                  <a:lnTo>
                    <a:pt x="301" y="18"/>
                  </a:lnTo>
                  <a:lnTo>
                    <a:pt x="302" y="13"/>
                  </a:lnTo>
                  <a:lnTo>
                    <a:pt x="303" y="14"/>
                  </a:lnTo>
                  <a:lnTo>
                    <a:pt x="303" y="11"/>
                  </a:lnTo>
                  <a:lnTo>
                    <a:pt x="304" y="18"/>
                  </a:lnTo>
                  <a:lnTo>
                    <a:pt x="305" y="16"/>
                  </a:lnTo>
                  <a:lnTo>
                    <a:pt x="306" y="15"/>
                  </a:lnTo>
                  <a:lnTo>
                    <a:pt x="307" y="10"/>
                  </a:lnTo>
                  <a:lnTo>
                    <a:pt x="308" y="17"/>
                  </a:lnTo>
                  <a:lnTo>
                    <a:pt x="309" y="18"/>
                  </a:lnTo>
                  <a:lnTo>
                    <a:pt x="310" y="10"/>
                  </a:lnTo>
                  <a:lnTo>
                    <a:pt x="310" y="17"/>
                  </a:lnTo>
                  <a:lnTo>
                    <a:pt x="311" y="15"/>
                  </a:lnTo>
                  <a:lnTo>
                    <a:pt x="312" y="14"/>
                  </a:lnTo>
                  <a:lnTo>
                    <a:pt x="313" y="19"/>
                  </a:lnTo>
                  <a:lnTo>
                    <a:pt x="314" y="20"/>
                  </a:lnTo>
                  <a:lnTo>
                    <a:pt x="315" y="23"/>
                  </a:lnTo>
                  <a:lnTo>
                    <a:pt x="316" y="19"/>
                  </a:lnTo>
                  <a:lnTo>
                    <a:pt x="317" y="21"/>
                  </a:lnTo>
                  <a:lnTo>
                    <a:pt x="318" y="16"/>
                  </a:lnTo>
                  <a:lnTo>
                    <a:pt x="318" y="20"/>
                  </a:lnTo>
                  <a:lnTo>
                    <a:pt x="319" y="16"/>
                  </a:lnTo>
                  <a:lnTo>
                    <a:pt x="320" y="23"/>
                  </a:lnTo>
                  <a:lnTo>
                    <a:pt x="321" y="22"/>
                  </a:lnTo>
                  <a:lnTo>
                    <a:pt x="322" y="23"/>
                  </a:lnTo>
                  <a:lnTo>
                    <a:pt x="323" y="17"/>
                  </a:lnTo>
                  <a:lnTo>
                    <a:pt x="324" y="20"/>
                  </a:lnTo>
                  <a:lnTo>
                    <a:pt x="325" y="22"/>
                  </a:lnTo>
                  <a:lnTo>
                    <a:pt x="325" y="20"/>
                  </a:lnTo>
                  <a:lnTo>
                    <a:pt x="326" y="18"/>
                  </a:lnTo>
                  <a:lnTo>
                    <a:pt x="327" y="22"/>
                  </a:lnTo>
                  <a:lnTo>
                    <a:pt x="328" y="21"/>
                  </a:lnTo>
                  <a:lnTo>
                    <a:pt x="329" y="19"/>
                  </a:lnTo>
                  <a:lnTo>
                    <a:pt x="330" y="24"/>
                  </a:lnTo>
                  <a:lnTo>
                    <a:pt x="331" y="19"/>
                  </a:lnTo>
                  <a:lnTo>
                    <a:pt x="332" y="21"/>
                  </a:lnTo>
                  <a:lnTo>
                    <a:pt x="333" y="25"/>
                  </a:lnTo>
                  <a:lnTo>
                    <a:pt x="333" y="19"/>
                  </a:lnTo>
                  <a:lnTo>
                    <a:pt x="334" y="23"/>
                  </a:lnTo>
                  <a:lnTo>
                    <a:pt x="335" y="21"/>
                  </a:lnTo>
                  <a:lnTo>
                    <a:pt x="336" y="25"/>
                  </a:lnTo>
                  <a:lnTo>
                    <a:pt x="337" y="23"/>
                  </a:lnTo>
                  <a:lnTo>
                    <a:pt x="338" y="25"/>
                  </a:lnTo>
                  <a:lnTo>
                    <a:pt x="339" y="20"/>
                  </a:lnTo>
                  <a:lnTo>
                    <a:pt x="340" y="22"/>
                  </a:lnTo>
                  <a:lnTo>
                    <a:pt x="340" y="19"/>
                  </a:lnTo>
                  <a:lnTo>
                    <a:pt x="341" y="16"/>
                  </a:lnTo>
                  <a:lnTo>
                    <a:pt x="342" y="18"/>
                  </a:lnTo>
                  <a:lnTo>
                    <a:pt x="343" y="16"/>
                  </a:lnTo>
                  <a:lnTo>
                    <a:pt x="344" y="16"/>
                  </a:lnTo>
                  <a:lnTo>
                    <a:pt x="345" y="16"/>
                  </a:lnTo>
                  <a:lnTo>
                    <a:pt x="346" y="21"/>
                  </a:lnTo>
                  <a:lnTo>
                    <a:pt x="347" y="23"/>
                  </a:lnTo>
                  <a:lnTo>
                    <a:pt x="348" y="19"/>
                  </a:lnTo>
                  <a:lnTo>
                    <a:pt x="348" y="14"/>
                  </a:lnTo>
                  <a:lnTo>
                    <a:pt x="349" y="20"/>
                  </a:lnTo>
                  <a:lnTo>
                    <a:pt x="350" y="14"/>
                  </a:lnTo>
                  <a:lnTo>
                    <a:pt x="351" y="22"/>
                  </a:lnTo>
                  <a:lnTo>
                    <a:pt x="352" y="18"/>
                  </a:lnTo>
                  <a:lnTo>
                    <a:pt x="353" y="14"/>
                  </a:lnTo>
                  <a:lnTo>
                    <a:pt x="354" y="26"/>
                  </a:lnTo>
                  <a:lnTo>
                    <a:pt x="355" y="22"/>
                  </a:lnTo>
                  <a:lnTo>
                    <a:pt x="355" y="23"/>
                  </a:lnTo>
                  <a:lnTo>
                    <a:pt x="356" y="22"/>
                  </a:lnTo>
                  <a:lnTo>
                    <a:pt x="357" y="21"/>
                  </a:lnTo>
                  <a:lnTo>
                    <a:pt x="358" y="24"/>
                  </a:lnTo>
                  <a:lnTo>
                    <a:pt x="359" y="20"/>
                  </a:lnTo>
                  <a:lnTo>
                    <a:pt x="360" y="19"/>
                  </a:lnTo>
                  <a:lnTo>
                    <a:pt x="361" y="25"/>
                  </a:lnTo>
                  <a:lnTo>
                    <a:pt x="362" y="25"/>
                  </a:lnTo>
                  <a:lnTo>
                    <a:pt x="363" y="30"/>
                  </a:lnTo>
                  <a:lnTo>
                    <a:pt x="363" y="24"/>
                  </a:lnTo>
                  <a:lnTo>
                    <a:pt x="364" y="30"/>
                  </a:lnTo>
                  <a:lnTo>
                    <a:pt x="365" y="24"/>
                  </a:lnTo>
                  <a:lnTo>
                    <a:pt x="366" y="25"/>
                  </a:lnTo>
                  <a:lnTo>
                    <a:pt x="367" y="27"/>
                  </a:lnTo>
                  <a:lnTo>
                    <a:pt x="368" y="31"/>
                  </a:lnTo>
                  <a:lnTo>
                    <a:pt x="369" y="33"/>
                  </a:lnTo>
                  <a:lnTo>
                    <a:pt x="370" y="29"/>
                  </a:lnTo>
                  <a:lnTo>
                    <a:pt x="370" y="21"/>
                  </a:lnTo>
                  <a:lnTo>
                    <a:pt x="371" y="20"/>
                  </a:lnTo>
                  <a:lnTo>
                    <a:pt x="372" y="21"/>
                  </a:lnTo>
                  <a:lnTo>
                    <a:pt x="373" y="28"/>
                  </a:lnTo>
                  <a:lnTo>
                    <a:pt x="374" y="19"/>
                  </a:lnTo>
                  <a:lnTo>
                    <a:pt x="375" y="18"/>
                  </a:lnTo>
                  <a:lnTo>
                    <a:pt x="376" y="22"/>
                  </a:lnTo>
                  <a:lnTo>
                    <a:pt x="377" y="24"/>
                  </a:lnTo>
                  <a:lnTo>
                    <a:pt x="378" y="22"/>
                  </a:lnTo>
                  <a:lnTo>
                    <a:pt x="378" y="20"/>
                  </a:lnTo>
                  <a:lnTo>
                    <a:pt x="379" y="15"/>
                  </a:lnTo>
                  <a:lnTo>
                    <a:pt x="380" y="20"/>
                  </a:lnTo>
                  <a:lnTo>
                    <a:pt x="381" y="19"/>
                  </a:lnTo>
                  <a:lnTo>
                    <a:pt x="382" y="19"/>
                  </a:lnTo>
                  <a:lnTo>
                    <a:pt x="383" y="20"/>
                  </a:lnTo>
                  <a:lnTo>
                    <a:pt x="384" y="20"/>
                  </a:lnTo>
                  <a:lnTo>
                    <a:pt x="385" y="20"/>
                  </a:lnTo>
                  <a:lnTo>
                    <a:pt x="385" y="19"/>
                  </a:lnTo>
                  <a:lnTo>
                    <a:pt x="386" y="20"/>
                  </a:lnTo>
                  <a:lnTo>
                    <a:pt x="387" y="15"/>
                  </a:lnTo>
                  <a:lnTo>
                    <a:pt x="388" y="18"/>
                  </a:lnTo>
                  <a:lnTo>
                    <a:pt x="389" y="18"/>
                  </a:lnTo>
                  <a:lnTo>
                    <a:pt x="390" y="18"/>
                  </a:lnTo>
                  <a:lnTo>
                    <a:pt x="391" y="20"/>
                  </a:lnTo>
                  <a:lnTo>
                    <a:pt x="392" y="19"/>
                  </a:lnTo>
                  <a:lnTo>
                    <a:pt x="393" y="15"/>
                  </a:lnTo>
                  <a:lnTo>
                    <a:pt x="393" y="13"/>
                  </a:lnTo>
                  <a:lnTo>
                    <a:pt x="394" y="20"/>
                  </a:lnTo>
                  <a:lnTo>
                    <a:pt x="395" y="17"/>
                  </a:lnTo>
                  <a:lnTo>
                    <a:pt x="396" y="22"/>
                  </a:lnTo>
                  <a:lnTo>
                    <a:pt x="397" y="16"/>
                  </a:lnTo>
                  <a:lnTo>
                    <a:pt x="398" y="17"/>
                  </a:lnTo>
                  <a:lnTo>
                    <a:pt x="399" y="18"/>
                  </a:lnTo>
                  <a:lnTo>
                    <a:pt x="400" y="14"/>
                  </a:lnTo>
                  <a:lnTo>
                    <a:pt x="400" y="18"/>
                  </a:lnTo>
                  <a:lnTo>
                    <a:pt x="401" y="15"/>
                  </a:lnTo>
                  <a:lnTo>
                    <a:pt x="402" y="20"/>
                  </a:lnTo>
                  <a:lnTo>
                    <a:pt x="403" y="18"/>
                  </a:lnTo>
                  <a:lnTo>
                    <a:pt x="404" y="16"/>
                  </a:lnTo>
                  <a:lnTo>
                    <a:pt x="405" y="19"/>
                  </a:lnTo>
                  <a:lnTo>
                    <a:pt x="406" y="14"/>
                  </a:lnTo>
                  <a:lnTo>
                    <a:pt x="407" y="15"/>
                  </a:lnTo>
                  <a:lnTo>
                    <a:pt x="408" y="20"/>
                  </a:lnTo>
                  <a:lnTo>
                    <a:pt x="408" y="21"/>
                  </a:lnTo>
                  <a:lnTo>
                    <a:pt x="409" y="17"/>
                  </a:lnTo>
                  <a:lnTo>
                    <a:pt x="410" y="20"/>
                  </a:lnTo>
                  <a:lnTo>
                    <a:pt x="411" y="20"/>
                  </a:lnTo>
                  <a:lnTo>
                    <a:pt x="412" y="21"/>
                  </a:lnTo>
                  <a:lnTo>
                    <a:pt x="413" y="22"/>
                  </a:lnTo>
                  <a:lnTo>
                    <a:pt x="414" y="19"/>
                  </a:lnTo>
                  <a:lnTo>
                    <a:pt x="415" y="14"/>
                  </a:lnTo>
                  <a:lnTo>
                    <a:pt x="415" y="25"/>
                  </a:lnTo>
                  <a:lnTo>
                    <a:pt x="416" y="17"/>
                  </a:lnTo>
                  <a:lnTo>
                    <a:pt x="417" y="19"/>
                  </a:lnTo>
                  <a:lnTo>
                    <a:pt x="418" y="27"/>
                  </a:lnTo>
                  <a:lnTo>
                    <a:pt x="419" y="20"/>
                  </a:lnTo>
                  <a:lnTo>
                    <a:pt x="420" y="24"/>
                  </a:lnTo>
                  <a:lnTo>
                    <a:pt x="421" y="28"/>
                  </a:lnTo>
                  <a:lnTo>
                    <a:pt x="422" y="27"/>
                  </a:lnTo>
                  <a:lnTo>
                    <a:pt x="422" y="21"/>
                  </a:lnTo>
                  <a:lnTo>
                    <a:pt x="423" y="22"/>
                  </a:lnTo>
                  <a:lnTo>
                    <a:pt x="424" y="23"/>
                  </a:lnTo>
                  <a:lnTo>
                    <a:pt x="425" y="24"/>
                  </a:lnTo>
                  <a:lnTo>
                    <a:pt x="426" y="24"/>
                  </a:lnTo>
                  <a:lnTo>
                    <a:pt x="427" y="26"/>
                  </a:lnTo>
                  <a:lnTo>
                    <a:pt x="428" y="16"/>
                  </a:lnTo>
                  <a:lnTo>
                    <a:pt x="429" y="24"/>
                  </a:lnTo>
                  <a:lnTo>
                    <a:pt x="430" y="24"/>
                  </a:lnTo>
                  <a:lnTo>
                    <a:pt x="430" y="19"/>
                  </a:lnTo>
                  <a:lnTo>
                    <a:pt x="431" y="20"/>
                  </a:lnTo>
                  <a:lnTo>
                    <a:pt x="432" y="23"/>
                  </a:lnTo>
                  <a:lnTo>
                    <a:pt x="433" y="22"/>
                  </a:lnTo>
                  <a:lnTo>
                    <a:pt x="434" y="26"/>
                  </a:lnTo>
                  <a:lnTo>
                    <a:pt x="435" y="24"/>
                  </a:lnTo>
                  <a:lnTo>
                    <a:pt x="436" y="23"/>
                  </a:lnTo>
                  <a:lnTo>
                    <a:pt x="437" y="21"/>
                  </a:lnTo>
                  <a:lnTo>
                    <a:pt x="437" y="24"/>
                  </a:lnTo>
                  <a:lnTo>
                    <a:pt x="438" y="26"/>
                  </a:lnTo>
                  <a:lnTo>
                    <a:pt x="439" y="26"/>
                  </a:lnTo>
                  <a:lnTo>
                    <a:pt x="440" y="21"/>
                  </a:lnTo>
                  <a:lnTo>
                    <a:pt x="441" y="26"/>
                  </a:lnTo>
                  <a:lnTo>
                    <a:pt x="442" y="29"/>
                  </a:lnTo>
                  <a:lnTo>
                    <a:pt x="443" y="27"/>
                  </a:lnTo>
                  <a:lnTo>
                    <a:pt x="444" y="24"/>
                  </a:lnTo>
                  <a:lnTo>
                    <a:pt x="445" y="25"/>
                  </a:lnTo>
                  <a:lnTo>
                    <a:pt x="445" y="17"/>
                  </a:lnTo>
                  <a:lnTo>
                    <a:pt x="446" y="23"/>
                  </a:lnTo>
                  <a:lnTo>
                    <a:pt x="447" y="27"/>
                  </a:lnTo>
                  <a:lnTo>
                    <a:pt x="448" y="22"/>
                  </a:lnTo>
                  <a:lnTo>
                    <a:pt x="449" y="21"/>
                  </a:lnTo>
                  <a:lnTo>
                    <a:pt x="450" y="23"/>
                  </a:lnTo>
                  <a:lnTo>
                    <a:pt x="451" y="19"/>
                  </a:lnTo>
                  <a:lnTo>
                    <a:pt x="452" y="23"/>
                  </a:lnTo>
                  <a:lnTo>
                    <a:pt x="452" y="19"/>
                  </a:lnTo>
                  <a:lnTo>
                    <a:pt x="453" y="22"/>
                  </a:lnTo>
                  <a:lnTo>
                    <a:pt x="454" y="22"/>
                  </a:lnTo>
                  <a:lnTo>
                    <a:pt x="455" y="13"/>
                  </a:lnTo>
                  <a:lnTo>
                    <a:pt x="456" y="21"/>
                  </a:lnTo>
                  <a:lnTo>
                    <a:pt x="457" y="19"/>
                  </a:lnTo>
                  <a:lnTo>
                    <a:pt x="458" y="22"/>
                  </a:lnTo>
                  <a:lnTo>
                    <a:pt x="459" y="18"/>
                  </a:lnTo>
                  <a:lnTo>
                    <a:pt x="460" y="22"/>
                  </a:lnTo>
                  <a:lnTo>
                    <a:pt x="460" y="20"/>
                  </a:lnTo>
                  <a:lnTo>
                    <a:pt x="461" y="21"/>
                  </a:lnTo>
                  <a:lnTo>
                    <a:pt x="462" y="22"/>
                  </a:lnTo>
                  <a:lnTo>
                    <a:pt x="463" y="23"/>
                  </a:lnTo>
                  <a:lnTo>
                    <a:pt x="464" y="22"/>
                  </a:lnTo>
                  <a:lnTo>
                    <a:pt x="465" y="19"/>
                  </a:lnTo>
                  <a:lnTo>
                    <a:pt x="466" y="17"/>
                  </a:lnTo>
                  <a:lnTo>
                    <a:pt x="467" y="16"/>
                  </a:lnTo>
                  <a:lnTo>
                    <a:pt x="467" y="18"/>
                  </a:lnTo>
                  <a:lnTo>
                    <a:pt x="468" y="19"/>
                  </a:lnTo>
                  <a:lnTo>
                    <a:pt x="469" y="19"/>
                  </a:lnTo>
                  <a:lnTo>
                    <a:pt x="470" y="15"/>
                  </a:lnTo>
                  <a:lnTo>
                    <a:pt x="471" y="18"/>
                  </a:lnTo>
                  <a:lnTo>
                    <a:pt x="472" y="17"/>
                  </a:lnTo>
                  <a:lnTo>
                    <a:pt x="473" y="15"/>
                  </a:lnTo>
                  <a:lnTo>
                    <a:pt x="474" y="16"/>
                  </a:lnTo>
                  <a:lnTo>
                    <a:pt x="475" y="18"/>
                  </a:lnTo>
                  <a:lnTo>
                    <a:pt x="475" y="15"/>
                  </a:lnTo>
                  <a:lnTo>
                    <a:pt x="476" y="12"/>
                  </a:lnTo>
                  <a:lnTo>
                    <a:pt x="477" y="14"/>
                  </a:lnTo>
                  <a:lnTo>
                    <a:pt x="478" y="16"/>
                  </a:lnTo>
                  <a:lnTo>
                    <a:pt x="479" y="17"/>
                  </a:lnTo>
                  <a:lnTo>
                    <a:pt x="480" y="18"/>
                  </a:lnTo>
                  <a:lnTo>
                    <a:pt x="481" y="19"/>
                  </a:lnTo>
                  <a:lnTo>
                    <a:pt x="482" y="16"/>
                  </a:lnTo>
                  <a:lnTo>
                    <a:pt x="482" y="15"/>
                  </a:lnTo>
                  <a:lnTo>
                    <a:pt x="483" y="19"/>
                  </a:lnTo>
                  <a:lnTo>
                    <a:pt x="484" y="13"/>
                  </a:lnTo>
                  <a:lnTo>
                    <a:pt x="485" y="15"/>
                  </a:lnTo>
                  <a:lnTo>
                    <a:pt x="486" y="16"/>
                  </a:lnTo>
                  <a:lnTo>
                    <a:pt x="487" y="11"/>
                  </a:lnTo>
                  <a:lnTo>
                    <a:pt x="488" y="18"/>
                  </a:lnTo>
                  <a:lnTo>
                    <a:pt x="489" y="19"/>
                  </a:lnTo>
                  <a:lnTo>
                    <a:pt x="490" y="13"/>
                  </a:lnTo>
                  <a:lnTo>
                    <a:pt x="490" y="16"/>
                  </a:lnTo>
                  <a:lnTo>
                    <a:pt x="491" y="14"/>
                  </a:lnTo>
                  <a:lnTo>
                    <a:pt x="492" y="13"/>
                  </a:lnTo>
                  <a:lnTo>
                    <a:pt x="493" y="11"/>
                  </a:lnTo>
                  <a:lnTo>
                    <a:pt x="494" y="17"/>
                  </a:lnTo>
                  <a:lnTo>
                    <a:pt x="495" y="11"/>
                  </a:lnTo>
                  <a:lnTo>
                    <a:pt x="496" y="20"/>
                  </a:lnTo>
                  <a:lnTo>
                    <a:pt x="497" y="17"/>
                  </a:lnTo>
                  <a:lnTo>
                    <a:pt x="497" y="11"/>
                  </a:lnTo>
                  <a:lnTo>
                    <a:pt x="498" y="19"/>
                  </a:lnTo>
                  <a:lnTo>
                    <a:pt x="499" y="16"/>
                  </a:lnTo>
                  <a:lnTo>
                    <a:pt x="500" y="15"/>
                  </a:lnTo>
                  <a:lnTo>
                    <a:pt x="501" y="16"/>
                  </a:lnTo>
                  <a:lnTo>
                    <a:pt x="502" y="19"/>
                  </a:lnTo>
                  <a:lnTo>
                    <a:pt x="503" y="16"/>
                  </a:lnTo>
                  <a:lnTo>
                    <a:pt x="504" y="16"/>
                  </a:lnTo>
                  <a:lnTo>
                    <a:pt x="505" y="17"/>
                  </a:lnTo>
                  <a:lnTo>
                    <a:pt x="505" y="12"/>
                  </a:lnTo>
                  <a:lnTo>
                    <a:pt x="506" y="17"/>
                  </a:lnTo>
                  <a:lnTo>
                    <a:pt x="507" y="13"/>
                  </a:lnTo>
                  <a:lnTo>
                    <a:pt x="508" y="22"/>
                  </a:lnTo>
                  <a:lnTo>
                    <a:pt x="509" y="15"/>
                  </a:lnTo>
                  <a:lnTo>
                    <a:pt x="510" y="17"/>
                  </a:lnTo>
                  <a:lnTo>
                    <a:pt x="511" y="17"/>
                  </a:lnTo>
                  <a:lnTo>
                    <a:pt x="512" y="18"/>
                  </a:lnTo>
                  <a:lnTo>
                    <a:pt x="512" y="21"/>
                  </a:lnTo>
                  <a:lnTo>
                    <a:pt x="513" y="20"/>
                  </a:lnTo>
                  <a:lnTo>
                    <a:pt x="514" y="24"/>
                  </a:lnTo>
                  <a:lnTo>
                    <a:pt x="515" y="19"/>
                  </a:lnTo>
                  <a:lnTo>
                    <a:pt x="516" y="26"/>
                  </a:lnTo>
                  <a:lnTo>
                    <a:pt x="517" y="24"/>
                  </a:lnTo>
                  <a:lnTo>
                    <a:pt x="518" y="26"/>
                  </a:lnTo>
                  <a:lnTo>
                    <a:pt x="519" y="24"/>
                  </a:lnTo>
                  <a:lnTo>
                    <a:pt x="520" y="21"/>
                  </a:lnTo>
                  <a:lnTo>
                    <a:pt x="520" y="20"/>
                  </a:lnTo>
                  <a:lnTo>
                    <a:pt x="521" y="23"/>
                  </a:lnTo>
                  <a:lnTo>
                    <a:pt x="522" y="18"/>
                  </a:lnTo>
                  <a:lnTo>
                    <a:pt x="523" y="16"/>
                  </a:lnTo>
                  <a:lnTo>
                    <a:pt x="524" y="22"/>
                  </a:lnTo>
                  <a:lnTo>
                    <a:pt x="525" y="15"/>
                  </a:lnTo>
                  <a:lnTo>
                    <a:pt x="526" y="21"/>
                  </a:lnTo>
                  <a:lnTo>
                    <a:pt x="527" y="16"/>
                  </a:lnTo>
                  <a:lnTo>
                    <a:pt x="527" y="16"/>
                  </a:lnTo>
                  <a:lnTo>
                    <a:pt x="528" y="16"/>
                  </a:lnTo>
                  <a:lnTo>
                    <a:pt x="529" y="16"/>
                  </a:lnTo>
                  <a:lnTo>
                    <a:pt x="530" y="21"/>
                  </a:lnTo>
                  <a:lnTo>
                    <a:pt x="531" y="19"/>
                  </a:lnTo>
                  <a:lnTo>
                    <a:pt x="532" y="24"/>
                  </a:lnTo>
                  <a:lnTo>
                    <a:pt x="533" y="24"/>
                  </a:lnTo>
                  <a:lnTo>
                    <a:pt x="534" y="20"/>
                  </a:lnTo>
                  <a:lnTo>
                    <a:pt x="535" y="20"/>
                  </a:lnTo>
                  <a:lnTo>
                    <a:pt x="535" y="21"/>
                  </a:lnTo>
                  <a:lnTo>
                    <a:pt x="536" y="27"/>
                  </a:lnTo>
                  <a:lnTo>
                    <a:pt x="537" y="19"/>
                  </a:lnTo>
                  <a:lnTo>
                    <a:pt x="538" y="18"/>
                  </a:lnTo>
                  <a:lnTo>
                    <a:pt x="539" y="21"/>
                  </a:lnTo>
                  <a:lnTo>
                    <a:pt x="540" y="21"/>
                  </a:lnTo>
                  <a:lnTo>
                    <a:pt x="541" y="15"/>
                  </a:lnTo>
                  <a:lnTo>
                    <a:pt x="542" y="14"/>
                  </a:lnTo>
                  <a:lnTo>
                    <a:pt x="542" y="13"/>
                  </a:lnTo>
                  <a:lnTo>
                    <a:pt x="543" y="16"/>
                  </a:lnTo>
                  <a:lnTo>
                    <a:pt x="544" y="18"/>
                  </a:lnTo>
                  <a:lnTo>
                    <a:pt x="545" y="19"/>
                  </a:lnTo>
                  <a:lnTo>
                    <a:pt x="546" y="16"/>
                  </a:lnTo>
                  <a:lnTo>
                    <a:pt x="547" y="17"/>
                  </a:lnTo>
                  <a:lnTo>
                    <a:pt x="548" y="16"/>
                  </a:lnTo>
                  <a:lnTo>
                    <a:pt x="549" y="18"/>
                  </a:lnTo>
                  <a:lnTo>
                    <a:pt x="550" y="18"/>
                  </a:lnTo>
                  <a:lnTo>
                    <a:pt x="550" y="16"/>
                  </a:lnTo>
                  <a:lnTo>
                    <a:pt x="551" y="19"/>
                  </a:lnTo>
                  <a:lnTo>
                    <a:pt x="552" y="16"/>
                  </a:lnTo>
                  <a:lnTo>
                    <a:pt x="553" y="17"/>
                  </a:lnTo>
                  <a:lnTo>
                    <a:pt x="554" y="17"/>
                  </a:lnTo>
                  <a:lnTo>
                    <a:pt x="555" y="16"/>
                  </a:lnTo>
                  <a:lnTo>
                    <a:pt x="556" y="14"/>
                  </a:lnTo>
                  <a:lnTo>
                    <a:pt x="557" y="15"/>
                  </a:lnTo>
                  <a:lnTo>
                    <a:pt x="557" y="12"/>
                  </a:lnTo>
                  <a:lnTo>
                    <a:pt x="558" y="13"/>
                  </a:lnTo>
                  <a:lnTo>
                    <a:pt x="559" y="15"/>
                  </a:lnTo>
                  <a:lnTo>
                    <a:pt x="560" y="14"/>
                  </a:lnTo>
                  <a:lnTo>
                    <a:pt x="561" y="13"/>
                  </a:lnTo>
                  <a:lnTo>
                    <a:pt x="562" y="15"/>
                  </a:lnTo>
                  <a:lnTo>
                    <a:pt x="563" y="15"/>
                  </a:lnTo>
                  <a:lnTo>
                    <a:pt x="564" y="15"/>
                  </a:lnTo>
                  <a:lnTo>
                    <a:pt x="565" y="14"/>
                  </a:lnTo>
                  <a:lnTo>
                    <a:pt x="565" y="13"/>
                  </a:lnTo>
                  <a:lnTo>
                    <a:pt x="566" y="8"/>
                  </a:lnTo>
                  <a:lnTo>
                    <a:pt x="567" y="18"/>
                  </a:lnTo>
                  <a:lnTo>
                    <a:pt x="568" y="12"/>
                  </a:lnTo>
                  <a:lnTo>
                    <a:pt x="569" y="12"/>
                  </a:lnTo>
                  <a:lnTo>
                    <a:pt x="570" y="10"/>
                  </a:lnTo>
                  <a:lnTo>
                    <a:pt x="571" y="12"/>
                  </a:lnTo>
                  <a:lnTo>
                    <a:pt x="572" y="13"/>
                  </a:lnTo>
                  <a:lnTo>
                    <a:pt x="572" y="13"/>
                  </a:lnTo>
                  <a:lnTo>
                    <a:pt x="573" y="6"/>
                  </a:lnTo>
                  <a:lnTo>
                    <a:pt x="574" y="14"/>
                  </a:lnTo>
                  <a:lnTo>
                    <a:pt x="575" y="11"/>
                  </a:lnTo>
                  <a:lnTo>
                    <a:pt x="576" y="12"/>
                  </a:lnTo>
                  <a:lnTo>
                    <a:pt x="577" y="12"/>
                  </a:lnTo>
                  <a:lnTo>
                    <a:pt x="578" y="10"/>
                  </a:lnTo>
                  <a:lnTo>
                    <a:pt x="579" y="12"/>
                  </a:lnTo>
                  <a:lnTo>
                    <a:pt x="580" y="10"/>
                  </a:lnTo>
                  <a:lnTo>
                    <a:pt x="580" y="14"/>
                  </a:lnTo>
                  <a:lnTo>
                    <a:pt x="581" y="12"/>
                  </a:lnTo>
                  <a:lnTo>
                    <a:pt x="582" y="8"/>
                  </a:lnTo>
                  <a:lnTo>
                    <a:pt x="583" y="12"/>
                  </a:lnTo>
                  <a:lnTo>
                    <a:pt x="584" y="9"/>
                  </a:lnTo>
                  <a:lnTo>
                    <a:pt x="585" y="16"/>
                  </a:lnTo>
                  <a:lnTo>
                    <a:pt x="586" y="10"/>
                  </a:lnTo>
                  <a:lnTo>
                    <a:pt x="587" y="16"/>
                  </a:lnTo>
                  <a:lnTo>
                    <a:pt x="587" y="8"/>
                  </a:lnTo>
                  <a:lnTo>
                    <a:pt x="588" y="10"/>
                  </a:lnTo>
                  <a:lnTo>
                    <a:pt x="589" y="13"/>
                  </a:lnTo>
                  <a:lnTo>
                    <a:pt x="590" y="7"/>
                  </a:lnTo>
                  <a:lnTo>
                    <a:pt x="591" y="10"/>
                  </a:lnTo>
                  <a:lnTo>
                    <a:pt x="592" y="10"/>
                  </a:lnTo>
                  <a:lnTo>
                    <a:pt x="593" y="8"/>
                  </a:lnTo>
                  <a:lnTo>
                    <a:pt x="594" y="13"/>
                  </a:lnTo>
                  <a:lnTo>
                    <a:pt x="595" y="11"/>
                  </a:lnTo>
                  <a:lnTo>
                    <a:pt x="595" y="7"/>
                  </a:lnTo>
                  <a:lnTo>
                    <a:pt x="596" y="10"/>
                  </a:lnTo>
                  <a:lnTo>
                    <a:pt x="597" y="9"/>
                  </a:lnTo>
                  <a:lnTo>
                    <a:pt x="598" y="16"/>
                  </a:lnTo>
                  <a:lnTo>
                    <a:pt x="599" y="11"/>
                  </a:lnTo>
                  <a:lnTo>
                    <a:pt x="600" y="14"/>
                  </a:lnTo>
                  <a:lnTo>
                    <a:pt x="601" y="12"/>
                  </a:lnTo>
                  <a:lnTo>
                    <a:pt x="602" y="15"/>
                  </a:lnTo>
                  <a:lnTo>
                    <a:pt x="602" y="16"/>
                  </a:lnTo>
                  <a:lnTo>
                    <a:pt x="603" y="10"/>
                  </a:lnTo>
                  <a:lnTo>
                    <a:pt x="604" y="11"/>
                  </a:lnTo>
                  <a:lnTo>
                    <a:pt x="605" y="13"/>
                  </a:lnTo>
                  <a:lnTo>
                    <a:pt x="606" y="16"/>
                  </a:lnTo>
                  <a:lnTo>
                    <a:pt x="607" y="11"/>
                  </a:lnTo>
                  <a:lnTo>
                    <a:pt x="608" y="15"/>
                  </a:lnTo>
                  <a:lnTo>
                    <a:pt x="609" y="13"/>
                  </a:lnTo>
                  <a:lnTo>
                    <a:pt x="610" y="10"/>
                  </a:lnTo>
                  <a:lnTo>
                    <a:pt x="610" y="14"/>
                  </a:lnTo>
                  <a:lnTo>
                    <a:pt x="611" y="14"/>
                  </a:lnTo>
                  <a:lnTo>
                    <a:pt x="612" y="12"/>
                  </a:lnTo>
                  <a:lnTo>
                    <a:pt x="613" y="13"/>
                  </a:lnTo>
                  <a:lnTo>
                    <a:pt x="614" y="17"/>
                  </a:lnTo>
                  <a:lnTo>
                    <a:pt x="615" y="8"/>
                  </a:lnTo>
                  <a:lnTo>
                    <a:pt x="616" y="18"/>
                  </a:lnTo>
                  <a:lnTo>
                    <a:pt x="617" y="11"/>
                  </a:lnTo>
                  <a:lnTo>
                    <a:pt x="617" y="10"/>
                  </a:lnTo>
                  <a:lnTo>
                    <a:pt x="618" y="14"/>
                  </a:lnTo>
                  <a:lnTo>
                    <a:pt x="619" y="13"/>
                  </a:lnTo>
                  <a:lnTo>
                    <a:pt x="620" y="15"/>
                  </a:lnTo>
                  <a:lnTo>
                    <a:pt x="621" y="7"/>
                  </a:lnTo>
                  <a:lnTo>
                    <a:pt x="622" y="12"/>
                  </a:lnTo>
                  <a:lnTo>
                    <a:pt x="623" y="12"/>
                  </a:lnTo>
                  <a:lnTo>
                    <a:pt x="624" y="15"/>
                  </a:lnTo>
                  <a:lnTo>
                    <a:pt x="624" y="10"/>
                  </a:lnTo>
                  <a:lnTo>
                    <a:pt x="625" y="9"/>
                  </a:lnTo>
                  <a:lnTo>
                    <a:pt x="626" y="12"/>
                  </a:lnTo>
                  <a:lnTo>
                    <a:pt x="627" y="13"/>
                  </a:lnTo>
                  <a:lnTo>
                    <a:pt x="628" y="13"/>
                  </a:lnTo>
                  <a:lnTo>
                    <a:pt x="629" y="8"/>
                  </a:lnTo>
                  <a:lnTo>
                    <a:pt x="630" y="14"/>
                  </a:lnTo>
                  <a:lnTo>
                    <a:pt x="631" y="9"/>
                  </a:lnTo>
                  <a:lnTo>
                    <a:pt x="632" y="8"/>
                  </a:lnTo>
                  <a:lnTo>
                    <a:pt x="632" y="12"/>
                  </a:lnTo>
                  <a:lnTo>
                    <a:pt x="633" y="9"/>
                  </a:lnTo>
                  <a:lnTo>
                    <a:pt x="634" y="11"/>
                  </a:lnTo>
                  <a:lnTo>
                    <a:pt x="635" y="10"/>
                  </a:lnTo>
                  <a:lnTo>
                    <a:pt x="636" y="12"/>
                  </a:lnTo>
                  <a:lnTo>
                    <a:pt x="637" y="15"/>
                  </a:lnTo>
                  <a:lnTo>
                    <a:pt x="638" y="12"/>
                  </a:lnTo>
                  <a:lnTo>
                    <a:pt x="639" y="10"/>
                  </a:lnTo>
                  <a:lnTo>
                    <a:pt x="639" y="10"/>
                  </a:lnTo>
                  <a:lnTo>
                    <a:pt x="640" y="10"/>
                  </a:lnTo>
                  <a:lnTo>
                    <a:pt x="641" y="11"/>
                  </a:lnTo>
                  <a:lnTo>
                    <a:pt x="642" y="13"/>
                  </a:lnTo>
                  <a:lnTo>
                    <a:pt x="643" y="11"/>
                  </a:lnTo>
                  <a:lnTo>
                    <a:pt x="644" y="7"/>
                  </a:lnTo>
                  <a:lnTo>
                    <a:pt x="645" y="10"/>
                  </a:lnTo>
                  <a:lnTo>
                    <a:pt x="646" y="10"/>
                  </a:lnTo>
                  <a:lnTo>
                    <a:pt x="647" y="6"/>
                  </a:lnTo>
                  <a:lnTo>
                    <a:pt x="647" y="12"/>
                  </a:lnTo>
                  <a:lnTo>
                    <a:pt x="648" y="12"/>
                  </a:lnTo>
                  <a:lnTo>
                    <a:pt x="649" y="14"/>
                  </a:lnTo>
                  <a:lnTo>
                    <a:pt x="650" y="10"/>
                  </a:lnTo>
                  <a:lnTo>
                    <a:pt x="651" y="11"/>
                  </a:lnTo>
                  <a:lnTo>
                    <a:pt x="652" y="7"/>
                  </a:lnTo>
                  <a:lnTo>
                    <a:pt x="653" y="12"/>
                  </a:lnTo>
                  <a:lnTo>
                    <a:pt x="654" y="11"/>
                  </a:lnTo>
                  <a:lnTo>
                    <a:pt x="654" y="11"/>
                  </a:lnTo>
                  <a:lnTo>
                    <a:pt x="655" y="9"/>
                  </a:lnTo>
                  <a:lnTo>
                    <a:pt x="656" y="7"/>
                  </a:lnTo>
                  <a:lnTo>
                    <a:pt x="657" y="9"/>
                  </a:lnTo>
                  <a:lnTo>
                    <a:pt x="658" y="12"/>
                  </a:lnTo>
                  <a:lnTo>
                    <a:pt x="659" y="8"/>
                  </a:lnTo>
                  <a:lnTo>
                    <a:pt x="660" y="11"/>
                  </a:lnTo>
                  <a:lnTo>
                    <a:pt x="661" y="7"/>
                  </a:lnTo>
                  <a:lnTo>
                    <a:pt x="662" y="6"/>
                  </a:lnTo>
                  <a:lnTo>
                    <a:pt x="662" y="8"/>
                  </a:lnTo>
                  <a:lnTo>
                    <a:pt x="663" y="13"/>
                  </a:lnTo>
                  <a:lnTo>
                    <a:pt x="664" y="11"/>
                  </a:lnTo>
                  <a:lnTo>
                    <a:pt x="665" y="12"/>
                  </a:lnTo>
                  <a:lnTo>
                    <a:pt x="666" y="10"/>
                  </a:lnTo>
                  <a:lnTo>
                    <a:pt x="667" y="8"/>
                  </a:lnTo>
                  <a:lnTo>
                    <a:pt x="668" y="11"/>
                  </a:lnTo>
                  <a:lnTo>
                    <a:pt x="669" y="10"/>
                  </a:lnTo>
                  <a:lnTo>
                    <a:pt x="669" y="8"/>
                  </a:lnTo>
                  <a:lnTo>
                    <a:pt x="670" y="8"/>
                  </a:lnTo>
                  <a:lnTo>
                    <a:pt x="671" y="10"/>
                  </a:lnTo>
                  <a:lnTo>
                    <a:pt x="672" y="9"/>
                  </a:lnTo>
                  <a:lnTo>
                    <a:pt x="673" y="4"/>
                  </a:lnTo>
                  <a:lnTo>
                    <a:pt x="674" y="13"/>
                  </a:lnTo>
                  <a:lnTo>
                    <a:pt x="675" y="10"/>
                  </a:lnTo>
                  <a:lnTo>
                    <a:pt x="676" y="11"/>
                  </a:lnTo>
                  <a:lnTo>
                    <a:pt x="677" y="8"/>
                  </a:lnTo>
                  <a:lnTo>
                    <a:pt x="677" y="13"/>
                  </a:lnTo>
                  <a:lnTo>
                    <a:pt x="678" y="13"/>
                  </a:lnTo>
                  <a:lnTo>
                    <a:pt x="679" y="11"/>
                  </a:lnTo>
                  <a:lnTo>
                    <a:pt x="680" y="12"/>
                  </a:lnTo>
                  <a:lnTo>
                    <a:pt x="681" y="4"/>
                  </a:lnTo>
                  <a:lnTo>
                    <a:pt x="682" y="12"/>
                  </a:lnTo>
                  <a:lnTo>
                    <a:pt x="683" y="16"/>
                  </a:lnTo>
                  <a:lnTo>
                    <a:pt x="684" y="5"/>
                  </a:lnTo>
                  <a:lnTo>
                    <a:pt x="684" y="10"/>
                  </a:lnTo>
                  <a:lnTo>
                    <a:pt x="685" y="9"/>
                  </a:lnTo>
                  <a:lnTo>
                    <a:pt x="686" y="11"/>
                  </a:lnTo>
                  <a:lnTo>
                    <a:pt x="687" y="13"/>
                  </a:lnTo>
                  <a:lnTo>
                    <a:pt x="688" y="7"/>
                  </a:lnTo>
                  <a:lnTo>
                    <a:pt x="689" y="12"/>
                  </a:lnTo>
                  <a:lnTo>
                    <a:pt x="690" y="7"/>
                  </a:lnTo>
                  <a:lnTo>
                    <a:pt x="691" y="8"/>
                  </a:lnTo>
                  <a:lnTo>
                    <a:pt x="692" y="10"/>
                  </a:lnTo>
                  <a:lnTo>
                    <a:pt x="692" y="12"/>
                  </a:lnTo>
                  <a:lnTo>
                    <a:pt x="693" y="9"/>
                  </a:lnTo>
                  <a:lnTo>
                    <a:pt x="694" y="5"/>
                  </a:lnTo>
                  <a:lnTo>
                    <a:pt x="695" y="11"/>
                  </a:lnTo>
                  <a:lnTo>
                    <a:pt x="696" y="14"/>
                  </a:lnTo>
                  <a:lnTo>
                    <a:pt x="697" y="11"/>
                  </a:lnTo>
                  <a:lnTo>
                    <a:pt x="698" y="12"/>
                  </a:lnTo>
                  <a:lnTo>
                    <a:pt x="699" y="16"/>
                  </a:lnTo>
                  <a:lnTo>
                    <a:pt x="699" y="9"/>
                  </a:lnTo>
                  <a:lnTo>
                    <a:pt x="700" y="9"/>
                  </a:lnTo>
                  <a:lnTo>
                    <a:pt x="701" y="10"/>
                  </a:lnTo>
                  <a:lnTo>
                    <a:pt x="702" y="9"/>
                  </a:lnTo>
                  <a:lnTo>
                    <a:pt x="703" y="11"/>
                  </a:lnTo>
                  <a:lnTo>
                    <a:pt x="704" y="15"/>
                  </a:lnTo>
                  <a:lnTo>
                    <a:pt x="705" y="6"/>
                  </a:lnTo>
                  <a:lnTo>
                    <a:pt x="706" y="11"/>
                  </a:lnTo>
                  <a:lnTo>
                    <a:pt x="707" y="15"/>
                  </a:lnTo>
                  <a:lnTo>
                    <a:pt x="707" y="11"/>
                  </a:lnTo>
                  <a:lnTo>
                    <a:pt x="708" y="8"/>
                  </a:lnTo>
                  <a:lnTo>
                    <a:pt x="709" y="13"/>
                  </a:lnTo>
                  <a:lnTo>
                    <a:pt x="710" y="10"/>
                  </a:lnTo>
                  <a:lnTo>
                    <a:pt x="711" y="12"/>
                  </a:lnTo>
                  <a:lnTo>
                    <a:pt x="712" y="14"/>
                  </a:lnTo>
                  <a:lnTo>
                    <a:pt x="713" y="11"/>
                  </a:lnTo>
                  <a:lnTo>
                    <a:pt x="714" y="11"/>
                  </a:lnTo>
                  <a:lnTo>
                    <a:pt x="714" y="14"/>
                  </a:lnTo>
                  <a:lnTo>
                    <a:pt x="715" y="11"/>
                  </a:lnTo>
                  <a:lnTo>
                    <a:pt x="716" y="12"/>
                  </a:lnTo>
                  <a:lnTo>
                    <a:pt x="717" y="12"/>
                  </a:lnTo>
                  <a:lnTo>
                    <a:pt x="718" y="12"/>
                  </a:lnTo>
                  <a:lnTo>
                    <a:pt x="719" y="6"/>
                  </a:lnTo>
                  <a:lnTo>
                    <a:pt x="720" y="7"/>
                  </a:lnTo>
                  <a:lnTo>
                    <a:pt x="721" y="10"/>
                  </a:lnTo>
                  <a:lnTo>
                    <a:pt x="722" y="15"/>
                  </a:lnTo>
                  <a:lnTo>
                    <a:pt x="722" y="9"/>
                  </a:lnTo>
                  <a:lnTo>
                    <a:pt x="723" y="10"/>
                  </a:lnTo>
                  <a:lnTo>
                    <a:pt x="724" y="6"/>
                  </a:lnTo>
                  <a:lnTo>
                    <a:pt x="725" y="9"/>
                  </a:lnTo>
                  <a:lnTo>
                    <a:pt x="726" y="9"/>
                  </a:lnTo>
                  <a:lnTo>
                    <a:pt x="727" y="11"/>
                  </a:lnTo>
                  <a:lnTo>
                    <a:pt x="728" y="12"/>
                  </a:lnTo>
                  <a:lnTo>
                    <a:pt x="729" y="8"/>
                  </a:lnTo>
                  <a:lnTo>
                    <a:pt x="729" y="8"/>
                  </a:lnTo>
                  <a:lnTo>
                    <a:pt x="730" y="11"/>
                  </a:lnTo>
                  <a:lnTo>
                    <a:pt x="731" y="10"/>
                  </a:lnTo>
                  <a:lnTo>
                    <a:pt x="732" y="15"/>
                  </a:lnTo>
                  <a:lnTo>
                    <a:pt x="733" y="11"/>
                  </a:lnTo>
                  <a:lnTo>
                    <a:pt x="734" y="8"/>
                  </a:lnTo>
                  <a:lnTo>
                    <a:pt x="735" y="11"/>
                  </a:lnTo>
                  <a:lnTo>
                    <a:pt x="736" y="8"/>
                  </a:lnTo>
                  <a:lnTo>
                    <a:pt x="737" y="16"/>
                  </a:lnTo>
                  <a:lnTo>
                    <a:pt x="737" y="16"/>
                  </a:lnTo>
                  <a:lnTo>
                    <a:pt x="738" y="9"/>
                  </a:lnTo>
                  <a:lnTo>
                    <a:pt x="739" y="12"/>
                  </a:lnTo>
                  <a:lnTo>
                    <a:pt x="740" y="6"/>
                  </a:lnTo>
                  <a:lnTo>
                    <a:pt x="741" y="14"/>
                  </a:lnTo>
                  <a:lnTo>
                    <a:pt x="742" y="8"/>
                  </a:lnTo>
                  <a:lnTo>
                    <a:pt x="743" y="11"/>
                  </a:lnTo>
                  <a:lnTo>
                    <a:pt x="744" y="9"/>
                  </a:lnTo>
                  <a:lnTo>
                    <a:pt x="744" y="10"/>
                  </a:lnTo>
                  <a:lnTo>
                    <a:pt x="745" y="8"/>
                  </a:lnTo>
                  <a:lnTo>
                    <a:pt x="746" y="9"/>
                  </a:lnTo>
                  <a:lnTo>
                    <a:pt x="747" y="9"/>
                  </a:lnTo>
                  <a:lnTo>
                    <a:pt x="748" y="8"/>
                  </a:lnTo>
                  <a:lnTo>
                    <a:pt x="749" y="12"/>
                  </a:lnTo>
                  <a:lnTo>
                    <a:pt x="750" y="5"/>
                  </a:lnTo>
                  <a:lnTo>
                    <a:pt x="751" y="9"/>
                  </a:lnTo>
                  <a:lnTo>
                    <a:pt x="752" y="12"/>
                  </a:lnTo>
                  <a:lnTo>
                    <a:pt x="752" y="10"/>
                  </a:lnTo>
                  <a:lnTo>
                    <a:pt x="753" y="8"/>
                  </a:lnTo>
                  <a:lnTo>
                    <a:pt x="754" y="11"/>
                  </a:lnTo>
                  <a:lnTo>
                    <a:pt x="755" y="10"/>
                  </a:lnTo>
                  <a:lnTo>
                    <a:pt x="756" y="7"/>
                  </a:lnTo>
                  <a:lnTo>
                    <a:pt x="757" y="7"/>
                  </a:lnTo>
                  <a:lnTo>
                    <a:pt x="758" y="5"/>
                  </a:lnTo>
                  <a:lnTo>
                    <a:pt x="759" y="8"/>
                  </a:lnTo>
                  <a:lnTo>
                    <a:pt x="759" y="12"/>
                  </a:lnTo>
                  <a:lnTo>
                    <a:pt x="760" y="12"/>
                  </a:lnTo>
                  <a:lnTo>
                    <a:pt x="761" y="8"/>
                  </a:lnTo>
                  <a:lnTo>
                    <a:pt x="762" y="11"/>
                  </a:lnTo>
                  <a:lnTo>
                    <a:pt x="763" y="9"/>
                  </a:lnTo>
                  <a:lnTo>
                    <a:pt x="764" y="8"/>
                  </a:lnTo>
                  <a:lnTo>
                    <a:pt x="765" y="7"/>
                  </a:lnTo>
                  <a:lnTo>
                    <a:pt x="766" y="6"/>
                  </a:lnTo>
                  <a:lnTo>
                    <a:pt x="767" y="6"/>
                  </a:lnTo>
                  <a:lnTo>
                    <a:pt x="767" y="6"/>
                  </a:lnTo>
                  <a:lnTo>
                    <a:pt x="768" y="6"/>
                  </a:lnTo>
                  <a:lnTo>
                    <a:pt x="769" y="6"/>
                  </a:lnTo>
                  <a:lnTo>
                    <a:pt x="770" y="8"/>
                  </a:lnTo>
                  <a:lnTo>
                    <a:pt x="771" y="13"/>
                  </a:lnTo>
                  <a:lnTo>
                    <a:pt x="772" y="12"/>
                  </a:lnTo>
                  <a:lnTo>
                    <a:pt x="773" y="10"/>
                  </a:lnTo>
                  <a:lnTo>
                    <a:pt x="773" y="1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cxnSp>
        <p:nvCxnSpPr>
          <p:cNvPr id="3" name="Straight Arrow Connector 2"/>
          <p:cNvCxnSpPr>
            <a:stCxn id="197" idx="2"/>
          </p:cNvCxnSpPr>
          <p:nvPr/>
        </p:nvCxnSpPr>
        <p:spPr>
          <a:xfrm>
            <a:off x="1757371" y="4918274"/>
            <a:ext cx="82397" cy="214019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8" name="TextBox 237"/>
          <p:cNvSpPr txBox="1"/>
          <p:nvPr/>
        </p:nvSpPr>
        <p:spPr>
          <a:xfrm>
            <a:off x="2335602" y="495718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" name="TextBox 238"/>
          <p:cNvSpPr txBox="1"/>
          <p:nvPr/>
        </p:nvSpPr>
        <p:spPr>
          <a:xfrm>
            <a:off x="1698266" y="642167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56491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85"/>
          <p:cNvSpPr txBox="1"/>
          <p:nvPr/>
        </p:nvSpPr>
        <p:spPr>
          <a:xfrm>
            <a:off x="304800" y="6477000"/>
            <a:ext cx="61722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3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etermination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bsolute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figuration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(1S,5S,7R,10R)-guaia-4(15)-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n-11-ol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nantioselective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uteration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rtial HSQC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pectra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)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l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guaia-4(15)-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n-11-ol (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gio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C2, C6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C8), guaia-4(15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)-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n-11-ol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btain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B) (</a:t>
            </a:r>
            <a:r>
              <a:rPr lang="de-DE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-(1-</a:t>
            </a:r>
            <a:r>
              <a:rPr lang="de-DE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,1-</a:t>
            </a:r>
            <a:r>
              <a:rPr lang="de-DE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)IPP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C) (</a:t>
            </a:r>
            <a:r>
              <a:rPr lang="de-DE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-(1-</a:t>
            </a:r>
            <a:r>
              <a:rPr lang="de-DE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,1-</a:t>
            </a:r>
            <a:r>
              <a:rPr lang="de-DE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)IPP, D)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l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guaia-4(15)-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n-11-ol (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gio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C3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C9)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guaia-4(15)-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n-11-ol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btain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E) (</a:t>
            </a:r>
            <a:r>
              <a:rPr lang="de-DE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-(4-</a:t>
            </a:r>
            <a:r>
              <a:rPr lang="de-DE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,4-</a:t>
            </a:r>
            <a:r>
              <a:rPr lang="de-DE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)IPP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F) (</a:t>
            </a:r>
            <a:r>
              <a:rPr lang="de-DE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-(4-</a:t>
            </a:r>
            <a:r>
              <a:rPr lang="de-DE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,4-</a:t>
            </a:r>
            <a:r>
              <a:rPr lang="de-DE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)IPP.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ake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gether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s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tablish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bsolute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figuratio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(1</a:t>
            </a:r>
            <a:r>
              <a:rPr lang="de-DE" sz="1200" i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,5</a:t>
            </a:r>
            <a:r>
              <a:rPr lang="de-DE" sz="1200" i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,7</a:t>
            </a:r>
            <a:r>
              <a:rPr lang="de-DE" sz="12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,10</a:t>
            </a:r>
            <a:r>
              <a:rPr lang="de-DE" sz="12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)-guaia-4(15)-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n-11-ol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038" y="533400"/>
            <a:ext cx="6077724" cy="57637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22069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7</Words>
  <Application>Microsoft Office PowerPoint</Application>
  <PresentationFormat>On-screen Show (4:3)</PresentationFormat>
  <Paragraphs>9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MPI for chemical ecolog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bias Koellner</dc:creator>
  <cp:lastModifiedBy>Tobias Koellner</cp:lastModifiedBy>
  <cp:revision>42</cp:revision>
  <cp:lastPrinted>2021-01-14T15:10:19Z</cp:lastPrinted>
  <dcterms:created xsi:type="dcterms:W3CDTF">2020-06-30T11:29:02Z</dcterms:created>
  <dcterms:modified xsi:type="dcterms:W3CDTF">2021-01-15T11:24:44Z</dcterms:modified>
</cp:coreProperties>
</file>